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autoCompressPictures="0">
  <p:sldMasterIdLst>
    <p:sldMasterId id="2147483696" r:id="rId1"/>
  </p:sldMasterIdLst>
  <p:notesMasterIdLst>
    <p:notesMasterId r:id="rId10"/>
  </p:notesMasterIdLst>
  <p:handoutMasterIdLst>
    <p:handoutMasterId r:id="rId11"/>
  </p:handoutMasterIdLst>
  <p:sldIdLst>
    <p:sldId id="415" r:id="rId2"/>
    <p:sldId id="467" r:id="rId3"/>
    <p:sldId id="390" r:id="rId4"/>
    <p:sldId id="455" r:id="rId5"/>
    <p:sldId id="465" r:id="rId6"/>
    <p:sldId id="462" r:id="rId7"/>
    <p:sldId id="474" r:id="rId8"/>
    <p:sldId id="400" r:id="rId9"/>
  </p:sldIdLst>
  <p:sldSz cx="6408738" cy="9359900"/>
  <p:notesSz cx="7010400" cy="9296400"/>
  <p:embeddedFontLst>
    <p:embeddedFont>
      <p:font typeface="Arial Nova" panose="020B0504020202020204" pitchFamily="34" charset="0"/>
      <p:regular r:id="rId12"/>
      <p:bold r:id="rId13"/>
      <p:italic r:id="rId14"/>
      <p:boldItalic r:id="rId15"/>
    </p:embeddedFont>
    <p:embeddedFont>
      <p:font typeface="Calibri" panose="020F0502020204030204" pitchFamily="34" charset="0"/>
      <p:regular r:id="rId16"/>
      <p:bold r:id="rId17"/>
      <p:italic r:id="rId18"/>
      <p:boldItalic r:id="rId19"/>
    </p:embeddedFont>
    <p:embeddedFont>
      <p:font typeface="Calibri Light" panose="020F0302020204030204" pitchFamily="34" charset="0"/>
      <p:regular r:id="rId20"/>
      <p:italic r:id="rId21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48" userDrawn="1">
          <p15:clr>
            <a:srgbClr val="A4A3A4"/>
          </p15:clr>
        </p15:guide>
        <p15:guide id="2" pos="188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later" initials="SC" lastIdx="1" clrIdx="0">
    <p:extLst>
      <p:ext uri="{19B8F6BF-5375-455C-9EA6-DF929625EA0E}">
        <p15:presenceInfo xmlns:p15="http://schemas.microsoft.com/office/powerpoint/2012/main" userId="Slat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009900"/>
    <a:srgbClr val="F0F5AB"/>
    <a:srgbClr val="660066"/>
    <a:srgbClr val="EA8024"/>
    <a:srgbClr val="056E9F"/>
    <a:srgbClr val="F87F16"/>
    <a:srgbClr val="0033CC"/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32" autoAdjust="0"/>
    <p:restoredTop sz="85000" autoAdjust="0"/>
  </p:normalViewPr>
  <p:slideViewPr>
    <p:cSldViewPr snapToGrid="0" showGuides="1">
      <p:cViewPr varScale="1">
        <p:scale>
          <a:sx n="58" d="100"/>
          <a:sy n="58" d="100"/>
        </p:scale>
        <p:origin x="2054" y="22"/>
      </p:cViewPr>
      <p:guideLst>
        <p:guide orient="horz" pos="2948"/>
        <p:guide pos="188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22848"/>
    </p:cViewPr>
  </p:sorterViewPr>
  <p:notesViewPr>
    <p:cSldViewPr snapToGrid="0">
      <p:cViewPr varScale="1">
        <p:scale>
          <a:sx n="59" d="100"/>
          <a:sy n="59" d="100"/>
        </p:scale>
        <p:origin x="2172" y="4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2.fntdata"/><Relationship Id="rId18" Type="http://schemas.openxmlformats.org/officeDocument/2006/relationships/font" Target="fonts/font7.fntdata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font" Target="fonts/font10.fntdata"/><Relationship Id="rId7" Type="http://schemas.openxmlformats.org/officeDocument/2006/relationships/slide" Target="slides/slide6.xml"/><Relationship Id="rId12" Type="http://schemas.openxmlformats.org/officeDocument/2006/relationships/font" Target="fonts/font1.fntdata"/><Relationship Id="rId17" Type="http://schemas.openxmlformats.org/officeDocument/2006/relationships/font" Target="fonts/font6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font" Target="fonts/font5.fntdata"/><Relationship Id="rId20" Type="http://schemas.openxmlformats.org/officeDocument/2006/relationships/font" Target="fonts/font9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font" Target="fonts/font4.fntdata"/><Relationship Id="rId23" Type="http://schemas.openxmlformats.org/officeDocument/2006/relationships/presProps" Target="presProps.xml"/><Relationship Id="rId10" Type="http://schemas.openxmlformats.org/officeDocument/2006/relationships/notesMaster" Target="notesMasters/notesMaster1.xml"/><Relationship Id="rId19" Type="http://schemas.openxmlformats.org/officeDocument/2006/relationships/font" Target="fonts/font8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3.fntdata"/><Relationship Id="rId22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BACD04B-5CD7-400D-BC9B-91E1E951B29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463" cy="4654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8E95B1C-638D-496C-8EBF-DF954DDAC3F6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971321" y="0"/>
            <a:ext cx="3037463" cy="4654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539463-06F6-4FC1-8317-1AAC8C89426C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AAE697-5D23-494D-8C8F-C0643D8FD542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830991"/>
            <a:ext cx="3037463" cy="4654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89411-D43E-4C62-B15D-426F88FB3BD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971321" y="8830991"/>
            <a:ext cx="3037463" cy="4654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038058-E8BF-4715-895F-AF0F99FA87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6983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7840" cy="466434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C1778893-F5E3-4AC7-AC4D-B0FD74FD4FD5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32050" y="1162050"/>
            <a:ext cx="2146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73893"/>
            <a:ext cx="5608320" cy="3660457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8"/>
            <a:ext cx="3037840" cy="466433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8"/>
            <a:ext cx="3037840" cy="466433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1CB293CA-6C74-4C0F-9152-4E77A50058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514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531818"/>
            <a:ext cx="5447427" cy="3258632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4916115"/>
            <a:ext cx="4806554" cy="2259809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100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448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498328"/>
            <a:ext cx="1381884" cy="793208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498328"/>
            <a:ext cx="4065543" cy="793208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947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56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2333478"/>
            <a:ext cx="5527537" cy="3893458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6263769"/>
            <a:ext cx="5527537" cy="2047477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8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491640"/>
            <a:ext cx="2723714" cy="59387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491640"/>
            <a:ext cx="2723714" cy="59387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726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498330"/>
            <a:ext cx="5527537" cy="1809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2294476"/>
            <a:ext cx="2711196" cy="1124487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3418964"/>
            <a:ext cx="2711196" cy="50287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2294476"/>
            <a:ext cx="2724548" cy="1124487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3418964"/>
            <a:ext cx="2724548" cy="50287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7671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00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4525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623993"/>
            <a:ext cx="2066985" cy="2183977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347654"/>
            <a:ext cx="3244424" cy="6651596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807970"/>
            <a:ext cx="2066985" cy="5202112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992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623993"/>
            <a:ext cx="2066985" cy="2183977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347654"/>
            <a:ext cx="3244424" cy="6651596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807970"/>
            <a:ext cx="2066985" cy="5202112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42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498330"/>
            <a:ext cx="5527537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491640"/>
            <a:ext cx="5527537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8675243"/>
            <a:ext cx="1441966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0C8FC-230F-4281-84AB-D7E1D1978627}" type="datetimeFigureOut">
              <a:rPr lang="en-GB" smtClean="0"/>
              <a:t>09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8675243"/>
            <a:ext cx="216294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8675243"/>
            <a:ext cx="1441966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4AB8E-BD48-41C1-A71F-75E02B4E21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702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40903" rtl="0" eaLnBrk="1" latinLnBrk="0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0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12" Type="http://schemas.openxmlformats.org/officeDocument/2006/relationships/image" Target="../media/image29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"/><Relationship Id="rId11" Type="http://schemas.openxmlformats.org/officeDocument/2006/relationships/image" Target="../media/image28.emf"/><Relationship Id="rId5" Type="http://schemas.openxmlformats.org/officeDocument/2006/relationships/image" Target="../media/image22.emf"/><Relationship Id="rId10" Type="http://schemas.openxmlformats.org/officeDocument/2006/relationships/image" Target="../media/image27.png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image" Target="../media/image42.emf"/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12" Type="http://schemas.openxmlformats.org/officeDocument/2006/relationships/image" Target="../media/image41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emf"/><Relationship Id="rId11" Type="http://schemas.openxmlformats.org/officeDocument/2006/relationships/image" Target="../media/image40.emf"/><Relationship Id="rId5" Type="http://schemas.openxmlformats.org/officeDocument/2006/relationships/image" Target="../media/image34.emf"/><Relationship Id="rId15" Type="http://schemas.openxmlformats.org/officeDocument/2006/relationships/image" Target="../media/image44.emf"/><Relationship Id="rId10" Type="http://schemas.openxmlformats.org/officeDocument/2006/relationships/image" Target="../media/image39.tif"/><Relationship Id="rId4" Type="http://schemas.openxmlformats.org/officeDocument/2006/relationships/image" Target="../media/image33.emf"/><Relationship Id="rId9" Type="http://schemas.openxmlformats.org/officeDocument/2006/relationships/image" Target="../media/image38.tif"/><Relationship Id="rId14" Type="http://schemas.openxmlformats.org/officeDocument/2006/relationships/image" Target="../media/image43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3">
            <a:extLst>
              <a:ext uri="{FF2B5EF4-FFF2-40B4-BE49-F238E27FC236}">
                <a16:creationId xmlns:a16="http://schemas.microsoft.com/office/drawing/2014/main" id="{03D6EBE0-AF5B-4383-BA5A-95F88F5784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4087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528D61A-5F1E-46EE-A6DF-9ACD13BAE3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8495871"/>
            <a:ext cx="6408738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 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 for 2W1S:IA</a:t>
            </a:r>
            <a:r>
              <a:rPr kumimoji="0" lang="en-GB" altLang="en-US" sz="120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etramer</a:t>
            </a:r>
            <a:r>
              <a:rPr kumimoji="0" lang="en-GB" altLang="en-US" sz="120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 T cells in the MLNs and colon.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resentative plots from BRD509-2W1S-infected mice 6 days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.i.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etramer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ells are identified from single cell suspension of 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LN and 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alt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lonic cells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Cells are identified as live, single CD45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CD3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ump (MHCII, B220, CD8, CD64)</a:t>
            </a:r>
            <a:r>
              <a:rPr kumimoji="0" lang="en-GB" altLang="en-US" sz="1200" b="1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CD4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CD44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i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tetramer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ells.</a:t>
            </a:r>
            <a:endParaRPr kumimoji="0" lang="en-GB" altLang="en-US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A25AD95-1D0E-404C-83AF-F7B1D77454E9}"/>
              </a:ext>
            </a:extLst>
          </p:cNvPr>
          <p:cNvGrpSpPr/>
          <p:nvPr/>
        </p:nvGrpSpPr>
        <p:grpSpPr>
          <a:xfrm>
            <a:off x="280344" y="365352"/>
            <a:ext cx="5627624" cy="7823936"/>
            <a:chOff x="238512" y="359369"/>
            <a:chExt cx="5627624" cy="7823936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2E3AA6B-9A85-46D1-A321-7ED49DFE1E7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84140" y="598167"/>
              <a:ext cx="5381996" cy="3452241"/>
              <a:chOff x="1009925" y="323852"/>
              <a:chExt cx="4164330" cy="2655570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ECDC0CBB-5907-4DD2-AC57-47DF94CDBC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09925" y="323852"/>
                <a:ext cx="4164330" cy="2655570"/>
              </a:xfrm>
              <a:prstGeom prst="rect">
                <a:avLst/>
              </a:prstGeom>
            </p:spPr>
          </p:pic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B4635FF4-A0C7-4529-BE81-171C0089E821}"/>
                  </a:ext>
                </a:extLst>
              </p:cNvPr>
              <p:cNvCxnSpPr/>
              <p:nvPr/>
            </p:nvCxnSpPr>
            <p:spPr>
              <a:xfrm flipV="1">
                <a:off x="1750959" y="1148862"/>
                <a:ext cx="925175" cy="437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D73778A0-406A-4877-AFC7-BD9921072D04}"/>
                  </a:ext>
                </a:extLst>
              </p:cNvPr>
              <p:cNvCxnSpPr/>
              <p:nvPr/>
            </p:nvCxnSpPr>
            <p:spPr>
              <a:xfrm flipV="1">
                <a:off x="3020959" y="609600"/>
                <a:ext cx="1149526" cy="6300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4823A816-2212-4CB1-8377-C8CC3CFAECFA}"/>
                  </a:ext>
                </a:extLst>
              </p:cNvPr>
              <p:cNvCxnSpPr/>
              <p:nvPr/>
            </p:nvCxnSpPr>
            <p:spPr>
              <a:xfrm flipH="1">
                <a:off x="2165838" y="1238250"/>
                <a:ext cx="2387113" cy="649165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4C3FAEE3-2478-4BA5-AB6D-5DA7604D1DED}"/>
                  </a:ext>
                </a:extLst>
              </p:cNvPr>
              <p:cNvCxnSpPr/>
              <p:nvPr/>
            </p:nvCxnSpPr>
            <p:spPr>
              <a:xfrm flipV="1">
                <a:off x="1473200" y="2628849"/>
                <a:ext cx="1202934" cy="6401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3308D2E7-C9AF-46A4-8243-FB596E154042}"/>
                  </a:ext>
                </a:extLst>
              </p:cNvPr>
              <p:cNvCxnSpPr/>
              <p:nvPr/>
            </p:nvCxnSpPr>
            <p:spPr>
              <a:xfrm flipV="1">
                <a:off x="3595722" y="2635250"/>
                <a:ext cx="574763" cy="3201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F80762A0-E4C2-4295-A189-5048D4D6AB9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84140" y="4731064"/>
              <a:ext cx="5381996" cy="3452241"/>
              <a:chOff x="1009925" y="3633789"/>
              <a:chExt cx="4164330" cy="265557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65238FC3-613B-4793-91D9-35E69A2F4E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09925" y="3633789"/>
                <a:ext cx="4164330" cy="2655570"/>
              </a:xfrm>
              <a:prstGeom prst="rect">
                <a:avLst/>
              </a:prstGeom>
            </p:spPr>
          </p:pic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F3DE52E8-558C-430B-97F5-AE3B22D51491}"/>
                  </a:ext>
                </a:extLst>
              </p:cNvPr>
              <p:cNvCxnSpPr/>
              <p:nvPr/>
            </p:nvCxnSpPr>
            <p:spPr>
              <a:xfrm flipV="1">
                <a:off x="1727514" y="4466493"/>
                <a:ext cx="925175" cy="437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6604F13E-44B5-4168-A375-330AE2ED0EDB}"/>
                  </a:ext>
                </a:extLst>
              </p:cNvPr>
              <p:cNvCxnSpPr/>
              <p:nvPr/>
            </p:nvCxnSpPr>
            <p:spPr>
              <a:xfrm flipV="1">
                <a:off x="2985790" y="3918438"/>
                <a:ext cx="1184695" cy="15093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D29A01A8-73BC-41BA-902F-7CA7F69F22A4}"/>
                  </a:ext>
                </a:extLst>
              </p:cNvPr>
              <p:cNvCxnSpPr/>
              <p:nvPr/>
            </p:nvCxnSpPr>
            <p:spPr>
              <a:xfrm flipH="1">
                <a:off x="2190101" y="4587898"/>
                <a:ext cx="2313028" cy="599564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720E7355-3B4C-4229-9E8F-22E9CE7AAE96}"/>
                  </a:ext>
                </a:extLst>
              </p:cNvPr>
              <p:cNvCxnSpPr/>
              <p:nvPr/>
            </p:nvCxnSpPr>
            <p:spPr>
              <a:xfrm flipV="1">
                <a:off x="1473200" y="5952881"/>
                <a:ext cx="1179489" cy="1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58878BBB-1540-4ED7-8975-5C2B592BD367}"/>
                  </a:ext>
                </a:extLst>
              </p:cNvPr>
              <p:cNvCxnSpPr/>
              <p:nvPr/>
            </p:nvCxnSpPr>
            <p:spPr>
              <a:xfrm flipV="1">
                <a:off x="3522453" y="5952881"/>
                <a:ext cx="648032" cy="3202"/>
              </a:xfrm>
              <a:prstGeom prst="straightConnector1">
                <a:avLst/>
              </a:prstGeom>
              <a:ln w="25400">
                <a:solidFill>
                  <a:srgbClr val="0070C0"/>
                </a:solidFill>
                <a:tailEnd type="stealth" w="lg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B2DF2FB-EE2C-4B94-8676-7AC71C47F59B}"/>
                </a:ext>
              </a:extLst>
            </p:cNvPr>
            <p:cNvSpPr txBox="1"/>
            <p:nvPr/>
          </p:nvSpPr>
          <p:spPr>
            <a:xfrm>
              <a:off x="244122" y="359369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D45AB85-CFCF-43E7-985C-62C32921537F}"/>
                </a:ext>
              </a:extLst>
            </p:cNvPr>
            <p:cNvSpPr txBox="1"/>
            <p:nvPr/>
          </p:nvSpPr>
          <p:spPr>
            <a:xfrm>
              <a:off x="238512" y="4459559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80222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8E54C160-EB29-4255-B9CD-71CE2335B6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801" y="0"/>
            <a:ext cx="64087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4097" name="Picture 39">
            <a:extLst>
              <a:ext uri="{FF2B5EF4-FFF2-40B4-BE49-F238E27FC236}">
                <a16:creationId xmlns:a16="http://schemas.microsoft.com/office/drawing/2014/main" id="{049D5200-7EBC-4191-96EB-8330004905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101" y="3596003"/>
            <a:ext cx="4690713" cy="4759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DF3C02D6-CF9C-48DE-B58A-57B881EF9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8342808"/>
            <a:ext cx="6408738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Figure S2 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2W1S-specific CD4 T cells are detected in multiple intestinal and lymphoid sites. 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kumimoji="0" lang="en-GB" altLang="en-US" sz="120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Representative plots of 2W1S:IA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tetramer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CD4 T cells from the colon and MLN of animals infected with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strain BRD509-2W1S, the non-2W1S-expressing BRD509 parental strain, or mock infected with PBS. 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Representative plots of tetramer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  <a:cs typeface="Calibri" panose="020F0502020204030204" pitchFamily="34" charset="0"/>
              </a:rPr>
              <a:t> cells from 7 tissues at day 30 post-infection with BRD509-2W1S (top) or mock-infected with PBS (bottom).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effectLst/>
              <a:cs typeface="Calibri" panose="020F050202020403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4AEFBF4-8FDB-4435-8DC2-5EEDF919AF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5446" y="219743"/>
            <a:ext cx="1969320" cy="30835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30C6816-399A-465F-B876-D6E5EC48C0E4}"/>
              </a:ext>
            </a:extLst>
          </p:cNvPr>
          <p:cNvSpPr txBox="1"/>
          <p:nvPr/>
        </p:nvSpPr>
        <p:spPr>
          <a:xfrm>
            <a:off x="2621368" y="4406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Col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F9251A-8003-47DD-AF8D-0E253837DC73}"/>
              </a:ext>
            </a:extLst>
          </p:cNvPr>
          <p:cNvSpPr txBox="1"/>
          <p:nvPr/>
        </p:nvSpPr>
        <p:spPr>
          <a:xfrm>
            <a:off x="3652711" y="55561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ML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1C9268-F131-46B6-8F1A-90AF6902D0B9}"/>
              </a:ext>
            </a:extLst>
          </p:cNvPr>
          <p:cNvSpPr txBox="1"/>
          <p:nvPr/>
        </p:nvSpPr>
        <p:spPr>
          <a:xfrm>
            <a:off x="3883423" y="301782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0.07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64194B7-1F66-476B-9E5C-015D7C3BD39B}"/>
              </a:ext>
            </a:extLst>
          </p:cNvPr>
          <p:cNvSpPr txBox="1"/>
          <p:nvPr/>
        </p:nvSpPr>
        <p:spPr>
          <a:xfrm>
            <a:off x="2826990" y="299665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6.13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5893C9-3F14-4174-B679-E554B7DBFBFD}"/>
              </a:ext>
            </a:extLst>
          </p:cNvPr>
          <p:cNvSpPr txBox="1"/>
          <p:nvPr/>
        </p:nvSpPr>
        <p:spPr>
          <a:xfrm>
            <a:off x="2835923" y="1319899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0.02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42DB70-946E-48C1-B2AB-AF4652D89A59}"/>
              </a:ext>
            </a:extLst>
          </p:cNvPr>
          <p:cNvSpPr txBox="1"/>
          <p:nvPr/>
        </p:nvSpPr>
        <p:spPr>
          <a:xfrm>
            <a:off x="2826990" y="2361298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0.00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B48399-20BF-4003-9F62-F904496DD9DA}"/>
              </a:ext>
            </a:extLst>
          </p:cNvPr>
          <p:cNvSpPr txBox="1"/>
          <p:nvPr/>
        </p:nvSpPr>
        <p:spPr>
          <a:xfrm>
            <a:off x="3883423" y="2361298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0.00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808B9A-5042-47CD-88EE-D03F639DDFC5}"/>
              </a:ext>
            </a:extLst>
          </p:cNvPr>
          <p:cNvSpPr txBox="1"/>
          <p:nvPr/>
        </p:nvSpPr>
        <p:spPr>
          <a:xfrm>
            <a:off x="3881305" y="1313548"/>
            <a:ext cx="276285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/>
              <a:t>0.00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B5357F9-66B3-4508-ADC2-DD71DB72C52D}"/>
              </a:ext>
            </a:extLst>
          </p:cNvPr>
          <p:cNvSpPr txBox="1"/>
          <p:nvPr/>
        </p:nvSpPr>
        <p:spPr>
          <a:xfrm>
            <a:off x="1688754" y="473695"/>
            <a:ext cx="6447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BRD509-</a:t>
            </a:r>
          </a:p>
          <a:p>
            <a:pPr algn="ctr"/>
            <a:r>
              <a:rPr lang="en-GB" sz="1000" b="1" dirty="0"/>
              <a:t>2W1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596C61-9E46-4A24-9B89-149270042313}"/>
              </a:ext>
            </a:extLst>
          </p:cNvPr>
          <p:cNvSpPr txBox="1"/>
          <p:nvPr/>
        </p:nvSpPr>
        <p:spPr>
          <a:xfrm>
            <a:off x="1707990" y="1531128"/>
            <a:ext cx="6062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BRD50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1975DDD-B047-4E49-AC0A-C5578F84C715}"/>
              </a:ext>
            </a:extLst>
          </p:cNvPr>
          <p:cNvSpPr txBox="1"/>
          <p:nvPr/>
        </p:nvSpPr>
        <p:spPr>
          <a:xfrm>
            <a:off x="1824146" y="2566178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PB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0D173F4-3EE5-4CDE-A87D-5E2562229BBA}"/>
              </a:ext>
            </a:extLst>
          </p:cNvPr>
          <p:cNvSpPr txBox="1"/>
          <p:nvPr/>
        </p:nvSpPr>
        <p:spPr>
          <a:xfrm>
            <a:off x="1554447" y="-51155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29145A-1E59-43CE-B4D1-86BB35808358}"/>
              </a:ext>
            </a:extLst>
          </p:cNvPr>
          <p:cNvSpPr txBox="1"/>
          <p:nvPr/>
        </p:nvSpPr>
        <p:spPr>
          <a:xfrm>
            <a:off x="2535119" y="3171369"/>
            <a:ext cx="605499" cy="2240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Tetrame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855812-0E90-4506-9E2C-75F1CB0C6EC0}"/>
              </a:ext>
            </a:extLst>
          </p:cNvPr>
          <p:cNvSpPr txBox="1"/>
          <p:nvPr/>
        </p:nvSpPr>
        <p:spPr>
          <a:xfrm rot="16200000">
            <a:off x="2094242" y="2710423"/>
            <a:ext cx="422115" cy="2240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CD44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E309AB0-6F09-4712-A64F-FB47B5FC3417}"/>
              </a:ext>
            </a:extLst>
          </p:cNvPr>
          <p:cNvCxnSpPr>
            <a:cxnSpLocks/>
          </p:cNvCxnSpPr>
          <p:nvPr/>
        </p:nvCxnSpPr>
        <p:spPr>
          <a:xfrm>
            <a:off x="3083342" y="3287362"/>
            <a:ext cx="833085" cy="323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4140DA6-BE56-4018-919E-F66E1D1652DA}"/>
              </a:ext>
            </a:extLst>
          </p:cNvPr>
          <p:cNvCxnSpPr>
            <a:cxnSpLocks/>
            <a:endCxn id="16" idx="3"/>
          </p:cNvCxnSpPr>
          <p:nvPr/>
        </p:nvCxnSpPr>
        <p:spPr>
          <a:xfrm flipV="1">
            <a:off x="2309863" y="673750"/>
            <a:ext cx="23619" cy="1984672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med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E33C5548-B0C6-4A83-A3AE-204485474BF8}"/>
              </a:ext>
            </a:extLst>
          </p:cNvPr>
          <p:cNvSpPr txBox="1"/>
          <p:nvPr/>
        </p:nvSpPr>
        <p:spPr>
          <a:xfrm>
            <a:off x="597278" y="3440443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7427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FF6E2D2-7B8F-4BC6-86F2-068E996A26E6}"/>
              </a:ext>
            </a:extLst>
          </p:cNvPr>
          <p:cNvSpPr/>
          <p:nvPr/>
        </p:nvSpPr>
        <p:spPr>
          <a:xfrm>
            <a:off x="0" y="7584683"/>
            <a:ext cx="640873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sz="1200" b="1" dirty="0">
                <a:ea typeface="Calibri" panose="020F0502020204030204" pitchFamily="34" charset="0"/>
              </a:rPr>
              <a:t>Figure S3 </a:t>
            </a:r>
            <a:r>
              <a:rPr lang="en-GB" sz="1200" dirty="0">
                <a:ea typeface="Calibri" panose="020F0502020204030204" pitchFamily="34" charset="0"/>
              </a:rPr>
              <a:t>The MLN CD4 T cell response 6 days </a:t>
            </a:r>
            <a:r>
              <a:rPr lang="en-GB" sz="1200" dirty="0" err="1">
                <a:ea typeface="Calibri" panose="020F0502020204030204" pitchFamily="34" charset="0"/>
              </a:rPr>
              <a:t>p.i.</a:t>
            </a:r>
            <a:r>
              <a:rPr lang="en-GB" sz="1200" dirty="0">
                <a:ea typeface="Calibri" panose="020F0502020204030204" pitchFamily="34" charset="0"/>
              </a:rPr>
              <a:t> is confined to colon and caecum draining nodes. </a:t>
            </a:r>
            <a:r>
              <a:rPr lang="en-GB" sz="1200" b="1" dirty="0">
                <a:ea typeface="Calibri" panose="020F0502020204030204" pitchFamily="34" charset="0"/>
              </a:rPr>
              <a:t>a</a:t>
            </a:r>
            <a:r>
              <a:rPr lang="en-GB" sz="1200" dirty="0">
                <a:ea typeface="Calibri" panose="020F0502020204030204" pitchFamily="34" charset="0"/>
              </a:rPr>
              <a:t> Schematic representation of intestines and MLN, including small intestine draining MLNs (</a:t>
            </a:r>
            <a:r>
              <a:rPr lang="en-GB" sz="1200" dirty="0" err="1">
                <a:ea typeface="Calibri" panose="020F0502020204030204" pitchFamily="34" charset="0"/>
              </a:rPr>
              <a:t>sMLN</a:t>
            </a:r>
            <a:r>
              <a:rPr lang="en-GB" sz="1200" dirty="0">
                <a:ea typeface="Calibri" panose="020F0502020204030204" pitchFamily="34" charset="0"/>
              </a:rPr>
              <a:t>), and colonic draining MLNs (cMLN). </a:t>
            </a:r>
            <a:r>
              <a:rPr lang="en-GB" sz="1200" b="1" dirty="0">
                <a:ea typeface="Calibri" panose="020F0502020204030204" pitchFamily="34" charset="0"/>
              </a:rPr>
              <a:t>b</a:t>
            </a:r>
            <a:r>
              <a:rPr lang="en-GB" sz="1200" dirty="0">
                <a:ea typeface="Calibri" panose="020F0502020204030204" pitchFamily="34" charset="0"/>
              </a:rPr>
              <a:t> Representative plots of CD4 T cells from </a:t>
            </a:r>
            <a:r>
              <a:rPr lang="en-GB" sz="1200" dirty="0" err="1">
                <a:ea typeface="Calibri" panose="020F0502020204030204" pitchFamily="34" charset="0"/>
              </a:rPr>
              <a:t>sMLN</a:t>
            </a:r>
            <a:r>
              <a:rPr lang="en-GB" sz="1200" dirty="0">
                <a:ea typeface="Calibri" panose="020F0502020204030204" pitchFamily="34" charset="0"/>
              </a:rPr>
              <a:t> (left) and cMLN (right) that are CXCR3</a:t>
            </a:r>
            <a:r>
              <a:rPr lang="en-GB" sz="1200" baseline="30000" dirty="0">
                <a:ea typeface="Calibri" panose="020F0502020204030204" pitchFamily="34" charset="0"/>
              </a:rPr>
              <a:t>+</a:t>
            </a:r>
            <a:r>
              <a:rPr lang="en-GB" sz="1200" dirty="0">
                <a:ea typeface="Calibri" panose="020F0502020204030204" pitchFamily="34" charset="0"/>
              </a:rPr>
              <a:t> (top) and tetramer</a:t>
            </a:r>
            <a:r>
              <a:rPr lang="en-GB" sz="1200" baseline="30000" dirty="0">
                <a:ea typeface="Calibri" panose="020F0502020204030204" pitchFamily="34" charset="0"/>
              </a:rPr>
              <a:t>+</a:t>
            </a:r>
            <a:r>
              <a:rPr lang="en-GB" sz="1200" dirty="0">
                <a:ea typeface="Calibri" panose="020F0502020204030204" pitchFamily="34" charset="0"/>
              </a:rPr>
              <a:t> (bottom), 6 days </a:t>
            </a:r>
            <a:r>
              <a:rPr lang="en-GB" sz="1200" dirty="0" err="1">
                <a:ea typeface="Calibri" panose="020F0502020204030204" pitchFamily="34" charset="0"/>
              </a:rPr>
              <a:t>p.i.</a:t>
            </a:r>
            <a:r>
              <a:rPr lang="en-GB" sz="1200" dirty="0">
                <a:ea typeface="Calibri" panose="020F0502020204030204" pitchFamily="34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</a:rPr>
              <a:t>c </a:t>
            </a:r>
            <a:r>
              <a:rPr lang="en-GB" sz="1200" dirty="0">
                <a:ea typeface="Calibri" panose="020F0502020204030204" pitchFamily="34" charset="0"/>
              </a:rPr>
              <a:t>Graphs showing the number and proportion of total cells, CD4 T cells, and CD4 T cells that are CXCR3</a:t>
            </a:r>
            <a:r>
              <a:rPr lang="en-GB" sz="1200" baseline="30000" dirty="0">
                <a:ea typeface="Calibri" panose="020F0502020204030204" pitchFamily="34" charset="0"/>
              </a:rPr>
              <a:t>+</a:t>
            </a:r>
            <a:r>
              <a:rPr lang="en-GB" sz="1200" dirty="0">
                <a:ea typeface="Calibri" panose="020F0502020204030204" pitchFamily="34" charset="0"/>
              </a:rPr>
              <a:t> or tetramer</a:t>
            </a:r>
            <a:r>
              <a:rPr lang="en-GB" sz="1200" baseline="30000" dirty="0">
                <a:ea typeface="Calibri" panose="020F0502020204030204" pitchFamily="34" charset="0"/>
              </a:rPr>
              <a:t>+</a:t>
            </a:r>
            <a:r>
              <a:rPr lang="en-GB" sz="1200" dirty="0">
                <a:ea typeface="Calibri" panose="020F0502020204030204" pitchFamily="34" charset="0"/>
              </a:rPr>
              <a:t> at day 6 </a:t>
            </a:r>
            <a:r>
              <a:rPr lang="en-GB" sz="1200" dirty="0" err="1">
                <a:ea typeface="Calibri" panose="020F0502020204030204" pitchFamily="34" charset="0"/>
              </a:rPr>
              <a:t>p.i.</a:t>
            </a:r>
            <a:r>
              <a:rPr lang="en-GB" sz="1200" dirty="0">
                <a:ea typeface="Calibri" panose="020F0502020204030204" pitchFamily="34" charset="0"/>
              </a:rPr>
              <a:t> Data points represent individual animals (n=4). Mean ± SEM are plotted. Statistical significance calculated by a one-way ANOVA with Tukey’s test. *p&lt;.05; **p&lt;.01; ***p&lt;.001; ****p&lt;.0001.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B9CFDC8-2DF6-4E36-B83A-24B3A8B0B9E0}"/>
              </a:ext>
            </a:extLst>
          </p:cNvPr>
          <p:cNvGrpSpPr>
            <a:grpSpLocks noChangeAspect="1"/>
          </p:cNvGrpSpPr>
          <p:nvPr/>
        </p:nvGrpSpPr>
        <p:grpSpPr>
          <a:xfrm>
            <a:off x="42009" y="569623"/>
            <a:ext cx="6346573" cy="7060549"/>
            <a:chOff x="118209" y="426199"/>
            <a:chExt cx="6102474" cy="678898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0C69F88-416E-411A-87FE-659228D86B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58542" b="69051"/>
            <a:stretch/>
          </p:blipFill>
          <p:spPr>
            <a:xfrm>
              <a:off x="118209" y="3108606"/>
              <a:ext cx="1503416" cy="203297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B287789-2393-40C6-A9DD-FA40B389A1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2994" r="60160" b="34920"/>
            <a:stretch/>
          </p:blipFill>
          <p:spPr>
            <a:xfrm>
              <a:off x="2841126" y="3066405"/>
              <a:ext cx="1444742" cy="210765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B14DF1E-CF88-4029-B985-7BA2182C92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57297" b="55120"/>
            <a:stretch/>
          </p:blipFill>
          <p:spPr>
            <a:xfrm>
              <a:off x="147389" y="5134571"/>
              <a:ext cx="1506373" cy="205717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8919B60-5C05-4F5B-8DFE-7FC350B447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6592" r="57764"/>
            <a:stretch/>
          </p:blipFill>
          <p:spPr>
            <a:xfrm>
              <a:off x="2853624" y="5225488"/>
              <a:ext cx="1489900" cy="19897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8F50183-685A-4534-BD51-35BF50EEEA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329" r="14667" b="69051"/>
            <a:stretch/>
          </p:blipFill>
          <p:spPr>
            <a:xfrm>
              <a:off x="1613003" y="3105428"/>
              <a:ext cx="1341899" cy="203297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D64EF96-6E2D-4B29-9D6F-4DFE0A95B0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0430" t="32994" r="15630" b="34920"/>
            <a:stretch/>
          </p:blipFill>
          <p:spPr>
            <a:xfrm>
              <a:off x="4426653" y="3069580"/>
              <a:ext cx="1230787" cy="2107658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FF641B4-F61C-40D3-B405-B09E9BAED6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7437" r="14400" b="55120"/>
            <a:stretch/>
          </p:blipFill>
          <p:spPr>
            <a:xfrm>
              <a:off x="1602872" y="5137746"/>
              <a:ext cx="1346222" cy="2057172"/>
            </a:xfrm>
            <a:prstGeom prst="rect">
              <a:avLst/>
            </a:prstGeom>
          </p:spPr>
        </p:pic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729391EC-908F-480B-8F68-D745DE2A88C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67690" y="5225350"/>
              <a:ext cx="1465948" cy="1989700"/>
              <a:chOff x="4232275" y="6087104"/>
              <a:chExt cx="1382277" cy="1876150"/>
            </a:xfrm>
          </p:grpSpPr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8B47E55A-B95D-49B9-B29C-AE9132E914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7174" t="56592" r="11269"/>
              <a:stretch/>
            </p:blipFill>
            <p:spPr>
              <a:xfrm>
                <a:off x="4232275" y="6087104"/>
                <a:ext cx="1382277" cy="1876150"/>
              </a:xfrm>
              <a:prstGeom prst="rect">
                <a:avLst/>
              </a:prstGeom>
            </p:spPr>
          </p:pic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D8EAAF2C-06AA-4118-AB20-F84A81E30F73}"/>
                  </a:ext>
                </a:extLst>
              </p:cNvPr>
              <p:cNvSpPr/>
              <p:nvPr/>
            </p:nvSpPr>
            <p:spPr>
              <a:xfrm>
                <a:off x="5400675" y="6492875"/>
                <a:ext cx="82550" cy="27622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B870439C-480E-4C2E-959F-2C83AAA33CA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78610" y="3438312"/>
              <a:ext cx="539080" cy="440258"/>
              <a:chOff x="4891219" y="3406769"/>
              <a:chExt cx="508308" cy="415133"/>
            </a:xfrm>
          </p:grpSpPr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116E9C04-EB2C-4225-8963-F18A13985A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3280" t="66369" r="3143" b="24765"/>
              <a:stretch/>
            </p:blipFill>
            <p:spPr>
              <a:xfrm>
                <a:off x="4910296" y="3406769"/>
                <a:ext cx="489231" cy="415133"/>
              </a:xfrm>
              <a:prstGeom prst="rect">
                <a:avLst/>
              </a:prstGeom>
            </p:spPr>
          </p:pic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ADCE46B-B457-4DD2-9196-8310D8EBC777}"/>
                  </a:ext>
                </a:extLst>
              </p:cNvPr>
              <p:cNvSpPr txBox="1"/>
              <p:nvPr/>
            </p:nvSpPr>
            <p:spPr>
              <a:xfrm>
                <a:off x="4891219" y="3422646"/>
                <a:ext cx="237566" cy="3420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>
                    <a:solidFill>
                      <a:schemeClr val="bg2">
                        <a:lumMod val="50000"/>
                      </a:schemeClr>
                    </a:solidFill>
                  </a:rPr>
                  <a:t>.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B0F1EBD-5A50-48E6-B157-B63A9BC32BF2}"/>
                </a:ext>
              </a:extLst>
            </p:cNvPr>
            <p:cNvSpPr txBox="1"/>
            <p:nvPr/>
          </p:nvSpPr>
          <p:spPr>
            <a:xfrm>
              <a:off x="142212" y="3031366"/>
              <a:ext cx="2712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/>
                <a:t>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B6958CB-3AFC-4BD1-9F9D-79E7CDDB0FEA}"/>
                </a:ext>
              </a:extLst>
            </p:cNvPr>
            <p:cNvSpPr txBox="1"/>
            <p:nvPr/>
          </p:nvSpPr>
          <p:spPr>
            <a:xfrm>
              <a:off x="547353" y="471919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/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F48A8EE-FF0C-47DF-BEC2-FF470C2ADF02}"/>
                </a:ext>
              </a:extLst>
            </p:cNvPr>
            <p:cNvSpPr txBox="1"/>
            <p:nvPr/>
          </p:nvSpPr>
          <p:spPr>
            <a:xfrm>
              <a:off x="3322214" y="426199"/>
              <a:ext cx="2952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/>
                <a:t>b</a:t>
              </a:r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C21E60AE-2895-4DA6-B7DB-B7E4EF8F03D3}"/>
                </a:ext>
              </a:extLst>
            </p:cNvPr>
            <p:cNvGrpSpPr/>
            <p:nvPr/>
          </p:nvGrpSpPr>
          <p:grpSpPr>
            <a:xfrm>
              <a:off x="3485410" y="522672"/>
              <a:ext cx="2116697" cy="2350208"/>
              <a:chOff x="2875508" y="590157"/>
              <a:chExt cx="2116697" cy="2350208"/>
            </a:xfrm>
          </p:grpSpPr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8263B2B2-212E-4108-B88F-48F7652C29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082" b="58341"/>
              <a:stretch/>
            </p:blipFill>
            <p:spPr>
              <a:xfrm>
                <a:off x="3013804" y="738956"/>
                <a:ext cx="1965553" cy="933634"/>
              </a:xfrm>
              <a:prstGeom prst="rect">
                <a:avLst/>
              </a:prstGeom>
            </p:spPr>
          </p:pic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59B9C205-61B2-4F3B-9E2F-59D040CD3D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082" t="54456" b="4063"/>
              <a:stretch/>
            </p:blipFill>
            <p:spPr>
              <a:xfrm>
                <a:off x="3013804" y="1866364"/>
                <a:ext cx="1965553" cy="929640"/>
              </a:xfrm>
              <a:prstGeom prst="rect">
                <a:avLst/>
              </a:prstGeom>
            </p:spPr>
          </p:pic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2EDA8A3-15B1-44DA-9940-8AF9CC8DBD45}"/>
                  </a:ext>
                </a:extLst>
              </p:cNvPr>
              <p:cNvSpPr txBox="1"/>
              <p:nvPr/>
            </p:nvSpPr>
            <p:spPr>
              <a:xfrm>
                <a:off x="3204210" y="2724921"/>
                <a:ext cx="5822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/>
                  <a:t>Tetramer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606F2A9-1AE5-4868-89E3-8396C17E9098}"/>
                  </a:ext>
                </a:extLst>
              </p:cNvPr>
              <p:cNvSpPr txBox="1"/>
              <p:nvPr/>
            </p:nvSpPr>
            <p:spPr>
              <a:xfrm>
                <a:off x="3276600" y="1600581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/>
                  <a:t>CXCR3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502F247A-BD63-46C9-857F-789B3AF4B4D9}"/>
                  </a:ext>
                </a:extLst>
              </p:cNvPr>
              <p:cNvSpPr txBox="1"/>
              <p:nvPr/>
            </p:nvSpPr>
            <p:spPr>
              <a:xfrm rot="16200000">
                <a:off x="2780290" y="2301431"/>
                <a:ext cx="4058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/>
                  <a:t>CD44</a:t>
                </a:r>
              </a:p>
            </p:txBody>
          </p: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id="{23978891-5F61-4C2C-9DCD-8F4394C89C67}"/>
                  </a:ext>
                </a:extLst>
              </p:cNvPr>
              <p:cNvCxnSpPr/>
              <p:nvPr/>
            </p:nvCxnSpPr>
            <p:spPr>
              <a:xfrm flipV="1">
                <a:off x="3731347" y="2835951"/>
                <a:ext cx="1027072" cy="50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>
                <a:extLst>
                  <a:ext uri="{FF2B5EF4-FFF2-40B4-BE49-F238E27FC236}">
                    <a16:creationId xmlns:a16="http://schemas.microsoft.com/office/drawing/2014/main" id="{78A47F49-77CD-4530-A1AE-EE97575525F7}"/>
                  </a:ext>
                </a:extLst>
              </p:cNvPr>
              <p:cNvCxnSpPr/>
              <p:nvPr/>
            </p:nvCxnSpPr>
            <p:spPr>
              <a:xfrm flipV="1">
                <a:off x="2987618" y="1042703"/>
                <a:ext cx="2280" cy="120872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D878348B-612E-439F-8AFD-3E95814A91FD}"/>
                  </a:ext>
                </a:extLst>
              </p:cNvPr>
              <p:cNvSpPr txBox="1"/>
              <p:nvPr/>
            </p:nvSpPr>
            <p:spPr>
              <a:xfrm>
                <a:off x="3247817" y="590157"/>
                <a:ext cx="17443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err="1"/>
                  <a:t>sMLN</a:t>
                </a:r>
                <a:r>
                  <a:rPr lang="en-GB" sz="1000" b="1" dirty="0"/>
                  <a:t>                           </a:t>
                </a:r>
                <a:r>
                  <a:rPr lang="en-GB" sz="1000" b="1" dirty="0" err="1"/>
                  <a:t>cMLN</a:t>
                </a:r>
                <a:r>
                  <a:rPr lang="en-GB" sz="1000" b="1" dirty="0"/>
                  <a:t>      </a:t>
                </a:r>
                <a:endParaRPr lang="en-GB" sz="800" b="1" dirty="0"/>
              </a:p>
            </p:txBody>
          </p: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FD4C837A-921B-4431-873D-67D00F18D03F}"/>
                  </a:ext>
                </a:extLst>
              </p:cNvPr>
              <p:cNvCxnSpPr/>
              <p:nvPr/>
            </p:nvCxnSpPr>
            <p:spPr>
              <a:xfrm flipV="1">
                <a:off x="3731347" y="1704381"/>
                <a:ext cx="1027072" cy="50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317002C-45C9-4581-8F4C-43CEA0D60CEB}"/>
                </a:ext>
              </a:extLst>
            </p:cNvPr>
            <p:cNvSpPr txBox="1"/>
            <p:nvPr/>
          </p:nvSpPr>
          <p:spPr>
            <a:xfrm>
              <a:off x="4124559" y="727293"/>
              <a:ext cx="309365" cy="114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" rIns="36000" bIns="3600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.8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DB7FDEF-37CC-4E0F-95FE-B98268AD2693}"/>
                </a:ext>
              </a:extLst>
            </p:cNvPr>
            <p:cNvSpPr txBox="1"/>
            <p:nvPr/>
          </p:nvSpPr>
          <p:spPr>
            <a:xfrm>
              <a:off x="5195376" y="727292"/>
              <a:ext cx="291584" cy="114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" rIns="36000" bIns="3600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.3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FE3B4F5-2B09-4BD9-84CF-7BD20319EAE5}"/>
                </a:ext>
              </a:extLst>
            </p:cNvPr>
            <p:cNvSpPr txBox="1"/>
            <p:nvPr/>
          </p:nvSpPr>
          <p:spPr>
            <a:xfrm>
              <a:off x="4133226" y="1853242"/>
              <a:ext cx="309365" cy="114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" rIns="36000" bIns="3600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003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C97B9C0-FCD9-4942-BF0B-E10CBCB6E693}"/>
                </a:ext>
              </a:extLst>
            </p:cNvPr>
            <p:cNvSpPr txBox="1"/>
            <p:nvPr/>
          </p:nvSpPr>
          <p:spPr>
            <a:xfrm>
              <a:off x="5191756" y="1858322"/>
              <a:ext cx="309365" cy="114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" rIns="36000" bIns="3600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026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6B92EEE8-7FB7-48EF-BE42-143B9B419396}"/>
                </a:ext>
              </a:extLst>
            </p:cNvPr>
            <p:cNvGrpSpPr/>
            <p:nvPr/>
          </p:nvGrpSpPr>
          <p:grpSpPr>
            <a:xfrm>
              <a:off x="631693" y="690775"/>
              <a:ext cx="2764572" cy="1674389"/>
              <a:chOff x="125207" y="1433725"/>
              <a:chExt cx="2764572" cy="1674389"/>
            </a:xfrm>
          </p:grpSpPr>
          <p:sp>
            <p:nvSpPr>
              <p:cNvPr id="29" name="Freeform 124">
                <a:extLst>
                  <a:ext uri="{FF2B5EF4-FFF2-40B4-BE49-F238E27FC236}">
                    <a16:creationId xmlns:a16="http://schemas.microsoft.com/office/drawing/2014/main" id="{7E8FDD47-AD16-4F50-AAE2-2DF4CD548289}"/>
                  </a:ext>
                </a:extLst>
              </p:cNvPr>
              <p:cNvSpPr/>
              <p:nvPr/>
            </p:nvSpPr>
            <p:spPr>
              <a:xfrm rot="1495354" flipH="1">
                <a:off x="1523455" y="1685049"/>
                <a:ext cx="327092" cy="602242"/>
              </a:xfrm>
              <a:custGeom>
                <a:avLst/>
                <a:gdLst>
                  <a:gd name="connsiteX0" fmla="*/ 0 w 178594"/>
                  <a:gd name="connsiteY0" fmla="*/ 797719 h 797719"/>
                  <a:gd name="connsiteX1" fmla="*/ 66675 w 178594"/>
                  <a:gd name="connsiteY1" fmla="*/ 614362 h 797719"/>
                  <a:gd name="connsiteX2" fmla="*/ 59531 w 178594"/>
                  <a:gd name="connsiteY2" fmla="*/ 304800 h 797719"/>
                  <a:gd name="connsiteX3" fmla="*/ 102394 w 178594"/>
                  <a:gd name="connsiteY3" fmla="*/ 104775 h 797719"/>
                  <a:gd name="connsiteX4" fmla="*/ 178594 w 178594"/>
                  <a:gd name="connsiteY4" fmla="*/ 0 h 7977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78594" h="797719">
                    <a:moveTo>
                      <a:pt x="0" y="797719"/>
                    </a:moveTo>
                    <a:cubicBezTo>
                      <a:pt x="28376" y="747117"/>
                      <a:pt x="56753" y="696515"/>
                      <a:pt x="66675" y="614362"/>
                    </a:cubicBezTo>
                    <a:cubicBezTo>
                      <a:pt x="76597" y="532209"/>
                      <a:pt x="53578" y="389731"/>
                      <a:pt x="59531" y="304800"/>
                    </a:cubicBezTo>
                    <a:cubicBezTo>
                      <a:pt x="65484" y="219869"/>
                      <a:pt x="82550" y="155575"/>
                      <a:pt x="102394" y="104775"/>
                    </a:cubicBezTo>
                    <a:cubicBezTo>
                      <a:pt x="122238" y="53975"/>
                      <a:pt x="150416" y="26987"/>
                      <a:pt x="178594" y="0"/>
                    </a:cubicBezTo>
                  </a:path>
                </a:pathLst>
              </a:custGeom>
              <a:noFill/>
              <a:ln>
                <a:solidFill>
                  <a:schemeClr val="accent5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7427680D-4CD2-4BCA-9441-BFD90D39459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25207" y="1433725"/>
                <a:ext cx="2764572" cy="1674389"/>
                <a:chOff x="4532603" y="3694447"/>
                <a:chExt cx="4046961" cy="2451084"/>
              </a:xfrm>
            </p:grpSpPr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24327963-6238-4EFD-A3AB-1270FCAFB19A}"/>
                    </a:ext>
                  </a:extLst>
                </p:cNvPr>
                <p:cNvSpPr txBox="1"/>
                <p:nvPr/>
              </p:nvSpPr>
              <p:spPr>
                <a:xfrm>
                  <a:off x="6789829" y="4603010"/>
                  <a:ext cx="578502" cy="354883"/>
                </a:xfrm>
                <a:prstGeom prst="rect">
                  <a:avLst/>
                </a:prstGeom>
                <a:noFill/>
                <a:effectLst>
                  <a:softEdge rad="12700"/>
                </a:effectLst>
              </p:spPr>
              <p:txBody>
                <a:bodyPr wrap="none" lIns="72000" tIns="72000" rIns="72000" bIns="72000" rtlCol="0" anchor="ctr" anchorCtr="0">
                  <a:spAutoFit/>
                </a:bodyPr>
                <a:lstStyle/>
                <a:p>
                  <a:pPr algn="ctr"/>
                  <a:r>
                    <a:rPr lang="en-GB" sz="900" b="1" dirty="0" err="1">
                      <a:solidFill>
                        <a:schemeClr val="accent1">
                          <a:lumMod val="50000"/>
                        </a:schemeClr>
                      </a:solidFill>
                    </a:rPr>
                    <a:t>sMLNs</a:t>
                  </a:r>
                  <a:endParaRPr lang="en-GB" sz="1050" b="1" dirty="0">
                    <a:solidFill>
                      <a:schemeClr val="accent1">
                        <a:lumMod val="50000"/>
                      </a:schemeClr>
                    </a:solidFill>
                  </a:endParaRPr>
                </a:p>
              </p:txBody>
            </p:sp>
            <p:sp>
              <p:nvSpPr>
                <p:cNvPr id="32" name="Freeform 93">
                  <a:extLst>
                    <a:ext uri="{FF2B5EF4-FFF2-40B4-BE49-F238E27FC236}">
                      <a16:creationId xmlns:a16="http://schemas.microsoft.com/office/drawing/2014/main" id="{B1FE16B8-4DEC-4765-B69C-762A39DFB568}"/>
                    </a:ext>
                  </a:extLst>
                </p:cNvPr>
                <p:cNvSpPr/>
                <p:nvPr/>
              </p:nvSpPr>
              <p:spPr>
                <a:xfrm flipH="1">
                  <a:off x="6539475" y="4526331"/>
                  <a:ext cx="217528" cy="564415"/>
                </a:xfrm>
                <a:custGeom>
                  <a:avLst/>
                  <a:gdLst>
                    <a:gd name="connsiteX0" fmla="*/ 0 w 212971"/>
                    <a:gd name="connsiteY0" fmla="*/ 542925 h 542925"/>
                    <a:gd name="connsiteX1" fmla="*/ 47625 w 212971"/>
                    <a:gd name="connsiteY1" fmla="*/ 452437 h 542925"/>
                    <a:gd name="connsiteX2" fmla="*/ 192881 w 212971"/>
                    <a:gd name="connsiteY2" fmla="*/ 211931 h 542925"/>
                    <a:gd name="connsiteX3" fmla="*/ 202406 w 212971"/>
                    <a:gd name="connsiteY3" fmla="*/ 85725 h 542925"/>
                    <a:gd name="connsiteX4" fmla="*/ 104775 w 212971"/>
                    <a:gd name="connsiteY4" fmla="*/ 0 h 5429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12971" h="542925">
                      <a:moveTo>
                        <a:pt x="0" y="542925"/>
                      </a:moveTo>
                      <a:cubicBezTo>
                        <a:pt x="7739" y="525264"/>
                        <a:pt x="15478" y="507603"/>
                        <a:pt x="47625" y="452437"/>
                      </a:cubicBezTo>
                      <a:cubicBezTo>
                        <a:pt x="79772" y="397271"/>
                        <a:pt x="167084" y="273050"/>
                        <a:pt x="192881" y="211931"/>
                      </a:cubicBezTo>
                      <a:cubicBezTo>
                        <a:pt x="218678" y="150812"/>
                        <a:pt x="217090" y="121047"/>
                        <a:pt x="202406" y="85725"/>
                      </a:cubicBezTo>
                      <a:cubicBezTo>
                        <a:pt x="187722" y="50403"/>
                        <a:pt x="146248" y="25201"/>
                        <a:pt x="104775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3" name="Freeform 94">
                  <a:extLst>
                    <a:ext uri="{FF2B5EF4-FFF2-40B4-BE49-F238E27FC236}">
                      <a16:creationId xmlns:a16="http://schemas.microsoft.com/office/drawing/2014/main" id="{4ECCF8C7-B6B7-4248-9103-89B04D166256}"/>
                    </a:ext>
                  </a:extLst>
                </p:cNvPr>
                <p:cNvSpPr/>
                <p:nvPr/>
              </p:nvSpPr>
              <p:spPr>
                <a:xfrm flipH="1">
                  <a:off x="6328726" y="4516617"/>
                  <a:ext cx="423203" cy="588169"/>
                </a:xfrm>
                <a:custGeom>
                  <a:avLst/>
                  <a:gdLst>
                    <a:gd name="connsiteX0" fmla="*/ 0 w 414338"/>
                    <a:gd name="connsiteY0" fmla="*/ 588169 h 588169"/>
                    <a:gd name="connsiteX1" fmla="*/ 76200 w 414338"/>
                    <a:gd name="connsiteY1" fmla="*/ 431006 h 588169"/>
                    <a:gd name="connsiteX2" fmla="*/ 257175 w 414338"/>
                    <a:gd name="connsiteY2" fmla="*/ 157162 h 588169"/>
                    <a:gd name="connsiteX3" fmla="*/ 414338 w 414338"/>
                    <a:gd name="connsiteY3" fmla="*/ 0 h 5881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14338" h="588169">
                      <a:moveTo>
                        <a:pt x="0" y="588169"/>
                      </a:moveTo>
                      <a:cubicBezTo>
                        <a:pt x="16668" y="545505"/>
                        <a:pt x="33337" y="502841"/>
                        <a:pt x="76200" y="431006"/>
                      </a:cubicBezTo>
                      <a:cubicBezTo>
                        <a:pt x="119063" y="359171"/>
                        <a:pt x="200819" y="228996"/>
                        <a:pt x="257175" y="157162"/>
                      </a:cubicBezTo>
                      <a:cubicBezTo>
                        <a:pt x="313531" y="85328"/>
                        <a:pt x="363934" y="42664"/>
                        <a:pt x="414338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4" name="Freeform 96">
                  <a:extLst>
                    <a:ext uri="{FF2B5EF4-FFF2-40B4-BE49-F238E27FC236}">
                      <a16:creationId xmlns:a16="http://schemas.microsoft.com/office/drawing/2014/main" id="{E2BFCF33-CC66-403B-A344-F77C2804116F}"/>
                    </a:ext>
                  </a:extLst>
                </p:cNvPr>
                <p:cNvSpPr/>
                <p:nvPr/>
              </p:nvSpPr>
              <p:spPr>
                <a:xfrm flipH="1">
                  <a:off x="6602430" y="5368241"/>
                  <a:ext cx="604256" cy="398310"/>
                </a:xfrm>
                <a:custGeom>
                  <a:avLst/>
                  <a:gdLst>
                    <a:gd name="connsiteX0" fmla="*/ 0 w 512518"/>
                    <a:gd name="connsiteY0" fmla="*/ 571518 h 594976"/>
                    <a:gd name="connsiteX1" fmla="*/ 82550 w 512518"/>
                    <a:gd name="connsiteY1" fmla="*/ 508018 h 594976"/>
                    <a:gd name="connsiteX2" fmla="*/ 136525 w 512518"/>
                    <a:gd name="connsiteY2" fmla="*/ 381018 h 594976"/>
                    <a:gd name="connsiteX3" fmla="*/ 161925 w 512518"/>
                    <a:gd name="connsiteY3" fmla="*/ 177818 h 594976"/>
                    <a:gd name="connsiteX4" fmla="*/ 155575 w 512518"/>
                    <a:gd name="connsiteY4" fmla="*/ 18 h 594976"/>
                    <a:gd name="connsiteX5" fmla="*/ 184150 w 512518"/>
                    <a:gd name="connsiteY5" fmla="*/ 168293 h 594976"/>
                    <a:gd name="connsiteX6" fmla="*/ 266700 w 512518"/>
                    <a:gd name="connsiteY6" fmla="*/ 400068 h 594976"/>
                    <a:gd name="connsiteX7" fmla="*/ 488950 w 512518"/>
                    <a:gd name="connsiteY7" fmla="*/ 577868 h 594976"/>
                    <a:gd name="connsiteX8" fmla="*/ 495300 w 512518"/>
                    <a:gd name="connsiteY8" fmla="*/ 577868 h 5949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512518" h="594976">
                      <a:moveTo>
                        <a:pt x="0" y="571518"/>
                      </a:moveTo>
                      <a:cubicBezTo>
                        <a:pt x="29898" y="555643"/>
                        <a:pt x="59796" y="539768"/>
                        <a:pt x="82550" y="508018"/>
                      </a:cubicBezTo>
                      <a:cubicBezTo>
                        <a:pt x="105304" y="476268"/>
                        <a:pt x="123296" y="436051"/>
                        <a:pt x="136525" y="381018"/>
                      </a:cubicBezTo>
                      <a:cubicBezTo>
                        <a:pt x="149754" y="325985"/>
                        <a:pt x="158750" y="241318"/>
                        <a:pt x="161925" y="177818"/>
                      </a:cubicBezTo>
                      <a:cubicBezTo>
                        <a:pt x="165100" y="114318"/>
                        <a:pt x="151871" y="1605"/>
                        <a:pt x="155575" y="18"/>
                      </a:cubicBezTo>
                      <a:cubicBezTo>
                        <a:pt x="159279" y="-1569"/>
                        <a:pt x="165629" y="101618"/>
                        <a:pt x="184150" y="168293"/>
                      </a:cubicBezTo>
                      <a:cubicBezTo>
                        <a:pt x="202671" y="234968"/>
                        <a:pt x="215900" y="331805"/>
                        <a:pt x="266700" y="400068"/>
                      </a:cubicBezTo>
                      <a:cubicBezTo>
                        <a:pt x="317500" y="468330"/>
                        <a:pt x="450850" y="548235"/>
                        <a:pt x="488950" y="577868"/>
                      </a:cubicBezTo>
                      <a:cubicBezTo>
                        <a:pt x="527050" y="607501"/>
                        <a:pt x="511175" y="592684"/>
                        <a:pt x="495300" y="577868"/>
                      </a:cubicBezTo>
                    </a:path>
                  </a:pathLst>
                </a:custGeom>
                <a:noFill/>
                <a:ln>
                  <a:solidFill>
                    <a:srgbClr val="C55A1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5" name="Freeform 97">
                  <a:extLst>
                    <a:ext uri="{FF2B5EF4-FFF2-40B4-BE49-F238E27FC236}">
                      <a16:creationId xmlns:a16="http://schemas.microsoft.com/office/drawing/2014/main" id="{9B9937C2-2D4F-4F38-8411-7E5099B42772}"/>
                    </a:ext>
                  </a:extLst>
                </p:cNvPr>
                <p:cNvSpPr/>
                <p:nvPr/>
              </p:nvSpPr>
              <p:spPr>
                <a:xfrm flipH="1">
                  <a:off x="5978248" y="5335131"/>
                  <a:ext cx="1053245" cy="485079"/>
                </a:xfrm>
                <a:custGeom>
                  <a:avLst/>
                  <a:gdLst>
                    <a:gd name="connsiteX0" fmla="*/ 1203 w 845499"/>
                    <a:gd name="connsiteY0" fmla="*/ 0 h 535220"/>
                    <a:gd name="connsiteX1" fmla="*/ 22539 w 845499"/>
                    <a:gd name="connsiteY1" fmla="*/ 94488 h 535220"/>
                    <a:gd name="connsiteX2" fmla="*/ 155127 w 845499"/>
                    <a:gd name="connsiteY2" fmla="*/ 249936 h 535220"/>
                    <a:gd name="connsiteX3" fmla="*/ 507171 w 845499"/>
                    <a:gd name="connsiteY3" fmla="*/ 475488 h 535220"/>
                    <a:gd name="connsiteX4" fmla="*/ 705291 w 845499"/>
                    <a:gd name="connsiteY4" fmla="*/ 534924 h 535220"/>
                    <a:gd name="connsiteX5" fmla="*/ 845499 w 845499"/>
                    <a:gd name="connsiteY5" fmla="*/ 499872 h 535220"/>
                    <a:gd name="connsiteX6" fmla="*/ 845499 w 845499"/>
                    <a:gd name="connsiteY6" fmla="*/ 499872 h 5352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845499" h="535220">
                      <a:moveTo>
                        <a:pt x="1203" y="0"/>
                      </a:moveTo>
                      <a:cubicBezTo>
                        <a:pt x="-956" y="26416"/>
                        <a:pt x="-3115" y="52832"/>
                        <a:pt x="22539" y="94488"/>
                      </a:cubicBezTo>
                      <a:cubicBezTo>
                        <a:pt x="48193" y="136144"/>
                        <a:pt x="74355" y="186436"/>
                        <a:pt x="155127" y="249936"/>
                      </a:cubicBezTo>
                      <a:cubicBezTo>
                        <a:pt x="235899" y="313436"/>
                        <a:pt x="415477" y="427990"/>
                        <a:pt x="507171" y="475488"/>
                      </a:cubicBezTo>
                      <a:cubicBezTo>
                        <a:pt x="598865" y="522986"/>
                        <a:pt x="648903" y="530860"/>
                        <a:pt x="705291" y="534924"/>
                      </a:cubicBezTo>
                      <a:cubicBezTo>
                        <a:pt x="761679" y="538988"/>
                        <a:pt x="845499" y="499872"/>
                        <a:pt x="845499" y="499872"/>
                      </a:cubicBezTo>
                      <a:lnTo>
                        <a:pt x="845499" y="499872"/>
                      </a:lnTo>
                    </a:path>
                  </a:pathLst>
                </a:custGeom>
                <a:noFill/>
                <a:ln>
                  <a:solidFill>
                    <a:srgbClr val="C55A1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6" name="Freeform 98">
                  <a:extLst>
                    <a:ext uri="{FF2B5EF4-FFF2-40B4-BE49-F238E27FC236}">
                      <a16:creationId xmlns:a16="http://schemas.microsoft.com/office/drawing/2014/main" id="{5FE460BF-240F-4DC5-96F9-97D402818866}"/>
                    </a:ext>
                  </a:extLst>
                </p:cNvPr>
                <p:cNvSpPr/>
                <p:nvPr/>
              </p:nvSpPr>
              <p:spPr>
                <a:xfrm flipH="1">
                  <a:off x="5431376" y="5393392"/>
                  <a:ext cx="686716" cy="349296"/>
                </a:xfrm>
                <a:custGeom>
                  <a:avLst/>
                  <a:gdLst>
                    <a:gd name="connsiteX0" fmla="*/ 0 w 800100"/>
                    <a:gd name="connsiteY0" fmla="*/ 0 h 301789"/>
                    <a:gd name="connsiteX1" fmla="*/ 214884 w 800100"/>
                    <a:gd name="connsiteY1" fmla="*/ 150876 h 301789"/>
                    <a:gd name="connsiteX2" fmla="*/ 452628 w 800100"/>
                    <a:gd name="connsiteY2" fmla="*/ 256032 h 301789"/>
                    <a:gd name="connsiteX3" fmla="*/ 687324 w 800100"/>
                    <a:gd name="connsiteY3" fmla="*/ 300228 h 301789"/>
                    <a:gd name="connsiteX4" fmla="*/ 800100 w 800100"/>
                    <a:gd name="connsiteY4" fmla="*/ 292608 h 301789"/>
                    <a:gd name="connsiteX5" fmla="*/ 800100 w 800100"/>
                    <a:gd name="connsiteY5" fmla="*/ 292608 h 301789"/>
                    <a:gd name="connsiteX0" fmla="*/ 0 w 800100"/>
                    <a:gd name="connsiteY0" fmla="*/ 0 h 301789"/>
                    <a:gd name="connsiteX1" fmla="*/ 187452 w 800100"/>
                    <a:gd name="connsiteY1" fmla="*/ 149352 h 301789"/>
                    <a:gd name="connsiteX2" fmla="*/ 452628 w 800100"/>
                    <a:gd name="connsiteY2" fmla="*/ 256032 h 301789"/>
                    <a:gd name="connsiteX3" fmla="*/ 687324 w 800100"/>
                    <a:gd name="connsiteY3" fmla="*/ 300228 h 301789"/>
                    <a:gd name="connsiteX4" fmla="*/ 800100 w 800100"/>
                    <a:gd name="connsiteY4" fmla="*/ 292608 h 301789"/>
                    <a:gd name="connsiteX5" fmla="*/ 800100 w 800100"/>
                    <a:gd name="connsiteY5" fmla="*/ 292608 h 30178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800100" h="301789">
                      <a:moveTo>
                        <a:pt x="0" y="0"/>
                      </a:moveTo>
                      <a:cubicBezTo>
                        <a:pt x="69723" y="54102"/>
                        <a:pt x="112014" y="106680"/>
                        <a:pt x="187452" y="149352"/>
                      </a:cubicBezTo>
                      <a:cubicBezTo>
                        <a:pt x="262890" y="192024"/>
                        <a:pt x="369316" y="230886"/>
                        <a:pt x="452628" y="256032"/>
                      </a:cubicBezTo>
                      <a:cubicBezTo>
                        <a:pt x="535940" y="281178"/>
                        <a:pt x="629412" y="294132"/>
                        <a:pt x="687324" y="300228"/>
                      </a:cubicBezTo>
                      <a:cubicBezTo>
                        <a:pt x="745236" y="306324"/>
                        <a:pt x="800100" y="292608"/>
                        <a:pt x="800100" y="292608"/>
                      </a:cubicBezTo>
                      <a:lnTo>
                        <a:pt x="800100" y="292608"/>
                      </a:lnTo>
                    </a:path>
                  </a:pathLst>
                </a:custGeom>
                <a:noFill/>
                <a:ln>
                  <a:solidFill>
                    <a:srgbClr val="C55A1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7" name="Freeform 99">
                  <a:extLst>
                    <a:ext uri="{FF2B5EF4-FFF2-40B4-BE49-F238E27FC236}">
                      <a16:creationId xmlns:a16="http://schemas.microsoft.com/office/drawing/2014/main" id="{7BF3E3AC-478D-4463-8291-81C845968E13}"/>
                    </a:ext>
                  </a:extLst>
                </p:cNvPr>
                <p:cNvSpPr/>
                <p:nvPr/>
              </p:nvSpPr>
              <p:spPr>
                <a:xfrm flipH="1">
                  <a:off x="5258070" y="5213115"/>
                  <a:ext cx="1070801" cy="224613"/>
                </a:xfrm>
                <a:custGeom>
                  <a:avLst/>
                  <a:gdLst>
                    <a:gd name="connsiteX0" fmla="*/ 0 w 1028700"/>
                    <a:gd name="connsiteY0" fmla="*/ 38372 h 239263"/>
                    <a:gd name="connsiteX1" fmla="*/ 114300 w 1028700"/>
                    <a:gd name="connsiteY1" fmla="*/ 272 h 239263"/>
                    <a:gd name="connsiteX2" fmla="*/ 512618 w 1028700"/>
                    <a:gd name="connsiteY2" fmla="*/ 55690 h 239263"/>
                    <a:gd name="connsiteX3" fmla="*/ 827809 w 1028700"/>
                    <a:gd name="connsiteY3" fmla="*/ 142281 h 239263"/>
                    <a:gd name="connsiteX4" fmla="*/ 1028700 w 1028700"/>
                    <a:gd name="connsiteY4" fmla="*/ 239263 h 239263"/>
                    <a:gd name="connsiteX5" fmla="*/ 1028700 w 1028700"/>
                    <a:gd name="connsiteY5" fmla="*/ 239263 h 2392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028700" h="239263">
                      <a:moveTo>
                        <a:pt x="0" y="38372"/>
                      </a:moveTo>
                      <a:cubicBezTo>
                        <a:pt x="14432" y="17879"/>
                        <a:pt x="28864" y="-2614"/>
                        <a:pt x="114300" y="272"/>
                      </a:cubicBezTo>
                      <a:cubicBezTo>
                        <a:pt x="199736" y="3158"/>
                        <a:pt x="393700" y="32022"/>
                        <a:pt x="512618" y="55690"/>
                      </a:cubicBezTo>
                      <a:cubicBezTo>
                        <a:pt x="631536" y="79358"/>
                        <a:pt x="741795" y="111686"/>
                        <a:pt x="827809" y="142281"/>
                      </a:cubicBezTo>
                      <a:cubicBezTo>
                        <a:pt x="913823" y="172877"/>
                        <a:pt x="1028700" y="239263"/>
                        <a:pt x="1028700" y="239263"/>
                      </a:cubicBezTo>
                      <a:lnTo>
                        <a:pt x="1028700" y="239263"/>
                      </a:ln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8" name="Freeform 100">
                  <a:extLst>
                    <a:ext uri="{FF2B5EF4-FFF2-40B4-BE49-F238E27FC236}">
                      <a16:creationId xmlns:a16="http://schemas.microsoft.com/office/drawing/2014/main" id="{58E7B418-EFE4-4D9E-9CEB-D2EBCB563A3E}"/>
                    </a:ext>
                  </a:extLst>
                </p:cNvPr>
                <p:cNvSpPr/>
                <p:nvPr/>
              </p:nvSpPr>
              <p:spPr>
                <a:xfrm flipH="1">
                  <a:off x="5828601" y="5095627"/>
                  <a:ext cx="689860" cy="90258"/>
                </a:xfrm>
                <a:custGeom>
                  <a:avLst/>
                  <a:gdLst>
                    <a:gd name="connsiteX0" fmla="*/ 0 w 675409"/>
                    <a:gd name="connsiteY0" fmla="*/ 90258 h 90258"/>
                    <a:gd name="connsiteX1" fmla="*/ 107373 w 675409"/>
                    <a:gd name="connsiteY1" fmla="*/ 17522 h 90258"/>
                    <a:gd name="connsiteX2" fmla="*/ 280555 w 675409"/>
                    <a:gd name="connsiteY2" fmla="*/ 204 h 90258"/>
                    <a:gd name="connsiteX3" fmla="*/ 554182 w 675409"/>
                    <a:gd name="connsiteY3" fmla="*/ 24449 h 90258"/>
                    <a:gd name="connsiteX4" fmla="*/ 675409 w 675409"/>
                    <a:gd name="connsiteY4" fmla="*/ 45231 h 90258"/>
                    <a:gd name="connsiteX5" fmla="*/ 675409 w 675409"/>
                    <a:gd name="connsiteY5" fmla="*/ 45231 h 9025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675409" h="90258">
                      <a:moveTo>
                        <a:pt x="0" y="90258"/>
                      </a:moveTo>
                      <a:cubicBezTo>
                        <a:pt x="30307" y="61394"/>
                        <a:pt x="60614" y="32531"/>
                        <a:pt x="107373" y="17522"/>
                      </a:cubicBezTo>
                      <a:cubicBezTo>
                        <a:pt x="154132" y="2513"/>
                        <a:pt x="206087" y="-950"/>
                        <a:pt x="280555" y="204"/>
                      </a:cubicBezTo>
                      <a:cubicBezTo>
                        <a:pt x="355023" y="1358"/>
                        <a:pt x="488373" y="16945"/>
                        <a:pt x="554182" y="24449"/>
                      </a:cubicBezTo>
                      <a:cubicBezTo>
                        <a:pt x="619991" y="31953"/>
                        <a:pt x="675409" y="45231"/>
                        <a:pt x="675409" y="45231"/>
                      </a:cubicBezTo>
                      <a:lnTo>
                        <a:pt x="675409" y="45231"/>
                      </a:ln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9" name="Freeform 101">
                  <a:extLst>
                    <a:ext uri="{FF2B5EF4-FFF2-40B4-BE49-F238E27FC236}">
                      <a16:creationId xmlns:a16="http://schemas.microsoft.com/office/drawing/2014/main" id="{C5937CC1-5BA2-49C3-8ED0-A3EAB0AED799}"/>
                    </a:ext>
                  </a:extLst>
                </p:cNvPr>
                <p:cNvSpPr/>
                <p:nvPr/>
              </p:nvSpPr>
              <p:spPr>
                <a:xfrm flipH="1">
                  <a:off x="5764677" y="4878784"/>
                  <a:ext cx="757086" cy="313396"/>
                </a:xfrm>
                <a:custGeom>
                  <a:avLst/>
                  <a:gdLst>
                    <a:gd name="connsiteX0" fmla="*/ 0 w 720436"/>
                    <a:gd name="connsiteY0" fmla="*/ 287482 h 287482"/>
                    <a:gd name="connsiteX1" fmla="*/ 148936 w 720436"/>
                    <a:gd name="connsiteY1" fmla="*/ 190500 h 287482"/>
                    <a:gd name="connsiteX2" fmla="*/ 526473 w 720436"/>
                    <a:gd name="connsiteY2" fmla="*/ 117763 h 287482"/>
                    <a:gd name="connsiteX3" fmla="*/ 720436 w 720436"/>
                    <a:gd name="connsiteY3" fmla="*/ 0 h 28748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20436" h="287482">
                      <a:moveTo>
                        <a:pt x="0" y="287482"/>
                      </a:moveTo>
                      <a:cubicBezTo>
                        <a:pt x="30595" y="253134"/>
                        <a:pt x="61191" y="218786"/>
                        <a:pt x="148936" y="190500"/>
                      </a:cubicBezTo>
                      <a:cubicBezTo>
                        <a:pt x="236681" y="162214"/>
                        <a:pt x="431223" y="149513"/>
                        <a:pt x="526473" y="117763"/>
                      </a:cubicBezTo>
                      <a:cubicBezTo>
                        <a:pt x="621723" y="86013"/>
                        <a:pt x="671079" y="43006"/>
                        <a:pt x="720436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0" name="Freeform 102">
                  <a:extLst>
                    <a:ext uri="{FF2B5EF4-FFF2-40B4-BE49-F238E27FC236}">
                      <a16:creationId xmlns:a16="http://schemas.microsoft.com/office/drawing/2014/main" id="{5410F3E8-3DA9-4F7B-9F09-F57448ADCA4F}"/>
                    </a:ext>
                  </a:extLst>
                </p:cNvPr>
                <p:cNvSpPr/>
                <p:nvPr/>
              </p:nvSpPr>
              <p:spPr>
                <a:xfrm flipH="1">
                  <a:off x="5978249" y="4866998"/>
                  <a:ext cx="620211" cy="283031"/>
                </a:xfrm>
                <a:custGeom>
                  <a:avLst/>
                  <a:gdLst>
                    <a:gd name="connsiteX0" fmla="*/ 0 w 573881"/>
                    <a:gd name="connsiteY0" fmla="*/ 221456 h 221456"/>
                    <a:gd name="connsiteX1" fmla="*/ 128587 w 573881"/>
                    <a:gd name="connsiteY1" fmla="*/ 121444 h 221456"/>
                    <a:gd name="connsiteX2" fmla="*/ 330993 w 573881"/>
                    <a:gd name="connsiteY2" fmla="*/ 38100 h 221456"/>
                    <a:gd name="connsiteX3" fmla="*/ 495300 w 573881"/>
                    <a:gd name="connsiteY3" fmla="*/ 19050 h 221456"/>
                    <a:gd name="connsiteX4" fmla="*/ 573881 w 573881"/>
                    <a:gd name="connsiteY4" fmla="*/ 0 h 221456"/>
                    <a:gd name="connsiteX0" fmla="*/ 0 w 540667"/>
                    <a:gd name="connsiteY0" fmla="*/ 272884 h 272884"/>
                    <a:gd name="connsiteX1" fmla="*/ 128587 w 540667"/>
                    <a:gd name="connsiteY1" fmla="*/ 172872 h 272884"/>
                    <a:gd name="connsiteX2" fmla="*/ 330993 w 540667"/>
                    <a:gd name="connsiteY2" fmla="*/ 89528 h 272884"/>
                    <a:gd name="connsiteX3" fmla="*/ 495300 w 540667"/>
                    <a:gd name="connsiteY3" fmla="*/ 70478 h 272884"/>
                    <a:gd name="connsiteX4" fmla="*/ 540667 w 540667"/>
                    <a:gd name="connsiteY4" fmla="*/ 0 h 272884"/>
                    <a:gd name="connsiteX0" fmla="*/ 0 w 540667"/>
                    <a:gd name="connsiteY0" fmla="*/ 272884 h 272884"/>
                    <a:gd name="connsiteX1" fmla="*/ 128587 w 540667"/>
                    <a:gd name="connsiteY1" fmla="*/ 172872 h 272884"/>
                    <a:gd name="connsiteX2" fmla="*/ 330993 w 540667"/>
                    <a:gd name="connsiteY2" fmla="*/ 89528 h 272884"/>
                    <a:gd name="connsiteX3" fmla="*/ 465408 w 540667"/>
                    <a:gd name="connsiteY3" fmla="*/ 52111 h 272884"/>
                    <a:gd name="connsiteX4" fmla="*/ 540667 w 540667"/>
                    <a:gd name="connsiteY4" fmla="*/ 0 h 27288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540667" h="272884">
                      <a:moveTo>
                        <a:pt x="0" y="272884"/>
                      </a:moveTo>
                      <a:cubicBezTo>
                        <a:pt x="36711" y="238157"/>
                        <a:pt x="73422" y="203431"/>
                        <a:pt x="128587" y="172872"/>
                      </a:cubicBezTo>
                      <a:cubicBezTo>
                        <a:pt x="183752" y="142313"/>
                        <a:pt x="274856" y="109655"/>
                        <a:pt x="330993" y="89528"/>
                      </a:cubicBezTo>
                      <a:cubicBezTo>
                        <a:pt x="387130" y="69401"/>
                        <a:pt x="430462" y="67032"/>
                        <a:pt x="465408" y="52111"/>
                      </a:cubicBezTo>
                      <a:cubicBezTo>
                        <a:pt x="500354" y="37190"/>
                        <a:pt x="521617" y="6350"/>
                        <a:pt x="540667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1" name="Freeform 103">
                  <a:extLst>
                    <a:ext uri="{FF2B5EF4-FFF2-40B4-BE49-F238E27FC236}">
                      <a16:creationId xmlns:a16="http://schemas.microsoft.com/office/drawing/2014/main" id="{DE5C8875-035C-467C-B08B-EBF2000784EE}"/>
                    </a:ext>
                  </a:extLst>
                </p:cNvPr>
                <p:cNvSpPr/>
                <p:nvPr/>
              </p:nvSpPr>
              <p:spPr>
                <a:xfrm flipH="1">
                  <a:off x="6292927" y="4699973"/>
                  <a:ext cx="331234" cy="445294"/>
                </a:xfrm>
                <a:custGeom>
                  <a:avLst/>
                  <a:gdLst>
                    <a:gd name="connsiteX0" fmla="*/ 0 w 324295"/>
                    <a:gd name="connsiteY0" fmla="*/ 445294 h 445294"/>
                    <a:gd name="connsiteX1" fmla="*/ 61913 w 324295"/>
                    <a:gd name="connsiteY1" fmla="*/ 411956 h 445294"/>
                    <a:gd name="connsiteX2" fmla="*/ 211932 w 324295"/>
                    <a:gd name="connsiteY2" fmla="*/ 304800 h 445294"/>
                    <a:gd name="connsiteX3" fmla="*/ 307182 w 324295"/>
                    <a:gd name="connsiteY3" fmla="*/ 147638 h 445294"/>
                    <a:gd name="connsiteX4" fmla="*/ 323850 w 324295"/>
                    <a:gd name="connsiteY4" fmla="*/ 0 h 44529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24295" h="445294">
                      <a:moveTo>
                        <a:pt x="0" y="445294"/>
                      </a:moveTo>
                      <a:cubicBezTo>
                        <a:pt x="13295" y="440333"/>
                        <a:pt x="26591" y="435372"/>
                        <a:pt x="61913" y="411956"/>
                      </a:cubicBezTo>
                      <a:cubicBezTo>
                        <a:pt x="97235" y="388540"/>
                        <a:pt x="171054" y="348853"/>
                        <a:pt x="211932" y="304800"/>
                      </a:cubicBezTo>
                      <a:cubicBezTo>
                        <a:pt x="252810" y="260747"/>
                        <a:pt x="288529" y="198438"/>
                        <a:pt x="307182" y="147638"/>
                      </a:cubicBezTo>
                      <a:cubicBezTo>
                        <a:pt x="325835" y="96838"/>
                        <a:pt x="324842" y="48419"/>
                        <a:pt x="323850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2" name="Freeform 104">
                  <a:extLst>
                    <a:ext uri="{FF2B5EF4-FFF2-40B4-BE49-F238E27FC236}">
                      <a16:creationId xmlns:a16="http://schemas.microsoft.com/office/drawing/2014/main" id="{41A7A9B8-EE3C-416A-BE20-3A29F34302DF}"/>
                    </a:ext>
                  </a:extLst>
                </p:cNvPr>
                <p:cNvSpPr/>
                <p:nvPr/>
              </p:nvSpPr>
              <p:spPr>
                <a:xfrm flipH="1">
                  <a:off x="5505181" y="5172617"/>
                  <a:ext cx="843601" cy="102838"/>
                </a:xfrm>
                <a:custGeom>
                  <a:avLst/>
                  <a:gdLst>
                    <a:gd name="connsiteX0" fmla="*/ 0 w 971550"/>
                    <a:gd name="connsiteY0" fmla="*/ 78581 h 159543"/>
                    <a:gd name="connsiteX1" fmla="*/ 47625 w 971550"/>
                    <a:gd name="connsiteY1" fmla="*/ 33337 h 159543"/>
                    <a:gd name="connsiteX2" fmla="*/ 166688 w 971550"/>
                    <a:gd name="connsiteY2" fmla="*/ 0 h 159543"/>
                    <a:gd name="connsiteX3" fmla="*/ 481013 w 971550"/>
                    <a:gd name="connsiteY3" fmla="*/ 33337 h 159543"/>
                    <a:gd name="connsiteX4" fmla="*/ 781050 w 971550"/>
                    <a:gd name="connsiteY4" fmla="*/ 107156 h 159543"/>
                    <a:gd name="connsiteX5" fmla="*/ 971550 w 971550"/>
                    <a:gd name="connsiteY5" fmla="*/ 159543 h 159543"/>
                    <a:gd name="connsiteX0" fmla="*/ 0 w 971550"/>
                    <a:gd name="connsiteY0" fmla="*/ 91468 h 172430"/>
                    <a:gd name="connsiteX1" fmla="*/ 47625 w 971550"/>
                    <a:gd name="connsiteY1" fmla="*/ 46224 h 172430"/>
                    <a:gd name="connsiteX2" fmla="*/ 163297 w 971550"/>
                    <a:gd name="connsiteY2" fmla="*/ 0 h 172430"/>
                    <a:gd name="connsiteX3" fmla="*/ 481013 w 971550"/>
                    <a:gd name="connsiteY3" fmla="*/ 46224 h 172430"/>
                    <a:gd name="connsiteX4" fmla="*/ 781050 w 971550"/>
                    <a:gd name="connsiteY4" fmla="*/ 120043 h 172430"/>
                    <a:gd name="connsiteX5" fmla="*/ 971550 w 971550"/>
                    <a:gd name="connsiteY5" fmla="*/ 172430 h 172430"/>
                    <a:gd name="connsiteX0" fmla="*/ 0 w 971550"/>
                    <a:gd name="connsiteY0" fmla="*/ 96002 h 176964"/>
                    <a:gd name="connsiteX1" fmla="*/ 47625 w 971550"/>
                    <a:gd name="connsiteY1" fmla="*/ 50758 h 176964"/>
                    <a:gd name="connsiteX2" fmla="*/ 163297 w 971550"/>
                    <a:gd name="connsiteY2" fmla="*/ 4534 h 176964"/>
                    <a:gd name="connsiteX3" fmla="*/ 416582 w 971550"/>
                    <a:gd name="connsiteY3" fmla="*/ 15321 h 176964"/>
                    <a:gd name="connsiteX4" fmla="*/ 781050 w 971550"/>
                    <a:gd name="connsiteY4" fmla="*/ 124577 h 176964"/>
                    <a:gd name="connsiteX5" fmla="*/ 971550 w 971550"/>
                    <a:gd name="connsiteY5" fmla="*/ 176964 h 176964"/>
                    <a:gd name="connsiteX0" fmla="*/ 0 w 971550"/>
                    <a:gd name="connsiteY0" fmla="*/ 94208 h 175170"/>
                    <a:gd name="connsiteX1" fmla="*/ 47625 w 971550"/>
                    <a:gd name="connsiteY1" fmla="*/ 48964 h 175170"/>
                    <a:gd name="connsiteX2" fmla="*/ 163297 w 971550"/>
                    <a:gd name="connsiteY2" fmla="*/ 2740 h 175170"/>
                    <a:gd name="connsiteX3" fmla="*/ 416582 w 971550"/>
                    <a:gd name="connsiteY3" fmla="*/ 13527 h 175170"/>
                    <a:gd name="connsiteX4" fmla="*/ 723402 w 971550"/>
                    <a:gd name="connsiteY4" fmla="*/ 80903 h 175170"/>
                    <a:gd name="connsiteX5" fmla="*/ 971550 w 971550"/>
                    <a:gd name="connsiteY5" fmla="*/ 175170 h 175170"/>
                    <a:gd name="connsiteX0" fmla="*/ 0 w 723402"/>
                    <a:gd name="connsiteY0" fmla="*/ 94208 h 94208"/>
                    <a:gd name="connsiteX1" fmla="*/ 47625 w 723402"/>
                    <a:gd name="connsiteY1" fmla="*/ 48964 h 94208"/>
                    <a:gd name="connsiteX2" fmla="*/ 163297 w 723402"/>
                    <a:gd name="connsiteY2" fmla="*/ 2740 h 94208"/>
                    <a:gd name="connsiteX3" fmla="*/ 416582 w 723402"/>
                    <a:gd name="connsiteY3" fmla="*/ 13527 h 94208"/>
                    <a:gd name="connsiteX4" fmla="*/ 723402 w 723402"/>
                    <a:gd name="connsiteY4" fmla="*/ 80903 h 94208"/>
                    <a:gd name="connsiteX0" fmla="*/ 0 w 760704"/>
                    <a:gd name="connsiteY0" fmla="*/ 94316 h 94316"/>
                    <a:gd name="connsiteX1" fmla="*/ 47625 w 760704"/>
                    <a:gd name="connsiteY1" fmla="*/ 49072 h 94316"/>
                    <a:gd name="connsiteX2" fmla="*/ 163297 w 760704"/>
                    <a:gd name="connsiteY2" fmla="*/ 2848 h 94316"/>
                    <a:gd name="connsiteX3" fmla="*/ 416582 w 760704"/>
                    <a:gd name="connsiteY3" fmla="*/ 13635 h 94316"/>
                    <a:gd name="connsiteX4" fmla="*/ 760704 w 760704"/>
                    <a:gd name="connsiteY4" fmla="*/ 84232 h 9431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60704" h="94316">
                      <a:moveTo>
                        <a:pt x="0" y="94316"/>
                      </a:moveTo>
                      <a:cubicBezTo>
                        <a:pt x="9922" y="78242"/>
                        <a:pt x="20409" y="64317"/>
                        <a:pt x="47625" y="49072"/>
                      </a:cubicBezTo>
                      <a:cubicBezTo>
                        <a:pt x="74841" y="33827"/>
                        <a:pt x="101804" y="8754"/>
                        <a:pt x="163297" y="2848"/>
                      </a:cubicBezTo>
                      <a:cubicBezTo>
                        <a:pt x="224790" y="-3058"/>
                        <a:pt x="317014" y="71"/>
                        <a:pt x="416582" y="13635"/>
                      </a:cubicBezTo>
                      <a:cubicBezTo>
                        <a:pt x="516150" y="27199"/>
                        <a:pt x="668209" y="57292"/>
                        <a:pt x="760704" y="84232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3" name="Freeform 105">
                  <a:extLst>
                    <a:ext uri="{FF2B5EF4-FFF2-40B4-BE49-F238E27FC236}">
                      <a16:creationId xmlns:a16="http://schemas.microsoft.com/office/drawing/2014/main" id="{859BA8B5-40E3-43AE-88BE-EF42343CB331}"/>
                    </a:ext>
                  </a:extLst>
                </p:cNvPr>
                <p:cNvSpPr/>
                <p:nvPr/>
              </p:nvSpPr>
              <p:spPr>
                <a:xfrm flipH="1">
                  <a:off x="6614233" y="4228135"/>
                  <a:ext cx="260245" cy="794685"/>
                </a:xfrm>
                <a:custGeom>
                  <a:avLst/>
                  <a:gdLst>
                    <a:gd name="connsiteX0" fmla="*/ 0 w 178594"/>
                    <a:gd name="connsiteY0" fmla="*/ 797719 h 797719"/>
                    <a:gd name="connsiteX1" fmla="*/ 66675 w 178594"/>
                    <a:gd name="connsiteY1" fmla="*/ 614362 h 797719"/>
                    <a:gd name="connsiteX2" fmla="*/ 59531 w 178594"/>
                    <a:gd name="connsiteY2" fmla="*/ 304800 h 797719"/>
                    <a:gd name="connsiteX3" fmla="*/ 102394 w 178594"/>
                    <a:gd name="connsiteY3" fmla="*/ 104775 h 797719"/>
                    <a:gd name="connsiteX4" fmla="*/ 178594 w 178594"/>
                    <a:gd name="connsiteY4" fmla="*/ 0 h 79771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78594" h="797719">
                      <a:moveTo>
                        <a:pt x="0" y="797719"/>
                      </a:moveTo>
                      <a:cubicBezTo>
                        <a:pt x="28376" y="747117"/>
                        <a:pt x="56753" y="696515"/>
                        <a:pt x="66675" y="614362"/>
                      </a:cubicBezTo>
                      <a:cubicBezTo>
                        <a:pt x="76597" y="532209"/>
                        <a:pt x="53578" y="389731"/>
                        <a:pt x="59531" y="304800"/>
                      </a:cubicBezTo>
                      <a:cubicBezTo>
                        <a:pt x="65484" y="219869"/>
                        <a:pt x="82550" y="155575"/>
                        <a:pt x="102394" y="104775"/>
                      </a:cubicBezTo>
                      <a:cubicBezTo>
                        <a:pt x="122238" y="53975"/>
                        <a:pt x="150416" y="26987"/>
                        <a:pt x="178594" y="0"/>
                      </a:cubicBezTo>
                    </a:path>
                  </a:pathLst>
                </a:custGeom>
                <a:noFill/>
                <a:ln>
                  <a:solidFill>
                    <a:schemeClr val="accent5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4" name="Freeform 107">
                  <a:extLst>
                    <a:ext uri="{FF2B5EF4-FFF2-40B4-BE49-F238E27FC236}">
                      <a16:creationId xmlns:a16="http://schemas.microsoft.com/office/drawing/2014/main" id="{5E7B343E-EE7B-4734-BFDD-35D8180B693D}"/>
                    </a:ext>
                  </a:extLst>
                </p:cNvPr>
                <p:cNvSpPr/>
                <p:nvPr/>
              </p:nvSpPr>
              <p:spPr>
                <a:xfrm rot="11373066" flipH="1">
                  <a:off x="5066653" y="3694447"/>
                  <a:ext cx="1826727" cy="2084446"/>
                </a:xfrm>
                <a:custGeom>
                  <a:avLst/>
                  <a:gdLst>
                    <a:gd name="connsiteX0" fmla="*/ 60786 w 1666890"/>
                    <a:gd name="connsiteY0" fmla="*/ 315046 h 1594902"/>
                    <a:gd name="connsiteX1" fmla="*/ 232236 w 1666890"/>
                    <a:gd name="connsiteY1" fmla="*/ 184871 h 1594902"/>
                    <a:gd name="connsiteX2" fmla="*/ 603711 w 1666890"/>
                    <a:gd name="connsiteY2" fmla="*/ 86446 h 1594902"/>
                    <a:gd name="connsiteX3" fmla="*/ 625936 w 1666890"/>
                    <a:gd name="connsiteY3" fmla="*/ 283296 h 1594902"/>
                    <a:gd name="connsiteX4" fmla="*/ 365586 w 1666890"/>
                    <a:gd name="connsiteY4" fmla="*/ 502371 h 1594902"/>
                    <a:gd name="connsiteX5" fmla="*/ 308436 w 1666890"/>
                    <a:gd name="connsiteY5" fmla="*/ 661121 h 1594902"/>
                    <a:gd name="connsiteX6" fmla="*/ 511636 w 1666890"/>
                    <a:gd name="connsiteY6" fmla="*/ 692871 h 1594902"/>
                    <a:gd name="connsiteX7" fmla="*/ 829136 w 1666890"/>
                    <a:gd name="connsiteY7" fmla="*/ 502371 h 1594902"/>
                    <a:gd name="connsiteX8" fmla="*/ 1003761 w 1666890"/>
                    <a:gd name="connsiteY8" fmla="*/ 476971 h 1594902"/>
                    <a:gd name="connsiteX9" fmla="*/ 1022811 w 1666890"/>
                    <a:gd name="connsiteY9" fmla="*/ 651596 h 1594902"/>
                    <a:gd name="connsiteX10" fmla="*/ 819611 w 1666890"/>
                    <a:gd name="connsiteY10" fmla="*/ 842096 h 1594902"/>
                    <a:gd name="connsiteX11" fmla="*/ 705311 w 1666890"/>
                    <a:gd name="connsiteY11" fmla="*/ 969096 h 1594902"/>
                    <a:gd name="connsiteX12" fmla="*/ 756111 w 1666890"/>
                    <a:gd name="connsiteY12" fmla="*/ 1118321 h 1594902"/>
                    <a:gd name="connsiteX13" fmla="*/ 1038686 w 1666890"/>
                    <a:gd name="connsiteY13" fmla="*/ 1007196 h 1594902"/>
                    <a:gd name="connsiteX14" fmla="*/ 1279986 w 1666890"/>
                    <a:gd name="connsiteY14" fmla="*/ 892896 h 1594902"/>
                    <a:gd name="connsiteX15" fmla="*/ 1419686 w 1666890"/>
                    <a:gd name="connsiteY15" fmla="*/ 1061171 h 1594902"/>
                    <a:gd name="connsiteX16" fmla="*/ 984711 w 1666890"/>
                    <a:gd name="connsiteY16" fmla="*/ 1359621 h 1594902"/>
                    <a:gd name="connsiteX17" fmla="*/ 1105361 w 1666890"/>
                    <a:gd name="connsiteY17" fmla="*/ 1527896 h 1594902"/>
                    <a:gd name="connsiteX18" fmla="*/ 1387936 w 1666890"/>
                    <a:gd name="connsiteY18" fmla="*/ 1496146 h 1594902"/>
                    <a:gd name="connsiteX19" fmla="*/ 1607011 w 1666890"/>
                    <a:gd name="connsiteY19" fmla="*/ 1594571 h 1594902"/>
                    <a:gd name="connsiteX20" fmla="*/ 1660986 w 1666890"/>
                    <a:gd name="connsiteY20" fmla="*/ 1524721 h 1594902"/>
                    <a:gd name="connsiteX21" fmla="*/ 1495886 w 1666890"/>
                    <a:gd name="connsiteY21" fmla="*/ 1432646 h 1594902"/>
                    <a:gd name="connsiteX22" fmla="*/ 1318086 w 1666890"/>
                    <a:gd name="connsiteY22" fmla="*/ 1407246 h 1594902"/>
                    <a:gd name="connsiteX23" fmla="*/ 1181561 w 1666890"/>
                    <a:gd name="connsiteY23" fmla="*/ 1423121 h 1594902"/>
                    <a:gd name="connsiteX24" fmla="*/ 1095836 w 1666890"/>
                    <a:gd name="connsiteY24" fmla="*/ 1416771 h 1594902"/>
                    <a:gd name="connsiteX25" fmla="*/ 1095836 w 1666890"/>
                    <a:gd name="connsiteY25" fmla="*/ 1365971 h 1594902"/>
                    <a:gd name="connsiteX26" fmla="*/ 1378411 w 1666890"/>
                    <a:gd name="connsiteY26" fmla="*/ 1238971 h 1594902"/>
                    <a:gd name="connsiteX27" fmla="*/ 1518111 w 1666890"/>
                    <a:gd name="connsiteY27" fmla="*/ 1064346 h 1594902"/>
                    <a:gd name="connsiteX28" fmla="*/ 1480011 w 1666890"/>
                    <a:gd name="connsiteY28" fmla="*/ 889721 h 1594902"/>
                    <a:gd name="connsiteX29" fmla="*/ 1260936 w 1666890"/>
                    <a:gd name="connsiteY29" fmla="*/ 797646 h 1594902"/>
                    <a:gd name="connsiteX30" fmla="*/ 1035511 w 1666890"/>
                    <a:gd name="connsiteY30" fmla="*/ 867496 h 1594902"/>
                    <a:gd name="connsiteX31" fmla="*/ 781511 w 1666890"/>
                    <a:gd name="connsiteY31" fmla="*/ 988146 h 1594902"/>
                    <a:gd name="connsiteX32" fmla="*/ 845011 w 1666890"/>
                    <a:gd name="connsiteY32" fmla="*/ 892896 h 1594902"/>
                    <a:gd name="connsiteX33" fmla="*/ 1108536 w 1666890"/>
                    <a:gd name="connsiteY33" fmla="*/ 711921 h 1594902"/>
                    <a:gd name="connsiteX34" fmla="*/ 1118061 w 1666890"/>
                    <a:gd name="connsiteY34" fmla="*/ 505546 h 1594902"/>
                    <a:gd name="connsiteX35" fmla="*/ 959311 w 1666890"/>
                    <a:gd name="connsiteY35" fmla="*/ 369021 h 1594902"/>
                    <a:gd name="connsiteX36" fmla="*/ 794211 w 1666890"/>
                    <a:gd name="connsiteY36" fmla="*/ 448396 h 1594902"/>
                    <a:gd name="connsiteX37" fmla="*/ 533861 w 1666890"/>
                    <a:gd name="connsiteY37" fmla="*/ 572221 h 1594902"/>
                    <a:gd name="connsiteX38" fmla="*/ 448136 w 1666890"/>
                    <a:gd name="connsiteY38" fmla="*/ 572221 h 1594902"/>
                    <a:gd name="connsiteX39" fmla="*/ 441786 w 1666890"/>
                    <a:gd name="connsiteY39" fmla="*/ 549996 h 1594902"/>
                    <a:gd name="connsiteX40" fmla="*/ 479886 w 1666890"/>
                    <a:gd name="connsiteY40" fmla="*/ 508721 h 1594902"/>
                    <a:gd name="connsiteX41" fmla="*/ 641811 w 1666890"/>
                    <a:gd name="connsiteY41" fmla="*/ 410296 h 1594902"/>
                    <a:gd name="connsiteX42" fmla="*/ 743411 w 1666890"/>
                    <a:gd name="connsiteY42" fmla="*/ 146771 h 1594902"/>
                    <a:gd name="connsiteX43" fmla="*/ 629111 w 1666890"/>
                    <a:gd name="connsiteY43" fmla="*/ 3896 h 1594902"/>
                    <a:gd name="connsiteX44" fmla="*/ 314786 w 1666890"/>
                    <a:gd name="connsiteY44" fmla="*/ 51521 h 1594902"/>
                    <a:gd name="connsiteX45" fmla="*/ 57611 w 1666890"/>
                    <a:gd name="connsiteY45" fmla="*/ 168996 h 1594902"/>
                    <a:gd name="connsiteX46" fmla="*/ 461 w 1666890"/>
                    <a:gd name="connsiteY46" fmla="*/ 264246 h 1594902"/>
                    <a:gd name="connsiteX47" fmla="*/ 60786 w 1666890"/>
                    <a:gd name="connsiteY47" fmla="*/ 315046 h 1594902"/>
                    <a:gd name="connsiteX0" fmla="*/ 16642 w 1622746"/>
                    <a:gd name="connsiteY0" fmla="*/ 315046 h 1594902"/>
                    <a:gd name="connsiteX1" fmla="*/ 188092 w 1622746"/>
                    <a:gd name="connsiteY1" fmla="*/ 184871 h 1594902"/>
                    <a:gd name="connsiteX2" fmla="*/ 559567 w 1622746"/>
                    <a:gd name="connsiteY2" fmla="*/ 86446 h 1594902"/>
                    <a:gd name="connsiteX3" fmla="*/ 581792 w 1622746"/>
                    <a:gd name="connsiteY3" fmla="*/ 283296 h 1594902"/>
                    <a:gd name="connsiteX4" fmla="*/ 321442 w 1622746"/>
                    <a:gd name="connsiteY4" fmla="*/ 502371 h 1594902"/>
                    <a:gd name="connsiteX5" fmla="*/ 264292 w 1622746"/>
                    <a:gd name="connsiteY5" fmla="*/ 661121 h 1594902"/>
                    <a:gd name="connsiteX6" fmla="*/ 467492 w 1622746"/>
                    <a:gd name="connsiteY6" fmla="*/ 692871 h 1594902"/>
                    <a:gd name="connsiteX7" fmla="*/ 784992 w 1622746"/>
                    <a:gd name="connsiteY7" fmla="*/ 502371 h 1594902"/>
                    <a:gd name="connsiteX8" fmla="*/ 959617 w 1622746"/>
                    <a:gd name="connsiteY8" fmla="*/ 476971 h 1594902"/>
                    <a:gd name="connsiteX9" fmla="*/ 978667 w 1622746"/>
                    <a:gd name="connsiteY9" fmla="*/ 651596 h 1594902"/>
                    <a:gd name="connsiteX10" fmla="*/ 775467 w 1622746"/>
                    <a:gd name="connsiteY10" fmla="*/ 842096 h 1594902"/>
                    <a:gd name="connsiteX11" fmla="*/ 661167 w 1622746"/>
                    <a:gd name="connsiteY11" fmla="*/ 969096 h 1594902"/>
                    <a:gd name="connsiteX12" fmla="*/ 711967 w 1622746"/>
                    <a:gd name="connsiteY12" fmla="*/ 1118321 h 1594902"/>
                    <a:gd name="connsiteX13" fmla="*/ 994542 w 1622746"/>
                    <a:gd name="connsiteY13" fmla="*/ 1007196 h 1594902"/>
                    <a:gd name="connsiteX14" fmla="*/ 1235842 w 1622746"/>
                    <a:gd name="connsiteY14" fmla="*/ 892896 h 1594902"/>
                    <a:gd name="connsiteX15" fmla="*/ 1375542 w 1622746"/>
                    <a:gd name="connsiteY15" fmla="*/ 1061171 h 1594902"/>
                    <a:gd name="connsiteX16" fmla="*/ 940567 w 1622746"/>
                    <a:gd name="connsiteY16" fmla="*/ 1359621 h 1594902"/>
                    <a:gd name="connsiteX17" fmla="*/ 1061217 w 1622746"/>
                    <a:gd name="connsiteY17" fmla="*/ 1527896 h 1594902"/>
                    <a:gd name="connsiteX18" fmla="*/ 1343792 w 1622746"/>
                    <a:gd name="connsiteY18" fmla="*/ 1496146 h 1594902"/>
                    <a:gd name="connsiteX19" fmla="*/ 1562867 w 1622746"/>
                    <a:gd name="connsiteY19" fmla="*/ 1594571 h 1594902"/>
                    <a:gd name="connsiteX20" fmla="*/ 1616842 w 1622746"/>
                    <a:gd name="connsiteY20" fmla="*/ 1524721 h 1594902"/>
                    <a:gd name="connsiteX21" fmla="*/ 1451742 w 1622746"/>
                    <a:gd name="connsiteY21" fmla="*/ 1432646 h 1594902"/>
                    <a:gd name="connsiteX22" fmla="*/ 1273942 w 1622746"/>
                    <a:gd name="connsiteY22" fmla="*/ 1407246 h 1594902"/>
                    <a:gd name="connsiteX23" fmla="*/ 1137417 w 1622746"/>
                    <a:gd name="connsiteY23" fmla="*/ 1423121 h 1594902"/>
                    <a:gd name="connsiteX24" fmla="*/ 1051692 w 1622746"/>
                    <a:gd name="connsiteY24" fmla="*/ 1416771 h 1594902"/>
                    <a:gd name="connsiteX25" fmla="*/ 1051692 w 1622746"/>
                    <a:gd name="connsiteY25" fmla="*/ 1365971 h 1594902"/>
                    <a:gd name="connsiteX26" fmla="*/ 1334267 w 1622746"/>
                    <a:gd name="connsiteY26" fmla="*/ 1238971 h 1594902"/>
                    <a:gd name="connsiteX27" fmla="*/ 1473967 w 1622746"/>
                    <a:gd name="connsiteY27" fmla="*/ 1064346 h 1594902"/>
                    <a:gd name="connsiteX28" fmla="*/ 1435867 w 1622746"/>
                    <a:gd name="connsiteY28" fmla="*/ 889721 h 1594902"/>
                    <a:gd name="connsiteX29" fmla="*/ 1216792 w 1622746"/>
                    <a:gd name="connsiteY29" fmla="*/ 797646 h 1594902"/>
                    <a:gd name="connsiteX30" fmla="*/ 991367 w 1622746"/>
                    <a:gd name="connsiteY30" fmla="*/ 867496 h 1594902"/>
                    <a:gd name="connsiteX31" fmla="*/ 737367 w 1622746"/>
                    <a:gd name="connsiteY31" fmla="*/ 988146 h 1594902"/>
                    <a:gd name="connsiteX32" fmla="*/ 800867 w 1622746"/>
                    <a:gd name="connsiteY32" fmla="*/ 892896 h 1594902"/>
                    <a:gd name="connsiteX33" fmla="*/ 1064392 w 1622746"/>
                    <a:gd name="connsiteY33" fmla="*/ 711921 h 1594902"/>
                    <a:gd name="connsiteX34" fmla="*/ 1073917 w 1622746"/>
                    <a:gd name="connsiteY34" fmla="*/ 505546 h 1594902"/>
                    <a:gd name="connsiteX35" fmla="*/ 915167 w 1622746"/>
                    <a:gd name="connsiteY35" fmla="*/ 369021 h 1594902"/>
                    <a:gd name="connsiteX36" fmla="*/ 750067 w 1622746"/>
                    <a:gd name="connsiteY36" fmla="*/ 448396 h 1594902"/>
                    <a:gd name="connsiteX37" fmla="*/ 489717 w 1622746"/>
                    <a:gd name="connsiteY37" fmla="*/ 572221 h 1594902"/>
                    <a:gd name="connsiteX38" fmla="*/ 403992 w 1622746"/>
                    <a:gd name="connsiteY38" fmla="*/ 572221 h 1594902"/>
                    <a:gd name="connsiteX39" fmla="*/ 397642 w 1622746"/>
                    <a:gd name="connsiteY39" fmla="*/ 549996 h 1594902"/>
                    <a:gd name="connsiteX40" fmla="*/ 435742 w 1622746"/>
                    <a:gd name="connsiteY40" fmla="*/ 508721 h 1594902"/>
                    <a:gd name="connsiteX41" fmla="*/ 597667 w 1622746"/>
                    <a:gd name="connsiteY41" fmla="*/ 410296 h 1594902"/>
                    <a:gd name="connsiteX42" fmla="*/ 699267 w 1622746"/>
                    <a:gd name="connsiteY42" fmla="*/ 146771 h 1594902"/>
                    <a:gd name="connsiteX43" fmla="*/ 584967 w 1622746"/>
                    <a:gd name="connsiteY43" fmla="*/ 3896 h 1594902"/>
                    <a:gd name="connsiteX44" fmla="*/ 270642 w 1622746"/>
                    <a:gd name="connsiteY44" fmla="*/ 51521 h 1594902"/>
                    <a:gd name="connsiteX45" fmla="*/ 13467 w 1622746"/>
                    <a:gd name="connsiteY45" fmla="*/ 168996 h 1594902"/>
                    <a:gd name="connsiteX46" fmla="*/ 80907 w 1622746"/>
                    <a:gd name="connsiteY46" fmla="*/ 240885 h 1594902"/>
                    <a:gd name="connsiteX47" fmla="*/ 16642 w 1622746"/>
                    <a:gd name="connsiteY47" fmla="*/ 315046 h 1594902"/>
                    <a:gd name="connsiteX0" fmla="*/ 38099 w 1644203"/>
                    <a:gd name="connsiteY0" fmla="*/ 315046 h 1594902"/>
                    <a:gd name="connsiteX1" fmla="*/ 209549 w 1644203"/>
                    <a:gd name="connsiteY1" fmla="*/ 184871 h 1594902"/>
                    <a:gd name="connsiteX2" fmla="*/ 581024 w 1644203"/>
                    <a:gd name="connsiteY2" fmla="*/ 86446 h 1594902"/>
                    <a:gd name="connsiteX3" fmla="*/ 603249 w 1644203"/>
                    <a:gd name="connsiteY3" fmla="*/ 283296 h 1594902"/>
                    <a:gd name="connsiteX4" fmla="*/ 342899 w 1644203"/>
                    <a:gd name="connsiteY4" fmla="*/ 502371 h 1594902"/>
                    <a:gd name="connsiteX5" fmla="*/ 285749 w 1644203"/>
                    <a:gd name="connsiteY5" fmla="*/ 661121 h 1594902"/>
                    <a:gd name="connsiteX6" fmla="*/ 488949 w 1644203"/>
                    <a:gd name="connsiteY6" fmla="*/ 692871 h 1594902"/>
                    <a:gd name="connsiteX7" fmla="*/ 806449 w 1644203"/>
                    <a:gd name="connsiteY7" fmla="*/ 502371 h 1594902"/>
                    <a:gd name="connsiteX8" fmla="*/ 981074 w 1644203"/>
                    <a:gd name="connsiteY8" fmla="*/ 476971 h 1594902"/>
                    <a:gd name="connsiteX9" fmla="*/ 1000124 w 1644203"/>
                    <a:gd name="connsiteY9" fmla="*/ 651596 h 1594902"/>
                    <a:gd name="connsiteX10" fmla="*/ 796924 w 1644203"/>
                    <a:gd name="connsiteY10" fmla="*/ 842096 h 1594902"/>
                    <a:gd name="connsiteX11" fmla="*/ 682624 w 1644203"/>
                    <a:gd name="connsiteY11" fmla="*/ 969096 h 1594902"/>
                    <a:gd name="connsiteX12" fmla="*/ 733424 w 1644203"/>
                    <a:gd name="connsiteY12" fmla="*/ 1118321 h 1594902"/>
                    <a:gd name="connsiteX13" fmla="*/ 1015999 w 1644203"/>
                    <a:gd name="connsiteY13" fmla="*/ 1007196 h 1594902"/>
                    <a:gd name="connsiteX14" fmla="*/ 1257299 w 1644203"/>
                    <a:gd name="connsiteY14" fmla="*/ 892896 h 1594902"/>
                    <a:gd name="connsiteX15" fmla="*/ 1396999 w 1644203"/>
                    <a:gd name="connsiteY15" fmla="*/ 1061171 h 1594902"/>
                    <a:gd name="connsiteX16" fmla="*/ 962024 w 1644203"/>
                    <a:gd name="connsiteY16" fmla="*/ 1359621 h 1594902"/>
                    <a:gd name="connsiteX17" fmla="*/ 1082674 w 1644203"/>
                    <a:gd name="connsiteY17" fmla="*/ 1527896 h 1594902"/>
                    <a:gd name="connsiteX18" fmla="*/ 1365249 w 1644203"/>
                    <a:gd name="connsiteY18" fmla="*/ 1496146 h 1594902"/>
                    <a:gd name="connsiteX19" fmla="*/ 1584324 w 1644203"/>
                    <a:gd name="connsiteY19" fmla="*/ 1594571 h 1594902"/>
                    <a:gd name="connsiteX20" fmla="*/ 1638299 w 1644203"/>
                    <a:gd name="connsiteY20" fmla="*/ 1524721 h 1594902"/>
                    <a:gd name="connsiteX21" fmla="*/ 1473199 w 1644203"/>
                    <a:gd name="connsiteY21" fmla="*/ 1432646 h 1594902"/>
                    <a:gd name="connsiteX22" fmla="*/ 1295399 w 1644203"/>
                    <a:gd name="connsiteY22" fmla="*/ 1407246 h 1594902"/>
                    <a:gd name="connsiteX23" fmla="*/ 1158874 w 1644203"/>
                    <a:gd name="connsiteY23" fmla="*/ 1423121 h 1594902"/>
                    <a:gd name="connsiteX24" fmla="*/ 1073149 w 1644203"/>
                    <a:gd name="connsiteY24" fmla="*/ 1416771 h 1594902"/>
                    <a:gd name="connsiteX25" fmla="*/ 1073149 w 1644203"/>
                    <a:gd name="connsiteY25" fmla="*/ 1365971 h 1594902"/>
                    <a:gd name="connsiteX26" fmla="*/ 1355724 w 1644203"/>
                    <a:gd name="connsiteY26" fmla="*/ 1238971 h 1594902"/>
                    <a:gd name="connsiteX27" fmla="*/ 1495424 w 1644203"/>
                    <a:gd name="connsiteY27" fmla="*/ 1064346 h 1594902"/>
                    <a:gd name="connsiteX28" fmla="*/ 1457324 w 1644203"/>
                    <a:gd name="connsiteY28" fmla="*/ 889721 h 1594902"/>
                    <a:gd name="connsiteX29" fmla="*/ 1238249 w 1644203"/>
                    <a:gd name="connsiteY29" fmla="*/ 797646 h 1594902"/>
                    <a:gd name="connsiteX30" fmla="*/ 1012824 w 1644203"/>
                    <a:gd name="connsiteY30" fmla="*/ 867496 h 1594902"/>
                    <a:gd name="connsiteX31" fmla="*/ 758824 w 1644203"/>
                    <a:gd name="connsiteY31" fmla="*/ 988146 h 1594902"/>
                    <a:gd name="connsiteX32" fmla="*/ 822324 w 1644203"/>
                    <a:gd name="connsiteY32" fmla="*/ 892896 h 1594902"/>
                    <a:gd name="connsiteX33" fmla="*/ 1085849 w 1644203"/>
                    <a:gd name="connsiteY33" fmla="*/ 711921 h 1594902"/>
                    <a:gd name="connsiteX34" fmla="*/ 1095374 w 1644203"/>
                    <a:gd name="connsiteY34" fmla="*/ 505546 h 1594902"/>
                    <a:gd name="connsiteX35" fmla="*/ 936624 w 1644203"/>
                    <a:gd name="connsiteY35" fmla="*/ 369021 h 1594902"/>
                    <a:gd name="connsiteX36" fmla="*/ 771524 w 1644203"/>
                    <a:gd name="connsiteY36" fmla="*/ 448396 h 1594902"/>
                    <a:gd name="connsiteX37" fmla="*/ 511174 w 1644203"/>
                    <a:gd name="connsiteY37" fmla="*/ 572221 h 1594902"/>
                    <a:gd name="connsiteX38" fmla="*/ 425449 w 1644203"/>
                    <a:gd name="connsiteY38" fmla="*/ 572221 h 1594902"/>
                    <a:gd name="connsiteX39" fmla="*/ 419099 w 1644203"/>
                    <a:gd name="connsiteY39" fmla="*/ 549996 h 1594902"/>
                    <a:gd name="connsiteX40" fmla="*/ 457199 w 1644203"/>
                    <a:gd name="connsiteY40" fmla="*/ 508721 h 1594902"/>
                    <a:gd name="connsiteX41" fmla="*/ 619124 w 1644203"/>
                    <a:gd name="connsiteY41" fmla="*/ 410296 h 1594902"/>
                    <a:gd name="connsiteX42" fmla="*/ 720724 w 1644203"/>
                    <a:gd name="connsiteY42" fmla="*/ 146771 h 1594902"/>
                    <a:gd name="connsiteX43" fmla="*/ 606424 w 1644203"/>
                    <a:gd name="connsiteY43" fmla="*/ 3896 h 1594902"/>
                    <a:gd name="connsiteX44" fmla="*/ 292099 w 1644203"/>
                    <a:gd name="connsiteY44" fmla="*/ 51521 h 1594902"/>
                    <a:gd name="connsiteX45" fmla="*/ 34924 w 1644203"/>
                    <a:gd name="connsiteY45" fmla="*/ 168996 h 1594902"/>
                    <a:gd name="connsiteX46" fmla="*/ 6527 w 1644203"/>
                    <a:gd name="connsiteY46" fmla="*/ 218238 h 1594902"/>
                    <a:gd name="connsiteX47" fmla="*/ 38099 w 1644203"/>
                    <a:gd name="connsiteY47" fmla="*/ 315046 h 1594902"/>
                    <a:gd name="connsiteX0" fmla="*/ 24186 w 1630290"/>
                    <a:gd name="connsiteY0" fmla="*/ 315046 h 1594902"/>
                    <a:gd name="connsiteX1" fmla="*/ 195636 w 1630290"/>
                    <a:gd name="connsiteY1" fmla="*/ 184871 h 1594902"/>
                    <a:gd name="connsiteX2" fmla="*/ 567111 w 1630290"/>
                    <a:gd name="connsiteY2" fmla="*/ 86446 h 1594902"/>
                    <a:gd name="connsiteX3" fmla="*/ 589336 w 1630290"/>
                    <a:gd name="connsiteY3" fmla="*/ 283296 h 1594902"/>
                    <a:gd name="connsiteX4" fmla="*/ 328986 w 1630290"/>
                    <a:gd name="connsiteY4" fmla="*/ 502371 h 1594902"/>
                    <a:gd name="connsiteX5" fmla="*/ 271836 w 1630290"/>
                    <a:gd name="connsiteY5" fmla="*/ 661121 h 1594902"/>
                    <a:gd name="connsiteX6" fmla="*/ 475036 w 1630290"/>
                    <a:gd name="connsiteY6" fmla="*/ 692871 h 1594902"/>
                    <a:gd name="connsiteX7" fmla="*/ 792536 w 1630290"/>
                    <a:gd name="connsiteY7" fmla="*/ 502371 h 1594902"/>
                    <a:gd name="connsiteX8" fmla="*/ 967161 w 1630290"/>
                    <a:gd name="connsiteY8" fmla="*/ 476971 h 1594902"/>
                    <a:gd name="connsiteX9" fmla="*/ 986211 w 1630290"/>
                    <a:gd name="connsiteY9" fmla="*/ 651596 h 1594902"/>
                    <a:gd name="connsiteX10" fmla="*/ 783011 w 1630290"/>
                    <a:gd name="connsiteY10" fmla="*/ 842096 h 1594902"/>
                    <a:gd name="connsiteX11" fmla="*/ 668711 w 1630290"/>
                    <a:gd name="connsiteY11" fmla="*/ 969096 h 1594902"/>
                    <a:gd name="connsiteX12" fmla="*/ 719511 w 1630290"/>
                    <a:gd name="connsiteY12" fmla="*/ 1118321 h 1594902"/>
                    <a:gd name="connsiteX13" fmla="*/ 1002086 w 1630290"/>
                    <a:gd name="connsiteY13" fmla="*/ 1007196 h 1594902"/>
                    <a:gd name="connsiteX14" fmla="*/ 1243386 w 1630290"/>
                    <a:gd name="connsiteY14" fmla="*/ 892896 h 1594902"/>
                    <a:gd name="connsiteX15" fmla="*/ 1383086 w 1630290"/>
                    <a:gd name="connsiteY15" fmla="*/ 1061171 h 1594902"/>
                    <a:gd name="connsiteX16" fmla="*/ 948111 w 1630290"/>
                    <a:gd name="connsiteY16" fmla="*/ 1359621 h 1594902"/>
                    <a:gd name="connsiteX17" fmla="*/ 1068761 w 1630290"/>
                    <a:gd name="connsiteY17" fmla="*/ 1527896 h 1594902"/>
                    <a:gd name="connsiteX18" fmla="*/ 1351336 w 1630290"/>
                    <a:gd name="connsiteY18" fmla="*/ 1496146 h 1594902"/>
                    <a:gd name="connsiteX19" fmla="*/ 1570411 w 1630290"/>
                    <a:gd name="connsiteY19" fmla="*/ 1594571 h 1594902"/>
                    <a:gd name="connsiteX20" fmla="*/ 1624386 w 1630290"/>
                    <a:gd name="connsiteY20" fmla="*/ 1524721 h 1594902"/>
                    <a:gd name="connsiteX21" fmla="*/ 1459286 w 1630290"/>
                    <a:gd name="connsiteY21" fmla="*/ 1432646 h 1594902"/>
                    <a:gd name="connsiteX22" fmla="*/ 1281486 w 1630290"/>
                    <a:gd name="connsiteY22" fmla="*/ 1407246 h 1594902"/>
                    <a:gd name="connsiteX23" fmla="*/ 1144961 w 1630290"/>
                    <a:gd name="connsiteY23" fmla="*/ 1423121 h 1594902"/>
                    <a:gd name="connsiteX24" fmla="*/ 1059236 w 1630290"/>
                    <a:gd name="connsiteY24" fmla="*/ 1416771 h 1594902"/>
                    <a:gd name="connsiteX25" fmla="*/ 1059236 w 1630290"/>
                    <a:gd name="connsiteY25" fmla="*/ 1365971 h 1594902"/>
                    <a:gd name="connsiteX26" fmla="*/ 1341811 w 1630290"/>
                    <a:gd name="connsiteY26" fmla="*/ 1238971 h 1594902"/>
                    <a:gd name="connsiteX27" fmla="*/ 1481511 w 1630290"/>
                    <a:gd name="connsiteY27" fmla="*/ 1064346 h 1594902"/>
                    <a:gd name="connsiteX28" fmla="*/ 1443411 w 1630290"/>
                    <a:gd name="connsiteY28" fmla="*/ 889721 h 1594902"/>
                    <a:gd name="connsiteX29" fmla="*/ 1224336 w 1630290"/>
                    <a:gd name="connsiteY29" fmla="*/ 797646 h 1594902"/>
                    <a:gd name="connsiteX30" fmla="*/ 998911 w 1630290"/>
                    <a:gd name="connsiteY30" fmla="*/ 867496 h 1594902"/>
                    <a:gd name="connsiteX31" fmla="*/ 744911 w 1630290"/>
                    <a:gd name="connsiteY31" fmla="*/ 988146 h 1594902"/>
                    <a:gd name="connsiteX32" fmla="*/ 808411 w 1630290"/>
                    <a:gd name="connsiteY32" fmla="*/ 892896 h 1594902"/>
                    <a:gd name="connsiteX33" fmla="*/ 1071936 w 1630290"/>
                    <a:gd name="connsiteY33" fmla="*/ 711921 h 1594902"/>
                    <a:gd name="connsiteX34" fmla="*/ 1081461 w 1630290"/>
                    <a:gd name="connsiteY34" fmla="*/ 505546 h 1594902"/>
                    <a:gd name="connsiteX35" fmla="*/ 922711 w 1630290"/>
                    <a:gd name="connsiteY35" fmla="*/ 369021 h 1594902"/>
                    <a:gd name="connsiteX36" fmla="*/ 757611 w 1630290"/>
                    <a:gd name="connsiteY36" fmla="*/ 448396 h 1594902"/>
                    <a:gd name="connsiteX37" fmla="*/ 497261 w 1630290"/>
                    <a:gd name="connsiteY37" fmla="*/ 572221 h 1594902"/>
                    <a:gd name="connsiteX38" fmla="*/ 411536 w 1630290"/>
                    <a:gd name="connsiteY38" fmla="*/ 572221 h 1594902"/>
                    <a:gd name="connsiteX39" fmla="*/ 405186 w 1630290"/>
                    <a:gd name="connsiteY39" fmla="*/ 549996 h 1594902"/>
                    <a:gd name="connsiteX40" fmla="*/ 443286 w 1630290"/>
                    <a:gd name="connsiteY40" fmla="*/ 508721 h 1594902"/>
                    <a:gd name="connsiteX41" fmla="*/ 605211 w 1630290"/>
                    <a:gd name="connsiteY41" fmla="*/ 410296 h 1594902"/>
                    <a:gd name="connsiteX42" fmla="*/ 706811 w 1630290"/>
                    <a:gd name="connsiteY42" fmla="*/ 146771 h 1594902"/>
                    <a:gd name="connsiteX43" fmla="*/ 592511 w 1630290"/>
                    <a:gd name="connsiteY43" fmla="*/ 3896 h 1594902"/>
                    <a:gd name="connsiteX44" fmla="*/ 278186 w 1630290"/>
                    <a:gd name="connsiteY44" fmla="*/ 51521 h 1594902"/>
                    <a:gd name="connsiteX45" fmla="*/ 21011 w 1630290"/>
                    <a:gd name="connsiteY45" fmla="*/ 168996 h 1594902"/>
                    <a:gd name="connsiteX46" fmla="*/ 33029 w 1630290"/>
                    <a:gd name="connsiteY46" fmla="*/ 242620 h 1594902"/>
                    <a:gd name="connsiteX47" fmla="*/ 24186 w 1630290"/>
                    <a:gd name="connsiteY47" fmla="*/ 315046 h 1594902"/>
                    <a:gd name="connsiteX0" fmla="*/ 24186 w 1630766"/>
                    <a:gd name="connsiteY0" fmla="*/ 315046 h 1614753"/>
                    <a:gd name="connsiteX1" fmla="*/ 195636 w 1630766"/>
                    <a:gd name="connsiteY1" fmla="*/ 184871 h 1614753"/>
                    <a:gd name="connsiteX2" fmla="*/ 567111 w 1630766"/>
                    <a:gd name="connsiteY2" fmla="*/ 86446 h 1614753"/>
                    <a:gd name="connsiteX3" fmla="*/ 589336 w 1630766"/>
                    <a:gd name="connsiteY3" fmla="*/ 283296 h 1614753"/>
                    <a:gd name="connsiteX4" fmla="*/ 328986 w 1630766"/>
                    <a:gd name="connsiteY4" fmla="*/ 502371 h 1614753"/>
                    <a:gd name="connsiteX5" fmla="*/ 271836 w 1630766"/>
                    <a:gd name="connsiteY5" fmla="*/ 661121 h 1614753"/>
                    <a:gd name="connsiteX6" fmla="*/ 475036 w 1630766"/>
                    <a:gd name="connsiteY6" fmla="*/ 692871 h 1614753"/>
                    <a:gd name="connsiteX7" fmla="*/ 792536 w 1630766"/>
                    <a:gd name="connsiteY7" fmla="*/ 502371 h 1614753"/>
                    <a:gd name="connsiteX8" fmla="*/ 967161 w 1630766"/>
                    <a:gd name="connsiteY8" fmla="*/ 476971 h 1614753"/>
                    <a:gd name="connsiteX9" fmla="*/ 986211 w 1630766"/>
                    <a:gd name="connsiteY9" fmla="*/ 651596 h 1614753"/>
                    <a:gd name="connsiteX10" fmla="*/ 783011 w 1630766"/>
                    <a:gd name="connsiteY10" fmla="*/ 842096 h 1614753"/>
                    <a:gd name="connsiteX11" fmla="*/ 668711 w 1630766"/>
                    <a:gd name="connsiteY11" fmla="*/ 969096 h 1614753"/>
                    <a:gd name="connsiteX12" fmla="*/ 719511 w 1630766"/>
                    <a:gd name="connsiteY12" fmla="*/ 1118321 h 1614753"/>
                    <a:gd name="connsiteX13" fmla="*/ 1002086 w 1630766"/>
                    <a:gd name="connsiteY13" fmla="*/ 1007196 h 1614753"/>
                    <a:gd name="connsiteX14" fmla="*/ 1243386 w 1630766"/>
                    <a:gd name="connsiteY14" fmla="*/ 892896 h 1614753"/>
                    <a:gd name="connsiteX15" fmla="*/ 1383086 w 1630766"/>
                    <a:gd name="connsiteY15" fmla="*/ 1061171 h 1614753"/>
                    <a:gd name="connsiteX16" fmla="*/ 948111 w 1630766"/>
                    <a:gd name="connsiteY16" fmla="*/ 1359621 h 1614753"/>
                    <a:gd name="connsiteX17" fmla="*/ 1068761 w 1630766"/>
                    <a:gd name="connsiteY17" fmla="*/ 1527896 h 1614753"/>
                    <a:gd name="connsiteX18" fmla="*/ 1351336 w 1630766"/>
                    <a:gd name="connsiteY18" fmla="*/ 1496146 h 1614753"/>
                    <a:gd name="connsiteX19" fmla="*/ 1572854 w 1630766"/>
                    <a:gd name="connsiteY19" fmla="*/ 1614503 h 1614753"/>
                    <a:gd name="connsiteX20" fmla="*/ 1624386 w 1630766"/>
                    <a:gd name="connsiteY20" fmla="*/ 1524721 h 1614753"/>
                    <a:gd name="connsiteX21" fmla="*/ 1459286 w 1630766"/>
                    <a:gd name="connsiteY21" fmla="*/ 1432646 h 1614753"/>
                    <a:gd name="connsiteX22" fmla="*/ 1281486 w 1630766"/>
                    <a:gd name="connsiteY22" fmla="*/ 1407246 h 1614753"/>
                    <a:gd name="connsiteX23" fmla="*/ 1144961 w 1630766"/>
                    <a:gd name="connsiteY23" fmla="*/ 1423121 h 1614753"/>
                    <a:gd name="connsiteX24" fmla="*/ 1059236 w 1630766"/>
                    <a:gd name="connsiteY24" fmla="*/ 1416771 h 1614753"/>
                    <a:gd name="connsiteX25" fmla="*/ 1059236 w 1630766"/>
                    <a:gd name="connsiteY25" fmla="*/ 1365971 h 1614753"/>
                    <a:gd name="connsiteX26" fmla="*/ 1341811 w 1630766"/>
                    <a:gd name="connsiteY26" fmla="*/ 1238971 h 1614753"/>
                    <a:gd name="connsiteX27" fmla="*/ 1481511 w 1630766"/>
                    <a:gd name="connsiteY27" fmla="*/ 1064346 h 1614753"/>
                    <a:gd name="connsiteX28" fmla="*/ 1443411 w 1630766"/>
                    <a:gd name="connsiteY28" fmla="*/ 889721 h 1614753"/>
                    <a:gd name="connsiteX29" fmla="*/ 1224336 w 1630766"/>
                    <a:gd name="connsiteY29" fmla="*/ 797646 h 1614753"/>
                    <a:gd name="connsiteX30" fmla="*/ 998911 w 1630766"/>
                    <a:gd name="connsiteY30" fmla="*/ 867496 h 1614753"/>
                    <a:gd name="connsiteX31" fmla="*/ 744911 w 1630766"/>
                    <a:gd name="connsiteY31" fmla="*/ 988146 h 1614753"/>
                    <a:gd name="connsiteX32" fmla="*/ 808411 w 1630766"/>
                    <a:gd name="connsiteY32" fmla="*/ 892896 h 1614753"/>
                    <a:gd name="connsiteX33" fmla="*/ 1071936 w 1630766"/>
                    <a:gd name="connsiteY33" fmla="*/ 711921 h 1614753"/>
                    <a:gd name="connsiteX34" fmla="*/ 1081461 w 1630766"/>
                    <a:gd name="connsiteY34" fmla="*/ 505546 h 1614753"/>
                    <a:gd name="connsiteX35" fmla="*/ 922711 w 1630766"/>
                    <a:gd name="connsiteY35" fmla="*/ 369021 h 1614753"/>
                    <a:gd name="connsiteX36" fmla="*/ 757611 w 1630766"/>
                    <a:gd name="connsiteY36" fmla="*/ 448396 h 1614753"/>
                    <a:gd name="connsiteX37" fmla="*/ 497261 w 1630766"/>
                    <a:gd name="connsiteY37" fmla="*/ 572221 h 1614753"/>
                    <a:gd name="connsiteX38" fmla="*/ 411536 w 1630766"/>
                    <a:gd name="connsiteY38" fmla="*/ 572221 h 1614753"/>
                    <a:gd name="connsiteX39" fmla="*/ 405186 w 1630766"/>
                    <a:gd name="connsiteY39" fmla="*/ 549996 h 1614753"/>
                    <a:gd name="connsiteX40" fmla="*/ 443286 w 1630766"/>
                    <a:gd name="connsiteY40" fmla="*/ 508721 h 1614753"/>
                    <a:gd name="connsiteX41" fmla="*/ 605211 w 1630766"/>
                    <a:gd name="connsiteY41" fmla="*/ 410296 h 1614753"/>
                    <a:gd name="connsiteX42" fmla="*/ 706811 w 1630766"/>
                    <a:gd name="connsiteY42" fmla="*/ 146771 h 1614753"/>
                    <a:gd name="connsiteX43" fmla="*/ 592511 w 1630766"/>
                    <a:gd name="connsiteY43" fmla="*/ 3896 h 1614753"/>
                    <a:gd name="connsiteX44" fmla="*/ 278186 w 1630766"/>
                    <a:gd name="connsiteY44" fmla="*/ 51521 h 1614753"/>
                    <a:gd name="connsiteX45" fmla="*/ 21011 w 1630766"/>
                    <a:gd name="connsiteY45" fmla="*/ 168996 h 1614753"/>
                    <a:gd name="connsiteX46" fmla="*/ 33029 w 1630766"/>
                    <a:gd name="connsiteY46" fmla="*/ 242620 h 1614753"/>
                    <a:gd name="connsiteX47" fmla="*/ 24186 w 1630766"/>
                    <a:gd name="connsiteY47" fmla="*/ 315046 h 1614753"/>
                    <a:gd name="connsiteX0" fmla="*/ 24186 w 1664282"/>
                    <a:gd name="connsiteY0" fmla="*/ 315046 h 1615146"/>
                    <a:gd name="connsiteX1" fmla="*/ 195636 w 1664282"/>
                    <a:gd name="connsiteY1" fmla="*/ 184871 h 1615146"/>
                    <a:gd name="connsiteX2" fmla="*/ 567111 w 1664282"/>
                    <a:gd name="connsiteY2" fmla="*/ 86446 h 1615146"/>
                    <a:gd name="connsiteX3" fmla="*/ 589336 w 1664282"/>
                    <a:gd name="connsiteY3" fmla="*/ 283296 h 1615146"/>
                    <a:gd name="connsiteX4" fmla="*/ 328986 w 1664282"/>
                    <a:gd name="connsiteY4" fmla="*/ 502371 h 1615146"/>
                    <a:gd name="connsiteX5" fmla="*/ 271836 w 1664282"/>
                    <a:gd name="connsiteY5" fmla="*/ 661121 h 1615146"/>
                    <a:gd name="connsiteX6" fmla="*/ 475036 w 1664282"/>
                    <a:gd name="connsiteY6" fmla="*/ 692871 h 1615146"/>
                    <a:gd name="connsiteX7" fmla="*/ 792536 w 1664282"/>
                    <a:gd name="connsiteY7" fmla="*/ 502371 h 1615146"/>
                    <a:gd name="connsiteX8" fmla="*/ 967161 w 1664282"/>
                    <a:gd name="connsiteY8" fmla="*/ 476971 h 1615146"/>
                    <a:gd name="connsiteX9" fmla="*/ 986211 w 1664282"/>
                    <a:gd name="connsiteY9" fmla="*/ 651596 h 1615146"/>
                    <a:gd name="connsiteX10" fmla="*/ 783011 w 1664282"/>
                    <a:gd name="connsiteY10" fmla="*/ 842096 h 1615146"/>
                    <a:gd name="connsiteX11" fmla="*/ 668711 w 1664282"/>
                    <a:gd name="connsiteY11" fmla="*/ 969096 h 1615146"/>
                    <a:gd name="connsiteX12" fmla="*/ 719511 w 1664282"/>
                    <a:gd name="connsiteY12" fmla="*/ 1118321 h 1615146"/>
                    <a:gd name="connsiteX13" fmla="*/ 1002086 w 1664282"/>
                    <a:gd name="connsiteY13" fmla="*/ 1007196 h 1615146"/>
                    <a:gd name="connsiteX14" fmla="*/ 1243386 w 1664282"/>
                    <a:gd name="connsiteY14" fmla="*/ 892896 h 1615146"/>
                    <a:gd name="connsiteX15" fmla="*/ 1383086 w 1664282"/>
                    <a:gd name="connsiteY15" fmla="*/ 1061171 h 1615146"/>
                    <a:gd name="connsiteX16" fmla="*/ 948111 w 1664282"/>
                    <a:gd name="connsiteY16" fmla="*/ 1359621 h 1615146"/>
                    <a:gd name="connsiteX17" fmla="*/ 1068761 w 1664282"/>
                    <a:gd name="connsiteY17" fmla="*/ 1527896 h 1615146"/>
                    <a:gd name="connsiteX18" fmla="*/ 1351336 w 1664282"/>
                    <a:gd name="connsiteY18" fmla="*/ 1496146 h 1615146"/>
                    <a:gd name="connsiteX19" fmla="*/ 1572854 w 1664282"/>
                    <a:gd name="connsiteY19" fmla="*/ 1614503 h 1615146"/>
                    <a:gd name="connsiteX20" fmla="*/ 1660468 w 1664282"/>
                    <a:gd name="connsiteY20" fmla="*/ 1538507 h 1615146"/>
                    <a:gd name="connsiteX21" fmla="*/ 1459286 w 1664282"/>
                    <a:gd name="connsiteY21" fmla="*/ 1432646 h 1615146"/>
                    <a:gd name="connsiteX22" fmla="*/ 1281486 w 1664282"/>
                    <a:gd name="connsiteY22" fmla="*/ 1407246 h 1615146"/>
                    <a:gd name="connsiteX23" fmla="*/ 1144961 w 1664282"/>
                    <a:gd name="connsiteY23" fmla="*/ 1423121 h 1615146"/>
                    <a:gd name="connsiteX24" fmla="*/ 1059236 w 1664282"/>
                    <a:gd name="connsiteY24" fmla="*/ 1416771 h 1615146"/>
                    <a:gd name="connsiteX25" fmla="*/ 1059236 w 1664282"/>
                    <a:gd name="connsiteY25" fmla="*/ 1365971 h 1615146"/>
                    <a:gd name="connsiteX26" fmla="*/ 1341811 w 1664282"/>
                    <a:gd name="connsiteY26" fmla="*/ 1238971 h 1615146"/>
                    <a:gd name="connsiteX27" fmla="*/ 1481511 w 1664282"/>
                    <a:gd name="connsiteY27" fmla="*/ 1064346 h 1615146"/>
                    <a:gd name="connsiteX28" fmla="*/ 1443411 w 1664282"/>
                    <a:gd name="connsiteY28" fmla="*/ 889721 h 1615146"/>
                    <a:gd name="connsiteX29" fmla="*/ 1224336 w 1664282"/>
                    <a:gd name="connsiteY29" fmla="*/ 797646 h 1615146"/>
                    <a:gd name="connsiteX30" fmla="*/ 998911 w 1664282"/>
                    <a:gd name="connsiteY30" fmla="*/ 867496 h 1615146"/>
                    <a:gd name="connsiteX31" fmla="*/ 744911 w 1664282"/>
                    <a:gd name="connsiteY31" fmla="*/ 988146 h 1615146"/>
                    <a:gd name="connsiteX32" fmla="*/ 808411 w 1664282"/>
                    <a:gd name="connsiteY32" fmla="*/ 892896 h 1615146"/>
                    <a:gd name="connsiteX33" fmla="*/ 1071936 w 1664282"/>
                    <a:gd name="connsiteY33" fmla="*/ 711921 h 1615146"/>
                    <a:gd name="connsiteX34" fmla="*/ 1081461 w 1664282"/>
                    <a:gd name="connsiteY34" fmla="*/ 505546 h 1615146"/>
                    <a:gd name="connsiteX35" fmla="*/ 922711 w 1664282"/>
                    <a:gd name="connsiteY35" fmla="*/ 369021 h 1615146"/>
                    <a:gd name="connsiteX36" fmla="*/ 757611 w 1664282"/>
                    <a:gd name="connsiteY36" fmla="*/ 448396 h 1615146"/>
                    <a:gd name="connsiteX37" fmla="*/ 497261 w 1664282"/>
                    <a:gd name="connsiteY37" fmla="*/ 572221 h 1615146"/>
                    <a:gd name="connsiteX38" fmla="*/ 411536 w 1664282"/>
                    <a:gd name="connsiteY38" fmla="*/ 572221 h 1615146"/>
                    <a:gd name="connsiteX39" fmla="*/ 405186 w 1664282"/>
                    <a:gd name="connsiteY39" fmla="*/ 549996 h 1615146"/>
                    <a:gd name="connsiteX40" fmla="*/ 443286 w 1664282"/>
                    <a:gd name="connsiteY40" fmla="*/ 508721 h 1615146"/>
                    <a:gd name="connsiteX41" fmla="*/ 605211 w 1664282"/>
                    <a:gd name="connsiteY41" fmla="*/ 410296 h 1615146"/>
                    <a:gd name="connsiteX42" fmla="*/ 706811 w 1664282"/>
                    <a:gd name="connsiteY42" fmla="*/ 146771 h 1615146"/>
                    <a:gd name="connsiteX43" fmla="*/ 592511 w 1664282"/>
                    <a:gd name="connsiteY43" fmla="*/ 3896 h 1615146"/>
                    <a:gd name="connsiteX44" fmla="*/ 278186 w 1664282"/>
                    <a:gd name="connsiteY44" fmla="*/ 51521 h 1615146"/>
                    <a:gd name="connsiteX45" fmla="*/ 21011 w 1664282"/>
                    <a:gd name="connsiteY45" fmla="*/ 168996 h 1615146"/>
                    <a:gd name="connsiteX46" fmla="*/ 33029 w 1664282"/>
                    <a:gd name="connsiteY46" fmla="*/ 242620 h 1615146"/>
                    <a:gd name="connsiteX47" fmla="*/ 24186 w 1664282"/>
                    <a:gd name="connsiteY47" fmla="*/ 315046 h 1615146"/>
                    <a:gd name="connsiteX0" fmla="*/ 24186 w 1727211"/>
                    <a:gd name="connsiteY0" fmla="*/ 315046 h 1615007"/>
                    <a:gd name="connsiteX1" fmla="*/ 195636 w 1727211"/>
                    <a:gd name="connsiteY1" fmla="*/ 184871 h 1615007"/>
                    <a:gd name="connsiteX2" fmla="*/ 567111 w 1727211"/>
                    <a:gd name="connsiteY2" fmla="*/ 86446 h 1615007"/>
                    <a:gd name="connsiteX3" fmla="*/ 589336 w 1727211"/>
                    <a:gd name="connsiteY3" fmla="*/ 283296 h 1615007"/>
                    <a:gd name="connsiteX4" fmla="*/ 328986 w 1727211"/>
                    <a:gd name="connsiteY4" fmla="*/ 502371 h 1615007"/>
                    <a:gd name="connsiteX5" fmla="*/ 271836 w 1727211"/>
                    <a:gd name="connsiteY5" fmla="*/ 661121 h 1615007"/>
                    <a:gd name="connsiteX6" fmla="*/ 475036 w 1727211"/>
                    <a:gd name="connsiteY6" fmla="*/ 692871 h 1615007"/>
                    <a:gd name="connsiteX7" fmla="*/ 792536 w 1727211"/>
                    <a:gd name="connsiteY7" fmla="*/ 502371 h 1615007"/>
                    <a:gd name="connsiteX8" fmla="*/ 967161 w 1727211"/>
                    <a:gd name="connsiteY8" fmla="*/ 476971 h 1615007"/>
                    <a:gd name="connsiteX9" fmla="*/ 986211 w 1727211"/>
                    <a:gd name="connsiteY9" fmla="*/ 651596 h 1615007"/>
                    <a:gd name="connsiteX10" fmla="*/ 783011 w 1727211"/>
                    <a:gd name="connsiteY10" fmla="*/ 842096 h 1615007"/>
                    <a:gd name="connsiteX11" fmla="*/ 668711 w 1727211"/>
                    <a:gd name="connsiteY11" fmla="*/ 969096 h 1615007"/>
                    <a:gd name="connsiteX12" fmla="*/ 719511 w 1727211"/>
                    <a:gd name="connsiteY12" fmla="*/ 1118321 h 1615007"/>
                    <a:gd name="connsiteX13" fmla="*/ 1002086 w 1727211"/>
                    <a:gd name="connsiteY13" fmla="*/ 1007196 h 1615007"/>
                    <a:gd name="connsiteX14" fmla="*/ 1243386 w 1727211"/>
                    <a:gd name="connsiteY14" fmla="*/ 892896 h 1615007"/>
                    <a:gd name="connsiteX15" fmla="*/ 1383086 w 1727211"/>
                    <a:gd name="connsiteY15" fmla="*/ 1061171 h 1615007"/>
                    <a:gd name="connsiteX16" fmla="*/ 948111 w 1727211"/>
                    <a:gd name="connsiteY16" fmla="*/ 1359621 h 1615007"/>
                    <a:gd name="connsiteX17" fmla="*/ 1068761 w 1727211"/>
                    <a:gd name="connsiteY17" fmla="*/ 1527896 h 1615007"/>
                    <a:gd name="connsiteX18" fmla="*/ 1351336 w 1727211"/>
                    <a:gd name="connsiteY18" fmla="*/ 1496146 h 1615007"/>
                    <a:gd name="connsiteX19" fmla="*/ 1572854 w 1727211"/>
                    <a:gd name="connsiteY19" fmla="*/ 1614503 h 1615007"/>
                    <a:gd name="connsiteX20" fmla="*/ 1660468 w 1727211"/>
                    <a:gd name="connsiteY20" fmla="*/ 1538507 h 1615007"/>
                    <a:gd name="connsiteX21" fmla="*/ 1704290 w 1727211"/>
                    <a:gd name="connsiteY21" fmla="*/ 1530983 h 1615007"/>
                    <a:gd name="connsiteX22" fmla="*/ 1281486 w 1727211"/>
                    <a:gd name="connsiteY22" fmla="*/ 1407246 h 1615007"/>
                    <a:gd name="connsiteX23" fmla="*/ 1144961 w 1727211"/>
                    <a:gd name="connsiteY23" fmla="*/ 1423121 h 1615007"/>
                    <a:gd name="connsiteX24" fmla="*/ 1059236 w 1727211"/>
                    <a:gd name="connsiteY24" fmla="*/ 1416771 h 1615007"/>
                    <a:gd name="connsiteX25" fmla="*/ 1059236 w 1727211"/>
                    <a:gd name="connsiteY25" fmla="*/ 1365971 h 1615007"/>
                    <a:gd name="connsiteX26" fmla="*/ 1341811 w 1727211"/>
                    <a:gd name="connsiteY26" fmla="*/ 1238971 h 1615007"/>
                    <a:gd name="connsiteX27" fmla="*/ 1481511 w 1727211"/>
                    <a:gd name="connsiteY27" fmla="*/ 1064346 h 1615007"/>
                    <a:gd name="connsiteX28" fmla="*/ 1443411 w 1727211"/>
                    <a:gd name="connsiteY28" fmla="*/ 889721 h 1615007"/>
                    <a:gd name="connsiteX29" fmla="*/ 1224336 w 1727211"/>
                    <a:gd name="connsiteY29" fmla="*/ 797646 h 1615007"/>
                    <a:gd name="connsiteX30" fmla="*/ 998911 w 1727211"/>
                    <a:gd name="connsiteY30" fmla="*/ 867496 h 1615007"/>
                    <a:gd name="connsiteX31" fmla="*/ 744911 w 1727211"/>
                    <a:gd name="connsiteY31" fmla="*/ 988146 h 1615007"/>
                    <a:gd name="connsiteX32" fmla="*/ 808411 w 1727211"/>
                    <a:gd name="connsiteY32" fmla="*/ 892896 h 1615007"/>
                    <a:gd name="connsiteX33" fmla="*/ 1071936 w 1727211"/>
                    <a:gd name="connsiteY33" fmla="*/ 711921 h 1615007"/>
                    <a:gd name="connsiteX34" fmla="*/ 1081461 w 1727211"/>
                    <a:gd name="connsiteY34" fmla="*/ 505546 h 1615007"/>
                    <a:gd name="connsiteX35" fmla="*/ 922711 w 1727211"/>
                    <a:gd name="connsiteY35" fmla="*/ 369021 h 1615007"/>
                    <a:gd name="connsiteX36" fmla="*/ 757611 w 1727211"/>
                    <a:gd name="connsiteY36" fmla="*/ 448396 h 1615007"/>
                    <a:gd name="connsiteX37" fmla="*/ 497261 w 1727211"/>
                    <a:gd name="connsiteY37" fmla="*/ 572221 h 1615007"/>
                    <a:gd name="connsiteX38" fmla="*/ 411536 w 1727211"/>
                    <a:gd name="connsiteY38" fmla="*/ 572221 h 1615007"/>
                    <a:gd name="connsiteX39" fmla="*/ 405186 w 1727211"/>
                    <a:gd name="connsiteY39" fmla="*/ 549996 h 1615007"/>
                    <a:gd name="connsiteX40" fmla="*/ 443286 w 1727211"/>
                    <a:gd name="connsiteY40" fmla="*/ 508721 h 1615007"/>
                    <a:gd name="connsiteX41" fmla="*/ 605211 w 1727211"/>
                    <a:gd name="connsiteY41" fmla="*/ 410296 h 1615007"/>
                    <a:gd name="connsiteX42" fmla="*/ 706811 w 1727211"/>
                    <a:gd name="connsiteY42" fmla="*/ 146771 h 1615007"/>
                    <a:gd name="connsiteX43" fmla="*/ 592511 w 1727211"/>
                    <a:gd name="connsiteY43" fmla="*/ 3896 h 1615007"/>
                    <a:gd name="connsiteX44" fmla="*/ 278186 w 1727211"/>
                    <a:gd name="connsiteY44" fmla="*/ 51521 h 1615007"/>
                    <a:gd name="connsiteX45" fmla="*/ 21011 w 1727211"/>
                    <a:gd name="connsiteY45" fmla="*/ 168996 h 1615007"/>
                    <a:gd name="connsiteX46" fmla="*/ 33029 w 1727211"/>
                    <a:gd name="connsiteY46" fmla="*/ 242620 h 1615007"/>
                    <a:gd name="connsiteX47" fmla="*/ 24186 w 1727211"/>
                    <a:gd name="connsiteY47" fmla="*/ 315046 h 1615007"/>
                    <a:gd name="connsiteX0" fmla="*/ 24186 w 1710954"/>
                    <a:gd name="connsiteY0" fmla="*/ 315046 h 1615007"/>
                    <a:gd name="connsiteX1" fmla="*/ 195636 w 1710954"/>
                    <a:gd name="connsiteY1" fmla="*/ 184871 h 1615007"/>
                    <a:gd name="connsiteX2" fmla="*/ 567111 w 1710954"/>
                    <a:gd name="connsiteY2" fmla="*/ 86446 h 1615007"/>
                    <a:gd name="connsiteX3" fmla="*/ 589336 w 1710954"/>
                    <a:gd name="connsiteY3" fmla="*/ 283296 h 1615007"/>
                    <a:gd name="connsiteX4" fmla="*/ 328986 w 1710954"/>
                    <a:gd name="connsiteY4" fmla="*/ 502371 h 1615007"/>
                    <a:gd name="connsiteX5" fmla="*/ 271836 w 1710954"/>
                    <a:gd name="connsiteY5" fmla="*/ 661121 h 1615007"/>
                    <a:gd name="connsiteX6" fmla="*/ 475036 w 1710954"/>
                    <a:gd name="connsiteY6" fmla="*/ 692871 h 1615007"/>
                    <a:gd name="connsiteX7" fmla="*/ 792536 w 1710954"/>
                    <a:gd name="connsiteY7" fmla="*/ 502371 h 1615007"/>
                    <a:gd name="connsiteX8" fmla="*/ 967161 w 1710954"/>
                    <a:gd name="connsiteY8" fmla="*/ 476971 h 1615007"/>
                    <a:gd name="connsiteX9" fmla="*/ 986211 w 1710954"/>
                    <a:gd name="connsiteY9" fmla="*/ 651596 h 1615007"/>
                    <a:gd name="connsiteX10" fmla="*/ 783011 w 1710954"/>
                    <a:gd name="connsiteY10" fmla="*/ 842096 h 1615007"/>
                    <a:gd name="connsiteX11" fmla="*/ 668711 w 1710954"/>
                    <a:gd name="connsiteY11" fmla="*/ 969096 h 1615007"/>
                    <a:gd name="connsiteX12" fmla="*/ 719511 w 1710954"/>
                    <a:gd name="connsiteY12" fmla="*/ 1118321 h 1615007"/>
                    <a:gd name="connsiteX13" fmla="*/ 1002086 w 1710954"/>
                    <a:gd name="connsiteY13" fmla="*/ 1007196 h 1615007"/>
                    <a:gd name="connsiteX14" fmla="*/ 1243386 w 1710954"/>
                    <a:gd name="connsiteY14" fmla="*/ 892896 h 1615007"/>
                    <a:gd name="connsiteX15" fmla="*/ 1383086 w 1710954"/>
                    <a:gd name="connsiteY15" fmla="*/ 1061171 h 1615007"/>
                    <a:gd name="connsiteX16" fmla="*/ 948111 w 1710954"/>
                    <a:gd name="connsiteY16" fmla="*/ 1359621 h 1615007"/>
                    <a:gd name="connsiteX17" fmla="*/ 1068761 w 1710954"/>
                    <a:gd name="connsiteY17" fmla="*/ 1527896 h 1615007"/>
                    <a:gd name="connsiteX18" fmla="*/ 1351336 w 1710954"/>
                    <a:gd name="connsiteY18" fmla="*/ 1496146 h 1615007"/>
                    <a:gd name="connsiteX19" fmla="*/ 1572854 w 1710954"/>
                    <a:gd name="connsiteY19" fmla="*/ 1614503 h 1615007"/>
                    <a:gd name="connsiteX20" fmla="*/ 1660468 w 1710954"/>
                    <a:gd name="connsiteY20" fmla="*/ 1538507 h 1615007"/>
                    <a:gd name="connsiteX21" fmla="*/ 1704290 w 1710954"/>
                    <a:gd name="connsiteY21" fmla="*/ 1530983 h 1615007"/>
                    <a:gd name="connsiteX22" fmla="*/ 1518001 w 1710954"/>
                    <a:gd name="connsiteY22" fmla="*/ 1441858 h 1615007"/>
                    <a:gd name="connsiteX23" fmla="*/ 1144961 w 1710954"/>
                    <a:gd name="connsiteY23" fmla="*/ 1423121 h 1615007"/>
                    <a:gd name="connsiteX24" fmla="*/ 1059236 w 1710954"/>
                    <a:gd name="connsiteY24" fmla="*/ 1416771 h 1615007"/>
                    <a:gd name="connsiteX25" fmla="*/ 1059236 w 1710954"/>
                    <a:gd name="connsiteY25" fmla="*/ 1365971 h 1615007"/>
                    <a:gd name="connsiteX26" fmla="*/ 1341811 w 1710954"/>
                    <a:gd name="connsiteY26" fmla="*/ 1238971 h 1615007"/>
                    <a:gd name="connsiteX27" fmla="*/ 1481511 w 1710954"/>
                    <a:gd name="connsiteY27" fmla="*/ 1064346 h 1615007"/>
                    <a:gd name="connsiteX28" fmla="*/ 1443411 w 1710954"/>
                    <a:gd name="connsiteY28" fmla="*/ 889721 h 1615007"/>
                    <a:gd name="connsiteX29" fmla="*/ 1224336 w 1710954"/>
                    <a:gd name="connsiteY29" fmla="*/ 797646 h 1615007"/>
                    <a:gd name="connsiteX30" fmla="*/ 998911 w 1710954"/>
                    <a:gd name="connsiteY30" fmla="*/ 867496 h 1615007"/>
                    <a:gd name="connsiteX31" fmla="*/ 744911 w 1710954"/>
                    <a:gd name="connsiteY31" fmla="*/ 988146 h 1615007"/>
                    <a:gd name="connsiteX32" fmla="*/ 808411 w 1710954"/>
                    <a:gd name="connsiteY32" fmla="*/ 892896 h 1615007"/>
                    <a:gd name="connsiteX33" fmla="*/ 1071936 w 1710954"/>
                    <a:gd name="connsiteY33" fmla="*/ 711921 h 1615007"/>
                    <a:gd name="connsiteX34" fmla="*/ 1081461 w 1710954"/>
                    <a:gd name="connsiteY34" fmla="*/ 505546 h 1615007"/>
                    <a:gd name="connsiteX35" fmla="*/ 922711 w 1710954"/>
                    <a:gd name="connsiteY35" fmla="*/ 369021 h 1615007"/>
                    <a:gd name="connsiteX36" fmla="*/ 757611 w 1710954"/>
                    <a:gd name="connsiteY36" fmla="*/ 448396 h 1615007"/>
                    <a:gd name="connsiteX37" fmla="*/ 497261 w 1710954"/>
                    <a:gd name="connsiteY37" fmla="*/ 572221 h 1615007"/>
                    <a:gd name="connsiteX38" fmla="*/ 411536 w 1710954"/>
                    <a:gd name="connsiteY38" fmla="*/ 572221 h 1615007"/>
                    <a:gd name="connsiteX39" fmla="*/ 405186 w 1710954"/>
                    <a:gd name="connsiteY39" fmla="*/ 549996 h 1615007"/>
                    <a:gd name="connsiteX40" fmla="*/ 443286 w 1710954"/>
                    <a:gd name="connsiteY40" fmla="*/ 508721 h 1615007"/>
                    <a:gd name="connsiteX41" fmla="*/ 605211 w 1710954"/>
                    <a:gd name="connsiteY41" fmla="*/ 410296 h 1615007"/>
                    <a:gd name="connsiteX42" fmla="*/ 706811 w 1710954"/>
                    <a:gd name="connsiteY42" fmla="*/ 146771 h 1615007"/>
                    <a:gd name="connsiteX43" fmla="*/ 592511 w 1710954"/>
                    <a:gd name="connsiteY43" fmla="*/ 3896 h 1615007"/>
                    <a:gd name="connsiteX44" fmla="*/ 278186 w 1710954"/>
                    <a:gd name="connsiteY44" fmla="*/ 51521 h 1615007"/>
                    <a:gd name="connsiteX45" fmla="*/ 21011 w 1710954"/>
                    <a:gd name="connsiteY45" fmla="*/ 168996 h 1615007"/>
                    <a:gd name="connsiteX46" fmla="*/ 33029 w 1710954"/>
                    <a:gd name="connsiteY46" fmla="*/ 242620 h 1615007"/>
                    <a:gd name="connsiteX47" fmla="*/ 24186 w 1710954"/>
                    <a:gd name="connsiteY47" fmla="*/ 315046 h 1615007"/>
                    <a:gd name="connsiteX0" fmla="*/ 24186 w 1715871"/>
                    <a:gd name="connsiteY0" fmla="*/ 315046 h 1615007"/>
                    <a:gd name="connsiteX1" fmla="*/ 195636 w 1715871"/>
                    <a:gd name="connsiteY1" fmla="*/ 184871 h 1615007"/>
                    <a:gd name="connsiteX2" fmla="*/ 567111 w 1715871"/>
                    <a:gd name="connsiteY2" fmla="*/ 86446 h 1615007"/>
                    <a:gd name="connsiteX3" fmla="*/ 589336 w 1715871"/>
                    <a:gd name="connsiteY3" fmla="*/ 283296 h 1615007"/>
                    <a:gd name="connsiteX4" fmla="*/ 328986 w 1715871"/>
                    <a:gd name="connsiteY4" fmla="*/ 502371 h 1615007"/>
                    <a:gd name="connsiteX5" fmla="*/ 271836 w 1715871"/>
                    <a:gd name="connsiteY5" fmla="*/ 661121 h 1615007"/>
                    <a:gd name="connsiteX6" fmla="*/ 475036 w 1715871"/>
                    <a:gd name="connsiteY6" fmla="*/ 692871 h 1615007"/>
                    <a:gd name="connsiteX7" fmla="*/ 792536 w 1715871"/>
                    <a:gd name="connsiteY7" fmla="*/ 502371 h 1615007"/>
                    <a:gd name="connsiteX8" fmla="*/ 967161 w 1715871"/>
                    <a:gd name="connsiteY8" fmla="*/ 476971 h 1615007"/>
                    <a:gd name="connsiteX9" fmla="*/ 986211 w 1715871"/>
                    <a:gd name="connsiteY9" fmla="*/ 651596 h 1615007"/>
                    <a:gd name="connsiteX10" fmla="*/ 783011 w 1715871"/>
                    <a:gd name="connsiteY10" fmla="*/ 842096 h 1615007"/>
                    <a:gd name="connsiteX11" fmla="*/ 668711 w 1715871"/>
                    <a:gd name="connsiteY11" fmla="*/ 969096 h 1615007"/>
                    <a:gd name="connsiteX12" fmla="*/ 719511 w 1715871"/>
                    <a:gd name="connsiteY12" fmla="*/ 1118321 h 1615007"/>
                    <a:gd name="connsiteX13" fmla="*/ 1002086 w 1715871"/>
                    <a:gd name="connsiteY13" fmla="*/ 1007196 h 1615007"/>
                    <a:gd name="connsiteX14" fmla="*/ 1243386 w 1715871"/>
                    <a:gd name="connsiteY14" fmla="*/ 892896 h 1615007"/>
                    <a:gd name="connsiteX15" fmla="*/ 1383086 w 1715871"/>
                    <a:gd name="connsiteY15" fmla="*/ 1061171 h 1615007"/>
                    <a:gd name="connsiteX16" fmla="*/ 948111 w 1715871"/>
                    <a:gd name="connsiteY16" fmla="*/ 1359621 h 1615007"/>
                    <a:gd name="connsiteX17" fmla="*/ 1068761 w 1715871"/>
                    <a:gd name="connsiteY17" fmla="*/ 1527896 h 1615007"/>
                    <a:gd name="connsiteX18" fmla="*/ 1351336 w 1715871"/>
                    <a:gd name="connsiteY18" fmla="*/ 1496146 h 1615007"/>
                    <a:gd name="connsiteX19" fmla="*/ 1572854 w 1715871"/>
                    <a:gd name="connsiteY19" fmla="*/ 1614503 h 1615007"/>
                    <a:gd name="connsiteX20" fmla="*/ 1660468 w 1715871"/>
                    <a:gd name="connsiteY20" fmla="*/ 1538507 h 1615007"/>
                    <a:gd name="connsiteX21" fmla="*/ 1704290 w 1715871"/>
                    <a:gd name="connsiteY21" fmla="*/ 1530983 h 1615007"/>
                    <a:gd name="connsiteX22" fmla="*/ 1443534 w 1715871"/>
                    <a:gd name="connsiteY22" fmla="*/ 1413656 h 1615007"/>
                    <a:gd name="connsiteX23" fmla="*/ 1144961 w 1715871"/>
                    <a:gd name="connsiteY23" fmla="*/ 1423121 h 1615007"/>
                    <a:gd name="connsiteX24" fmla="*/ 1059236 w 1715871"/>
                    <a:gd name="connsiteY24" fmla="*/ 1416771 h 1615007"/>
                    <a:gd name="connsiteX25" fmla="*/ 1059236 w 1715871"/>
                    <a:gd name="connsiteY25" fmla="*/ 1365971 h 1615007"/>
                    <a:gd name="connsiteX26" fmla="*/ 1341811 w 1715871"/>
                    <a:gd name="connsiteY26" fmla="*/ 1238971 h 1615007"/>
                    <a:gd name="connsiteX27" fmla="*/ 1481511 w 1715871"/>
                    <a:gd name="connsiteY27" fmla="*/ 1064346 h 1615007"/>
                    <a:gd name="connsiteX28" fmla="*/ 1443411 w 1715871"/>
                    <a:gd name="connsiteY28" fmla="*/ 889721 h 1615007"/>
                    <a:gd name="connsiteX29" fmla="*/ 1224336 w 1715871"/>
                    <a:gd name="connsiteY29" fmla="*/ 797646 h 1615007"/>
                    <a:gd name="connsiteX30" fmla="*/ 998911 w 1715871"/>
                    <a:gd name="connsiteY30" fmla="*/ 867496 h 1615007"/>
                    <a:gd name="connsiteX31" fmla="*/ 744911 w 1715871"/>
                    <a:gd name="connsiteY31" fmla="*/ 988146 h 1615007"/>
                    <a:gd name="connsiteX32" fmla="*/ 808411 w 1715871"/>
                    <a:gd name="connsiteY32" fmla="*/ 892896 h 1615007"/>
                    <a:gd name="connsiteX33" fmla="*/ 1071936 w 1715871"/>
                    <a:gd name="connsiteY33" fmla="*/ 711921 h 1615007"/>
                    <a:gd name="connsiteX34" fmla="*/ 1081461 w 1715871"/>
                    <a:gd name="connsiteY34" fmla="*/ 505546 h 1615007"/>
                    <a:gd name="connsiteX35" fmla="*/ 922711 w 1715871"/>
                    <a:gd name="connsiteY35" fmla="*/ 369021 h 1615007"/>
                    <a:gd name="connsiteX36" fmla="*/ 757611 w 1715871"/>
                    <a:gd name="connsiteY36" fmla="*/ 448396 h 1615007"/>
                    <a:gd name="connsiteX37" fmla="*/ 497261 w 1715871"/>
                    <a:gd name="connsiteY37" fmla="*/ 572221 h 1615007"/>
                    <a:gd name="connsiteX38" fmla="*/ 411536 w 1715871"/>
                    <a:gd name="connsiteY38" fmla="*/ 572221 h 1615007"/>
                    <a:gd name="connsiteX39" fmla="*/ 405186 w 1715871"/>
                    <a:gd name="connsiteY39" fmla="*/ 549996 h 1615007"/>
                    <a:gd name="connsiteX40" fmla="*/ 443286 w 1715871"/>
                    <a:gd name="connsiteY40" fmla="*/ 508721 h 1615007"/>
                    <a:gd name="connsiteX41" fmla="*/ 605211 w 1715871"/>
                    <a:gd name="connsiteY41" fmla="*/ 410296 h 1615007"/>
                    <a:gd name="connsiteX42" fmla="*/ 706811 w 1715871"/>
                    <a:gd name="connsiteY42" fmla="*/ 146771 h 1615007"/>
                    <a:gd name="connsiteX43" fmla="*/ 592511 w 1715871"/>
                    <a:gd name="connsiteY43" fmla="*/ 3896 h 1615007"/>
                    <a:gd name="connsiteX44" fmla="*/ 278186 w 1715871"/>
                    <a:gd name="connsiteY44" fmla="*/ 51521 h 1615007"/>
                    <a:gd name="connsiteX45" fmla="*/ 21011 w 1715871"/>
                    <a:gd name="connsiteY45" fmla="*/ 168996 h 1615007"/>
                    <a:gd name="connsiteX46" fmla="*/ 33029 w 1715871"/>
                    <a:gd name="connsiteY46" fmla="*/ 242620 h 1615007"/>
                    <a:gd name="connsiteX47" fmla="*/ 24186 w 1715871"/>
                    <a:gd name="connsiteY47" fmla="*/ 315046 h 1615007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89336 w 1711507"/>
                    <a:gd name="connsiteY3" fmla="*/ 283296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92536 w 1711507"/>
                    <a:gd name="connsiteY7" fmla="*/ 502371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57611 w 1711507"/>
                    <a:gd name="connsiteY36" fmla="*/ 448396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605211 w 1711507"/>
                    <a:gd name="connsiteY41" fmla="*/ 410296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89336 w 1711507"/>
                    <a:gd name="connsiteY3" fmla="*/ 283296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57611 w 1711507"/>
                    <a:gd name="connsiteY36" fmla="*/ 448396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605211 w 1711507"/>
                    <a:gd name="connsiteY41" fmla="*/ 410296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89336 w 1711507"/>
                    <a:gd name="connsiteY3" fmla="*/ 283296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605211 w 1711507"/>
                    <a:gd name="connsiteY41" fmla="*/ 410296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89336 w 1711507"/>
                    <a:gd name="connsiteY3" fmla="*/ 283296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601876 w 1711507"/>
                    <a:gd name="connsiteY41" fmla="*/ 387645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601876 w 1711507"/>
                    <a:gd name="connsiteY41" fmla="*/ 387645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83011 w 1711507"/>
                    <a:gd name="connsiteY10" fmla="*/ 84209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744911 w 1711507"/>
                    <a:gd name="connsiteY31" fmla="*/ 988146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19511 w 1711507"/>
                    <a:gd name="connsiteY12" fmla="*/ 1118321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02086 w 1711507"/>
                    <a:gd name="connsiteY13" fmla="*/ 1007196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059236 w 1711507"/>
                    <a:gd name="connsiteY25" fmla="*/ 136597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144961 w 1711507"/>
                    <a:gd name="connsiteY23" fmla="*/ 1423121 h 1617994"/>
                    <a:gd name="connsiteX24" fmla="*/ 1059236 w 1711507"/>
                    <a:gd name="connsiteY24" fmla="*/ 1416771 h 1617994"/>
                    <a:gd name="connsiteX25" fmla="*/ 1145304 w 1711507"/>
                    <a:gd name="connsiteY25" fmla="*/ 133995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274973 w 1711507"/>
                    <a:gd name="connsiteY23" fmla="*/ 1393303 h 1617994"/>
                    <a:gd name="connsiteX24" fmla="*/ 1059236 w 1711507"/>
                    <a:gd name="connsiteY24" fmla="*/ 1416771 h 1617994"/>
                    <a:gd name="connsiteX25" fmla="*/ 1145304 w 1711507"/>
                    <a:gd name="connsiteY25" fmla="*/ 133995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67161 w 1711507"/>
                    <a:gd name="connsiteY8" fmla="*/ 476971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274973 w 1711507"/>
                    <a:gd name="connsiteY23" fmla="*/ 1393303 h 1617994"/>
                    <a:gd name="connsiteX24" fmla="*/ 1108612 w 1711507"/>
                    <a:gd name="connsiteY24" fmla="*/ 1401492 h 1617994"/>
                    <a:gd name="connsiteX25" fmla="*/ 1145304 w 1711507"/>
                    <a:gd name="connsiteY25" fmla="*/ 133995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49155 w 1711507"/>
                    <a:gd name="connsiteY3" fmla="*/ 264288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53275 w 1711507"/>
                    <a:gd name="connsiteY8" fmla="*/ 491476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274973 w 1711507"/>
                    <a:gd name="connsiteY23" fmla="*/ 1393303 h 1617994"/>
                    <a:gd name="connsiteX24" fmla="*/ 1108612 w 1711507"/>
                    <a:gd name="connsiteY24" fmla="*/ 1401492 h 1617994"/>
                    <a:gd name="connsiteX25" fmla="*/ 1145304 w 1711507"/>
                    <a:gd name="connsiteY25" fmla="*/ 133995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24186 w 1711507"/>
                    <a:gd name="connsiteY0" fmla="*/ 315046 h 1617994"/>
                    <a:gd name="connsiteX1" fmla="*/ 195636 w 1711507"/>
                    <a:gd name="connsiteY1" fmla="*/ 184871 h 1617994"/>
                    <a:gd name="connsiteX2" fmla="*/ 567111 w 1711507"/>
                    <a:gd name="connsiteY2" fmla="*/ 86446 h 1617994"/>
                    <a:gd name="connsiteX3" fmla="*/ 536007 w 1711507"/>
                    <a:gd name="connsiteY3" fmla="*/ 247531 h 1617994"/>
                    <a:gd name="connsiteX4" fmla="*/ 328986 w 1711507"/>
                    <a:gd name="connsiteY4" fmla="*/ 502371 h 1617994"/>
                    <a:gd name="connsiteX5" fmla="*/ 271836 w 1711507"/>
                    <a:gd name="connsiteY5" fmla="*/ 661121 h 1617994"/>
                    <a:gd name="connsiteX6" fmla="*/ 475036 w 1711507"/>
                    <a:gd name="connsiteY6" fmla="*/ 692871 h 1617994"/>
                    <a:gd name="connsiteX7" fmla="*/ 748007 w 1711507"/>
                    <a:gd name="connsiteY7" fmla="*/ 544528 h 1617994"/>
                    <a:gd name="connsiteX8" fmla="*/ 953275 w 1711507"/>
                    <a:gd name="connsiteY8" fmla="*/ 491476 h 1617994"/>
                    <a:gd name="connsiteX9" fmla="*/ 986211 w 1711507"/>
                    <a:gd name="connsiteY9" fmla="*/ 651596 h 1617994"/>
                    <a:gd name="connsiteX10" fmla="*/ 766684 w 1711507"/>
                    <a:gd name="connsiteY10" fmla="*/ 809786 h 1617994"/>
                    <a:gd name="connsiteX11" fmla="*/ 668711 w 1711507"/>
                    <a:gd name="connsiteY11" fmla="*/ 969096 h 1617994"/>
                    <a:gd name="connsiteX12" fmla="*/ 780212 w 1711507"/>
                    <a:gd name="connsiteY12" fmla="*/ 1101375 h 1617994"/>
                    <a:gd name="connsiteX13" fmla="*/ 1015817 w 1711507"/>
                    <a:gd name="connsiteY13" fmla="*/ 985593 h 1617994"/>
                    <a:gd name="connsiteX14" fmla="*/ 1243386 w 1711507"/>
                    <a:gd name="connsiteY14" fmla="*/ 892896 h 1617994"/>
                    <a:gd name="connsiteX15" fmla="*/ 1383086 w 1711507"/>
                    <a:gd name="connsiteY15" fmla="*/ 1061171 h 1617994"/>
                    <a:gd name="connsiteX16" fmla="*/ 948111 w 1711507"/>
                    <a:gd name="connsiteY16" fmla="*/ 1359621 h 1617994"/>
                    <a:gd name="connsiteX17" fmla="*/ 1068761 w 1711507"/>
                    <a:gd name="connsiteY17" fmla="*/ 1527896 h 1617994"/>
                    <a:gd name="connsiteX18" fmla="*/ 1351336 w 1711507"/>
                    <a:gd name="connsiteY18" fmla="*/ 1496146 h 1617994"/>
                    <a:gd name="connsiteX19" fmla="*/ 1572854 w 1711507"/>
                    <a:gd name="connsiteY19" fmla="*/ 1614503 h 1617994"/>
                    <a:gd name="connsiteX20" fmla="*/ 1633005 w 1711507"/>
                    <a:gd name="connsiteY20" fmla="*/ 1581713 h 1617994"/>
                    <a:gd name="connsiteX21" fmla="*/ 1704290 w 1711507"/>
                    <a:gd name="connsiteY21" fmla="*/ 1530983 h 1617994"/>
                    <a:gd name="connsiteX22" fmla="*/ 1443534 w 1711507"/>
                    <a:gd name="connsiteY22" fmla="*/ 1413656 h 1617994"/>
                    <a:gd name="connsiteX23" fmla="*/ 1274973 w 1711507"/>
                    <a:gd name="connsiteY23" fmla="*/ 1393303 h 1617994"/>
                    <a:gd name="connsiteX24" fmla="*/ 1108612 w 1711507"/>
                    <a:gd name="connsiteY24" fmla="*/ 1401492 h 1617994"/>
                    <a:gd name="connsiteX25" fmla="*/ 1145304 w 1711507"/>
                    <a:gd name="connsiteY25" fmla="*/ 1339951 h 1617994"/>
                    <a:gd name="connsiteX26" fmla="*/ 1341811 w 1711507"/>
                    <a:gd name="connsiteY26" fmla="*/ 1238971 h 1617994"/>
                    <a:gd name="connsiteX27" fmla="*/ 1481511 w 1711507"/>
                    <a:gd name="connsiteY27" fmla="*/ 1064346 h 1617994"/>
                    <a:gd name="connsiteX28" fmla="*/ 1443411 w 1711507"/>
                    <a:gd name="connsiteY28" fmla="*/ 889721 h 1617994"/>
                    <a:gd name="connsiteX29" fmla="*/ 1224336 w 1711507"/>
                    <a:gd name="connsiteY29" fmla="*/ 797646 h 1617994"/>
                    <a:gd name="connsiteX30" fmla="*/ 998911 w 1711507"/>
                    <a:gd name="connsiteY30" fmla="*/ 867496 h 1617994"/>
                    <a:gd name="connsiteX31" fmla="*/ 811506 w 1711507"/>
                    <a:gd name="connsiteY31" fmla="*/ 981014 h 1617994"/>
                    <a:gd name="connsiteX32" fmla="*/ 808411 w 1711507"/>
                    <a:gd name="connsiteY32" fmla="*/ 892896 h 1617994"/>
                    <a:gd name="connsiteX33" fmla="*/ 1071936 w 1711507"/>
                    <a:gd name="connsiteY33" fmla="*/ 711921 h 1617994"/>
                    <a:gd name="connsiteX34" fmla="*/ 1081461 w 1711507"/>
                    <a:gd name="connsiteY34" fmla="*/ 505546 h 1617994"/>
                    <a:gd name="connsiteX35" fmla="*/ 922711 w 1711507"/>
                    <a:gd name="connsiteY35" fmla="*/ 369021 h 1617994"/>
                    <a:gd name="connsiteX36" fmla="*/ 745666 w 1711507"/>
                    <a:gd name="connsiteY36" fmla="*/ 421671 h 1617994"/>
                    <a:gd name="connsiteX37" fmla="*/ 497261 w 1711507"/>
                    <a:gd name="connsiteY37" fmla="*/ 572221 h 1617994"/>
                    <a:gd name="connsiteX38" fmla="*/ 411536 w 1711507"/>
                    <a:gd name="connsiteY38" fmla="*/ 572221 h 1617994"/>
                    <a:gd name="connsiteX39" fmla="*/ 405186 w 1711507"/>
                    <a:gd name="connsiteY39" fmla="*/ 549996 h 1617994"/>
                    <a:gd name="connsiteX40" fmla="*/ 443286 w 1711507"/>
                    <a:gd name="connsiteY40" fmla="*/ 508721 h 1617994"/>
                    <a:gd name="connsiteX41" fmla="*/ 599589 w 1711507"/>
                    <a:gd name="connsiteY41" fmla="*/ 347928 h 1617994"/>
                    <a:gd name="connsiteX42" fmla="*/ 706811 w 1711507"/>
                    <a:gd name="connsiteY42" fmla="*/ 146771 h 1617994"/>
                    <a:gd name="connsiteX43" fmla="*/ 592511 w 1711507"/>
                    <a:gd name="connsiteY43" fmla="*/ 3896 h 1617994"/>
                    <a:gd name="connsiteX44" fmla="*/ 278186 w 1711507"/>
                    <a:gd name="connsiteY44" fmla="*/ 51521 h 1617994"/>
                    <a:gd name="connsiteX45" fmla="*/ 21011 w 1711507"/>
                    <a:gd name="connsiteY45" fmla="*/ 168996 h 1617994"/>
                    <a:gd name="connsiteX46" fmla="*/ 33029 w 1711507"/>
                    <a:gd name="connsiteY46" fmla="*/ 242620 h 1617994"/>
                    <a:gd name="connsiteX47" fmla="*/ 24186 w 1711507"/>
                    <a:gd name="connsiteY47" fmla="*/ 315046 h 1617994"/>
                    <a:gd name="connsiteX0" fmla="*/ 60998 w 1712246"/>
                    <a:gd name="connsiteY0" fmla="*/ 275914 h 1617994"/>
                    <a:gd name="connsiteX1" fmla="*/ 196375 w 1712246"/>
                    <a:gd name="connsiteY1" fmla="*/ 184871 h 1617994"/>
                    <a:gd name="connsiteX2" fmla="*/ 567850 w 1712246"/>
                    <a:gd name="connsiteY2" fmla="*/ 86446 h 1617994"/>
                    <a:gd name="connsiteX3" fmla="*/ 536746 w 1712246"/>
                    <a:gd name="connsiteY3" fmla="*/ 247531 h 1617994"/>
                    <a:gd name="connsiteX4" fmla="*/ 329725 w 1712246"/>
                    <a:gd name="connsiteY4" fmla="*/ 502371 h 1617994"/>
                    <a:gd name="connsiteX5" fmla="*/ 272575 w 1712246"/>
                    <a:gd name="connsiteY5" fmla="*/ 661121 h 1617994"/>
                    <a:gd name="connsiteX6" fmla="*/ 475775 w 1712246"/>
                    <a:gd name="connsiteY6" fmla="*/ 692871 h 1617994"/>
                    <a:gd name="connsiteX7" fmla="*/ 748746 w 1712246"/>
                    <a:gd name="connsiteY7" fmla="*/ 544528 h 1617994"/>
                    <a:gd name="connsiteX8" fmla="*/ 954014 w 1712246"/>
                    <a:gd name="connsiteY8" fmla="*/ 491476 h 1617994"/>
                    <a:gd name="connsiteX9" fmla="*/ 986950 w 1712246"/>
                    <a:gd name="connsiteY9" fmla="*/ 651596 h 1617994"/>
                    <a:gd name="connsiteX10" fmla="*/ 767423 w 1712246"/>
                    <a:gd name="connsiteY10" fmla="*/ 809786 h 1617994"/>
                    <a:gd name="connsiteX11" fmla="*/ 669450 w 1712246"/>
                    <a:gd name="connsiteY11" fmla="*/ 969096 h 1617994"/>
                    <a:gd name="connsiteX12" fmla="*/ 780951 w 1712246"/>
                    <a:gd name="connsiteY12" fmla="*/ 1101375 h 1617994"/>
                    <a:gd name="connsiteX13" fmla="*/ 1016556 w 1712246"/>
                    <a:gd name="connsiteY13" fmla="*/ 985593 h 1617994"/>
                    <a:gd name="connsiteX14" fmla="*/ 1244125 w 1712246"/>
                    <a:gd name="connsiteY14" fmla="*/ 892896 h 1617994"/>
                    <a:gd name="connsiteX15" fmla="*/ 1383825 w 1712246"/>
                    <a:gd name="connsiteY15" fmla="*/ 1061171 h 1617994"/>
                    <a:gd name="connsiteX16" fmla="*/ 948850 w 1712246"/>
                    <a:gd name="connsiteY16" fmla="*/ 1359621 h 1617994"/>
                    <a:gd name="connsiteX17" fmla="*/ 1069500 w 1712246"/>
                    <a:gd name="connsiteY17" fmla="*/ 1527896 h 1617994"/>
                    <a:gd name="connsiteX18" fmla="*/ 1352075 w 1712246"/>
                    <a:gd name="connsiteY18" fmla="*/ 1496146 h 1617994"/>
                    <a:gd name="connsiteX19" fmla="*/ 1573593 w 1712246"/>
                    <a:gd name="connsiteY19" fmla="*/ 1614503 h 1617994"/>
                    <a:gd name="connsiteX20" fmla="*/ 1633744 w 1712246"/>
                    <a:gd name="connsiteY20" fmla="*/ 1581713 h 1617994"/>
                    <a:gd name="connsiteX21" fmla="*/ 1705029 w 1712246"/>
                    <a:gd name="connsiteY21" fmla="*/ 1530983 h 1617994"/>
                    <a:gd name="connsiteX22" fmla="*/ 1444273 w 1712246"/>
                    <a:gd name="connsiteY22" fmla="*/ 1413656 h 1617994"/>
                    <a:gd name="connsiteX23" fmla="*/ 1275712 w 1712246"/>
                    <a:gd name="connsiteY23" fmla="*/ 1393303 h 1617994"/>
                    <a:gd name="connsiteX24" fmla="*/ 1109351 w 1712246"/>
                    <a:gd name="connsiteY24" fmla="*/ 1401492 h 1617994"/>
                    <a:gd name="connsiteX25" fmla="*/ 1146043 w 1712246"/>
                    <a:gd name="connsiteY25" fmla="*/ 1339951 h 1617994"/>
                    <a:gd name="connsiteX26" fmla="*/ 1342550 w 1712246"/>
                    <a:gd name="connsiteY26" fmla="*/ 1238971 h 1617994"/>
                    <a:gd name="connsiteX27" fmla="*/ 1482250 w 1712246"/>
                    <a:gd name="connsiteY27" fmla="*/ 1064346 h 1617994"/>
                    <a:gd name="connsiteX28" fmla="*/ 1444150 w 1712246"/>
                    <a:gd name="connsiteY28" fmla="*/ 889721 h 1617994"/>
                    <a:gd name="connsiteX29" fmla="*/ 1225075 w 1712246"/>
                    <a:gd name="connsiteY29" fmla="*/ 797646 h 1617994"/>
                    <a:gd name="connsiteX30" fmla="*/ 999650 w 1712246"/>
                    <a:gd name="connsiteY30" fmla="*/ 867496 h 1617994"/>
                    <a:gd name="connsiteX31" fmla="*/ 812245 w 1712246"/>
                    <a:gd name="connsiteY31" fmla="*/ 981014 h 1617994"/>
                    <a:gd name="connsiteX32" fmla="*/ 809150 w 1712246"/>
                    <a:gd name="connsiteY32" fmla="*/ 892896 h 1617994"/>
                    <a:gd name="connsiteX33" fmla="*/ 1072675 w 1712246"/>
                    <a:gd name="connsiteY33" fmla="*/ 711921 h 1617994"/>
                    <a:gd name="connsiteX34" fmla="*/ 1082200 w 1712246"/>
                    <a:gd name="connsiteY34" fmla="*/ 505546 h 1617994"/>
                    <a:gd name="connsiteX35" fmla="*/ 923450 w 1712246"/>
                    <a:gd name="connsiteY35" fmla="*/ 369021 h 1617994"/>
                    <a:gd name="connsiteX36" fmla="*/ 746405 w 1712246"/>
                    <a:gd name="connsiteY36" fmla="*/ 421671 h 1617994"/>
                    <a:gd name="connsiteX37" fmla="*/ 498000 w 1712246"/>
                    <a:gd name="connsiteY37" fmla="*/ 572221 h 1617994"/>
                    <a:gd name="connsiteX38" fmla="*/ 412275 w 1712246"/>
                    <a:gd name="connsiteY38" fmla="*/ 572221 h 1617994"/>
                    <a:gd name="connsiteX39" fmla="*/ 405925 w 1712246"/>
                    <a:gd name="connsiteY39" fmla="*/ 549996 h 1617994"/>
                    <a:gd name="connsiteX40" fmla="*/ 444025 w 1712246"/>
                    <a:gd name="connsiteY40" fmla="*/ 508721 h 1617994"/>
                    <a:gd name="connsiteX41" fmla="*/ 600328 w 1712246"/>
                    <a:gd name="connsiteY41" fmla="*/ 347928 h 1617994"/>
                    <a:gd name="connsiteX42" fmla="*/ 707550 w 1712246"/>
                    <a:gd name="connsiteY42" fmla="*/ 146771 h 1617994"/>
                    <a:gd name="connsiteX43" fmla="*/ 593250 w 1712246"/>
                    <a:gd name="connsiteY43" fmla="*/ 3896 h 1617994"/>
                    <a:gd name="connsiteX44" fmla="*/ 278925 w 1712246"/>
                    <a:gd name="connsiteY44" fmla="*/ 51521 h 1617994"/>
                    <a:gd name="connsiteX45" fmla="*/ 21750 w 1712246"/>
                    <a:gd name="connsiteY45" fmla="*/ 168996 h 1617994"/>
                    <a:gd name="connsiteX46" fmla="*/ 33768 w 1712246"/>
                    <a:gd name="connsiteY46" fmla="*/ 242620 h 1617994"/>
                    <a:gd name="connsiteX47" fmla="*/ 60998 w 1712246"/>
                    <a:gd name="connsiteY47" fmla="*/ 275914 h 1617994"/>
                    <a:gd name="connsiteX0" fmla="*/ 60998 w 1712246"/>
                    <a:gd name="connsiteY0" fmla="*/ 275914 h 1617994"/>
                    <a:gd name="connsiteX1" fmla="*/ 196375 w 1712246"/>
                    <a:gd name="connsiteY1" fmla="*/ 184871 h 1617994"/>
                    <a:gd name="connsiteX2" fmla="*/ 567850 w 1712246"/>
                    <a:gd name="connsiteY2" fmla="*/ 86446 h 1617994"/>
                    <a:gd name="connsiteX3" fmla="*/ 536746 w 1712246"/>
                    <a:gd name="connsiteY3" fmla="*/ 247531 h 1617994"/>
                    <a:gd name="connsiteX4" fmla="*/ 324878 w 1712246"/>
                    <a:gd name="connsiteY4" fmla="*/ 475493 h 1617994"/>
                    <a:gd name="connsiteX5" fmla="*/ 272575 w 1712246"/>
                    <a:gd name="connsiteY5" fmla="*/ 661121 h 1617994"/>
                    <a:gd name="connsiteX6" fmla="*/ 475775 w 1712246"/>
                    <a:gd name="connsiteY6" fmla="*/ 692871 h 1617994"/>
                    <a:gd name="connsiteX7" fmla="*/ 748746 w 1712246"/>
                    <a:gd name="connsiteY7" fmla="*/ 544528 h 1617994"/>
                    <a:gd name="connsiteX8" fmla="*/ 954014 w 1712246"/>
                    <a:gd name="connsiteY8" fmla="*/ 491476 h 1617994"/>
                    <a:gd name="connsiteX9" fmla="*/ 986950 w 1712246"/>
                    <a:gd name="connsiteY9" fmla="*/ 651596 h 1617994"/>
                    <a:gd name="connsiteX10" fmla="*/ 767423 w 1712246"/>
                    <a:gd name="connsiteY10" fmla="*/ 809786 h 1617994"/>
                    <a:gd name="connsiteX11" fmla="*/ 669450 w 1712246"/>
                    <a:gd name="connsiteY11" fmla="*/ 969096 h 1617994"/>
                    <a:gd name="connsiteX12" fmla="*/ 780951 w 1712246"/>
                    <a:gd name="connsiteY12" fmla="*/ 1101375 h 1617994"/>
                    <a:gd name="connsiteX13" fmla="*/ 1016556 w 1712246"/>
                    <a:gd name="connsiteY13" fmla="*/ 985593 h 1617994"/>
                    <a:gd name="connsiteX14" fmla="*/ 1244125 w 1712246"/>
                    <a:gd name="connsiteY14" fmla="*/ 892896 h 1617994"/>
                    <a:gd name="connsiteX15" fmla="*/ 1383825 w 1712246"/>
                    <a:gd name="connsiteY15" fmla="*/ 1061171 h 1617994"/>
                    <a:gd name="connsiteX16" fmla="*/ 948850 w 1712246"/>
                    <a:gd name="connsiteY16" fmla="*/ 1359621 h 1617994"/>
                    <a:gd name="connsiteX17" fmla="*/ 1069500 w 1712246"/>
                    <a:gd name="connsiteY17" fmla="*/ 1527896 h 1617994"/>
                    <a:gd name="connsiteX18" fmla="*/ 1352075 w 1712246"/>
                    <a:gd name="connsiteY18" fmla="*/ 1496146 h 1617994"/>
                    <a:gd name="connsiteX19" fmla="*/ 1573593 w 1712246"/>
                    <a:gd name="connsiteY19" fmla="*/ 1614503 h 1617994"/>
                    <a:gd name="connsiteX20" fmla="*/ 1633744 w 1712246"/>
                    <a:gd name="connsiteY20" fmla="*/ 1581713 h 1617994"/>
                    <a:gd name="connsiteX21" fmla="*/ 1705029 w 1712246"/>
                    <a:gd name="connsiteY21" fmla="*/ 1530983 h 1617994"/>
                    <a:gd name="connsiteX22" fmla="*/ 1444273 w 1712246"/>
                    <a:gd name="connsiteY22" fmla="*/ 1413656 h 1617994"/>
                    <a:gd name="connsiteX23" fmla="*/ 1275712 w 1712246"/>
                    <a:gd name="connsiteY23" fmla="*/ 1393303 h 1617994"/>
                    <a:gd name="connsiteX24" fmla="*/ 1109351 w 1712246"/>
                    <a:gd name="connsiteY24" fmla="*/ 1401492 h 1617994"/>
                    <a:gd name="connsiteX25" fmla="*/ 1146043 w 1712246"/>
                    <a:gd name="connsiteY25" fmla="*/ 1339951 h 1617994"/>
                    <a:gd name="connsiteX26" fmla="*/ 1342550 w 1712246"/>
                    <a:gd name="connsiteY26" fmla="*/ 1238971 h 1617994"/>
                    <a:gd name="connsiteX27" fmla="*/ 1482250 w 1712246"/>
                    <a:gd name="connsiteY27" fmla="*/ 1064346 h 1617994"/>
                    <a:gd name="connsiteX28" fmla="*/ 1444150 w 1712246"/>
                    <a:gd name="connsiteY28" fmla="*/ 889721 h 1617994"/>
                    <a:gd name="connsiteX29" fmla="*/ 1225075 w 1712246"/>
                    <a:gd name="connsiteY29" fmla="*/ 797646 h 1617994"/>
                    <a:gd name="connsiteX30" fmla="*/ 999650 w 1712246"/>
                    <a:gd name="connsiteY30" fmla="*/ 867496 h 1617994"/>
                    <a:gd name="connsiteX31" fmla="*/ 812245 w 1712246"/>
                    <a:gd name="connsiteY31" fmla="*/ 981014 h 1617994"/>
                    <a:gd name="connsiteX32" fmla="*/ 809150 w 1712246"/>
                    <a:gd name="connsiteY32" fmla="*/ 892896 h 1617994"/>
                    <a:gd name="connsiteX33" fmla="*/ 1072675 w 1712246"/>
                    <a:gd name="connsiteY33" fmla="*/ 711921 h 1617994"/>
                    <a:gd name="connsiteX34" fmla="*/ 1082200 w 1712246"/>
                    <a:gd name="connsiteY34" fmla="*/ 505546 h 1617994"/>
                    <a:gd name="connsiteX35" fmla="*/ 923450 w 1712246"/>
                    <a:gd name="connsiteY35" fmla="*/ 369021 h 1617994"/>
                    <a:gd name="connsiteX36" fmla="*/ 746405 w 1712246"/>
                    <a:gd name="connsiteY36" fmla="*/ 421671 h 1617994"/>
                    <a:gd name="connsiteX37" fmla="*/ 498000 w 1712246"/>
                    <a:gd name="connsiteY37" fmla="*/ 572221 h 1617994"/>
                    <a:gd name="connsiteX38" fmla="*/ 412275 w 1712246"/>
                    <a:gd name="connsiteY38" fmla="*/ 572221 h 1617994"/>
                    <a:gd name="connsiteX39" fmla="*/ 405925 w 1712246"/>
                    <a:gd name="connsiteY39" fmla="*/ 549996 h 1617994"/>
                    <a:gd name="connsiteX40" fmla="*/ 444025 w 1712246"/>
                    <a:gd name="connsiteY40" fmla="*/ 508721 h 1617994"/>
                    <a:gd name="connsiteX41" fmla="*/ 600328 w 1712246"/>
                    <a:gd name="connsiteY41" fmla="*/ 347928 h 1617994"/>
                    <a:gd name="connsiteX42" fmla="*/ 707550 w 1712246"/>
                    <a:gd name="connsiteY42" fmla="*/ 146771 h 1617994"/>
                    <a:gd name="connsiteX43" fmla="*/ 593250 w 1712246"/>
                    <a:gd name="connsiteY43" fmla="*/ 3896 h 1617994"/>
                    <a:gd name="connsiteX44" fmla="*/ 278925 w 1712246"/>
                    <a:gd name="connsiteY44" fmla="*/ 51521 h 1617994"/>
                    <a:gd name="connsiteX45" fmla="*/ 21750 w 1712246"/>
                    <a:gd name="connsiteY45" fmla="*/ 168996 h 1617994"/>
                    <a:gd name="connsiteX46" fmla="*/ 33768 w 1712246"/>
                    <a:gd name="connsiteY46" fmla="*/ 242620 h 1617994"/>
                    <a:gd name="connsiteX47" fmla="*/ 60998 w 1712246"/>
                    <a:gd name="connsiteY47" fmla="*/ 275914 h 1617994"/>
                    <a:gd name="connsiteX0" fmla="*/ 60998 w 1712246"/>
                    <a:gd name="connsiteY0" fmla="*/ 275914 h 1617994"/>
                    <a:gd name="connsiteX1" fmla="*/ 196375 w 1712246"/>
                    <a:gd name="connsiteY1" fmla="*/ 184871 h 1617994"/>
                    <a:gd name="connsiteX2" fmla="*/ 567850 w 1712246"/>
                    <a:gd name="connsiteY2" fmla="*/ 86446 h 1617994"/>
                    <a:gd name="connsiteX3" fmla="*/ 536746 w 1712246"/>
                    <a:gd name="connsiteY3" fmla="*/ 247531 h 1617994"/>
                    <a:gd name="connsiteX4" fmla="*/ 324878 w 1712246"/>
                    <a:gd name="connsiteY4" fmla="*/ 475493 h 1617994"/>
                    <a:gd name="connsiteX5" fmla="*/ 272575 w 1712246"/>
                    <a:gd name="connsiteY5" fmla="*/ 661121 h 1617994"/>
                    <a:gd name="connsiteX6" fmla="*/ 475775 w 1712246"/>
                    <a:gd name="connsiteY6" fmla="*/ 692871 h 1617994"/>
                    <a:gd name="connsiteX7" fmla="*/ 748746 w 1712246"/>
                    <a:gd name="connsiteY7" fmla="*/ 544528 h 1617994"/>
                    <a:gd name="connsiteX8" fmla="*/ 954014 w 1712246"/>
                    <a:gd name="connsiteY8" fmla="*/ 491476 h 1617994"/>
                    <a:gd name="connsiteX9" fmla="*/ 986950 w 1712246"/>
                    <a:gd name="connsiteY9" fmla="*/ 651596 h 1617994"/>
                    <a:gd name="connsiteX10" fmla="*/ 767423 w 1712246"/>
                    <a:gd name="connsiteY10" fmla="*/ 809786 h 1617994"/>
                    <a:gd name="connsiteX11" fmla="*/ 669450 w 1712246"/>
                    <a:gd name="connsiteY11" fmla="*/ 969096 h 1617994"/>
                    <a:gd name="connsiteX12" fmla="*/ 780951 w 1712246"/>
                    <a:gd name="connsiteY12" fmla="*/ 1101375 h 1617994"/>
                    <a:gd name="connsiteX13" fmla="*/ 1016556 w 1712246"/>
                    <a:gd name="connsiteY13" fmla="*/ 985593 h 1617994"/>
                    <a:gd name="connsiteX14" fmla="*/ 1244125 w 1712246"/>
                    <a:gd name="connsiteY14" fmla="*/ 892896 h 1617994"/>
                    <a:gd name="connsiteX15" fmla="*/ 1383825 w 1712246"/>
                    <a:gd name="connsiteY15" fmla="*/ 1061171 h 1617994"/>
                    <a:gd name="connsiteX16" fmla="*/ 948850 w 1712246"/>
                    <a:gd name="connsiteY16" fmla="*/ 1359621 h 1617994"/>
                    <a:gd name="connsiteX17" fmla="*/ 1069500 w 1712246"/>
                    <a:gd name="connsiteY17" fmla="*/ 1527896 h 1617994"/>
                    <a:gd name="connsiteX18" fmla="*/ 1352075 w 1712246"/>
                    <a:gd name="connsiteY18" fmla="*/ 1496146 h 1617994"/>
                    <a:gd name="connsiteX19" fmla="*/ 1573593 w 1712246"/>
                    <a:gd name="connsiteY19" fmla="*/ 1614503 h 1617994"/>
                    <a:gd name="connsiteX20" fmla="*/ 1633744 w 1712246"/>
                    <a:gd name="connsiteY20" fmla="*/ 1581713 h 1617994"/>
                    <a:gd name="connsiteX21" fmla="*/ 1705029 w 1712246"/>
                    <a:gd name="connsiteY21" fmla="*/ 1530983 h 1617994"/>
                    <a:gd name="connsiteX22" fmla="*/ 1444273 w 1712246"/>
                    <a:gd name="connsiteY22" fmla="*/ 1413656 h 1617994"/>
                    <a:gd name="connsiteX23" fmla="*/ 1275712 w 1712246"/>
                    <a:gd name="connsiteY23" fmla="*/ 1393303 h 1617994"/>
                    <a:gd name="connsiteX24" fmla="*/ 1109351 w 1712246"/>
                    <a:gd name="connsiteY24" fmla="*/ 1401492 h 1617994"/>
                    <a:gd name="connsiteX25" fmla="*/ 1146043 w 1712246"/>
                    <a:gd name="connsiteY25" fmla="*/ 1339951 h 1617994"/>
                    <a:gd name="connsiteX26" fmla="*/ 1319435 w 1712246"/>
                    <a:gd name="connsiteY26" fmla="*/ 1221012 h 1617994"/>
                    <a:gd name="connsiteX27" fmla="*/ 1482250 w 1712246"/>
                    <a:gd name="connsiteY27" fmla="*/ 1064346 h 1617994"/>
                    <a:gd name="connsiteX28" fmla="*/ 1444150 w 1712246"/>
                    <a:gd name="connsiteY28" fmla="*/ 889721 h 1617994"/>
                    <a:gd name="connsiteX29" fmla="*/ 1225075 w 1712246"/>
                    <a:gd name="connsiteY29" fmla="*/ 797646 h 1617994"/>
                    <a:gd name="connsiteX30" fmla="*/ 999650 w 1712246"/>
                    <a:gd name="connsiteY30" fmla="*/ 867496 h 1617994"/>
                    <a:gd name="connsiteX31" fmla="*/ 812245 w 1712246"/>
                    <a:gd name="connsiteY31" fmla="*/ 981014 h 1617994"/>
                    <a:gd name="connsiteX32" fmla="*/ 809150 w 1712246"/>
                    <a:gd name="connsiteY32" fmla="*/ 892896 h 1617994"/>
                    <a:gd name="connsiteX33" fmla="*/ 1072675 w 1712246"/>
                    <a:gd name="connsiteY33" fmla="*/ 711921 h 1617994"/>
                    <a:gd name="connsiteX34" fmla="*/ 1082200 w 1712246"/>
                    <a:gd name="connsiteY34" fmla="*/ 505546 h 1617994"/>
                    <a:gd name="connsiteX35" fmla="*/ 923450 w 1712246"/>
                    <a:gd name="connsiteY35" fmla="*/ 369021 h 1617994"/>
                    <a:gd name="connsiteX36" fmla="*/ 746405 w 1712246"/>
                    <a:gd name="connsiteY36" fmla="*/ 421671 h 1617994"/>
                    <a:gd name="connsiteX37" fmla="*/ 498000 w 1712246"/>
                    <a:gd name="connsiteY37" fmla="*/ 572221 h 1617994"/>
                    <a:gd name="connsiteX38" fmla="*/ 412275 w 1712246"/>
                    <a:gd name="connsiteY38" fmla="*/ 572221 h 1617994"/>
                    <a:gd name="connsiteX39" fmla="*/ 405925 w 1712246"/>
                    <a:gd name="connsiteY39" fmla="*/ 549996 h 1617994"/>
                    <a:gd name="connsiteX40" fmla="*/ 444025 w 1712246"/>
                    <a:gd name="connsiteY40" fmla="*/ 508721 h 1617994"/>
                    <a:gd name="connsiteX41" fmla="*/ 600328 w 1712246"/>
                    <a:gd name="connsiteY41" fmla="*/ 347928 h 1617994"/>
                    <a:gd name="connsiteX42" fmla="*/ 707550 w 1712246"/>
                    <a:gd name="connsiteY42" fmla="*/ 146771 h 1617994"/>
                    <a:gd name="connsiteX43" fmla="*/ 593250 w 1712246"/>
                    <a:gd name="connsiteY43" fmla="*/ 3896 h 1617994"/>
                    <a:gd name="connsiteX44" fmla="*/ 278925 w 1712246"/>
                    <a:gd name="connsiteY44" fmla="*/ 51521 h 1617994"/>
                    <a:gd name="connsiteX45" fmla="*/ 21750 w 1712246"/>
                    <a:gd name="connsiteY45" fmla="*/ 168996 h 1617994"/>
                    <a:gd name="connsiteX46" fmla="*/ 33768 w 1712246"/>
                    <a:gd name="connsiteY46" fmla="*/ 242620 h 1617994"/>
                    <a:gd name="connsiteX47" fmla="*/ 60998 w 1712246"/>
                    <a:gd name="connsiteY47" fmla="*/ 275914 h 1617994"/>
                    <a:gd name="connsiteX0" fmla="*/ 60998 w 1712246"/>
                    <a:gd name="connsiteY0" fmla="*/ 275914 h 1617994"/>
                    <a:gd name="connsiteX1" fmla="*/ 196375 w 1712246"/>
                    <a:gd name="connsiteY1" fmla="*/ 184871 h 1617994"/>
                    <a:gd name="connsiteX2" fmla="*/ 567850 w 1712246"/>
                    <a:gd name="connsiteY2" fmla="*/ 86446 h 1617994"/>
                    <a:gd name="connsiteX3" fmla="*/ 536746 w 1712246"/>
                    <a:gd name="connsiteY3" fmla="*/ 247531 h 1617994"/>
                    <a:gd name="connsiteX4" fmla="*/ 324878 w 1712246"/>
                    <a:gd name="connsiteY4" fmla="*/ 475493 h 1617994"/>
                    <a:gd name="connsiteX5" fmla="*/ 272575 w 1712246"/>
                    <a:gd name="connsiteY5" fmla="*/ 661121 h 1617994"/>
                    <a:gd name="connsiteX6" fmla="*/ 475775 w 1712246"/>
                    <a:gd name="connsiteY6" fmla="*/ 692871 h 1617994"/>
                    <a:gd name="connsiteX7" fmla="*/ 748746 w 1712246"/>
                    <a:gd name="connsiteY7" fmla="*/ 544528 h 1617994"/>
                    <a:gd name="connsiteX8" fmla="*/ 954014 w 1712246"/>
                    <a:gd name="connsiteY8" fmla="*/ 491476 h 1617994"/>
                    <a:gd name="connsiteX9" fmla="*/ 986950 w 1712246"/>
                    <a:gd name="connsiteY9" fmla="*/ 651596 h 1617994"/>
                    <a:gd name="connsiteX10" fmla="*/ 767423 w 1712246"/>
                    <a:gd name="connsiteY10" fmla="*/ 809786 h 1617994"/>
                    <a:gd name="connsiteX11" fmla="*/ 669450 w 1712246"/>
                    <a:gd name="connsiteY11" fmla="*/ 969096 h 1617994"/>
                    <a:gd name="connsiteX12" fmla="*/ 780951 w 1712246"/>
                    <a:gd name="connsiteY12" fmla="*/ 1101375 h 1617994"/>
                    <a:gd name="connsiteX13" fmla="*/ 1016556 w 1712246"/>
                    <a:gd name="connsiteY13" fmla="*/ 985593 h 1617994"/>
                    <a:gd name="connsiteX14" fmla="*/ 1244125 w 1712246"/>
                    <a:gd name="connsiteY14" fmla="*/ 892896 h 1617994"/>
                    <a:gd name="connsiteX15" fmla="*/ 1383825 w 1712246"/>
                    <a:gd name="connsiteY15" fmla="*/ 1061171 h 1617994"/>
                    <a:gd name="connsiteX16" fmla="*/ 948850 w 1712246"/>
                    <a:gd name="connsiteY16" fmla="*/ 1359621 h 1617994"/>
                    <a:gd name="connsiteX17" fmla="*/ 1069500 w 1712246"/>
                    <a:gd name="connsiteY17" fmla="*/ 1527896 h 1617994"/>
                    <a:gd name="connsiteX18" fmla="*/ 1352075 w 1712246"/>
                    <a:gd name="connsiteY18" fmla="*/ 1496146 h 1617994"/>
                    <a:gd name="connsiteX19" fmla="*/ 1573593 w 1712246"/>
                    <a:gd name="connsiteY19" fmla="*/ 1614503 h 1617994"/>
                    <a:gd name="connsiteX20" fmla="*/ 1633744 w 1712246"/>
                    <a:gd name="connsiteY20" fmla="*/ 1581713 h 1617994"/>
                    <a:gd name="connsiteX21" fmla="*/ 1705029 w 1712246"/>
                    <a:gd name="connsiteY21" fmla="*/ 1530983 h 1617994"/>
                    <a:gd name="connsiteX22" fmla="*/ 1444273 w 1712246"/>
                    <a:gd name="connsiteY22" fmla="*/ 1413656 h 1617994"/>
                    <a:gd name="connsiteX23" fmla="*/ 1303639 w 1712246"/>
                    <a:gd name="connsiteY23" fmla="*/ 1371391 h 1617994"/>
                    <a:gd name="connsiteX24" fmla="*/ 1109351 w 1712246"/>
                    <a:gd name="connsiteY24" fmla="*/ 1401492 h 1617994"/>
                    <a:gd name="connsiteX25" fmla="*/ 1146043 w 1712246"/>
                    <a:gd name="connsiteY25" fmla="*/ 1339951 h 1617994"/>
                    <a:gd name="connsiteX26" fmla="*/ 1319435 w 1712246"/>
                    <a:gd name="connsiteY26" fmla="*/ 1221012 h 1617994"/>
                    <a:gd name="connsiteX27" fmla="*/ 1482250 w 1712246"/>
                    <a:gd name="connsiteY27" fmla="*/ 1064346 h 1617994"/>
                    <a:gd name="connsiteX28" fmla="*/ 1444150 w 1712246"/>
                    <a:gd name="connsiteY28" fmla="*/ 889721 h 1617994"/>
                    <a:gd name="connsiteX29" fmla="*/ 1225075 w 1712246"/>
                    <a:gd name="connsiteY29" fmla="*/ 797646 h 1617994"/>
                    <a:gd name="connsiteX30" fmla="*/ 999650 w 1712246"/>
                    <a:gd name="connsiteY30" fmla="*/ 867496 h 1617994"/>
                    <a:gd name="connsiteX31" fmla="*/ 812245 w 1712246"/>
                    <a:gd name="connsiteY31" fmla="*/ 981014 h 1617994"/>
                    <a:gd name="connsiteX32" fmla="*/ 809150 w 1712246"/>
                    <a:gd name="connsiteY32" fmla="*/ 892896 h 1617994"/>
                    <a:gd name="connsiteX33" fmla="*/ 1072675 w 1712246"/>
                    <a:gd name="connsiteY33" fmla="*/ 711921 h 1617994"/>
                    <a:gd name="connsiteX34" fmla="*/ 1082200 w 1712246"/>
                    <a:gd name="connsiteY34" fmla="*/ 505546 h 1617994"/>
                    <a:gd name="connsiteX35" fmla="*/ 923450 w 1712246"/>
                    <a:gd name="connsiteY35" fmla="*/ 369021 h 1617994"/>
                    <a:gd name="connsiteX36" fmla="*/ 746405 w 1712246"/>
                    <a:gd name="connsiteY36" fmla="*/ 421671 h 1617994"/>
                    <a:gd name="connsiteX37" fmla="*/ 498000 w 1712246"/>
                    <a:gd name="connsiteY37" fmla="*/ 572221 h 1617994"/>
                    <a:gd name="connsiteX38" fmla="*/ 412275 w 1712246"/>
                    <a:gd name="connsiteY38" fmla="*/ 572221 h 1617994"/>
                    <a:gd name="connsiteX39" fmla="*/ 405925 w 1712246"/>
                    <a:gd name="connsiteY39" fmla="*/ 549996 h 1617994"/>
                    <a:gd name="connsiteX40" fmla="*/ 444025 w 1712246"/>
                    <a:gd name="connsiteY40" fmla="*/ 508721 h 1617994"/>
                    <a:gd name="connsiteX41" fmla="*/ 600328 w 1712246"/>
                    <a:gd name="connsiteY41" fmla="*/ 347928 h 1617994"/>
                    <a:gd name="connsiteX42" fmla="*/ 707550 w 1712246"/>
                    <a:gd name="connsiteY42" fmla="*/ 146771 h 1617994"/>
                    <a:gd name="connsiteX43" fmla="*/ 593250 w 1712246"/>
                    <a:gd name="connsiteY43" fmla="*/ 3896 h 1617994"/>
                    <a:gd name="connsiteX44" fmla="*/ 278925 w 1712246"/>
                    <a:gd name="connsiteY44" fmla="*/ 51521 h 1617994"/>
                    <a:gd name="connsiteX45" fmla="*/ 21750 w 1712246"/>
                    <a:gd name="connsiteY45" fmla="*/ 168996 h 1617994"/>
                    <a:gd name="connsiteX46" fmla="*/ 33768 w 1712246"/>
                    <a:gd name="connsiteY46" fmla="*/ 242620 h 1617994"/>
                    <a:gd name="connsiteX47" fmla="*/ 60998 w 1712246"/>
                    <a:gd name="connsiteY47" fmla="*/ 275914 h 1617994"/>
                    <a:gd name="connsiteX0" fmla="*/ 60998 w 1708809"/>
                    <a:gd name="connsiteY0" fmla="*/ 275914 h 1617994"/>
                    <a:gd name="connsiteX1" fmla="*/ 196375 w 1708809"/>
                    <a:gd name="connsiteY1" fmla="*/ 184871 h 1617994"/>
                    <a:gd name="connsiteX2" fmla="*/ 567850 w 1708809"/>
                    <a:gd name="connsiteY2" fmla="*/ 86446 h 1617994"/>
                    <a:gd name="connsiteX3" fmla="*/ 536746 w 1708809"/>
                    <a:gd name="connsiteY3" fmla="*/ 247531 h 1617994"/>
                    <a:gd name="connsiteX4" fmla="*/ 324878 w 1708809"/>
                    <a:gd name="connsiteY4" fmla="*/ 475493 h 1617994"/>
                    <a:gd name="connsiteX5" fmla="*/ 272575 w 1708809"/>
                    <a:gd name="connsiteY5" fmla="*/ 661121 h 1617994"/>
                    <a:gd name="connsiteX6" fmla="*/ 475775 w 1708809"/>
                    <a:gd name="connsiteY6" fmla="*/ 692871 h 1617994"/>
                    <a:gd name="connsiteX7" fmla="*/ 748746 w 1708809"/>
                    <a:gd name="connsiteY7" fmla="*/ 544528 h 1617994"/>
                    <a:gd name="connsiteX8" fmla="*/ 954014 w 1708809"/>
                    <a:gd name="connsiteY8" fmla="*/ 491476 h 1617994"/>
                    <a:gd name="connsiteX9" fmla="*/ 986950 w 1708809"/>
                    <a:gd name="connsiteY9" fmla="*/ 651596 h 1617994"/>
                    <a:gd name="connsiteX10" fmla="*/ 767423 w 1708809"/>
                    <a:gd name="connsiteY10" fmla="*/ 809786 h 1617994"/>
                    <a:gd name="connsiteX11" fmla="*/ 669450 w 1708809"/>
                    <a:gd name="connsiteY11" fmla="*/ 969096 h 1617994"/>
                    <a:gd name="connsiteX12" fmla="*/ 780951 w 1708809"/>
                    <a:gd name="connsiteY12" fmla="*/ 1101375 h 1617994"/>
                    <a:gd name="connsiteX13" fmla="*/ 1016556 w 1708809"/>
                    <a:gd name="connsiteY13" fmla="*/ 985593 h 1617994"/>
                    <a:gd name="connsiteX14" fmla="*/ 1244125 w 1708809"/>
                    <a:gd name="connsiteY14" fmla="*/ 892896 h 1617994"/>
                    <a:gd name="connsiteX15" fmla="*/ 1383825 w 1708809"/>
                    <a:gd name="connsiteY15" fmla="*/ 1061171 h 1617994"/>
                    <a:gd name="connsiteX16" fmla="*/ 948850 w 1708809"/>
                    <a:gd name="connsiteY16" fmla="*/ 1359621 h 1617994"/>
                    <a:gd name="connsiteX17" fmla="*/ 1069500 w 1708809"/>
                    <a:gd name="connsiteY17" fmla="*/ 1527896 h 1617994"/>
                    <a:gd name="connsiteX18" fmla="*/ 1352075 w 1708809"/>
                    <a:gd name="connsiteY18" fmla="*/ 1496146 h 1617994"/>
                    <a:gd name="connsiteX19" fmla="*/ 1573593 w 1708809"/>
                    <a:gd name="connsiteY19" fmla="*/ 1614503 h 1617994"/>
                    <a:gd name="connsiteX20" fmla="*/ 1633744 w 1708809"/>
                    <a:gd name="connsiteY20" fmla="*/ 1581713 h 1617994"/>
                    <a:gd name="connsiteX21" fmla="*/ 1705029 w 1708809"/>
                    <a:gd name="connsiteY21" fmla="*/ 1530983 h 1617994"/>
                    <a:gd name="connsiteX22" fmla="*/ 1509511 w 1708809"/>
                    <a:gd name="connsiteY22" fmla="*/ 1409393 h 1617994"/>
                    <a:gd name="connsiteX23" fmla="*/ 1303639 w 1708809"/>
                    <a:gd name="connsiteY23" fmla="*/ 1371391 h 1617994"/>
                    <a:gd name="connsiteX24" fmla="*/ 1109351 w 1708809"/>
                    <a:gd name="connsiteY24" fmla="*/ 1401492 h 1617994"/>
                    <a:gd name="connsiteX25" fmla="*/ 1146043 w 1708809"/>
                    <a:gd name="connsiteY25" fmla="*/ 1339951 h 1617994"/>
                    <a:gd name="connsiteX26" fmla="*/ 1319435 w 1708809"/>
                    <a:gd name="connsiteY26" fmla="*/ 1221012 h 1617994"/>
                    <a:gd name="connsiteX27" fmla="*/ 1482250 w 1708809"/>
                    <a:gd name="connsiteY27" fmla="*/ 1064346 h 1617994"/>
                    <a:gd name="connsiteX28" fmla="*/ 1444150 w 1708809"/>
                    <a:gd name="connsiteY28" fmla="*/ 889721 h 1617994"/>
                    <a:gd name="connsiteX29" fmla="*/ 1225075 w 1708809"/>
                    <a:gd name="connsiteY29" fmla="*/ 797646 h 1617994"/>
                    <a:gd name="connsiteX30" fmla="*/ 999650 w 1708809"/>
                    <a:gd name="connsiteY30" fmla="*/ 867496 h 1617994"/>
                    <a:gd name="connsiteX31" fmla="*/ 812245 w 1708809"/>
                    <a:gd name="connsiteY31" fmla="*/ 981014 h 1617994"/>
                    <a:gd name="connsiteX32" fmla="*/ 809150 w 1708809"/>
                    <a:gd name="connsiteY32" fmla="*/ 892896 h 1617994"/>
                    <a:gd name="connsiteX33" fmla="*/ 1072675 w 1708809"/>
                    <a:gd name="connsiteY33" fmla="*/ 711921 h 1617994"/>
                    <a:gd name="connsiteX34" fmla="*/ 1082200 w 1708809"/>
                    <a:gd name="connsiteY34" fmla="*/ 505546 h 1617994"/>
                    <a:gd name="connsiteX35" fmla="*/ 923450 w 1708809"/>
                    <a:gd name="connsiteY35" fmla="*/ 369021 h 1617994"/>
                    <a:gd name="connsiteX36" fmla="*/ 746405 w 1708809"/>
                    <a:gd name="connsiteY36" fmla="*/ 421671 h 1617994"/>
                    <a:gd name="connsiteX37" fmla="*/ 498000 w 1708809"/>
                    <a:gd name="connsiteY37" fmla="*/ 572221 h 1617994"/>
                    <a:gd name="connsiteX38" fmla="*/ 412275 w 1708809"/>
                    <a:gd name="connsiteY38" fmla="*/ 572221 h 1617994"/>
                    <a:gd name="connsiteX39" fmla="*/ 405925 w 1708809"/>
                    <a:gd name="connsiteY39" fmla="*/ 549996 h 1617994"/>
                    <a:gd name="connsiteX40" fmla="*/ 444025 w 1708809"/>
                    <a:gd name="connsiteY40" fmla="*/ 508721 h 1617994"/>
                    <a:gd name="connsiteX41" fmla="*/ 600328 w 1708809"/>
                    <a:gd name="connsiteY41" fmla="*/ 347928 h 1617994"/>
                    <a:gd name="connsiteX42" fmla="*/ 707550 w 1708809"/>
                    <a:gd name="connsiteY42" fmla="*/ 146771 h 1617994"/>
                    <a:gd name="connsiteX43" fmla="*/ 593250 w 1708809"/>
                    <a:gd name="connsiteY43" fmla="*/ 3896 h 1617994"/>
                    <a:gd name="connsiteX44" fmla="*/ 278925 w 1708809"/>
                    <a:gd name="connsiteY44" fmla="*/ 51521 h 1617994"/>
                    <a:gd name="connsiteX45" fmla="*/ 21750 w 1708809"/>
                    <a:gd name="connsiteY45" fmla="*/ 168996 h 1617994"/>
                    <a:gd name="connsiteX46" fmla="*/ 33768 w 1708809"/>
                    <a:gd name="connsiteY46" fmla="*/ 242620 h 1617994"/>
                    <a:gd name="connsiteX47" fmla="*/ 60998 w 1708809"/>
                    <a:gd name="connsiteY47" fmla="*/ 275914 h 1617994"/>
                    <a:gd name="connsiteX0" fmla="*/ 59026 w 1706837"/>
                    <a:gd name="connsiteY0" fmla="*/ 275914 h 1617994"/>
                    <a:gd name="connsiteX1" fmla="*/ 194403 w 1706837"/>
                    <a:gd name="connsiteY1" fmla="*/ 184871 h 1617994"/>
                    <a:gd name="connsiteX2" fmla="*/ 565878 w 1706837"/>
                    <a:gd name="connsiteY2" fmla="*/ 86446 h 1617994"/>
                    <a:gd name="connsiteX3" fmla="*/ 534774 w 1706837"/>
                    <a:gd name="connsiteY3" fmla="*/ 247531 h 1617994"/>
                    <a:gd name="connsiteX4" fmla="*/ 322906 w 1706837"/>
                    <a:gd name="connsiteY4" fmla="*/ 475493 h 1617994"/>
                    <a:gd name="connsiteX5" fmla="*/ 270603 w 1706837"/>
                    <a:gd name="connsiteY5" fmla="*/ 661121 h 1617994"/>
                    <a:gd name="connsiteX6" fmla="*/ 473803 w 1706837"/>
                    <a:gd name="connsiteY6" fmla="*/ 692871 h 1617994"/>
                    <a:gd name="connsiteX7" fmla="*/ 746774 w 1706837"/>
                    <a:gd name="connsiteY7" fmla="*/ 544528 h 1617994"/>
                    <a:gd name="connsiteX8" fmla="*/ 952042 w 1706837"/>
                    <a:gd name="connsiteY8" fmla="*/ 491476 h 1617994"/>
                    <a:gd name="connsiteX9" fmla="*/ 984978 w 1706837"/>
                    <a:gd name="connsiteY9" fmla="*/ 651596 h 1617994"/>
                    <a:gd name="connsiteX10" fmla="*/ 765451 w 1706837"/>
                    <a:gd name="connsiteY10" fmla="*/ 809786 h 1617994"/>
                    <a:gd name="connsiteX11" fmla="*/ 667478 w 1706837"/>
                    <a:gd name="connsiteY11" fmla="*/ 969096 h 1617994"/>
                    <a:gd name="connsiteX12" fmla="*/ 778979 w 1706837"/>
                    <a:gd name="connsiteY12" fmla="*/ 1101375 h 1617994"/>
                    <a:gd name="connsiteX13" fmla="*/ 1014584 w 1706837"/>
                    <a:gd name="connsiteY13" fmla="*/ 985593 h 1617994"/>
                    <a:gd name="connsiteX14" fmla="*/ 1242153 w 1706837"/>
                    <a:gd name="connsiteY14" fmla="*/ 892896 h 1617994"/>
                    <a:gd name="connsiteX15" fmla="*/ 1381853 w 1706837"/>
                    <a:gd name="connsiteY15" fmla="*/ 1061171 h 1617994"/>
                    <a:gd name="connsiteX16" fmla="*/ 946878 w 1706837"/>
                    <a:gd name="connsiteY16" fmla="*/ 1359621 h 1617994"/>
                    <a:gd name="connsiteX17" fmla="*/ 1067528 w 1706837"/>
                    <a:gd name="connsiteY17" fmla="*/ 1527896 h 1617994"/>
                    <a:gd name="connsiteX18" fmla="*/ 1350103 w 1706837"/>
                    <a:gd name="connsiteY18" fmla="*/ 1496146 h 1617994"/>
                    <a:gd name="connsiteX19" fmla="*/ 1571621 w 1706837"/>
                    <a:gd name="connsiteY19" fmla="*/ 1614503 h 1617994"/>
                    <a:gd name="connsiteX20" fmla="*/ 1631772 w 1706837"/>
                    <a:gd name="connsiteY20" fmla="*/ 1581713 h 1617994"/>
                    <a:gd name="connsiteX21" fmla="*/ 1703057 w 1706837"/>
                    <a:gd name="connsiteY21" fmla="*/ 1530983 h 1617994"/>
                    <a:gd name="connsiteX22" fmla="*/ 1507539 w 1706837"/>
                    <a:gd name="connsiteY22" fmla="*/ 1409393 h 1617994"/>
                    <a:gd name="connsiteX23" fmla="*/ 1301667 w 1706837"/>
                    <a:gd name="connsiteY23" fmla="*/ 1371391 h 1617994"/>
                    <a:gd name="connsiteX24" fmla="*/ 1107379 w 1706837"/>
                    <a:gd name="connsiteY24" fmla="*/ 1401492 h 1617994"/>
                    <a:gd name="connsiteX25" fmla="*/ 1144071 w 1706837"/>
                    <a:gd name="connsiteY25" fmla="*/ 1339951 h 1617994"/>
                    <a:gd name="connsiteX26" fmla="*/ 1317463 w 1706837"/>
                    <a:gd name="connsiteY26" fmla="*/ 1221012 h 1617994"/>
                    <a:gd name="connsiteX27" fmla="*/ 1480278 w 1706837"/>
                    <a:gd name="connsiteY27" fmla="*/ 1064346 h 1617994"/>
                    <a:gd name="connsiteX28" fmla="*/ 1442178 w 1706837"/>
                    <a:gd name="connsiteY28" fmla="*/ 889721 h 1617994"/>
                    <a:gd name="connsiteX29" fmla="*/ 1223103 w 1706837"/>
                    <a:gd name="connsiteY29" fmla="*/ 797646 h 1617994"/>
                    <a:gd name="connsiteX30" fmla="*/ 997678 w 1706837"/>
                    <a:gd name="connsiteY30" fmla="*/ 867496 h 1617994"/>
                    <a:gd name="connsiteX31" fmla="*/ 810273 w 1706837"/>
                    <a:gd name="connsiteY31" fmla="*/ 981014 h 1617994"/>
                    <a:gd name="connsiteX32" fmla="*/ 807178 w 1706837"/>
                    <a:gd name="connsiteY32" fmla="*/ 892896 h 1617994"/>
                    <a:gd name="connsiteX33" fmla="*/ 1070703 w 1706837"/>
                    <a:gd name="connsiteY33" fmla="*/ 711921 h 1617994"/>
                    <a:gd name="connsiteX34" fmla="*/ 1080228 w 1706837"/>
                    <a:gd name="connsiteY34" fmla="*/ 505546 h 1617994"/>
                    <a:gd name="connsiteX35" fmla="*/ 921478 w 1706837"/>
                    <a:gd name="connsiteY35" fmla="*/ 369021 h 1617994"/>
                    <a:gd name="connsiteX36" fmla="*/ 744433 w 1706837"/>
                    <a:gd name="connsiteY36" fmla="*/ 421671 h 1617994"/>
                    <a:gd name="connsiteX37" fmla="*/ 496028 w 1706837"/>
                    <a:gd name="connsiteY37" fmla="*/ 572221 h 1617994"/>
                    <a:gd name="connsiteX38" fmla="*/ 410303 w 1706837"/>
                    <a:gd name="connsiteY38" fmla="*/ 572221 h 1617994"/>
                    <a:gd name="connsiteX39" fmla="*/ 403953 w 1706837"/>
                    <a:gd name="connsiteY39" fmla="*/ 549996 h 1617994"/>
                    <a:gd name="connsiteX40" fmla="*/ 442053 w 1706837"/>
                    <a:gd name="connsiteY40" fmla="*/ 508721 h 1617994"/>
                    <a:gd name="connsiteX41" fmla="*/ 598356 w 1706837"/>
                    <a:gd name="connsiteY41" fmla="*/ 347928 h 1617994"/>
                    <a:gd name="connsiteX42" fmla="*/ 705578 w 1706837"/>
                    <a:gd name="connsiteY42" fmla="*/ 146771 h 1617994"/>
                    <a:gd name="connsiteX43" fmla="*/ 591278 w 1706837"/>
                    <a:gd name="connsiteY43" fmla="*/ 3896 h 1617994"/>
                    <a:gd name="connsiteX44" fmla="*/ 276953 w 1706837"/>
                    <a:gd name="connsiteY44" fmla="*/ 51521 h 1617994"/>
                    <a:gd name="connsiteX45" fmla="*/ 19778 w 1706837"/>
                    <a:gd name="connsiteY45" fmla="*/ 168996 h 1617994"/>
                    <a:gd name="connsiteX46" fmla="*/ 41455 w 1706837"/>
                    <a:gd name="connsiteY46" fmla="*/ 229627 h 1617994"/>
                    <a:gd name="connsiteX47" fmla="*/ 59026 w 1706837"/>
                    <a:gd name="connsiteY47" fmla="*/ 275914 h 1617994"/>
                    <a:gd name="connsiteX0" fmla="*/ 34147 w 1681958"/>
                    <a:gd name="connsiteY0" fmla="*/ 293119 h 1635199"/>
                    <a:gd name="connsiteX1" fmla="*/ 169524 w 1681958"/>
                    <a:gd name="connsiteY1" fmla="*/ 202076 h 1635199"/>
                    <a:gd name="connsiteX2" fmla="*/ 540999 w 1681958"/>
                    <a:gd name="connsiteY2" fmla="*/ 103651 h 1635199"/>
                    <a:gd name="connsiteX3" fmla="*/ 509895 w 1681958"/>
                    <a:gd name="connsiteY3" fmla="*/ 264736 h 1635199"/>
                    <a:gd name="connsiteX4" fmla="*/ 298027 w 1681958"/>
                    <a:gd name="connsiteY4" fmla="*/ 492698 h 1635199"/>
                    <a:gd name="connsiteX5" fmla="*/ 245724 w 1681958"/>
                    <a:gd name="connsiteY5" fmla="*/ 678326 h 1635199"/>
                    <a:gd name="connsiteX6" fmla="*/ 448924 w 1681958"/>
                    <a:gd name="connsiteY6" fmla="*/ 710076 h 1635199"/>
                    <a:gd name="connsiteX7" fmla="*/ 721895 w 1681958"/>
                    <a:gd name="connsiteY7" fmla="*/ 561733 h 1635199"/>
                    <a:gd name="connsiteX8" fmla="*/ 927163 w 1681958"/>
                    <a:gd name="connsiteY8" fmla="*/ 508681 h 1635199"/>
                    <a:gd name="connsiteX9" fmla="*/ 960099 w 1681958"/>
                    <a:gd name="connsiteY9" fmla="*/ 668801 h 1635199"/>
                    <a:gd name="connsiteX10" fmla="*/ 740572 w 1681958"/>
                    <a:gd name="connsiteY10" fmla="*/ 826991 h 1635199"/>
                    <a:gd name="connsiteX11" fmla="*/ 642599 w 1681958"/>
                    <a:gd name="connsiteY11" fmla="*/ 986301 h 1635199"/>
                    <a:gd name="connsiteX12" fmla="*/ 754100 w 1681958"/>
                    <a:gd name="connsiteY12" fmla="*/ 1118580 h 1635199"/>
                    <a:gd name="connsiteX13" fmla="*/ 989705 w 1681958"/>
                    <a:gd name="connsiteY13" fmla="*/ 1002798 h 1635199"/>
                    <a:gd name="connsiteX14" fmla="*/ 1217274 w 1681958"/>
                    <a:gd name="connsiteY14" fmla="*/ 910101 h 1635199"/>
                    <a:gd name="connsiteX15" fmla="*/ 1356974 w 1681958"/>
                    <a:gd name="connsiteY15" fmla="*/ 1078376 h 1635199"/>
                    <a:gd name="connsiteX16" fmla="*/ 921999 w 1681958"/>
                    <a:gd name="connsiteY16" fmla="*/ 1376826 h 1635199"/>
                    <a:gd name="connsiteX17" fmla="*/ 1042649 w 1681958"/>
                    <a:gd name="connsiteY17" fmla="*/ 1545101 h 1635199"/>
                    <a:gd name="connsiteX18" fmla="*/ 1325224 w 1681958"/>
                    <a:gd name="connsiteY18" fmla="*/ 1513351 h 1635199"/>
                    <a:gd name="connsiteX19" fmla="*/ 1546742 w 1681958"/>
                    <a:gd name="connsiteY19" fmla="*/ 1631708 h 1635199"/>
                    <a:gd name="connsiteX20" fmla="*/ 1606893 w 1681958"/>
                    <a:gd name="connsiteY20" fmla="*/ 1598918 h 1635199"/>
                    <a:gd name="connsiteX21" fmla="*/ 1678178 w 1681958"/>
                    <a:gd name="connsiteY21" fmla="*/ 1548188 h 1635199"/>
                    <a:gd name="connsiteX22" fmla="*/ 1482660 w 1681958"/>
                    <a:gd name="connsiteY22" fmla="*/ 1426598 h 1635199"/>
                    <a:gd name="connsiteX23" fmla="*/ 1276788 w 1681958"/>
                    <a:gd name="connsiteY23" fmla="*/ 1388596 h 1635199"/>
                    <a:gd name="connsiteX24" fmla="*/ 1082500 w 1681958"/>
                    <a:gd name="connsiteY24" fmla="*/ 1418697 h 1635199"/>
                    <a:gd name="connsiteX25" fmla="*/ 1119192 w 1681958"/>
                    <a:gd name="connsiteY25" fmla="*/ 1357156 h 1635199"/>
                    <a:gd name="connsiteX26" fmla="*/ 1292584 w 1681958"/>
                    <a:gd name="connsiteY26" fmla="*/ 1238217 h 1635199"/>
                    <a:gd name="connsiteX27" fmla="*/ 1455399 w 1681958"/>
                    <a:gd name="connsiteY27" fmla="*/ 1081551 h 1635199"/>
                    <a:gd name="connsiteX28" fmla="*/ 1417299 w 1681958"/>
                    <a:gd name="connsiteY28" fmla="*/ 906926 h 1635199"/>
                    <a:gd name="connsiteX29" fmla="*/ 1198224 w 1681958"/>
                    <a:gd name="connsiteY29" fmla="*/ 814851 h 1635199"/>
                    <a:gd name="connsiteX30" fmla="*/ 972799 w 1681958"/>
                    <a:gd name="connsiteY30" fmla="*/ 884701 h 1635199"/>
                    <a:gd name="connsiteX31" fmla="*/ 785394 w 1681958"/>
                    <a:gd name="connsiteY31" fmla="*/ 998219 h 1635199"/>
                    <a:gd name="connsiteX32" fmla="*/ 782299 w 1681958"/>
                    <a:gd name="connsiteY32" fmla="*/ 910101 h 1635199"/>
                    <a:gd name="connsiteX33" fmla="*/ 1045824 w 1681958"/>
                    <a:gd name="connsiteY33" fmla="*/ 729126 h 1635199"/>
                    <a:gd name="connsiteX34" fmla="*/ 1055349 w 1681958"/>
                    <a:gd name="connsiteY34" fmla="*/ 522751 h 1635199"/>
                    <a:gd name="connsiteX35" fmla="*/ 896599 w 1681958"/>
                    <a:gd name="connsiteY35" fmla="*/ 386226 h 1635199"/>
                    <a:gd name="connsiteX36" fmla="*/ 719554 w 1681958"/>
                    <a:gd name="connsiteY36" fmla="*/ 438876 h 1635199"/>
                    <a:gd name="connsiteX37" fmla="*/ 471149 w 1681958"/>
                    <a:gd name="connsiteY37" fmla="*/ 589426 h 1635199"/>
                    <a:gd name="connsiteX38" fmla="*/ 385424 w 1681958"/>
                    <a:gd name="connsiteY38" fmla="*/ 589426 h 1635199"/>
                    <a:gd name="connsiteX39" fmla="*/ 379074 w 1681958"/>
                    <a:gd name="connsiteY39" fmla="*/ 567201 h 1635199"/>
                    <a:gd name="connsiteX40" fmla="*/ 417174 w 1681958"/>
                    <a:gd name="connsiteY40" fmla="*/ 525926 h 1635199"/>
                    <a:gd name="connsiteX41" fmla="*/ 573477 w 1681958"/>
                    <a:gd name="connsiteY41" fmla="*/ 365133 h 1635199"/>
                    <a:gd name="connsiteX42" fmla="*/ 680699 w 1681958"/>
                    <a:gd name="connsiteY42" fmla="*/ 163976 h 1635199"/>
                    <a:gd name="connsiteX43" fmla="*/ 566399 w 1681958"/>
                    <a:gd name="connsiteY43" fmla="*/ 21101 h 1635199"/>
                    <a:gd name="connsiteX44" fmla="*/ 252074 w 1681958"/>
                    <a:gd name="connsiteY44" fmla="*/ 68726 h 1635199"/>
                    <a:gd name="connsiteX45" fmla="*/ 26521 w 1681958"/>
                    <a:gd name="connsiteY45" fmla="*/ 7982 h 1635199"/>
                    <a:gd name="connsiteX46" fmla="*/ 16576 w 1681958"/>
                    <a:gd name="connsiteY46" fmla="*/ 246832 h 1635199"/>
                    <a:gd name="connsiteX47" fmla="*/ 34147 w 1681958"/>
                    <a:gd name="connsiteY47" fmla="*/ 293119 h 1635199"/>
                    <a:gd name="connsiteX0" fmla="*/ 48739 w 1696550"/>
                    <a:gd name="connsiteY0" fmla="*/ 293119 h 1635199"/>
                    <a:gd name="connsiteX1" fmla="*/ 184116 w 1696550"/>
                    <a:gd name="connsiteY1" fmla="*/ 202076 h 1635199"/>
                    <a:gd name="connsiteX2" fmla="*/ 555591 w 1696550"/>
                    <a:gd name="connsiteY2" fmla="*/ 103651 h 1635199"/>
                    <a:gd name="connsiteX3" fmla="*/ 524487 w 1696550"/>
                    <a:gd name="connsiteY3" fmla="*/ 264736 h 1635199"/>
                    <a:gd name="connsiteX4" fmla="*/ 312619 w 1696550"/>
                    <a:gd name="connsiteY4" fmla="*/ 492698 h 1635199"/>
                    <a:gd name="connsiteX5" fmla="*/ 260316 w 1696550"/>
                    <a:gd name="connsiteY5" fmla="*/ 678326 h 1635199"/>
                    <a:gd name="connsiteX6" fmla="*/ 463516 w 1696550"/>
                    <a:gd name="connsiteY6" fmla="*/ 710076 h 1635199"/>
                    <a:gd name="connsiteX7" fmla="*/ 736487 w 1696550"/>
                    <a:gd name="connsiteY7" fmla="*/ 561733 h 1635199"/>
                    <a:gd name="connsiteX8" fmla="*/ 941755 w 1696550"/>
                    <a:gd name="connsiteY8" fmla="*/ 508681 h 1635199"/>
                    <a:gd name="connsiteX9" fmla="*/ 974691 w 1696550"/>
                    <a:gd name="connsiteY9" fmla="*/ 668801 h 1635199"/>
                    <a:gd name="connsiteX10" fmla="*/ 755164 w 1696550"/>
                    <a:gd name="connsiteY10" fmla="*/ 826991 h 1635199"/>
                    <a:gd name="connsiteX11" fmla="*/ 657191 w 1696550"/>
                    <a:gd name="connsiteY11" fmla="*/ 986301 h 1635199"/>
                    <a:gd name="connsiteX12" fmla="*/ 768692 w 1696550"/>
                    <a:gd name="connsiteY12" fmla="*/ 1118580 h 1635199"/>
                    <a:gd name="connsiteX13" fmla="*/ 1004297 w 1696550"/>
                    <a:gd name="connsiteY13" fmla="*/ 1002798 h 1635199"/>
                    <a:gd name="connsiteX14" fmla="*/ 1231866 w 1696550"/>
                    <a:gd name="connsiteY14" fmla="*/ 910101 h 1635199"/>
                    <a:gd name="connsiteX15" fmla="*/ 1371566 w 1696550"/>
                    <a:gd name="connsiteY15" fmla="*/ 1078376 h 1635199"/>
                    <a:gd name="connsiteX16" fmla="*/ 936591 w 1696550"/>
                    <a:gd name="connsiteY16" fmla="*/ 1376826 h 1635199"/>
                    <a:gd name="connsiteX17" fmla="*/ 1057241 w 1696550"/>
                    <a:gd name="connsiteY17" fmla="*/ 1545101 h 1635199"/>
                    <a:gd name="connsiteX18" fmla="*/ 1339816 w 1696550"/>
                    <a:gd name="connsiteY18" fmla="*/ 1513351 h 1635199"/>
                    <a:gd name="connsiteX19" fmla="*/ 1561334 w 1696550"/>
                    <a:gd name="connsiteY19" fmla="*/ 1631708 h 1635199"/>
                    <a:gd name="connsiteX20" fmla="*/ 1621485 w 1696550"/>
                    <a:gd name="connsiteY20" fmla="*/ 1598918 h 1635199"/>
                    <a:gd name="connsiteX21" fmla="*/ 1692770 w 1696550"/>
                    <a:gd name="connsiteY21" fmla="*/ 1548188 h 1635199"/>
                    <a:gd name="connsiteX22" fmla="*/ 1497252 w 1696550"/>
                    <a:gd name="connsiteY22" fmla="*/ 1426598 h 1635199"/>
                    <a:gd name="connsiteX23" fmla="*/ 1291380 w 1696550"/>
                    <a:gd name="connsiteY23" fmla="*/ 1388596 h 1635199"/>
                    <a:gd name="connsiteX24" fmla="*/ 1097092 w 1696550"/>
                    <a:gd name="connsiteY24" fmla="*/ 1418697 h 1635199"/>
                    <a:gd name="connsiteX25" fmla="*/ 1133784 w 1696550"/>
                    <a:gd name="connsiteY25" fmla="*/ 1357156 h 1635199"/>
                    <a:gd name="connsiteX26" fmla="*/ 1307176 w 1696550"/>
                    <a:gd name="connsiteY26" fmla="*/ 1238217 h 1635199"/>
                    <a:gd name="connsiteX27" fmla="*/ 1469991 w 1696550"/>
                    <a:gd name="connsiteY27" fmla="*/ 1081551 h 1635199"/>
                    <a:gd name="connsiteX28" fmla="*/ 1431891 w 1696550"/>
                    <a:gd name="connsiteY28" fmla="*/ 906926 h 1635199"/>
                    <a:gd name="connsiteX29" fmla="*/ 1212816 w 1696550"/>
                    <a:gd name="connsiteY29" fmla="*/ 814851 h 1635199"/>
                    <a:gd name="connsiteX30" fmla="*/ 987391 w 1696550"/>
                    <a:gd name="connsiteY30" fmla="*/ 884701 h 1635199"/>
                    <a:gd name="connsiteX31" fmla="*/ 799986 w 1696550"/>
                    <a:gd name="connsiteY31" fmla="*/ 998219 h 1635199"/>
                    <a:gd name="connsiteX32" fmla="*/ 796891 w 1696550"/>
                    <a:gd name="connsiteY32" fmla="*/ 910101 h 1635199"/>
                    <a:gd name="connsiteX33" fmla="*/ 1060416 w 1696550"/>
                    <a:gd name="connsiteY33" fmla="*/ 729126 h 1635199"/>
                    <a:gd name="connsiteX34" fmla="*/ 1069941 w 1696550"/>
                    <a:gd name="connsiteY34" fmla="*/ 522751 h 1635199"/>
                    <a:gd name="connsiteX35" fmla="*/ 911191 w 1696550"/>
                    <a:gd name="connsiteY35" fmla="*/ 386226 h 1635199"/>
                    <a:gd name="connsiteX36" fmla="*/ 734146 w 1696550"/>
                    <a:gd name="connsiteY36" fmla="*/ 438876 h 1635199"/>
                    <a:gd name="connsiteX37" fmla="*/ 485741 w 1696550"/>
                    <a:gd name="connsiteY37" fmla="*/ 589426 h 1635199"/>
                    <a:gd name="connsiteX38" fmla="*/ 400016 w 1696550"/>
                    <a:gd name="connsiteY38" fmla="*/ 589426 h 1635199"/>
                    <a:gd name="connsiteX39" fmla="*/ 393666 w 1696550"/>
                    <a:gd name="connsiteY39" fmla="*/ 567201 h 1635199"/>
                    <a:gd name="connsiteX40" fmla="*/ 431766 w 1696550"/>
                    <a:gd name="connsiteY40" fmla="*/ 525926 h 1635199"/>
                    <a:gd name="connsiteX41" fmla="*/ 588069 w 1696550"/>
                    <a:gd name="connsiteY41" fmla="*/ 365133 h 1635199"/>
                    <a:gd name="connsiteX42" fmla="*/ 695291 w 1696550"/>
                    <a:gd name="connsiteY42" fmla="*/ 163976 h 1635199"/>
                    <a:gd name="connsiteX43" fmla="*/ 580991 w 1696550"/>
                    <a:gd name="connsiteY43" fmla="*/ 21101 h 1635199"/>
                    <a:gd name="connsiteX44" fmla="*/ 266666 w 1696550"/>
                    <a:gd name="connsiteY44" fmla="*/ 68726 h 1635199"/>
                    <a:gd name="connsiteX45" fmla="*/ 41113 w 1696550"/>
                    <a:gd name="connsiteY45" fmla="*/ 7982 h 1635199"/>
                    <a:gd name="connsiteX46" fmla="*/ 2090 w 1696550"/>
                    <a:gd name="connsiteY46" fmla="*/ 85558 h 1635199"/>
                    <a:gd name="connsiteX47" fmla="*/ 48739 w 1696550"/>
                    <a:gd name="connsiteY47" fmla="*/ 293119 h 1635199"/>
                    <a:gd name="connsiteX0" fmla="*/ 80119 w 1698714"/>
                    <a:gd name="connsiteY0" fmla="*/ 134836 h 1635199"/>
                    <a:gd name="connsiteX1" fmla="*/ 186280 w 1698714"/>
                    <a:gd name="connsiteY1" fmla="*/ 202076 h 1635199"/>
                    <a:gd name="connsiteX2" fmla="*/ 557755 w 1698714"/>
                    <a:gd name="connsiteY2" fmla="*/ 103651 h 1635199"/>
                    <a:gd name="connsiteX3" fmla="*/ 526651 w 1698714"/>
                    <a:gd name="connsiteY3" fmla="*/ 264736 h 1635199"/>
                    <a:gd name="connsiteX4" fmla="*/ 314783 w 1698714"/>
                    <a:gd name="connsiteY4" fmla="*/ 492698 h 1635199"/>
                    <a:gd name="connsiteX5" fmla="*/ 262480 w 1698714"/>
                    <a:gd name="connsiteY5" fmla="*/ 678326 h 1635199"/>
                    <a:gd name="connsiteX6" fmla="*/ 465680 w 1698714"/>
                    <a:gd name="connsiteY6" fmla="*/ 710076 h 1635199"/>
                    <a:gd name="connsiteX7" fmla="*/ 738651 w 1698714"/>
                    <a:gd name="connsiteY7" fmla="*/ 561733 h 1635199"/>
                    <a:gd name="connsiteX8" fmla="*/ 943919 w 1698714"/>
                    <a:gd name="connsiteY8" fmla="*/ 508681 h 1635199"/>
                    <a:gd name="connsiteX9" fmla="*/ 976855 w 1698714"/>
                    <a:gd name="connsiteY9" fmla="*/ 668801 h 1635199"/>
                    <a:gd name="connsiteX10" fmla="*/ 757328 w 1698714"/>
                    <a:gd name="connsiteY10" fmla="*/ 826991 h 1635199"/>
                    <a:gd name="connsiteX11" fmla="*/ 659355 w 1698714"/>
                    <a:gd name="connsiteY11" fmla="*/ 986301 h 1635199"/>
                    <a:gd name="connsiteX12" fmla="*/ 770856 w 1698714"/>
                    <a:gd name="connsiteY12" fmla="*/ 1118580 h 1635199"/>
                    <a:gd name="connsiteX13" fmla="*/ 1006461 w 1698714"/>
                    <a:gd name="connsiteY13" fmla="*/ 1002798 h 1635199"/>
                    <a:gd name="connsiteX14" fmla="*/ 1234030 w 1698714"/>
                    <a:gd name="connsiteY14" fmla="*/ 910101 h 1635199"/>
                    <a:gd name="connsiteX15" fmla="*/ 1373730 w 1698714"/>
                    <a:gd name="connsiteY15" fmla="*/ 1078376 h 1635199"/>
                    <a:gd name="connsiteX16" fmla="*/ 938755 w 1698714"/>
                    <a:gd name="connsiteY16" fmla="*/ 1376826 h 1635199"/>
                    <a:gd name="connsiteX17" fmla="*/ 1059405 w 1698714"/>
                    <a:gd name="connsiteY17" fmla="*/ 1545101 h 1635199"/>
                    <a:gd name="connsiteX18" fmla="*/ 1341980 w 1698714"/>
                    <a:gd name="connsiteY18" fmla="*/ 1513351 h 1635199"/>
                    <a:gd name="connsiteX19" fmla="*/ 1563498 w 1698714"/>
                    <a:gd name="connsiteY19" fmla="*/ 1631708 h 1635199"/>
                    <a:gd name="connsiteX20" fmla="*/ 1623649 w 1698714"/>
                    <a:gd name="connsiteY20" fmla="*/ 1598918 h 1635199"/>
                    <a:gd name="connsiteX21" fmla="*/ 1694934 w 1698714"/>
                    <a:gd name="connsiteY21" fmla="*/ 1548188 h 1635199"/>
                    <a:gd name="connsiteX22" fmla="*/ 1499416 w 1698714"/>
                    <a:gd name="connsiteY22" fmla="*/ 1426598 h 1635199"/>
                    <a:gd name="connsiteX23" fmla="*/ 1293544 w 1698714"/>
                    <a:gd name="connsiteY23" fmla="*/ 1388596 h 1635199"/>
                    <a:gd name="connsiteX24" fmla="*/ 1099256 w 1698714"/>
                    <a:gd name="connsiteY24" fmla="*/ 1418697 h 1635199"/>
                    <a:gd name="connsiteX25" fmla="*/ 1135948 w 1698714"/>
                    <a:gd name="connsiteY25" fmla="*/ 1357156 h 1635199"/>
                    <a:gd name="connsiteX26" fmla="*/ 1309340 w 1698714"/>
                    <a:gd name="connsiteY26" fmla="*/ 1238217 h 1635199"/>
                    <a:gd name="connsiteX27" fmla="*/ 1472155 w 1698714"/>
                    <a:gd name="connsiteY27" fmla="*/ 1081551 h 1635199"/>
                    <a:gd name="connsiteX28" fmla="*/ 1434055 w 1698714"/>
                    <a:gd name="connsiteY28" fmla="*/ 906926 h 1635199"/>
                    <a:gd name="connsiteX29" fmla="*/ 1214980 w 1698714"/>
                    <a:gd name="connsiteY29" fmla="*/ 814851 h 1635199"/>
                    <a:gd name="connsiteX30" fmla="*/ 989555 w 1698714"/>
                    <a:gd name="connsiteY30" fmla="*/ 884701 h 1635199"/>
                    <a:gd name="connsiteX31" fmla="*/ 802150 w 1698714"/>
                    <a:gd name="connsiteY31" fmla="*/ 998219 h 1635199"/>
                    <a:gd name="connsiteX32" fmla="*/ 799055 w 1698714"/>
                    <a:gd name="connsiteY32" fmla="*/ 910101 h 1635199"/>
                    <a:gd name="connsiteX33" fmla="*/ 1062580 w 1698714"/>
                    <a:gd name="connsiteY33" fmla="*/ 729126 h 1635199"/>
                    <a:gd name="connsiteX34" fmla="*/ 1072105 w 1698714"/>
                    <a:gd name="connsiteY34" fmla="*/ 522751 h 1635199"/>
                    <a:gd name="connsiteX35" fmla="*/ 913355 w 1698714"/>
                    <a:gd name="connsiteY35" fmla="*/ 386226 h 1635199"/>
                    <a:gd name="connsiteX36" fmla="*/ 736310 w 1698714"/>
                    <a:gd name="connsiteY36" fmla="*/ 438876 h 1635199"/>
                    <a:gd name="connsiteX37" fmla="*/ 487905 w 1698714"/>
                    <a:gd name="connsiteY37" fmla="*/ 589426 h 1635199"/>
                    <a:gd name="connsiteX38" fmla="*/ 402180 w 1698714"/>
                    <a:gd name="connsiteY38" fmla="*/ 589426 h 1635199"/>
                    <a:gd name="connsiteX39" fmla="*/ 395830 w 1698714"/>
                    <a:gd name="connsiteY39" fmla="*/ 567201 h 1635199"/>
                    <a:gd name="connsiteX40" fmla="*/ 433930 w 1698714"/>
                    <a:gd name="connsiteY40" fmla="*/ 525926 h 1635199"/>
                    <a:gd name="connsiteX41" fmla="*/ 590233 w 1698714"/>
                    <a:gd name="connsiteY41" fmla="*/ 365133 h 1635199"/>
                    <a:gd name="connsiteX42" fmla="*/ 697455 w 1698714"/>
                    <a:gd name="connsiteY42" fmla="*/ 163976 h 1635199"/>
                    <a:gd name="connsiteX43" fmla="*/ 583155 w 1698714"/>
                    <a:gd name="connsiteY43" fmla="*/ 21101 h 1635199"/>
                    <a:gd name="connsiteX44" fmla="*/ 268830 w 1698714"/>
                    <a:gd name="connsiteY44" fmla="*/ 68726 h 1635199"/>
                    <a:gd name="connsiteX45" fmla="*/ 43277 w 1698714"/>
                    <a:gd name="connsiteY45" fmla="*/ 7982 h 1635199"/>
                    <a:gd name="connsiteX46" fmla="*/ 4254 w 1698714"/>
                    <a:gd name="connsiteY46" fmla="*/ 85558 h 1635199"/>
                    <a:gd name="connsiteX47" fmla="*/ 80119 w 1698714"/>
                    <a:gd name="connsiteY47" fmla="*/ 134836 h 1635199"/>
                    <a:gd name="connsiteX0" fmla="*/ 76378 w 1694973"/>
                    <a:gd name="connsiteY0" fmla="*/ 185407 h 1685770"/>
                    <a:gd name="connsiteX1" fmla="*/ 182539 w 1694973"/>
                    <a:gd name="connsiteY1" fmla="*/ 252647 h 1685770"/>
                    <a:gd name="connsiteX2" fmla="*/ 554014 w 1694973"/>
                    <a:gd name="connsiteY2" fmla="*/ 154222 h 1685770"/>
                    <a:gd name="connsiteX3" fmla="*/ 522910 w 1694973"/>
                    <a:gd name="connsiteY3" fmla="*/ 315307 h 1685770"/>
                    <a:gd name="connsiteX4" fmla="*/ 311042 w 1694973"/>
                    <a:gd name="connsiteY4" fmla="*/ 543269 h 1685770"/>
                    <a:gd name="connsiteX5" fmla="*/ 258739 w 1694973"/>
                    <a:gd name="connsiteY5" fmla="*/ 728897 h 1685770"/>
                    <a:gd name="connsiteX6" fmla="*/ 461939 w 1694973"/>
                    <a:gd name="connsiteY6" fmla="*/ 760647 h 1685770"/>
                    <a:gd name="connsiteX7" fmla="*/ 734910 w 1694973"/>
                    <a:gd name="connsiteY7" fmla="*/ 612304 h 1685770"/>
                    <a:gd name="connsiteX8" fmla="*/ 940178 w 1694973"/>
                    <a:gd name="connsiteY8" fmla="*/ 559252 h 1685770"/>
                    <a:gd name="connsiteX9" fmla="*/ 973114 w 1694973"/>
                    <a:gd name="connsiteY9" fmla="*/ 719372 h 1685770"/>
                    <a:gd name="connsiteX10" fmla="*/ 753587 w 1694973"/>
                    <a:gd name="connsiteY10" fmla="*/ 877562 h 1685770"/>
                    <a:gd name="connsiteX11" fmla="*/ 655614 w 1694973"/>
                    <a:gd name="connsiteY11" fmla="*/ 1036872 h 1685770"/>
                    <a:gd name="connsiteX12" fmla="*/ 767115 w 1694973"/>
                    <a:gd name="connsiteY12" fmla="*/ 1169151 h 1685770"/>
                    <a:gd name="connsiteX13" fmla="*/ 1002720 w 1694973"/>
                    <a:gd name="connsiteY13" fmla="*/ 1053369 h 1685770"/>
                    <a:gd name="connsiteX14" fmla="*/ 1230289 w 1694973"/>
                    <a:gd name="connsiteY14" fmla="*/ 960672 h 1685770"/>
                    <a:gd name="connsiteX15" fmla="*/ 1369989 w 1694973"/>
                    <a:gd name="connsiteY15" fmla="*/ 1128947 h 1685770"/>
                    <a:gd name="connsiteX16" fmla="*/ 935014 w 1694973"/>
                    <a:gd name="connsiteY16" fmla="*/ 1427397 h 1685770"/>
                    <a:gd name="connsiteX17" fmla="*/ 1055664 w 1694973"/>
                    <a:gd name="connsiteY17" fmla="*/ 1595672 h 1685770"/>
                    <a:gd name="connsiteX18" fmla="*/ 1338239 w 1694973"/>
                    <a:gd name="connsiteY18" fmla="*/ 1563922 h 1685770"/>
                    <a:gd name="connsiteX19" fmla="*/ 1559757 w 1694973"/>
                    <a:gd name="connsiteY19" fmla="*/ 1682279 h 1685770"/>
                    <a:gd name="connsiteX20" fmla="*/ 1619908 w 1694973"/>
                    <a:gd name="connsiteY20" fmla="*/ 1649489 h 1685770"/>
                    <a:gd name="connsiteX21" fmla="*/ 1691193 w 1694973"/>
                    <a:gd name="connsiteY21" fmla="*/ 1598759 h 1685770"/>
                    <a:gd name="connsiteX22" fmla="*/ 1495675 w 1694973"/>
                    <a:gd name="connsiteY22" fmla="*/ 1477169 h 1685770"/>
                    <a:gd name="connsiteX23" fmla="*/ 1289803 w 1694973"/>
                    <a:gd name="connsiteY23" fmla="*/ 1439167 h 1685770"/>
                    <a:gd name="connsiteX24" fmla="*/ 1095515 w 1694973"/>
                    <a:gd name="connsiteY24" fmla="*/ 1469268 h 1685770"/>
                    <a:gd name="connsiteX25" fmla="*/ 1132207 w 1694973"/>
                    <a:gd name="connsiteY25" fmla="*/ 1407727 h 1685770"/>
                    <a:gd name="connsiteX26" fmla="*/ 1305599 w 1694973"/>
                    <a:gd name="connsiteY26" fmla="*/ 1288788 h 1685770"/>
                    <a:gd name="connsiteX27" fmla="*/ 1468414 w 1694973"/>
                    <a:gd name="connsiteY27" fmla="*/ 1132122 h 1685770"/>
                    <a:gd name="connsiteX28" fmla="*/ 1430314 w 1694973"/>
                    <a:gd name="connsiteY28" fmla="*/ 957497 h 1685770"/>
                    <a:gd name="connsiteX29" fmla="*/ 1211239 w 1694973"/>
                    <a:gd name="connsiteY29" fmla="*/ 865422 h 1685770"/>
                    <a:gd name="connsiteX30" fmla="*/ 985814 w 1694973"/>
                    <a:gd name="connsiteY30" fmla="*/ 935272 h 1685770"/>
                    <a:gd name="connsiteX31" fmla="*/ 798409 w 1694973"/>
                    <a:gd name="connsiteY31" fmla="*/ 1048790 h 1685770"/>
                    <a:gd name="connsiteX32" fmla="*/ 795314 w 1694973"/>
                    <a:gd name="connsiteY32" fmla="*/ 960672 h 1685770"/>
                    <a:gd name="connsiteX33" fmla="*/ 1058839 w 1694973"/>
                    <a:gd name="connsiteY33" fmla="*/ 779697 h 1685770"/>
                    <a:gd name="connsiteX34" fmla="*/ 1068364 w 1694973"/>
                    <a:gd name="connsiteY34" fmla="*/ 573322 h 1685770"/>
                    <a:gd name="connsiteX35" fmla="*/ 909614 w 1694973"/>
                    <a:gd name="connsiteY35" fmla="*/ 436797 h 1685770"/>
                    <a:gd name="connsiteX36" fmla="*/ 732569 w 1694973"/>
                    <a:gd name="connsiteY36" fmla="*/ 489447 h 1685770"/>
                    <a:gd name="connsiteX37" fmla="*/ 484164 w 1694973"/>
                    <a:gd name="connsiteY37" fmla="*/ 639997 h 1685770"/>
                    <a:gd name="connsiteX38" fmla="*/ 398439 w 1694973"/>
                    <a:gd name="connsiteY38" fmla="*/ 639997 h 1685770"/>
                    <a:gd name="connsiteX39" fmla="*/ 392089 w 1694973"/>
                    <a:gd name="connsiteY39" fmla="*/ 617772 h 1685770"/>
                    <a:gd name="connsiteX40" fmla="*/ 430189 w 1694973"/>
                    <a:gd name="connsiteY40" fmla="*/ 576497 h 1685770"/>
                    <a:gd name="connsiteX41" fmla="*/ 586492 w 1694973"/>
                    <a:gd name="connsiteY41" fmla="*/ 415704 h 1685770"/>
                    <a:gd name="connsiteX42" fmla="*/ 693714 w 1694973"/>
                    <a:gd name="connsiteY42" fmla="*/ 214547 h 1685770"/>
                    <a:gd name="connsiteX43" fmla="*/ 579414 w 1694973"/>
                    <a:gd name="connsiteY43" fmla="*/ 71672 h 1685770"/>
                    <a:gd name="connsiteX44" fmla="*/ 265089 w 1694973"/>
                    <a:gd name="connsiteY44" fmla="*/ 119297 h 1685770"/>
                    <a:gd name="connsiteX45" fmla="*/ 113659 w 1694973"/>
                    <a:gd name="connsiteY45" fmla="*/ 5809 h 1685770"/>
                    <a:gd name="connsiteX46" fmla="*/ 513 w 1694973"/>
                    <a:gd name="connsiteY46" fmla="*/ 136129 h 1685770"/>
                    <a:gd name="connsiteX47" fmla="*/ 76378 w 1694973"/>
                    <a:gd name="connsiteY47" fmla="*/ 185407 h 1685770"/>
                    <a:gd name="connsiteX0" fmla="*/ 20570 w 1639165"/>
                    <a:gd name="connsiteY0" fmla="*/ 185407 h 1685770"/>
                    <a:gd name="connsiteX1" fmla="*/ 126731 w 1639165"/>
                    <a:gd name="connsiteY1" fmla="*/ 252647 h 1685770"/>
                    <a:gd name="connsiteX2" fmla="*/ 498206 w 1639165"/>
                    <a:gd name="connsiteY2" fmla="*/ 154222 h 1685770"/>
                    <a:gd name="connsiteX3" fmla="*/ 467102 w 1639165"/>
                    <a:gd name="connsiteY3" fmla="*/ 315307 h 1685770"/>
                    <a:gd name="connsiteX4" fmla="*/ 255234 w 1639165"/>
                    <a:gd name="connsiteY4" fmla="*/ 543269 h 1685770"/>
                    <a:gd name="connsiteX5" fmla="*/ 202931 w 1639165"/>
                    <a:gd name="connsiteY5" fmla="*/ 728897 h 1685770"/>
                    <a:gd name="connsiteX6" fmla="*/ 406131 w 1639165"/>
                    <a:gd name="connsiteY6" fmla="*/ 760647 h 1685770"/>
                    <a:gd name="connsiteX7" fmla="*/ 679102 w 1639165"/>
                    <a:gd name="connsiteY7" fmla="*/ 612304 h 1685770"/>
                    <a:gd name="connsiteX8" fmla="*/ 884370 w 1639165"/>
                    <a:gd name="connsiteY8" fmla="*/ 559252 h 1685770"/>
                    <a:gd name="connsiteX9" fmla="*/ 917306 w 1639165"/>
                    <a:gd name="connsiteY9" fmla="*/ 719372 h 1685770"/>
                    <a:gd name="connsiteX10" fmla="*/ 697779 w 1639165"/>
                    <a:gd name="connsiteY10" fmla="*/ 877562 h 1685770"/>
                    <a:gd name="connsiteX11" fmla="*/ 599806 w 1639165"/>
                    <a:gd name="connsiteY11" fmla="*/ 1036872 h 1685770"/>
                    <a:gd name="connsiteX12" fmla="*/ 711307 w 1639165"/>
                    <a:gd name="connsiteY12" fmla="*/ 1169151 h 1685770"/>
                    <a:gd name="connsiteX13" fmla="*/ 946912 w 1639165"/>
                    <a:gd name="connsiteY13" fmla="*/ 1053369 h 1685770"/>
                    <a:gd name="connsiteX14" fmla="*/ 1174481 w 1639165"/>
                    <a:gd name="connsiteY14" fmla="*/ 960672 h 1685770"/>
                    <a:gd name="connsiteX15" fmla="*/ 1314181 w 1639165"/>
                    <a:gd name="connsiteY15" fmla="*/ 1128947 h 1685770"/>
                    <a:gd name="connsiteX16" fmla="*/ 879206 w 1639165"/>
                    <a:gd name="connsiteY16" fmla="*/ 1427397 h 1685770"/>
                    <a:gd name="connsiteX17" fmla="*/ 999856 w 1639165"/>
                    <a:gd name="connsiteY17" fmla="*/ 1595672 h 1685770"/>
                    <a:gd name="connsiteX18" fmla="*/ 1282431 w 1639165"/>
                    <a:gd name="connsiteY18" fmla="*/ 1563922 h 1685770"/>
                    <a:gd name="connsiteX19" fmla="*/ 1503949 w 1639165"/>
                    <a:gd name="connsiteY19" fmla="*/ 1682279 h 1685770"/>
                    <a:gd name="connsiteX20" fmla="*/ 1564100 w 1639165"/>
                    <a:gd name="connsiteY20" fmla="*/ 1649489 h 1685770"/>
                    <a:gd name="connsiteX21" fmla="*/ 1635385 w 1639165"/>
                    <a:gd name="connsiteY21" fmla="*/ 1598759 h 1685770"/>
                    <a:gd name="connsiteX22" fmla="*/ 1439867 w 1639165"/>
                    <a:gd name="connsiteY22" fmla="*/ 1477169 h 1685770"/>
                    <a:gd name="connsiteX23" fmla="*/ 1233995 w 1639165"/>
                    <a:gd name="connsiteY23" fmla="*/ 1439167 h 1685770"/>
                    <a:gd name="connsiteX24" fmla="*/ 1039707 w 1639165"/>
                    <a:gd name="connsiteY24" fmla="*/ 1469268 h 1685770"/>
                    <a:gd name="connsiteX25" fmla="*/ 1076399 w 1639165"/>
                    <a:gd name="connsiteY25" fmla="*/ 1407727 h 1685770"/>
                    <a:gd name="connsiteX26" fmla="*/ 1249791 w 1639165"/>
                    <a:gd name="connsiteY26" fmla="*/ 1288788 h 1685770"/>
                    <a:gd name="connsiteX27" fmla="*/ 1412606 w 1639165"/>
                    <a:gd name="connsiteY27" fmla="*/ 1132122 h 1685770"/>
                    <a:gd name="connsiteX28" fmla="*/ 1374506 w 1639165"/>
                    <a:gd name="connsiteY28" fmla="*/ 957497 h 1685770"/>
                    <a:gd name="connsiteX29" fmla="*/ 1155431 w 1639165"/>
                    <a:gd name="connsiteY29" fmla="*/ 865422 h 1685770"/>
                    <a:gd name="connsiteX30" fmla="*/ 930006 w 1639165"/>
                    <a:gd name="connsiteY30" fmla="*/ 935272 h 1685770"/>
                    <a:gd name="connsiteX31" fmla="*/ 742601 w 1639165"/>
                    <a:gd name="connsiteY31" fmla="*/ 1048790 h 1685770"/>
                    <a:gd name="connsiteX32" fmla="*/ 739506 w 1639165"/>
                    <a:gd name="connsiteY32" fmla="*/ 960672 h 1685770"/>
                    <a:gd name="connsiteX33" fmla="*/ 1003031 w 1639165"/>
                    <a:gd name="connsiteY33" fmla="*/ 779697 h 1685770"/>
                    <a:gd name="connsiteX34" fmla="*/ 1012556 w 1639165"/>
                    <a:gd name="connsiteY34" fmla="*/ 573322 h 1685770"/>
                    <a:gd name="connsiteX35" fmla="*/ 853806 w 1639165"/>
                    <a:gd name="connsiteY35" fmla="*/ 436797 h 1685770"/>
                    <a:gd name="connsiteX36" fmla="*/ 676761 w 1639165"/>
                    <a:gd name="connsiteY36" fmla="*/ 489447 h 1685770"/>
                    <a:gd name="connsiteX37" fmla="*/ 428356 w 1639165"/>
                    <a:gd name="connsiteY37" fmla="*/ 639997 h 1685770"/>
                    <a:gd name="connsiteX38" fmla="*/ 342631 w 1639165"/>
                    <a:gd name="connsiteY38" fmla="*/ 639997 h 1685770"/>
                    <a:gd name="connsiteX39" fmla="*/ 336281 w 1639165"/>
                    <a:gd name="connsiteY39" fmla="*/ 617772 h 1685770"/>
                    <a:gd name="connsiteX40" fmla="*/ 374381 w 1639165"/>
                    <a:gd name="connsiteY40" fmla="*/ 576497 h 1685770"/>
                    <a:gd name="connsiteX41" fmla="*/ 530684 w 1639165"/>
                    <a:gd name="connsiteY41" fmla="*/ 415704 h 1685770"/>
                    <a:gd name="connsiteX42" fmla="*/ 637906 w 1639165"/>
                    <a:gd name="connsiteY42" fmla="*/ 214547 h 1685770"/>
                    <a:gd name="connsiteX43" fmla="*/ 523606 w 1639165"/>
                    <a:gd name="connsiteY43" fmla="*/ 71672 h 1685770"/>
                    <a:gd name="connsiteX44" fmla="*/ 209281 w 1639165"/>
                    <a:gd name="connsiteY44" fmla="*/ 119297 h 1685770"/>
                    <a:gd name="connsiteX45" fmla="*/ 57851 w 1639165"/>
                    <a:gd name="connsiteY45" fmla="*/ 5809 h 1685770"/>
                    <a:gd name="connsiteX46" fmla="*/ 2811 w 1639165"/>
                    <a:gd name="connsiteY46" fmla="*/ 65270 h 1685770"/>
                    <a:gd name="connsiteX47" fmla="*/ 20570 w 1639165"/>
                    <a:gd name="connsiteY47" fmla="*/ 185407 h 1685770"/>
                    <a:gd name="connsiteX0" fmla="*/ 57787 w 1636390"/>
                    <a:gd name="connsiteY0" fmla="*/ 130566 h 1685770"/>
                    <a:gd name="connsiteX1" fmla="*/ 123956 w 1636390"/>
                    <a:gd name="connsiteY1" fmla="*/ 252647 h 1685770"/>
                    <a:gd name="connsiteX2" fmla="*/ 495431 w 1636390"/>
                    <a:gd name="connsiteY2" fmla="*/ 154222 h 1685770"/>
                    <a:gd name="connsiteX3" fmla="*/ 464327 w 1636390"/>
                    <a:gd name="connsiteY3" fmla="*/ 315307 h 1685770"/>
                    <a:gd name="connsiteX4" fmla="*/ 252459 w 1636390"/>
                    <a:gd name="connsiteY4" fmla="*/ 543269 h 1685770"/>
                    <a:gd name="connsiteX5" fmla="*/ 200156 w 1636390"/>
                    <a:gd name="connsiteY5" fmla="*/ 728897 h 1685770"/>
                    <a:gd name="connsiteX6" fmla="*/ 403356 w 1636390"/>
                    <a:gd name="connsiteY6" fmla="*/ 760647 h 1685770"/>
                    <a:gd name="connsiteX7" fmla="*/ 676327 w 1636390"/>
                    <a:gd name="connsiteY7" fmla="*/ 612304 h 1685770"/>
                    <a:gd name="connsiteX8" fmla="*/ 881595 w 1636390"/>
                    <a:gd name="connsiteY8" fmla="*/ 559252 h 1685770"/>
                    <a:gd name="connsiteX9" fmla="*/ 914531 w 1636390"/>
                    <a:gd name="connsiteY9" fmla="*/ 719372 h 1685770"/>
                    <a:gd name="connsiteX10" fmla="*/ 695004 w 1636390"/>
                    <a:gd name="connsiteY10" fmla="*/ 877562 h 1685770"/>
                    <a:gd name="connsiteX11" fmla="*/ 597031 w 1636390"/>
                    <a:gd name="connsiteY11" fmla="*/ 1036872 h 1685770"/>
                    <a:gd name="connsiteX12" fmla="*/ 708532 w 1636390"/>
                    <a:gd name="connsiteY12" fmla="*/ 1169151 h 1685770"/>
                    <a:gd name="connsiteX13" fmla="*/ 944137 w 1636390"/>
                    <a:gd name="connsiteY13" fmla="*/ 1053369 h 1685770"/>
                    <a:gd name="connsiteX14" fmla="*/ 1171706 w 1636390"/>
                    <a:gd name="connsiteY14" fmla="*/ 960672 h 1685770"/>
                    <a:gd name="connsiteX15" fmla="*/ 1311406 w 1636390"/>
                    <a:gd name="connsiteY15" fmla="*/ 1128947 h 1685770"/>
                    <a:gd name="connsiteX16" fmla="*/ 876431 w 1636390"/>
                    <a:gd name="connsiteY16" fmla="*/ 1427397 h 1685770"/>
                    <a:gd name="connsiteX17" fmla="*/ 997081 w 1636390"/>
                    <a:gd name="connsiteY17" fmla="*/ 1595672 h 1685770"/>
                    <a:gd name="connsiteX18" fmla="*/ 1279656 w 1636390"/>
                    <a:gd name="connsiteY18" fmla="*/ 1563922 h 1685770"/>
                    <a:gd name="connsiteX19" fmla="*/ 1501174 w 1636390"/>
                    <a:gd name="connsiteY19" fmla="*/ 1682279 h 1685770"/>
                    <a:gd name="connsiteX20" fmla="*/ 1561325 w 1636390"/>
                    <a:gd name="connsiteY20" fmla="*/ 1649489 h 1685770"/>
                    <a:gd name="connsiteX21" fmla="*/ 1632610 w 1636390"/>
                    <a:gd name="connsiteY21" fmla="*/ 1598759 h 1685770"/>
                    <a:gd name="connsiteX22" fmla="*/ 1437092 w 1636390"/>
                    <a:gd name="connsiteY22" fmla="*/ 1477169 h 1685770"/>
                    <a:gd name="connsiteX23" fmla="*/ 1231220 w 1636390"/>
                    <a:gd name="connsiteY23" fmla="*/ 1439167 h 1685770"/>
                    <a:gd name="connsiteX24" fmla="*/ 1036932 w 1636390"/>
                    <a:gd name="connsiteY24" fmla="*/ 1469268 h 1685770"/>
                    <a:gd name="connsiteX25" fmla="*/ 1073624 w 1636390"/>
                    <a:gd name="connsiteY25" fmla="*/ 1407727 h 1685770"/>
                    <a:gd name="connsiteX26" fmla="*/ 1247016 w 1636390"/>
                    <a:gd name="connsiteY26" fmla="*/ 1288788 h 1685770"/>
                    <a:gd name="connsiteX27" fmla="*/ 1409831 w 1636390"/>
                    <a:gd name="connsiteY27" fmla="*/ 1132122 h 1685770"/>
                    <a:gd name="connsiteX28" fmla="*/ 1371731 w 1636390"/>
                    <a:gd name="connsiteY28" fmla="*/ 957497 h 1685770"/>
                    <a:gd name="connsiteX29" fmla="*/ 1152656 w 1636390"/>
                    <a:gd name="connsiteY29" fmla="*/ 865422 h 1685770"/>
                    <a:gd name="connsiteX30" fmla="*/ 927231 w 1636390"/>
                    <a:gd name="connsiteY30" fmla="*/ 935272 h 1685770"/>
                    <a:gd name="connsiteX31" fmla="*/ 739826 w 1636390"/>
                    <a:gd name="connsiteY31" fmla="*/ 1048790 h 1685770"/>
                    <a:gd name="connsiteX32" fmla="*/ 736731 w 1636390"/>
                    <a:gd name="connsiteY32" fmla="*/ 960672 h 1685770"/>
                    <a:gd name="connsiteX33" fmla="*/ 1000256 w 1636390"/>
                    <a:gd name="connsiteY33" fmla="*/ 779697 h 1685770"/>
                    <a:gd name="connsiteX34" fmla="*/ 1009781 w 1636390"/>
                    <a:gd name="connsiteY34" fmla="*/ 573322 h 1685770"/>
                    <a:gd name="connsiteX35" fmla="*/ 851031 w 1636390"/>
                    <a:gd name="connsiteY35" fmla="*/ 436797 h 1685770"/>
                    <a:gd name="connsiteX36" fmla="*/ 673986 w 1636390"/>
                    <a:gd name="connsiteY36" fmla="*/ 489447 h 1685770"/>
                    <a:gd name="connsiteX37" fmla="*/ 425581 w 1636390"/>
                    <a:gd name="connsiteY37" fmla="*/ 639997 h 1685770"/>
                    <a:gd name="connsiteX38" fmla="*/ 339856 w 1636390"/>
                    <a:gd name="connsiteY38" fmla="*/ 639997 h 1685770"/>
                    <a:gd name="connsiteX39" fmla="*/ 333506 w 1636390"/>
                    <a:gd name="connsiteY39" fmla="*/ 617772 h 1685770"/>
                    <a:gd name="connsiteX40" fmla="*/ 371606 w 1636390"/>
                    <a:gd name="connsiteY40" fmla="*/ 576497 h 1685770"/>
                    <a:gd name="connsiteX41" fmla="*/ 527909 w 1636390"/>
                    <a:gd name="connsiteY41" fmla="*/ 415704 h 1685770"/>
                    <a:gd name="connsiteX42" fmla="*/ 635131 w 1636390"/>
                    <a:gd name="connsiteY42" fmla="*/ 214547 h 1685770"/>
                    <a:gd name="connsiteX43" fmla="*/ 520831 w 1636390"/>
                    <a:gd name="connsiteY43" fmla="*/ 71672 h 1685770"/>
                    <a:gd name="connsiteX44" fmla="*/ 206506 w 1636390"/>
                    <a:gd name="connsiteY44" fmla="*/ 119297 h 1685770"/>
                    <a:gd name="connsiteX45" fmla="*/ 55076 w 1636390"/>
                    <a:gd name="connsiteY45" fmla="*/ 5809 h 1685770"/>
                    <a:gd name="connsiteX46" fmla="*/ 36 w 1636390"/>
                    <a:gd name="connsiteY46" fmla="*/ 65270 h 1685770"/>
                    <a:gd name="connsiteX47" fmla="*/ 57787 w 1636390"/>
                    <a:gd name="connsiteY47" fmla="*/ 130566 h 1685770"/>
                    <a:gd name="connsiteX0" fmla="*/ 57787 w 1636390"/>
                    <a:gd name="connsiteY0" fmla="*/ 130566 h 1685770"/>
                    <a:gd name="connsiteX1" fmla="*/ 182681 w 1636390"/>
                    <a:gd name="connsiteY1" fmla="*/ 210180 h 1685770"/>
                    <a:gd name="connsiteX2" fmla="*/ 495431 w 1636390"/>
                    <a:gd name="connsiteY2" fmla="*/ 154222 h 1685770"/>
                    <a:gd name="connsiteX3" fmla="*/ 464327 w 1636390"/>
                    <a:gd name="connsiteY3" fmla="*/ 315307 h 1685770"/>
                    <a:gd name="connsiteX4" fmla="*/ 252459 w 1636390"/>
                    <a:gd name="connsiteY4" fmla="*/ 543269 h 1685770"/>
                    <a:gd name="connsiteX5" fmla="*/ 200156 w 1636390"/>
                    <a:gd name="connsiteY5" fmla="*/ 728897 h 1685770"/>
                    <a:gd name="connsiteX6" fmla="*/ 403356 w 1636390"/>
                    <a:gd name="connsiteY6" fmla="*/ 760647 h 1685770"/>
                    <a:gd name="connsiteX7" fmla="*/ 676327 w 1636390"/>
                    <a:gd name="connsiteY7" fmla="*/ 612304 h 1685770"/>
                    <a:gd name="connsiteX8" fmla="*/ 881595 w 1636390"/>
                    <a:gd name="connsiteY8" fmla="*/ 559252 h 1685770"/>
                    <a:gd name="connsiteX9" fmla="*/ 914531 w 1636390"/>
                    <a:gd name="connsiteY9" fmla="*/ 719372 h 1685770"/>
                    <a:gd name="connsiteX10" fmla="*/ 695004 w 1636390"/>
                    <a:gd name="connsiteY10" fmla="*/ 877562 h 1685770"/>
                    <a:gd name="connsiteX11" fmla="*/ 597031 w 1636390"/>
                    <a:gd name="connsiteY11" fmla="*/ 1036872 h 1685770"/>
                    <a:gd name="connsiteX12" fmla="*/ 708532 w 1636390"/>
                    <a:gd name="connsiteY12" fmla="*/ 1169151 h 1685770"/>
                    <a:gd name="connsiteX13" fmla="*/ 944137 w 1636390"/>
                    <a:gd name="connsiteY13" fmla="*/ 1053369 h 1685770"/>
                    <a:gd name="connsiteX14" fmla="*/ 1171706 w 1636390"/>
                    <a:gd name="connsiteY14" fmla="*/ 960672 h 1685770"/>
                    <a:gd name="connsiteX15" fmla="*/ 1311406 w 1636390"/>
                    <a:gd name="connsiteY15" fmla="*/ 1128947 h 1685770"/>
                    <a:gd name="connsiteX16" fmla="*/ 876431 w 1636390"/>
                    <a:gd name="connsiteY16" fmla="*/ 1427397 h 1685770"/>
                    <a:gd name="connsiteX17" fmla="*/ 997081 w 1636390"/>
                    <a:gd name="connsiteY17" fmla="*/ 1595672 h 1685770"/>
                    <a:gd name="connsiteX18" fmla="*/ 1279656 w 1636390"/>
                    <a:gd name="connsiteY18" fmla="*/ 1563922 h 1685770"/>
                    <a:gd name="connsiteX19" fmla="*/ 1501174 w 1636390"/>
                    <a:gd name="connsiteY19" fmla="*/ 1682279 h 1685770"/>
                    <a:gd name="connsiteX20" fmla="*/ 1561325 w 1636390"/>
                    <a:gd name="connsiteY20" fmla="*/ 1649489 h 1685770"/>
                    <a:gd name="connsiteX21" fmla="*/ 1632610 w 1636390"/>
                    <a:gd name="connsiteY21" fmla="*/ 1598759 h 1685770"/>
                    <a:gd name="connsiteX22" fmla="*/ 1437092 w 1636390"/>
                    <a:gd name="connsiteY22" fmla="*/ 1477169 h 1685770"/>
                    <a:gd name="connsiteX23" fmla="*/ 1231220 w 1636390"/>
                    <a:gd name="connsiteY23" fmla="*/ 1439167 h 1685770"/>
                    <a:gd name="connsiteX24" fmla="*/ 1036932 w 1636390"/>
                    <a:gd name="connsiteY24" fmla="*/ 1469268 h 1685770"/>
                    <a:gd name="connsiteX25" fmla="*/ 1073624 w 1636390"/>
                    <a:gd name="connsiteY25" fmla="*/ 1407727 h 1685770"/>
                    <a:gd name="connsiteX26" fmla="*/ 1247016 w 1636390"/>
                    <a:gd name="connsiteY26" fmla="*/ 1288788 h 1685770"/>
                    <a:gd name="connsiteX27" fmla="*/ 1409831 w 1636390"/>
                    <a:gd name="connsiteY27" fmla="*/ 1132122 h 1685770"/>
                    <a:gd name="connsiteX28" fmla="*/ 1371731 w 1636390"/>
                    <a:gd name="connsiteY28" fmla="*/ 957497 h 1685770"/>
                    <a:gd name="connsiteX29" fmla="*/ 1152656 w 1636390"/>
                    <a:gd name="connsiteY29" fmla="*/ 865422 h 1685770"/>
                    <a:gd name="connsiteX30" fmla="*/ 927231 w 1636390"/>
                    <a:gd name="connsiteY30" fmla="*/ 935272 h 1685770"/>
                    <a:gd name="connsiteX31" fmla="*/ 739826 w 1636390"/>
                    <a:gd name="connsiteY31" fmla="*/ 1048790 h 1685770"/>
                    <a:gd name="connsiteX32" fmla="*/ 736731 w 1636390"/>
                    <a:gd name="connsiteY32" fmla="*/ 960672 h 1685770"/>
                    <a:gd name="connsiteX33" fmla="*/ 1000256 w 1636390"/>
                    <a:gd name="connsiteY33" fmla="*/ 779697 h 1685770"/>
                    <a:gd name="connsiteX34" fmla="*/ 1009781 w 1636390"/>
                    <a:gd name="connsiteY34" fmla="*/ 573322 h 1685770"/>
                    <a:gd name="connsiteX35" fmla="*/ 851031 w 1636390"/>
                    <a:gd name="connsiteY35" fmla="*/ 436797 h 1685770"/>
                    <a:gd name="connsiteX36" fmla="*/ 673986 w 1636390"/>
                    <a:gd name="connsiteY36" fmla="*/ 489447 h 1685770"/>
                    <a:gd name="connsiteX37" fmla="*/ 425581 w 1636390"/>
                    <a:gd name="connsiteY37" fmla="*/ 639997 h 1685770"/>
                    <a:gd name="connsiteX38" fmla="*/ 339856 w 1636390"/>
                    <a:gd name="connsiteY38" fmla="*/ 639997 h 1685770"/>
                    <a:gd name="connsiteX39" fmla="*/ 333506 w 1636390"/>
                    <a:gd name="connsiteY39" fmla="*/ 617772 h 1685770"/>
                    <a:gd name="connsiteX40" fmla="*/ 371606 w 1636390"/>
                    <a:gd name="connsiteY40" fmla="*/ 576497 h 1685770"/>
                    <a:gd name="connsiteX41" fmla="*/ 527909 w 1636390"/>
                    <a:gd name="connsiteY41" fmla="*/ 415704 h 1685770"/>
                    <a:gd name="connsiteX42" fmla="*/ 635131 w 1636390"/>
                    <a:gd name="connsiteY42" fmla="*/ 214547 h 1685770"/>
                    <a:gd name="connsiteX43" fmla="*/ 520831 w 1636390"/>
                    <a:gd name="connsiteY43" fmla="*/ 71672 h 1685770"/>
                    <a:gd name="connsiteX44" fmla="*/ 206506 w 1636390"/>
                    <a:gd name="connsiteY44" fmla="*/ 119297 h 1685770"/>
                    <a:gd name="connsiteX45" fmla="*/ 55076 w 1636390"/>
                    <a:gd name="connsiteY45" fmla="*/ 5809 h 1685770"/>
                    <a:gd name="connsiteX46" fmla="*/ 36 w 1636390"/>
                    <a:gd name="connsiteY46" fmla="*/ 65270 h 1685770"/>
                    <a:gd name="connsiteX47" fmla="*/ 57787 w 1636390"/>
                    <a:gd name="connsiteY47" fmla="*/ 130566 h 1685770"/>
                    <a:gd name="connsiteX0" fmla="*/ 57787 w 1636390"/>
                    <a:gd name="connsiteY0" fmla="*/ 130566 h 1685770"/>
                    <a:gd name="connsiteX1" fmla="*/ 182681 w 1636390"/>
                    <a:gd name="connsiteY1" fmla="*/ 210180 h 1685770"/>
                    <a:gd name="connsiteX2" fmla="*/ 495431 w 1636390"/>
                    <a:gd name="connsiteY2" fmla="*/ 154222 h 1685770"/>
                    <a:gd name="connsiteX3" fmla="*/ 464327 w 1636390"/>
                    <a:gd name="connsiteY3" fmla="*/ 315307 h 1685770"/>
                    <a:gd name="connsiteX4" fmla="*/ 252459 w 1636390"/>
                    <a:gd name="connsiteY4" fmla="*/ 543269 h 1685770"/>
                    <a:gd name="connsiteX5" fmla="*/ 200156 w 1636390"/>
                    <a:gd name="connsiteY5" fmla="*/ 728897 h 1685770"/>
                    <a:gd name="connsiteX6" fmla="*/ 403356 w 1636390"/>
                    <a:gd name="connsiteY6" fmla="*/ 760647 h 1685770"/>
                    <a:gd name="connsiteX7" fmla="*/ 676327 w 1636390"/>
                    <a:gd name="connsiteY7" fmla="*/ 612304 h 1685770"/>
                    <a:gd name="connsiteX8" fmla="*/ 881595 w 1636390"/>
                    <a:gd name="connsiteY8" fmla="*/ 559252 h 1685770"/>
                    <a:gd name="connsiteX9" fmla="*/ 914531 w 1636390"/>
                    <a:gd name="connsiteY9" fmla="*/ 719372 h 1685770"/>
                    <a:gd name="connsiteX10" fmla="*/ 695004 w 1636390"/>
                    <a:gd name="connsiteY10" fmla="*/ 877562 h 1685770"/>
                    <a:gd name="connsiteX11" fmla="*/ 597031 w 1636390"/>
                    <a:gd name="connsiteY11" fmla="*/ 1036872 h 1685770"/>
                    <a:gd name="connsiteX12" fmla="*/ 708532 w 1636390"/>
                    <a:gd name="connsiteY12" fmla="*/ 1169151 h 1685770"/>
                    <a:gd name="connsiteX13" fmla="*/ 944137 w 1636390"/>
                    <a:gd name="connsiteY13" fmla="*/ 1053369 h 1685770"/>
                    <a:gd name="connsiteX14" fmla="*/ 1171706 w 1636390"/>
                    <a:gd name="connsiteY14" fmla="*/ 960672 h 1685770"/>
                    <a:gd name="connsiteX15" fmla="*/ 1311406 w 1636390"/>
                    <a:gd name="connsiteY15" fmla="*/ 1128947 h 1685770"/>
                    <a:gd name="connsiteX16" fmla="*/ 876431 w 1636390"/>
                    <a:gd name="connsiteY16" fmla="*/ 1427397 h 1685770"/>
                    <a:gd name="connsiteX17" fmla="*/ 1039203 w 1636390"/>
                    <a:gd name="connsiteY17" fmla="*/ 1573450 h 1685770"/>
                    <a:gd name="connsiteX18" fmla="*/ 1279656 w 1636390"/>
                    <a:gd name="connsiteY18" fmla="*/ 1563922 h 1685770"/>
                    <a:gd name="connsiteX19" fmla="*/ 1501174 w 1636390"/>
                    <a:gd name="connsiteY19" fmla="*/ 1682279 h 1685770"/>
                    <a:gd name="connsiteX20" fmla="*/ 1561325 w 1636390"/>
                    <a:gd name="connsiteY20" fmla="*/ 1649489 h 1685770"/>
                    <a:gd name="connsiteX21" fmla="*/ 1632610 w 1636390"/>
                    <a:gd name="connsiteY21" fmla="*/ 1598759 h 1685770"/>
                    <a:gd name="connsiteX22" fmla="*/ 1437092 w 1636390"/>
                    <a:gd name="connsiteY22" fmla="*/ 1477169 h 1685770"/>
                    <a:gd name="connsiteX23" fmla="*/ 1231220 w 1636390"/>
                    <a:gd name="connsiteY23" fmla="*/ 1439167 h 1685770"/>
                    <a:gd name="connsiteX24" fmla="*/ 1036932 w 1636390"/>
                    <a:gd name="connsiteY24" fmla="*/ 1469268 h 1685770"/>
                    <a:gd name="connsiteX25" fmla="*/ 1073624 w 1636390"/>
                    <a:gd name="connsiteY25" fmla="*/ 1407727 h 1685770"/>
                    <a:gd name="connsiteX26" fmla="*/ 1247016 w 1636390"/>
                    <a:gd name="connsiteY26" fmla="*/ 1288788 h 1685770"/>
                    <a:gd name="connsiteX27" fmla="*/ 1409831 w 1636390"/>
                    <a:gd name="connsiteY27" fmla="*/ 1132122 h 1685770"/>
                    <a:gd name="connsiteX28" fmla="*/ 1371731 w 1636390"/>
                    <a:gd name="connsiteY28" fmla="*/ 957497 h 1685770"/>
                    <a:gd name="connsiteX29" fmla="*/ 1152656 w 1636390"/>
                    <a:gd name="connsiteY29" fmla="*/ 865422 h 1685770"/>
                    <a:gd name="connsiteX30" fmla="*/ 927231 w 1636390"/>
                    <a:gd name="connsiteY30" fmla="*/ 935272 h 1685770"/>
                    <a:gd name="connsiteX31" fmla="*/ 739826 w 1636390"/>
                    <a:gd name="connsiteY31" fmla="*/ 1048790 h 1685770"/>
                    <a:gd name="connsiteX32" fmla="*/ 736731 w 1636390"/>
                    <a:gd name="connsiteY32" fmla="*/ 960672 h 1685770"/>
                    <a:gd name="connsiteX33" fmla="*/ 1000256 w 1636390"/>
                    <a:gd name="connsiteY33" fmla="*/ 779697 h 1685770"/>
                    <a:gd name="connsiteX34" fmla="*/ 1009781 w 1636390"/>
                    <a:gd name="connsiteY34" fmla="*/ 573322 h 1685770"/>
                    <a:gd name="connsiteX35" fmla="*/ 851031 w 1636390"/>
                    <a:gd name="connsiteY35" fmla="*/ 436797 h 1685770"/>
                    <a:gd name="connsiteX36" fmla="*/ 673986 w 1636390"/>
                    <a:gd name="connsiteY36" fmla="*/ 489447 h 1685770"/>
                    <a:gd name="connsiteX37" fmla="*/ 425581 w 1636390"/>
                    <a:gd name="connsiteY37" fmla="*/ 639997 h 1685770"/>
                    <a:gd name="connsiteX38" fmla="*/ 339856 w 1636390"/>
                    <a:gd name="connsiteY38" fmla="*/ 639997 h 1685770"/>
                    <a:gd name="connsiteX39" fmla="*/ 333506 w 1636390"/>
                    <a:gd name="connsiteY39" fmla="*/ 617772 h 1685770"/>
                    <a:gd name="connsiteX40" fmla="*/ 371606 w 1636390"/>
                    <a:gd name="connsiteY40" fmla="*/ 576497 h 1685770"/>
                    <a:gd name="connsiteX41" fmla="*/ 527909 w 1636390"/>
                    <a:gd name="connsiteY41" fmla="*/ 415704 h 1685770"/>
                    <a:gd name="connsiteX42" fmla="*/ 635131 w 1636390"/>
                    <a:gd name="connsiteY42" fmla="*/ 214547 h 1685770"/>
                    <a:gd name="connsiteX43" fmla="*/ 520831 w 1636390"/>
                    <a:gd name="connsiteY43" fmla="*/ 71672 h 1685770"/>
                    <a:gd name="connsiteX44" fmla="*/ 206506 w 1636390"/>
                    <a:gd name="connsiteY44" fmla="*/ 119297 h 1685770"/>
                    <a:gd name="connsiteX45" fmla="*/ 55076 w 1636390"/>
                    <a:gd name="connsiteY45" fmla="*/ 5809 h 1685770"/>
                    <a:gd name="connsiteX46" fmla="*/ 36 w 1636390"/>
                    <a:gd name="connsiteY46" fmla="*/ 65270 h 1685770"/>
                    <a:gd name="connsiteX47" fmla="*/ 57787 w 1636390"/>
                    <a:gd name="connsiteY47" fmla="*/ 130566 h 1685770"/>
                    <a:gd name="connsiteX0" fmla="*/ 57787 w 1636390"/>
                    <a:gd name="connsiteY0" fmla="*/ 130566 h 1685770"/>
                    <a:gd name="connsiteX1" fmla="*/ 182681 w 1636390"/>
                    <a:gd name="connsiteY1" fmla="*/ 210180 h 1685770"/>
                    <a:gd name="connsiteX2" fmla="*/ 495431 w 1636390"/>
                    <a:gd name="connsiteY2" fmla="*/ 154222 h 1685770"/>
                    <a:gd name="connsiteX3" fmla="*/ 464327 w 1636390"/>
                    <a:gd name="connsiteY3" fmla="*/ 315307 h 1685770"/>
                    <a:gd name="connsiteX4" fmla="*/ 252459 w 1636390"/>
                    <a:gd name="connsiteY4" fmla="*/ 543269 h 1685770"/>
                    <a:gd name="connsiteX5" fmla="*/ 200156 w 1636390"/>
                    <a:gd name="connsiteY5" fmla="*/ 728897 h 1685770"/>
                    <a:gd name="connsiteX6" fmla="*/ 403356 w 1636390"/>
                    <a:gd name="connsiteY6" fmla="*/ 760647 h 1685770"/>
                    <a:gd name="connsiteX7" fmla="*/ 676327 w 1636390"/>
                    <a:gd name="connsiteY7" fmla="*/ 612304 h 1685770"/>
                    <a:gd name="connsiteX8" fmla="*/ 881595 w 1636390"/>
                    <a:gd name="connsiteY8" fmla="*/ 559252 h 1685770"/>
                    <a:gd name="connsiteX9" fmla="*/ 914531 w 1636390"/>
                    <a:gd name="connsiteY9" fmla="*/ 719372 h 1685770"/>
                    <a:gd name="connsiteX10" fmla="*/ 695004 w 1636390"/>
                    <a:gd name="connsiteY10" fmla="*/ 877562 h 1685770"/>
                    <a:gd name="connsiteX11" fmla="*/ 597031 w 1636390"/>
                    <a:gd name="connsiteY11" fmla="*/ 1036872 h 1685770"/>
                    <a:gd name="connsiteX12" fmla="*/ 708532 w 1636390"/>
                    <a:gd name="connsiteY12" fmla="*/ 1169151 h 1685770"/>
                    <a:gd name="connsiteX13" fmla="*/ 944137 w 1636390"/>
                    <a:gd name="connsiteY13" fmla="*/ 1053369 h 1685770"/>
                    <a:gd name="connsiteX14" fmla="*/ 1171706 w 1636390"/>
                    <a:gd name="connsiteY14" fmla="*/ 960672 h 1685770"/>
                    <a:gd name="connsiteX15" fmla="*/ 1311406 w 1636390"/>
                    <a:gd name="connsiteY15" fmla="*/ 1128947 h 1685770"/>
                    <a:gd name="connsiteX16" fmla="*/ 934417 w 1636390"/>
                    <a:gd name="connsiteY16" fmla="*/ 1416191 h 1685770"/>
                    <a:gd name="connsiteX17" fmla="*/ 1039203 w 1636390"/>
                    <a:gd name="connsiteY17" fmla="*/ 1573450 h 1685770"/>
                    <a:gd name="connsiteX18" fmla="*/ 1279656 w 1636390"/>
                    <a:gd name="connsiteY18" fmla="*/ 1563922 h 1685770"/>
                    <a:gd name="connsiteX19" fmla="*/ 1501174 w 1636390"/>
                    <a:gd name="connsiteY19" fmla="*/ 1682279 h 1685770"/>
                    <a:gd name="connsiteX20" fmla="*/ 1561325 w 1636390"/>
                    <a:gd name="connsiteY20" fmla="*/ 1649489 h 1685770"/>
                    <a:gd name="connsiteX21" fmla="*/ 1632610 w 1636390"/>
                    <a:gd name="connsiteY21" fmla="*/ 1598759 h 1685770"/>
                    <a:gd name="connsiteX22" fmla="*/ 1437092 w 1636390"/>
                    <a:gd name="connsiteY22" fmla="*/ 1477169 h 1685770"/>
                    <a:gd name="connsiteX23" fmla="*/ 1231220 w 1636390"/>
                    <a:gd name="connsiteY23" fmla="*/ 1439167 h 1685770"/>
                    <a:gd name="connsiteX24" fmla="*/ 1036932 w 1636390"/>
                    <a:gd name="connsiteY24" fmla="*/ 1469268 h 1685770"/>
                    <a:gd name="connsiteX25" fmla="*/ 1073624 w 1636390"/>
                    <a:gd name="connsiteY25" fmla="*/ 1407727 h 1685770"/>
                    <a:gd name="connsiteX26" fmla="*/ 1247016 w 1636390"/>
                    <a:gd name="connsiteY26" fmla="*/ 1288788 h 1685770"/>
                    <a:gd name="connsiteX27" fmla="*/ 1409831 w 1636390"/>
                    <a:gd name="connsiteY27" fmla="*/ 1132122 h 1685770"/>
                    <a:gd name="connsiteX28" fmla="*/ 1371731 w 1636390"/>
                    <a:gd name="connsiteY28" fmla="*/ 957497 h 1685770"/>
                    <a:gd name="connsiteX29" fmla="*/ 1152656 w 1636390"/>
                    <a:gd name="connsiteY29" fmla="*/ 865422 h 1685770"/>
                    <a:gd name="connsiteX30" fmla="*/ 927231 w 1636390"/>
                    <a:gd name="connsiteY30" fmla="*/ 935272 h 1685770"/>
                    <a:gd name="connsiteX31" fmla="*/ 739826 w 1636390"/>
                    <a:gd name="connsiteY31" fmla="*/ 1048790 h 1685770"/>
                    <a:gd name="connsiteX32" fmla="*/ 736731 w 1636390"/>
                    <a:gd name="connsiteY32" fmla="*/ 960672 h 1685770"/>
                    <a:gd name="connsiteX33" fmla="*/ 1000256 w 1636390"/>
                    <a:gd name="connsiteY33" fmla="*/ 779697 h 1685770"/>
                    <a:gd name="connsiteX34" fmla="*/ 1009781 w 1636390"/>
                    <a:gd name="connsiteY34" fmla="*/ 573322 h 1685770"/>
                    <a:gd name="connsiteX35" fmla="*/ 851031 w 1636390"/>
                    <a:gd name="connsiteY35" fmla="*/ 436797 h 1685770"/>
                    <a:gd name="connsiteX36" fmla="*/ 673986 w 1636390"/>
                    <a:gd name="connsiteY36" fmla="*/ 489447 h 1685770"/>
                    <a:gd name="connsiteX37" fmla="*/ 425581 w 1636390"/>
                    <a:gd name="connsiteY37" fmla="*/ 639997 h 1685770"/>
                    <a:gd name="connsiteX38" fmla="*/ 339856 w 1636390"/>
                    <a:gd name="connsiteY38" fmla="*/ 639997 h 1685770"/>
                    <a:gd name="connsiteX39" fmla="*/ 333506 w 1636390"/>
                    <a:gd name="connsiteY39" fmla="*/ 617772 h 1685770"/>
                    <a:gd name="connsiteX40" fmla="*/ 371606 w 1636390"/>
                    <a:gd name="connsiteY40" fmla="*/ 576497 h 1685770"/>
                    <a:gd name="connsiteX41" fmla="*/ 527909 w 1636390"/>
                    <a:gd name="connsiteY41" fmla="*/ 415704 h 1685770"/>
                    <a:gd name="connsiteX42" fmla="*/ 635131 w 1636390"/>
                    <a:gd name="connsiteY42" fmla="*/ 214547 h 1685770"/>
                    <a:gd name="connsiteX43" fmla="*/ 520831 w 1636390"/>
                    <a:gd name="connsiteY43" fmla="*/ 71672 h 1685770"/>
                    <a:gd name="connsiteX44" fmla="*/ 206506 w 1636390"/>
                    <a:gd name="connsiteY44" fmla="*/ 119297 h 1685770"/>
                    <a:gd name="connsiteX45" fmla="*/ 55076 w 1636390"/>
                    <a:gd name="connsiteY45" fmla="*/ 5809 h 1685770"/>
                    <a:gd name="connsiteX46" fmla="*/ 36 w 1636390"/>
                    <a:gd name="connsiteY46" fmla="*/ 65270 h 1685770"/>
                    <a:gd name="connsiteX47" fmla="*/ 57787 w 1636390"/>
                    <a:gd name="connsiteY47" fmla="*/ 130566 h 1685770"/>
                    <a:gd name="connsiteX0" fmla="*/ 57787 w 1636390"/>
                    <a:gd name="connsiteY0" fmla="*/ 130566 h 1685770"/>
                    <a:gd name="connsiteX1" fmla="*/ 182681 w 1636390"/>
                    <a:gd name="connsiteY1" fmla="*/ 210180 h 1685770"/>
                    <a:gd name="connsiteX2" fmla="*/ 495431 w 1636390"/>
                    <a:gd name="connsiteY2" fmla="*/ 154222 h 1685770"/>
                    <a:gd name="connsiteX3" fmla="*/ 464327 w 1636390"/>
                    <a:gd name="connsiteY3" fmla="*/ 315307 h 1685770"/>
                    <a:gd name="connsiteX4" fmla="*/ 252459 w 1636390"/>
                    <a:gd name="connsiteY4" fmla="*/ 543269 h 1685770"/>
                    <a:gd name="connsiteX5" fmla="*/ 200156 w 1636390"/>
                    <a:gd name="connsiteY5" fmla="*/ 728897 h 1685770"/>
                    <a:gd name="connsiteX6" fmla="*/ 403356 w 1636390"/>
                    <a:gd name="connsiteY6" fmla="*/ 760647 h 1685770"/>
                    <a:gd name="connsiteX7" fmla="*/ 676327 w 1636390"/>
                    <a:gd name="connsiteY7" fmla="*/ 612304 h 1685770"/>
                    <a:gd name="connsiteX8" fmla="*/ 881595 w 1636390"/>
                    <a:gd name="connsiteY8" fmla="*/ 559252 h 1685770"/>
                    <a:gd name="connsiteX9" fmla="*/ 914531 w 1636390"/>
                    <a:gd name="connsiteY9" fmla="*/ 719372 h 1685770"/>
                    <a:gd name="connsiteX10" fmla="*/ 695004 w 1636390"/>
                    <a:gd name="connsiteY10" fmla="*/ 877562 h 1685770"/>
                    <a:gd name="connsiteX11" fmla="*/ 597031 w 1636390"/>
                    <a:gd name="connsiteY11" fmla="*/ 1036872 h 1685770"/>
                    <a:gd name="connsiteX12" fmla="*/ 708532 w 1636390"/>
                    <a:gd name="connsiteY12" fmla="*/ 1169151 h 1685770"/>
                    <a:gd name="connsiteX13" fmla="*/ 944137 w 1636390"/>
                    <a:gd name="connsiteY13" fmla="*/ 1053369 h 1685770"/>
                    <a:gd name="connsiteX14" fmla="*/ 1171706 w 1636390"/>
                    <a:gd name="connsiteY14" fmla="*/ 960672 h 1685770"/>
                    <a:gd name="connsiteX15" fmla="*/ 1311406 w 1636390"/>
                    <a:gd name="connsiteY15" fmla="*/ 1128947 h 1685770"/>
                    <a:gd name="connsiteX16" fmla="*/ 934417 w 1636390"/>
                    <a:gd name="connsiteY16" fmla="*/ 1416191 h 1685770"/>
                    <a:gd name="connsiteX17" fmla="*/ 1039203 w 1636390"/>
                    <a:gd name="connsiteY17" fmla="*/ 1573450 h 1685770"/>
                    <a:gd name="connsiteX18" fmla="*/ 1279656 w 1636390"/>
                    <a:gd name="connsiteY18" fmla="*/ 1563922 h 1685770"/>
                    <a:gd name="connsiteX19" fmla="*/ 1501174 w 1636390"/>
                    <a:gd name="connsiteY19" fmla="*/ 1682279 h 1685770"/>
                    <a:gd name="connsiteX20" fmla="*/ 1561325 w 1636390"/>
                    <a:gd name="connsiteY20" fmla="*/ 1649489 h 1685770"/>
                    <a:gd name="connsiteX21" fmla="*/ 1632610 w 1636390"/>
                    <a:gd name="connsiteY21" fmla="*/ 1598759 h 1685770"/>
                    <a:gd name="connsiteX22" fmla="*/ 1437092 w 1636390"/>
                    <a:gd name="connsiteY22" fmla="*/ 1477169 h 1685770"/>
                    <a:gd name="connsiteX23" fmla="*/ 1231220 w 1636390"/>
                    <a:gd name="connsiteY23" fmla="*/ 1439167 h 1685770"/>
                    <a:gd name="connsiteX24" fmla="*/ 1106244 w 1636390"/>
                    <a:gd name="connsiteY24" fmla="*/ 1456395 h 1685770"/>
                    <a:gd name="connsiteX25" fmla="*/ 1073624 w 1636390"/>
                    <a:gd name="connsiteY25" fmla="*/ 1407727 h 1685770"/>
                    <a:gd name="connsiteX26" fmla="*/ 1247016 w 1636390"/>
                    <a:gd name="connsiteY26" fmla="*/ 1288788 h 1685770"/>
                    <a:gd name="connsiteX27" fmla="*/ 1409831 w 1636390"/>
                    <a:gd name="connsiteY27" fmla="*/ 1132122 h 1685770"/>
                    <a:gd name="connsiteX28" fmla="*/ 1371731 w 1636390"/>
                    <a:gd name="connsiteY28" fmla="*/ 957497 h 1685770"/>
                    <a:gd name="connsiteX29" fmla="*/ 1152656 w 1636390"/>
                    <a:gd name="connsiteY29" fmla="*/ 865422 h 1685770"/>
                    <a:gd name="connsiteX30" fmla="*/ 927231 w 1636390"/>
                    <a:gd name="connsiteY30" fmla="*/ 935272 h 1685770"/>
                    <a:gd name="connsiteX31" fmla="*/ 739826 w 1636390"/>
                    <a:gd name="connsiteY31" fmla="*/ 1048790 h 1685770"/>
                    <a:gd name="connsiteX32" fmla="*/ 736731 w 1636390"/>
                    <a:gd name="connsiteY32" fmla="*/ 960672 h 1685770"/>
                    <a:gd name="connsiteX33" fmla="*/ 1000256 w 1636390"/>
                    <a:gd name="connsiteY33" fmla="*/ 779697 h 1685770"/>
                    <a:gd name="connsiteX34" fmla="*/ 1009781 w 1636390"/>
                    <a:gd name="connsiteY34" fmla="*/ 573322 h 1685770"/>
                    <a:gd name="connsiteX35" fmla="*/ 851031 w 1636390"/>
                    <a:gd name="connsiteY35" fmla="*/ 436797 h 1685770"/>
                    <a:gd name="connsiteX36" fmla="*/ 673986 w 1636390"/>
                    <a:gd name="connsiteY36" fmla="*/ 489447 h 1685770"/>
                    <a:gd name="connsiteX37" fmla="*/ 425581 w 1636390"/>
                    <a:gd name="connsiteY37" fmla="*/ 639997 h 1685770"/>
                    <a:gd name="connsiteX38" fmla="*/ 339856 w 1636390"/>
                    <a:gd name="connsiteY38" fmla="*/ 639997 h 1685770"/>
                    <a:gd name="connsiteX39" fmla="*/ 333506 w 1636390"/>
                    <a:gd name="connsiteY39" fmla="*/ 617772 h 1685770"/>
                    <a:gd name="connsiteX40" fmla="*/ 371606 w 1636390"/>
                    <a:gd name="connsiteY40" fmla="*/ 576497 h 1685770"/>
                    <a:gd name="connsiteX41" fmla="*/ 527909 w 1636390"/>
                    <a:gd name="connsiteY41" fmla="*/ 415704 h 1685770"/>
                    <a:gd name="connsiteX42" fmla="*/ 635131 w 1636390"/>
                    <a:gd name="connsiteY42" fmla="*/ 214547 h 1685770"/>
                    <a:gd name="connsiteX43" fmla="*/ 520831 w 1636390"/>
                    <a:gd name="connsiteY43" fmla="*/ 71672 h 1685770"/>
                    <a:gd name="connsiteX44" fmla="*/ 206506 w 1636390"/>
                    <a:gd name="connsiteY44" fmla="*/ 119297 h 1685770"/>
                    <a:gd name="connsiteX45" fmla="*/ 55076 w 1636390"/>
                    <a:gd name="connsiteY45" fmla="*/ 5809 h 1685770"/>
                    <a:gd name="connsiteX46" fmla="*/ 36 w 1636390"/>
                    <a:gd name="connsiteY46" fmla="*/ 65270 h 1685770"/>
                    <a:gd name="connsiteX47" fmla="*/ 57787 w 1636390"/>
                    <a:gd name="connsiteY47" fmla="*/ 130566 h 1685770"/>
                    <a:gd name="connsiteX0" fmla="*/ 57787 w 1612694"/>
                    <a:gd name="connsiteY0" fmla="*/ 130566 h 1685434"/>
                    <a:gd name="connsiteX1" fmla="*/ 182681 w 1612694"/>
                    <a:gd name="connsiteY1" fmla="*/ 210180 h 1685434"/>
                    <a:gd name="connsiteX2" fmla="*/ 495431 w 1612694"/>
                    <a:gd name="connsiteY2" fmla="*/ 154222 h 1685434"/>
                    <a:gd name="connsiteX3" fmla="*/ 464327 w 1612694"/>
                    <a:gd name="connsiteY3" fmla="*/ 315307 h 1685434"/>
                    <a:gd name="connsiteX4" fmla="*/ 252459 w 1612694"/>
                    <a:gd name="connsiteY4" fmla="*/ 543269 h 1685434"/>
                    <a:gd name="connsiteX5" fmla="*/ 200156 w 1612694"/>
                    <a:gd name="connsiteY5" fmla="*/ 728897 h 1685434"/>
                    <a:gd name="connsiteX6" fmla="*/ 403356 w 1612694"/>
                    <a:gd name="connsiteY6" fmla="*/ 760647 h 1685434"/>
                    <a:gd name="connsiteX7" fmla="*/ 676327 w 1612694"/>
                    <a:gd name="connsiteY7" fmla="*/ 612304 h 1685434"/>
                    <a:gd name="connsiteX8" fmla="*/ 881595 w 1612694"/>
                    <a:gd name="connsiteY8" fmla="*/ 559252 h 1685434"/>
                    <a:gd name="connsiteX9" fmla="*/ 914531 w 1612694"/>
                    <a:gd name="connsiteY9" fmla="*/ 719372 h 1685434"/>
                    <a:gd name="connsiteX10" fmla="*/ 695004 w 1612694"/>
                    <a:gd name="connsiteY10" fmla="*/ 877562 h 1685434"/>
                    <a:gd name="connsiteX11" fmla="*/ 597031 w 1612694"/>
                    <a:gd name="connsiteY11" fmla="*/ 1036872 h 1685434"/>
                    <a:gd name="connsiteX12" fmla="*/ 708532 w 1612694"/>
                    <a:gd name="connsiteY12" fmla="*/ 1169151 h 1685434"/>
                    <a:gd name="connsiteX13" fmla="*/ 944137 w 1612694"/>
                    <a:gd name="connsiteY13" fmla="*/ 1053369 h 1685434"/>
                    <a:gd name="connsiteX14" fmla="*/ 1171706 w 1612694"/>
                    <a:gd name="connsiteY14" fmla="*/ 960672 h 1685434"/>
                    <a:gd name="connsiteX15" fmla="*/ 1311406 w 1612694"/>
                    <a:gd name="connsiteY15" fmla="*/ 1128947 h 1685434"/>
                    <a:gd name="connsiteX16" fmla="*/ 934417 w 1612694"/>
                    <a:gd name="connsiteY16" fmla="*/ 1416191 h 1685434"/>
                    <a:gd name="connsiteX17" fmla="*/ 1039203 w 1612694"/>
                    <a:gd name="connsiteY17" fmla="*/ 1573450 h 1685434"/>
                    <a:gd name="connsiteX18" fmla="*/ 1279656 w 1612694"/>
                    <a:gd name="connsiteY18" fmla="*/ 1563922 h 1685434"/>
                    <a:gd name="connsiteX19" fmla="*/ 1501174 w 1612694"/>
                    <a:gd name="connsiteY19" fmla="*/ 1682279 h 1685434"/>
                    <a:gd name="connsiteX20" fmla="*/ 1561325 w 1612694"/>
                    <a:gd name="connsiteY20" fmla="*/ 1649489 h 1685434"/>
                    <a:gd name="connsiteX21" fmla="*/ 1607707 w 1612694"/>
                    <a:gd name="connsiteY21" fmla="*/ 1629127 h 1685434"/>
                    <a:gd name="connsiteX22" fmla="*/ 1437092 w 1612694"/>
                    <a:gd name="connsiteY22" fmla="*/ 1477169 h 1685434"/>
                    <a:gd name="connsiteX23" fmla="*/ 1231220 w 1612694"/>
                    <a:gd name="connsiteY23" fmla="*/ 1439167 h 1685434"/>
                    <a:gd name="connsiteX24" fmla="*/ 1106244 w 1612694"/>
                    <a:gd name="connsiteY24" fmla="*/ 1456395 h 1685434"/>
                    <a:gd name="connsiteX25" fmla="*/ 1073624 w 1612694"/>
                    <a:gd name="connsiteY25" fmla="*/ 1407727 h 1685434"/>
                    <a:gd name="connsiteX26" fmla="*/ 1247016 w 1612694"/>
                    <a:gd name="connsiteY26" fmla="*/ 1288788 h 1685434"/>
                    <a:gd name="connsiteX27" fmla="*/ 1409831 w 1612694"/>
                    <a:gd name="connsiteY27" fmla="*/ 1132122 h 1685434"/>
                    <a:gd name="connsiteX28" fmla="*/ 1371731 w 1612694"/>
                    <a:gd name="connsiteY28" fmla="*/ 957497 h 1685434"/>
                    <a:gd name="connsiteX29" fmla="*/ 1152656 w 1612694"/>
                    <a:gd name="connsiteY29" fmla="*/ 865422 h 1685434"/>
                    <a:gd name="connsiteX30" fmla="*/ 927231 w 1612694"/>
                    <a:gd name="connsiteY30" fmla="*/ 935272 h 1685434"/>
                    <a:gd name="connsiteX31" fmla="*/ 739826 w 1612694"/>
                    <a:gd name="connsiteY31" fmla="*/ 1048790 h 1685434"/>
                    <a:gd name="connsiteX32" fmla="*/ 736731 w 1612694"/>
                    <a:gd name="connsiteY32" fmla="*/ 960672 h 1685434"/>
                    <a:gd name="connsiteX33" fmla="*/ 1000256 w 1612694"/>
                    <a:gd name="connsiteY33" fmla="*/ 779697 h 1685434"/>
                    <a:gd name="connsiteX34" fmla="*/ 1009781 w 1612694"/>
                    <a:gd name="connsiteY34" fmla="*/ 573322 h 1685434"/>
                    <a:gd name="connsiteX35" fmla="*/ 851031 w 1612694"/>
                    <a:gd name="connsiteY35" fmla="*/ 436797 h 1685434"/>
                    <a:gd name="connsiteX36" fmla="*/ 673986 w 1612694"/>
                    <a:gd name="connsiteY36" fmla="*/ 489447 h 1685434"/>
                    <a:gd name="connsiteX37" fmla="*/ 425581 w 1612694"/>
                    <a:gd name="connsiteY37" fmla="*/ 639997 h 1685434"/>
                    <a:gd name="connsiteX38" fmla="*/ 339856 w 1612694"/>
                    <a:gd name="connsiteY38" fmla="*/ 639997 h 1685434"/>
                    <a:gd name="connsiteX39" fmla="*/ 333506 w 1612694"/>
                    <a:gd name="connsiteY39" fmla="*/ 617772 h 1685434"/>
                    <a:gd name="connsiteX40" fmla="*/ 371606 w 1612694"/>
                    <a:gd name="connsiteY40" fmla="*/ 576497 h 1685434"/>
                    <a:gd name="connsiteX41" fmla="*/ 527909 w 1612694"/>
                    <a:gd name="connsiteY41" fmla="*/ 415704 h 1685434"/>
                    <a:gd name="connsiteX42" fmla="*/ 635131 w 1612694"/>
                    <a:gd name="connsiteY42" fmla="*/ 214547 h 1685434"/>
                    <a:gd name="connsiteX43" fmla="*/ 520831 w 1612694"/>
                    <a:gd name="connsiteY43" fmla="*/ 71672 h 1685434"/>
                    <a:gd name="connsiteX44" fmla="*/ 206506 w 1612694"/>
                    <a:gd name="connsiteY44" fmla="*/ 119297 h 1685434"/>
                    <a:gd name="connsiteX45" fmla="*/ 55076 w 1612694"/>
                    <a:gd name="connsiteY45" fmla="*/ 5809 h 1685434"/>
                    <a:gd name="connsiteX46" fmla="*/ 36 w 1612694"/>
                    <a:gd name="connsiteY46" fmla="*/ 65270 h 1685434"/>
                    <a:gd name="connsiteX47" fmla="*/ 57787 w 1612694"/>
                    <a:gd name="connsiteY47" fmla="*/ 130566 h 1685434"/>
                    <a:gd name="connsiteX0" fmla="*/ 57787 w 1613253"/>
                    <a:gd name="connsiteY0" fmla="*/ 130566 h 1685434"/>
                    <a:gd name="connsiteX1" fmla="*/ 182681 w 1613253"/>
                    <a:gd name="connsiteY1" fmla="*/ 210180 h 1685434"/>
                    <a:gd name="connsiteX2" fmla="*/ 495431 w 1613253"/>
                    <a:gd name="connsiteY2" fmla="*/ 154222 h 1685434"/>
                    <a:gd name="connsiteX3" fmla="*/ 464327 w 1613253"/>
                    <a:gd name="connsiteY3" fmla="*/ 315307 h 1685434"/>
                    <a:gd name="connsiteX4" fmla="*/ 252459 w 1613253"/>
                    <a:gd name="connsiteY4" fmla="*/ 543269 h 1685434"/>
                    <a:gd name="connsiteX5" fmla="*/ 200156 w 1613253"/>
                    <a:gd name="connsiteY5" fmla="*/ 728897 h 1685434"/>
                    <a:gd name="connsiteX6" fmla="*/ 403356 w 1613253"/>
                    <a:gd name="connsiteY6" fmla="*/ 760647 h 1685434"/>
                    <a:gd name="connsiteX7" fmla="*/ 676327 w 1613253"/>
                    <a:gd name="connsiteY7" fmla="*/ 612304 h 1685434"/>
                    <a:gd name="connsiteX8" fmla="*/ 881595 w 1613253"/>
                    <a:gd name="connsiteY8" fmla="*/ 559252 h 1685434"/>
                    <a:gd name="connsiteX9" fmla="*/ 914531 w 1613253"/>
                    <a:gd name="connsiteY9" fmla="*/ 719372 h 1685434"/>
                    <a:gd name="connsiteX10" fmla="*/ 695004 w 1613253"/>
                    <a:gd name="connsiteY10" fmla="*/ 877562 h 1685434"/>
                    <a:gd name="connsiteX11" fmla="*/ 597031 w 1613253"/>
                    <a:gd name="connsiteY11" fmla="*/ 1036872 h 1685434"/>
                    <a:gd name="connsiteX12" fmla="*/ 708532 w 1613253"/>
                    <a:gd name="connsiteY12" fmla="*/ 1169151 h 1685434"/>
                    <a:gd name="connsiteX13" fmla="*/ 944137 w 1613253"/>
                    <a:gd name="connsiteY13" fmla="*/ 1053369 h 1685434"/>
                    <a:gd name="connsiteX14" fmla="*/ 1171706 w 1613253"/>
                    <a:gd name="connsiteY14" fmla="*/ 960672 h 1685434"/>
                    <a:gd name="connsiteX15" fmla="*/ 1311406 w 1613253"/>
                    <a:gd name="connsiteY15" fmla="*/ 1128947 h 1685434"/>
                    <a:gd name="connsiteX16" fmla="*/ 934417 w 1613253"/>
                    <a:gd name="connsiteY16" fmla="*/ 1416191 h 1685434"/>
                    <a:gd name="connsiteX17" fmla="*/ 1039203 w 1613253"/>
                    <a:gd name="connsiteY17" fmla="*/ 1573450 h 1685434"/>
                    <a:gd name="connsiteX18" fmla="*/ 1279656 w 1613253"/>
                    <a:gd name="connsiteY18" fmla="*/ 1563922 h 1685434"/>
                    <a:gd name="connsiteX19" fmla="*/ 1501174 w 1613253"/>
                    <a:gd name="connsiteY19" fmla="*/ 1682279 h 1685434"/>
                    <a:gd name="connsiteX20" fmla="*/ 1561325 w 1613253"/>
                    <a:gd name="connsiteY20" fmla="*/ 1649489 h 1685434"/>
                    <a:gd name="connsiteX21" fmla="*/ 1607707 w 1613253"/>
                    <a:gd name="connsiteY21" fmla="*/ 1629127 h 1685434"/>
                    <a:gd name="connsiteX22" fmla="*/ 1427588 w 1613253"/>
                    <a:gd name="connsiteY22" fmla="*/ 1497259 h 1685434"/>
                    <a:gd name="connsiteX23" fmla="*/ 1231220 w 1613253"/>
                    <a:gd name="connsiteY23" fmla="*/ 1439167 h 1685434"/>
                    <a:gd name="connsiteX24" fmla="*/ 1106244 w 1613253"/>
                    <a:gd name="connsiteY24" fmla="*/ 1456395 h 1685434"/>
                    <a:gd name="connsiteX25" fmla="*/ 1073624 w 1613253"/>
                    <a:gd name="connsiteY25" fmla="*/ 1407727 h 1685434"/>
                    <a:gd name="connsiteX26" fmla="*/ 1247016 w 1613253"/>
                    <a:gd name="connsiteY26" fmla="*/ 1288788 h 1685434"/>
                    <a:gd name="connsiteX27" fmla="*/ 1409831 w 1613253"/>
                    <a:gd name="connsiteY27" fmla="*/ 1132122 h 1685434"/>
                    <a:gd name="connsiteX28" fmla="*/ 1371731 w 1613253"/>
                    <a:gd name="connsiteY28" fmla="*/ 957497 h 1685434"/>
                    <a:gd name="connsiteX29" fmla="*/ 1152656 w 1613253"/>
                    <a:gd name="connsiteY29" fmla="*/ 865422 h 1685434"/>
                    <a:gd name="connsiteX30" fmla="*/ 927231 w 1613253"/>
                    <a:gd name="connsiteY30" fmla="*/ 935272 h 1685434"/>
                    <a:gd name="connsiteX31" fmla="*/ 739826 w 1613253"/>
                    <a:gd name="connsiteY31" fmla="*/ 1048790 h 1685434"/>
                    <a:gd name="connsiteX32" fmla="*/ 736731 w 1613253"/>
                    <a:gd name="connsiteY32" fmla="*/ 960672 h 1685434"/>
                    <a:gd name="connsiteX33" fmla="*/ 1000256 w 1613253"/>
                    <a:gd name="connsiteY33" fmla="*/ 779697 h 1685434"/>
                    <a:gd name="connsiteX34" fmla="*/ 1009781 w 1613253"/>
                    <a:gd name="connsiteY34" fmla="*/ 573322 h 1685434"/>
                    <a:gd name="connsiteX35" fmla="*/ 851031 w 1613253"/>
                    <a:gd name="connsiteY35" fmla="*/ 436797 h 1685434"/>
                    <a:gd name="connsiteX36" fmla="*/ 673986 w 1613253"/>
                    <a:gd name="connsiteY36" fmla="*/ 489447 h 1685434"/>
                    <a:gd name="connsiteX37" fmla="*/ 425581 w 1613253"/>
                    <a:gd name="connsiteY37" fmla="*/ 639997 h 1685434"/>
                    <a:gd name="connsiteX38" fmla="*/ 339856 w 1613253"/>
                    <a:gd name="connsiteY38" fmla="*/ 639997 h 1685434"/>
                    <a:gd name="connsiteX39" fmla="*/ 333506 w 1613253"/>
                    <a:gd name="connsiteY39" fmla="*/ 617772 h 1685434"/>
                    <a:gd name="connsiteX40" fmla="*/ 371606 w 1613253"/>
                    <a:gd name="connsiteY40" fmla="*/ 576497 h 1685434"/>
                    <a:gd name="connsiteX41" fmla="*/ 527909 w 1613253"/>
                    <a:gd name="connsiteY41" fmla="*/ 415704 h 1685434"/>
                    <a:gd name="connsiteX42" fmla="*/ 635131 w 1613253"/>
                    <a:gd name="connsiteY42" fmla="*/ 214547 h 1685434"/>
                    <a:gd name="connsiteX43" fmla="*/ 520831 w 1613253"/>
                    <a:gd name="connsiteY43" fmla="*/ 71672 h 1685434"/>
                    <a:gd name="connsiteX44" fmla="*/ 206506 w 1613253"/>
                    <a:gd name="connsiteY44" fmla="*/ 119297 h 1685434"/>
                    <a:gd name="connsiteX45" fmla="*/ 55076 w 1613253"/>
                    <a:gd name="connsiteY45" fmla="*/ 5809 h 1685434"/>
                    <a:gd name="connsiteX46" fmla="*/ 36 w 1613253"/>
                    <a:gd name="connsiteY46" fmla="*/ 65270 h 1685434"/>
                    <a:gd name="connsiteX47" fmla="*/ 57787 w 1613253"/>
                    <a:gd name="connsiteY47" fmla="*/ 130566 h 1685434"/>
                    <a:gd name="connsiteX0" fmla="*/ 57787 w 1613253"/>
                    <a:gd name="connsiteY0" fmla="*/ 130566 h 1685884"/>
                    <a:gd name="connsiteX1" fmla="*/ 182681 w 1613253"/>
                    <a:gd name="connsiteY1" fmla="*/ 210180 h 1685884"/>
                    <a:gd name="connsiteX2" fmla="*/ 495431 w 1613253"/>
                    <a:gd name="connsiteY2" fmla="*/ 154222 h 1685884"/>
                    <a:gd name="connsiteX3" fmla="*/ 464327 w 1613253"/>
                    <a:gd name="connsiteY3" fmla="*/ 315307 h 1685884"/>
                    <a:gd name="connsiteX4" fmla="*/ 252459 w 1613253"/>
                    <a:gd name="connsiteY4" fmla="*/ 543269 h 1685884"/>
                    <a:gd name="connsiteX5" fmla="*/ 200156 w 1613253"/>
                    <a:gd name="connsiteY5" fmla="*/ 728897 h 1685884"/>
                    <a:gd name="connsiteX6" fmla="*/ 403356 w 1613253"/>
                    <a:gd name="connsiteY6" fmla="*/ 760647 h 1685884"/>
                    <a:gd name="connsiteX7" fmla="*/ 676327 w 1613253"/>
                    <a:gd name="connsiteY7" fmla="*/ 612304 h 1685884"/>
                    <a:gd name="connsiteX8" fmla="*/ 881595 w 1613253"/>
                    <a:gd name="connsiteY8" fmla="*/ 559252 h 1685884"/>
                    <a:gd name="connsiteX9" fmla="*/ 914531 w 1613253"/>
                    <a:gd name="connsiteY9" fmla="*/ 719372 h 1685884"/>
                    <a:gd name="connsiteX10" fmla="*/ 695004 w 1613253"/>
                    <a:gd name="connsiteY10" fmla="*/ 877562 h 1685884"/>
                    <a:gd name="connsiteX11" fmla="*/ 597031 w 1613253"/>
                    <a:gd name="connsiteY11" fmla="*/ 1036872 h 1685884"/>
                    <a:gd name="connsiteX12" fmla="*/ 708532 w 1613253"/>
                    <a:gd name="connsiteY12" fmla="*/ 1169151 h 1685884"/>
                    <a:gd name="connsiteX13" fmla="*/ 944137 w 1613253"/>
                    <a:gd name="connsiteY13" fmla="*/ 1053369 h 1685884"/>
                    <a:gd name="connsiteX14" fmla="*/ 1171706 w 1613253"/>
                    <a:gd name="connsiteY14" fmla="*/ 960672 h 1685884"/>
                    <a:gd name="connsiteX15" fmla="*/ 1311406 w 1613253"/>
                    <a:gd name="connsiteY15" fmla="*/ 1128947 h 1685884"/>
                    <a:gd name="connsiteX16" fmla="*/ 934417 w 1613253"/>
                    <a:gd name="connsiteY16" fmla="*/ 1416191 h 1685884"/>
                    <a:gd name="connsiteX17" fmla="*/ 1039203 w 1613253"/>
                    <a:gd name="connsiteY17" fmla="*/ 1573450 h 1685884"/>
                    <a:gd name="connsiteX18" fmla="*/ 1322088 w 1613253"/>
                    <a:gd name="connsiteY18" fmla="*/ 1555897 h 1685884"/>
                    <a:gd name="connsiteX19" fmla="*/ 1501174 w 1613253"/>
                    <a:gd name="connsiteY19" fmla="*/ 1682279 h 1685884"/>
                    <a:gd name="connsiteX20" fmla="*/ 1561325 w 1613253"/>
                    <a:gd name="connsiteY20" fmla="*/ 1649489 h 1685884"/>
                    <a:gd name="connsiteX21" fmla="*/ 1607707 w 1613253"/>
                    <a:gd name="connsiteY21" fmla="*/ 1629127 h 1685884"/>
                    <a:gd name="connsiteX22" fmla="*/ 1427588 w 1613253"/>
                    <a:gd name="connsiteY22" fmla="*/ 1497259 h 1685884"/>
                    <a:gd name="connsiteX23" fmla="*/ 1231220 w 1613253"/>
                    <a:gd name="connsiteY23" fmla="*/ 1439167 h 1685884"/>
                    <a:gd name="connsiteX24" fmla="*/ 1106244 w 1613253"/>
                    <a:gd name="connsiteY24" fmla="*/ 1456395 h 1685884"/>
                    <a:gd name="connsiteX25" fmla="*/ 1073624 w 1613253"/>
                    <a:gd name="connsiteY25" fmla="*/ 1407727 h 1685884"/>
                    <a:gd name="connsiteX26" fmla="*/ 1247016 w 1613253"/>
                    <a:gd name="connsiteY26" fmla="*/ 1288788 h 1685884"/>
                    <a:gd name="connsiteX27" fmla="*/ 1409831 w 1613253"/>
                    <a:gd name="connsiteY27" fmla="*/ 1132122 h 1685884"/>
                    <a:gd name="connsiteX28" fmla="*/ 1371731 w 1613253"/>
                    <a:gd name="connsiteY28" fmla="*/ 957497 h 1685884"/>
                    <a:gd name="connsiteX29" fmla="*/ 1152656 w 1613253"/>
                    <a:gd name="connsiteY29" fmla="*/ 865422 h 1685884"/>
                    <a:gd name="connsiteX30" fmla="*/ 927231 w 1613253"/>
                    <a:gd name="connsiteY30" fmla="*/ 935272 h 1685884"/>
                    <a:gd name="connsiteX31" fmla="*/ 739826 w 1613253"/>
                    <a:gd name="connsiteY31" fmla="*/ 1048790 h 1685884"/>
                    <a:gd name="connsiteX32" fmla="*/ 736731 w 1613253"/>
                    <a:gd name="connsiteY32" fmla="*/ 960672 h 1685884"/>
                    <a:gd name="connsiteX33" fmla="*/ 1000256 w 1613253"/>
                    <a:gd name="connsiteY33" fmla="*/ 779697 h 1685884"/>
                    <a:gd name="connsiteX34" fmla="*/ 1009781 w 1613253"/>
                    <a:gd name="connsiteY34" fmla="*/ 573322 h 1685884"/>
                    <a:gd name="connsiteX35" fmla="*/ 851031 w 1613253"/>
                    <a:gd name="connsiteY35" fmla="*/ 436797 h 1685884"/>
                    <a:gd name="connsiteX36" fmla="*/ 673986 w 1613253"/>
                    <a:gd name="connsiteY36" fmla="*/ 489447 h 1685884"/>
                    <a:gd name="connsiteX37" fmla="*/ 425581 w 1613253"/>
                    <a:gd name="connsiteY37" fmla="*/ 639997 h 1685884"/>
                    <a:gd name="connsiteX38" fmla="*/ 339856 w 1613253"/>
                    <a:gd name="connsiteY38" fmla="*/ 639997 h 1685884"/>
                    <a:gd name="connsiteX39" fmla="*/ 333506 w 1613253"/>
                    <a:gd name="connsiteY39" fmla="*/ 617772 h 1685884"/>
                    <a:gd name="connsiteX40" fmla="*/ 371606 w 1613253"/>
                    <a:gd name="connsiteY40" fmla="*/ 576497 h 1685884"/>
                    <a:gd name="connsiteX41" fmla="*/ 527909 w 1613253"/>
                    <a:gd name="connsiteY41" fmla="*/ 415704 h 1685884"/>
                    <a:gd name="connsiteX42" fmla="*/ 635131 w 1613253"/>
                    <a:gd name="connsiteY42" fmla="*/ 214547 h 1685884"/>
                    <a:gd name="connsiteX43" fmla="*/ 520831 w 1613253"/>
                    <a:gd name="connsiteY43" fmla="*/ 71672 h 1685884"/>
                    <a:gd name="connsiteX44" fmla="*/ 206506 w 1613253"/>
                    <a:gd name="connsiteY44" fmla="*/ 119297 h 1685884"/>
                    <a:gd name="connsiteX45" fmla="*/ 55076 w 1613253"/>
                    <a:gd name="connsiteY45" fmla="*/ 5809 h 1685884"/>
                    <a:gd name="connsiteX46" fmla="*/ 36 w 1613253"/>
                    <a:gd name="connsiteY46" fmla="*/ 65270 h 1685884"/>
                    <a:gd name="connsiteX47" fmla="*/ 57787 w 1613253"/>
                    <a:gd name="connsiteY47" fmla="*/ 130566 h 1685884"/>
                    <a:gd name="connsiteX0" fmla="*/ 57787 w 1613253"/>
                    <a:gd name="connsiteY0" fmla="*/ 130566 h 1685943"/>
                    <a:gd name="connsiteX1" fmla="*/ 182681 w 1613253"/>
                    <a:gd name="connsiteY1" fmla="*/ 210180 h 1685943"/>
                    <a:gd name="connsiteX2" fmla="*/ 495431 w 1613253"/>
                    <a:gd name="connsiteY2" fmla="*/ 154222 h 1685943"/>
                    <a:gd name="connsiteX3" fmla="*/ 464327 w 1613253"/>
                    <a:gd name="connsiteY3" fmla="*/ 315307 h 1685943"/>
                    <a:gd name="connsiteX4" fmla="*/ 252459 w 1613253"/>
                    <a:gd name="connsiteY4" fmla="*/ 543269 h 1685943"/>
                    <a:gd name="connsiteX5" fmla="*/ 200156 w 1613253"/>
                    <a:gd name="connsiteY5" fmla="*/ 728897 h 1685943"/>
                    <a:gd name="connsiteX6" fmla="*/ 403356 w 1613253"/>
                    <a:gd name="connsiteY6" fmla="*/ 760647 h 1685943"/>
                    <a:gd name="connsiteX7" fmla="*/ 676327 w 1613253"/>
                    <a:gd name="connsiteY7" fmla="*/ 612304 h 1685943"/>
                    <a:gd name="connsiteX8" fmla="*/ 881595 w 1613253"/>
                    <a:gd name="connsiteY8" fmla="*/ 559252 h 1685943"/>
                    <a:gd name="connsiteX9" fmla="*/ 914531 w 1613253"/>
                    <a:gd name="connsiteY9" fmla="*/ 719372 h 1685943"/>
                    <a:gd name="connsiteX10" fmla="*/ 695004 w 1613253"/>
                    <a:gd name="connsiteY10" fmla="*/ 877562 h 1685943"/>
                    <a:gd name="connsiteX11" fmla="*/ 597031 w 1613253"/>
                    <a:gd name="connsiteY11" fmla="*/ 1036872 h 1685943"/>
                    <a:gd name="connsiteX12" fmla="*/ 708532 w 1613253"/>
                    <a:gd name="connsiteY12" fmla="*/ 1169151 h 1685943"/>
                    <a:gd name="connsiteX13" fmla="*/ 944137 w 1613253"/>
                    <a:gd name="connsiteY13" fmla="*/ 1053369 h 1685943"/>
                    <a:gd name="connsiteX14" fmla="*/ 1171706 w 1613253"/>
                    <a:gd name="connsiteY14" fmla="*/ 960672 h 1685943"/>
                    <a:gd name="connsiteX15" fmla="*/ 1311406 w 1613253"/>
                    <a:gd name="connsiteY15" fmla="*/ 1128947 h 1685943"/>
                    <a:gd name="connsiteX16" fmla="*/ 934417 w 1613253"/>
                    <a:gd name="connsiteY16" fmla="*/ 1416191 h 1685943"/>
                    <a:gd name="connsiteX17" fmla="*/ 1039203 w 1613253"/>
                    <a:gd name="connsiteY17" fmla="*/ 1573450 h 1685943"/>
                    <a:gd name="connsiteX18" fmla="*/ 1305022 w 1613253"/>
                    <a:gd name="connsiteY18" fmla="*/ 1554849 h 1685943"/>
                    <a:gd name="connsiteX19" fmla="*/ 1501174 w 1613253"/>
                    <a:gd name="connsiteY19" fmla="*/ 1682279 h 1685943"/>
                    <a:gd name="connsiteX20" fmla="*/ 1561325 w 1613253"/>
                    <a:gd name="connsiteY20" fmla="*/ 1649489 h 1685943"/>
                    <a:gd name="connsiteX21" fmla="*/ 1607707 w 1613253"/>
                    <a:gd name="connsiteY21" fmla="*/ 1629127 h 1685943"/>
                    <a:gd name="connsiteX22" fmla="*/ 1427588 w 1613253"/>
                    <a:gd name="connsiteY22" fmla="*/ 1497259 h 1685943"/>
                    <a:gd name="connsiteX23" fmla="*/ 1231220 w 1613253"/>
                    <a:gd name="connsiteY23" fmla="*/ 1439167 h 1685943"/>
                    <a:gd name="connsiteX24" fmla="*/ 1106244 w 1613253"/>
                    <a:gd name="connsiteY24" fmla="*/ 1456395 h 1685943"/>
                    <a:gd name="connsiteX25" fmla="*/ 1073624 w 1613253"/>
                    <a:gd name="connsiteY25" fmla="*/ 1407727 h 1685943"/>
                    <a:gd name="connsiteX26" fmla="*/ 1247016 w 1613253"/>
                    <a:gd name="connsiteY26" fmla="*/ 1288788 h 1685943"/>
                    <a:gd name="connsiteX27" fmla="*/ 1409831 w 1613253"/>
                    <a:gd name="connsiteY27" fmla="*/ 1132122 h 1685943"/>
                    <a:gd name="connsiteX28" fmla="*/ 1371731 w 1613253"/>
                    <a:gd name="connsiteY28" fmla="*/ 957497 h 1685943"/>
                    <a:gd name="connsiteX29" fmla="*/ 1152656 w 1613253"/>
                    <a:gd name="connsiteY29" fmla="*/ 865422 h 1685943"/>
                    <a:gd name="connsiteX30" fmla="*/ 927231 w 1613253"/>
                    <a:gd name="connsiteY30" fmla="*/ 935272 h 1685943"/>
                    <a:gd name="connsiteX31" fmla="*/ 739826 w 1613253"/>
                    <a:gd name="connsiteY31" fmla="*/ 1048790 h 1685943"/>
                    <a:gd name="connsiteX32" fmla="*/ 736731 w 1613253"/>
                    <a:gd name="connsiteY32" fmla="*/ 960672 h 1685943"/>
                    <a:gd name="connsiteX33" fmla="*/ 1000256 w 1613253"/>
                    <a:gd name="connsiteY33" fmla="*/ 779697 h 1685943"/>
                    <a:gd name="connsiteX34" fmla="*/ 1009781 w 1613253"/>
                    <a:gd name="connsiteY34" fmla="*/ 573322 h 1685943"/>
                    <a:gd name="connsiteX35" fmla="*/ 851031 w 1613253"/>
                    <a:gd name="connsiteY35" fmla="*/ 436797 h 1685943"/>
                    <a:gd name="connsiteX36" fmla="*/ 673986 w 1613253"/>
                    <a:gd name="connsiteY36" fmla="*/ 489447 h 1685943"/>
                    <a:gd name="connsiteX37" fmla="*/ 425581 w 1613253"/>
                    <a:gd name="connsiteY37" fmla="*/ 639997 h 1685943"/>
                    <a:gd name="connsiteX38" fmla="*/ 339856 w 1613253"/>
                    <a:gd name="connsiteY38" fmla="*/ 639997 h 1685943"/>
                    <a:gd name="connsiteX39" fmla="*/ 333506 w 1613253"/>
                    <a:gd name="connsiteY39" fmla="*/ 617772 h 1685943"/>
                    <a:gd name="connsiteX40" fmla="*/ 371606 w 1613253"/>
                    <a:gd name="connsiteY40" fmla="*/ 576497 h 1685943"/>
                    <a:gd name="connsiteX41" fmla="*/ 527909 w 1613253"/>
                    <a:gd name="connsiteY41" fmla="*/ 415704 h 1685943"/>
                    <a:gd name="connsiteX42" fmla="*/ 635131 w 1613253"/>
                    <a:gd name="connsiteY42" fmla="*/ 214547 h 1685943"/>
                    <a:gd name="connsiteX43" fmla="*/ 520831 w 1613253"/>
                    <a:gd name="connsiteY43" fmla="*/ 71672 h 1685943"/>
                    <a:gd name="connsiteX44" fmla="*/ 206506 w 1613253"/>
                    <a:gd name="connsiteY44" fmla="*/ 119297 h 1685943"/>
                    <a:gd name="connsiteX45" fmla="*/ 55076 w 1613253"/>
                    <a:gd name="connsiteY45" fmla="*/ 5809 h 1685943"/>
                    <a:gd name="connsiteX46" fmla="*/ 36 w 1613253"/>
                    <a:gd name="connsiteY46" fmla="*/ 65270 h 1685943"/>
                    <a:gd name="connsiteX47" fmla="*/ 57787 w 1613253"/>
                    <a:gd name="connsiteY47" fmla="*/ 130566 h 1685943"/>
                    <a:gd name="connsiteX0" fmla="*/ 57787 w 1613253"/>
                    <a:gd name="connsiteY0" fmla="*/ 130566 h 1685943"/>
                    <a:gd name="connsiteX1" fmla="*/ 182681 w 1613253"/>
                    <a:gd name="connsiteY1" fmla="*/ 210180 h 1685943"/>
                    <a:gd name="connsiteX2" fmla="*/ 495431 w 1613253"/>
                    <a:gd name="connsiteY2" fmla="*/ 154222 h 1685943"/>
                    <a:gd name="connsiteX3" fmla="*/ 464327 w 1613253"/>
                    <a:gd name="connsiteY3" fmla="*/ 315307 h 1685943"/>
                    <a:gd name="connsiteX4" fmla="*/ 252459 w 1613253"/>
                    <a:gd name="connsiteY4" fmla="*/ 543269 h 1685943"/>
                    <a:gd name="connsiteX5" fmla="*/ 200156 w 1613253"/>
                    <a:gd name="connsiteY5" fmla="*/ 728897 h 1685943"/>
                    <a:gd name="connsiteX6" fmla="*/ 403356 w 1613253"/>
                    <a:gd name="connsiteY6" fmla="*/ 760647 h 1685943"/>
                    <a:gd name="connsiteX7" fmla="*/ 676327 w 1613253"/>
                    <a:gd name="connsiteY7" fmla="*/ 612304 h 1685943"/>
                    <a:gd name="connsiteX8" fmla="*/ 881595 w 1613253"/>
                    <a:gd name="connsiteY8" fmla="*/ 559252 h 1685943"/>
                    <a:gd name="connsiteX9" fmla="*/ 914531 w 1613253"/>
                    <a:gd name="connsiteY9" fmla="*/ 719372 h 1685943"/>
                    <a:gd name="connsiteX10" fmla="*/ 695004 w 1613253"/>
                    <a:gd name="connsiteY10" fmla="*/ 877562 h 1685943"/>
                    <a:gd name="connsiteX11" fmla="*/ 597031 w 1613253"/>
                    <a:gd name="connsiteY11" fmla="*/ 1036872 h 1685943"/>
                    <a:gd name="connsiteX12" fmla="*/ 708532 w 1613253"/>
                    <a:gd name="connsiteY12" fmla="*/ 1169151 h 1685943"/>
                    <a:gd name="connsiteX13" fmla="*/ 944137 w 1613253"/>
                    <a:gd name="connsiteY13" fmla="*/ 1053369 h 1685943"/>
                    <a:gd name="connsiteX14" fmla="*/ 1171706 w 1613253"/>
                    <a:gd name="connsiteY14" fmla="*/ 960672 h 1685943"/>
                    <a:gd name="connsiteX15" fmla="*/ 1311406 w 1613253"/>
                    <a:gd name="connsiteY15" fmla="*/ 1128947 h 1685943"/>
                    <a:gd name="connsiteX16" fmla="*/ 934417 w 1613253"/>
                    <a:gd name="connsiteY16" fmla="*/ 1416191 h 1685943"/>
                    <a:gd name="connsiteX17" fmla="*/ 1055805 w 1613253"/>
                    <a:gd name="connsiteY17" fmla="*/ 1553203 h 1685943"/>
                    <a:gd name="connsiteX18" fmla="*/ 1305022 w 1613253"/>
                    <a:gd name="connsiteY18" fmla="*/ 1554849 h 1685943"/>
                    <a:gd name="connsiteX19" fmla="*/ 1501174 w 1613253"/>
                    <a:gd name="connsiteY19" fmla="*/ 1682279 h 1685943"/>
                    <a:gd name="connsiteX20" fmla="*/ 1561325 w 1613253"/>
                    <a:gd name="connsiteY20" fmla="*/ 1649489 h 1685943"/>
                    <a:gd name="connsiteX21" fmla="*/ 1607707 w 1613253"/>
                    <a:gd name="connsiteY21" fmla="*/ 1629127 h 1685943"/>
                    <a:gd name="connsiteX22" fmla="*/ 1427588 w 1613253"/>
                    <a:gd name="connsiteY22" fmla="*/ 1497259 h 1685943"/>
                    <a:gd name="connsiteX23" fmla="*/ 1231220 w 1613253"/>
                    <a:gd name="connsiteY23" fmla="*/ 1439167 h 1685943"/>
                    <a:gd name="connsiteX24" fmla="*/ 1106244 w 1613253"/>
                    <a:gd name="connsiteY24" fmla="*/ 1456395 h 1685943"/>
                    <a:gd name="connsiteX25" fmla="*/ 1073624 w 1613253"/>
                    <a:gd name="connsiteY25" fmla="*/ 1407727 h 1685943"/>
                    <a:gd name="connsiteX26" fmla="*/ 1247016 w 1613253"/>
                    <a:gd name="connsiteY26" fmla="*/ 1288788 h 1685943"/>
                    <a:gd name="connsiteX27" fmla="*/ 1409831 w 1613253"/>
                    <a:gd name="connsiteY27" fmla="*/ 1132122 h 1685943"/>
                    <a:gd name="connsiteX28" fmla="*/ 1371731 w 1613253"/>
                    <a:gd name="connsiteY28" fmla="*/ 957497 h 1685943"/>
                    <a:gd name="connsiteX29" fmla="*/ 1152656 w 1613253"/>
                    <a:gd name="connsiteY29" fmla="*/ 865422 h 1685943"/>
                    <a:gd name="connsiteX30" fmla="*/ 927231 w 1613253"/>
                    <a:gd name="connsiteY30" fmla="*/ 935272 h 1685943"/>
                    <a:gd name="connsiteX31" fmla="*/ 739826 w 1613253"/>
                    <a:gd name="connsiteY31" fmla="*/ 1048790 h 1685943"/>
                    <a:gd name="connsiteX32" fmla="*/ 736731 w 1613253"/>
                    <a:gd name="connsiteY32" fmla="*/ 960672 h 1685943"/>
                    <a:gd name="connsiteX33" fmla="*/ 1000256 w 1613253"/>
                    <a:gd name="connsiteY33" fmla="*/ 779697 h 1685943"/>
                    <a:gd name="connsiteX34" fmla="*/ 1009781 w 1613253"/>
                    <a:gd name="connsiteY34" fmla="*/ 573322 h 1685943"/>
                    <a:gd name="connsiteX35" fmla="*/ 851031 w 1613253"/>
                    <a:gd name="connsiteY35" fmla="*/ 436797 h 1685943"/>
                    <a:gd name="connsiteX36" fmla="*/ 673986 w 1613253"/>
                    <a:gd name="connsiteY36" fmla="*/ 489447 h 1685943"/>
                    <a:gd name="connsiteX37" fmla="*/ 425581 w 1613253"/>
                    <a:gd name="connsiteY37" fmla="*/ 639997 h 1685943"/>
                    <a:gd name="connsiteX38" fmla="*/ 339856 w 1613253"/>
                    <a:gd name="connsiteY38" fmla="*/ 639997 h 1685943"/>
                    <a:gd name="connsiteX39" fmla="*/ 333506 w 1613253"/>
                    <a:gd name="connsiteY39" fmla="*/ 617772 h 1685943"/>
                    <a:gd name="connsiteX40" fmla="*/ 371606 w 1613253"/>
                    <a:gd name="connsiteY40" fmla="*/ 576497 h 1685943"/>
                    <a:gd name="connsiteX41" fmla="*/ 527909 w 1613253"/>
                    <a:gd name="connsiteY41" fmla="*/ 415704 h 1685943"/>
                    <a:gd name="connsiteX42" fmla="*/ 635131 w 1613253"/>
                    <a:gd name="connsiteY42" fmla="*/ 214547 h 1685943"/>
                    <a:gd name="connsiteX43" fmla="*/ 520831 w 1613253"/>
                    <a:gd name="connsiteY43" fmla="*/ 71672 h 1685943"/>
                    <a:gd name="connsiteX44" fmla="*/ 206506 w 1613253"/>
                    <a:gd name="connsiteY44" fmla="*/ 119297 h 1685943"/>
                    <a:gd name="connsiteX45" fmla="*/ 55076 w 1613253"/>
                    <a:gd name="connsiteY45" fmla="*/ 5809 h 1685943"/>
                    <a:gd name="connsiteX46" fmla="*/ 36 w 1613253"/>
                    <a:gd name="connsiteY46" fmla="*/ 65270 h 1685943"/>
                    <a:gd name="connsiteX47" fmla="*/ 57787 w 1613253"/>
                    <a:gd name="connsiteY47" fmla="*/ 130566 h 1685943"/>
                    <a:gd name="connsiteX0" fmla="*/ 57787 w 1613253"/>
                    <a:gd name="connsiteY0" fmla="*/ 130566 h 1685943"/>
                    <a:gd name="connsiteX1" fmla="*/ 182681 w 1613253"/>
                    <a:gd name="connsiteY1" fmla="*/ 210180 h 1685943"/>
                    <a:gd name="connsiteX2" fmla="*/ 495431 w 1613253"/>
                    <a:gd name="connsiteY2" fmla="*/ 154222 h 1685943"/>
                    <a:gd name="connsiteX3" fmla="*/ 464327 w 1613253"/>
                    <a:gd name="connsiteY3" fmla="*/ 315307 h 1685943"/>
                    <a:gd name="connsiteX4" fmla="*/ 252459 w 1613253"/>
                    <a:gd name="connsiteY4" fmla="*/ 543269 h 1685943"/>
                    <a:gd name="connsiteX5" fmla="*/ 200156 w 1613253"/>
                    <a:gd name="connsiteY5" fmla="*/ 728897 h 1685943"/>
                    <a:gd name="connsiteX6" fmla="*/ 403356 w 1613253"/>
                    <a:gd name="connsiteY6" fmla="*/ 760647 h 1685943"/>
                    <a:gd name="connsiteX7" fmla="*/ 676327 w 1613253"/>
                    <a:gd name="connsiteY7" fmla="*/ 612304 h 1685943"/>
                    <a:gd name="connsiteX8" fmla="*/ 881595 w 1613253"/>
                    <a:gd name="connsiteY8" fmla="*/ 559252 h 1685943"/>
                    <a:gd name="connsiteX9" fmla="*/ 914531 w 1613253"/>
                    <a:gd name="connsiteY9" fmla="*/ 719372 h 1685943"/>
                    <a:gd name="connsiteX10" fmla="*/ 695004 w 1613253"/>
                    <a:gd name="connsiteY10" fmla="*/ 877562 h 1685943"/>
                    <a:gd name="connsiteX11" fmla="*/ 597031 w 1613253"/>
                    <a:gd name="connsiteY11" fmla="*/ 1036872 h 1685943"/>
                    <a:gd name="connsiteX12" fmla="*/ 708532 w 1613253"/>
                    <a:gd name="connsiteY12" fmla="*/ 1169151 h 1685943"/>
                    <a:gd name="connsiteX13" fmla="*/ 944137 w 1613253"/>
                    <a:gd name="connsiteY13" fmla="*/ 1053369 h 1685943"/>
                    <a:gd name="connsiteX14" fmla="*/ 1171706 w 1613253"/>
                    <a:gd name="connsiteY14" fmla="*/ 960672 h 1685943"/>
                    <a:gd name="connsiteX15" fmla="*/ 1311406 w 1613253"/>
                    <a:gd name="connsiteY15" fmla="*/ 1128947 h 1685943"/>
                    <a:gd name="connsiteX16" fmla="*/ 934417 w 1613253"/>
                    <a:gd name="connsiteY16" fmla="*/ 1416191 h 1685943"/>
                    <a:gd name="connsiteX17" fmla="*/ 1055805 w 1613253"/>
                    <a:gd name="connsiteY17" fmla="*/ 1553203 h 1685943"/>
                    <a:gd name="connsiteX18" fmla="*/ 1305022 w 1613253"/>
                    <a:gd name="connsiteY18" fmla="*/ 1554849 h 1685943"/>
                    <a:gd name="connsiteX19" fmla="*/ 1501174 w 1613253"/>
                    <a:gd name="connsiteY19" fmla="*/ 1682279 h 1685943"/>
                    <a:gd name="connsiteX20" fmla="*/ 1561325 w 1613253"/>
                    <a:gd name="connsiteY20" fmla="*/ 1649489 h 1685943"/>
                    <a:gd name="connsiteX21" fmla="*/ 1607707 w 1613253"/>
                    <a:gd name="connsiteY21" fmla="*/ 1629127 h 1685943"/>
                    <a:gd name="connsiteX22" fmla="*/ 1427588 w 1613253"/>
                    <a:gd name="connsiteY22" fmla="*/ 1497259 h 1685943"/>
                    <a:gd name="connsiteX23" fmla="*/ 1231220 w 1613253"/>
                    <a:gd name="connsiteY23" fmla="*/ 1439167 h 1685943"/>
                    <a:gd name="connsiteX24" fmla="*/ 1106244 w 1613253"/>
                    <a:gd name="connsiteY24" fmla="*/ 1456395 h 1685943"/>
                    <a:gd name="connsiteX25" fmla="*/ 1129943 w 1613253"/>
                    <a:gd name="connsiteY25" fmla="*/ 1385196 h 1685943"/>
                    <a:gd name="connsiteX26" fmla="*/ 1247016 w 1613253"/>
                    <a:gd name="connsiteY26" fmla="*/ 1288788 h 1685943"/>
                    <a:gd name="connsiteX27" fmla="*/ 1409831 w 1613253"/>
                    <a:gd name="connsiteY27" fmla="*/ 1132122 h 1685943"/>
                    <a:gd name="connsiteX28" fmla="*/ 1371731 w 1613253"/>
                    <a:gd name="connsiteY28" fmla="*/ 957497 h 1685943"/>
                    <a:gd name="connsiteX29" fmla="*/ 1152656 w 1613253"/>
                    <a:gd name="connsiteY29" fmla="*/ 865422 h 1685943"/>
                    <a:gd name="connsiteX30" fmla="*/ 927231 w 1613253"/>
                    <a:gd name="connsiteY30" fmla="*/ 935272 h 1685943"/>
                    <a:gd name="connsiteX31" fmla="*/ 739826 w 1613253"/>
                    <a:gd name="connsiteY31" fmla="*/ 1048790 h 1685943"/>
                    <a:gd name="connsiteX32" fmla="*/ 736731 w 1613253"/>
                    <a:gd name="connsiteY32" fmla="*/ 960672 h 1685943"/>
                    <a:gd name="connsiteX33" fmla="*/ 1000256 w 1613253"/>
                    <a:gd name="connsiteY33" fmla="*/ 779697 h 1685943"/>
                    <a:gd name="connsiteX34" fmla="*/ 1009781 w 1613253"/>
                    <a:gd name="connsiteY34" fmla="*/ 573322 h 1685943"/>
                    <a:gd name="connsiteX35" fmla="*/ 851031 w 1613253"/>
                    <a:gd name="connsiteY35" fmla="*/ 436797 h 1685943"/>
                    <a:gd name="connsiteX36" fmla="*/ 673986 w 1613253"/>
                    <a:gd name="connsiteY36" fmla="*/ 489447 h 1685943"/>
                    <a:gd name="connsiteX37" fmla="*/ 425581 w 1613253"/>
                    <a:gd name="connsiteY37" fmla="*/ 639997 h 1685943"/>
                    <a:gd name="connsiteX38" fmla="*/ 339856 w 1613253"/>
                    <a:gd name="connsiteY38" fmla="*/ 639997 h 1685943"/>
                    <a:gd name="connsiteX39" fmla="*/ 333506 w 1613253"/>
                    <a:gd name="connsiteY39" fmla="*/ 617772 h 1685943"/>
                    <a:gd name="connsiteX40" fmla="*/ 371606 w 1613253"/>
                    <a:gd name="connsiteY40" fmla="*/ 576497 h 1685943"/>
                    <a:gd name="connsiteX41" fmla="*/ 527909 w 1613253"/>
                    <a:gd name="connsiteY41" fmla="*/ 415704 h 1685943"/>
                    <a:gd name="connsiteX42" fmla="*/ 635131 w 1613253"/>
                    <a:gd name="connsiteY42" fmla="*/ 214547 h 1685943"/>
                    <a:gd name="connsiteX43" fmla="*/ 520831 w 1613253"/>
                    <a:gd name="connsiteY43" fmla="*/ 71672 h 1685943"/>
                    <a:gd name="connsiteX44" fmla="*/ 206506 w 1613253"/>
                    <a:gd name="connsiteY44" fmla="*/ 119297 h 1685943"/>
                    <a:gd name="connsiteX45" fmla="*/ 55076 w 1613253"/>
                    <a:gd name="connsiteY45" fmla="*/ 5809 h 1685943"/>
                    <a:gd name="connsiteX46" fmla="*/ 36 w 1613253"/>
                    <a:gd name="connsiteY46" fmla="*/ 65270 h 1685943"/>
                    <a:gd name="connsiteX47" fmla="*/ 57787 w 1613253"/>
                    <a:gd name="connsiteY47" fmla="*/ 130566 h 1685943"/>
                    <a:gd name="connsiteX0" fmla="*/ 57787 w 1613253"/>
                    <a:gd name="connsiteY0" fmla="*/ 130566 h 1685943"/>
                    <a:gd name="connsiteX1" fmla="*/ 182681 w 1613253"/>
                    <a:gd name="connsiteY1" fmla="*/ 210180 h 1685943"/>
                    <a:gd name="connsiteX2" fmla="*/ 495431 w 1613253"/>
                    <a:gd name="connsiteY2" fmla="*/ 154222 h 1685943"/>
                    <a:gd name="connsiteX3" fmla="*/ 464327 w 1613253"/>
                    <a:gd name="connsiteY3" fmla="*/ 315307 h 1685943"/>
                    <a:gd name="connsiteX4" fmla="*/ 252459 w 1613253"/>
                    <a:gd name="connsiteY4" fmla="*/ 543269 h 1685943"/>
                    <a:gd name="connsiteX5" fmla="*/ 200156 w 1613253"/>
                    <a:gd name="connsiteY5" fmla="*/ 728897 h 1685943"/>
                    <a:gd name="connsiteX6" fmla="*/ 403356 w 1613253"/>
                    <a:gd name="connsiteY6" fmla="*/ 760647 h 1685943"/>
                    <a:gd name="connsiteX7" fmla="*/ 676327 w 1613253"/>
                    <a:gd name="connsiteY7" fmla="*/ 612304 h 1685943"/>
                    <a:gd name="connsiteX8" fmla="*/ 881595 w 1613253"/>
                    <a:gd name="connsiteY8" fmla="*/ 559252 h 1685943"/>
                    <a:gd name="connsiteX9" fmla="*/ 914531 w 1613253"/>
                    <a:gd name="connsiteY9" fmla="*/ 719372 h 1685943"/>
                    <a:gd name="connsiteX10" fmla="*/ 695004 w 1613253"/>
                    <a:gd name="connsiteY10" fmla="*/ 877562 h 1685943"/>
                    <a:gd name="connsiteX11" fmla="*/ 597031 w 1613253"/>
                    <a:gd name="connsiteY11" fmla="*/ 1036872 h 1685943"/>
                    <a:gd name="connsiteX12" fmla="*/ 708532 w 1613253"/>
                    <a:gd name="connsiteY12" fmla="*/ 1169151 h 1685943"/>
                    <a:gd name="connsiteX13" fmla="*/ 944137 w 1613253"/>
                    <a:gd name="connsiteY13" fmla="*/ 1053369 h 1685943"/>
                    <a:gd name="connsiteX14" fmla="*/ 1171706 w 1613253"/>
                    <a:gd name="connsiteY14" fmla="*/ 960672 h 1685943"/>
                    <a:gd name="connsiteX15" fmla="*/ 1311406 w 1613253"/>
                    <a:gd name="connsiteY15" fmla="*/ 1128947 h 1685943"/>
                    <a:gd name="connsiteX16" fmla="*/ 934417 w 1613253"/>
                    <a:gd name="connsiteY16" fmla="*/ 1416191 h 1685943"/>
                    <a:gd name="connsiteX17" fmla="*/ 1055805 w 1613253"/>
                    <a:gd name="connsiteY17" fmla="*/ 1553203 h 1685943"/>
                    <a:gd name="connsiteX18" fmla="*/ 1305022 w 1613253"/>
                    <a:gd name="connsiteY18" fmla="*/ 1554849 h 1685943"/>
                    <a:gd name="connsiteX19" fmla="*/ 1501174 w 1613253"/>
                    <a:gd name="connsiteY19" fmla="*/ 1682279 h 1685943"/>
                    <a:gd name="connsiteX20" fmla="*/ 1561325 w 1613253"/>
                    <a:gd name="connsiteY20" fmla="*/ 1649489 h 1685943"/>
                    <a:gd name="connsiteX21" fmla="*/ 1607707 w 1613253"/>
                    <a:gd name="connsiteY21" fmla="*/ 1629127 h 1685943"/>
                    <a:gd name="connsiteX22" fmla="*/ 1427588 w 1613253"/>
                    <a:gd name="connsiteY22" fmla="*/ 1497259 h 1685943"/>
                    <a:gd name="connsiteX23" fmla="*/ 1231220 w 1613253"/>
                    <a:gd name="connsiteY23" fmla="*/ 1439167 h 1685943"/>
                    <a:gd name="connsiteX24" fmla="*/ 1126025 w 1613253"/>
                    <a:gd name="connsiteY24" fmla="*/ 1451704 h 1685943"/>
                    <a:gd name="connsiteX25" fmla="*/ 1129943 w 1613253"/>
                    <a:gd name="connsiteY25" fmla="*/ 1385196 h 1685943"/>
                    <a:gd name="connsiteX26" fmla="*/ 1247016 w 1613253"/>
                    <a:gd name="connsiteY26" fmla="*/ 1288788 h 1685943"/>
                    <a:gd name="connsiteX27" fmla="*/ 1409831 w 1613253"/>
                    <a:gd name="connsiteY27" fmla="*/ 1132122 h 1685943"/>
                    <a:gd name="connsiteX28" fmla="*/ 1371731 w 1613253"/>
                    <a:gd name="connsiteY28" fmla="*/ 957497 h 1685943"/>
                    <a:gd name="connsiteX29" fmla="*/ 1152656 w 1613253"/>
                    <a:gd name="connsiteY29" fmla="*/ 865422 h 1685943"/>
                    <a:gd name="connsiteX30" fmla="*/ 927231 w 1613253"/>
                    <a:gd name="connsiteY30" fmla="*/ 935272 h 1685943"/>
                    <a:gd name="connsiteX31" fmla="*/ 739826 w 1613253"/>
                    <a:gd name="connsiteY31" fmla="*/ 1048790 h 1685943"/>
                    <a:gd name="connsiteX32" fmla="*/ 736731 w 1613253"/>
                    <a:gd name="connsiteY32" fmla="*/ 960672 h 1685943"/>
                    <a:gd name="connsiteX33" fmla="*/ 1000256 w 1613253"/>
                    <a:gd name="connsiteY33" fmla="*/ 779697 h 1685943"/>
                    <a:gd name="connsiteX34" fmla="*/ 1009781 w 1613253"/>
                    <a:gd name="connsiteY34" fmla="*/ 573322 h 1685943"/>
                    <a:gd name="connsiteX35" fmla="*/ 851031 w 1613253"/>
                    <a:gd name="connsiteY35" fmla="*/ 436797 h 1685943"/>
                    <a:gd name="connsiteX36" fmla="*/ 673986 w 1613253"/>
                    <a:gd name="connsiteY36" fmla="*/ 489447 h 1685943"/>
                    <a:gd name="connsiteX37" fmla="*/ 425581 w 1613253"/>
                    <a:gd name="connsiteY37" fmla="*/ 639997 h 1685943"/>
                    <a:gd name="connsiteX38" fmla="*/ 339856 w 1613253"/>
                    <a:gd name="connsiteY38" fmla="*/ 639997 h 1685943"/>
                    <a:gd name="connsiteX39" fmla="*/ 333506 w 1613253"/>
                    <a:gd name="connsiteY39" fmla="*/ 617772 h 1685943"/>
                    <a:gd name="connsiteX40" fmla="*/ 371606 w 1613253"/>
                    <a:gd name="connsiteY40" fmla="*/ 576497 h 1685943"/>
                    <a:gd name="connsiteX41" fmla="*/ 527909 w 1613253"/>
                    <a:gd name="connsiteY41" fmla="*/ 415704 h 1685943"/>
                    <a:gd name="connsiteX42" fmla="*/ 635131 w 1613253"/>
                    <a:gd name="connsiteY42" fmla="*/ 214547 h 1685943"/>
                    <a:gd name="connsiteX43" fmla="*/ 520831 w 1613253"/>
                    <a:gd name="connsiteY43" fmla="*/ 71672 h 1685943"/>
                    <a:gd name="connsiteX44" fmla="*/ 206506 w 1613253"/>
                    <a:gd name="connsiteY44" fmla="*/ 119297 h 1685943"/>
                    <a:gd name="connsiteX45" fmla="*/ 55076 w 1613253"/>
                    <a:gd name="connsiteY45" fmla="*/ 5809 h 1685943"/>
                    <a:gd name="connsiteX46" fmla="*/ 36 w 1613253"/>
                    <a:gd name="connsiteY46" fmla="*/ 65270 h 1685943"/>
                    <a:gd name="connsiteX47" fmla="*/ 57787 w 1613253"/>
                    <a:gd name="connsiteY47" fmla="*/ 130566 h 1685943"/>
                    <a:gd name="connsiteX0" fmla="*/ 57787 w 1613253"/>
                    <a:gd name="connsiteY0" fmla="*/ 130566 h 1685943"/>
                    <a:gd name="connsiteX1" fmla="*/ 182681 w 1613253"/>
                    <a:gd name="connsiteY1" fmla="*/ 210180 h 1685943"/>
                    <a:gd name="connsiteX2" fmla="*/ 495431 w 1613253"/>
                    <a:gd name="connsiteY2" fmla="*/ 154222 h 1685943"/>
                    <a:gd name="connsiteX3" fmla="*/ 464327 w 1613253"/>
                    <a:gd name="connsiteY3" fmla="*/ 315307 h 1685943"/>
                    <a:gd name="connsiteX4" fmla="*/ 252459 w 1613253"/>
                    <a:gd name="connsiteY4" fmla="*/ 543269 h 1685943"/>
                    <a:gd name="connsiteX5" fmla="*/ 200156 w 1613253"/>
                    <a:gd name="connsiteY5" fmla="*/ 728897 h 1685943"/>
                    <a:gd name="connsiteX6" fmla="*/ 403356 w 1613253"/>
                    <a:gd name="connsiteY6" fmla="*/ 760647 h 1685943"/>
                    <a:gd name="connsiteX7" fmla="*/ 676327 w 1613253"/>
                    <a:gd name="connsiteY7" fmla="*/ 612304 h 1685943"/>
                    <a:gd name="connsiteX8" fmla="*/ 881595 w 1613253"/>
                    <a:gd name="connsiteY8" fmla="*/ 559252 h 1685943"/>
                    <a:gd name="connsiteX9" fmla="*/ 914531 w 1613253"/>
                    <a:gd name="connsiteY9" fmla="*/ 719372 h 1685943"/>
                    <a:gd name="connsiteX10" fmla="*/ 695004 w 1613253"/>
                    <a:gd name="connsiteY10" fmla="*/ 877562 h 1685943"/>
                    <a:gd name="connsiteX11" fmla="*/ 597031 w 1613253"/>
                    <a:gd name="connsiteY11" fmla="*/ 1036872 h 1685943"/>
                    <a:gd name="connsiteX12" fmla="*/ 708532 w 1613253"/>
                    <a:gd name="connsiteY12" fmla="*/ 1169151 h 1685943"/>
                    <a:gd name="connsiteX13" fmla="*/ 944137 w 1613253"/>
                    <a:gd name="connsiteY13" fmla="*/ 1053369 h 1685943"/>
                    <a:gd name="connsiteX14" fmla="*/ 1171706 w 1613253"/>
                    <a:gd name="connsiteY14" fmla="*/ 960672 h 1685943"/>
                    <a:gd name="connsiteX15" fmla="*/ 1311406 w 1613253"/>
                    <a:gd name="connsiteY15" fmla="*/ 1128947 h 1685943"/>
                    <a:gd name="connsiteX16" fmla="*/ 986353 w 1613253"/>
                    <a:gd name="connsiteY16" fmla="*/ 1388074 h 1685943"/>
                    <a:gd name="connsiteX17" fmla="*/ 1055805 w 1613253"/>
                    <a:gd name="connsiteY17" fmla="*/ 1553203 h 1685943"/>
                    <a:gd name="connsiteX18" fmla="*/ 1305022 w 1613253"/>
                    <a:gd name="connsiteY18" fmla="*/ 1554849 h 1685943"/>
                    <a:gd name="connsiteX19" fmla="*/ 1501174 w 1613253"/>
                    <a:gd name="connsiteY19" fmla="*/ 1682279 h 1685943"/>
                    <a:gd name="connsiteX20" fmla="*/ 1561325 w 1613253"/>
                    <a:gd name="connsiteY20" fmla="*/ 1649489 h 1685943"/>
                    <a:gd name="connsiteX21" fmla="*/ 1607707 w 1613253"/>
                    <a:gd name="connsiteY21" fmla="*/ 1629127 h 1685943"/>
                    <a:gd name="connsiteX22" fmla="*/ 1427588 w 1613253"/>
                    <a:gd name="connsiteY22" fmla="*/ 1497259 h 1685943"/>
                    <a:gd name="connsiteX23" fmla="*/ 1231220 w 1613253"/>
                    <a:gd name="connsiteY23" fmla="*/ 1439167 h 1685943"/>
                    <a:gd name="connsiteX24" fmla="*/ 1126025 w 1613253"/>
                    <a:gd name="connsiteY24" fmla="*/ 1451704 h 1685943"/>
                    <a:gd name="connsiteX25" fmla="*/ 1129943 w 1613253"/>
                    <a:gd name="connsiteY25" fmla="*/ 1385196 h 1685943"/>
                    <a:gd name="connsiteX26" fmla="*/ 1247016 w 1613253"/>
                    <a:gd name="connsiteY26" fmla="*/ 1288788 h 1685943"/>
                    <a:gd name="connsiteX27" fmla="*/ 1409831 w 1613253"/>
                    <a:gd name="connsiteY27" fmla="*/ 1132122 h 1685943"/>
                    <a:gd name="connsiteX28" fmla="*/ 1371731 w 1613253"/>
                    <a:gd name="connsiteY28" fmla="*/ 957497 h 1685943"/>
                    <a:gd name="connsiteX29" fmla="*/ 1152656 w 1613253"/>
                    <a:gd name="connsiteY29" fmla="*/ 865422 h 1685943"/>
                    <a:gd name="connsiteX30" fmla="*/ 927231 w 1613253"/>
                    <a:gd name="connsiteY30" fmla="*/ 935272 h 1685943"/>
                    <a:gd name="connsiteX31" fmla="*/ 739826 w 1613253"/>
                    <a:gd name="connsiteY31" fmla="*/ 1048790 h 1685943"/>
                    <a:gd name="connsiteX32" fmla="*/ 736731 w 1613253"/>
                    <a:gd name="connsiteY32" fmla="*/ 960672 h 1685943"/>
                    <a:gd name="connsiteX33" fmla="*/ 1000256 w 1613253"/>
                    <a:gd name="connsiteY33" fmla="*/ 779697 h 1685943"/>
                    <a:gd name="connsiteX34" fmla="*/ 1009781 w 1613253"/>
                    <a:gd name="connsiteY34" fmla="*/ 573322 h 1685943"/>
                    <a:gd name="connsiteX35" fmla="*/ 851031 w 1613253"/>
                    <a:gd name="connsiteY35" fmla="*/ 436797 h 1685943"/>
                    <a:gd name="connsiteX36" fmla="*/ 673986 w 1613253"/>
                    <a:gd name="connsiteY36" fmla="*/ 489447 h 1685943"/>
                    <a:gd name="connsiteX37" fmla="*/ 425581 w 1613253"/>
                    <a:gd name="connsiteY37" fmla="*/ 639997 h 1685943"/>
                    <a:gd name="connsiteX38" fmla="*/ 339856 w 1613253"/>
                    <a:gd name="connsiteY38" fmla="*/ 639997 h 1685943"/>
                    <a:gd name="connsiteX39" fmla="*/ 333506 w 1613253"/>
                    <a:gd name="connsiteY39" fmla="*/ 617772 h 1685943"/>
                    <a:gd name="connsiteX40" fmla="*/ 371606 w 1613253"/>
                    <a:gd name="connsiteY40" fmla="*/ 576497 h 1685943"/>
                    <a:gd name="connsiteX41" fmla="*/ 527909 w 1613253"/>
                    <a:gd name="connsiteY41" fmla="*/ 415704 h 1685943"/>
                    <a:gd name="connsiteX42" fmla="*/ 635131 w 1613253"/>
                    <a:gd name="connsiteY42" fmla="*/ 214547 h 1685943"/>
                    <a:gd name="connsiteX43" fmla="*/ 520831 w 1613253"/>
                    <a:gd name="connsiteY43" fmla="*/ 71672 h 1685943"/>
                    <a:gd name="connsiteX44" fmla="*/ 206506 w 1613253"/>
                    <a:gd name="connsiteY44" fmla="*/ 119297 h 1685943"/>
                    <a:gd name="connsiteX45" fmla="*/ 55076 w 1613253"/>
                    <a:gd name="connsiteY45" fmla="*/ 5809 h 1685943"/>
                    <a:gd name="connsiteX46" fmla="*/ 36 w 1613253"/>
                    <a:gd name="connsiteY46" fmla="*/ 65270 h 1685943"/>
                    <a:gd name="connsiteX47" fmla="*/ 57787 w 1613253"/>
                    <a:gd name="connsiteY47" fmla="*/ 130566 h 1685943"/>
                    <a:gd name="connsiteX0" fmla="*/ 242118 w 1797584"/>
                    <a:gd name="connsiteY0" fmla="*/ 321421 h 1876798"/>
                    <a:gd name="connsiteX1" fmla="*/ 367012 w 1797584"/>
                    <a:gd name="connsiteY1" fmla="*/ 401035 h 1876798"/>
                    <a:gd name="connsiteX2" fmla="*/ 679762 w 1797584"/>
                    <a:gd name="connsiteY2" fmla="*/ 345077 h 1876798"/>
                    <a:gd name="connsiteX3" fmla="*/ 648658 w 1797584"/>
                    <a:gd name="connsiteY3" fmla="*/ 506162 h 1876798"/>
                    <a:gd name="connsiteX4" fmla="*/ 436790 w 1797584"/>
                    <a:gd name="connsiteY4" fmla="*/ 734124 h 1876798"/>
                    <a:gd name="connsiteX5" fmla="*/ 384487 w 1797584"/>
                    <a:gd name="connsiteY5" fmla="*/ 919752 h 1876798"/>
                    <a:gd name="connsiteX6" fmla="*/ 587687 w 1797584"/>
                    <a:gd name="connsiteY6" fmla="*/ 951502 h 1876798"/>
                    <a:gd name="connsiteX7" fmla="*/ 860658 w 1797584"/>
                    <a:gd name="connsiteY7" fmla="*/ 803159 h 1876798"/>
                    <a:gd name="connsiteX8" fmla="*/ 1065926 w 1797584"/>
                    <a:gd name="connsiteY8" fmla="*/ 750107 h 1876798"/>
                    <a:gd name="connsiteX9" fmla="*/ 1098862 w 1797584"/>
                    <a:gd name="connsiteY9" fmla="*/ 910227 h 1876798"/>
                    <a:gd name="connsiteX10" fmla="*/ 879335 w 1797584"/>
                    <a:gd name="connsiteY10" fmla="*/ 1068417 h 1876798"/>
                    <a:gd name="connsiteX11" fmla="*/ 781362 w 1797584"/>
                    <a:gd name="connsiteY11" fmla="*/ 1227727 h 1876798"/>
                    <a:gd name="connsiteX12" fmla="*/ 892863 w 1797584"/>
                    <a:gd name="connsiteY12" fmla="*/ 1360006 h 1876798"/>
                    <a:gd name="connsiteX13" fmla="*/ 1128468 w 1797584"/>
                    <a:gd name="connsiteY13" fmla="*/ 1244224 h 1876798"/>
                    <a:gd name="connsiteX14" fmla="*/ 1356037 w 1797584"/>
                    <a:gd name="connsiteY14" fmla="*/ 1151527 h 1876798"/>
                    <a:gd name="connsiteX15" fmla="*/ 1495737 w 1797584"/>
                    <a:gd name="connsiteY15" fmla="*/ 1319802 h 1876798"/>
                    <a:gd name="connsiteX16" fmla="*/ 1170684 w 1797584"/>
                    <a:gd name="connsiteY16" fmla="*/ 1578929 h 1876798"/>
                    <a:gd name="connsiteX17" fmla="*/ 1240136 w 1797584"/>
                    <a:gd name="connsiteY17" fmla="*/ 1744058 h 1876798"/>
                    <a:gd name="connsiteX18" fmla="*/ 1489353 w 1797584"/>
                    <a:gd name="connsiteY18" fmla="*/ 1745704 h 1876798"/>
                    <a:gd name="connsiteX19" fmla="*/ 1685505 w 1797584"/>
                    <a:gd name="connsiteY19" fmla="*/ 1873134 h 1876798"/>
                    <a:gd name="connsiteX20" fmla="*/ 1745656 w 1797584"/>
                    <a:gd name="connsiteY20" fmla="*/ 1840344 h 1876798"/>
                    <a:gd name="connsiteX21" fmla="*/ 1792038 w 1797584"/>
                    <a:gd name="connsiteY21" fmla="*/ 1819982 h 1876798"/>
                    <a:gd name="connsiteX22" fmla="*/ 1611919 w 1797584"/>
                    <a:gd name="connsiteY22" fmla="*/ 1688114 h 1876798"/>
                    <a:gd name="connsiteX23" fmla="*/ 1415551 w 1797584"/>
                    <a:gd name="connsiteY23" fmla="*/ 1630022 h 1876798"/>
                    <a:gd name="connsiteX24" fmla="*/ 1310356 w 1797584"/>
                    <a:gd name="connsiteY24" fmla="*/ 1642559 h 1876798"/>
                    <a:gd name="connsiteX25" fmla="*/ 1314274 w 1797584"/>
                    <a:gd name="connsiteY25" fmla="*/ 1576051 h 1876798"/>
                    <a:gd name="connsiteX26" fmla="*/ 1431347 w 1797584"/>
                    <a:gd name="connsiteY26" fmla="*/ 1479643 h 1876798"/>
                    <a:gd name="connsiteX27" fmla="*/ 1594162 w 1797584"/>
                    <a:gd name="connsiteY27" fmla="*/ 1322977 h 1876798"/>
                    <a:gd name="connsiteX28" fmla="*/ 1556062 w 1797584"/>
                    <a:gd name="connsiteY28" fmla="*/ 1148352 h 1876798"/>
                    <a:gd name="connsiteX29" fmla="*/ 1336987 w 1797584"/>
                    <a:gd name="connsiteY29" fmla="*/ 1056277 h 1876798"/>
                    <a:gd name="connsiteX30" fmla="*/ 1111562 w 1797584"/>
                    <a:gd name="connsiteY30" fmla="*/ 1126127 h 1876798"/>
                    <a:gd name="connsiteX31" fmla="*/ 924157 w 1797584"/>
                    <a:gd name="connsiteY31" fmla="*/ 1239645 h 1876798"/>
                    <a:gd name="connsiteX32" fmla="*/ 921062 w 1797584"/>
                    <a:gd name="connsiteY32" fmla="*/ 1151527 h 1876798"/>
                    <a:gd name="connsiteX33" fmla="*/ 1184587 w 1797584"/>
                    <a:gd name="connsiteY33" fmla="*/ 970552 h 1876798"/>
                    <a:gd name="connsiteX34" fmla="*/ 1194112 w 1797584"/>
                    <a:gd name="connsiteY34" fmla="*/ 764177 h 1876798"/>
                    <a:gd name="connsiteX35" fmla="*/ 1035362 w 1797584"/>
                    <a:gd name="connsiteY35" fmla="*/ 627652 h 1876798"/>
                    <a:gd name="connsiteX36" fmla="*/ 858317 w 1797584"/>
                    <a:gd name="connsiteY36" fmla="*/ 680302 h 1876798"/>
                    <a:gd name="connsiteX37" fmla="*/ 609912 w 1797584"/>
                    <a:gd name="connsiteY37" fmla="*/ 830852 h 1876798"/>
                    <a:gd name="connsiteX38" fmla="*/ 524187 w 1797584"/>
                    <a:gd name="connsiteY38" fmla="*/ 830852 h 1876798"/>
                    <a:gd name="connsiteX39" fmla="*/ 517837 w 1797584"/>
                    <a:gd name="connsiteY39" fmla="*/ 808627 h 1876798"/>
                    <a:gd name="connsiteX40" fmla="*/ 555937 w 1797584"/>
                    <a:gd name="connsiteY40" fmla="*/ 767352 h 1876798"/>
                    <a:gd name="connsiteX41" fmla="*/ 712240 w 1797584"/>
                    <a:gd name="connsiteY41" fmla="*/ 606559 h 1876798"/>
                    <a:gd name="connsiteX42" fmla="*/ 819462 w 1797584"/>
                    <a:gd name="connsiteY42" fmla="*/ 405402 h 1876798"/>
                    <a:gd name="connsiteX43" fmla="*/ 705162 w 1797584"/>
                    <a:gd name="connsiteY43" fmla="*/ 262527 h 1876798"/>
                    <a:gd name="connsiteX44" fmla="*/ 390837 w 1797584"/>
                    <a:gd name="connsiteY44" fmla="*/ 310152 h 1876798"/>
                    <a:gd name="connsiteX45" fmla="*/ 239407 w 1797584"/>
                    <a:gd name="connsiteY45" fmla="*/ 196664 h 1876798"/>
                    <a:gd name="connsiteX46" fmla="*/ 0 w 1797584"/>
                    <a:gd name="connsiteY46" fmla="*/ 1223 h 1876798"/>
                    <a:gd name="connsiteX47" fmla="*/ 242118 w 1797584"/>
                    <a:gd name="connsiteY47" fmla="*/ 321421 h 1876798"/>
                    <a:gd name="connsiteX0" fmla="*/ 250888 w 1806354"/>
                    <a:gd name="connsiteY0" fmla="*/ 341711 h 1897088"/>
                    <a:gd name="connsiteX1" fmla="*/ 375782 w 1806354"/>
                    <a:gd name="connsiteY1" fmla="*/ 421325 h 1897088"/>
                    <a:gd name="connsiteX2" fmla="*/ 688532 w 1806354"/>
                    <a:gd name="connsiteY2" fmla="*/ 365367 h 1897088"/>
                    <a:gd name="connsiteX3" fmla="*/ 657428 w 1806354"/>
                    <a:gd name="connsiteY3" fmla="*/ 526452 h 1897088"/>
                    <a:gd name="connsiteX4" fmla="*/ 445560 w 1806354"/>
                    <a:gd name="connsiteY4" fmla="*/ 754414 h 1897088"/>
                    <a:gd name="connsiteX5" fmla="*/ 393257 w 1806354"/>
                    <a:gd name="connsiteY5" fmla="*/ 940042 h 1897088"/>
                    <a:gd name="connsiteX6" fmla="*/ 596457 w 1806354"/>
                    <a:gd name="connsiteY6" fmla="*/ 971792 h 1897088"/>
                    <a:gd name="connsiteX7" fmla="*/ 869428 w 1806354"/>
                    <a:gd name="connsiteY7" fmla="*/ 823449 h 1897088"/>
                    <a:gd name="connsiteX8" fmla="*/ 1074696 w 1806354"/>
                    <a:gd name="connsiteY8" fmla="*/ 770397 h 1897088"/>
                    <a:gd name="connsiteX9" fmla="*/ 1107632 w 1806354"/>
                    <a:gd name="connsiteY9" fmla="*/ 930517 h 1897088"/>
                    <a:gd name="connsiteX10" fmla="*/ 888105 w 1806354"/>
                    <a:gd name="connsiteY10" fmla="*/ 1088707 h 1897088"/>
                    <a:gd name="connsiteX11" fmla="*/ 790132 w 1806354"/>
                    <a:gd name="connsiteY11" fmla="*/ 1248017 h 1897088"/>
                    <a:gd name="connsiteX12" fmla="*/ 901633 w 1806354"/>
                    <a:gd name="connsiteY12" fmla="*/ 1380296 h 1897088"/>
                    <a:gd name="connsiteX13" fmla="*/ 1137238 w 1806354"/>
                    <a:gd name="connsiteY13" fmla="*/ 1264514 h 1897088"/>
                    <a:gd name="connsiteX14" fmla="*/ 1364807 w 1806354"/>
                    <a:gd name="connsiteY14" fmla="*/ 1171817 h 1897088"/>
                    <a:gd name="connsiteX15" fmla="*/ 1504507 w 1806354"/>
                    <a:gd name="connsiteY15" fmla="*/ 1340092 h 1897088"/>
                    <a:gd name="connsiteX16" fmla="*/ 1179454 w 1806354"/>
                    <a:gd name="connsiteY16" fmla="*/ 1599219 h 1897088"/>
                    <a:gd name="connsiteX17" fmla="*/ 1248906 w 1806354"/>
                    <a:gd name="connsiteY17" fmla="*/ 1764348 h 1897088"/>
                    <a:gd name="connsiteX18" fmla="*/ 1498123 w 1806354"/>
                    <a:gd name="connsiteY18" fmla="*/ 1765994 h 1897088"/>
                    <a:gd name="connsiteX19" fmla="*/ 1694275 w 1806354"/>
                    <a:gd name="connsiteY19" fmla="*/ 1893424 h 1897088"/>
                    <a:gd name="connsiteX20" fmla="*/ 1754426 w 1806354"/>
                    <a:gd name="connsiteY20" fmla="*/ 1860634 h 1897088"/>
                    <a:gd name="connsiteX21" fmla="*/ 1800808 w 1806354"/>
                    <a:gd name="connsiteY21" fmla="*/ 1840272 h 1897088"/>
                    <a:gd name="connsiteX22" fmla="*/ 1620689 w 1806354"/>
                    <a:gd name="connsiteY22" fmla="*/ 1708404 h 1897088"/>
                    <a:gd name="connsiteX23" fmla="*/ 1424321 w 1806354"/>
                    <a:gd name="connsiteY23" fmla="*/ 1650312 h 1897088"/>
                    <a:gd name="connsiteX24" fmla="*/ 1319126 w 1806354"/>
                    <a:gd name="connsiteY24" fmla="*/ 1662849 h 1897088"/>
                    <a:gd name="connsiteX25" fmla="*/ 1323044 w 1806354"/>
                    <a:gd name="connsiteY25" fmla="*/ 1596341 h 1897088"/>
                    <a:gd name="connsiteX26" fmla="*/ 1440117 w 1806354"/>
                    <a:gd name="connsiteY26" fmla="*/ 1499933 h 1897088"/>
                    <a:gd name="connsiteX27" fmla="*/ 1602932 w 1806354"/>
                    <a:gd name="connsiteY27" fmla="*/ 1343267 h 1897088"/>
                    <a:gd name="connsiteX28" fmla="*/ 1564832 w 1806354"/>
                    <a:gd name="connsiteY28" fmla="*/ 1168642 h 1897088"/>
                    <a:gd name="connsiteX29" fmla="*/ 1345757 w 1806354"/>
                    <a:gd name="connsiteY29" fmla="*/ 1076567 h 1897088"/>
                    <a:gd name="connsiteX30" fmla="*/ 1120332 w 1806354"/>
                    <a:gd name="connsiteY30" fmla="*/ 1146417 h 1897088"/>
                    <a:gd name="connsiteX31" fmla="*/ 932927 w 1806354"/>
                    <a:gd name="connsiteY31" fmla="*/ 1259935 h 1897088"/>
                    <a:gd name="connsiteX32" fmla="*/ 929832 w 1806354"/>
                    <a:gd name="connsiteY32" fmla="*/ 1171817 h 1897088"/>
                    <a:gd name="connsiteX33" fmla="*/ 1193357 w 1806354"/>
                    <a:gd name="connsiteY33" fmla="*/ 990842 h 1897088"/>
                    <a:gd name="connsiteX34" fmla="*/ 1202882 w 1806354"/>
                    <a:gd name="connsiteY34" fmla="*/ 784467 h 1897088"/>
                    <a:gd name="connsiteX35" fmla="*/ 1044132 w 1806354"/>
                    <a:gd name="connsiteY35" fmla="*/ 647942 h 1897088"/>
                    <a:gd name="connsiteX36" fmla="*/ 867087 w 1806354"/>
                    <a:gd name="connsiteY36" fmla="*/ 700592 h 1897088"/>
                    <a:gd name="connsiteX37" fmla="*/ 618682 w 1806354"/>
                    <a:gd name="connsiteY37" fmla="*/ 851142 h 1897088"/>
                    <a:gd name="connsiteX38" fmla="*/ 532957 w 1806354"/>
                    <a:gd name="connsiteY38" fmla="*/ 851142 h 1897088"/>
                    <a:gd name="connsiteX39" fmla="*/ 526607 w 1806354"/>
                    <a:gd name="connsiteY39" fmla="*/ 828917 h 1897088"/>
                    <a:gd name="connsiteX40" fmla="*/ 564707 w 1806354"/>
                    <a:gd name="connsiteY40" fmla="*/ 787642 h 1897088"/>
                    <a:gd name="connsiteX41" fmla="*/ 721010 w 1806354"/>
                    <a:gd name="connsiteY41" fmla="*/ 626849 h 1897088"/>
                    <a:gd name="connsiteX42" fmla="*/ 828232 w 1806354"/>
                    <a:gd name="connsiteY42" fmla="*/ 425692 h 1897088"/>
                    <a:gd name="connsiteX43" fmla="*/ 713932 w 1806354"/>
                    <a:gd name="connsiteY43" fmla="*/ 282817 h 1897088"/>
                    <a:gd name="connsiteX44" fmla="*/ 399607 w 1806354"/>
                    <a:gd name="connsiteY44" fmla="*/ 330442 h 1897088"/>
                    <a:gd name="connsiteX45" fmla="*/ 78879 w 1806354"/>
                    <a:gd name="connsiteY45" fmla="*/ 5395 h 1897088"/>
                    <a:gd name="connsiteX46" fmla="*/ 8770 w 1806354"/>
                    <a:gd name="connsiteY46" fmla="*/ 21513 h 1897088"/>
                    <a:gd name="connsiteX47" fmla="*/ 250888 w 1806354"/>
                    <a:gd name="connsiteY47" fmla="*/ 341711 h 1897088"/>
                    <a:gd name="connsiteX0" fmla="*/ 429123 w 1984589"/>
                    <a:gd name="connsiteY0" fmla="*/ 339099 h 1894476"/>
                    <a:gd name="connsiteX1" fmla="*/ 554017 w 1984589"/>
                    <a:gd name="connsiteY1" fmla="*/ 418713 h 1894476"/>
                    <a:gd name="connsiteX2" fmla="*/ 866767 w 1984589"/>
                    <a:gd name="connsiteY2" fmla="*/ 362755 h 1894476"/>
                    <a:gd name="connsiteX3" fmla="*/ 835663 w 1984589"/>
                    <a:gd name="connsiteY3" fmla="*/ 523840 h 1894476"/>
                    <a:gd name="connsiteX4" fmla="*/ 623795 w 1984589"/>
                    <a:gd name="connsiteY4" fmla="*/ 751802 h 1894476"/>
                    <a:gd name="connsiteX5" fmla="*/ 571492 w 1984589"/>
                    <a:gd name="connsiteY5" fmla="*/ 937430 h 1894476"/>
                    <a:gd name="connsiteX6" fmla="*/ 774692 w 1984589"/>
                    <a:gd name="connsiteY6" fmla="*/ 969180 h 1894476"/>
                    <a:gd name="connsiteX7" fmla="*/ 1047663 w 1984589"/>
                    <a:gd name="connsiteY7" fmla="*/ 820837 h 1894476"/>
                    <a:gd name="connsiteX8" fmla="*/ 1252931 w 1984589"/>
                    <a:gd name="connsiteY8" fmla="*/ 767785 h 1894476"/>
                    <a:gd name="connsiteX9" fmla="*/ 1285867 w 1984589"/>
                    <a:gd name="connsiteY9" fmla="*/ 927905 h 1894476"/>
                    <a:gd name="connsiteX10" fmla="*/ 1066340 w 1984589"/>
                    <a:gd name="connsiteY10" fmla="*/ 1086095 h 1894476"/>
                    <a:gd name="connsiteX11" fmla="*/ 968367 w 1984589"/>
                    <a:gd name="connsiteY11" fmla="*/ 1245405 h 1894476"/>
                    <a:gd name="connsiteX12" fmla="*/ 1079868 w 1984589"/>
                    <a:gd name="connsiteY12" fmla="*/ 1377684 h 1894476"/>
                    <a:gd name="connsiteX13" fmla="*/ 1315473 w 1984589"/>
                    <a:gd name="connsiteY13" fmla="*/ 1261902 h 1894476"/>
                    <a:gd name="connsiteX14" fmla="*/ 1543042 w 1984589"/>
                    <a:gd name="connsiteY14" fmla="*/ 1169205 h 1894476"/>
                    <a:gd name="connsiteX15" fmla="*/ 1682742 w 1984589"/>
                    <a:gd name="connsiteY15" fmla="*/ 1337480 h 1894476"/>
                    <a:gd name="connsiteX16" fmla="*/ 1357689 w 1984589"/>
                    <a:gd name="connsiteY16" fmla="*/ 1596607 h 1894476"/>
                    <a:gd name="connsiteX17" fmla="*/ 1427141 w 1984589"/>
                    <a:gd name="connsiteY17" fmla="*/ 1761736 h 1894476"/>
                    <a:gd name="connsiteX18" fmla="*/ 1676358 w 1984589"/>
                    <a:gd name="connsiteY18" fmla="*/ 1763382 h 1894476"/>
                    <a:gd name="connsiteX19" fmla="*/ 1872510 w 1984589"/>
                    <a:gd name="connsiteY19" fmla="*/ 1890812 h 1894476"/>
                    <a:gd name="connsiteX20" fmla="*/ 1932661 w 1984589"/>
                    <a:gd name="connsiteY20" fmla="*/ 1858022 h 1894476"/>
                    <a:gd name="connsiteX21" fmla="*/ 1979043 w 1984589"/>
                    <a:gd name="connsiteY21" fmla="*/ 1837660 h 1894476"/>
                    <a:gd name="connsiteX22" fmla="*/ 1798924 w 1984589"/>
                    <a:gd name="connsiteY22" fmla="*/ 1705792 h 1894476"/>
                    <a:gd name="connsiteX23" fmla="*/ 1602556 w 1984589"/>
                    <a:gd name="connsiteY23" fmla="*/ 1647700 h 1894476"/>
                    <a:gd name="connsiteX24" fmla="*/ 1497361 w 1984589"/>
                    <a:gd name="connsiteY24" fmla="*/ 1660237 h 1894476"/>
                    <a:gd name="connsiteX25" fmla="*/ 1501279 w 1984589"/>
                    <a:gd name="connsiteY25" fmla="*/ 1593729 h 1894476"/>
                    <a:gd name="connsiteX26" fmla="*/ 1618352 w 1984589"/>
                    <a:gd name="connsiteY26" fmla="*/ 1497321 h 1894476"/>
                    <a:gd name="connsiteX27" fmla="*/ 1781167 w 1984589"/>
                    <a:gd name="connsiteY27" fmla="*/ 1340655 h 1894476"/>
                    <a:gd name="connsiteX28" fmla="*/ 1743067 w 1984589"/>
                    <a:gd name="connsiteY28" fmla="*/ 1166030 h 1894476"/>
                    <a:gd name="connsiteX29" fmla="*/ 1523992 w 1984589"/>
                    <a:gd name="connsiteY29" fmla="*/ 1073955 h 1894476"/>
                    <a:gd name="connsiteX30" fmla="*/ 1298567 w 1984589"/>
                    <a:gd name="connsiteY30" fmla="*/ 1143805 h 1894476"/>
                    <a:gd name="connsiteX31" fmla="*/ 1111162 w 1984589"/>
                    <a:gd name="connsiteY31" fmla="*/ 1257323 h 1894476"/>
                    <a:gd name="connsiteX32" fmla="*/ 1108067 w 1984589"/>
                    <a:gd name="connsiteY32" fmla="*/ 1169205 h 1894476"/>
                    <a:gd name="connsiteX33" fmla="*/ 1371592 w 1984589"/>
                    <a:gd name="connsiteY33" fmla="*/ 988230 h 1894476"/>
                    <a:gd name="connsiteX34" fmla="*/ 1381117 w 1984589"/>
                    <a:gd name="connsiteY34" fmla="*/ 781855 h 1894476"/>
                    <a:gd name="connsiteX35" fmla="*/ 1222367 w 1984589"/>
                    <a:gd name="connsiteY35" fmla="*/ 645330 h 1894476"/>
                    <a:gd name="connsiteX36" fmla="*/ 1045322 w 1984589"/>
                    <a:gd name="connsiteY36" fmla="*/ 697980 h 1894476"/>
                    <a:gd name="connsiteX37" fmla="*/ 796917 w 1984589"/>
                    <a:gd name="connsiteY37" fmla="*/ 848530 h 1894476"/>
                    <a:gd name="connsiteX38" fmla="*/ 711192 w 1984589"/>
                    <a:gd name="connsiteY38" fmla="*/ 848530 h 1894476"/>
                    <a:gd name="connsiteX39" fmla="*/ 704842 w 1984589"/>
                    <a:gd name="connsiteY39" fmla="*/ 826305 h 1894476"/>
                    <a:gd name="connsiteX40" fmla="*/ 742942 w 1984589"/>
                    <a:gd name="connsiteY40" fmla="*/ 785030 h 1894476"/>
                    <a:gd name="connsiteX41" fmla="*/ 899245 w 1984589"/>
                    <a:gd name="connsiteY41" fmla="*/ 624237 h 1894476"/>
                    <a:gd name="connsiteX42" fmla="*/ 1006467 w 1984589"/>
                    <a:gd name="connsiteY42" fmla="*/ 423080 h 1894476"/>
                    <a:gd name="connsiteX43" fmla="*/ 892167 w 1984589"/>
                    <a:gd name="connsiteY43" fmla="*/ 280205 h 1894476"/>
                    <a:gd name="connsiteX44" fmla="*/ 577842 w 1984589"/>
                    <a:gd name="connsiteY44" fmla="*/ 327830 h 1894476"/>
                    <a:gd name="connsiteX45" fmla="*/ 257114 w 1984589"/>
                    <a:gd name="connsiteY45" fmla="*/ 2783 h 1894476"/>
                    <a:gd name="connsiteX46" fmla="*/ 2454 w 1984589"/>
                    <a:gd name="connsiteY46" fmla="*/ 74115 h 1894476"/>
                    <a:gd name="connsiteX47" fmla="*/ 429123 w 1984589"/>
                    <a:gd name="connsiteY47" fmla="*/ 339099 h 1894476"/>
                    <a:gd name="connsiteX0" fmla="*/ 456924 w 2012390"/>
                    <a:gd name="connsiteY0" fmla="*/ 317106 h 1872483"/>
                    <a:gd name="connsiteX1" fmla="*/ 581818 w 2012390"/>
                    <a:gd name="connsiteY1" fmla="*/ 396720 h 1872483"/>
                    <a:gd name="connsiteX2" fmla="*/ 894568 w 2012390"/>
                    <a:gd name="connsiteY2" fmla="*/ 340762 h 1872483"/>
                    <a:gd name="connsiteX3" fmla="*/ 863464 w 2012390"/>
                    <a:gd name="connsiteY3" fmla="*/ 501847 h 1872483"/>
                    <a:gd name="connsiteX4" fmla="*/ 651596 w 2012390"/>
                    <a:gd name="connsiteY4" fmla="*/ 729809 h 1872483"/>
                    <a:gd name="connsiteX5" fmla="*/ 599293 w 2012390"/>
                    <a:gd name="connsiteY5" fmla="*/ 915437 h 1872483"/>
                    <a:gd name="connsiteX6" fmla="*/ 802493 w 2012390"/>
                    <a:gd name="connsiteY6" fmla="*/ 947187 h 1872483"/>
                    <a:gd name="connsiteX7" fmla="*/ 1075464 w 2012390"/>
                    <a:gd name="connsiteY7" fmla="*/ 798844 h 1872483"/>
                    <a:gd name="connsiteX8" fmla="*/ 1280732 w 2012390"/>
                    <a:gd name="connsiteY8" fmla="*/ 745792 h 1872483"/>
                    <a:gd name="connsiteX9" fmla="*/ 1313668 w 2012390"/>
                    <a:gd name="connsiteY9" fmla="*/ 905912 h 1872483"/>
                    <a:gd name="connsiteX10" fmla="*/ 1094141 w 2012390"/>
                    <a:gd name="connsiteY10" fmla="*/ 1064102 h 1872483"/>
                    <a:gd name="connsiteX11" fmla="*/ 996168 w 2012390"/>
                    <a:gd name="connsiteY11" fmla="*/ 1223412 h 1872483"/>
                    <a:gd name="connsiteX12" fmla="*/ 1107669 w 2012390"/>
                    <a:gd name="connsiteY12" fmla="*/ 1355691 h 1872483"/>
                    <a:gd name="connsiteX13" fmla="*/ 1343274 w 2012390"/>
                    <a:gd name="connsiteY13" fmla="*/ 1239909 h 1872483"/>
                    <a:gd name="connsiteX14" fmla="*/ 1570843 w 2012390"/>
                    <a:gd name="connsiteY14" fmla="*/ 1147212 h 1872483"/>
                    <a:gd name="connsiteX15" fmla="*/ 1710543 w 2012390"/>
                    <a:gd name="connsiteY15" fmla="*/ 1315487 h 1872483"/>
                    <a:gd name="connsiteX16" fmla="*/ 1385490 w 2012390"/>
                    <a:gd name="connsiteY16" fmla="*/ 1574614 h 1872483"/>
                    <a:gd name="connsiteX17" fmla="*/ 1454942 w 2012390"/>
                    <a:gd name="connsiteY17" fmla="*/ 1739743 h 1872483"/>
                    <a:gd name="connsiteX18" fmla="*/ 1704159 w 2012390"/>
                    <a:gd name="connsiteY18" fmla="*/ 1741389 h 1872483"/>
                    <a:gd name="connsiteX19" fmla="*/ 1900311 w 2012390"/>
                    <a:gd name="connsiteY19" fmla="*/ 1868819 h 1872483"/>
                    <a:gd name="connsiteX20" fmla="*/ 1960462 w 2012390"/>
                    <a:gd name="connsiteY20" fmla="*/ 1836029 h 1872483"/>
                    <a:gd name="connsiteX21" fmla="*/ 2006844 w 2012390"/>
                    <a:gd name="connsiteY21" fmla="*/ 1815667 h 1872483"/>
                    <a:gd name="connsiteX22" fmla="*/ 1826725 w 2012390"/>
                    <a:gd name="connsiteY22" fmla="*/ 1683799 h 1872483"/>
                    <a:gd name="connsiteX23" fmla="*/ 1630357 w 2012390"/>
                    <a:gd name="connsiteY23" fmla="*/ 1625707 h 1872483"/>
                    <a:gd name="connsiteX24" fmla="*/ 1525162 w 2012390"/>
                    <a:gd name="connsiteY24" fmla="*/ 1638244 h 1872483"/>
                    <a:gd name="connsiteX25" fmla="*/ 1529080 w 2012390"/>
                    <a:gd name="connsiteY25" fmla="*/ 1571736 h 1872483"/>
                    <a:gd name="connsiteX26" fmla="*/ 1646153 w 2012390"/>
                    <a:gd name="connsiteY26" fmla="*/ 1475328 h 1872483"/>
                    <a:gd name="connsiteX27" fmla="*/ 1808968 w 2012390"/>
                    <a:gd name="connsiteY27" fmla="*/ 1318662 h 1872483"/>
                    <a:gd name="connsiteX28" fmla="*/ 1770868 w 2012390"/>
                    <a:gd name="connsiteY28" fmla="*/ 1144037 h 1872483"/>
                    <a:gd name="connsiteX29" fmla="*/ 1551793 w 2012390"/>
                    <a:gd name="connsiteY29" fmla="*/ 1051962 h 1872483"/>
                    <a:gd name="connsiteX30" fmla="*/ 1326368 w 2012390"/>
                    <a:gd name="connsiteY30" fmla="*/ 1121812 h 1872483"/>
                    <a:gd name="connsiteX31" fmla="*/ 1138963 w 2012390"/>
                    <a:gd name="connsiteY31" fmla="*/ 1235330 h 1872483"/>
                    <a:gd name="connsiteX32" fmla="*/ 1135868 w 2012390"/>
                    <a:gd name="connsiteY32" fmla="*/ 1147212 h 1872483"/>
                    <a:gd name="connsiteX33" fmla="*/ 1399393 w 2012390"/>
                    <a:gd name="connsiteY33" fmla="*/ 966237 h 1872483"/>
                    <a:gd name="connsiteX34" fmla="*/ 1408918 w 2012390"/>
                    <a:gd name="connsiteY34" fmla="*/ 759862 h 1872483"/>
                    <a:gd name="connsiteX35" fmla="*/ 1250168 w 2012390"/>
                    <a:gd name="connsiteY35" fmla="*/ 623337 h 1872483"/>
                    <a:gd name="connsiteX36" fmla="*/ 1073123 w 2012390"/>
                    <a:gd name="connsiteY36" fmla="*/ 675987 h 1872483"/>
                    <a:gd name="connsiteX37" fmla="*/ 824718 w 2012390"/>
                    <a:gd name="connsiteY37" fmla="*/ 826537 h 1872483"/>
                    <a:gd name="connsiteX38" fmla="*/ 738993 w 2012390"/>
                    <a:gd name="connsiteY38" fmla="*/ 826537 h 1872483"/>
                    <a:gd name="connsiteX39" fmla="*/ 732643 w 2012390"/>
                    <a:gd name="connsiteY39" fmla="*/ 804312 h 1872483"/>
                    <a:gd name="connsiteX40" fmla="*/ 770743 w 2012390"/>
                    <a:gd name="connsiteY40" fmla="*/ 763037 h 1872483"/>
                    <a:gd name="connsiteX41" fmla="*/ 927046 w 2012390"/>
                    <a:gd name="connsiteY41" fmla="*/ 602244 h 1872483"/>
                    <a:gd name="connsiteX42" fmla="*/ 1034268 w 2012390"/>
                    <a:gd name="connsiteY42" fmla="*/ 401087 h 1872483"/>
                    <a:gd name="connsiteX43" fmla="*/ 919968 w 2012390"/>
                    <a:gd name="connsiteY43" fmla="*/ 258212 h 1872483"/>
                    <a:gd name="connsiteX44" fmla="*/ 605643 w 2012390"/>
                    <a:gd name="connsiteY44" fmla="*/ 305837 h 1872483"/>
                    <a:gd name="connsiteX45" fmla="*/ 69229 w 2012390"/>
                    <a:gd name="connsiteY45" fmla="*/ 2943 h 1872483"/>
                    <a:gd name="connsiteX46" fmla="*/ 30255 w 2012390"/>
                    <a:gd name="connsiteY46" fmla="*/ 52122 h 1872483"/>
                    <a:gd name="connsiteX47" fmla="*/ 456924 w 2012390"/>
                    <a:gd name="connsiteY47" fmla="*/ 317106 h 1872483"/>
                    <a:gd name="connsiteX0" fmla="*/ 457011 w 2012477"/>
                    <a:gd name="connsiteY0" fmla="*/ 345880 h 1901257"/>
                    <a:gd name="connsiteX1" fmla="*/ 581905 w 2012477"/>
                    <a:gd name="connsiteY1" fmla="*/ 425494 h 1901257"/>
                    <a:gd name="connsiteX2" fmla="*/ 894655 w 2012477"/>
                    <a:gd name="connsiteY2" fmla="*/ 369536 h 1901257"/>
                    <a:gd name="connsiteX3" fmla="*/ 863551 w 2012477"/>
                    <a:gd name="connsiteY3" fmla="*/ 530621 h 1901257"/>
                    <a:gd name="connsiteX4" fmla="*/ 651683 w 2012477"/>
                    <a:gd name="connsiteY4" fmla="*/ 758583 h 1901257"/>
                    <a:gd name="connsiteX5" fmla="*/ 599380 w 2012477"/>
                    <a:gd name="connsiteY5" fmla="*/ 944211 h 1901257"/>
                    <a:gd name="connsiteX6" fmla="*/ 802580 w 2012477"/>
                    <a:gd name="connsiteY6" fmla="*/ 975961 h 1901257"/>
                    <a:gd name="connsiteX7" fmla="*/ 1075551 w 2012477"/>
                    <a:gd name="connsiteY7" fmla="*/ 827618 h 1901257"/>
                    <a:gd name="connsiteX8" fmla="*/ 1280819 w 2012477"/>
                    <a:gd name="connsiteY8" fmla="*/ 774566 h 1901257"/>
                    <a:gd name="connsiteX9" fmla="*/ 1313755 w 2012477"/>
                    <a:gd name="connsiteY9" fmla="*/ 934686 h 1901257"/>
                    <a:gd name="connsiteX10" fmla="*/ 1094228 w 2012477"/>
                    <a:gd name="connsiteY10" fmla="*/ 1092876 h 1901257"/>
                    <a:gd name="connsiteX11" fmla="*/ 996255 w 2012477"/>
                    <a:gd name="connsiteY11" fmla="*/ 1252186 h 1901257"/>
                    <a:gd name="connsiteX12" fmla="*/ 1107756 w 2012477"/>
                    <a:gd name="connsiteY12" fmla="*/ 1384465 h 1901257"/>
                    <a:gd name="connsiteX13" fmla="*/ 1343361 w 2012477"/>
                    <a:gd name="connsiteY13" fmla="*/ 1268683 h 1901257"/>
                    <a:gd name="connsiteX14" fmla="*/ 1570930 w 2012477"/>
                    <a:gd name="connsiteY14" fmla="*/ 1175986 h 1901257"/>
                    <a:gd name="connsiteX15" fmla="*/ 1710630 w 2012477"/>
                    <a:gd name="connsiteY15" fmla="*/ 1344261 h 1901257"/>
                    <a:gd name="connsiteX16" fmla="*/ 1385577 w 2012477"/>
                    <a:gd name="connsiteY16" fmla="*/ 1603388 h 1901257"/>
                    <a:gd name="connsiteX17" fmla="*/ 1455029 w 2012477"/>
                    <a:gd name="connsiteY17" fmla="*/ 1768517 h 1901257"/>
                    <a:gd name="connsiteX18" fmla="*/ 1704246 w 2012477"/>
                    <a:gd name="connsiteY18" fmla="*/ 1770163 h 1901257"/>
                    <a:gd name="connsiteX19" fmla="*/ 1900398 w 2012477"/>
                    <a:gd name="connsiteY19" fmla="*/ 1897593 h 1901257"/>
                    <a:gd name="connsiteX20" fmla="*/ 1960549 w 2012477"/>
                    <a:gd name="connsiteY20" fmla="*/ 1864803 h 1901257"/>
                    <a:gd name="connsiteX21" fmla="*/ 2006931 w 2012477"/>
                    <a:gd name="connsiteY21" fmla="*/ 1844441 h 1901257"/>
                    <a:gd name="connsiteX22" fmla="*/ 1826812 w 2012477"/>
                    <a:gd name="connsiteY22" fmla="*/ 1712573 h 1901257"/>
                    <a:gd name="connsiteX23" fmla="*/ 1630444 w 2012477"/>
                    <a:gd name="connsiteY23" fmla="*/ 1654481 h 1901257"/>
                    <a:gd name="connsiteX24" fmla="*/ 1525249 w 2012477"/>
                    <a:gd name="connsiteY24" fmla="*/ 1667018 h 1901257"/>
                    <a:gd name="connsiteX25" fmla="*/ 1529167 w 2012477"/>
                    <a:gd name="connsiteY25" fmla="*/ 1600510 h 1901257"/>
                    <a:gd name="connsiteX26" fmla="*/ 1646240 w 2012477"/>
                    <a:gd name="connsiteY26" fmla="*/ 1504102 h 1901257"/>
                    <a:gd name="connsiteX27" fmla="*/ 1809055 w 2012477"/>
                    <a:gd name="connsiteY27" fmla="*/ 1347436 h 1901257"/>
                    <a:gd name="connsiteX28" fmla="*/ 1770955 w 2012477"/>
                    <a:gd name="connsiteY28" fmla="*/ 1172811 h 1901257"/>
                    <a:gd name="connsiteX29" fmla="*/ 1551880 w 2012477"/>
                    <a:gd name="connsiteY29" fmla="*/ 1080736 h 1901257"/>
                    <a:gd name="connsiteX30" fmla="*/ 1326455 w 2012477"/>
                    <a:gd name="connsiteY30" fmla="*/ 1150586 h 1901257"/>
                    <a:gd name="connsiteX31" fmla="*/ 1139050 w 2012477"/>
                    <a:gd name="connsiteY31" fmla="*/ 1264104 h 1901257"/>
                    <a:gd name="connsiteX32" fmla="*/ 1135955 w 2012477"/>
                    <a:gd name="connsiteY32" fmla="*/ 1175986 h 1901257"/>
                    <a:gd name="connsiteX33" fmla="*/ 1399480 w 2012477"/>
                    <a:gd name="connsiteY33" fmla="*/ 995011 h 1901257"/>
                    <a:gd name="connsiteX34" fmla="*/ 1409005 w 2012477"/>
                    <a:gd name="connsiteY34" fmla="*/ 788636 h 1901257"/>
                    <a:gd name="connsiteX35" fmla="*/ 1250255 w 2012477"/>
                    <a:gd name="connsiteY35" fmla="*/ 652111 h 1901257"/>
                    <a:gd name="connsiteX36" fmla="*/ 1073210 w 2012477"/>
                    <a:gd name="connsiteY36" fmla="*/ 704761 h 1901257"/>
                    <a:gd name="connsiteX37" fmla="*/ 824805 w 2012477"/>
                    <a:gd name="connsiteY37" fmla="*/ 855311 h 1901257"/>
                    <a:gd name="connsiteX38" fmla="*/ 739080 w 2012477"/>
                    <a:gd name="connsiteY38" fmla="*/ 855311 h 1901257"/>
                    <a:gd name="connsiteX39" fmla="*/ 732730 w 2012477"/>
                    <a:gd name="connsiteY39" fmla="*/ 833086 h 1901257"/>
                    <a:gd name="connsiteX40" fmla="*/ 770830 w 2012477"/>
                    <a:gd name="connsiteY40" fmla="*/ 791811 h 1901257"/>
                    <a:gd name="connsiteX41" fmla="*/ 927133 w 2012477"/>
                    <a:gd name="connsiteY41" fmla="*/ 631018 h 1901257"/>
                    <a:gd name="connsiteX42" fmla="*/ 1034355 w 2012477"/>
                    <a:gd name="connsiteY42" fmla="*/ 429861 h 1901257"/>
                    <a:gd name="connsiteX43" fmla="*/ 920055 w 2012477"/>
                    <a:gd name="connsiteY43" fmla="*/ 286986 h 1901257"/>
                    <a:gd name="connsiteX44" fmla="*/ 605730 w 2012477"/>
                    <a:gd name="connsiteY44" fmla="*/ 334611 h 1901257"/>
                    <a:gd name="connsiteX45" fmla="*/ 69059 w 2012477"/>
                    <a:gd name="connsiteY45" fmla="*/ 2736 h 1901257"/>
                    <a:gd name="connsiteX46" fmla="*/ 30342 w 2012477"/>
                    <a:gd name="connsiteY46" fmla="*/ 80896 h 1901257"/>
                    <a:gd name="connsiteX47" fmla="*/ 457011 w 2012477"/>
                    <a:gd name="connsiteY47" fmla="*/ 345880 h 1901257"/>
                    <a:gd name="connsiteX0" fmla="*/ 457011 w 2012477"/>
                    <a:gd name="connsiteY0" fmla="*/ 349803 h 1905180"/>
                    <a:gd name="connsiteX1" fmla="*/ 581905 w 2012477"/>
                    <a:gd name="connsiteY1" fmla="*/ 429417 h 1905180"/>
                    <a:gd name="connsiteX2" fmla="*/ 894655 w 2012477"/>
                    <a:gd name="connsiteY2" fmla="*/ 373459 h 1905180"/>
                    <a:gd name="connsiteX3" fmla="*/ 863551 w 2012477"/>
                    <a:gd name="connsiteY3" fmla="*/ 534544 h 1905180"/>
                    <a:gd name="connsiteX4" fmla="*/ 651683 w 2012477"/>
                    <a:gd name="connsiteY4" fmla="*/ 762506 h 1905180"/>
                    <a:gd name="connsiteX5" fmla="*/ 599380 w 2012477"/>
                    <a:gd name="connsiteY5" fmla="*/ 948134 h 1905180"/>
                    <a:gd name="connsiteX6" fmla="*/ 802580 w 2012477"/>
                    <a:gd name="connsiteY6" fmla="*/ 979884 h 1905180"/>
                    <a:gd name="connsiteX7" fmla="*/ 1075551 w 2012477"/>
                    <a:gd name="connsiteY7" fmla="*/ 831541 h 1905180"/>
                    <a:gd name="connsiteX8" fmla="*/ 1280819 w 2012477"/>
                    <a:gd name="connsiteY8" fmla="*/ 778489 h 1905180"/>
                    <a:gd name="connsiteX9" fmla="*/ 1313755 w 2012477"/>
                    <a:gd name="connsiteY9" fmla="*/ 938609 h 1905180"/>
                    <a:gd name="connsiteX10" fmla="*/ 1094228 w 2012477"/>
                    <a:gd name="connsiteY10" fmla="*/ 1096799 h 1905180"/>
                    <a:gd name="connsiteX11" fmla="*/ 996255 w 2012477"/>
                    <a:gd name="connsiteY11" fmla="*/ 1256109 h 1905180"/>
                    <a:gd name="connsiteX12" fmla="*/ 1107756 w 2012477"/>
                    <a:gd name="connsiteY12" fmla="*/ 1388388 h 1905180"/>
                    <a:gd name="connsiteX13" fmla="*/ 1343361 w 2012477"/>
                    <a:gd name="connsiteY13" fmla="*/ 1272606 h 1905180"/>
                    <a:gd name="connsiteX14" fmla="*/ 1570930 w 2012477"/>
                    <a:gd name="connsiteY14" fmla="*/ 1179909 h 1905180"/>
                    <a:gd name="connsiteX15" fmla="*/ 1710630 w 2012477"/>
                    <a:gd name="connsiteY15" fmla="*/ 1348184 h 1905180"/>
                    <a:gd name="connsiteX16" fmla="*/ 1385577 w 2012477"/>
                    <a:gd name="connsiteY16" fmla="*/ 1607311 h 1905180"/>
                    <a:gd name="connsiteX17" fmla="*/ 1455029 w 2012477"/>
                    <a:gd name="connsiteY17" fmla="*/ 1772440 h 1905180"/>
                    <a:gd name="connsiteX18" fmla="*/ 1704246 w 2012477"/>
                    <a:gd name="connsiteY18" fmla="*/ 1774086 h 1905180"/>
                    <a:gd name="connsiteX19" fmla="*/ 1900398 w 2012477"/>
                    <a:gd name="connsiteY19" fmla="*/ 1901516 h 1905180"/>
                    <a:gd name="connsiteX20" fmla="*/ 1960549 w 2012477"/>
                    <a:gd name="connsiteY20" fmla="*/ 1868726 h 1905180"/>
                    <a:gd name="connsiteX21" fmla="*/ 2006931 w 2012477"/>
                    <a:gd name="connsiteY21" fmla="*/ 1848364 h 1905180"/>
                    <a:gd name="connsiteX22" fmla="*/ 1826812 w 2012477"/>
                    <a:gd name="connsiteY22" fmla="*/ 1716496 h 1905180"/>
                    <a:gd name="connsiteX23" fmla="*/ 1630444 w 2012477"/>
                    <a:gd name="connsiteY23" fmla="*/ 1658404 h 1905180"/>
                    <a:gd name="connsiteX24" fmla="*/ 1525249 w 2012477"/>
                    <a:gd name="connsiteY24" fmla="*/ 1670941 h 1905180"/>
                    <a:gd name="connsiteX25" fmla="*/ 1529167 w 2012477"/>
                    <a:gd name="connsiteY25" fmla="*/ 1604433 h 1905180"/>
                    <a:gd name="connsiteX26" fmla="*/ 1646240 w 2012477"/>
                    <a:gd name="connsiteY26" fmla="*/ 1508025 h 1905180"/>
                    <a:gd name="connsiteX27" fmla="*/ 1809055 w 2012477"/>
                    <a:gd name="connsiteY27" fmla="*/ 1351359 h 1905180"/>
                    <a:gd name="connsiteX28" fmla="*/ 1770955 w 2012477"/>
                    <a:gd name="connsiteY28" fmla="*/ 1176734 h 1905180"/>
                    <a:gd name="connsiteX29" fmla="*/ 1551880 w 2012477"/>
                    <a:gd name="connsiteY29" fmla="*/ 1084659 h 1905180"/>
                    <a:gd name="connsiteX30" fmla="*/ 1326455 w 2012477"/>
                    <a:gd name="connsiteY30" fmla="*/ 1154509 h 1905180"/>
                    <a:gd name="connsiteX31" fmla="*/ 1139050 w 2012477"/>
                    <a:gd name="connsiteY31" fmla="*/ 1268027 h 1905180"/>
                    <a:gd name="connsiteX32" fmla="*/ 1135955 w 2012477"/>
                    <a:gd name="connsiteY32" fmla="*/ 1179909 h 1905180"/>
                    <a:gd name="connsiteX33" fmla="*/ 1399480 w 2012477"/>
                    <a:gd name="connsiteY33" fmla="*/ 998934 h 1905180"/>
                    <a:gd name="connsiteX34" fmla="*/ 1409005 w 2012477"/>
                    <a:gd name="connsiteY34" fmla="*/ 792559 h 1905180"/>
                    <a:gd name="connsiteX35" fmla="*/ 1250255 w 2012477"/>
                    <a:gd name="connsiteY35" fmla="*/ 656034 h 1905180"/>
                    <a:gd name="connsiteX36" fmla="*/ 1073210 w 2012477"/>
                    <a:gd name="connsiteY36" fmla="*/ 708684 h 1905180"/>
                    <a:gd name="connsiteX37" fmla="*/ 824805 w 2012477"/>
                    <a:gd name="connsiteY37" fmla="*/ 859234 h 1905180"/>
                    <a:gd name="connsiteX38" fmla="*/ 739080 w 2012477"/>
                    <a:gd name="connsiteY38" fmla="*/ 859234 h 1905180"/>
                    <a:gd name="connsiteX39" fmla="*/ 732730 w 2012477"/>
                    <a:gd name="connsiteY39" fmla="*/ 837009 h 1905180"/>
                    <a:gd name="connsiteX40" fmla="*/ 770830 w 2012477"/>
                    <a:gd name="connsiteY40" fmla="*/ 795734 h 1905180"/>
                    <a:gd name="connsiteX41" fmla="*/ 927133 w 2012477"/>
                    <a:gd name="connsiteY41" fmla="*/ 634941 h 1905180"/>
                    <a:gd name="connsiteX42" fmla="*/ 1034355 w 2012477"/>
                    <a:gd name="connsiteY42" fmla="*/ 433784 h 1905180"/>
                    <a:gd name="connsiteX43" fmla="*/ 920055 w 2012477"/>
                    <a:gd name="connsiteY43" fmla="*/ 290909 h 1905180"/>
                    <a:gd name="connsiteX44" fmla="*/ 630348 w 2012477"/>
                    <a:gd name="connsiteY44" fmla="*/ 133994 h 1905180"/>
                    <a:gd name="connsiteX45" fmla="*/ 69059 w 2012477"/>
                    <a:gd name="connsiteY45" fmla="*/ 6659 h 1905180"/>
                    <a:gd name="connsiteX46" fmla="*/ 30342 w 2012477"/>
                    <a:gd name="connsiteY46" fmla="*/ 84819 h 1905180"/>
                    <a:gd name="connsiteX47" fmla="*/ 457011 w 2012477"/>
                    <a:gd name="connsiteY47" fmla="*/ 349803 h 1905180"/>
                    <a:gd name="connsiteX0" fmla="*/ 434683 w 1990149"/>
                    <a:gd name="connsiteY0" fmla="*/ 554419 h 2109796"/>
                    <a:gd name="connsiteX1" fmla="*/ 559577 w 1990149"/>
                    <a:gd name="connsiteY1" fmla="*/ 634033 h 2109796"/>
                    <a:gd name="connsiteX2" fmla="*/ 872327 w 1990149"/>
                    <a:gd name="connsiteY2" fmla="*/ 578075 h 2109796"/>
                    <a:gd name="connsiteX3" fmla="*/ 841223 w 1990149"/>
                    <a:gd name="connsiteY3" fmla="*/ 739160 h 2109796"/>
                    <a:gd name="connsiteX4" fmla="*/ 629355 w 1990149"/>
                    <a:gd name="connsiteY4" fmla="*/ 967122 h 2109796"/>
                    <a:gd name="connsiteX5" fmla="*/ 577052 w 1990149"/>
                    <a:gd name="connsiteY5" fmla="*/ 1152750 h 2109796"/>
                    <a:gd name="connsiteX6" fmla="*/ 780252 w 1990149"/>
                    <a:gd name="connsiteY6" fmla="*/ 1184500 h 2109796"/>
                    <a:gd name="connsiteX7" fmla="*/ 1053223 w 1990149"/>
                    <a:gd name="connsiteY7" fmla="*/ 1036157 h 2109796"/>
                    <a:gd name="connsiteX8" fmla="*/ 1258491 w 1990149"/>
                    <a:gd name="connsiteY8" fmla="*/ 983105 h 2109796"/>
                    <a:gd name="connsiteX9" fmla="*/ 1291427 w 1990149"/>
                    <a:gd name="connsiteY9" fmla="*/ 1143225 h 2109796"/>
                    <a:gd name="connsiteX10" fmla="*/ 1071900 w 1990149"/>
                    <a:gd name="connsiteY10" fmla="*/ 1301415 h 2109796"/>
                    <a:gd name="connsiteX11" fmla="*/ 973927 w 1990149"/>
                    <a:gd name="connsiteY11" fmla="*/ 1460725 h 2109796"/>
                    <a:gd name="connsiteX12" fmla="*/ 1085428 w 1990149"/>
                    <a:gd name="connsiteY12" fmla="*/ 1593004 h 2109796"/>
                    <a:gd name="connsiteX13" fmla="*/ 1321033 w 1990149"/>
                    <a:gd name="connsiteY13" fmla="*/ 1477222 h 2109796"/>
                    <a:gd name="connsiteX14" fmla="*/ 1548602 w 1990149"/>
                    <a:gd name="connsiteY14" fmla="*/ 1384525 h 2109796"/>
                    <a:gd name="connsiteX15" fmla="*/ 1688302 w 1990149"/>
                    <a:gd name="connsiteY15" fmla="*/ 1552800 h 2109796"/>
                    <a:gd name="connsiteX16" fmla="*/ 1363249 w 1990149"/>
                    <a:gd name="connsiteY16" fmla="*/ 1811927 h 2109796"/>
                    <a:gd name="connsiteX17" fmla="*/ 1432701 w 1990149"/>
                    <a:gd name="connsiteY17" fmla="*/ 1977056 h 2109796"/>
                    <a:gd name="connsiteX18" fmla="*/ 1681918 w 1990149"/>
                    <a:gd name="connsiteY18" fmla="*/ 1978702 h 2109796"/>
                    <a:gd name="connsiteX19" fmla="*/ 1878070 w 1990149"/>
                    <a:gd name="connsiteY19" fmla="*/ 2106132 h 2109796"/>
                    <a:gd name="connsiteX20" fmla="*/ 1938221 w 1990149"/>
                    <a:gd name="connsiteY20" fmla="*/ 2073342 h 2109796"/>
                    <a:gd name="connsiteX21" fmla="*/ 1984603 w 1990149"/>
                    <a:gd name="connsiteY21" fmla="*/ 2052980 h 2109796"/>
                    <a:gd name="connsiteX22" fmla="*/ 1804484 w 1990149"/>
                    <a:gd name="connsiteY22" fmla="*/ 1921112 h 2109796"/>
                    <a:gd name="connsiteX23" fmla="*/ 1608116 w 1990149"/>
                    <a:gd name="connsiteY23" fmla="*/ 1863020 h 2109796"/>
                    <a:gd name="connsiteX24" fmla="*/ 1502921 w 1990149"/>
                    <a:gd name="connsiteY24" fmla="*/ 1875557 h 2109796"/>
                    <a:gd name="connsiteX25" fmla="*/ 1506839 w 1990149"/>
                    <a:gd name="connsiteY25" fmla="*/ 1809049 h 2109796"/>
                    <a:gd name="connsiteX26" fmla="*/ 1623912 w 1990149"/>
                    <a:gd name="connsiteY26" fmla="*/ 1712641 h 2109796"/>
                    <a:gd name="connsiteX27" fmla="*/ 1786727 w 1990149"/>
                    <a:gd name="connsiteY27" fmla="*/ 1555975 h 2109796"/>
                    <a:gd name="connsiteX28" fmla="*/ 1748627 w 1990149"/>
                    <a:gd name="connsiteY28" fmla="*/ 1381350 h 2109796"/>
                    <a:gd name="connsiteX29" fmla="*/ 1529552 w 1990149"/>
                    <a:gd name="connsiteY29" fmla="*/ 1289275 h 2109796"/>
                    <a:gd name="connsiteX30" fmla="*/ 1304127 w 1990149"/>
                    <a:gd name="connsiteY30" fmla="*/ 1359125 h 2109796"/>
                    <a:gd name="connsiteX31" fmla="*/ 1116722 w 1990149"/>
                    <a:gd name="connsiteY31" fmla="*/ 1472643 h 2109796"/>
                    <a:gd name="connsiteX32" fmla="*/ 1113627 w 1990149"/>
                    <a:gd name="connsiteY32" fmla="*/ 1384525 h 2109796"/>
                    <a:gd name="connsiteX33" fmla="*/ 1377152 w 1990149"/>
                    <a:gd name="connsiteY33" fmla="*/ 1203550 h 2109796"/>
                    <a:gd name="connsiteX34" fmla="*/ 1386677 w 1990149"/>
                    <a:gd name="connsiteY34" fmla="*/ 997175 h 2109796"/>
                    <a:gd name="connsiteX35" fmla="*/ 1227927 w 1990149"/>
                    <a:gd name="connsiteY35" fmla="*/ 860650 h 2109796"/>
                    <a:gd name="connsiteX36" fmla="*/ 1050882 w 1990149"/>
                    <a:gd name="connsiteY36" fmla="*/ 913300 h 2109796"/>
                    <a:gd name="connsiteX37" fmla="*/ 802477 w 1990149"/>
                    <a:gd name="connsiteY37" fmla="*/ 1063850 h 2109796"/>
                    <a:gd name="connsiteX38" fmla="*/ 716752 w 1990149"/>
                    <a:gd name="connsiteY38" fmla="*/ 1063850 h 2109796"/>
                    <a:gd name="connsiteX39" fmla="*/ 710402 w 1990149"/>
                    <a:gd name="connsiteY39" fmla="*/ 1041625 h 2109796"/>
                    <a:gd name="connsiteX40" fmla="*/ 748502 w 1990149"/>
                    <a:gd name="connsiteY40" fmla="*/ 1000350 h 2109796"/>
                    <a:gd name="connsiteX41" fmla="*/ 904805 w 1990149"/>
                    <a:gd name="connsiteY41" fmla="*/ 839557 h 2109796"/>
                    <a:gd name="connsiteX42" fmla="*/ 1012027 w 1990149"/>
                    <a:gd name="connsiteY42" fmla="*/ 638400 h 2109796"/>
                    <a:gd name="connsiteX43" fmla="*/ 897727 w 1990149"/>
                    <a:gd name="connsiteY43" fmla="*/ 495525 h 2109796"/>
                    <a:gd name="connsiteX44" fmla="*/ 608020 w 1990149"/>
                    <a:gd name="connsiteY44" fmla="*/ 338610 h 2109796"/>
                    <a:gd name="connsiteX45" fmla="*/ 168242 w 1990149"/>
                    <a:gd name="connsiteY45" fmla="*/ 2998 h 2109796"/>
                    <a:gd name="connsiteX46" fmla="*/ 8014 w 1990149"/>
                    <a:gd name="connsiteY46" fmla="*/ 289435 h 2109796"/>
                    <a:gd name="connsiteX47" fmla="*/ 434683 w 1990149"/>
                    <a:gd name="connsiteY47" fmla="*/ 554419 h 2109796"/>
                    <a:gd name="connsiteX0" fmla="*/ 375941 w 1931407"/>
                    <a:gd name="connsiteY0" fmla="*/ 554419 h 2109796"/>
                    <a:gd name="connsiteX1" fmla="*/ 500835 w 1931407"/>
                    <a:gd name="connsiteY1" fmla="*/ 634033 h 2109796"/>
                    <a:gd name="connsiteX2" fmla="*/ 813585 w 1931407"/>
                    <a:gd name="connsiteY2" fmla="*/ 578075 h 2109796"/>
                    <a:gd name="connsiteX3" fmla="*/ 782481 w 1931407"/>
                    <a:gd name="connsiteY3" fmla="*/ 739160 h 2109796"/>
                    <a:gd name="connsiteX4" fmla="*/ 570613 w 1931407"/>
                    <a:gd name="connsiteY4" fmla="*/ 967122 h 2109796"/>
                    <a:gd name="connsiteX5" fmla="*/ 518310 w 1931407"/>
                    <a:gd name="connsiteY5" fmla="*/ 1152750 h 2109796"/>
                    <a:gd name="connsiteX6" fmla="*/ 721510 w 1931407"/>
                    <a:gd name="connsiteY6" fmla="*/ 1184500 h 2109796"/>
                    <a:gd name="connsiteX7" fmla="*/ 994481 w 1931407"/>
                    <a:gd name="connsiteY7" fmla="*/ 1036157 h 2109796"/>
                    <a:gd name="connsiteX8" fmla="*/ 1199749 w 1931407"/>
                    <a:gd name="connsiteY8" fmla="*/ 983105 h 2109796"/>
                    <a:gd name="connsiteX9" fmla="*/ 1232685 w 1931407"/>
                    <a:gd name="connsiteY9" fmla="*/ 1143225 h 2109796"/>
                    <a:gd name="connsiteX10" fmla="*/ 1013158 w 1931407"/>
                    <a:gd name="connsiteY10" fmla="*/ 1301415 h 2109796"/>
                    <a:gd name="connsiteX11" fmla="*/ 915185 w 1931407"/>
                    <a:gd name="connsiteY11" fmla="*/ 1460725 h 2109796"/>
                    <a:gd name="connsiteX12" fmla="*/ 1026686 w 1931407"/>
                    <a:gd name="connsiteY12" fmla="*/ 1593004 h 2109796"/>
                    <a:gd name="connsiteX13" fmla="*/ 1262291 w 1931407"/>
                    <a:gd name="connsiteY13" fmla="*/ 1477222 h 2109796"/>
                    <a:gd name="connsiteX14" fmla="*/ 1489860 w 1931407"/>
                    <a:gd name="connsiteY14" fmla="*/ 1384525 h 2109796"/>
                    <a:gd name="connsiteX15" fmla="*/ 1629560 w 1931407"/>
                    <a:gd name="connsiteY15" fmla="*/ 1552800 h 2109796"/>
                    <a:gd name="connsiteX16" fmla="*/ 1304507 w 1931407"/>
                    <a:gd name="connsiteY16" fmla="*/ 1811927 h 2109796"/>
                    <a:gd name="connsiteX17" fmla="*/ 1373959 w 1931407"/>
                    <a:gd name="connsiteY17" fmla="*/ 1977056 h 2109796"/>
                    <a:gd name="connsiteX18" fmla="*/ 1623176 w 1931407"/>
                    <a:gd name="connsiteY18" fmla="*/ 1978702 h 2109796"/>
                    <a:gd name="connsiteX19" fmla="*/ 1819328 w 1931407"/>
                    <a:gd name="connsiteY19" fmla="*/ 2106132 h 2109796"/>
                    <a:gd name="connsiteX20" fmla="*/ 1879479 w 1931407"/>
                    <a:gd name="connsiteY20" fmla="*/ 2073342 h 2109796"/>
                    <a:gd name="connsiteX21" fmla="*/ 1925861 w 1931407"/>
                    <a:gd name="connsiteY21" fmla="*/ 2052980 h 2109796"/>
                    <a:gd name="connsiteX22" fmla="*/ 1745742 w 1931407"/>
                    <a:gd name="connsiteY22" fmla="*/ 1921112 h 2109796"/>
                    <a:gd name="connsiteX23" fmla="*/ 1549374 w 1931407"/>
                    <a:gd name="connsiteY23" fmla="*/ 1863020 h 2109796"/>
                    <a:gd name="connsiteX24" fmla="*/ 1444179 w 1931407"/>
                    <a:gd name="connsiteY24" fmla="*/ 1875557 h 2109796"/>
                    <a:gd name="connsiteX25" fmla="*/ 1448097 w 1931407"/>
                    <a:gd name="connsiteY25" fmla="*/ 1809049 h 2109796"/>
                    <a:gd name="connsiteX26" fmla="*/ 1565170 w 1931407"/>
                    <a:gd name="connsiteY26" fmla="*/ 1712641 h 2109796"/>
                    <a:gd name="connsiteX27" fmla="*/ 1727985 w 1931407"/>
                    <a:gd name="connsiteY27" fmla="*/ 1555975 h 2109796"/>
                    <a:gd name="connsiteX28" fmla="*/ 1689885 w 1931407"/>
                    <a:gd name="connsiteY28" fmla="*/ 1381350 h 2109796"/>
                    <a:gd name="connsiteX29" fmla="*/ 1470810 w 1931407"/>
                    <a:gd name="connsiteY29" fmla="*/ 1289275 h 2109796"/>
                    <a:gd name="connsiteX30" fmla="*/ 1245385 w 1931407"/>
                    <a:gd name="connsiteY30" fmla="*/ 1359125 h 2109796"/>
                    <a:gd name="connsiteX31" fmla="*/ 1057980 w 1931407"/>
                    <a:gd name="connsiteY31" fmla="*/ 1472643 h 2109796"/>
                    <a:gd name="connsiteX32" fmla="*/ 1054885 w 1931407"/>
                    <a:gd name="connsiteY32" fmla="*/ 1384525 h 2109796"/>
                    <a:gd name="connsiteX33" fmla="*/ 1318410 w 1931407"/>
                    <a:gd name="connsiteY33" fmla="*/ 1203550 h 2109796"/>
                    <a:gd name="connsiteX34" fmla="*/ 1327935 w 1931407"/>
                    <a:gd name="connsiteY34" fmla="*/ 997175 h 2109796"/>
                    <a:gd name="connsiteX35" fmla="*/ 1169185 w 1931407"/>
                    <a:gd name="connsiteY35" fmla="*/ 860650 h 2109796"/>
                    <a:gd name="connsiteX36" fmla="*/ 992140 w 1931407"/>
                    <a:gd name="connsiteY36" fmla="*/ 913300 h 2109796"/>
                    <a:gd name="connsiteX37" fmla="*/ 743735 w 1931407"/>
                    <a:gd name="connsiteY37" fmla="*/ 1063850 h 2109796"/>
                    <a:gd name="connsiteX38" fmla="*/ 658010 w 1931407"/>
                    <a:gd name="connsiteY38" fmla="*/ 1063850 h 2109796"/>
                    <a:gd name="connsiteX39" fmla="*/ 651660 w 1931407"/>
                    <a:gd name="connsiteY39" fmla="*/ 1041625 h 2109796"/>
                    <a:gd name="connsiteX40" fmla="*/ 689760 w 1931407"/>
                    <a:gd name="connsiteY40" fmla="*/ 1000350 h 2109796"/>
                    <a:gd name="connsiteX41" fmla="*/ 846063 w 1931407"/>
                    <a:gd name="connsiteY41" fmla="*/ 839557 h 2109796"/>
                    <a:gd name="connsiteX42" fmla="*/ 953285 w 1931407"/>
                    <a:gd name="connsiteY42" fmla="*/ 638400 h 2109796"/>
                    <a:gd name="connsiteX43" fmla="*/ 838985 w 1931407"/>
                    <a:gd name="connsiteY43" fmla="*/ 495525 h 2109796"/>
                    <a:gd name="connsiteX44" fmla="*/ 549278 w 1931407"/>
                    <a:gd name="connsiteY44" fmla="*/ 338610 h 2109796"/>
                    <a:gd name="connsiteX45" fmla="*/ 109500 w 1931407"/>
                    <a:gd name="connsiteY45" fmla="*/ 2998 h 2109796"/>
                    <a:gd name="connsiteX46" fmla="*/ 11980 w 1931407"/>
                    <a:gd name="connsiteY46" fmla="*/ 74422 h 2109796"/>
                    <a:gd name="connsiteX47" fmla="*/ 375941 w 1931407"/>
                    <a:gd name="connsiteY47" fmla="*/ 554419 h 2109796"/>
                    <a:gd name="connsiteX0" fmla="*/ 375941 w 1931407"/>
                    <a:gd name="connsiteY0" fmla="*/ 554419 h 2109796"/>
                    <a:gd name="connsiteX1" fmla="*/ 575793 w 1931407"/>
                    <a:gd name="connsiteY1" fmla="*/ 475429 h 2109796"/>
                    <a:gd name="connsiteX2" fmla="*/ 813585 w 1931407"/>
                    <a:gd name="connsiteY2" fmla="*/ 578075 h 2109796"/>
                    <a:gd name="connsiteX3" fmla="*/ 782481 w 1931407"/>
                    <a:gd name="connsiteY3" fmla="*/ 739160 h 2109796"/>
                    <a:gd name="connsiteX4" fmla="*/ 570613 w 1931407"/>
                    <a:gd name="connsiteY4" fmla="*/ 967122 h 2109796"/>
                    <a:gd name="connsiteX5" fmla="*/ 518310 w 1931407"/>
                    <a:gd name="connsiteY5" fmla="*/ 1152750 h 2109796"/>
                    <a:gd name="connsiteX6" fmla="*/ 721510 w 1931407"/>
                    <a:gd name="connsiteY6" fmla="*/ 1184500 h 2109796"/>
                    <a:gd name="connsiteX7" fmla="*/ 994481 w 1931407"/>
                    <a:gd name="connsiteY7" fmla="*/ 1036157 h 2109796"/>
                    <a:gd name="connsiteX8" fmla="*/ 1199749 w 1931407"/>
                    <a:gd name="connsiteY8" fmla="*/ 983105 h 2109796"/>
                    <a:gd name="connsiteX9" fmla="*/ 1232685 w 1931407"/>
                    <a:gd name="connsiteY9" fmla="*/ 1143225 h 2109796"/>
                    <a:gd name="connsiteX10" fmla="*/ 1013158 w 1931407"/>
                    <a:gd name="connsiteY10" fmla="*/ 1301415 h 2109796"/>
                    <a:gd name="connsiteX11" fmla="*/ 915185 w 1931407"/>
                    <a:gd name="connsiteY11" fmla="*/ 1460725 h 2109796"/>
                    <a:gd name="connsiteX12" fmla="*/ 1026686 w 1931407"/>
                    <a:gd name="connsiteY12" fmla="*/ 1593004 h 2109796"/>
                    <a:gd name="connsiteX13" fmla="*/ 1262291 w 1931407"/>
                    <a:gd name="connsiteY13" fmla="*/ 1477222 h 2109796"/>
                    <a:gd name="connsiteX14" fmla="*/ 1489860 w 1931407"/>
                    <a:gd name="connsiteY14" fmla="*/ 1384525 h 2109796"/>
                    <a:gd name="connsiteX15" fmla="*/ 1629560 w 1931407"/>
                    <a:gd name="connsiteY15" fmla="*/ 1552800 h 2109796"/>
                    <a:gd name="connsiteX16" fmla="*/ 1304507 w 1931407"/>
                    <a:gd name="connsiteY16" fmla="*/ 1811927 h 2109796"/>
                    <a:gd name="connsiteX17" fmla="*/ 1373959 w 1931407"/>
                    <a:gd name="connsiteY17" fmla="*/ 1977056 h 2109796"/>
                    <a:gd name="connsiteX18" fmla="*/ 1623176 w 1931407"/>
                    <a:gd name="connsiteY18" fmla="*/ 1978702 h 2109796"/>
                    <a:gd name="connsiteX19" fmla="*/ 1819328 w 1931407"/>
                    <a:gd name="connsiteY19" fmla="*/ 2106132 h 2109796"/>
                    <a:gd name="connsiteX20" fmla="*/ 1879479 w 1931407"/>
                    <a:gd name="connsiteY20" fmla="*/ 2073342 h 2109796"/>
                    <a:gd name="connsiteX21" fmla="*/ 1925861 w 1931407"/>
                    <a:gd name="connsiteY21" fmla="*/ 2052980 h 2109796"/>
                    <a:gd name="connsiteX22" fmla="*/ 1745742 w 1931407"/>
                    <a:gd name="connsiteY22" fmla="*/ 1921112 h 2109796"/>
                    <a:gd name="connsiteX23" fmla="*/ 1549374 w 1931407"/>
                    <a:gd name="connsiteY23" fmla="*/ 1863020 h 2109796"/>
                    <a:gd name="connsiteX24" fmla="*/ 1444179 w 1931407"/>
                    <a:gd name="connsiteY24" fmla="*/ 1875557 h 2109796"/>
                    <a:gd name="connsiteX25" fmla="*/ 1448097 w 1931407"/>
                    <a:gd name="connsiteY25" fmla="*/ 1809049 h 2109796"/>
                    <a:gd name="connsiteX26" fmla="*/ 1565170 w 1931407"/>
                    <a:gd name="connsiteY26" fmla="*/ 1712641 h 2109796"/>
                    <a:gd name="connsiteX27" fmla="*/ 1727985 w 1931407"/>
                    <a:gd name="connsiteY27" fmla="*/ 1555975 h 2109796"/>
                    <a:gd name="connsiteX28" fmla="*/ 1689885 w 1931407"/>
                    <a:gd name="connsiteY28" fmla="*/ 1381350 h 2109796"/>
                    <a:gd name="connsiteX29" fmla="*/ 1470810 w 1931407"/>
                    <a:gd name="connsiteY29" fmla="*/ 1289275 h 2109796"/>
                    <a:gd name="connsiteX30" fmla="*/ 1245385 w 1931407"/>
                    <a:gd name="connsiteY30" fmla="*/ 1359125 h 2109796"/>
                    <a:gd name="connsiteX31" fmla="*/ 1057980 w 1931407"/>
                    <a:gd name="connsiteY31" fmla="*/ 1472643 h 2109796"/>
                    <a:gd name="connsiteX32" fmla="*/ 1054885 w 1931407"/>
                    <a:gd name="connsiteY32" fmla="*/ 1384525 h 2109796"/>
                    <a:gd name="connsiteX33" fmla="*/ 1318410 w 1931407"/>
                    <a:gd name="connsiteY33" fmla="*/ 1203550 h 2109796"/>
                    <a:gd name="connsiteX34" fmla="*/ 1327935 w 1931407"/>
                    <a:gd name="connsiteY34" fmla="*/ 997175 h 2109796"/>
                    <a:gd name="connsiteX35" fmla="*/ 1169185 w 1931407"/>
                    <a:gd name="connsiteY35" fmla="*/ 860650 h 2109796"/>
                    <a:gd name="connsiteX36" fmla="*/ 992140 w 1931407"/>
                    <a:gd name="connsiteY36" fmla="*/ 913300 h 2109796"/>
                    <a:gd name="connsiteX37" fmla="*/ 743735 w 1931407"/>
                    <a:gd name="connsiteY37" fmla="*/ 1063850 h 2109796"/>
                    <a:gd name="connsiteX38" fmla="*/ 658010 w 1931407"/>
                    <a:gd name="connsiteY38" fmla="*/ 1063850 h 2109796"/>
                    <a:gd name="connsiteX39" fmla="*/ 651660 w 1931407"/>
                    <a:gd name="connsiteY39" fmla="*/ 1041625 h 2109796"/>
                    <a:gd name="connsiteX40" fmla="*/ 689760 w 1931407"/>
                    <a:gd name="connsiteY40" fmla="*/ 1000350 h 2109796"/>
                    <a:gd name="connsiteX41" fmla="*/ 846063 w 1931407"/>
                    <a:gd name="connsiteY41" fmla="*/ 839557 h 2109796"/>
                    <a:gd name="connsiteX42" fmla="*/ 953285 w 1931407"/>
                    <a:gd name="connsiteY42" fmla="*/ 638400 h 2109796"/>
                    <a:gd name="connsiteX43" fmla="*/ 838985 w 1931407"/>
                    <a:gd name="connsiteY43" fmla="*/ 495525 h 2109796"/>
                    <a:gd name="connsiteX44" fmla="*/ 549278 w 1931407"/>
                    <a:gd name="connsiteY44" fmla="*/ 338610 h 2109796"/>
                    <a:gd name="connsiteX45" fmla="*/ 109500 w 1931407"/>
                    <a:gd name="connsiteY45" fmla="*/ 2998 h 2109796"/>
                    <a:gd name="connsiteX46" fmla="*/ 11980 w 1931407"/>
                    <a:gd name="connsiteY46" fmla="*/ 74422 h 2109796"/>
                    <a:gd name="connsiteX47" fmla="*/ 375941 w 1931407"/>
                    <a:gd name="connsiteY47" fmla="*/ 554419 h 2109796"/>
                    <a:gd name="connsiteX0" fmla="*/ 336268 w 1929126"/>
                    <a:gd name="connsiteY0" fmla="*/ 312738 h 2109796"/>
                    <a:gd name="connsiteX1" fmla="*/ 573512 w 1929126"/>
                    <a:gd name="connsiteY1" fmla="*/ 475429 h 2109796"/>
                    <a:gd name="connsiteX2" fmla="*/ 811304 w 1929126"/>
                    <a:gd name="connsiteY2" fmla="*/ 578075 h 2109796"/>
                    <a:gd name="connsiteX3" fmla="*/ 780200 w 1929126"/>
                    <a:gd name="connsiteY3" fmla="*/ 739160 h 2109796"/>
                    <a:gd name="connsiteX4" fmla="*/ 568332 w 1929126"/>
                    <a:gd name="connsiteY4" fmla="*/ 967122 h 2109796"/>
                    <a:gd name="connsiteX5" fmla="*/ 516029 w 1929126"/>
                    <a:gd name="connsiteY5" fmla="*/ 1152750 h 2109796"/>
                    <a:gd name="connsiteX6" fmla="*/ 719229 w 1929126"/>
                    <a:gd name="connsiteY6" fmla="*/ 1184500 h 2109796"/>
                    <a:gd name="connsiteX7" fmla="*/ 992200 w 1929126"/>
                    <a:gd name="connsiteY7" fmla="*/ 1036157 h 2109796"/>
                    <a:gd name="connsiteX8" fmla="*/ 1197468 w 1929126"/>
                    <a:gd name="connsiteY8" fmla="*/ 983105 h 2109796"/>
                    <a:gd name="connsiteX9" fmla="*/ 1230404 w 1929126"/>
                    <a:gd name="connsiteY9" fmla="*/ 1143225 h 2109796"/>
                    <a:gd name="connsiteX10" fmla="*/ 1010877 w 1929126"/>
                    <a:gd name="connsiteY10" fmla="*/ 1301415 h 2109796"/>
                    <a:gd name="connsiteX11" fmla="*/ 912904 w 1929126"/>
                    <a:gd name="connsiteY11" fmla="*/ 1460725 h 2109796"/>
                    <a:gd name="connsiteX12" fmla="*/ 1024405 w 1929126"/>
                    <a:gd name="connsiteY12" fmla="*/ 1593004 h 2109796"/>
                    <a:gd name="connsiteX13" fmla="*/ 1260010 w 1929126"/>
                    <a:gd name="connsiteY13" fmla="*/ 1477222 h 2109796"/>
                    <a:gd name="connsiteX14" fmla="*/ 1487579 w 1929126"/>
                    <a:gd name="connsiteY14" fmla="*/ 1384525 h 2109796"/>
                    <a:gd name="connsiteX15" fmla="*/ 1627279 w 1929126"/>
                    <a:gd name="connsiteY15" fmla="*/ 1552800 h 2109796"/>
                    <a:gd name="connsiteX16" fmla="*/ 1302226 w 1929126"/>
                    <a:gd name="connsiteY16" fmla="*/ 1811927 h 2109796"/>
                    <a:gd name="connsiteX17" fmla="*/ 1371678 w 1929126"/>
                    <a:gd name="connsiteY17" fmla="*/ 1977056 h 2109796"/>
                    <a:gd name="connsiteX18" fmla="*/ 1620895 w 1929126"/>
                    <a:gd name="connsiteY18" fmla="*/ 1978702 h 2109796"/>
                    <a:gd name="connsiteX19" fmla="*/ 1817047 w 1929126"/>
                    <a:gd name="connsiteY19" fmla="*/ 2106132 h 2109796"/>
                    <a:gd name="connsiteX20" fmla="*/ 1877198 w 1929126"/>
                    <a:gd name="connsiteY20" fmla="*/ 2073342 h 2109796"/>
                    <a:gd name="connsiteX21" fmla="*/ 1923580 w 1929126"/>
                    <a:gd name="connsiteY21" fmla="*/ 2052980 h 2109796"/>
                    <a:gd name="connsiteX22" fmla="*/ 1743461 w 1929126"/>
                    <a:gd name="connsiteY22" fmla="*/ 1921112 h 2109796"/>
                    <a:gd name="connsiteX23" fmla="*/ 1547093 w 1929126"/>
                    <a:gd name="connsiteY23" fmla="*/ 1863020 h 2109796"/>
                    <a:gd name="connsiteX24" fmla="*/ 1441898 w 1929126"/>
                    <a:gd name="connsiteY24" fmla="*/ 1875557 h 2109796"/>
                    <a:gd name="connsiteX25" fmla="*/ 1445816 w 1929126"/>
                    <a:gd name="connsiteY25" fmla="*/ 1809049 h 2109796"/>
                    <a:gd name="connsiteX26" fmla="*/ 1562889 w 1929126"/>
                    <a:gd name="connsiteY26" fmla="*/ 1712641 h 2109796"/>
                    <a:gd name="connsiteX27" fmla="*/ 1725704 w 1929126"/>
                    <a:gd name="connsiteY27" fmla="*/ 1555975 h 2109796"/>
                    <a:gd name="connsiteX28" fmla="*/ 1687604 w 1929126"/>
                    <a:gd name="connsiteY28" fmla="*/ 1381350 h 2109796"/>
                    <a:gd name="connsiteX29" fmla="*/ 1468529 w 1929126"/>
                    <a:gd name="connsiteY29" fmla="*/ 1289275 h 2109796"/>
                    <a:gd name="connsiteX30" fmla="*/ 1243104 w 1929126"/>
                    <a:gd name="connsiteY30" fmla="*/ 1359125 h 2109796"/>
                    <a:gd name="connsiteX31" fmla="*/ 1055699 w 1929126"/>
                    <a:gd name="connsiteY31" fmla="*/ 1472643 h 2109796"/>
                    <a:gd name="connsiteX32" fmla="*/ 1052604 w 1929126"/>
                    <a:gd name="connsiteY32" fmla="*/ 1384525 h 2109796"/>
                    <a:gd name="connsiteX33" fmla="*/ 1316129 w 1929126"/>
                    <a:gd name="connsiteY33" fmla="*/ 1203550 h 2109796"/>
                    <a:gd name="connsiteX34" fmla="*/ 1325654 w 1929126"/>
                    <a:gd name="connsiteY34" fmla="*/ 997175 h 2109796"/>
                    <a:gd name="connsiteX35" fmla="*/ 1166904 w 1929126"/>
                    <a:gd name="connsiteY35" fmla="*/ 860650 h 2109796"/>
                    <a:gd name="connsiteX36" fmla="*/ 989859 w 1929126"/>
                    <a:gd name="connsiteY36" fmla="*/ 913300 h 2109796"/>
                    <a:gd name="connsiteX37" fmla="*/ 741454 w 1929126"/>
                    <a:gd name="connsiteY37" fmla="*/ 1063850 h 2109796"/>
                    <a:gd name="connsiteX38" fmla="*/ 655729 w 1929126"/>
                    <a:gd name="connsiteY38" fmla="*/ 1063850 h 2109796"/>
                    <a:gd name="connsiteX39" fmla="*/ 649379 w 1929126"/>
                    <a:gd name="connsiteY39" fmla="*/ 1041625 h 2109796"/>
                    <a:gd name="connsiteX40" fmla="*/ 687479 w 1929126"/>
                    <a:gd name="connsiteY40" fmla="*/ 1000350 h 2109796"/>
                    <a:gd name="connsiteX41" fmla="*/ 843782 w 1929126"/>
                    <a:gd name="connsiteY41" fmla="*/ 839557 h 2109796"/>
                    <a:gd name="connsiteX42" fmla="*/ 951004 w 1929126"/>
                    <a:gd name="connsiteY42" fmla="*/ 638400 h 2109796"/>
                    <a:gd name="connsiteX43" fmla="*/ 836704 w 1929126"/>
                    <a:gd name="connsiteY43" fmla="*/ 495525 h 2109796"/>
                    <a:gd name="connsiteX44" fmla="*/ 546997 w 1929126"/>
                    <a:gd name="connsiteY44" fmla="*/ 338610 h 2109796"/>
                    <a:gd name="connsiteX45" fmla="*/ 107219 w 1929126"/>
                    <a:gd name="connsiteY45" fmla="*/ 2998 h 2109796"/>
                    <a:gd name="connsiteX46" fmla="*/ 9699 w 1929126"/>
                    <a:gd name="connsiteY46" fmla="*/ 74422 h 2109796"/>
                    <a:gd name="connsiteX47" fmla="*/ 336268 w 1929126"/>
                    <a:gd name="connsiteY47" fmla="*/ 312738 h 2109796"/>
                    <a:gd name="connsiteX0" fmla="*/ 299009 w 1891867"/>
                    <a:gd name="connsiteY0" fmla="*/ 312738 h 2109796"/>
                    <a:gd name="connsiteX1" fmla="*/ 536253 w 1891867"/>
                    <a:gd name="connsiteY1" fmla="*/ 475429 h 2109796"/>
                    <a:gd name="connsiteX2" fmla="*/ 774045 w 1891867"/>
                    <a:gd name="connsiteY2" fmla="*/ 578075 h 2109796"/>
                    <a:gd name="connsiteX3" fmla="*/ 742941 w 1891867"/>
                    <a:gd name="connsiteY3" fmla="*/ 739160 h 2109796"/>
                    <a:gd name="connsiteX4" fmla="*/ 531073 w 1891867"/>
                    <a:gd name="connsiteY4" fmla="*/ 967122 h 2109796"/>
                    <a:gd name="connsiteX5" fmla="*/ 478770 w 1891867"/>
                    <a:gd name="connsiteY5" fmla="*/ 1152750 h 2109796"/>
                    <a:gd name="connsiteX6" fmla="*/ 681970 w 1891867"/>
                    <a:gd name="connsiteY6" fmla="*/ 1184500 h 2109796"/>
                    <a:gd name="connsiteX7" fmla="*/ 954941 w 1891867"/>
                    <a:gd name="connsiteY7" fmla="*/ 1036157 h 2109796"/>
                    <a:gd name="connsiteX8" fmla="*/ 1160209 w 1891867"/>
                    <a:gd name="connsiteY8" fmla="*/ 983105 h 2109796"/>
                    <a:gd name="connsiteX9" fmla="*/ 1193145 w 1891867"/>
                    <a:gd name="connsiteY9" fmla="*/ 1143225 h 2109796"/>
                    <a:gd name="connsiteX10" fmla="*/ 973618 w 1891867"/>
                    <a:gd name="connsiteY10" fmla="*/ 1301415 h 2109796"/>
                    <a:gd name="connsiteX11" fmla="*/ 875645 w 1891867"/>
                    <a:gd name="connsiteY11" fmla="*/ 1460725 h 2109796"/>
                    <a:gd name="connsiteX12" fmla="*/ 987146 w 1891867"/>
                    <a:gd name="connsiteY12" fmla="*/ 1593004 h 2109796"/>
                    <a:gd name="connsiteX13" fmla="*/ 1222751 w 1891867"/>
                    <a:gd name="connsiteY13" fmla="*/ 1477222 h 2109796"/>
                    <a:gd name="connsiteX14" fmla="*/ 1450320 w 1891867"/>
                    <a:gd name="connsiteY14" fmla="*/ 1384525 h 2109796"/>
                    <a:gd name="connsiteX15" fmla="*/ 1590020 w 1891867"/>
                    <a:gd name="connsiteY15" fmla="*/ 1552800 h 2109796"/>
                    <a:gd name="connsiteX16" fmla="*/ 1264967 w 1891867"/>
                    <a:gd name="connsiteY16" fmla="*/ 1811927 h 2109796"/>
                    <a:gd name="connsiteX17" fmla="*/ 1334419 w 1891867"/>
                    <a:gd name="connsiteY17" fmla="*/ 1977056 h 2109796"/>
                    <a:gd name="connsiteX18" fmla="*/ 1583636 w 1891867"/>
                    <a:gd name="connsiteY18" fmla="*/ 1978702 h 2109796"/>
                    <a:gd name="connsiteX19" fmla="*/ 1779788 w 1891867"/>
                    <a:gd name="connsiteY19" fmla="*/ 2106132 h 2109796"/>
                    <a:gd name="connsiteX20" fmla="*/ 1839939 w 1891867"/>
                    <a:gd name="connsiteY20" fmla="*/ 2073342 h 2109796"/>
                    <a:gd name="connsiteX21" fmla="*/ 1886321 w 1891867"/>
                    <a:gd name="connsiteY21" fmla="*/ 2052980 h 2109796"/>
                    <a:gd name="connsiteX22" fmla="*/ 1706202 w 1891867"/>
                    <a:gd name="connsiteY22" fmla="*/ 1921112 h 2109796"/>
                    <a:gd name="connsiteX23" fmla="*/ 1509834 w 1891867"/>
                    <a:gd name="connsiteY23" fmla="*/ 1863020 h 2109796"/>
                    <a:gd name="connsiteX24" fmla="*/ 1404639 w 1891867"/>
                    <a:gd name="connsiteY24" fmla="*/ 1875557 h 2109796"/>
                    <a:gd name="connsiteX25" fmla="*/ 1408557 w 1891867"/>
                    <a:gd name="connsiteY25" fmla="*/ 1809049 h 2109796"/>
                    <a:gd name="connsiteX26" fmla="*/ 1525630 w 1891867"/>
                    <a:gd name="connsiteY26" fmla="*/ 1712641 h 2109796"/>
                    <a:gd name="connsiteX27" fmla="*/ 1688445 w 1891867"/>
                    <a:gd name="connsiteY27" fmla="*/ 1555975 h 2109796"/>
                    <a:gd name="connsiteX28" fmla="*/ 1650345 w 1891867"/>
                    <a:gd name="connsiteY28" fmla="*/ 1381350 h 2109796"/>
                    <a:gd name="connsiteX29" fmla="*/ 1431270 w 1891867"/>
                    <a:gd name="connsiteY29" fmla="*/ 1289275 h 2109796"/>
                    <a:gd name="connsiteX30" fmla="*/ 1205845 w 1891867"/>
                    <a:gd name="connsiteY30" fmla="*/ 1359125 h 2109796"/>
                    <a:gd name="connsiteX31" fmla="*/ 1018440 w 1891867"/>
                    <a:gd name="connsiteY31" fmla="*/ 1472643 h 2109796"/>
                    <a:gd name="connsiteX32" fmla="*/ 1015345 w 1891867"/>
                    <a:gd name="connsiteY32" fmla="*/ 1384525 h 2109796"/>
                    <a:gd name="connsiteX33" fmla="*/ 1278870 w 1891867"/>
                    <a:gd name="connsiteY33" fmla="*/ 1203550 h 2109796"/>
                    <a:gd name="connsiteX34" fmla="*/ 1288395 w 1891867"/>
                    <a:gd name="connsiteY34" fmla="*/ 997175 h 2109796"/>
                    <a:gd name="connsiteX35" fmla="*/ 1129645 w 1891867"/>
                    <a:gd name="connsiteY35" fmla="*/ 860650 h 2109796"/>
                    <a:gd name="connsiteX36" fmla="*/ 952600 w 1891867"/>
                    <a:gd name="connsiteY36" fmla="*/ 913300 h 2109796"/>
                    <a:gd name="connsiteX37" fmla="*/ 704195 w 1891867"/>
                    <a:gd name="connsiteY37" fmla="*/ 1063850 h 2109796"/>
                    <a:gd name="connsiteX38" fmla="*/ 618470 w 1891867"/>
                    <a:gd name="connsiteY38" fmla="*/ 1063850 h 2109796"/>
                    <a:gd name="connsiteX39" fmla="*/ 612120 w 1891867"/>
                    <a:gd name="connsiteY39" fmla="*/ 1041625 h 2109796"/>
                    <a:gd name="connsiteX40" fmla="*/ 650220 w 1891867"/>
                    <a:gd name="connsiteY40" fmla="*/ 1000350 h 2109796"/>
                    <a:gd name="connsiteX41" fmla="*/ 806523 w 1891867"/>
                    <a:gd name="connsiteY41" fmla="*/ 839557 h 2109796"/>
                    <a:gd name="connsiteX42" fmla="*/ 913745 w 1891867"/>
                    <a:gd name="connsiteY42" fmla="*/ 638400 h 2109796"/>
                    <a:gd name="connsiteX43" fmla="*/ 799445 w 1891867"/>
                    <a:gd name="connsiteY43" fmla="*/ 495525 h 2109796"/>
                    <a:gd name="connsiteX44" fmla="*/ 509738 w 1891867"/>
                    <a:gd name="connsiteY44" fmla="*/ 338610 h 2109796"/>
                    <a:gd name="connsiteX45" fmla="*/ 69960 w 1891867"/>
                    <a:gd name="connsiteY45" fmla="*/ 2998 h 2109796"/>
                    <a:gd name="connsiteX46" fmla="*/ 14987 w 1891867"/>
                    <a:gd name="connsiteY46" fmla="*/ 69708 h 2109796"/>
                    <a:gd name="connsiteX47" fmla="*/ 299009 w 1891867"/>
                    <a:gd name="connsiteY47" fmla="*/ 312738 h 2109796"/>
                    <a:gd name="connsiteX0" fmla="*/ 293548 w 1886406"/>
                    <a:gd name="connsiteY0" fmla="*/ 307216 h 2104274"/>
                    <a:gd name="connsiteX1" fmla="*/ 530792 w 1886406"/>
                    <a:gd name="connsiteY1" fmla="*/ 469907 h 2104274"/>
                    <a:gd name="connsiteX2" fmla="*/ 768584 w 1886406"/>
                    <a:gd name="connsiteY2" fmla="*/ 572553 h 2104274"/>
                    <a:gd name="connsiteX3" fmla="*/ 737480 w 1886406"/>
                    <a:gd name="connsiteY3" fmla="*/ 733638 h 2104274"/>
                    <a:gd name="connsiteX4" fmla="*/ 525612 w 1886406"/>
                    <a:gd name="connsiteY4" fmla="*/ 961600 h 2104274"/>
                    <a:gd name="connsiteX5" fmla="*/ 473309 w 1886406"/>
                    <a:gd name="connsiteY5" fmla="*/ 1147228 h 2104274"/>
                    <a:gd name="connsiteX6" fmla="*/ 676509 w 1886406"/>
                    <a:gd name="connsiteY6" fmla="*/ 1178978 h 2104274"/>
                    <a:gd name="connsiteX7" fmla="*/ 949480 w 1886406"/>
                    <a:gd name="connsiteY7" fmla="*/ 1030635 h 2104274"/>
                    <a:gd name="connsiteX8" fmla="*/ 1154748 w 1886406"/>
                    <a:gd name="connsiteY8" fmla="*/ 977583 h 2104274"/>
                    <a:gd name="connsiteX9" fmla="*/ 1187684 w 1886406"/>
                    <a:gd name="connsiteY9" fmla="*/ 1137703 h 2104274"/>
                    <a:gd name="connsiteX10" fmla="*/ 968157 w 1886406"/>
                    <a:gd name="connsiteY10" fmla="*/ 1295893 h 2104274"/>
                    <a:gd name="connsiteX11" fmla="*/ 870184 w 1886406"/>
                    <a:gd name="connsiteY11" fmla="*/ 1455203 h 2104274"/>
                    <a:gd name="connsiteX12" fmla="*/ 981685 w 1886406"/>
                    <a:gd name="connsiteY12" fmla="*/ 1587482 h 2104274"/>
                    <a:gd name="connsiteX13" fmla="*/ 1217290 w 1886406"/>
                    <a:gd name="connsiteY13" fmla="*/ 1471700 h 2104274"/>
                    <a:gd name="connsiteX14" fmla="*/ 1444859 w 1886406"/>
                    <a:gd name="connsiteY14" fmla="*/ 1379003 h 2104274"/>
                    <a:gd name="connsiteX15" fmla="*/ 1584559 w 1886406"/>
                    <a:gd name="connsiteY15" fmla="*/ 1547278 h 2104274"/>
                    <a:gd name="connsiteX16" fmla="*/ 1259506 w 1886406"/>
                    <a:gd name="connsiteY16" fmla="*/ 1806405 h 2104274"/>
                    <a:gd name="connsiteX17" fmla="*/ 1328958 w 1886406"/>
                    <a:gd name="connsiteY17" fmla="*/ 1971534 h 2104274"/>
                    <a:gd name="connsiteX18" fmla="*/ 1578175 w 1886406"/>
                    <a:gd name="connsiteY18" fmla="*/ 1973180 h 2104274"/>
                    <a:gd name="connsiteX19" fmla="*/ 1774327 w 1886406"/>
                    <a:gd name="connsiteY19" fmla="*/ 2100610 h 2104274"/>
                    <a:gd name="connsiteX20" fmla="*/ 1834478 w 1886406"/>
                    <a:gd name="connsiteY20" fmla="*/ 2067820 h 2104274"/>
                    <a:gd name="connsiteX21" fmla="*/ 1880860 w 1886406"/>
                    <a:gd name="connsiteY21" fmla="*/ 2047458 h 2104274"/>
                    <a:gd name="connsiteX22" fmla="*/ 1700741 w 1886406"/>
                    <a:gd name="connsiteY22" fmla="*/ 1915590 h 2104274"/>
                    <a:gd name="connsiteX23" fmla="*/ 1504373 w 1886406"/>
                    <a:gd name="connsiteY23" fmla="*/ 1857498 h 2104274"/>
                    <a:gd name="connsiteX24" fmla="*/ 1399178 w 1886406"/>
                    <a:gd name="connsiteY24" fmla="*/ 1870035 h 2104274"/>
                    <a:gd name="connsiteX25" fmla="*/ 1403096 w 1886406"/>
                    <a:gd name="connsiteY25" fmla="*/ 1803527 h 2104274"/>
                    <a:gd name="connsiteX26" fmla="*/ 1520169 w 1886406"/>
                    <a:gd name="connsiteY26" fmla="*/ 1707119 h 2104274"/>
                    <a:gd name="connsiteX27" fmla="*/ 1682984 w 1886406"/>
                    <a:gd name="connsiteY27" fmla="*/ 1550453 h 2104274"/>
                    <a:gd name="connsiteX28" fmla="*/ 1644884 w 1886406"/>
                    <a:gd name="connsiteY28" fmla="*/ 1375828 h 2104274"/>
                    <a:gd name="connsiteX29" fmla="*/ 1425809 w 1886406"/>
                    <a:gd name="connsiteY29" fmla="*/ 1283753 h 2104274"/>
                    <a:gd name="connsiteX30" fmla="*/ 1200384 w 1886406"/>
                    <a:gd name="connsiteY30" fmla="*/ 1353603 h 2104274"/>
                    <a:gd name="connsiteX31" fmla="*/ 1012979 w 1886406"/>
                    <a:gd name="connsiteY31" fmla="*/ 1467121 h 2104274"/>
                    <a:gd name="connsiteX32" fmla="*/ 1009884 w 1886406"/>
                    <a:gd name="connsiteY32" fmla="*/ 1379003 h 2104274"/>
                    <a:gd name="connsiteX33" fmla="*/ 1273409 w 1886406"/>
                    <a:gd name="connsiteY33" fmla="*/ 1198028 h 2104274"/>
                    <a:gd name="connsiteX34" fmla="*/ 1282934 w 1886406"/>
                    <a:gd name="connsiteY34" fmla="*/ 991653 h 2104274"/>
                    <a:gd name="connsiteX35" fmla="*/ 1124184 w 1886406"/>
                    <a:gd name="connsiteY35" fmla="*/ 855128 h 2104274"/>
                    <a:gd name="connsiteX36" fmla="*/ 947139 w 1886406"/>
                    <a:gd name="connsiteY36" fmla="*/ 907778 h 2104274"/>
                    <a:gd name="connsiteX37" fmla="*/ 698734 w 1886406"/>
                    <a:gd name="connsiteY37" fmla="*/ 1058328 h 2104274"/>
                    <a:gd name="connsiteX38" fmla="*/ 613009 w 1886406"/>
                    <a:gd name="connsiteY38" fmla="*/ 1058328 h 2104274"/>
                    <a:gd name="connsiteX39" fmla="*/ 606659 w 1886406"/>
                    <a:gd name="connsiteY39" fmla="*/ 1036103 h 2104274"/>
                    <a:gd name="connsiteX40" fmla="*/ 644759 w 1886406"/>
                    <a:gd name="connsiteY40" fmla="*/ 994828 h 2104274"/>
                    <a:gd name="connsiteX41" fmla="*/ 801062 w 1886406"/>
                    <a:gd name="connsiteY41" fmla="*/ 834035 h 2104274"/>
                    <a:gd name="connsiteX42" fmla="*/ 908284 w 1886406"/>
                    <a:gd name="connsiteY42" fmla="*/ 632878 h 2104274"/>
                    <a:gd name="connsiteX43" fmla="*/ 793984 w 1886406"/>
                    <a:gd name="connsiteY43" fmla="*/ 490003 h 2104274"/>
                    <a:gd name="connsiteX44" fmla="*/ 504277 w 1886406"/>
                    <a:gd name="connsiteY44" fmla="*/ 333088 h 2104274"/>
                    <a:gd name="connsiteX45" fmla="*/ 90983 w 1886406"/>
                    <a:gd name="connsiteY45" fmla="*/ 3044 h 2104274"/>
                    <a:gd name="connsiteX46" fmla="*/ 9526 w 1886406"/>
                    <a:gd name="connsiteY46" fmla="*/ 64186 h 2104274"/>
                    <a:gd name="connsiteX47" fmla="*/ 293548 w 1886406"/>
                    <a:gd name="connsiteY47" fmla="*/ 307216 h 2104274"/>
                    <a:gd name="connsiteX0" fmla="*/ 293548 w 1886406"/>
                    <a:gd name="connsiteY0" fmla="*/ 310640 h 2107698"/>
                    <a:gd name="connsiteX1" fmla="*/ 530792 w 1886406"/>
                    <a:gd name="connsiteY1" fmla="*/ 473331 h 2107698"/>
                    <a:gd name="connsiteX2" fmla="*/ 768584 w 1886406"/>
                    <a:gd name="connsiteY2" fmla="*/ 575977 h 2107698"/>
                    <a:gd name="connsiteX3" fmla="*/ 737480 w 1886406"/>
                    <a:gd name="connsiteY3" fmla="*/ 737062 h 2107698"/>
                    <a:gd name="connsiteX4" fmla="*/ 525612 w 1886406"/>
                    <a:gd name="connsiteY4" fmla="*/ 965024 h 2107698"/>
                    <a:gd name="connsiteX5" fmla="*/ 473309 w 1886406"/>
                    <a:gd name="connsiteY5" fmla="*/ 1150652 h 2107698"/>
                    <a:gd name="connsiteX6" fmla="*/ 676509 w 1886406"/>
                    <a:gd name="connsiteY6" fmla="*/ 1182402 h 2107698"/>
                    <a:gd name="connsiteX7" fmla="*/ 949480 w 1886406"/>
                    <a:gd name="connsiteY7" fmla="*/ 1034059 h 2107698"/>
                    <a:gd name="connsiteX8" fmla="*/ 1154748 w 1886406"/>
                    <a:gd name="connsiteY8" fmla="*/ 981007 h 2107698"/>
                    <a:gd name="connsiteX9" fmla="*/ 1187684 w 1886406"/>
                    <a:gd name="connsiteY9" fmla="*/ 1141127 h 2107698"/>
                    <a:gd name="connsiteX10" fmla="*/ 968157 w 1886406"/>
                    <a:gd name="connsiteY10" fmla="*/ 1299317 h 2107698"/>
                    <a:gd name="connsiteX11" fmla="*/ 870184 w 1886406"/>
                    <a:gd name="connsiteY11" fmla="*/ 1458627 h 2107698"/>
                    <a:gd name="connsiteX12" fmla="*/ 981685 w 1886406"/>
                    <a:gd name="connsiteY12" fmla="*/ 1590906 h 2107698"/>
                    <a:gd name="connsiteX13" fmla="*/ 1217290 w 1886406"/>
                    <a:gd name="connsiteY13" fmla="*/ 1475124 h 2107698"/>
                    <a:gd name="connsiteX14" fmla="*/ 1444859 w 1886406"/>
                    <a:gd name="connsiteY14" fmla="*/ 1382427 h 2107698"/>
                    <a:gd name="connsiteX15" fmla="*/ 1584559 w 1886406"/>
                    <a:gd name="connsiteY15" fmla="*/ 1550702 h 2107698"/>
                    <a:gd name="connsiteX16" fmla="*/ 1259506 w 1886406"/>
                    <a:gd name="connsiteY16" fmla="*/ 1809829 h 2107698"/>
                    <a:gd name="connsiteX17" fmla="*/ 1328958 w 1886406"/>
                    <a:gd name="connsiteY17" fmla="*/ 1974958 h 2107698"/>
                    <a:gd name="connsiteX18" fmla="*/ 1578175 w 1886406"/>
                    <a:gd name="connsiteY18" fmla="*/ 1976604 h 2107698"/>
                    <a:gd name="connsiteX19" fmla="*/ 1774327 w 1886406"/>
                    <a:gd name="connsiteY19" fmla="*/ 2104034 h 2107698"/>
                    <a:gd name="connsiteX20" fmla="*/ 1834478 w 1886406"/>
                    <a:gd name="connsiteY20" fmla="*/ 2071244 h 2107698"/>
                    <a:gd name="connsiteX21" fmla="*/ 1880860 w 1886406"/>
                    <a:gd name="connsiteY21" fmla="*/ 2050882 h 2107698"/>
                    <a:gd name="connsiteX22" fmla="*/ 1700741 w 1886406"/>
                    <a:gd name="connsiteY22" fmla="*/ 1919014 h 2107698"/>
                    <a:gd name="connsiteX23" fmla="*/ 1504373 w 1886406"/>
                    <a:gd name="connsiteY23" fmla="*/ 1860922 h 2107698"/>
                    <a:gd name="connsiteX24" fmla="*/ 1399178 w 1886406"/>
                    <a:gd name="connsiteY24" fmla="*/ 1873459 h 2107698"/>
                    <a:gd name="connsiteX25" fmla="*/ 1403096 w 1886406"/>
                    <a:gd name="connsiteY25" fmla="*/ 1806951 h 2107698"/>
                    <a:gd name="connsiteX26" fmla="*/ 1520169 w 1886406"/>
                    <a:gd name="connsiteY26" fmla="*/ 1710543 h 2107698"/>
                    <a:gd name="connsiteX27" fmla="*/ 1682984 w 1886406"/>
                    <a:gd name="connsiteY27" fmla="*/ 1553877 h 2107698"/>
                    <a:gd name="connsiteX28" fmla="*/ 1644884 w 1886406"/>
                    <a:gd name="connsiteY28" fmla="*/ 1379252 h 2107698"/>
                    <a:gd name="connsiteX29" fmla="*/ 1425809 w 1886406"/>
                    <a:gd name="connsiteY29" fmla="*/ 1287177 h 2107698"/>
                    <a:gd name="connsiteX30" fmla="*/ 1200384 w 1886406"/>
                    <a:gd name="connsiteY30" fmla="*/ 1357027 h 2107698"/>
                    <a:gd name="connsiteX31" fmla="*/ 1012979 w 1886406"/>
                    <a:gd name="connsiteY31" fmla="*/ 1470545 h 2107698"/>
                    <a:gd name="connsiteX32" fmla="*/ 1009884 w 1886406"/>
                    <a:gd name="connsiteY32" fmla="*/ 1382427 h 2107698"/>
                    <a:gd name="connsiteX33" fmla="*/ 1273409 w 1886406"/>
                    <a:gd name="connsiteY33" fmla="*/ 1201452 h 2107698"/>
                    <a:gd name="connsiteX34" fmla="*/ 1282934 w 1886406"/>
                    <a:gd name="connsiteY34" fmla="*/ 995077 h 2107698"/>
                    <a:gd name="connsiteX35" fmla="*/ 1124184 w 1886406"/>
                    <a:gd name="connsiteY35" fmla="*/ 858552 h 2107698"/>
                    <a:gd name="connsiteX36" fmla="*/ 947139 w 1886406"/>
                    <a:gd name="connsiteY36" fmla="*/ 911202 h 2107698"/>
                    <a:gd name="connsiteX37" fmla="*/ 698734 w 1886406"/>
                    <a:gd name="connsiteY37" fmla="*/ 1061752 h 2107698"/>
                    <a:gd name="connsiteX38" fmla="*/ 613009 w 1886406"/>
                    <a:gd name="connsiteY38" fmla="*/ 1061752 h 2107698"/>
                    <a:gd name="connsiteX39" fmla="*/ 606659 w 1886406"/>
                    <a:gd name="connsiteY39" fmla="*/ 1039527 h 2107698"/>
                    <a:gd name="connsiteX40" fmla="*/ 644759 w 1886406"/>
                    <a:gd name="connsiteY40" fmla="*/ 998252 h 2107698"/>
                    <a:gd name="connsiteX41" fmla="*/ 801062 w 1886406"/>
                    <a:gd name="connsiteY41" fmla="*/ 837459 h 2107698"/>
                    <a:gd name="connsiteX42" fmla="*/ 908284 w 1886406"/>
                    <a:gd name="connsiteY42" fmla="*/ 636302 h 2107698"/>
                    <a:gd name="connsiteX43" fmla="*/ 793984 w 1886406"/>
                    <a:gd name="connsiteY43" fmla="*/ 493427 h 2107698"/>
                    <a:gd name="connsiteX44" fmla="*/ 286919 w 1886406"/>
                    <a:gd name="connsiteY44" fmla="*/ 170292 h 2107698"/>
                    <a:gd name="connsiteX45" fmla="*/ 90983 w 1886406"/>
                    <a:gd name="connsiteY45" fmla="*/ 6468 h 2107698"/>
                    <a:gd name="connsiteX46" fmla="*/ 9526 w 1886406"/>
                    <a:gd name="connsiteY46" fmla="*/ 67610 h 2107698"/>
                    <a:gd name="connsiteX47" fmla="*/ 293548 w 1886406"/>
                    <a:gd name="connsiteY47" fmla="*/ 310640 h 2107698"/>
                    <a:gd name="connsiteX0" fmla="*/ 293548 w 1886406"/>
                    <a:gd name="connsiteY0" fmla="*/ 309784 h 2106842"/>
                    <a:gd name="connsiteX1" fmla="*/ 530792 w 1886406"/>
                    <a:gd name="connsiteY1" fmla="*/ 472475 h 2106842"/>
                    <a:gd name="connsiteX2" fmla="*/ 768584 w 1886406"/>
                    <a:gd name="connsiteY2" fmla="*/ 575121 h 2106842"/>
                    <a:gd name="connsiteX3" fmla="*/ 737480 w 1886406"/>
                    <a:gd name="connsiteY3" fmla="*/ 736206 h 2106842"/>
                    <a:gd name="connsiteX4" fmla="*/ 525612 w 1886406"/>
                    <a:gd name="connsiteY4" fmla="*/ 964168 h 2106842"/>
                    <a:gd name="connsiteX5" fmla="*/ 473309 w 1886406"/>
                    <a:gd name="connsiteY5" fmla="*/ 1149796 h 2106842"/>
                    <a:gd name="connsiteX6" fmla="*/ 676509 w 1886406"/>
                    <a:gd name="connsiteY6" fmla="*/ 1181546 h 2106842"/>
                    <a:gd name="connsiteX7" fmla="*/ 949480 w 1886406"/>
                    <a:gd name="connsiteY7" fmla="*/ 1033203 h 2106842"/>
                    <a:gd name="connsiteX8" fmla="*/ 1154748 w 1886406"/>
                    <a:gd name="connsiteY8" fmla="*/ 980151 h 2106842"/>
                    <a:gd name="connsiteX9" fmla="*/ 1187684 w 1886406"/>
                    <a:gd name="connsiteY9" fmla="*/ 1140271 h 2106842"/>
                    <a:gd name="connsiteX10" fmla="*/ 968157 w 1886406"/>
                    <a:gd name="connsiteY10" fmla="*/ 1298461 h 2106842"/>
                    <a:gd name="connsiteX11" fmla="*/ 870184 w 1886406"/>
                    <a:gd name="connsiteY11" fmla="*/ 1457771 h 2106842"/>
                    <a:gd name="connsiteX12" fmla="*/ 981685 w 1886406"/>
                    <a:gd name="connsiteY12" fmla="*/ 1590050 h 2106842"/>
                    <a:gd name="connsiteX13" fmla="*/ 1217290 w 1886406"/>
                    <a:gd name="connsiteY13" fmla="*/ 1474268 h 2106842"/>
                    <a:gd name="connsiteX14" fmla="*/ 1444859 w 1886406"/>
                    <a:gd name="connsiteY14" fmla="*/ 1381571 h 2106842"/>
                    <a:gd name="connsiteX15" fmla="*/ 1584559 w 1886406"/>
                    <a:gd name="connsiteY15" fmla="*/ 1549846 h 2106842"/>
                    <a:gd name="connsiteX16" fmla="*/ 1259506 w 1886406"/>
                    <a:gd name="connsiteY16" fmla="*/ 1808973 h 2106842"/>
                    <a:gd name="connsiteX17" fmla="*/ 1328958 w 1886406"/>
                    <a:gd name="connsiteY17" fmla="*/ 1974102 h 2106842"/>
                    <a:gd name="connsiteX18" fmla="*/ 1578175 w 1886406"/>
                    <a:gd name="connsiteY18" fmla="*/ 1975748 h 2106842"/>
                    <a:gd name="connsiteX19" fmla="*/ 1774327 w 1886406"/>
                    <a:gd name="connsiteY19" fmla="*/ 2103178 h 2106842"/>
                    <a:gd name="connsiteX20" fmla="*/ 1834478 w 1886406"/>
                    <a:gd name="connsiteY20" fmla="*/ 2070388 h 2106842"/>
                    <a:gd name="connsiteX21" fmla="*/ 1880860 w 1886406"/>
                    <a:gd name="connsiteY21" fmla="*/ 2050026 h 2106842"/>
                    <a:gd name="connsiteX22" fmla="*/ 1700741 w 1886406"/>
                    <a:gd name="connsiteY22" fmla="*/ 1918158 h 2106842"/>
                    <a:gd name="connsiteX23" fmla="*/ 1504373 w 1886406"/>
                    <a:gd name="connsiteY23" fmla="*/ 1860066 h 2106842"/>
                    <a:gd name="connsiteX24" fmla="*/ 1399178 w 1886406"/>
                    <a:gd name="connsiteY24" fmla="*/ 1872603 h 2106842"/>
                    <a:gd name="connsiteX25" fmla="*/ 1403096 w 1886406"/>
                    <a:gd name="connsiteY25" fmla="*/ 1806095 h 2106842"/>
                    <a:gd name="connsiteX26" fmla="*/ 1520169 w 1886406"/>
                    <a:gd name="connsiteY26" fmla="*/ 1709687 h 2106842"/>
                    <a:gd name="connsiteX27" fmla="*/ 1682984 w 1886406"/>
                    <a:gd name="connsiteY27" fmla="*/ 1553021 h 2106842"/>
                    <a:gd name="connsiteX28" fmla="*/ 1644884 w 1886406"/>
                    <a:gd name="connsiteY28" fmla="*/ 1378396 h 2106842"/>
                    <a:gd name="connsiteX29" fmla="*/ 1425809 w 1886406"/>
                    <a:gd name="connsiteY29" fmla="*/ 1286321 h 2106842"/>
                    <a:gd name="connsiteX30" fmla="*/ 1200384 w 1886406"/>
                    <a:gd name="connsiteY30" fmla="*/ 1356171 h 2106842"/>
                    <a:gd name="connsiteX31" fmla="*/ 1012979 w 1886406"/>
                    <a:gd name="connsiteY31" fmla="*/ 1469689 h 2106842"/>
                    <a:gd name="connsiteX32" fmla="*/ 1009884 w 1886406"/>
                    <a:gd name="connsiteY32" fmla="*/ 1381571 h 2106842"/>
                    <a:gd name="connsiteX33" fmla="*/ 1273409 w 1886406"/>
                    <a:gd name="connsiteY33" fmla="*/ 1200596 h 2106842"/>
                    <a:gd name="connsiteX34" fmla="*/ 1282934 w 1886406"/>
                    <a:gd name="connsiteY34" fmla="*/ 994221 h 2106842"/>
                    <a:gd name="connsiteX35" fmla="*/ 1124184 w 1886406"/>
                    <a:gd name="connsiteY35" fmla="*/ 857696 h 2106842"/>
                    <a:gd name="connsiteX36" fmla="*/ 947139 w 1886406"/>
                    <a:gd name="connsiteY36" fmla="*/ 910346 h 2106842"/>
                    <a:gd name="connsiteX37" fmla="*/ 698734 w 1886406"/>
                    <a:gd name="connsiteY37" fmla="*/ 1060896 h 2106842"/>
                    <a:gd name="connsiteX38" fmla="*/ 613009 w 1886406"/>
                    <a:gd name="connsiteY38" fmla="*/ 1060896 h 2106842"/>
                    <a:gd name="connsiteX39" fmla="*/ 606659 w 1886406"/>
                    <a:gd name="connsiteY39" fmla="*/ 1038671 h 2106842"/>
                    <a:gd name="connsiteX40" fmla="*/ 644759 w 1886406"/>
                    <a:gd name="connsiteY40" fmla="*/ 997396 h 2106842"/>
                    <a:gd name="connsiteX41" fmla="*/ 801062 w 1886406"/>
                    <a:gd name="connsiteY41" fmla="*/ 836603 h 2106842"/>
                    <a:gd name="connsiteX42" fmla="*/ 908284 w 1886406"/>
                    <a:gd name="connsiteY42" fmla="*/ 635446 h 2106842"/>
                    <a:gd name="connsiteX43" fmla="*/ 521030 w 1886406"/>
                    <a:gd name="connsiteY43" fmla="*/ 350018 h 2106842"/>
                    <a:gd name="connsiteX44" fmla="*/ 286919 w 1886406"/>
                    <a:gd name="connsiteY44" fmla="*/ 169436 h 2106842"/>
                    <a:gd name="connsiteX45" fmla="*/ 90983 w 1886406"/>
                    <a:gd name="connsiteY45" fmla="*/ 5612 h 2106842"/>
                    <a:gd name="connsiteX46" fmla="*/ 9526 w 1886406"/>
                    <a:gd name="connsiteY46" fmla="*/ 66754 h 2106842"/>
                    <a:gd name="connsiteX47" fmla="*/ 293548 w 1886406"/>
                    <a:gd name="connsiteY47" fmla="*/ 309784 h 2106842"/>
                    <a:gd name="connsiteX0" fmla="*/ 281997 w 1874855"/>
                    <a:gd name="connsiteY0" fmla="*/ 309784 h 2106842"/>
                    <a:gd name="connsiteX1" fmla="*/ 519241 w 1874855"/>
                    <a:gd name="connsiteY1" fmla="*/ 472475 h 2106842"/>
                    <a:gd name="connsiteX2" fmla="*/ 757033 w 1874855"/>
                    <a:gd name="connsiteY2" fmla="*/ 575121 h 2106842"/>
                    <a:gd name="connsiteX3" fmla="*/ 725929 w 1874855"/>
                    <a:gd name="connsiteY3" fmla="*/ 736206 h 2106842"/>
                    <a:gd name="connsiteX4" fmla="*/ 514061 w 1874855"/>
                    <a:gd name="connsiteY4" fmla="*/ 964168 h 2106842"/>
                    <a:gd name="connsiteX5" fmla="*/ 461758 w 1874855"/>
                    <a:gd name="connsiteY5" fmla="*/ 1149796 h 2106842"/>
                    <a:gd name="connsiteX6" fmla="*/ 664958 w 1874855"/>
                    <a:gd name="connsiteY6" fmla="*/ 1181546 h 2106842"/>
                    <a:gd name="connsiteX7" fmla="*/ 937929 w 1874855"/>
                    <a:gd name="connsiteY7" fmla="*/ 1033203 h 2106842"/>
                    <a:gd name="connsiteX8" fmla="*/ 1143197 w 1874855"/>
                    <a:gd name="connsiteY8" fmla="*/ 980151 h 2106842"/>
                    <a:gd name="connsiteX9" fmla="*/ 1176133 w 1874855"/>
                    <a:gd name="connsiteY9" fmla="*/ 1140271 h 2106842"/>
                    <a:gd name="connsiteX10" fmla="*/ 956606 w 1874855"/>
                    <a:gd name="connsiteY10" fmla="*/ 1298461 h 2106842"/>
                    <a:gd name="connsiteX11" fmla="*/ 858633 w 1874855"/>
                    <a:gd name="connsiteY11" fmla="*/ 1457771 h 2106842"/>
                    <a:gd name="connsiteX12" fmla="*/ 970134 w 1874855"/>
                    <a:gd name="connsiteY12" fmla="*/ 1590050 h 2106842"/>
                    <a:gd name="connsiteX13" fmla="*/ 1205739 w 1874855"/>
                    <a:gd name="connsiteY13" fmla="*/ 1474268 h 2106842"/>
                    <a:gd name="connsiteX14" fmla="*/ 1433308 w 1874855"/>
                    <a:gd name="connsiteY14" fmla="*/ 1381571 h 2106842"/>
                    <a:gd name="connsiteX15" fmla="*/ 1573008 w 1874855"/>
                    <a:gd name="connsiteY15" fmla="*/ 1549846 h 2106842"/>
                    <a:gd name="connsiteX16" fmla="*/ 1247955 w 1874855"/>
                    <a:gd name="connsiteY16" fmla="*/ 1808973 h 2106842"/>
                    <a:gd name="connsiteX17" fmla="*/ 1317407 w 1874855"/>
                    <a:gd name="connsiteY17" fmla="*/ 1974102 h 2106842"/>
                    <a:gd name="connsiteX18" fmla="*/ 1566624 w 1874855"/>
                    <a:gd name="connsiteY18" fmla="*/ 1975748 h 2106842"/>
                    <a:gd name="connsiteX19" fmla="*/ 1762776 w 1874855"/>
                    <a:gd name="connsiteY19" fmla="*/ 2103178 h 2106842"/>
                    <a:gd name="connsiteX20" fmla="*/ 1822927 w 1874855"/>
                    <a:gd name="connsiteY20" fmla="*/ 2070388 h 2106842"/>
                    <a:gd name="connsiteX21" fmla="*/ 1869309 w 1874855"/>
                    <a:gd name="connsiteY21" fmla="*/ 2050026 h 2106842"/>
                    <a:gd name="connsiteX22" fmla="*/ 1689190 w 1874855"/>
                    <a:gd name="connsiteY22" fmla="*/ 1918158 h 2106842"/>
                    <a:gd name="connsiteX23" fmla="*/ 1492822 w 1874855"/>
                    <a:gd name="connsiteY23" fmla="*/ 1860066 h 2106842"/>
                    <a:gd name="connsiteX24" fmla="*/ 1387627 w 1874855"/>
                    <a:gd name="connsiteY24" fmla="*/ 1872603 h 2106842"/>
                    <a:gd name="connsiteX25" fmla="*/ 1391545 w 1874855"/>
                    <a:gd name="connsiteY25" fmla="*/ 1806095 h 2106842"/>
                    <a:gd name="connsiteX26" fmla="*/ 1508618 w 1874855"/>
                    <a:gd name="connsiteY26" fmla="*/ 1709687 h 2106842"/>
                    <a:gd name="connsiteX27" fmla="*/ 1671433 w 1874855"/>
                    <a:gd name="connsiteY27" fmla="*/ 1553021 h 2106842"/>
                    <a:gd name="connsiteX28" fmla="*/ 1633333 w 1874855"/>
                    <a:gd name="connsiteY28" fmla="*/ 1378396 h 2106842"/>
                    <a:gd name="connsiteX29" fmla="*/ 1414258 w 1874855"/>
                    <a:gd name="connsiteY29" fmla="*/ 1286321 h 2106842"/>
                    <a:gd name="connsiteX30" fmla="*/ 1188833 w 1874855"/>
                    <a:gd name="connsiteY30" fmla="*/ 1356171 h 2106842"/>
                    <a:gd name="connsiteX31" fmla="*/ 1001428 w 1874855"/>
                    <a:gd name="connsiteY31" fmla="*/ 1469689 h 2106842"/>
                    <a:gd name="connsiteX32" fmla="*/ 998333 w 1874855"/>
                    <a:gd name="connsiteY32" fmla="*/ 1381571 h 2106842"/>
                    <a:gd name="connsiteX33" fmla="*/ 1261858 w 1874855"/>
                    <a:gd name="connsiteY33" fmla="*/ 1200596 h 2106842"/>
                    <a:gd name="connsiteX34" fmla="*/ 1271383 w 1874855"/>
                    <a:gd name="connsiteY34" fmla="*/ 994221 h 2106842"/>
                    <a:gd name="connsiteX35" fmla="*/ 1112633 w 1874855"/>
                    <a:gd name="connsiteY35" fmla="*/ 857696 h 2106842"/>
                    <a:gd name="connsiteX36" fmla="*/ 935588 w 1874855"/>
                    <a:gd name="connsiteY36" fmla="*/ 910346 h 2106842"/>
                    <a:gd name="connsiteX37" fmla="*/ 687183 w 1874855"/>
                    <a:gd name="connsiteY37" fmla="*/ 1060896 h 2106842"/>
                    <a:gd name="connsiteX38" fmla="*/ 601458 w 1874855"/>
                    <a:gd name="connsiteY38" fmla="*/ 1060896 h 2106842"/>
                    <a:gd name="connsiteX39" fmla="*/ 595108 w 1874855"/>
                    <a:gd name="connsiteY39" fmla="*/ 1038671 h 2106842"/>
                    <a:gd name="connsiteX40" fmla="*/ 633208 w 1874855"/>
                    <a:gd name="connsiteY40" fmla="*/ 997396 h 2106842"/>
                    <a:gd name="connsiteX41" fmla="*/ 789511 w 1874855"/>
                    <a:gd name="connsiteY41" fmla="*/ 836603 h 2106842"/>
                    <a:gd name="connsiteX42" fmla="*/ 896733 w 1874855"/>
                    <a:gd name="connsiteY42" fmla="*/ 635446 h 2106842"/>
                    <a:gd name="connsiteX43" fmla="*/ 509479 w 1874855"/>
                    <a:gd name="connsiteY43" fmla="*/ 350018 h 2106842"/>
                    <a:gd name="connsiteX44" fmla="*/ 275368 w 1874855"/>
                    <a:gd name="connsiteY44" fmla="*/ 169436 h 2106842"/>
                    <a:gd name="connsiteX45" fmla="*/ 79432 w 1874855"/>
                    <a:gd name="connsiteY45" fmla="*/ 5612 h 2106842"/>
                    <a:gd name="connsiteX46" fmla="*/ 11024 w 1874855"/>
                    <a:gd name="connsiteY46" fmla="*/ 47803 h 2106842"/>
                    <a:gd name="connsiteX47" fmla="*/ 281997 w 1874855"/>
                    <a:gd name="connsiteY47" fmla="*/ 309784 h 2106842"/>
                    <a:gd name="connsiteX0" fmla="*/ 281997 w 1874855"/>
                    <a:gd name="connsiteY0" fmla="*/ 309784 h 2106842"/>
                    <a:gd name="connsiteX1" fmla="*/ 519241 w 1874855"/>
                    <a:gd name="connsiteY1" fmla="*/ 472475 h 2106842"/>
                    <a:gd name="connsiteX2" fmla="*/ 718879 w 1874855"/>
                    <a:gd name="connsiteY2" fmla="*/ 578350 h 2106842"/>
                    <a:gd name="connsiteX3" fmla="*/ 725929 w 1874855"/>
                    <a:gd name="connsiteY3" fmla="*/ 736206 h 2106842"/>
                    <a:gd name="connsiteX4" fmla="*/ 514061 w 1874855"/>
                    <a:gd name="connsiteY4" fmla="*/ 964168 h 2106842"/>
                    <a:gd name="connsiteX5" fmla="*/ 461758 w 1874855"/>
                    <a:gd name="connsiteY5" fmla="*/ 1149796 h 2106842"/>
                    <a:gd name="connsiteX6" fmla="*/ 664958 w 1874855"/>
                    <a:gd name="connsiteY6" fmla="*/ 1181546 h 2106842"/>
                    <a:gd name="connsiteX7" fmla="*/ 937929 w 1874855"/>
                    <a:gd name="connsiteY7" fmla="*/ 1033203 h 2106842"/>
                    <a:gd name="connsiteX8" fmla="*/ 1143197 w 1874855"/>
                    <a:gd name="connsiteY8" fmla="*/ 980151 h 2106842"/>
                    <a:gd name="connsiteX9" fmla="*/ 1176133 w 1874855"/>
                    <a:gd name="connsiteY9" fmla="*/ 1140271 h 2106842"/>
                    <a:gd name="connsiteX10" fmla="*/ 956606 w 1874855"/>
                    <a:gd name="connsiteY10" fmla="*/ 1298461 h 2106842"/>
                    <a:gd name="connsiteX11" fmla="*/ 858633 w 1874855"/>
                    <a:gd name="connsiteY11" fmla="*/ 1457771 h 2106842"/>
                    <a:gd name="connsiteX12" fmla="*/ 970134 w 1874855"/>
                    <a:gd name="connsiteY12" fmla="*/ 1590050 h 2106842"/>
                    <a:gd name="connsiteX13" fmla="*/ 1205739 w 1874855"/>
                    <a:gd name="connsiteY13" fmla="*/ 1474268 h 2106842"/>
                    <a:gd name="connsiteX14" fmla="*/ 1433308 w 1874855"/>
                    <a:gd name="connsiteY14" fmla="*/ 1381571 h 2106842"/>
                    <a:gd name="connsiteX15" fmla="*/ 1573008 w 1874855"/>
                    <a:gd name="connsiteY15" fmla="*/ 1549846 h 2106842"/>
                    <a:gd name="connsiteX16" fmla="*/ 1247955 w 1874855"/>
                    <a:gd name="connsiteY16" fmla="*/ 1808973 h 2106842"/>
                    <a:gd name="connsiteX17" fmla="*/ 1317407 w 1874855"/>
                    <a:gd name="connsiteY17" fmla="*/ 1974102 h 2106842"/>
                    <a:gd name="connsiteX18" fmla="*/ 1566624 w 1874855"/>
                    <a:gd name="connsiteY18" fmla="*/ 1975748 h 2106842"/>
                    <a:gd name="connsiteX19" fmla="*/ 1762776 w 1874855"/>
                    <a:gd name="connsiteY19" fmla="*/ 2103178 h 2106842"/>
                    <a:gd name="connsiteX20" fmla="*/ 1822927 w 1874855"/>
                    <a:gd name="connsiteY20" fmla="*/ 2070388 h 2106842"/>
                    <a:gd name="connsiteX21" fmla="*/ 1869309 w 1874855"/>
                    <a:gd name="connsiteY21" fmla="*/ 2050026 h 2106842"/>
                    <a:gd name="connsiteX22" fmla="*/ 1689190 w 1874855"/>
                    <a:gd name="connsiteY22" fmla="*/ 1918158 h 2106842"/>
                    <a:gd name="connsiteX23" fmla="*/ 1492822 w 1874855"/>
                    <a:gd name="connsiteY23" fmla="*/ 1860066 h 2106842"/>
                    <a:gd name="connsiteX24" fmla="*/ 1387627 w 1874855"/>
                    <a:gd name="connsiteY24" fmla="*/ 1872603 h 2106842"/>
                    <a:gd name="connsiteX25" fmla="*/ 1391545 w 1874855"/>
                    <a:gd name="connsiteY25" fmla="*/ 1806095 h 2106842"/>
                    <a:gd name="connsiteX26" fmla="*/ 1508618 w 1874855"/>
                    <a:gd name="connsiteY26" fmla="*/ 1709687 h 2106842"/>
                    <a:gd name="connsiteX27" fmla="*/ 1671433 w 1874855"/>
                    <a:gd name="connsiteY27" fmla="*/ 1553021 h 2106842"/>
                    <a:gd name="connsiteX28" fmla="*/ 1633333 w 1874855"/>
                    <a:gd name="connsiteY28" fmla="*/ 1378396 h 2106842"/>
                    <a:gd name="connsiteX29" fmla="*/ 1414258 w 1874855"/>
                    <a:gd name="connsiteY29" fmla="*/ 1286321 h 2106842"/>
                    <a:gd name="connsiteX30" fmla="*/ 1188833 w 1874855"/>
                    <a:gd name="connsiteY30" fmla="*/ 1356171 h 2106842"/>
                    <a:gd name="connsiteX31" fmla="*/ 1001428 w 1874855"/>
                    <a:gd name="connsiteY31" fmla="*/ 1469689 h 2106842"/>
                    <a:gd name="connsiteX32" fmla="*/ 998333 w 1874855"/>
                    <a:gd name="connsiteY32" fmla="*/ 1381571 h 2106842"/>
                    <a:gd name="connsiteX33" fmla="*/ 1261858 w 1874855"/>
                    <a:gd name="connsiteY33" fmla="*/ 1200596 h 2106842"/>
                    <a:gd name="connsiteX34" fmla="*/ 1271383 w 1874855"/>
                    <a:gd name="connsiteY34" fmla="*/ 994221 h 2106842"/>
                    <a:gd name="connsiteX35" fmla="*/ 1112633 w 1874855"/>
                    <a:gd name="connsiteY35" fmla="*/ 857696 h 2106842"/>
                    <a:gd name="connsiteX36" fmla="*/ 935588 w 1874855"/>
                    <a:gd name="connsiteY36" fmla="*/ 910346 h 2106842"/>
                    <a:gd name="connsiteX37" fmla="*/ 687183 w 1874855"/>
                    <a:gd name="connsiteY37" fmla="*/ 1060896 h 2106842"/>
                    <a:gd name="connsiteX38" fmla="*/ 601458 w 1874855"/>
                    <a:gd name="connsiteY38" fmla="*/ 1060896 h 2106842"/>
                    <a:gd name="connsiteX39" fmla="*/ 595108 w 1874855"/>
                    <a:gd name="connsiteY39" fmla="*/ 1038671 h 2106842"/>
                    <a:gd name="connsiteX40" fmla="*/ 633208 w 1874855"/>
                    <a:gd name="connsiteY40" fmla="*/ 997396 h 2106842"/>
                    <a:gd name="connsiteX41" fmla="*/ 789511 w 1874855"/>
                    <a:gd name="connsiteY41" fmla="*/ 836603 h 2106842"/>
                    <a:gd name="connsiteX42" fmla="*/ 896733 w 1874855"/>
                    <a:gd name="connsiteY42" fmla="*/ 635446 h 2106842"/>
                    <a:gd name="connsiteX43" fmla="*/ 509479 w 1874855"/>
                    <a:gd name="connsiteY43" fmla="*/ 350018 h 2106842"/>
                    <a:gd name="connsiteX44" fmla="*/ 275368 w 1874855"/>
                    <a:gd name="connsiteY44" fmla="*/ 169436 h 2106842"/>
                    <a:gd name="connsiteX45" fmla="*/ 79432 w 1874855"/>
                    <a:gd name="connsiteY45" fmla="*/ 5612 h 2106842"/>
                    <a:gd name="connsiteX46" fmla="*/ 11024 w 1874855"/>
                    <a:gd name="connsiteY46" fmla="*/ 47803 h 2106842"/>
                    <a:gd name="connsiteX47" fmla="*/ 281997 w 1874855"/>
                    <a:gd name="connsiteY47" fmla="*/ 309784 h 2106842"/>
                    <a:gd name="connsiteX0" fmla="*/ 281997 w 1874855"/>
                    <a:gd name="connsiteY0" fmla="*/ 309784 h 2106842"/>
                    <a:gd name="connsiteX1" fmla="*/ 519241 w 1874855"/>
                    <a:gd name="connsiteY1" fmla="*/ 472475 h 2106842"/>
                    <a:gd name="connsiteX2" fmla="*/ 695474 w 1874855"/>
                    <a:gd name="connsiteY2" fmla="*/ 588696 h 2106842"/>
                    <a:gd name="connsiteX3" fmla="*/ 725929 w 1874855"/>
                    <a:gd name="connsiteY3" fmla="*/ 736206 h 2106842"/>
                    <a:gd name="connsiteX4" fmla="*/ 514061 w 1874855"/>
                    <a:gd name="connsiteY4" fmla="*/ 964168 h 2106842"/>
                    <a:gd name="connsiteX5" fmla="*/ 461758 w 1874855"/>
                    <a:gd name="connsiteY5" fmla="*/ 1149796 h 2106842"/>
                    <a:gd name="connsiteX6" fmla="*/ 664958 w 1874855"/>
                    <a:gd name="connsiteY6" fmla="*/ 1181546 h 2106842"/>
                    <a:gd name="connsiteX7" fmla="*/ 937929 w 1874855"/>
                    <a:gd name="connsiteY7" fmla="*/ 1033203 h 2106842"/>
                    <a:gd name="connsiteX8" fmla="*/ 1143197 w 1874855"/>
                    <a:gd name="connsiteY8" fmla="*/ 980151 h 2106842"/>
                    <a:gd name="connsiteX9" fmla="*/ 1176133 w 1874855"/>
                    <a:gd name="connsiteY9" fmla="*/ 1140271 h 2106842"/>
                    <a:gd name="connsiteX10" fmla="*/ 956606 w 1874855"/>
                    <a:gd name="connsiteY10" fmla="*/ 1298461 h 2106842"/>
                    <a:gd name="connsiteX11" fmla="*/ 858633 w 1874855"/>
                    <a:gd name="connsiteY11" fmla="*/ 1457771 h 2106842"/>
                    <a:gd name="connsiteX12" fmla="*/ 970134 w 1874855"/>
                    <a:gd name="connsiteY12" fmla="*/ 1590050 h 2106842"/>
                    <a:gd name="connsiteX13" fmla="*/ 1205739 w 1874855"/>
                    <a:gd name="connsiteY13" fmla="*/ 1474268 h 2106842"/>
                    <a:gd name="connsiteX14" fmla="*/ 1433308 w 1874855"/>
                    <a:gd name="connsiteY14" fmla="*/ 1381571 h 2106842"/>
                    <a:gd name="connsiteX15" fmla="*/ 1573008 w 1874855"/>
                    <a:gd name="connsiteY15" fmla="*/ 1549846 h 2106842"/>
                    <a:gd name="connsiteX16" fmla="*/ 1247955 w 1874855"/>
                    <a:gd name="connsiteY16" fmla="*/ 1808973 h 2106842"/>
                    <a:gd name="connsiteX17" fmla="*/ 1317407 w 1874855"/>
                    <a:gd name="connsiteY17" fmla="*/ 1974102 h 2106842"/>
                    <a:gd name="connsiteX18" fmla="*/ 1566624 w 1874855"/>
                    <a:gd name="connsiteY18" fmla="*/ 1975748 h 2106842"/>
                    <a:gd name="connsiteX19" fmla="*/ 1762776 w 1874855"/>
                    <a:gd name="connsiteY19" fmla="*/ 2103178 h 2106842"/>
                    <a:gd name="connsiteX20" fmla="*/ 1822927 w 1874855"/>
                    <a:gd name="connsiteY20" fmla="*/ 2070388 h 2106842"/>
                    <a:gd name="connsiteX21" fmla="*/ 1869309 w 1874855"/>
                    <a:gd name="connsiteY21" fmla="*/ 2050026 h 2106842"/>
                    <a:gd name="connsiteX22" fmla="*/ 1689190 w 1874855"/>
                    <a:gd name="connsiteY22" fmla="*/ 1918158 h 2106842"/>
                    <a:gd name="connsiteX23" fmla="*/ 1492822 w 1874855"/>
                    <a:gd name="connsiteY23" fmla="*/ 1860066 h 2106842"/>
                    <a:gd name="connsiteX24" fmla="*/ 1387627 w 1874855"/>
                    <a:gd name="connsiteY24" fmla="*/ 1872603 h 2106842"/>
                    <a:gd name="connsiteX25" fmla="*/ 1391545 w 1874855"/>
                    <a:gd name="connsiteY25" fmla="*/ 1806095 h 2106842"/>
                    <a:gd name="connsiteX26" fmla="*/ 1508618 w 1874855"/>
                    <a:gd name="connsiteY26" fmla="*/ 1709687 h 2106842"/>
                    <a:gd name="connsiteX27" fmla="*/ 1671433 w 1874855"/>
                    <a:gd name="connsiteY27" fmla="*/ 1553021 h 2106842"/>
                    <a:gd name="connsiteX28" fmla="*/ 1633333 w 1874855"/>
                    <a:gd name="connsiteY28" fmla="*/ 1378396 h 2106842"/>
                    <a:gd name="connsiteX29" fmla="*/ 1414258 w 1874855"/>
                    <a:gd name="connsiteY29" fmla="*/ 1286321 h 2106842"/>
                    <a:gd name="connsiteX30" fmla="*/ 1188833 w 1874855"/>
                    <a:gd name="connsiteY30" fmla="*/ 1356171 h 2106842"/>
                    <a:gd name="connsiteX31" fmla="*/ 1001428 w 1874855"/>
                    <a:gd name="connsiteY31" fmla="*/ 1469689 h 2106842"/>
                    <a:gd name="connsiteX32" fmla="*/ 998333 w 1874855"/>
                    <a:gd name="connsiteY32" fmla="*/ 1381571 h 2106842"/>
                    <a:gd name="connsiteX33" fmla="*/ 1261858 w 1874855"/>
                    <a:gd name="connsiteY33" fmla="*/ 1200596 h 2106842"/>
                    <a:gd name="connsiteX34" fmla="*/ 1271383 w 1874855"/>
                    <a:gd name="connsiteY34" fmla="*/ 994221 h 2106842"/>
                    <a:gd name="connsiteX35" fmla="*/ 1112633 w 1874855"/>
                    <a:gd name="connsiteY35" fmla="*/ 857696 h 2106842"/>
                    <a:gd name="connsiteX36" fmla="*/ 935588 w 1874855"/>
                    <a:gd name="connsiteY36" fmla="*/ 910346 h 2106842"/>
                    <a:gd name="connsiteX37" fmla="*/ 687183 w 1874855"/>
                    <a:gd name="connsiteY37" fmla="*/ 1060896 h 2106842"/>
                    <a:gd name="connsiteX38" fmla="*/ 601458 w 1874855"/>
                    <a:gd name="connsiteY38" fmla="*/ 1060896 h 2106842"/>
                    <a:gd name="connsiteX39" fmla="*/ 595108 w 1874855"/>
                    <a:gd name="connsiteY39" fmla="*/ 1038671 h 2106842"/>
                    <a:gd name="connsiteX40" fmla="*/ 633208 w 1874855"/>
                    <a:gd name="connsiteY40" fmla="*/ 997396 h 2106842"/>
                    <a:gd name="connsiteX41" fmla="*/ 789511 w 1874855"/>
                    <a:gd name="connsiteY41" fmla="*/ 836603 h 2106842"/>
                    <a:gd name="connsiteX42" fmla="*/ 896733 w 1874855"/>
                    <a:gd name="connsiteY42" fmla="*/ 635446 h 2106842"/>
                    <a:gd name="connsiteX43" fmla="*/ 509479 w 1874855"/>
                    <a:gd name="connsiteY43" fmla="*/ 350018 h 2106842"/>
                    <a:gd name="connsiteX44" fmla="*/ 275368 w 1874855"/>
                    <a:gd name="connsiteY44" fmla="*/ 169436 h 2106842"/>
                    <a:gd name="connsiteX45" fmla="*/ 79432 w 1874855"/>
                    <a:gd name="connsiteY45" fmla="*/ 5612 h 2106842"/>
                    <a:gd name="connsiteX46" fmla="*/ 11024 w 1874855"/>
                    <a:gd name="connsiteY46" fmla="*/ 47803 h 2106842"/>
                    <a:gd name="connsiteX47" fmla="*/ 281997 w 1874855"/>
                    <a:gd name="connsiteY47" fmla="*/ 309784 h 2106842"/>
                    <a:gd name="connsiteX0" fmla="*/ 251637 w 1844495"/>
                    <a:gd name="connsiteY0" fmla="*/ 309784 h 2106842"/>
                    <a:gd name="connsiteX1" fmla="*/ 488881 w 1844495"/>
                    <a:gd name="connsiteY1" fmla="*/ 472475 h 2106842"/>
                    <a:gd name="connsiteX2" fmla="*/ 665114 w 1844495"/>
                    <a:gd name="connsiteY2" fmla="*/ 588696 h 2106842"/>
                    <a:gd name="connsiteX3" fmla="*/ 695569 w 1844495"/>
                    <a:gd name="connsiteY3" fmla="*/ 736206 h 2106842"/>
                    <a:gd name="connsiteX4" fmla="*/ 483701 w 1844495"/>
                    <a:gd name="connsiteY4" fmla="*/ 964168 h 2106842"/>
                    <a:gd name="connsiteX5" fmla="*/ 431398 w 1844495"/>
                    <a:gd name="connsiteY5" fmla="*/ 1149796 h 2106842"/>
                    <a:gd name="connsiteX6" fmla="*/ 634598 w 1844495"/>
                    <a:gd name="connsiteY6" fmla="*/ 1181546 h 2106842"/>
                    <a:gd name="connsiteX7" fmla="*/ 907569 w 1844495"/>
                    <a:gd name="connsiteY7" fmla="*/ 1033203 h 2106842"/>
                    <a:gd name="connsiteX8" fmla="*/ 1112837 w 1844495"/>
                    <a:gd name="connsiteY8" fmla="*/ 980151 h 2106842"/>
                    <a:gd name="connsiteX9" fmla="*/ 1145773 w 1844495"/>
                    <a:gd name="connsiteY9" fmla="*/ 1140271 h 2106842"/>
                    <a:gd name="connsiteX10" fmla="*/ 926246 w 1844495"/>
                    <a:gd name="connsiteY10" fmla="*/ 1298461 h 2106842"/>
                    <a:gd name="connsiteX11" fmla="*/ 828273 w 1844495"/>
                    <a:gd name="connsiteY11" fmla="*/ 1457771 h 2106842"/>
                    <a:gd name="connsiteX12" fmla="*/ 939774 w 1844495"/>
                    <a:gd name="connsiteY12" fmla="*/ 1590050 h 2106842"/>
                    <a:gd name="connsiteX13" fmla="*/ 1175379 w 1844495"/>
                    <a:gd name="connsiteY13" fmla="*/ 1474268 h 2106842"/>
                    <a:gd name="connsiteX14" fmla="*/ 1402948 w 1844495"/>
                    <a:gd name="connsiteY14" fmla="*/ 1381571 h 2106842"/>
                    <a:gd name="connsiteX15" fmla="*/ 1542648 w 1844495"/>
                    <a:gd name="connsiteY15" fmla="*/ 1549846 h 2106842"/>
                    <a:gd name="connsiteX16" fmla="*/ 1217595 w 1844495"/>
                    <a:gd name="connsiteY16" fmla="*/ 1808973 h 2106842"/>
                    <a:gd name="connsiteX17" fmla="*/ 1287047 w 1844495"/>
                    <a:gd name="connsiteY17" fmla="*/ 1974102 h 2106842"/>
                    <a:gd name="connsiteX18" fmla="*/ 1536264 w 1844495"/>
                    <a:gd name="connsiteY18" fmla="*/ 1975748 h 2106842"/>
                    <a:gd name="connsiteX19" fmla="*/ 1732416 w 1844495"/>
                    <a:gd name="connsiteY19" fmla="*/ 2103178 h 2106842"/>
                    <a:gd name="connsiteX20" fmla="*/ 1792567 w 1844495"/>
                    <a:gd name="connsiteY20" fmla="*/ 2070388 h 2106842"/>
                    <a:gd name="connsiteX21" fmla="*/ 1838949 w 1844495"/>
                    <a:gd name="connsiteY21" fmla="*/ 2050026 h 2106842"/>
                    <a:gd name="connsiteX22" fmla="*/ 1658830 w 1844495"/>
                    <a:gd name="connsiteY22" fmla="*/ 1918158 h 2106842"/>
                    <a:gd name="connsiteX23" fmla="*/ 1462462 w 1844495"/>
                    <a:gd name="connsiteY23" fmla="*/ 1860066 h 2106842"/>
                    <a:gd name="connsiteX24" fmla="*/ 1357267 w 1844495"/>
                    <a:gd name="connsiteY24" fmla="*/ 1872603 h 2106842"/>
                    <a:gd name="connsiteX25" fmla="*/ 1361185 w 1844495"/>
                    <a:gd name="connsiteY25" fmla="*/ 1806095 h 2106842"/>
                    <a:gd name="connsiteX26" fmla="*/ 1478258 w 1844495"/>
                    <a:gd name="connsiteY26" fmla="*/ 1709687 h 2106842"/>
                    <a:gd name="connsiteX27" fmla="*/ 1641073 w 1844495"/>
                    <a:gd name="connsiteY27" fmla="*/ 1553021 h 2106842"/>
                    <a:gd name="connsiteX28" fmla="*/ 1602973 w 1844495"/>
                    <a:gd name="connsiteY28" fmla="*/ 1378396 h 2106842"/>
                    <a:gd name="connsiteX29" fmla="*/ 1383898 w 1844495"/>
                    <a:gd name="connsiteY29" fmla="*/ 1286321 h 2106842"/>
                    <a:gd name="connsiteX30" fmla="*/ 1158473 w 1844495"/>
                    <a:gd name="connsiteY30" fmla="*/ 1356171 h 2106842"/>
                    <a:gd name="connsiteX31" fmla="*/ 971068 w 1844495"/>
                    <a:gd name="connsiteY31" fmla="*/ 1469689 h 2106842"/>
                    <a:gd name="connsiteX32" fmla="*/ 967973 w 1844495"/>
                    <a:gd name="connsiteY32" fmla="*/ 1381571 h 2106842"/>
                    <a:gd name="connsiteX33" fmla="*/ 1231498 w 1844495"/>
                    <a:gd name="connsiteY33" fmla="*/ 1200596 h 2106842"/>
                    <a:gd name="connsiteX34" fmla="*/ 1241023 w 1844495"/>
                    <a:gd name="connsiteY34" fmla="*/ 994221 h 2106842"/>
                    <a:gd name="connsiteX35" fmla="*/ 1082273 w 1844495"/>
                    <a:gd name="connsiteY35" fmla="*/ 857696 h 2106842"/>
                    <a:gd name="connsiteX36" fmla="*/ 905228 w 1844495"/>
                    <a:gd name="connsiteY36" fmla="*/ 910346 h 2106842"/>
                    <a:gd name="connsiteX37" fmla="*/ 656823 w 1844495"/>
                    <a:gd name="connsiteY37" fmla="*/ 1060896 h 2106842"/>
                    <a:gd name="connsiteX38" fmla="*/ 571098 w 1844495"/>
                    <a:gd name="connsiteY38" fmla="*/ 1060896 h 2106842"/>
                    <a:gd name="connsiteX39" fmla="*/ 564748 w 1844495"/>
                    <a:gd name="connsiteY39" fmla="*/ 1038671 h 2106842"/>
                    <a:gd name="connsiteX40" fmla="*/ 602848 w 1844495"/>
                    <a:gd name="connsiteY40" fmla="*/ 997396 h 2106842"/>
                    <a:gd name="connsiteX41" fmla="*/ 759151 w 1844495"/>
                    <a:gd name="connsiteY41" fmla="*/ 836603 h 2106842"/>
                    <a:gd name="connsiteX42" fmla="*/ 866373 w 1844495"/>
                    <a:gd name="connsiteY42" fmla="*/ 635446 h 2106842"/>
                    <a:gd name="connsiteX43" fmla="*/ 479119 w 1844495"/>
                    <a:gd name="connsiteY43" fmla="*/ 350018 h 2106842"/>
                    <a:gd name="connsiteX44" fmla="*/ 245008 w 1844495"/>
                    <a:gd name="connsiteY44" fmla="*/ 169436 h 2106842"/>
                    <a:gd name="connsiteX45" fmla="*/ 49072 w 1844495"/>
                    <a:gd name="connsiteY45" fmla="*/ 5612 h 2106842"/>
                    <a:gd name="connsiteX46" fmla="*/ 19205 w 1844495"/>
                    <a:gd name="connsiteY46" fmla="*/ 88046 h 2106842"/>
                    <a:gd name="connsiteX47" fmla="*/ 251637 w 1844495"/>
                    <a:gd name="connsiteY47" fmla="*/ 309784 h 2106842"/>
                    <a:gd name="connsiteX0" fmla="*/ 263951 w 1856809"/>
                    <a:gd name="connsiteY0" fmla="*/ 325104 h 2122162"/>
                    <a:gd name="connsiteX1" fmla="*/ 501195 w 1856809"/>
                    <a:gd name="connsiteY1" fmla="*/ 487795 h 2122162"/>
                    <a:gd name="connsiteX2" fmla="*/ 677428 w 1856809"/>
                    <a:gd name="connsiteY2" fmla="*/ 604016 h 2122162"/>
                    <a:gd name="connsiteX3" fmla="*/ 707883 w 1856809"/>
                    <a:gd name="connsiteY3" fmla="*/ 751526 h 2122162"/>
                    <a:gd name="connsiteX4" fmla="*/ 496015 w 1856809"/>
                    <a:gd name="connsiteY4" fmla="*/ 979488 h 2122162"/>
                    <a:gd name="connsiteX5" fmla="*/ 443712 w 1856809"/>
                    <a:gd name="connsiteY5" fmla="*/ 1165116 h 2122162"/>
                    <a:gd name="connsiteX6" fmla="*/ 646912 w 1856809"/>
                    <a:gd name="connsiteY6" fmla="*/ 1196866 h 2122162"/>
                    <a:gd name="connsiteX7" fmla="*/ 919883 w 1856809"/>
                    <a:gd name="connsiteY7" fmla="*/ 1048523 h 2122162"/>
                    <a:gd name="connsiteX8" fmla="*/ 1125151 w 1856809"/>
                    <a:gd name="connsiteY8" fmla="*/ 995471 h 2122162"/>
                    <a:gd name="connsiteX9" fmla="*/ 1158087 w 1856809"/>
                    <a:gd name="connsiteY9" fmla="*/ 1155591 h 2122162"/>
                    <a:gd name="connsiteX10" fmla="*/ 938560 w 1856809"/>
                    <a:gd name="connsiteY10" fmla="*/ 1313781 h 2122162"/>
                    <a:gd name="connsiteX11" fmla="*/ 840587 w 1856809"/>
                    <a:gd name="connsiteY11" fmla="*/ 1473091 h 2122162"/>
                    <a:gd name="connsiteX12" fmla="*/ 952088 w 1856809"/>
                    <a:gd name="connsiteY12" fmla="*/ 1605370 h 2122162"/>
                    <a:gd name="connsiteX13" fmla="*/ 1187693 w 1856809"/>
                    <a:gd name="connsiteY13" fmla="*/ 1489588 h 2122162"/>
                    <a:gd name="connsiteX14" fmla="*/ 1415262 w 1856809"/>
                    <a:gd name="connsiteY14" fmla="*/ 1396891 h 2122162"/>
                    <a:gd name="connsiteX15" fmla="*/ 1554962 w 1856809"/>
                    <a:gd name="connsiteY15" fmla="*/ 1565166 h 2122162"/>
                    <a:gd name="connsiteX16" fmla="*/ 1229909 w 1856809"/>
                    <a:gd name="connsiteY16" fmla="*/ 1824293 h 2122162"/>
                    <a:gd name="connsiteX17" fmla="*/ 1299361 w 1856809"/>
                    <a:gd name="connsiteY17" fmla="*/ 1989422 h 2122162"/>
                    <a:gd name="connsiteX18" fmla="*/ 1548578 w 1856809"/>
                    <a:gd name="connsiteY18" fmla="*/ 1991068 h 2122162"/>
                    <a:gd name="connsiteX19" fmla="*/ 1744730 w 1856809"/>
                    <a:gd name="connsiteY19" fmla="*/ 2118498 h 2122162"/>
                    <a:gd name="connsiteX20" fmla="*/ 1804881 w 1856809"/>
                    <a:gd name="connsiteY20" fmla="*/ 2085708 h 2122162"/>
                    <a:gd name="connsiteX21" fmla="*/ 1851263 w 1856809"/>
                    <a:gd name="connsiteY21" fmla="*/ 2065346 h 2122162"/>
                    <a:gd name="connsiteX22" fmla="*/ 1671144 w 1856809"/>
                    <a:gd name="connsiteY22" fmla="*/ 1933478 h 2122162"/>
                    <a:gd name="connsiteX23" fmla="*/ 1474776 w 1856809"/>
                    <a:gd name="connsiteY23" fmla="*/ 1875386 h 2122162"/>
                    <a:gd name="connsiteX24" fmla="*/ 1369581 w 1856809"/>
                    <a:gd name="connsiteY24" fmla="*/ 1887923 h 2122162"/>
                    <a:gd name="connsiteX25" fmla="*/ 1373499 w 1856809"/>
                    <a:gd name="connsiteY25" fmla="*/ 1821415 h 2122162"/>
                    <a:gd name="connsiteX26" fmla="*/ 1490572 w 1856809"/>
                    <a:gd name="connsiteY26" fmla="*/ 1725007 h 2122162"/>
                    <a:gd name="connsiteX27" fmla="*/ 1653387 w 1856809"/>
                    <a:gd name="connsiteY27" fmla="*/ 1568341 h 2122162"/>
                    <a:gd name="connsiteX28" fmla="*/ 1615287 w 1856809"/>
                    <a:gd name="connsiteY28" fmla="*/ 1393716 h 2122162"/>
                    <a:gd name="connsiteX29" fmla="*/ 1396212 w 1856809"/>
                    <a:gd name="connsiteY29" fmla="*/ 1301641 h 2122162"/>
                    <a:gd name="connsiteX30" fmla="*/ 1170787 w 1856809"/>
                    <a:gd name="connsiteY30" fmla="*/ 1371491 h 2122162"/>
                    <a:gd name="connsiteX31" fmla="*/ 983382 w 1856809"/>
                    <a:gd name="connsiteY31" fmla="*/ 1485009 h 2122162"/>
                    <a:gd name="connsiteX32" fmla="*/ 980287 w 1856809"/>
                    <a:gd name="connsiteY32" fmla="*/ 1396891 h 2122162"/>
                    <a:gd name="connsiteX33" fmla="*/ 1243812 w 1856809"/>
                    <a:gd name="connsiteY33" fmla="*/ 1215916 h 2122162"/>
                    <a:gd name="connsiteX34" fmla="*/ 1253337 w 1856809"/>
                    <a:gd name="connsiteY34" fmla="*/ 1009541 h 2122162"/>
                    <a:gd name="connsiteX35" fmla="*/ 1094587 w 1856809"/>
                    <a:gd name="connsiteY35" fmla="*/ 873016 h 2122162"/>
                    <a:gd name="connsiteX36" fmla="*/ 917542 w 1856809"/>
                    <a:gd name="connsiteY36" fmla="*/ 925666 h 2122162"/>
                    <a:gd name="connsiteX37" fmla="*/ 669137 w 1856809"/>
                    <a:gd name="connsiteY37" fmla="*/ 1076216 h 2122162"/>
                    <a:gd name="connsiteX38" fmla="*/ 583412 w 1856809"/>
                    <a:gd name="connsiteY38" fmla="*/ 1076216 h 2122162"/>
                    <a:gd name="connsiteX39" fmla="*/ 577062 w 1856809"/>
                    <a:gd name="connsiteY39" fmla="*/ 1053991 h 2122162"/>
                    <a:gd name="connsiteX40" fmla="*/ 615162 w 1856809"/>
                    <a:gd name="connsiteY40" fmla="*/ 1012716 h 2122162"/>
                    <a:gd name="connsiteX41" fmla="*/ 771465 w 1856809"/>
                    <a:gd name="connsiteY41" fmla="*/ 851923 h 2122162"/>
                    <a:gd name="connsiteX42" fmla="*/ 878687 w 1856809"/>
                    <a:gd name="connsiteY42" fmla="*/ 650766 h 2122162"/>
                    <a:gd name="connsiteX43" fmla="*/ 491433 w 1856809"/>
                    <a:gd name="connsiteY43" fmla="*/ 365338 h 2122162"/>
                    <a:gd name="connsiteX44" fmla="*/ 257322 w 1856809"/>
                    <a:gd name="connsiteY44" fmla="*/ 184756 h 2122162"/>
                    <a:gd name="connsiteX45" fmla="*/ 36280 w 1856809"/>
                    <a:gd name="connsiteY45" fmla="*/ 5208 h 2122162"/>
                    <a:gd name="connsiteX46" fmla="*/ 31519 w 1856809"/>
                    <a:gd name="connsiteY46" fmla="*/ 103366 h 2122162"/>
                    <a:gd name="connsiteX47" fmla="*/ 263951 w 1856809"/>
                    <a:gd name="connsiteY47" fmla="*/ 325104 h 2122162"/>
                    <a:gd name="connsiteX0" fmla="*/ 263951 w 1856809"/>
                    <a:gd name="connsiteY0" fmla="*/ 330097 h 2127155"/>
                    <a:gd name="connsiteX1" fmla="*/ 501195 w 1856809"/>
                    <a:gd name="connsiteY1" fmla="*/ 492788 h 2127155"/>
                    <a:gd name="connsiteX2" fmla="*/ 677428 w 1856809"/>
                    <a:gd name="connsiteY2" fmla="*/ 609009 h 2127155"/>
                    <a:gd name="connsiteX3" fmla="*/ 707883 w 1856809"/>
                    <a:gd name="connsiteY3" fmla="*/ 756519 h 2127155"/>
                    <a:gd name="connsiteX4" fmla="*/ 496015 w 1856809"/>
                    <a:gd name="connsiteY4" fmla="*/ 984481 h 2127155"/>
                    <a:gd name="connsiteX5" fmla="*/ 443712 w 1856809"/>
                    <a:gd name="connsiteY5" fmla="*/ 1170109 h 2127155"/>
                    <a:gd name="connsiteX6" fmla="*/ 646912 w 1856809"/>
                    <a:gd name="connsiteY6" fmla="*/ 1201859 h 2127155"/>
                    <a:gd name="connsiteX7" fmla="*/ 919883 w 1856809"/>
                    <a:gd name="connsiteY7" fmla="*/ 1053516 h 2127155"/>
                    <a:gd name="connsiteX8" fmla="*/ 1125151 w 1856809"/>
                    <a:gd name="connsiteY8" fmla="*/ 1000464 h 2127155"/>
                    <a:gd name="connsiteX9" fmla="*/ 1158087 w 1856809"/>
                    <a:gd name="connsiteY9" fmla="*/ 1160584 h 2127155"/>
                    <a:gd name="connsiteX10" fmla="*/ 938560 w 1856809"/>
                    <a:gd name="connsiteY10" fmla="*/ 1318774 h 2127155"/>
                    <a:gd name="connsiteX11" fmla="*/ 840587 w 1856809"/>
                    <a:gd name="connsiteY11" fmla="*/ 1478084 h 2127155"/>
                    <a:gd name="connsiteX12" fmla="*/ 952088 w 1856809"/>
                    <a:gd name="connsiteY12" fmla="*/ 1610363 h 2127155"/>
                    <a:gd name="connsiteX13" fmla="*/ 1187693 w 1856809"/>
                    <a:gd name="connsiteY13" fmla="*/ 1494581 h 2127155"/>
                    <a:gd name="connsiteX14" fmla="*/ 1415262 w 1856809"/>
                    <a:gd name="connsiteY14" fmla="*/ 1401884 h 2127155"/>
                    <a:gd name="connsiteX15" fmla="*/ 1554962 w 1856809"/>
                    <a:gd name="connsiteY15" fmla="*/ 1570159 h 2127155"/>
                    <a:gd name="connsiteX16" fmla="*/ 1229909 w 1856809"/>
                    <a:gd name="connsiteY16" fmla="*/ 1829286 h 2127155"/>
                    <a:gd name="connsiteX17" fmla="*/ 1299361 w 1856809"/>
                    <a:gd name="connsiteY17" fmla="*/ 1994415 h 2127155"/>
                    <a:gd name="connsiteX18" fmla="*/ 1548578 w 1856809"/>
                    <a:gd name="connsiteY18" fmla="*/ 1996061 h 2127155"/>
                    <a:gd name="connsiteX19" fmla="*/ 1744730 w 1856809"/>
                    <a:gd name="connsiteY19" fmla="*/ 2123491 h 2127155"/>
                    <a:gd name="connsiteX20" fmla="*/ 1804881 w 1856809"/>
                    <a:gd name="connsiteY20" fmla="*/ 2090701 h 2127155"/>
                    <a:gd name="connsiteX21" fmla="*/ 1851263 w 1856809"/>
                    <a:gd name="connsiteY21" fmla="*/ 2070339 h 2127155"/>
                    <a:gd name="connsiteX22" fmla="*/ 1671144 w 1856809"/>
                    <a:gd name="connsiteY22" fmla="*/ 1938471 h 2127155"/>
                    <a:gd name="connsiteX23" fmla="*/ 1474776 w 1856809"/>
                    <a:gd name="connsiteY23" fmla="*/ 1880379 h 2127155"/>
                    <a:gd name="connsiteX24" fmla="*/ 1369581 w 1856809"/>
                    <a:gd name="connsiteY24" fmla="*/ 1892916 h 2127155"/>
                    <a:gd name="connsiteX25" fmla="*/ 1373499 w 1856809"/>
                    <a:gd name="connsiteY25" fmla="*/ 1826408 h 2127155"/>
                    <a:gd name="connsiteX26" fmla="*/ 1490572 w 1856809"/>
                    <a:gd name="connsiteY26" fmla="*/ 1730000 h 2127155"/>
                    <a:gd name="connsiteX27" fmla="*/ 1653387 w 1856809"/>
                    <a:gd name="connsiteY27" fmla="*/ 1573334 h 2127155"/>
                    <a:gd name="connsiteX28" fmla="*/ 1615287 w 1856809"/>
                    <a:gd name="connsiteY28" fmla="*/ 1398709 h 2127155"/>
                    <a:gd name="connsiteX29" fmla="*/ 1396212 w 1856809"/>
                    <a:gd name="connsiteY29" fmla="*/ 1306634 h 2127155"/>
                    <a:gd name="connsiteX30" fmla="*/ 1170787 w 1856809"/>
                    <a:gd name="connsiteY30" fmla="*/ 1376484 h 2127155"/>
                    <a:gd name="connsiteX31" fmla="*/ 983382 w 1856809"/>
                    <a:gd name="connsiteY31" fmla="*/ 1490002 h 2127155"/>
                    <a:gd name="connsiteX32" fmla="*/ 980287 w 1856809"/>
                    <a:gd name="connsiteY32" fmla="*/ 1401884 h 2127155"/>
                    <a:gd name="connsiteX33" fmla="*/ 1243812 w 1856809"/>
                    <a:gd name="connsiteY33" fmla="*/ 1220909 h 2127155"/>
                    <a:gd name="connsiteX34" fmla="*/ 1253337 w 1856809"/>
                    <a:gd name="connsiteY34" fmla="*/ 1014534 h 2127155"/>
                    <a:gd name="connsiteX35" fmla="*/ 1094587 w 1856809"/>
                    <a:gd name="connsiteY35" fmla="*/ 878009 h 2127155"/>
                    <a:gd name="connsiteX36" fmla="*/ 917542 w 1856809"/>
                    <a:gd name="connsiteY36" fmla="*/ 930659 h 2127155"/>
                    <a:gd name="connsiteX37" fmla="*/ 669137 w 1856809"/>
                    <a:gd name="connsiteY37" fmla="*/ 1081209 h 2127155"/>
                    <a:gd name="connsiteX38" fmla="*/ 583412 w 1856809"/>
                    <a:gd name="connsiteY38" fmla="*/ 1081209 h 2127155"/>
                    <a:gd name="connsiteX39" fmla="*/ 577062 w 1856809"/>
                    <a:gd name="connsiteY39" fmla="*/ 1058984 h 2127155"/>
                    <a:gd name="connsiteX40" fmla="*/ 615162 w 1856809"/>
                    <a:gd name="connsiteY40" fmla="*/ 1017709 h 2127155"/>
                    <a:gd name="connsiteX41" fmla="*/ 771465 w 1856809"/>
                    <a:gd name="connsiteY41" fmla="*/ 856916 h 2127155"/>
                    <a:gd name="connsiteX42" fmla="*/ 878687 w 1856809"/>
                    <a:gd name="connsiteY42" fmla="*/ 655759 h 2127155"/>
                    <a:gd name="connsiteX43" fmla="*/ 491433 w 1856809"/>
                    <a:gd name="connsiteY43" fmla="*/ 370331 h 2127155"/>
                    <a:gd name="connsiteX44" fmla="*/ 247278 w 1856809"/>
                    <a:gd name="connsiteY44" fmla="*/ 98425 h 2127155"/>
                    <a:gd name="connsiteX45" fmla="*/ 36280 w 1856809"/>
                    <a:gd name="connsiteY45" fmla="*/ 10201 h 2127155"/>
                    <a:gd name="connsiteX46" fmla="*/ 31519 w 1856809"/>
                    <a:gd name="connsiteY46" fmla="*/ 108359 h 2127155"/>
                    <a:gd name="connsiteX47" fmla="*/ 263951 w 1856809"/>
                    <a:gd name="connsiteY47" fmla="*/ 330097 h 2127155"/>
                    <a:gd name="connsiteX0" fmla="*/ 159995 w 1851187"/>
                    <a:gd name="connsiteY0" fmla="*/ 167572 h 2127155"/>
                    <a:gd name="connsiteX1" fmla="*/ 495573 w 1851187"/>
                    <a:gd name="connsiteY1" fmla="*/ 492788 h 2127155"/>
                    <a:gd name="connsiteX2" fmla="*/ 671806 w 1851187"/>
                    <a:gd name="connsiteY2" fmla="*/ 609009 h 2127155"/>
                    <a:gd name="connsiteX3" fmla="*/ 702261 w 1851187"/>
                    <a:gd name="connsiteY3" fmla="*/ 756519 h 2127155"/>
                    <a:gd name="connsiteX4" fmla="*/ 490393 w 1851187"/>
                    <a:gd name="connsiteY4" fmla="*/ 984481 h 2127155"/>
                    <a:gd name="connsiteX5" fmla="*/ 438090 w 1851187"/>
                    <a:gd name="connsiteY5" fmla="*/ 1170109 h 2127155"/>
                    <a:gd name="connsiteX6" fmla="*/ 641290 w 1851187"/>
                    <a:gd name="connsiteY6" fmla="*/ 1201859 h 2127155"/>
                    <a:gd name="connsiteX7" fmla="*/ 914261 w 1851187"/>
                    <a:gd name="connsiteY7" fmla="*/ 1053516 h 2127155"/>
                    <a:gd name="connsiteX8" fmla="*/ 1119529 w 1851187"/>
                    <a:gd name="connsiteY8" fmla="*/ 1000464 h 2127155"/>
                    <a:gd name="connsiteX9" fmla="*/ 1152465 w 1851187"/>
                    <a:gd name="connsiteY9" fmla="*/ 1160584 h 2127155"/>
                    <a:gd name="connsiteX10" fmla="*/ 932938 w 1851187"/>
                    <a:gd name="connsiteY10" fmla="*/ 1318774 h 2127155"/>
                    <a:gd name="connsiteX11" fmla="*/ 834965 w 1851187"/>
                    <a:gd name="connsiteY11" fmla="*/ 1478084 h 2127155"/>
                    <a:gd name="connsiteX12" fmla="*/ 946466 w 1851187"/>
                    <a:gd name="connsiteY12" fmla="*/ 1610363 h 2127155"/>
                    <a:gd name="connsiteX13" fmla="*/ 1182071 w 1851187"/>
                    <a:gd name="connsiteY13" fmla="*/ 1494581 h 2127155"/>
                    <a:gd name="connsiteX14" fmla="*/ 1409640 w 1851187"/>
                    <a:gd name="connsiteY14" fmla="*/ 1401884 h 2127155"/>
                    <a:gd name="connsiteX15" fmla="*/ 1549340 w 1851187"/>
                    <a:gd name="connsiteY15" fmla="*/ 1570159 h 2127155"/>
                    <a:gd name="connsiteX16" fmla="*/ 1224287 w 1851187"/>
                    <a:gd name="connsiteY16" fmla="*/ 1829286 h 2127155"/>
                    <a:gd name="connsiteX17" fmla="*/ 1293739 w 1851187"/>
                    <a:gd name="connsiteY17" fmla="*/ 1994415 h 2127155"/>
                    <a:gd name="connsiteX18" fmla="*/ 1542956 w 1851187"/>
                    <a:gd name="connsiteY18" fmla="*/ 1996061 h 2127155"/>
                    <a:gd name="connsiteX19" fmla="*/ 1739108 w 1851187"/>
                    <a:gd name="connsiteY19" fmla="*/ 2123491 h 2127155"/>
                    <a:gd name="connsiteX20" fmla="*/ 1799259 w 1851187"/>
                    <a:gd name="connsiteY20" fmla="*/ 2090701 h 2127155"/>
                    <a:gd name="connsiteX21" fmla="*/ 1845641 w 1851187"/>
                    <a:gd name="connsiteY21" fmla="*/ 2070339 h 2127155"/>
                    <a:gd name="connsiteX22" fmla="*/ 1665522 w 1851187"/>
                    <a:gd name="connsiteY22" fmla="*/ 1938471 h 2127155"/>
                    <a:gd name="connsiteX23" fmla="*/ 1469154 w 1851187"/>
                    <a:gd name="connsiteY23" fmla="*/ 1880379 h 2127155"/>
                    <a:gd name="connsiteX24" fmla="*/ 1363959 w 1851187"/>
                    <a:gd name="connsiteY24" fmla="*/ 1892916 h 2127155"/>
                    <a:gd name="connsiteX25" fmla="*/ 1367877 w 1851187"/>
                    <a:gd name="connsiteY25" fmla="*/ 1826408 h 2127155"/>
                    <a:gd name="connsiteX26" fmla="*/ 1484950 w 1851187"/>
                    <a:gd name="connsiteY26" fmla="*/ 1730000 h 2127155"/>
                    <a:gd name="connsiteX27" fmla="*/ 1647765 w 1851187"/>
                    <a:gd name="connsiteY27" fmla="*/ 1573334 h 2127155"/>
                    <a:gd name="connsiteX28" fmla="*/ 1609665 w 1851187"/>
                    <a:gd name="connsiteY28" fmla="*/ 1398709 h 2127155"/>
                    <a:gd name="connsiteX29" fmla="*/ 1390590 w 1851187"/>
                    <a:gd name="connsiteY29" fmla="*/ 1306634 h 2127155"/>
                    <a:gd name="connsiteX30" fmla="*/ 1165165 w 1851187"/>
                    <a:gd name="connsiteY30" fmla="*/ 1376484 h 2127155"/>
                    <a:gd name="connsiteX31" fmla="*/ 977760 w 1851187"/>
                    <a:gd name="connsiteY31" fmla="*/ 1490002 h 2127155"/>
                    <a:gd name="connsiteX32" fmla="*/ 974665 w 1851187"/>
                    <a:gd name="connsiteY32" fmla="*/ 1401884 h 2127155"/>
                    <a:gd name="connsiteX33" fmla="*/ 1238190 w 1851187"/>
                    <a:gd name="connsiteY33" fmla="*/ 1220909 h 2127155"/>
                    <a:gd name="connsiteX34" fmla="*/ 1247715 w 1851187"/>
                    <a:gd name="connsiteY34" fmla="*/ 1014534 h 2127155"/>
                    <a:gd name="connsiteX35" fmla="*/ 1088965 w 1851187"/>
                    <a:gd name="connsiteY35" fmla="*/ 878009 h 2127155"/>
                    <a:gd name="connsiteX36" fmla="*/ 911920 w 1851187"/>
                    <a:gd name="connsiteY36" fmla="*/ 930659 h 2127155"/>
                    <a:gd name="connsiteX37" fmla="*/ 663515 w 1851187"/>
                    <a:gd name="connsiteY37" fmla="*/ 1081209 h 2127155"/>
                    <a:gd name="connsiteX38" fmla="*/ 577790 w 1851187"/>
                    <a:gd name="connsiteY38" fmla="*/ 1081209 h 2127155"/>
                    <a:gd name="connsiteX39" fmla="*/ 571440 w 1851187"/>
                    <a:gd name="connsiteY39" fmla="*/ 1058984 h 2127155"/>
                    <a:gd name="connsiteX40" fmla="*/ 609540 w 1851187"/>
                    <a:gd name="connsiteY40" fmla="*/ 1017709 h 2127155"/>
                    <a:gd name="connsiteX41" fmla="*/ 765843 w 1851187"/>
                    <a:gd name="connsiteY41" fmla="*/ 856916 h 2127155"/>
                    <a:gd name="connsiteX42" fmla="*/ 873065 w 1851187"/>
                    <a:gd name="connsiteY42" fmla="*/ 655759 h 2127155"/>
                    <a:gd name="connsiteX43" fmla="*/ 485811 w 1851187"/>
                    <a:gd name="connsiteY43" fmla="*/ 370331 h 2127155"/>
                    <a:gd name="connsiteX44" fmla="*/ 241656 w 1851187"/>
                    <a:gd name="connsiteY44" fmla="*/ 98425 h 2127155"/>
                    <a:gd name="connsiteX45" fmla="*/ 30658 w 1851187"/>
                    <a:gd name="connsiteY45" fmla="*/ 10201 h 2127155"/>
                    <a:gd name="connsiteX46" fmla="*/ 25897 w 1851187"/>
                    <a:gd name="connsiteY46" fmla="*/ 108359 h 2127155"/>
                    <a:gd name="connsiteX47" fmla="*/ 159995 w 1851187"/>
                    <a:gd name="connsiteY47" fmla="*/ 167572 h 2127155"/>
                    <a:gd name="connsiteX0" fmla="*/ 159995 w 1851187"/>
                    <a:gd name="connsiteY0" fmla="*/ 167572 h 2127155"/>
                    <a:gd name="connsiteX1" fmla="*/ 373016 w 1851187"/>
                    <a:gd name="connsiteY1" fmla="*/ 446793 h 2127155"/>
                    <a:gd name="connsiteX2" fmla="*/ 671806 w 1851187"/>
                    <a:gd name="connsiteY2" fmla="*/ 609009 h 2127155"/>
                    <a:gd name="connsiteX3" fmla="*/ 702261 w 1851187"/>
                    <a:gd name="connsiteY3" fmla="*/ 756519 h 2127155"/>
                    <a:gd name="connsiteX4" fmla="*/ 490393 w 1851187"/>
                    <a:gd name="connsiteY4" fmla="*/ 984481 h 2127155"/>
                    <a:gd name="connsiteX5" fmla="*/ 438090 w 1851187"/>
                    <a:gd name="connsiteY5" fmla="*/ 1170109 h 2127155"/>
                    <a:gd name="connsiteX6" fmla="*/ 641290 w 1851187"/>
                    <a:gd name="connsiteY6" fmla="*/ 1201859 h 2127155"/>
                    <a:gd name="connsiteX7" fmla="*/ 914261 w 1851187"/>
                    <a:gd name="connsiteY7" fmla="*/ 1053516 h 2127155"/>
                    <a:gd name="connsiteX8" fmla="*/ 1119529 w 1851187"/>
                    <a:gd name="connsiteY8" fmla="*/ 1000464 h 2127155"/>
                    <a:gd name="connsiteX9" fmla="*/ 1152465 w 1851187"/>
                    <a:gd name="connsiteY9" fmla="*/ 1160584 h 2127155"/>
                    <a:gd name="connsiteX10" fmla="*/ 932938 w 1851187"/>
                    <a:gd name="connsiteY10" fmla="*/ 1318774 h 2127155"/>
                    <a:gd name="connsiteX11" fmla="*/ 834965 w 1851187"/>
                    <a:gd name="connsiteY11" fmla="*/ 1478084 h 2127155"/>
                    <a:gd name="connsiteX12" fmla="*/ 946466 w 1851187"/>
                    <a:gd name="connsiteY12" fmla="*/ 1610363 h 2127155"/>
                    <a:gd name="connsiteX13" fmla="*/ 1182071 w 1851187"/>
                    <a:gd name="connsiteY13" fmla="*/ 1494581 h 2127155"/>
                    <a:gd name="connsiteX14" fmla="*/ 1409640 w 1851187"/>
                    <a:gd name="connsiteY14" fmla="*/ 1401884 h 2127155"/>
                    <a:gd name="connsiteX15" fmla="*/ 1549340 w 1851187"/>
                    <a:gd name="connsiteY15" fmla="*/ 1570159 h 2127155"/>
                    <a:gd name="connsiteX16" fmla="*/ 1224287 w 1851187"/>
                    <a:gd name="connsiteY16" fmla="*/ 1829286 h 2127155"/>
                    <a:gd name="connsiteX17" fmla="*/ 1293739 w 1851187"/>
                    <a:gd name="connsiteY17" fmla="*/ 1994415 h 2127155"/>
                    <a:gd name="connsiteX18" fmla="*/ 1542956 w 1851187"/>
                    <a:gd name="connsiteY18" fmla="*/ 1996061 h 2127155"/>
                    <a:gd name="connsiteX19" fmla="*/ 1739108 w 1851187"/>
                    <a:gd name="connsiteY19" fmla="*/ 2123491 h 2127155"/>
                    <a:gd name="connsiteX20" fmla="*/ 1799259 w 1851187"/>
                    <a:gd name="connsiteY20" fmla="*/ 2090701 h 2127155"/>
                    <a:gd name="connsiteX21" fmla="*/ 1845641 w 1851187"/>
                    <a:gd name="connsiteY21" fmla="*/ 2070339 h 2127155"/>
                    <a:gd name="connsiteX22" fmla="*/ 1665522 w 1851187"/>
                    <a:gd name="connsiteY22" fmla="*/ 1938471 h 2127155"/>
                    <a:gd name="connsiteX23" fmla="*/ 1469154 w 1851187"/>
                    <a:gd name="connsiteY23" fmla="*/ 1880379 h 2127155"/>
                    <a:gd name="connsiteX24" fmla="*/ 1363959 w 1851187"/>
                    <a:gd name="connsiteY24" fmla="*/ 1892916 h 2127155"/>
                    <a:gd name="connsiteX25" fmla="*/ 1367877 w 1851187"/>
                    <a:gd name="connsiteY25" fmla="*/ 1826408 h 2127155"/>
                    <a:gd name="connsiteX26" fmla="*/ 1484950 w 1851187"/>
                    <a:gd name="connsiteY26" fmla="*/ 1730000 h 2127155"/>
                    <a:gd name="connsiteX27" fmla="*/ 1647765 w 1851187"/>
                    <a:gd name="connsiteY27" fmla="*/ 1573334 h 2127155"/>
                    <a:gd name="connsiteX28" fmla="*/ 1609665 w 1851187"/>
                    <a:gd name="connsiteY28" fmla="*/ 1398709 h 2127155"/>
                    <a:gd name="connsiteX29" fmla="*/ 1390590 w 1851187"/>
                    <a:gd name="connsiteY29" fmla="*/ 1306634 h 2127155"/>
                    <a:gd name="connsiteX30" fmla="*/ 1165165 w 1851187"/>
                    <a:gd name="connsiteY30" fmla="*/ 1376484 h 2127155"/>
                    <a:gd name="connsiteX31" fmla="*/ 977760 w 1851187"/>
                    <a:gd name="connsiteY31" fmla="*/ 1490002 h 2127155"/>
                    <a:gd name="connsiteX32" fmla="*/ 974665 w 1851187"/>
                    <a:gd name="connsiteY32" fmla="*/ 1401884 h 2127155"/>
                    <a:gd name="connsiteX33" fmla="*/ 1238190 w 1851187"/>
                    <a:gd name="connsiteY33" fmla="*/ 1220909 h 2127155"/>
                    <a:gd name="connsiteX34" fmla="*/ 1247715 w 1851187"/>
                    <a:gd name="connsiteY34" fmla="*/ 1014534 h 2127155"/>
                    <a:gd name="connsiteX35" fmla="*/ 1088965 w 1851187"/>
                    <a:gd name="connsiteY35" fmla="*/ 878009 h 2127155"/>
                    <a:gd name="connsiteX36" fmla="*/ 911920 w 1851187"/>
                    <a:gd name="connsiteY36" fmla="*/ 930659 h 2127155"/>
                    <a:gd name="connsiteX37" fmla="*/ 663515 w 1851187"/>
                    <a:gd name="connsiteY37" fmla="*/ 1081209 h 2127155"/>
                    <a:gd name="connsiteX38" fmla="*/ 577790 w 1851187"/>
                    <a:gd name="connsiteY38" fmla="*/ 1081209 h 2127155"/>
                    <a:gd name="connsiteX39" fmla="*/ 571440 w 1851187"/>
                    <a:gd name="connsiteY39" fmla="*/ 1058984 h 2127155"/>
                    <a:gd name="connsiteX40" fmla="*/ 609540 w 1851187"/>
                    <a:gd name="connsiteY40" fmla="*/ 1017709 h 2127155"/>
                    <a:gd name="connsiteX41" fmla="*/ 765843 w 1851187"/>
                    <a:gd name="connsiteY41" fmla="*/ 856916 h 2127155"/>
                    <a:gd name="connsiteX42" fmla="*/ 873065 w 1851187"/>
                    <a:gd name="connsiteY42" fmla="*/ 655759 h 2127155"/>
                    <a:gd name="connsiteX43" fmla="*/ 485811 w 1851187"/>
                    <a:gd name="connsiteY43" fmla="*/ 370331 h 2127155"/>
                    <a:gd name="connsiteX44" fmla="*/ 241656 w 1851187"/>
                    <a:gd name="connsiteY44" fmla="*/ 98425 h 2127155"/>
                    <a:gd name="connsiteX45" fmla="*/ 30658 w 1851187"/>
                    <a:gd name="connsiteY45" fmla="*/ 10201 h 2127155"/>
                    <a:gd name="connsiteX46" fmla="*/ 25897 w 1851187"/>
                    <a:gd name="connsiteY46" fmla="*/ 108359 h 2127155"/>
                    <a:gd name="connsiteX47" fmla="*/ 159995 w 1851187"/>
                    <a:gd name="connsiteY47" fmla="*/ 167572 h 2127155"/>
                    <a:gd name="connsiteX0" fmla="*/ 159995 w 1851187"/>
                    <a:gd name="connsiteY0" fmla="*/ 167693 h 2127276"/>
                    <a:gd name="connsiteX1" fmla="*/ 373016 w 1851187"/>
                    <a:gd name="connsiteY1" fmla="*/ 446914 h 2127276"/>
                    <a:gd name="connsiteX2" fmla="*/ 671806 w 1851187"/>
                    <a:gd name="connsiteY2" fmla="*/ 609130 h 2127276"/>
                    <a:gd name="connsiteX3" fmla="*/ 702261 w 1851187"/>
                    <a:gd name="connsiteY3" fmla="*/ 756640 h 2127276"/>
                    <a:gd name="connsiteX4" fmla="*/ 490393 w 1851187"/>
                    <a:gd name="connsiteY4" fmla="*/ 984602 h 2127276"/>
                    <a:gd name="connsiteX5" fmla="*/ 438090 w 1851187"/>
                    <a:gd name="connsiteY5" fmla="*/ 1170230 h 2127276"/>
                    <a:gd name="connsiteX6" fmla="*/ 641290 w 1851187"/>
                    <a:gd name="connsiteY6" fmla="*/ 1201980 h 2127276"/>
                    <a:gd name="connsiteX7" fmla="*/ 914261 w 1851187"/>
                    <a:gd name="connsiteY7" fmla="*/ 1053637 h 2127276"/>
                    <a:gd name="connsiteX8" fmla="*/ 1119529 w 1851187"/>
                    <a:gd name="connsiteY8" fmla="*/ 1000585 h 2127276"/>
                    <a:gd name="connsiteX9" fmla="*/ 1152465 w 1851187"/>
                    <a:gd name="connsiteY9" fmla="*/ 1160705 h 2127276"/>
                    <a:gd name="connsiteX10" fmla="*/ 932938 w 1851187"/>
                    <a:gd name="connsiteY10" fmla="*/ 1318895 h 2127276"/>
                    <a:gd name="connsiteX11" fmla="*/ 834965 w 1851187"/>
                    <a:gd name="connsiteY11" fmla="*/ 1478205 h 2127276"/>
                    <a:gd name="connsiteX12" fmla="*/ 946466 w 1851187"/>
                    <a:gd name="connsiteY12" fmla="*/ 1610484 h 2127276"/>
                    <a:gd name="connsiteX13" fmla="*/ 1182071 w 1851187"/>
                    <a:gd name="connsiteY13" fmla="*/ 1494702 h 2127276"/>
                    <a:gd name="connsiteX14" fmla="*/ 1409640 w 1851187"/>
                    <a:gd name="connsiteY14" fmla="*/ 1402005 h 2127276"/>
                    <a:gd name="connsiteX15" fmla="*/ 1549340 w 1851187"/>
                    <a:gd name="connsiteY15" fmla="*/ 1570280 h 2127276"/>
                    <a:gd name="connsiteX16" fmla="*/ 1224287 w 1851187"/>
                    <a:gd name="connsiteY16" fmla="*/ 1829407 h 2127276"/>
                    <a:gd name="connsiteX17" fmla="*/ 1293739 w 1851187"/>
                    <a:gd name="connsiteY17" fmla="*/ 1994536 h 2127276"/>
                    <a:gd name="connsiteX18" fmla="*/ 1542956 w 1851187"/>
                    <a:gd name="connsiteY18" fmla="*/ 1996182 h 2127276"/>
                    <a:gd name="connsiteX19" fmla="*/ 1739108 w 1851187"/>
                    <a:gd name="connsiteY19" fmla="*/ 2123612 h 2127276"/>
                    <a:gd name="connsiteX20" fmla="*/ 1799259 w 1851187"/>
                    <a:gd name="connsiteY20" fmla="*/ 2090822 h 2127276"/>
                    <a:gd name="connsiteX21" fmla="*/ 1845641 w 1851187"/>
                    <a:gd name="connsiteY21" fmla="*/ 2070460 h 2127276"/>
                    <a:gd name="connsiteX22" fmla="*/ 1665522 w 1851187"/>
                    <a:gd name="connsiteY22" fmla="*/ 1938592 h 2127276"/>
                    <a:gd name="connsiteX23" fmla="*/ 1469154 w 1851187"/>
                    <a:gd name="connsiteY23" fmla="*/ 1880500 h 2127276"/>
                    <a:gd name="connsiteX24" fmla="*/ 1363959 w 1851187"/>
                    <a:gd name="connsiteY24" fmla="*/ 1893037 h 2127276"/>
                    <a:gd name="connsiteX25" fmla="*/ 1367877 w 1851187"/>
                    <a:gd name="connsiteY25" fmla="*/ 1826529 h 2127276"/>
                    <a:gd name="connsiteX26" fmla="*/ 1484950 w 1851187"/>
                    <a:gd name="connsiteY26" fmla="*/ 1730121 h 2127276"/>
                    <a:gd name="connsiteX27" fmla="*/ 1647765 w 1851187"/>
                    <a:gd name="connsiteY27" fmla="*/ 1573455 h 2127276"/>
                    <a:gd name="connsiteX28" fmla="*/ 1609665 w 1851187"/>
                    <a:gd name="connsiteY28" fmla="*/ 1398830 h 2127276"/>
                    <a:gd name="connsiteX29" fmla="*/ 1390590 w 1851187"/>
                    <a:gd name="connsiteY29" fmla="*/ 1306755 h 2127276"/>
                    <a:gd name="connsiteX30" fmla="*/ 1165165 w 1851187"/>
                    <a:gd name="connsiteY30" fmla="*/ 1376605 h 2127276"/>
                    <a:gd name="connsiteX31" fmla="*/ 977760 w 1851187"/>
                    <a:gd name="connsiteY31" fmla="*/ 1490123 h 2127276"/>
                    <a:gd name="connsiteX32" fmla="*/ 974665 w 1851187"/>
                    <a:gd name="connsiteY32" fmla="*/ 1402005 h 2127276"/>
                    <a:gd name="connsiteX33" fmla="*/ 1238190 w 1851187"/>
                    <a:gd name="connsiteY33" fmla="*/ 1221030 h 2127276"/>
                    <a:gd name="connsiteX34" fmla="*/ 1247715 w 1851187"/>
                    <a:gd name="connsiteY34" fmla="*/ 1014655 h 2127276"/>
                    <a:gd name="connsiteX35" fmla="*/ 1088965 w 1851187"/>
                    <a:gd name="connsiteY35" fmla="*/ 878130 h 2127276"/>
                    <a:gd name="connsiteX36" fmla="*/ 911920 w 1851187"/>
                    <a:gd name="connsiteY36" fmla="*/ 930780 h 2127276"/>
                    <a:gd name="connsiteX37" fmla="*/ 663515 w 1851187"/>
                    <a:gd name="connsiteY37" fmla="*/ 1081330 h 2127276"/>
                    <a:gd name="connsiteX38" fmla="*/ 577790 w 1851187"/>
                    <a:gd name="connsiteY38" fmla="*/ 1081330 h 2127276"/>
                    <a:gd name="connsiteX39" fmla="*/ 571440 w 1851187"/>
                    <a:gd name="connsiteY39" fmla="*/ 1059105 h 2127276"/>
                    <a:gd name="connsiteX40" fmla="*/ 609540 w 1851187"/>
                    <a:gd name="connsiteY40" fmla="*/ 1017830 h 2127276"/>
                    <a:gd name="connsiteX41" fmla="*/ 765843 w 1851187"/>
                    <a:gd name="connsiteY41" fmla="*/ 857037 h 2127276"/>
                    <a:gd name="connsiteX42" fmla="*/ 873065 w 1851187"/>
                    <a:gd name="connsiteY42" fmla="*/ 655880 h 2127276"/>
                    <a:gd name="connsiteX43" fmla="*/ 424696 w 1851187"/>
                    <a:gd name="connsiteY43" fmla="*/ 377971 h 2127276"/>
                    <a:gd name="connsiteX44" fmla="*/ 241656 w 1851187"/>
                    <a:gd name="connsiteY44" fmla="*/ 98546 h 2127276"/>
                    <a:gd name="connsiteX45" fmla="*/ 30658 w 1851187"/>
                    <a:gd name="connsiteY45" fmla="*/ 10322 h 2127276"/>
                    <a:gd name="connsiteX46" fmla="*/ 25897 w 1851187"/>
                    <a:gd name="connsiteY46" fmla="*/ 108480 h 2127276"/>
                    <a:gd name="connsiteX47" fmla="*/ 159995 w 1851187"/>
                    <a:gd name="connsiteY47" fmla="*/ 167693 h 2127276"/>
                    <a:gd name="connsiteX0" fmla="*/ 158515 w 1849707"/>
                    <a:gd name="connsiteY0" fmla="*/ 167693 h 2127276"/>
                    <a:gd name="connsiteX1" fmla="*/ 371536 w 1849707"/>
                    <a:gd name="connsiteY1" fmla="*/ 446914 h 2127276"/>
                    <a:gd name="connsiteX2" fmla="*/ 670326 w 1849707"/>
                    <a:gd name="connsiteY2" fmla="*/ 609130 h 2127276"/>
                    <a:gd name="connsiteX3" fmla="*/ 700781 w 1849707"/>
                    <a:gd name="connsiteY3" fmla="*/ 756640 h 2127276"/>
                    <a:gd name="connsiteX4" fmla="*/ 488913 w 1849707"/>
                    <a:gd name="connsiteY4" fmla="*/ 984602 h 2127276"/>
                    <a:gd name="connsiteX5" fmla="*/ 436610 w 1849707"/>
                    <a:gd name="connsiteY5" fmla="*/ 1170230 h 2127276"/>
                    <a:gd name="connsiteX6" fmla="*/ 639810 w 1849707"/>
                    <a:gd name="connsiteY6" fmla="*/ 1201980 h 2127276"/>
                    <a:gd name="connsiteX7" fmla="*/ 912781 w 1849707"/>
                    <a:gd name="connsiteY7" fmla="*/ 1053637 h 2127276"/>
                    <a:gd name="connsiteX8" fmla="*/ 1118049 w 1849707"/>
                    <a:gd name="connsiteY8" fmla="*/ 1000585 h 2127276"/>
                    <a:gd name="connsiteX9" fmla="*/ 1150985 w 1849707"/>
                    <a:gd name="connsiteY9" fmla="*/ 1160705 h 2127276"/>
                    <a:gd name="connsiteX10" fmla="*/ 931458 w 1849707"/>
                    <a:gd name="connsiteY10" fmla="*/ 1318895 h 2127276"/>
                    <a:gd name="connsiteX11" fmla="*/ 833485 w 1849707"/>
                    <a:gd name="connsiteY11" fmla="*/ 1478205 h 2127276"/>
                    <a:gd name="connsiteX12" fmla="*/ 944986 w 1849707"/>
                    <a:gd name="connsiteY12" fmla="*/ 1610484 h 2127276"/>
                    <a:gd name="connsiteX13" fmla="*/ 1180591 w 1849707"/>
                    <a:gd name="connsiteY13" fmla="*/ 1494702 h 2127276"/>
                    <a:gd name="connsiteX14" fmla="*/ 1408160 w 1849707"/>
                    <a:gd name="connsiteY14" fmla="*/ 1402005 h 2127276"/>
                    <a:gd name="connsiteX15" fmla="*/ 1547860 w 1849707"/>
                    <a:gd name="connsiteY15" fmla="*/ 1570280 h 2127276"/>
                    <a:gd name="connsiteX16" fmla="*/ 1222807 w 1849707"/>
                    <a:gd name="connsiteY16" fmla="*/ 1829407 h 2127276"/>
                    <a:gd name="connsiteX17" fmla="*/ 1292259 w 1849707"/>
                    <a:gd name="connsiteY17" fmla="*/ 1994536 h 2127276"/>
                    <a:gd name="connsiteX18" fmla="*/ 1541476 w 1849707"/>
                    <a:gd name="connsiteY18" fmla="*/ 1996182 h 2127276"/>
                    <a:gd name="connsiteX19" fmla="*/ 1737628 w 1849707"/>
                    <a:gd name="connsiteY19" fmla="*/ 2123612 h 2127276"/>
                    <a:gd name="connsiteX20" fmla="*/ 1797779 w 1849707"/>
                    <a:gd name="connsiteY20" fmla="*/ 2090822 h 2127276"/>
                    <a:gd name="connsiteX21" fmla="*/ 1844161 w 1849707"/>
                    <a:gd name="connsiteY21" fmla="*/ 2070460 h 2127276"/>
                    <a:gd name="connsiteX22" fmla="*/ 1664042 w 1849707"/>
                    <a:gd name="connsiteY22" fmla="*/ 1938592 h 2127276"/>
                    <a:gd name="connsiteX23" fmla="*/ 1467674 w 1849707"/>
                    <a:gd name="connsiteY23" fmla="*/ 1880500 h 2127276"/>
                    <a:gd name="connsiteX24" fmla="*/ 1362479 w 1849707"/>
                    <a:gd name="connsiteY24" fmla="*/ 1893037 h 2127276"/>
                    <a:gd name="connsiteX25" fmla="*/ 1366397 w 1849707"/>
                    <a:gd name="connsiteY25" fmla="*/ 1826529 h 2127276"/>
                    <a:gd name="connsiteX26" fmla="*/ 1483470 w 1849707"/>
                    <a:gd name="connsiteY26" fmla="*/ 1730121 h 2127276"/>
                    <a:gd name="connsiteX27" fmla="*/ 1646285 w 1849707"/>
                    <a:gd name="connsiteY27" fmla="*/ 1573455 h 2127276"/>
                    <a:gd name="connsiteX28" fmla="*/ 1608185 w 1849707"/>
                    <a:gd name="connsiteY28" fmla="*/ 1398830 h 2127276"/>
                    <a:gd name="connsiteX29" fmla="*/ 1389110 w 1849707"/>
                    <a:gd name="connsiteY29" fmla="*/ 1306755 h 2127276"/>
                    <a:gd name="connsiteX30" fmla="*/ 1163685 w 1849707"/>
                    <a:gd name="connsiteY30" fmla="*/ 1376605 h 2127276"/>
                    <a:gd name="connsiteX31" fmla="*/ 976280 w 1849707"/>
                    <a:gd name="connsiteY31" fmla="*/ 1490123 h 2127276"/>
                    <a:gd name="connsiteX32" fmla="*/ 973185 w 1849707"/>
                    <a:gd name="connsiteY32" fmla="*/ 1402005 h 2127276"/>
                    <a:gd name="connsiteX33" fmla="*/ 1236710 w 1849707"/>
                    <a:gd name="connsiteY33" fmla="*/ 1221030 h 2127276"/>
                    <a:gd name="connsiteX34" fmla="*/ 1246235 w 1849707"/>
                    <a:gd name="connsiteY34" fmla="*/ 1014655 h 2127276"/>
                    <a:gd name="connsiteX35" fmla="*/ 1087485 w 1849707"/>
                    <a:gd name="connsiteY35" fmla="*/ 878130 h 2127276"/>
                    <a:gd name="connsiteX36" fmla="*/ 910440 w 1849707"/>
                    <a:gd name="connsiteY36" fmla="*/ 930780 h 2127276"/>
                    <a:gd name="connsiteX37" fmla="*/ 662035 w 1849707"/>
                    <a:gd name="connsiteY37" fmla="*/ 1081330 h 2127276"/>
                    <a:gd name="connsiteX38" fmla="*/ 576310 w 1849707"/>
                    <a:gd name="connsiteY38" fmla="*/ 1081330 h 2127276"/>
                    <a:gd name="connsiteX39" fmla="*/ 569960 w 1849707"/>
                    <a:gd name="connsiteY39" fmla="*/ 1059105 h 2127276"/>
                    <a:gd name="connsiteX40" fmla="*/ 608060 w 1849707"/>
                    <a:gd name="connsiteY40" fmla="*/ 1017830 h 2127276"/>
                    <a:gd name="connsiteX41" fmla="*/ 764363 w 1849707"/>
                    <a:gd name="connsiteY41" fmla="*/ 857037 h 2127276"/>
                    <a:gd name="connsiteX42" fmla="*/ 871585 w 1849707"/>
                    <a:gd name="connsiteY42" fmla="*/ 655880 h 2127276"/>
                    <a:gd name="connsiteX43" fmla="*/ 423216 w 1849707"/>
                    <a:gd name="connsiteY43" fmla="*/ 377971 h 2127276"/>
                    <a:gd name="connsiteX44" fmla="*/ 240176 w 1849707"/>
                    <a:gd name="connsiteY44" fmla="*/ 98546 h 2127276"/>
                    <a:gd name="connsiteX45" fmla="*/ 29178 w 1849707"/>
                    <a:gd name="connsiteY45" fmla="*/ 10322 h 2127276"/>
                    <a:gd name="connsiteX46" fmla="*/ 28269 w 1849707"/>
                    <a:gd name="connsiteY46" fmla="*/ 81202 h 2127276"/>
                    <a:gd name="connsiteX47" fmla="*/ 158515 w 1849707"/>
                    <a:gd name="connsiteY47" fmla="*/ 167693 h 21272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</a:cxnLst>
                  <a:rect l="l" t="t" r="r" b="b"/>
                  <a:pathLst>
                    <a:path w="1849707" h="2127276">
                      <a:moveTo>
                        <a:pt x="158515" y="167693"/>
                      </a:moveTo>
                      <a:cubicBezTo>
                        <a:pt x="215726" y="228645"/>
                        <a:pt x="286234" y="373341"/>
                        <a:pt x="371536" y="446914"/>
                      </a:cubicBezTo>
                      <a:cubicBezTo>
                        <a:pt x="456838" y="520487"/>
                        <a:pt x="615452" y="557509"/>
                        <a:pt x="670326" y="609130"/>
                      </a:cubicBezTo>
                      <a:cubicBezTo>
                        <a:pt x="725200" y="660751"/>
                        <a:pt x="731017" y="694061"/>
                        <a:pt x="700781" y="756640"/>
                      </a:cubicBezTo>
                      <a:cubicBezTo>
                        <a:pt x="670546" y="819219"/>
                        <a:pt x="532942" y="915670"/>
                        <a:pt x="488913" y="984602"/>
                      </a:cubicBezTo>
                      <a:cubicBezTo>
                        <a:pt x="444884" y="1053534"/>
                        <a:pt x="411461" y="1134000"/>
                        <a:pt x="436610" y="1170230"/>
                      </a:cubicBezTo>
                      <a:cubicBezTo>
                        <a:pt x="461760" y="1206460"/>
                        <a:pt x="560448" y="1221412"/>
                        <a:pt x="639810" y="1201980"/>
                      </a:cubicBezTo>
                      <a:cubicBezTo>
                        <a:pt x="719172" y="1182548"/>
                        <a:pt x="833075" y="1087203"/>
                        <a:pt x="912781" y="1053637"/>
                      </a:cubicBezTo>
                      <a:cubicBezTo>
                        <a:pt x="992488" y="1020071"/>
                        <a:pt x="1078348" y="982740"/>
                        <a:pt x="1118049" y="1000585"/>
                      </a:cubicBezTo>
                      <a:cubicBezTo>
                        <a:pt x="1157750" y="1018430"/>
                        <a:pt x="1182083" y="1107654"/>
                        <a:pt x="1150985" y="1160705"/>
                      </a:cubicBezTo>
                      <a:cubicBezTo>
                        <a:pt x="1119887" y="1213756"/>
                        <a:pt x="984375" y="1265978"/>
                        <a:pt x="931458" y="1318895"/>
                      </a:cubicBezTo>
                      <a:cubicBezTo>
                        <a:pt x="878541" y="1371812"/>
                        <a:pt x="831230" y="1429607"/>
                        <a:pt x="833485" y="1478205"/>
                      </a:cubicBezTo>
                      <a:cubicBezTo>
                        <a:pt x="835740" y="1526803"/>
                        <a:pt x="887135" y="1607735"/>
                        <a:pt x="944986" y="1610484"/>
                      </a:cubicBezTo>
                      <a:cubicBezTo>
                        <a:pt x="1002837" y="1613233"/>
                        <a:pt x="1103395" y="1529448"/>
                        <a:pt x="1180591" y="1494702"/>
                      </a:cubicBezTo>
                      <a:cubicBezTo>
                        <a:pt x="1257787" y="1459956"/>
                        <a:pt x="1346949" y="1389409"/>
                        <a:pt x="1408160" y="1402005"/>
                      </a:cubicBezTo>
                      <a:cubicBezTo>
                        <a:pt x="1469371" y="1414601"/>
                        <a:pt x="1578752" y="1499046"/>
                        <a:pt x="1547860" y="1570280"/>
                      </a:cubicBezTo>
                      <a:cubicBezTo>
                        <a:pt x="1516968" y="1641514"/>
                        <a:pt x="1265407" y="1758698"/>
                        <a:pt x="1222807" y="1829407"/>
                      </a:cubicBezTo>
                      <a:cubicBezTo>
                        <a:pt x="1180207" y="1900116"/>
                        <a:pt x="1239148" y="1966740"/>
                        <a:pt x="1292259" y="1994536"/>
                      </a:cubicBezTo>
                      <a:cubicBezTo>
                        <a:pt x="1345371" y="2022332"/>
                        <a:pt x="1467248" y="1974669"/>
                        <a:pt x="1541476" y="1996182"/>
                      </a:cubicBezTo>
                      <a:cubicBezTo>
                        <a:pt x="1615704" y="2017695"/>
                        <a:pt x="1694911" y="2107839"/>
                        <a:pt x="1737628" y="2123612"/>
                      </a:cubicBezTo>
                      <a:cubicBezTo>
                        <a:pt x="1780345" y="2139385"/>
                        <a:pt x="1780024" y="2099681"/>
                        <a:pt x="1797779" y="2090822"/>
                      </a:cubicBezTo>
                      <a:cubicBezTo>
                        <a:pt x="1815535" y="2081963"/>
                        <a:pt x="1866450" y="2095832"/>
                        <a:pt x="1844161" y="2070460"/>
                      </a:cubicBezTo>
                      <a:cubicBezTo>
                        <a:pt x="1821872" y="2045088"/>
                        <a:pt x="1726790" y="1970252"/>
                        <a:pt x="1664042" y="1938592"/>
                      </a:cubicBezTo>
                      <a:cubicBezTo>
                        <a:pt x="1601294" y="1906932"/>
                        <a:pt x="1517935" y="1888093"/>
                        <a:pt x="1467674" y="1880500"/>
                      </a:cubicBezTo>
                      <a:cubicBezTo>
                        <a:pt x="1417414" y="1872908"/>
                        <a:pt x="1379359" y="1902032"/>
                        <a:pt x="1362479" y="1893037"/>
                      </a:cubicBezTo>
                      <a:cubicBezTo>
                        <a:pt x="1345599" y="1884042"/>
                        <a:pt x="1346232" y="1853682"/>
                        <a:pt x="1366397" y="1826529"/>
                      </a:cubicBezTo>
                      <a:cubicBezTo>
                        <a:pt x="1386562" y="1799376"/>
                        <a:pt x="1436822" y="1772300"/>
                        <a:pt x="1483470" y="1730121"/>
                      </a:cubicBezTo>
                      <a:cubicBezTo>
                        <a:pt x="1530118" y="1687942"/>
                        <a:pt x="1625499" y="1628670"/>
                        <a:pt x="1646285" y="1573455"/>
                      </a:cubicBezTo>
                      <a:cubicBezTo>
                        <a:pt x="1667071" y="1518240"/>
                        <a:pt x="1651047" y="1443280"/>
                        <a:pt x="1608185" y="1398830"/>
                      </a:cubicBezTo>
                      <a:cubicBezTo>
                        <a:pt x="1565323" y="1354380"/>
                        <a:pt x="1463193" y="1310459"/>
                        <a:pt x="1389110" y="1306755"/>
                      </a:cubicBezTo>
                      <a:cubicBezTo>
                        <a:pt x="1315027" y="1303051"/>
                        <a:pt x="1232490" y="1346044"/>
                        <a:pt x="1163685" y="1376605"/>
                      </a:cubicBezTo>
                      <a:cubicBezTo>
                        <a:pt x="1094880" y="1407166"/>
                        <a:pt x="1008030" y="1485890"/>
                        <a:pt x="976280" y="1490123"/>
                      </a:cubicBezTo>
                      <a:cubicBezTo>
                        <a:pt x="944530" y="1494356"/>
                        <a:pt x="929780" y="1446854"/>
                        <a:pt x="973185" y="1402005"/>
                      </a:cubicBezTo>
                      <a:cubicBezTo>
                        <a:pt x="1016590" y="1357156"/>
                        <a:pt x="1191202" y="1285588"/>
                        <a:pt x="1236710" y="1221030"/>
                      </a:cubicBezTo>
                      <a:cubicBezTo>
                        <a:pt x="1282218" y="1156472"/>
                        <a:pt x="1271106" y="1071805"/>
                        <a:pt x="1246235" y="1014655"/>
                      </a:cubicBezTo>
                      <a:cubicBezTo>
                        <a:pt x="1221364" y="957505"/>
                        <a:pt x="1143451" y="892109"/>
                        <a:pt x="1087485" y="878130"/>
                      </a:cubicBezTo>
                      <a:cubicBezTo>
                        <a:pt x="1031519" y="864151"/>
                        <a:pt x="910440" y="930780"/>
                        <a:pt x="910440" y="930780"/>
                      </a:cubicBezTo>
                      <a:cubicBezTo>
                        <a:pt x="839532" y="964647"/>
                        <a:pt x="717723" y="1056238"/>
                        <a:pt x="662035" y="1081330"/>
                      </a:cubicBezTo>
                      <a:cubicBezTo>
                        <a:pt x="606347" y="1106422"/>
                        <a:pt x="591656" y="1085034"/>
                        <a:pt x="576310" y="1081330"/>
                      </a:cubicBezTo>
                      <a:cubicBezTo>
                        <a:pt x="560964" y="1077626"/>
                        <a:pt x="564668" y="1069688"/>
                        <a:pt x="569960" y="1059105"/>
                      </a:cubicBezTo>
                      <a:cubicBezTo>
                        <a:pt x="575252" y="1048522"/>
                        <a:pt x="575660" y="1051508"/>
                        <a:pt x="608060" y="1017830"/>
                      </a:cubicBezTo>
                      <a:cubicBezTo>
                        <a:pt x="640460" y="984152"/>
                        <a:pt x="720442" y="917362"/>
                        <a:pt x="764363" y="857037"/>
                      </a:cubicBezTo>
                      <a:cubicBezTo>
                        <a:pt x="808284" y="796712"/>
                        <a:pt x="928443" y="735724"/>
                        <a:pt x="871585" y="655880"/>
                      </a:cubicBezTo>
                      <a:cubicBezTo>
                        <a:pt x="814727" y="576036"/>
                        <a:pt x="528451" y="470860"/>
                        <a:pt x="423216" y="377971"/>
                      </a:cubicBezTo>
                      <a:cubicBezTo>
                        <a:pt x="317981" y="285082"/>
                        <a:pt x="305849" y="159821"/>
                        <a:pt x="240176" y="98546"/>
                      </a:cubicBezTo>
                      <a:cubicBezTo>
                        <a:pt x="174503" y="37271"/>
                        <a:pt x="81566" y="-25132"/>
                        <a:pt x="29178" y="10322"/>
                      </a:cubicBezTo>
                      <a:cubicBezTo>
                        <a:pt x="-23210" y="45776"/>
                        <a:pt x="6713" y="54974"/>
                        <a:pt x="28269" y="81202"/>
                      </a:cubicBezTo>
                      <a:cubicBezTo>
                        <a:pt x="49825" y="107430"/>
                        <a:pt x="101304" y="106741"/>
                        <a:pt x="158515" y="167693"/>
                      </a:cubicBezTo>
                      <a:close/>
                    </a:path>
                  </a:pathLst>
                </a:cu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solidFill>
                    <a:srgbClr val="004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5" name="Freeform 108">
                  <a:extLst>
                    <a:ext uri="{FF2B5EF4-FFF2-40B4-BE49-F238E27FC236}">
                      <a16:creationId xmlns:a16="http://schemas.microsoft.com/office/drawing/2014/main" id="{7E17F44D-1711-4A64-A9ED-275248E1B6CD}"/>
                    </a:ext>
                  </a:extLst>
                </p:cNvPr>
                <p:cNvSpPr/>
                <p:nvPr/>
              </p:nvSpPr>
              <p:spPr>
                <a:xfrm flipH="1">
                  <a:off x="5113107" y="5383917"/>
                  <a:ext cx="997679" cy="336332"/>
                </a:xfrm>
                <a:custGeom>
                  <a:avLst/>
                  <a:gdLst>
                    <a:gd name="connsiteX0" fmla="*/ 0 w 1021080"/>
                    <a:gd name="connsiteY0" fmla="*/ 0 h 195033"/>
                    <a:gd name="connsiteX1" fmla="*/ 167640 w 1021080"/>
                    <a:gd name="connsiteY1" fmla="*/ 120396 h 195033"/>
                    <a:gd name="connsiteX2" fmla="*/ 598932 w 1021080"/>
                    <a:gd name="connsiteY2" fmla="*/ 193548 h 195033"/>
                    <a:gd name="connsiteX3" fmla="*/ 1021080 w 1021080"/>
                    <a:gd name="connsiteY3" fmla="*/ 54864 h 195033"/>
                    <a:gd name="connsiteX4" fmla="*/ 1021080 w 1021080"/>
                    <a:gd name="connsiteY4" fmla="*/ 54864 h 195033"/>
                    <a:gd name="connsiteX0" fmla="*/ 0 w 1021080"/>
                    <a:gd name="connsiteY0" fmla="*/ 0 h 194185"/>
                    <a:gd name="connsiteX1" fmla="*/ 193509 w 1021080"/>
                    <a:gd name="connsiteY1" fmla="*/ 102108 h 194185"/>
                    <a:gd name="connsiteX2" fmla="*/ 598932 w 1021080"/>
                    <a:gd name="connsiteY2" fmla="*/ 193548 h 194185"/>
                    <a:gd name="connsiteX3" fmla="*/ 1021080 w 1021080"/>
                    <a:gd name="connsiteY3" fmla="*/ 54864 h 194185"/>
                    <a:gd name="connsiteX4" fmla="*/ 1021080 w 1021080"/>
                    <a:gd name="connsiteY4" fmla="*/ 54864 h 194185"/>
                    <a:gd name="connsiteX0" fmla="*/ 0 w 1021080"/>
                    <a:gd name="connsiteY0" fmla="*/ 0 h 165540"/>
                    <a:gd name="connsiteX1" fmla="*/ 193509 w 1021080"/>
                    <a:gd name="connsiteY1" fmla="*/ 102108 h 165540"/>
                    <a:gd name="connsiteX2" fmla="*/ 614149 w 1021080"/>
                    <a:gd name="connsiteY2" fmla="*/ 164592 h 165540"/>
                    <a:gd name="connsiteX3" fmla="*/ 1021080 w 1021080"/>
                    <a:gd name="connsiteY3" fmla="*/ 54864 h 165540"/>
                    <a:gd name="connsiteX4" fmla="*/ 1021080 w 1021080"/>
                    <a:gd name="connsiteY4" fmla="*/ 54864 h 165540"/>
                    <a:gd name="connsiteX0" fmla="*/ 0 w 1047543"/>
                    <a:gd name="connsiteY0" fmla="*/ 0 h 165540"/>
                    <a:gd name="connsiteX1" fmla="*/ 193509 w 1047543"/>
                    <a:gd name="connsiteY1" fmla="*/ 102108 h 165540"/>
                    <a:gd name="connsiteX2" fmla="*/ 614149 w 1047543"/>
                    <a:gd name="connsiteY2" fmla="*/ 164592 h 165540"/>
                    <a:gd name="connsiteX3" fmla="*/ 1021080 w 1047543"/>
                    <a:gd name="connsiteY3" fmla="*/ 54864 h 165540"/>
                    <a:gd name="connsiteX4" fmla="*/ 1005863 w 1047543"/>
                    <a:gd name="connsiteY4" fmla="*/ 33528 h 165540"/>
                    <a:gd name="connsiteX0" fmla="*/ 0 w 1125212"/>
                    <a:gd name="connsiteY0" fmla="*/ 0 h 165540"/>
                    <a:gd name="connsiteX1" fmla="*/ 193509 w 1125212"/>
                    <a:gd name="connsiteY1" fmla="*/ 102108 h 165540"/>
                    <a:gd name="connsiteX2" fmla="*/ 614149 w 1125212"/>
                    <a:gd name="connsiteY2" fmla="*/ 164592 h 165540"/>
                    <a:gd name="connsiteX3" fmla="*/ 1021080 w 1125212"/>
                    <a:gd name="connsiteY3" fmla="*/ 54864 h 165540"/>
                    <a:gd name="connsiteX4" fmla="*/ 1124558 w 1125212"/>
                    <a:gd name="connsiteY4" fmla="*/ 4572 h 165540"/>
                    <a:gd name="connsiteX0" fmla="*/ 0 w 1124708"/>
                    <a:gd name="connsiteY0" fmla="*/ 0 h 164672"/>
                    <a:gd name="connsiteX1" fmla="*/ 193509 w 1124708"/>
                    <a:gd name="connsiteY1" fmla="*/ 102108 h 164672"/>
                    <a:gd name="connsiteX2" fmla="*/ 614149 w 1124708"/>
                    <a:gd name="connsiteY2" fmla="*/ 164592 h 164672"/>
                    <a:gd name="connsiteX3" fmla="*/ 920646 w 1124708"/>
                    <a:gd name="connsiteY3" fmla="*/ 89915 h 164672"/>
                    <a:gd name="connsiteX4" fmla="*/ 1124558 w 1124708"/>
                    <a:gd name="connsiteY4" fmla="*/ 4572 h 164672"/>
                    <a:gd name="connsiteX0" fmla="*/ 0 w 1023043"/>
                    <a:gd name="connsiteY0" fmla="*/ 0 h 164672"/>
                    <a:gd name="connsiteX1" fmla="*/ 193509 w 1023043"/>
                    <a:gd name="connsiteY1" fmla="*/ 102108 h 164672"/>
                    <a:gd name="connsiteX2" fmla="*/ 614149 w 1023043"/>
                    <a:gd name="connsiteY2" fmla="*/ 164592 h 164672"/>
                    <a:gd name="connsiteX3" fmla="*/ 920646 w 1023043"/>
                    <a:gd name="connsiteY3" fmla="*/ 89915 h 164672"/>
                    <a:gd name="connsiteX4" fmla="*/ 1022602 w 1023043"/>
                    <a:gd name="connsiteY4" fmla="*/ 32004 h 164672"/>
                    <a:gd name="connsiteX0" fmla="*/ 0 w 1023123"/>
                    <a:gd name="connsiteY0" fmla="*/ 0 h 194449"/>
                    <a:gd name="connsiteX1" fmla="*/ 193509 w 1023123"/>
                    <a:gd name="connsiteY1" fmla="*/ 102108 h 194449"/>
                    <a:gd name="connsiteX2" fmla="*/ 570937 w 1023123"/>
                    <a:gd name="connsiteY2" fmla="*/ 194401 h 194449"/>
                    <a:gd name="connsiteX3" fmla="*/ 920646 w 1023123"/>
                    <a:gd name="connsiteY3" fmla="*/ 89915 h 194449"/>
                    <a:gd name="connsiteX4" fmla="*/ 1022602 w 1023123"/>
                    <a:gd name="connsiteY4" fmla="*/ 32004 h 194449"/>
                    <a:gd name="connsiteX0" fmla="*/ 0 w 1022714"/>
                    <a:gd name="connsiteY0" fmla="*/ 0 h 200248"/>
                    <a:gd name="connsiteX1" fmla="*/ 193509 w 1022714"/>
                    <a:gd name="connsiteY1" fmla="*/ 102108 h 200248"/>
                    <a:gd name="connsiteX2" fmla="*/ 570937 w 1022714"/>
                    <a:gd name="connsiteY2" fmla="*/ 194401 h 200248"/>
                    <a:gd name="connsiteX3" fmla="*/ 784838 w 1022714"/>
                    <a:gd name="connsiteY3" fmla="*/ 173379 h 200248"/>
                    <a:gd name="connsiteX4" fmla="*/ 1022602 w 1022714"/>
                    <a:gd name="connsiteY4" fmla="*/ 32004 h 200248"/>
                    <a:gd name="connsiteX0" fmla="*/ 0 w 862605"/>
                    <a:gd name="connsiteY0" fmla="*/ 0 h 197261"/>
                    <a:gd name="connsiteX1" fmla="*/ 193509 w 862605"/>
                    <a:gd name="connsiteY1" fmla="*/ 102108 h 197261"/>
                    <a:gd name="connsiteX2" fmla="*/ 570937 w 862605"/>
                    <a:gd name="connsiteY2" fmla="*/ 194401 h 197261"/>
                    <a:gd name="connsiteX3" fmla="*/ 784838 w 862605"/>
                    <a:gd name="connsiteY3" fmla="*/ 173379 h 197261"/>
                    <a:gd name="connsiteX4" fmla="*/ 862102 w 862605"/>
                    <a:gd name="connsiteY4" fmla="*/ 169123 h 197261"/>
                    <a:gd name="connsiteX0" fmla="*/ 0 w 862426"/>
                    <a:gd name="connsiteY0" fmla="*/ 0 h 199430"/>
                    <a:gd name="connsiteX1" fmla="*/ 193509 w 862426"/>
                    <a:gd name="connsiteY1" fmla="*/ 102108 h 199430"/>
                    <a:gd name="connsiteX2" fmla="*/ 570937 w 862426"/>
                    <a:gd name="connsiteY2" fmla="*/ 194401 h 199430"/>
                    <a:gd name="connsiteX3" fmla="*/ 763233 w 862426"/>
                    <a:gd name="connsiteY3" fmla="*/ 185302 h 199430"/>
                    <a:gd name="connsiteX4" fmla="*/ 862102 w 862426"/>
                    <a:gd name="connsiteY4" fmla="*/ 169123 h 199430"/>
                    <a:gd name="connsiteX0" fmla="*/ 0 w 862360"/>
                    <a:gd name="connsiteY0" fmla="*/ 0 h 192969"/>
                    <a:gd name="connsiteX1" fmla="*/ 193509 w 862360"/>
                    <a:gd name="connsiteY1" fmla="*/ 102108 h 192969"/>
                    <a:gd name="connsiteX2" fmla="*/ 663533 w 862360"/>
                    <a:gd name="connsiteY2" fmla="*/ 186452 h 192969"/>
                    <a:gd name="connsiteX3" fmla="*/ 763233 w 862360"/>
                    <a:gd name="connsiteY3" fmla="*/ 185302 h 192969"/>
                    <a:gd name="connsiteX4" fmla="*/ 862102 w 862360"/>
                    <a:gd name="connsiteY4" fmla="*/ 169123 h 1929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862360" h="192969">
                      <a:moveTo>
                        <a:pt x="0" y="0"/>
                      </a:moveTo>
                      <a:cubicBezTo>
                        <a:pt x="33909" y="44069"/>
                        <a:pt x="82920" y="71033"/>
                        <a:pt x="193509" y="102108"/>
                      </a:cubicBezTo>
                      <a:cubicBezTo>
                        <a:pt x="304098" y="133183"/>
                        <a:pt x="568579" y="172586"/>
                        <a:pt x="663533" y="186452"/>
                      </a:cubicBezTo>
                      <a:cubicBezTo>
                        <a:pt x="758487" y="200318"/>
                        <a:pt x="730138" y="188190"/>
                        <a:pt x="763233" y="185302"/>
                      </a:cubicBezTo>
                      <a:cubicBezTo>
                        <a:pt x="796328" y="182414"/>
                        <a:pt x="867174" y="176235"/>
                        <a:pt x="862102" y="169123"/>
                      </a:cubicBezTo>
                    </a:path>
                  </a:pathLst>
                </a:custGeom>
                <a:noFill/>
                <a:ln>
                  <a:solidFill>
                    <a:srgbClr val="C55A1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6" name="Freeform 109">
                  <a:extLst>
                    <a:ext uri="{FF2B5EF4-FFF2-40B4-BE49-F238E27FC236}">
                      <a16:creationId xmlns:a16="http://schemas.microsoft.com/office/drawing/2014/main" id="{4637AF7C-41F6-4256-B781-ABEAB2B165B0}"/>
                    </a:ext>
                  </a:extLst>
                </p:cNvPr>
                <p:cNvSpPr/>
                <p:nvPr/>
              </p:nvSpPr>
              <p:spPr>
                <a:xfrm flipH="1">
                  <a:off x="4984508" y="5389917"/>
                  <a:ext cx="1218235" cy="218337"/>
                </a:xfrm>
                <a:custGeom>
                  <a:avLst/>
                  <a:gdLst>
                    <a:gd name="connsiteX0" fmla="*/ 0 w 964598"/>
                    <a:gd name="connsiteY0" fmla="*/ 103632 h 257635"/>
                    <a:gd name="connsiteX1" fmla="*/ 64008 w 964598"/>
                    <a:gd name="connsiteY1" fmla="*/ 152400 h 257635"/>
                    <a:gd name="connsiteX2" fmla="*/ 345948 w 964598"/>
                    <a:gd name="connsiteY2" fmla="*/ 228600 h 257635"/>
                    <a:gd name="connsiteX3" fmla="*/ 569976 w 964598"/>
                    <a:gd name="connsiteY3" fmla="*/ 256032 h 257635"/>
                    <a:gd name="connsiteX4" fmla="*/ 722376 w 964598"/>
                    <a:gd name="connsiteY4" fmla="*/ 234696 h 257635"/>
                    <a:gd name="connsiteX5" fmla="*/ 934212 w 964598"/>
                    <a:gd name="connsiteY5" fmla="*/ 76200 h 257635"/>
                    <a:gd name="connsiteX6" fmla="*/ 963168 w 964598"/>
                    <a:gd name="connsiteY6" fmla="*/ 0 h 257635"/>
                    <a:gd name="connsiteX7" fmla="*/ 963168 w 964598"/>
                    <a:gd name="connsiteY7" fmla="*/ 0 h 257635"/>
                    <a:gd name="connsiteX0" fmla="*/ 0 w 964598"/>
                    <a:gd name="connsiteY0" fmla="*/ 103632 h 288704"/>
                    <a:gd name="connsiteX1" fmla="*/ 64008 w 964598"/>
                    <a:gd name="connsiteY1" fmla="*/ 152400 h 288704"/>
                    <a:gd name="connsiteX2" fmla="*/ 345948 w 964598"/>
                    <a:gd name="connsiteY2" fmla="*/ 228600 h 288704"/>
                    <a:gd name="connsiteX3" fmla="*/ 569977 w 964598"/>
                    <a:gd name="connsiteY3" fmla="*/ 288667 h 288704"/>
                    <a:gd name="connsiteX4" fmla="*/ 722376 w 964598"/>
                    <a:gd name="connsiteY4" fmla="*/ 234696 h 288704"/>
                    <a:gd name="connsiteX5" fmla="*/ 934212 w 964598"/>
                    <a:gd name="connsiteY5" fmla="*/ 76200 h 288704"/>
                    <a:gd name="connsiteX6" fmla="*/ 963168 w 964598"/>
                    <a:gd name="connsiteY6" fmla="*/ 0 h 288704"/>
                    <a:gd name="connsiteX7" fmla="*/ 963168 w 964598"/>
                    <a:gd name="connsiteY7" fmla="*/ 0 h 288704"/>
                    <a:gd name="connsiteX0" fmla="*/ 0 w 964598"/>
                    <a:gd name="connsiteY0" fmla="*/ 103632 h 288684"/>
                    <a:gd name="connsiteX1" fmla="*/ 64008 w 964598"/>
                    <a:gd name="connsiteY1" fmla="*/ 152400 h 288684"/>
                    <a:gd name="connsiteX2" fmla="*/ 342556 w 964598"/>
                    <a:gd name="connsiteY2" fmla="*/ 239478 h 288684"/>
                    <a:gd name="connsiteX3" fmla="*/ 569977 w 964598"/>
                    <a:gd name="connsiteY3" fmla="*/ 288667 h 288684"/>
                    <a:gd name="connsiteX4" fmla="*/ 722376 w 964598"/>
                    <a:gd name="connsiteY4" fmla="*/ 234696 h 288684"/>
                    <a:gd name="connsiteX5" fmla="*/ 934212 w 964598"/>
                    <a:gd name="connsiteY5" fmla="*/ 76200 h 288684"/>
                    <a:gd name="connsiteX6" fmla="*/ 963168 w 964598"/>
                    <a:gd name="connsiteY6" fmla="*/ 0 h 288684"/>
                    <a:gd name="connsiteX7" fmla="*/ 963168 w 964598"/>
                    <a:gd name="connsiteY7" fmla="*/ 0 h 288684"/>
                    <a:gd name="connsiteX0" fmla="*/ 0 w 963493"/>
                    <a:gd name="connsiteY0" fmla="*/ 103632 h 301615"/>
                    <a:gd name="connsiteX1" fmla="*/ 64008 w 963493"/>
                    <a:gd name="connsiteY1" fmla="*/ 152400 h 301615"/>
                    <a:gd name="connsiteX2" fmla="*/ 342556 w 963493"/>
                    <a:gd name="connsiteY2" fmla="*/ 239478 h 301615"/>
                    <a:gd name="connsiteX3" fmla="*/ 569977 w 963493"/>
                    <a:gd name="connsiteY3" fmla="*/ 288667 h 301615"/>
                    <a:gd name="connsiteX4" fmla="*/ 756287 w 963493"/>
                    <a:gd name="connsiteY4" fmla="*/ 281835 h 301615"/>
                    <a:gd name="connsiteX5" fmla="*/ 934212 w 963493"/>
                    <a:gd name="connsiteY5" fmla="*/ 76200 h 301615"/>
                    <a:gd name="connsiteX6" fmla="*/ 963168 w 963493"/>
                    <a:gd name="connsiteY6" fmla="*/ 0 h 301615"/>
                    <a:gd name="connsiteX7" fmla="*/ 963168 w 963493"/>
                    <a:gd name="connsiteY7" fmla="*/ 0 h 301615"/>
                    <a:gd name="connsiteX0" fmla="*/ 0 w 985187"/>
                    <a:gd name="connsiteY0" fmla="*/ 103632 h 296197"/>
                    <a:gd name="connsiteX1" fmla="*/ 64008 w 985187"/>
                    <a:gd name="connsiteY1" fmla="*/ 152400 h 296197"/>
                    <a:gd name="connsiteX2" fmla="*/ 342556 w 985187"/>
                    <a:gd name="connsiteY2" fmla="*/ 239478 h 296197"/>
                    <a:gd name="connsiteX3" fmla="*/ 569977 w 985187"/>
                    <a:gd name="connsiteY3" fmla="*/ 288667 h 296197"/>
                    <a:gd name="connsiteX4" fmla="*/ 756287 w 985187"/>
                    <a:gd name="connsiteY4" fmla="*/ 281835 h 296197"/>
                    <a:gd name="connsiteX5" fmla="*/ 971514 w 985187"/>
                    <a:gd name="connsiteY5" fmla="*/ 155975 h 296197"/>
                    <a:gd name="connsiteX6" fmla="*/ 963168 w 985187"/>
                    <a:gd name="connsiteY6" fmla="*/ 0 h 296197"/>
                    <a:gd name="connsiteX7" fmla="*/ 963168 w 985187"/>
                    <a:gd name="connsiteY7" fmla="*/ 0 h 296197"/>
                    <a:gd name="connsiteX0" fmla="*/ 0 w 986905"/>
                    <a:gd name="connsiteY0" fmla="*/ 105064 h 297629"/>
                    <a:gd name="connsiteX1" fmla="*/ 64008 w 986905"/>
                    <a:gd name="connsiteY1" fmla="*/ 153832 h 297629"/>
                    <a:gd name="connsiteX2" fmla="*/ 342556 w 986905"/>
                    <a:gd name="connsiteY2" fmla="*/ 240910 h 297629"/>
                    <a:gd name="connsiteX3" fmla="*/ 569977 w 986905"/>
                    <a:gd name="connsiteY3" fmla="*/ 290099 h 297629"/>
                    <a:gd name="connsiteX4" fmla="*/ 756287 w 986905"/>
                    <a:gd name="connsiteY4" fmla="*/ 283267 h 297629"/>
                    <a:gd name="connsiteX5" fmla="*/ 971514 w 986905"/>
                    <a:gd name="connsiteY5" fmla="*/ 157407 h 297629"/>
                    <a:gd name="connsiteX6" fmla="*/ 963168 w 986905"/>
                    <a:gd name="connsiteY6" fmla="*/ 1432 h 297629"/>
                    <a:gd name="connsiteX7" fmla="*/ 986905 w 986905"/>
                    <a:gd name="connsiteY7" fmla="*/ 84833 h 297629"/>
                    <a:gd name="connsiteX0" fmla="*/ 0 w 986905"/>
                    <a:gd name="connsiteY0" fmla="*/ 108858 h 296970"/>
                    <a:gd name="connsiteX1" fmla="*/ 64008 w 986905"/>
                    <a:gd name="connsiteY1" fmla="*/ 157626 h 296970"/>
                    <a:gd name="connsiteX2" fmla="*/ 342556 w 986905"/>
                    <a:gd name="connsiteY2" fmla="*/ 244704 h 296970"/>
                    <a:gd name="connsiteX3" fmla="*/ 569977 w 986905"/>
                    <a:gd name="connsiteY3" fmla="*/ 293893 h 296970"/>
                    <a:gd name="connsiteX4" fmla="*/ 756287 w 986905"/>
                    <a:gd name="connsiteY4" fmla="*/ 287061 h 296970"/>
                    <a:gd name="connsiteX5" fmla="*/ 890128 w 986905"/>
                    <a:gd name="connsiteY5" fmla="*/ 248227 h 296970"/>
                    <a:gd name="connsiteX6" fmla="*/ 963168 w 986905"/>
                    <a:gd name="connsiteY6" fmla="*/ 5226 h 296970"/>
                    <a:gd name="connsiteX7" fmla="*/ 986905 w 986905"/>
                    <a:gd name="connsiteY7" fmla="*/ 88627 h 296970"/>
                    <a:gd name="connsiteX0" fmla="*/ 0 w 998431"/>
                    <a:gd name="connsiteY0" fmla="*/ 27485 h 215597"/>
                    <a:gd name="connsiteX1" fmla="*/ 64008 w 998431"/>
                    <a:gd name="connsiteY1" fmla="*/ 76253 h 215597"/>
                    <a:gd name="connsiteX2" fmla="*/ 342556 w 998431"/>
                    <a:gd name="connsiteY2" fmla="*/ 163331 h 215597"/>
                    <a:gd name="connsiteX3" fmla="*/ 569977 w 998431"/>
                    <a:gd name="connsiteY3" fmla="*/ 212520 h 215597"/>
                    <a:gd name="connsiteX4" fmla="*/ 756287 w 998431"/>
                    <a:gd name="connsiteY4" fmla="*/ 205688 h 215597"/>
                    <a:gd name="connsiteX5" fmla="*/ 890128 w 998431"/>
                    <a:gd name="connsiteY5" fmla="*/ 166854 h 215597"/>
                    <a:gd name="connsiteX6" fmla="*/ 993688 w 998431"/>
                    <a:gd name="connsiteY6" fmla="*/ 65270 h 215597"/>
                    <a:gd name="connsiteX7" fmla="*/ 986905 w 998431"/>
                    <a:gd name="connsiteY7" fmla="*/ 7254 h 215597"/>
                    <a:gd name="connsiteX0" fmla="*/ 0 w 993688"/>
                    <a:gd name="connsiteY0" fmla="*/ -1 h 188111"/>
                    <a:gd name="connsiteX1" fmla="*/ 64008 w 993688"/>
                    <a:gd name="connsiteY1" fmla="*/ 48767 h 188111"/>
                    <a:gd name="connsiteX2" fmla="*/ 342556 w 993688"/>
                    <a:gd name="connsiteY2" fmla="*/ 135845 h 188111"/>
                    <a:gd name="connsiteX3" fmla="*/ 569977 w 993688"/>
                    <a:gd name="connsiteY3" fmla="*/ 185034 h 188111"/>
                    <a:gd name="connsiteX4" fmla="*/ 756287 w 993688"/>
                    <a:gd name="connsiteY4" fmla="*/ 178202 h 188111"/>
                    <a:gd name="connsiteX5" fmla="*/ 890128 w 993688"/>
                    <a:gd name="connsiteY5" fmla="*/ 139368 h 188111"/>
                    <a:gd name="connsiteX6" fmla="*/ 993688 w 993688"/>
                    <a:gd name="connsiteY6" fmla="*/ 37784 h 18811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993688" h="188111">
                      <a:moveTo>
                        <a:pt x="0" y="-1"/>
                      </a:moveTo>
                      <a:cubicBezTo>
                        <a:pt x="3175" y="13969"/>
                        <a:pt x="6915" y="26126"/>
                        <a:pt x="64008" y="48767"/>
                      </a:cubicBezTo>
                      <a:cubicBezTo>
                        <a:pt x="121101" y="71408"/>
                        <a:pt x="258228" y="113134"/>
                        <a:pt x="342556" y="135845"/>
                      </a:cubicBezTo>
                      <a:cubicBezTo>
                        <a:pt x="426884" y="158556"/>
                        <a:pt x="501022" y="177975"/>
                        <a:pt x="569977" y="185034"/>
                      </a:cubicBezTo>
                      <a:cubicBezTo>
                        <a:pt x="638932" y="192093"/>
                        <a:pt x="702929" y="185813"/>
                        <a:pt x="756287" y="178202"/>
                      </a:cubicBezTo>
                      <a:cubicBezTo>
                        <a:pt x="809646" y="170591"/>
                        <a:pt x="850561" y="162771"/>
                        <a:pt x="890128" y="139368"/>
                      </a:cubicBezTo>
                      <a:cubicBezTo>
                        <a:pt x="929695" y="115965"/>
                        <a:pt x="977559" y="64384"/>
                        <a:pt x="993688" y="37784"/>
                      </a:cubicBezTo>
                    </a:path>
                  </a:pathLst>
                </a:custGeom>
                <a:noFill/>
                <a:ln>
                  <a:solidFill>
                    <a:srgbClr val="C55A1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7" name="Freeform 110">
                  <a:extLst>
                    <a:ext uri="{FF2B5EF4-FFF2-40B4-BE49-F238E27FC236}">
                      <a16:creationId xmlns:a16="http://schemas.microsoft.com/office/drawing/2014/main" id="{A8D28037-0DE0-45E2-A573-038FF1E33F55}"/>
                    </a:ext>
                  </a:extLst>
                </p:cNvPr>
                <p:cNvSpPr/>
                <p:nvPr/>
              </p:nvSpPr>
              <p:spPr>
                <a:xfrm flipH="1">
                  <a:off x="4671903" y="5004933"/>
                  <a:ext cx="2965420" cy="922177"/>
                </a:xfrm>
                <a:custGeom>
                  <a:avLst/>
                  <a:gdLst>
                    <a:gd name="connsiteX0" fmla="*/ 111125 w 3181470"/>
                    <a:gd name="connsiteY0" fmla="*/ 882650 h 912615"/>
                    <a:gd name="connsiteX1" fmla="*/ 241300 w 3181470"/>
                    <a:gd name="connsiteY1" fmla="*/ 847725 h 912615"/>
                    <a:gd name="connsiteX2" fmla="*/ 381000 w 3181470"/>
                    <a:gd name="connsiteY2" fmla="*/ 854075 h 912615"/>
                    <a:gd name="connsiteX3" fmla="*/ 469900 w 3181470"/>
                    <a:gd name="connsiteY3" fmla="*/ 866775 h 912615"/>
                    <a:gd name="connsiteX4" fmla="*/ 542925 w 3181470"/>
                    <a:gd name="connsiteY4" fmla="*/ 869950 h 912615"/>
                    <a:gd name="connsiteX5" fmla="*/ 654050 w 3181470"/>
                    <a:gd name="connsiteY5" fmla="*/ 860425 h 912615"/>
                    <a:gd name="connsiteX6" fmla="*/ 733425 w 3181470"/>
                    <a:gd name="connsiteY6" fmla="*/ 838200 h 912615"/>
                    <a:gd name="connsiteX7" fmla="*/ 825500 w 3181470"/>
                    <a:gd name="connsiteY7" fmla="*/ 819150 h 912615"/>
                    <a:gd name="connsiteX8" fmla="*/ 981075 w 3181470"/>
                    <a:gd name="connsiteY8" fmla="*/ 812800 h 912615"/>
                    <a:gd name="connsiteX9" fmla="*/ 1177925 w 3181470"/>
                    <a:gd name="connsiteY9" fmla="*/ 838200 h 912615"/>
                    <a:gd name="connsiteX10" fmla="*/ 1365250 w 3181470"/>
                    <a:gd name="connsiteY10" fmla="*/ 904875 h 912615"/>
                    <a:gd name="connsiteX11" fmla="*/ 1498600 w 3181470"/>
                    <a:gd name="connsiteY11" fmla="*/ 908050 h 912615"/>
                    <a:gd name="connsiteX12" fmla="*/ 1657350 w 3181470"/>
                    <a:gd name="connsiteY12" fmla="*/ 876300 h 912615"/>
                    <a:gd name="connsiteX13" fmla="*/ 1749425 w 3181470"/>
                    <a:gd name="connsiteY13" fmla="*/ 844550 h 912615"/>
                    <a:gd name="connsiteX14" fmla="*/ 1793875 w 3181470"/>
                    <a:gd name="connsiteY14" fmla="*/ 819150 h 912615"/>
                    <a:gd name="connsiteX15" fmla="*/ 1857375 w 3181470"/>
                    <a:gd name="connsiteY15" fmla="*/ 793750 h 912615"/>
                    <a:gd name="connsiteX16" fmla="*/ 1911350 w 3181470"/>
                    <a:gd name="connsiteY16" fmla="*/ 796925 h 912615"/>
                    <a:gd name="connsiteX17" fmla="*/ 2060575 w 3181470"/>
                    <a:gd name="connsiteY17" fmla="*/ 819150 h 912615"/>
                    <a:gd name="connsiteX18" fmla="*/ 2162175 w 3181470"/>
                    <a:gd name="connsiteY18" fmla="*/ 822325 h 912615"/>
                    <a:gd name="connsiteX19" fmla="*/ 2266950 w 3181470"/>
                    <a:gd name="connsiteY19" fmla="*/ 841375 h 912615"/>
                    <a:gd name="connsiteX20" fmla="*/ 2371725 w 3181470"/>
                    <a:gd name="connsiteY20" fmla="*/ 873125 h 912615"/>
                    <a:gd name="connsiteX21" fmla="*/ 2501900 w 3181470"/>
                    <a:gd name="connsiteY21" fmla="*/ 860425 h 912615"/>
                    <a:gd name="connsiteX22" fmla="*/ 2597150 w 3181470"/>
                    <a:gd name="connsiteY22" fmla="*/ 838200 h 912615"/>
                    <a:gd name="connsiteX23" fmla="*/ 2644775 w 3181470"/>
                    <a:gd name="connsiteY23" fmla="*/ 815975 h 912615"/>
                    <a:gd name="connsiteX24" fmla="*/ 2714625 w 3181470"/>
                    <a:gd name="connsiteY24" fmla="*/ 819150 h 912615"/>
                    <a:gd name="connsiteX25" fmla="*/ 2771775 w 3181470"/>
                    <a:gd name="connsiteY25" fmla="*/ 806450 h 912615"/>
                    <a:gd name="connsiteX26" fmla="*/ 2819400 w 3181470"/>
                    <a:gd name="connsiteY26" fmla="*/ 787400 h 912615"/>
                    <a:gd name="connsiteX27" fmla="*/ 2841625 w 3181470"/>
                    <a:gd name="connsiteY27" fmla="*/ 771525 h 912615"/>
                    <a:gd name="connsiteX28" fmla="*/ 2876550 w 3181470"/>
                    <a:gd name="connsiteY28" fmla="*/ 787400 h 912615"/>
                    <a:gd name="connsiteX29" fmla="*/ 2914650 w 3181470"/>
                    <a:gd name="connsiteY29" fmla="*/ 822325 h 912615"/>
                    <a:gd name="connsiteX30" fmla="*/ 2994025 w 3181470"/>
                    <a:gd name="connsiteY30" fmla="*/ 847725 h 912615"/>
                    <a:gd name="connsiteX31" fmla="*/ 3070225 w 3181470"/>
                    <a:gd name="connsiteY31" fmla="*/ 841375 h 912615"/>
                    <a:gd name="connsiteX32" fmla="*/ 3130550 w 3181470"/>
                    <a:gd name="connsiteY32" fmla="*/ 800100 h 912615"/>
                    <a:gd name="connsiteX33" fmla="*/ 3146425 w 3181470"/>
                    <a:gd name="connsiteY33" fmla="*/ 762000 h 912615"/>
                    <a:gd name="connsiteX34" fmla="*/ 3175000 w 3181470"/>
                    <a:gd name="connsiteY34" fmla="*/ 695325 h 912615"/>
                    <a:gd name="connsiteX35" fmla="*/ 3181350 w 3181470"/>
                    <a:gd name="connsiteY35" fmla="*/ 628650 h 912615"/>
                    <a:gd name="connsiteX36" fmla="*/ 3171825 w 3181470"/>
                    <a:gd name="connsiteY36" fmla="*/ 584200 h 912615"/>
                    <a:gd name="connsiteX37" fmla="*/ 3146425 w 3181470"/>
                    <a:gd name="connsiteY37" fmla="*/ 539750 h 912615"/>
                    <a:gd name="connsiteX38" fmla="*/ 3133725 w 3181470"/>
                    <a:gd name="connsiteY38" fmla="*/ 485775 h 912615"/>
                    <a:gd name="connsiteX39" fmla="*/ 3124200 w 3181470"/>
                    <a:gd name="connsiteY39" fmla="*/ 425450 h 912615"/>
                    <a:gd name="connsiteX40" fmla="*/ 3114675 w 3181470"/>
                    <a:gd name="connsiteY40" fmla="*/ 374650 h 912615"/>
                    <a:gd name="connsiteX41" fmla="*/ 3082925 w 3181470"/>
                    <a:gd name="connsiteY41" fmla="*/ 311150 h 912615"/>
                    <a:gd name="connsiteX42" fmla="*/ 3073400 w 3181470"/>
                    <a:gd name="connsiteY42" fmla="*/ 307975 h 912615"/>
                    <a:gd name="connsiteX43" fmla="*/ 3044825 w 3181470"/>
                    <a:gd name="connsiteY43" fmla="*/ 295275 h 912615"/>
                    <a:gd name="connsiteX44" fmla="*/ 2997200 w 3181470"/>
                    <a:gd name="connsiteY44" fmla="*/ 279400 h 912615"/>
                    <a:gd name="connsiteX45" fmla="*/ 2965450 w 3181470"/>
                    <a:gd name="connsiteY45" fmla="*/ 247650 h 912615"/>
                    <a:gd name="connsiteX46" fmla="*/ 2949575 w 3181470"/>
                    <a:gd name="connsiteY46" fmla="*/ 225425 h 912615"/>
                    <a:gd name="connsiteX47" fmla="*/ 2933700 w 3181470"/>
                    <a:gd name="connsiteY47" fmla="*/ 200025 h 912615"/>
                    <a:gd name="connsiteX48" fmla="*/ 2892425 w 3181470"/>
                    <a:gd name="connsiteY48" fmla="*/ 152400 h 912615"/>
                    <a:gd name="connsiteX49" fmla="*/ 2876550 w 3181470"/>
                    <a:gd name="connsiteY49" fmla="*/ 139700 h 912615"/>
                    <a:gd name="connsiteX50" fmla="*/ 2851150 w 3181470"/>
                    <a:gd name="connsiteY50" fmla="*/ 104775 h 912615"/>
                    <a:gd name="connsiteX51" fmla="*/ 2813050 w 3181470"/>
                    <a:gd name="connsiteY51" fmla="*/ 57150 h 912615"/>
                    <a:gd name="connsiteX52" fmla="*/ 2784475 w 3181470"/>
                    <a:gd name="connsiteY52" fmla="*/ 28575 h 912615"/>
                    <a:gd name="connsiteX53" fmla="*/ 2746375 w 3181470"/>
                    <a:gd name="connsiteY53" fmla="*/ 15875 h 912615"/>
                    <a:gd name="connsiteX54" fmla="*/ 2686050 w 3181470"/>
                    <a:gd name="connsiteY54" fmla="*/ 6350 h 912615"/>
                    <a:gd name="connsiteX55" fmla="*/ 2619375 w 3181470"/>
                    <a:gd name="connsiteY55" fmla="*/ 0 h 912615"/>
                    <a:gd name="connsiteX56" fmla="*/ 2590800 w 3181470"/>
                    <a:gd name="connsiteY56" fmla="*/ 6350 h 912615"/>
                    <a:gd name="connsiteX57" fmla="*/ 2552700 w 3181470"/>
                    <a:gd name="connsiteY57" fmla="*/ 19050 h 912615"/>
                    <a:gd name="connsiteX58" fmla="*/ 2501900 w 3181470"/>
                    <a:gd name="connsiteY58" fmla="*/ 41275 h 912615"/>
                    <a:gd name="connsiteX59" fmla="*/ 2482850 w 3181470"/>
                    <a:gd name="connsiteY59" fmla="*/ 76200 h 912615"/>
                    <a:gd name="connsiteX60" fmla="*/ 2476500 w 3181470"/>
                    <a:gd name="connsiteY60" fmla="*/ 107950 h 912615"/>
                    <a:gd name="connsiteX61" fmla="*/ 2486025 w 3181470"/>
                    <a:gd name="connsiteY61" fmla="*/ 136525 h 912615"/>
                    <a:gd name="connsiteX62" fmla="*/ 2489200 w 3181470"/>
                    <a:gd name="connsiteY62" fmla="*/ 152400 h 912615"/>
                    <a:gd name="connsiteX63" fmla="*/ 2536825 w 3181470"/>
                    <a:gd name="connsiteY63" fmla="*/ 155575 h 912615"/>
                    <a:gd name="connsiteX64" fmla="*/ 2552700 w 3181470"/>
                    <a:gd name="connsiteY64" fmla="*/ 155575 h 912615"/>
                    <a:gd name="connsiteX65" fmla="*/ 2581275 w 3181470"/>
                    <a:gd name="connsiteY65" fmla="*/ 146050 h 912615"/>
                    <a:gd name="connsiteX66" fmla="*/ 2593975 w 3181470"/>
                    <a:gd name="connsiteY66" fmla="*/ 133350 h 912615"/>
                    <a:gd name="connsiteX67" fmla="*/ 2609850 w 3181470"/>
                    <a:gd name="connsiteY67" fmla="*/ 120650 h 912615"/>
                    <a:gd name="connsiteX68" fmla="*/ 2651125 w 3181470"/>
                    <a:gd name="connsiteY68" fmla="*/ 123825 h 912615"/>
                    <a:gd name="connsiteX69" fmla="*/ 2676525 w 3181470"/>
                    <a:gd name="connsiteY69" fmla="*/ 142875 h 912615"/>
                    <a:gd name="connsiteX70" fmla="*/ 2714625 w 3181470"/>
                    <a:gd name="connsiteY70" fmla="*/ 171450 h 912615"/>
                    <a:gd name="connsiteX71" fmla="*/ 2743200 w 3181470"/>
                    <a:gd name="connsiteY71" fmla="*/ 206375 h 912615"/>
                    <a:gd name="connsiteX72" fmla="*/ 2784475 w 3181470"/>
                    <a:gd name="connsiteY72" fmla="*/ 276225 h 912615"/>
                    <a:gd name="connsiteX73" fmla="*/ 2800350 w 3181470"/>
                    <a:gd name="connsiteY73" fmla="*/ 311150 h 912615"/>
                    <a:gd name="connsiteX74" fmla="*/ 2813050 w 3181470"/>
                    <a:gd name="connsiteY74" fmla="*/ 352425 h 912615"/>
                    <a:gd name="connsiteX75" fmla="*/ 2825750 w 3181470"/>
                    <a:gd name="connsiteY75" fmla="*/ 390525 h 912615"/>
                    <a:gd name="connsiteX76" fmla="*/ 2828925 w 3181470"/>
                    <a:gd name="connsiteY76" fmla="*/ 409575 h 912615"/>
                    <a:gd name="connsiteX77" fmla="*/ 2828925 w 3181470"/>
                    <a:gd name="connsiteY77" fmla="*/ 431800 h 912615"/>
                    <a:gd name="connsiteX78" fmla="*/ 2832100 w 3181470"/>
                    <a:gd name="connsiteY78" fmla="*/ 466725 h 912615"/>
                    <a:gd name="connsiteX79" fmla="*/ 2835275 w 3181470"/>
                    <a:gd name="connsiteY79" fmla="*/ 495300 h 912615"/>
                    <a:gd name="connsiteX80" fmla="*/ 2838450 w 3181470"/>
                    <a:gd name="connsiteY80" fmla="*/ 520700 h 912615"/>
                    <a:gd name="connsiteX81" fmla="*/ 2838450 w 3181470"/>
                    <a:gd name="connsiteY81" fmla="*/ 549275 h 912615"/>
                    <a:gd name="connsiteX82" fmla="*/ 2835275 w 3181470"/>
                    <a:gd name="connsiteY82" fmla="*/ 561975 h 912615"/>
                    <a:gd name="connsiteX83" fmla="*/ 2828925 w 3181470"/>
                    <a:gd name="connsiteY83" fmla="*/ 574675 h 912615"/>
                    <a:gd name="connsiteX84" fmla="*/ 2819400 w 3181470"/>
                    <a:gd name="connsiteY84" fmla="*/ 593725 h 912615"/>
                    <a:gd name="connsiteX85" fmla="*/ 2816225 w 3181470"/>
                    <a:gd name="connsiteY85" fmla="*/ 609600 h 912615"/>
                    <a:gd name="connsiteX86" fmla="*/ 2816225 w 3181470"/>
                    <a:gd name="connsiteY86" fmla="*/ 625475 h 912615"/>
                    <a:gd name="connsiteX87" fmla="*/ 2819400 w 3181470"/>
                    <a:gd name="connsiteY87" fmla="*/ 638175 h 912615"/>
                    <a:gd name="connsiteX88" fmla="*/ 2819400 w 3181470"/>
                    <a:gd name="connsiteY88" fmla="*/ 638175 h 912615"/>
                    <a:gd name="connsiteX89" fmla="*/ 2768600 w 3181470"/>
                    <a:gd name="connsiteY89" fmla="*/ 657225 h 912615"/>
                    <a:gd name="connsiteX90" fmla="*/ 2717800 w 3181470"/>
                    <a:gd name="connsiteY90" fmla="*/ 666750 h 912615"/>
                    <a:gd name="connsiteX91" fmla="*/ 2670175 w 3181470"/>
                    <a:gd name="connsiteY91" fmla="*/ 673100 h 912615"/>
                    <a:gd name="connsiteX92" fmla="*/ 2644775 w 3181470"/>
                    <a:gd name="connsiteY92" fmla="*/ 673100 h 912615"/>
                    <a:gd name="connsiteX93" fmla="*/ 2606675 w 3181470"/>
                    <a:gd name="connsiteY93" fmla="*/ 673100 h 912615"/>
                    <a:gd name="connsiteX94" fmla="*/ 2568575 w 3181470"/>
                    <a:gd name="connsiteY94" fmla="*/ 669925 h 912615"/>
                    <a:gd name="connsiteX95" fmla="*/ 2552700 w 3181470"/>
                    <a:gd name="connsiteY95" fmla="*/ 673100 h 912615"/>
                    <a:gd name="connsiteX96" fmla="*/ 2527300 w 3181470"/>
                    <a:gd name="connsiteY96" fmla="*/ 685800 h 912615"/>
                    <a:gd name="connsiteX97" fmla="*/ 2505075 w 3181470"/>
                    <a:gd name="connsiteY97" fmla="*/ 695325 h 912615"/>
                    <a:gd name="connsiteX98" fmla="*/ 2460625 w 3181470"/>
                    <a:gd name="connsiteY98" fmla="*/ 704850 h 912615"/>
                    <a:gd name="connsiteX99" fmla="*/ 2416175 w 3181470"/>
                    <a:gd name="connsiteY99" fmla="*/ 714375 h 912615"/>
                    <a:gd name="connsiteX100" fmla="*/ 2368550 w 3181470"/>
                    <a:gd name="connsiteY100" fmla="*/ 720725 h 912615"/>
                    <a:gd name="connsiteX101" fmla="*/ 2336800 w 3181470"/>
                    <a:gd name="connsiteY101" fmla="*/ 708025 h 912615"/>
                    <a:gd name="connsiteX102" fmla="*/ 2273300 w 3181470"/>
                    <a:gd name="connsiteY102" fmla="*/ 695325 h 912615"/>
                    <a:gd name="connsiteX103" fmla="*/ 2235200 w 3181470"/>
                    <a:gd name="connsiteY103" fmla="*/ 688975 h 912615"/>
                    <a:gd name="connsiteX104" fmla="*/ 2193925 w 3181470"/>
                    <a:gd name="connsiteY104" fmla="*/ 682625 h 912615"/>
                    <a:gd name="connsiteX105" fmla="*/ 2136775 w 3181470"/>
                    <a:gd name="connsiteY105" fmla="*/ 673100 h 912615"/>
                    <a:gd name="connsiteX106" fmla="*/ 2098675 w 3181470"/>
                    <a:gd name="connsiteY106" fmla="*/ 666750 h 912615"/>
                    <a:gd name="connsiteX107" fmla="*/ 2051050 w 3181470"/>
                    <a:gd name="connsiteY107" fmla="*/ 657225 h 912615"/>
                    <a:gd name="connsiteX108" fmla="*/ 1936750 w 3181470"/>
                    <a:gd name="connsiteY108" fmla="*/ 650875 h 912615"/>
                    <a:gd name="connsiteX109" fmla="*/ 1876425 w 3181470"/>
                    <a:gd name="connsiteY109" fmla="*/ 654050 h 912615"/>
                    <a:gd name="connsiteX110" fmla="*/ 1790700 w 3181470"/>
                    <a:gd name="connsiteY110" fmla="*/ 657225 h 912615"/>
                    <a:gd name="connsiteX111" fmla="*/ 1752600 w 3181470"/>
                    <a:gd name="connsiteY111" fmla="*/ 663575 h 912615"/>
                    <a:gd name="connsiteX112" fmla="*/ 1708150 w 3181470"/>
                    <a:gd name="connsiteY112" fmla="*/ 685800 h 912615"/>
                    <a:gd name="connsiteX113" fmla="*/ 1651000 w 3181470"/>
                    <a:gd name="connsiteY113" fmla="*/ 708025 h 912615"/>
                    <a:gd name="connsiteX114" fmla="*/ 1606550 w 3181470"/>
                    <a:gd name="connsiteY114" fmla="*/ 730250 h 912615"/>
                    <a:gd name="connsiteX115" fmla="*/ 1539875 w 3181470"/>
                    <a:gd name="connsiteY115" fmla="*/ 733425 h 912615"/>
                    <a:gd name="connsiteX116" fmla="*/ 1492250 w 3181470"/>
                    <a:gd name="connsiteY116" fmla="*/ 733425 h 912615"/>
                    <a:gd name="connsiteX117" fmla="*/ 1473200 w 3181470"/>
                    <a:gd name="connsiteY117" fmla="*/ 733425 h 912615"/>
                    <a:gd name="connsiteX118" fmla="*/ 1444625 w 3181470"/>
                    <a:gd name="connsiteY118" fmla="*/ 768350 h 912615"/>
                    <a:gd name="connsiteX119" fmla="*/ 1374775 w 3181470"/>
                    <a:gd name="connsiteY119" fmla="*/ 768350 h 912615"/>
                    <a:gd name="connsiteX120" fmla="*/ 1263650 w 3181470"/>
                    <a:gd name="connsiteY120" fmla="*/ 742950 h 912615"/>
                    <a:gd name="connsiteX121" fmla="*/ 1190625 w 3181470"/>
                    <a:gd name="connsiteY121" fmla="*/ 727075 h 912615"/>
                    <a:gd name="connsiteX122" fmla="*/ 1050925 w 3181470"/>
                    <a:gd name="connsiteY122" fmla="*/ 695325 h 912615"/>
                    <a:gd name="connsiteX123" fmla="*/ 981075 w 3181470"/>
                    <a:gd name="connsiteY123" fmla="*/ 692150 h 912615"/>
                    <a:gd name="connsiteX124" fmla="*/ 889000 w 3181470"/>
                    <a:gd name="connsiteY124" fmla="*/ 688975 h 912615"/>
                    <a:gd name="connsiteX125" fmla="*/ 835025 w 3181470"/>
                    <a:gd name="connsiteY125" fmla="*/ 692150 h 912615"/>
                    <a:gd name="connsiteX126" fmla="*/ 796925 w 3181470"/>
                    <a:gd name="connsiteY126" fmla="*/ 704850 h 912615"/>
                    <a:gd name="connsiteX127" fmla="*/ 733425 w 3181470"/>
                    <a:gd name="connsiteY127" fmla="*/ 717550 h 912615"/>
                    <a:gd name="connsiteX128" fmla="*/ 698500 w 3181470"/>
                    <a:gd name="connsiteY128" fmla="*/ 730250 h 912615"/>
                    <a:gd name="connsiteX129" fmla="*/ 568325 w 3181470"/>
                    <a:gd name="connsiteY129" fmla="*/ 723900 h 912615"/>
                    <a:gd name="connsiteX130" fmla="*/ 536575 w 3181470"/>
                    <a:gd name="connsiteY130" fmla="*/ 723900 h 912615"/>
                    <a:gd name="connsiteX131" fmla="*/ 422275 w 3181470"/>
                    <a:gd name="connsiteY131" fmla="*/ 711200 h 912615"/>
                    <a:gd name="connsiteX132" fmla="*/ 387350 w 3181470"/>
                    <a:gd name="connsiteY132" fmla="*/ 714375 h 912615"/>
                    <a:gd name="connsiteX133" fmla="*/ 365125 w 3181470"/>
                    <a:gd name="connsiteY133" fmla="*/ 723900 h 912615"/>
                    <a:gd name="connsiteX134" fmla="*/ 254000 w 3181470"/>
                    <a:gd name="connsiteY134" fmla="*/ 708025 h 912615"/>
                    <a:gd name="connsiteX135" fmla="*/ 234950 w 3181470"/>
                    <a:gd name="connsiteY135" fmla="*/ 708025 h 912615"/>
                    <a:gd name="connsiteX136" fmla="*/ 168275 w 3181470"/>
                    <a:gd name="connsiteY136" fmla="*/ 708025 h 912615"/>
                    <a:gd name="connsiteX137" fmla="*/ 152400 w 3181470"/>
                    <a:gd name="connsiteY137" fmla="*/ 711200 h 912615"/>
                    <a:gd name="connsiteX138" fmla="*/ 120650 w 3181470"/>
                    <a:gd name="connsiteY138" fmla="*/ 723900 h 912615"/>
                    <a:gd name="connsiteX139" fmla="*/ 92075 w 3181470"/>
                    <a:gd name="connsiteY139" fmla="*/ 733425 h 912615"/>
                    <a:gd name="connsiteX140" fmla="*/ 66675 w 3181470"/>
                    <a:gd name="connsiteY140" fmla="*/ 739775 h 912615"/>
                    <a:gd name="connsiteX141" fmla="*/ 25400 w 3181470"/>
                    <a:gd name="connsiteY141" fmla="*/ 749300 h 912615"/>
                    <a:gd name="connsiteX142" fmla="*/ 12700 w 3181470"/>
                    <a:gd name="connsiteY142" fmla="*/ 752475 h 912615"/>
                    <a:gd name="connsiteX143" fmla="*/ 0 w 3181470"/>
                    <a:gd name="connsiteY143" fmla="*/ 762000 h 912615"/>
                    <a:gd name="connsiteX0" fmla="*/ 103297 w 3173642"/>
                    <a:gd name="connsiteY0" fmla="*/ 882650 h 912615"/>
                    <a:gd name="connsiteX1" fmla="*/ 233472 w 3173642"/>
                    <a:gd name="connsiteY1" fmla="*/ 847725 h 912615"/>
                    <a:gd name="connsiteX2" fmla="*/ 373172 w 3173642"/>
                    <a:gd name="connsiteY2" fmla="*/ 854075 h 912615"/>
                    <a:gd name="connsiteX3" fmla="*/ 462072 w 3173642"/>
                    <a:gd name="connsiteY3" fmla="*/ 866775 h 912615"/>
                    <a:gd name="connsiteX4" fmla="*/ 535097 w 3173642"/>
                    <a:gd name="connsiteY4" fmla="*/ 869950 h 912615"/>
                    <a:gd name="connsiteX5" fmla="*/ 646222 w 3173642"/>
                    <a:gd name="connsiteY5" fmla="*/ 860425 h 912615"/>
                    <a:gd name="connsiteX6" fmla="*/ 725597 w 3173642"/>
                    <a:gd name="connsiteY6" fmla="*/ 838200 h 912615"/>
                    <a:gd name="connsiteX7" fmla="*/ 817672 w 3173642"/>
                    <a:gd name="connsiteY7" fmla="*/ 819150 h 912615"/>
                    <a:gd name="connsiteX8" fmla="*/ 973247 w 3173642"/>
                    <a:gd name="connsiteY8" fmla="*/ 812800 h 912615"/>
                    <a:gd name="connsiteX9" fmla="*/ 1170097 w 3173642"/>
                    <a:gd name="connsiteY9" fmla="*/ 838200 h 912615"/>
                    <a:gd name="connsiteX10" fmla="*/ 1357422 w 3173642"/>
                    <a:gd name="connsiteY10" fmla="*/ 904875 h 912615"/>
                    <a:gd name="connsiteX11" fmla="*/ 1490772 w 3173642"/>
                    <a:gd name="connsiteY11" fmla="*/ 908050 h 912615"/>
                    <a:gd name="connsiteX12" fmla="*/ 1649522 w 3173642"/>
                    <a:gd name="connsiteY12" fmla="*/ 876300 h 912615"/>
                    <a:gd name="connsiteX13" fmla="*/ 1741597 w 3173642"/>
                    <a:gd name="connsiteY13" fmla="*/ 844550 h 912615"/>
                    <a:gd name="connsiteX14" fmla="*/ 1786047 w 3173642"/>
                    <a:gd name="connsiteY14" fmla="*/ 819150 h 912615"/>
                    <a:gd name="connsiteX15" fmla="*/ 1849547 w 3173642"/>
                    <a:gd name="connsiteY15" fmla="*/ 793750 h 912615"/>
                    <a:gd name="connsiteX16" fmla="*/ 1903522 w 3173642"/>
                    <a:gd name="connsiteY16" fmla="*/ 796925 h 912615"/>
                    <a:gd name="connsiteX17" fmla="*/ 2052747 w 3173642"/>
                    <a:gd name="connsiteY17" fmla="*/ 819150 h 912615"/>
                    <a:gd name="connsiteX18" fmla="*/ 2154347 w 3173642"/>
                    <a:gd name="connsiteY18" fmla="*/ 822325 h 912615"/>
                    <a:gd name="connsiteX19" fmla="*/ 2259122 w 3173642"/>
                    <a:gd name="connsiteY19" fmla="*/ 841375 h 912615"/>
                    <a:gd name="connsiteX20" fmla="*/ 2363897 w 3173642"/>
                    <a:gd name="connsiteY20" fmla="*/ 873125 h 912615"/>
                    <a:gd name="connsiteX21" fmla="*/ 2494072 w 3173642"/>
                    <a:gd name="connsiteY21" fmla="*/ 860425 h 912615"/>
                    <a:gd name="connsiteX22" fmla="*/ 2589322 w 3173642"/>
                    <a:gd name="connsiteY22" fmla="*/ 838200 h 912615"/>
                    <a:gd name="connsiteX23" fmla="*/ 2636947 w 3173642"/>
                    <a:gd name="connsiteY23" fmla="*/ 815975 h 912615"/>
                    <a:gd name="connsiteX24" fmla="*/ 2706797 w 3173642"/>
                    <a:gd name="connsiteY24" fmla="*/ 819150 h 912615"/>
                    <a:gd name="connsiteX25" fmla="*/ 2763947 w 3173642"/>
                    <a:gd name="connsiteY25" fmla="*/ 806450 h 912615"/>
                    <a:gd name="connsiteX26" fmla="*/ 2811572 w 3173642"/>
                    <a:gd name="connsiteY26" fmla="*/ 787400 h 912615"/>
                    <a:gd name="connsiteX27" fmla="*/ 2833797 w 3173642"/>
                    <a:gd name="connsiteY27" fmla="*/ 771525 h 912615"/>
                    <a:gd name="connsiteX28" fmla="*/ 2868722 w 3173642"/>
                    <a:gd name="connsiteY28" fmla="*/ 787400 h 912615"/>
                    <a:gd name="connsiteX29" fmla="*/ 2906822 w 3173642"/>
                    <a:gd name="connsiteY29" fmla="*/ 822325 h 912615"/>
                    <a:gd name="connsiteX30" fmla="*/ 2986197 w 3173642"/>
                    <a:gd name="connsiteY30" fmla="*/ 847725 h 912615"/>
                    <a:gd name="connsiteX31" fmla="*/ 3062397 w 3173642"/>
                    <a:gd name="connsiteY31" fmla="*/ 841375 h 912615"/>
                    <a:gd name="connsiteX32" fmla="*/ 3122722 w 3173642"/>
                    <a:gd name="connsiteY32" fmla="*/ 800100 h 912615"/>
                    <a:gd name="connsiteX33" fmla="*/ 3138597 w 3173642"/>
                    <a:gd name="connsiteY33" fmla="*/ 762000 h 912615"/>
                    <a:gd name="connsiteX34" fmla="*/ 3167172 w 3173642"/>
                    <a:gd name="connsiteY34" fmla="*/ 695325 h 912615"/>
                    <a:gd name="connsiteX35" fmla="*/ 3173522 w 3173642"/>
                    <a:gd name="connsiteY35" fmla="*/ 628650 h 912615"/>
                    <a:gd name="connsiteX36" fmla="*/ 3163997 w 3173642"/>
                    <a:gd name="connsiteY36" fmla="*/ 584200 h 912615"/>
                    <a:gd name="connsiteX37" fmla="*/ 3138597 w 3173642"/>
                    <a:gd name="connsiteY37" fmla="*/ 539750 h 912615"/>
                    <a:gd name="connsiteX38" fmla="*/ 3125897 w 3173642"/>
                    <a:gd name="connsiteY38" fmla="*/ 485775 h 912615"/>
                    <a:gd name="connsiteX39" fmla="*/ 3116372 w 3173642"/>
                    <a:gd name="connsiteY39" fmla="*/ 425450 h 912615"/>
                    <a:gd name="connsiteX40" fmla="*/ 3106847 w 3173642"/>
                    <a:gd name="connsiteY40" fmla="*/ 374650 h 912615"/>
                    <a:gd name="connsiteX41" fmla="*/ 3075097 w 3173642"/>
                    <a:gd name="connsiteY41" fmla="*/ 311150 h 912615"/>
                    <a:gd name="connsiteX42" fmla="*/ 3065572 w 3173642"/>
                    <a:gd name="connsiteY42" fmla="*/ 307975 h 912615"/>
                    <a:gd name="connsiteX43" fmla="*/ 3036997 w 3173642"/>
                    <a:gd name="connsiteY43" fmla="*/ 295275 h 912615"/>
                    <a:gd name="connsiteX44" fmla="*/ 2989372 w 3173642"/>
                    <a:gd name="connsiteY44" fmla="*/ 279400 h 912615"/>
                    <a:gd name="connsiteX45" fmla="*/ 2957622 w 3173642"/>
                    <a:gd name="connsiteY45" fmla="*/ 247650 h 912615"/>
                    <a:gd name="connsiteX46" fmla="*/ 2941747 w 3173642"/>
                    <a:gd name="connsiteY46" fmla="*/ 225425 h 912615"/>
                    <a:gd name="connsiteX47" fmla="*/ 2925872 w 3173642"/>
                    <a:gd name="connsiteY47" fmla="*/ 200025 h 912615"/>
                    <a:gd name="connsiteX48" fmla="*/ 2884597 w 3173642"/>
                    <a:gd name="connsiteY48" fmla="*/ 152400 h 912615"/>
                    <a:gd name="connsiteX49" fmla="*/ 2868722 w 3173642"/>
                    <a:gd name="connsiteY49" fmla="*/ 139700 h 912615"/>
                    <a:gd name="connsiteX50" fmla="*/ 2843322 w 3173642"/>
                    <a:gd name="connsiteY50" fmla="*/ 104775 h 912615"/>
                    <a:gd name="connsiteX51" fmla="*/ 2805222 w 3173642"/>
                    <a:gd name="connsiteY51" fmla="*/ 57150 h 912615"/>
                    <a:gd name="connsiteX52" fmla="*/ 2776647 w 3173642"/>
                    <a:gd name="connsiteY52" fmla="*/ 28575 h 912615"/>
                    <a:gd name="connsiteX53" fmla="*/ 2738547 w 3173642"/>
                    <a:gd name="connsiteY53" fmla="*/ 15875 h 912615"/>
                    <a:gd name="connsiteX54" fmla="*/ 2678222 w 3173642"/>
                    <a:gd name="connsiteY54" fmla="*/ 6350 h 912615"/>
                    <a:gd name="connsiteX55" fmla="*/ 2611547 w 3173642"/>
                    <a:gd name="connsiteY55" fmla="*/ 0 h 912615"/>
                    <a:gd name="connsiteX56" fmla="*/ 2582972 w 3173642"/>
                    <a:gd name="connsiteY56" fmla="*/ 6350 h 912615"/>
                    <a:gd name="connsiteX57" fmla="*/ 2544872 w 3173642"/>
                    <a:gd name="connsiteY57" fmla="*/ 19050 h 912615"/>
                    <a:gd name="connsiteX58" fmla="*/ 2494072 w 3173642"/>
                    <a:gd name="connsiteY58" fmla="*/ 41275 h 912615"/>
                    <a:gd name="connsiteX59" fmla="*/ 2475022 w 3173642"/>
                    <a:gd name="connsiteY59" fmla="*/ 76200 h 912615"/>
                    <a:gd name="connsiteX60" fmla="*/ 2468672 w 3173642"/>
                    <a:gd name="connsiteY60" fmla="*/ 107950 h 912615"/>
                    <a:gd name="connsiteX61" fmla="*/ 2478197 w 3173642"/>
                    <a:gd name="connsiteY61" fmla="*/ 136525 h 912615"/>
                    <a:gd name="connsiteX62" fmla="*/ 2481372 w 3173642"/>
                    <a:gd name="connsiteY62" fmla="*/ 152400 h 912615"/>
                    <a:gd name="connsiteX63" fmla="*/ 2528997 w 3173642"/>
                    <a:gd name="connsiteY63" fmla="*/ 155575 h 912615"/>
                    <a:gd name="connsiteX64" fmla="*/ 2544872 w 3173642"/>
                    <a:gd name="connsiteY64" fmla="*/ 155575 h 912615"/>
                    <a:gd name="connsiteX65" fmla="*/ 2573447 w 3173642"/>
                    <a:gd name="connsiteY65" fmla="*/ 146050 h 912615"/>
                    <a:gd name="connsiteX66" fmla="*/ 2586147 w 3173642"/>
                    <a:gd name="connsiteY66" fmla="*/ 133350 h 912615"/>
                    <a:gd name="connsiteX67" fmla="*/ 2602022 w 3173642"/>
                    <a:gd name="connsiteY67" fmla="*/ 120650 h 912615"/>
                    <a:gd name="connsiteX68" fmla="*/ 2643297 w 3173642"/>
                    <a:gd name="connsiteY68" fmla="*/ 123825 h 912615"/>
                    <a:gd name="connsiteX69" fmla="*/ 2668697 w 3173642"/>
                    <a:gd name="connsiteY69" fmla="*/ 142875 h 912615"/>
                    <a:gd name="connsiteX70" fmla="*/ 2706797 w 3173642"/>
                    <a:gd name="connsiteY70" fmla="*/ 171450 h 912615"/>
                    <a:gd name="connsiteX71" fmla="*/ 2735372 w 3173642"/>
                    <a:gd name="connsiteY71" fmla="*/ 206375 h 912615"/>
                    <a:gd name="connsiteX72" fmla="*/ 2776647 w 3173642"/>
                    <a:gd name="connsiteY72" fmla="*/ 276225 h 912615"/>
                    <a:gd name="connsiteX73" fmla="*/ 2792522 w 3173642"/>
                    <a:gd name="connsiteY73" fmla="*/ 311150 h 912615"/>
                    <a:gd name="connsiteX74" fmla="*/ 2805222 w 3173642"/>
                    <a:gd name="connsiteY74" fmla="*/ 352425 h 912615"/>
                    <a:gd name="connsiteX75" fmla="*/ 2817922 w 3173642"/>
                    <a:gd name="connsiteY75" fmla="*/ 390525 h 912615"/>
                    <a:gd name="connsiteX76" fmla="*/ 2821097 w 3173642"/>
                    <a:gd name="connsiteY76" fmla="*/ 409575 h 912615"/>
                    <a:gd name="connsiteX77" fmla="*/ 2821097 w 3173642"/>
                    <a:gd name="connsiteY77" fmla="*/ 431800 h 912615"/>
                    <a:gd name="connsiteX78" fmla="*/ 2824272 w 3173642"/>
                    <a:gd name="connsiteY78" fmla="*/ 466725 h 912615"/>
                    <a:gd name="connsiteX79" fmla="*/ 2827447 w 3173642"/>
                    <a:gd name="connsiteY79" fmla="*/ 495300 h 912615"/>
                    <a:gd name="connsiteX80" fmla="*/ 2830622 w 3173642"/>
                    <a:gd name="connsiteY80" fmla="*/ 520700 h 912615"/>
                    <a:gd name="connsiteX81" fmla="*/ 2830622 w 3173642"/>
                    <a:gd name="connsiteY81" fmla="*/ 549275 h 912615"/>
                    <a:gd name="connsiteX82" fmla="*/ 2827447 w 3173642"/>
                    <a:gd name="connsiteY82" fmla="*/ 561975 h 912615"/>
                    <a:gd name="connsiteX83" fmla="*/ 2821097 w 3173642"/>
                    <a:gd name="connsiteY83" fmla="*/ 574675 h 912615"/>
                    <a:gd name="connsiteX84" fmla="*/ 2811572 w 3173642"/>
                    <a:gd name="connsiteY84" fmla="*/ 593725 h 912615"/>
                    <a:gd name="connsiteX85" fmla="*/ 2808397 w 3173642"/>
                    <a:gd name="connsiteY85" fmla="*/ 609600 h 912615"/>
                    <a:gd name="connsiteX86" fmla="*/ 2808397 w 3173642"/>
                    <a:gd name="connsiteY86" fmla="*/ 625475 h 912615"/>
                    <a:gd name="connsiteX87" fmla="*/ 2811572 w 3173642"/>
                    <a:gd name="connsiteY87" fmla="*/ 638175 h 912615"/>
                    <a:gd name="connsiteX88" fmla="*/ 2811572 w 3173642"/>
                    <a:gd name="connsiteY88" fmla="*/ 638175 h 912615"/>
                    <a:gd name="connsiteX89" fmla="*/ 2760772 w 3173642"/>
                    <a:gd name="connsiteY89" fmla="*/ 657225 h 912615"/>
                    <a:gd name="connsiteX90" fmla="*/ 2709972 w 3173642"/>
                    <a:gd name="connsiteY90" fmla="*/ 666750 h 912615"/>
                    <a:gd name="connsiteX91" fmla="*/ 2662347 w 3173642"/>
                    <a:gd name="connsiteY91" fmla="*/ 673100 h 912615"/>
                    <a:gd name="connsiteX92" fmla="*/ 2636947 w 3173642"/>
                    <a:gd name="connsiteY92" fmla="*/ 673100 h 912615"/>
                    <a:gd name="connsiteX93" fmla="*/ 2598847 w 3173642"/>
                    <a:gd name="connsiteY93" fmla="*/ 673100 h 912615"/>
                    <a:gd name="connsiteX94" fmla="*/ 2560747 w 3173642"/>
                    <a:gd name="connsiteY94" fmla="*/ 669925 h 912615"/>
                    <a:gd name="connsiteX95" fmla="*/ 2544872 w 3173642"/>
                    <a:gd name="connsiteY95" fmla="*/ 673100 h 912615"/>
                    <a:gd name="connsiteX96" fmla="*/ 2519472 w 3173642"/>
                    <a:gd name="connsiteY96" fmla="*/ 685800 h 912615"/>
                    <a:gd name="connsiteX97" fmla="*/ 2497247 w 3173642"/>
                    <a:gd name="connsiteY97" fmla="*/ 695325 h 912615"/>
                    <a:gd name="connsiteX98" fmla="*/ 2452797 w 3173642"/>
                    <a:gd name="connsiteY98" fmla="*/ 704850 h 912615"/>
                    <a:gd name="connsiteX99" fmla="*/ 2408347 w 3173642"/>
                    <a:gd name="connsiteY99" fmla="*/ 714375 h 912615"/>
                    <a:gd name="connsiteX100" fmla="*/ 2360722 w 3173642"/>
                    <a:gd name="connsiteY100" fmla="*/ 720725 h 912615"/>
                    <a:gd name="connsiteX101" fmla="*/ 2328972 w 3173642"/>
                    <a:gd name="connsiteY101" fmla="*/ 708025 h 912615"/>
                    <a:gd name="connsiteX102" fmla="*/ 2265472 w 3173642"/>
                    <a:gd name="connsiteY102" fmla="*/ 695325 h 912615"/>
                    <a:gd name="connsiteX103" fmla="*/ 2227372 w 3173642"/>
                    <a:gd name="connsiteY103" fmla="*/ 688975 h 912615"/>
                    <a:gd name="connsiteX104" fmla="*/ 2186097 w 3173642"/>
                    <a:gd name="connsiteY104" fmla="*/ 682625 h 912615"/>
                    <a:gd name="connsiteX105" fmla="*/ 2128947 w 3173642"/>
                    <a:gd name="connsiteY105" fmla="*/ 673100 h 912615"/>
                    <a:gd name="connsiteX106" fmla="*/ 2090847 w 3173642"/>
                    <a:gd name="connsiteY106" fmla="*/ 666750 h 912615"/>
                    <a:gd name="connsiteX107" fmla="*/ 2043222 w 3173642"/>
                    <a:gd name="connsiteY107" fmla="*/ 657225 h 912615"/>
                    <a:gd name="connsiteX108" fmla="*/ 1928922 w 3173642"/>
                    <a:gd name="connsiteY108" fmla="*/ 650875 h 912615"/>
                    <a:gd name="connsiteX109" fmla="*/ 1868597 w 3173642"/>
                    <a:gd name="connsiteY109" fmla="*/ 654050 h 912615"/>
                    <a:gd name="connsiteX110" fmla="*/ 1782872 w 3173642"/>
                    <a:gd name="connsiteY110" fmla="*/ 657225 h 912615"/>
                    <a:gd name="connsiteX111" fmla="*/ 1744772 w 3173642"/>
                    <a:gd name="connsiteY111" fmla="*/ 663575 h 912615"/>
                    <a:gd name="connsiteX112" fmla="*/ 1700322 w 3173642"/>
                    <a:gd name="connsiteY112" fmla="*/ 685800 h 912615"/>
                    <a:gd name="connsiteX113" fmla="*/ 1643172 w 3173642"/>
                    <a:gd name="connsiteY113" fmla="*/ 708025 h 912615"/>
                    <a:gd name="connsiteX114" fmla="*/ 1598722 w 3173642"/>
                    <a:gd name="connsiteY114" fmla="*/ 730250 h 912615"/>
                    <a:gd name="connsiteX115" fmla="*/ 1532047 w 3173642"/>
                    <a:gd name="connsiteY115" fmla="*/ 733425 h 912615"/>
                    <a:gd name="connsiteX116" fmla="*/ 1484422 w 3173642"/>
                    <a:gd name="connsiteY116" fmla="*/ 733425 h 912615"/>
                    <a:gd name="connsiteX117" fmla="*/ 1465372 w 3173642"/>
                    <a:gd name="connsiteY117" fmla="*/ 733425 h 912615"/>
                    <a:gd name="connsiteX118" fmla="*/ 1436797 w 3173642"/>
                    <a:gd name="connsiteY118" fmla="*/ 768350 h 912615"/>
                    <a:gd name="connsiteX119" fmla="*/ 1366947 w 3173642"/>
                    <a:gd name="connsiteY119" fmla="*/ 768350 h 912615"/>
                    <a:gd name="connsiteX120" fmla="*/ 1255822 w 3173642"/>
                    <a:gd name="connsiteY120" fmla="*/ 742950 h 912615"/>
                    <a:gd name="connsiteX121" fmla="*/ 1182797 w 3173642"/>
                    <a:gd name="connsiteY121" fmla="*/ 727075 h 912615"/>
                    <a:gd name="connsiteX122" fmla="*/ 1043097 w 3173642"/>
                    <a:gd name="connsiteY122" fmla="*/ 695325 h 912615"/>
                    <a:gd name="connsiteX123" fmla="*/ 973247 w 3173642"/>
                    <a:gd name="connsiteY123" fmla="*/ 692150 h 912615"/>
                    <a:gd name="connsiteX124" fmla="*/ 881172 w 3173642"/>
                    <a:gd name="connsiteY124" fmla="*/ 688975 h 912615"/>
                    <a:gd name="connsiteX125" fmla="*/ 827197 w 3173642"/>
                    <a:gd name="connsiteY125" fmla="*/ 692150 h 912615"/>
                    <a:gd name="connsiteX126" fmla="*/ 789097 w 3173642"/>
                    <a:gd name="connsiteY126" fmla="*/ 704850 h 912615"/>
                    <a:gd name="connsiteX127" fmla="*/ 725597 w 3173642"/>
                    <a:gd name="connsiteY127" fmla="*/ 717550 h 912615"/>
                    <a:gd name="connsiteX128" fmla="*/ 690672 w 3173642"/>
                    <a:gd name="connsiteY128" fmla="*/ 730250 h 912615"/>
                    <a:gd name="connsiteX129" fmla="*/ 560497 w 3173642"/>
                    <a:gd name="connsiteY129" fmla="*/ 723900 h 912615"/>
                    <a:gd name="connsiteX130" fmla="*/ 528747 w 3173642"/>
                    <a:gd name="connsiteY130" fmla="*/ 723900 h 912615"/>
                    <a:gd name="connsiteX131" fmla="*/ 414447 w 3173642"/>
                    <a:gd name="connsiteY131" fmla="*/ 711200 h 912615"/>
                    <a:gd name="connsiteX132" fmla="*/ 379522 w 3173642"/>
                    <a:gd name="connsiteY132" fmla="*/ 714375 h 912615"/>
                    <a:gd name="connsiteX133" fmla="*/ 357297 w 3173642"/>
                    <a:gd name="connsiteY133" fmla="*/ 723900 h 912615"/>
                    <a:gd name="connsiteX134" fmla="*/ 246172 w 3173642"/>
                    <a:gd name="connsiteY134" fmla="*/ 708025 h 912615"/>
                    <a:gd name="connsiteX135" fmla="*/ 227122 w 3173642"/>
                    <a:gd name="connsiteY135" fmla="*/ 708025 h 912615"/>
                    <a:gd name="connsiteX136" fmla="*/ 160447 w 3173642"/>
                    <a:gd name="connsiteY136" fmla="*/ 708025 h 912615"/>
                    <a:gd name="connsiteX137" fmla="*/ 144572 w 3173642"/>
                    <a:gd name="connsiteY137" fmla="*/ 711200 h 912615"/>
                    <a:gd name="connsiteX138" fmla="*/ 112822 w 3173642"/>
                    <a:gd name="connsiteY138" fmla="*/ 723900 h 912615"/>
                    <a:gd name="connsiteX139" fmla="*/ 84247 w 3173642"/>
                    <a:gd name="connsiteY139" fmla="*/ 733425 h 912615"/>
                    <a:gd name="connsiteX140" fmla="*/ 58847 w 3173642"/>
                    <a:gd name="connsiteY140" fmla="*/ 739775 h 912615"/>
                    <a:gd name="connsiteX141" fmla="*/ 17572 w 3173642"/>
                    <a:gd name="connsiteY141" fmla="*/ 749300 h 912615"/>
                    <a:gd name="connsiteX142" fmla="*/ 4872 w 3173642"/>
                    <a:gd name="connsiteY142" fmla="*/ 752475 h 912615"/>
                    <a:gd name="connsiteX143" fmla="*/ 96947 w 3173642"/>
                    <a:gd name="connsiteY143" fmla="*/ 889000 h 912615"/>
                    <a:gd name="connsiteX0" fmla="*/ 103751 w 3174096"/>
                    <a:gd name="connsiteY0" fmla="*/ 882650 h 912615"/>
                    <a:gd name="connsiteX1" fmla="*/ 233926 w 3174096"/>
                    <a:gd name="connsiteY1" fmla="*/ 847725 h 912615"/>
                    <a:gd name="connsiteX2" fmla="*/ 373626 w 3174096"/>
                    <a:gd name="connsiteY2" fmla="*/ 854075 h 912615"/>
                    <a:gd name="connsiteX3" fmla="*/ 462526 w 3174096"/>
                    <a:gd name="connsiteY3" fmla="*/ 866775 h 912615"/>
                    <a:gd name="connsiteX4" fmla="*/ 535551 w 3174096"/>
                    <a:gd name="connsiteY4" fmla="*/ 869950 h 912615"/>
                    <a:gd name="connsiteX5" fmla="*/ 646676 w 3174096"/>
                    <a:gd name="connsiteY5" fmla="*/ 860425 h 912615"/>
                    <a:gd name="connsiteX6" fmla="*/ 726051 w 3174096"/>
                    <a:gd name="connsiteY6" fmla="*/ 838200 h 912615"/>
                    <a:gd name="connsiteX7" fmla="*/ 818126 w 3174096"/>
                    <a:gd name="connsiteY7" fmla="*/ 819150 h 912615"/>
                    <a:gd name="connsiteX8" fmla="*/ 973701 w 3174096"/>
                    <a:gd name="connsiteY8" fmla="*/ 812800 h 912615"/>
                    <a:gd name="connsiteX9" fmla="*/ 1170551 w 3174096"/>
                    <a:gd name="connsiteY9" fmla="*/ 838200 h 912615"/>
                    <a:gd name="connsiteX10" fmla="*/ 1357876 w 3174096"/>
                    <a:gd name="connsiteY10" fmla="*/ 904875 h 912615"/>
                    <a:gd name="connsiteX11" fmla="*/ 1491226 w 3174096"/>
                    <a:gd name="connsiteY11" fmla="*/ 908050 h 912615"/>
                    <a:gd name="connsiteX12" fmla="*/ 1649976 w 3174096"/>
                    <a:gd name="connsiteY12" fmla="*/ 876300 h 912615"/>
                    <a:gd name="connsiteX13" fmla="*/ 1742051 w 3174096"/>
                    <a:gd name="connsiteY13" fmla="*/ 844550 h 912615"/>
                    <a:gd name="connsiteX14" fmla="*/ 1786501 w 3174096"/>
                    <a:gd name="connsiteY14" fmla="*/ 819150 h 912615"/>
                    <a:gd name="connsiteX15" fmla="*/ 1850001 w 3174096"/>
                    <a:gd name="connsiteY15" fmla="*/ 793750 h 912615"/>
                    <a:gd name="connsiteX16" fmla="*/ 1903976 w 3174096"/>
                    <a:gd name="connsiteY16" fmla="*/ 796925 h 912615"/>
                    <a:gd name="connsiteX17" fmla="*/ 2053201 w 3174096"/>
                    <a:gd name="connsiteY17" fmla="*/ 819150 h 912615"/>
                    <a:gd name="connsiteX18" fmla="*/ 2154801 w 3174096"/>
                    <a:gd name="connsiteY18" fmla="*/ 822325 h 912615"/>
                    <a:gd name="connsiteX19" fmla="*/ 2259576 w 3174096"/>
                    <a:gd name="connsiteY19" fmla="*/ 841375 h 912615"/>
                    <a:gd name="connsiteX20" fmla="*/ 2364351 w 3174096"/>
                    <a:gd name="connsiteY20" fmla="*/ 873125 h 912615"/>
                    <a:gd name="connsiteX21" fmla="*/ 2494526 w 3174096"/>
                    <a:gd name="connsiteY21" fmla="*/ 860425 h 912615"/>
                    <a:gd name="connsiteX22" fmla="*/ 2589776 w 3174096"/>
                    <a:gd name="connsiteY22" fmla="*/ 838200 h 912615"/>
                    <a:gd name="connsiteX23" fmla="*/ 2637401 w 3174096"/>
                    <a:gd name="connsiteY23" fmla="*/ 815975 h 912615"/>
                    <a:gd name="connsiteX24" fmla="*/ 2707251 w 3174096"/>
                    <a:gd name="connsiteY24" fmla="*/ 819150 h 912615"/>
                    <a:gd name="connsiteX25" fmla="*/ 2764401 w 3174096"/>
                    <a:gd name="connsiteY25" fmla="*/ 806450 h 912615"/>
                    <a:gd name="connsiteX26" fmla="*/ 2812026 w 3174096"/>
                    <a:gd name="connsiteY26" fmla="*/ 787400 h 912615"/>
                    <a:gd name="connsiteX27" fmla="*/ 2834251 w 3174096"/>
                    <a:gd name="connsiteY27" fmla="*/ 771525 h 912615"/>
                    <a:gd name="connsiteX28" fmla="*/ 2869176 w 3174096"/>
                    <a:gd name="connsiteY28" fmla="*/ 787400 h 912615"/>
                    <a:gd name="connsiteX29" fmla="*/ 2907276 w 3174096"/>
                    <a:gd name="connsiteY29" fmla="*/ 822325 h 912615"/>
                    <a:gd name="connsiteX30" fmla="*/ 2986651 w 3174096"/>
                    <a:gd name="connsiteY30" fmla="*/ 847725 h 912615"/>
                    <a:gd name="connsiteX31" fmla="*/ 3062851 w 3174096"/>
                    <a:gd name="connsiteY31" fmla="*/ 841375 h 912615"/>
                    <a:gd name="connsiteX32" fmla="*/ 3123176 w 3174096"/>
                    <a:gd name="connsiteY32" fmla="*/ 800100 h 912615"/>
                    <a:gd name="connsiteX33" fmla="*/ 3139051 w 3174096"/>
                    <a:gd name="connsiteY33" fmla="*/ 762000 h 912615"/>
                    <a:gd name="connsiteX34" fmla="*/ 3167626 w 3174096"/>
                    <a:gd name="connsiteY34" fmla="*/ 695325 h 912615"/>
                    <a:gd name="connsiteX35" fmla="*/ 3173976 w 3174096"/>
                    <a:gd name="connsiteY35" fmla="*/ 628650 h 912615"/>
                    <a:gd name="connsiteX36" fmla="*/ 3164451 w 3174096"/>
                    <a:gd name="connsiteY36" fmla="*/ 584200 h 912615"/>
                    <a:gd name="connsiteX37" fmla="*/ 3139051 w 3174096"/>
                    <a:gd name="connsiteY37" fmla="*/ 539750 h 912615"/>
                    <a:gd name="connsiteX38" fmla="*/ 3126351 w 3174096"/>
                    <a:gd name="connsiteY38" fmla="*/ 485775 h 912615"/>
                    <a:gd name="connsiteX39" fmla="*/ 3116826 w 3174096"/>
                    <a:gd name="connsiteY39" fmla="*/ 425450 h 912615"/>
                    <a:gd name="connsiteX40" fmla="*/ 3107301 w 3174096"/>
                    <a:gd name="connsiteY40" fmla="*/ 374650 h 912615"/>
                    <a:gd name="connsiteX41" fmla="*/ 3075551 w 3174096"/>
                    <a:gd name="connsiteY41" fmla="*/ 311150 h 912615"/>
                    <a:gd name="connsiteX42" fmla="*/ 3066026 w 3174096"/>
                    <a:gd name="connsiteY42" fmla="*/ 307975 h 912615"/>
                    <a:gd name="connsiteX43" fmla="*/ 3037451 w 3174096"/>
                    <a:gd name="connsiteY43" fmla="*/ 295275 h 912615"/>
                    <a:gd name="connsiteX44" fmla="*/ 2989826 w 3174096"/>
                    <a:gd name="connsiteY44" fmla="*/ 279400 h 912615"/>
                    <a:gd name="connsiteX45" fmla="*/ 2958076 w 3174096"/>
                    <a:gd name="connsiteY45" fmla="*/ 247650 h 912615"/>
                    <a:gd name="connsiteX46" fmla="*/ 2942201 w 3174096"/>
                    <a:gd name="connsiteY46" fmla="*/ 225425 h 912615"/>
                    <a:gd name="connsiteX47" fmla="*/ 2926326 w 3174096"/>
                    <a:gd name="connsiteY47" fmla="*/ 200025 h 912615"/>
                    <a:gd name="connsiteX48" fmla="*/ 2885051 w 3174096"/>
                    <a:gd name="connsiteY48" fmla="*/ 152400 h 912615"/>
                    <a:gd name="connsiteX49" fmla="*/ 2869176 w 3174096"/>
                    <a:gd name="connsiteY49" fmla="*/ 139700 h 912615"/>
                    <a:gd name="connsiteX50" fmla="*/ 2843776 w 3174096"/>
                    <a:gd name="connsiteY50" fmla="*/ 104775 h 912615"/>
                    <a:gd name="connsiteX51" fmla="*/ 2805676 w 3174096"/>
                    <a:gd name="connsiteY51" fmla="*/ 57150 h 912615"/>
                    <a:gd name="connsiteX52" fmla="*/ 2777101 w 3174096"/>
                    <a:gd name="connsiteY52" fmla="*/ 28575 h 912615"/>
                    <a:gd name="connsiteX53" fmla="*/ 2739001 w 3174096"/>
                    <a:gd name="connsiteY53" fmla="*/ 15875 h 912615"/>
                    <a:gd name="connsiteX54" fmla="*/ 2678676 w 3174096"/>
                    <a:gd name="connsiteY54" fmla="*/ 6350 h 912615"/>
                    <a:gd name="connsiteX55" fmla="*/ 2612001 w 3174096"/>
                    <a:gd name="connsiteY55" fmla="*/ 0 h 912615"/>
                    <a:gd name="connsiteX56" fmla="*/ 2583426 w 3174096"/>
                    <a:gd name="connsiteY56" fmla="*/ 6350 h 912615"/>
                    <a:gd name="connsiteX57" fmla="*/ 2545326 w 3174096"/>
                    <a:gd name="connsiteY57" fmla="*/ 19050 h 912615"/>
                    <a:gd name="connsiteX58" fmla="*/ 2494526 w 3174096"/>
                    <a:gd name="connsiteY58" fmla="*/ 41275 h 912615"/>
                    <a:gd name="connsiteX59" fmla="*/ 2475476 w 3174096"/>
                    <a:gd name="connsiteY59" fmla="*/ 76200 h 912615"/>
                    <a:gd name="connsiteX60" fmla="*/ 2469126 w 3174096"/>
                    <a:gd name="connsiteY60" fmla="*/ 107950 h 912615"/>
                    <a:gd name="connsiteX61" fmla="*/ 2478651 w 3174096"/>
                    <a:gd name="connsiteY61" fmla="*/ 136525 h 912615"/>
                    <a:gd name="connsiteX62" fmla="*/ 2481826 w 3174096"/>
                    <a:gd name="connsiteY62" fmla="*/ 152400 h 912615"/>
                    <a:gd name="connsiteX63" fmla="*/ 2529451 w 3174096"/>
                    <a:gd name="connsiteY63" fmla="*/ 155575 h 912615"/>
                    <a:gd name="connsiteX64" fmla="*/ 2545326 w 3174096"/>
                    <a:gd name="connsiteY64" fmla="*/ 155575 h 912615"/>
                    <a:gd name="connsiteX65" fmla="*/ 2573901 w 3174096"/>
                    <a:gd name="connsiteY65" fmla="*/ 146050 h 912615"/>
                    <a:gd name="connsiteX66" fmla="*/ 2586601 w 3174096"/>
                    <a:gd name="connsiteY66" fmla="*/ 133350 h 912615"/>
                    <a:gd name="connsiteX67" fmla="*/ 2602476 w 3174096"/>
                    <a:gd name="connsiteY67" fmla="*/ 120650 h 912615"/>
                    <a:gd name="connsiteX68" fmla="*/ 2643751 w 3174096"/>
                    <a:gd name="connsiteY68" fmla="*/ 123825 h 912615"/>
                    <a:gd name="connsiteX69" fmla="*/ 2669151 w 3174096"/>
                    <a:gd name="connsiteY69" fmla="*/ 142875 h 912615"/>
                    <a:gd name="connsiteX70" fmla="*/ 2707251 w 3174096"/>
                    <a:gd name="connsiteY70" fmla="*/ 171450 h 912615"/>
                    <a:gd name="connsiteX71" fmla="*/ 2735826 w 3174096"/>
                    <a:gd name="connsiteY71" fmla="*/ 206375 h 912615"/>
                    <a:gd name="connsiteX72" fmla="*/ 2777101 w 3174096"/>
                    <a:gd name="connsiteY72" fmla="*/ 276225 h 912615"/>
                    <a:gd name="connsiteX73" fmla="*/ 2792976 w 3174096"/>
                    <a:gd name="connsiteY73" fmla="*/ 311150 h 912615"/>
                    <a:gd name="connsiteX74" fmla="*/ 2805676 w 3174096"/>
                    <a:gd name="connsiteY74" fmla="*/ 352425 h 912615"/>
                    <a:gd name="connsiteX75" fmla="*/ 2818376 w 3174096"/>
                    <a:gd name="connsiteY75" fmla="*/ 390525 h 912615"/>
                    <a:gd name="connsiteX76" fmla="*/ 2821551 w 3174096"/>
                    <a:gd name="connsiteY76" fmla="*/ 409575 h 912615"/>
                    <a:gd name="connsiteX77" fmla="*/ 2821551 w 3174096"/>
                    <a:gd name="connsiteY77" fmla="*/ 431800 h 912615"/>
                    <a:gd name="connsiteX78" fmla="*/ 2824726 w 3174096"/>
                    <a:gd name="connsiteY78" fmla="*/ 466725 h 912615"/>
                    <a:gd name="connsiteX79" fmla="*/ 2827901 w 3174096"/>
                    <a:gd name="connsiteY79" fmla="*/ 495300 h 912615"/>
                    <a:gd name="connsiteX80" fmla="*/ 2831076 w 3174096"/>
                    <a:gd name="connsiteY80" fmla="*/ 520700 h 912615"/>
                    <a:gd name="connsiteX81" fmla="*/ 2831076 w 3174096"/>
                    <a:gd name="connsiteY81" fmla="*/ 549275 h 912615"/>
                    <a:gd name="connsiteX82" fmla="*/ 2827901 w 3174096"/>
                    <a:gd name="connsiteY82" fmla="*/ 561975 h 912615"/>
                    <a:gd name="connsiteX83" fmla="*/ 2821551 w 3174096"/>
                    <a:gd name="connsiteY83" fmla="*/ 574675 h 912615"/>
                    <a:gd name="connsiteX84" fmla="*/ 2812026 w 3174096"/>
                    <a:gd name="connsiteY84" fmla="*/ 593725 h 912615"/>
                    <a:gd name="connsiteX85" fmla="*/ 2808851 w 3174096"/>
                    <a:gd name="connsiteY85" fmla="*/ 609600 h 912615"/>
                    <a:gd name="connsiteX86" fmla="*/ 2808851 w 3174096"/>
                    <a:gd name="connsiteY86" fmla="*/ 625475 h 912615"/>
                    <a:gd name="connsiteX87" fmla="*/ 2812026 w 3174096"/>
                    <a:gd name="connsiteY87" fmla="*/ 638175 h 912615"/>
                    <a:gd name="connsiteX88" fmla="*/ 2812026 w 3174096"/>
                    <a:gd name="connsiteY88" fmla="*/ 638175 h 912615"/>
                    <a:gd name="connsiteX89" fmla="*/ 2761226 w 3174096"/>
                    <a:gd name="connsiteY89" fmla="*/ 657225 h 912615"/>
                    <a:gd name="connsiteX90" fmla="*/ 2710426 w 3174096"/>
                    <a:gd name="connsiteY90" fmla="*/ 666750 h 912615"/>
                    <a:gd name="connsiteX91" fmla="*/ 2662801 w 3174096"/>
                    <a:gd name="connsiteY91" fmla="*/ 673100 h 912615"/>
                    <a:gd name="connsiteX92" fmla="*/ 2637401 w 3174096"/>
                    <a:gd name="connsiteY92" fmla="*/ 673100 h 912615"/>
                    <a:gd name="connsiteX93" fmla="*/ 2599301 w 3174096"/>
                    <a:gd name="connsiteY93" fmla="*/ 673100 h 912615"/>
                    <a:gd name="connsiteX94" fmla="*/ 2561201 w 3174096"/>
                    <a:gd name="connsiteY94" fmla="*/ 669925 h 912615"/>
                    <a:gd name="connsiteX95" fmla="*/ 2545326 w 3174096"/>
                    <a:gd name="connsiteY95" fmla="*/ 673100 h 912615"/>
                    <a:gd name="connsiteX96" fmla="*/ 2519926 w 3174096"/>
                    <a:gd name="connsiteY96" fmla="*/ 685800 h 912615"/>
                    <a:gd name="connsiteX97" fmla="*/ 2497701 w 3174096"/>
                    <a:gd name="connsiteY97" fmla="*/ 695325 h 912615"/>
                    <a:gd name="connsiteX98" fmla="*/ 2453251 w 3174096"/>
                    <a:gd name="connsiteY98" fmla="*/ 704850 h 912615"/>
                    <a:gd name="connsiteX99" fmla="*/ 2408801 w 3174096"/>
                    <a:gd name="connsiteY99" fmla="*/ 714375 h 912615"/>
                    <a:gd name="connsiteX100" fmla="*/ 2361176 w 3174096"/>
                    <a:gd name="connsiteY100" fmla="*/ 720725 h 912615"/>
                    <a:gd name="connsiteX101" fmla="*/ 2329426 w 3174096"/>
                    <a:gd name="connsiteY101" fmla="*/ 708025 h 912615"/>
                    <a:gd name="connsiteX102" fmla="*/ 2265926 w 3174096"/>
                    <a:gd name="connsiteY102" fmla="*/ 695325 h 912615"/>
                    <a:gd name="connsiteX103" fmla="*/ 2227826 w 3174096"/>
                    <a:gd name="connsiteY103" fmla="*/ 688975 h 912615"/>
                    <a:gd name="connsiteX104" fmla="*/ 2186551 w 3174096"/>
                    <a:gd name="connsiteY104" fmla="*/ 682625 h 912615"/>
                    <a:gd name="connsiteX105" fmla="*/ 2129401 w 3174096"/>
                    <a:gd name="connsiteY105" fmla="*/ 673100 h 912615"/>
                    <a:gd name="connsiteX106" fmla="*/ 2091301 w 3174096"/>
                    <a:gd name="connsiteY106" fmla="*/ 666750 h 912615"/>
                    <a:gd name="connsiteX107" fmla="*/ 2043676 w 3174096"/>
                    <a:gd name="connsiteY107" fmla="*/ 657225 h 912615"/>
                    <a:gd name="connsiteX108" fmla="*/ 1929376 w 3174096"/>
                    <a:gd name="connsiteY108" fmla="*/ 650875 h 912615"/>
                    <a:gd name="connsiteX109" fmla="*/ 1869051 w 3174096"/>
                    <a:gd name="connsiteY109" fmla="*/ 654050 h 912615"/>
                    <a:gd name="connsiteX110" fmla="*/ 1783326 w 3174096"/>
                    <a:gd name="connsiteY110" fmla="*/ 657225 h 912615"/>
                    <a:gd name="connsiteX111" fmla="*/ 1745226 w 3174096"/>
                    <a:gd name="connsiteY111" fmla="*/ 663575 h 912615"/>
                    <a:gd name="connsiteX112" fmla="*/ 1700776 w 3174096"/>
                    <a:gd name="connsiteY112" fmla="*/ 685800 h 912615"/>
                    <a:gd name="connsiteX113" fmla="*/ 1643626 w 3174096"/>
                    <a:gd name="connsiteY113" fmla="*/ 708025 h 912615"/>
                    <a:gd name="connsiteX114" fmla="*/ 1599176 w 3174096"/>
                    <a:gd name="connsiteY114" fmla="*/ 730250 h 912615"/>
                    <a:gd name="connsiteX115" fmla="*/ 1532501 w 3174096"/>
                    <a:gd name="connsiteY115" fmla="*/ 733425 h 912615"/>
                    <a:gd name="connsiteX116" fmla="*/ 1484876 w 3174096"/>
                    <a:gd name="connsiteY116" fmla="*/ 733425 h 912615"/>
                    <a:gd name="connsiteX117" fmla="*/ 1465826 w 3174096"/>
                    <a:gd name="connsiteY117" fmla="*/ 733425 h 912615"/>
                    <a:gd name="connsiteX118" fmla="*/ 1437251 w 3174096"/>
                    <a:gd name="connsiteY118" fmla="*/ 768350 h 912615"/>
                    <a:gd name="connsiteX119" fmla="*/ 1367401 w 3174096"/>
                    <a:gd name="connsiteY119" fmla="*/ 768350 h 912615"/>
                    <a:gd name="connsiteX120" fmla="*/ 1256276 w 3174096"/>
                    <a:gd name="connsiteY120" fmla="*/ 742950 h 912615"/>
                    <a:gd name="connsiteX121" fmla="*/ 1183251 w 3174096"/>
                    <a:gd name="connsiteY121" fmla="*/ 727075 h 912615"/>
                    <a:gd name="connsiteX122" fmla="*/ 1043551 w 3174096"/>
                    <a:gd name="connsiteY122" fmla="*/ 695325 h 912615"/>
                    <a:gd name="connsiteX123" fmla="*/ 973701 w 3174096"/>
                    <a:gd name="connsiteY123" fmla="*/ 692150 h 912615"/>
                    <a:gd name="connsiteX124" fmla="*/ 881626 w 3174096"/>
                    <a:gd name="connsiteY124" fmla="*/ 688975 h 912615"/>
                    <a:gd name="connsiteX125" fmla="*/ 827651 w 3174096"/>
                    <a:gd name="connsiteY125" fmla="*/ 692150 h 912615"/>
                    <a:gd name="connsiteX126" fmla="*/ 789551 w 3174096"/>
                    <a:gd name="connsiteY126" fmla="*/ 704850 h 912615"/>
                    <a:gd name="connsiteX127" fmla="*/ 726051 w 3174096"/>
                    <a:gd name="connsiteY127" fmla="*/ 717550 h 912615"/>
                    <a:gd name="connsiteX128" fmla="*/ 691126 w 3174096"/>
                    <a:gd name="connsiteY128" fmla="*/ 730250 h 912615"/>
                    <a:gd name="connsiteX129" fmla="*/ 560951 w 3174096"/>
                    <a:gd name="connsiteY129" fmla="*/ 723900 h 912615"/>
                    <a:gd name="connsiteX130" fmla="*/ 529201 w 3174096"/>
                    <a:gd name="connsiteY130" fmla="*/ 723900 h 912615"/>
                    <a:gd name="connsiteX131" fmla="*/ 414901 w 3174096"/>
                    <a:gd name="connsiteY131" fmla="*/ 711200 h 912615"/>
                    <a:gd name="connsiteX132" fmla="*/ 379976 w 3174096"/>
                    <a:gd name="connsiteY132" fmla="*/ 714375 h 912615"/>
                    <a:gd name="connsiteX133" fmla="*/ 357751 w 3174096"/>
                    <a:gd name="connsiteY133" fmla="*/ 723900 h 912615"/>
                    <a:gd name="connsiteX134" fmla="*/ 246626 w 3174096"/>
                    <a:gd name="connsiteY134" fmla="*/ 708025 h 912615"/>
                    <a:gd name="connsiteX135" fmla="*/ 227576 w 3174096"/>
                    <a:gd name="connsiteY135" fmla="*/ 708025 h 912615"/>
                    <a:gd name="connsiteX136" fmla="*/ 160901 w 3174096"/>
                    <a:gd name="connsiteY136" fmla="*/ 708025 h 912615"/>
                    <a:gd name="connsiteX137" fmla="*/ 145026 w 3174096"/>
                    <a:gd name="connsiteY137" fmla="*/ 711200 h 912615"/>
                    <a:gd name="connsiteX138" fmla="*/ 113276 w 3174096"/>
                    <a:gd name="connsiteY138" fmla="*/ 723900 h 912615"/>
                    <a:gd name="connsiteX139" fmla="*/ 84701 w 3174096"/>
                    <a:gd name="connsiteY139" fmla="*/ 733425 h 912615"/>
                    <a:gd name="connsiteX140" fmla="*/ 59301 w 3174096"/>
                    <a:gd name="connsiteY140" fmla="*/ 739775 h 912615"/>
                    <a:gd name="connsiteX141" fmla="*/ 18026 w 3174096"/>
                    <a:gd name="connsiteY141" fmla="*/ 749300 h 912615"/>
                    <a:gd name="connsiteX142" fmla="*/ 5326 w 3174096"/>
                    <a:gd name="connsiteY142" fmla="*/ 752475 h 912615"/>
                    <a:gd name="connsiteX143" fmla="*/ 103751 w 3174096"/>
                    <a:gd name="connsiteY143" fmla="*/ 895350 h 912615"/>
                    <a:gd name="connsiteX0" fmla="*/ 103751 w 3174096"/>
                    <a:gd name="connsiteY0" fmla="*/ 882650 h 912615"/>
                    <a:gd name="connsiteX1" fmla="*/ 221226 w 3174096"/>
                    <a:gd name="connsiteY1" fmla="*/ 809625 h 912615"/>
                    <a:gd name="connsiteX2" fmla="*/ 373626 w 3174096"/>
                    <a:gd name="connsiteY2" fmla="*/ 854075 h 912615"/>
                    <a:gd name="connsiteX3" fmla="*/ 462526 w 3174096"/>
                    <a:gd name="connsiteY3" fmla="*/ 866775 h 912615"/>
                    <a:gd name="connsiteX4" fmla="*/ 535551 w 3174096"/>
                    <a:gd name="connsiteY4" fmla="*/ 869950 h 912615"/>
                    <a:gd name="connsiteX5" fmla="*/ 646676 w 3174096"/>
                    <a:gd name="connsiteY5" fmla="*/ 860425 h 912615"/>
                    <a:gd name="connsiteX6" fmla="*/ 726051 w 3174096"/>
                    <a:gd name="connsiteY6" fmla="*/ 838200 h 912615"/>
                    <a:gd name="connsiteX7" fmla="*/ 818126 w 3174096"/>
                    <a:gd name="connsiteY7" fmla="*/ 819150 h 912615"/>
                    <a:gd name="connsiteX8" fmla="*/ 973701 w 3174096"/>
                    <a:gd name="connsiteY8" fmla="*/ 812800 h 912615"/>
                    <a:gd name="connsiteX9" fmla="*/ 1170551 w 3174096"/>
                    <a:gd name="connsiteY9" fmla="*/ 838200 h 912615"/>
                    <a:gd name="connsiteX10" fmla="*/ 1357876 w 3174096"/>
                    <a:gd name="connsiteY10" fmla="*/ 904875 h 912615"/>
                    <a:gd name="connsiteX11" fmla="*/ 1491226 w 3174096"/>
                    <a:gd name="connsiteY11" fmla="*/ 908050 h 912615"/>
                    <a:gd name="connsiteX12" fmla="*/ 1649976 w 3174096"/>
                    <a:gd name="connsiteY12" fmla="*/ 876300 h 912615"/>
                    <a:gd name="connsiteX13" fmla="*/ 1742051 w 3174096"/>
                    <a:gd name="connsiteY13" fmla="*/ 844550 h 912615"/>
                    <a:gd name="connsiteX14" fmla="*/ 1786501 w 3174096"/>
                    <a:gd name="connsiteY14" fmla="*/ 819150 h 912615"/>
                    <a:gd name="connsiteX15" fmla="*/ 1850001 w 3174096"/>
                    <a:gd name="connsiteY15" fmla="*/ 793750 h 912615"/>
                    <a:gd name="connsiteX16" fmla="*/ 1903976 w 3174096"/>
                    <a:gd name="connsiteY16" fmla="*/ 796925 h 912615"/>
                    <a:gd name="connsiteX17" fmla="*/ 2053201 w 3174096"/>
                    <a:gd name="connsiteY17" fmla="*/ 819150 h 912615"/>
                    <a:gd name="connsiteX18" fmla="*/ 2154801 w 3174096"/>
                    <a:gd name="connsiteY18" fmla="*/ 822325 h 912615"/>
                    <a:gd name="connsiteX19" fmla="*/ 2259576 w 3174096"/>
                    <a:gd name="connsiteY19" fmla="*/ 841375 h 912615"/>
                    <a:gd name="connsiteX20" fmla="*/ 2364351 w 3174096"/>
                    <a:gd name="connsiteY20" fmla="*/ 873125 h 912615"/>
                    <a:gd name="connsiteX21" fmla="*/ 2494526 w 3174096"/>
                    <a:gd name="connsiteY21" fmla="*/ 860425 h 912615"/>
                    <a:gd name="connsiteX22" fmla="*/ 2589776 w 3174096"/>
                    <a:gd name="connsiteY22" fmla="*/ 838200 h 912615"/>
                    <a:gd name="connsiteX23" fmla="*/ 2637401 w 3174096"/>
                    <a:gd name="connsiteY23" fmla="*/ 815975 h 912615"/>
                    <a:gd name="connsiteX24" fmla="*/ 2707251 w 3174096"/>
                    <a:gd name="connsiteY24" fmla="*/ 819150 h 912615"/>
                    <a:gd name="connsiteX25" fmla="*/ 2764401 w 3174096"/>
                    <a:gd name="connsiteY25" fmla="*/ 806450 h 912615"/>
                    <a:gd name="connsiteX26" fmla="*/ 2812026 w 3174096"/>
                    <a:gd name="connsiteY26" fmla="*/ 787400 h 912615"/>
                    <a:gd name="connsiteX27" fmla="*/ 2834251 w 3174096"/>
                    <a:gd name="connsiteY27" fmla="*/ 771525 h 912615"/>
                    <a:gd name="connsiteX28" fmla="*/ 2869176 w 3174096"/>
                    <a:gd name="connsiteY28" fmla="*/ 787400 h 912615"/>
                    <a:gd name="connsiteX29" fmla="*/ 2907276 w 3174096"/>
                    <a:gd name="connsiteY29" fmla="*/ 822325 h 912615"/>
                    <a:gd name="connsiteX30" fmla="*/ 2986651 w 3174096"/>
                    <a:gd name="connsiteY30" fmla="*/ 847725 h 912615"/>
                    <a:gd name="connsiteX31" fmla="*/ 3062851 w 3174096"/>
                    <a:gd name="connsiteY31" fmla="*/ 841375 h 912615"/>
                    <a:gd name="connsiteX32" fmla="*/ 3123176 w 3174096"/>
                    <a:gd name="connsiteY32" fmla="*/ 800100 h 912615"/>
                    <a:gd name="connsiteX33" fmla="*/ 3139051 w 3174096"/>
                    <a:gd name="connsiteY33" fmla="*/ 762000 h 912615"/>
                    <a:gd name="connsiteX34" fmla="*/ 3167626 w 3174096"/>
                    <a:gd name="connsiteY34" fmla="*/ 695325 h 912615"/>
                    <a:gd name="connsiteX35" fmla="*/ 3173976 w 3174096"/>
                    <a:gd name="connsiteY35" fmla="*/ 628650 h 912615"/>
                    <a:gd name="connsiteX36" fmla="*/ 3164451 w 3174096"/>
                    <a:gd name="connsiteY36" fmla="*/ 584200 h 912615"/>
                    <a:gd name="connsiteX37" fmla="*/ 3139051 w 3174096"/>
                    <a:gd name="connsiteY37" fmla="*/ 539750 h 912615"/>
                    <a:gd name="connsiteX38" fmla="*/ 3126351 w 3174096"/>
                    <a:gd name="connsiteY38" fmla="*/ 485775 h 912615"/>
                    <a:gd name="connsiteX39" fmla="*/ 3116826 w 3174096"/>
                    <a:gd name="connsiteY39" fmla="*/ 425450 h 912615"/>
                    <a:gd name="connsiteX40" fmla="*/ 3107301 w 3174096"/>
                    <a:gd name="connsiteY40" fmla="*/ 374650 h 912615"/>
                    <a:gd name="connsiteX41" fmla="*/ 3075551 w 3174096"/>
                    <a:gd name="connsiteY41" fmla="*/ 311150 h 912615"/>
                    <a:gd name="connsiteX42" fmla="*/ 3066026 w 3174096"/>
                    <a:gd name="connsiteY42" fmla="*/ 307975 h 912615"/>
                    <a:gd name="connsiteX43" fmla="*/ 3037451 w 3174096"/>
                    <a:gd name="connsiteY43" fmla="*/ 295275 h 912615"/>
                    <a:gd name="connsiteX44" fmla="*/ 2989826 w 3174096"/>
                    <a:gd name="connsiteY44" fmla="*/ 279400 h 912615"/>
                    <a:gd name="connsiteX45" fmla="*/ 2958076 w 3174096"/>
                    <a:gd name="connsiteY45" fmla="*/ 247650 h 912615"/>
                    <a:gd name="connsiteX46" fmla="*/ 2942201 w 3174096"/>
                    <a:gd name="connsiteY46" fmla="*/ 225425 h 912615"/>
                    <a:gd name="connsiteX47" fmla="*/ 2926326 w 3174096"/>
                    <a:gd name="connsiteY47" fmla="*/ 200025 h 912615"/>
                    <a:gd name="connsiteX48" fmla="*/ 2885051 w 3174096"/>
                    <a:gd name="connsiteY48" fmla="*/ 152400 h 912615"/>
                    <a:gd name="connsiteX49" fmla="*/ 2869176 w 3174096"/>
                    <a:gd name="connsiteY49" fmla="*/ 139700 h 912615"/>
                    <a:gd name="connsiteX50" fmla="*/ 2843776 w 3174096"/>
                    <a:gd name="connsiteY50" fmla="*/ 104775 h 912615"/>
                    <a:gd name="connsiteX51" fmla="*/ 2805676 w 3174096"/>
                    <a:gd name="connsiteY51" fmla="*/ 57150 h 912615"/>
                    <a:gd name="connsiteX52" fmla="*/ 2777101 w 3174096"/>
                    <a:gd name="connsiteY52" fmla="*/ 28575 h 912615"/>
                    <a:gd name="connsiteX53" fmla="*/ 2739001 w 3174096"/>
                    <a:gd name="connsiteY53" fmla="*/ 15875 h 912615"/>
                    <a:gd name="connsiteX54" fmla="*/ 2678676 w 3174096"/>
                    <a:gd name="connsiteY54" fmla="*/ 6350 h 912615"/>
                    <a:gd name="connsiteX55" fmla="*/ 2612001 w 3174096"/>
                    <a:gd name="connsiteY55" fmla="*/ 0 h 912615"/>
                    <a:gd name="connsiteX56" fmla="*/ 2583426 w 3174096"/>
                    <a:gd name="connsiteY56" fmla="*/ 6350 h 912615"/>
                    <a:gd name="connsiteX57" fmla="*/ 2545326 w 3174096"/>
                    <a:gd name="connsiteY57" fmla="*/ 19050 h 912615"/>
                    <a:gd name="connsiteX58" fmla="*/ 2494526 w 3174096"/>
                    <a:gd name="connsiteY58" fmla="*/ 41275 h 912615"/>
                    <a:gd name="connsiteX59" fmla="*/ 2475476 w 3174096"/>
                    <a:gd name="connsiteY59" fmla="*/ 76200 h 912615"/>
                    <a:gd name="connsiteX60" fmla="*/ 2469126 w 3174096"/>
                    <a:gd name="connsiteY60" fmla="*/ 107950 h 912615"/>
                    <a:gd name="connsiteX61" fmla="*/ 2478651 w 3174096"/>
                    <a:gd name="connsiteY61" fmla="*/ 136525 h 912615"/>
                    <a:gd name="connsiteX62" fmla="*/ 2481826 w 3174096"/>
                    <a:gd name="connsiteY62" fmla="*/ 152400 h 912615"/>
                    <a:gd name="connsiteX63" fmla="*/ 2529451 w 3174096"/>
                    <a:gd name="connsiteY63" fmla="*/ 155575 h 912615"/>
                    <a:gd name="connsiteX64" fmla="*/ 2545326 w 3174096"/>
                    <a:gd name="connsiteY64" fmla="*/ 155575 h 912615"/>
                    <a:gd name="connsiteX65" fmla="*/ 2573901 w 3174096"/>
                    <a:gd name="connsiteY65" fmla="*/ 146050 h 912615"/>
                    <a:gd name="connsiteX66" fmla="*/ 2586601 w 3174096"/>
                    <a:gd name="connsiteY66" fmla="*/ 133350 h 912615"/>
                    <a:gd name="connsiteX67" fmla="*/ 2602476 w 3174096"/>
                    <a:gd name="connsiteY67" fmla="*/ 120650 h 912615"/>
                    <a:gd name="connsiteX68" fmla="*/ 2643751 w 3174096"/>
                    <a:gd name="connsiteY68" fmla="*/ 123825 h 912615"/>
                    <a:gd name="connsiteX69" fmla="*/ 2669151 w 3174096"/>
                    <a:gd name="connsiteY69" fmla="*/ 142875 h 912615"/>
                    <a:gd name="connsiteX70" fmla="*/ 2707251 w 3174096"/>
                    <a:gd name="connsiteY70" fmla="*/ 171450 h 912615"/>
                    <a:gd name="connsiteX71" fmla="*/ 2735826 w 3174096"/>
                    <a:gd name="connsiteY71" fmla="*/ 206375 h 912615"/>
                    <a:gd name="connsiteX72" fmla="*/ 2777101 w 3174096"/>
                    <a:gd name="connsiteY72" fmla="*/ 276225 h 912615"/>
                    <a:gd name="connsiteX73" fmla="*/ 2792976 w 3174096"/>
                    <a:gd name="connsiteY73" fmla="*/ 311150 h 912615"/>
                    <a:gd name="connsiteX74" fmla="*/ 2805676 w 3174096"/>
                    <a:gd name="connsiteY74" fmla="*/ 352425 h 912615"/>
                    <a:gd name="connsiteX75" fmla="*/ 2818376 w 3174096"/>
                    <a:gd name="connsiteY75" fmla="*/ 390525 h 912615"/>
                    <a:gd name="connsiteX76" fmla="*/ 2821551 w 3174096"/>
                    <a:gd name="connsiteY76" fmla="*/ 409575 h 912615"/>
                    <a:gd name="connsiteX77" fmla="*/ 2821551 w 3174096"/>
                    <a:gd name="connsiteY77" fmla="*/ 431800 h 912615"/>
                    <a:gd name="connsiteX78" fmla="*/ 2824726 w 3174096"/>
                    <a:gd name="connsiteY78" fmla="*/ 466725 h 912615"/>
                    <a:gd name="connsiteX79" fmla="*/ 2827901 w 3174096"/>
                    <a:gd name="connsiteY79" fmla="*/ 495300 h 912615"/>
                    <a:gd name="connsiteX80" fmla="*/ 2831076 w 3174096"/>
                    <a:gd name="connsiteY80" fmla="*/ 520700 h 912615"/>
                    <a:gd name="connsiteX81" fmla="*/ 2831076 w 3174096"/>
                    <a:gd name="connsiteY81" fmla="*/ 549275 h 912615"/>
                    <a:gd name="connsiteX82" fmla="*/ 2827901 w 3174096"/>
                    <a:gd name="connsiteY82" fmla="*/ 561975 h 912615"/>
                    <a:gd name="connsiteX83" fmla="*/ 2821551 w 3174096"/>
                    <a:gd name="connsiteY83" fmla="*/ 574675 h 912615"/>
                    <a:gd name="connsiteX84" fmla="*/ 2812026 w 3174096"/>
                    <a:gd name="connsiteY84" fmla="*/ 593725 h 912615"/>
                    <a:gd name="connsiteX85" fmla="*/ 2808851 w 3174096"/>
                    <a:gd name="connsiteY85" fmla="*/ 609600 h 912615"/>
                    <a:gd name="connsiteX86" fmla="*/ 2808851 w 3174096"/>
                    <a:gd name="connsiteY86" fmla="*/ 625475 h 912615"/>
                    <a:gd name="connsiteX87" fmla="*/ 2812026 w 3174096"/>
                    <a:gd name="connsiteY87" fmla="*/ 638175 h 912615"/>
                    <a:gd name="connsiteX88" fmla="*/ 2812026 w 3174096"/>
                    <a:gd name="connsiteY88" fmla="*/ 638175 h 912615"/>
                    <a:gd name="connsiteX89" fmla="*/ 2761226 w 3174096"/>
                    <a:gd name="connsiteY89" fmla="*/ 657225 h 912615"/>
                    <a:gd name="connsiteX90" fmla="*/ 2710426 w 3174096"/>
                    <a:gd name="connsiteY90" fmla="*/ 666750 h 912615"/>
                    <a:gd name="connsiteX91" fmla="*/ 2662801 w 3174096"/>
                    <a:gd name="connsiteY91" fmla="*/ 673100 h 912615"/>
                    <a:gd name="connsiteX92" fmla="*/ 2637401 w 3174096"/>
                    <a:gd name="connsiteY92" fmla="*/ 673100 h 912615"/>
                    <a:gd name="connsiteX93" fmla="*/ 2599301 w 3174096"/>
                    <a:gd name="connsiteY93" fmla="*/ 673100 h 912615"/>
                    <a:gd name="connsiteX94" fmla="*/ 2561201 w 3174096"/>
                    <a:gd name="connsiteY94" fmla="*/ 669925 h 912615"/>
                    <a:gd name="connsiteX95" fmla="*/ 2545326 w 3174096"/>
                    <a:gd name="connsiteY95" fmla="*/ 673100 h 912615"/>
                    <a:gd name="connsiteX96" fmla="*/ 2519926 w 3174096"/>
                    <a:gd name="connsiteY96" fmla="*/ 685800 h 912615"/>
                    <a:gd name="connsiteX97" fmla="*/ 2497701 w 3174096"/>
                    <a:gd name="connsiteY97" fmla="*/ 695325 h 912615"/>
                    <a:gd name="connsiteX98" fmla="*/ 2453251 w 3174096"/>
                    <a:gd name="connsiteY98" fmla="*/ 704850 h 912615"/>
                    <a:gd name="connsiteX99" fmla="*/ 2408801 w 3174096"/>
                    <a:gd name="connsiteY99" fmla="*/ 714375 h 912615"/>
                    <a:gd name="connsiteX100" fmla="*/ 2361176 w 3174096"/>
                    <a:gd name="connsiteY100" fmla="*/ 720725 h 912615"/>
                    <a:gd name="connsiteX101" fmla="*/ 2329426 w 3174096"/>
                    <a:gd name="connsiteY101" fmla="*/ 708025 h 912615"/>
                    <a:gd name="connsiteX102" fmla="*/ 2265926 w 3174096"/>
                    <a:gd name="connsiteY102" fmla="*/ 695325 h 912615"/>
                    <a:gd name="connsiteX103" fmla="*/ 2227826 w 3174096"/>
                    <a:gd name="connsiteY103" fmla="*/ 688975 h 912615"/>
                    <a:gd name="connsiteX104" fmla="*/ 2186551 w 3174096"/>
                    <a:gd name="connsiteY104" fmla="*/ 682625 h 912615"/>
                    <a:gd name="connsiteX105" fmla="*/ 2129401 w 3174096"/>
                    <a:gd name="connsiteY105" fmla="*/ 673100 h 912615"/>
                    <a:gd name="connsiteX106" fmla="*/ 2091301 w 3174096"/>
                    <a:gd name="connsiteY106" fmla="*/ 666750 h 912615"/>
                    <a:gd name="connsiteX107" fmla="*/ 2043676 w 3174096"/>
                    <a:gd name="connsiteY107" fmla="*/ 657225 h 912615"/>
                    <a:gd name="connsiteX108" fmla="*/ 1929376 w 3174096"/>
                    <a:gd name="connsiteY108" fmla="*/ 650875 h 912615"/>
                    <a:gd name="connsiteX109" fmla="*/ 1869051 w 3174096"/>
                    <a:gd name="connsiteY109" fmla="*/ 654050 h 912615"/>
                    <a:gd name="connsiteX110" fmla="*/ 1783326 w 3174096"/>
                    <a:gd name="connsiteY110" fmla="*/ 657225 h 912615"/>
                    <a:gd name="connsiteX111" fmla="*/ 1745226 w 3174096"/>
                    <a:gd name="connsiteY111" fmla="*/ 663575 h 912615"/>
                    <a:gd name="connsiteX112" fmla="*/ 1700776 w 3174096"/>
                    <a:gd name="connsiteY112" fmla="*/ 685800 h 912615"/>
                    <a:gd name="connsiteX113" fmla="*/ 1643626 w 3174096"/>
                    <a:gd name="connsiteY113" fmla="*/ 708025 h 912615"/>
                    <a:gd name="connsiteX114" fmla="*/ 1599176 w 3174096"/>
                    <a:gd name="connsiteY114" fmla="*/ 730250 h 912615"/>
                    <a:gd name="connsiteX115" fmla="*/ 1532501 w 3174096"/>
                    <a:gd name="connsiteY115" fmla="*/ 733425 h 912615"/>
                    <a:gd name="connsiteX116" fmla="*/ 1484876 w 3174096"/>
                    <a:gd name="connsiteY116" fmla="*/ 733425 h 912615"/>
                    <a:gd name="connsiteX117" fmla="*/ 1465826 w 3174096"/>
                    <a:gd name="connsiteY117" fmla="*/ 733425 h 912615"/>
                    <a:gd name="connsiteX118" fmla="*/ 1437251 w 3174096"/>
                    <a:gd name="connsiteY118" fmla="*/ 768350 h 912615"/>
                    <a:gd name="connsiteX119" fmla="*/ 1367401 w 3174096"/>
                    <a:gd name="connsiteY119" fmla="*/ 768350 h 912615"/>
                    <a:gd name="connsiteX120" fmla="*/ 1256276 w 3174096"/>
                    <a:gd name="connsiteY120" fmla="*/ 742950 h 912615"/>
                    <a:gd name="connsiteX121" fmla="*/ 1183251 w 3174096"/>
                    <a:gd name="connsiteY121" fmla="*/ 727075 h 912615"/>
                    <a:gd name="connsiteX122" fmla="*/ 1043551 w 3174096"/>
                    <a:gd name="connsiteY122" fmla="*/ 695325 h 912615"/>
                    <a:gd name="connsiteX123" fmla="*/ 973701 w 3174096"/>
                    <a:gd name="connsiteY123" fmla="*/ 692150 h 912615"/>
                    <a:gd name="connsiteX124" fmla="*/ 881626 w 3174096"/>
                    <a:gd name="connsiteY124" fmla="*/ 688975 h 912615"/>
                    <a:gd name="connsiteX125" fmla="*/ 827651 w 3174096"/>
                    <a:gd name="connsiteY125" fmla="*/ 692150 h 912615"/>
                    <a:gd name="connsiteX126" fmla="*/ 789551 w 3174096"/>
                    <a:gd name="connsiteY126" fmla="*/ 704850 h 912615"/>
                    <a:gd name="connsiteX127" fmla="*/ 726051 w 3174096"/>
                    <a:gd name="connsiteY127" fmla="*/ 717550 h 912615"/>
                    <a:gd name="connsiteX128" fmla="*/ 691126 w 3174096"/>
                    <a:gd name="connsiteY128" fmla="*/ 730250 h 912615"/>
                    <a:gd name="connsiteX129" fmla="*/ 560951 w 3174096"/>
                    <a:gd name="connsiteY129" fmla="*/ 723900 h 912615"/>
                    <a:gd name="connsiteX130" fmla="*/ 529201 w 3174096"/>
                    <a:gd name="connsiteY130" fmla="*/ 723900 h 912615"/>
                    <a:gd name="connsiteX131" fmla="*/ 414901 w 3174096"/>
                    <a:gd name="connsiteY131" fmla="*/ 711200 h 912615"/>
                    <a:gd name="connsiteX132" fmla="*/ 379976 w 3174096"/>
                    <a:gd name="connsiteY132" fmla="*/ 714375 h 912615"/>
                    <a:gd name="connsiteX133" fmla="*/ 357751 w 3174096"/>
                    <a:gd name="connsiteY133" fmla="*/ 723900 h 912615"/>
                    <a:gd name="connsiteX134" fmla="*/ 246626 w 3174096"/>
                    <a:gd name="connsiteY134" fmla="*/ 708025 h 912615"/>
                    <a:gd name="connsiteX135" fmla="*/ 227576 w 3174096"/>
                    <a:gd name="connsiteY135" fmla="*/ 708025 h 912615"/>
                    <a:gd name="connsiteX136" fmla="*/ 160901 w 3174096"/>
                    <a:gd name="connsiteY136" fmla="*/ 708025 h 912615"/>
                    <a:gd name="connsiteX137" fmla="*/ 145026 w 3174096"/>
                    <a:gd name="connsiteY137" fmla="*/ 711200 h 912615"/>
                    <a:gd name="connsiteX138" fmla="*/ 113276 w 3174096"/>
                    <a:gd name="connsiteY138" fmla="*/ 723900 h 912615"/>
                    <a:gd name="connsiteX139" fmla="*/ 84701 w 3174096"/>
                    <a:gd name="connsiteY139" fmla="*/ 733425 h 912615"/>
                    <a:gd name="connsiteX140" fmla="*/ 59301 w 3174096"/>
                    <a:gd name="connsiteY140" fmla="*/ 739775 h 912615"/>
                    <a:gd name="connsiteX141" fmla="*/ 18026 w 3174096"/>
                    <a:gd name="connsiteY141" fmla="*/ 749300 h 912615"/>
                    <a:gd name="connsiteX142" fmla="*/ 5326 w 3174096"/>
                    <a:gd name="connsiteY142" fmla="*/ 752475 h 912615"/>
                    <a:gd name="connsiteX143" fmla="*/ 103751 w 3174096"/>
                    <a:gd name="connsiteY143" fmla="*/ 895350 h 912615"/>
                    <a:gd name="connsiteX0" fmla="*/ 103751 w 3174096"/>
                    <a:gd name="connsiteY0" fmla="*/ 882650 h 912615"/>
                    <a:gd name="connsiteX1" fmla="*/ 218051 w 3174096"/>
                    <a:gd name="connsiteY1" fmla="*/ 835025 h 912615"/>
                    <a:gd name="connsiteX2" fmla="*/ 373626 w 3174096"/>
                    <a:gd name="connsiteY2" fmla="*/ 854075 h 912615"/>
                    <a:gd name="connsiteX3" fmla="*/ 462526 w 3174096"/>
                    <a:gd name="connsiteY3" fmla="*/ 866775 h 912615"/>
                    <a:gd name="connsiteX4" fmla="*/ 535551 w 3174096"/>
                    <a:gd name="connsiteY4" fmla="*/ 869950 h 912615"/>
                    <a:gd name="connsiteX5" fmla="*/ 646676 w 3174096"/>
                    <a:gd name="connsiteY5" fmla="*/ 860425 h 912615"/>
                    <a:gd name="connsiteX6" fmla="*/ 726051 w 3174096"/>
                    <a:gd name="connsiteY6" fmla="*/ 838200 h 912615"/>
                    <a:gd name="connsiteX7" fmla="*/ 818126 w 3174096"/>
                    <a:gd name="connsiteY7" fmla="*/ 819150 h 912615"/>
                    <a:gd name="connsiteX8" fmla="*/ 973701 w 3174096"/>
                    <a:gd name="connsiteY8" fmla="*/ 812800 h 912615"/>
                    <a:gd name="connsiteX9" fmla="*/ 1170551 w 3174096"/>
                    <a:gd name="connsiteY9" fmla="*/ 838200 h 912615"/>
                    <a:gd name="connsiteX10" fmla="*/ 1357876 w 3174096"/>
                    <a:gd name="connsiteY10" fmla="*/ 904875 h 912615"/>
                    <a:gd name="connsiteX11" fmla="*/ 1491226 w 3174096"/>
                    <a:gd name="connsiteY11" fmla="*/ 908050 h 912615"/>
                    <a:gd name="connsiteX12" fmla="*/ 1649976 w 3174096"/>
                    <a:gd name="connsiteY12" fmla="*/ 876300 h 912615"/>
                    <a:gd name="connsiteX13" fmla="*/ 1742051 w 3174096"/>
                    <a:gd name="connsiteY13" fmla="*/ 844550 h 912615"/>
                    <a:gd name="connsiteX14" fmla="*/ 1786501 w 3174096"/>
                    <a:gd name="connsiteY14" fmla="*/ 819150 h 912615"/>
                    <a:gd name="connsiteX15" fmla="*/ 1850001 w 3174096"/>
                    <a:gd name="connsiteY15" fmla="*/ 793750 h 912615"/>
                    <a:gd name="connsiteX16" fmla="*/ 1903976 w 3174096"/>
                    <a:gd name="connsiteY16" fmla="*/ 796925 h 912615"/>
                    <a:gd name="connsiteX17" fmla="*/ 2053201 w 3174096"/>
                    <a:gd name="connsiteY17" fmla="*/ 819150 h 912615"/>
                    <a:gd name="connsiteX18" fmla="*/ 2154801 w 3174096"/>
                    <a:gd name="connsiteY18" fmla="*/ 822325 h 912615"/>
                    <a:gd name="connsiteX19" fmla="*/ 2259576 w 3174096"/>
                    <a:gd name="connsiteY19" fmla="*/ 841375 h 912615"/>
                    <a:gd name="connsiteX20" fmla="*/ 2364351 w 3174096"/>
                    <a:gd name="connsiteY20" fmla="*/ 873125 h 912615"/>
                    <a:gd name="connsiteX21" fmla="*/ 2494526 w 3174096"/>
                    <a:gd name="connsiteY21" fmla="*/ 860425 h 912615"/>
                    <a:gd name="connsiteX22" fmla="*/ 2589776 w 3174096"/>
                    <a:gd name="connsiteY22" fmla="*/ 838200 h 912615"/>
                    <a:gd name="connsiteX23" fmla="*/ 2637401 w 3174096"/>
                    <a:gd name="connsiteY23" fmla="*/ 815975 h 912615"/>
                    <a:gd name="connsiteX24" fmla="*/ 2707251 w 3174096"/>
                    <a:gd name="connsiteY24" fmla="*/ 819150 h 912615"/>
                    <a:gd name="connsiteX25" fmla="*/ 2764401 w 3174096"/>
                    <a:gd name="connsiteY25" fmla="*/ 806450 h 912615"/>
                    <a:gd name="connsiteX26" fmla="*/ 2812026 w 3174096"/>
                    <a:gd name="connsiteY26" fmla="*/ 787400 h 912615"/>
                    <a:gd name="connsiteX27" fmla="*/ 2834251 w 3174096"/>
                    <a:gd name="connsiteY27" fmla="*/ 771525 h 912615"/>
                    <a:gd name="connsiteX28" fmla="*/ 2869176 w 3174096"/>
                    <a:gd name="connsiteY28" fmla="*/ 787400 h 912615"/>
                    <a:gd name="connsiteX29" fmla="*/ 2907276 w 3174096"/>
                    <a:gd name="connsiteY29" fmla="*/ 822325 h 912615"/>
                    <a:gd name="connsiteX30" fmla="*/ 2986651 w 3174096"/>
                    <a:gd name="connsiteY30" fmla="*/ 847725 h 912615"/>
                    <a:gd name="connsiteX31" fmla="*/ 3062851 w 3174096"/>
                    <a:gd name="connsiteY31" fmla="*/ 841375 h 912615"/>
                    <a:gd name="connsiteX32" fmla="*/ 3123176 w 3174096"/>
                    <a:gd name="connsiteY32" fmla="*/ 800100 h 912615"/>
                    <a:gd name="connsiteX33" fmla="*/ 3139051 w 3174096"/>
                    <a:gd name="connsiteY33" fmla="*/ 762000 h 912615"/>
                    <a:gd name="connsiteX34" fmla="*/ 3167626 w 3174096"/>
                    <a:gd name="connsiteY34" fmla="*/ 695325 h 912615"/>
                    <a:gd name="connsiteX35" fmla="*/ 3173976 w 3174096"/>
                    <a:gd name="connsiteY35" fmla="*/ 628650 h 912615"/>
                    <a:gd name="connsiteX36" fmla="*/ 3164451 w 3174096"/>
                    <a:gd name="connsiteY36" fmla="*/ 584200 h 912615"/>
                    <a:gd name="connsiteX37" fmla="*/ 3139051 w 3174096"/>
                    <a:gd name="connsiteY37" fmla="*/ 539750 h 912615"/>
                    <a:gd name="connsiteX38" fmla="*/ 3126351 w 3174096"/>
                    <a:gd name="connsiteY38" fmla="*/ 485775 h 912615"/>
                    <a:gd name="connsiteX39" fmla="*/ 3116826 w 3174096"/>
                    <a:gd name="connsiteY39" fmla="*/ 425450 h 912615"/>
                    <a:gd name="connsiteX40" fmla="*/ 3107301 w 3174096"/>
                    <a:gd name="connsiteY40" fmla="*/ 374650 h 912615"/>
                    <a:gd name="connsiteX41" fmla="*/ 3075551 w 3174096"/>
                    <a:gd name="connsiteY41" fmla="*/ 311150 h 912615"/>
                    <a:gd name="connsiteX42" fmla="*/ 3066026 w 3174096"/>
                    <a:gd name="connsiteY42" fmla="*/ 307975 h 912615"/>
                    <a:gd name="connsiteX43" fmla="*/ 3037451 w 3174096"/>
                    <a:gd name="connsiteY43" fmla="*/ 295275 h 912615"/>
                    <a:gd name="connsiteX44" fmla="*/ 2989826 w 3174096"/>
                    <a:gd name="connsiteY44" fmla="*/ 279400 h 912615"/>
                    <a:gd name="connsiteX45" fmla="*/ 2958076 w 3174096"/>
                    <a:gd name="connsiteY45" fmla="*/ 247650 h 912615"/>
                    <a:gd name="connsiteX46" fmla="*/ 2942201 w 3174096"/>
                    <a:gd name="connsiteY46" fmla="*/ 225425 h 912615"/>
                    <a:gd name="connsiteX47" fmla="*/ 2926326 w 3174096"/>
                    <a:gd name="connsiteY47" fmla="*/ 200025 h 912615"/>
                    <a:gd name="connsiteX48" fmla="*/ 2885051 w 3174096"/>
                    <a:gd name="connsiteY48" fmla="*/ 152400 h 912615"/>
                    <a:gd name="connsiteX49" fmla="*/ 2869176 w 3174096"/>
                    <a:gd name="connsiteY49" fmla="*/ 139700 h 912615"/>
                    <a:gd name="connsiteX50" fmla="*/ 2843776 w 3174096"/>
                    <a:gd name="connsiteY50" fmla="*/ 104775 h 912615"/>
                    <a:gd name="connsiteX51" fmla="*/ 2805676 w 3174096"/>
                    <a:gd name="connsiteY51" fmla="*/ 57150 h 912615"/>
                    <a:gd name="connsiteX52" fmla="*/ 2777101 w 3174096"/>
                    <a:gd name="connsiteY52" fmla="*/ 28575 h 912615"/>
                    <a:gd name="connsiteX53" fmla="*/ 2739001 w 3174096"/>
                    <a:gd name="connsiteY53" fmla="*/ 15875 h 912615"/>
                    <a:gd name="connsiteX54" fmla="*/ 2678676 w 3174096"/>
                    <a:gd name="connsiteY54" fmla="*/ 6350 h 912615"/>
                    <a:gd name="connsiteX55" fmla="*/ 2612001 w 3174096"/>
                    <a:gd name="connsiteY55" fmla="*/ 0 h 912615"/>
                    <a:gd name="connsiteX56" fmla="*/ 2583426 w 3174096"/>
                    <a:gd name="connsiteY56" fmla="*/ 6350 h 912615"/>
                    <a:gd name="connsiteX57" fmla="*/ 2545326 w 3174096"/>
                    <a:gd name="connsiteY57" fmla="*/ 19050 h 912615"/>
                    <a:gd name="connsiteX58" fmla="*/ 2494526 w 3174096"/>
                    <a:gd name="connsiteY58" fmla="*/ 41275 h 912615"/>
                    <a:gd name="connsiteX59" fmla="*/ 2475476 w 3174096"/>
                    <a:gd name="connsiteY59" fmla="*/ 76200 h 912615"/>
                    <a:gd name="connsiteX60" fmla="*/ 2469126 w 3174096"/>
                    <a:gd name="connsiteY60" fmla="*/ 107950 h 912615"/>
                    <a:gd name="connsiteX61" fmla="*/ 2478651 w 3174096"/>
                    <a:gd name="connsiteY61" fmla="*/ 136525 h 912615"/>
                    <a:gd name="connsiteX62" fmla="*/ 2481826 w 3174096"/>
                    <a:gd name="connsiteY62" fmla="*/ 152400 h 912615"/>
                    <a:gd name="connsiteX63" fmla="*/ 2529451 w 3174096"/>
                    <a:gd name="connsiteY63" fmla="*/ 155575 h 912615"/>
                    <a:gd name="connsiteX64" fmla="*/ 2545326 w 3174096"/>
                    <a:gd name="connsiteY64" fmla="*/ 155575 h 912615"/>
                    <a:gd name="connsiteX65" fmla="*/ 2573901 w 3174096"/>
                    <a:gd name="connsiteY65" fmla="*/ 146050 h 912615"/>
                    <a:gd name="connsiteX66" fmla="*/ 2586601 w 3174096"/>
                    <a:gd name="connsiteY66" fmla="*/ 133350 h 912615"/>
                    <a:gd name="connsiteX67" fmla="*/ 2602476 w 3174096"/>
                    <a:gd name="connsiteY67" fmla="*/ 120650 h 912615"/>
                    <a:gd name="connsiteX68" fmla="*/ 2643751 w 3174096"/>
                    <a:gd name="connsiteY68" fmla="*/ 123825 h 912615"/>
                    <a:gd name="connsiteX69" fmla="*/ 2669151 w 3174096"/>
                    <a:gd name="connsiteY69" fmla="*/ 142875 h 912615"/>
                    <a:gd name="connsiteX70" fmla="*/ 2707251 w 3174096"/>
                    <a:gd name="connsiteY70" fmla="*/ 171450 h 912615"/>
                    <a:gd name="connsiteX71" fmla="*/ 2735826 w 3174096"/>
                    <a:gd name="connsiteY71" fmla="*/ 206375 h 912615"/>
                    <a:gd name="connsiteX72" fmla="*/ 2777101 w 3174096"/>
                    <a:gd name="connsiteY72" fmla="*/ 276225 h 912615"/>
                    <a:gd name="connsiteX73" fmla="*/ 2792976 w 3174096"/>
                    <a:gd name="connsiteY73" fmla="*/ 311150 h 912615"/>
                    <a:gd name="connsiteX74" fmla="*/ 2805676 w 3174096"/>
                    <a:gd name="connsiteY74" fmla="*/ 352425 h 912615"/>
                    <a:gd name="connsiteX75" fmla="*/ 2818376 w 3174096"/>
                    <a:gd name="connsiteY75" fmla="*/ 390525 h 912615"/>
                    <a:gd name="connsiteX76" fmla="*/ 2821551 w 3174096"/>
                    <a:gd name="connsiteY76" fmla="*/ 409575 h 912615"/>
                    <a:gd name="connsiteX77" fmla="*/ 2821551 w 3174096"/>
                    <a:gd name="connsiteY77" fmla="*/ 431800 h 912615"/>
                    <a:gd name="connsiteX78" fmla="*/ 2824726 w 3174096"/>
                    <a:gd name="connsiteY78" fmla="*/ 466725 h 912615"/>
                    <a:gd name="connsiteX79" fmla="*/ 2827901 w 3174096"/>
                    <a:gd name="connsiteY79" fmla="*/ 495300 h 912615"/>
                    <a:gd name="connsiteX80" fmla="*/ 2831076 w 3174096"/>
                    <a:gd name="connsiteY80" fmla="*/ 520700 h 912615"/>
                    <a:gd name="connsiteX81" fmla="*/ 2831076 w 3174096"/>
                    <a:gd name="connsiteY81" fmla="*/ 549275 h 912615"/>
                    <a:gd name="connsiteX82" fmla="*/ 2827901 w 3174096"/>
                    <a:gd name="connsiteY82" fmla="*/ 561975 h 912615"/>
                    <a:gd name="connsiteX83" fmla="*/ 2821551 w 3174096"/>
                    <a:gd name="connsiteY83" fmla="*/ 574675 h 912615"/>
                    <a:gd name="connsiteX84" fmla="*/ 2812026 w 3174096"/>
                    <a:gd name="connsiteY84" fmla="*/ 593725 h 912615"/>
                    <a:gd name="connsiteX85" fmla="*/ 2808851 w 3174096"/>
                    <a:gd name="connsiteY85" fmla="*/ 609600 h 912615"/>
                    <a:gd name="connsiteX86" fmla="*/ 2808851 w 3174096"/>
                    <a:gd name="connsiteY86" fmla="*/ 625475 h 912615"/>
                    <a:gd name="connsiteX87" fmla="*/ 2812026 w 3174096"/>
                    <a:gd name="connsiteY87" fmla="*/ 638175 h 912615"/>
                    <a:gd name="connsiteX88" fmla="*/ 2812026 w 3174096"/>
                    <a:gd name="connsiteY88" fmla="*/ 638175 h 912615"/>
                    <a:gd name="connsiteX89" fmla="*/ 2761226 w 3174096"/>
                    <a:gd name="connsiteY89" fmla="*/ 657225 h 912615"/>
                    <a:gd name="connsiteX90" fmla="*/ 2710426 w 3174096"/>
                    <a:gd name="connsiteY90" fmla="*/ 666750 h 912615"/>
                    <a:gd name="connsiteX91" fmla="*/ 2662801 w 3174096"/>
                    <a:gd name="connsiteY91" fmla="*/ 673100 h 912615"/>
                    <a:gd name="connsiteX92" fmla="*/ 2637401 w 3174096"/>
                    <a:gd name="connsiteY92" fmla="*/ 673100 h 912615"/>
                    <a:gd name="connsiteX93" fmla="*/ 2599301 w 3174096"/>
                    <a:gd name="connsiteY93" fmla="*/ 673100 h 912615"/>
                    <a:gd name="connsiteX94" fmla="*/ 2561201 w 3174096"/>
                    <a:gd name="connsiteY94" fmla="*/ 669925 h 912615"/>
                    <a:gd name="connsiteX95" fmla="*/ 2545326 w 3174096"/>
                    <a:gd name="connsiteY95" fmla="*/ 673100 h 912615"/>
                    <a:gd name="connsiteX96" fmla="*/ 2519926 w 3174096"/>
                    <a:gd name="connsiteY96" fmla="*/ 685800 h 912615"/>
                    <a:gd name="connsiteX97" fmla="*/ 2497701 w 3174096"/>
                    <a:gd name="connsiteY97" fmla="*/ 695325 h 912615"/>
                    <a:gd name="connsiteX98" fmla="*/ 2453251 w 3174096"/>
                    <a:gd name="connsiteY98" fmla="*/ 704850 h 912615"/>
                    <a:gd name="connsiteX99" fmla="*/ 2408801 w 3174096"/>
                    <a:gd name="connsiteY99" fmla="*/ 714375 h 912615"/>
                    <a:gd name="connsiteX100" fmla="*/ 2361176 w 3174096"/>
                    <a:gd name="connsiteY100" fmla="*/ 720725 h 912615"/>
                    <a:gd name="connsiteX101" fmla="*/ 2329426 w 3174096"/>
                    <a:gd name="connsiteY101" fmla="*/ 708025 h 912615"/>
                    <a:gd name="connsiteX102" fmla="*/ 2265926 w 3174096"/>
                    <a:gd name="connsiteY102" fmla="*/ 695325 h 912615"/>
                    <a:gd name="connsiteX103" fmla="*/ 2227826 w 3174096"/>
                    <a:gd name="connsiteY103" fmla="*/ 688975 h 912615"/>
                    <a:gd name="connsiteX104" fmla="*/ 2186551 w 3174096"/>
                    <a:gd name="connsiteY104" fmla="*/ 682625 h 912615"/>
                    <a:gd name="connsiteX105" fmla="*/ 2129401 w 3174096"/>
                    <a:gd name="connsiteY105" fmla="*/ 673100 h 912615"/>
                    <a:gd name="connsiteX106" fmla="*/ 2091301 w 3174096"/>
                    <a:gd name="connsiteY106" fmla="*/ 666750 h 912615"/>
                    <a:gd name="connsiteX107" fmla="*/ 2043676 w 3174096"/>
                    <a:gd name="connsiteY107" fmla="*/ 657225 h 912615"/>
                    <a:gd name="connsiteX108" fmla="*/ 1929376 w 3174096"/>
                    <a:gd name="connsiteY108" fmla="*/ 650875 h 912615"/>
                    <a:gd name="connsiteX109" fmla="*/ 1869051 w 3174096"/>
                    <a:gd name="connsiteY109" fmla="*/ 654050 h 912615"/>
                    <a:gd name="connsiteX110" fmla="*/ 1783326 w 3174096"/>
                    <a:gd name="connsiteY110" fmla="*/ 657225 h 912615"/>
                    <a:gd name="connsiteX111" fmla="*/ 1745226 w 3174096"/>
                    <a:gd name="connsiteY111" fmla="*/ 663575 h 912615"/>
                    <a:gd name="connsiteX112" fmla="*/ 1700776 w 3174096"/>
                    <a:gd name="connsiteY112" fmla="*/ 685800 h 912615"/>
                    <a:gd name="connsiteX113" fmla="*/ 1643626 w 3174096"/>
                    <a:gd name="connsiteY113" fmla="*/ 708025 h 912615"/>
                    <a:gd name="connsiteX114" fmla="*/ 1599176 w 3174096"/>
                    <a:gd name="connsiteY114" fmla="*/ 730250 h 912615"/>
                    <a:gd name="connsiteX115" fmla="*/ 1532501 w 3174096"/>
                    <a:gd name="connsiteY115" fmla="*/ 733425 h 912615"/>
                    <a:gd name="connsiteX116" fmla="*/ 1484876 w 3174096"/>
                    <a:gd name="connsiteY116" fmla="*/ 733425 h 912615"/>
                    <a:gd name="connsiteX117" fmla="*/ 1465826 w 3174096"/>
                    <a:gd name="connsiteY117" fmla="*/ 733425 h 912615"/>
                    <a:gd name="connsiteX118" fmla="*/ 1437251 w 3174096"/>
                    <a:gd name="connsiteY118" fmla="*/ 768350 h 912615"/>
                    <a:gd name="connsiteX119" fmla="*/ 1367401 w 3174096"/>
                    <a:gd name="connsiteY119" fmla="*/ 768350 h 912615"/>
                    <a:gd name="connsiteX120" fmla="*/ 1256276 w 3174096"/>
                    <a:gd name="connsiteY120" fmla="*/ 742950 h 912615"/>
                    <a:gd name="connsiteX121" fmla="*/ 1183251 w 3174096"/>
                    <a:gd name="connsiteY121" fmla="*/ 727075 h 912615"/>
                    <a:gd name="connsiteX122" fmla="*/ 1043551 w 3174096"/>
                    <a:gd name="connsiteY122" fmla="*/ 695325 h 912615"/>
                    <a:gd name="connsiteX123" fmla="*/ 973701 w 3174096"/>
                    <a:gd name="connsiteY123" fmla="*/ 692150 h 912615"/>
                    <a:gd name="connsiteX124" fmla="*/ 881626 w 3174096"/>
                    <a:gd name="connsiteY124" fmla="*/ 688975 h 912615"/>
                    <a:gd name="connsiteX125" fmla="*/ 827651 w 3174096"/>
                    <a:gd name="connsiteY125" fmla="*/ 692150 h 912615"/>
                    <a:gd name="connsiteX126" fmla="*/ 789551 w 3174096"/>
                    <a:gd name="connsiteY126" fmla="*/ 704850 h 912615"/>
                    <a:gd name="connsiteX127" fmla="*/ 726051 w 3174096"/>
                    <a:gd name="connsiteY127" fmla="*/ 717550 h 912615"/>
                    <a:gd name="connsiteX128" fmla="*/ 691126 w 3174096"/>
                    <a:gd name="connsiteY128" fmla="*/ 730250 h 912615"/>
                    <a:gd name="connsiteX129" fmla="*/ 560951 w 3174096"/>
                    <a:gd name="connsiteY129" fmla="*/ 723900 h 912615"/>
                    <a:gd name="connsiteX130" fmla="*/ 529201 w 3174096"/>
                    <a:gd name="connsiteY130" fmla="*/ 723900 h 912615"/>
                    <a:gd name="connsiteX131" fmla="*/ 414901 w 3174096"/>
                    <a:gd name="connsiteY131" fmla="*/ 711200 h 912615"/>
                    <a:gd name="connsiteX132" fmla="*/ 379976 w 3174096"/>
                    <a:gd name="connsiteY132" fmla="*/ 714375 h 912615"/>
                    <a:gd name="connsiteX133" fmla="*/ 357751 w 3174096"/>
                    <a:gd name="connsiteY133" fmla="*/ 723900 h 912615"/>
                    <a:gd name="connsiteX134" fmla="*/ 246626 w 3174096"/>
                    <a:gd name="connsiteY134" fmla="*/ 708025 h 912615"/>
                    <a:gd name="connsiteX135" fmla="*/ 227576 w 3174096"/>
                    <a:gd name="connsiteY135" fmla="*/ 708025 h 912615"/>
                    <a:gd name="connsiteX136" fmla="*/ 160901 w 3174096"/>
                    <a:gd name="connsiteY136" fmla="*/ 708025 h 912615"/>
                    <a:gd name="connsiteX137" fmla="*/ 145026 w 3174096"/>
                    <a:gd name="connsiteY137" fmla="*/ 711200 h 912615"/>
                    <a:gd name="connsiteX138" fmla="*/ 113276 w 3174096"/>
                    <a:gd name="connsiteY138" fmla="*/ 723900 h 912615"/>
                    <a:gd name="connsiteX139" fmla="*/ 84701 w 3174096"/>
                    <a:gd name="connsiteY139" fmla="*/ 733425 h 912615"/>
                    <a:gd name="connsiteX140" fmla="*/ 59301 w 3174096"/>
                    <a:gd name="connsiteY140" fmla="*/ 739775 h 912615"/>
                    <a:gd name="connsiteX141" fmla="*/ 18026 w 3174096"/>
                    <a:gd name="connsiteY141" fmla="*/ 749300 h 912615"/>
                    <a:gd name="connsiteX142" fmla="*/ 5326 w 3174096"/>
                    <a:gd name="connsiteY142" fmla="*/ 752475 h 912615"/>
                    <a:gd name="connsiteX143" fmla="*/ 103751 w 3174096"/>
                    <a:gd name="connsiteY143" fmla="*/ 895350 h 912615"/>
                    <a:gd name="connsiteX0" fmla="*/ 102845 w 3173190"/>
                    <a:gd name="connsiteY0" fmla="*/ 882650 h 912615"/>
                    <a:gd name="connsiteX1" fmla="*/ 217145 w 3173190"/>
                    <a:gd name="connsiteY1" fmla="*/ 835025 h 912615"/>
                    <a:gd name="connsiteX2" fmla="*/ 372720 w 3173190"/>
                    <a:gd name="connsiteY2" fmla="*/ 854075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483970 w 3173190"/>
                    <a:gd name="connsiteY116" fmla="*/ 733425 h 912615"/>
                    <a:gd name="connsiteX117" fmla="*/ 1464920 w 3173190"/>
                    <a:gd name="connsiteY117" fmla="*/ 733425 h 912615"/>
                    <a:gd name="connsiteX118" fmla="*/ 1436345 w 3173190"/>
                    <a:gd name="connsiteY118" fmla="*/ 768350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72720 w 3173190"/>
                    <a:gd name="connsiteY2" fmla="*/ 854075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483970 w 3173190"/>
                    <a:gd name="connsiteY116" fmla="*/ 733425 h 912615"/>
                    <a:gd name="connsiteX117" fmla="*/ 1464920 w 3173190"/>
                    <a:gd name="connsiteY117" fmla="*/ 733425 h 912615"/>
                    <a:gd name="connsiteX118" fmla="*/ 1436345 w 3173190"/>
                    <a:gd name="connsiteY118" fmla="*/ 768350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483970 w 3173190"/>
                    <a:gd name="connsiteY116" fmla="*/ 733425 h 912615"/>
                    <a:gd name="connsiteX117" fmla="*/ 1464920 w 3173190"/>
                    <a:gd name="connsiteY117" fmla="*/ 733425 h 912615"/>
                    <a:gd name="connsiteX118" fmla="*/ 1436345 w 3173190"/>
                    <a:gd name="connsiteY118" fmla="*/ 768350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483970 w 3173190"/>
                    <a:gd name="connsiteY116" fmla="*/ 733425 h 912615"/>
                    <a:gd name="connsiteX117" fmla="*/ 1464920 w 3173190"/>
                    <a:gd name="connsiteY117" fmla="*/ 7334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483970 w 3173190"/>
                    <a:gd name="connsiteY116" fmla="*/ 73342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31595 w 3173190"/>
                    <a:gd name="connsiteY115" fmla="*/ 7334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156820 w 3173190"/>
                    <a:gd name="connsiteY0" fmla="*/ 841375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206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58750 h 912615"/>
                    <a:gd name="connsiteX68" fmla="*/ 2642845 w 3173190"/>
                    <a:gd name="connsiteY68" fmla="*/ 123825 h 912615"/>
                    <a:gd name="connsiteX69" fmla="*/ 2668245 w 3173190"/>
                    <a:gd name="connsiteY69" fmla="*/ 142875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58750 h 912615"/>
                    <a:gd name="connsiteX68" fmla="*/ 2642845 w 3173190"/>
                    <a:gd name="connsiteY68" fmla="*/ 123825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58750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5695 w 3173190"/>
                    <a:gd name="connsiteY66" fmla="*/ 133350 h 912615"/>
                    <a:gd name="connsiteX67" fmla="*/ 2601570 w 3173190"/>
                    <a:gd name="connsiteY67" fmla="*/ 1746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2520 w 3173190"/>
                    <a:gd name="connsiteY66" fmla="*/ 158750 h 912615"/>
                    <a:gd name="connsiteX67" fmla="*/ 2601570 w 3173190"/>
                    <a:gd name="connsiteY67" fmla="*/ 1746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46050 h 912615"/>
                    <a:gd name="connsiteX66" fmla="*/ 2582520 w 3173190"/>
                    <a:gd name="connsiteY66" fmla="*/ 158750 h 912615"/>
                    <a:gd name="connsiteX67" fmla="*/ 2614270 w 3173190"/>
                    <a:gd name="connsiteY67" fmla="*/ 1619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77745 w 3173190"/>
                    <a:gd name="connsiteY61" fmla="*/ 136525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55989 h 912615"/>
                    <a:gd name="connsiteX66" fmla="*/ 2582520 w 3173190"/>
                    <a:gd name="connsiteY66" fmla="*/ 158750 h 912615"/>
                    <a:gd name="connsiteX67" fmla="*/ 2614270 w 3173190"/>
                    <a:gd name="connsiteY67" fmla="*/ 1619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44420 w 3173190"/>
                    <a:gd name="connsiteY57" fmla="*/ 19050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69462 w 3173190"/>
                    <a:gd name="connsiteY61" fmla="*/ 143151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55989 h 912615"/>
                    <a:gd name="connsiteX66" fmla="*/ 2582520 w 3173190"/>
                    <a:gd name="connsiteY66" fmla="*/ 158750 h 912615"/>
                    <a:gd name="connsiteX67" fmla="*/ 2614270 w 3173190"/>
                    <a:gd name="connsiteY67" fmla="*/ 1619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57250 h 912615"/>
                    <a:gd name="connsiteX1" fmla="*/ 217145 w 3173190"/>
                    <a:gd name="connsiteY1" fmla="*/ 835025 h 912615"/>
                    <a:gd name="connsiteX2" fmla="*/ 340970 w 3173190"/>
                    <a:gd name="connsiteY2" fmla="*/ 825500 h 912615"/>
                    <a:gd name="connsiteX3" fmla="*/ 461620 w 3173190"/>
                    <a:gd name="connsiteY3" fmla="*/ 866775 h 912615"/>
                    <a:gd name="connsiteX4" fmla="*/ 534645 w 3173190"/>
                    <a:gd name="connsiteY4" fmla="*/ 869950 h 912615"/>
                    <a:gd name="connsiteX5" fmla="*/ 645770 w 3173190"/>
                    <a:gd name="connsiteY5" fmla="*/ 860425 h 912615"/>
                    <a:gd name="connsiteX6" fmla="*/ 725145 w 3173190"/>
                    <a:gd name="connsiteY6" fmla="*/ 838200 h 912615"/>
                    <a:gd name="connsiteX7" fmla="*/ 817220 w 3173190"/>
                    <a:gd name="connsiteY7" fmla="*/ 819150 h 912615"/>
                    <a:gd name="connsiteX8" fmla="*/ 972795 w 3173190"/>
                    <a:gd name="connsiteY8" fmla="*/ 812800 h 912615"/>
                    <a:gd name="connsiteX9" fmla="*/ 1169645 w 3173190"/>
                    <a:gd name="connsiteY9" fmla="*/ 838200 h 912615"/>
                    <a:gd name="connsiteX10" fmla="*/ 1356970 w 3173190"/>
                    <a:gd name="connsiteY10" fmla="*/ 904875 h 912615"/>
                    <a:gd name="connsiteX11" fmla="*/ 1490320 w 3173190"/>
                    <a:gd name="connsiteY11" fmla="*/ 908050 h 912615"/>
                    <a:gd name="connsiteX12" fmla="*/ 1649070 w 3173190"/>
                    <a:gd name="connsiteY12" fmla="*/ 876300 h 912615"/>
                    <a:gd name="connsiteX13" fmla="*/ 1741145 w 3173190"/>
                    <a:gd name="connsiteY13" fmla="*/ 844550 h 912615"/>
                    <a:gd name="connsiteX14" fmla="*/ 1785595 w 3173190"/>
                    <a:gd name="connsiteY14" fmla="*/ 819150 h 912615"/>
                    <a:gd name="connsiteX15" fmla="*/ 1849095 w 3173190"/>
                    <a:gd name="connsiteY15" fmla="*/ 793750 h 912615"/>
                    <a:gd name="connsiteX16" fmla="*/ 1903070 w 3173190"/>
                    <a:gd name="connsiteY16" fmla="*/ 796925 h 912615"/>
                    <a:gd name="connsiteX17" fmla="*/ 2052295 w 3173190"/>
                    <a:gd name="connsiteY17" fmla="*/ 819150 h 912615"/>
                    <a:gd name="connsiteX18" fmla="*/ 2153895 w 3173190"/>
                    <a:gd name="connsiteY18" fmla="*/ 822325 h 912615"/>
                    <a:gd name="connsiteX19" fmla="*/ 2258670 w 3173190"/>
                    <a:gd name="connsiteY19" fmla="*/ 841375 h 912615"/>
                    <a:gd name="connsiteX20" fmla="*/ 2363445 w 3173190"/>
                    <a:gd name="connsiteY20" fmla="*/ 873125 h 912615"/>
                    <a:gd name="connsiteX21" fmla="*/ 2493620 w 3173190"/>
                    <a:gd name="connsiteY21" fmla="*/ 860425 h 912615"/>
                    <a:gd name="connsiteX22" fmla="*/ 2588870 w 3173190"/>
                    <a:gd name="connsiteY22" fmla="*/ 838200 h 912615"/>
                    <a:gd name="connsiteX23" fmla="*/ 2636495 w 3173190"/>
                    <a:gd name="connsiteY23" fmla="*/ 815975 h 912615"/>
                    <a:gd name="connsiteX24" fmla="*/ 2706345 w 3173190"/>
                    <a:gd name="connsiteY24" fmla="*/ 819150 h 912615"/>
                    <a:gd name="connsiteX25" fmla="*/ 2763495 w 3173190"/>
                    <a:gd name="connsiteY25" fmla="*/ 806450 h 912615"/>
                    <a:gd name="connsiteX26" fmla="*/ 2811120 w 3173190"/>
                    <a:gd name="connsiteY26" fmla="*/ 787400 h 912615"/>
                    <a:gd name="connsiteX27" fmla="*/ 2833345 w 3173190"/>
                    <a:gd name="connsiteY27" fmla="*/ 771525 h 912615"/>
                    <a:gd name="connsiteX28" fmla="*/ 2868270 w 3173190"/>
                    <a:gd name="connsiteY28" fmla="*/ 787400 h 912615"/>
                    <a:gd name="connsiteX29" fmla="*/ 2906370 w 3173190"/>
                    <a:gd name="connsiteY29" fmla="*/ 822325 h 912615"/>
                    <a:gd name="connsiteX30" fmla="*/ 2985745 w 3173190"/>
                    <a:gd name="connsiteY30" fmla="*/ 847725 h 912615"/>
                    <a:gd name="connsiteX31" fmla="*/ 3061945 w 3173190"/>
                    <a:gd name="connsiteY31" fmla="*/ 841375 h 912615"/>
                    <a:gd name="connsiteX32" fmla="*/ 3122270 w 3173190"/>
                    <a:gd name="connsiteY32" fmla="*/ 800100 h 912615"/>
                    <a:gd name="connsiteX33" fmla="*/ 3138145 w 3173190"/>
                    <a:gd name="connsiteY33" fmla="*/ 762000 h 912615"/>
                    <a:gd name="connsiteX34" fmla="*/ 3166720 w 3173190"/>
                    <a:gd name="connsiteY34" fmla="*/ 695325 h 912615"/>
                    <a:gd name="connsiteX35" fmla="*/ 3173070 w 3173190"/>
                    <a:gd name="connsiteY35" fmla="*/ 628650 h 912615"/>
                    <a:gd name="connsiteX36" fmla="*/ 3163545 w 3173190"/>
                    <a:gd name="connsiteY36" fmla="*/ 584200 h 912615"/>
                    <a:gd name="connsiteX37" fmla="*/ 3138145 w 3173190"/>
                    <a:gd name="connsiteY37" fmla="*/ 539750 h 912615"/>
                    <a:gd name="connsiteX38" fmla="*/ 3125445 w 3173190"/>
                    <a:gd name="connsiteY38" fmla="*/ 485775 h 912615"/>
                    <a:gd name="connsiteX39" fmla="*/ 3115920 w 3173190"/>
                    <a:gd name="connsiteY39" fmla="*/ 425450 h 912615"/>
                    <a:gd name="connsiteX40" fmla="*/ 3106395 w 3173190"/>
                    <a:gd name="connsiteY40" fmla="*/ 374650 h 912615"/>
                    <a:gd name="connsiteX41" fmla="*/ 3074645 w 3173190"/>
                    <a:gd name="connsiteY41" fmla="*/ 311150 h 912615"/>
                    <a:gd name="connsiteX42" fmla="*/ 3065120 w 3173190"/>
                    <a:gd name="connsiteY42" fmla="*/ 307975 h 912615"/>
                    <a:gd name="connsiteX43" fmla="*/ 3036545 w 3173190"/>
                    <a:gd name="connsiteY43" fmla="*/ 295275 h 912615"/>
                    <a:gd name="connsiteX44" fmla="*/ 2988920 w 3173190"/>
                    <a:gd name="connsiteY44" fmla="*/ 279400 h 912615"/>
                    <a:gd name="connsiteX45" fmla="*/ 2957170 w 3173190"/>
                    <a:gd name="connsiteY45" fmla="*/ 247650 h 912615"/>
                    <a:gd name="connsiteX46" fmla="*/ 2941295 w 3173190"/>
                    <a:gd name="connsiteY46" fmla="*/ 225425 h 912615"/>
                    <a:gd name="connsiteX47" fmla="*/ 2925420 w 3173190"/>
                    <a:gd name="connsiteY47" fmla="*/ 200025 h 912615"/>
                    <a:gd name="connsiteX48" fmla="*/ 2884145 w 3173190"/>
                    <a:gd name="connsiteY48" fmla="*/ 152400 h 912615"/>
                    <a:gd name="connsiteX49" fmla="*/ 2868270 w 3173190"/>
                    <a:gd name="connsiteY49" fmla="*/ 139700 h 912615"/>
                    <a:gd name="connsiteX50" fmla="*/ 2842870 w 3173190"/>
                    <a:gd name="connsiteY50" fmla="*/ 104775 h 912615"/>
                    <a:gd name="connsiteX51" fmla="*/ 2804770 w 3173190"/>
                    <a:gd name="connsiteY51" fmla="*/ 57150 h 912615"/>
                    <a:gd name="connsiteX52" fmla="*/ 2776195 w 3173190"/>
                    <a:gd name="connsiteY52" fmla="*/ 28575 h 912615"/>
                    <a:gd name="connsiteX53" fmla="*/ 2738095 w 3173190"/>
                    <a:gd name="connsiteY53" fmla="*/ 15875 h 912615"/>
                    <a:gd name="connsiteX54" fmla="*/ 2677770 w 3173190"/>
                    <a:gd name="connsiteY54" fmla="*/ 6350 h 912615"/>
                    <a:gd name="connsiteX55" fmla="*/ 2611095 w 3173190"/>
                    <a:gd name="connsiteY55" fmla="*/ 0 h 912615"/>
                    <a:gd name="connsiteX56" fmla="*/ 2582520 w 3173190"/>
                    <a:gd name="connsiteY56" fmla="*/ 6350 h 912615"/>
                    <a:gd name="connsiteX57" fmla="*/ 2531168 w 3173190"/>
                    <a:gd name="connsiteY57" fmla="*/ 5797 h 912615"/>
                    <a:gd name="connsiteX58" fmla="*/ 2493620 w 3173190"/>
                    <a:gd name="connsiteY58" fmla="*/ 41275 h 912615"/>
                    <a:gd name="connsiteX59" fmla="*/ 2474570 w 3173190"/>
                    <a:gd name="connsiteY59" fmla="*/ 76200 h 912615"/>
                    <a:gd name="connsiteX60" fmla="*/ 2468220 w 3173190"/>
                    <a:gd name="connsiteY60" fmla="*/ 107950 h 912615"/>
                    <a:gd name="connsiteX61" fmla="*/ 2469462 w 3173190"/>
                    <a:gd name="connsiteY61" fmla="*/ 143151 h 912615"/>
                    <a:gd name="connsiteX62" fmla="*/ 2480920 w 3173190"/>
                    <a:gd name="connsiteY62" fmla="*/ 152400 h 912615"/>
                    <a:gd name="connsiteX63" fmla="*/ 2528545 w 3173190"/>
                    <a:gd name="connsiteY63" fmla="*/ 155575 h 912615"/>
                    <a:gd name="connsiteX64" fmla="*/ 2544420 w 3173190"/>
                    <a:gd name="connsiteY64" fmla="*/ 155575 h 912615"/>
                    <a:gd name="connsiteX65" fmla="*/ 2572995 w 3173190"/>
                    <a:gd name="connsiteY65" fmla="*/ 155989 h 912615"/>
                    <a:gd name="connsiteX66" fmla="*/ 2582520 w 3173190"/>
                    <a:gd name="connsiteY66" fmla="*/ 158750 h 912615"/>
                    <a:gd name="connsiteX67" fmla="*/ 2614270 w 3173190"/>
                    <a:gd name="connsiteY67" fmla="*/ 161925 h 912615"/>
                    <a:gd name="connsiteX68" fmla="*/ 2642845 w 3173190"/>
                    <a:gd name="connsiteY68" fmla="*/ 152400 h 912615"/>
                    <a:gd name="connsiteX69" fmla="*/ 2677770 w 3173190"/>
                    <a:gd name="connsiteY69" fmla="*/ 165100 h 912615"/>
                    <a:gd name="connsiteX70" fmla="*/ 2706345 w 3173190"/>
                    <a:gd name="connsiteY70" fmla="*/ 171450 h 912615"/>
                    <a:gd name="connsiteX71" fmla="*/ 2734920 w 3173190"/>
                    <a:gd name="connsiteY71" fmla="*/ 206375 h 912615"/>
                    <a:gd name="connsiteX72" fmla="*/ 2776195 w 3173190"/>
                    <a:gd name="connsiteY72" fmla="*/ 276225 h 912615"/>
                    <a:gd name="connsiteX73" fmla="*/ 2792070 w 3173190"/>
                    <a:gd name="connsiteY73" fmla="*/ 311150 h 912615"/>
                    <a:gd name="connsiteX74" fmla="*/ 2804770 w 3173190"/>
                    <a:gd name="connsiteY74" fmla="*/ 352425 h 912615"/>
                    <a:gd name="connsiteX75" fmla="*/ 2817470 w 3173190"/>
                    <a:gd name="connsiteY75" fmla="*/ 390525 h 912615"/>
                    <a:gd name="connsiteX76" fmla="*/ 2820645 w 3173190"/>
                    <a:gd name="connsiteY76" fmla="*/ 409575 h 912615"/>
                    <a:gd name="connsiteX77" fmla="*/ 2820645 w 3173190"/>
                    <a:gd name="connsiteY77" fmla="*/ 431800 h 912615"/>
                    <a:gd name="connsiteX78" fmla="*/ 2823820 w 3173190"/>
                    <a:gd name="connsiteY78" fmla="*/ 466725 h 912615"/>
                    <a:gd name="connsiteX79" fmla="*/ 2826995 w 3173190"/>
                    <a:gd name="connsiteY79" fmla="*/ 495300 h 912615"/>
                    <a:gd name="connsiteX80" fmla="*/ 2830170 w 3173190"/>
                    <a:gd name="connsiteY80" fmla="*/ 520700 h 912615"/>
                    <a:gd name="connsiteX81" fmla="*/ 2830170 w 3173190"/>
                    <a:gd name="connsiteY81" fmla="*/ 549275 h 912615"/>
                    <a:gd name="connsiteX82" fmla="*/ 2826995 w 3173190"/>
                    <a:gd name="connsiteY82" fmla="*/ 561975 h 912615"/>
                    <a:gd name="connsiteX83" fmla="*/ 2820645 w 3173190"/>
                    <a:gd name="connsiteY83" fmla="*/ 574675 h 912615"/>
                    <a:gd name="connsiteX84" fmla="*/ 2811120 w 3173190"/>
                    <a:gd name="connsiteY84" fmla="*/ 593725 h 912615"/>
                    <a:gd name="connsiteX85" fmla="*/ 2807945 w 3173190"/>
                    <a:gd name="connsiteY85" fmla="*/ 609600 h 912615"/>
                    <a:gd name="connsiteX86" fmla="*/ 2807945 w 3173190"/>
                    <a:gd name="connsiteY86" fmla="*/ 625475 h 912615"/>
                    <a:gd name="connsiteX87" fmla="*/ 2811120 w 3173190"/>
                    <a:gd name="connsiteY87" fmla="*/ 638175 h 912615"/>
                    <a:gd name="connsiteX88" fmla="*/ 2811120 w 3173190"/>
                    <a:gd name="connsiteY88" fmla="*/ 638175 h 912615"/>
                    <a:gd name="connsiteX89" fmla="*/ 2760320 w 3173190"/>
                    <a:gd name="connsiteY89" fmla="*/ 657225 h 912615"/>
                    <a:gd name="connsiteX90" fmla="*/ 2709520 w 3173190"/>
                    <a:gd name="connsiteY90" fmla="*/ 666750 h 912615"/>
                    <a:gd name="connsiteX91" fmla="*/ 2661895 w 3173190"/>
                    <a:gd name="connsiteY91" fmla="*/ 673100 h 912615"/>
                    <a:gd name="connsiteX92" fmla="*/ 2636495 w 3173190"/>
                    <a:gd name="connsiteY92" fmla="*/ 673100 h 912615"/>
                    <a:gd name="connsiteX93" fmla="*/ 2598395 w 3173190"/>
                    <a:gd name="connsiteY93" fmla="*/ 673100 h 912615"/>
                    <a:gd name="connsiteX94" fmla="*/ 2560295 w 3173190"/>
                    <a:gd name="connsiteY94" fmla="*/ 669925 h 912615"/>
                    <a:gd name="connsiteX95" fmla="*/ 2544420 w 3173190"/>
                    <a:gd name="connsiteY95" fmla="*/ 673100 h 912615"/>
                    <a:gd name="connsiteX96" fmla="*/ 2519020 w 3173190"/>
                    <a:gd name="connsiteY96" fmla="*/ 685800 h 912615"/>
                    <a:gd name="connsiteX97" fmla="*/ 2496795 w 3173190"/>
                    <a:gd name="connsiteY97" fmla="*/ 695325 h 912615"/>
                    <a:gd name="connsiteX98" fmla="*/ 2452345 w 3173190"/>
                    <a:gd name="connsiteY98" fmla="*/ 704850 h 912615"/>
                    <a:gd name="connsiteX99" fmla="*/ 2407895 w 3173190"/>
                    <a:gd name="connsiteY99" fmla="*/ 714375 h 912615"/>
                    <a:gd name="connsiteX100" fmla="*/ 2360270 w 3173190"/>
                    <a:gd name="connsiteY100" fmla="*/ 720725 h 912615"/>
                    <a:gd name="connsiteX101" fmla="*/ 2328520 w 3173190"/>
                    <a:gd name="connsiteY101" fmla="*/ 708025 h 912615"/>
                    <a:gd name="connsiteX102" fmla="*/ 2265020 w 3173190"/>
                    <a:gd name="connsiteY102" fmla="*/ 695325 h 912615"/>
                    <a:gd name="connsiteX103" fmla="*/ 2226920 w 3173190"/>
                    <a:gd name="connsiteY103" fmla="*/ 688975 h 912615"/>
                    <a:gd name="connsiteX104" fmla="*/ 2185645 w 3173190"/>
                    <a:gd name="connsiteY104" fmla="*/ 682625 h 912615"/>
                    <a:gd name="connsiteX105" fmla="*/ 2128495 w 3173190"/>
                    <a:gd name="connsiteY105" fmla="*/ 673100 h 912615"/>
                    <a:gd name="connsiteX106" fmla="*/ 2090395 w 3173190"/>
                    <a:gd name="connsiteY106" fmla="*/ 666750 h 912615"/>
                    <a:gd name="connsiteX107" fmla="*/ 2042770 w 3173190"/>
                    <a:gd name="connsiteY107" fmla="*/ 657225 h 912615"/>
                    <a:gd name="connsiteX108" fmla="*/ 1928470 w 3173190"/>
                    <a:gd name="connsiteY108" fmla="*/ 650875 h 912615"/>
                    <a:gd name="connsiteX109" fmla="*/ 1868145 w 3173190"/>
                    <a:gd name="connsiteY109" fmla="*/ 654050 h 912615"/>
                    <a:gd name="connsiteX110" fmla="*/ 1782420 w 3173190"/>
                    <a:gd name="connsiteY110" fmla="*/ 657225 h 912615"/>
                    <a:gd name="connsiteX111" fmla="*/ 1744320 w 3173190"/>
                    <a:gd name="connsiteY111" fmla="*/ 663575 h 912615"/>
                    <a:gd name="connsiteX112" fmla="*/ 1699870 w 3173190"/>
                    <a:gd name="connsiteY112" fmla="*/ 685800 h 912615"/>
                    <a:gd name="connsiteX113" fmla="*/ 1642720 w 3173190"/>
                    <a:gd name="connsiteY113" fmla="*/ 708025 h 912615"/>
                    <a:gd name="connsiteX114" fmla="*/ 1598270 w 3173190"/>
                    <a:gd name="connsiteY114" fmla="*/ 730250 h 912615"/>
                    <a:gd name="connsiteX115" fmla="*/ 1541120 w 3173190"/>
                    <a:gd name="connsiteY115" fmla="*/ 746125 h 912615"/>
                    <a:gd name="connsiteX116" fmla="*/ 1509370 w 3173190"/>
                    <a:gd name="connsiteY116" fmla="*/ 765175 h 912615"/>
                    <a:gd name="connsiteX117" fmla="*/ 1483970 w 3173190"/>
                    <a:gd name="connsiteY117" fmla="*/ 771525 h 912615"/>
                    <a:gd name="connsiteX118" fmla="*/ 1439520 w 3173190"/>
                    <a:gd name="connsiteY118" fmla="*/ 790575 h 912615"/>
                    <a:gd name="connsiteX119" fmla="*/ 1366495 w 3173190"/>
                    <a:gd name="connsiteY119" fmla="*/ 768350 h 912615"/>
                    <a:gd name="connsiteX120" fmla="*/ 1255370 w 3173190"/>
                    <a:gd name="connsiteY120" fmla="*/ 742950 h 912615"/>
                    <a:gd name="connsiteX121" fmla="*/ 1182345 w 3173190"/>
                    <a:gd name="connsiteY121" fmla="*/ 727075 h 912615"/>
                    <a:gd name="connsiteX122" fmla="*/ 1042645 w 3173190"/>
                    <a:gd name="connsiteY122" fmla="*/ 695325 h 912615"/>
                    <a:gd name="connsiteX123" fmla="*/ 972795 w 3173190"/>
                    <a:gd name="connsiteY123" fmla="*/ 692150 h 912615"/>
                    <a:gd name="connsiteX124" fmla="*/ 880720 w 3173190"/>
                    <a:gd name="connsiteY124" fmla="*/ 688975 h 912615"/>
                    <a:gd name="connsiteX125" fmla="*/ 826745 w 3173190"/>
                    <a:gd name="connsiteY125" fmla="*/ 692150 h 912615"/>
                    <a:gd name="connsiteX126" fmla="*/ 788645 w 3173190"/>
                    <a:gd name="connsiteY126" fmla="*/ 704850 h 912615"/>
                    <a:gd name="connsiteX127" fmla="*/ 725145 w 3173190"/>
                    <a:gd name="connsiteY127" fmla="*/ 717550 h 912615"/>
                    <a:gd name="connsiteX128" fmla="*/ 690220 w 3173190"/>
                    <a:gd name="connsiteY128" fmla="*/ 730250 h 912615"/>
                    <a:gd name="connsiteX129" fmla="*/ 560045 w 3173190"/>
                    <a:gd name="connsiteY129" fmla="*/ 723900 h 912615"/>
                    <a:gd name="connsiteX130" fmla="*/ 528295 w 3173190"/>
                    <a:gd name="connsiteY130" fmla="*/ 723900 h 912615"/>
                    <a:gd name="connsiteX131" fmla="*/ 413995 w 3173190"/>
                    <a:gd name="connsiteY131" fmla="*/ 711200 h 912615"/>
                    <a:gd name="connsiteX132" fmla="*/ 379070 w 3173190"/>
                    <a:gd name="connsiteY132" fmla="*/ 714375 h 912615"/>
                    <a:gd name="connsiteX133" fmla="*/ 356845 w 3173190"/>
                    <a:gd name="connsiteY133" fmla="*/ 723900 h 912615"/>
                    <a:gd name="connsiteX134" fmla="*/ 245720 w 3173190"/>
                    <a:gd name="connsiteY134" fmla="*/ 708025 h 912615"/>
                    <a:gd name="connsiteX135" fmla="*/ 226670 w 3173190"/>
                    <a:gd name="connsiteY135" fmla="*/ 708025 h 912615"/>
                    <a:gd name="connsiteX136" fmla="*/ 159995 w 3173190"/>
                    <a:gd name="connsiteY136" fmla="*/ 708025 h 912615"/>
                    <a:gd name="connsiteX137" fmla="*/ 144120 w 3173190"/>
                    <a:gd name="connsiteY137" fmla="*/ 711200 h 912615"/>
                    <a:gd name="connsiteX138" fmla="*/ 112370 w 3173190"/>
                    <a:gd name="connsiteY138" fmla="*/ 723900 h 912615"/>
                    <a:gd name="connsiteX139" fmla="*/ 83795 w 3173190"/>
                    <a:gd name="connsiteY139" fmla="*/ 733425 h 912615"/>
                    <a:gd name="connsiteX140" fmla="*/ 58395 w 3173190"/>
                    <a:gd name="connsiteY140" fmla="*/ 739775 h 912615"/>
                    <a:gd name="connsiteX141" fmla="*/ 17120 w 3173190"/>
                    <a:gd name="connsiteY141" fmla="*/ 749300 h 912615"/>
                    <a:gd name="connsiteX142" fmla="*/ 4420 w 3173190"/>
                    <a:gd name="connsiteY142" fmla="*/ 752475 h 912615"/>
                    <a:gd name="connsiteX143" fmla="*/ 90145 w 3173190"/>
                    <a:gd name="connsiteY143" fmla="*/ 850900 h 912615"/>
                    <a:gd name="connsiteX0" fmla="*/ 86970 w 3173190"/>
                    <a:gd name="connsiteY0" fmla="*/ 865899 h 921264"/>
                    <a:gd name="connsiteX1" fmla="*/ 217145 w 3173190"/>
                    <a:gd name="connsiteY1" fmla="*/ 843674 h 921264"/>
                    <a:gd name="connsiteX2" fmla="*/ 340970 w 3173190"/>
                    <a:gd name="connsiteY2" fmla="*/ 834149 h 921264"/>
                    <a:gd name="connsiteX3" fmla="*/ 461620 w 3173190"/>
                    <a:gd name="connsiteY3" fmla="*/ 875424 h 921264"/>
                    <a:gd name="connsiteX4" fmla="*/ 534645 w 3173190"/>
                    <a:gd name="connsiteY4" fmla="*/ 878599 h 921264"/>
                    <a:gd name="connsiteX5" fmla="*/ 645770 w 3173190"/>
                    <a:gd name="connsiteY5" fmla="*/ 869074 h 921264"/>
                    <a:gd name="connsiteX6" fmla="*/ 725145 w 3173190"/>
                    <a:gd name="connsiteY6" fmla="*/ 846849 h 921264"/>
                    <a:gd name="connsiteX7" fmla="*/ 817220 w 3173190"/>
                    <a:gd name="connsiteY7" fmla="*/ 827799 h 921264"/>
                    <a:gd name="connsiteX8" fmla="*/ 972795 w 3173190"/>
                    <a:gd name="connsiteY8" fmla="*/ 821449 h 921264"/>
                    <a:gd name="connsiteX9" fmla="*/ 1169645 w 3173190"/>
                    <a:gd name="connsiteY9" fmla="*/ 846849 h 921264"/>
                    <a:gd name="connsiteX10" fmla="*/ 1356970 w 3173190"/>
                    <a:gd name="connsiteY10" fmla="*/ 913524 h 921264"/>
                    <a:gd name="connsiteX11" fmla="*/ 1490320 w 3173190"/>
                    <a:gd name="connsiteY11" fmla="*/ 916699 h 921264"/>
                    <a:gd name="connsiteX12" fmla="*/ 1649070 w 3173190"/>
                    <a:gd name="connsiteY12" fmla="*/ 884949 h 921264"/>
                    <a:gd name="connsiteX13" fmla="*/ 1741145 w 3173190"/>
                    <a:gd name="connsiteY13" fmla="*/ 853199 h 921264"/>
                    <a:gd name="connsiteX14" fmla="*/ 1785595 w 3173190"/>
                    <a:gd name="connsiteY14" fmla="*/ 827799 h 921264"/>
                    <a:gd name="connsiteX15" fmla="*/ 1849095 w 3173190"/>
                    <a:gd name="connsiteY15" fmla="*/ 802399 h 921264"/>
                    <a:gd name="connsiteX16" fmla="*/ 1903070 w 3173190"/>
                    <a:gd name="connsiteY16" fmla="*/ 805574 h 921264"/>
                    <a:gd name="connsiteX17" fmla="*/ 2052295 w 3173190"/>
                    <a:gd name="connsiteY17" fmla="*/ 827799 h 921264"/>
                    <a:gd name="connsiteX18" fmla="*/ 2153895 w 3173190"/>
                    <a:gd name="connsiteY18" fmla="*/ 830974 h 921264"/>
                    <a:gd name="connsiteX19" fmla="*/ 2258670 w 3173190"/>
                    <a:gd name="connsiteY19" fmla="*/ 850024 h 921264"/>
                    <a:gd name="connsiteX20" fmla="*/ 2363445 w 3173190"/>
                    <a:gd name="connsiteY20" fmla="*/ 881774 h 921264"/>
                    <a:gd name="connsiteX21" fmla="*/ 2493620 w 3173190"/>
                    <a:gd name="connsiteY21" fmla="*/ 869074 h 921264"/>
                    <a:gd name="connsiteX22" fmla="*/ 2588870 w 3173190"/>
                    <a:gd name="connsiteY22" fmla="*/ 846849 h 921264"/>
                    <a:gd name="connsiteX23" fmla="*/ 2636495 w 3173190"/>
                    <a:gd name="connsiteY23" fmla="*/ 824624 h 921264"/>
                    <a:gd name="connsiteX24" fmla="*/ 2706345 w 3173190"/>
                    <a:gd name="connsiteY24" fmla="*/ 827799 h 921264"/>
                    <a:gd name="connsiteX25" fmla="*/ 2763495 w 3173190"/>
                    <a:gd name="connsiteY25" fmla="*/ 815099 h 921264"/>
                    <a:gd name="connsiteX26" fmla="*/ 2811120 w 3173190"/>
                    <a:gd name="connsiteY26" fmla="*/ 796049 h 921264"/>
                    <a:gd name="connsiteX27" fmla="*/ 2833345 w 3173190"/>
                    <a:gd name="connsiteY27" fmla="*/ 780174 h 921264"/>
                    <a:gd name="connsiteX28" fmla="*/ 2868270 w 3173190"/>
                    <a:gd name="connsiteY28" fmla="*/ 796049 h 921264"/>
                    <a:gd name="connsiteX29" fmla="*/ 2906370 w 3173190"/>
                    <a:gd name="connsiteY29" fmla="*/ 830974 h 921264"/>
                    <a:gd name="connsiteX30" fmla="*/ 2985745 w 3173190"/>
                    <a:gd name="connsiteY30" fmla="*/ 856374 h 921264"/>
                    <a:gd name="connsiteX31" fmla="*/ 3061945 w 3173190"/>
                    <a:gd name="connsiteY31" fmla="*/ 850024 h 921264"/>
                    <a:gd name="connsiteX32" fmla="*/ 3122270 w 3173190"/>
                    <a:gd name="connsiteY32" fmla="*/ 808749 h 921264"/>
                    <a:gd name="connsiteX33" fmla="*/ 3138145 w 3173190"/>
                    <a:gd name="connsiteY33" fmla="*/ 770649 h 921264"/>
                    <a:gd name="connsiteX34" fmla="*/ 3166720 w 3173190"/>
                    <a:gd name="connsiteY34" fmla="*/ 703974 h 921264"/>
                    <a:gd name="connsiteX35" fmla="*/ 3173070 w 3173190"/>
                    <a:gd name="connsiteY35" fmla="*/ 637299 h 921264"/>
                    <a:gd name="connsiteX36" fmla="*/ 3163545 w 3173190"/>
                    <a:gd name="connsiteY36" fmla="*/ 592849 h 921264"/>
                    <a:gd name="connsiteX37" fmla="*/ 3138145 w 3173190"/>
                    <a:gd name="connsiteY37" fmla="*/ 548399 h 921264"/>
                    <a:gd name="connsiteX38" fmla="*/ 3125445 w 3173190"/>
                    <a:gd name="connsiteY38" fmla="*/ 494424 h 921264"/>
                    <a:gd name="connsiteX39" fmla="*/ 3115920 w 3173190"/>
                    <a:gd name="connsiteY39" fmla="*/ 434099 h 921264"/>
                    <a:gd name="connsiteX40" fmla="*/ 3106395 w 3173190"/>
                    <a:gd name="connsiteY40" fmla="*/ 383299 h 921264"/>
                    <a:gd name="connsiteX41" fmla="*/ 3074645 w 3173190"/>
                    <a:gd name="connsiteY41" fmla="*/ 319799 h 921264"/>
                    <a:gd name="connsiteX42" fmla="*/ 3065120 w 3173190"/>
                    <a:gd name="connsiteY42" fmla="*/ 316624 h 921264"/>
                    <a:gd name="connsiteX43" fmla="*/ 3036545 w 3173190"/>
                    <a:gd name="connsiteY43" fmla="*/ 303924 h 921264"/>
                    <a:gd name="connsiteX44" fmla="*/ 2988920 w 3173190"/>
                    <a:gd name="connsiteY44" fmla="*/ 288049 h 921264"/>
                    <a:gd name="connsiteX45" fmla="*/ 2957170 w 3173190"/>
                    <a:gd name="connsiteY45" fmla="*/ 256299 h 921264"/>
                    <a:gd name="connsiteX46" fmla="*/ 2941295 w 3173190"/>
                    <a:gd name="connsiteY46" fmla="*/ 234074 h 921264"/>
                    <a:gd name="connsiteX47" fmla="*/ 2925420 w 3173190"/>
                    <a:gd name="connsiteY47" fmla="*/ 208674 h 921264"/>
                    <a:gd name="connsiteX48" fmla="*/ 2884145 w 3173190"/>
                    <a:gd name="connsiteY48" fmla="*/ 161049 h 921264"/>
                    <a:gd name="connsiteX49" fmla="*/ 2868270 w 3173190"/>
                    <a:gd name="connsiteY49" fmla="*/ 148349 h 921264"/>
                    <a:gd name="connsiteX50" fmla="*/ 2842870 w 3173190"/>
                    <a:gd name="connsiteY50" fmla="*/ 113424 h 921264"/>
                    <a:gd name="connsiteX51" fmla="*/ 2804770 w 3173190"/>
                    <a:gd name="connsiteY51" fmla="*/ 65799 h 921264"/>
                    <a:gd name="connsiteX52" fmla="*/ 2776195 w 3173190"/>
                    <a:gd name="connsiteY52" fmla="*/ 37224 h 921264"/>
                    <a:gd name="connsiteX53" fmla="*/ 2738095 w 3173190"/>
                    <a:gd name="connsiteY53" fmla="*/ 24524 h 921264"/>
                    <a:gd name="connsiteX54" fmla="*/ 2677770 w 3173190"/>
                    <a:gd name="connsiteY54" fmla="*/ 14999 h 921264"/>
                    <a:gd name="connsiteX55" fmla="*/ 2611095 w 3173190"/>
                    <a:gd name="connsiteY55" fmla="*/ 8649 h 921264"/>
                    <a:gd name="connsiteX56" fmla="*/ 2559328 w 3173190"/>
                    <a:gd name="connsiteY56" fmla="*/ 90 h 921264"/>
                    <a:gd name="connsiteX57" fmla="*/ 2531168 w 3173190"/>
                    <a:gd name="connsiteY57" fmla="*/ 14446 h 921264"/>
                    <a:gd name="connsiteX58" fmla="*/ 2493620 w 3173190"/>
                    <a:gd name="connsiteY58" fmla="*/ 49924 h 921264"/>
                    <a:gd name="connsiteX59" fmla="*/ 2474570 w 3173190"/>
                    <a:gd name="connsiteY59" fmla="*/ 84849 h 921264"/>
                    <a:gd name="connsiteX60" fmla="*/ 2468220 w 3173190"/>
                    <a:gd name="connsiteY60" fmla="*/ 116599 h 921264"/>
                    <a:gd name="connsiteX61" fmla="*/ 2469462 w 3173190"/>
                    <a:gd name="connsiteY61" fmla="*/ 151800 h 921264"/>
                    <a:gd name="connsiteX62" fmla="*/ 2480920 w 3173190"/>
                    <a:gd name="connsiteY62" fmla="*/ 161049 h 921264"/>
                    <a:gd name="connsiteX63" fmla="*/ 2528545 w 3173190"/>
                    <a:gd name="connsiteY63" fmla="*/ 164224 h 921264"/>
                    <a:gd name="connsiteX64" fmla="*/ 2544420 w 3173190"/>
                    <a:gd name="connsiteY64" fmla="*/ 164224 h 921264"/>
                    <a:gd name="connsiteX65" fmla="*/ 2572995 w 3173190"/>
                    <a:gd name="connsiteY65" fmla="*/ 164638 h 921264"/>
                    <a:gd name="connsiteX66" fmla="*/ 2582520 w 3173190"/>
                    <a:gd name="connsiteY66" fmla="*/ 167399 h 921264"/>
                    <a:gd name="connsiteX67" fmla="*/ 2614270 w 3173190"/>
                    <a:gd name="connsiteY67" fmla="*/ 170574 h 921264"/>
                    <a:gd name="connsiteX68" fmla="*/ 2642845 w 3173190"/>
                    <a:gd name="connsiteY68" fmla="*/ 161049 h 921264"/>
                    <a:gd name="connsiteX69" fmla="*/ 2677770 w 3173190"/>
                    <a:gd name="connsiteY69" fmla="*/ 173749 h 921264"/>
                    <a:gd name="connsiteX70" fmla="*/ 2706345 w 3173190"/>
                    <a:gd name="connsiteY70" fmla="*/ 180099 h 921264"/>
                    <a:gd name="connsiteX71" fmla="*/ 2734920 w 3173190"/>
                    <a:gd name="connsiteY71" fmla="*/ 215024 h 921264"/>
                    <a:gd name="connsiteX72" fmla="*/ 2776195 w 3173190"/>
                    <a:gd name="connsiteY72" fmla="*/ 284874 h 921264"/>
                    <a:gd name="connsiteX73" fmla="*/ 2792070 w 3173190"/>
                    <a:gd name="connsiteY73" fmla="*/ 319799 h 921264"/>
                    <a:gd name="connsiteX74" fmla="*/ 2804770 w 3173190"/>
                    <a:gd name="connsiteY74" fmla="*/ 361074 h 921264"/>
                    <a:gd name="connsiteX75" fmla="*/ 2817470 w 3173190"/>
                    <a:gd name="connsiteY75" fmla="*/ 399174 h 921264"/>
                    <a:gd name="connsiteX76" fmla="*/ 2820645 w 3173190"/>
                    <a:gd name="connsiteY76" fmla="*/ 418224 h 921264"/>
                    <a:gd name="connsiteX77" fmla="*/ 2820645 w 3173190"/>
                    <a:gd name="connsiteY77" fmla="*/ 440449 h 921264"/>
                    <a:gd name="connsiteX78" fmla="*/ 2823820 w 3173190"/>
                    <a:gd name="connsiteY78" fmla="*/ 475374 h 921264"/>
                    <a:gd name="connsiteX79" fmla="*/ 2826995 w 3173190"/>
                    <a:gd name="connsiteY79" fmla="*/ 503949 h 921264"/>
                    <a:gd name="connsiteX80" fmla="*/ 2830170 w 3173190"/>
                    <a:gd name="connsiteY80" fmla="*/ 529349 h 921264"/>
                    <a:gd name="connsiteX81" fmla="*/ 2830170 w 3173190"/>
                    <a:gd name="connsiteY81" fmla="*/ 557924 h 921264"/>
                    <a:gd name="connsiteX82" fmla="*/ 2826995 w 3173190"/>
                    <a:gd name="connsiteY82" fmla="*/ 570624 h 921264"/>
                    <a:gd name="connsiteX83" fmla="*/ 2820645 w 3173190"/>
                    <a:gd name="connsiteY83" fmla="*/ 583324 h 921264"/>
                    <a:gd name="connsiteX84" fmla="*/ 2811120 w 3173190"/>
                    <a:gd name="connsiteY84" fmla="*/ 602374 h 921264"/>
                    <a:gd name="connsiteX85" fmla="*/ 2807945 w 3173190"/>
                    <a:gd name="connsiteY85" fmla="*/ 618249 h 921264"/>
                    <a:gd name="connsiteX86" fmla="*/ 2807945 w 3173190"/>
                    <a:gd name="connsiteY86" fmla="*/ 634124 h 921264"/>
                    <a:gd name="connsiteX87" fmla="*/ 2811120 w 3173190"/>
                    <a:gd name="connsiteY87" fmla="*/ 646824 h 921264"/>
                    <a:gd name="connsiteX88" fmla="*/ 2811120 w 3173190"/>
                    <a:gd name="connsiteY88" fmla="*/ 646824 h 921264"/>
                    <a:gd name="connsiteX89" fmla="*/ 2760320 w 3173190"/>
                    <a:gd name="connsiteY89" fmla="*/ 665874 h 921264"/>
                    <a:gd name="connsiteX90" fmla="*/ 2709520 w 3173190"/>
                    <a:gd name="connsiteY90" fmla="*/ 675399 h 921264"/>
                    <a:gd name="connsiteX91" fmla="*/ 2661895 w 3173190"/>
                    <a:gd name="connsiteY91" fmla="*/ 681749 h 921264"/>
                    <a:gd name="connsiteX92" fmla="*/ 2636495 w 3173190"/>
                    <a:gd name="connsiteY92" fmla="*/ 681749 h 921264"/>
                    <a:gd name="connsiteX93" fmla="*/ 2598395 w 3173190"/>
                    <a:gd name="connsiteY93" fmla="*/ 681749 h 921264"/>
                    <a:gd name="connsiteX94" fmla="*/ 2560295 w 3173190"/>
                    <a:gd name="connsiteY94" fmla="*/ 678574 h 921264"/>
                    <a:gd name="connsiteX95" fmla="*/ 2544420 w 3173190"/>
                    <a:gd name="connsiteY95" fmla="*/ 681749 h 921264"/>
                    <a:gd name="connsiteX96" fmla="*/ 2519020 w 3173190"/>
                    <a:gd name="connsiteY96" fmla="*/ 694449 h 921264"/>
                    <a:gd name="connsiteX97" fmla="*/ 2496795 w 3173190"/>
                    <a:gd name="connsiteY97" fmla="*/ 703974 h 921264"/>
                    <a:gd name="connsiteX98" fmla="*/ 2452345 w 3173190"/>
                    <a:gd name="connsiteY98" fmla="*/ 713499 h 921264"/>
                    <a:gd name="connsiteX99" fmla="*/ 2407895 w 3173190"/>
                    <a:gd name="connsiteY99" fmla="*/ 723024 h 921264"/>
                    <a:gd name="connsiteX100" fmla="*/ 2360270 w 3173190"/>
                    <a:gd name="connsiteY100" fmla="*/ 729374 h 921264"/>
                    <a:gd name="connsiteX101" fmla="*/ 2328520 w 3173190"/>
                    <a:gd name="connsiteY101" fmla="*/ 716674 h 921264"/>
                    <a:gd name="connsiteX102" fmla="*/ 2265020 w 3173190"/>
                    <a:gd name="connsiteY102" fmla="*/ 703974 h 921264"/>
                    <a:gd name="connsiteX103" fmla="*/ 2226920 w 3173190"/>
                    <a:gd name="connsiteY103" fmla="*/ 697624 h 921264"/>
                    <a:gd name="connsiteX104" fmla="*/ 2185645 w 3173190"/>
                    <a:gd name="connsiteY104" fmla="*/ 691274 h 921264"/>
                    <a:gd name="connsiteX105" fmla="*/ 2128495 w 3173190"/>
                    <a:gd name="connsiteY105" fmla="*/ 681749 h 921264"/>
                    <a:gd name="connsiteX106" fmla="*/ 2090395 w 3173190"/>
                    <a:gd name="connsiteY106" fmla="*/ 675399 h 921264"/>
                    <a:gd name="connsiteX107" fmla="*/ 2042770 w 3173190"/>
                    <a:gd name="connsiteY107" fmla="*/ 665874 h 921264"/>
                    <a:gd name="connsiteX108" fmla="*/ 1928470 w 3173190"/>
                    <a:gd name="connsiteY108" fmla="*/ 659524 h 921264"/>
                    <a:gd name="connsiteX109" fmla="*/ 1868145 w 3173190"/>
                    <a:gd name="connsiteY109" fmla="*/ 662699 h 921264"/>
                    <a:gd name="connsiteX110" fmla="*/ 1782420 w 3173190"/>
                    <a:gd name="connsiteY110" fmla="*/ 665874 h 921264"/>
                    <a:gd name="connsiteX111" fmla="*/ 1744320 w 3173190"/>
                    <a:gd name="connsiteY111" fmla="*/ 672224 h 921264"/>
                    <a:gd name="connsiteX112" fmla="*/ 1699870 w 3173190"/>
                    <a:gd name="connsiteY112" fmla="*/ 694449 h 921264"/>
                    <a:gd name="connsiteX113" fmla="*/ 1642720 w 3173190"/>
                    <a:gd name="connsiteY113" fmla="*/ 716674 h 921264"/>
                    <a:gd name="connsiteX114" fmla="*/ 1598270 w 3173190"/>
                    <a:gd name="connsiteY114" fmla="*/ 738899 h 921264"/>
                    <a:gd name="connsiteX115" fmla="*/ 1541120 w 3173190"/>
                    <a:gd name="connsiteY115" fmla="*/ 754774 h 921264"/>
                    <a:gd name="connsiteX116" fmla="*/ 1509370 w 3173190"/>
                    <a:gd name="connsiteY116" fmla="*/ 773824 h 921264"/>
                    <a:gd name="connsiteX117" fmla="*/ 1483970 w 3173190"/>
                    <a:gd name="connsiteY117" fmla="*/ 780174 h 921264"/>
                    <a:gd name="connsiteX118" fmla="*/ 1439520 w 3173190"/>
                    <a:gd name="connsiteY118" fmla="*/ 799224 h 921264"/>
                    <a:gd name="connsiteX119" fmla="*/ 1366495 w 3173190"/>
                    <a:gd name="connsiteY119" fmla="*/ 776999 h 921264"/>
                    <a:gd name="connsiteX120" fmla="*/ 1255370 w 3173190"/>
                    <a:gd name="connsiteY120" fmla="*/ 751599 h 921264"/>
                    <a:gd name="connsiteX121" fmla="*/ 1182345 w 3173190"/>
                    <a:gd name="connsiteY121" fmla="*/ 735724 h 921264"/>
                    <a:gd name="connsiteX122" fmla="*/ 1042645 w 3173190"/>
                    <a:gd name="connsiteY122" fmla="*/ 703974 h 921264"/>
                    <a:gd name="connsiteX123" fmla="*/ 972795 w 3173190"/>
                    <a:gd name="connsiteY123" fmla="*/ 700799 h 921264"/>
                    <a:gd name="connsiteX124" fmla="*/ 880720 w 3173190"/>
                    <a:gd name="connsiteY124" fmla="*/ 697624 h 921264"/>
                    <a:gd name="connsiteX125" fmla="*/ 826745 w 3173190"/>
                    <a:gd name="connsiteY125" fmla="*/ 700799 h 921264"/>
                    <a:gd name="connsiteX126" fmla="*/ 788645 w 3173190"/>
                    <a:gd name="connsiteY126" fmla="*/ 713499 h 921264"/>
                    <a:gd name="connsiteX127" fmla="*/ 725145 w 3173190"/>
                    <a:gd name="connsiteY127" fmla="*/ 726199 h 921264"/>
                    <a:gd name="connsiteX128" fmla="*/ 690220 w 3173190"/>
                    <a:gd name="connsiteY128" fmla="*/ 738899 h 921264"/>
                    <a:gd name="connsiteX129" fmla="*/ 560045 w 3173190"/>
                    <a:gd name="connsiteY129" fmla="*/ 732549 h 921264"/>
                    <a:gd name="connsiteX130" fmla="*/ 528295 w 3173190"/>
                    <a:gd name="connsiteY130" fmla="*/ 732549 h 921264"/>
                    <a:gd name="connsiteX131" fmla="*/ 413995 w 3173190"/>
                    <a:gd name="connsiteY131" fmla="*/ 719849 h 921264"/>
                    <a:gd name="connsiteX132" fmla="*/ 379070 w 3173190"/>
                    <a:gd name="connsiteY132" fmla="*/ 723024 h 921264"/>
                    <a:gd name="connsiteX133" fmla="*/ 356845 w 3173190"/>
                    <a:gd name="connsiteY133" fmla="*/ 732549 h 921264"/>
                    <a:gd name="connsiteX134" fmla="*/ 245720 w 3173190"/>
                    <a:gd name="connsiteY134" fmla="*/ 716674 h 921264"/>
                    <a:gd name="connsiteX135" fmla="*/ 226670 w 3173190"/>
                    <a:gd name="connsiteY135" fmla="*/ 716674 h 921264"/>
                    <a:gd name="connsiteX136" fmla="*/ 159995 w 3173190"/>
                    <a:gd name="connsiteY136" fmla="*/ 716674 h 921264"/>
                    <a:gd name="connsiteX137" fmla="*/ 144120 w 3173190"/>
                    <a:gd name="connsiteY137" fmla="*/ 719849 h 921264"/>
                    <a:gd name="connsiteX138" fmla="*/ 112370 w 3173190"/>
                    <a:gd name="connsiteY138" fmla="*/ 732549 h 921264"/>
                    <a:gd name="connsiteX139" fmla="*/ 83795 w 3173190"/>
                    <a:gd name="connsiteY139" fmla="*/ 742074 h 921264"/>
                    <a:gd name="connsiteX140" fmla="*/ 58395 w 3173190"/>
                    <a:gd name="connsiteY140" fmla="*/ 748424 h 921264"/>
                    <a:gd name="connsiteX141" fmla="*/ 17120 w 3173190"/>
                    <a:gd name="connsiteY141" fmla="*/ 757949 h 921264"/>
                    <a:gd name="connsiteX142" fmla="*/ 4420 w 3173190"/>
                    <a:gd name="connsiteY142" fmla="*/ 761124 h 921264"/>
                    <a:gd name="connsiteX143" fmla="*/ 90145 w 3173190"/>
                    <a:gd name="connsiteY143" fmla="*/ 859549 h 921264"/>
                    <a:gd name="connsiteX0" fmla="*/ 86970 w 3173190"/>
                    <a:gd name="connsiteY0" fmla="*/ 865899 h 921264"/>
                    <a:gd name="connsiteX1" fmla="*/ 217145 w 3173190"/>
                    <a:gd name="connsiteY1" fmla="*/ 843674 h 921264"/>
                    <a:gd name="connsiteX2" fmla="*/ 340970 w 3173190"/>
                    <a:gd name="connsiteY2" fmla="*/ 834149 h 921264"/>
                    <a:gd name="connsiteX3" fmla="*/ 461620 w 3173190"/>
                    <a:gd name="connsiteY3" fmla="*/ 875424 h 921264"/>
                    <a:gd name="connsiteX4" fmla="*/ 534645 w 3173190"/>
                    <a:gd name="connsiteY4" fmla="*/ 878599 h 921264"/>
                    <a:gd name="connsiteX5" fmla="*/ 645770 w 3173190"/>
                    <a:gd name="connsiteY5" fmla="*/ 869074 h 921264"/>
                    <a:gd name="connsiteX6" fmla="*/ 725145 w 3173190"/>
                    <a:gd name="connsiteY6" fmla="*/ 846849 h 921264"/>
                    <a:gd name="connsiteX7" fmla="*/ 817220 w 3173190"/>
                    <a:gd name="connsiteY7" fmla="*/ 827799 h 921264"/>
                    <a:gd name="connsiteX8" fmla="*/ 972795 w 3173190"/>
                    <a:gd name="connsiteY8" fmla="*/ 821449 h 921264"/>
                    <a:gd name="connsiteX9" fmla="*/ 1169645 w 3173190"/>
                    <a:gd name="connsiteY9" fmla="*/ 846849 h 921264"/>
                    <a:gd name="connsiteX10" fmla="*/ 1356970 w 3173190"/>
                    <a:gd name="connsiteY10" fmla="*/ 913524 h 921264"/>
                    <a:gd name="connsiteX11" fmla="*/ 1490320 w 3173190"/>
                    <a:gd name="connsiteY11" fmla="*/ 916699 h 921264"/>
                    <a:gd name="connsiteX12" fmla="*/ 1649070 w 3173190"/>
                    <a:gd name="connsiteY12" fmla="*/ 884949 h 921264"/>
                    <a:gd name="connsiteX13" fmla="*/ 1741145 w 3173190"/>
                    <a:gd name="connsiteY13" fmla="*/ 853199 h 921264"/>
                    <a:gd name="connsiteX14" fmla="*/ 1785595 w 3173190"/>
                    <a:gd name="connsiteY14" fmla="*/ 827799 h 921264"/>
                    <a:gd name="connsiteX15" fmla="*/ 1849095 w 3173190"/>
                    <a:gd name="connsiteY15" fmla="*/ 802399 h 921264"/>
                    <a:gd name="connsiteX16" fmla="*/ 1903070 w 3173190"/>
                    <a:gd name="connsiteY16" fmla="*/ 805574 h 921264"/>
                    <a:gd name="connsiteX17" fmla="*/ 2052295 w 3173190"/>
                    <a:gd name="connsiteY17" fmla="*/ 827799 h 921264"/>
                    <a:gd name="connsiteX18" fmla="*/ 2153895 w 3173190"/>
                    <a:gd name="connsiteY18" fmla="*/ 830974 h 921264"/>
                    <a:gd name="connsiteX19" fmla="*/ 2258670 w 3173190"/>
                    <a:gd name="connsiteY19" fmla="*/ 850024 h 921264"/>
                    <a:gd name="connsiteX20" fmla="*/ 2363445 w 3173190"/>
                    <a:gd name="connsiteY20" fmla="*/ 881774 h 921264"/>
                    <a:gd name="connsiteX21" fmla="*/ 2493620 w 3173190"/>
                    <a:gd name="connsiteY21" fmla="*/ 869074 h 921264"/>
                    <a:gd name="connsiteX22" fmla="*/ 2588870 w 3173190"/>
                    <a:gd name="connsiteY22" fmla="*/ 846849 h 921264"/>
                    <a:gd name="connsiteX23" fmla="*/ 2636495 w 3173190"/>
                    <a:gd name="connsiteY23" fmla="*/ 824624 h 921264"/>
                    <a:gd name="connsiteX24" fmla="*/ 2706345 w 3173190"/>
                    <a:gd name="connsiteY24" fmla="*/ 827799 h 921264"/>
                    <a:gd name="connsiteX25" fmla="*/ 2763495 w 3173190"/>
                    <a:gd name="connsiteY25" fmla="*/ 815099 h 921264"/>
                    <a:gd name="connsiteX26" fmla="*/ 2811120 w 3173190"/>
                    <a:gd name="connsiteY26" fmla="*/ 796049 h 921264"/>
                    <a:gd name="connsiteX27" fmla="*/ 2833345 w 3173190"/>
                    <a:gd name="connsiteY27" fmla="*/ 780174 h 921264"/>
                    <a:gd name="connsiteX28" fmla="*/ 2868270 w 3173190"/>
                    <a:gd name="connsiteY28" fmla="*/ 796049 h 921264"/>
                    <a:gd name="connsiteX29" fmla="*/ 2906370 w 3173190"/>
                    <a:gd name="connsiteY29" fmla="*/ 830974 h 921264"/>
                    <a:gd name="connsiteX30" fmla="*/ 2985745 w 3173190"/>
                    <a:gd name="connsiteY30" fmla="*/ 856374 h 921264"/>
                    <a:gd name="connsiteX31" fmla="*/ 3061945 w 3173190"/>
                    <a:gd name="connsiteY31" fmla="*/ 850024 h 921264"/>
                    <a:gd name="connsiteX32" fmla="*/ 3122270 w 3173190"/>
                    <a:gd name="connsiteY32" fmla="*/ 808749 h 921264"/>
                    <a:gd name="connsiteX33" fmla="*/ 3138145 w 3173190"/>
                    <a:gd name="connsiteY33" fmla="*/ 770649 h 921264"/>
                    <a:gd name="connsiteX34" fmla="*/ 3166720 w 3173190"/>
                    <a:gd name="connsiteY34" fmla="*/ 703974 h 921264"/>
                    <a:gd name="connsiteX35" fmla="*/ 3173070 w 3173190"/>
                    <a:gd name="connsiteY35" fmla="*/ 637299 h 921264"/>
                    <a:gd name="connsiteX36" fmla="*/ 3163545 w 3173190"/>
                    <a:gd name="connsiteY36" fmla="*/ 592849 h 921264"/>
                    <a:gd name="connsiteX37" fmla="*/ 3138145 w 3173190"/>
                    <a:gd name="connsiteY37" fmla="*/ 548399 h 921264"/>
                    <a:gd name="connsiteX38" fmla="*/ 3125445 w 3173190"/>
                    <a:gd name="connsiteY38" fmla="*/ 494424 h 921264"/>
                    <a:gd name="connsiteX39" fmla="*/ 3115920 w 3173190"/>
                    <a:gd name="connsiteY39" fmla="*/ 434099 h 921264"/>
                    <a:gd name="connsiteX40" fmla="*/ 3106395 w 3173190"/>
                    <a:gd name="connsiteY40" fmla="*/ 383299 h 921264"/>
                    <a:gd name="connsiteX41" fmla="*/ 3074645 w 3173190"/>
                    <a:gd name="connsiteY41" fmla="*/ 319799 h 921264"/>
                    <a:gd name="connsiteX42" fmla="*/ 3065120 w 3173190"/>
                    <a:gd name="connsiteY42" fmla="*/ 316624 h 921264"/>
                    <a:gd name="connsiteX43" fmla="*/ 3036545 w 3173190"/>
                    <a:gd name="connsiteY43" fmla="*/ 303924 h 921264"/>
                    <a:gd name="connsiteX44" fmla="*/ 2988920 w 3173190"/>
                    <a:gd name="connsiteY44" fmla="*/ 288049 h 921264"/>
                    <a:gd name="connsiteX45" fmla="*/ 2957170 w 3173190"/>
                    <a:gd name="connsiteY45" fmla="*/ 256299 h 921264"/>
                    <a:gd name="connsiteX46" fmla="*/ 2941295 w 3173190"/>
                    <a:gd name="connsiteY46" fmla="*/ 234074 h 921264"/>
                    <a:gd name="connsiteX47" fmla="*/ 2925420 w 3173190"/>
                    <a:gd name="connsiteY47" fmla="*/ 208674 h 921264"/>
                    <a:gd name="connsiteX48" fmla="*/ 2884145 w 3173190"/>
                    <a:gd name="connsiteY48" fmla="*/ 161049 h 921264"/>
                    <a:gd name="connsiteX49" fmla="*/ 2868270 w 3173190"/>
                    <a:gd name="connsiteY49" fmla="*/ 148349 h 921264"/>
                    <a:gd name="connsiteX50" fmla="*/ 2842870 w 3173190"/>
                    <a:gd name="connsiteY50" fmla="*/ 113424 h 921264"/>
                    <a:gd name="connsiteX51" fmla="*/ 2804770 w 3173190"/>
                    <a:gd name="connsiteY51" fmla="*/ 65799 h 921264"/>
                    <a:gd name="connsiteX52" fmla="*/ 2776195 w 3173190"/>
                    <a:gd name="connsiteY52" fmla="*/ 37224 h 921264"/>
                    <a:gd name="connsiteX53" fmla="*/ 2738095 w 3173190"/>
                    <a:gd name="connsiteY53" fmla="*/ 24524 h 921264"/>
                    <a:gd name="connsiteX54" fmla="*/ 2677770 w 3173190"/>
                    <a:gd name="connsiteY54" fmla="*/ 14999 h 921264"/>
                    <a:gd name="connsiteX55" fmla="*/ 2611095 w 3173190"/>
                    <a:gd name="connsiteY55" fmla="*/ 8649 h 921264"/>
                    <a:gd name="connsiteX56" fmla="*/ 2559328 w 3173190"/>
                    <a:gd name="connsiteY56" fmla="*/ 90 h 921264"/>
                    <a:gd name="connsiteX57" fmla="*/ 2531168 w 3173190"/>
                    <a:gd name="connsiteY57" fmla="*/ 14446 h 921264"/>
                    <a:gd name="connsiteX58" fmla="*/ 2493620 w 3173190"/>
                    <a:gd name="connsiteY58" fmla="*/ 49924 h 921264"/>
                    <a:gd name="connsiteX59" fmla="*/ 2474570 w 3173190"/>
                    <a:gd name="connsiteY59" fmla="*/ 84849 h 921264"/>
                    <a:gd name="connsiteX60" fmla="*/ 2468220 w 3173190"/>
                    <a:gd name="connsiteY60" fmla="*/ 116599 h 921264"/>
                    <a:gd name="connsiteX61" fmla="*/ 2469462 w 3173190"/>
                    <a:gd name="connsiteY61" fmla="*/ 151800 h 921264"/>
                    <a:gd name="connsiteX62" fmla="*/ 2499142 w 3173190"/>
                    <a:gd name="connsiteY62" fmla="*/ 154423 h 921264"/>
                    <a:gd name="connsiteX63" fmla="*/ 2528545 w 3173190"/>
                    <a:gd name="connsiteY63" fmla="*/ 164224 h 921264"/>
                    <a:gd name="connsiteX64" fmla="*/ 2544420 w 3173190"/>
                    <a:gd name="connsiteY64" fmla="*/ 164224 h 921264"/>
                    <a:gd name="connsiteX65" fmla="*/ 2572995 w 3173190"/>
                    <a:gd name="connsiteY65" fmla="*/ 164638 h 921264"/>
                    <a:gd name="connsiteX66" fmla="*/ 2582520 w 3173190"/>
                    <a:gd name="connsiteY66" fmla="*/ 167399 h 921264"/>
                    <a:gd name="connsiteX67" fmla="*/ 2614270 w 3173190"/>
                    <a:gd name="connsiteY67" fmla="*/ 170574 h 921264"/>
                    <a:gd name="connsiteX68" fmla="*/ 2642845 w 3173190"/>
                    <a:gd name="connsiteY68" fmla="*/ 161049 h 921264"/>
                    <a:gd name="connsiteX69" fmla="*/ 2677770 w 3173190"/>
                    <a:gd name="connsiteY69" fmla="*/ 173749 h 921264"/>
                    <a:gd name="connsiteX70" fmla="*/ 2706345 w 3173190"/>
                    <a:gd name="connsiteY70" fmla="*/ 180099 h 921264"/>
                    <a:gd name="connsiteX71" fmla="*/ 2734920 w 3173190"/>
                    <a:gd name="connsiteY71" fmla="*/ 215024 h 921264"/>
                    <a:gd name="connsiteX72" fmla="*/ 2776195 w 3173190"/>
                    <a:gd name="connsiteY72" fmla="*/ 284874 h 921264"/>
                    <a:gd name="connsiteX73" fmla="*/ 2792070 w 3173190"/>
                    <a:gd name="connsiteY73" fmla="*/ 319799 h 921264"/>
                    <a:gd name="connsiteX74" fmla="*/ 2804770 w 3173190"/>
                    <a:gd name="connsiteY74" fmla="*/ 361074 h 921264"/>
                    <a:gd name="connsiteX75" fmla="*/ 2817470 w 3173190"/>
                    <a:gd name="connsiteY75" fmla="*/ 399174 h 921264"/>
                    <a:gd name="connsiteX76" fmla="*/ 2820645 w 3173190"/>
                    <a:gd name="connsiteY76" fmla="*/ 418224 h 921264"/>
                    <a:gd name="connsiteX77" fmla="*/ 2820645 w 3173190"/>
                    <a:gd name="connsiteY77" fmla="*/ 440449 h 921264"/>
                    <a:gd name="connsiteX78" fmla="*/ 2823820 w 3173190"/>
                    <a:gd name="connsiteY78" fmla="*/ 475374 h 921264"/>
                    <a:gd name="connsiteX79" fmla="*/ 2826995 w 3173190"/>
                    <a:gd name="connsiteY79" fmla="*/ 503949 h 921264"/>
                    <a:gd name="connsiteX80" fmla="*/ 2830170 w 3173190"/>
                    <a:gd name="connsiteY80" fmla="*/ 529349 h 921264"/>
                    <a:gd name="connsiteX81" fmla="*/ 2830170 w 3173190"/>
                    <a:gd name="connsiteY81" fmla="*/ 557924 h 921264"/>
                    <a:gd name="connsiteX82" fmla="*/ 2826995 w 3173190"/>
                    <a:gd name="connsiteY82" fmla="*/ 570624 h 921264"/>
                    <a:gd name="connsiteX83" fmla="*/ 2820645 w 3173190"/>
                    <a:gd name="connsiteY83" fmla="*/ 583324 h 921264"/>
                    <a:gd name="connsiteX84" fmla="*/ 2811120 w 3173190"/>
                    <a:gd name="connsiteY84" fmla="*/ 602374 h 921264"/>
                    <a:gd name="connsiteX85" fmla="*/ 2807945 w 3173190"/>
                    <a:gd name="connsiteY85" fmla="*/ 618249 h 921264"/>
                    <a:gd name="connsiteX86" fmla="*/ 2807945 w 3173190"/>
                    <a:gd name="connsiteY86" fmla="*/ 634124 h 921264"/>
                    <a:gd name="connsiteX87" fmla="*/ 2811120 w 3173190"/>
                    <a:gd name="connsiteY87" fmla="*/ 646824 h 921264"/>
                    <a:gd name="connsiteX88" fmla="*/ 2811120 w 3173190"/>
                    <a:gd name="connsiteY88" fmla="*/ 646824 h 921264"/>
                    <a:gd name="connsiteX89" fmla="*/ 2760320 w 3173190"/>
                    <a:gd name="connsiteY89" fmla="*/ 665874 h 921264"/>
                    <a:gd name="connsiteX90" fmla="*/ 2709520 w 3173190"/>
                    <a:gd name="connsiteY90" fmla="*/ 675399 h 921264"/>
                    <a:gd name="connsiteX91" fmla="*/ 2661895 w 3173190"/>
                    <a:gd name="connsiteY91" fmla="*/ 681749 h 921264"/>
                    <a:gd name="connsiteX92" fmla="*/ 2636495 w 3173190"/>
                    <a:gd name="connsiteY92" fmla="*/ 681749 h 921264"/>
                    <a:gd name="connsiteX93" fmla="*/ 2598395 w 3173190"/>
                    <a:gd name="connsiteY93" fmla="*/ 681749 h 921264"/>
                    <a:gd name="connsiteX94" fmla="*/ 2560295 w 3173190"/>
                    <a:gd name="connsiteY94" fmla="*/ 678574 h 921264"/>
                    <a:gd name="connsiteX95" fmla="*/ 2544420 w 3173190"/>
                    <a:gd name="connsiteY95" fmla="*/ 681749 h 921264"/>
                    <a:gd name="connsiteX96" fmla="*/ 2519020 w 3173190"/>
                    <a:gd name="connsiteY96" fmla="*/ 694449 h 921264"/>
                    <a:gd name="connsiteX97" fmla="*/ 2496795 w 3173190"/>
                    <a:gd name="connsiteY97" fmla="*/ 703974 h 921264"/>
                    <a:gd name="connsiteX98" fmla="*/ 2452345 w 3173190"/>
                    <a:gd name="connsiteY98" fmla="*/ 713499 h 921264"/>
                    <a:gd name="connsiteX99" fmla="*/ 2407895 w 3173190"/>
                    <a:gd name="connsiteY99" fmla="*/ 723024 h 921264"/>
                    <a:gd name="connsiteX100" fmla="*/ 2360270 w 3173190"/>
                    <a:gd name="connsiteY100" fmla="*/ 729374 h 921264"/>
                    <a:gd name="connsiteX101" fmla="*/ 2328520 w 3173190"/>
                    <a:gd name="connsiteY101" fmla="*/ 716674 h 921264"/>
                    <a:gd name="connsiteX102" fmla="*/ 2265020 w 3173190"/>
                    <a:gd name="connsiteY102" fmla="*/ 703974 h 921264"/>
                    <a:gd name="connsiteX103" fmla="*/ 2226920 w 3173190"/>
                    <a:gd name="connsiteY103" fmla="*/ 697624 h 921264"/>
                    <a:gd name="connsiteX104" fmla="*/ 2185645 w 3173190"/>
                    <a:gd name="connsiteY104" fmla="*/ 691274 h 921264"/>
                    <a:gd name="connsiteX105" fmla="*/ 2128495 w 3173190"/>
                    <a:gd name="connsiteY105" fmla="*/ 681749 h 921264"/>
                    <a:gd name="connsiteX106" fmla="*/ 2090395 w 3173190"/>
                    <a:gd name="connsiteY106" fmla="*/ 675399 h 921264"/>
                    <a:gd name="connsiteX107" fmla="*/ 2042770 w 3173190"/>
                    <a:gd name="connsiteY107" fmla="*/ 665874 h 921264"/>
                    <a:gd name="connsiteX108" fmla="*/ 1928470 w 3173190"/>
                    <a:gd name="connsiteY108" fmla="*/ 659524 h 921264"/>
                    <a:gd name="connsiteX109" fmla="*/ 1868145 w 3173190"/>
                    <a:gd name="connsiteY109" fmla="*/ 662699 h 921264"/>
                    <a:gd name="connsiteX110" fmla="*/ 1782420 w 3173190"/>
                    <a:gd name="connsiteY110" fmla="*/ 665874 h 921264"/>
                    <a:gd name="connsiteX111" fmla="*/ 1744320 w 3173190"/>
                    <a:gd name="connsiteY111" fmla="*/ 672224 h 921264"/>
                    <a:gd name="connsiteX112" fmla="*/ 1699870 w 3173190"/>
                    <a:gd name="connsiteY112" fmla="*/ 694449 h 921264"/>
                    <a:gd name="connsiteX113" fmla="*/ 1642720 w 3173190"/>
                    <a:gd name="connsiteY113" fmla="*/ 716674 h 921264"/>
                    <a:gd name="connsiteX114" fmla="*/ 1598270 w 3173190"/>
                    <a:gd name="connsiteY114" fmla="*/ 738899 h 921264"/>
                    <a:gd name="connsiteX115" fmla="*/ 1541120 w 3173190"/>
                    <a:gd name="connsiteY115" fmla="*/ 754774 h 921264"/>
                    <a:gd name="connsiteX116" fmla="*/ 1509370 w 3173190"/>
                    <a:gd name="connsiteY116" fmla="*/ 773824 h 921264"/>
                    <a:gd name="connsiteX117" fmla="*/ 1483970 w 3173190"/>
                    <a:gd name="connsiteY117" fmla="*/ 780174 h 921264"/>
                    <a:gd name="connsiteX118" fmla="*/ 1439520 w 3173190"/>
                    <a:gd name="connsiteY118" fmla="*/ 799224 h 921264"/>
                    <a:gd name="connsiteX119" fmla="*/ 1366495 w 3173190"/>
                    <a:gd name="connsiteY119" fmla="*/ 776999 h 921264"/>
                    <a:gd name="connsiteX120" fmla="*/ 1255370 w 3173190"/>
                    <a:gd name="connsiteY120" fmla="*/ 751599 h 921264"/>
                    <a:gd name="connsiteX121" fmla="*/ 1182345 w 3173190"/>
                    <a:gd name="connsiteY121" fmla="*/ 735724 h 921264"/>
                    <a:gd name="connsiteX122" fmla="*/ 1042645 w 3173190"/>
                    <a:gd name="connsiteY122" fmla="*/ 703974 h 921264"/>
                    <a:gd name="connsiteX123" fmla="*/ 972795 w 3173190"/>
                    <a:gd name="connsiteY123" fmla="*/ 700799 h 921264"/>
                    <a:gd name="connsiteX124" fmla="*/ 880720 w 3173190"/>
                    <a:gd name="connsiteY124" fmla="*/ 697624 h 921264"/>
                    <a:gd name="connsiteX125" fmla="*/ 826745 w 3173190"/>
                    <a:gd name="connsiteY125" fmla="*/ 700799 h 921264"/>
                    <a:gd name="connsiteX126" fmla="*/ 788645 w 3173190"/>
                    <a:gd name="connsiteY126" fmla="*/ 713499 h 921264"/>
                    <a:gd name="connsiteX127" fmla="*/ 725145 w 3173190"/>
                    <a:gd name="connsiteY127" fmla="*/ 726199 h 921264"/>
                    <a:gd name="connsiteX128" fmla="*/ 690220 w 3173190"/>
                    <a:gd name="connsiteY128" fmla="*/ 738899 h 921264"/>
                    <a:gd name="connsiteX129" fmla="*/ 560045 w 3173190"/>
                    <a:gd name="connsiteY129" fmla="*/ 732549 h 921264"/>
                    <a:gd name="connsiteX130" fmla="*/ 528295 w 3173190"/>
                    <a:gd name="connsiteY130" fmla="*/ 732549 h 921264"/>
                    <a:gd name="connsiteX131" fmla="*/ 413995 w 3173190"/>
                    <a:gd name="connsiteY131" fmla="*/ 719849 h 921264"/>
                    <a:gd name="connsiteX132" fmla="*/ 379070 w 3173190"/>
                    <a:gd name="connsiteY132" fmla="*/ 723024 h 921264"/>
                    <a:gd name="connsiteX133" fmla="*/ 356845 w 3173190"/>
                    <a:gd name="connsiteY133" fmla="*/ 732549 h 921264"/>
                    <a:gd name="connsiteX134" fmla="*/ 245720 w 3173190"/>
                    <a:gd name="connsiteY134" fmla="*/ 716674 h 921264"/>
                    <a:gd name="connsiteX135" fmla="*/ 226670 w 3173190"/>
                    <a:gd name="connsiteY135" fmla="*/ 716674 h 921264"/>
                    <a:gd name="connsiteX136" fmla="*/ 159995 w 3173190"/>
                    <a:gd name="connsiteY136" fmla="*/ 716674 h 921264"/>
                    <a:gd name="connsiteX137" fmla="*/ 144120 w 3173190"/>
                    <a:gd name="connsiteY137" fmla="*/ 719849 h 921264"/>
                    <a:gd name="connsiteX138" fmla="*/ 112370 w 3173190"/>
                    <a:gd name="connsiteY138" fmla="*/ 732549 h 921264"/>
                    <a:gd name="connsiteX139" fmla="*/ 83795 w 3173190"/>
                    <a:gd name="connsiteY139" fmla="*/ 742074 h 921264"/>
                    <a:gd name="connsiteX140" fmla="*/ 58395 w 3173190"/>
                    <a:gd name="connsiteY140" fmla="*/ 748424 h 921264"/>
                    <a:gd name="connsiteX141" fmla="*/ 17120 w 3173190"/>
                    <a:gd name="connsiteY141" fmla="*/ 757949 h 921264"/>
                    <a:gd name="connsiteX142" fmla="*/ 4420 w 3173190"/>
                    <a:gd name="connsiteY142" fmla="*/ 761124 h 921264"/>
                    <a:gd name="connsiteX143" fmla="*/ 90145 w 3173190"/>
                    <a:gd name="connsiteY143" fmla="*/ 859549 h 921264"/>
                    <a:gd name="connsiteX0" fmla="*/ 86970 w 3173190"/>
                    <a:gd name="connsiteY0" fmla="*/ 865899 h 921264"/>
                    <a:gd name="connsiteX1" fmla="*/ 217145 w 3173190"/>
                    <a:gd name="connsiteY1" fmla="*/ 843674 h 921264"/>
                    <a:gd name="connsiteX2" fmla="*/ 340970 w 3173190"/>
                    <a:gd name="connsiteY2" fmla="*/ 834149 h 921264"/>
                    <a:gd name="connsiteX3" fmla="*/ 461620 w 3173190"/>
                    <a:gd name="connsiteY3" fmla="*/ 875424 h 921264"/>
                    <a:gd name="connsiteX4" fmla="*/ 534645 w 3173190"/>
                    <a:gd name="connsiteY4" fmla="*/ 878599 h 921264"/>
                    <a:gd name="connsiteX5" fmla="*/ 645770 w 3173190"/>
                    <a:gd name="connsiteY5" fmla="*/ 869074 h 921264"/>
                    <a:gd name="connsiteX6" fmla="*/ 725145 w 3173190"/>
                    <a:gd name="connsiteY6" fmla="*/ 846849 h 921264"/>
                    <a:gd name="connsiteX7" fmla="*/ 817220 w 3173190"/>
                    <a:gd name="connsiteY7" fmla="*/ 827799 h 921264"/>
                    <a:gd name="connsiteX8" fmla="*/ 972795 w 3173190"/>
                    <a:gd name="connsiteY8" fmla="*/ 821449 h 921264"/>
                    <a:gd name="connsiteX9" fmla="*/ 1169645 w 3173190"/>
                    <a:gd name="connsiteY9" fmla="*/ 846849 h 921264"/>
                    <a:gd name="connsiteX10" fmla="*/ 1356970 w 3173190"/>
                    <a:gd name="connsiteY10" fmla="*/ 913524 h 921264"/>
                    <a:gd name="connsiteX11" fmla="*/ 1490320 w 3173190"/>
                    <a:gd name="connsiteY11" fmla="*/ 916699 h 921264"/>
                    <a:gd name="connsiteX12" fmla="*/ 1649070 w 3173190"/>
                    <a:gd name="connsiteY12" fmla="*/ 884949 h 921264"/>
                    <a:gd name="connsiteX13" fmla="*/ 1741145 w 3173190"/>
                    <a:gd name="connsiteY13" fmla="*/ 853199 h 921264"/>
                    <a:gd name="connsiteX14" fmla="*/ 1785595 w 3173190"/>
                    <a:gd name="connsiteY14" fmla="*/ 827799 h 921264"/>
                    <a:gd name="connsiteX15" fmla="*/ 1849095 w 3173190"/>
                    <a:gd name="connsiteY15" fmla="*/ 802399 h 921264"/>
                    <a:gd name="connsiteX16" fmla="*/ 1903070 w 3173190"/>
                    <a:gd name="connsiteY16" fmla="*/ 805574 h 921264"/>
                    <a:gd name="connsiteX17" fmla="*/ 2052295 w 3173190"/>
                    <a:gd name="connsiteY17" fmla="*/ 827799 h 921264"/>
                    <a:gd name="connsiteX18" fmla="*/ 2153895 w 3173190"/>
                    <a:gd name="connsiteY18" fmla="*/ 830974 h 921264"/>
                    <a:gd name="connsiteX19" fmla="*/ 2258670 w 3173190"/>
                    <a:gd name="connsiteY19" fmla="*/ 850024 h 921264"/>
                    <a:gd name="connsiteX20" fmla="*/ 2363445 w 3173190"/>
                    <a:gd name="connsiteY20" fmla="*/ 881774 h 921264"/>
                    <a:gd name="connsiteX21" fmla="*/ 2493620 w 3173190"/>
                    <a:gd name="connsiteY21" fmla="*/ 869074 h 921264"/>
                    <a:gd name="connsiteX22" fmla="*/ 2588870 w 3173190"/>
                    <a:gd name="connsiteY22" fmla="*/ 846849 h 921264"/>
                    <a:gd name="connsiteX23" fmla="*/ 2636495 w 3173190"/>
                    <a:gd name="connsiteY23" fmla="*/ 824624 h 921264"/>
                    <a:gd name="connsiteX24" fmla="*/ 2706345 w 3173190"/>
                    <a:gd name="connsiteY24" fmla="*/ 827799 h 921264"/>
                    <a:gd name="connsiteX25" fmla="*/ 2763495 w 3173190"/>
                    <a:gd name="connsiteY25" fmla="*/ 815099 h 921264"/>
                    <a:gd name="connsiteX26" fmla="*/ 2811120 w 3173190"/>
                    <a:gd name="connsiteY26" fmla="*/ 796049 h 921264"/>
                    <a:gd name="connsiteX27" fmla="*/ 2833345 w 3173190"/>
                    <a:gd name="connsiteY27" fmla="*/ 780174 h 921264"/>
                    <a:gd name="connsiteX28" fmla="*/ 2868270 w 3173190"/>
                    <a:gd name="connsiteY28" fmla="*/ 796049 h 921264"/>
                    <a:gd name="connsiteX29" fmla="*/ 2906370 w 3173190"/>
                    <a:gd name="connsiteY29" fmla="*/ 830974 h 921264"/>
                    <a:gd name="connsiteX30" fmla="*/ 2985745 w 3173190"/>
                    <a:gd name="connsiteY30" fmla="*/ 856374 h 921264"/>
                    <a:gd name="connsiteX31" fmla="*/ 3061945 w 3173190"/>
                    <a:gd name="connsiteY31" fmla="*/ 850024 h 921264"/>
                    <a:gd name="connsiteX32" fmla="*/ 3122270 w 3173190"/>
                    <a:gd name="connsiteY32" fmla="*/ 808749 h 921264"/>
                    <a:gd name="connsiteX33" fmla="*/ 3138145 w 3173190"/>
                    <a:gd name="connsiteY33" fmla="*/ 770649 h 921264"/>
                    <a:gd name="connsiteX34" fmla="*/ 3166720 w 3173190"/>
                    <a:gd name="connsiteY34" fmla="*/ 703974 h 921264"/>
                    <a:gd name="connsiteX35" fmla="*/ 3173070 w 3173190"/>
                    <a:gd name="connsiteY35" fmla="*/ 637299 h 921264"/>
                    <a:gd name="connsiteX36" fmla="*/ 3163545 w 3173190"/>
                    <a:gd name="connsiteY36" fmla="*/ 592849 h 921264"/>
                    <a:gd name="connsiteX37" fmla="*/ 3138145 w 3173190"/>
                    <a:gd name="connsiteY37" fmla="*/ 548399 h 921264"/>
                    <a:gd name="connsiteX38" fmla="*/ 3125445 w 3173190"/>
                    <a:gd name="connsiteY38" fmla="*/ 494424 h 921264"/>
                    <a:gd name="connsiteX39" fmla="*/ 3115920 w 3173190"/>
                    <a:gd name="connsiteY39" fmla="*/ 434099 h 921264"/>
                    <a:gd name="connsiteX40" fmla="*/ 3106395 w 3173190"/>
                    <a:gd name="connsiteY40" fmla="*/ 383299 h 921264"/>
                    <a:gd name="connsiteX41" fmla="*/ 3074645 w 3173190"/>
                    <a:gd name="connsiteY41" fmla="*/ 319799 h 921264"/>
                    <a:gd name="connsiteX42" fmla="*/ 3065120 w 3173190"/>
                    <a:gd name="connsiteY42" fmla="*/ 316624 h 921264"/>
                    <a:gd name="connsiteX43" fmla="*/ 3036545 w 3173190"/>
                    <a:gd name="connsiteY43" fmla="*/ 303924 h 921264"/>
                    <a:gd name="connsiteX44" fmla="*/ 2988920 w 3173190"/>
                    <a:gd name="connsiteY44" fmla="*/ 288049 h 921264"/>
                    <a:gd name="connsiteX45" fmla="*/ 2957170 w 3173190"/>
                    <a:gd name="connsiteY45" fmla="*/ 256299 h 921264"/>
                    <a:gd name="connsiteX46" fmla="*/ 2941295 w 3173190"/>
                    <a:gd name="connsiteY46" fmla="*/ 234074 h 921264"/>
                    <a:gd name="connsiteX47" fmla="*/ 2925420 w 3173190"/>
                    <a:gd name="connsiteY47" fmla="*/ 208674 h 921264"/>
                    <a:gd name="connsiteX48" fmla="*/ 2884145 w 3173190"/>
                    <a:gd name="connsiteY48" fmla="*/ 161049 h 921264"/>
                    <a:gd name="connsiteX49" fmla="*/ 2868270 w 3173190"/>
                    <a:gd name="connsiteY49" fmla="*/ 148349 h 921264"/>
                    <a:gd name="connsiteX50" fmla="*/ 2842870 w 3173190"/>
                    <a:gd name="connsiteY50" fmla="*/ 113424 h 921264"/>
                    <a:gd name="connsiteX51" fmla="*/ 2804770 w 3173190"/>
                    <a:gd name="connsiteY51" fmla="*/ 65799 h 921264"/>
                    <a:gd name="connsiteX52" fmla="*/ 2776195 w 3173190"/>
                    <a:gd name="connsiteY52" fmla="*/ 37224 h 921264"/>
                    <a:gd name="connsiteX53" fmla="*/ 2738095 w 3173190"/>
                    <a:gd name="connsiteY53" fmla="*/ 24524 h 921264"/>
                    <a:gd name="connsiteX54" fmla="*/ 2677770 w 3173190"/>
                    <a:gd name="connsiteY54" fmla="*/ 14999 h 921264"/>
                    <a:gd name="connsiteX55" fmla="*/ 2611095 w 3173190"/>
                    <a:gd name="connsiteY55" fmla="*/ 8649 h 921264"/>
                    <a:gd name="connsiteX56" fmla="*/ 2559328 w 3173190"/>
                    <a:gd name="connsiteY56" fmla="*/ 90 h 921264"/>
                    <a:gd name="connsiteX57" fmla="*/ 2531168 w 3173190"/>
                    <a:gd name="connsiteY57" fmla="*/ 14446 h 921264"/>
                    <a:gd name="connsiteX58" fmla="*/ 2493620 w 3173190"/>
                    <a:gd name="connsiteY58" fmla="*/ 49924 h 921264"/>
                    <a:gd name="connsiteX59" fmla="*/ 2474570 w 3173190"/>
                    <a:gd name="connsiteY59" fmla="*/ 84849 h 921264"/>
                    <a:gd name="connsiteX60" fmla="*/ 2468220 w 3173190"/>
                    <a:gd name="connsiteY60" fmla="*/ 116599 h 921264"/>
                    <a:gd name="connsiteX61" fmla="*/ 2476088 w 3173190"/>
                    <a:gd name="connsiteY61" fmla="*/ 140205 h 921264"/>
                    <a:gd name="connsiteX62" fmla="*/ 2499142 w 3173190"/>
                    <a:gd name="connsiteY62" fmla="*/ 154423 h 921264"/>
                    <a:gd name="connsiteX63" fmla="*/ 2528545 w 3173190"/>
                    <a:gd name="connsiteY63" fmla="*/ 164224 h 921264"/>
                    <a:gd name="connsiteX64" fmla="*/ 2544420 w 3173190"/>
                    <a:gd name="connsiteY64" fmla="*/ 164224 h 921264"/>
                    <a:gd name="connsiteX65" fmla="*/ 2572995 w 3173190"/>
                    <a:gd name="connsiteY65" fmla="*/ 164638 h 921264"/>
                    <a:gd name="connsiteX66" fmla="*/ 2582520 w 3173190"/>
                    <a:gd name="connsiteY66" fmla="*/ 167399 h 921264"/>
                    <a:gd name="connsiteX67" fmla="*/ 2614270 w 3173190"/>
                    <a:gd name="connsiteY67" fmla="*/ 170574 h 921264"/>
                    <a:gd name="connsiteX68" fmla="*/ 2642845 w 3173190"/>
                    <a:gd name="connsiteY68" fmla="*/ 161049 h 921264"/>
                    <a:gd name="connsiteX69" fmla="*/ 2677770 w 3173190"/>
                    <a:gd name="connsiteY69" fmla="*/ 173749 h 921264"/>
                    <a:gd name="connsiteX70" fmla="*/ 2706345 w 3173190"/>
                    <a:gd name="connsiteY70" fmla="*/ 180099 h 921264"/>
                    <a:gd name="connsiteX71" fmla="*/ 2734920 w 3173190"/>
                    <a:gd name="connsiteY71" fmla="*/ 215024 h 921264"/>
                    <a:gd name="connsiteX72" fmla="*/ 2776195 w 3173190"/>
                    <a:gd name="connsiteY72" fmla="*/ 284874 h 921264"/>
                    <a:gd name="connsiteX73" fmla="*/ 2792070 w 3173190"/>
                    <a:gd name="connsiteY73" fmla="*/ 319799 h 921264"/>
                    <a:gd name="connsiteX74" fmla="*/ 2804770 w 3173190"/>
                    <a:gd name="connsiteY74" fmla="*/ 361074 h 921264"/>
                    <a:gd name="connsiteX75" fmla="*/ 2817470 w 3173190"/>
                    <a:gd name="connsiteY75" fmla="*/ 399174 h 921264"/>
                    <a:gd name="connsiteX76" fmla="*/ 2820645 w 3173190"/>
                    <a:gd name="connsiteY76" fmla="*/ 418224 h 921264"/>
                    <a:gd name="connsiteX77" fmla="*/ 2820645 w 3173190"/>
                    <a:gd name="connsiteY77" fmla="*/ 440449 h 921264"/>
                    <a:gd name="connsiteX78" fmla="*/ 2823820 w 3173190"/>
                    <a:gd name="connsiteY78" fmla="*/ 475374 h 921264"/>
                    <a:gd name="connsiteX79" fmla="*/ 2826995 w 3173190"/>
                    <a:gd name="connsiteY79" fmla="*/ 503949 h 921264"/>
                    <a:gd name="connsiteX80" fmla="*/ 2830170 w 3173190"/>
                    <a:gd name="connsiteY80" fmla="*/ 529349 h 921264"/>
                    <a:gd name="connsiteX81" fmla="*/ 2830170 w 3173190"/>
                    <a:gd name="connsiteY81" fmla="*/ 557924 h 921264"/>
                    <a:gd name="connsiteX82" fmla="*/ 2826995 w 3173190"/>
                    <a:gd name="connsiteY82" fmla="*/ 570624 h 921264"/>
                    <a:gd name="connsiteX83" fmla="*/ 2820645 w 3173190"/>
                    <a:gd name="connsiteY83" fmla="*/ 583324 h 921264"/>
                    <a:gd name="connsiteX84" fmla="*/ 2811120 w 3173190"/>
                    <a:gd name="connsiteY84" fmla="*/ 602374 h 921264"/>
                    <a:gd name="connsiteX85" fmla="*/ 2807945 w 3173190"/>
                    <a:gd name="connsiteY85" fmla="*/ 618249 h 921264"/>
                    <a:gd name="connsiteX86" fmla="*/ 2807945 w 3173190"/>
                    <a:gd name="connsiteY86" fmla="*/ 634124 h 921264"/>
                    <a:gd name="connsiteX87" fmla="*/ 2811120 w 3173190"/>
                    <a:gd name="connsiteY87" fmla="*/ 646824 h 921264"/>
                    <a:gd name="connsiteX88" fmla="*/ 2811120 w 3173190"/>
                    <a:gd name="connsiteY88" fmla="*/ 646824 h 921264"/>
                    <a:gd name="connsiteX89" fmla="*/ 2760320 w 3173190"/>
                    <a:gd name="connsiteY89" fmla="*/ 665874 h 921264"/>
                    <a:gd name="connsiteX90" fmla="*/ 2709520 w 3173190"/>
                    <a:gd name="connsiteY90" fmla="*/ 675399 h 921264"/>
                    <a:gd name="connsiteX91" fmla="*/ 2661895 w 3173190"/>
                    <a:gd name="connsiteY91" fmla="*/ 681749 h 921264"/>
                    <a:gd name="connsiteX92" fmla="*/ 2636495 w 3173190"/>
                    <a:gd name="connsiteY92" fmla="*/ 681749 h 921264"/>
                    <a:gd name="connsiteX93" fmla="*/ 2598395 w 3173190"/>
                    <a:gd name="connsiteY93" fmla="*/ 681749 h 921264"/>
                    <a:gd name="connsiteX94" fmla="*/ 2560295 w 3173190"/>
                    <a:gd name="connsiteY94" fmla="*/ 678574 h 921264"/>
                    <a:gd name="connsiteX95" fmla="*/ 2544420 w 3173190"/>
                    <a:gd name="connsiteY95" fmla="*/ 681749 h 921264"/>
                    <a:gd name="connsiteX96" fmla="*/ 2519020 w 3173190"/>
                    <a:gd name="connsiteY96" fmla="*/ 694449 h 921264"/>
                    <a:gd name="connsiteX97" fmla="*/ 2496795 w 3173190"/>
                    <a:gd name="connsiteY97" fmla="*/ 703974 h 921264"/>
                    <a:gd name="connsiteX98" fmla="*/ 2452345 w 3173190"/>
                    <a:gd name="connsiteY98" fmla="*/ 713499 h 921264"/>
                    <a:gd name="connsiteX99" fmla="*/ 2407895 w 3173190"/>
                    <a:gd name="connsiteY99" fmla="*/ 723024 h 921264"/>
                    <a:gd name="connsiteX100" fmla="*/ 2360270 w 3173190"/>
                    <a:gd name="connsiteY100" fmla="*/ 729374 h 921264"/>
                    <a:gd name="connsiteX101" fmla="*/ 2328520 w 3173190"/>
                    <a:gd name="connsiteY101" fmla="*/ 716674 h 921264"/>
                    <a:gd name="connsiteX102" fmla="*/ 2265020 w 3173190"/>
                    <a:gd name="connsiteY102" fmla="*/ 703974 h 921264"/>
                    <a:gd name="connsiteX103" fmla="*/ 2226920 w 3173190"/>
                    <a:gd name="connsiteY103" fmla="*/ 697624 h 921264"/>
                    <a:gd name="connsiteX104" fmla="*/ 2185645 w 3173190"/>
                    <a:gd name="connsiteY104" fmla="*/ 691274 h 921264"/>
                    <a:gd name="connsiteX105" fmla="*/ 2128495 w 3173190"/>
                    <a:gd name="connsiteY105" fmla="*/ 681749 h 921264"/>
                    <a:gd name="connsiteX106" fmla="*/ 2090395 w 3173190"/>
                    <a:gd name="connsiteY106" fmla="*/ 675399 h 921264"/>
                    <a:gd name="connsiteX107" fmla="*/ 2042770 w 3173190"/>
                    <a:gd name="connsiteY107" fmla="*/ 665874 h 921264"/>
                    <a:gd name="connsiteX108" fmla="*/ 1928470 w 3173190"/>
                    <a:gd name="connsiteY108" fmla="*/ 659524 h 921264"/>
                    <a:gd name="connsiteX109" fmla="*/ 1868145 w 3173190"/>
                    <a:gd name="connsiteY109" fmla="*/ 662699 h 921264"/>
                    <a:gd name="connsiteX110" fmla="*/ 1782420 w 3173190"/>
                    <a:gd name="connsiteY110" fmla="*/ 665874 h 921264"/>
                    <a:gd name="connsiteX111" fmla="*/ 1744320 w 3173190"/>
                    <a:gd name="connsiteY111" fmla="*/ 672224 h 921264"/>
                    <a:gd name="connsiteX112" fmla="*/ 1699870 w 3173190"/>
                    <a:gd name="connsiteY112" fmla="*/ 694449 h 921264"/>
                    <a:gd name="connsiteX113" fmla="*/ 1642720 w 3173190"/>
                    <a:gd name="connsiteY113" fmla="*/ 716674 h 921264"/>
                    <a:gd name="connsiteX114" fmla="*/ 1598270 w 3173190"/>
                    <a:gd name="connsiteY114" fmla="*/ 738899 h 921264"/>
                    <a:gd name="connsiteX115" fmla="*/ 1541120 w 3173190"/>
                    <a:gd name="connsiteY115" fmla="*/ 754774 h 921264"/>
                    <a:gd name="connsiteX116" fmla="*/ 1509370 w 3173190"/>
                    <a:gd name="connsiteY116" fmla="*/ 773824 h 921264"/>
                    <a:gd name="connsiteX117" fmla="*/ 1483970 w 3173190"/>
                    <a:gd name="connsiteY117" fmla="*/ 780174 h 921264"/>
                    <a:gd name="connsiteX118" fmla="*/ 1439520 w 3173190"/>
                    <a:gd name="connsiteY118" fmla="*/ 799224 h 921264"/>
                    <a:gd name="connsiteX119" fmla="*/ 1366495 w 3173190"/>
                    <a:gd name="connsiteY119" fmla="*/ 776999 h 921264"/>
                    <a:gd name="connsiteX120" fmla="*/ 1255370 w 3173190"/>
                    <a:gd name="connsiteY120" fmla="*/ 751599 h 921264"/>
                    <a:gd name="connsiteX121" fmla="*/ 1182345 w 3173190"/>
                    <a:gd name="connsiteY121" fmla="*/ 735724 h 921264"/>
                    <a:gd name="connsiteX122" fmla="*/ 1042645 w 3173190"/>
                    <a:gd name="connsiteY122" fmla="*/ 703974 h 921264"/>
                    <a:gd name="connsiteX123" fmla="*/ 972795 w 3173190"/>
                    <a:gd name="connsiteY123" fmla="*/ 700799 h 921264"/>
                    <a:gd name="connsiteX124" fmla="*/ 880720 w 3173190"/>
                    <a:gd name="connsiteY124" fmla="*/ 697624 h 921264"/>
                    <a:gd name="connsiteX125" fmla="*/ 826745 w 3173190"/>
                    <a:gd name="connsiteY125" fmla="*/ 700799 h 921264"/>
                    <a:gd name="connsiteX126" fmla="*/ 788645 w 3173190"/>
                    <a:gd name="connsiteY126" fmla="*/ 713499 h 921264"/>
                    <a:gd name="connsiteX127" fmla="*/ 725145 w 3173190"/>
                    <a:gd name="connsiteY127" fmla="*/ 726199 h 921264"/>
                    <a:gd name="connsiteX128" fmla="*/ 690220 w 3173190"/>
                    <a:gd name="connsiteY128" fmla="*/ 738899 h 921264"/>
                    <a:gd name="connsiteX129" fmla="*/ 560045 w 3173190"/>
                    <a:gd name="connsiteY129" fmla="*/ 732549 h 921264"/>
                    <a:gd name="connsiteX130" fmla="*/ 528295 w 3173190"/>
                    <a:gd name="connsiteY130" fmla="*/ 732549 h 921264"/>
                    <a:gd name="connsiteX131" fmla="*/ 413995 w 3173190"/>
                    <a:gd name="connsiteY131" fmla="*/ 719849 h 921264"/>
                    <a:gd name="connsiteX132" fmla="*/ 379070 w 3173190"/>
                    <a:gd name="connsiteY132" fmla="*/ 723024 h 921264"/>
                    <a:gd name="connsiteX133" fmla="*/ 356845 w 3173190"/>
                    <a:gd name="connsiteY133" fmla="*/ 732549 h 921264"/>
                    <a:gd name="connsiteX134" fmla="*/ 245720 w 3173190"/>
                    <a:gd name="connsiteY134" fmla="*/ 716674 h 921264"/>
                    <a:gd name="connsiteX135" fmla="*/ 226670 w 3173190"/>
                    <a:gd name="connsiteY135" fmla="*/ 716674 h 921264"/>
                    <a:gd name="connsiteX136" fmla="*/ 159995 w 3173190"/>
                    <a:gd name="connsiteY136" fmla="*/ 716674 h 921264"/>
                    <a:gd name="connsiteX137" fmla="*/ 144120 w 3173190"/>
                    <a:gd name="connsiteY137" fmla="*/ 719849 h 921264"/>
                    <a:gd name="connsiteX138" fmla="*/ 112370 w 3173190"/>
                    <a:gd name="connsiteY138" fmla="*/ 732549 h 921264"/>
                    <a:gd name="connsiteX139" fmla="*/ 83795 w 3173190"/>
                    <a:gd name="connsiteY139" fmla="*/ 742074 h 921264"/>
                    <a:gd name="connsiteX140" fmla="*/ 58395 w 3173190"/>
                    <a:gd name="connsiteY140" fmla="*/ 748424 h 921264"/>
                    <a:gd name="connsiteX141" fmla="*/ 17120 w 3173190"/>
                    <a:gd name="connsiteY141" fmla="*/ 757949 h 921264"/>
                    <a:gd name="connsiteX142" fmla="*/ 4420 w 3173190"/>
                    <a:gd name="connsiteY142" fmla="*/ 761124 h 921264"/>
                    <a:gd name="connsiteX143" fmla="*/ 90145 w 3173190"/>
                    <a:gd name="connsiteY143" fmla="*/ 859549 h 921264"/>
                    <a:gd name="connsiteX0" fmla="*/ 86970 w 3173190"/>
                    <a:gd name="connsiteY0" fmla="*/ 865899 h 921264"/>
                    <a:gd name="connsiteX1" fmla="*/ 217145 w 3173190"/>
                    <a:gd name="connsiteY1" fmla="*/ 843674 h 921264"/>
                    <a:gd name="connsiteX2" fmla="*/ 340970 w 3173190"/>
                    <a:gd name="connsiteY2" fmla="*/ 834149 h 921264"/>
                    <a:gd name="connsiteX3" fmla="*/ 461620 w 3173190"/>
                    <a:gd name="connsiteY3" fmla="*/ 875424 h 921264"/>
                    <a:gd name="connsiteX4" fmla="*/ 534645 w 3173190"/>
                    <a:gd name="connsiteY4" fmla="*/ 878599 h 921264"/>
                    <a:gd name="connsiteX5" fmla="*/ 645770 w 3173190"/>
                    <a:gd name="connsiteY5" fmla="*/ 869074 h 921264"/>
                    <a:gd name="connsiteX6" fmla="*/ 725145 w 3173190"/>
                    <a:gd name="connsiteY6" fmla="*/ 846849 h 921264"/>
                    <a:gd name="connsiteX7" fmla="*/ 817220 w 3173190"/>
                    <a:gd name="connsiteY7" fmla="*/ 827799 h 921264"/>
                    <a:gd name="connsiteX8" fmla="*/ 972795 w 3173190"/>
                    <a:gd name="connsiteY8" fmla="*/ 821449 h 921264"/>
                    <a:gd name="connsiteX9" fmla="*/ 1169645 w 3173190"/>
                    <a:gd name="connsiteY9" fmla="*/ 846849 h 921264"/>
                    <a:gd name="connsiteX10" fmla="*/ 1356970 w 3173190"/>
                    <a:gd name="connsiteY10" fmla="*/ 913524 h 921264"/>
                    <a:gd name="connsiteX11" fmla="*/ 1490320 w 3173190"/>
                    <a:gd name="connsiteY11" fmla="*/ 916699 h 921264"/>
                    <a:gd name="connsiteX12" fmla="*/ 1649070 w 3173190"/>
                    <a:gd name="connsiteY12" fmla="*/ 884949 h 921264"/>
                    <a:gd name="connsiteX13" fmla="*/ 1741145 w 3173190"/>
                    <a:gd name="connsiteY13" fmla="*/ 853199 h 921264"/>
                    <a:gd name="connsiteX14" fmla="*/ 1785595 w 3173190"/>
                    <a:gd name="connsiteY14" fmla="*/ 827799 h 921264"/>
                    <a:gd name="connsiteX15" fmla="*/ 1849095 w 3173190"/>
                    <a:gd name="connsiteY15" fmla="*/ 802399 h 921264"/>
                    <a:gd name="connsiteX16" fmla="*/ 1903070 w 3173190"/>
                    <a:gd name="connsiteY16" fmla="*/ 805574 h 921264"/>
                    <a:gd name="connsiteX17" fmla="*/ 2052295 w 3173190"/>
                    <a:gd name="connsiteY17" fmla="*/ 827799 h 921264"/>
                    <a:gd name="connsiteX18" fmla="*/ 2153895 w 3173190"/>
                    <a:gd name="connsiteY18" fmla="*/ 830974 h 921264"/>
                    <a:gd name="connsiteX19" fmla="*/ 2258670 w 3173190"/>
                    <a:gd name="connsiteY19" fmla="*/ 850024 h 921264"/>
                    <a:gd name="connsiteX20" fmla="*/ 2363445 w 3173190"/>
                    <a:gd name="connsiteY20" fmla="*/ 881774 h 921264"/>
                    <a:gd name="connsiteX21" fmla="*/ 2493620 w 3173190"/>
                    <a:gd name="connsiteY21" fmla="*/ 869074 h 921264"/>
                    <a:gd name="connsiteX22" fmla="*/ 2588870 w 3173190"/>
                    <a:gd name="connsiteY22" fmla="*/ 846849 h 921264"/>
                    <a:gd name="connsiteX23" fmla="*/ 2636495 w 3173190"/>
                    <a:gd name="connsiteY23" fmla="*/ 824624 h 921264"/>
                    <a:gd name="connsiteX24" fmla="*/ 2706345 w 3173190"/>
                    <a:gd name="connsiteY24" fmla="*/ 827799 h 921264"/>
                    <a:gd name="connsiteX25" fmla="*/ 2763495 w 3173190"/>
                    <a:gd name="connsiteY25" fmla="*/ 815099 h 921264"/>
                    <a:gd name="connsiteX26" fmla="*/ 2811120 w 3173190"/>
                    <a:gd name="connsiteY26" fmla="*/ 796049 h 921264"/>
                    <a:gd name="connsiteX27" fmla="*/ 2833345 w 3173190"/>
                    <a:gd name="connsiteY27" fmla="*/ 780174 h 921264"/>
                    <a:gd name="connsiteX28" fmla="*/ 2868270 w 3173190"/>
                    <a:gd name="connsiteY28" fmla="*/ 796049 h 921264"/>
                    <a:gd name="connsiteX29" fmla="*/ 2906370 w 3173190"/>
                    <a:gd name="connsiteY29" fmla="*/ 830974 h 921264"/>
                    <a:gd name="connsiteX30" fmla="*/ 2985745 w 3173190"/>
                    <a:gd name="connsiteY30" fmla="*/ 856374 h 921264"/>
                    <a:gd name="connsiteX31" fmla="*/ 3061945 w 3173190"/>
                    <a:gd name="connsiteY31" fmla="*/ 850024 h 921264"/>
                    <a:gd name="connsiteX32" fmla="*/ 3122270 w 3173190"/>
                    <a:gd name="connsiteY32" fmla="*/ 808749 h 921264"/>
                    <a:gd name="connsiteX33" fmla="*/ 3138145 w 3173190"/>
                    <a:gd name="connsiteY33" fmla="*/ 770649 h 921264"/>
                    <a:gd name="connsiteX34" fmla="*/ 3166720 w 3173190"/>
                    <a:gd name="connsiteY34" fmla="*/ 703974 h 921264"/>
                    <a:gd name="connsiteX35" fmla="*/ 3173070 w 3173190"/>
                    <a:gd name="connsiteY35" fmla="*/ 637299 h 921264"/>
                    <a:gd name="connsiteX36" fmla="*/ 3163545 w 3173190"/>
                    <a:gd name="connsiteY36" fmla="*/ 592849 h 921264"/>
                    <a:gd name="connsiteX37" fmla="*/ 3138145 w 3173190"/>
                    <a:gd name="connsiteY37" fmla="*/ 548399 h 921264"/>
                    <a:gd name="connsiteX38" fmla="*/ 3125445 w 3173190"/>
                    <a:gd name="connsiteY38" fmla="*/ 494424 h 921264"/>
                    <a:gd name="connsiteX39" fmla="*/ 3115920 w 3173190"/>
                    <a:gd name="connsiteY39" fmla="*/ 434099 h 921264"/>
                    <a:gd name="connsiteX40" fmla="*/ 3106395 w 3173190"/>
                    <a:gd name="connsiteY40" fmla="*/ 383299 h 921264"/>
                    <a:gd name="connsiteX41" fmla="*/ 3074645 w 3173190"/>
                    <a:gd name="connsiteY41" fmla="*/ 319799 h 921264"/>
                    <a:gd name="connsiteX42" fmla="*/ 3065120 w 3173190"/>
                    <a:gd name="connsiteY42" fmla="*/ 316624 h 921264"/>
                    <a:gd name="connsiteX43" fmla="*/ 3036545 w 3173190"/>
                    <a:gd name="connsiteY43" fmla="*/ 303924 h 921264"/>
                    <a:gd name="connsiteX44" fmla="*/ 2998860 w 3173190"/>
                    <a:gd name="connsiteY44" fmla="*/ 271484 h 921264"/>
                    <a:gd name="connsiteX45" fmla="*/ 2957170 w 3173190"/>
                    <a:gd name="connsiteY45" fmla="*/ 256299 h 921264"/>
                    <a:gd name="connsiteX46" fmla="*/ 2941295 w 3173190"/>
                    <a:gd name="connsiteY46" fmla="*/ 234074 h 921264"/>
                    <a:gd name="connsiteX47" fmla="*/ 2925420 w 3173190"/>
                    <a:gd name="connsiteY47" fmla="*/ 208674 h 921264"/>
                    <a:gd name="connsiteX48" fmla="*/ 2884145 w 3173190"/>
                    <a:gd name="connsiteY48" fmla="*/ 161049 h 921264"/>
                    <a:gd name="connsiteX49" fmla="*/ 2868270 w 3173190"/>
                    <a:gd name="connsiteY49" fmla="*/ 148349 h 921264"/>
                    <a:gd name="connsiteX50" fmla="*/ 2842870 w 3173190"/>
                    <a:gd name="connsiteY50" fmla="*/ 113424 h 921264"/>
                    <a:gd name="connsiteX51" fmla="*/ 2804770 w 3173190"/>
                    <a:gd name="connsiteY51" fmla="*/ 65799 h 921264"/>
                    <a:gd name="connsiteX52" fmla="*/ 2776195 w 3173190"/>
                    <a:gd name="connsiteY52" fmla="*/ 37224 h 921264"/>
                    <a:gd name="connsiteX53" fmla="*/ 2738095 w 3173190"/>
                    <a:gd name="connsiteY53" fmla="*/ 24524 h 921264"/>
                    <a:gd name="connsiteX54" fmla="*/ 2677770 w 3173190"/>
                    <a:gd name="connsiteY54" fmla="*/ 14999 h 921264"/>
                    <a:gd name="connsiteX55" fmla="*/ 2611095 w 3173190"/>
                    <a:gd name="connsiteY55" fmla="*/ 8649 h 921264"/>
                    <a:gd name="connsiteX56" fmla="*/ 2559328 w 3173190"/>
                    <a:gd name="connsiteY56" fmla="*/ 90 h 921264"/>
                    <a:gd name="connsiteX57" fmla="*/ 2531168 w 3173190"/>
                    <a:gd name="connsiteY57" fmla="*/ 14446 h 921264"/>
                    <a:gd name="connsiteX58" fmla="*/ 2493620 w 3173190"/>
                    <a:gd name="connsiteY58" fmla="*/ 49924 h 921264"/>
                    <a:gd name="connsiteX59" fmla="*/ 2474570 w 3173190"/>
                    <a:gd name="connsiteY59" fmla="*/ 84849 h 921264"/>
                    <a:gd name="connsiteX60" fmla="*/ 2468220 w 3173190"/>
                    <a:gd name="connsiteY60" fmla="*/ 116599 h 921264"/>
                    <a:gd name="connsiteX61" fmla="*/ 2476088 w 3173190"/>
                    <a:gd name="connsiteY61" fmla="*/ 140205 h 921264"/>
                    <a:gd name="connsiteX62" fmla="*/ 2499142 w 3173190"/>
                    <a:gd name="connsiteY62" fmla="*/ 154423 h 921264"/>
                    <a:gd name="connsiteX63" fmla="*/ 2528545 w 3173190"/>
                    <a:gd name="connsiteY63" fmla="*/ 164224 h 921264"/>
                    <a:gd name="connsiteX64" fmla="*/ 2544420 w 3173190"/>
                    <a:gd name="connsiteY64" fmla="*/ 164224 h 921264"/>
                    <a:gd name="connsiteX65" fmla="*/ 2572995 w 3173190"/>
                    <a:gd name="connsiteY65" fmla="*/ 164638 h 921264"/>
                    <a:gd name="connsiteX66" fmla="*/ 2582520 w 3173190"/>
                    <a:gd name="connsiteY66" fmla="*/ 167399 h 921264"/>
                    <a:gd name="connsiteX67" fmla="*/ 2614270 w 3173190"/>
                    <a:gd name="connsiteY67" fmla="*/ 170574 h 921264"/>
                    <a:gd name="connsiteX68" fmla="*/ 2642845 w 3173190"/>
                    <a:gd name="connsiteY68" fmla="*/ 161049 h 921264"/>
                    <a:gd name="connsiteX69" fmla="*/ 2677770 w 3173190"/>
                    <a:gd name="connsiteY69" fmla="*/ 173749 h 921264"/>
                    <a:gd name="connsiteX70" fmla="*/ 2706345 w 3173190"/>
                    <a:gd name="connsiteY70" fmla="*/ 180099 h 921264"/>
                    <a:gd name="connsiteX71" fmla="*/ 2734920 w 3173190"/>
                    <a:gd name="connsiteY71" fmla="*/ 215024 h 921264"/>
                    <a:gd name="connsiteX72" fmla="*/ 2776195 w 3173190"/>
                    <a:gd name="connsiteY72" fmla="*/ 284874 h 921264"/>
                    <a:gd name="connsiteX73" fmla="*/ 2792070 w 3173190"/>
                    <a:gd name="connsiteY73" fmla="*/ 319799 h 921264"/>
                    <a:gd name="connsiteX74" fmla="*/ 2804770 w 3173190"/>
                    <a:gd name="connsiteY74" fmla="*/ 361074 h 921264"/>
                    <a:gd name="connsiteX75" fmla="*/ 2817470 w 3173190"/>
                    <a:gd name="connsiteY75" fmla="*/ 399174 h 921264"/>
                    <a:gd name="connsiteX76" fmla="*/ 2820645 w 3173190"/>
                    <a:gd name="connsiteY76" fmla="*/ 418224 h 921264"/>
                    <a:gd name="connsiteX77" fmla="*/ 2820645 w 3173190"/>
                    <a:gd name="connsiteY77" fmla="*/ 440449 h 921264"/>
                    <a:gd name="connsiteX78" fmla="*/ 2823820 w 3173190"/>
                    <a:gd name="connsiteY78" fmla="*/ 475374 h 921264"/>
                    <a:gd name="connsiteX79" fmla="*/ 2826995 w 3173190"/>
                    <a:gd name="connsiteY79" fmla="*/ 503949 h 921264"/>
                    <a:gd name="connsiteX80" fmla="*/ 2830170 w 3173190"/>
                    <a:gd name="connsiteY80" fmla="*/ 529349 h 921264"/>
                    <a:gd name="connsiteX81" fmla="*/ 2830170 w 3173190"/>
                    <a:gd name="connsiteY81" fmla="*/ 557924 h 921264"/>
                    <a:gd name="connsiteX82" fmla="*/ 2826995 w 3173190"/>
                    <a:gd name="connsiteY82" fmla="*/ 570624 h 921264"/>
                    <a:gd name="connsiteX83" fmla="*/ 2820645 w 3173190"/>
                    <a:gd name="connsiteY83" fmla="*/ 583324 h 921264"/>
                    <a:gd name="connsiteX84" fmla="*/ 2811120 w 3173190"/>
                    <a:gd name="connsiteY84" fmla="*/ 602374 h 921264"/>
                    <a:gd name="connsiteX85" fmla="*/ 2807945 w 3173190"/>
                    <a:gd name="connsiteY85" fmla="*/ 618249 h 921264"/>
                    <a:gd name="connsiteX86" fmla="*/ 2807945 w 3173190"/>
                    <a:gd name="connsiteY86" fmla="*/ 634124 h 921264"/>
                    <a:gd name="connsiteX87" fmla="*/ 2811120 w 3173190"/>
                    <a:gd name="connsiteY87" fmla="*/ 646824 h 921264"/>
                    <a:gd name="connsiteX88" fmla="*/ 2811120 w 3173190"/>
                    <a:gd name="connsiteY88" fmla="*/ 646824 h 921264"/>
                    <a:gd name="connsiteX89" fmla="*/ 2760320 w 3173190"/>
                    <a:gd name="connsiteY89" fmla="*/ 665874 h 921264"/>
                    <a:gd name="connsiteX90" fmla="*/ 2709520 w 3173190"/>
                    <a:gd name="connsiteY90" fmla="*/ 675399 h 921264"/>
                    <a:gd name="connsiteX91" fmla="*/ 2661895 w 3173190"/>
                    <a:gd name="connsiteY91" fmla="*/ 681749 h 921264"/>
                    <a:gd name="connsiteX92" fmla="*/ 2636495 w 3173190"/>
                    <a:gd name="connsiteY92" fmla="*/ 681749 h 921264"/>
                    <a:gd name="connsiteX93" fmla="*/ 2598395 w 3173190"/>
                    <a:gd name="connsiteY93" fmla="*/ 681749 h 921264"/>
                    <a:gd name="connsiteX94" fmla="*/ 2560295 w 3173190"/>
                    <a:gd name="connsiteY94" fmla="*/ 678574 h 921264"/>
                    <a:gd name="connsiteX95" fmla="*/ 2544420 w 3173190"/>
                    <a:gd name="connsiteY95" fmla="*/ 681749 h 921264"/>
                    <a:gd name="connsiteX96" fmla="*/ 2519020 w 3173190"/>
                    <a:gd name="connsiteY96" fmla="*/ 694449 h 921264"/>
                    <a:gd name="connsiteX97" fmla="*/ 2496795 w 3173190"/>
                    <a:gd name="connsiteY97" fmla="*/ 703974 h 921264"/>
                    <a:gd name="connsiteX98" fmla="*/ 2452345 w 3173190"/>
                    <a:gd name="connsiteY98" fmla="*/ 713499 h 921264"/>
                    <a:gd name="connsiteX99" fmla="*/ 2407895 w 3173190"/>
                    <a:gd name="connsiteY99" fmla="*/ 723024 h 921264"/>
                    <a:gd name="connsiteX100" fmla="*/ 2360270 w 3173190"/>
                    <a:gd name="connsiteY100" fmla="*/ 729374 h 921264"/>
                    <a:gd name="connsiteX101" fmla="*/ 2328520 w 3173190"/>
                    <a:gd name="connsiteY101" fmla="*/ 716674 h 921264"/>
                    <a:gd name="connsiteX102" fmla="*/ 2265020 w 3173190"/>
                    <a:gd name="connsiteY102" fmla="*/ 703974 h 921264"/>
                    <a:gd name="connsiteX103" fmla="*/ 2226920 w 3173190"/>
                    <a:gd name="connsiteY103" fmla="*/ 697624 h 921264"/>
                    <a:gd name="connsiteX104" fmla="*/ 2185645 w 3173190"/>
                    <a:gd name="connsiteY104" fmla="*/ 691274 h 921264"/>
                    <a:gd name="connsiteX105" fmla="*/ 2128495 w 3173190"/>
                    <a:gd name="connsiteY105" fmla="*/ 681749 h 921264"/>
                    <a:gd name="connsiteX106" fmla="*/ 2090395 w 3173190"/>
                    <a:gd name="connsiteY106" fmla="*/ 675399 h 921264"/>
                    <a:gd name="connsiteX107" fmla="*/ 2042770 w 3173190"/>
                    <a:gd name="connsiteY107" fmla="*/ 665874 h 921264"/>
                    <a:gd name="connsiteX108" fmla="*/ 1928470 w 3173190"/>
                    <a:gd name="connsiteY108" fmla="*/ 659524 h 921264"/>
                    <a:gd name="connsiteX109" fmla="*/ 1868145 w 3173190"/>
                    <a:gd name="connsiteY109" fmla="*/ 662699 h 921264"/>
                    <a:gd name="connsiteX110" fmla="*/ 1782420 w 3173190"/>
                    <a:gd name="connsiteY110" fmla="*/ 665874 h 921264"/>
                    <a:gd name="connsiteX111" fmla="*/ 1744320 w 3173190"/>
                    <a:gd name="connsiteY111" fmla="*/ 672224 h 921264"/>
                    <a:gd name="connsiteX112" fmla="*/ 1699870 w 3173190"/>
                    <a:gd name="connsiteY112" fmla="*/ 694449 h 921264"/>
                    <a:gd name="connsiteX113" fmla="*/ 1642720 w 3173190"/>
                    <a:gd name="connsiteY113" fmla="*/ 716674 h 921264"/>
                    <a:gd name="connsiteX114" fmla="*/ 1598270 w 3173190"/>
                    <a:gd name="connsiteY114" fmla="*/ 738899 h 921264"/>
                    <a:gd name="connsiteX115" fmla="*/ 1541120 w 3173190"/>
                    <a:gd name="connsiteY115" fmla="*/ 754774 h 921264"/>
                    <a:gd name="connsiteX116" fmla="*/ 1509370 w 3173190"/>
                    <a:gd name="connsiteY116" fmla="*/ 773824 h 921264"/>
                    <a:gd name="connsiteX117" fmla="*/ 1483970 w 3173190"/>
                    <a:gd name="connsiteY117" fmla="*/ 780174 h 921264"/>
                    <a:gd name="connsiteX118" fmla="*/ 1439520 w 3173190"/>
                    <a:gd name="connsiteY118" fmla="*/ 799224 h 921264"/>
                    <a:gd name="connsiteX119" fmla="*/ 1366495 w 3173190"/>
                    <a:gd name="connsiteY119" fmla="*/ 776999 h 921264"/>
                    <a:gd name="connsiteX120" fmla="*/ 1255370 w 3173190"/>
                    <a:gd name="connsiteY120" fmla="*/ 751599 h 921264"/>
                    <a:gd name="connsiteX121" fmla="*/ 1182345 w 3173190"/>
                    <a:gd name="connsiteY121" fmla="*/ 735724 h 921264"/>
                    <a:gd name="connsiteX122" fmla="*/ 1042645 w 3173190"/>
                    <a:gd name="connsiteY122" fmla="*/ 703974 h 921264"/>
                    <a:gd name="connsiteX123" fmla="*/ 972795 w 3173190"/>
                    <a:gd name="connsiteY123" fmla="*/ 700799 h 921264"/>
                    <a:gd name="connsiteX124" fmla="*/ 880720 w 3173190"/>
                    <a:gd name="connsiteY124" fmla="*/ 697624 h 921264"/>
                    <a:gd name="connsiteX125" fmla="*/ 826745 w 3173190"/>
                    <a:gd name="connsiteY125" fmla="*/ 700799 h 921264"/>
                    <a:gd name="connsiteX126" fmla="*/ 788645 w 3173190"/>
                    <a:gd name="connsiteY126" fmla="*/ 713499 h 921264"/>
                    <a:gd name="connsiteX127" fmla="*/ 725145 w 3173190"/>
                    <a:gd name="connsiteY127" fmla="*/ 726199 h 921264"/>
                    <a:gd name="connsiteX128" fmla="*/ 690220 w 3173190"/>
                    <a:gd name="connsiteY128" fmla="*/ 738899 h 921264"/>
                    <a:gd name="connsiteX129" fmla="*/ 560045 w 3173190"/>
                    <a:gd name="connsiteY129" fmla="*/ 732549 h 921264"/>
                    <a:gd name="connsiteX130" fmla="*/ 528295 w 3173190"/>
                    <a:gd name="connsiteY130" fmla="*/ 732549 h 921264"/>
                    <a:gd name="connsiteX131" fmla="*/ 413995 w 3173190"/>
                    <a:gd name="connsiteY131" fmla="*/ 719849 h 921264"/>
                    <a:gd name="connsiteX132" fmla="*/ 379070 w 3173190"/>
                    <a:gd name="connsiteY132" fmla="*/ 723024 h 921264"/>
                    <a:gd name="connsiteX133" fmla="*/ 356845 w 3173190"/>
                    <a:gd name="connsiteY133" fmla="*/ 732549 h 921264"/>
                    <a:gd name="connsiteX134" fmla="*/ 245720 w 3173190"/>
                    <a:gd name="connsiteY134" fmla="*/ 716674 h 921264"/>
                    <a:gd name="connsiteX135" fmla="*/ 226670 w 3173190"/>
                    <a:gd name="connsiteY135" fmla="*/ 716674 h 921264"/>
                    <a:gd name="connsiteX136" fmla="*/ 159995 w 3173190"/>
                    <a:gd name="connsiteY136" fmla="*/ 716674 h 921264"/>
                    <a:gd name="connsiteX137" fmla="*/ 144120 w 3173190"/>
                    <a:gd name="connsiteY137" fmla="*/ 719849 h 921264"/>
                    <a:gd name="connsiteX138" fmla="*/ 112370 w 3173190"/>
                    <a:gd name="connsiteY138" fmla="*/ 732549 h 921264"/>
                    <a:gd name="connsiteX139" fmla="*/ 83795 w 3173190"/>
                    <a:gd name="connsiteY139" fmla="*/ 742074 h 921264"/>
                    <a:gd name="connsiteX140" fmla="*/ 58395 w 3173190"/>
                    <a:gd name="connsiteY140" fmla="*/ 748424 h 921264"/>
                    <a:gd name="connsiteX141" fmla="*/ 17120 w 3173190"/>
                    <a:gd name="connsiteY141" fmla="*/ 757949 h 921264"/>
                    <a:gd name="connsiteX142" fmla="*/ 4420 w 3173190"/>
                    <a:gd name="connsiteY142" fmla="*/ 761124 h 921264"/>
                    <a:gd name="connsiteX143" fmla="*/ 90145 w 3173190"/>
                    <a:gd name="connsiteY143" fmla="*/ 859549 h 921264"/>
                    <a:gd name="connsiteX0" fmla="*/ 86970 w 3173190"/>
                    <a:gd name="connsiteY0" fmla="*/ 865899 h 921264"/>
                    <a:gd name="connsiteX1" fmla="*/ 217145 w 3173190"/>
                    <a:gd name="connsiteY1" fmla="*/ 843674 h 921264"/>
                    <a:gd name="connsiteX2" fmla="*/ 340970 w 3173190"/>
                    <a:gd name="connsiteY2" fmla="*/ 834149 h 921264"/>
                    <a:gd name="connsiteX3" fmla="*/ 461620 w 3173190"/>
                    <a:gd name="connsiteY3" fmla="*/ 875424 h 921264"/>
                    <a:gd name="connsiteX4" fmla="*/ 534645 w 3173190"/>
                    <a:gd name="connsiteY4" fmla="*/ 878599 h 921264"/>
                    <a:gd name="connsiteX5" fmla="*/ 645770 w 3173190"/>
                    <a:gd name="connsiteY5" fmla="*/ 869074 h 921264"/>
                    <a:gd name="connsiteX6" fmla="*/ 725145 w 3173190"/>
                    <a:gd name="connsiteY6" fmla="*/ 846849 h 921264"/>
                    <a:gd name="connsiteX7" fmla="*/ 817220 w 3173190"/>
                    <a:gd name="connsiteY7" fmla="*/ 827799 h 921264"/>
                    <a:gd name="connsiteX8" fmla="*/ 972795 w 3173190"/>
                    <a:gd name="connsiteY8" fmla="*/ 821449 h 921264"/>
                    <a:gd name="connsiteX9" fmla="*/ 1169645 w 3173190"/>
                    <a:gd name="connsiteY9" fmla="*/ 846849 h 921264"/>
                    <a:gd name="connsiteX10" fmla="*/ 1356970 w 3173190"/>
                    <a:gd name="connsiteY10" fmla="*/ 913524 h 921264"/>
                    <a:gd name="connsiteX11" fmla="*/ 1490320 w 3173190"/>
                    <a:gd name="connsiteY11" fmla="*/ 916699 h 921264"/>
                    <a:gd name="connsiteX12" fmla="*/ 1649070 w 3173190"/>
                    <a:gd name="connsiteY12" fmla="*/ 884949 h 921264"/>
                    <a:gd name="connsiteX13" fmla="*/ 1741145 w 3173190"/>
                    <a:gd name="connsiteY13" fmla="*/ 853199 h 921264"/>
                    <a:gd name="connsiteX14" fmla="*/ 1785595 w 3173190"/>
                    <a:gd name="connsiteY14" fmla="*/ 827799 h 921264"/>
                    <a:gd name="connsiteX15" fmla="*/ 1849095 w 3173190"/>
                    <a:gd name="connsiteY15" fmla="*/ 802399 h 921264"/>
                    <a:gd name="connsiteX16" fmla="*/ 1903070 w 3173190"/>
                    <a:gd name="connsiteY16" fmla="*/ 805574 h 921264"/>
                    <a:gd name="connsiteX17" fmla="*/ 2052295 w 3173190"/>
                    <a:gd name="connsiteY17" fmla="*/ 827799 h 921264"/>
                    <a:gd name="connsiteX18" fmla="*/ 2153895 w 3173190"/>
                    <a:gd name="connsiteY18" fmla="*/ 830974 h 921264"/>
                    <a:gd name="connsiteX19" fmla="*/ 2258670 w 3173190"/>
                    <a:gd name="connsiteY19" fmla="*/ 850024 h 921264"/>
                    <a:gd name="connsiteX20" fmla="*/ 2363445 w 3173190"/>
                    <a:gd name="connsiteY20" fmla="*/ 881774 h 921264"/>
                    <a:gd name="connsiteX21" fmla="*/ 2493620 w 3173190"/>
                    <a:gd name="connsiteY21" fmla="*/ 869074 h 921264"/>
                    <a:gd name="connsiteX22" fmla="*/ 2588870 w 3173190"/>
                    <a:gd name="connsiteY22" fmla="*/ 846849 h 921264"/>
                    <a:gd name="connsiteX23" fmla="*/ 2636495 w 3173190"/>
                    <a:gd name="connsiteY23" fmla="*/ 824624 h 921264"/>
                    <a:gd name="connsiteX24" fmla="*/ 2706345 w 3173190"/>
                    <a:gd name="connsiteY24" fmla="*/ 827799 h 921264"/>
                    <a:gd name="connsiteX25" fmla="*/ 2763495 w 3173190"/>
                    <a:gd name="connsiteY25" fmla="*/ 815099 h 921264"/>
                    <a:gd name="connsiteX26" fmla="*/ 2811120 w 3173190"/>
                    <a:gd name="connsiteY26" fmla="*/ 796049 h 921264"/>
                    <a:gd name="connsiteX27" fmla="*/ 2833345 w 3173190"/>
                    <a:gd name="connsiteY27" fmla="*/ 780174 h 921264"/>
                    <a:gd name="connsiteX28" fmla="*/ 2868270 w 3173190"/>
                    <a:gd name="connsiteY28" fmla="*/ 796049 h 921264"/>
                    <a:gd name="connsiteX29" fmla="*/ 2906370 w 3173190"/>
                    <a:gd name="connsiteY29" fmla="*/ 830974 h 921264"/>
                    <a:gd name="connsiteX30" fmla="*/ 2985745 w 3173190"/>
                    <a:gd name="connsiteY30" fmla="*/ 856374 h 921264"/>
                    <a:gd name="connsiteX31" fmla="*/ 3061945 w 3173190"/>
                    <a:gd name="connsiteY31" fmla="*/ 850024 h 921264"/>
                    <a:gd name="connsiteX32" fmla="*/ 3122270 w 3173190"/>
                    <a:gd name="connsiteY32" fmla="*/ 808749 h 921264"/>
                    <a:gd name="connsiteX33" fmla="*/ 3138145 w 3173190"/>
                    <a:gd name="connsiteY33" fmla="*/ 770649 h 921264"/>
                    <a:gd name="connsiteX34" fmla="*/ 3166720 w 3173190"/>
                    <a:gd name="connsiteY34" fmla="*/ 703974 h 921264"/>
                    <a:gd name="connsiteX35" fmla="*/ 3173070 w 3173190"/>
                    <a:gd name="connsiteY35" fmla="*/ 637299 h 921264"/>
                    <a:gd name="connsiteX36" fmla="*/ 3163545 w 3173190"/>
                    <a:gd name="connsiteY36" fmla="*/ 592849 h 921264"/>
                    <a:gd name="connsiteX37" fmla="*/ 3138145 w 3173190"/>
                    <a:gd name="connsiteY37" fmla="*/ 548399 h 921264"/>
                    <a:gd name="connsiteX38" fmla="*/ 3125445 w 3173190"/>
                    <a:gd name="connsiteY38" fmla="*/ 494424 h 921264"/>
                    <a:gd name="connsiteX39" fmla="*/ 3115920 w 3173190"/>
                    <a:gd name="connsiteY39" fmla="*/ 434099 h 921264"/>
                    <a:gd name="connsiteX40" fmla="*/ 3106395 w 3173190"/>
                    <a:gd name="connsiteY40" fmla="*/ 383299 h 921264"/>
                    <a:gd name="connsiteX41" fmla="*/ 3074645 w 3173190"/>
                    <a:gd name="connsiteY41" fmla="*/ 319799 h 921264"/>
                    <a:gd name="connsiteX42" fmla="*/ 3065120 w 3173190"/>
                    <a:gd name="connsiteY42" fmla="*/ 316624 h 921264"/>
                    <a:gd name="connsiteX43" fmla="*/ 3036545 w 3173190"/>
                    <a:gd name="connsiteY43" fmla="*/ 303924 h 921264"/>
                    <a:gd name="connsiteX44" fmla="*/ 2998860 w 3173190"/>
                    <a:gd name="connsiteY44" fmla="*/ 271484 h 921264"/>
                    <a:gd name="connsiteX45" fmla="*/ 2957170 w 3173190"/>
                    <a:gd name="connsiteY45" fmla="*/ 256299 h 921264"/>
                    <a:gd name="connsiteX46" fmla="*/ 2949577 w 3173190"/>
                    <a:gd name="connsiteY46" fmla="*/ 220822 h 921264"/>
                    <a:gd name="connsiteX47" fmla="*/ 2925420 w 3173190"/>
                    <a:gd name="connsiteY47" fmla="*/ 208674 h 921264"/>
                    <a:gd name="connsiteX48" fmla="*/ 2884145 w 3173190"/>
                    <a:gd name="connsiteY48" fmla="*/ 161049 h 921264"/>
                    <a:gd name="connsiteX49" fmla="*/ 2868270 w 3173190"/>
                    <a:gd name="connsiteY49" fmla="*/ 148349 h 921264"/>
                    <a:gd name="connsiteX50" fmla="*/ 2842870 w 3173190"/>
                    <a:gd name="connsiteY50" fmla="*/ 113424 h 921264"/>
                    <a:gd name="connsiteX51" fmla="*/ 2804770 w 3173190"/>
                    <a:gd name="connsiteY51" fmla="*/ 65799 h 921264"/>
                    <a:gd name="connsiteX52" fmla="*/ 2776195 w 3173190"/>
                    <a:gd name="connsiteY52" fmla="*/ 37224 h 921264"/>
                    <a:gd name="connsiteX53" fmla="*/ 2738095 w 3173190"/>
                    <a:gd name="connsiteY53" fmla="*/ 24524 h 921264"/>
                    <a:gd name="connsiteX54" fmla="*/ 2677770 w 3173190"/>
                    <a:gd name="connsiteY54" fmla="*/ 14999 h 921264"/>
                    <a:gd name="connsiteX55" fmla="*/ 2611095 w 3173190"/>
                    <a:gd name="connsiteY55" fmla="*/ 8649 h 921264"/>
                    <a:gd name="connsiteX56" fmla="*/ 2559328 w 3173190"/>
                    <a:gd name="connsiteY56" fmla="*/ 90 h 921264"/>
                    <a:gd name="connsiteX57" fmla="*/ 2531168 w 3173190"/>
                    <a:gd name="connsiteY57" fmla="*/ 14446 h 921264"/>
                    <a:gd name="connsiteX58" fmla="*/ 2493620 w 3173190"/>
                    <a:gd name="connsiteY58" fmla="*/ 49924 h 921264"/>
                    <a:gd name="connsiteX59" fmla="*/ 2474570 w 3173190"/>
                    <a:gd name="connsiteY59" fmla="*/ 84849 h 921264"/>
                    <a:gd name="connsiteX60" fmla="*/ 2468220 w 3173190"/>
                    <a:gd name="connsiteY60" fmla="*/ 116599 h 921264"/>
                    <a:gd name="connsiteX61" fmla="*/ 2476088 w 3173190"/>
                    <a:gd name="connsiteY61" fmla="*/ 140205 h 921264"/>
                    <a:gd name="connsiteX62" fmla="*/ 2499142 w 3173190"/>
                    <a:gd name="connsiteY62" fmla="*/ 154423 h 921264"/>
                    <a:gd name="connsiteX63" fmla="*/ 2528545 w 3173190"/>
                    <a:gd name="connsiteY63" fmla="*/ 164224 h 921264"/>
                    <a:gd name="connsiteX64" fmla="*/ 2544420 w 3173190"/>
                    <a:gd name="connsiteY64" fmla="*/ 164224 h 921264"/>
                    <a:gd name="connsiteX65" fmla="*/ 2572995 w 3173190"/>
                    <a:gd name="connsiteY65" fmla="*/ 164638 h 921264"/>
                    <a:gd name="connsiteX66" fmla="*/ 2582520 w 3173190"/>
                    <a:gd name="connsiteY66" fmla="*/ 167399 h 921264"/>
                    <a:gd name="connsiteX67" fmla="*/ 2614270 w 3173190"/>
                    <a:gd name="connsiteY67" fmla="*/ 170574 h 921264"/>
                    <a:gd name="connsiteX68" fmla="*/ 2642845 w 3173190"/>
                    <a:gd name="connsiteY68" fmla="*/ 161049 h 921264"/>
                    <a:gd name="connsiteX69" fmla="*/ 2677770 w 3173190"/>
                    <a:gd name="connsiteY69" fmla="*/ 173749 h 921264"/>
                    <a:gd name="connsiteX70" fmla="*/ 2706345 w 3173190"/>
                    <a:gd name="connsiteY70" fmla="*/ 180099 h 921264"/>
                    <a:gd name="connsiteX71" fmla="*/ 2734920 w 3173190"/>
                    <a:gd name="connsiteY71" fmla="*/ 215024 h 921264"/>
                    <a:gd name="connsiteX72" fmla="*/ 2776195 w 3173190"/>
                    <a:gd name="connsiteY72" fmla="*/ 284874 h 921264"/>
                    <a:gd name="connsiteX73" fmla="*/ 2792070 w 3173190"/>
                    <a:gd name="connsiteY73" fmla="*/ 319799 h 921264"/>
                    <a:gd name="connsiteX74" fmla="*/ 2804770 w 3173190"/>
                    <a:gd name="connsiteY74" fmla="*/ 361074 h 921264"/>
                    <a:gd name="connsiteX75" fmla="*/ 2817470 w 3173190"/>
                    <a:gd name="connsiteY75" fmla="*/ 399174 h 921264"/>
                    <a:gd name="connsiteX76" fmla="*/ 2820645 w 3173190"/>
                    <a:gd name="connsiteY76" fmla="*/ 418224 h 921264"/>
                    <a:gd name="connsiteX77" fmla="*/ 2820645 w 3173190"/>
                    <a:gd name="connsiteY77" fmla="*/ 440449 h 921264"/>
                    <a:gd name="connsiteX78" fmla="*/ 2823820 w 3173190"/>
                    <a:gd name="connsiteY78" fmla="*/ 475374 h 921264"/>
                    <a:gd name="connsiteX79" fmla="*/ 2826995 w 3173190"/>
                    <a:gd name="connsiteY79" fmla="*/ 503949 h 921264"/>
                    <a:gd name="connsiteX80" fmla="*/ 2830170 w 3173190"/>
                    <a:gd name="connsiteY80" fmla="*/ 529349 h 921264"/>
                    <a:gd name="connsiteX81" fmla="*/ 2830170 w 3173190"/>
                    <a:gd name="connsiteY81" fmla="*/ 557924 h 921264"/>
                    <a:gd name="connsiteX82" fmla="*/ 2826995 w 3173190"/>
                    <a:gd name="connsiteY82" fmla="*/ 570624 h 921264"/>
                    <a:gd name="connsiteX83" fmla="*/ 2820645 w 3173190"/>
                    <a:gd name="connsiteY83" fmla="*/ 583324 h 921264"/>
                    <a:gd name="connsiteX84" fmla="*/ 2811120 w 3173190"/>
                    <a:gd name="connsiteY84" fmla="*/ 602374 h 921264"/>
                    <a:gd name="connsiteX85" fmla="*/ 2807945 w 3173190"/>
                    <a:gd name="connsiteY85" fmla="*/ 618249 h 921264"/>
                    <a:gd name="connsiteX86" fmla="*/ 2807945 w 3173190"/>
                    <a:gd name="connsiteY86" fmla="*/ 634124 h 921264"/>
                    <a:gd name="connsiteX87" fmla="*/ 2811120 w 3173190"/>
                    <a:gd name="connsiteY87" fmla="*/ 646824 h 921264"/>
                    <a:gd name="connsiteX88" fmla="*/ 2811120 w 3173190"/>
                    <a:gd name="connsiteY88" fmla="*/ 646824 h 921264"/>
                    <a:gd name="connsiteX89" fmla="*/ 2760320 w 3173190"/>
                    <a:gd name="connsiteY89" fmla="*/ 665874 h 921264"/>
                    <a:gd name="connsiteX90" fmla="*/ 2709520 w 3173190"/>
                    <a:gd name="connsiteY90" fmla="*/ 675399 h 921264"/>
                    <a:gd name="connsiteX91" fmla="*/ 2661895 w 3173190"/>
                    <a:gd name="connsiteY91" fmla="*/ 681749 h 921264"/>
                    <a:gd name="connsiteX92" fmla="*/ 2636495 w 3173190"/>
                    <a:gd name="connsiteY92" fmla="*/ 681749 h 921264"/>
                    <a:gd name="connsiteX93" fmla="*/ 2598395 w 3173190"/>
                    <a:gd name="connsiteY93" fmla="*/ 681749 h 921264"/>
                    <a:gd name="connsiteX94" fmla="*/ 2560295 w 3173190"/>
                    <a:gd name="connsiteY94" fmla="*/ 678574 h 921264"/>
                    <a:gd name="connsiteX95" fmla="*/ 2544420 w 3173190"/>
                    <a:gd name="connsiteY95" fmla="*/ 681749 h 921264"/>
                    <a:gd name="connsiteX96" fmla="*/ 2519020 w 3173190"/>
                    <a:gd name="connsiteY96" fmla="*/ 694449 h 921264"/>
                    <a:gd name="connsiteX97" fmla="*/ 2496795 w 3173190"/>
                    <a:gd name="connsiteY97" fmla="*/ 703974 h 921264"/>
                    <a:gd name="connsiteX98" fmla="*/ 2452345 w 3173190"/>
                    <a:gd name="connsiteY98" fmla="*/ 713499 h 921264"/>
                    <a:gd name="connsiteX99" fmla="*/ 2407895 w 3173190"/>
                    <a:gd name="connsiteY99" fmla="*/ 723024 h 921264"/>
                    <a:gd name="connsiteX100" fmla="*/ 2360270 w 3173190"/>
                    <a:gd name="connsiteY100" fmla="*/ 729374 h 921264"/>
                    <a:gd name="connsiteX101" fmla="*/ 2328520 w 3173190"/>
                    <a:gd name="connsiteY101" fmla="*/ 716674 h 921264"/>
                    <a:gd name="connsiteX102" fmla="*/ 2265020 w 3173190"/>
                    <a:gd name="connsiteY102" fmla="*/ 703974 h 921264"/>
                    <a:gd name="connsiteX103" fmla="*/ 2226920 w 3173190"/>
                    <a:gd name="connsiteY103" fmla="*/ 697624 h 921264"/>
                    <a:gd name="connsiteX104" fmla="*/ 2185645 w 3173190"/>
                    <a:gd name="connsiteY104" fmla="*/ 691274 h 921264"/>
                    <a:gd name="connsiteX105" fmla="*/ 2128495 w 3173190"/>
                    <a:gd name="connsiteY105" fmla="*/ 681749 h 921264"/>
                    <a:gd name="connsiteX106" fmla="*/ 2090395 w 3173190"/>
                    <a:gd name="connsiteY106" fmla="*/ 675399 h 921264"/>
                    <a:gd name="connsiteX107" fmla="*/ 2042770 w 3173190"/>
                    <a:gd name="connsiteY107" fmla="*/ 665874 h 921264"/>
                    <a:gd name="connsiteX108" fmla="*/ 1928470 w 3173190"/>
                    <a:gd name="connsiteY108" fmla="*/ 659524 h 921264"/>
                    <a:gd name="connsiteX109" fmla="*/ 1868145 w 3173190"/>
                    <a:gd name="connsiteY109" fmla="*/ 662699 h 921264"/>
                    <a:gd name="connsiteX110" fmla="*/ 1782420 w 3173190"/>
                    <a:gd name="connsiteY110" fmla="*/ 665874 h 921264"/>
                    <a:gd name="connsiteX111" fmla="*/ 1744320 w 3173190"/>
                    <a:gd name="connsiteY111" fmla="*/ 672224 h 921264"/>
                    <a:gd name="connsiteX112" fmla="*/ 1699870 w 3173190"/>
                    <a:gd name="connsiteY112" fmla="*/ 694449 h 921264"/>
                    <a:gd name="connsiteX113" fmla="*/ 1642720 w 3173190"/>
                    <a:gd name="connsiteY113" fmla="*/ 716674 h 921264"/>
                    <a:gd name="connsiteX114" fmla="*/ 1598270 w 3173190"/>
                    <a:gd name="connsiteY114" fmla="*/ 738899 h 921264"/>
                    <a:gd name="connsiteX115" fmla="*/ 1541120 w 3173190"/>
                    <a:gd name="connsiteY115" fmla="*/ 754774 h 921264"/>
                    <a:gd name="connsiteX116" fmla="*/ 1509370 w 3173190"/>
                    <a:gd name="connsiteY116" fmla="*/ 773824 h 921264"/>
                    <a:gd name="connsiteX117" fmla="*/ 1483970 w 3173190"/>
                    <a:gd name="connsiteY117" fmla="*/ 780174 h 921264"/>
                    <a:gd name="connsiteX118" fmla="*/ 1439520 w 3173190"/>
                    <a:gd name="connsiteY118" fmla="*/ 799224 h 921264"/>
                    <a:gd name="connsiteX119" fmla="*/ 1366495 w 3173190"/>
                    <a:gd name="connsiteY119" fmla="*/ 776999 h 921264"/>
                    <a:gd name="connsiteX120" fmla="*/ 1255370 w 3173190"/>
                    <a:gd name="connsiteY120" fmla="*/ 751599 h 921264"/>
                    <a:gd name="connsiteX121" fmla="*/ 1182345 w 3173190"/>
                    <a:gd name="connsiteY121" fmla="*/ 735724 h 921264"/>
                    <a:gd name="connsiteX122" fmla="*/ 1042645 w 3173190"/>
                    <a:gd name="connsiteY122" fmla="*/ 703974 h 921264"/>
                    <a:gd name="connsiteX123" fmla="*/ 972795 w 3173190"/>
                    <a:gd name="connsiteY123" fmla="*/ 700799 h 921264"/>
                    <a:gd name="connsiteX124" fmla="*/ 880720 w 3173190"/>
                    <a:gd name="connsiteY124" fmla="*/ 697624 h 921264"/>
                    <a:gd name="connsiteX125" fmla="*/ 826745 w 3173190"/>
                    <a:gd name="connsiteY125" fmla="*/ 700799 h 921264"/>
                    <a:gd name="connsiteX126" fmla="*/ 788645 w 3173190"/>
                    <a:gd name="connsiteY126" fmla="*/ 713499 h 921264"/>
                    <a:gd name="connsiteX127" fmla="*/ 725145 w 3173190"/>
                    <a:gd name="connsiteY127" fmla="*/ 726199 h 921264"/>
                    <a:gd name="connsiteX128" fmla="*/ 690220 w 3173190"/>
                    <a:gd name="connsiteY128" fmla="*/ 738899 h 921264"/>
                    <a:gd name="connsiteX129" fmla="*/ 560045 w 3173190"/>
                    <a:gd name="connsiteY129" fmla="*/ 732549 h 921264"/>
                    <a:gd name="connsiteX130" fmla="*/ 528295 w 3173190"/>
                    <a:gd name="connsiteY130" fmla="*/ 732549 h 921264"/>
                    <a:gd name="connsiteX131" fmla="*/ 413995 w 3173190"/>
                    <a:gd name="connsiteY131" fmla="*/ 719849 h 921264"/>
                    <a:gd name="connsiteX132" fmla="*/ 379070 w 3173190"/>
                    <a:gd name="connsiteY132" fmla="*/ 723024 h 921264"/>
                    <a:gd name="connsiteX133" fmla="*/ 356845 w 3173190"/>
                    <a:gd name="connsiteY133" fmla="*/ 732549 h 921264"/>
                    <a:gd name="connsiteX134" fmla="*/ 245720 w 3173190"/>
                    <a:gd name="connsiteY134" fmla="*/ 716674 h 921264"/>
                    <a:gd name="connsiteX135" fmla="*/ 226670 w 3173190"/>
                    <a:gd name="connsiteY135" fmla="*/ 716674 h 921264"/>
                    <a:gd name="connsiteX136" fmla="*/ 159995 w 3173190"/>
                    <a:gd name="connsiteY136" fmla="*/ 716674 h 921264"/>
                    <a:gd name="connsiteX137" fmla="*/ 144120 w 3173190"/>
                    <a:gd name="connsiteY137" fmla="*/ 719849 h 921264"/>
                    <a:gd name="connsiteX138" fmla="*/ 112370 w 3173190"/>
                    <a:gd name="connsiteY138" fmla="*/ 732549 h 921264"/>
                    <a:gd name="connsiteX139" fmla="*/ 83795 w 3173190"/>
                    <a:gd name="connsiteY139" fmla="*/ 742074 h 921264"/>
                    <a:gd name="connsiteX140" fmla="*/ 58395 w 3173190"/>
                    <a:gd name="connsiteY140" fmla="*/ 748424 h 921264"/>
                    <a:gd name="connsiteX141" fmla="*/ 17120 w 3173190"/>
                    <a:gd name="connsiteY141" fmla="*/ 757949 h 921264"/>
                    <a:gd name="connsiteX142" fmla="*/ 4420 w 3173190"/>
                    <a:gd name="connsiteY142" fmla="*/ 761124 h 921264"/>
                    <a:gd name="connsiteX143" fmla="*/ 90145 w 3173190"/>
                    <a:gd name="connsiteY143" fmla="*/ 859549 h 921264"/>
                    <a:gd name="connsiteX0" fmla="*/ 83493 w 3169713"/>
                    <a:gd name="connsiteY0" fmla="*/ 865899 h 921264"/>
                    <a:gd name="connsiteX1" fmla="*/ 213668 w 3169713"/>
                    <a:gd name="connsiteY1" fmla="*/ 843674 h 921264"/>
                    <a:gd name="connsiteX2" fmla="*/ 337493 w 3169713"/>
                    <a:gd name="connsiteY2" fmla="*/ 834149 h 921264"/>
                    <a:gd name="connsiteX3" fmla="*/ 458143 w 3169713"/>
                    <a:gd name="connsiteY3" fmla="*/ 875424 h 921264"/>
                    <a:gd name="connsiteX4" fmla="*/ 531168 w 3169713"/>
                    <a:gd name="connsiteY4" fmla="*/ 878599 h 921264"/>
                    <a:gd name="connsiteX5" fmla="*/ 642293 w 3169713"/>
                    <a:gd name="connsiteY5" fmla="*/ 869074 h 921264"/>
                    <a:gd name="connsiteX6" fmla="*/ 721668 w 3169713"/>
                    <a:gd name="connsiteY6" fmla="*/ 846849 h 921264"/>
                    <a:gd name="connsiteX7" fmla="*/ 813743 w 3169713"/>
                    <a:gd name="connsiteY7" fmla="*/ 827799 h 921264"/>
                    <a:gd name="connsiteX8" fmla="*/ 969318 w 3169713"/>
                    <a:gd name="connsiteY8" fmla="*/ 821449 h 921264"/>
                    <a:gd name="connsiteX9" fmla="*/ 1166168 w 3169713"/>
                    <a:gd name="connsiteY9" fmla="*/ 846849 h 921264"/>
                    <a:gd name="connsiteX10" fmla="*/ 1353493 w 3169713"/>
                    <a:gd name="connsiteY10" fmla="*/ 913524 h 921264"/>
                    <a:gd name="connsiteX11" fmla="*/ 1486843 w 3169713"/>
                    <a:gd name="connsiteY11" fmla="*/ 916699 h 921264"/>
                    <a:gd name="connsiteX12" fmla="*/ 1645593 w 3169713"/>
                    <a:gd name="connsiteY12" fmla="*/ 884949 h 921264"/>
                    <a:gd name="connsiteX13" fmla="*/ 1737668 w 3169713"/>
                    <a:gd name="connsiteY13" fmla="*/ 853199 h 921264"/>
                    <a:gd name="connsiteX14" fmla="*/ 1782118 w 3169713"/>
                    <a:gd name="connsiteY14" fmla="*/ 827799 h 921264"/>
                    <a:gd name="connsiteX15" fmla="*/ 1845618 w 3169713"/>
                    <a:gd name="connsiteY15" fmla="*/ 802399 h 921264"/>
                    <a:gd name="connsiteX16" fmla="*/ 1899593 w 3169713"/>
                    <a:gd name="connsiteY16" fmla="*/ 805574 h 921264"/>
                    <a:gd name="connsiteX17" fmla="*/ 2048818 w 3169713"/>
                    <a:gd name="connsiteY17" fmla="*/ 827799 h 921264"/>
                    <a:gd name="connsiteX18" fmla="*/ 2150418 w 3169713"/>
                    <a:gd name="connsiteY18" fmla="*/ 830974 h 921264"/>
                    <a:gd name="connsiteX19" fmla="*/ 2255193 w 3169713"/>
                    <a:gd name="connsiteY19" fmla="*/ 850024 h 921264"/>
                    <a:gd name="connsiteX20" fmla="*/ 2359968 w 3169713"/>
                    <a:gd name="connsiteY20" fmla="*/ 881774 h 921264"/>
                    <a:gd name="connsiteX21" fmla="*/ 2490143 w 3169713"/>
                    <a:gd name="connsiteY21" fmla="*/ 869074 h 921264"/>
                    <a:gd name="connsiteX22" fmla="*/ 2585393 w 3169713"/>
                    <a:gd name="connsiteY22" fmla="*/ 846849 h 921264"/>
                    <a:gd name="connsiteX23" fmla="*/ 2633018 w 3169713"/>
                    <a:gd name="connsiteY23" fmla="*/ 824624 h 921264"/>
                    <a:gd name="connsiteX24" fmla="*/ 2702868 w 3169713"/>
                    <a:gd name="connsiteY24" fmla="*/ 827799 h 921264"/>
                    <a:gd name="connsiteX25" fmla="*/ 2760018 w 3169713"/>
                    <a:gd name="connsiteY25" fmla="*/ 815099 h 921264"/>
                    <a:gd name="connsiteX26" fmla="*/ 2807643 w 3169713"/>
                    <a:gd name="connsiteY26" fmla="*/ 796049 h 921264"/>
                    <a:gd name="connsiteX27" fmla="*/ 2829868 w 3169713"/>
                    <a:gd name="connsiteY27" fmla="*/ 780174 h 921264"/>
                    <a:gd name="connsiteX28" fmla="*/ 2864793 w 3169713"/>
                    <a:gd name="connsiteY28" fmla="*/ 796049 h 921264"/>
                    <a:gd name="connsiteX29" fmla="*/ 2902893 w 3169713"/>
                    <a:gd name="connsiteY29" fmla="*/ 830974 h 921264"/>
                    <a:gd name="connsiteX30" fmla="*/ 2982268 w 3169713"/>
                    <a:gd name="connsiteY30" fmla="*/ 856374 h 921264"/>
                    <a:gd name="connsiteX31" fmla="*/ 3058468 w 3169713"/>
                    <a:gd name="connsiteY31" fmla="*/ 850024 h 921264"/>
                    <a:gd name="connsiteX32" fmla="*/ 3118793 w 3169713"/>
                    <a:gd name="connsiteY32" fmla="*/ 808749 h 921264"/>
                    <a:gd name="connsiteX33" fmla="*/ 3134668 w 3169713"/>
                    <a:gd name="connsiteY33" fmla="*/ 770649 h 921264"/>
                    <a:gd name="connsiteX34" fmla="*/ 3163243 w 3169713"/>
                    <a:gd name="connsiteY34" fmla="*/ 703974 h 921264"/>
                    <a:gd name="connsiteX35" fmla="*/ 3169593 w 3169713"/>
                    <a:gd name="connsiteY35" fmla="*/ 637299 h 921264"/>
                    <a:gd name="connsiteX36" fmla="*/ 3160068 w 3169713"/>
                    <a:gd name="connsiteY36" fmla="*/ 592849 h 921264"/>
                    <a:gd name="connsiteX37" fmla="*/ 3134668 w 3169713"/>
                    <a:gd name="connsiteY37" fmla="*/ 548399 h 921264"/>
                    <a:gd name="connsiteX38" fmla="*/ 3121968 w 3169713"/>
                    <a:gd name="connsiteY38" fmla="*/ 494424 h 921264"/>
                    <a:gd name="connsiteX39" fmla="*/ 3112443 w 3169713"/>
                    <a:gd name="connsiteY39" fmla="*/ 434099 h 921264"/>
                    <a:gd name="connsiteX40" fmla="*/ 3102918 w 3169713"/>
                    <a:gd name="connsiteY40" fmla="*/ 383299 h 921264"/>
                    <a:gd name="connsiteX41" fmla="*/ 3071168 w 3169713"/>
                    <a:gd name="connsiteY41" fmla="*/ 319799 h 921264"/>
                    <a:gd name="connsiteX42" fmla="*/ 3061643 w 3169713"/>
                    <a:gd name="connsiteY42" fmla="*/ 316624 h 921264"/>
                    <a:gd name="connsiteX43" fmla="*/ 3033068 w 3169713"/>
                    <a:gd name="connsiteY43" fmla="*/ 303924 h 921264"/>
                    <a:gd name="connsiteX44" fmla="*/ 2995383 w 3169713"/>
                    <a:gd name="connsiteY44" fmla="*/ 271484 h 921264"/>
                    <a:gd name="connsiteX45" fmla="*/ 2953693 w 3169713"/>
                    <a:gd name="connsiteY45" fmla="*/ 256299 h 921264"/>
                    <a:gd name="connsiteX46" fmla="*/ 2946100 w 3169713"/>
                    <a:gd name="connsiteY46" fmla="*/ 220822 h 921264"/>
                    <a:gd name="connsiteX47" fmla="*/ 2921943 w 3169713"/>
                    <a:gd name="connsiteY47" fmla="*/ 208674 h 921264"/>
                    <a:gd name="connsiteX48" fmla="*/ 2880668 w 3169713"/>
                    <a:gd name="connsiteY48" fmla="*/ 161049 h 921264"/>
                    <a:gd name="connsiteX49" fmla="*/ 2864793 w 3169713"/>
                    <a:gd name="connsiteY49" fmla="*/ 148349 h 921264"/>
                    <a:gd name="connsiteX50" fmla="*/ 2839393 w 3169713"/>
                    <a:gd name="connsiteY50" fmla="*/ 113424 h 921264"/>
                    <a:gd name="connsiteX51" fmla="*/ 2801293 w 3169713"/>
                    <a:gd name="connsiteY51" fmla="*/ 65799 h 921264"/>
                    <a:gd name="connsiteX52" fmla="*/ 2772718 w 3169713"/>
                    <a:gd name="connsiteY52" fmla="*/ 37224 h 921264"/>
                    <a:gd name="connsiteX53" fmla="*/ 2734618 w 3169713"/>
                    <a:gd name="connsiteY53" fmla="*/ 24524 h 921264"/>
                    <a:gd name="connsiteX54" fmla="*/ 2674293 w 3169713"/>
                    <a:gd name="connsiteY54" fmla="*/ 14999 h 921264"/>
                    <a:gd name="connsiteX55" fmla="*/ 2607618 w 3169713"/>
                    <a:gd name="connsiteY55" fmla="*/ 8649 h 921264"/>
                    <a:gd name="connsiteX56" fmla="*/ 2555851 w 3169713"/>
                    <a:gd name="connsiteY56" fmla="*/ 90 h 921264"/>
                    <a:gd name="connsiteX57" fmla="*/ 2527691 w 3169713"/>
                    <a:gd name="connsiteY57" fmla="*/ 14446 h 921264"/>
                    <a:gd name="connsiteX58" fmla="*/ 2490143 w 3169713"/>
                    <a:gd name="connsiteY58" fmla="*/ 49924 h 921264"/>
                    <a:gd name="connsiteX59" fmla="*/ 2471093 w 3169713"/>
                    <a:gd name="connsiteY59" fmla="*/ 84849 h 921264"/>
                    <a:gd name="connsiteX60" fmla="*/ 2464743 w 3169713"/>
                    <a:gd name="connsiteY60" fmla="*/ 116599 h 921264"/>
                    <a:gd name="connsiteX61" fmla="*/ 2472611 w 3169713"/>
                    <a:gd name="connsiteY61" fmla="*/ 140205 h 921264"/>
                    <a:gd name="connsiteX62" fmla="*/ 2495665 w 3169713"/>
                    <a:gd name="connsiteY62" fmla="*/ 154423 h 921264"/>
                    <a:gd name="connsiteX63" fmla="*/ 2525068 w 3169713"/>
                    <a:gd name="connsiteY63" fmla="*/ 164224 h 921264"/>
                    <a:gd name="connsiteX64" fmla="*/ 2540943 w 3169713"/>
                    <a:gd name="connsiteY64" fmla="*/ 164224 h 921264"/>
                    <a:gd name="connsiteX65" fmla="*/ 2569518 w 3169713"/>
                    <a:gd name="connsiteY65" fmla="*/ 164638 h 921264"/>
                    <a:gd name="connsiteX66" fmla="*/ 2579043 w 3169713"/>
                    <a:gd name="connsiteY66" fmla="*/ 167399 h 921264"/>
                    <a:gd name="connsiteX67" fmla="*/ 2610793 w 3169713"/>
                    <a:gd name="connsiteY67" fmla="*/ 170574 h 921264"/>
                    <a:gd name="connsiteX68" fmla="*/ 2639368 w 3169713"/>
                    <a:gd name="connsiteY68" fmla="*/ 161049 h 921264"/>
                    <a:gd name="connsiteX69" fmla="*/ 2674293 w 3169713"/>
                    <a:gd name="connsiteY69" fmla="*/ 173749 h 921264"/>
                    <a:gd name="connsiteX70" fmla="*/ 2702868 w 3169713"/>
                    <a:gd name="connsiteY70" fmla="*/ 180099 h 921264"/>
                    <a:gd name="connsiteX71" fmla="*/ 2731443 w 3169713"/>
                    <a:gd name="connsiteY71" fmla="*/ 215024 h 921264"/>
                    <a:gd name="connsiteX72" fmla="*/ 2772718 w 3169713"/>
                    <a:gd name="connsiteY72" fmla="*/ 284874 h 921264"/>
                    <a:gd name="connsiteX73" fmla="*/ 2788593 w 3169713"/>
                    <a:gd name="connsiteY73" fmla="*/ 319799 h 921264"/>
                    <a:gd name="connsiteX74" fmla="*/ 2801293 w 3169713"/>
                    <a:gd name="connsiteY74" fmla="*/ 361074 h 921264"/>
                    <a:gd name="connsiteX75" fmla="*/ 2813993 w 3169713"/>
                    <a:gd name="connsiteY75" fmla="*/ 399174 h 921264"/>
                    <a:gd name="connsiteX76" fmla="*/ 2817168 w 3169713"/>
                    <a:gd name="connsiteY76" fmla="*/ 418224 h 921264"/>
                    <a:gd name="connsiteX77" fmla="*/ 2817168 w 3169713"/>
                    <a:gd name="connsiteY77" fmla="*/ 440449 h 921264"/>
                    <a:gd name="connsiteX78" fmla="*/ 2820343 w 3169713"/>
                    <a:gd name="connsiteY78" fmla="*/ 475374 h 921264"/>
                    <a:gd name="connsiteX79" fmla="*/ 2823518 w 3169713"/>
                    <a:gd name="connsiteY79" fmla="*/ 503949 h 921264"/>
                    <a:gd name="connsiteX80" fmla="*/ 2826693 w 3169713"/>
                    <a:gd name="connsiteY80" fmla="*/ 529349 h 921264"/>
                    <a:gd name="connsiteX81" fmla="*/ 2826693 w 3169713"/>
                    <a:gd name="connsiteY81" fmla="*/ 557924 h 921264"/>
                    <a:gd name="connsiteX82" fmla="*/ 2823518 w 3169713"/>
                    <a:gd name="connsiteY82" fmla="*/ 570624 h 921264"/>
                    <a:gd name="connsiteX83" fmla="*/ 2817168 w 3169713"/>
                    <a:gd name="connsiteY83" fmla="*/ 583324 h 921264"/>
                    <a:gd name="connsiteX84" fmla="*/ 2807643 w 3169713"/>
                    <a:gd name="connsiteY84" fmla="*/ 602374 h 921264"/>
                    <a:gd name="connsiteX85" fmla="*/ 2804468 w 3169713"/>
                    <a:gd name="connsiteY85" fmla="*/ 618249 h 921264"/>
                    <a:gd name="connsiteX86" fmla="*/ 2804468 w 3169713"/>
                    <a:gd name="connsiteY86" fmla="*/ 634124 h 921264"/>
                    <a:gd name="connsiteX87" fmla="*/ 2807643 w 3169713"/>
                    <a:gd name="connsiteY87" fmla="*/ 646824 h 921264"/>
                    <a:gd name="connsiteX88" fmla="*/ 2807643 w 3169713"/>
                    <a:gd name="connsiteY88" fmla="*/ 646824 h 921264"/>
                    <a:gd name="connsiteX89" fmla="*/ 2756843 w 3169713"/>
                    <a:gd name="connsiteY89" fmla="*/ 665874 h 921264"/>
                    <a:gd name="connsiteX90" fmla="*/ 2706043 w 3169713"/>
                    <a:gd name="connsiteY90" fmla="*/ 675399 h 921264"/>
                    <a:gd name="connsiteX91" fmla="*/ 2658418 w 3169713"/>
                    <a:gd name="connsiteY91" fmla="*/ 681749 h 921264"/>
                    <a:gd name="connsiteX92" fmla="*/ 2633018 w 3169713"/>
                    <a:gd name="connsiteY92" fmla="*/ 681749 h 921264"/>
                    <a:gd name="connsiteX93" fmla="*/ 2594918 w 3169713"/>
                    <a:gd name="connsiteY93" fmla="*/ 681749 h 921264"/>
                    <a:gd name="connsiteX94" fmla="*/ 2556818 w 3169713"/>
                    <a:gd name="connsiteY94" fmla="*/ 678574 h 921264"/>
                    <a:gd name="connsiteX95" fmla="*/ 2540943 w 3169713"/>
                    <a:gd name="connsiteY95" fmla="*/ 681749 h 921264"/>
                    <a:gd name="connsiteX96" fmla="*/ 2515543 w 3169713"/>
                    <a:gd name="connsiteY96" fmla="*/ 694449 h 921264"/>
                    <a:gd name="connsiteX97" fmla="*/ 2493318 w 3169713"/>
                    <a:gd name="connsiteY97" fmla="*/ 703974 h 921264"/>
                    <a:gd name="connsiteX98" fmla="*/ 2448868 w 3169713"/>
                    <a:gd name="connsiteY98" fmla="*/ 713499 h 921264"/>
                    <a:gd name="connsiteX99" fmla="*/ 2404418 w 3169713"/>
                    <a:gd name="connsiteY99" fmla="*/ 723024 h 921264"/>
                    <a:gd name="connsiteX100" fmla="*/ 2356793 w 3169713"/>
                    <a:gd name="connsiteY100" fmla="*/ 729374 h 921264"/>
                    <a:gd name="connsiteX101" fmla="*/ 2325043 w 3169713"/>
                    <a:gd name="connsiteY101" fmla="*/ 716674 h 921264"/>
                    <a:gd name="connsiteX102" fmla="*/ 2261543 w 3169713"/>
                    <a:gd name="connsiteY102" fmla="*/ 703974 h 921264"/>
                    <a:gd name="connsiteX103" fmla="*/ 2223443 w 3169713"/>
                    <a:gd name="connsiteY103" fmla="*/ 697624 h 921264"/>
                    <a:gd name="connsiteX104" fmla="*/ 2182168 w 3169713"/>
                    <a:gd name="connsiteY104" fmla="*/ 691274 h 921264"/>
                    <a:gd name="connsiteX105" fmla="*/ 2125018 w 3169713"/>
                    <a:gd name="connsiteY105" fmla="*/ 681749 h 921264"/>
                    <a:gd name="connsiteX106" fmla="*/ 2086918 w 3169713"/>
                    <a:gd name="connsiteY106" fmla="*/ 675399 h 921264"/>
                    <a:gd name="connsiteX107" fmla="*/ 2039293 w 3169713"/>
                    <a:gd name="connsiteY107" fmla="*/ 665874 h 921264"/>
                    <a:gd name="connsiteX108" fmla="*/ 1924993 w 3169713"/>
                    <a:gd name="connsiteY108" fmla="*/ 659524 h 921264"/>
                    <a:gd name="connsiteX109" fmla="*/ 1864668 w 3169713"/>
                    <a:gd name="connsiteY109" fmla="*/ 662699 h 921264"/>
                    <a:gd name="connsiteX110" fmla="*/ 1778943 w 3169713"/>
                    <a:gd name="connsiteY110" fmla="*/ 665874 h 921264"/>
                    <a:gd name="connsiteX111" fmla="*/ 1740843 w 3169713"/>
                    <a:gd name="connsiteY111" fmla="*/ 672224 h 921264"/>
                    <a:gd name="connsiteX112" fmla="*/ 1696393 w 3169713"/>
                    <a:gd name="connsiteY112" fmla="*/ 694449 h 921264"/>
                    <a:gd name="connsiteX113" fmla="*/ 1639243 w 3169713"/>
                    <a:gd name="connsiteY113" fmla="*/ 716674 h 921264"/>
                    <a:gd name="connsiteX114" fmla="*/ 1594793 w 3169713"/>
                    <a:gd name="connsiteY114" fmla="*/ 738899 h 921264"/>
                    <a:gd name="connsiteX115" fmla="*/ 1537643 w 3169713"/>
                    <a:gd name="connsiteY115" fmla="*/ 754774 h 921264"/>
                    <a:gd name="connsiteX116" fmla="*/ 1505893 w 3169713"/>
                    <a:gd name="connsiteY116" fmla="*/ 773824 h 921264"/>
                    <a:gd name="connsiteX117" fmla="*/ 1480493 w 3169713"/>
                    <a:gd name="connsiteY117" fmla="*/ 780174 h 921264"/>
                    <a:gd name="connsiteX118" fmla="*/ 1436043 w 3169713"/>
                    <a:gd name="connsiteY118" fmla="*/ 799224 h 921264"/>
                    <a:gd name="connsiteX119" fmla="*/ 1363018 w 3169713"/>
                    <a:gd name="connsiteY119" fmla="*/ 776999 h 921264"/>
                    <a:gd name="connsiteX120" fmla="*/ 1251893 w 3169713"/>
                    <a:gd name="connsiteY120" fmla="*/ 751599 h 921264"/>
                    <a:gd name="connsiteX121" fmla="*/ 1178868 w 3169713"/>
                    <a:gd name="connsiteY121" fmla="*/ 735724 h 921264"/>
                    <a:gd name="connsiteX122" fmla="*/ 1039168 w 3169713"/>
                    <a:gd name="connsiteY122" fmla="*/ 703974 h 921264"/>
                    <a:gd name="connsiteX123" fmla="*/ 969318 w 3169713"/>
                    <a:gd name="connsiteY123" fmla="*/ 700799 h 921264"/>
                    <a:gd name="connsiteX124" fmla="*/ 877243 w 3169713"/>
                    <a:gd name="connsiteY124" fmla="*/ 697624 h 921264"/>
                    <a:gd name="connsiteX125" fmla="*/ 823268 w 3169713"/>
                    <a:gd name="connsiteY125" fmla="*/ 700799 h 921264"/>
                    <a:gd name="connsiteX126" fmla="*/ 785168 w 3169713"/>
                    <a:gd name="connsiteY126" fmla="*/ 713499 h 921264"/>
                    <a:gd name="connsiteX127" fmla="*/ 721668 w 3169713"/>
                    <a:gd name="connsiteY127" fmla="*/ 726199 h 921264"/>
                    <a:gd name="connsiteX128" fmla="*/ 686743 w 3169713"/>
                    <a:gd name="connsiteY128" fmla="*/ 738899 h 921264"/>
                    <a:gd name="connsiteX129" fmla="*/ 556568 w 3169713"/>
                    <a:gd name="connsiteY129" fmla="*/ 732549 h 921264"/>
                    <a:gd name="connsiteX130" fmla="*/ 524818 w 3169713"/>
                    <a:gd name="connsiteY130" fmla="*/ 732549 h 921264"/>
                    <a:gd name="connsiteX131" fmla="*/ 410518 w 3169713"/>
                    <a:gd name="connsiteY131" fmla="*/ 719849 h 921264"/>
                    <a:gd name="connsiteX132" fmla="*/ 375593 w 3169713"/>
                    <a:gd name="connsiteY132" fmla="*/ 723024 h 921264"/>
                    <a:gd name="connsiteX133" fmla="*/ 353368 w 3169713"/>
                    <a:gd name="connsiteY133" fmla="*/ 732549 h 921264"/>
                    <a:gd name="connsiteX134" fmla="*/ 242243 w 3169713"/>
                    <a:gd name="connsiteY134" fmla="*/ 716674 h 921264"/>
                    <a:gd name="connsiteX135" fmla="*/ 223193 w 3169713"/>
                    <a:gd name="connsiteY135" fmla="*/ 716674 h 921264"/>
                    <a:gd name="connsiteX136" fmla="*/ 156518 w 3169713"/>
                    <a:gd name="connsiteY136" fmla="*/ 716674 h 921264"/>
                    <a:gd name="connsiteX137" fmla="*/ 140643 w 3169713"/>
                    <a:gd name="connsiteY137" fmla="*/ 719849 h 921264"/>
                    <a:gd name="connsiteX138" fmla="*/ 108893 w 3169713"/>
                    <a:gd name="connsiteY138" fmla="*/ 732549 h 921264"/>
                    <a:gd name="connsiteX139" fmla="*/ 80318 w 3169713"/>
                    <a:gd name="connsiteY139" fmla="*/ 742074 h 921264"/>
                    <a:gd name="connsiteX140" fmla="*/ 54918 w 3169713"/>
                    <a:gd name="connsiteY140" fmla="*/ 748424 h 921264"/>
                    <a:gd name="connsiteX141" fmla="*/ 13643 w 3169713"/>
                    <a:gd name="connsiteY141" fmla="*/ 757949 h 921264"/>
                    <a:gd name="connsiteX142" fmla="*/ 943 w 3169713"/>
                    <a:gd name="connsiteY142" fmla="*/ 761124 h 921264"/>
                    <a:gd name="connsiteX143" fmla="*/ 35316 w 3169713"/>
                    <a:gd name="connsiteY143" fmla="*/ 831388 h 921264"/>
                    <a:gd name="connsiteX0" fmla="*/ 87205 w 3173425"/>
                    <a:gd name="connsiteY0" fmla="*/ 865899 h 921264"/>
                    <a:gd name="connsiteX1" fmla="*/ 217380 w 3173425"/>
                    <a:gd name="connsiteY1" fmla="*/ 843674 h 921264"/>
                    <a:gd name="connsiteX2" fmla="*/ 341205 w 3173425"/>
                    <a:gd name="connsiteY2" fmla="*/ 834149 h 921264"/>
                    <a:gd name="connsiteX3" fmla="*/ 461855 w 3173425"/>
                    <a:gd name="connsiteY3" fmla="*/ 875424 h 921264"/>
                    <a:gd name="connsiteX4" fmla="*/ 534880 w 3173425"/>
                    <a:gd name="connsiteY4" fmla="*/ 878599 h 921264"/>
                    <a:gd name="connsiteX5" fmla="*/ 646005 w 3173425"/>
                    <a:gd name="connsiteY5" fmla="*/ 869074 h 921264"/>
                    <a:gd name="connsiteX6" fmla="*/ 725380 w 3173425"/>
                    <a:gd name="connsiteY6" fmla="*/ 846849 h 921264"/>
                    <a:gd name="connsiteX7" fmla="*/ 817455 w 3173425"/>
                    <a:gd name="connsiteY7" fmla="*/ 827799 h 921264"/>
                    <a:gd name="connsiteX8" fmla="*/ 973030 w 3173425"/>
                    <a:gd name="connsiteY8" fmla="*/ 821449 h 921264"/>
                    <a:gd name="connsiteX9" fmla="*/ 1169880 w 3173425"/>
                    <a:gd name="connsiteY9" fmla="*/ 846849 h 921264"/>
                    <a:gd name="connsiteX10" fmla="*/ 1357205 w 3173425"/>
                    <a:gd name="connsiteY10" fmla="*/ 913524 h 921264"/>
                    <a:gd name="connsiteX11" fmla="*/ 1490555 w 3173425"/>
                    <a:gd name="connsiteY11" fmla="*/ 916699 h 921264"/>
                    <a:gd name="connsiteX12" fmla="*/ 1649305 w 3173425"/>
                    <a:gd name="connsiteY12" fmla="*/ 884949 h 921264"/>
                    <a:gd name="connsiteX13" fmla="*/ 1741380 w 3173425"/>
                    <a:gd name="connsiteY13" fmla="*/ 853199 h 921264"/>
                    <a:gd name="connsiteX14" fmla="*/ 1785830 w 3173425"/>
                    <a:gd name="connsiteY14" fmla="*/ 827799 h 921264"/>
                    <a:gd name="connsiteX15" fmla="*/ 1849330 w 3173425"/>
                    <a:gd name="connsiteY15" fmla="*/ 802399 h 921264"/>
                    <a:gd name="connsiteX16" fmla="*/ 1903305 w 3173425"/>
                    <a:gd name="connsiteY16" fmla="*/ 805574 h 921264"/>
                    <a:gd name="connsiteX17" fmla="*/ 2052530 w 3173425"/>
                    <a:gd name="connsiteY17" fmla="*/ 827799 h 921264"/>
                    <a:gd name="connsiteX18" fmla="*/ 2154130 w 3173425"/>
                    <a:gd name="connsiteY18" fmla="*/ 830974 h 921264"/>
                    <a:gd name="connsiteX19" fmla="*/ 2258905 w 3173425"/>
                    <a:gd name="connsiteY19" fmla="*/ 850024 h 921264"/>
                    <a:gd name="connsiteX20" fmla="*/ 2363680 w 3173425"/>
                    <a:gd name="connsiteY20" fmla="*/ 881774 h 921264"/>
                    <a:gd name="connsiteX21" fmla="*/ 2493855 w 3173425"/>
                    <a:gd name="connsiteY21" fmla="*/ 869074 h 921264"/>
                    <a:gd name="connsiteX22" fmla="*/ 2589105 w 3173425"/>
                    <a:gd name="connsiteY22" fmla="*/ 846849 h 921264"/>
                    <a:gd name="connsiteX23" fmla="*/ 2636730 w 3173425"/>
                    <a:gd name="connsiteY23" fmla="*/ 824624 h 921264"/>
                    <a:gd name="connsiteX24" fmla="*/ 2706580 w 3173425"/>
                    <a:gd name="connsiteY24" fmla="*/ 827799 h 921264"/>
                    <a:gd name="connsiteX25" fmla="*/ 2763730 w 3173425"/>
                    <a:gd name="connsiteY25" fmla="*/ 815099 h 921264"/>
                    <a:gd name="connsiteX26" fmla="*/ 2811355 w 3173425"/>
                    <a:gd name="connsiteY26" fmla="*/ 796049 h 921264"/>
                    <a:gd name="connsiteX27" fmla="*/ 2833580 w 3173425"/>
                    <a:gd name="connsiteY27" fmla="*/ 780174 h 921264"/>
                    <a:gd name="connsiteX28" fmla="*/ 2868505 w 3173425"/>
                    <a:gd name="connsiteY28" fmla="*/ 796049 h 921264"/>
                    <a:gd name="connsiteX29" fmla="*/ 2906605 w 3173425"/>
                    <a:gd name="connsiteY29" fmla="*/ 830974 h 921264"/>
                    <a:gd name="connsiteX30" fmla="*/ 2985980 w 3173425"/>
                    <a:gd name="connsiteY30" fmla="*/ 856374 h 921264"/>
                    <a:gd name="connsiteX31" fmla="*/ 3062180 w 3173425"/>
                    <a:gd name="connsiteY31" fmla="*/ 850024 h 921264"/>
                    <a:gd name="connsiteX32" fmla="*/ 3122505 w 3173425"/>
                    <a:gd name="connsiteY32" fmla="*/ 808749 h 921264"/>
                    <a:gd name="connsiteX33" fmla="*/ 3138380 w 3173425"/>
                    <a:gd name="connsiteY33" fmla="*/ 770649 h 921264"/>
                    <a:gd name="connsiteX34" fmla="*/ 3166955 w 3173425"/>
                    <a:gd name="connsiteY34" fmla="*/ 703974 h 921264"/>
                    <a:gd name="connsiteX35" fmla="*/ 3173305 w 3173425"/>
                    <a:gd name="connsiteY35" fmla="*/ 637299 h 921264"/>
                    <a:gd name="connsiteX36" fmla="*/ 3163780 w 3173425"/>
                    <a:gd name="connsiteY36" fmla="*/ 592849 h 921264"/>
                    <a:gd name="connsiteX37" fmla="*/ 3138380 w 3173425"/>
                    <a:gd name="connsiteY37" fmla="*/ 548399 h 921264"/>
                    <a:gd name="connsiteX38" fmla="*/ 3125680 w 3173425"/>
                    <a:gd name="connsiteY38" fmla="*/ 494424 h 921264"/>
                    <a:gd name="connsiteX39" fmla="*/ 3116155 w 3173425"/>
                    <a:gd name="connsiteY39" fmla="*/ 434099 h 921264"/>
                    <a:gd name="connsiteX40" fmla="*/ 3106630 w 3173425"/>
                    <a:gd name="connsiteY40" fmla="*/ 383299 h 921264"/>
                    <a:gd name="connsiteX41" fmla="*/ 3074880 w 3173425"/>
                    <a:gd name="connsiteY41" fmla="*/ 319799 h 921264"/>
                    <a:gd name="connsiteX42" fmla="*/ 3065355 w 3173425"/>
                    <a:gd name="connsiteY42" fmla="*/ 316624 h 921264"/>
                    <a:gd name="connsiteX43" fmla="*/ 3036780 w 3173425"/>
                    <a:gd name="connsiteY43" fmla="*/ 303924 h 921264"/>
                    <a:gd name="connsiteX44" fmla="*/ 2999095 w 3173425"/>
                    <a:gd name="connsiteY44" fmla="*/ 271484 h 921264"/>
                    <a:gd name="connsiteX45" fmla="*/ 2957405 w 3173425"/>
                    <a:gd name="connsiteY45" fmla="*/ 256299 h 921264"/>
                    <a:gd name="connsiteX46" fmla="*/ 2949812 w 3173425"/>
                    <a:gd name="connsiteY46" fmla="*/ 220822 h 921264"/>
                    <a:gd name="connsiteX47" fmla="*/ 2925655 w 3173425"/>
                    <a:gd name="connsiteY47" fmla="*/ 208674 h 921264"/>
                    <a:gd name="connsiteX48" fmla="*/ 2884380 w 3173425"/>
                    <a:gd name="connsiteY48" fmla="*/ 161049 h 921264"/>
                    <a:gd name="connsiteX49" fmla="*/ 2868505 w 3173425"/>
                    <a:gd name="connsiteY49" fmla="*/ 148349 h 921264"/>
                    <a:gd name="connsiteX50" fmla="*/ 2843105 w 3173425"/>
                    <a:gd name="connsiteY50" fmla="*/ 113424 h 921264"/>
                    <a:gd name="connsiteX51" fmla="*/ 2805005 w 3173425"/>
                    <a:gd name="connsiteY51" fmla="*/ 65799 h 921264"/>
                    <a:gd name="connsiteX52" fmla="*/ 2776430 w 3173425"/>
                    <a:gd name="connsiteY52" fmla="*/ 37224 h 921264"/>
                    <a:gd name="connsiteX53" fmla="*/ 2738330 w 3173425"/>
                    <a:gd name="connsiteY53" fmla="*/ 24524 h 921264"/>
                    <a:gd name="connsiteX54" fmla="*/ 2678005 w 3173425"/>
                    <a:gd name="connsiteY54" fmla="*/ 14999 h 921264"/>
                    <a:gd name="connsiteX55" fmla="*/ 2611330 w 3173425"/>
                    <a:gd name="connsiteY55" fmla="*/ 8649 h 921264"/>
                    <a:gd name="connsiteX56" fmla="*/ 2559563 w 3173425"/>
                    <a:gd name="connsiteY56" fmla="*/ 90 h 921264"/>
                    <a:gd name="connsiteX57" fmla="*/ 2531403 w 3173425"/>
                    <a:gd name="connsiteY57" fmla="*/ 14446 h 921264"/>
                    <a:gd name="connsiteX58" fmla="*/ 2493855 w 3173425"/>
                    <a:gd name="connsiteY58" fmla="*/ 49924 h 921264"/>
                    <a:gd name="connsiteX59" fmla="*/ 2474805 w 3173425"/>
                    <a:gd name="connsiteY59" fmla="*/ 84849 h 921264"/>
                    <a:gd name="connsiteX60" fmla="*/ 2468455 w 3173425"/>
                    <a:gd name="connsiteY60" fmla="*/ 116599 h 921264"/>
                    <a:gd name="connsiteX61" fmla="*/ 2476323 w 3173425"/>
                    <a:gd name="connsiteY61" fmla="*/ 140205 h 921264"/>
                    <a:gd name="connsiteX62" fmla="*/ 2499377 w 3173425"/>
                    <a:gd name="connsiteY62" fmla="*/ 154423 h 921264"/>
                    <a:gd name="connsiteX63" fmla="*/ 2528780 w 3173425"/>
                    <a:gd name="connsiteY63" fmla="*/ 164224 h 921264"/>
                    <a:gd name="connsiteX64" fmla="*/ 2544655 w 3173425"/>
                    <a:gd name="connsiteY64" fmla="*/ 164224 h 921264"/>
                    <a:gd name="connsiteX65" fmla="*/ 2573230 w 3173425"/>
                    <a:gd name="connsiteY65" fmla="*/ 164638 h 921264"/>
                    <a:gd name="connsiteX66" fmla="*/ 2582755 w 3173425"/>
                    <a:gd name="connsiteY66" fmla="*/ 167399 h 921264"/>
                    <a:gd name="connsiteX67" fmla="*/ 2614505 w 3173425"/>
                    <a:gd name="connsiteY67" fmla="*/ 170574 h 921264"/>
                    <a:gd name="connsiteX68" fmla="*/ 2643080 w 3173425"/>
                    <a:gd name="connsiteY68" fmla="*/ 161049 h 921264"/>
                    <a:gd name="connsiteX69" fmla="*/ 2678005 w 3173425"/>
                    <a:gd name="connsiteY69" fmla="*/ 173749 h 921264"/>
                    <a:gd name="connsiteX70" fmla="*/ 2706580 w 3173425"/>
                    <a:gd name="connsiteY70" fmla="*/ 180099 h 921264"/>
                    <a:gd name="connsiteX71" fmla="*/ 2735155 w 3173425"/>
                    <a:gd name="connsiteY71" fmla="*/ 215024 h 921264"/>
                    <a:gd name="connsiteX72" fmla="*/ 2776430 w 3173425"/>
                    <a:gd name="connsiteY72" fmla="*/ 284874 h 921264"/>
                    <a:gd name="connsiteX73" fmla="*/ 2792305 w 3173425"/>
                    <a:gd name="connsiteY73" fmla="*/ 319799 h 921264"/>
                    <a:gd name="connsiteX74" fmla="*/ 2805005 w 3173425"/>
                    <a:gd name="connsiteY74" fmla="*/ 361074 h 921264"/>
                    <a:gd name="connsiteX75" fmla="*/ 2817705 w 3173425"/>
                    <a:gd name="connsiteY75" fmla="*/ 399174 h 921264"/>
                    <a:gd name="connsiteX76" fmla="*/ 2820880 w 3173425"/>
                    <a:gd name="connsiteY76" fmla="*/ 418224 h 921264"/>
                    <a:gd name="connsiteX77" fmla="*/ 2820880 w 3173425"/>
                    <a:gd name="connsiteY77" fmla="*/ 440449 h 921264"/>
                    <a:gd name="connsiteX78" fmla="*/ 2824055 w 3173425"/>
                    <a:gd name="connsiteY78" fmla="*/ 475374 h 921264"/>
                    <a:gd name="connsiteX79" fmla="*/ 2827230 w 3173425"/>
                    <a:gd name="connsiteY79" fmla="*/ 503949 h 921264"/>
                    <a:gd name="connsiteX80" fmla="*/ 2830405 w 3173425"/>
                    <a:gd name="connsiteY80" fmla="*/ 529349 h 921264"/>
                    <a:gd name="connsiteX81" fmla="*/ 2830405 w 3173425"/>
                    <a:gd name="connsiteY81" fmla="*/ 557924 h 921264"/>
                    <a:gd name="connsiteX82" fmla="*/ 2827230 w 3173425"/>
                    <a:gd name="connsiteY82" fmla="*/ 570624 h 921264"/>
                    <a:gd name="connsiteX83" fmla="*/ 2820880 w 3173425"/>
                    <a:gd name="connsiteY83" fmla="*/ 583324 h 921264"/>
                    <a:gd name="connsiteX84" fmla="*/ 2811355 w 3173425"/>
                    <a:gd name="connsiteY84" fmla="*/ 602374 h 921264"/>
                    <a:gd name="connsiteX85" fmla="*/ 2808180 w 3173425"/>
                    <a:gd name="connsiteY85" fmla="*/ 618249 h 921264"/>
                    <a:gd name="connsiteX86" fmla="*/ 2808180 w 3173425"/>
                    <a:gd name="connsiteY86" fmla="*/ 634124 h 921264"/>
                    <a:gd name="connsiteX87" fmla="*/ 2811355 w 3173425"/>
                    <a:gd name="connsiteY87" fmla="*/ 646824 h 921264"/>
                    <a:gd name="connsiteX88" fmla="*/ 2811355 w 3173425"/>
                    <a:gd name="connsiteY88" fmla="*/ 646824 h 921264"/>
                    <a:gd name="connsiteX89" fmla="*/ 2760555 w 3173425"/>
                    <a:gd name="connsiteY89" fmla="*/ 665874 h 921264"/>
                    <a:gd name="connsiteX90" fmla="*/ 2709755 w 3173425"/>
                    <a:gd name="connsiteY90" fmla="*/ 675399 h 921264"/>
                    <a:gd name="connsiteX91" fmla="*/ 2662130 w 3173425"/>
                    <a:gd name="connsiteY91" fmla="*/ 681749 h 921264"/>
                    <a:gd name="connsiteX92" fmla="*/ 2636730 w 3173425"/>
                    <a:gd name="connsiteY92" fmla="*/ 681749 h 921264"/>
                    <a:gd name="connsiteX93" fmla="*/ 2598630 w 3173425"/>
                    <a:gd name="connsiteY93" fmla="*/ 681749 h 921264"/>
                    <a:gd name="connsiteX94" fmla="*/ 2560530 w 3173425"/>
                    <a:gd name="connsiteY94" fmla="*/ 678574 h 921264"/>
                    <a:gd name="connsiteX95" fmla="*/ 2544655 w 3173425"/>
                    <a:gd name="connsiteY95" fmla="*/ 681749 h 921264"/>
                    <a:gd name="connsiteX96" fmla="*/ 2519255 w 3173425"/>
                    <a:gd name="connsiteY96" fmla="*/ 694449 h 921264"/>
                    <a:gd name="connsiteX97" fmla="*/ 2497030 w 3173425"/>
                    <a:gd name="connsiteY97" fmla="*/ 703974 h 921264"/>
                    <a:gd name="connsiteX98" fmla="*/ 2452580 w 3173425"/>
                    <a:gd name="connsiteY98" fmla="*/ 713499 h 921264"/>
                    <a:gd name="connsiteX99" fmla="*/ 2408130 w 3173425"/>
                    <a:gd name="connsiteY99" fmla="*/ 723024 h 921264"/>
                    <a:gd name="connsiteX100" fmla="*/ 2360505 w 3173425"/>
                    <a:gd name="connsiteY100" fmla="*/ 729374 h 921264"/>
                    <a:gd name="connsiteX101" fmla="*/ 2328755 w 3173425"/>
                    <a:gd name="connsiteY101" fmla="*/ 716674 h 921264"/>
                    <a:gd name="connsiteX102" fmla="*/ 2265255 w 3173425"/>
                    <a:gd name="connsiteY102" fmla="*/ 703974 h 921264"/>
                    <a:gd name="connsiteX103" fmla="*/ 2227155 w 3173425"/>
                    <a:gd name="connsiteY103" fmla="*/ 697624 h 921264"/>
                    <a:gd name="connsiteX104" fmla="*/ 2185880 w 3173425"/>
                    <a:gd name="connsiteY104" fmla="*/ 691274 h 921264"/>
                    <a:gd name="connsiteX105" fmla="*/ 2128730 w 3173425"/>
                    <a:gd name="connsiteY105" fmla="*/ 681749 h 921264"/>
                    <a:gd name="connsiteX106" fmla="*/ 2090630 w 3173425"/>
                    <a:gd name="connsiteY106" fmla="*/ 675399 h 921264"/>
                    <a:gd name="connsiteX107" fmla="*/ 2043005 w 3173425"/>
                    <a:gd name="connsiteY107" fmla="*/ 665874 h 921264"/>
                    <a:gd name="connsiteX108" fmla="*/ 1928705 w 3173425"/>
                    <a:gd name="connsiteY108" fmla="*/ 659524 h 921264"/>
                    <a:gd name="connsiteX109" fmla="*/ 1868380 w 3173425"/>
                    <a:gd name="connsiteY109" fmla="*/ 662699 h 921264"/>
                    <a:gd name="connsiteX110" fmla="*/ 1782655 w 3173425"/>
                    <a:gd name="connsiteY110" fmla="*/ 665874 h 921264"/>
                    <a:gd name="connsiteX111" fmla="*/ 1744555 w 3173425"/>
                    <a:gd name="connsiteY111" fmla="*/ 672224 h 921264"/>
                    <a:gd name="connsiteX112" fmla="*/ 1700105 w 3173425"/>
                    <a:gd name="connsiteY112" fmla="*/ 694449 h 921264"/>
                    <a:gd name="connsiteX113" fmla="*/ 1642955 w 3173425"/>
                    <a:gd name="connsiteY113" fmla="*/ 716674 h 921264"/>
                    <a:gd name="connsiteX114" fmla="*/ 1598505 w 3173425"/>
                    <a:gd name="connsiteY114" fmla="*/ 738899 h 921264"/>
                    <a:gd name="connsiteX115" fmla="*/ 1541355 w 3173425"/>
                    <a:gd name="connsiteY115" fmla="*/ 754774 h 921264"/>
                    <a:gd name="connsiteX116" fmla="*/ 1509605 w 3173425"/>
                    <a:gd name="connsiteY116" fmla="*/ 773824 h 921264"/>
                    <a:gd name="connsiteX117" fmla="*/ 1484205 w 3173425"/>
                    <a:gd name="connsiteY117" fmla="*/ 780174 h 921264"/>
                    <a:gd name="connsiteX118" fmla="*/ 1439755 w 3173425"/>
                    <a:gd name="connsiteY118" fmla="*/ 799224 h 921264"/>
                    <a:gd name="connsiteX119" fmla="*/ 1366730 w 3173425"/>
                    <a:gd name="connsiteY119" fmla="*/ 776999 h 921264"/>
                    <a:gd name="connsiteX120" fmla="*/ 1255605 w 3173425"/>
                    <a:gd name="connsiteY120" fmla="*/ 751599 h 921264"/>
                    <a:gd name="connsiteX121" fmla="*/ 1182580 w 3173425"/>
                    <a:gd name="connsiteY121" fmla="*/ 735724 h 921264"/>
                    <a:gd name="connsiteX122" fmla="*/ 1042880 w 3173425"/>
                    <a:gd name="connsiteY122" fmla="*/ 703974 h 921264"/>
                    <a:gd name="connsiteX123" fmla="*/ 973030 w 3173425"/>
                    <a:gd name="connsiteY123" fmla="*/ 700799 h 921264"/>
                    <a:gd name="connsiteX124" fmla="*/ 880955 w 3173425"/>
                    <a:gd name="connsiteY124" fmla="*/ 697624 h 921264"/>
                    <a:gd name="connsiteX125" fmla="*/ 826980 w 3173425"/>
                    <a:gd name="connsiteY125" fmla="*/ 700799 h 921264"/>
                    <a:gd name="connsiteX126" fmla="*/ 788880 w 3173425"/>
                    <a:gd name="connsiteY126" fmla="*/ 713499 h 921264"/>
                    <a:gd name="connsiteX127" fmla="*/ 725380 w 3173425"/>
                    <a:gd name="connsiteY127" fmla="*/ 726199 h 921264"/>
                    <a:gd name="connsiteX128" fmla="*/ 690455 w 3173425"/>
                    <a:gd name="connsiteY128" fmla="*/ 738899 h 921264"/>
                    <a:gd name="connsiteX129" fmla="*/ 560280 w 3173425"/>
                    <a:gd name="connsiteY129" fmla="*/ 732549 h 921264"/>
                    <a:gd name="connsiteX130" fmla="*/ 528530 w 3173425"/>
                    <a:gd name="connsiteY130" fmla="*/ 732549 h 921264"/>
                    <a:gd name="connsiteX131" fmla="*/ 414230 w 3173425"/>
                    <a:gd name="connsiteY131" fmla="*/ 719849 h 921264"/>
                    <a:gd name="connsiteX132" fmla="*/ 379305 w 3173425"/>
                    <a:gd name="connsiteY132" fmla="*/ 723024 h 921264"/>
                    <a:gd name="connsiteX133" fmla="*/ 357080 w 3173425"/>
                    <a:gd name="connsiteY133" fmla="*/ 732549 h 921264"/>
                    <a:gd name="connsiteX134" fmla="*/ 245955 w 3173425"/>
                    <a:gd name="connsiteY134" fmla="*/ 716674 h 921264"/>
                    <a:gd name="connsiteX135" fmla="*/ 226905 w 3173425"/>
                    <a:gd name="connsiteY135" fmla="*/ 716674 h 921264"/>
                    <a:gd name="connsiteX136" fmla="*/ 160230 w 3173425"/>
                    <a:gd name="connsiteY136" fmla="*/ 716674 h 921264"/>
                    <a:gd name="connsiteX137" fmla="*/ 144355 w 3173425"/>
                    <a:gd name="connsiteY137" fmla="*/ 719849 h 921264"/>
                    <a:gd name="connsiteX138" fmla="*/ 112605 w 3173425"/>
                    <a:gd name="connsiteY138" fmla="*/ 732549 h 921264"/>
                    <a:gd name="connsiteX139" fmla="*/ 84030 w 3173425"/>
                    <a:gd name="connsiteY139" fmla="*/ 742074 h 921264"/>
                    <a:gd name="connsiteX140" fmla="*/ 58630 w 3173425"/>
                    <a:gd name="connsiteY140" fmla="*/ 748424 h 921264"/>
                    <a:gd name="connsiteX141" fmla="*/ 17355 w 3173425"/>
                    <a:gd name="connsiteY141" fmla="*/ 757949 h 921264"/>
                    <a:gd name="connsiteX142" fmla="*/ 4655 w 3173425"/>
                    <a:gd name="connsiteY142" fmla="*/ 761124 h 921264"/>
                    <a:gd name="connsiteX143" fmla="*/ 93693 w 3173425"/>
                    <a:gd name="connsiteY143" fmla="*/ 864518 h 921264"/>
                    <a:gd name="connsiteX0" fmla="*/ 69902 w 3156122"/>
                    <a:gd name="connsiteY0" fmla="*/ 865899 h 921264"/>
                    <a:gd name="connsiteX1" fmla="*/ 200077 w 3156122"/>
                    <a:gd name="connsiteY1" fmla="*/ 843674 h 921264"/>
                    <a:gd name="connsiteX2" fmla="*/ 323902 w 3156122"/>
                    <a:gd name="connsiteY2" fmla="*/ 834149 h 921264"/>
                    <a:gd name="connsiteX3" fmla="*/ 444552 w 3156122"/>
                    <a:gd name="connsiteY3" fmla="*/ 875424 h 921264"/>
                    <a:gd name="connsiteX4" fmla="*/ 517577 w 3156122"/>
                    <a:gd name="connsiteY4" fmla="*/ 878599 h 921264"/>
                    <a:gd name="connsiteX5" fmla="*/ 628702 w 3156122"/>
                    <a:gd name="connsiteY5" fmla="*/ 869074 h 921264"/>
                    <a:gd name="connsiteX6" fmla="*/ 708077 w 3156122"/>
                    <a:gd name="connsiteY6" fmla="*/ 846849 h 921264"/>
                    <a:gd name="connsiteX7" fmla="*/ 800152 w 3156122"/>
                    <a:gd name="connsiteY7" fmla="*/ 827799 h 921264"/>
                    <a:gd name="connsiteX8" fmla="*/ 955727 w 3156122"/>
                    <a:gd name="connsiteY8" fmla="*/ 821449 h 921264"/>
                    <a:gd name="connsiteX9" fmla="*/ 1152577 w 3156122"/>
                    <a:gd name="connsiteY9" fmla="*/ 846849 h 921264"/>
                    <a:gd name="connsiteX10" fmla="*/ 1339902 w 3156122"/>
                    <a:gd name="connsiteY10" fmla="*/ 913524 h 921264"/>
                    <a:gd name="connsiteX11" fmla="*/ 1473252 w 3156122"/>
                    <a:gd name="connsiteY11" fmla="*/ 916699 h 921264"/>
                    <a:gd name="connsiteX12" fmla="*/ 1632002 w 3156122"/>
                    <a:gd name="connsiteY12" fmla="*/ 884949 h 921264"/>
                    <a:gd name="connsiteX13" fmla="*/ 1724077 w 3156122"/>
                    <a:gd name="connsiteY13" fmla="*/ 853199 h 921264"/>
                    <a:gd name="connsiteX14" fmla="*/ 1768527 w 3156122"/>
                    <a:gd name="connsiteY14" fmla="*/ 827799 h 921264"/>
                    <a:gd name="connsiteX15" fmla="*/ 1832027 w 3156122"/>
                    <a:gd name="connsiteY15" fmla="*/ 802399 h 921264"/>
                    <a:gd name="connsiteX16" fmla="*/ 1886002 w 3156122"/>
                    <a:gd name="connsiteY16" fmla="*/ 805574 h 921264"/>
                    <a:gd name="connsiteX17" fmla="*/ 2035227 w 3156122"/>
                    <a:gd name="connsiteY17" fmla="*/ 827799 h 921264"/>
                    <a:gd name="connsiteX18" fmla="*/ 2136827 w 3156122"/>
                    <a:gd name="connsiteY18" fmla="*/ 830974 h 921264"/>
                    <a:gd name="connsiteX19" fmla="*/ 2241602 w 3156122"/>
                    <a:gd name="connsiteY19" fmla="*/ 850024 h 921264"/>
                    <a:gd name="connsiteX20" fmla="*/ 2346377 w 3156122"/>
                    <a:gd name="connsiteY20" fmla="*/ 881774 h 921264"/>
                    <a:gd name="connsiteX21" fmla="*/ 2476552 w 3156122"/>
                    <a:gd name="connsiteY21" fmla="*/ 869074 h 921264"/>
                    <a:gd name="connsiteX22" fmla="*/ 2571802 w 3156122"/>
                    <a:gd name="connsiteY22" fmla="*/ 846849 h 921264"/>
                    <a:gd name="connsiteX23" fmla="*/ 2619427 w 3156122"/>
                    <a:gd name="connsiteY23" fmla="*/ 824624 h 921264"/>
                    <a:gd name="connsiteX24" fmla="*/ 2689277 w 3156122"/>
                    <a:gd name="connsiteY24" fmla="*/ 827799 h 921264"/>
                    <a:gd name="connsiteX25" fmla="*/ 2746427 w 3156122"/>
                    <a:gd name="connsiteY25" fmla="*/ 815099 h 921264"/>
                    <a:gd name="connsiteX26" fmla="*/ 2794052 w 3156122"/>
                    <a:gd name="connsiteY26" fmla="*/ 796049 h 921264"/>
                    <a:gd name="connsiteX27" fmla="*/ 2816277 w 3156122"/>
                    <a:gd name="connsiteY27" fmla="*/ 780174 h 921264"/>
                    <a:gd name="connsiteX28" fmla="*/ 2851202 w 3156122"/>
                    <a:gd name="connsiteY28" fmla="*/ 796049 h 921264"/>
                    <a:gd name="connsiteX29" fmla="*/ 2889302 w 3156122"/>
                    <a:gd name="connsiteY29" fmla="*/ 830974 h 921264"/>
                    <a:gd name="connsiteX30" fmla="*/ 2968677 w 3156122"/>
                    <a:gd name="connsiteY30" fmla="*/ 856374 h 921264"/>
                    <a:gd name="connsiteX31" fmla="*/ 3044877 w 3156122"/>
                    <a:gd name="connsiteY31" fmla="*/ 850024 h 921264"/>
                    <a:gd name="connsiteX32" fmla="*/ 3105202 w 3156122"/>
                    <a:gd name="connsiteY32" fmla="*/ 808749 h 921264"/>
                    <a:gd name="connsiteX33" fmla="*/ 3121077 w 3156122"/>
                    <a:gd name="connsiteY33" fmla="*/ 770649 h 921264"/>
                    <a:gd name="connsiteX34" fmla="*/ 3149652 w 3156122"/>
                    <a:gd name="connsiteY34" fmla="*/ 703974 h 921264"/>
                    <a:gd name="connsiteX35" fmla="*/ 3156002 w 3156122"/>
                    <a:gd name="connsiteY35" fmla="*/ 637299 h 921264"/>
                    <a:gd name="connsiteX36" fmla="*/ 3146477 w 3156122"/>
                    <a:gd name="connsiteY36" fmla="*/ 592849 h 921264"/>
                    <a:gd name="connsiteX37" fmla="*/ 3121077 w 3156122"/>
                    <a:gd name="connsiteY37" fmla="*/ 548399 h 921264"/>
                    <a:gd name="connsiteX38" fmla="*/ 3108377 w 3156122"/>
                    <a:gd name="connsiteY38" fmla="*/ 494424 h 921264"/>
                    <a:gd name="connsiteX39" fmla="*/ 3098852 w 3156122"/>
                    <a:gd name="connsiteY39" fmla="*/ 434099 h 921264"/>
                    <a:gd name="connsiteX40" fmla="*/ 3089327 w 3156122"/>
                    <a:gd name="connsiteY40" fmla="*/ 383299 h 921264"/>
                    <a:gd name="connsiteX41" fmla="*/ 3057577 w 3156122"/>
                    <a:gd name="connsiteY41" fmla="*/ 319799 h 921264"/>
                    <a:gd name="connsiteX42" fmla="*/ 3048052 w 3156122"/>
                    <a:gd name="connsiteY42" fmla="*/ 316624 h 921264"/>
                    <a:gd name="connsiteX43" fmla="*/ 3019477 w 3156122"/>
                    <a:gd name="connsiteY43" fmla="*/ 303924 h 921264"/>
                    <a:gd name="connsiteX44" fmla="*/ 2981792 w 3156122"/>
                    <a:gd name="connsiteY44" fmla="*/ 271484 h 921264"/>
                    <a:gd name="connsiteX45" fmla="*/ 2940102 w 3156122"/>
                    <a:gd name="connsiteY45" fmla="*/ 256299 h 921264"/>
                    <a:gd name="connsiteX46" fmla="*/ 2932509 w 3156122"/>
                    <a:gd name="connsiteY46" fmla="*/ 220822 h 921264"/>
                    <a:gd name="connsiteX47" fmla="*/ 2908352 w 3156122"/>
                    <a:gd name="connsiteY47" fmla="*/ 208674 h 921264"/>
                    <a:gd name="connsiteX48" fmla="*/ 2867077 w 3156122"/>
                    <a:gd name="connsiteY48" fmla="*/ 161049 h 921264"/>
                    <a:gd name="connsiteX49" fmla="*/ 2851202 w 3156122"/>
                    <a:gd name="connsiteY49" fmla="*/ 148349 h 921264"/>
                    <a:gd name="connsiteX50" fmla="*/ 2825802 w 3156122"/>
                    <a:gd name="connsiteY50" fmla="*/ 113424 h 921264"/>
                    <a:gd name="connsiteX51" fmla="*/ 2787702 w 3156122"/>
                    <a:gd name="connsiteY51" fmla="*/ 65799 h 921264"/>
                    <a:gd name="connsiteX52" fmla="*/ 2759127 w 3156122"/>
                    <a:gd name="connsiteY52" fmla="*/ 37224 h 921264"/>
                    <a:gd name="connsiteX53" fmla="*/ 2721027 w 3156122"/>
                    <a:gd name="connsiteY53" fmla="*/ 24524 h 921264"/>
                    <a:gd name="connsiteX54" fmla="*/ 2660702 w 3156122"/>
                    <a:gd name="connsiteY54" fmla="*/ 14999 h 921264"/>
                    <a:gd name="connsiteX55" fmla="*/ 2594027 w 3156122"/>
                    <a:gd name="connsiteY55" fmla="*/ 8649 h 921264"/>
                    <a:gd name="connsiteX56" fmla="*/ 2542260 w 3156122"/>
                    <a:gd name="connsiteY56" fmla="*/ 90 h 921264"/>
                    <a:gd name="connsiteX57" fmla="*/ 2514100 w 3156122"/>
                    <a:gd name="connsiteY57" fmla="*/ 14446 h 921264"/>
                    <a:gd name="connsiteX58" fmla="*/ 2476552 w 3156122"/>
                    <a:gd name="connsiteY58" fmla="*/ 49924 h 921264"/>
                    <a:gd name="connsiteX59" fmla="*/ 2457502 w 3156122"/>
                    <a:gd name="connsiteY59" fmla="*/ 84849 h 921264"/>
                    <a:gd name="connsiteX60" fmla="*/ 2451152 w 3156122"/>
                    <a:gd name="connsiteY60" fmla="*/ 116599 h 921264"/>
                    <a:gd name="connsiteX61" fmla="*/ 2459020 w 3156122"/>
                    <a:gd name="connsiteY61" fmla="*/ 140205 h 921264"/>
                    <a:gd name="connsiteX62" fmla="*/ 2482074 w 3156122"/>
                    <a:gd name="connsiteY62" fmla="*/ 154423 h 921264"/>
                    <a:gd name="connsiteX63" fmla="*/ 2511477 w 3156122"/>
                    <a:gd name="connsiteY63" fmla="*/ 164224 h 921264"/>
                    <a:gd name="connsiteX64" fmla="*/ 2527352 w 3156122"/>
                    <a:gd name="connsiteY64" fmla="*/ 164224 h 921264"/>
                    <a:gd name="connsiteX65" fmla="*/ 2555927 w 3156122"/>
                    <a:gd name="connsiteY65" fmla="*/ 164638 h 921264"/>
                    <a:gd name="connsiteX66" fmla="*/ 2565452 w 3156122"/>
                    <a:gd name="connsiteY66" fmla="*/ 167399 h 921264"/>
                    <a:gd name="connsiteX67" fmla="*/ 2597202 w 3156122"/>
                    <a:gd name="connsiteY67" fmla="*/ 170574 h 921264"/>
                    <a:gd name="connsiteX68" fmla="*/ 2625777 w 3156122"/>
                    <a:gd name="connsiteY68" fmla="*/ 161049 h 921264"/>
                    <a:gd name="connsiteX69" fmla="*/ 2660702 w 3156122"/>
                    <a:gd name="connsiteY69" fmla="*/ 173749 h 921264"/>
                    <a:gd name="connsiteX70" fmla="*/ 2689277 w 3156122"/>
                    <a:gd name="connsiteY70" fmla="*/ 180099 h 921264"/>
                    <a:gd name="connsiteX71" fmla="*/ 2717852 w 3156122"/>
                    <a:gd name="connsiteY71" fmla="*/ 215024 h 921264"/>
                    <a:gd name="connsiteX72" fmla="*/ 2759127 w 3156122"/>
                    <a:gd name="connsiteY72" fmla="*/ 284874 h 921264"/>
                    <a:gd name="connsiteX73" fmla="*/ 2775002 w 3156122"/>
                    <a:gd name="connsiteY73" fmla="*/ 319799 h 921264"/>
                    <a:gd name="connsiteX74" fmla="*/ 2787702 w 3156122"/>
                    <a:gd name="connsiteY74" fmla="*/ 361074 h 921264"/>
                    <a:gd name="connsiteX75" fmla="*/ 2800402 w 3156122"/>
                    <a:gd name="connsiteY75" fmla="*/ 399174 h 921264"/>
                    <a:gd name="connsiteX76" fmla="*/ 2803577 w 3156122"/>
                    <a:gd name="connsiteY76" fmla="*/ 418224 h 921264"/>
                    <a:gd name="connsiteX77" fmla="*/ 2803577 w 3156122"/>
                    <a:gd name="connsiteY77" fmla="*/ 440449 h 921264"/>
                    <a:gd name="connsiteX78" fmla="*/ 2806752 w 3156122"/>
                    <a:gd name="connsiteY78" fmla="*/ 475374 h 921264"/>
                    <a:gd name="connsiteX79" fmla="*/ 2809927 w 3156122"/>
                    <a:gd name="connsiteY79" fmla="*/ 503949 h 921264"/>
                    <a:gd name="connsiteX80" fmla="*/ 2813102 w 3156122"/>
                    <a:gd name="connsiteY80" fmla="*/ 529349 h 921264"/>
                    <a:gd name="connsiteX81" fmla="*/ 2813102 w 3156122"/>
                    <a:gd name="connsiteY81" fmla="*/ 557924 h 921264"/>
                    <a:gd name="connsiteX82" fmla="*/ 2809927 w 3156122"/>
                    <a:gd name="connsiteY82" fmla="*/ 570624 h 921264"/>
                    <a:gd name="connsiteX83" fmla="*/ 2803577 w 3156122"/>
                    <a:gd name="connsiteY83" fmla="*/ 583324 h 921264"/>
                    <a:gd name="connsiteX84" fmla="*/ 2794052 w 3156122"/>
                    <a:gd name="connsiteY84" fmla="*/ 602374 h 921264"/>
                    <a:gd name="connsiteX85" fmla="*/ 2790877 w 3156122"/>
                    <a:gd name="connsiteY85" fmla="*/ 618249 h 921264"/>
                    <a:gd name="connsiteX86" fmla="*/ 2790877 w 3156122"/>
                    <a:gd name="connsiteY86" fmla="*/ 634124 h 921264"/>
                    <a:gd name="connsiteX87" fmla="*/ 2794052 w 3156122"/>
                    <a:gd name="connsiteY87" fmla="*/ 646824 h 921264"/>
                    <a:gd name="connsiteX88" fmla="*/ 2794052 w 3156122"/>
                    <a:gd name="connsiteY88" fmla="*/ 646824 h 921264"/>
                    <a:gd name="connsiteX89" fmla="*/ 2743252 w 3156122"/>
                    <a:gd name="connsiteY89" fmla="*/ 665874 h 921264"/>
                    <a:gd name="connsiteX90" fmla="*/ 2692452 w 3156122"/>
                    <a:gd name="connsiteY90" fmla="*/ 675399 h 921264"/>
                    <a:gd name="connsiteX91" fmla="*/ 2644827 w 3156122"/>
                    <a:gd name="connsiteY91" fmla="*/ 681749 h 921264"/>
                    <a:gd name="connsiteX92" fmla="*/ 2619427 w 3156122"/>
                    <a:gd name="connsiteY92" fmla="*/ 681749 h 921264"/>
                    <a:gd name="connsiteX93" fmla="*/ 2581327 w 3156122"/>
                    <a:gd name="connsiteY93" fmla="*/ 681749 h 921264"/>
                    <a:gd name="connsiteX94" fmla="*/ 2543227 w 3156122"/>
                    <a:gd name="connsiteY94" fmla="*/ 678574 h 921264"/>
                    <a:gd name="connsiteX95" fmla="*/ 2527352 w 3156122"/>
                    <a:gd name="connsiteY95" fmla="*/ 681749 h 921264"/>
                    <a:gd name="connsiteX96" fmla="*/ 2501952 w 3156122"/>
                    <a:gd name="connsiteY96" fmla="*/ 694449 h 921264"/>
                    <a:gd name="connsiteX97" fmla="*/ 2479727 w 3156122"/>
                    <a:gd name="connsiteY97" fmla="*/ 703974 h 921264"/>
                    <a:gd name="connsiteX98" fmla="*/ 2435277 w 3156122"/>
                    <a:gd name="connsiteY98" fmla="*/ 713499 h 921264"/>
                    <a:gd name="connsiteX99" fmla="*/ 2390827 w 3156122"/>
                    <a:gd name="connsiteY99" fmla="*/ 723024 h 921264"/>
                    <a:gd name="connsiteX100" fmla="*/ 2343202 w 3156122"/>
                    <a:gd name="connsiteY100" fmla="*/ 729374 h 921264"/>
                    <a:gd name="connsiteX101" fmla="*/ 2311452 w 3156122"/>
                    <a:gd name="connsiteY101" fmla="*/ 716674 h 921264"/>
                    <a:gd name="connsiteX102" fmla="*/ 2247952 w 3156122"/>
                    <a:gd name="connsiteY102" fmla="*/ 703974 h 921264"/>
                    <a:gd name="connsiteX103" fmla="*/ 2209852 w 3156122"/>
                    <a:gd name="connsiteY103" fmla="*/ 697624 h 921264"/>
                    <a:gd name="connsiteX104" fmla="*/ 2168577 w 3156122"/>
                    <a:gd name="connsiteY104" fmla="*/ 691274 h 921264"/>
                    <a:gd name="connsiteX105" fmla="*/ 2111427 w 3156122"/>
                    <a:gd name="connsiteY105" fmla="*/ 681749 h 921264"/>
                    <a:gd name="connsiteX106" fmla="*/ 2073327 w 3156122"/>
                    <a:gd name="connsiteY106" fmla="*/ 675399 h 921264"/>
                    <a:gd name="connsiteX107" fmla="*/ 2025702 w 3156122"/>
                    <a:gd name="connsiteY107" fmla="*/ 665874 h 921264"/>
                    <a:gd name="connsiteX108" fmla="*/ 1911402 w 3156122"/>
                    <a:gd name="connsiteY108" fmla="*/ 659524 h 921264"/>
                    <a:gd name="connsiteX109" fmla="*/ 1851077 w 3156122"/>
                    <a:gd name="connsiteY109" fmla="*/ 662699 h 921264"/>
                    <a:gd name="connsiteX110" fmla="*/ 1765352 w 3156122"/>
                    <a:gd name="connsiteY110" fmla="*/ 665874 h 921264"/>
                    <a:gd name="connsiteX111" fmla="*/ 1727252 w 3156122"/>
                    <a:gd name="connsiteY111" fmla="*/ 672224 h 921264"/>
                    <a:gd name="connsiteX112" fmla="*/ 1682802 w 3156122"/>
                    <a:gd name="connsiteY112" fmla="*/ 694449 h 921264"/>
                    <a:gd name="connsiteX113" fmla="*/ 1625652 w 3156122"/>
                    <a:gd name="connsiteY113" fmla="*/ 716674 h 921264"/>
                    <a:gd name="connsiteX114" fmla="*/ 1581202 w 3156122"/>
                    <a:gd name="connsiteY114" fmla="*/ 738899 h 921264"/>
                    <a:gd name="connsiteX115" fmla="*/ 1524052 w 3156122"/>
                    <a:gd name="connsiteY115" fmla="*/ 754774 h 921264"/>
                    <a:gd name="connsiteX116" fmla="*/ 1492302 w 3156122"/>
                    <a:gd name="connsiteY116" fmla="*/ 773824 h 921264"/>
                    <a:gd name="connsiteX117" fmla="*/ 1466902 w 3156122"/>
                    <a:gd name="connsiteY117" fmla="*/ 780174 h 921264"/>
                    <a:gd name="connsiteX118" fmla="*/ 1422452 w 3156122"/>
                    <a:gd name="connsiteY118" fmla="*/ 799224 h 921264"/>
                    <a:gd name="connsiteX119" fmla="*/ 1349427 w 3156122"/>
                    <a:gd name="connsiteY119" fmla="*/ 776999 h 921264"/>
                    <a:gd name="connsiteX120" fmla="*/ 1238302 w 3156122"/>
                    <a:gd name="connsiteY120" fmla="*/ 751599 h 921264"/>
                    <a:gd name="connsiteX121" fmla="*/ 1165277 w 3156122"/>
                    <a:gd name="connsiteY121" fmla="*/ 735724 h 921264"/>
                    <a:gd name="connsiteX122" fmla="*/ 1025577 w 3156122"/>
                    <a:gd name="connsiteY122" fmla="*/ 703974 h 921264"/>
                    <a:gd name="connsiteX123" fmla="*/ 955727 w 3156122"/>
                    <a:gd name="connsiteY123" fmla="*/ 700799 h 921264"/>
                    <a:gd name="connsiteX124" fmla="*/ 863652 w 3156122"/>
                    <a:gd name="connsiteY124" fmla="*/ 697624 h 921264"/>
                    <a:gd name="connsiteX125" fmla="*/ 809677 w 3156122"/>
                    <a:gd name="connsiteY125" fmla="*/ 700799 h 921264"/>
                    <a:gd name="connsiteX126" fmla="*/ 771577 w 3156122"/>
                    <a:gd name="connsiteY126" fmla="*/ 713499 h 921264"/>
                    <a:gd name="connsiteX127" fmla="*/ 708077 w 3156122"/>
                    <a:gd name="connsiteY127" fmla="*/ 726199 h 921264"/>
                    <a:gd name="connsiteX128" fmla="*/ 673152 w 3156122"/>
                    <a:gd name="connsiteY128" fmla="*/ 738899 h 921264"/>
                    <a:gd name="connsiteX129" fmla="*/ 542977 w 3156122"/>
                    <a:gd name="connsiteY129" fmla="*/ 732549 h 921264"/>
                    <a:gd name="connsiteX130" fmla="*/ 511227 w 3156122"/>
                    <a:gd name="connsiteY130" fmla="*/ 732549 h 921264"/>
                    <a:gd name="connsiteX131" fmla="*/ 396927 w 3156122"/>
                    <a:gd name="connsiteY131" fmla="*/ 719849 h 921264"/>
                    <a:gd name="connsiteX132" fmla="*/ 362002 w 3156122"/>
                    <a:gd name="connsiteY132" fmla="*/ 723024 h 921264"/>
                    <a:gd name="connsiteX133" fmla="*/ 339777 w 3156122"/>
                    <a:gd name="connsiteY133" fmla="*/ 732549 h 921264"/>
                    <a:gd name="connsiteX134" fmla="*/ 228652 w 3156122"/>
                    <a:gd name="connsiteY134" fmla="*/ 716674 h 921264"/>
                    <a:gd name="connsiteX135" fmla="*/ 209602 w 3156122"/>
                    <a:gd name="connsiteY135" fmla="*/ 716674 h 921264"/>
                    <a:gd name="connsiteX136" fmla="*/ 142927 w 3156122"/>
                    <a:gd name="connsiteY136" fmla="*/ 716674 h 921264"/>
                    <a:gd name="connsiteX137" fmla="*/ 127052 w 3156122"/>
                    <a:gd name="connsiteY137" fmla="*/ 719849 h 921264"/>
                    <a:gd name="connsiteX138" fmla="*/ 95302 w 3156122"/>
                    <a:gd name="connsiteY138" fmla="*/ 732549 h 921264"/>
                    <a:gd name="connsiteX139" fmla="*/ 66727 w 3156122"/>
                    <a:gd name="connsiteY139" fmla="*/ 742074 h 921264"/>
                    <a:gd name="connsiteX140" fmla="*/ 41327 w 3156122"/>
                    <a:gd name="connsiteY140" fmla="*/ 748424 h 921264"/>
                    <a:gd name="connsiteX141" fmla="*/ 52 w 3156122"/>
                    <a:gd name="connsiteY141" fmla="*/ 757949 h 921264"/>
                    <a:gd name="connsiteX142" fmla="*/ 33734 w 3156122"/>
                    <a:gd name="connsiteY142" fmla="*/ 842293 h 921264"/>
                    <a:gd name="connsiteX143" fmla="*/ 76390 w 3156122"/>
                    <a:gd name="connsiteY143" fmla="*/ 864518 h 921264"/>
                    <a:gd name="connsiteX0" fmla="*/ 73209 w 3159429"/>
                    <a:gd name="connsiteY0" fmla="*/ 865899 h 921264"/>
                    <a:gd name="connsiteX1" fmla="*/ 203384 w 3159429"/>
                    <a:gd name="connsiteY1" fmla="*/ 843674 h 921264"/>
                    <a:gd name="connsiteX2" fmla="*/ 327209 w 3159429"/>
                    <a:gd name="connsiteY2" fmla="*/ 834149 h 921264"/>
                    <a:gd name="connsiteX3" fmla="*/ 447859 w 3159429"/>
                    <a:gd name="connsiteY3" fmla="*/ 875424 h 921264"/>
                    <a:gd name="connsiteX4" fmla="*/ 520884 w 3159429"/>
                    <a:gd name="connsiteY4" fmla="*/ 878599 h 921264"/>
                    <a:gd name="connsiteX5" fmla="*/ 632009 w 3159429"/>
                    <a:gd name="connsiteY5" fmla="*/ 869074 h 921264"/>
                    <a:gd name="connsiteX6" fmla="*/ 711384 w 3159429"/>
                    <a:gd name="connsiteY6" fmla="*/ 846849 h 921264"/>
                    <a:gd name="connsiteX7" fmla="*/ 803459 w 3159429"/>
                    <a:gd name="connsiteY7" fmla="*/ 827799 h 921264"/>
                    <a:gd name="connsiteX8" fmla="*/ 959034 w 3159429"/>
                    <a:gd name="connsiteY8" fmla="*/ 821449 h 921264"/>
                    <a:gd name="connsiteX9" fmla="*/ 1155884 w 3159429"/>
                    <a:gd name="connsiteY9" fmla="*/ 846849 h 921264"/>
                    <a:gd name="connsiteX10" fmla="*/ 1343209 w 3159429"/>
                    <a:gd name="connsiteY10" fmla="*/ 913524 h 921264"/>
                    <a:gd name="connsiteX11" fmla="*/ 1476559 w 3159429"/>
                    <a:gd name="connsiteY11" fmla="*/ 916699 h 921264"/>
                    <a:gd name="connsiteX12" fmla="*/ 1635309 w 3159429"/>
                    <a:gd name="connsiteY12" fmla="*/ 884949 h 921264"/>
                    <a:gd name="connsiteX13" fmla="*/ 1727384 w 3159429"/>
                    <a:gd name="connsiteY13" fmla="*/ 853199 h 921264"/>
                    <a:gd name="connsiteX14" fmla="*/ 1771834 w 3159429"/>
                    <a:gd name="connsiteY14" fmla="*/ 827799 h 921264"/>
                    <a:gd name="connsiteX15" fmla="*/ 1835334 w 3159429"/>
                    <a:gd name="connsiteY15" fmla="*/ 802399 h 921264"/>
                    <a:gd name="connsiteX16" fmla="*/ 1889309 w 3159429"/>
                    <a:gd name="connsiteY16" fmla="*/ 805574 h 921264"/>
                    <a:gd name="connsiteX17" fmla="*/ 2038534 w 3159429"/>
                    <a:gd name="connsiteY17" fmla="*/ 827799 h 921264"/>
                    <a:gd name="connsiteX18" fmla="*/ 2140134 w 3159429"/>
                    <a:gd name="connsiteY18" fmla="*/ 830974 h 921264"/>
                    <a:gd name="connsiteX19" fmla="*/ 2244909 w 3159429"/>
                    <a:gd name="connsiteY19" fmla="*/ 850024 h 921264"/>
                    <a:gd name="connsiteX20" fmla="*/ 2349684 w 3159429"/>
                    <a:gd name="connsiteY20" fmla="*/ 881774 h 921264"/>
                    <a:gd name="connsiteX21" fmla="*/ 2479859 w 3159429"/>
                    <a:gd name="connsiteY21" fmla="*/ 869074 h 921264"/>
                    <a:gd name="connsiteX22" fmla="*/ 2575109 w 3159429"/>
                    <a:gd name="connsiteY22" fmla="*/ 846849 h 921264"/>
                    <a:gd name="connsiteX23" fmla="*/ 2622734 w 3159429"/>
                    <a:gd name="connsiteY23" fmla="*/ 824624 h 921264"/>
                    <a:gd name="connsiteX24" fmla="*/ 2692584 w 3159429"/>
                    <a:gd name="connsiteY24" fmla="*/ 827799 h 921264"/>
                    <a:gd name="connsiteX25" fmla="*/ 2749734 w 3159429"/>
                    <a:gd name="connsiteY25" fmla="*/ 815099 h 921264"/>
                    <a:gd name="connsiteX26" fmla="*/ 2797359 w 3159429"/>
                    <a:gd name="connsiteY26" fmla="*/ 796049 h 921264"/>
                    <a:gd name="connsiteX27" fmla="*/ 2819584 w 3159429"/>
                    <a:gd name="connsiteY27" fmla="*/ 780174 h 921264"/>
                    <a:gd name="connsiteX28" fmla="*/ 2854509 w 3159429"/>
                    <a:gd name="connsiteY28" fmla="*/ 796049 h 921264"/>
                    <a:gd name="connsiteX29" fmla="*/ 2892609 w 3159429"/>
                    <a:gd name="connsiteY29" fmla="*/ 830974 h 921264"/>
                    <a:gd name="connsiteX30" fmla="*/ 2971984 w 3159429"/>
                    <a:gd name="connsiteY30" fmla="*/ 856374 h 921264"/>
                    <a:gd name="connsiteX31" fmla="*/ 3048184 w 3159429"/>
                    <a:gd name="connsiteY31" fmla="*/ 850024 h 921264"/>
                    <a:gd name="connsiteX32" fmla="*/ 3108509 w 3159429"/>
                    <a:gd name="connsiteY32" fmla="*/ 808749 h 921264"/>
                    <a:gd name="connsiteX33" fmla="*/ 3124384 w 3159429"/>
                    <a:gd name="connsiteY33" fmla="*/ 770649 h 921264"/>
                    <a:gd name="connsiteX34" fmla="*/ 3152959 w 3159429"/>
                    <a:gd name="connsiteY34" fmla="*/ 703974 h 921264"/>
                    <a:gd name="connsiteX35" fmla="*/ 3159309 w 3159429"/>
                    <a:gd name="connsiteY35" fmla="*/ 637299 h 921264"/>
                    <a:gd name="connsiteX36" fmla="*/ 3149784 w 3159429"/>
                    <a:gd name="connsiteY36" fmla="*/ 592849 h 921264"/>
                    <a:gd name="connsiteX37" fmla="*/ 3124384 w 3159429"/>
                    <a:gd name="connsiteY37" fmla="*/ 548399 h 921264"/>
                    <a:gd name="connsiteX38" fmla="*/ 3111684 w 3159429"/>
                    <a:gd name="connsiteY38" fmla="*/ 494424 h 921264"/>
                    <a:gd name="connsiteX39" fmla="*/ 3102159 w 3159429"/>
                    <a:gd name="connsiteY39" fmla="*/ 434099 h 921264"/>
                    <a:gd name="connsiteX40" fmla="*/ 3092634 w 3159429"/>
                    <a:gd name="connsiteY40" fmla="*/ 383299 h 921264"/>
                    <a:gd name="connsiteX41" fmla="*/ 3060884 w 3159429"/>
                    <a:gd name="connsiteY41" fmla="*/ 319799 h 921264"/>
                    <a:gd name="connsiteX42" fmla="*/ 3051359 w 3159429"/>
                    <a:gd name="connsiteY42" fmla="*/ 316624 h 921264"/>
                    <a:gd name="connsiteX43" fmla="*/ 3022784 w 3159429"/>
                    <a:gd name="connsiteY43" fmla="*/ 303924 h 921264"/>
                    <a:gd name="connsiteX44" fmla="*/ 2985099 w 3159429"/>
                    <a:gd name="connsiteY44" fmla="*/ 271484 h 921264"/>
                    <a:gd name="connsiteX45" fmla="*/ 2943409 w 3159429"/>
                    <a:gd name="connsiteY45" fmla="*/ 256299 h 921264"/>
                    <a:gd name="connsiteX46" fmla="*/ 2935816 w 3159429"/>
                    <a:gd name="connsiteY46" fmla="*/ 220822 h 921264"/>
                    <a:gd name="connsiteX47" fmla="*/ 2911659 w 3159429"/>
                    <a:gd name="connsiteY47" fmla="*/ 208674 h 921264"/>
                    <a:gd name="connsiteX48" fmla="*/ 2870384 w 3159429"/>
                    <a:gd name="connsiteY48" fmla="*/ 161049 h 921264"/>
                    <a:gd name="connsiteX49" fmla="*/ 2854509 w 3159429"/>
                    <a:gd name="connsiteY49" fmla="*/ 148349 h 921264"/>
                    <a:gd name="connsiteX50" fmla="*/ 2829109 w 3159429"/>
                    <a:gd name="connsiteY50" fmla="*/ 113424 h 921264"/>
                    <a:gd name="connsiteX51" fmla="*/ 2791009 w 3159429"/>
                    <a:gd name="connsiteY51" fmla="*/ 65799 h 921264"/>
                    <a:gd name="connsiteX52" fmla="*/ 2762434 w 3159429"/>
                    <a:gd name="connsiteY52" fmla="*/ 37224 h 921264"/>
                    <a:gd name="connsiteX53" fmla="*/ 2724334 w 3159429"/>
                    <a:gd name="connsiteY53" fmla="*/ 24524 h 921264"/>
                    <a:gd name="connsiteX54" fmla="*/ 2664009 w 3159429"/>
                    <a:gd name="connsiteY54" fmla="*/ 14999 h 921264"/>
                    <a:gd name="connsiteX55" fmla="*/ 2597334 w 3159429"/>
                    <a:gd name="connsiteY55" fmla="*/ 8649 h 921264"/>
                    <a:gd name="connsiteX56" fmla="*/ 2545567 w 3159429"/>
                    <a:gd name="connsiteY56" fmla="*/ 90 h 921264"/>
                    <a:gd name="connsiteX57" fmla="*/ 2517407 w 3159429"/>
                    <a:gd name="connsiteY57" fmla="*/ 14446 h 921264"/>
                    <a:gd name="connsiteX58" fmla="*/ 2479859 w 3159429"/>
                    <a:gd name="connsiteY58" fmla="*/ 49924 h 921264"/>
                    <a:gd name="connsiteX59" fmla="*/ 2460809 w 3159429"/>
                    <a:gd name="connsiteY59" fmla="*/ 84849 h 921264"/>
                    <a:gd name="connsiteX60" fmla="*/ 2454459 w 3159429"/>
                    <a:gd name="connsiteY60" fmla="*/ 116599 h 921264"/>
                    <a:gd name="connsiteX61" fmla="*/ 2462327 w 3159429"/>
                    <a:gd name="connsiteY61" fmla="*/ 140205 h 921264"/>
                    <a:gd name="connsiteX62" fmla="*/ 2485381 w 3159429"/>
                    <a:gd name="connsiteY62" fmla="*/ 154423 h 921264"/>
                    <a:gd name="connsiteX63" fmla="*/ 2514784 w 3159429"/>
                    <a:gd name="connsiteY63" fmla="*/ 164224 h 921264"/>
                    <a:gd name="connsiteX64" fmla="*/ 2530659 w 3159429"/>
                    <a:gd name="connsiteY64" fmla="*/ 164224 h 921264"/>
                    <a:gd name="connsiteX65" fmla="*/ 2559234 w 3159429"/>
                    <a:gd name="connsiteY65" fmla="*/ 164638 h 921264"/>
                    <a:gd name="connsiteX66" fmla="*/ 2568759 w 3159429"/>
                    <a:gd name="connsiteY66" fmla="*/ 167399 h 921264"/>
                    <a:gd name="connsiteX67" fmla="*/ 2600509 w 3159429"/>
                    <a:gd name="connsiteY67" fmla="*/ 170574 h 921264"/>
                    <a:gd name="connsiteX68" fmla="*/ 2629084 w 3159429"/>
                    <a:gd name="connsiteY68" fmla="*/ 161049 h 921264"/>
                    <a:gd name="connsiteX69" fmla="*/ 2664009 w 3159429"/>
                    <a:gd name="connsiteY69" fmla="*/ 173749 h 921264"/>
                    <a:gd name="connsiteX70" fmla="*/ 2692584 w 3159429"/>
                    <a:gd name="connsiteY70" fmla="*/ 180099 h 921264"/>
                    <a:gd name="connsiteX71" fmla="*/ 2721159 w 3159429"/>
                    <a:gd name="connsiteY71" fmla="*/ 215024 h 921264"/>
                    <a:gd name="connsiteX72" fmla="*/ 2762434 w 3159429"/>
                    <a:gd name="connsiteY72" fmla="*/ 284874 h 921264"/>
                    <a:gd name="connsiteX73" fmla="*/ 2778309 w 3159429"/>
                    <a:gd name="connsiteY73" fmla="*/ 319799 h 921264"/>
                    <a:gd name="connsiteX74" fmla="*/ 2791009 w 3159429"/>
                    <a:gd name="connsiteY74" fmla="*/ 361074 h 921264"/>
                    <a:gd name="connsiteX75" fmla="*/ 2803709 w 3159429"/>
                    <a:gd name="connsiteY75" fmla="*/ 399174 h 921264"/>
                    <a:gd name="connsiteX76" fmla="*/ 2806884 w 3159429"/>
                    <a:gd name="connsiteY76" fmla="*/ 418224 h 921264"/>
                    <a:gd name="connsiteX77" fmla="*/ 2806884 w 3159429"/>
                    <a:gd name="connsiteY77" fmla="*/ 440449 h 921264"/>
                    <a:gd name="connsiteX78" fmla="*/ 2810059 w 3159429"/>
                    <a:gd name="connsiteY78" fmla="*/ 475374 h 921264"/>
                    <a:gd name="connsiteX79" fmla="*/ 2813234 w 3159429"/>
                    <a:gd name="connsiteY79" fmla="*/ 503949 h 921264"/>
                    <a:gd name="connsiteX80" fmla="*/ 2816409 w 3159429"/>
                    <a:gd name="connsiteY80" fmla="*/ 529349 h 921264"/>
                    <a:gd name="connsiteX81" fmla="*/ 2816409 w 3159429"/>
                    <a:gd name="connsiteY81" fmla="*/ 557924 h 921264"/>
                    <a:gd name="connsiteX82" fmla="*/ 2813234 w 3159429"/>
                    <a:gd name="connsiteY82" fmla="*/ 570624 h 921264"/>
                    <a:gd name="connsiteX83" fmla="*/ 2806884 w 3159429"/>
                    <a:gd name="connsiteY83" fmla="*/ 583324 h 921264"/>
                    <a:gd name="connsiteX84" fmla="*/ 2797359 w 3159429"/>
                    <a:gd name="connsiteY84" fmla="*/ 602374 h 921264"/>
                    <a:gd name="connsiteX85" fmla="*/ 2794184 w 3159429"/>
                    <a:gd name="connsiteY85" fmla="*/ 618249 h 921264"/>
                    <a:gd name="connsiteX86" fmla="*/ 2794184 w 3159429"/>
                    <a:gd name="connsiteY86" fmla="*/ 634124 h 921264"/>
                    <a:gd name="connsiteX87" fmla="*/ 2797359 w 3159429"/>
                    <a:gd name="connsiteY87" fmla="*/ 646824 h 921264"/>
                    <a:gd name="connsiteX88" fmla="*/ 2797359 w 3159429"/>
                    <a:gd name="connsiteY88" fmla="*/ 646824 h 921264"/>
                    <a:gd name="connsiteX89" fmla="*/ 2746559 w 3159429"/>
                    <a:gd name="connsiteY89" fmla="*/ 665874 h 921264"/>
                    <a:gd name="connsiteX90" fmla="*/ 2695759 w 3159429"/>
                    <a:gd name="connsiteY90" fmla="*/ 675399 h 921264"/>
                    <a:gd name="connsiteX91" fmla="*/ 2648134 w 3159429"/>
                    <a:gd name="connsiteY91" fmla="*/ 681749 h 921264"/>
                    <a:gd name="connsiteX92" fmla="*/ 2622734 w 3159429"/>
                    <a:gd name="connsiteY92" fmla="*/ 681749 h 921264"/>
                    <a:gd name="connsiteX93" fmla="*/ 2584634 w 3159429"/>
                    <a:gd name="connsiteY93" fmla="*/ 681749 h 921264"/>
                    <a:gd name="connsiteX94" fmla="*/ 2546534 w 3159429"/>
                    <a:gd name="connsiteY94" fmla="*/ 678574 h 921264"/>
                    <a:gd name="connsiteX95" fmla="*/ 2530659 w 3159429"/>
                    <a:gd name="connsiteY95" fmla="*/ 681749 h 921264"/>
                    <a:gd name="connsiteX96" fmla="*/ 2505259 w 3159429"/>
                    <a:gd name="connsiteY96" fmla="*/ 694449 h 921264"/>
                    <a:gd name="connsiteX97" fmla="*/ 2483034 w 3159429"/>
                    <a:gd name="connsiteY97" fmla="*/ 703974 h 921264"/>
                    <a:gd name="connsiteX98" fmla="*/ 2438584 w 3159429"/>
                    <a:gd name="connsiteY98" fmla="*/ 713499 h 921264"/>
                    <a:gd name="connsiteX99" fmla="*/ 2394134 w 3159429"/>
                    <a:gd name="connsiteY99" fmla="*/ 723024 h 921264"/>
                    <a:gd name="connsiteX100" fmla="*/ 2346509 w 3159429"/>
                    <a:gd name="connsiteY100" fmla="*/ 729374 h 921264"/>
                    <a:gd name="connsiteX101" fmla="*/ 2314759 w 3159429"/>
                    <a:gd name="connsiteY101" fmla="*/ 716674 h 921264"/>
                    <a:gd name="connsiteX102" fmla="*/ 2251259 w 3159429"/>
                    <a:gd name="connsiteY102" fmla="*/ 703974 h 921264"/>
                    <a:gd name="connsiteX103" fmla="*/ 2213159 w 3159429"/>
                    <a:gd name="connsiteY103" fmla="*/ 697624 h 921264"/>
                    <a:gd name="connsiteX104" fmla="*/ 2171884 w 3159429"/>
                    <a:gd name="connsiteY104" fmla="*/ 691274 h 921264"/>
                    <a:gd name="connsiteX105" fmla="*/ 2114734 w 3159429"/>
                    <a:gd name="connsiteY105" fmla="*/ 681749 h 921264"/>
                    <a:gd name="connsiteX106" fmla="*/ 2076634 w 3159429"/>
                    <a:gd name="connsiteY106" fmla="*/ 675399 h 921264"/>
                    <a:gd name="connsiteX107" fmla="*/ 2029009 w 3159429"/>
                    <a:gd name="connsiteY107" fmla="*/ 665874 h 921264"/>
                    <a:gd name="connsiteX108" fmla="*/ 1914709 w 3159429"/>
                    <a:gd name="connsiteY108" fmla="*/ 659524 h 921264"/>
                    <a:gd name="connsiteX109" fmla="*/ 1854384 w 3159429"/>
                    <a:gd name="connsiteY109" fmla="*/ 662699 h 921264"/>
                    <a:gd name="connsiteX110" fmla="*/ 1768659 w 3159429"/>
                    <a:gd name="connsiteY110" fmla="*/ 665874 h 921264"/>
                    <a:gd name="connsiteX111" fmla="*/ 1730559 w 3159429"/>
                    <a:gd name="connsiteY111" fmla="*/ 672224 h 921264"/>
                    <a:gd name="connsiteX112" fmla="*/ 1686109 w 3159429"/>
                    <a:gd name="connsiteY112" fmla="*/ 694449 h 921264"/>
                    <a:gd name="connsiteX113" fmla="*/ 1628959 w 3159429"/>
                    <a:gd name="connsiteY113" fmla="*/ 716674 h 921264"/>
                    <a:gd name="connsiteX114" fmla="*/ 1584509 w 3159429"/>
                    <a:gd name="connsiteY114" fmla="*/ 738899 h 921264"/>
                    <a:gd name="connsiteX115" fmla="*/ 1527359 w 3159429"/>
                    <a:gd name="connsiteY115" fmla="*/ 754774 h 921264"/>
                    <a:gd name="connsiteX116" fmla="*/ 1495609 w 3159429"/>
                    <a:gd name="connsiteY116" fmla="*/ 773824 h 921264"/>
                    <a:gd name="connsiteX117" fmla="*/ 1470209 w 3159429"/>
                    <a:gd name="connsiteY117" fmla="*/ 780174 h 921264"/>
                    <a:gd name="connsiteX118" fmla="*/ 1425759 w 3159429"/>
                    <a:gd name="connsiteY118" fmla="*/ 799224 h 921264"/>
                    <a:gd name="connsiteX119" fmla="*/ 1352734 w 3159429"/>
                    <a:gd name="connsiteY119" fmla="*/ 776999 h 921264"/>
                    <a:gd name="connsiteX120" fmla="*/ 1241609 w 3159429"/>
                    <a:gd name="connsiteY120" fmla="*/ 751599 h 921264"/>
                    <a:gd name="connsiteX121" fmla="*/ 1168584 w 3159429"/>
                    <a:gd name="connsiteY121" fmla="*/ 735724 h 921264"/>
                    <a:gd name="connsiteX122" fmla="*/ 1028884 w 3159429"/>
                    <a:gd name="connsiteY122" fmla="*/ 703974 h 921264"/>
                    <a:gd name="connsiteX123" fmla="*/ 959034 w 3159429"/>
                    <a:gd name="connsiteY123" fmla="*/ 700799 h 921264"/>
                    <a:gd name="connsiteX124" fmla="*/ 866959 w 3159429"/>
                    <a:gd name="connsiteY124" fmla="*/ 697624 h 921264"/>
                    <a:gd name="connsiteX125" fmla="*/ 812984 w 3159429"/>
                    <a:gd name="connsiteY125" fmla="*/ 700799 h 921264"/>
                    <a:gd name="connsiteX126" fmla="*/ 774884 w 3159429"/>
                    <a:gd name="connsiteY126" fmla="*/ 713499 h 921264"/>
                    <a:gd name="connsiteX127" fmla="*/ 711384 w 3159429"/>
                    <a:gd name="connsiteY127" fmla="*/ 726199 h 921264"/>
                    <a:gd name="connsiteX128" fmla="*/ 676459 w 3159429"/>
                    <a:gd name="connsiteY128" fmla="*/ 738899 h 921264"/>
                    <a:gd name="connsiteX129" fmla="*/ 546284 w 3159429"/>
                    <a:gd name="connsiteY129" fmla="*/ 732549 h 921264"/>
                    <a:gd name="connsiteX130" fmla="*/ 514534 w 3159429"/>
                    <a:gd name="connsiteY130" fmla="*/ 732549 h 921264"/>
                    <a:gd name="connsiteX131" fmla="*/ 400234 w 3159429"/>
                    <a:gd name="connsiteY131" fmla="*/ 719849 h 921264"/>
                    <a:gd name="connsiteX132" fmla="*/ 365309 w 3159429"/>
                    <a:gd name="connsiteY132" fmla="*/ 723024 h 921264"/>
                    <a:gd name="connsiteX133" fmla="*/ 343084 w 3159429"/>
                    <a:gd name="connsiteY133" fmla="*/ 732549 h 921264"/>
                    <a:gd name="connsiteX134" fmla="*/ 231959 w 3159429"/>
                    <a:gd name="connsiteY134" fmla="*/ 716674 h 921264"/>
                    <a:gd name="connsiteX135" fmla="*/ 212909 w 3159429"/>
                    <a:gd name="connsiteY135" fmla="*/ 716674 h 921264"/>
                    <a:gd name="connsiteX136" fmla="*/ 146234 w 3159429"/>
                    <a:gd name="connsiteY136" fmla="*/ 716674 h 921264"/>
                    <a:gd name="connsiteX137" fmla="*/ 130359 w 3159429"/>
                    <a:gd name="connsiteY137" fmla="*/ 719849 h 921264"/>
                    <a:gd name="connsiteX138" fmla="*/ 98609 w 3159429"/>
                    <a:gd name="connsiteY138" fmla="*/ 732549 h 921264"/>
                    <a:gd name="connsiteX139" fmla="*/ 70034 w 3159429"/>
                    <a:gd name="connsiteY139" fmla="*/ 742074 h 921264"/>
                    <a:gd name="connsiteX140" fmla="*/ 44634 w 3159429"/>
                    <a:gd name="connsiteY140" fmla="*/ 748424 h 921264"/>
                    <a:gd name="connsiteX141" fmla="*/ 46 w 3159429"/>
                    <a:gd name="connsiteY141" fmla="*/ 786110 h 921264"/>
                    <a:gd name="connsiteX142" fmla="*/ 37041 w 3159429"/>
                    <a:gd name="connsiteY142" fmla="*/ 842293 h 921264"/>
                    <a:gd name="connsiteX143" fmla="*/ 79697 w 3159429"/>
                    <a:gd name="connsiteY143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3023525 w 3160170"/>
                    <a:gd name="connsiteY43" fmla="*/ 303924 h 921264"/>
                    <a:gd name="connsiteX44" fmla="*/ 2985840 w 3160170"/>
                    <a:gd name="connsiteY44" fmla="*/ 271484 h 921264"/>
                    <a:gd name="connsiteX45" fmla="*/ 2944150 w 3160170"/>
                    <a:gd name="connsiteY45" fmla="*/ 256299 h 921264"/>
                    <a:gd name="connsiteX46" fmla="*/ 2936557 w 3160170"/>
                    <a:gd name="connsiteY46" fmla="*/ 220822 h 921264"/>
                    <a:gd name="connsiteX47" fmla="*/ 2912400 w 3160170"/>
                    <a:gd name="connsiteY47" fmla="*/ 208674 h 921264"/>
                    <a:gd name="connsiteX48" fmla="*/ 2871125 w 3160170"/>
                    <a:gd name="connsiteY48" fmla="*/ 161049 h 921264"/>
                    <a:gd name="connsiteX49" fmla="*/ 2855250 w 3160170"/>
                    <a:gd name="connsiteY49" fmla="*/ 148349 h 921264"/>
                    <a:gd name="connsiteX50" fmla="*/ 2829850 w 3160170"/>
                    <a:gd name="connsiteY50" fmla="*/ 113424 h 921264"/>
                    <a:gd name="connsiteX51" fmla="*/ 2791750 w 3160170"/>
                    <a:gd name="connsiteY51" fmla="*/ 65799 h 921264"/>
                    <a:gd name="connsiteX52" fmla="*/ 2763175 w 3160170"/>
                    <a:gd name="connsiteY52" fmla="*/ 37224 h 921264"/>
                    <a:gd name="connsiteX53" fmla="*/ 2725075 w 3160170"/>
                    <a:gd name="connsiteY53" fmla="*/ 24524 h 921264"/>
                    <a:gd name="connsiteX54" fmla="*/ 2664750 w 3160170"/>
                    <a:gd name="connsiteY54" fmla="*/ 14999 h 921264"/>
                    <a:gd name="connsiteX55" fmla="*/ 2598075 w 3160170"/>
                    <a:gd name="connsiteY55" fmla="*/ 8649 h 921264"/>
                    <a:gd name="connsiteX56" fmla="*/ 2546308 w 3160170"/>
                    <a:gd name="connsiteY56" fmla="*/ 90 h 921264"/>
                    <a:gd name="connsiteX57" fmla="*/ 2518148 w 3160170"/>
                    <a:gd name="connsiteY57" fmla="*/ 14446 h 921264"/>
                    <a:gd name="connsiteX58" fmla="*/ 2480600 w 3160170"/>
                    <a:gd name="connsiteY58" fmla="*/ 49924 h 921264"/>
                    <a:gd name="connsiteX59" fmla="*/ 2461550 w 3160170"/>
                    <a:gd name="connsiteY59" fmla="*/ 84849 h 921264"/>
                    <a:gd name="connsiteX60" fmla="*/ 2455200 w 3160170"/>
                    <a:gd name="connsiteY60" fmla="*/ 116599 h 921264"/>
                    <a:gd name="connsiteX61" fmla="*/ 2463068 w 3160170"/>
                    <a:gd name="connsiteY61" fmla="*/ 140205 h 921264"/>
                    <a:gd name="connsiteX62" fmla="*/ 2486122 w 3160170"/>
                    <a:gd name="connsiteY62" fmla="*/ 154423 h 921264"/>
                    <a:gd name="connsiteX63" fmla="*/ 2515525 w 3160170"/>
                    <a:gd name="connsiteY63" fmla="*/ 164224 h 921264"/>
                    <a:gd name="connsiteX64" fmla="*/ 2531400 w 3160170"/>
                    <a:gd name="connsiteY64" fmla="*/ 164224 h 921264"/>
                    <a:gd name="connsiteX65" fmla="*/ 2559975 w 3160170"/>
                    <a:gd name="connsiteY65" fmla="*/ 164638 h 921264"/>
                    <a:gd name="connsiteX66" fmla="*/ 2569500 w 3160170"/>
                    <a:gd name="connsiteY66" fmla="*/ 167399 h 921264"/>
                    <a:gd name="connsiteX67" fmla="*/ 2601250 w 3160170"/>
                    <a:gd name="connsiteY67" fmla="*/ 170574 h 921264"/>
                    <a:gd name="connsiteX68" fmla="*/ 2629825 w 3160170"/>
                    <a:gd name="connsiteY68" fmla="*/ 161049 h 921264"/>
                    <a:gd name="connsiteX69" fmla="*/ 2664750 w 3160170"/>
                    <a:gd name="connsiteY69" fmla="*/ 173749 h 921264"/>
                    <a:gd name="connsiteX70" fmla="*/ 2693325 w 3160170"/>
                    <a:gd name="connsiteY70" fmla="*/ 180099 h 921264"/>
                    <a:gd name="connsiteX71" fmla="*/ 2721900 w 3160170"/>
                    <a:gd name="connsiteY71" fmla="*/ 215024 h 921264"/>
                    <a:gd name="connsiteX72" fmla="*/ 2763175 w 3160170"/>
                    <a:gd name="connsiteY72" fmla="*/ 284874 h 921264"/>
                    <a:gd name="connsiteX73" fmla="*/ 2779050 w 3160170"/>
                    <a:gd name="connsiteY73" fmla="*/ 319799 h 921264"/>
                    <a:gd name="connsiteX74" fmla="*/ 2791750 w 3160170"/>
                    <a:gd name="connsiteY74" fmla="*/ 361074 h 921264"/>
                    <a:gd name="connsiteX75" fmla="*/ 2804450 w 3160170"/>
                    <a:gd name="connsiteY75" fmla="*/ 399174 h 921264"/>
                    <a:gd name="connsiteX76" fmla="*/ 2807625 w 3160170"/>
                    <a:gd name="connsiteY76" fmla="*/ 418224 h 921264"/>
                    <a:gd name="connsiteX77" fmla="*/ 2807625 w 3160170"/>
                    <a:gd name="connsiteY77" fmla="*/ 440449 h 921264"/>
                    <a:gd name="connsiteX78" fmla="*/ 2810800 w 3160170"/>
                    <a:gd name="connsiteY78" fmla="*/ 475374 h 921264"/>
                    <a:gd name="connsiteX79" fmla="*/ 2813975 w 3160170"/>
                    <a:gd name="connsiteY79" fmla="*/ 503949 h 921264"/>
                    <a:gd name="connsiteX80" fmla="*/ 2817150 w 3160170"/>
                    <a:gd name="connsiteY80" fmla="*/ 529349 h 921264"/>
                    <a:gd name="connsiteX81" fmla="*/ 2817150 w 3160170"/>
                    <a:gd name="connsiteY81" fmla="*/ 557924 h 921264"/>
                    <a:gd name="connsiteX82" fmla="*/ 2813975 w 3160170"/>
                    <a:gd name="connsiteY82" fmla="*/ 570624 h 921264"/>
                    <a:gd name="connsiteX83" fmla="*/ 2807625 w 3160170"/>
                    <a:gd name="connsiteY83" fmla="*/ 583324 h 921264"/>
                    <a:gd name="connsiteX84" fmla="*/ 2798100 w 3160170"/>
                    <a:gd name="connsiteY84" fmla="*/ 602374 h 921264"/>
                    <a:gd name="connsiteX85" fmla="*/ 2794925 w 3160170"/>
                    <a:gd name="connsiteY85" fmla="*/ 618249 h 921264"/>
                    <a:gd name="connsiteX86" fmla="*/ 2794925 w 3160170"/>
                    <a:gd name="connsiteY86" fmla="*/ 634124 h 921264"/>
                    <a:gd name="connsiteX87" fmla="*/ 2798100 w 3160170"/>
                    <a:gd name="connsiteY87" fmla="*/ 646824 h 921264"/>
                    <a:gd name="connsiteX88" fmla="*/ 2798100 w 3160170"/>
                    <a:gd name="connsiteY88" fmla="*/ 646824 h 921264"/>
                    <a:gd name="connsiteX89" fmla="*/ 2747300 w 3160170"/>
                    <a:gd name="connsiteY89" fmla="*/ 665874 h 921264"/>
                    <a:gd name="connsiteX90" fmla="*/ 2696500 w 3160170"/>
                    <a:gd name="connsiteY90" fmla="*/ 675399 h 921264"/>
                    <a:gd name="connsiteX91" fmla="*/ 2648875 w 3160170"/>
                    <a:gd name="connsiteY91" fmla="*/ 681749 h 921264"/>
                    <a:gd name="connsiteX92" fmla="*/ 2623475 w 3160170"/>
                    <a:gd name="connsiteY92" fmla="*/ 681749 h 921264"/>
                    <a:gd name="connsiteX93" fmla="*/ 2585375 w 3160170"/>
                    <a:gd name="connsiteY93" fmla="*/ 681749 h 921264"/>
                    <a:gd name="connsiteX94" fmla="*/ 2547275 w 3160170"/>
                    <a:gd name="connsiteY94" fmla="*/ 678574 h 921264"/>
                    <a:gd name="connsiteX95" fmla="*/ 2531400 w 3160170"/>
                    <a:gd name="connsiteY95" fmla="*/ 681749 h 921264"/>
                    <a:gd name="connsiteX96" fmla="*/ 2506000 w 3160170"/>
                    <a:gd name="connsiteY96" fmla="*/ 694449 h 921264"/>
                    <a:gd name="connsiteX97" fmla="*/ 2483775 w 3160170"/>
                    <a:gd name="connsiteY97" fmla="*/ 703974 h 921264"/>
                    <a:gd name="connsiteX98" fmla="*/ 2439325 w 3160170"/>
                    <a:gd name="connsiteY98" fmla="*/ 713499 h 921264"/>
                    <a:gd name="connsiteX99" fmla="*/ 2394875 w 3160170"/>
                    <a:gd name="connsiteY99" fmla="*/ 723024 h 921264"/>
                    <a:gd name="connsiteX100" fmla="*/ 2347250 w 3160170"/>
                    <a:gd name="connsiteY100" fmla="*/ 729374 h 921264"/>
                    <a:gd name="connsiteX101" fmla="*/ 2315500 w 3160170"/>
                    <a:gd name="connsiteY101" fmla="*/ 716674 h 921264"/>
                    <a:gd name="connsiteX102" fmla="*/ 2252000 w 3160170"/>
                    <a:gd name="connsiteY102" fmla="*/ 703974 h 921264"/>
                    <a:gd name="connsiteX103" fmla="*/ 2213900 w 3160170"/>
                    <a:gd name="connsiteY103" fmla="*/ 697624 h 921264"/>
                    <a:gd name="connsiteX104" fmla="*/ 2172625 w 3160170"/>
                    <a:gd name="connsiteY104" fmla="*/ 691274 h 921264"/>
                    <a:gd name="connsiteX105" fmla="*/ 2115475 w 3160170"/>
                    <a:gd name="connsiteY105" fmla="*/ 681749 h 921264"/>
                    <a:gd name="connsiteX106" fmla="*/ 2077375 w 3160170"/>
                    <a:gd name="connsiteY106" fmla="*/ 675399 h 921264"/>
                    <a:gd name="connsiteX107" fmla="*/ 2029750 w 3160170"/>
                    <a:gd name="connsiteY107" fmla="*/ 665874 h 921264"/>
                    <a:gd name="connsiteX108" fmla="*/ 1915450 w 3160170"/>
                    <a:gd name="connsiteY108" fmla="*/ 659524 h 921264"/>
                    <a:gd name="connsiteX109" fmla="*/ 1855125 w 3160170"/>
                    <a:gd name="connsiteY109" fmla="*/ 662699 h 921264"/>
                    <a:gd name="connsiteX110" fmla="*/ 1769400 w 3160170"/>
                    <a:gd name="connsiteY110" fmla="*/ 665874 h 921264"/>
                    <a:gd name="connsiteX111" fmla="*/ 1731300 w 3160170"/>
                    <a:gd name="connsiteY111" fmla="*/ 672224 h 921264"/>
                    <a:gd name="connsiteX112" fmla="*/ 1686850 w 3160170"/>
                    <a:gd name="connsiteY112" fmla="*/ 694449 h 921264"/>
                    <a:gd name="connsiteX113" fmla="*/ 1629700 w 3160170"/>
                    <a:gd name="connsiteY113" fmla="*/ 716674 h 921264"/>
                    <a:gd name="connsiteX114" fmla="*/ 1585250 w 3160170"/>
                    <a:gd name="connsiteY114" fmla="*/ 738899 h 921264"/>
                    <a:gd name="connsiteX115" fmla="*/ 1528100 w 3160170"/>
                    <a:gd name="connsiteY115" fmla="*/ 754774 h 921264"/>
                    <a:gd name="connsiteX116" fmla="*/ 1496350 w 3160170"/>
                    <a:gd name="connsiteY116" fmla="*/ 773824 h 921264"/>
                    <a:gd name="connsiteX117" fmla="*/ 1470950 w 3160170"/>
                    <a:gd name="connsiteY117" fmla="*/ 780174 h 921264"/>
                    <a:gd name="connsiteX118" fmla="*/ 1426500 w 3160170"/>
                    <a:gd name="connsiteY118" fmla="*/ 799224 h 921264"/>
                    <a:gd name="connsiteX119" fmla="*/ 1353475 w 3160170"/>
                    <a:gd name="connsiteY119" fmla="*/ 776999 h 921264"/>
                    <a:gd name="connsiteX120" fmla="*/ 1242350 w 3160170"/>
                    <a:gd name="connsiteY120" fmla="*/ 751599 h 921264"/>
                    <a:gd name="connsiteX121" fmla="*/ 1169325 w 3160170"/>
                    <a:gd name="connsiteY121" fmla="*/ 735724 h 921264"/>
                    <a:gd name="connsiteX122" fmla="*/ 1029625 w 3160170"/>
                    <a:gd name="connsiteY122" fmla="*/ 703974 h 921264"/>
                    <a:gd name="connsiteX123" fmla="*/ 959775 w 3160170"/>
                    <a:gd name="connsiteY123" fmla="*/ 700799 h 921264"/>
                    <a:gd name="connsiteX124" fmla="*/ 867700 w 3160170"/>
                    <a:gd name="connsiteY124" fmla="*/ 697624 h 921264"/>
                    <a:gd name="connsiteX125" fmla="*/ 813725 w 3160170"/>
                    <a:gd name="connsiteY125" fmla="*/ 700799 h 921264"/>
                    <a:gd name="connsiteX126" fmla="*/ 775625 w 3160170"/>
                    <a:gd name="connsiteY126" fmla="*/ 713499 h 921264"/>
                    <a:gd name="connsiteX127" fmla="*/ 712125 w 3160170"/>
                    <a:gd name="connsiteY127" fmla="*/ 726199 h 921264"/>
                    <a:gd name="connsiteX128" fmla="*/ 677200 w 3160170"/>
                    <a:gd name="connsiteY128" fmla="*/ 738899 h 921264"/>
                    <a:gd name="connsiteX129" fmla="*/ 547025 w 3160170"/>
                    <a:gd name="connsiteY129" fmla="*/ 732549 h 921264"/>
                    <a:gd name="connsiteX130" fmla="*/ 515275 w 3160170"/>
                    <a:gd name="connsiteY130" fmla="*/ 732549 h 921264"/>
                    <a:gd name="connsiteX131" fmla="*/ 400975 w 3160170"/>
                    <a:gd name="connsiteY131" fmla="*/ 719849 h 921264"/>
                    <a:gd name="connsiteX132" fmla="*/ 366050 w 3160170"/>
                    <a:gd name="connsiteY132" fmla="*/ 723024 h 921264"/>
                    <a:gd name="connsiteX133" fmla="*/ 343825 w 3160170"/>
                    <a:gd name="connsiteY133" fmla="*/ 732549 h 921264"/>
                    <a:gd name="connsiteX134" fmla="*/ 232700 w 3160170"/>
                    <a:gd name="connsiteY134" fmla="*/ 716674 h 921264"/>
                    <a:gd name="connsiteX135" fmla="*/ 213650 w 3160170"/>
                    <a:gd name="connsiteY135" fmla="*/ 716674 h 921264"/>
                    <a:gd name="connsiteX136" fmla="*/ 146975 w 3160170"/>
                    <a:gd name="connsiteY136" fmla="*/ 716674 h 921264"/>
                    <a:gd name="connsiteX137" fmla="*/ 131100 w 3160170"/>
                    <a:gd name="connsiteY137" fmla="*/ 719849 h 921264"/>
                    <a:gd name="connsiteX138" fmla="*/ 99350 w 3160170"/>
                    <a:gd name="connsiteY138" fmla="*/ 732549 h 921264"/>
                    <a:gd name="connsiteX139" fmla="*/ 70775 w 3160170"/>
                    <a:gd name="connsiteY139" fmla="*/ 742074 h 921264"/>
                    <a:gd name="connsiteX140" fmla="*/ 17214 w 3160170"/>
                    <a:gd name="connsiteY140" fmla="*/ 751737 h 921264"/>
                    <a:gd name="connsiteX141" fmla="*/ 787 w 3160170"/>
                    <a:gd name="connsiteY141" fmla="*/ 786110 h 921264"/>
                    <a:gd name="connsiteX142" fmla="*/ 37782 w 3160170"/>
                    <a:gd name="connsiteY142" fmla="*/ 842293 h 921264"/>
                    <a:gd name="connsiteX143" fmla="*/ 80438 w 3160170"/>
                    <a:gd name="connsiteY143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3023525 w 3160170"/>
                    <a:gd name="connsiteY43" fmla="*/ 303924 h 921264"/>
                    <a:gd name="connsiteX44" fmla="*/ 2985840 w 3160170"/>
                    <a:gd name="connsiteY44" fmla="*/ 271484 h 921264"/>
                    <a:gd name="connsiteX45" fmla="*/ 2944150 w 3160170"/>
                    <a:gd name="connsiteY45" fmla="*/ 256299 h 921264"/>
                    <a:gd name="connsiteX46" fmla="*/ 2936557 w 3160170"/>
                    <a:gd name="connsiteY46" fmla="*/ 220822 h 921264"/>
                    <a:gd name="connsiteX47" fmla="*/ 2912400 w 3160170"/>
                    <a:gd name="connsiteY47" fmla="*/ 208674 h 921264"/>
                    <a:gd name="connsiteX48" fmla="*/ 2871125 w 3160170"/>
                    <a:gd name="connsiteY48" fmla="*/ 161049 h 921264"/>
                    <a:gd name="connsiteX49" fmla="*/ 2855250 w 3160170"/>
                    <a:gd name="connsiteY49" fmla="*/ 148349 h 921264"/>
                    <a:gd name="connsiteX50" fmla="*/ 2829850 w 3160170"/>
                    <a:gd name="connsiteY50" fmla="*/ 113424 h 921264"/>
                    <a:gd name="connsiteX51" fmla="*/ 2791750 w 3160170"/>
                    <a:gd name="connsiteY51" fmla="*/ 65799 h 921264"/>
                    <a:gd name="connsiteX52" fmla="*/ 2763175 w 3160170"/>
                    <a:gd name="connsiteY52" fmla="*/ 37224 h 921264"/>
                    <a:gd name="connsiteX53" fmla="*/ 2725075 w 3160170"/>
                    <a:gd name="connsiteY53" fmla="*/ 24524 h 921264"/>
                    <a:gd name="connsiteX54" fmla="*/ 2664750 w 3160170"/>
                    <a:gd name="connsiteY54" fmla="*/ 14999 h 921264"/>
                    <a:gd name="connsiteX55" fmla="*/ 2598075 w 3160170"/>
                    <a:gd name="connsiteY55" fmla="*/ 8649 h 921264"/>
                    <a:gd name="connsiteX56" fmla="*/ 2546308 w 3160170"/>
                    <a:gd name="connsiteY56" fmla="*/ 90 h 921264"/>
                    <a:gd name="connsiteX57" fmla="*/ 2518148 w 3160170"/>
                    <a:gd name="connsiteY57" fmla="*/ 14446 h 921264"/>
                    <a:gd name="connsiteX58" fmla="*/ 2480600 w 3160170"/>
                    <a:gd name="connsiteY58" fmla="*/ 49924 h 921264"/>
                    <a:gd name="connsiteX59" fmla="*/ 2461550 w 3160170"/>
                    <a:gd name="connsiteY59" fmla="*/ 84849 h 921264"/>
                    <a:gd name="connsiteX60" fmla="*/ 2455200 w 3160170"/>
                    <a:gd name="connsiteY60" fmla="*/ 116599 h 921264"/>
                    <a:gd name="connsiteX61" fmla="*/ 2463068 w 3160170"/>
                    <a:gd name="connsiteY61" fmla="*/ 140205 h 921264"/>
                    <a:gd name="connsiteX62" fmla="*/ 2486122 w 3160170"/>
                    <a:gd name="connsiteY62" fmla="*/ 154423 h 921264"/>
                    <a:gd name="connsiteX63" fmla="*/ 2515525 w 3160170"/>
                    <a:gd name="connsiteY63" fmla="*/ 164224 h 921264"/>
                    <a:gd name="connsiteX64" fmla="*/ 2531400 w 3160170"/>
                    <a:gd name="connsiteY64" fmla="*/ 164224 h 921264"/>
                    <a:gd name="connsiteX65" fmla="*/ 2559975 w 3160170"/>
                    <a:gd name="connsiteY65" fmla="*/ 164638 h 921264"/>
                    <a:gd name="connsiteX66" fmla="*/ 2569500 w 3160170"/>
                    <a:gd name="connsiteY66" fmla="*/ 167399 h 921264"/>
                    <a:gd name="connsiteX67" fmla="*/ 2601250 w 3160170"/>
                    <a:gd name="connsiteY67" fmla="*/ 170574 h 921264"/>
                    <a:gd name="connsiteX68" fmla="*/ 2629825 w 3160170"/>
                    <a:gd name="connsiteY68" fmla="*/ 161049 h 921264"/>
                    <a:gd name="connsiteX69" fmla="*/ 2664750 w 3160170"/>
                    <a:gd name="connsiteY69" fmla="*/ 173749 h 921264"/>
                    <a:gd name="connsiteX70" fmla="*/ 2693325 w 3160170"/>
                    <a:gd name="connsiteY70" fmla="*/ 180099 h 921264"/>
                    <a:gd name="connsiteX71" fmla="*/ 2721900 w 3160170"/>
                    <a:gd name="connsiteY71" fmla="*/ 215024 h 921264"/>
                    <a:gd name="connsiteX72" fmla="*/ 2763175 w 3160170"/>
                    <a:gd name="connsiteY72" fmla="*/ 284874 h 921264"/>
                    <a:gd name="connsiteX73" fmla="*/ 2779050 w 3160170"/>
                    <a:gd name="connsiteY73" fmla="*/ 319799 h 921264"/>
                    <a:gd name="connsiteX74" fmla="*/ 2791750 w 3160170"/>
                    <a:gd name="connsiteY74" fmla="*/ 361074 h 921264"/>
                    <a:gd name="connsiteX75" fmla="*/ 2804450 w 3160170"/>
                    <a:gd name="connsiteY75" fmla="*/ 399174 h 921264"/>
                    <a:gd name="connsiteX76" fmla="*/ 2807625 w 3160170"/>
                    <a:gd name="connsiteY76" fmla="*/ 418224 h 921264"/>
                    <a:gd name="connsiteX77" fmla="*/ 2807625 w 3160170"/>
                    <a:gd name="connsiteY77" fmla="*/ 440449 h 921264"/>
                    <a:gd name="connsiteX78" fmla="*/ 2810800 w 3160170"/>
                    <a:gd name="connsiteY78" fmla="*/ 475374 h 921264"/>
                    <a:gd name="connsiteX79" fmla="*/ 2813975 w 3160170"/>
                    <a:gd name="connsiteY79" fmla="*/ 503949 h 921264"/>
                    <a:gd name="connsiteX80" fmla="*/ 2817150 w 3160170"/>
                    <a:gd name="connsiteY80" fmla="*/ 529349 h 921264"/>
                    <a:gd name="connsiteX81" fmla="*/ 2817150 w 3160170"/>
                    <a:gd name="connsiteY81" fmla="*/ 557924 h 921264"/>
                    <a:gd name="connsiteX82" fmla="*/ 2813975 w 3160170"/>
                    <a:gd name="connsiteY82" fmla="*/ 570624 h 921264"/>
                    <a:gd name="connsiteX83" fmla="*/ 2807625 w 3160170"/>
                    <a:gd name="connsiteY83" fmla="*/ 583324 h 921264"/>
                    <a:gd name="connsiteX84" fmla="*/ 2798100 w 3160170"/>
                    <a:gd name="connsiteY84" fmla="*/ 602374 h 921264"/>
                    <a:gd name="connsiteX85" fmla="*/ 2794925 w 3160170"/>
                    <a:gd name="connsiteY85" fmla="*/ 618249 h 921264"/>
                    <a:gd name="connsiteX86" fmla="*/ 2794925 w 3160170"/>
                    <a:gd name="connsiteY86" fmla="*/ 634124 h 921264"/>
                    <a:gd name="connsiteX87" fmla="*/ 2798100 w 3160170"/>
                    <a:gd name="connsiteY87" fmla="*/ 646824 h 921264"/>
                    <a:gd name="connsiteX88" fmla="*/ 2798100 w 3160170"/>
                    <a:gd name="connsiteY88" fmla="*/ 646824 h 921264"/>
                    <a:gd name="connsiteX89" fmla="*/ 2747300 w 3160170"/>
                    <a:gd name="connsiteY89" fmla="*/ 665874 h 921264"/>
                    <a:gd name="connsiteX90" fmla="*/ 2696500 w 3160170"/>
                    <a:gd name="connsiteY90" fmla="*/ 675399 h 921264"/>
                    <a:gd name="connsiteX91" fmla="*/ 2648875 w 3160170"/>
                    <a:gd name="connsiteY91" fmla="*/ 681749 h 921264"/>
                    <a:gd name="connsiteX92" fmla="*/ 2623475 w 3160170"/>
                    <a:gd name="connsiteY92" fmla="*/ 681749 h 921264"/>
                    <a:gd name="connsiteX93" fmla="*/ 2585375 w 3160170"/>
                    <a:gd name="connsiteY93" fmla="*/ 681749 h 921264"/>
                    <a:gd name="connsiteX94" fmla="*/ 2547275 w 3160170"/>
                    <a:gd name="connsiteY94" fmla="*/ 678574 h 921264"/>
                    <a:gd name="connsiteX95" fmla="*/ 2531400 w 3160170"/>
                    <a:gd name="connsiteY95" fmla="*/ 681749 h 921264"/>
                    <a:gd name="connsiteX96" fmla="*/ 2506000 w 3160170"/>
                    <a:gd name="connsiteY96" fmla="*/ 694449 h 921264"/>
                    <a:gd name="connsiteX97" fmla="*/ 2483775 w 3160170"/>
                    <a:gd name="connsiteY97" fmla="*/ 703974 h 921264"/>
                    <a:gd name="connsiteX98" fmla="*/ 2439325 w 3160170"/>
                    <a:gd name="connsiteY98" fmla="*/ 713499 h 921264"/>
                    <a:gd name="connsiteX99" fmla="*/ 2394875 w 3160170"/>
                    <a:gd name="connsiteY99" fmla="*/ 723024 h 921264"/>
                    <a:gd name="connsiteX100" fmla="*/ 2347250 w 3160170"/>
                    <a:gd name="connsiteY100" fmla="*/ 729374 h 921264"/>
                    <a:gd name="connsiteX101" fmla="*/ 2315500 w 3160170"/>
                    <a:gd name="connsiteY101" fmla="*/ 716674 h 921264"/>
                    <a:gd name="connsiteX102" fmla="*/ 2252000 w 3160170"/>
                    <a:gd name="connsiteY102" fmla="*/ 703974 h 921264"/>
                    <a:gd name="connsiteX103" fmla="*/ 2213900 w 3160170"/>
                    <a:gd name="connsiteY103" fmla="*/ 697624 h 921264"/>
                    <a:gd name="connsiteX104" fmla="*/ 2172625 w 3160170"/>
                    <a:gd name="connsiteY104" fmla="*/ 691274 h 921264"/>
                    <a:gd name="connsiteX105" fmla="*/ 2115475 w 3160170"/>
                    <a:gd name="connsiteY105" fmla="*/ 681749 h 921264"/>
                    <a:gd name="connsiteX106" fmla="*/ 2077375 w 3160170"/>
                    <a:gd name="connsiteY106" fmla="*/ 675399 h 921264"/>
                    <a:gd name="connsiteX107" fmla="*/ 2029750 w 3160170"/>
                    <a:gd name="connsiteY107" fmla="*/ 665874 h 921264"/>
                    <a:gd name="connsiteX108" fmla="*/ 1915450 w 3160170"/>
                    <a:gd name="connsiteY108" fmla="*/ 659524 h 921264"/>
                    <a:gd name="connsiteX109" fmla="*/ 1855125 w 3160170"/>
                    <a:gd name="connsiteY109" fmla="*/ 662699 h 921264"/>
                    <a:gd name="connsiteX110" fmla="*/ 1769400 w 3160170"/>
                    <a:gd name="connsiteY110" fmla="*/ 665874 h 921264"/>
                    <a:gd name="connsiteX111" fmla="*/ 1731300 w 3160170"/>
                    <a:gd name="connsiteY111" fmla="*/ 672224 h 921264"/>
                    <a:gd name="connsiteX112" fmla="*/ 1686850 w 3160170"/>
                    <a:gd name="connsiteY112" fmla="*/ 694449 h 921264"/>
                    <a:gd name="connsiteX113" fmla="*/ 1629700 w 3160170"/>
                    <a:gd name="connsiteY113" fmla="*/ 716674 h 921264"/>
                    <a:gd name="connsiteX114" fmla="*/ 1585250 w 3160170"/>
                    <a:gd name="connsiteY114" fmla="*/ 738899 h 921264"/>
                    <a:gd name="connsiteX115" fmla="*/ 1528100 w 3160170"/>
                    <a:gd name="connsiteY115" fmla="*/ 754774 h 921264"/>
                    <a:gd name="connsiteX116" fmla="*/ 1496350 w 3160170"/>
                    <a:gd name="connsiteY116" fmla="*/ 773824 h 921264"/>
                    <a:gd name="connsiteX117" fmla="*/ 1470950 w 3160170"/>
                    <a:gd name="connsiteY117" fmla="*/ 780174 h 921264"/>
                    <a:gd name="connsiteX118" fmla="*/ 1426500 w 3160170"/>
                    <a:gd name="connsiteY118" fmla="*/ 799224 h 921264"/>
                    <a:gd name="connsiteX119" fmla="*/ 1353475 w 3160170"/>
                    <a:gd name="connsiteY119" fmla="*/ 776999 h 921264"/>
                    <a:gd name="connsiteX120" fmla="*/ 1242350 w 3160170"/>
                    <a:gd name="connsiteY120" fmla="*/ 751599 h 921264"/>
                    <a:gd name="connsiteX121" fmla="*/ 1169325 w 3160170"/>
                    <a:gd name="connsiteY121" fmla="*/ 735724 h 921264"/>
                    <a:gd name="connsiteX122" fmla="*/ 1029625 w 3160170"/>
                    <a:gd name="connsiteY122" fmla="*/ 703974 h 921264"/>
                    <a:gd name="connsiteX123" fmla="*/ 959775 w 3160170"/>
                    <a:gd name="connsiteY123" fmla="*/ 700799 h 921264"/>
                    <a:gd name="connsiteX124" fmla="*/ 867700 w 3160170"/>
                    <a:gd name="connsiteY124" fmla="*/ 697624 h 921264"/>
                    <a:gd name="connsiteX125" fmla="*/ 813725 w 3160170"/>
                    <a:gd name="connsiteY125" fmla="*/ 700799 h 921264"/>
                    <a:gd name="connsiteX126" fmla="*/ 775625 w 3160170"/>
                    <a:gd name="connsiteY126" fmla="*/ 713499 h 921264"/>
                    <a:gd name="connsiteX127" fmla="*/ 712125 w 3160170"/>
                    <a:gd name="connsiteY127" fmla="*/ 726199 h 921264"/>
                    <a:gd name="connsiteX128" fmla="*/ 677200 w 3160170"/>
                    <a:gd name="connsiteY128" fmla="*/ 738899 h 921264"/>
                    <a:gd name="connsiteX129" fmla="*/ 547025 w 3160170"/>
                    <a:gd name="connsiteY129" fmla="*/ 732549 h 921264"/>
                    <a:gd name="connsiteX130" fmla="*/ 515275 w 3160170"/>
                    <a:gd name="connsiteY130" fmla="*/ 732549 h 921264"/>
                    <a:gd name="connsiteX131" fmla="*/ 400975 w 3160170"/>
                    <a:gd name="connsiteY131" fmla="*/ 719849 h 921264"/>
                    <a:gd name="connsiteX132" fmla="*/ 366050 w 3160170"/>
                    <a:gd name="connsiteY132" fmla="*/ 723024 h 921264"/>
                    <a:gd name="connsiteX133" fmla="*/ 319172 w 3160170"/>
                    <a:gd name="connsiteY133" fmla="*/ 728066 h 921264"/>
                    <a:gd name="connsiteX134" fmla="*/ 232700 w 3160170"/>
                    <a:gd name="connsiteY134" fmla="*/ 716674 h 921264"/>
                    <a:gd name="connsiteX135" fmla="*/ 213650 w 3160170"/>
                    <a:gd name="connsiteY135" fmla="*/ 716674 h 921264"/>
                    <a:gd name="connsiteX136" fmla="*/ 146975 w 3160170"/>
                    <a:gd name="connsiteY136" fmla="*/ 716674 h 921264"/>
                    <a:gd name="connsiteX137" fmla="*/ 131100 w 3160170"/>
                    <a:gd name="connsiteY137" fmla="*/ 719849 h 921264"/>
                    <a:gd name="connsiteX138" fmla="*/ 99350 w 3160170"/>
                    <a:gd name="connsiteY138" fmla="*/ 732549 h 921264"/>
                    <a:gd name="connsiteX139" fmla="*/ 70775 w 3160170"/>
                    <a:gd name="connsiteY139" fmla="*/ 742074 h 921264"/>
                    <a:gd name="connsiteX140" fmla="*/ 17214 w 3160170"/>
                    <a:gd name="connsiteY140" fmla="*/ 751737 h 921264"/>
                    <a:gd name="connsiteX141" fmla="*/ 787 w 3160170"/>
                    <a:gd name="connsiteY141" fmla="*/ 786110 h 921264"/>
                    <a:gd name="connsiteX142" fmla="*/ 37782 w 3160170"/>
                    <a:gd name="connsiteY142" fmla="*/ 842293 h 921264"/>
                    <a:gd name="connsiteX143" fmla="*/ 80438 w 3160170"/>
                    <a:gd name="connsiteY143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3023525 w 3160170"/>
                    <a:gd name="connsiteY43" fmla="*/ 303924 h 921264"/>
                    <a:gd name="connsiteX44" fmla="*/ 2985840 w 3160170"/>
                    <a:gd name="connsiteY44" fmla="*/ 271484 h 921264"/>
                    <a:gd name="connsiteX45" fmla="*/ 2957597 w 3160170"/>
                    <a:gd name="connsiteY45" fmla="*/ 245094 h 921264"/>
                    <a:gd name="connsiteX46" fmla="*/ 2936557 w 3160170"/>
                    <a:gd name="connsiteY46" fmla="*/ 220822 h 921264"/>
                    <a:gd name="connsiteX47" fmla="*/ 2912400 w 3160170"/>
                    <a:gd name="connsiteY47" fmla="*/ 208674 h 921264"/>
                    <a:gd name="connsiteX48" fmla="*/ 2871125 w 3160170"/>
                    <a:gd name="connsiteY48" fmla="*/ 161049 h 921264"/>
                    <a:gd name="connsiteX49" fmla="*/ 2855250 w 3160170"/>
                    <a:gd name="connsiteY49" fmla="*/ 148349 h 921264"/>
                    <a:gd name="connsiteX50" fmla="*/ 2829850 w 3160170"/>
                    <a:gd name="connsiteY50" fmla="*/ 113424 h 921264"/>
                    <a:gd name="connsiteX51" fmla="*/ 2791750 w 3160170"/>
                    <a:gd name="connsiteY51" fmla="*/ 65799 h 921264"/>
                    <a:gd name="connsiteX52" fmla="*/ 2763175 w 3160170"/>
                    <a:gd name="connsiteY52" fmla="*/ 37224 h 921264"/>
                    <a:gd name="connsiteX53" fmla="*/ 2725075 w 3160170"/>
                    <a:gd name="connsiteY53" fmla="*/ 24524 h 921264"/>
                    <a:gd name="connsiteX54" fmla="*/ 2664750 w 3160170"/>
                    <a:gd name="connsiteY54" fmla="*/ 14999 h 921264"/>
                    <a:gd name="connsiteX55" fmla="*/ 2598075 w 3160170"/>
                    <a:gd name="connsiteY55" fmla="*/ 8649 h 921264"/>
                    <a:gd name="connsiteX56" fmla="*/ 2546308 w 3160170"/>
                    <a:gd name="connsiteY56" fmla="*/ 90 h 921264"/>
                    <a:gd name="connsiteX57" fmla="*/ 2518148 w 3160170"/>
                    <a:gd name="connsiteY57" fmla="*/ 14446 h 921264"/>
                    <a:gd name="connsiteX58" fmla="*/ 2480600 w 3160170"/>
                    <a:gd name="connsiteY58" fmla="*/ 49924 h 921264"/>
                    <a:gd name="connsiteX59" fmla="*/ 2461550 w 3160170"/>
                    <a:gd name="connsiteY59" fmla="*/ 84849 h 921264"/>
                    <a:gd name="connsiteX60" fmla="*/ 2455200 w 3160170"/>
                    <a:gd name="connsiteY60" fmla="*/ 116599 h 921264"/>
                    <a:gd name="connsiteX61" fmla="*/ 2463068 w 3160170"/>
                    <a:gd name="connsiteY61" fmla="*/ 140205 h 921264"/>
                    <a:gd name="connsiteX62" fmla="*/ 2486122 w 3160170"/>
                    <a:gd name="connsiteY62" fmla="*/ 154423 h 921264"/>
                    <a:gd name="connsiteX63" fmla="*/ 2515525 w 3160170"/>
                    <a:gd name="connsiteY63" fmla="*/ 164224 h 921264"/>
                    <a:gd name="connsiteX64" fmla="*/ 2531400 w 3160170"/>
                    <a:gd name="connsiteY64" fmla="*/ 164224 h 921264"/>
                    <a:gd name="connsiteX65" fmla="*/ 2559975 w 3160170"/>
                    <a:gd name="connsiteY65" fmla="*/ 164638 h 921264"/>
                    <a:gd name="connsiteX66" fmla="*/ 2569500 w 3160170"/>
                    <a:gd name="connsiteY66" fmla="*/ 167399 h 921264"/>
                    <a:gd name="connsiteX67" fmla="*/ 2601250 w 3160170"/>
                    <a:gd name="connsiteY67" fmla="*/ 170574 h 921264"/>
                    <a:gd name="connsiteX68" fmla="*/ 2629825 w 3160170"/>
                    <a:gd name="connsiteY68" fmla="*/ 161049 h 921264"/>
                    <a:gd name="connsiteX69" fmla="*/ 2664750 w 3160170"/>
                    <a:gd name="connsiteY69" fmla="*/ 173749 h 921264"/>
                    <a:gd name="connsiteX70" fmla="*/ 2693325 w 3160170"/>
                    <a:gd name="connsiteY70" fmla="*/ 180099 h 921264"/>
                    <a:gd name="connsiteX71" fmla="*/ 2721900 w 3160170"/>
                    <a:gd name="connsiteY71" fmla="*/ 215024 h 921264"/>
                    <a:gd name="connsiteX72" fmla="*/ 2763175 w 3160170"/>
                    <a:gd name="connsiteY72" fmla="*/ 284874 h 921264"/>
                    <a:gd name="connsiteX73" fmla="*/ 2779050 w 3160170"/>
                    <a:gd name="connsiteY73" fmla="*/ 319799 h 921264"/>
                    <a:gd name="connsiteX74" fmla="*/ 2791750 w 3160170"/>
                    <a:gd name="connsiteY74" fmla="*/ 361074 h 921264"/>
                    <a:gd name="connsiteX75" fmla="*/ 2804450 w 3160170"/>
                    <a:gd name="connsiteY75" fmla="*/ 399174 h 921264"/>
                    <a:gd name="connsiteX76" fmla="*/ 2807625 w 3160170"/>
                    <a:gd name="connsiteY76" fmla="*/ 418224 h 921264"/>
                    <a:gd name="connsiteX77" fmla="*/ 2807625 w 3160170"/>
                    <a:gd name="connsiteY77" fmla="*/ 440449 h 921264"/>
                    <a:gd name="connsiteX78" fmla="*/ 2810800 w 3160170"/>
                    <a:gd name="connsiteY78" fmla="*/ 475374 h 921264"/>
                    <a:gd name="connsiteX79" fmla="*/ 2813975 w 3160170"/>
                    <a:gd name="connsiteY79" fmla="*/ 503949 h 921264"/>
                    <a:gd name="connsiteX80" fmla="*/ 2817150 w 3160170"/>
                    <a:gd name="connsiteY80" fmla="*/ 529349 h 921264"/>
                    <a:gd name="connsiteX81" fmla="*/ 2817150 w 3160170"/>
                    <a:gd name="connsiteY81" fmla="*/ 557924 h 921264"/>
                    <a:gd name="connsiteX82" fmla="*/ 2813975 w 3160170"/>
                    <a:gd name="connsiteY82" fmla="*/ 570624 h 921264"/>
                    <a:gd name="connsiteX83" fmla="*/ 2807625 w 3160170"/>
                    <a:gd name="connsiteY83" fmla="*/ 583324 h 921264"/>
                    <a:gd name="connsiteX84" fmla="*/ 2798100 w 3160170"/>
                    <a:gd name="connsiteY84" fmla="*/ 602374 h 921264"/>
                    <a:gd name="connsiteX85" fmla="*/ 2794925 w 3160170"/>
                    <a:gd name="connsiteY85" fmla="*/ 618249 h 921264"/>
                    <a:gd name="connsiteX86" fmla="*/ 2794925 w 3160170"/>
                    <a:gd name="connsiteY86" fmla="*/ 634124 h 921264"/>
                    <a:gd name="connsiteX87" fmla="*/ 2798100 w 3160170"/>
                    <a:gd name="connsiteY87" fmla="*/ 646824 h 921264"/>
                    <a:gd name="connsiteX88" fmla="*/ 2798100 w 3160170"/>
                    <a:gd name="connsiteY88" fmla="*/ 646824 h 921264"/>
                    <a:gd name="connsiteX89" fmla="*/ 2747300 w 3160170"/>
                    <a:gd name="connsiteY89" fmla="*/ 665874 h 921264"/>
                    <a:gd name="connsiteX90" fmla="*/ 2696500 w 3160170"/>
                    <a:gd name="connsiteY90" fmla="*/ 675399 h 921264"/>
                    <a:gd name="connsiteX91" fmla="*/ 2648875 w 3160170"/>
                    <a:gd name="connsiteY91" fmla="*/ 681749 h 921264"/>
                    <a:gd name="connsiteX92" fmla="*/ 2623475 w 3160170"/>
                    <a:gd name="connsiteY92" fmla="*/ 681749 h 921264"/>
                    <a:gd name="connsiteX93" fmla="*/ 2585375 w 3160170"/>
                    <a:gd name="connsiteY93" fmla="*/ 681749 h 921264"/>
                    <a:gd name="connsiteX94" fmla="*/ 2547275 w 3160170"/>
                    <a:gd name="connsiteY94" fmla="*/ 678574 h 921264"/>
                    <a:gd name="connsiteX95" fmla="*/ 2531400 w 3160170"/>
                    <a:gd name="connsiteY95" fmla="*/ 681749 h 921264"/>
                    <a:gd name="connsiteX96" fmla="*/ 2506000 w 3160170"/>
                    <a:gd name="connsiteY96" fmla="*/ 694449 h 921264"/>
                    <a:gd name="connsiteX97" fmla="*/ 2483775 w 3160170"/>
                    <a:gd name="connsiteY97" fmla="*/ 703974 h 921264"/>
                    <a:gd name="connsiteX98" fmla="*/ 2439325 w 3160170"/>
                    <a:gd name="connsiteY98" fmla="*/ 713499 h 921264"/>
                    <a:gd name="connsiteX99" fmla="*/ 2394875 w 3160170"/>
                    <a:gd name="connsiteY99" fmla="*/ 723024 h 921264"/>
                    <a:gd name="connsiteX100" fmla="*/ 2347250 w 3160170"/>
                    <a:gd name="connsiteY100" fmla="*/ 729374 h 921264"/>
                    <a:gd name="connsiteX101" fmla="*/ 2315500 w 3160170"/>
                    <a:gd name="connsiteY101" fmla="*/ 716674 h 921264"/>
                    <a:gd name="connsiteX102" fmla="*/ 2252000 w 3160170"/>
                    <a:gd name="connsiteY102" fmla="*/ 703974 h 921264"/>
                    <a:gd name="connsiteX103" fmla="*/ 2213900 w 3160170"/>
                    <a:gd name="connsiteY103" fmla="*/ 697624 h 921264"/>
                    <a:gd name="connsiteX104" fmla="*/ 2172625 w 3160170"/>
                    <a:gd name="connsiteY104" fmla="*/ 691274 h 921264"/>
                    <a:gd name="connsiteX105" fmla="*/ 2115475 w 3160170"/>
                    <a:gd name="connsiteY105" fmla="*/ 681749 h 921264"/>
                    <a:gd name="connsiteX106" fmla="*/ 2077375 w 3160170"/>
                    <a:gd name="connsiteY106" fmla="*/ 675399 h 921264"/>
                    <a:gd name="connsiteX107" fmla="*/ 2029750 w 3160170"/>
                    <a:gd name="connsiteY107" fmla="*/ 665874 h 921264"/>
                    <a:gd name="connsiteX108" fmla="*/ 1915450 w 3160170"/>
                    <a:gd name="connsiteY108" fmla="*/ 659524 h 921264"/>
                    <a:gd name="connsiteX109" fmla="*/ 1855125 w 3160170"/>
                    <a:gd name="connsiteY109" fmla="*/ 662699 h 921264"/>
                    <a:gd name="connsiteX110" fmla="*/ 1769400 w 3160170"/>
                    <a:gd name="connsiteY110" fmla="*/ 665874 h 921264"/>
                    <a:gd name="connsiteX111" fmla="*/ 1731300 w 3160170"/>
                    <a:gd name="connsiteY111" fmla="*/ 672224 h 921264"/>
                    <a:gd name="connsiteX112" fmla="*/ 1686850 w 3160170"/>
                    <a:gd name="connsiteY112" fmla="*/ 694449 h 921264"/>
                    <a:gd name="connsiteX113" fmla="*/ 1629700 w 3160170"/>
                    <a:gd name="connsiteY113" fmla="*/ 716674 h 921264"/>
                    <a:gd name="connsiteX114" fmla="*/ 1585250 w 3160170"/>
                    <a:gd name="connsiteY114" fmla="*/ 738899 h 921264"/>
                    <a:gd name="connsiteX115" fmla="*/ 1528100 w 3160170"/>
                    <a:gd name="connsiteY115" fmla="*/ 754774 h 921264"/>
                    <a:gd name="connsiteX116" fmla="*/ 1496350 w 3160170"/>
                    <a:gd name="connsiteY116" fmla="*/ 773824 h 921264"/>
                    <a:gd name="connsiteX117" fmla="*/ 1470950 w 3160170"/>
                    <a:gd name="connsiteY117" fmla="*/ 780174 h 921264"/>
                    <a:gd name="connsiteX118" fmla="*/ 1426500 w 3160170"/>
                    <a:gd name="connsiteY118" fmla="*/ 799224 h 921264"/>
                    <a:gd name="connsiteX119" fmla="*/ 1353475 w 3160170"/>
                    <a:gd name="connsiteY119" fmla="*/ 776999 h 921264"/>
                    <a:gd name="connsiteX120" fmla="*/ 1242350 w 3160170"/>
                    <a:gd name="connsiteY120" fmla="*/ 751599 h 921264"/>
                    <a:gd name="connsiteX121" fmla="*/ 1169325 w 3160170"/>
                    <a:gd name="connsiteY121" fmla="*/ 735724 h 921264"/>
                    <a:gd name="connsiteX122" fmla="*/ 1029625 w 3160170"/>
                    <a:gd name="connsiteY122" fmla="*/ 703974 h 921264"/>
                    <a:gd name="connsiteX123" fmla="*/ 959775 w 3160170"/>
                    <a:gd name="connsiteY123" fmla="*/ 700799 h 921264"/>
                    <a:gd name="connsiteX124" fmla="*/ 867700 w 3160170"/>
                    <a:gd name="connsiteY124" fmla="*/ 697624 h 921264"/>
                    <a:gd name="connsiteX125" fmla="*/ 813725 w 3160170"/>
                    <a:gd name="connsiteY125" fmla="*/ 700799 h 921264"/>
                    <a:gd name="connsiteX126" fmla="*/ 775625 w 3160170"/>
                    <a:gd name="connsiteY126" fmla="*/ 713499 h 921264"/>
                    <a:gd name="connsiteX127" fmla="*/ 712125 w 3160170"/>
                    <a:gd name="connsiteY127" fmla="*/ 726199 h 921264"/>
                    <a:gd name="connsiteX128" fmla="*/ 677200 w 3160170"/>
                    <a:gd name="connsiteY128" fmla="*/ 738899 h 921264"/>
                    <a:gd name="connsiteX129" fmla="*/ 547025 w 3160170"/>
                    <a:gd name="connsiteY129" fmla="*/ 732549 h 921264"/>
                    <a:gd name="connsiteX130" fmla="*/ 515275 w 3160170"/>
                    <a:gd name="connsiteY130" fmla="*/ 732549 h 921264"/>
                    <a:gd name="connsiteX131" fmla="*/ 400975 w 3160170"/>
                    <a:gd name="connsiteY131" fmla="*/ 719849 h 921264"/>
                    <a:gd name="connsiteX132" fmla="*/ 366050 w 3160170"/>
                    <a:gd name="connsiteY132" fmla="*/ 723024 h 921264"/>
                    <a:gd name="connsiteX133" fmla="*/ 319172 w 3160170"/>
                    <a:gd name="connsiteY133" fmla="*/ 728066 h 921264"/>
                    <a:gd name="connsiteX134" fmla="*/ 232700 w 3160170"/>
                    <a:gd name="connsiteY134" fmla="*/ 716674 h 921264"/>
                    <a:gd name="connsiteX135" fmla="*/ 213650 w 3160170"/>
                    <a:gd name="connsiteY135" fmla="*/ 716674 h 921264"/>
                    <a:gd name="connsiteX136" fmla="*/ 146975 w 3160170"/>
                    <a:gd name="connsiteY136" fmla="*/ 716674 h 921264"/>
                    <a:gd name="connsiteX137" fmla="*/ 131100 w 3160170"/>
                    <a:gd name="connsiteY137" fmla="*/ 719849 h 921264"/>
                    <a:gd name="connsiteX138" fmla="*/ 99350 w 3160170"/>
                    <a:gd name="connsiteY138" fmla="*/ 732549 h 921264"/>
                    <a:gd name="connsiteX139" fmla="*/ 70775 w 3160170"/>
                    <a:gd name="connsiteY139" fmla="*/ 742074 h 921264"/>
                    <a:gd name="connsiteX140" fmla="*/ 17214 w 3160170"/>
                    <a:gd name="connsiteY140" fmla="*/ 751737 h 921264"/>
                    <a:gd name="connsiteX141" fmla="*/ 787 w 3160170"/>
                    <a:gd name="connsiteY141" fmla="*/ 786110 h 921264"/>
                    <a:gd name="connsiteX142" fmla="*/ 37782 w 3160170"/>
                    <a:gd name="connsiteY142" fmla="*/ 842293 h 921264"/>
                    <a:gd name="connsiteX143" fmla="*/ 80438 w 3160170"/>
                    <a:gd name="connsiteY143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3023525 w 3160170"/>
                    <a:gd name="connsiteY43" fmla="*/ 303924 h 921264"/>
                    <a:gd name="connsiteX44" fmla="*/ 2985840 w 3160170"/>
                    <a:gd name="connsiteY44" fmla="*/ 271484 h 921264"/>
                    <a:gd name="connsiteX45" fmla="*/ 2936557 w 3160170"/>
                    <a:gd name="connsiteY45" fmla="*/ 220822 h 921264"/>
                    <a:gd name="connsiteX46" fmla="*/ 2912400 w 3160170"/>
                    <a:gd name="connsiteY46" fmla="*/ 208674 h 921264"/>
                    <a:gd name="connsiteX47" fmla="*/ 2871125 w 3160170"/>
                    <a:gd name="connsiteY47" fmla="*/ 161049 h 921264"/>
                    <a:gd name="connsiteX48" fmla="*/ 2855250 w 3160170"/>
                    <a:gd name="connsiteY48" fmla="*/ 148349 h 921264"/>
                    <a:gd name="connsiteX49" fmla="*/ 2829850 w 3160170"/>
                    <a:gd name="connsiteY49" fmla="*/ 113424 h 921264"/>
                    <a:gd name="connsiteX50" fmla="*/ 2791750 w 3160170"/>
                    <a:gd name="connsiteY50" fmla="*/ 65799 h 921264"/>
                    <a:gd name="connsiteX51" fmla="*/ 2763175 w 3160170"/>
                    <a:gd name="connsiteY51" fmla="*/ 37224 h 921264"/>
                    <a:gd name="connsiteX52" fmla="*/ 2725075 w 3160170"/>
                    <a:gd name="connsiteY52" fmla="*/ 24524 h 921264"/>
                    <a:gd name="connsiteX53" fmla="*/ 2664750 w 3160170"/>
                    <a:gd name="connsiteY53" fmla="*/ 14999 h 921264"/>
                    <a:gd name="connsiteX54" fmla="*/ 2598075 w 3160170"/>
                    <a:gd name="connsiteY54" fmla="*/ 8649 h 921264"/>
                    <a:gd name="connsiteX55" fmla="*/ 2546308 w 3160170"/>
                    <a:gd name="connsiteY55" fmla="*/ 90 h 921264"/>
                    <a:gd name="connsiteX56" fmla="*/ 2518148 w 3160170"/>
                    <a:gd name="connsiteY56" fmla="*/ 14446 h 921264"/>
                    <a:gd name="connsiteX57" fmla="*/ 2480600 w 3160170"/>
                    <a:gd name="connsiteY57" fmla="*/ 49924 h 921264"/>
                    <a:gd name="connsiteX58" fmla="*/ 2461550 w 3160170"/>
                    <a:gd name="connsiteY58" fmla="*/ 84849 h 921264"/>
                    <a:gd name="connsiteX59" fmla="*/ 2455200 w 3160170"/>
                    <a:gd name="connsiteY59" fmla="*/ 116599 h 921264"/>
                    <a:gd name="connsiteX60" fmla="*/ 2463068 w 3160170"/>
                    <a:gd name="connsiteY60" fmla="*/ 140205 h 921264"/>
                    <a:gd name="connsiteX61" fmla="*/ 2486122 w 3160170"/>
                    <a:gd name="connsiteY61" fmla="*/ 154423 h 921264"/>
                    <a:gd name="connsiteX62" fmla="*/ 2515525 w 3160170"/>
                    <a:gd name="connsiteY62" fmla="*/ 164224 h 921264"/>
                    <a:gd name="connsiteX63" fmla="*/ 2531400 w 3160170"/>
                    <a:gd name="connsiteY63" fmla="*/ 164224 h 921264"/>
                    <a:gd name="connsiteX64" fmla="*/ 2559975 w 3160170"/>
                    <a:gd name="connsiteY64" fmla="*/ 164638 h 921264"/>
                    <a:gd name="connsiteX65" fmla="*/ 2569500 w 3160170"/>
                    <a:gd name="connsiteY65" fmla="*/ 167399 h 921264"/>
                    <a:gd name="connsiteX66" fmla="*/ 2601250 w 3160170"/>
                    <a:gd name="connsiteY66" fmla="*/ 170574 h 921264"/>
                    <a:gd name="connsiteX67" fmla="*/ 2629825 w 3160170"/>
                    <a:gd name="connsiteY67" fmla="*/ 161049 h 921264"/>
                    <a:gd name="connsiteX68" fmla="*/ 2664750 w 3160170"/>
                    <a:gd name="connsiteY68" fmla="*/ 173749 h 921264"/>
                    <a:gd name="connsiteX69" fmla="*/ 2693325 w 3160170"/>
                    <a:gd name="connsiteY69" fmla="*/ 180099 h 921264"/>
                    <a:gd name="connsiteX70" fmla="*/ 2721900 w 3160170"/>
                    <a:gd name="connsiteY70" fmla="*/ 215024 h 921264"/>
                    <a:gd name="connsiteX71" fmla="*/ 2763175 w 3160170"/>
                    <a:gd name="connsiteY71" fmla="*/ 284874 h 921264"/>
                    <a:gd name="connsiteX72" fmla="*/ 2779050 w 3160170"/>
                    <a:gd name="connsiteY72" fmla="*/ 319799 h 921264"/>
                    <a:gd name="connsiteX73" fmla="*/ 2791750 w 3160170"/>
                    <a:gd name="connsiteY73" fmla="*/ 361074 h 921264"/>
                    <a:gd name="connsiteX74" fmla="*/ 2804450 w 3160170"/>
                    <a:gd name="connsiteY74" fmla="*/ 399174 h 921264"/>
                    <a:gd name="connsiteX75" fmla="*/ 2807625 w 3160170"/>
                    <a:gd name="connsiteY75" fmla="*/ 418224 h 921264"/>
                    <a:gd name="connsiteX76" fmla="*/ 2807625 w 3160170"/>
                    <a:gd name="connsiteY76" fmla="*/ 440449 h 921264"/>
                    <a:gd name="connsiteX77" fmla="*/ 2810800 w 3160170"/>
                    <a:gd name="connsiteY77" fmla="*/ 475374 h 921264"/>
                    <a:gd name="connsiteX78" fmla="*/ 2813975 w 3160170"/>
                    <a:gd name="connsiteY78" fmla="*/ 503949 h 921264"/>
                    <a:gd name="connsiteX79" fmla="*/ 2817150 w 3160170"/>
                    <a:gd name="connsiteY79" fmla="*/ 529349 h 921264"/>
                    <a:gd name="connsiteX80" fmla="*/ 2817150 w 3160170"/>
                    <a:gd name="connsiteY80" fmla="*/ 557924 h 921264"/>
                    <a:gd name="connsiteX81" fmla="*/ 2813975 w 3160170"/>
                    <a:gd name="connsiteY81" fmla="*/ 570624 h 921264"/>
                    <a:gd name="connsiteX82" fmla="*/ 2807625 w 3160170"/>
                    <a:gd name="connsiteY82" fmla="*/ 583324 h 921264"/>
                    <a:gd name="connsiteX83" fmla="*/ 2798100 w 3160170"/>
                    <a:gd name="connsiteY83" fmla="*/ 602374 h 921264"/>
                    <a:gd name="connsiteX84" fmla="*/ 2794925 w 3160170"/>
                    <a:gd name="connsiteY84" fmla="*/ 618249 h 921264"/>
                    <a:gd name="connsiteX85" fmla="*/ 2794925 w 3160170"/>
                    <a:gd name="connsiteY85" fmla="*/ 634124 h 921264"/>
                    <a:gd name="connsiteX86" fmla="*/ 2798100 w 3160170"/>
                    <a:gd name="connsiteY86" fmla="*/ 646824 h 921264"/>
                    <a:gd name="connsiteX87" fmla="*/ 2798100 w 3160170"/>
                    <a:gd name="connsiteY87" fmla="*/ 646824 h 921264"/>
                    <a:gd name="connsiteX88" fmla="*/ 2747300 w 3160170"/>
                    <a:gd name="connsiteY88" fmla="*/ 665874 h 921264"/>
                    <a:gd name="connsiteX89" fmla="*/ 2696500 w 3160170"/>
                    <a:gd name="connsiteY89" fmla="*/ 675399 h 921264"/>
                    <a:gd name="connsiteX90" fmla="*/ 2648875 w 3160170"/>
                    <a:gd name="connsiteY90" fmla="*/ 681749 h 921264"/>
                    <a:gd name="connsiteX91" fmla="*/ 2623475 w 3160170"/>
                    <a:gd name="connsiteY91" fmla="*/ 681749 h 921264"/>
                    <a:gd name="connsiteX92" fmla="*/ 2585375 w 3160170"/>
                    <a:gd name="connsiteY92" fmla="*/ 681749 h 921264"/>
                    <a:gd name="connsiteX93" fmla="*/ 2547275 w 3160170"/>
                    <a:gd name="connsiteY93" fmla="*/ 678574 h 921264"/>
                    <a:gd name="connsiteX94" fmla="*/ 2531400 w 3160170"/>
                    <a:gd name="connsiteY94" fmla="*/ 681749 h 921264"/>
                    <a:gd name="connsiteX95" fmla="*/ 2506000 w 3160170"/>
                    <a:gd name="connsiteY95" fmla="*/ 694449 h 921264"/>
                    <a:gd name="connsiteX96" fmla="*/ 2483775 w 3160170"/>
                    <a:gd name="connsiteY96" fmla="*/ 703974 h 921264"/>
                    <a:gd name="connsiteX97" fmla="*/ 2439325 w 3160170"/>
                    <a:gd name="connsiteY97" fmla="*/ 713499 h 921264"/>
                    <a:gd name="connsiteX98" fmla="*/ 2394875 w 3160170"/>
                    <a:gd name="connsiteY98" fmla="*/ 723024 h 921264"/>
                    <a:gd name="connsiteX99" fmla="*/ 2347250 w 3160170"/>
                    <a:gd name="connsiteY99" fmla="*/ 729374 h 921264"/>
                    <a:gd name="connsiteX100" fmla="*/ 2315500 w 3160170"/>
                    <a:gd name="connsiteY100" fmla="*/ 716674 h 921264"/>
                    <a:gd name="connsiteX101" fmla="*/ 2252000 w 3160170"/>
                    <a:gd name="connsiteY101" fmla="*/ 703974 h 921264"/>
                    <a:gd name="connsiteX102" fmla="*/ 2213900 w 3160170"/>
                    <a:gd name="connsiteY102" fmla="*/ 697624 h 921264"/>
                    <a:gd name="connsiteX103" fmla="*/ 2172625 w 3160170"/>
                    <a:gd name="connsiteY103" fmla="*/ 691274 h 921264"/>
                    <a:gd name="connsiteX104" fmla="*/ 2115475 w 3160170"/>
                    <a:gd name="connsiteY104" fmla="*/ 681749 h 921264"/>
                    <a:gd name="connsiteX105" fmla="*/ 2077375 w 3160170"/>
                    <a:gd name="connsiteY105" fmla="*/ 675399 h 921264"/>
                    <a:gd name="connsiteX106" fmla="*/ 2029750 w 3160170"/>
                    <a:gd name="connsiteY106" fmla="*/ 665874 h 921264"/>
                    <a:gd name="connsiteX107" fmla="*/ 1915450 w 3160170"/>
                    <a:gd name="connsiteY107" fmla="*/ 659524 h 921264"/>
                    <a:gd name="connsiteX108" fmla="*/ 1855125 w 3160170"/>
                    <a:gd name="connsiteY108" fmla="*/ 662699 h 921264"/>
                    <a:gd name="connsiteX109" fmla="*/ 1769400 w 3160170"/>
                    <a:gd name="connsiteY109" fmla="*/ 665874 h 921264"/>
                    <a:gd name="connsiteX110" fmla="*/ 1731300 w 3160170"/>
                    <a:gd name="connsiteY110" fmla="*/ 672224 h 921264"/>
                    <a:gd name="connsiteX111" fmla="*/ 1686850 w 3160170"/>
                    <a:gd name="connsiteY111" fmla="*/ 694449 h 921264"/>
                    <a:gd name="connsiteX112" fmla="*/ 1629700 w 3160170"/>
                    <a:gd name="connsiteY112" fmla="*/ 716674 h 921264"/>
                    <a:gd name="connsiteX113" fmla="*/ 1585250 w 3160170"/>
                    <a:gd name="connsiteY113" fmla="*/ 738899 h 921264"/>
                    <a:gd name="connsiteX114" fmla="*/ 1528100 w 3160170"/>
                    <a:gd name="connsiteY114" fmla="*/ 754774 h 921264"/>
                    <a:gd name="connsiteX115" fmla="*/ 1496350 w 3160170"/>
                    <a:gd name="connsiteY115" fmla="*/ 773824 h 921264"/>
                    <a:gd name="connsiteX116" fmla="*/ 1470950 w 3160170"/>
                    <a:gd name="connsiteY116" fmla="*/ 780174 h 921264"/>
                    <a:gd name="connsiteX117" fmla="*/ 1426500 w 3160170"/>
                    <a:gd name="connsiteY117" fmla="*/ 799224 h 921264"/>
                    <a:gd name="connsiteX118" fmla="*/ 1353475 w 3160170"/>
                    <a:gd name="connsiteY118" fmla="*/ 776999 h 921264"/>
                    <a:gd name="connsiteX119" fmla="*/ 1242350 w 3160170"/>
                    <a:gd name="connsiteY119" fmla="*/ 751599 h 921264"/>
                    <a:gd name="connsiteX120" fmla="*/ 1169325 w 3160170"/>
                    <a:gd name="connsiteY120" fmla="*/ 735724 h 921264"/>
                    <a:gd name="connsiteX121" fmla="*/ 1029625 w 3160170"/>
                    <a:gd name="connsiteY121" fmla="*/ 703974 h 921264"/>
                    <a:gd name="connsiteX122" fmla="*/ 959775 w 3160170"/>
                    <a:gd name="connsiteY122" fmla="*/ 700799 h 921264"/>
                    <a:gd name="connsiteX123" fmla="*/ 867700 w 3160170"/>
                    <a:gd name="connsiteY123" fmla="*/ 697624 h 921264"/>
                    <a:gd name="connsiteX124" fmla="*/ 813725 w 3160170"/>
                    <a:gd name="connsiteY124" fmla="*/ 700799 h 921264"/>
                    <a:gd name="connsiteX125" fmla="*/ 775625 w 3160170"/>
                    <a:gd name="connsiteY125" fmla="*/ 713499 h 921264"/>
                    <a:gd name="connsiteX126" fmla="*/ 712125 w 3160170"/>
                    <a:gd name="connsiteY126" fmla="*/ 726199 h 921264"/>
                    <a:gd name="connsiteX127" fmla="*/ 677200 w 3160170"/>
                    <a:gd name="connsiteY127" fmla="*/ 738899 h 921264"/>
                    <a:gd name="connsiteX128" fmla="*/ 547025 w 3160170"/>
                    <a:gd name="connsiteY128" fmla="*/ 732549 h 921264"/>
                    <a:gd name="connsiteX129" fmla="*/ 515275 w 3160170"/>
                    <a:gd name="connsiteY129" fmla="*/ 732549 h 921264"/>
                    <a:gd name="connsiteX130" fmla="*/ 400975 w 3160170"/>
                    <a:gd name="connsiteY130" fmla="*/ 719849 h 921264"/>
                    <a:gd name="connsiteX131" fmla="*/ 366050 w 3160170"/>
                    <a:gd name="connsiteY131" fmla="*/ 723024 h 921264"/>
                    <a:gd name="connsiteX132" fmla="*/ 319172 w 3160170"/>
                    <a:gd name="connsiteY132" fmla="*/ 728066 h 921264"/>
                    <a:gd name="connsiteX133" fmla="*/ 232700 w 3160170"/>
                    <a:gd name="connsiteY133" fmla="*/ 716674 h 921264"/>
                    <a:gd name="connsiteX134" fmla="*/ 213650 w 3160170"/>
                    <a:gd name="connsiteY134" fmla="*/ 716674 h 921264"/>
                    <a:gd name="connsiteX135" fmla="*/ 146975 w 3160170"/>
                    <a:gd name="connsiteY135" fmla="*/ 716674 h 921264"/>
                    <a:gd name="connsiteX136" fmla="*/ 131100 w 3160170"/>
                    <a:gd name="connsiteY136" fmla="*/ 719849 h 921264"/>
                    <a:gd name="connsiteX137" fmla="*/ 99350 w 3160170"/>
                    <a:gd name="connsiteY137" fmla="*/ 732549 h 921264"/>
                    <a:gd name="connsiteX138" fmla="*/ 70775 w 3160170"/>
                    <a:gd name="connsiteY138" fmla="*/ 742074 h 921264"/>
                    <a:gd name="connsiteX139" fmla="*/ 17214 w 3160170"/>
                    <a:gd name="connsiteY139" fmla="*/ 751737 h 921264"/>
                    <a:gd name="connsiteX140" fmla="*/ 787 w 3160170"/>
                    <a:gd name="connsiteY140" fmla="*/ 786110 h 921264"/>
                    <a:gd name="connsiteX141" fmla="*/ 37782 w 3160170"/>
                    <a:gd name="connsiteY141" fmla="*/ 842293 h 921264"/>
                    <a:gd name="connsiteX142" fmla="*/ 80438 w 3160170"/>
                    <a:gd name="connsiteY142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3023525 w 3160170"/>
                    <a:gd name="connsiteY43" fmla="*/ 303924 h 921264"/>
                    <a:gd name="connsiteX44" fmla="*/ 2985840 w 3160170"/>
                    <a:gd name="connsiteY44" fmla="*/ 271484 h 921264"/>
                    <a:gd name="connsiteX45" fmla="*/ 2936557 w 3160170"/>
                    <a:gd name="connsiteY45" fmla="*/ 220822 h 921264"/>
                    <a:gd name="connsiteX46" fmla="*/ 2871125 w 3160170"/>
                    <a:gd name="connsiteY46" fmla="*/ 161049 h 921264"/>
                    <a:gd name="connsiteX47" fmla="*/ 2855250 w 3160170"/>
                    <a:gd name="connsiteY47" fmla="*/ 148349 h 921264"/>
                    <a:gd name="connsiteX48" fmla="*/ 2829850 w 3160170"/>
                    <a:gd name="connsiteY48" fmla="*/ 113424 h 921264"/>
                    <a:gd name="connsiteX49" fmla="*/ 2791750 w 3160170"/>
                    <a:gd name="connsiteY49" fmla="*/ 65799 h 921264"/>
                    <a:gd name="connsiteX50" fmla="*/ 2763175 w 3160170"/>
                    <a:gd name="connsiteY50" fmla="*/ 37224 h 921264"/>
                    <a:gd name="connsiteX51" fmla="*/ 2725075 w 3160170"/>
                    <a:gd name="connsiteY51" fmla="*/ 24524 h 921264"/>
                    <a:gd name="connsiteX52" fmla="*/ 2664750 w 3160170"/>
                    <a:gd name="connsiteY52" fmla="*/ 14999 h 921264"/>
                    <a:gd name="connsiteX53" fmla="*/ 2598075 w 3160170"/>
                    <a:gd name="connsiteY53" fmla="*/ 8649 h 921264"/>
                    <a:gd name="connsiteX54" fmla="*/ 2546308 w 3160170"/>
                    <a:gd name="connsiteY54" fmla="*/ 90 h 921264"/>
                    <a:gd name="connsiteX55" fmla="*/ 2518148 w 3160170"/>
                    <a:gd name="connsiteY55" fmla="*/ 14446 h 921264"/>
                    <a:gd name="connsiteX56" fmla="*/ 2480600 w 3160170"/>
                    <a:gd name="connsiteY56" fmla="*/ 49924 h 921264"/>
                    <a:gd name="connsiteX57" fmla="*/ 2461550 w 3160170"/>
                    <a:gd name="connsiteY57" fmla="*/ 84849 h 921264"/>
                    <a:gd name="connsiteX58" fmla="*/ 2455200 w 3160170"/>
                    <a:gd name="connsiteY58" fmla="*/ 116599 h 921264"/>
                    <a:gd name="connsiteX59" fmla="*/ 2463068 w 3160170"/>
                    <a:gd name="connsiteY59" fmla="*/ 140205 h 921264"/>
                    <a:gd name="connsiteX60" fmla="*/ 2486122 w 3160170"/>
                    <a:gd name="connsiteY60" fmla="*/ 154423 h 921264"/>
                    <a:gd name="connsiteX61" fmla="*/ 2515525 w 3160170"/>
                    <a:gd name="connsiteY61" fmla="*/ 164224 h 921264"/>
                    <a:gd name="connsiteX62" fmla="*/ 2531400 w 3160170"/>
                    <a:gd name="connsiteY62" fmla="*/ 164224 h 921264"/>
                    <a:gd name="connsiteX63" fmla="*/ 2559975 w 3160170"/>
                    <a:gd name="connsiteY63" fmla="*/ 164638 h 921264"/>
                    <a:gd name="connsiteX64" fmla="*/ 2569500 w 3160170"/>
                    <a:gd name="connsiteY64" fmla="*/ 167399 h 921264"/>
                    <a:gd name="connsiteX65" fmla="*/ 2601250 w 3160170"/>
                    <a:gd name="connsiteY65" fmla="*/ 170574 h 921264"/>
                    <a:gd name="connsiteX66" fmla="*/ 2629825 w 3160170"/>
                    <a:gd name="connsiteY66" fmla="*/ 161049 h 921264"/>
                    <a:gd name="connsiteX67" fmla="*/ 2664750 w 3160170"/>
                    <a:gd name="connsiteY67" fmla="*/ 173749 h 921264"/>
                    <a:gd name="connsiteX68" fmla="*/ 2693325 w 3160170"/>
                    <a:gd name="connsiteY68" fmla="*/ 180099 h 921264"/>
                    <a:gd name="connsiteX69" fmla="*/ 2721900 w 3160170"/>
                    <a:gd name="connsiteY69" fmla="*/ 215024 h 921264"/>
                    <a:gd name="connsiteX70" fmla="*/ 2763175 w 3160170"/>
                    <a:gd name="connsiteY70" fmla="*/ 284874 h 921264"/>
                    <a:gd name="connsiteX71" fmla="*/ 2779050 w 3160170"/>
                    <a:gd name="connsiteY71" fmla="*/ 319799 h 921264"/>
                    <a:gd name="connsiteX72" fmla="*/ 2791750 w 3160170"/>
                    <a:gd name="connsiteY72" fmla="*/ 361074 h 921264"/>
                    <a:gd name="connsiteX73" fmla="*/ 2804450 w 3160170"/>
                    <a:gd name="connsiteY73" fmla="*/ 399174 h 921264"/>
                    <a:gd name="connsiteX74" fmla="*/ 2807625 w 3160170"/>
                    <a:gd name="connsiteY74" fmla="*/ 418224 h 921264"/>
                    <a:gd name="connsiteX75" fmla="*/ 2807625 w 3160170"/>
                    <a:gd name="connsiteY75" fmla="*/ 440449 h 921264"/>
                    <a:gd name="connsiteX76" fmla="*/ 2810800 w 3160170"/>
                    <a:gd name="connsiteY76" fmla="*/ 475374 h 921264"/>
                    <a:gd name="connsiteX77" fmla="*/ 2813975 w 3160170"/>
                    <a:gd name="connsiteY77" fmla="*/ 503949 h 921264"/>
                    <a:gd name="connsiteX78" fmla="*/ 2817150 w 3160170"/>
                    <a:gd name="connsiteY78" fmla="*/ 529349 h 921264"/>
                    <a:gd name="connsiteX79" fmla="*/ 2817150 w 3160170"/>
                    <a:gd name="connsiteY79" fmla="*/ 557924 h 921264"/>
                    <a:gd name="connsiteX80" fmla="*/ 2813975 w 3160170"/>
                    <a:gd name="connsiteY80" fmla="*/ 570624 h 921264"/>
                    <a:gd name="connsiteX81" fmla="*/ 2807625 w 3160170"/>
                    <a:gd name="connsiteY81" fmla="*/ 583324 h 921264"/>
                    <a:gd name="connsiteX82" fmla="*/ 2798100 w 3160170"/>
                    <a:gd name="connsiteY82" fmla="*/ 602374 h 921264"/>
                    <a:gd name="connsiteX83" fmla="*/ 2794925 w 3160170"/>
                    <a:gd name="connsiteY83" fmla="*/ 618249 h 921264"/>
                    <a:gd name="connsiteX84" fmla="*/ 2794925 w 3160170"/>
                    <a:gd name="connsiteY84" fmla="*/ 634124 h 921264"/>
                    <a:gd name="connsiteX85" fmla="*/ 2798100 w 3160170"/>
                    <a:gd name="connsiteY85" fmla="*/ 646824 h 921264"/>
                    <a:gd name="connsiteX86" fmla="*/ 2798100 w 3160170"/>
                    <a:gd name="connsiteY86" fmla="*/ 646824 h 921264"/>
                    <a:gd name="connsiteX87" fmla="*/ 2747300 w 3160170"/>
                    <a:gd name="connsiteY87" fmla="*/ 665874 h 921264"/>
                    <a:gd name="connsiteX88" fmla="*/ 2696500 w 3160170"/>
                    <a:gd name="connsiteY88" fmla="*/ 675399 h 921264"/>
                    <a:gd name="connsiteX89" fmla="*/ 2648875 w 3160170"/>
                    <a:gd name="connsiteY89" fmla="*/ 681749 h 921264"/>
                    <a:gd name="connsiteX90" fmla="*/ 2623475 w 3160170"/>
                    <a:gd name="connsiteY90" fmla="*/ 681749 h 921264"/>
                    <a:gd name="connsiteX91" fmla="*/ 2585375 w 3160170"/>
                    <a:gd name="connsiteY91" fmla="*/ 681749 h 921264"/>
                    <a:gd name="connsiteX92" fmla="*/ 2547275 w 3160170"/>
                    <a:gd name="connsiteY92" fmla="*/ 678574 h 921264"/>
                    <a:gd name="connsiteX93" fmla="*/ 2531400 w 3160170"/>
                    <a:gd name="connsiteY93" fmla="*/ 681749 h 921264"/>
                    <a:gd name="connsiteX94" fmla="*/ 2506000 w 3160170"/>
                    <a:gd name="connsiteY94" fmla="*/ 694449 h 921264"/>
                    <a:gd name="connsiteX95" fmla="*/ 2483775 w 3160170"/>
                    <a:gd name="connsiteY95" fmla="*/ 703974 h 921264"/>
                    <a:gd name="connsiteX96" fmla="*/ 2439325 w 3160170"/>
                    <a:gd name="connsiteY96" fmla="*/ 713499 h 921264"/>
                    <a:gd name="connsiteX97" fmla="*/ 2394875 w 3160170"/>
                    <a:gd name="connsiteY97" fmla="*/ 723024 h 921264"/>
                    <a:gd name="connsiteX98" fmla="*/ 2347250 w 3160170"/>
                    <a:gd name="connsiteY98" fmla="*/ 729374 h 921264"/>
                    <a:gd name="connsiteX99" fmla="*/ 2315500 w 3160170"/>
                    <a:gd name="connsiteY99" fmla="*/ 716674 h 921264"/>
                    <a:gd name="connsiteX100" fmla="*/ 2252000 w 3160170"/>
                    <a:gd name="connsiteY100" fmla="*/ 703974 h 921264"/>
                    <a:gd name="connsiteX101" fmla="*/ 2213900 w 3160170"/>
                    <a:gd name="connsiteY101" fmla="*/ 697624 h 921264"/>
                    <a:gd name="connsiteX102" fmla="*/ 2172625 w 3160170"/>
                    <a:gd name="connsiteY102" fmla="*/ 691274 h 921264"/>
                    <a:gd name="connsiteX103" fmla="*/ 2115475 w 3160170"/>
                    <a:gd name="connsiteY103" fmla="*/ 681749 h 921264"/>
                    <a:gd name="connsiteX104" fmla="*/ 2077375 w 3160170"/>
                    <a:gd name="connsiteY104" fmla="*/ 675399 h 921264"/>
                    <a:gd name="connsiteX105" fmla="*/ 2029750 w 3160170"/>
                    <a:gd name="connsiteY105" fmla="*/ 665874 h 921264"/>
                    <a:gd name="connsiteX106" fmla="*/ 1915450 w 3160170"/>
                    <a:gd name="connsiteY106" fmla="*/ 659524 h 921264"/>
                    <a:gd name="connsiteX107" fmla="*/ 1855125 w 3160170"/>
                    <a:gd name="connsiteY107" fmla="*/ 662699 h 921264"/>
                    <a:gd name="connsiteX108" fmla="*/ 1769400 w 3160170"/>
                    <a:gd name="connsiteY108" fmla="*/ 665874 h 921264"/>
                    <a:gd name="connsiteX109" fmla="*/ 1731300 w 3160170"/>
                    <a:gd name="connsiteY109" fmla="*/ 672224 h 921264"/>
                    <a:gd name="connsiteX110" fmla="*/ 1686850 w 3160170"/>
                    <a:gd name="connsiteY110" fmla="*/ 694449 h 921264"/>
                    <a:gd name="connsiteX111" fmla="*/ 1629700 w 3160170"/>
                    <a:gd name="connsiteY111" fmla="*/ 716674 h 921264"/>
                    <a:gd name="connsiteX112" fmla="*/ 1585250 w 3160170"/>
                    <a:gd name="connsiteY112" fmla="*/ 738899 h 921264"/>
                    <a:gd name="connsiteX113" fmla="*/ 1528100 w 3160170"/>
                    <a:gd name="connsiteY113" fmla="*/ 754774 h 921264"/>
                    <a:gd name="connsiteX114" fmla="*/ 1496350 w 3160170"/>
                    <a:gd name="connsiteY114" fmla="*/ 773824 h 921264"/>
                    <a:gd name="connsiteX115" fmla="*/ 1470950 w 3160170"/>
                    <a:gd name="connsiteY115" fmla="*/ 780174 h 921264"/>
                    <a:gd name="connsiteX116" fmla="*/ 1426500 w 3160170"/>
                    <a:gd name="connsiteY116" fmla="*/ 799224 h 921264"/>
                    <a:gd name="connsiteX117" fmla="*/ 1353475 w 3160170"/>
                    <a:gd name="connsiteY117" fmla="*/ 776999 h 921264"/>
                    <a:gd name="connsiteX118" fmla="*/ 1242350 w 3160170"/>
                    <a:gd name="connsiteY118" fmla="*/ 751599 h 921264"/>
                    <a:gd name="connsiteX119" fmla="*/ 1169325 w 3160170"/>
                    <a:gd name="connsiteY119" fmla="*/ 735724 h 921264"/>
                    <a:gd name="connsiteX120" fmla="*/ 1029625 w 3160170"/>
                    <a:gd name="connsiteY120" fmla="*/ 703974 h 921264"/>
                    <a:gd name="connsiteX121" fmla="*/ 959775 w 3160170"/>
                    <a:gd name="connsiteY121" fmla="*/ 700799 h 921264"/>
                    <a:gd name="connsiteX122" fmla="*/ 867700 w 3160170"/>
                    <a:gd name="connsiteY122" fmla="*/ 697624 h 921264"/>
                    <a:gd name="connsiteX123" fmla="*/ 813725 w 3160170"/>
                    <a:gd name="connsiteY123" fmla="*/ 700799 h 921264"/>
                    <a:gd name="connsiteX124" fmla="*/ 775625 w 3160170"/>
                    <a:gd name="connsiteY124" fmla="*/ 713499 h 921264"/>
                    <a:gd name="connsiteX125" fmla="*/ 712125 w 3160170"/>
                    <a:gd name="connsiteY125" fmla="*/ 726199 h 921264"/>
                    <a:gd name="connsiteX126" fmla="*/ 677200 w 3160170"/>
                    <a:gd name="connsiteY126" fmla="*/ 738899 h 921264"/>
                    <a:gd name="connsiteX127" fmla="*/ 547025 w 3160170"/>
                    <a:gd name="connsiteY127" fmla="*/ 732549 h 921264"/>
                    <a:gd name="connsiteX128" fmla="*/ 515275 w 3160170"/>
                    <a:gd name="connsiteY128" fmla="*/ 732549 h 921264"/>
                    <a:gd name="connsiteX129" fmla="*/ 400975 w 3160170"/>
                    <a:gd name="connsiteY129" fmla="*/ 719849 h 921264"/>
                    <a:gd name="connsiteX130" fmla="*/ 366050 w 3160170"/>
                    <a:gd name="connsiteY130" fmla="*/ 723024 h 921264"/>
                    <a:gd name="connsiteX131" fmla="*/ 319172 w 3160170"/>
                    <a:gd name="connsiteY131" fmla="*/ 728066 h 921264"/>
                    <a:gd name="connsiteX132" fmla="*/ 232700 w 3160170"/>
                    <a:gd name="connsiteY132" fmla="*/ 716674 h 921264"/>
                    <a:gd name="connsiteX133" fmla="*/ 213650 w 3160170"/>
                    <a:gd name="connsiteY133" fmla="*/ 716674 h 921264"/>
                    <a:gd name="connsiteX134" fmla="*/ 146975 w 3160170"/>
                    <a:gd name="connsiteY134" fmla="*/ 716674 h 921264"/>
                    <a:gd name="connsiteX135" fmla="*/ 131100 w 3160170"/>
                    <a:gd name="connsiteY135" fmla="*/ 719849 h 921264"/>
                    <a:gd name="connsiteX136" fmla="*/ 99350 w 3160170"/>
                    <a:gd name="connsiteY136" fmla="*/ 732549 h 921264"/>
                    <a:gd name="connsiteX137" fmla="*/ 70775 w 3160170"/>
                    <a:gd name="connsiteY137" fmla="*/ 742074 h 921264"/>
                    <a:gd name="connsiteX138" fmla="*/ 17214 w 3160170"/>
                    <a:gd name="connsiteY138" fmla="*/ 751737 h 921264"/>
                    <a:gd name="connsiteX139" fmla="*/ 787 w 3160170"/>
                    <a:gd name="connsiteY139" fmla="*/ 786110 h 921264"/>
                    <a:gd name="connsiteX140" fmla="*/ 37782 w 3160170"/>
                    <a:gd name="connsiteY140" fmla="*/ 842293 h 921264"/>
                    <a:gd name="connsiteX141" fmla="*/ 80438 w 3160170"/>
                    <a:gd name="connsiteY141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52100 w 3160170"/>
                    <a:gd name="connsiteY42" fmla="*/ 316624 h 921264"/>
                    <a:gd name="connsiteX43" fmla="*/ 2985840 w 3160170"/>
                    <a:gd name="connsiteY43" fmla="*/ 271484 h 921264"/>
                    <a:gd name="connsiteX44" fmla="*/ 2936557 w 3160170"/>
                    <a:gd name="connsiteY44" fmla="*/ 220822 h 921264"/>
                    <a:gd name="connsiteX45" fmla="*/ 2871125 w 3160170"/>
                    <a:gd name="connsiteY45" fmla="*/ 161049 h 921264"/>
                    <a:gd name="connsiteX46" fmla="*/ 2855250 w 3160170"/>
                    <a:gd name="connsiteY46" fmla="*/ 148349 h 921264"/>
                    <a:gd name="connsiteX47" fmla="*/ 2829850 w 3160170"/>
                    <a:gd name="connsiteY47" fmla="*/ 113424 h 921264"/>
                    <a:gd name="connsiteX48" fmla="*/ 2791750 w 3160170"/>
                    <a:gd name="connsiteY48" fmla="*/ 65799 h 921264"/>
                    <a:gd name="connsiteX49" fmla="*/ 2763175 w 3160170"/>
                    <a:gd name="connsiteY49" fmla="*/ 37224 h 921264"/>
                    <a:gd name="connsiteX50" fmla="*/ 2725075 w 3160170"/>
                    <a:gd name="connsiteY50" fmla="*/ 24524 h 921264"/>
                    <a:gd name="connsiteX51" fmla="*/ 2664750 w 3160170"/>
                    <a:gd name="connsiteY51" fmla="*/ 14999 h 921264"/>
                    <a:gd name="connsiteX52" fmla="*/ 2598075 w 3160170"/>
                    <a:gd name="connsiteY52" fmla="*/ 8649 h 921264"/>
                    <a:gd name="connsiteX53" fmla="*/ 2546308 w 3160170"/>
                    <a:gd name="connsiteY53" fmla="*/ 90 h 921264"/>
                    <a:gd name="connsiteX54" fmla="*/ 2518148 w 3160170"/>
                    <a:gd name="connsiteY54" fmla="*/ 14446 h 921264"/>
                    <a:gd name="connsiteX55" fmla="*/ 2480600 w 3160170"/>
                    <a:gd name="connsiteY55" fmla="*/ 49924 h 921264"/>
                    <a:gd name="connsiteX56" fmla="*/ 2461550 w 3160170"/>
                    <a:gd name="connsiteY56" fmla="*/ 84849 h 921264"/>
                    <a:gd name="connsiteX57" fmla="*/ 2455200 w 3160170"/>
                    <a:gd name="connsiteY57" fmla="*/ 116599 h 921264"/>
                    <a:gd name="connsiteX58" fmla="*/ 2463068 w 3160170"/>
                    <a:gd name="connsiteY58" fmla="*/ 140205 h 921264"/>
                    <a:gd name="connsiteX59" fmla="*/ 2486122 w 3160170"/>
                    <a:gd name="connsiteY59" fmla="*/ 154423 h 921264"/>
                    <a:gd name="connsiteX60" fmla="*/ 2515525 w 3160170"/>
                    <a:gd name="connsiteY60" fmla="*/ 164224 h 921264"/>
                    <a:gd name="connsiteX61" fmla="*/ 2531400 w 3160170"/>
                    <a:gd name="connsiteY61" fmla="*/ 164224 h 921264"/>
                    <a:gd name="connsiteX62" fmla="*/ 2559975 w 3160170"/>
                    <a:gd name="connsiteY62" fmla="*/ 164638 h 921264"/>
                    <a:gd name="connsiteX63" fmla="*/ 2569500 w 3160170"/>
                    <a:gd name="connsiteY63" fmla="*/ 167399 h 921264"/>
                    <a:gd name="connsiteX64" fmla="*/ 2601250 w 3160170"/>
                    <a:gd name="connsiteY64" fmla="*/ 170574 h 921264"/>
                    <a:gd name="connsiteX65" fmla="*/ 2629825 w 3160170"/>
                    <a:gd name="connsiteY65" fmla="*/ 161049 h 921264"/>
                    <a:gd name="connsiteX66" fmla="*/ 2664750 w 3160170"/>
                    <a:gd name="connsiteY66" fmla="*/ 173749 h 921264"/>
                    <a:gd name="connsiteX67" fmla="*/ 2693325 w 3160170"/>
                    <a:gd name="connsiteY67" fmla="*/ 180099 h 921264"/>
                    <a:gd name="connsiteX68" fmla="*/ 2721900 w 3160170"/>
                    <a:gd name="connsiteY68" fmla="*/ 215024 h 921264"/>
                    <a:gd name="connsiteX69" fmla="*/ 2763175 w 3160170"/>
                    <a:gd name="connsiteY69" fmla="*/ 284874 h 921264"/>
                    <a:gd name="connsiteX70" fmla="*/ 2779050 w 3160170"/>
                    <a:gd name="connsiteY70" fmla="*/ 319799 h 921264"/>
                    <a:gd name="connsiteX71" fmla="*/ 2791750 w 3160170"/>
                    <a:gd name="connsiteY71" fmla="*/ 361074 h 921264"/>
                    <a:gd name="connsiteX72" fmla="*/ 2804450 w 3160170"/>
                    <a:gd name="connsiteY72" fmla="*/ 399174 h 921264"/>
                    <a:gd name="connsiteX73" fmla="*/ 2807625 w 3160170"/>
                    <a:gd name="connsiteY73" fmla="*/ 418224 h 921264"/>
                    <a:gd name="connsiteX74" fmla="*/ 2807625 w 3160170"/>
                    <a:gd name="connsiteY74" fmla="*/ 440449 h 921264"/>
                    <a:gd name="connsiteX75" fmla="*/ 2810800 w 3160170"/>
                    <a:gd name="connsiteY75" fmla="*/ 475374 h 921264"/>
                    <a:gd name="connsiteX76" fmla="*/ 2813975 w 3160170"/>
                    <a:gd name="connsiteY76" fmla="*/ 503949 h 921264"/>
                    <a:gd name="connsiteX77" fmla="*/ 2817150 w 3160170"/>
                    <a:gd name="connsiteY77" fmla="*/ 529349 h 921264"/>
                    <a:gd name="connsiteX78" fmla="*/ 2817150 w 3160170"/>
                    <a:gd name="connsiteY78" fmla="*/ 557924 h 921264"/>
                    <a:gd name="connsiteX79" fmla="*/ 2813975 w 3160170"/>
                    <a:gd name="connsiteY79" fmla="*/ 570624 h 921264"/>
                    <a:gd name="connsiteX80" fmla="*/ 2807625 w 3160170"/>
                    <a:gd name="connsiteY80" fmla="*/ 583324 h 921264"/>
                    <a:gd name="connsiteX81" fmla="*/ 2798100 w 3160170"/>
                    <a:gd name="connsiteY81" fmla="*/ 602374 h 921264"/>
                    <a:gd name="connsiteX82" fmla="*/ 2794925 w 3160170"/>
                    <a:gd name="connsiteY82" fmla="*/ 618249 h 921264"/>
                    <a:gd name="connsiteX83" fmla="*/ 2794925 w 3160170"/>
                    <a:gd name="connsiteY83" fmla="*/ 634124 h 921264"/>
                    <a:gd name="connsiteX84" fmla="*/ 2798100 w 3160170"/>
                    <a:gd name="connsiteY84" fmla="*/ 646824 h 921264"/>
                    <a:gd name="connsiteX85" fmla="*/ 2798100 w 3160170"/>
                    <a:gd name="connsiteY85" fmla="*/ 646824 h 921264"/>
                    <a:gd name="connsiteX86" fmla="*/ 2747300 w 3160170"/>
                    <a:gd name="connsiteY86" fmla="*/ 665874 h 921264"/>
                    <a:gd name="connsiteX87" fmla="*/ 2696500 w 3160170"/>
                    <a:gd name="connsiteY87" fmla="*/ 675399 h 921264"/>
                    <a:gd name="connsiteX88" fmla="*/ 2648875 w 3160170"/>
                    <a:gd name="connsiteY88" fmla="*/ 681749 h 921264"/>
                    <a:gd name="connsiteX89" fmla="*/ 2623475 w 3160170"/>
                    <a:gd name="connsiteY89" fmla="*/ 681749 h 921264"/>
                    <a:gd name="connsiteX90" fmla="*/ 2585375 w 3160170"/>
                    <a:gd name="connsiteY90" fmla="*/ 681749 h 921264"/>
                    <a:gd name="connsiteX91" fmla="*/ 2547275 w 3160170"/>
                    <a:gd name="connsiteY91" fmla="*/ 678574 h 921264"/>
                    <a:gd name="connsiteX92" fmla="*/ 2531400 w 3160170"/>
                    <a:gd name="connsiteY92" fmla="*/ 681749 h 921264"/>
                    <a:gd name="connsiteX93" fmla="*/ 2506000 w 3160170"/>
                    <a:gd name="connsiteY93" fmla="*/ 694449 h 921264"/>
                    <a:gd name="connsiteX94" fmla="*/ 2483775 w 3160170"/>
                    <a:gd name="connsiteY94" fmla="*/ 703974 h 921264"/>
                    <a:gd name="connsiteX95" fmla="*/ 2439325 w 3160170"/>
                    <a:gd name="connsiteY95" fmla="*/ 713499 h 921264"/>
                    <a:gd name="connsiteX96" fmla="*/ 2394875 w 3160170"/>
                    <a:gd name="connsiteY96" fmla="*/ 723024 h 921264"/>
                    <a:gd name="connsiteX97" fmla="*/ 2347250 w 3160170"/>
                    <a:gd name="connsiteY97" fmla="*/ 729374 h 921264"/>
                    <a:gd name="connsiteX98" fmla="*/ 2315500 w 3160170"/>
                    <a:gd name="connsiteY98" fmla="*/ 716674 h 921264"/>
                    <a:gd name="connsiteX99" fmla="*/ 2252000 w 3160170"/>
                    <a:gd name="connsiteY99" fmla="*/ 703974 h 921264"/>
                    <a:gd name="connsiteX100" fmla="*/ 2213900 w 3160170"/>
                    <a:gd name="connsiteY100" fmla="*/ 697624 h 921264"/>
                    <a:gd name="connsiteX101" fmla="*/ 2172625 w 3160170"/>
                    <a:gd name="connsiteY101" fmla="*/ 691274 h 921264"/>
                    <a:gd name="connsiteX102" fmla="*/ 2115475 w 3160170"/>
                    <a:gd name="connsiteY102" fmla="*/ 681749 h 921264"/>
                    <a:gd name="connsiteX103" fmla="*/ 2077375 w 3160170"/>
                    <a:gd name="connsiteY103" fmla="*/ 675399 h 921264"/>
                    <a:gd name="connsiteX104" fmla="*/ 2029750 w 3160170"/>
                    <a:gd name="connsiteY104" fmla="*/ 665874 h 921264"/>
                    <a:gd name="connsiteX105" fmla="*/ 1915450 w 3160170"/>
                    <a:gd name="connsiteY105" fmla="*/ 659524 h 921264"/>
                    <a:gd name="connsiteX106" fmla="*/ 1855125 w 3160170"/>
                    <a:gd name="connsiteY106" fmla="*/ 662699 h 921264"/>
                    <a:gd name="connsiteX107" fmla="*/ 1769400 w 3160170"/>
                    <a:gd name="connsiteY107" fmla="*/ 665874 h 921264"/>
                    <a:gd name="connsiteX108" fmla="*/ 1731300 w 3160170"/>
                    <a:gd name="connsiteY108" fmla="*/ 672224 h 921264"/>
                    <a:gd name="connsiteX109" fmla="*/ 1686850 w 3160170"/>
                    <a:gd name="connsiteY109" fmla="*/ 694449 h 921264"/>
                    <a:gd name="connsiteX110" fmla="*/ 1629700 w 3160170"/>
                    <a:gd name="connsiteY110" fmla="*/ 716674 h 921264"/>
                    <a:gd name="connsiteX111" fmla="*/ 1585250 w 3160170"/>
                    <a:gd name="connsiteY111" fmla="*/ 738899 h 921264"/>
                    <a:gd name="connsiteX112" fmla="*/ 1528100 w 3160170"/>
                    <a:gd name="connsiteY112" fmla="*/ 754774 h 921264"/>
                    <a:gd name="connsiteX113" fmla="*/ 1496350 w 3160170"/>
                    <a:gd name="connsiteY113" fmla="*/ 773824 h 921264"/>
                    <a:gd name="connsiteX114" fmla="*/ 1470950 w 3160170"/>
                    <a:gd name="connsiteY114" fmla="*/ 780174 h 921264"/>
                    <a:gd name="connsiteX115" fmla="*/ 1426500 w 3160170"/>
                    <a:gd name="connsiteY115" fmla="*/ 799224 h 921264"/>
                    <a:gd name="connsiteX116" fmla="*/ 1353475 w 3160170"/>
                    <a:gd name="connsiteY116" fmla="*/ 776999 h 921264"/>
                    <a:gd name="connsiteX117" fmla="*/ 1242350 w 3160170"/>
                    <a:gd name="connsiteY117" fmla="*/ 751599 h 921264"/>
                    <a:gd name="connsiteX118" fmla="*/ 1169325 w 3160170"/>
                    <a:gd name="connsiteY118" fmla="*/ 735724 h 921264"/>
                    <a:gd name="connsiteX119" fmla="*/ 1029625 w 3160170"/>
                    <a:gd name="connsiteY119" fmla="*/ 703974 h 921264"/>
                    <a:gd name="connsiteX120" fmla="*/ 959775 w 3160170"/>
                    <a:gd name="connsiteY120" fmla="*/ 700799 h 921264"/>
                    <a:gd name="connsiteX121" fmla="*/ 867700 w 3160170"/>
                    <a:gd name="connsiteY121" fmla="*/ 697624 h 921264"/>
                    <a:gd name="connsiteX122" fmla="*/ 813725 w 3160170"/>
                    <a:gd name="connsiteY122" fmla="*/ 700799 h 921264"/>
                    <a:gd name="connsiteX123" fmla="*/ 775625 w 3160170"/>
                    <a:gd name="connsiteY123" fmla="*/ 713499 h 921264"/>
                    <a:gd name="connsiteX124" fmla="*/ 712125 w 3160170"/>
                    <a:gd name="connsiteY124" fmla="*/ 726199 h 921264"/>
                    <a:gd name="connsiteX125" fmla="*/ 677200 w 3160170"/>
                    <a:gd name="connsiteY125" fmla="*/ 738899 h 921264"/>
                    <a:gd name="connsiteX126" fmla="*/ 547025 w 3160170"/>
                    <a:gd name="connsiteY126" fmla="*/ 732549 h 921264"/>
                    <a:gd name="connsiteX127" fmla="*/ 515275 w 3160170"/>
                    <a:gd name="connsiteY127" fmla="*/ 732549 h 921264"/>
                    <a:gd name="connsiteX128" fmla="*/ 400975 w 3160170"/>
                    <a:gd name="connsiteY128" fmla="*/ 719849 h 921264"/>
                    <a:gd name="connsiteX129" fmla="*/ 366050 w 3160170"/>
                    <a:gd name="connsiteY129" fmla="*/ 723024 h 921264"/>
                    <a:gd name="connsiteX130" fmla="*/ 319172 w 3160170"/>
                    <a:gd name="connsiteY130" fmla="*/ 728066 h 921264"/>
                    <a:gd name="connsiteX131" fmla="*/ 232700 w 3160170"/>
                    <a:gd name="connsiteY131" fmla="*/ 716674 h 921264"/>
                    <a:gd name="connsiteX132" fmla="*/ 213650 w 3160170"/>
                    <a:gd name="connsiteY132" fmla="*/ 716674 h 921264"/>
                    <a:gd name="connsiteX133" fmla="*/ 146975 w 3160170"/>
                    <a:gd name="connsiteY133" fmla="*/ 716674 h 921264"/>
                    <a:gd name="connsiteX134" fmla="*/ 131100 w 3160170"/>
                    <a:gd name="connsiteY134" fmla="*/ 719849 h 921264"/>
                    <a:gd name="connsiteX135" fmla="*/ 99350 w 3160170"/>
                    <a:gd name="connsiteY135" fmla="*/ 732549 h 921264"/>
                    <a:gd name="connsiteX136" fmla="*/ 70775 w 3160170"/>
                    <a:gd name="connsiteY136" fmla="*/ 742074 h 921264"/>
                    <a:gd name="connsiteX137" fmla="*/ 17214 w 3160170"/>
                    <a:gd name="connsiteY137" fmla="*/ 751737 h 921264"/>
                    <a:gd name="connsiteX138" fmla="*/ 787 w 3160170"/>
                    <a:gd name="connsiteY138" fmla="*/ 786110 h 921264"/>
                    <a:gd name="connsiteX139" fmla="*/ 37782 w 3160170"/>
                    <a:gd name="connsiteY139" fmla="*/ 842293 h 921264"/>
                    <a:gd name="connsiteX140" fmla="*/ 80438 w 3160170"/>
                    <a:gd name="connsiteY140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22965 w 3160170"/>
                    <a:gd name="connsiteY42" fmla="*/ 289730 h 921264"/>
                    <a:gd name="connsiteX43" fmla="*/ 2985840 w 3160170"/>
                    <a:gd name="connsiteY43" fmla="*/ 271484 h 921264"/>
                    <a:gd name="connsiteX44" fmla="*/ 2936557 w 3160170"/>
                    <a:gd name="connsiteY44" fmla="*/ 220822 h 921264"/>
                    <a:gd name="connsiteX45" fmla="*/ 2871125 w 3160170"/>
                    <a:gd name="connsiteY45" fmla="*/ 161049 h 921264"/>
                    <a:gd name="connsiteX46" fmla="*/ 2855250 w 3160170"/>
                    <a:gd name="connsiteY46" fmla="*/ 148349 h 921264"/>
                    <a:gd name="connsiteX47" fmla="*/ 2829850 w 3160170"/>
                    <a:gd name="connsiteY47" fmla="*/ 113424 h 921264"/>
                    <a:gd name="connsiteX48" fmla="*/ 2791750 w 3160170"/>
                    <a:gd name="connsiteY48" fmla="*/ 65799 h 921264"/>
                    <a:gd name="connsiteX49" fmla="*/ 2763175 w 3160170"/>
                    <a:gd name="connsiteY49" fmla="*/ 37224 h 921264"/>
                    <a:gd name="connsiteX50" fmla="*/ 2725075 w 3160170"/>
                    <a:gd name="connsiteY50" fmla="*/ 24524 h 921264"/>
                    <a:gd name="connsiteX51" fmla="*/ 2664750 w 3160170"/>
                    <a:gd name="connsiteY51" fmla="*/ 14999 h 921264"/>
                    <a:gd name="connsiteX52" fmla="*/ 2598075 w 3160170"/>
                    <a:gd name="connsiteY52" fmla="*/ 8649 h 921264"/>
                    <a:gd name="connsiteX53" fmla="*/ 2546308 w 3160170"/>
                    <a:gd name="connsiteY53" fmla="*/ 90 h 921264"/>
                    <a:gd name="connsiteX54" fmla="*/ 2518148 w 3160170"/>
                    <a:gd name="connsiteY54" fmla="*/ 14446 h 921264"/>
                    <a:gd name="connsiteX55" fmla="*/ 2480600 w 3160170"/>
                    <a:gd name="connsiteY55" fmla="*/ 49924 h 921264"/>
                    <a:gd name="connsiteX56" fmla="*/ 2461550 w 3160170"/>
                    <a:gd name="connsiteY56" fmla="*/ 84849 h 921264"/>
                    <a:gd name="connsiteX57" fmla="*/ 2455200 w 3160170"/>
                    <a:gd name="connsiteY57" fmla="*/ 116599 h 921264"/>
                    <a:gd name="connsiteX58" fmla="*/ 2463068 w 3160170"/>
                    <a:gd name="connsiteY58" fmla="*/ 140205 h 921264"/>
                    <a:gd name="connsiteX59" fmla="*/ 2486122 w 3160170"/>
                    <a:gd name="connsiteY59" fmla="*/ 154423 h 921264"/>
                    <a:gd name="connsiteX60" fmla="*/ 2515525 w 3160170"/>
                    <a:gd name="connsiteY60" fmla="*/ 164224 h 921264"/>
                    <a:gd name="connsiteX61" fmla="*/ 2531400 w 3160170"/>
                    <a:gd name="connsiteY61" fmla="*/ 164224 h 921264"/>
                    <a:gd name="connsiteX62" fmla="*/ 2559975 w 3160170"/>
                    <a:gd name="connsiteY62" fmla="*/ 164638 h 921264"/>
                    <a:gd name="connsiteX63" fmla="*/ 2569500 w 3160170"/>
                    <a:gd name="connsiteY63" fmla="*/ 167399 h 921264"/>
                    <a:gd name="connsiteX64" fmla="*/ 2601250 w 3160170"/>
                    <a:gd name="connsiteY64" fmla="*/ 170574 h 921264"/>
                    <a:gd name="connsiteX65" fmla="*/ 2629825 w 3160170"/>
                    <a:gd name="connsiteY65" fmla="*/ 161049 h 921264"/>
                    <a:gd name="connsiteX66" fmla="*/ 2664750 w 3160170"/>
                    <a:gd name="connsiteY66" fmla="*/ 173749 h 921264"/>
                    <a:gd name="connsiteX67" fmla="*/ 2693325 w 3160170"/>
                    <a:gd name="connsiteY67" fmla="*/ 180099 h 921264"/>
                    <a:gd name="connsiteX68" fmla="*/ 2721900 w 3160170"/>
                    <a:gd name="connsiteY68" fmla="*/ 215024 h 921264"/>
                    <a:gd name="connsiteX69" fmla="*/ 2763175 w 3160170"/>
                    <a:gd name="connsiteY69" fmla="*/ 284874 h 921264"/>
                    <a:gd name="connsiteX70" fmla="*/ 2779050 w 3160170"/>
                    <a:gd name="connsiteY70" fmla="*/ 319799 h 921264"/>
                    <a:gd name="connsiteX71" fmla="*/ 2791750 w 3160170"/>
                    <a:gd name="connsiteY71" fmla="*/ 361074 h 921264"/>
                    <a:gd name="connsiteX72" fmla="*/ 2804450 w 3160170"/>
                    <a:gd name="connsiteY72" fmla="*/ 399174 h 921264"/>
                    <a:gd name="connsiteX73" fmla="*/ 2807625 w 3160170"/>
                    <a:gd name="connsiteY73" fmla="*/ 418224 h 921264"/>
                    <a:gd name="connsiteX74" fmla="*/ 2807625 w 3160170"/>
                    <a:gd name="connsiteY74" fmla="*/ 440449 h 921264"/>
                    <a:gd name="connsiteX75" fmla="*/ 2810800 w 3160170"/>
                    <a:gd name="connsiteY75" fmla="*/ 475374 h 921264"/>
                    <a:gd name="connsiteX76" fmla="*/ 2813975 w 3160170"/>
                    <a:gd name="connsiteY76" fmla="*/ 503949 h 921264"/>
                    <a:gd name="connsiteX77" fmla="*/ 2817150 w 3160170"/>
                    <a:gd name="connsiteY77" fmla="*/ 529349 h 921264"/>
                    <a:gd name="connsiteX78" fmla="*/ 2817150 w 3160170"/>
                    <a:gd name="connsiteY78" fmla="*/ 557924 h 921264"/>
                    <a:gd name="connsiteX79" fmla="*/ 2813975 w 3160170"/>
                    <a:gd name="connsiteY79" fmla="*/ 570624 h 921264"/>
                    <a:gd name="connsiteX80" fmla="*/ 2807625 w 3160170"/>
                    <a:gd name="connsiteY80" fmla="*/ 583324 h 921264"/>
                    <a:gd name="connsiteX81" fmla="*/ 2798100 w 3160170"/>
                    <a:gd name="connsiteY81" fmla="*/ 602374 h 921264"/>
                    <a:gd name="connsiteX82" fmla="*/ 2794925 w 3160170"/>
                    <a:gd name="connsiteY82" fmla="*/ 618249 h 921264"/>
                    <a:gd name="connsiteX83" fmla="*/ 2794925 w 3160170"/>
                    <a:gd name="connsiteY83" fmla="*/ 634124 h 921264"/>
                    <a:gd name="connsiteX84" fmla="*/ 2798100 w 3160170"/>
                    <a:gd name="connsiteY84" fmla="*/ 646824 h 921264"/>
                    <a:gd name="connsiteX85" fmla="*/ 2798100 w 3160170"/>
                    <a:gd name="connsiteY85" fmla="*/ 646824 h 921264"/>
                    <a:gd name="connsiteX86" fmla="*/ 2747300 w 3160170"/>
                    <a:gd name="connsiteY86" fmla="*/ 665874 h 921264"/>
                    <a:gd name="connsiteX87" fmla="*/ 2696500 w 3160170"/>
                    <a:gd name="connsiteY87" fmla="*/ 675399 h 921264"/>
                    <a:gd name="connsiteX88" fmla="*/ 2648875 w 3160170"/>
                    <a:gd name="connsiteY88" fmla="*/ 681749 h 921264"/>
                    <a:gd name="connsiteX89" fmla="*/ 2623475 w 3160170"/>
                    <a:gd name="connsiteY89" fmla="*/ 681749 h 921264"/>
                    <a:gd name="connsiteX90" fmla="*/ 2585375 w 3160170"/>
                    <a:gd name="connsiteY90" fmla="*/ 681749 h 921264"/>
                    <a:gd name="connsiteX91" fmla="*/ 2547275 w 3160170"/>
                    <a:gd name="connsiteY91" fmla="*/ 678574 h 921264"/>
                    <a:gd name="connsiteX92" fmla="*/ 2531400 w 3160170"/>
                    <a:gd name="connsiteY92" fmla="*/ 681749 h 921264"/>
                    <a:gd name="connsiteX93" fmla="*/ 2506000 w 3160170"/>
                    <a:gd name="connsiteY93" fmla="*/ 694449 h 921264"/>
                    <a:gd name="connsiteX94" fmla="*/ 2483775 w 3160170"/>
                    <a:gd name="connsiteY94" fmla="*/ 703974 h 921264"/>
                    <a:gd name="connsiteX95" fmla="*/ 2439325 w 3160170"/>
                    <a:gd name="connsiteY95" fmla="*/ 713499 h 921264"/>
                    <a:gd name="connsiteX96" fmla="*/ 2394875 w 3160170"/>
                    <a:gd name="connsiteY96" fmla="*/ 723024 h 921264"/>
                    <a:gd name="connsiteX97" fmla="*/ 2347250 w 3160170"/>
                    <a:gd name="connsiteY97" fmla="*/ 729374 h 921264"/>
                    <a:gd name="connsiteX98" fmla="*/ 2315500 w 3160170"/>
                    <a:gd name="connsiteY98" fmla="*/ 716674 h 921264"/>
                    <a:gd name="connsiteX99" fmla="*/ 2252000 w 3160170"/>
                    <a:gd name="connsiteY99" fmla="*/ 703974 h 921264"/>
                    <a:gd name="connsiteX100" fmla="*/ 2213900 w 3160170"/>
                    <a:gd name="connsiteY100" fmla="*/ 697624 h 921264"/>
                    <a:gd name="connsiteX101" fmla="*/ 2172625 w 3160170"/>
                    <a:gd name="connsiteY101" fmla="*/ 691274 h 921264"/>
                    <a:gd name="connsiteX102" fmla="*/ 2115475 w 3160170"/>
                    <a:gd name="connsiteY102" fmla="*/ 681749 h 921264"/>
                    <a:gd name="connsiteX103" fmla="*/ 2077375 w 3160170"/>
                    <a:gd name="connsiteY103" fmla="*/ 675399 h 921264"/>
                    <a:gd name="connsiteX104" fmla="*/ 2029750 w 3160170"/>
                    <a:gd name="connsiteY104" fmla="*/ 665874 h 921264"/>
                    <a:gd name="connsiteX105" fmla="*/ 1915450 w 3160170"/>
                    <a:gd name="connsiteY105" fmla="*/ 659524 h 921264"/>
                    <a:gd name="connsiteX106" fmla="*/ 1855125 w 3160170"/>
                    <a:gd name="connsiteY106" fmla="*/ 662699 h 921264"/>
                    <a:gd name="connsiteX107" fmla="*/ 1769400 w 3160170"/>
                    <a:gd name="connsiteY107" fmla="*/ 665874 h 921264"/>
                    <a:gd name="connsiteX108" fmla="*/ 1731300 w 3160170"/>
                    <a:gd name="connsiteY108" fmla="*/ 672224 h 921264"/>
                    <a:gd name="connsiteX109" fmla="*/ 1686850 w 3160170"/>
                    <a:gd name="connsiteY109" fmla="*/ 694449 h 921264"/>
                    <a:gd name="connsiteX110" fmla="*/ 1629700 w 3160170"/>
                    <a:gd name="connsiteY110" fmla="*/ 716674 h 921264"/>
                    <a:gd name="connsiteX111" fmla="*/ 1585250 w 3160170"/>
                    <a:gd name="connsiteY111" fmla="*/ 738899 h 921264"/>
                    <a:gd name="connsiteX112" fmla="*/ 1528100 w 3160170"/>
                    <a:gd name="connsiteY112" fmla="*/ 754774 h 921264"/>
                    <a:gd name="connsiteX113" fmla="*/ 1496350 w 3160170"/>
                    <a:gd name="connsiteY113" fmla="*/ 773824 h 921264"/>
                    <a:gd name="connsiteX114" fmla="*/ 1470950 w 3160170"/>
                    <a:gd name="connsiteY114" fmla="*/ 780174 h 921264"/>
                    <a:gd name="connsiteX115" fmla="*/ 1426500 w 3160170"/>
                    <a:gd name="connsiteY115" fmla="*/ 799224 h 921264"/>
                    <a:gd name="connsiteX116" fmla="*/ 1353475 w 3160170"/>
                    <a:gd name="connsiteY116" fmla="*/ 776999 h 921264"/>
                    <a:gd name="connsiteX117" fmla="*/ 1242350 w 3160170"/>
                    <a:gd name="connsiteY117" fmla="*/ 751599 h 921264"/>
                    <a:gd name="connsiteX118" fmla="*/ 1169325 w 3160170"/>
                    <a:gd name="connsiteY118" fmla="*/ 735724 h 921264"/>
                    <a:gd name="connsiteX119" fmla="*/ 1029625 w 3160170"/>
                    <a:gd name="connsiteY119" fmla="*/ 703974 h 921264"/>
                    <a:gd name="connsiteX120" fmla="*/ 959775 w 3160170"/>
                    <a:gd name="connsiteY120" fmla="*/ 700799 h 921264"/>
                    <a:gd name="connsiteX121" fmla="*/ 867700 w 3160170"/>
                    <a:gd name="connsiteY121" fmla="*/ 697624 h 921264"/>
                    <a:gd name="connsiteX122" fmla="*/ 813725 w 3160170"/>
                    <a:gd name="connsiteY122" fmla="*/ 700799 h 921264"/>
                    <a:gd name="connsiteX123" fmla="*/ 775625 w 3160170"/>
                    <a:gd name="connsiteY123" fmla="*/ 713499 h 921264"/>
                    <a:gd name="connsiteX124" fmla="*/ 712125 w 3160170"/>
                    <a:gd name="connsiteY124" fmla="*/ 726199 h 921264"/>
                    <a:gd name="connsiteX125" fmla="*/ 677200 w 3160170"/>
                    <a:gd name="connsiteY125" fmla="*/ 738899 h 921264"/>
                    <a:gd name="connsiteX126" fmla="*/ 547025 w 3160170"/>
                    <a:gd name="connsiteY126" fmla="*/ 732549 h 921264"/>
                    <a:gd name="connsiteX127" fmla="*/ 515275 w 3160170"/>
                    <a:gd name="connsiteY127" fmla="*/ 732549 h 921264"/>
                    <a:gd name="connsiteX128" fmla="*/ 400975 w 3160170"/>
                    <a:gd name="connsiteY128" fmla="*/ 719849 h 921264"/>
                    <a:gd name="connsiteX129" fmla="*/ 366050 w 3160170"/>
                    <a:gd name="connsiteY129" fmla="*/ 723024 h 921264"/>
                    <a:gd name="connsiteX130" fmla="*/ 319172 w 3160170"/>
                    <a:gd name="connsiteY130" fmla="*/ 728066 h 921264"/>
                    <a:gd name="connsiteX131" fmla="*/ 232700 w 3160170"/>
                    <a:gd name="connsiteY131" fmla="*/ 716674 h 921264"/>
                    <a:gd name="connsiteX132" fmla="*/ 213650 w 3160170"/>
                    <a:gd name="connsiteY132" fmla="*/ 716674 h 921264"/>
                    <a:gd name="connsiteX133" fmla="*/ 146975 w 3160170"/>
                    <a:gd name="connsiteY133" fmla="*/ 716674 h 921264"/>
                    <a:gd name="connsiteX134" fmla="*/ 131100 w 3160170"/>
                    <a:gd name="connsiteY134" fmla="*/ 719849 h 921264"/>
                    <a:gd name="connsiteX135" fmla="*/ 99350 w 3160170"/>
                    <a:gd name="connsiteY135" fmla="*/ 732549 h 921264"/>
                    <a:gd name="connsiteX136" fmla="*/ 70775 w 3160170"/>
                    <a:gd name="connsiteY136" fmla="*/ 742074 h 921264"/>
                    <a:gd name="connsiteX137" fmla="*/ 17214 w 3160170"/>
                    <a:gd name="connsiteY137" fmla="*/ 751737 h 921264"/>
                    <a:gd name="connsiteX138" fmla="*/ 787 w 3160170"/>
                    <a:gd name="connsiteY138" fmla="*/ 786110 h 921264"/>
                    <a:gd name="connsiteX139" fmla="*/ 37782 w 3160170"/>
                    <a:gd name="connsiteY139" fmla="*/ 842293 h 921264"/>
                    <a:gd name="connsiteX140" fmla="*/ 80438 w 3160170"/>
                    <a:gd name="connsiteY140" fmla="*/ 864518 h 921264"/>
                    <a:gd name="connsiteX0" fmla="*/ 73950 w 3160170"/>
                    <a:gd name="connsiteY0" fmla="*/ 865899 h 921264"/>
                    <a:gd name="connsiteX1" fmla="*/ 204125 w 3160170"/>
                    <a:gd name="connsiteY1" fmla="*/ 843674 h 921264"/>
                    <a:gd name="connsiteX2" fmla="*/ 327950 w 3160170"/>
                    <a:gd name="connsiteY2" fmla="*/ 834149 h 921264"/>
                    <a:gd name="connsiteX3" fmla="*/ 448600 w 3160170"/>
                    <a:gd name="connsiteY3" fmla="*/ 875424 h 921264"/>
                    <a:gd name="connsiteX4" fmla="*/ 521625 w 3160170"/>
                    <a:gd name="connsiteY4" fmla="*/ 878599 h 921264"/>
                    <a:gd name="connsiteX5" fmla="*/ 632750 w 3160170"/>
                    <a:gd name="connsiteY5" fmla="*/ 869074 h 921264"/>
                    <a:gd name="connsiteX6" fmla="*/ 712125 w 3160170"/>
                    <a:gd name="connsiteY6" fmla="*/ 846849 h 921264"/>
                    <a:gd name="connsiteX7" fmla="*/ 804200 w 3160170"/>
                    <a:gd name="connsiteY7" fmla="*/ 827799 h 921264"/>
                    <a:gd name="connsiteX8" fmla="*/ 959775 w 3160170"/>
                    <a:gd name="connsiteY8" fmla="*/ 821449 h 921264"/>
                    <a:gd name="connsiteX9" fmla="*/ 1156625 w 3160170"/>
                    <a:gd name="connsiteY9" fmla="*/ 846849 h 921264"/>
                    <a:gd name="connsiteX10" fmla="*/ 1343950 w 3160170"/>
                    <a:gd name="connsiteY10" fmla="*/ 913524 h 921264"/>
                    <a:gd name="connsiteX11" fmla="*/ 1477300 w 3160170"/>
                    <a:gd name="connsiteY11" fmla="*/ 916699 h 921264"/>
                    <a:gd name="connsiteX12" fmla="*/ 1636050 w 3160170"/>
                    <a:gd name="connsiteY12" fmla="*/ 884949 h 921264"/>
                    <a:gd name="connsiteX13" fmla="*/ 1728125 w 3160170"/>
                    <a:gd name="connsiteY13" fmla="*/ 853199 h 921264"/>
                    <a:gd name="connsiteX14" fmla="*/ 1772575 w 3160170"/>
                    <a:gd name="connsiteY14" fmla="*/ 827799 h 921264"/>
                    <a:gd name="connsiteX15" fmla="*/ 1836075 w 3160170"/>
                    <a:gd name="connsiteY15" fmla="*/ 802399 h 921264"/>
                    <a:gd name="connsiteX16" fmla="*/ 1890050 w 3160170"/>
                    <a:gd name="connsiteY16" fmla="*/ 805574 h 921264"/>
                    <a:gd name="connsiteX17" fmla="*/ 2039275 w 3160170"/>
                    <a:gd name="connsiteY17" fmla="*/ 827799 h 921264"/>
                    <a:gd name="connsiteX18" fmla="*/ 2140875 w 3160170"/>
                    <a:gd name="connsiteY18" fmla="*/ 830974 h 921264"/>
                    <a:gd name="connsiteX19" fmla="*/ 2245650 w 3160170"/>
                    <a:gd name="connsiteY19" fmla="*/ 850024 h 921264"/>
                    <a:gd name="connsiteX20" fmla="*/ 2350425 w 3160170"/>
                    <a:gd name="connsiteY20" fmla="*/ 881774 h 921264"/>
                    <a:gd name="connsiteX21" fmla="*/ 2480600 w 3160170"/>
                    <a:gd name="connsiteY21" fmla="*/ 869074 h 921264"/>
                    <a:gd name="connsiteX22" fmla="*/ 2575850 w 3160170"/>
                    <a:gd name="connsiteY22" fmla="*/ 846849 h 921264"/>
                    <a:gd name="connsiteX23" fmla="*/ 2623475 w 3160170"/>
                    <a:gd name="connsiteY23" fmla="*/ 824624 h 921264"/>
                    <a:gd name="connsiteX24" fmla="*/ 2693325 w 3160170"/>
                    <a:gd name="connsiteY24" fmla="*/ 827799 h 921264"/>
                    <a:gd name="connsiteX25" fmla="*/ 2750475 w 3160170"/>
                    <a:gd name="connsiteY25" fmla="*/ 815099 h 921264"/>
                    <a:gd name="connsiteX26" fmla="*/ 2798100 w 3160170"/>
                    <a:gd name="connsiteY26" fmla="*/ 796049 h 921264"/>
                    <a:gd name="connsiteX27" fmla="*/ 2820325 w 3160170"/>
                    <a:gd name="connsiteY27" fmla="*/ 780174 h 921264"/>
                    <a:gd name="connsiteX28" fmla="*/ 2855250 w 3160170"/>
                    <a:gd name="connsiteY28" fmla="*/ 796049 h 921264"/>
                    <a:gd name="connsiteX29" fmla="*/ 2893350 w 3160170"/>
                    <a:gd name="connsiteY29" fmla="*/ 830974 h 921264"/>
                    <a:gd name="connsiteX30" fmla="*/ 2972725 w 3160170"/>
                    <a:gd name="connsiteY30" fmla="*/ 856374 h 921264"/>
                    <a:gd name="connsiteX31" fmla="*/ 3048925 w 3160170"/>
                    <a:gd name="connsiteY31" fmla="*/ 850024 h 921264"/>
                    <a:gd name="connsiteX32" fmla="*/ 3109250 w 3160170"/>
                    <a:gd name="connsiteY32" fmla="*/ 808749 h 921264"/>
                    <a:gd name="connsiteX33" fmla="*/ 3125125 w 3160170"/>
                    <a:gd name="connsiteY33" fmla="*/ 770649 h 921264"/>
                    <a:gd name="connsiteX34" fmla="*/ 3153700 w 3160170"/>
                    <a:gd name="connsiteY34" fmla="*/ 703974 h 921264"/>
                    <a:gd name="connsiteX35" fmla="*/ 3160050 w 3160170"/>
                    <a:gd name="connsiteY35" fmla="*/ 637299 h 921264"/>
                    <a:gd name="connsiteX36" fmla="*/ 3150525 w 3160170"/>
                    <a:gd name="connsiteY36" fmla="*/ 592849 h 921264"/>
                    <a:gd name="connsiteX37" fmla="*/ 3125125 w 3160170"/>
                    <a:gd name="connsiteY37" fmla="*/ 548399 h 921264"/>
                    <a:gd name="connsiteX38" fmla="*/ 3112425 w 3160170"/>
                    <a:gd name="connsiteY38" fmla="*/ 494424 h 921264"/>
                    <a:gd name="connsiteX39" fmla="*/ 3102900 w 3160170"/>
                    <a:gd name="connsiteY39" fmla="*/ 434099 h 921264"/>
                    <a:gd name="connsiteX40" fmla="*/ 3093375 w 3160170"/>
                    <a:gd name="connsiteY40" fmla="*/ 383299 h 921264"/>
                    <a:gd name="connsiteX41" fmla="*/ 3061625 w 3160170"/>
                    <a:gd name="connsiteY41" fmla="*/ 319799 h 921264"/>
                    <a:gd name="connsiteX42" fmla="*/ 3022965 w 3160170"/>
                    <a:gd name="connsiteY42" fmla="*/ 289730 h 921264"/>
                    <a:gd name="connsiteX43" fmla="*/ 2967910 w 3160170"/>
                    <a:gd name="connsiteY43" fmla="*/ 249072 h 921264"/>
                    <a:gd name="connsiteX44" fmla="*/ 2936557 w 3160170"/>
                    <a:gd name="connsiteY44" fmla="*/ 220822 h 921264"/>
                    <a:gd name="connsiteX45" fmla="*/ 2871125 w 3160170"/>
                    <a:gd name="connsiteY45" fmla="*/ 161049 h 921264"/>
                    <a:gd name="connsiteX46" fmla="*/ 2855250 w 3160170"/>
                    <a:gd name="connsiteY46" fmla="*/ 148349 h 921264"/>
                    <a:gd name="connsiteX47" fmla="*/ 2829850 w 3160170"/>
                    <a:gd name="connsiteY47" fmla="*/ 113424 h 921264"/>
                    <a:gd name="connsiteX48" fmla="*/ 2791750 w 3160170"/>
                    <a:gd name="connsiteY48" fmla="*/ 65799 h 921264"/>
                    <a:gd name="connsiteX49" fmla="*/ 2763175 w 3160170"/>
                    <a:gd name="connsiteY49" fmla="*/ 37224 h 921264"/>
                    <a:gd name="connsiteX50" fmla="*/ 2725075 w 3160170"/>
                    <a:gd name="connsiteY50" fmla="*/ 24524 h 921264"/>
                    <a:gd name="connsiteX51" fmla="*/ 2664750 w 3160170"/>
                    <a:gd name="connsiteY51" fmla="*/ 14999 h 921264"/>
                    <a:gd name="connsiteX52" fmla="*/ 2598075 w 3160170"/>
                    <a:gd name="connsiteY52" fmla="*/ 8649 h 921264"/>
                    <a:gd name="connsiteX53" fmla="*/ 2546308 w 3160170"/>
                    <a:gd name="connsiteY53" fmla="*/ 90 h 921264"/>
                    <a:gd name="connsiteX54" fmla="*/ 2518148 w 3160170"/>
                    <a:gd name="connsiteY54" fmla="*/ 14446 h 921264"/>
                    <a:gd name="connsiteX55" fmla="*/ 2480600 w 3160170"/>
                    <a:gd name="connsiteY55" fmla="*/ 49924 h 921264"/>
                    <a:gd name="connsiteX56" fmla="*/ 2461550 w 3160170"/>
                    <a:gd name="connsiteY56" fmla="*/ 84849 h 921264"/>
                    <a:gd name="connsiteX57" fmla="*/ 2455200 w 3160170"/>
                    <a:gd name="connsiteY57" fmla="*/ 116599 h 921264"/>
                    <a:gd name="connsiteX58" fmla="*/ 2463068 w 3160170"/>
                    <a:gd name="connsiteY58" fmla="*/ 140205 h 921264"/>
                    <a:gd name="connsiteX59" fmla="*/ 2486122 w 3160170"/>
                    <a:gd name="connsiteY59" fmla="*/ 154423 h 921264"/>
                    <a:gd name="connsiteX60" fmla="*/ 2515525 w 3160170"/>
                    <a:gd name="connsiteY60" fmla="*/ 164224 h 921264"/>
                    <a:gd name="connsiteX61" fmla="*/ 2531400 w 3160170"/>
                    <a:gd name="connsiteY61" fmla="*/ 164224 h 921264"/>
                    <a:gd name="connsiteX62" fmla="*/ 2559975 w 3160170"/>
                    <a:gd name="connsiteY62" fmla="*/ 164638 h 921264"/>
                    <a:gd name="connsiteX63" fmla="*/ 2569500 w 3160170"/>
                    <a:gd name="connsiteY63" fmla="*/ 167399 h 921264"/>
                    <a:gd name="connsiteX64" fmla="*/ 2601250 w 3160170"/>
                    <a:gd name="connsiteY64" fmla="*/ 170574 h 921264"/>
                    <a:gd name="connsiteX65" fmla="*/ 2629825 w 3160170"/>
                    <a:gd name="connsiteY65" fmla="*/ 161049 h 921264"/>
                    <a:gd name="connsiteX66" fmla="*/ 2664750 w 3160170"/>
                    <a:gd name="connsiteY66" fmla="*/ 173749 h 921264"/>
                    <a:gd name="connsiteX67" fmla="*/ 2693325 w 3160170"/>
                    <a:gd name="connsiteY67" fmla="*/ 180099 h 921264"/>
                    <a:gd name="connsiteX68" fmla="*/ 2721900 w 3160170"/>
                    <a:gd name="connsiteY68" fmla="*/ 215024 h 921264"/>
                    <a:gd name="connsiteX69" fmla="*/ 2763175 w 3160170"/>
                    <a:gd name="connsiteY69" fmla="*/ 284874 h 921264"/>
                    <a:gd name="connsiteX70" fmla="*/ 2779050 w 3160170"/>
                    <a:gd name="connsiteY70" fmla="*/ 319799 h 921264"/>
                    <a:gd name="connsiteX71" fmla="*/ 2791750 w 3160170"/>
                    <a:gd name="connsiteY71" fmla="*/ 361074 h 921264"/>
                    <a:gd name="connsiteX72" fmla="*/ 2804450 w 3160170"/>
                    <a:gd name="connsiteY72" fmla="*/ 399174 h 921264"/>
                    <a:gd name="connsiteX73" fmla="*/ 2807625 w 3160170"/>
                    <a:gd name="connsiteY73" fmla="*/ 418224 h 921264"/>
                    <a:gd name="connsiteX74" fmla="*/ 2807625 w 3160170"/>
                    <a:gd name="connsiteY74" fmla="*/ 440449 h 921264"/>
                    <a:gd name="connsiteX75" fmla="*/ 2810800 w 3160170"/>
                    <a:gd name="connsiteY75" fmla="*/ 475374 h 921264"/>
                    <a:gd name="connsiteX76" fmla="*/ 2813975 w 3160170"/>
                    <a:gd name="connsiteY76" fmla="*/ 503949 h 921264"/>
                    <a:gd name="connsiteX77" fmla="*/ 2817150 w 3160170"/>
                    <a:gd name="connsiteY77" fmla="*/ 529349 h 921264"/>
                    <a:gd name="connsiteX78" fmla="*/ 2817150 w 3160170"/>
                    <a:gd name="connsiteY78" fmla="*/ 557924 h 921264"/>
                    <a:gd name="connsiteX79" fmla="*/ 2813975 w 3160170"/>
                    <a:gd name="connsiteY79" fmla="*/ 570624 h 921264"/>
                    <a:gd name="connsiteX80" fmla="*/ 2807625 w 3160170"/>
                    <a:gd name="connsiteY80" fmla="*/ 583324 h 921264"/>
                    <a:gd name="connsiteX81" fmla="*/ 2798100 w 3160170"/>
                    <a:gd name="connsiteY81" fmla="*/ 602374 h 921264"/>
                    <a:gd name="connsiteX82" fmla="*/ 2794925 w 3160170"/>
                    <a:gd name="connsiteY82" fmla="*/ 618249 h 921264"/>
                    <a:gd name="connsiteX83" fmla="*/ 2794925 w 3160170"/>
                    <a:gd name="connsiteY83" fmla="*/ 634124 h 921264"/>
                    <a:gd name="connsiteX84" fmla="*/ 2798100 w 3160170"/>
                    <a:gd name="connsiteY84" fmla="*/ 646824 h 921264"/>
                    <a:gd name="connsiteX85" fmla="*/ 2798100 w 3160170"/>
                    <a:gd name="connsiteY85" fmla="*/ 646824 h 921264"/>
                    <a:gd name="connsiteX86" fmla="*/ 2747300 w 3160170"/>
                    <a:gd name="connsiteY86" fmla="*/ 665874 h 921264"/>
                    <a:gd name="connsiteX87" fmla="*/ 2696500 w 3160170"/>
                    <a:gd name="connsiteY87" fmla="*/ 675399 h 921264"/>
                    <a:gd name="connsiteX88" fmla="*/ 2648875 w 3160170"/>
                    <a:gd name="connsiteY88" fmla="*/ 681749 h 921264"/>
                    <a:gd name="connsiteX89" fmla="*/ 2623475 w 3160170"/>
                    <a:gd name="connsiteY89" fmla="*/ 681749 h 921264"/>
                    <a:gd name="connsiteX90" fmla="*/ 2585375 w 3160170"/>
                    <a:gd name="connsiteY90" fmla="*/ 681749 h 921264"/>
                    <a:gd name="connsiteX91" fmla="*/ 2547275 w 3160170"/>
                    <a:gd name="connsiteY91" fmla="*/ 678574 h 921264"/>
                    <a:gd name="connsiteX92" fmla="*/ 2531400 w 3160170"/>
                    <a:gd name="connsiteY92" fmla="*/ 681749 h 921264"/>
                    <a:gd name="connsiteX93" fmla="*/ 2506000 w 3160170"/>
                    <a:gd name="connsiteY93" fmla="*/ 694449 h 921264"/>
                    <a:gd name="connsiteX94" fmla="*/ 2483775 w 3160170"/>
                    <a:gd name="connsiteY94" fmla="*/ 703974 h 921264"/>
                    <a:gd name="connsiteX95" fmla="*/ 2439325 w 3160170"/>
                    <a:gd name="connsiteY95" fmla="*/ 713499 h 921264"/>
                    <a:gd name="connsiteX96" fmla="*/ 2394875 w 3160170"/>
                    <a:gd name="connsiteY96" fmla="*/ 723024 h 921264"/>
                    <a:gd name="connsiteX97" fmla="*/ 2347250 w 3160170"/>
                    <a:gd name="connsiteY97" fmla="*/ 729374 h 921264"/>
                    <a:gd name="connsiteX98" fmla="*/ 2315500 w 3160170"/>
                    <a:gd name="connsiteY98" fmla="*/ 716674 h 921264"/>
                    <a:gd name="connsiteX99" fmla="*/ 2252000 w 3160170"/>
                    <a:gd name="connsiteY99" fmla="*/ 703974 h 921264"/>
                    <a:gd name="connsiteX100" fmla="*/ 2213900 w 3160170"/>
                    <a:gd name="connsiteY100" fmla="*/ 697624 h 921264"/>
                    <a:gd name="connsiteX101" fmla="*/ 2172625 w 3160170"/>
                    <a:gd name="connsiteY101" fmla="*/ 691274 h 921264"/>
                    <a:gd name="connsiteX102" fmla="*/ 2115475 w 3160170"/>
                    <a:gd name="connsiteY102" fmla="*/ 681749 h 921264"/>
                    <a:gd name="connsiteX103" fmla="*/ 2077375 w 3160170"/>
                    <a:gd name="connsiteY103" fmla="*/ 675399 h 921264"/>
                    <a:gd name="connsiteX104" fmla="*/ 2029750 w 3160170"/>
                    <a:gd name="connsiteY104" fmla="*/ 665874 h 921264"/>
                    <a:gd name="connsiteX105" fmla="*/ 1915450 w 3160170"/>
                    <a:gd name="connsiteY105" fmla="*/ 659524 h 921264"/>
                    <a:gd name="connsiteX106" fmla="*/ 1855125 w 3160170"/>
                    <a:gd name="connsiteY106" fmla="*/ 662699 h 921264"/>
                    <a:gd name="connsiteX107" fmla="*/ 1769400 w 3160170"/>
                    <a:gd name="connsiteY107" fmla="*/ 665874 h 921264"/>
                    <a:gd name="connsiteX108" fmla="*/ 1731300 w 3160170"/>
                    <a:gd name="connsiteY108" fmla="*/ 672224 h 921264"/>
                    <a:gd name="connsiteX109" fmla="*/ 1686850 w 3160170"/>
                    <a:gd name="connsiteY109" fmla="*/ 694449 h 921264"/>
                    <a:gd name="connsiteX110" fmla="*/ 1629700 w 3160170"/>
                    <a:gd name="connsiteY110" fmla="*/ 716674 h 921264"/>
                    <a:gd name="connsiteX111" fmla="*/ 1585250 w 3160170"/>
                    <a:gd name="connsiteY111" fmla="*/ 738899 h 921264"/>
                    <a:gd name="connsiteX112" fmla="*/ 1528100 w 3160170"/>
                    <a:gd name="connsiteY112" fmla="*/ 754774 h 921264"/>
                    <a:gd name="connsiteX113" fmla="*/ 1496350 w 3160170"/>
                    <a:gd name="connsiteY113" fmla="*/ 773824 h 921264"/>
                    <a:gd name="connsiteX114" fmla="*/ 1470950 w 3160170"/>
                    <a:gd name="connsiteY114" fmla="*/ 780174 h 921264"/>
                    <a:gd name="connsiteX115" fmla="*/ 1426500 w 3160170"/>
                    <a:gd name="connsiteY115" fmla="*/ 799224 h 921264"/>
                    <a:gd name="connsiteX116" fmla="*/ 1353475 w 3160170"/>
                    <a:gd name="connsiteY116" fmla="*/ 776999 h 921264"/>
                    <a:gd name="connsiteX117" fmla="*/ 1242350 w 3160170"/>
                    <a:gd name="connsiteY117" fmla="*/ 751599 h 921264"/>
                    <a:gd name="connsiteX118" fmla="*/ 1169325 w 3160170"/>
                    <a:gd name="connsiteY118" fmla="*/ 735724 h 921264"/>
                    <a:gd name="connsiteX119" fmla="*/ 1029625 w 3160170"/>
                    <a:gd name="connsiteY119" fmla="*/ 703974 h 921264"/>
                    <a:gd name="connsiteX120" fmla="*/ 959775 w 3160170"/>
                    <a:gd name="connsiteY120" fmla="*/ 700799 h 921264"/>
                    <a:gd name="connsiteX121" fmla="*/ 867700 w 3160170"/>
                    <a:gd name="connsiteY121" fmla="*/ 697624 h 921264"/>
                    <a:gd name="connsiteX122" fmla="*/ 813725 w 3160170"/>
                    <a:gd name="connsiteY122" fmla="*/ 700799 h 921264"/>
                    <a:gd name="connsiteX123" fmla="*/ 775625 w 3160170"/>
                    <a:gd name="connsiteY123" fmla="*/ 713499 h 921264"/>
                    <a:gd name="connsiteX124" fmla="*/ 712125 w 3160170"/>
                    <a:gd name="connsiteY124" fmla="*/ 726199 h 921264"/>
                    <a:gd name="connsiteX125" fmla="*/ 677200 w 3160170"/>
                    <a:gd name="connsiteY125" fmla="*/ 738899 h 921264"/>
                    <a:gd name="connsiteX126" fmla="*/ 547025 w 3160170"/>
                    <a:gd name="connsiteY126" fmla="*/ 732549 h 921264"/>
                    <a:gd name="connsiteX127" fmla="*/ 515275 w 3160170"/>
                    <a:gd name="connsiteY127" fmla="*/ 732549 h 921264"/>
                    <a:gd name="connsiteX128" fmla="*/ 400975 w 3160170"/>
                    <a:gd name="connsiteY128" fmla="*/ 719849 h 921264"/>
                    <a:gd name="connsiteX129" fmla="*/ 366050 w 3160170"/>
                    <a:gd name="connsiteY129" fmla="*/ 723024 h 921264"/>
                    <a:gd name="connsiteX130" fmla="*/ 319172 w 3160170"/>
                    <a:gd name="connsiteY130" fmla="*/ 728066 h 921264"/>
                    <a:gd name="connsiteX131" fmla="*/ 232700 w 3160170"/>
                    <a:gd name="connsiteY131" fmla="*/ 716674 h 921264"/>
                    <a:gd name="connsiteX132" fmla="*/ 213650 w 3160170"/>
                    <a:gd name="connsiteY132" fmla="*/ 716674 h 921264"/>
                    <a:gd name="connsiteX133" fmla="*/ 146975 w 3160170"/>
                    <a:gd name="connsiteY133" fmla="*/ 716674 h 921264"/>
                    <a:gd name="connsiteX134" fmla="*/ 131100 w 3160170"/>
                    <a:gd name="connsiteY134" fmla="*/ 719849 h 921264"/>
                    <a:gd name="connsiteX135" fmla="*/ 99350 w 3160170"/>
                    <a:gd name="connsiteY135" fmla="*/ 732549 h 921264"/>
                    <a:gd name="connsiteX136" fmla="*/ 70775 w 3160170"/>
                    <a:gd name="connsiteY136" fmla="*/ 742074 h 921264"/>
                    <a:gd name="connsiteX137" fmla="*/ 17214 w 3160170"/>
                    <a:gd name="connsiteY137" fmla="*/ 751737 h 921264"/>
                    <a:gd name="connsiteX138" fmla="*/ 787 w 3160170"/>
                    <a:gd name="connsiteY138" fmla="*/ 786110 h 921264"/>
                    <a:gd name="connsiteX139" fmla="*/ 37782 w 3160170"/>
                    <a:gd name="connsiteY139" fmla="*/ 842293 h 921264"/>
                    <a:gd name="connsiteX140" fmla="*/ 80438 w 3160170"/>
                    <a:gd name="connsiteY140" fmla="*/ 864518 h 921264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93375 w 3160170"/>
                    <a:gd name="connsiteY40" fmla="*/ 384212 h 922177"/>
                    <a:gd name="connsiteX41" fmla="*/ 3061625 w 3160170"/>
                    <a:gd name="connsiteY41" fmla="*/ 320712 h 922177"/>
                    <a:gd name="connsiteX42" fmla="*/ 3022965 w 3160170"/>
                    <a:gd name="connsiteY42" fmla="*/ 290643 h 922177"/>
                    <a:gd name="connsiteX43" fmla="*/ 2967910 w 3160170"/>
                    <a:gd name="connsiteY43" fmla="*/ 249985 h 922177"/>
                    <a:gd name="connsiteX44" fmla="*/ 2936557 w 3160170"/>
                    <a:gd name="connsiteY44" fmla="*/ 221735 h 922177"/>
                    <a:gd name="connsiteX45" fmla="*/ 2871125 w 3160170"/>
                    <a:gd name="connsiteY45" fmla="*/ 161962 h 922177"/>
                    <a:gd name="connsiteX46" fmla="*/ 2855250 w 3160170"/>
                    <a:gd name="connsiteY46" fmla="*/ 149262 h 922177"/>
                    <a:gd name="connsiteX47" fmla="*/ 2829850 w 3160170"/>
                    <a:gd name="connsiteY47" fmla="*/ 114337 h 922177"/>
                    <a:gd name="connsiteX48" fmla="*/ 2791750 w 3160170"/>
                    <a:gd name="connsiteY48" fmla="*/ 66712 h 922177"/>
                    <a:gd name="connsiteX49" fmla="*/ 2763175 w 3160170"/>
                    <a:gd name="connsiteY49" fmla="*/ 38137 h 922177"/>
                    <a:gd name="connsiteX50" fmla="*/ 2725075 w 3160170"/>
                    <a:gd name="connsiteY50" fmla="*/ 25437 h 922177"/>
                    <a:gd name="connsiteX51" fmla="*/ 2664750 w 3160170"/>
                    <a:gd name="connsiteY51" fmla="*/ 15912 h 922177"/>
                    <a:gd name="connsiteX52" fmla="*/ 2600316 w 3160170"/>
                    <a:gd name="connsiteY52" fmla="*/ 2839 h 922177"/>
                    <a:gd name="connsiteX53" fmla="*/ 2546308 w 3160170"/>
                    <a:gd name="connsiteY53" fmla="*/ 1003 h 922177"/>
                    <a:gd name="connsiteX54" fmla="*/ 2518148 w 3160170"/>
                    <a:gd name="connsiteY54" fmla="*/ 15359 h 922177"/>
                    <a:gd name="connsiteX55" fmla="*/ 2480600 w 3160170"/>
                    <a:gd name="connsiteY55" fmla="*/ 50837 h 922177"/>
                    <a:gd name="connsiteX56" fmla="*/ 2461550 w 3160170"/>
                    <a:gd name="connsiteY56" fmla="*/ 85762 h 922177"/>
                    <a:gd name="connsiteX57" fmla="*/ 2455200 w 3160170"/>
                    <a:gd name="connsiteY57" fmla="*/ 117512 h 922177"/>
                    <a:gd name="connsiteX58" fmla="*/ 2463068 w 3160170"/>
                    <a:gd name="connsiteY58" fmla="*/ 141118 h 922177"/>
                    <a:gd name="connsiteX59" fmla="*/ 2486122 w 3160170"/>
                    <a:gd name="connsiteY59" fmla="*/ 155336 h 922177"/>
                    <a:gd name="connsiteX60" fmla="*/ 2515525 w 3160170"/>
                    <a:gd name="connsiteY60" fmla="*/ 165137 h 922177"/>
                    <a:gd name="connsiteX61" fmla="*/ 2531400 w 3160170"/>
                    <a:gd name="connsiteY61" fmla="*/ 165137 h 922177"/>
                    <a:gd name="connsiteX62" fmla="*/ 2559975 w 3160170"/>
                    <a:gd name="connsiteY62" fmla="*/ 165551 h 922177"/>
                    <a:gd name="connsiteX63" fmla="*/ 2569500 w 3160170"/>
                    <a:gd name="connsiteY63" fmla="*/ 168312 h 922177"/>
                    <a:gd name="connsiteX64" fmla="*/ 2601250 w 3160170"/>
                    <a:gd name="connsiteY64" fmla="*/ 171487 h 922177"/>
                    <a:gd name="connsiteX65" fmla="*/ 2629825 w 3160170"/>
                    <a:gd name="connsiteY65" fmla="*/ 161962 h 922177"/>
                    <a:gd name="connsiteX66" fmla="*/ 2664750 w 3160170"/>
                    <a:gd name="connsiteY66" fmla="*/ 174662 h 922177"/>
                    <a:gd name="connsiteX67" fmla="*/ 2693325 w 3160170"/>
                    <a:gd name="connsiteY67" fmla="*/ 181012 h 922177"/>
                    <a:gd name="connsiteX68" fmla="*/ 2721900 w 3160170"/>
                    <a:gd name="connsiteY68" fmla="*/ 215937 h 922177"/>
                    <a:gd name="connsiteX69" fmla="*/ 2763175 w 3160170"/>
                    <a:gd name="connsiteY69" fmla="*/ 285787 h 922177"/>
                    <a:gd name="connsiteX70" fmla="*/ 2779050 w 3160170"/>
                    <a:gd name="connsiteY70" fmla="*/ 320712 h 922177"/>
                    <a:gd name="connsiteX71" fmla="*/ 2791750 w 3160170"/>
                    <a:gd name="connsiteY71" fmla="*/ 361987 h 922177"/>
                    <a:gd name="connsiteX72" fmla="*/ 2804450 w 3160170"/>
                    <a:gd name="connsiteY72" fmla="*/ 400087 h 922177"/>
                    <a:gd name="connsiteX73" fmla="*/ 2807625 w 3160170"/>
                    <a:gd name="connsiteY73" fmla="*/ 419137 h 922177"/>
                    <a:gd name="connsiteX74" fmla="*/ 2807625 w 3160170"/>
                    <a:gd name="connsiteY74" fmla="*/ 441362 h 922177"/>
                    <a:gd name="connsiteX75" fmla="*/ 2810800 w 3160170"/>
                    <a:gd name="connsiteY75" fmla="*/ 476287 h 922177"/>
                    <a:gd name="connsiteX76" fmla="*/ 2813975 w 3160170"/>
                    <a:gd name="connsiteY76" fmla="*/ 504862 h 922177"/>
                    <a:gd name="connsiteX77" fmla="*/ 2817150 w 3160170"/>
                    <a:gd name="connsiteY77" fmla="*/ 530262 h 922177"/>
                    <a:gd name="connsiteX78" fmla="*/ 2817150 w 3160170"/>
                    <a:gd name="connsiteY78" fmla="*/ 558837 h 922177"/>
                    <a:gd name="connsiteX79" fmla="*/ 2813975 w 3160170"/>
                    <a:gd name="connsiteY79" fmla="*/ 571537 h 922177"/>
                    <a:gd name="connsiteX80" fmla="*/ 2807625 w 3160170"/>
                    <a:gd name="connsiteY80" fmla="*/ 584237 h 922177"/>
                    <a:gd name="connsiteX81" fmla="*/ 2798100 w 3160170"/>
                    <a:gd name="connsiteY81" fmla="*/ 603287 h 922177"/>
                    <a:gd name="connsiteX82" fmla="*/ 2794925 w 3160170"/>
                    <a:gd name="connsiteY82" fmla="*/ 619162 h 922177"/>
                    <a:gd name="connsiteX83" fmla="*/ 2794925 w 3160170"/>
                    <a:gd name="connsiteY83" fmla="*/ 635037 h 922177"/>
                    <a:gd name="connsiteX84" fmla="*/ 2798100 w 3160170"/>
                    <a:gd name="connsiteY84" fmla="*/ 647737 h 922177"/>
                    <a:gd name="connsiteX85" fmla="*/ 2798100 w 3160170"/>
                    <a:gd name="connsiteY85" fmla="*/ 647737 h 922177"/>
                    <a:gd name="connsiteX86" fmla="*/ 2747300 w 3160170"/>
                    <a:gd name="connsiteY86" fmla="*/ 666787 h 922177"/>
                    <a:gd name="connsiteX87" fmla="*/ 2696500 w 3160170"/>
                    <a:gd name="connsiteY87" fmla="*/ 676312 h 922177"/>
                    <a:gd name="connsiteX88" fmla="*/ 2648875 w 3160170"/>
                    <a:gd name="connsiteY88" fmla="*/ 682662 h 922177"/>
                    <a:gd name="connsiteX89" fmla="*/ 2623475 w 3160170"/>
                    <a:gd name="connsiteY89" fmla="*/ 682662 h 922177"/>
                    <a:gd name="connsiteX90" fmla="*/ 2585375 w 3160170"/>
                    <a:gd name="connsiteY90" fmla="*/ 682662 h 922177"/>
                    <a:gd name="connsiteX91" fmla="*/ 2547275 w 3160170"/>
                    <a:gd name="connsiteY91" fmla="*/ 679487 h 922177"/>
                    <a:gd name="connsiteX92" fmla="*/ 2531400 w 3160170"/>
                    <a:gd name="connsiteY92" fmla="*/ 682662 h 922177"/>
                    <a:gd name="connsiteX93" fmla="*/ 2506000 w 3160170"/>
                    <a:gd name="connsiteY93" fmla="*/ 695362 h 922177"/>
                    <a:gd name="connsiteX94" fmla="*/ 2483775 w 3160170"/>
                    <a:gd name="connsiteY94" fmla="*/ 704887 h 922177"/>
                    <a:gd name="connsiteX95" fmla="*/ 2439325 w 3160170"/>
                    <a:gd name="connsiteY95" fmla="*/ 714412 h 922177"/>
                    <a:gd name="connsiteX96" fmla="*/ 2394875 w 3160170"/>
                    <a:gd name="connsiteY96" fmla="*/ 723937 h 922177"/>
                    <a:gd name="connsiteX97" fmla="*/ 2347250 w 3160170"/>
                    <a:gd name="connsiteY97" fmla="*/ 730287 h 922177"/>
                    <a:gd name="connsiteX98" fmla="*/ 2315500 w 3160170"/>
                    <a:gd name="connsiteY98" fmla="*/ 717587 h 922177"/>
                    <a:gd name="connsiteX99" fmla="*/ 2252000 w 3160170"/>
                    <a:gd name="connsiteY99" fmla="*/ 704887 h 922177"/>
                    <a:gd name="connsiteX100" fmla="*/ 2213900 w 3160170"/>
                    <a:gd name="connsiteY100" fmla="*/ 698537 h 922177"/>
                    <a:gd name="connsiteX101" fmla="*/ 2172625 w 3160170"/>
                    <a:gd name="connsiteY101" fmla="*/ 692187 h 922177"/>
                    <a:gd name="connsiteX102" fmla="*/ 2115475 w 3160170"/>
                    <a:gd name="connsiteY102" fmla="*/ 682662 h 922177"/>
                    <a:gd name="connsiteX103" fmla="*/ 2077375 w 3160170"/>
                    <a:gd name="connsiteY103" fmla="*/ 676312 h 922177"/>
                    <a:gd name="connsiteX104" fmla="*/ 2029750 w 3160170"/>
                    <a:gd name="connsiteY104" fmla="*/ 666787 h 922177"/>
                    <a:gd name="connsiteX105" fmla="*/ 1915450 w 3160170"/>
                    <a:gd name="connsiteY105" fmla="*/ 660437 h 922177"/>
                    <a:gd name="connsiteX106" fmla="*/ 1855125 w 3160170"/>
                    <a:gd name="connsiteY106" fmla="*/ 663612 h 922177"/>
                    <a:gd name="connsiteX107" fmla="*/ 1769400 w 3160170"/>
                    <a:gd name="connsiteY107" fmla="*/ 666787 h 922177"/>
                    <a:gd name="connsiteX108" fmla="*/ 1731300 w 3160170"/>
                    <a:gd name="connsiteY108" fmla="*/ 673137 h 922177"/>
                    <a:gd name="connsiteX109" fmla="*/ 1686850 w 3160170"/>
                    <a:gd name="connsiteY109" fmla="*/ 695362 h 922177"/>
                    <a:gd name="connsiteX110" fmla="*/ 1629700 w 3160170"/>
                    <a:gd name="connsiteY110" fmla="*/ 717587 h 922177"/>
                    <a:gd name="connsiteX111" fmla="*/ 1585250 w 3160170"/>
                    <a:gd name="connsiteY111" fmla="*/ 739812 h 922177"/>
                    <a:gd name="connsiteX112" fmla="*/ 1528100 w 3160170"/>
                    <a:gd name="connsiteY112" fmla="*/ 755687 h 922177"/>
                    <a:gd name="connsiteX113" fmla="*/ 1496350 w 3160170"/>
                    <a:gd name="connsiteY113" fmla="*/ 774737 h 922177"/>
                    <a:gd name="connsiteX114" fmla="*/ 1470950 w 3160170"/>
                    <a:gd name="connsiteY114" fmla="*/ 781087 h 922177"/>
                    <a:gd name="connsiteX115" fmla="*/ 1426500 w 3160170"/>
                    <a:gd name="connsiteY115" fmla="*/ 800137 h 922177"/>
                    <a:gd name="connsiteX116" fmla="*/ 1353475 w 3160170"/>
                    <a:gd name="connsiteY116" fmla="*/ 777912 h 922177"/>
                    <a:gd name="connsiteX117" fmla="*/ 1242350 w 3160170"/>
                    <a:gd name="connsiteY117" fmla="*/ 752512 h 922177"/>
                    <a:gd name="connsiteX118" fmla="*/ 1169325 w 3160170"/>
                    <a:gd name="connsiteY118" fmla="*/ 736637 h 922177"/>
                    <a:gd name="connsiteX119" fmla="*/ 1029625 w 3160170"/>
                    <a:gd name="connsiteY119" fmla="*/ 704887 h 922177"/>
                    <a:gd name="connsiteX120" fmla="*/ 959775 w 3160170"/>
                    <a:gd name="connsiteY120" fmla="*/ 701712 h 922177"/>
                    <a:gd name="connsiteX121" fmla="*/ 867700 w 3160170"/>
                    <a:gd name="connsiteY121" fmla="*/ 698537 h 922177"/>
                    <a:gd name="connsiteX122" fmla="*/ 813725 w 3160170"/>
                    <a:gd name="connsiteY122" fmla="*/ 701712 h 922177"/>
                    <a:gd name="connsiteX123" fmla="*/ 775625 w 3160170"/>
                    <a:gd name="connsiteY123" fmla="*/ 714412 h 922177"/>
                    <a:gd name="connsiteX124" fmla="*/ 712125 w 3160170"/>
                    <a:gd name="connsiteY124" fmla="*/ 727112 h 922177"/>
                    <a:gd name="connsiteX125" fmla="*/ 677200 w 3160170"/>
                    <a:gd name="connsiteY125" fmla="*/ 739812 h 922177"/>
                    <a:gd name="connsiteX126" fmla="*/ 547025 w 3160170"/>
                    <a:gd name="connsiteY126" fmla="*/ 733462 h 922177"/>
                    <a:gd name="connsiteX127" fmla="*/ 515275 w 3160170"/>
                    <a:gd name="connsiteY127" fmla="*/ 733462 h 922177"/>
                    <a:gd name="connsiteX128" fmla="*/ 400975 w 3160170"/>
                    <a:gd name="connsiteY128" fmla="*/ 720762 h 922177"/>
                    <a:gd name="connsiteX129" fmla="*/ 366050 w 3160170"/>
                    <a:gd name="connsiteY129" fmla="*/ 723937 h 922177"/>
                    <a:gd name="connsiteX130" fmla="*/ 319172 w 3160170"/>
                    <a:gd name="connsiteY130" fmla="*/ 728979 h 922177"/>
                    <a:gd name="connsiteX131" fmla="*/ 232700 w 3160170"/>
                    <a:gd name="connsiteY131" fmla="*/ 717587 h 922177"/>
                    <a:gd name="connsiteX132" fmla="*/ 213650 w 3160170"/>
                    <a:gd name="connsiteY132" fmla="*/ 717587 h 922177"/>
                    <a:gd name="connsiteX133" fmla="*/ 146975 w 3160170"/>
                    <a:gd name="connsiteY133" fmla="*/ 717587 h 922177"/>
                    <a:gd name="connsiteX134" fmla="*/ 131100 w 3160170"/>
                    <a:gd name="connsiteY134" fmla="*/ 720762 h 922177"/>
                    <a:gd name="connsiteX135" fmla="*/ 99350 w 3160170"/>
                    <a:gd name="connsiteY135" fmla="*/ 733462 h 922177"/>
                    <a:gd name="connsiteX136" fmla="*/ 70775 w 3160170"/>
                    <a:gd name="connsiteY136" fmla="*/ 742987 h 922177"/>
                    <a:gd name="connsiteX137" fmla="*/ 17214 w 3160170"/>
                    <a:gd name="connsiteY137" fmla="*/ 752650 h 922177"/>
                    <a:gd name="connsiteX138" fmla="*/ 787 w 3160170"/>
                    <a:gd name="connsiteY138" fmla="*/ 787023 h 922177"/>
                    <a:gd name="connsiteX139" fmla="*/ 37782 w 3160170"/>
                    <a:gd name="connsiteY139" fmla="*/ 843206 h 922177"/>
                    <a:gd name="connsiteX140" fmla="*/ 80438 w 3160170"/>
                    <a:gd name="connsiteY140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61625 w 3160170"/>
                    <a:gd name="connsiteY41" fmla="*/ 320712 h 922177"/>
                    <a:gd name="connsiteX42" fmla="*/ 3022965 w 3160170"/>
                    <a:gd name="connsiteY42" fmla="*/ 290643 h 922177"/>
                    <a:gd name="connsiteX43" fmla="*/ 2967910 w 3160170"/>
                    <a:gd name="connsiteY43" fmla="*/ 249985 h 922177"/>
                    <a:gd name="connsiteX44" fmla="*/ 2936557 w 3160170"/>
                    <a:gd name="connsiteY44" fmla="*/ 221735 h 922177"/>
                    <a:gd name="connsiteX45" fmla="*/ 2871125 w 3160170"/>
                    <a:gd name="connsiteY45" fmla="*/ 161962 h 922177"/>
                    <a:gd name="connsiteX46" fmla="*/ 2855250 w 3160170"/>
                    <a:gd name="connsiteY46" fmla="*/ 149262 h 922177"/>
                    <a:gd name="connsiteX47" fmla="*/ 2829850 w 3160170"/>
                    <a:gd name="connsiteY47" fmla="*/ 114337 h 922177"/>
                    <a:gd name="connsiteX48" fmla="*/ 2791750 w 3160170"/>
                    <a:gd name="connsiteY48" fmla="*/ 66712 h 922177"/>
                    <a:gd name="connsiteX49" fmla="*/ 2763175 w 3160170"/>
                    <a:gd name="connsiteY49" fmla="*/ 38137 h 922177"/>
                    <a:gd name="connsiteX50" fmla="*/ 2725075 w 3160170"/>
                    <a:gd name="connsiteY50" fmla="*/ 25437 h 922177"/>
                    <a:gd name="connsiteX51" fmla="*/ 2664750 w 3160170"/>
                    <a:gd name="connsiteY51" fmla="*/ 15912 h 922177"/>
                    <a:gd name="connsiteX52" fmla="*/ 2600316 w 3160170"/>
                    <a:gd name="connsiteY52" fmla="*/ 2839 h 922177"/>
                    <a:gd name="connsiteX53" fmla="*/ 2546308 w 3160170"/>
                    <a:gd name="connsiteY53" fmla="*/ 1003 h 922177"/>
                    <a:gd name="connsiteX54" fmla="*/ 2518148 w 3160170"/>
                    <a:gd name="connsiteY54" fmla="*/ 15359 h 922177"/>
                    <a:gd name="connsiteX55" fmla="*/ 2480600 w 3160170"/>
                    <a:gd name="connsiteY55" fmla="*/ 50837 h 922177"/>
                    <a:gd name="connsiteX56" fmla="*/ 2461550 w 3160170"/>
                    <a:gd name="connsiteY56" fmla="*/ 85762 h 922177"/>
                    <a:gd name="connsiteX57" fmla="*/ 2455200 w 3160170"/>
                    <a:gd name="connsiteY57" fmla="*/ 117512 h 922177"/>
                    <a:gd name="connsiteX58" fmla="*/ 2463068 w 3160170"/>
                    <a:gd name="connsiteY58" fmla="*/ 141118 h 922177"/>
                    <a:gd name="connsiteX59" fmla="*/ 2486122 w 3160170"/>
                    <a:gd name="connsiteY59" fmla="*/ 155336 h 922177"/>
                    <a:gd name="connsiteX60" fmla="*/ 2515525 w 3160170"/>
                    <a:gd name="connsiteY60" fmla="*/ 165137 h 922177"/>
                    <a:gd name="connsiteX61" fmla="*/ 2531400 w 3160170"/>
                    <a:gd name="connsiteY61" fmla="*/ 165137 h 922177"/>
                    <a:gd name="connsiteX62" fmla="*/ 2559975 w 3160170"/>
                    <a:gd name="connsiteY62" fmla="*/ 165551 h 922177"/>
                    <a:gd name="connsiteX63" fmla="*/ 2569500 w 3160170"/>
                    <a:gd name="connsiteY63" fmla="*/ 168312 h 922177"/>
                    <a:gd name="connsiteX64" fmla="*/ 2601250 w 3160170"/>
                    <a:gd name="connsiteY64" fmla="*/ 171487 h 922177"/>
                    <a:gd name="connsiteX65" fmla="*/ 2629825 w 3160170"/>
                    <a:gd name="connsiteY65" fmla="*/ 161962 h 922177"/>
                    <a:gd name="connsiteX66" fmla="*/ 2664750 w 3160170"/>
                    <a:gd name="connsiteY66" fmla="*/ 174662 h 922177"/>
                    <a:gd name="connsiteX67" fmla="*/ 2693325 w 3160170"/>
                    <a:gd name="connsiteY67" fmla="*/ 181012 h 922177"/>
                    <a:gd name="connsiteX68" fmla="*/ 2721900 w 3160170"/>
                    <a:gd name="connsiteY68" fmla="*/ 215937 h 922177"/>
                    <a:gd name="connsiteX69" fmla="*/ 2763175 w 3160170"/>
                    <a:gd name="connsiteY69" fmla="*/ 285787 h 922177"/>
                    <a:gd name="connsiteX70" fmla="*/ 2779050 w 3160170"/>
                    <a:gd name="connsiteY70" fmla="*/ 320712 h 922177"/>
                    <a:gd name="connsiteX71" fmla="*/ 2791750 w 3160170"/>
                    <a:gd name="connsiteY71" fmla="*/ 361987 h 922177"/>
                    <a:gd name="connsiteX72" fmla="*/ 2804450 w 3160170"/>
                    <a:gd name="connsiteY72" fmla="*/ 400087 h 922177"/>
                    <a:gd name="connsiteX73" fmla="*/ 2807625 w 3160170"/>
                    <a:gd name="connsiteY73" fmla="*/ 419137 h 922177"/>
                    <a:gd name="connsiteX74" fmla="*/ 2807625 w 3160170"/>
                    <a:gd name="connsiteY74" fmla="*/ 441362 h 922177"/>
                    <a:gd name="connsiteX75" fmla="*/ 2810800 w 3160170"/>
                    <a:gd name="connsiteY75" fmla="*/ 476287 h 922177"/>
                    <a:gd name="connsiteX76" fmla="*/ 2813975 w 3160170"/>
                    <a:gd name="connsiteY76" fmla="*/ 504862 h 922177"/>
                    <a:gd name="connsiteX77" fmla="*/ 2817150 w 3160170"/>
                    <a:gd name="connsiteY77" fmla="*/ 530262 h 922177"/>
                    <a:gd name="connsiteX78" fmla="*/ 2817150 w 3160170"/>
                    <a:gd name="connsiteY78" fmla="*/ 558837 h 922177"/>
                    <a:gd name="connsiteX79" fmla="*/ 2813975 w 3160170"/>
                    <a:gd name="connsiteY79" fmla="*/ 571537 h 922177"/>
                    <a:gd name="connsiteX80" fmla="*/ 2807625 w 3160170"/>
                    <a:gd name="connsiteY80" fmla="*/ 584237 h 922177"/>
                    <a:gd name="connsiteX81" fmla="*/ 2798100 w 3160170"/>
                    <a:gd name="connsiteY81" fmla="*/ 603287 h 922177"/>
                    <a:gd name="connsiteX82" fmla="*/ 2794925 w 3160170"/>
                    <a:gd name="connsiteY82" fmla="*/ 619162 h 922177"/>
                    <a:gd name="connsiteX83" fmla="*/ 2794925 w 3160170"/>
                    <a:gd name="connsiteY83" fmla="*/ 635037 h 922177"/>
                    <a:gd name="connsiteX84" fmla="*/ 2798100 w 3160170"/>
                    <a:gd name="connsiteY84" fmla="*/ 647737 h 922177"/>
                    <a:gd name="connsiteX85" fmla="*/ 2798100 w 3160170"/>
                    <a:gd name="connsiteY85" fmla="*/ 647737 h 922177"/>
                    <a:gd name="connsiteX86" fmla="*/ 2747300 w 3160170"/>
                    <a:gd name="connsiteY86" fmla="*/ 666787 h 922177"/>
                    <a:gd name="connsiteX87" fmla="*/ 2696500 w 3160170"/>
                    <a:gd name="connsiteY87" fmla="*/ 676312 h 922177"/>
                    <a:gd name="connsiteX88" fmla="*/ 2648875 w 3160170"/>
                    <a:gd name="connsiteY88" fmla="*/ 682662 h 922177"/>
                    <a:gd name="connsiteX89" fmla="*/ 2623475 w 3160170"/>
                    <a:gd name="connsiteY89" fmla="*/ 682662 h 922177"/>
                    <a:gd name="connsiteX90" fmla="*/ 2585375 w 3160170"/>
                    <a:gd name="connsiteY90" fmla="*/ 682662 h 922177"/>
                    <a:gd name="connsiteX91" fmla="*/ 2547275 w 3160170"/>
                    <a:gd name="connsiteY91" fmla="*/ 679487 h 922177"/>
                    <a:gd name="connsiteX92" fmla="*/ 2531400 w 3160170"/>
                    <a:gd name="connsiteY92" fmla="*/ 682662 h 922177"/>
                    <a:gd name="connsiteX93" fmla="*/ 2506000 w 3160170"/>
                    <a:gd name="connsiteY93" fmla="*/ 695362 h 922177"/>
                    <a:gd name="connsiteX94" fmla="*/ 2483775 w 3160170"/>
                    <a:gd name="connsiteY94" fmla="*/ 704887 h 922177"/>
                    <a:gd name="connsiteX95" fmla="*/ 2439325 w 3160170"/>
                    <a:gd name="connsiteY95" fmla="*/ 714412 h 922177"/>
                    <a:gd name="connsiteX96" fmla="*/ 2394875 w 3160170"/>
                    <a:gd name="connsiteY96" fmla="*/ 723937 h 922177"/>
                    <a:gd name="connsiteX97" fmla="*/ 2347250 w 3160170"/>
                    <a:gd name="connsiteY97" fmla="*/ 730287 h 922177"/>
                    <a:gd name="connsiteX98" fmla="*/ 2315500 w 3160170"/>
                    <a:gd name="connsiteY98" fmla="*/ 717587 h 922177"/>
                    <a:gd name="connsiteX99" fmla="*/ 2252000 w 3160170"/>
                    <a:gd name="connsiteY99" fmla="*/ 704887 h 922177"/>
                    <a:gd name="connsiteX100" fmla="*/ 2213900 w 3160170"/>
                    <a:gd name="connsiteY100" fmla="*/ 698537 h 922177"/>
                    <a:gd name="connsiteX101" fmla="*/ 2172625 w 3160170"/>
                    <a:gd name="connsiteY101" fmla="*/ 692187 h 922177"/>
                    <a:gd name="connsiteX102" fmla="*/ 2115475 w 3160170"/>
                    <a:gd name="connsiteY102" fmla="*/ 682662 h 922177"/>
                    <a:gd name="connsiteX103" fmla="*/ 2077375 w 3160170"/>
                    <a:gd name="connsiteY103" fmla="*/ 676312 h 922177"/>
                    <a:gd name="connsiteX104" fmla="*/ 2029750 w 3160170"/>
                    <a:gd name="connsiteY104" fmla="*/ 666787 h 922177"/>
                    <a:gd name="connsiteX105" fmla="*/ 1915450 w 3160170"/>
                    <a:gd name="connsiteY105" fmla="*/ 660437 h 922177"/>
                    <a:gd name="connsiteX106" fmla="*/ 1855125 w 3160170"/>
                    <a:gd name="connsiteY106" fmla="*/ 663612 h 922177"/>
                    <a:gd name="connsiteX107" fmla="*/ 1769400 w 3160170"/>
                    <a:gd name="connsiteY107" fmla="*/ 666787 h 922177"/>
                    <a:gd name="connsiteX108" fmla="*/ 1731300 w 3160170"/>
                    <a:gd name="connsiteY108" fmla="*/ 673137 h 922177"/>
                    <a:gd name="connsiteX109" fmla="*/ 1686850 w 3160170"/>
                    <a:gd name="connsiteY109" fmla="*/ 695362 h 922177"/>
                    <a:gd name="connsiteX110" fmla="*/ 1629700 w 3160170"/>
                    <a:gd name="connsiteY110" fmla="*/ 717587 h 922177"/>
                    <a:gd name="connsiteX111" fmla="*/ 1585250 w 3160170"/>
                    <a:gd name="connsiteY111" fmla="*/ 739812 h 922177"/>
                    <a:gd name="connsiteX112" fmla="*/ 1528100 w 3160170"/>
                    <a:gd name="connsiteY112" fmla="*/ 755687 h 922177"/>
                    <a:gd name="connsiteX113" fmla="*/ 1496350 w 3160170"/>
                    <a:gd name="connsiteY113" fmla="*/ 774737 h 922177"/>
                    <a:gd name="connsiteX114" fmla="*/ 1470950 w 3160170"/>
                    <a:gd name="connsiteY114" fmla="*/ 781087 h 922177"/>
                    <a:gd name="connsiteX115" fmla="*/ 1426500 w 3160170"/>
                    <a:gd name="connsiteY115" fmla="*/ 800137 h 922177"/>
                    <a:gd name="connsiteX116" fmla="*/ 1353475 w 3160170"/>
                    <a:gd name="connsiteY116" fmla="*/ 777912 h 922177"/>
                    <a:gd name="connsiteX117" fmla="*/ 1242350 w 3160170"/>
                    <a:gd name="connsiteY117" fmla="*/ 752512 h 922177"/>
                    <a:gd name="connsiteX118" fmla="*/ 1169325 w 3160170"/>
                    <a:gd name="connsiteY118" fmla="*/ 736637 h 922177"/>
                    <a:gd name="connsiteX119" fmla="*/ 1029625 w 3160170"/>
                    <a:gd name="connsiteY119" fmla="*/ 704887 h 922177"/>
                    <a:gd name="connsiteX120" fmla="*/ 959775 w 3160170"/>
                    <a:gd name="connsiteY120" fmla="*/ 701712 h 922177"/>
                    <a:gd name="connsiteX121" fmla="*/ 867700 w 3160170"/>
                    <a:gd name="connsiteY121" fmla="*/ 698537 h 922177"/>
                    <a:gd name="connsiteX122" fmla="*/ 813725 w 3160170"/>
                    <a:gd name="connsiteY122" fmla="*/ 701712 h 922177"/>
                    <a:gd name="connsiteX123" fmla="*/ 775625 w 3160170"/>
                    <a:gd name="connsiteY123" fmla="*/ 714412 h 922177"/>
                    <a:gd name="connsiteX124" fmla="*/ 712125 w 3160170"/>
                    <a:gd name="connsiteY124" fmla="*/ 727112 h 922177"/>
                    <a:gd name="connsiteX125" fmla="*/ 677200 w 3160170"/>
                    <a:gd name="connsiteY125" fmla="*/ 739812 h 922177"/>
                    <a:gd name="connsiteX126" fmla="*/ 547025 w 3160170"/>
                    <a:gd name="connsiteY126" fmla="*/ 733462 h 922177"/>
                    <a:gd name="connsiteX127" fmla="*/ 515275 w 3160170"/>
                    <a:gd name="connsiteY127" fmla="*/ 733462 h 922177"/>
                    <a:gd name="connsiteX128" fmla="*/ 400975 w 3160170"/>
                    <a:gd name="connsiteY128" fmla="*/ 720762 h 922177"/>
                    <a:gd name="connsiteX129" fmla="*/ 366050 w 3160170"/>
                    <a:gd name="connsiteY129" fmla="*/ 723937 h 922177"/>
                    <a:gd name="connsiteX130" fmla="*/ 319172 w 3160170"/>
                    <a:gd name="connsiteY130" fmla="*/ 728979 h 922177"/>
                    <a:gd name="connsiteX131" fmla="*/ 232700 w 3160170"/>
                    <a:gd name="connsiteY131" fmla="*/ 717587 h 922177"/>
                    <a:gd name="connsiteX132" fmla="*/ 213650 w 3160170"/>
                    <a:gd name="connsiteY132" fmla="*/ 717587 h 922177"/>
                    <a:gd name="connsiteX133" fmla="*/ 146975 w 3160170"/>
                    <a:gd name="connsiteY133" fmla="*/ 717587 h 922177"/>
                    <a:gd name="connsiteX134" fmla="*/ 131100 w 3160170"/>
                    <a:gd name="connsiteY134" fmla="*/ 720762 h 922177"/>
                    <a:gd name="connsiteX135" fmla="*/ 99350 w 3160170"/>
                    <a:gd name="connsiteY135" fmla="*/ 733462 h 922177"/>
                    <a:gd name="connsiteX136" fmla="*/ 70775 w 3160170"/>
                    <a:gd name="connsiteY136" fmla="*/ 742987 h 922177"/>
                    <a:gd name="connsiteX137" fmla="*/ 17214 w 3160170"/>
                    <a:gd name="connsiteY137" fmla="*/ 752650 h 922177"/>
                    <a:gd name="connsiteX138" fmla="*/ 787 w 3160170"/>
                    <a:gd name="connsiteY138" fmla="*/ 787023 h 922177"/>
                    <a:gd name="connsiteX139" fmla="*/ 37782 w 3160170"/>
                    <a:gd name="connsiteY139" fmla="*/ 843206 h 922177"/>
                    <a:gd name="connsiteX140" fmla="*/ 80438 w 3160170"/>
                    <a:gd name="connsiteY140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29825 w 3160170"/>
                    <a:gd name="connsiteY64" fmla="*/ 161962 h 922177"/>
                    <a:gd name="connsiteX65" fmla="*/ 2664750 w 3160170"/>
                    <a:gd name="connsiteY65" fmla="*/ 174662 h 922177"/>
                    <a:gd name="connsiteX66" fmla="*/ 2693325 w 3160170"/>
                    <a:gd name="connsiteY66" fmla="*/ 181012 h 922177"/>
                    <a:gd name="connsiteX67" fmla="*/ 2721900 w 3160170"/>
                    <a:gd name="connsiteY67" fmla="*/ 215937 h 922177"/>
                    <a:gd name="connsiteX68" fmla="*/ 2763175 w 3160170"/>
                    <a:gd name="connsiteY68" fmla="*/ 285787 h 922177"/>
                    <a:gd name="connsiteX69" fmla="*/ 2779050 w 3160170"/>
                    <a:gd name="connsiteY69" fmla="*/ 320712 h 922177"/>
                    <a:gd name="connsiteX70" fmla="*/ 2791750 w 3160170"/>
                    <a:gd name="connsiteY70" fmla="*/ 361987 h 922177"/>
                    <a:gd name="connsiteX71" fmla="*/ 2804450 w 3160170"/>
                    <a:gd name="connsiteY71" fmla="*/ 400087 h 922177"/>
                    <a:gd name="connsiteX72" fmla="*/ 2807625 w 3160170"/>
                    <a:gd name="connsiteY72" fmla="*/ 419137 h 922177"/>
                    <a:gd name="connsiteX73" fmla="*/ 2807625 w 3160170"/>
                    <a:gd name="connsiteY73" fmla="*/ 441362 h 922177"/>
                    <a:gd name="connsiteX74" fmla="*/ 2810800 w 3160170"/>
                    <a:gd name="connsiteY74" fmla="*/ 476287 h 922177"/>
                    <a:gd name="connsiteX75" fmla="*/ 2813975 w 3160170"/>
                    <a:gd name="connsiteY75" fmla="*/ 504862 h 922177"/>
                    <a:gd name="connsiteX76" fmla="*/ 2817150 w 3160170"/>
                    <a:gd name="connsiteY76" fmla="*/ 530262 h 922177"/>
                    <a:gd name="connsiteX77" fmla="*/ 2817150 w 3160170"/>
                    <a:gd name="connsiteY77" fmla="*/ 558837 h 922177"/>
                    <a:gd name="connsiteX78" fmla="*/ 2813975 w 3160170"/>
                    <a:gd name="connsiteY78" fmla="*/ 571537 h 922177"/>
                    <a:gd name="connsiteX79" fmla="*/ 2807625 w 3160170"/>
                    <a:gd name="connsiteY79" fmla="*/ 584237 h 922177"/>
                    <a:gd name="connsiteX80" fmla="*/ 2798100 w 3160170"/>
                    <a:gd name="connsiteY80" fmla="*/ 603287 h 922177"/>
                    <a:gd name="connsiteX81" fmla="*/ 2794925 w 3160170"/>
                    <a:gd name="connsiteY81" fmla="*/ 619162 h 922177"/>
                    <a:gd name="connsiteX82" fmla="*/ 2794925 w 3160170"/>
                    <a:gd name="connsiteY82" fmla="*/ 635037 h 922177"/>
                    <a:gd name="connsiteX83" fmla="*/ 2798100 w 3160170"/>
                    <a:gd name="connsiteY83" fmla="*/ 647737 h 922177"/>
                    <a:gd name="connsiteX84" fmla="*/ 2798100 w 3160170"/>
                    <a:gd name="connsiteY84" fmla="*/ 647737 h 922177"/>
                    <a:gd name="connsiteX85" fmla="*/ 2747300 w 3160170"/>
                    <a:gd name="connsiteY85" fmla="*/ 666787 h 922177"/>
                    <a:gd name="connsiteX86" fmla="*/ 2696500 w 3160170"/>
                    <a:gd name="connsiteY86" fmla="*/ 676312 h 922177"/>
                    <a:gd name="connsiteX87" fmla="*/ 2648875 w 3160170"/>
                    <a:gd name="connsiteY87" fmla="*/ 682662 h 922177"/>
                    <a:gd name="connsiteX88" fmla="*/ 2623475 w 3160170"/>
                    <a:gd name="connsiteY88" fmla="*/ 682662 h 922177"/>
                    <a:gd name="connsiteX89" fmla="*/ 2585375 w 3160170"/>
                    <a:gd name="connsiteY89" fmla="*/ 682662 h 922177"/>
                    <a:gd name="connsiteX90" fmla="*/ 2547275 w 3160170"/>
                    <a:gd name="connsiteY90" fmla="*/ 679487 h 922177"/>
                    <a:gd name="connsiteX91" fmla="*/ 2531400 w 3160170"/>
                    <a:gd name="connsiteY91" fmla="*/ 682662 h 922177"/>
                    <a:gd name="connsiteX92" fmla="*/ 2506000 w 3160170"/>
                    <a:gd name="connsiteY92" fmla="*/ 695362 h 922177"/>
                    <a:gd name="connsiteX93" fmla="*/ 2483775 w 3160170"/>
                    <a:gd name="connsiteY93" fmla="*/ 704887 h 922177"/>
                    <a:gd name="connsiteX94" fmla="*/ 2439325 w 3160170"/>
                    <a:gd name="connsiteY94" fmla="*/ 714412 h 922177"/>
                    <a:gd name="connsiteX95" fmla="*/ 2394875 w 3160170"/>
                    <a:gd name="connsiteY95" fmla="*/ 723937 h 922177"/>
                    <a:gd name="connsiteX96" fmla="*/ 2347250 w 3160170"/>
                    <a:gd name="connsiteY96" fmla="*/ 730287 h 922177"/>
                    <a:gd name="connsiteX97" fmla="*/ 2315500 w 3160170"/>
                    <a:gd name="connsiteY97" fmla="*/ 717587 h 922177"/>
                    <a:gd name="connsiteX98" fmla="*/ 2252000 w 3160170"/>
                    <a:gd name="connsiteY98" fmla="*/ 704887 h 922177"/>
                    <a:gd name="connsiteX99" fmla="*/ 2213900 w 3160170"/>
                    <a:gd name="connsiteY99" fmla="*/ 698537 h 922177"/>
                    <a:gd name="connsiteX100" fmla="*/ 2172625 w 3160170"/>
                    <a:gd name="connsiteY100" fmla="*/ 692187 h 922177"/>
                    <a:gd name="connsiteX101" fmla="*/ 2115475 w 3160170"/>
                    <a:gd name="connsiteY101" fmla="*/ 682662 h 922177"/>
                    <a:gd name="connsiteX102" fmla="*/ 2077375 w 3160170"/>
                    <a:gd name="connsiteY102" fmla="*/ 676312 h 922177"/>
                    <a:gd name="connsiteX103" fmla="*/ 2029750 w 3160170"/>
                    <a:gd name="connsiteY103" fmla="*/ 666787 h 922177"/>
                    <a:gd name="connsiteX104" fmla="*/ 1915450 w 3160170"/>
                    <a:gd name="connsiteY104" fmla="*/ 660437 h 922177"/>
                    <a:gd name="connsiteX105" fmla="*/ 1855125 w 3160170"/>
                    <a:gd name="connsiteY105" fmla="*/ 663612 h 922177"/>
                    <a:gd name="connsiteX106" fmla="*/ 1769400 w 3160170"/>
                    <a:gd name="connsiteY106" fmla="*/ 666787 h 922177"/>
                    <a:gd name="connsiteX107" fmla="*/ 1731300 w 3160170"/>
                    <a:gd name="connsiteY107" fmla="*/ 673137 h 922177"/>
                    <a:gd name="connsiteX108" fmla="*/ 1686850 w 3160170"/>
                    <a:gd name="connsiteY108" fmla="*/ 695362 h 922177"/>
                    <a:gd name="connsiteX109" fmla="*/ 1629700 w 3160170"/>
                    <a:gd name="connsiteY109" fmla="*/ 717587 h 922177"/>
                    <a:gd name="connsiteX110" fmla="*/ 1585250 w 3160170"/>
                    <a:gd name="connsiteY110" fmla="*/ 739812 h 922177"/>
                    <a:gd name="connsiteX111" fmla="*/ 1528100 w 3160170"/>
                    <a:gd name="connsiteY111" fmla="*/ 755687 h 922177"/>
                    <a:gd name="connsiteX112" fmla="*/ 1496350 w 3160170"/>
                    <a:gd name="connsiteY112" fmla="*/ 774737 h 922177"/>
                    <a:gd name="connsiteX113" fmla="*/ 1470950 w 3160170"/>
                    <a:gd name="connsiteY113" fmla="*/ 781087 h 922177"/>
                    <a:gd name="connsiteX114" fmla="*/ 1426500 w 3160170"/>
                    <a:gd name="connsiteY114" fmla="*/ 800137 h 922177"/>
                    <a:gd name="connsiteX115" fmla="*/ 1353475 w 3160170"/>
                    <a:gd name="connsiteY115" fmla="*/ 777912 h 922177"/>
                    <a:gd name="connsiteX116" fmla="*/ 1242350 w 3160170"/>
                    <a:gd name="connsiteY116" fmla="*/ 752512 h 922177"/>
                    <a:gd name="connsiteX117" fmla="*/ 1169325 w 3160170"/>
                    <a:gd name="connsiteY117" fmla="*/ 736637 h 922177"/>
                    <a:gd name="connsiteX118" fmla="*/ 1029625 w 3160170"/>
                    <a:gd name="connsiteY118" fmla="*/ 704887 h 922177"/>
                    <a:gd name="connsiteX119" fmla="*/ 959775 w 3160170"/>
                    <a:gd name="connsiteY119" fmla="*/ 701712 h 922177"/>
                    <a:gd name="connsiteX120" fmla="*/ 867700 w 3160170"/>
                    <a:gd name="connsiteY120" fmla="*/ 698537 h 922177"/>
                    <a:gd name="connsiteX121" fmla="*/ 813725 w 3160170"/>
                    <a:gd name="connsiteY121" fmla="*/ 701712 h 922177"/>
                    <a:gd name="connsiteX122" fmla="*/ 775625 w 3160170"/>
                    <a:gd name="connsiteY122" fmla="*/ 714412 h 922177"/>
                    <a:gd name="connsiteX123" fmla="*/ 712125 w 3160170"/>
                    <a:gd name="connsiteY123" fmla="*/ 727112 h 922177"/>
                    <a:gd name="connsiteX124" fmla="*/ 677200 w 3160170"/>
                    <a:gd name="connsiteY124" fmla="*/ 739812 h 922177"/>
                    <a:gd name="connsiteX125" fmla="*/ 547025 w 3160170"/>
                    <a:gd name="connsiteY125" fmla="*/ 733462 h 922177"/>
                    <a:gd name="connsiteX126" fmla="*/ 515275 w 3160170"/>
                    <a:gd name="connsiteY126" fmla="*/ 733462 h 922177"/>
                    <a:gd name="connsiteX127" fmla="*/ 400975 w 3160170"/>
                    <a:gd name="connsiteY127" fmla="*/ 720762 h 922177"/>
                    <a:gd name="connsiteX128" fmla="*/ 366050 w 3160170"/>
                    <a:gd name="connsiteY128" fmla="*/ 723937 h 922177"/>
                    <a:gd name="connsiteX129" fmla="*/ 319172 w 3160170"/>
                    <a:gd name="connsiteY129" fmla="*/ 728979 h 922177"/>
                    <a:gd name="connsiteX130" fmla="*/ 232700 w 3160170"/>
                    <a:gd name="connsiteY130" fmla="*/ 717587 h 922177"/>
                    <a:gd name="connsiteX131" fmla="*/ 213650 w 3160170"/>
                    <a:gd name="connsiteY131" fmla="*/ 717587 h 922177"/>
                    <a:gd name="connsiteX132" fmla="*/ 146975 w 3160170"/>
                    <a:gd name="connsiteY132" fmla="*/ 717587 h 922177"/>
                    <a:gd name="connsiteX133" fmla="*/ 131100 w 3160170"/>
                    <a:gd name="connsiteY133" fmla="*/ 720762 h 922177"/>
                    <a:gd name="connsiteX134" fmla="*/ 99350 w 3160170"/>
                    <a:gd name="connsiteY134" fmla="*/ 733462 h 922177"/>
                    <a:gd name="connsiteX135" fmla="*/ 70775 w 3160170"/>
                    <a:gd name="connsiteY135" fmla="*/ 742987 h 922177"/>
                    <a:gd name="connsiteX136" fmla="*/ 17214 w 3160170"/>
                    <a:gd name="connsiteY136" fmla="*/ 752650 h 922177"/>
                    <a:gd name="connsiteX137" fmla="*/ 787 w 3160170"/>
                    <a:gd name="connsiteY137" fmla="*/ 787023 h 922177"/>
                    <a:gd name="connsiteX138" fmla="*/ 37782 w 3160170"/>
                    <a:gd name="connsiteY138" fmla="*/ 843206 h 922177"/>
                    <a:gd name="connsiteX139" fmla="*/ 80438 w 3160170"/>
                    <a:gd name="connsiteY139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29825 w 3160170"/>
                    <a:gd name="connsiteY64" fmla="*/ 161962 h 922177"/>
                    <a:gd name="connsiteX65" fmla="*/ 2664750 w 3160170"/>
                    <a:gd name="connsiteY65" fmla="*/ 174662 h 922177"/>
                    <a:gd name="connsiteX66" fmla="*/ 2693325 w 3160170"/>
                    <a:gd name="connsiteY66" fmla="*/ 181012 h 922177"/>
                    <a:gd name="connsiteX67" fmla="*/ 2721900 w 3160170"/>
                    <a:gd name="connsiteY67" fmla="*/ 215937 h 922177"/>
                    <a:gd name="connsiteX68" fmla="*/ 2763175 w 3160170"/>
                    <a:gd name="connsiteY68" fmla="*/ 285787 h 922177"/>
                    <a:gd name="connsiteX69" fmla="*/ 2779050 w 3160170"/>
                    <a:gd name="connsiteY69" fmla="*/ 320712 h 922177"/>
                    <a:gd name="connsiteX70" fmla="*/ 2791750 w 3160170"/>
                    <a:gd name="connsiteY70" fmla="*/ 361987 h 922177"/>
                    <a:gd name="connsiteX71" fmla="*/ 2804450 w 3160170"/>
                    <a:gd name="connsiteY71" fmla="*/ 400087 h 922177"/>
                    <a:gd name="connsiteX72" fmla="*/ 2807625 w 3160170"/>
                    <a:gd name="connsiteY72" fmla="*/ 419137 h 922177"/>
                    <a:gd name="connsiteX73" fmla="*/ 2807625 w 3160170"/>
                    <a:gd name="connsiteY73" fmla="*/ 441362 h 922177"/>
                    <a:gd name="connsiteX74" fmla="*/ 2810800 w 3160170"/>
                    <a:gd name="connsiteY74" fmla="*/ 476287 h 922177"/>
                    <a:gd name="connsiteX75" fmla="*/ 2813975 w 3160170"/>
                    <a:gd name="connsiteY75" fmla="*/ 504862 h 922177"/>
                    <a:gd name="connsiteX76" fmla="*/ 2817150 w 3160170"/>
                    <a:gd name="connsiteY76" fmla="*/ 530262 h 922177"/>
                    <a:gd name="connsiteX77" fmla="*/ 2817150 w 3160170"/>
                    <a:gd name="connsiteY77" fmla="*/ 558837 h 922177"/>
                    <a:gd name="connsiteX78" fmla="*/ 2813975 w 3160170"/>
                    <a:gd name="connsiteY78" fmla="*/ 571537 h 922177"/>
                    <a:gd name="connsiteX79" fmla="*/ 2807625 w 3160170"/>
                    <a:gd name="connsiteY79" fmla="*/ 584237 h 922177"/>
                    <a:gd name="connsiteX80" fmla="*/ 2798100 w 3160170"/>
                    <a:gd name="connsiteY80" fmla="*/ 603287 h 922177"/>
                    <a:gd name="connsiteX81" fmla="*/ 2794925 w 3160170"/>
                    <a:gd name="connsiteY81" fmla="*/ 619162 h 922177"/>
                    <a:gd name="connsiteX82" fmla="*/ 2794925 w 3160170"/>
                    <a:gd name="connsiteY82" fmla="*/ 635037 h 922177"/>
                    <a:gd name="connsiteX83" fmla="*/ 2798100 w 3160170"/>
                    <a:gd name="connsiteY83" fmla="*/ 647737 h 922177"/>
                    <a:gd name="connsiteX84" fmla="*/ 2798100 w 3160170"/>
                    <a:gd name="connsiteY84" fmla="*/ 647737 h 922177"/>
                    <a:gd name="connsiteX85" fmla="*/ 2747300 w 3160170"/>
                    <a:gd name="connsiteY85" fmla="*/ 666787 h 922177"/>
                    <a:gd name="connsiteX86" fmla="*/ 2696500 w 3160170"/>
                    <a:gd name="connsiteY86" fmla="*/ 676312 h 922177"/>
                    <a:gd name="connsiteX87" fmla="*/ 2648875 w 3160170"/>
                    <a:gd name="connsiteY87" fmla="*/ 682662 h 922177"/>
                    <a:gd name="connsiteX88" fmla="*/ 2623475 w 3160170"/>
                    <a:gd name="connsiteY88" fmla="*/ 682662 h 922177"/>
                    <a:gd name="connsiteX89" fmla="*/ 2585375 w 3160170"/>
                    <a:gd name="connsiteY89" fmla="*/ 682662 h 922177"/>
                    <a:gd name="connsiteX90" fmla="*/ 2547275 w 3160170"/>
                    <a:gd name="connsiteY90" fmla="*/ 679487 h 922177"/>
                    <a:gd name="connsiteX91" fmla="*/ 2531400 w 3160170"/>
                    <a:gd name="connsiteY91" fmla="*/ 682662 h 922177"/>
                    <a:gd name="connsiteX92" fmla="*/ 2506000 w 3160170"/>
                    <a:gd name="connsiteY92" fmla="*/ 695362 h 922177"/>
                    <a:gd name="connsiteX93" fmla="*/ 2483775 w 3160170"/>
                    <a:gd name="connsiteY93" fmla="*/ 704887 h 922177"/>
                    <a:gd name="connsiteX94" fmla="*/ 2439325 w 3160170"/>
                    <a:gd name="connsiteY94" fmla="*/ 714412 h 922177"/>
                    <a:gd name="connsiteX95" fmla="*/ 2394875 w 3160170"/>
                    <a:gd name="connsiteY95" fmla="*/ 723937 h 922177"/>
                    <a:gd name="connsiteX96" fmla="*/ 2347250 w 3160170"/>
                    <a:gd name="connsiteY96" fmla="*/ 730287 h 922177"/>
                    <a:gd name="connsiteX97" fmla="*/ 2315500 w 3160170"/>
                    <a:gd name="connsiteY97" fmla="*/ 717587 h 922177"/>
                    <a:gd name="connsiteX98" fmla="*/ 2252000 w 3160170"/>
                    <a:gd name="connsiteY98" fmla="*/ 704887 h 922177"/>
                    <a:gd name="connsiteX99" fmla="*/ 2213900 w 3160170"/>
                    <a:gd name="connsiteY99" fmla="*/ 698537 h 922177"/>
                    <a:gd name="connsiteX100" fmla="*/ 2172625 w 3160170"/>
                    <a:gd name="connsiteY100" fmla="*/ 692187 h 922177"/>
                    <a:gd name="connsiteX101" fmla="*/ 2115475 w 3160170"/>
                    <a:gd name="connsiteY101" fmla="*/ 682662 h 922177"/>
                    <a:gd name="connsiteX102" fmla="*/ 2077375 w 3160170"/>
                    <a:gd name="connsiteY102" fmla="*/ 676312 h 922177"/>
                    <a:gd name="connsiteX103" fmla="*/ 2029750 w 3160170"/>
                    <a:gd name="connsiteY103" fmla="*/ 666787 h 922177"/>
                    <a:gd name="connsiteX104" fmla="*/ 1915450 w 3160170"/>
                    <a:gd name="connsiteY104" fmla="*/ 660437 h 922177"/>
                    <a:gd name="connsiteX105" fmla="*/ 1855125 w 3160170"/>
                    <a:gd name="connsiteY105" fmla="*/ 663612 h 922177"/>
                    <a:gd name="connsiteX106" fmla="*/ 1769400 w 3160170"/>
                    <a:gd name="connsiteY106" fmla="*/ 666787 h 922177"/>
                    <a:gd name="connsiteX107" fmla="*/ 1731300 w 3160170"/>
                    <a:gd name="connsiteY107" fmla="*/ 673137 h 922177"/>
                    <a:gd name="connsiteX108" fmla="*/ 1686850 w 3160170"/>
                    <a:gd name="connsiteY108" fmla="*/ 695362 h 922177"/>
                    <a:gd name="connsiteX109" fmla="*/ 1629700 w 3160170"/>
                    <a:gd name="connsiteY109" fmla="*/ 717587 h 922177"/>
                    <a:gd name="connsiteX110" fmla="*/ 1585250 w 3160170"/>
                    <a:gd name="connsiteY110" fmla="*/ 739812 h 922177"/>
                    <a:gd name="connsiteX111" fmla="*/ 1528100 w 3160170"/>
                    <a:gd name="connsiteY111" fmla="*/ 755687 h 922177"/>
                    <a:gd name="connsiteX112" fmla="*/ 1496350 w 3160170"/>
                    <a:gd name="connsiteY112" fmla="*/ 774737 h 922177"/>
                    <a:gd name="connsiteX113" fmla="*/ 1470950 w 3160170"/>
                    <a:gd name="connsiteY113" fmla="*/ 781087 h 922177"/>
                    <a:gd name="connsiteX114" fmla="*/ 1426500 w 3160170"/>
                    <a:gd name="connsiteY114" fmla="*/ 800137 h 922177"/>
                    <a:gd name="connsiteX115" fmla="*/ 1353475 w 3160170"/>
                    <a:gd name="connsiteY115" fmla="*/ 777912 h 922177"/>
                    <a:gd name="connsiteX116" fmla="*/ 1242350 w 3160170"/>
                    <a:gd name="connsiteY116" fmla="*/ 752512 h 922177"/>
                    <a:gd name="connsiteX117" fmla="*/ 1169325 w 3160170"/>
                    <a:gd name="connsiteY117" fmla="*/ 736637 h 922177"/>
                    <a:gd name="connsiteX118" fmla="*/ 1029625 w 3160170"/>
                    <a:gd name="connsiteY118" fmla="*/ 704887 h 922177"/>
                    <a:gd name="connsiteX119" fmla="*/ 959775 w 3160170"/>
                    <a:gd name="connsiteY119" fmla="*/ 701712 h 922177"/>
                    <a:gd name="connsiteX120" fmla="*/ 867700 w 3160170"/>
                    <a:gd name="connsiteY120" fmla="*/ 698537 h 922177"/>
                    <a:gd name="connsiteX121" fmla="*/ 813725 w 3160170"/>
                    <a:gd name="connsiteY121" fmla="*/ 701712 h 922177"/>
                    <a:gd name="connsiteX122" fmla="*/ 775625 w 3160170"/>
                    <a:gd name="connsiteY122" fmla="*/ 714412 h 922177"/>
                    <a:gd name="connsiteX123" fmla="*/ 712125 w 3160170"/>
                    <a:gd name="connsiteY123" fmla="*/ 727112 h 922177"/>
                    <a:gd name="connsiteX124" fmla="*/ 677200 w 3160170"/>
                    <a:gd name="connsiteY124" fmla="*/ 739812 h 922177"/>
                    <a:gd name="connsiteX125" fmla="*/ 547025 w 3160170"/>
                    <a:gd name="connsiteY125" fmla="*/ 733462 h 922177"/>
                    <a:gd name="connsiteX126" fmla="*/ 400975 w 3160170"/>
                    <a:gd name="connsiteY126" fmla="*/ 720762 h 922177"/>
                    <a:gd name="connsiteX127" fmla="*/ 366050 w 3160170"/>
                    <a:gd name="connsiteY127" fmla="*/ 723937 h 922177"/>
                    <a:gd name="connsiteX128" fmla="*/ 319172 w 3160170"/>
                    <a:gd name="connsiteY128" fmla="*/ 728979 h 922177"/>
                    <a:gd name="connsiteX129" fmla="*/ 232700 w 3160170"/>
                    <a:gd name="connsiteY129" fmla="*/ 717587 h 922177"/>
                    <a:gd name="connsiteX130" fmla="*/ 213650 w 3160170"/>
                    <a:gd name="connsiteY130" fmla="*/ 717587 h 922177"/>
                    <a:gd name="connsiteX131" fmla="*/ 146975 w 3160170"/>
                    <a:gd name="connsiteY131" fmla="*/ 717587 h 922177"/>
                    <a:gd name="connsiteX132" fmla="*/ 131100 w 3160170"/>
                    <a:gd name="connsiteY132" fmla="*/ 720762 h 922177"/>
                    <a:gd name="connsiteX133" fmla="*/ 99350 w 3160170"/>
                    <a:gd name="connsiteY133" fmla="*/ 733462 h 922177"/>
                    <a:gd name="connsiteX134" fmla="*/ 70775 w 3160170"/>
                    <a:gd name="connsiteY134" fmla="*/ 742987 h 922177"/>
                    <a:gd name="connsiteX135" fmla="*/ 17214 w 3160170"/>
                    <a:gd name="connsiteY135" fmla="*/ 752650 h 922177"/>
                    <a:gd name="connsiteX136" fmla="*/ 787 w 3160170"/>
                    <a:gd name="connsiteY136" fmla="*/ 787023 h 922177"/>
                    <a:gd name="connsiteX137" fmla="*/ 37782 w 3160170"/>
                    <a:gd name="connsiteY137" fmla="*/ 843206 h 922177"/>
                    <a:gd name="connsiteX138" fmla="*/ 80438 w 3160170"/>
                    <a:gd name="connsiteY138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29825 w 3160170"/>
                    <a:gd name="connsiteY64" fmla="*/ 161962 h 922177"/>
                    <a:gd name="connsiteX65" fmla="*/ 2664750 w 3160170"/>
                    <a:gd name="connsiteY65" fmla="*/ 174662 h 922177"/>
                    <a:gd name="connsiteX66" fmla="*/ 2693325 w 3160170"/>
                    <a:gd name="connsiteY66" fmla="*/ 181012 h 922177"/>
                    <a:gd name="connsiteX67" fmla="*/ 2721900 w 3160170"/>
                    <a:gd name="connsiteY67" fmla="*/ 215937 h 922177"/>
                    <a:gd name="connsiteX68" fmla="*/ 2763175 w 3160170"/>
                    <a:gd name="connsiteY68" fmla="*/ 285787 h 922177"/>
                    <a:gd name="connsiteX69" fmla="*/ 2779050 w 3160170"/>
                    <a:gd name="connsiteY69" fmla="*/ 320712 h 922177"/>
                    <a:gd name="connsiteX70" fmla="*/ 2791750 w 3160170"/>
                    <a:gd name="connsiteY70" fmla="*/ 361987 h 922177"/>
                    <a:gd name="connsiteX71" fmla="*/ 2804450 w 3160170"/>
                    <a:gd name="connsiteY71" fmla="*/ 400087 h 922177"/>
                    <a:gd name="connsiteX72" fmla="*/ 2807625 w 3160170"/>
                    <a:gd name="connsiteY72" fmla="*/ 419137 h 922177"/>
                    <a:gd name="connsiteX73" fmla="*/ 2807625 w 3160170"/>
                    <a:gd name="connsiteY73" fmla="*/ 441362 h 922177"/>
                    <a:gd name="connsiteX74" fmla="*/ 2810800 w 3160170"/>
                    <a:gd name="connsiteY74" fmla="*/ 476287 h 922177"/>
                    <a:gd name="connsiteX75" fmla="*/ 2813975 w 3160170"/>
                    <a:gd name="connsiteY75" fmla="*/ 504862 h 922177"/>
                    <a:gd name="connsiteX76" fmla="*/ 2817150 w 3160170"/>
                    <a:gd name="connsiteY76" fmla="*/ 530262 h 922177"/>
                    <a:gd name="connsiteX77" fmla="*/ 2817150 w 3160170"/>
                    <a:gd name="connsiteY77" fmla="*/ 558837 h 922177"/>
                    <a:gd name="connsiteX78" fmla="*/ 2813975 w 3160170"/>
                    <a:gd name="connsiteY78" fmla="*/ 571537 h 922177"/>
                    <a:gd name="connsiteX79" fmla="*/ 2807625 w 3160170"/>
                    <a:gd name="connsiteY79" fmla="*/ 584237 h 922177"/>
                    <a:gd name="connsiteX80" fmla="*/ 2798100 w 3160170"/>
                    <a:gd name="connsiteY80" fmla="*/ 603287 h 922177"/>
                    <a:gd name="connsiteX81" fmla="*/ 2794925 w 3160170"/>
                    <a:gd name="connsiteY81" fmla="*/ 619162 h 922177"/>
                    <a:gd name="connsiteX82" fmla="*/ 2794925 w 3160170"/>
                    <a:gd name="connsiteY82" fmla="*/ 635037 h 922177"/>
                    <a:gd name="connsiteX83" fmla="*/ 2798100 w 3160170"/>
                    <a:gd name="connsiteY83" fmla="*/ 647737 h 922177"/>
                    <a:gd name="connsiteX84" fmla="*/ 2798100 w 3160170"/>
                    <a:gd name="connsiteY84" fmla="*/ 647737 h 922177"/>
                    <a:gd name="connsiteX85" fmla="*/ 2747300 w 3160170"/>
                    <a:gd name="connsiteY85" fmla="*/ 666787 h 922177"/>
                    <a:gd name="connsiteX86" fmla="*/ 2696500 w 3160170"/>
                    <a:gd name="connsiteY86" fmla="*/ 676312 h 922177"/>
                    <a:gd name="connsiteX87" fmla="*/ 2648875 w 3160170"/>
                    <a:gd name="connsiteY87" fmla="*/ 682662 h 922177"/>
                    <a:gd name="connsiteX88" fmla="*/ 2623475 w 3160170"/>
                    <a:gd name="connsiteY88" fmla="*/ 682662 h 922177"/>
                    <a:gd name="connsiteX89" fmla="*/ 2585375 w 3160170"/>
                    <a:gd name="connsiteY89" fmla="*/ 682662 h 922177"/>
                    <a:gd name="connsiteX90" fmla="*/ 2547275 w 3160170"/>
                    <a:gd name="connsiteY90" fmla="*/ 679487 h 922177"/>
                    <a:gd name="connsiteX91" fmla="*/ 2531400 w 3160170"/>
                    <a:gd name="connsiteY91" fmla="*/ 682662 h 922177"/>
                    <a:gd name="connsiteX92" fmla="*/ 2506000 w 3160170"/>
                    <a:gd name="connsiteY92" fmla="*/ 695362 h 922177"/>
                    <a:gd name="connsiteX93" fmla="*/ 2483775 w 3160170"/>
                    <a:gd name="connsiteY93" fmla="*/ 704887 h 922177"/>
                    <a:gd name="connsiteX94" fmla="*/ 2439325 w 3160170"/>
                    <a:gd name="connsiteY94" fmla="*/ 714412 h 922177"/>
                    <a:gd name="connsiteX95" fmla="*/ 2394875 w 3160170"/>
                    <a:gd name="connsiteY95" fmla="*/ 723937 h 922177"/>
                    <a:gd name="connsiteX96" fmla="*/ 2347250 w 3160170"/>
                    <a:gd name="connsiteY96" fmla="*/ 730287 h 922177"/>
                    <a:gd name="connsiteX97" fmla="*/ 2315500 w 3160170"/>
                    <a:gd name="connsiteY97" fmla="*/ 717587 h 922177"/>
                    <a:gd name="connsiteX98" fmla="*/ 2252000 w 3160170"/>
                    <a:gd name="connsiteY98" fmla="*/ 704887 h 922177"/>
                    <a:gd name="connsiteX99" fmla="*/ 2213900 w 3160170"/>
                    <a:gd name="connsiteY99" fmla="*/ 698537 h 922177"/>
                    <a:gd name="connsiteX100" fmla="*/ 2172625 w 3160170"/>
                    <a:gd name="connsiteY100" fmla="*/ 692187 h 922177"/>
                    <a:gd name="connsiteX101" fmla="*/ 2115475 w 3160170"/>
                    <a:gd name="connsiteY101" fmla="*/ 682662 h 922177"/>
                    <a:gd name="connsiteX102" fmla="*/ 2077375 w 3160170"/>
                    <a:gd name="connsiteY102" fmla="*/ 676312 h 922177"/>
                    <a:gd name="connsiteX103" fmla="*/ 2029750 w 3160170"/>
                    <a:gd name="connsiteY103" fmla="*/ 666787 h 922177"/>
                    <a:gd name="connsiteX104" fmla="*/ 1915450 w 3160170"/>
                    <a:gd name="connsiteY104" fmla="*/ 660437 h 922177"/>
                    <a:gd name="connsiteX105" fmla="*/ 1855125 w 3160170"/>
                    <a:gd name="connsiteY105" fmla="*/ 663612 h 922177"/>
                    <a:gd name="connsiteX106" fmla="*/ 1769400 w 3160170"/>
                    <a:gd name="connsiteY106" fmla="*/ 666787 h 922177"/>
                    <a:gd name="connsiteX107" fmla="*/ 1731300 w 3160170"/>
                    <a:gd name="connsiteY107" fmla="*/ 673137 h 922177"/>
                    <a:gd name="connsiteX108" fmla="*/ 1686850 w 3160170"/>
                    <a:gd name="connsiteY108" fmla="*/ 695362 h 922177"/>
                    <a:gd name="connsiteX109" fmla="*/ 1629700 w 3160170"/>
                    <a:gd name="connsiteY109" fmla="*/ 717587 h 922177"/>
                    <a:gd name="connsiteX110" fmla="*/ 1585250 w 3160170"/>
                    <a:gd name="connsiteY110" fmla="*/ 739812 h 922177"/>
                    <a:gd name="connsiteX111" fmla="*/ 1528100 w 3160170"/>
                    <a:gd name="connsiteY111" fmla="*/ 755687 h 922177"/>
                    <a:gd name="connsiteX112" fmla="*/ 1496350 w 3160170"/>
                    <a:gd name="connsiteY112" fmla="*/ 774737 h 922177"/>
                    <a:gd name="connsiteX113" fmla="*/ 1470950 w 3160170"/>
                    <a:gd name="connsiteY113" fmla="*/ 781087 h 922177"/>
                    <a:gd name="connsiteX114" fmla="*/ 1426500 w 3160170"/>
                    <a:gd name="connsiteY114" fmla="*/ 800137 h 922177"/>
                    <a:gd name="connsiteX115" fmla="*/ 1353475 w 3160170"/>
                    <a:gd name="connsiteY115" fmla="*/ 777912 h 922177"/>
                    <a:gd name="connsiteX116" fmla="*/ 1242350 w 3160170"/>
                    <a:gd name="connsiteY116" fmla="*/ 752512 h 922177"/>
                    <a:gd name="connsiteX117" fmla="*/ 1169325 w 3160170"/>
                    <a:gd name="connsiteY117" fmla="*/ 736637 h 922177"/>
                    <a:gd name="connsiteX118" fmla="*/ 1029625 w 3160170"/>
                    <a:gd name="connsiteY118" fmla="*/ 704887 h 922177"/>
                    <a:gd name="connsiteX119" fmla="*/ 959775 w 3160170"/>
                    <a:gd name="connsiteY119" fmla="*/ 701712 h 922177"/>
                    <a:gd name="connsiteX120" fmla="*/ 867700 w 3160170"/>
                    <a:gd name="connsiteY120" fmla="*/ 698537 h 922177"/>
                    <a:gd name="connsiteX121" fmla="*/ 813725 w 3160170"/>
                    <a:gd name="connsiteY121" fmla="*/ 701712 h 922177"/>
                    <a:gd name="connsiteX122" fmla="*/ 775625 w 3160170"/>
                    <a:gd name="connsiteY122" fmla="*/ 714412 h 922177"/>
                    <a:gd name="connsiteX123" fmla="*/ 712125 w 3160170"/>
                    <a:gd name="connsiteY123" fmla="*/ 727112 h 922177"/>
                    <a:gd name="connsiteX124" fmla="*/ 677200 w 3160170"/>
                    <a:gd name="connsiteY124" fmla="*/ 739812 h 922177"/>
                    <a:gd name="connsiteX125" fmla="*/ 538060 w 3160170"/>
                    <a:gd name="connsiteY125" fmla="*/ 749150 h 922177"/>
                    <a:gd name="connsiteX126" fmla="*/ 400975 w 3160170"/>
                    <a:gd name="connsiteY126" fmla="*/ 720762 h 922177"/>
                    <a:gd name="connsiteX127" fmla="*/ 366050 w 3160170"/>
                    <a:gd name="connsiteY127" fmla="*/ 723937 h 922177"/>
                    <a:gd name="connsiteX128" fmla="*/ 319172 w 3160170"/>
                    <a:gd name="connsiteY128" fmla="*/ 728979 h 922177"/>
                    <a:gd name="connsiteX129" fmla="*/ 232700 w 3160170"/>
                    <a:gd name="connsiteY129" fmla="*/ 717587 h 922177"/>
                    <a:gd name="connsiteX130" fmla="*/ 213650 w 3160170"/>
                    <a:gd name="connsiteY130" fmla="*/ 717587 h 922177"/>
                    <a:gd name="connsiteX131" fmla="*/ 146975 w 3160170"/>
                    <a:gd name="connsiteY131" fmla="*/ 717587 h 922177"/>
                    <a:gd name="connsiteX132" fmla="*/ 131100 w 3160170"/>
                    <a:gd name="connsiteY132" fmla="*/ 720762 h 922177"/>
                    <a:gd name="connsiteX133" fmla="*/ 99350 w 3160170"/>
                    <a:gd name="connsiteY133" fmla="*/ 733462 h 922177"/>
                    <a:gd name="connsiteX134" fmla="*/ 70775 w 3160170"/>
                    <a:gd name="connsiteY134" fmla="*/ 742987 h 922177"/>
                    <a:gd name="connsiteX135" fmla="*/ 17214 w 3160170"/>
                    <a:gd name="connsiteY135" fmla="*/ 752650 h 922177"/>
                    <a:gd name="connsiteX136" fmla="*/ 787 w 3160170"/>
                    <a:gd name="connsiteY136" fmla="*/ 787023 h 922177"/>
                    <a:gd name="connsiteX137" fmla="*/ 37782 w 3160170"/>
                    <a:gd name="connsiteY137" fmla="*/ 843206 h 922177"/>
                    <a:gd name="connsiteX138" fmla="*/ 80438 w 3160170"/>
                    <a:gd name="connsiteY138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29825 w 3160170"/>
                    <a:gd name="connsiteY64" fmla="*/ 161962 h 922177"/>
                    <a:gd name="connsiteX65" fmla="*/ 2664750 w 3160170"/>
                    <a:gd name="connsiteY65" fmla="*/ 174662 h 922177"/>
                    <a:gd name="connsiteX66" fmla="*/ 2693325 w 3160170"/>
                    <a:gd name="connsiteY66" fmla="*/ 181012 h 922177"/>
                    <a:gd name="connsiteX67" fmla="*/ 2721900 w 3160170"/>
                    <a:gd name="connsiteY67" fmla="*/ 215937 h 922177"/>
                    <a:gd name="connsiteX68" fmla="*/ 2763175 w 3160170"/>
                    <a:gd name="connsiteY68" fmla="*/ 285787 h 922177"/>
                    <a:gd name="connsiteX69" fmla="*/ 2779050 w 3160170"/>
                    <a:gd name="connsiteY69" fmla="*/ 320712 h 922177"/>
                    <a:gd name="connsiteX70" fmla="*/ 2791750 w 3160170"/>
                    <a:gd name="connsiteY70" fmla="*/ 361987 h 922177"/>
                    <a:gd name="connsiteX71" fmla="*/ 2804450 w 3160170"/>
                    <a:gd name="connsiteY71" fmla="*/ 400087 h 922177"/>
                    <a:gd name="connsiteX72" fmla="*/ 2807625 w 3160170"/>
                    <a:gd name="connsiteY72" fmla="*/ 419137 h 922177"/>
                    <a:gd name="connsiteX73" fmla="*/ 2807625 w 3160170"/>
                    <a:gd name="connsiteY73" fmla="*/ 441362 h 922177"/>
                    <a:gd name="connsiteX74" fmla="*/ 2810800 w 3160170"/>
                    <a:gd name="connsiteY74" fmla="*/ 476287 h 922177"/>
                    <a:gd name="connsiteX75" fmla="*/ 2813975 w 3160170"/>
                    <a:gd name="connsiteY75" fmla="*/ 504862 h 922177"/>
                    <a:gd name="connsiteX76" fmla="*/ 2817150 w 3160170"/>
                    <a:gd name="connsiteY76" fmla="*/ 530262 h 922177"/>
                    <a:gd name="connsiteX77" fmla="*/ 2817150 w 3160170"/>
                    <a:gd name="connsiteY77" fmla="*/ 558837 h 922177"/>
                    <a:gd name="connsiteX78" fmla="*/ 2813975 w 3160170"/>
                    <a:gd name="connsiteY78" fmla="*/ 571537 h 922177"/>
                    <a:gd name="connsiteX79" fmla="*/ 2807625 w 3160170"/>
                    <a:gd name="connsiteY79" fmla="*/ 584237 h 922177"/>
                    <a:gd name="connsiteX80" fmla="*/ 2798100 w 3160170"/>
                    <a:gd name="connsiteY80" fmla="*/ 603287 h 922177"/>
                    <a:gd name="connsiteX81" fmla="*/ 2794925 w 3160170"/>
                    <a:gd name="connsiteY81" fmla="*/ 619162 h 922177"/>
                    <a:gd name="connsiteX82" fmla="*/ 2794925 w 3160170"/>
                    <a:gd name="connsiteY82" fmla="*/ 635037 h 922177"/>
                    <a:gd name="connsiteX83" fmla="*/ 2798100 w 3160170"/>
                    <a:gd name="connsiteY83" fmla="*/ 647737 h 922177"/>
                    <a:gd name="connsiteX84" fmla="*/ 2798100 w 3160170"/>
                    <a:gd name="connsiteY84" fmla="*/ 647737 h 922177"/>
                    <a:gd name="connsiteX85" fmla="*/ 2747300 w 3160170"/>
                    <a:gd name="connsiteY85" fmla="*/ 666787 h 922177"/>
                    <a:gd name="connsiteX86" fmla="*/ 2696500 w 3160170"/>
                    <a:gd name="connsiteY86" fmla="*/ 676312 h 922177"/>
                    <a:gd name="connsiteX87" fmla="*/ 2648875 w 3160170"/>
                    <a:gd name="connsiteY87" fmla="*/ 682662 h 922177"/>
                    <a:gd name="connsiteX88" fmla="*/ 2623475 w 3160170"/>
                    <a:gd name="connsiteY88" fmla="*/ 682662 h 922177"/>
                    <a:gd name="connsiteX89" fmla="*/ 2585375 w 3160170"/>
                    <a:gd name="connsiteY89" fmla="*/ 682662 h 922177"/>
                    <a:gd name="connsiteX90" fmla="*/ 2547275 w 3160170"/>
                    <a:gd name="connsiteY90" fmla="*/ 679487 h 922177"/>
                    <a:gd name="connsiteX91" fmla="*/ 2531400 w 3160170"/>
                    <a:gd name="connsiteY91" fmla="*/ 682662 h 922177"/>
                    <a:gd name="connsiteX92" fmla="*/ 2506000 w 3160170"/>
                    <a:gd name="connsiteY92" fmla="*/ 695362 h 922177"/>
                    <a:gd name="connsiteX93" fmla="*/ 2483775 w 3160170"/>
                    <a:gd name="connsiteY93" fmla="*/ 704887 h 922177"/>
                    <a:gd name="connsiteX94" fmla="*/ 2439325 w 3160170"/>
                    <a:gd name="connsiteY94" fmla="*/ 714412 h 922177"/>
                    <a:gd name="connsiteX95" fmla="*/ 2394875 w 3160170"/>
                    <a:gd name="connsiteY95" fmla="*/ 723937 h 922177"/>
                    <a:gd name="connsiteX96" fmla="*/ 2347250 w 3160170"/>
                    <a:gd name="connsiteY96" fmla="*/ 730287 h 922177"/>
                    <a:gd name="connsiteX97" fmla="*/ 2315500 w 3160170"/>
                    <a:gd name="connsiteY97" fmla="*/ 717587 h 922177"/>
                    <a:gd name="connsiteX98" fmla="*/ 2252000 w 3160170"/>
                    <a:gd name="connsiteY98" fmla="*/ 704887 h 922177"/>
                    <a:gd name="connsiteX99" fmla="*/ 2213900 w 3160170"/>
                    <a:gd name="connsiteY99" fmla="*/ 698537 h 922177"/>
                    <a:gd name="connsiteX100" fmla="*/ 2172625 w 3160170"/>
                    <a:gd name="connsiteY100" fmla="*/ 692187 h 922177"/>
                    <a:gd name="connsiteX101" fmla="*/ 2115475 w 3160170"/>
                    <a:gd name="connsiteY101" fmla="*/ 682662 h 922177"/>
                    <a:gd name="connsiteX102" fmla="*/ 2077375 w 3160170"/>
                    <a:gd name="connsiteY102" fmla="*/ 676312 h 922177"/>
                    <a:gd name="connsiteX103" fmla="*/ 2029750 w 3160170"/>
                    <a:gd name="connsiteY103" fmla="*/ 666787 h 922177"/>
                    <a:gd name="connsiteX104" fmla="*/ 1915450 w 3160170"/>
                    <a:gd name="connsiteY104" fmla="*/ 660437 h 922177"/>
                    <a:gd name="connsiteX105" fmla="*/ 1855125 w 3160170"/>
                    <a:gd name="connsiteY105" fmla="*/ 663612 h 922177"/>
                    <a:gd name="connsiteX106" fmla="*/ 1769400 w 3160170"/>
                    <a:gd name="connsiteY106" fmla="*/ 666787 h 922177"/>
                    <a:gd name="connsiteX107" fmla="*/ 1731300 w 3160170"/>
                    <a:gd name="connsiteY107" fmla="*/ 673137 h 922177"/>
                    <a:gd name="connsiteX108" fmla="*/ 1686850 w 3160170"/>
                    <a:gd name="connsiteY108" fmla="*/ 695362 h 922177"/>
                    <a:gd name="connsiteX109" fmla="*/ 1629700 w 3160170"/>
                    <a:gd name="connsiteY109" fmla="*/ 717587 h 922177"/>
                    <a:gd name="connsiteX110" fmla="*/ 1585250 w 3160170"/>
                    <a:gd name="connsiteY110" fmla="*/ 739812 h 922177"/>
                    <a:gd name="connsiteX111" fmla="*/ 1528100 w 3160170"/>
                    <a:gd name="connsiteY111" fmla="*/ 755687 h 922177"/>
                    <a:gd name="connsiteX112" fmla="*/ 1496350 w 3160170"/>
                    <a:gd name="connsiteY112" fmla="*/ 774737 h 922177"/>
                    <a:gd name="connsiteX113" fmla="*/ 1470950 w 3160170"/>
                    <a:gd name="connsiteY113" fmla="*/ 781087 h 922177"/>
                    <a:gd name="connsiteX114" fmla="*/ 1426500 w 3160170"/>
                    <a:gd name="connsiteY114" fmla="*/ 800137 h 922177"/>
                    <a:gd name="connsiteX115" fmla="*/ 1353475 w 3160170"/>
                    <a:gd name="connsiteY115" fmla="*/ 777912 h 922177"/>
                    <a:gd name="connsiteX116" fmla="*/ 1242350 w 3160170"/>
                    <a:gd name="connsiteY116" fmla="*/ 752512 h 922177"/>
                    <a:gd name="connsiteX117" fmla="*/ 1169325 w 3160170"/>
                    <a:gd name="connsiteY117" fmla="*/ 736637 h 922177"/>
                    <a:gd name="connsiteX118" fmla="*/ 1029625 w 3160170"/>
                    <a:gd name="connsiteY118" fmla="*/ 704887 h 922177"/>
                    <a:gd name="connsiteX119" fmla="*/ 959775 w 3160170"/>
                    <a:gd name="connsiteY119" fmla="*/ 701712 h 922177"/>
                    <a:gd name="connsiteX120" fmla="*/ 867700 w 3160170"/>
                    <a:gd name="connsiteY120" fmla="*/ 698537 h 922177"/>
                    <a:gd name="connsiteX121" fmla="*/ 813725 w 3160170"/>
                    <a:gd name="connsiteY121" fmla="*/ 701712 h 922177"/>
                    <a:gd name="connsiteX122" fmla="*/ 775625 w 3160170"/>
                    <a:gd name="connsiteY122" fmla="*/ 714412 h 922177"/>
                    <a:gd name="connsiteX123" fmla="*/ 712125 w 3160170"/>
                    <a:gd name="connsiteY123" fmla="*/ 727112 h 922177"/>
                    <a:gd name="connsiteX124" fmla="*/ 677200 w 3160170"/>
                    <a:gd name="connsiteY124" fmla="*/ 739812 h 922177"/>
                    <a:gd name="connsiteX125" fmla="*/ 538060 w 3160170"/>
                    <a:gd name="connsiteY125" fmla="*/ 749150 h 922177"/>
                    <a:gd name="connsiteX126" fmla="*/ 427869 w 3160170"/>
                    <a:gd name="connsiteY126" fmla="*/ 731968 h 922177"/>
                    <a:gd name="connsiteX127" fmla="*/ 366050 w 3160170"/>
                    <a:gd name="connsiteY127" fmla="*/ 723937 h 922177"/>
                    <a:gd name="connsiteX128" fmla="*/ 319172 w 3160170"/>
                    <a:gd name="connsiteY128" fmla="*/ 728979 h 922177"/>
                    <a:gd name="connsiteX129" fmla="*/ 232700 w 3160170"/>
                    <a:gd name="connsiteY129" fmla="*/ 717587 h 922177"/>
                    <a:gd name="connsiteX130" fmla="*/ 213650 w 3160170"/>
                    <a:gd name="connsiteY130" fmla="*/ 717587 h 922177"/>
                    <a:gd name="connsiteX131" fmla="*/ 146975 w 3160170"/>
                    <a:gd name="connsiteY131" fmla="*/ 717587 h 922177"/>
                    <a:gd name="connsiteX132" fmla="*/ 131100 w 3160170"/>
                    <a:gd name="connsiteY132" fmla="*/ 720762 h 922177"/>
                    <a:gd name="connsiteX133" fmla="*/ 99350 w 3160170"/>
                    <a:gd name="connsiteY133" fmla="*/ 733462 h 922177"/>
                    <a:gd name="connsiteX134" fmla="*/ 70775 w 3160170"/>
                    <a:gd name="connsiteY134" fmla="*/ 742987 h 922177"/>
                    <a:gd name="connsiteX135" fmla="*/ 17214 w 3160170"/>
                    <a:gd name="connsiteY135" fmla="*/ 752650 h 922177"/>
                    <a:gd name="connsiteX136" fmla="*/ 787 w 3160170"/>
                    <a:gd name="connsiteY136" fmla="*/ 787023 h 922177"/>
                    <a:gd name="connsiteX137" fmla="*/ 37782 w 3160170"/>
                    <a:gd name="connsiteY137" fmla="*/ 843206 h 922177"/>
                    <a:gd name="connsiteX138" fmla="*/ 80438 w 3160170"/>
                    <a:gd name="connsiteY138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693325 w 3160170"/>
                    <a:gd name="connsiteY65" fmla="*/ 181012 h 922177"/>
                    <a:gd name="connsiteX66" fmla="*/ 2721900 w 3160170"/>
                    <a:gd name="connsiteY66" fmla="*/ 215937 h 922177"/>
                    <a:gd name="connsiteX67" fmla="*/ 2763175 w 3160170"/>
                    <a:gd name="connsiteY67" fmla="*/ 285787 h 922177"/>
                    <a:gd name="connsiteX68" fmla="*/ 2779050 w 3160170"/>
                    <a:gd name="connsiteY68" fmla="*/ 320712 h 922177"/>
                    <a:gd name="connsiteX69" fmla="*/ 2791750 w 3160170"/>
                    <a:gd name="connsiteY69" fmla="*/ 361987 h 922177"/>
                    <a:gd name="connsiteX70" fmla="*/ 2804450 w 3160170"/>
                    <a:gd name="connsiteY70" fmla="*/ 400087 h 922177"/>
                    <a:gd name="connsiteX71" fmla="*/ 2807625 w 3160170"/>
                    <a:gd name="connsiteY71" fmla="*/ 419137 h 922177"/>
                    <a:gd name="connsiteX72" fmla="*/ 2807625 w 3160170"/>
                    <a:gd name="connsiteY72" fmla="*/ 441362 h 922177"/>
                    <a:gd name="connsiteX73" fmla="*/ 2810800 w 3160170"/>
                    <a:gd name="connsiteY73" fmla="*/ 476287 h 922177"/>
                    <a:gd name="connsiteX74" fmla="*/ 2813975 w 3160170"/>
                    <a:gd name="connsiteY74" fmla="*/ 504862 h 922177"/>
                    <a:gd name="connsiteX75" fmla="*/ 2817150 w 3160170"/>
                    <a:gd name="connsiteY75" fmla="*/ 530262 h 922177"/>
                    <a:gd name="connsiteX76" fmla="*/ 2817150 w 3160170"/>
                    <a:gd name="connsiteY76" fmla="*/ 558837 h 922177"/>
                    <a:gd name="connsiteX77" fmla="*/ 2813975 w 3160170"/>
                    <a:gd name="connsiteY77" fmla="*/ 571537 h 922177"/>
                    <a:gd name="connsiteX78" fmla="*/ 2807625 w 3160170"/>
                    <a:gd name="connsiteY78" fmla="*/ 584237 h 922177"/>
                    <a:gd name="connsiteX79" fmla="*/ 2798100 w 3160170"/>
                    <a:gd name="connsiteY79" fmla="*/ 603287 h 922177"/>
                    <a:gd name="connsiteX80" fmla="*/ 2794925 w 3160170"/>
                    <a:gd name="connsiteY80" fmla="*/ 619162 h 922177"/>
                    <a:gd name="connsiteX81" fmla="*/ 2794925 w 3160170"/>
                    <a:gd name="connsiteY81" fmla="*/ 635037 h 922177"/>
                    <a:gd name="connsiteX82" fmla="*/ 2798100 w 3160170"/>
                    <a:gd name="connsiteY82" fmla="*/ 647737 h 922177"/>
                    <a:gd name="connsiteX83" fmla="*/ 2798100 w 3160170"/>
                    <a:gd name="connsiteY83" fmla="*/ 647737 h 922177"/>
                    <a:gd name="connsiteX84" fmla="*/ 2747300 w 3160170"/>
                    <a:gd name="connsiteY84" fmla="*/ 666787 h 922177"/>
                    <a:gd name="connsiteX85" fmla="*/ 2696500 w 3160170"/>
                    <a:gd name="connsiteY85" fmla="*/ 676312 h 922177"/>
                    <a:gd name="connsiteX86" fmla="*/ 2648875 w 3160170"/>
                    <a:gd name="connsiteY86" fmla="*/ 682662 h 922177"/>
                    <a:gd name="connsiteX87" fmla="*/ 2623475 w 3160170"/>
                    <a:gd name="connsiteY87" fmla="*/ 682662 h 922177"/>
                    <a:gd name="connsiteX88" fmla="*/ 2585375 w 3160170"/>
                    <a:gd name="connsiteY88" fmla="*/ 682662 h 922177"/>
                    <a:gd name="connsiteX89" fmla="*/ 2547275 w 3160170"/>
                    <a:gd name="connsiteY89" fmla="*/ 679487 h 922177"/>
                    <a:gd name="connsiteX90" fmla="*/ 2531400 w 3160170"/>
                    <a:gd name="connsiteY90" fmla="*/ 682662 h 922177"/>
                    <a:gd name="connsiteX91" fmla="*/ 2506000 w 3160170"/>
                    <a:gd name="connsiteY91" fmla="*/ 695362 h 922177"/>
                    <a:gd name="connsiteX92" fmla="*/ 2483775 w 3160170"/>
                    <a:gd name="connsiteY92" fmla="*/ 704887 h 922177"/>
                    <a:gd name="connsiteX93" fmla="*/ 2439325 w 3160170"/>
                    <a:gd name="connsiteY93" fmla="*/ 714412 h 922177"/>
                    <a:gd name="connsiteX94" fmla="*/ 2394875 w 3160170"/>
                    <a:gd name="connsiteY94" fmla="*/ 723937 h 922177"/>
                    <a:gd name="connsiteX95" fmla="*/ 2347250 w 3160170"/>
                    <a:gd name="connsiteY95" fmla="*/ 730287 h 922177"/>
                    <a:gd name="connsiteX96" fmla="*/ 2315500 w 3160170"/>
                    <a:gd name="connsiteY96" fmla="*/ 717587 h 922177"/>
                    <a:gd name="connsiteX97" fmla="*/ 2252000 w 3160170"/>
                    <a:gd name="connsiteY97" fmla="*/ 704887 h 922177"/>
                    <a:gd name="connsiteX98" fmla="*/ 2213900 w 3160170"/>
                    <a:gd name="connsiteY98" fmla="*/ 698537 h 922177"/>
                    <a:gd name="connsiteX99" fmla="*/ 2172625 w 3160170"/>
                    <a:gd name="connsiteY99" fmla="*/ 692187 h 922177"/>
                    <a:gd name="connsiteX100" fmla="*/ 2115475 w 3160170"/>
                    <a:gd name="connsiteY100" fmla="*/ 682662 h 922177"/>
                    <a:gd name="connsiteX101" fmla="*/ 2077375 w 3160170"/>
                    <a:gd name="connsiteY101" fmla="*/ 676312 h 922177"/>
                    <a:gd name="connsiteX102" fmla="*/ 2029750 w 3160170"/>
                    <a:gd name="connsiteY102" fmla="*/ 666787 h 922177"/>
                    <a:gd name="connsiteX103" fmla="*/ 1915450 w 3160170"/>
                    <a:gd name="connsiteY103" fmla="*/ 660437 h 922177"/>
                    <a:gd name="connsiteX104" fmla="*/ 1855125 w 3160170"/>
                    <a:gd name="connsiteY104" fmla="*/ 663612 h 922177"/>
                    <a:gd name="connsiteX105" fmla="*/ 1769400 w 3160170"/>
                    <a:gd name="connsiteY105" fmla="*/ 666787 h 922177"/>
                    <a:gd name="connsiteX106" fmla="*/ 1731300 w 3160170"/>
                    <a:gd name="connsiteY106" fmla="*/ 673137 h 922177"/>
                    <a:gd name="connsiteX107" fmla="*/ 1686850 w 3160170"/>
                    <a:gd name="connsiteY107" fmla="*/ 695362 h 922177"/>
                    <a:gd name="connsiteX108" fmla="*/ 1629700 w 3160170"/>
                    <a:gd name="connsiteY108" fmla="*/ 717587 h 922177"/>
                    <a:gd name="connsiteX109" fmla="*/ 1585250 w 3160170"/>
                    <a:gd name="connsiteY109" fmla="*/ 739812 h 922177"/>
                    <a:gd name="connsiteX110" fmla="*/ 1528100 w 3160170"/>
                    <a:gd name="connsiteY110" fmla="*/ 755687 h 922177"/>
                    <a:gd name="connsiteX111" fmla="*/ 1496350 w 3160170"/>
                    <a:gd name="connsiteY111" fmla="*/ 774737 h 922177"/>
                    <a:gd name="connsiteX112" fmla="*/ 1470950 w 3160170"/>
                    <a:gd name="connsiteY112" fmla="*/ 781087 h 922177"/>
                    <a:gd name="connsiteX113" fmla="*/ 1426500 w 3160170"/>
                    <a:gd name="connsiteY113" fmla="*/ 800137 h 922177"/>
                    <a:gd name="connsiteX114" fmla="*/ 1353475 w 3160170"/>
                    <a:gd name="connsiteY114" fmla="*/ 777912 h 922177"/>
                    <a:gd name="connsiteX115" fmla="*/ 1242350 w 3160170"/>
                    <a:gd name="connsiteY115" fmla="*/ 752512 h 922177"/>
                    <a:gd name="connsiteX116" fmla="*/ 1169325 w 3160170"/>
                    <a:gd name="connsiteY116" fmla="*/ 736637 h 922177"/>
                    <a:gd name="connsiteX117" fmla="*/ 1029625 w 3160170"/>
                    <a:gd name="connsiteY117" fmla="*/ 704887 h 922177"/>
                    <a:gd name="connsiteX118" fmla="*/ 959775 w 3160170"/>
                    <a:gd name="connsiteY118" fmla="*/ 701712 h 922177"/>
                    <a:gd name="connsiteX119" fmla="*/ 867700 w 3160170"/>
                    <a:gd name="connsiteY119" fmla="*/ 698537 h 922177"/>
                    <a:gd name="connsiteX120" fmla="*/ 813725 w 3160170"/>
                    <a:gd name="connsiteY120" fmla="*/ 701712 h 922177"/>
                    <a:gd name="connsiteX121" fmla="*/ 775625 w 3160170"/>
                    <a:gd name="connsiteY121" fmla="*/ 714412 h 922177"/>
                    <a:gd name="connsiteX122" fmla="*/ 712125 w 3160170"/>
                    <a:gd name="connsiteY122" fmla="*/ 727112 h 922177"/>
                    <a:gd name="connsiteX123" fmla="*/ 677200 w 3160170"/>
                    <a:gd name="connsiteY123" fmla="*/ 739812 h 922177"/>
                    <a:gd name="connsiteX124" fmla="*/ 538060 w 3160170"/>
                    <a:gd name="connsiteY124" fmla="*/ 749150 h 922177"/>
                    <a:gd name="connsiteX125" fmla="*/ 427869 w 3160170"/>
                    <a:gd name="connsiteY125" fmla="*/ 731968 h 922177"/>
                    <a:gd name="connsiteX126" fmla="*/ 366050 w 3160170"/>
                    <a:gd name="connsiteY126" fmla="*/ 723937 h 922177"/>
                    <a:gd name="connsiteX127" fmla="*/ 319172 w 3160170"/>
                    <a:gd name="connsiteY127" fmla="*/ 728979 h 922177"/>
                    <a:gd name="connsiteX128" fmla="*/ 232700 w 3160170"/>
                    <a:gd name="connsiteY128" fmla="*/ 717587 h 922177"/>
                    <a:gd name="connsiteX129" fmla="*/ 213650 w 3160170"/>
                    <a:gd name="connsiteY129" fmla="*/ 717587 h 922177"/>
                    <a:gd name="connsiteX130" fmla="*/ 146975 w 3160170"/>
                    <a:gd name="connsiteY130" fmla="*/ 717587 h 922177"/>
                    <a:gd name="connsiteX131" fmla="*/ 131100 w 3160170"/>
                    <a:gd name="connsiteY131" fmla="*/ 720762 h 922177"/>
                    <a:gd name="connsiteX132" fmla="*/ 99350 w 3160170"/>
                    <a:gd name="connsiteY132" fmla="*/ 733462 h 922177"/>
                    <a:gd name="connsiteX133" fmla="*/ 70775 w 3160170"/>
                    <a:gd name="connsiteY133" fmla="*/ 742987 h 922177"/>
                    <a:gd name="connsiteX134" fmla="*/ 17214 w 3160170"/>
                    <a:gd name="connsiteY134" fmla="*/ 752650 h 922177"/>
                    <a:gd name="connsiteX135" fmla="*/ 787 w 3160170"/>
                    <a:gd name="connsiteY135" fmla="*/ 787023 h 922177"/>
                    <a:gd name="connsiteX136" fmla="*/ 37782 w 3160170"/>
                    <a:gd name="connsiteY136" fmla="*/ 843206 h 922177"/>
                    <a:gd name="connsiteX137" fmla="*/ 80438 w 3160170"/>
                    <a:gd name="connsiteY137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47275 w 3160170"/>
                    <a:gd name="connsiteY88" fmla="*/ 679487 h 922177"/>
                    <a:gd name="connsiteX89" fmla="*/ 2531400 w 3160170"/>
                    <a:gd name="connsiteY89" fmla="*/ 682662 h 922177"/>
                    <a:gd name="connsiteX90" fmla="*/ 2506000 w 3160170"/>
                    <a:gd name="connsiteY90" fmla="*/ 695362 h 922177"/>
                    <a:gd name="connsiteX91" fmla="*/ 2483775 w 3160170"/>
                    <a:gd name="connsiteY91" fmla="*/ 704887 h 922177"/>
                    <a:gd name="connsiteX92" fmla="*/ 2439325 w 3160170"/>
                    <a:gd name="connsiteY92" fmla="*/ 714412 h 922177"/>
                    <a:gd name="connsiteX93" fmla="*/ 2394875 w 3160170"/>
                    <a:gd name="connsiteY93" fmla="*/ 723937 h 922177"/>
                    <a:gd name="connsiteX94" fmla="*/ 2347250 w 3160170"/>
                    <a:gd name="connsiteY94" fmla="*/ 730287 h 922177"/>
                    <a:gd name="connsiteX95" fmla="*/ 2315500 w 3160170"/>
                    <a:gd name="connsiteY95" fmla="*/ 717587 h 922177"/>
                    <a:gd name="connsiteX96" fmla="*/ 2252000 w 3160170"/>
                    <a:gd name="connsiteY96" fmla="*/ 704887 h 922177"/>
                    <a:gd name="connsiteX97" fmla="*/ 2213900 w 3160170"/>
                    <a:gd name="connsiteY97" fmla="*/ 698537 h 922177"/>
                    <a:gd name="connsiteX98" fmla="*/ 2172625 w 3160170"/>
                    <a:gd name="connsiteY98" fmla="*/ 692187 h 922177"/>
                    <a:gd name="connsiteX99" fmla="*/ 2115475 w 3160170"/>
                    <a:gd name="connsiteY99" fmla="*/ 682662 h 922177"/>
                    <a:gd name="connsiteX100" fmla="*/ 2077375 w 3160170"/>
                    <a:gd name="connsiteY100" fmla="*/ 676312 h 922177"/>
                    <a:gd name="connsiteX101" fmla="*/ 2029750 w 3160170"/>
                    <a:gd name="connsiteY101" fmla="*/ 666787 h 922177"/>
                    <a:gd name="connsiteX102" fmla="*/ 1915450 w 3160170"/>
                    <a:gd name="connsiteY102" fmla="*/ 660437 h 922177"/>
                    <a:gd name="connsiteX103" fmla="*/ 1855125 w 3160170"/>
                    <a:gd name="connsiteY103" fmla="*/ 663612 h 922177"/>
                    <a:gd name="connsiteX104" fmla="*/ 1769400 w 3160170"/>
                    <a:gd name="connsiteY104" fmla="*/ 666787 h 922177"/>
                    <a:gd name="connsiteX105" fmla="*/ 1731300 w 3160170"/>
                    <a:gd name="connsiteY105" fmla="*/ 673137 h 922177"/>
                    <a:gd name="connsiteX106" fmla="*/ 1686850 w 3160170"/>
                    <a:gd name="connsiteY106" fmla="*/ 695362 h 922177"/>
                    <a:gd name="connsiteX107" fmla="*/ 1629700 w 3160170"/>
                    <a:gd name="connsiteY107" fmla="*/ 717587 h 922177"/>
                    <a:gd name="connsiteX108" fmla="*/ 1585250 w 3160170"/>
                    <a:gd name="connsiteY108" fmla="*/ 739812 h 922177"/>
                    <a:gd name="connsiteX109" fmla="*/ 1528100 w 3160170"/>
                    <a:gd name="connsiteY109" fmla="*/ 755687 h 922177"/>
                    <a:gd name="connsiteX110" fmla="*/ 1496350 w 3160170"/>
                    <a:gd name="connsiteY110" fmla="*/ 774737 h 922177"/>
                    <a:gd name="connsiteX111" fmla="*/ 1470950 w 3160170"/>
                    <a:gd name="connsiteY111" fmla="*/ 781087 h 922177"/>
                    <a:gd name="connsiteX112" fmla="*/ 1426500 w 3160170"/>
                    <a:gd name="connsiteY112" fmla="*/ 800137 h 922177"/>
                    <a:gd name="connsiteX113" fmla="*/ 1353475 w 3160170"/>
                    <a:gd name="connsiteY113" fmla="*/ 777912 h 922177"/>
                    <a:gd name="connsiteX114" fmla="*/ 1242350 w 3160170"/>
                    <a:gd name="connsiteY114" fmla="*/ 752512 h 922177"/>
                    <a:gd name="connsiteX115" fmla="*/ 1169325 w 3160170"/>
                    <a:gd name="connsiteY115" fmla="*/ 736637 h 922177"/>
                    <a:gd name="connsiteX116" fmla="*/ 1029625 w 3160170"/>
                    <a:gd name="connsiteY116" fmla="*/ 704887 h 922177"/>
                    <a:gd name="connsiteX117" fmla="*/ 959775 w 3160170"/>
                    <a:gd name="connsiteY117" fmla="*/ 701712 h 922177"/>
                    <a:gd name="connsiteX118" fmla="*/ 867700 w 3160170"/>
                    <a:gd name="connsiteY118" fmla="*/ 698537 h 922177"/>
                    <a:gd name="connsiteX119" fmla="*/ 813725 w 3160170"/>
                    <a:gd name="connsiteY119" fmla="*/ 701712 h 922177"/>
                    <a:gd name="connsiteX120" fmla="*/ 775625 w 3160170"/>
                    <a:gd name="connsiteY120" fmla="*/ 714412 h 922177"/>
                    <a:gd name="connsiteX121" fmla="*/ 712125 w 3160170"/>
                    <a:gd name="connsiteY121" fmla="*/ 727112 h 922177"/>
                    <a:gd name="connsiteX122" fmla="*/ 677200 w 3160170"/>
                    <a:gd name="connsiteY122" fmla="*/ 739812 h 922177"/>
                    <a:gd name="connsiteX123" fmla="*/ 538060 w 3160170"/>
                    <a:gd name="connsiteY123" fmla="*/ 749150 h 922177"/>
                    <a:gd name="connsiteX124" fmla="*/ 427869 w 3160170"/>
                    <a:gd name="connsiteY124" fmla="*/ 731968 h 922177"/>
                    <a:gd name="connsiteX125" fmla="*/ 366050 w 3160170"/>
                    <a:gd name="connsiteY125" fmla="*/ 723937 h 922177"/>
                    <a:gd name="connsiteX126" fmla="*/ 319172 w 3160170"/>
                    <a:gd name="connsiteY126" fmla="*/ 728979 h 922177"/>
                    <a:gd name="connsiteX127" fmla="*/ 232700 w 3160170"/>
                    <a:gd name="connsiteY127" fmla="*/ 717587 h 922177"/>
                    <a:gd name="connsiteX128" fmla="*/ 213650 w 3160170"/>
                    <a:gd name="connsiteY128" fmla="*/ 717587 h 922177"/>
                    <a:gd name="connsiteX129" fmla="*/ 146975 w 3160170"/>
                    <a:gd name="connsiteY129" fmla="*/ 717587 h 922177"/>
                    <a:gd name="connsiteX130" fmla="*/ 131100 w 3160170"/>
                    <a:gd name="connsiteY130" fmla="*/ 720762 h 922177"/>
                    <a:gd name="connsiteX131" fmla="*/ 99350 w 3160170"/>
                    <a:gd name="connsiteY131" fmla="*/ 733462 h 922177"/>
                    <a:gd name="connsiteX132" fmla="*/ 70775 w 3160170"/>
                    <a:gd name="connsiteY132" fmla="*/ 742987 h 922177"/>
                    <a:gd name="connsiteX133" fmla="*/ 17214 w 3160170"/>
                    <a:gd name="connsiteY133" fmla="*/ 752650 h 922177"/>
                    <a:gd name="connsiteX134" fmla="*/ 787 w 3160170"/>
                    <a:gd name="connsiteY134" fmla="*/ 787023 h 922177"/>
                    <a:gd name="connsiteX135" fmla="*/ 37782 w 3160170"/>
                    <a:gd name="connsiteY135" fmla="*/ 843206 h 922177"/>
                    <a:gd name="connsiteX136" fmla="*/ 80438 w 3160170"/>
                    <a:gd name="connsiteY136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47275 w 3160170"/>
                    <a:gd name="connsiteY88" fmla="*/ 679487 h 922177"/>
                    <a:gd name="connsiteX89" fmla="*/ 2531400 w 3160170"/>
                    <a:gd name="connsiteY89" fmla="*/ 682662 h 922177"/>
                    <a:gd name="connsiteX90" fmla="*/ 2483775 w 3160170"/>
                    <a:gd name="connsiteY90" fmla="*/ 704887 h 922177"/>
                    <a:gd name="connsiteX91" fmla="*/ 2439325 w 3160170"/>
                    <a:gd name="connsiteY91" fmla="*/ 714412 h 922177"/>
                    <a:gd name="connsiteX92" fmla="*/ 2394875 w 3160170"/>
                    <a:gd name="connsiteY92" fmla="*/ 723937 h 922177"/>
                    <a:gd name="connsiteX93" fmla="*/ 2347250 w 3160170"/>
                    <a:gd name="connsiteY93" fmla="*/ 730287 h 922177"/>
                    <a:gd name="connsiteX94" fmla="*/ 2315500 w 3160170"/>
                    <a:gd name="connsiteY94" fmla="*/ 717587 h 922177"/>
                    <a:gd name="connsiteX95" fmla="*/ 2252000 w 3160170"/>
                    <a:gd name="connsiteY95" fmla="*/ 704887 h 922177"/>
                    <a:gd name="connsiteX96" fmla="*/ 2213900 w 3160170"/>
                    <a:gd name="connsiteY96" fmla="*/ 698537 h 922177"/>
                    <a:gd name="connsiteX97" fmla="*/ 2172625 w 3160170"/>
                    <a:gd name="connsiteY97" fmla="*/ 692187 h 922177"/>
                    <a:gd name="connsiteX98" fmla="*/ 2115475 w 3160170"/>
                    <a:gd name="connsiteY98" fmla="*/ 682662 h 922177"/>
                    <a:gd name="connsiteX99" fmla="*/ 2077375 w 3160170"/>
                    <a:gd name="connsiteY99" fmla="*/ 676312 h 922177"/>
                    <a:gd name="connsiteX100" fmla="*/ 2029750 w 3160170"/>
                    <a:gd name="connsiteY100" fmla="*/ 666787 h 922177"/>
                    <a:gd name="connsiteX101" fmla="*/ 1915450 w 3160170"/>
                    <a:gd name="connsiteY101" fmla="*/ 660437 h 922177"/>
                    <a:gd name="connsiteX102" fmla="*/ 1855125 w 3160170"/>
                    <a:gd name="connsiteY102" fmla="*/ 663612 h 922177"/>
                    <a:gd name="connsiteX103" fmla="*/ 1769400 w 3160170"/>
                    <a:gd name="connsiteY103" fmla="*/ 666787 h 922177"/>
                    <a:gd name="connsiteX104" fmla="*/ 1731300 w 3160170"/>
                    <a:gd name="connsiteY104" fmla="*/ 673137 h 922177"/>
                    <a:gd name="connsiteX105" fmla="*/ 1686850 w 3160170"/>
                    <a:gd name="connsiteY105" fmla="*/ 695362 h 922177"/>
                    <a:gd name="connsiteX106" fmla="*/ 1629700 w 3160170"/>
                    <a:gd name="connsiteY106" fmla="*/ 717587 h 922177"/>
                    <a:gd name="connsiteX107" fmla="*/ 1585250 w 3160170"/>
                    <a:gd name="connsiteY107" fmla="*/ 739812 h 922177"/>
                    <a:gd name="connsiteX108" fmla="*/ 1528100 w 3160170"/>
                    <a:gd name="connsiteY108" fmla="*/ 755687 h 922177"/>
                    <a:gd name="connsiteX109" fmla="*/ 1496350 w 3160170"/>
                    <a:gd name="connsiteY109" fmla="*/ 774737 h 922177"/>
                    <a:gd name="connsiteX110" fmla="*/ 1470950 w 3160170"/>
                    <a:gd name="connsiteY110" fmla="*/ 781087 h 922177"/>
                    <a:gd name="connsiteX111" fmla="*/ 1426500 w 3160170"/>
                    <a:gd name="connsiteY111" fmla="*/ 800137 h 922177"/>
                    <a:gd name="connsiteX112" fmla="*/ 1353475 w 3160170"/>
                    <a:gd name="connsiteY112" fmla="*/ 777912 h 922177"/>
                    <a:gd name="connsiteX113" fmla="*/ 1242350 w 3160170"/>
                    <a:gd name="connsiteY113" fmla="*/ 752512 h 922177"/>
                    <a:gd name="connsiteX114" fmla="*/ 1169325 w 3160170"/>
                    <a:gd name="connsiteY114" fmla="*/ 736637 h 922177"/>
                    <a:gd name="connsiteX115" fmla="*/ 1029625 w 3160170"/>
                    <a:gd name="connsiteY115" fmla="*/ 704887 h 922177"/>
                    <a:gd name="connsiteX116" fmla="*/ 959775 w 3160170"/>
                    <a:gd name="connsiteY116" fmla="*/ 701712 h 922177"/>
                    <a:gd name="connsiteX117" fmla="*/ 867700 w 3160170"/>
                    <a:gd name="connsiteY117" fmla="*/ 698537 h 922177"/>
                    <a:gd name="connsiteX118" fmla="*/ 813725 w 3160170"/>
                    <a:gd name="connsiteY118" fmla="*/ 701712 h 922177"/>
                    <a:gd name="connsiteX119" fmla="*/ 775625 w 3160170"/>
                    <a:gd name="connsiteY119" fmla="*/ 714412 h 922177"/>
                    <a:gd name="connsiteX120" fmla="*/ 712125 w 3160170"/>
                    <a:gd name="connsiteY120" fmla="*/ 727112 h 922177"/>
                    <a:gd name="connsiteX121" fmla="*/ 677200 w 3160170"/>
                    <a:gd name="connsiteY121" fmla="*/ 739812 h 922177"/>
                    <a:gd name="connsiteX122" fmla="*/ 538060 w 3160170"/>
                    <a:gd name="connsiteY122" fmla="*/ 749150 h 922177"/>
                    <a:gd name="connsiteX123" fmla="*/ 427869 w 3160170"/>
                    <a:gd name="connsiteY123" fmla="*/ 731968 h 922177"/>
                    <a:gd name="connsiteX124" fmla="*/ 366050 w 3160170"/>
                    <a:gd name="connsiteY124" fmla="*/ 723937 h 922177"/>
                    <a:gd name="connsiteX125" fmla="*/ 319172 w 3160170"/>
                    <a:gd name="connsiteY125" fmla="*/ 728979 h 922177"/>
                    <a:gd name="connsiteX126" fmla="*/ 232700 w 3160170"/>
                    <a:gd name="connsiteY126" fmla="*/ 717587 h 922177"/>
                    <a:gd name="connsiteX127" fmla="*/ 213650 w 3160170"/>
                    <a:gd name="connsiteY127" fmla="*/ 717587 h 922177"/>
                    <a:gd name="connsiteX128" fmla="*/ 146975 w 3160170"/>
                    <a:gd name="connsiteY128" fmla="*/ 717587 h 922177"/>
                    <a:gd name="connsiteX129" fmla="*/ 131100 w 3160170"/>
                    <a:gd name="connsiteY129" fmla="*/ 720762 h 922177"/>
                    <a:gd name="connsiteX130" fmla="*/ 99350 w 3160170"/>
                    <a:gd name="connsiteY130" fmla="*/ 733462 h 922177"/>
                    <a:gd name="connsiteX131" fmla="*/ 70775 w 3160170"/>
                    <a:gd name="connsiteY131" fmla="*/ 742987 h 922177"/>
                    <a:gd name="connsiteX132" fmla="*/ 17214 w 3160170"/>
                    <a:gd name="connsiteY132" fmla="*/ 752650 h 922177"/>
                    <a:gd name="connsiteX133" fmla="*/ 787 w 3160170"/>
                    <a:gd name="connsiteY133" fmla="*/ 787023 h 922177"/>
                    <a:gd name="connsiteX134" fmla="*/ 37782 w 3160170"/>
                    <a:gd name="connsiteY134" fmla="*/ 843206 h 922177"/>
                    <a:gd name="connsiteX135" fmla="*/ 80438 w 3160170"/>
                    <a:gd name="connsiteY135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47275 w 3160170"/>
                    <a:gd name="connsiteY88" fmla="*/ 679487 h 922177"/>
                    <a:gd name="connsiteX89" fmla="*/ 2533641 w 3160170"/>
                    <a:gd name="connsiteY89" fmla="*/ 689385 h 922177"/>
                    <a:gd name="connsiteX90" fmla="*/ 2483775 w 3160170"/>
                    <a:gd name="connsiteY90" fmla="*/ 704887 h 922177"/>
                    <a:gd name="connsiteX91" fmla="*/ 2439325 w 3160170"/>
                    <a:gd name="connsiteY91" fmla="*/ 714412 h 922177"/>
                    <a:gd name="connsiteX92" fmla="*/ 2394875 w 3160170"/>
                    <a:gd name="connsiteY92" fmla="*/ 723937 h 922177"/>
                    <a:gd name="connsiteX93" fmla="*/ 2347250 w 3160170"/>
                    <a:gd name="connsiteY93" fmla="*/ 730287 h 922177"/>
                    <a:gd name="connsiteX94" fmla="*/ 2315500 w 3160170"/>
                    <a:gd name="connsiteY94" fmla="*/ 717587 h 922177"/>
                    <a:gd name="connsiteX95" fmla="*/ 2252000 w 3160170"/>
                    <a:gd name="connsiteY95" fmla="*/ 704887 h 922177"/>
                    <a:gd name="connsiteX96" fmla="*/ 2213900 w 3160170"/>
                    <a:gd name="connsiteY96" fmla="*/ 698537 h 922177"/>
                    <a:gd name="connsiteX97" fmla="*/ 2172625 w 3160170"/>
                    <a:gd name="connsiteY97" fmla="*/ 692187 h 922177"/>
                    <a:gd name="connsiteX98" fmla="*/ 2115475 w 3160170"/>
                    <a:gd name="connsiteY98" fmla="*/ 682662 h 922177"/>
                    <a:gd name="connsiteX99" fmla="*/ 2077375 w 3160170"/>
                    <a:gd name="connsiteY99" fmla="*/ 676312 h 922177"/>
                    <a:gd name="connsiteX100" fmla="*/ 2029750 w 3160170"/>
                    <a:gd name="connsiteY100" fmla="*/ 666787 h 922177"/>
                    <a:gd name="connsiteX101" fmla="*/ 1915450 w 3160170"/>
                    <a:gd name="connsiteY101" fmla="*/ 660437 h 922177"/>
                    <a:gd name="connsiteX102" fmla="*/ 1855125 w 3160170"/>
                    <a:gd name="connsiteY102" fmla="*/ 663612 h 922177"/>
                    <a:gd name="connsiteX103" fmla="*/ 1769400 w 3160170"/>
                    <a:gd name="connsiteY103" fmla="*/ 666787 h 922177"/>
                    <a:gd name="connsiteX104" fmla="*/ 1731300 w 3160170"/>
                    <a:gd name="connsiteY104" fmla="*/ 673137 h 922177"/>
                    <a:gd name="connsiteX105" fmla="*/ 1686850 w 3160170"/>
                    <a:gd name="connsiteY105" fmla="*/ 695362 h 922177"/>
                    <a:gd name="connsiteX106" fmla="*/ 1629700 w 3160170"/>
                    <a:gd name="connsiteY106" fmla="*/ 717587 h 922177"/>
                    <a:gd name="connsiteX107" fmla="*/ 1585250 w 3160170"/>
                    <a:gd name="connsiteY107" fmla="*/ 739812 h 922177"/>
                    <a:gd name="connsiteX108" fmla="*/ 1528100 w 3160170"/>
                    <a:gd name="connsiteY108" fmla="*/ 755687 h 922177"/>
                    <a:gd name="connsiteX109" fmla="*/ 1496350 w 3160170"/>
                    <a:gd name="connsiteY109" fmla="*/ 774737 h 922177"/>
                    <a:gd name="connsiteX110" fmla="*/ 1470950 w 3160170"/>
                    <a:gd name="connsiteY110" fmla="*/ 781087 h 922177"/>
                    <a:gd name="connsiteX111" fmla="*/ 1426500 w 3160170"/>
                    <a:gd name="connsiteY111" fmla="*/ 800137 h 922177"/>
                    <a:gd name="connsiteX112" fmla="*/ 1353475 w 3160170"/>
                    <a:gd name="connsiteY112" fmla="*/ 777912 h 922177"/>
                    <a:gd name="connsiteX113" fmla="*/ 1242350 w 3160170"/>
                    <a:gd name="connsiteY113" fmla="*/ 752512 h 922177"/>
                    <a:gd name="connsiteX114" fmla="*/ 1169325 w 3160170"/>
                    <a:gd name="connsiteY114" fmla="*/ 736637 h 922177"/>
                    <a:gd name="connsiteX115" fmla="*/ 1029625 w 3160170"/>
                    <a:gd name="connsiteY115" fmla="*/ 704887 h 922177"/>
                    <a:gd name="connsiteX116" fmla="*/ 959775 w 3160170"/>
                    <a:gd name="connsiteY116" fmla="*/ 701712 h 922177"/>
                    <a:gd name="connsiteX117" fmla="*/ 867700 w 3160170"/>
                    <a:gd name="connsiteY117" fmla="*/ 698537 h 922177"/>
                    <a:gd name="connsiteX118" fmla="*/ 813725 w 3160170"/>
                    <a:gd name="connsiteY118" fmla="*/ 701712 h 922177"/>
                    <a:gd name="connsiteX119" fmla="*/ 775625 w 3160170"/>
                    <a:gd name="connsiteY119" fmla="*/ 714412 h 922177"/>
                    <a:gd name="connsiteX120" fmla="*/ 712125 w 3160170"/>
                    <a:gd name="connsiteY120" fmla="*/ 727112 h 922177"/>
                    <a:gd name="connsiteX121" fmla="*/ 677200 w 3160170"/>
                    <a:gd name="connsiteY121" fmla="*/ 739812 h 922177"/>
                    <a:gd name="connsiteX122" fmla="*/ 538060 w 3160170"/>
                    <a:gd name="connsiteY122" fmla="*/ 749150 h 922177"/>
                    <a:gd name="connsiteX123" fmla="*/ 427869 w 3160170"/>
                    <a:gd name="connsiteY123" fmla="*/ 731968 h 922177"/>
                    <a:gd name="connsiteX124" fmla="*/ 366050 w 3160170"/>
                    <a:gd name="connsiteY124" fmla="*/ 723937 h 922177"/>
                    <a:gd name="connsiteX125" fmla="*/ 319172 w 3160170"/>
                    <a:gd name="connsiteY125" fmla="*/ 728979 h 922177"/>
                    <a:gd name="connsiteX126" fmla="*/ 232700 w 3160170"/>
                    <a:gd name="connsiteY126" fmla="*/ 717587 h 922177"/>
                    <a:gd name="connsiteX127" fmla="*/ 213650 w 3160170"/>
                    <a:gd name="connsiteY127" fmla="*/ 717587 h 922177"/>
                    <a:gd name="connsiteX128" fmla="*/ 146975 w 3160170"/>
                    <a:gd name="connsiteY128" fmla="*/ 717587 h 922177"/>
                    <a:gd name="connsiteX129" fmla="*/ 131100 w 3160170"/>
                    <a:gd name="connsiteY129" fmla="*/ 720762 h 922177"/>
                    <a:gd name="connsiteX130" fmla="*/ 99350 w 3160170"/>
                    <a:gd name="connsiteY130" fmla="*/ 733462 h 922177"/>
                    <a:gd name="connsiteX131" fmla="*/ 70775 w 3160170"/>
                    <a:gd name="connsiteY131" fmla="*/ 742987 h 922177"/>
                    <a:gd name="connsiteX132" fmla="*/ 17214 w 3160170"/>
                    <a:gd name="connsiteY132" fmla="*/ 752650 h 922177"/>
                    <a:gd name="connsiteX133" fmla="*/ 787 w 3160170"/>
                    <a:gd name="connsiteY133" fmla="*/ 787023 h 922177"/>
                    <a:gd name="connsiteX134" fmla="*/ 37782 w 3160170"/>
                    <a:gd name="connsiteY134" fmla="*/ 843206 h 922177"/>
                    <a:gd name="connsiteX135" fmla="*/ 80438 w 3160170"/>
                    <a:gd name="connsiteY135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47275 w 3160170"/>
                    <a:gd name="connsiteY88" fmla="*/ 679487 h 922177"/>
                    <a:gd name="connsiteX89" fmla="*/ 2483775 w 3160170"/>
                    <a:gd name="connsiteY89" fmla="*/ 704887 h 922177"/>
                    <a:gd name="connsiteX90" fmla="*/ 2439325 w 3160170"/>
                    <a:gd name="connsiteY90" fmla="*/ 714412 h 922177"/>
                    <a:gd name="connsiteX91" fmla="*/ 2394875 w 3160170"/>
                    <a:gd name="connsiteY91" fmla="*/ 723937 h 922177"/>
                    <a:gd name="connsiteX92" fmla="*/ 2347250 w 3160170"/>
                    <a:gd name="connsiteY92" fmla="*/ 730287 h 922177"/>
                    <a:gd name="connsiteX93" fmla="*/ 2315500 w 3160170"/>
                    <a:gd name="connsiteY93" fmla="*/ 717587 h 922177"/>
                    <a:gd name="connsiteX94" fmla="*/ 2252000 w 3160170"/>
                    <a:gd name="connsiteY94" fmla="*/ 704887 h 922177"/>
                    <a:gd name="connsiteX95" fmla="*/ 2213900 w 3160170"/>
                    <a:gd name="connsiteY95" fmla="*/ 698537 h 922177"/>
                    <a:gd name="connsiteX96" fmla="*/ 2172625 w 3160170"/>
                    <a:gd name="connsiteY96" fmla="*/ 692187 h 922177"/>
                    <a:gd name="connsiteX97" fmla="*/ 2115475 w 3160170"/>
                    <a:gd name="connsiteY97" fmla="*/ 682662 h 922177"/>
                    <a:gd name="connsiteX98" fmla="*/ 2077375 w 3160170"/>
                    <a:gd name="connsiteY98" fmla="*/ 676312 h 922177"/>
                    <a:gd name="connsiteX99" fmla="*/ 2029750 w 3160170"/>
                    <a:gd name="connsiteY99" fmla="*/ 666787 h 922177"/>
                    <a:gd name="connsiteX100" fmla="*/ 1915450 w 3160170"/>
                    <a:gd name="connsiteY100" fmla="*/ 660437 h 922177"/>
                    <a:gd name="connsiteX101" fmla="*/ 1855125 w 3160170"/>
                    <a:gd name="connsiteY101" fmla="*/ 663612 h 922177"/>
                    <a:gd name="connsiteX102" fmla="*/ 1769400 w 3160170"/>
                    <a:gd name="connsiteY102" fmla="*/ 666787 h 922177"/>
                    <a:gd name="connsiteX103" fmla="*/ 1731300 w 3160170"/>
                    <a:gd name="connsiteY103" fmla="*/ 673137 h 922177"/>
                    <a:gd name="connsiteX104" fmla="*/ 1686850 w 3160170"/>
                    <a:gd name="connsiteY104" fmla="*/ 695362 h 922177"/>
                    <a:gd name="connsiteX105" fmla="*/ 1629700 w 3160170"/>
                    <a:gd name="connsiteY105" fmla="*/ 717587 h 922177"/>
                    <a:gd name="connsiteX106" fmla="*/ 1585250 w 3160170"/>
                    <a:gd name="connsiteY106" fmla="*/ 739812 h 922177"/>
                    <a:gd name="connsiteX107" fmla="*/ 1528100 w 3160170"/>
                    <a:gd name="connsiteY107" fmla="*/ 755687 h 922177"/>
                    <a:gd name="connsiteX108" fmla="*/ 1496350 w 3160170"/>
                    <a:gd name="connsiteY108" fmla="*/ 774737 h 922177"/>
                    <a:gd name="connsiteX109" fmla="*/ 1470950 w 3160170"/>
                    <a:gd name="connsiteY109" fmla="*/ 781087 h 922177"/>
                    <a:gd name="connsiteX110" fmla="*/ 1426500 w 3160170"/>
                    <a:gd name="connsiteY110" fmla="*/ 800137 h 922177"/>
                    <a:gd name="connsiteX111" fmla="*/ 1353475 w 3160170"/>
                    <a:gd name="connsiteY111" fmla="*/ 777912 h 922177"/>
                    <a:gd name="connsiteX112" fmla="*/ 1242350 w 3160170"/>
                    <a:gd name="connsiteY112" fmla="*/ 752512 h 922177"/>
                    <a:gd name="connsiteX113" fmla="*/ 1169325 w 3160170"/>
                    <a:gd name="connsiteY113" fmla="*/ 736637 h 922177"/>
                    <a:gd name="connsiteX114" fmla="*/ 1029625 w 3160170"/>
                    <a:gd name="connsiteY114" fmla="*/ 704887 h 922177"/>
                    <a:gd name="connsiteX115" fmla="*/ 959775 w 3160170"/>
                    <a:gd name="connsiteY115" fmla="*/ 701712 h 922177"/>
                    <a:gd name="connsiteX116" fmla="*/ 867700 w 3160170"/>
                    <a:gd name="connsiteY116" fmla="*/ 698537 h 922177"/>
                    <a:gd name="connsiteX117" fmla="*/ 813725 w 3160170"/>
                    <a:gd name="connsiteY117" fmla="*/ 701712 h 922177"/>
                    <a:gd name="connsiteX118" fmla="*/ 775625 w 3160170"/>
                    <a:gd name="connsiteY118" fmla="*/ 714412 h 922177"/>
                    <a:gd name="connsiteX119" fmla="*/ 712125 w 3160170"/>
                    <a:gd name="connsiteY119" fmla="*/ 727112 h 922177"/>
                    <a:gd name="connsiteX120" fmla="*/ 677200 w 3160170"/>
                    <a:gd name="connsiteY120" fmla="*/ 739812 h 922177"/>
                    <a:gd name="connsiteX121" fmla="*/ 538060 w 3160170"/>
                    <a:gd name="connsiteY121" fmla="*/ 749150 h 922177"/>
                    <a:gd name="connsiteX122" fmla="*/ 427869 w 3160170"/>
                    <a:gd name="connsiteY122" fmla="*/ 731968 h 922177"/>
                    <a:gd name="connsiteX123" fmla="*/ 366050 w 3160170"/>
                    <a:gd name="connsiteY123" fmla="*/ 723937 h 922177"/>
                    <a:gd name="connsiteX124" fmla="*/ 319172 w 3160170"/>
                    <a:gd name="connsiteY124" fmla="*/ 728979 h 922177"/>
                    <a:gd name="connsiteX125" fmla="*/ 232700 w 3160170"/>
                    <a:gd name="connsiteY125" fmla="*/ 717587 h 922177"/>
                    <a:gd name="connsiteX126" fmla="*/ 213650 w 3160170"/>
                    <a:gd name="connsiteY126" fmla="*/ 717587 h 922177"/>
                    <a:gd name="connsiteX127" fmla="*/ 146975 w 3160170"/>
                    <a:gd name="connsiteY127" fmla="*/ 717587 h 922177"/>
                    <a:gd name="connsiteX128" fmla="*/ 131100 w 3160170"/>
                    <a:gd name="connsiteY128" fmla="*/ 720762 h 922177"/>
                    <a:gd name="connsiteX129" fmla="*/ 99350 w 3160170"/>
                    <a:gd name="connsiteY129" fmla="*/ 733462 h 922177"/>
                    <a:gd name="connsiteX130" fmla="*/ 70775 w 3160170"/>
                    <a:gd name="connsiteY130" fmla="*/ 742987 h 922177"/>
                    <a:gd name="connsiteX131" fmla="*/ 17214 w 3160170"/>
                    <a:gd name="connsiteY131" fmla="*/ 752650 h 922177"/>
                    <a:gd name="connsiteX132" fmla="*/ 787 w 3160170"/>
                    <a:gd name="connsiteY132" fmla="*/ 787023 h 922177"/>
                    <a:gd name="connsiteX133" fmla="*/ 37782 w 3160170"/>
                    <a:gd name="connsiteY133" fmla="*/ 843206 h 922177"/>
                    <a:gd name="connsiteX134" fmla="*/ 80438 w 3160170"/>
                    <a:gd name="connsiteY134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38310 w 3160170"/>
                    <a:gd name="connsiteY88" fmla="*/ 683969 h 922177"/>
                    <a:gd name="connsiteX89" fmla="*/ 2483775 w 3160170"/>
                    <a:gd name="connsiteY89" fmla="*/ 704887 h 922177"/>
                    <a:gd name="connsiteX90" fmla="*/ 2439325 w 3160170"/>
                    <a:gd name="connsiteY90" fmla="*/ 714412 h 922177"/>
                    <a:gd name="connsiteX91" fmla="*/ 2394875 w 3160170"/>
                    <a:gd name="connsiteY91" fmla="*/ 723937 h 922177"/>
                    <a:gd name="connsiteX92" fmla="*/ 2347250 w 3160170"/>
                    <a:gd name="connsiteY92" fmla="*/ 730287 h 922177"/>
                    <a:gd name="connsiteX93" fmla="*/ 2315500 w 3160170"/>
                    <a:gd name="connsiteY93" fmla="*/ 717587 h 922177"/>
                    <a:gd name="connsiteX94" fmla="*/ 2252000 w 3160170"/>
                    <a:gd name="connsiteY94" fmla="*/ 704887 h 922177"/>
                    <a:gd name="connsiteX95" fmla="*/ 2213900 w 3160170"/>
                    <a:gd name="connsiteY95" fmla="*/ 698537 h 922177"/>
                    <a:gd name="connsiteX96" fmla="*/ 2172625 w 3160170"/>
                    <a:gd name="connsiteY96" fmla="*/ 692187 h 922177"/>
                    <a:gd name="connsiteX97" fmla="*/ 2115475 w 3160170"/>
                    <a:gd name="connsiteY97" fmla="*/ 682662 h 922177"/>
                    <a:gd name="connsiteX98" fmla="*/ 2077375 w 3160170"/>
                    <a:gd name="connsiteY98" fmla="*/ 676312 h 922177"/>
                    <a:gd name="connsiteX99" fmla="*/ 2029750 w 3160170"/>
                    <a:gd name="connsiteY99" fmla="*/ 666787 h 922177"/>
                    <a:gd name="connsiteX100" fmla="*/ 1915450 w 3160170"/>
                    <a:gd name="connsiteY100" fmla="*/ 660437 h 922177"/>
                    <a:gd name="connsiteX101" fmla="*/ 1855125 w 3160170"/>
                    <a:gd name="connsiteY101" fmla="*/ 663612 h 922177"/>
                    <a:gd name="connsiteX102" fmla="*/ 1769400 w 3160170"/>
                    <a:gd name="connsiteY102" fmla="*/ 666787 h 922177"/>
                    <a:gd name="connsiteX103" fmla="*/ 1731300 w 3160170"/>
                    <a:gd name="connsiteY103" fmla="*/ 673137 h 922177"/>
                    <a:gd name="connsiteX104" fmla="*/ 1686850 w 3160170"/>
                    <a:gd name="connsiteY104" fmla="*/ 695362 h 922177"/>
                    <a:gd name="connsiteX105" fmla="*/ 1629700 w 3160170"/>
                    <a:gd name="connsiteY105" fmla="*/ 717587 h 922177"/>
                    <a:gd name="connsiteX106" fmla="*/ 1585250 w 3160170"/>
                    <a:gd name="connsiteY106" fmla="*/ 739812 h 922177"/>
                    <a:gd name="connsiteX107" fmla="*/ 1528100 w 3160170"/>
                    <a:gd name="connsiteY107" fmla="*/ 755687 h 922177"/>
                    <a:gd name="connsiteX108" fmla="*/ 1496350 w 3160170"/>
                    <a:gd name="connsiteY108" fmla="*/ 774737 h 922177"/>
                    <a:gd name="connsiteX109" fmla="*/ 1470950 w 3160170"/>
                    <a:gd name="connsiteY109" fmla="*/ 781087 h 922177"/>
                    <a:gd name="connsiteX110" fmla="*/ 1426500 w 3160170"/>
                    <a:gd name="connsiteY110" fmla="*/ 800137 h 922177"/>
                    <a:gd name="connsiteX111" fmla="*/ 1353475 w 3160170"/>
                    <a:gd name="connsiteY111" fmla="*/ 777912 h 922177"/>
                    <a:gd name="connsiteX112" fmla="*/ 1242350 w 3160170"/>
                    <a:gd name="connsiteY112" fmla="*/ 752512 h 922177"/>
                    <a:gd name="connsiteX113" fmla="*/ 1169325 w 3160170"/>
                    <a:gd name="connsiteY113" fmla="*/ 736637 h 922177"/>
                    <a:gd name="connsiteX114" fmla="*/ 1029625 w 3160170"/>
                    <a:gd name="connsiteY114" fmla="*/ 704887 h 922177"/>
                    <a:gd name="connsiteX115" fmla="*/ 959775 w 3160170"/>
                    <a:gd name="connsiteY115" fmla="*/ 701712 h 922177"/>
                    <a:gd name="connsiteX116" fmla="*/ 867700 w 3160170"/>
                    <a:gd name="connsiteY116" fmla="*/ 698537 h 922177"/>
                    <a:gd name="connsiteX117" fmla="*/ 813725 w 3160170"/>
                    <a:gd name="connsiteY117" fmla="*/ 701712 h 922177"/>
                    <a:gd name="connsiteX118" fmla="*/ 775625 w 3160170"/>
                    <a:gd name="connsiteY118" fmla="*/ 714412 h 922177"/>
                    <a:gd name="connsiteX119" fmla="*/ 712125 w 3160170"/>
                    <a:gd name="connsiteY119" fmla="*/ 727112 h 922177"/>
                    <a:gd name="connsiteX120" fmla="*/ 677200 w 3160170"/>
                    <a:gd name="connsiteY120" fmla="*/ 739812 h 922177"/>
                    <a:gd name="connsiteX121" fmla="*/ 538060 w 3160170"/>
                    <a:gd name="connsiteY121" fmla="*/ 749150 h 922177"/>
                    <a:gd name="connsiteX122" fmla="*/ 427869 w 3160170"/>
                    <a:gd name="connsiteY122" fmla="*/ 731968 h 922177"/>
                    <a:gd name="connsiteX123" fmla="*/ 366050 w 3160170"/>
                    <a:gd name="connsiteY123" fmla="*/ 723937 h 922177"/>
                    <a:gd name="connsiteX124" fmla="*/ 319172 w 3160170"/>
                    <a:gd name="connsiteY124" fmla="*/ 728979 h 922177"/>
                    <a:gd name="connsiteX125" fmla="*/ 232700 w 3160170"/>
                    <a:gd name="connsiteY125" fmla="*/ 717587 h 922177"/>
                    <a:gd name="connsiteX126" fmla="*/ 213650 w 3160170"/>
                    <a:gd name="connsiteY126" fmla="*/ 717587 h 922177"/>
                    <a:gd name="connsiteX127" fmla="*/ 146975 w 3160170"/>
                    <a:gd name="connsiteY127" fmla="*/ 717587 h 922177"/>
                    <a:gd name="connsiteX128" fmla="*/ 131100 w 3160170"/>
                    <a:gd name="connsiteY128" fmla="*/ 720762 h 922177"/>
                    <a:gd name="connsiteX129" fmla="*/ 99350 w 3160170"/>
                    <a:gd name="connsiteY129" fmla="*/ 733462 h 922177"/>
                    <a:gd name="connsiteX130" fmla="*/ 70775 w 3160170"/>
                    <a:gd name="connsiteY130" fmla="*/ 742987 h 922177"/>
                    <a:gd name="connsiteX131" fmla="*/ 17214 w 3160170"/>
                    <a:gd name="connsiteY131" fmla="*/ 752650 h 922177"/>
                    <a:gd name="connsiteX132" fmla="*/ 787 w 3160170"/>
                    <a:gd name="connsiteY132" fmla="*/ 787023 h 922177"/>
                    <a:gd name="connsiteX133" fmla="*/ 37782 w 3160170"/>
                    <a:gd name="connsiteY133" fmla="*/ 843206 h 922177"/>
                    <a:gd name="connsiteX134" fmla="*/ 80438 w 3160170"/>
                    <a:gd name="connsiteY134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23475 w 3160170"/>
                    <a:gd name="connsiteY23" fmla="*/ 825537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38310 w 3160170"/>
                    <a:gd name="connsiteY88" fmla="*/ 697416 h 922177"/>
                    <a:gd name="connsiteX89" fmla="*/ 2483775 w 3160170"/>
                    <a:gd name="connsiteY89" fmla="*/ 704887 h 922177"/>
                    <a:gd name="connsiteX90" fmla="*/ 2439325 w 3160170"/>
                    <a:gd name="connsiteY90" fmla="*/ 714412 h 922177"/>
                    <a:gd name="connsiteX91" fmla="*/ 2394875 w 3160170"/>
                    <a:gd name="connsiteY91" fmla="*/ 723937 h 922177"/>
                    <a:gd name="connsiteX92" fmla="*/ 2347250 w 3160170"/>
                    <a:gd name="connsiteY92" fmla="*/ 730287 h 922177"/>
                    <a:gd name="connsiteX93" fmla="*/ 2315500 w 3160170"/>
                    <a:gd name="connsiteY93" fmla="*/ 717587 h 922177"/>
                    <a:gd name="connsiteX94" fmla="*/ 2252000 w 3160170"/>
                    <a:gd name="connsiteY94" fmla="*/ 704887 h 922177"/>
                    <a:gd name="connsiteX95" fmla="*/ 2213900 w 3160170"/>
                    <a:gd name="connsiteY95" fmla="*/ 698537 h 922177"/>
                    <a:gd name="connsiteX96" fmla="*/ 2172625 w 3160170"/>
                    <a:gd name="connsiteY96" fmla="*/ 692187 h 922177"/>
                    <a:gd name="connsiteX97" fmla="*/ 2115475 w 3160170"/>
                    <a:gd name="connsiteY97" fmla="*/ 682662 h 922177"/>
                    <a:gd name="connsiteX98" fmla="*/ 2077375 w 3160170"/>
                    <a:gd name="connsiteY98" fmla="*/ 676312 h 922177"/>
                    <a:gd name="connsiteX99" fmla="*/ 2029750 w 3160170"/>
                    <a:gd name="connsiteY99" fmla="*/ 666787 h 922177"/>
                    <a:gd name="connsiteX100" fmla="*/ 1915450 w 3160170"/>
                    <a:gd name="connsiteY100" fmla="*/ 660437 h 922177"/>
                    <a:gd name="connsiteX101" fmla="*/ 1855125 w 3160170"/>
                    <a:gd name="connsiteY101" fmla="*/ 663612 h 922177"/>
                    <a:gd name="connsiteX102" fmla="*/ 1769400 w 3160170"/>
                    <a:gd name="connsiteY102" fmla="*/ 666787 h 922177"/>
                    <a:gd name="connsiteX103" fmla="*/ 1731300 w 3160170"/>
                    <a:gd name="connsiteY103" fmla="*/ 673137 h 922177"/>
                    <a:gd name="connsiteX104" fmla="*/ 1686850 w 3160170"/>
                    <a:gd name="connsiteY104" fmla="*/ 695362 h 922177"/>
                    <a:gd name="connsiteX105" fmla="*/ 1629700 w 3160170"/>
                    <a:gd name="connsiteY105" fmla="*/ 717587 h 922177"/>
                    <a:gd name="connsiteX106" fmla="*/ 1585250 w 3160170"/>
                    <a:gd name="connsiteY106" fmla="*/ 739812 h 922177"/>
                    <a:gd name="connsiteX107" fmla="*/ 1528100 w 3160170"/>
                    <a:gd name="connsiteY107" fmla="*/ 755687 h 922177"/>
                    <a:gd name="connsiteX108" fmla="*/ 1496350 w 3160170"/>
                    <a:gd name="connsiteY108" fmla="*/ 774737 h 922177"/>
                    <a:gd name="connsiteX109" fmla="*/ 1470950 w 3160170"/>
                    <a:gd name="connsiteY109" fmla="*/ 781087 h 922177"/>
                    <a:gd name="connsiteX110" fmla="*/ 1426500 w 3160170"/>
                    <a:gd name="connsiteY110" fmla="*/ 800137 h 922177"/>
                    <a:gd name="connsiteX111" fmla="*/ 1353475 w 3160170"/>
                    <a:gd name="connsiteY111" fmla="*/ 777912 h 922177"/>
                    <a:gd name="connsiteX112" fmla="*/ 1242350 w 3160170"/>
                    <a:gd name="connsiteY112" fmla="*/ 752512 h 922177"/>
                    <a:gd name="connsiteX113" fmla="*/ 1169325 w 3160170"/>
                    <a:gd name="connsiteY113" fmla="*/ 736637 h 922177"/>
                    <a:gd name="connsiteX114" fmla="*/ 1029625 w 3160170"/>
                    <a:gd name="connsiteY114" fmla="*/ 704887 h 922177"/>
                    <a:gd name="connsiteX115" fmla="*/ 959775 w 3160170"/>
                    <a:gd name="connsiteY115" fmla="*/ 701712 h 922177"/>
                    <a:gd name="connsiteX116" fmla="*/ 867700 w 3160170"/>
                    <a:gd name="connsiteY116" fmla="*/ 698537 h 922177"/>
                    <a:gd name="connsiteX117" fmla="*/ 813725 w 3160170"/>
                    <a:gd name="connsiteY117" fmla="*/ 701712 h 922177"/>
                    <a:gd name="connsiteX118" fmla="*/ 775625 w 3160170"/>
                    <a:gd name="connsiteY118" fmla="*/ 714412 h 922177"/>
                    <a:gd name="connsiteX119" fmla="*/ 712125 w 3160170"/>
                    <a:gd name="connsiteY119" fmla="*/ 727112 h 922177"/>
                    <a:gd name="connsiteX120" fmla="*/ 677200 w 3160170"/>
                    <a:gd name="connsiteY120" fmla="*/ 739812 h 922177"/>
                    <a:gd name="connsiteX121" fmla="*/ 538060 w 3160170"/>
                    <a:gd name="connsiteY121" fmla="*/ 749150 h 922177"/>
                    <a:gd name="connsiteX122" fmla="*/ 427869 w 3160170"/>
                    <a:gd name="connsiteY122" fmla="*/ 731968 h 922177"/>
                    <a:gd name="connsiteX123" fmla="*/ 366050 w 3160170"/>
                    <a:gd name="connsiteY123" fmla="*/ 723937 h 922177"/>
                    <a:gd name="connsiteX124" fmla="*/ 319172 w 3160170"/>
                    <a:gd name="connsiteY124" fmla="*/ 728979 h 922177"/>
                    <a:gd name="connsiteX125" fmla="*/ 232700 w 3160170"/>
                    <a:gd name="connsiteY125" fmla="*/ 717587 h 922177"/>
                    <a:gd name="connsiteX126" fmla="*/ 213650 w 3160170"/>
                    <a:gd name="connsiteY126" fmla="*/ 717587 h 922177"/>
                    <a:gd name="connsiteX127" fmla="*/ 146975 w 3160170"/>
                    <a:gd name="connsiteY127" fmla="*/ 717587 h 922177"/>
                    <a:gd name="connsiteX128" fmla="*/ 131100 w 3160170"/>
                    <a:gd name="connsiteY128" fmla="*/ 720762 h 922177"/>
                    <a:gd name="connsiteX129" fmla="*/ 99350 w 3160170"/>
                    <a:gd name="connsiteY129" fmla="*/ 733462 h 922177"/>
                    <a:gd name="connsiteX130" fmla="*/ 70775 w 3160170"/>
                    <a:gd name="connsiteY130" fmla="*/ 742987 h 922177"/>
                    <a:gd name="connsiteX131" fmla="*/ 17214 w 3160170"/>
                    <a:gd name="connsiteY131" fmla="*/ 752650 h 922177"/>
                    <a:gd name="connsiteX132" fmla="*/ 787 w 3160170"/>
                    <a:gd name="connsiteY132" fmla="*/ 787023 h 922177"/>
                    <a:gd name="connsiteX133" fmla="*/ 37782 w 3160170"/>
                    <a:gd name="connsiteY133" fmla="*/ 843206 h 922177"/>
                    <a:gd name="connsiteX134" fmla="*/ 80438 w 3160170"/>
                    <a:gd name="connsiteY134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725075 w 3160170"/>
                    <a:gd name="connsiteY49" fmla="*/ 25437 h 922177"/>
                    <a:gd name="connsiteX50" fmla="*/ 2664750 w 3160170"/>
                    <a:gd name="connsiteY50" fmla="*/ 15912 h 922177"/>
                    <a:gd name="connsiteX51" fmla="*/ 2600316 w 3160170"/>
                    <a:gd name="connsiteY51" fmla="*/ 2839 h 922177"/>
                    <a:gd name="connsiteX52" fmla="*/ 2546308 w 3160170"/>
                    <a:gd name="connsiteY52" fmla="*/ 1003 h 922177"/>
                    <a:gd name="connsiteX53" fmla="*/ 2518148 w 3160170"/>
                    <a:gd name="connsiteY53" fmla="*/ 15359 h 922177"/>
                    <a:gd name="connsiteX54" fmla="*/ 2480600 w 3160170"/>
                    <a:gd name="connsiteY54" fmla="*/ 50837 h 922177"/>
                    <a:gd name="connsiteX55" fmla="*/ 2461550 w 3160170"/>
                    <a:gd name="connsiteY55" fmla="*/ 85762 h 922177"/>
                    <a:gd name="connsiteX56" fmla="*/ 2455200 w 3160170"/>
                    <a:gd name="connsiteY56" fmla="*/ 117512 h 922177"/>
                    <a:gd name="connsiteX57" fmla="*/ 2463068 w 3160170"/>
                    <a:gd name="connsiteY57" fmla="*/ 141118 h 922177"/>
                    <a:gd name="connsiteX58" fmla="*/ 2486122 w 3160170"/>
                    <a:gd name="connsiteY58" fmla="*/ 155336 h 922177"/>
                    <a:gd name="connsiteX59" fmla="*/ 2515525 w 3160170"/>
                    <a:gd name="connsiteY59" fmla="*/ 165137 h 922177"/>
                    <a:gd name="connsiteX60" fmla="*/ 2531400 w 3160170"/>
                    <a:gd name="connsiteY60" fmla="*/ 165137 h 922177"/>
                    <a:gd name="connsiteX61" fmla="*/ 2559975 w 3160170"/>
                    <a:gd name="connsiteY61" fmla="*/ 165551 h 922177"/>
                    <a:gd name="connsiteX62" fmla="*/ 2569500 w 3160170"/>
                    <a:gd name="connsiteY62" fmla="*/ 168312 h 922177"/>
                    <a:gd name="connsiteX63" fmla="*/ 2601250 w 3160170"/>
                    <a:gd name="connsiteY63" fmla="*/ 171487 h 922177"/>
                    <a:gd name="connsiteX64" fmla="*/ 2664750 w 3160170"/>
                    <a:gd name="connsiteY64" fmla="*/ 174662 h 922177"/>
                    <a:gd name="connsiteX65" fmla="*/ 2721900 w 3160170"/>
                    <a:gd name="connsiteY65" fmla="*/ 215937 h 922177"/>
                    <a:gd name="connsiteX66" fmla="*/ 2763175 w 3160170"/>
                    <a:gd name="connsiteY66" fmla="*/ 285787 h 922177"/>
                    <a:gd name="connsiteX67" fmla="*/ 2779050 w 3160170"/>
                    <a:gd name="connsiteY67" fmla="*/ 320712 h 922177"/>
                    <a:gd name="connsiteX68" fmla="*/ 2791750 w 3160170"/>
                    <a:gd name="connsiteY68" fmla="*/ 361987 h 922177"/>
                    <a:gd name="connsiteX69" fmla="*/ 2804450 w 3160170"/>
                    <a:gd name="connsiteY69" fmla="*/ 400087 h 922177"/>
                    <a:gd name="connsiteX70" fmla="*/ 2807625 w 3160170"/>
                    <a:gd name="connsiteY70" fmla="*/ 419137 h 922177"/>
                    <a:gd name="connsiteX71" fmla="*/ 2807625 w 3160170"/>
                    <a:gd name="connsiteY71" fmla="*/ 441362 h 922177"/>
                    <a:gd name="connsiteX72" fmla="*/ 2810800 w 3160170"/>
                    <a:gd name="connsiteY72" fmla="*/ 476287 h 922177"/>
                    <a:gd name="connsiteX73" fmla="*/ 2813975 w 3160170"/>
                    <a:gd name="connsiteY73" fmla="*/ 504862 h 922177"/>
                    <a:gd name="connsiteX74" fmla="*/ 2817150 w 3160170"/>
                    <a:gd name="connsiteY74" fmla="*/ 530262 h 922177"/>
                    <a:gd name="connsiteX75" fmla="*/ 2817150 w 3160170"/>
                    <a:gd name="connsiteY75" fmla="*/ 558837 h 922177"/>
                    <a:gd name="connsiteX76" fmla="*/ 2813975 w 3160170"/>
                    <a:gd name="connsiteY76" fmla="*/ 571537 h 922177"/>
                    <a:gd name="connsiteX77" fmla="*/ 2807625 w 3160170"/>
                    <a:gd name="connsiteY77" fmla="*/ 584237 h 922177"/>
                    <a:gd name="connsiteX78" fmla="*/ 2798100 w 3160170"/>
                    <a:gd name="connsiteY78" fmla="*/ 603287 h 922177"/>
                    <a:gd name="connsiteX79" fmla="*/ 2794925 w 3160170"/>
                    <a:gd name="connsiteY79" fmla="*/ 619162 h 922177"/>
                    <a:gd name="connsiteX80" fmla="*/ 2794925 w 3160170"/>
                    <a:gd name="connsiteY80" fmla="*/ 635037 h 922177"/>
                    <a:gd name="connsiteX81" fmla="*/ 2798100 w 3160170"/>
                    <a:gd name="connsiteY81" fmla="*/ 647737 h 922177"/>
                    <a:gd name="connsiteX82" fmla="*/ 2798100 w 3160170"/>
                    <a:gd name="connsiteY82" fmla="*/ 647737 h 922177"/>
                    <a:gd name="connsiteX83" fmla="*/ 2747300 w 3160170"/>
                    <a:gd name="connsiteY83" fmla="*/ 666787 h 922177"/>
                    <a:gd name="connsiteX84" fmla="*/ 2696500 w 3160170"/>
                    <a:gd name="connsiteY84" fmla="*/ 676312 h 922177"/>
                    <a:gd name="connsiteX85" fmla="*/ 2648875 w 3160170"/>
                    <a:gd name="connsiteY85" fmla="*/ 682662 h 922177"/>
                    <a:gd name="connsiteX86" fmla="*/ 2623475 w 3160170"/>
                    <a:gd name="connsiteY86" fmla="*/ 682662 h 922177"/>
                    <a:gd name="connsiteX87" fmla="*/ 2585375 w 3160170"/>
                    <a:gd name="connsiteY87" fmla="*/ 682662 h 922177"/>
                    <a:gd name="connsiteX88" fmla="*/ 2538310 w 3160170"/>
                    <a:gd name="connsiteY88" fmla="*/ 697416 h 922177"/>
                    <a:gd name="connsiteX89" fmla="*/ 2483775 w 3160170"/>
                    <a:gd name="connsiteY89" fmla="*/ 704887 h 922177"/>
                    <a:gd name="connsiteX90" fmla="*/ 2439325 w 3160170"/>
                    <a:gd name="connsiteY90" fmla="*/ 714412 h 922177"/>
                    <a:gd name="connsiteX91" fmla="*/ 2394875 w 3160170"/>
                    <a:gd name="connsiteY91" fmla="*/ 723937 h 922177"/>
                    <a:gd name="connsiteX92" fmla="*/ 2347250 w 3160170"/>
                    <a:gd name="connsiteY92" fmla="*/ 730287 h 922177"/>
                    <a:gd name="connsiteX93" fmla="*/ 2315500 w 3160170"/>
                    <a:gd name="connsiteY93" fmla="*/ 717587 h 922177"/>
                    <a:gd name="connsiteX94" fmla="*/ 2252000 w 3160170"/>
                    <a:gd name="connsiteY94" fmla="*/ 704887 h 922177"/>
                    <a:gd name="connsiteX95" fmla="*/ 2213900 w 3160170"/>
                    <a:gd name="connsiteY95" fmla="*/ 698537 h 922177"/>
                    <a:gd name="connsiteX96" fmla="*/ 2172625 w 3160170"/>
                    <a:gd name="connsiteY96" fmla="*/ 692187 h 922177"/>
                    <a:gd name="connsiteX97" fmla="*/ 2115475 w 3160170"/>
                    <a:gd name="connsiteY97" fmla="*/ 682662 h 922177"/>
                    <a:gd name="connsiteX98" fmla="*/ 2077375 w 3160170"/>
                    <a:gd name="connsiteY98" fmla="*/ 676312 h 922177"/>
                    <a:gd name="connsiteX99" fmla="*/ 2029750 w 3160170"/>
                    <a:gd name="connsiteY99" fmla="*/ 666787 h 922177"/>
                    <a:gd name="connsiteX100" fmla="*/ 1915450 w 3160170"/>
                    <a:gd name="connsiteY100" fmla="*/ 660437 h 922177"/>
                    <a:gd name="connsiteX101" fmla="*/ 1855125 w 3160170"/>
                    <a:gd name="connsiteY101" fmla="*/ 663612 h 922177"/>
                    <a:gd name="connsiteX102" fmla="*/ 1769400 w 3160170"/>
                    <a:gd name="connsiteY102" fmla="*/ 666787 h 922177"/>
                    <a:gd name="connsiteX103" fmla="*/ 1731300 w 3160170"/>
                    <a:gd name="connsiteY103" fmla="*/ 673137 h 922177"/>
                    <a:gd name="connsiteX104" fmla="*/ 1686850 w 3160170"/>
                    <a:gd name="connsiteY104" fmla="*/ 695362 h 922177"/>
                    <a:gd name="connsiteX105" fmla="*/ 1629700 w 3160170"/>
                    <a:gd name="connsiteY105" fmla="*/ 717587 h 922177"/>
                    <a:gd name="connsiteX106" fmla="*/ 1585250 w 3160170"/>
                    <a:gd name="connsiteY106" fmla="*/ 739812 h 922177"/>
                    <a:gd name="connsiteX107" fmla="*/ 1528100 w 3160170"/>
                    <a:gd name="connsiteY107" fmla="*/ 755687 h 922177"/>
                    <a:gd name="connsiteX108" fmla="*/ 1496350 w 3160170"/>
                    <a:gd name="connsiteY108" fmla="*/ 774737 h 922177"/>
                    <a:gd name="connsiteX109" fmla="*/ 1470950 w 3160170"/>
                    <a:gd name="connsiteY109" fmla="*/ 781087 h 922177"/>
                    <a:gd name="connsiteX110" fmla="*/ 1426500 w 3160170"/>
                    <a:gd name="connsiteY110" fmla="*/ 800137 h 922177"/>
                    <a:gd name="connsiteX111" fmla="*/ 1353475 w 3160170"/>
                    <a:gd name="connsiteY111" fmla="*/ 777912 h 922177"/>
                    <a:gd name="connsiteX112" fmla="*/ 1242350 w 3160170"/>
                    <a:gd name="connsiteY112" fmla="*/ 752512 h 922177"/>
                    <a:gd name="connsiteX113" fmla="*/ 1169325 w 3160170"/>
                    <a:gd name="connsiteY113" fmla="*/ 736637 h 922177"/>
                    <a:gd name="connsiteX114" fmla="*/ 1029625 w 3160170"/>
                    <a:gd name="connsiteY114" fmla="*/ 704887 h 922177"/>
                    <a:gd name="connsiteX115" fmla="*/ 959775 w 3160170"/>
                    <a:gd name="connsiteY115" fmla="*/ 701712 h 922177"/>
                    <a:gd name="connsiteX116" fmla="*/ 867700 w 3160170"/>
                    <a:gd name="connsiteY116" fmla="*/ 698537 h 922177"/>
                    <a:gd name="connsiteX117" fmla="*/ 813725 w 3160170"/>
                    <a:gd name="connsiteY117" fmla="*/ 701712 h 922177"/>
                    <a:gd name="connsiteX118" fmla="*/ 775625 w 3160170"/>
                    <a:gd name="connsiteY118" fmla="*/ 714412 h 922177"/>
                    <a:gd name="connsiteX119" fmla="*/ 712125 w 3160170"/>
                    <a:gd name="connsiteY119" fmla="*/ 727112 h 922177"/>
                    <a:gd name="connsiteX120" fmla="*/ 677200 w 3160170"/>
                    <a:gd name="connsiteY120" fmla="*/ 739812 h 922177"/>
                    <a:gd name="connsiteX121" fmla="*/ 538060 w 3160170"/>
                    <a:gd name="connsiteY121" fmla="*/ 749150 h 922177"/>
                    <a:gd name="connsiteX122" fmla="*/ 427869 w 3160170"/>
                    <a:gd name="connsiteY122" fmla="*/ 731968 h 922177"/>
                    <a:gd name="connsiteX123" fmla="*/ 366050 w 3160170"/>
                    <a:gd name="connsiteY123" fmla="*/ 723937 h 922177"/>
                    <a:gd name="connsiteX124" fmla="*/ 319172 w 3160170"/>
                    <a:gd name="connsiteY124" fmla="*/ 728979 h 922177"/>
                    <a:gd name="connsiteX125" fmla="*/ 232700 w 3160170"/>
                    <a:gd name="connsiteY125" fmla="*/ 717587 h 922177"/>
                    <a:gd name="connsiteX126" fmla="*/ 213650 w 3160170"/>
                    <a:gd name="connsiteY126" fmla="*/ 717587 h 922177"/>
                    <a:gd name="connsiteX127" fmla="*/ 146975 w 3160170"/>
                    <a:gd name="connsiteY127" fmla="*/ 717587 h 922177"/>
                    <a:gd name="connsiteX128" fmla="*/ 131100 w 3160170"/>
                    <a:gd name="connsiteY128" fmla="*/ 720762 h 922177"/>
                    <a:gd name="connsiteX129" fmla="*/ 99350 w 3160170"/>
                    <a:gd name="connsiteY129" fmla="*/ 733462 h 922177"/>
                    <a:gd name="connsiteX130" fmla="*/ 70775 w 3160170"/>
                    <a:gd name="connsiteY130" fmla="*/ 742987 h 922177"/>
                    <a:gd name="connsiteX131" fmla="*/ 17214 w 3160170"/>
                    <a:gd name="connsiteY131" fmla="*/ 752650 h 922177"/>
                    <a:gd name="connsiteX132" fmla="*/ 787 w 3160170"/>
                    <a:gd name="connsiteY132" fmla="*/ 787023 h 922177"/>
                    <a:gd name="connsiteX133" fmla="*/ 37782 w 3160170"/>
                    <a:gd name="connsiteY133" fmla="*/ 843206 h 922177"/>
                    <a:gd name="connsiteX134" fmla="*/ 80438 w 3160170"/>
                    <a:gd name="connsiteY134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63175 w 3160170"/>
                    <a:gd name="connsiteY48" fmla="*/ 38137 h 922177"/>
                    <a:gd name="connsiteX49" fmla="*/ 2664750 w 3160170"/>
                    <a:gd name="connsiteY49" fmla="*/ 15912 h 922177"/>
                    <a:gd name="connsiteX50" fmla="*/ 2600316 w 3160170"/>
                    <a:gd name="connsiteY50" fmla="*/ 2839 h 922177"/>
                    <a:gd name="connsiteX51" fmla="*/ 2546308 w 3160170"/>
                    <a:gd name="connsiteY51" fmla="*/ 1003 h 922177"/>
                    <a:gd name="connsiteX52" fmla="*/ 2518148 w 3160170"/>
                    <a:gd name="connsiteY52" fmla="*/ 15359 h 922177"/>
                    <a:gd name="connsiteX53" fmla="*/ 2480600 w 3160170"/>
                    <a:gd name="connsiteY53" fmla="*/ 50837 h 922177"/>
                    <a:gd name="connsiteX54" fmla="*/ 2461550 w 3160170"/>
                    <a:gd name="connsiteY54" fmla="*/ 85762 h 922177"/>
                    <a:gd name="connsiteX55" fmla="*/ 2455200 w 3160170"/>
                    <a:gd name="connsiteY55" fmla="*/ 117512 h 922177"/>
                    <a:gd name="connsiteX56" fmla="*/ 2463068 w 3160170"/>
                    <a:gd name="connsiteY56" fmla="*/ 141118 h 922177"/>
                    <a:gd name="connsiteX57" fmla="*/ 2486122 w 3160170"/>
                    <a:gd name="connsiteY57" fmla="*/ 155336 h 922177"/>
                    <a:gd name="connsiteX58" fmla="*/ 2515525 w 3160170"/>
                    <a:gd name="connsiteY58" fmla="*/ 165137 h 922177"/>
                    <a:gd name="connsiteX59" fmla="*/ 2531400 w 3160170"/>
                    <a:gd name="connsiteY59" fmla="*/ 165137 h 922177"/>
                    <a:gd name="connsiteX60" fmla="*/ 2559975 w 3160170"/>
                    <a:gd name="connsiteY60" fmla="*/ 165551 h 922177"/>
                    <a:gd name="connsiteX61" fmla="*/ 2569500 w 3160170"/>
                    <a:gd name="connsiteY61" fmla="*/ 168312 h 922177"/>
                    <a:gd name="connsiteX62" fmla="*/ 2601250 w 3160170"/>
                    <a:gd name="connsiteY62" fmla="*/ 171487 h 922177"/>
                    <a:gd name="connsiteX63" fmla="*/ 2664750 w 3160170"/>
                    <a:gd name="connsiteY63" fmla="*/ 174662 h 922177"/>
                    <a:gd name="connsiteX64" fmla="*/ 2721900 w 3160170"/>
                    <a:gd name="connsiteY64" fmla="*/ 215937 h 922177"/>
                    <a:gd name="connsiteX65" fmla="*/ 2763175 w 3160170"/>
                    <a:gd name="connsiteY65" fmla="*/ 285787 h 922177"/>
                    <a:gd name="connsiteX66" fmla="*/ 2779050 w 3160170"/>
                    <a:gd name="connsiteY66" fmla="*/ 320712 h 922177"/>
                    <a:gd name="connsiteX67" fmla="*/ 2791750 w 3160170"/>
                    <a:gd name="connsiteY67" fmla="*/ 361987 h 922177"/>
                    <a:gd name="connsiteX68" fmla="*/ 2804450 w 3160170"/>
                    <a:gd name="connsiteY68" fmla="*/ 400087 h 922177"/>
                    <a:gd name="connsiteX69" fmla="*/ 2807625 w 3160170"/>
                    <a:gd name="connsiteY69" fmla="*/ 419137 h 922177"/>
                    <a:gd name="connsiteX70" fmla="*/ 2807625 w 3160170"/>
                    <a:gd name="connsiteY70" fmla="*/ 441362 h 922177"/>
                    <a:gd name="connsiteX71" fmla="*/ 2810800 w 3160170"/>
                    <a:gd name="connsiteY71" fmla="*/ 476287 h 922177"/>
                    <a:gd name="connsiteX72" fmla="*/ 2813975 w 3160170"/>
                    <a:gd name="connsiteY72" fmla="*/ 504862 h 922177"/>
                    <a:gd name="connsiteX73" fmla="*/ 2817150 w 3160170"/>
                    <a:gd name="connsiteY73" fmla="*/ 530262 h 922177"/>
                    <a:gd name="connsiteX74" fmla="*/ 2817150 w 3160170"/>
                    <a:gd name="connsiteY74" fmla="*/ 558837 h 922177"/>
                    <a:gd name="connsiteX75" fmla="*/ 2813975 w 3160170"/>
                    <a:gd name="connsiteY75" fmla="*/ 571537 h 922177"/>
                    <a:gd name="connsiteX76" fmla="*/ 2807625 w 3160170"/>
                    <a:gd name="connsiteY76" fmla="*/ 584237 h 922177"/>
                    <a:gd name="connsiteX77" fmla="*/ 2798100 w 3160170"/>
                    <a:gd name="connsiteY77" fmla="*/ 603287 h 922177"/>
                    <a:gd name="connsiteX78" fmla="*/ 2794925 w 3160170"/>
                    <a:gd name="connsiteY78" fmla="*/ 619162 h 922177"/>
                    <a:gd name="connsiteX79" fmla="*/ 2794925 w 3160170"/>
                    <a:gd name="connsiteY79" fmla="*/ 635037 h 922177"/>
                    <a:gd name="connsiteX80" fmla="*/ 2798100 w 3160170"/>
                    <a:gd name="connsiteY80" fmla="*/ 647737 h 922177"/>
                    <a:gd name="connsiteX81" fmla="*/ 2798100 w 3160170"/>
                    <a:gd name="connsiteY81" fmla="*/ 647737 h 922177"/>
                    <a:gd name="connsiteX82" fmla="*/ 2747300 w 3160170"/>
                    <a:gd name="connsiteY82" fmla="*/ 666787 h 922177"/>
                    <a:gd name="connsiteX83" fmla="*/ 2696500 w 3160170"/>
                    <a:gd name="connsiteY83" fmla="*/ 676312 h 922177"/>
                    <a:gd name="connsiteX84" fmla="*/ 2648875 w 3160170"/>
                    <a:gd name="connsiteY84" fmla="*/ 682662 h 922177"/>
                    <a:gd name="connsiteX85" fmla="*/ 2623475 w 3160170"/>
                    <a:gd name="connsiteY85" fmla="*/ 682662 h 922177"/>
                    <a:gd name="connsiteX86" fmla="*/ 2585375 w 3160170"/>
                    <a:gd name="connsiteY86" fmla="*/ 682662 h 922177"/>
                    <a:gd name="connsiteX87" fmla="*/ 2538310 w 3160170"/>
                    <a:gd name="connsiteY87" fmla="*/ 697416 h 922177"/>
                    <a:gd name="connsiteX88" fmla="*/ 2483775 w 3160170"/>
                    <a:gd name="connsiteY88" fmla="*/ 704887 h 922177"/>
                    <a:gd name="connsiteX89" fmla="*/ 2439325 w 3160170"/>
                    <a:gd name="connsiteY89" fmla="*/ 714412 h 922177"/>
                    <a:gd name="connsiteX90" fmla="*/ 2394875 w 3160170"/>
                    <a:gd name="connsiteY90" fmla="*/ 723937 h 922177"/>
                    <a:gd name="connsiteX91" fmla="*/ 2347250 w 3160170"/>
                    <a:gd name="connsiteY91" fmla="*/ 730287 h 922177"/>
                    <a:gd name="connsiteX92" fmla="*/ 2315500 w 3160170"/>
                    <a:gd name="connsiteY92" fmla="*/ 717587 h 922177"/>
                    <a:gd name="connsiteX93" fmla="*/ 2252000 w 3160170"/>
                    <a:gd name="connsiteY93" fmla="*/ 704887 h 922177"/>
                    <a:gd name="connsiteX94" fmla="*/ 2213900 w 3160170"/>
                    <a:gd name="connsiteY94" fmla="*/ 698537 h 922177"/>
                    <a:gd name="connsiteX95" fmla="*/ 2172625 w 3160170"/>
                    <a:gd name="connsiteY95" fmla="*/ 692187 h 922177"/>
                    <a:gd name="connsiteX96" fmla="*/ 2115475 w 3160170"/>
                    <a:gd name="connsiteY96" fmla="*/ 682662 h 922177"/>
                    <a:gd name="connsiteX97" fmla="*/ 2077375 w 3160170"/>
                    <a:gd name="connsiteY97" fmla="*/ 676312 h 922177"/>
                    <a:gd name="connsiteX98" fmla="*/ 2029750 w 3160170"/>
                    <a:gd name="connsiteY98" fmla="*/ 666787 h 922177"/>
                    <a:gd name="connsiteX99" fmla="*/ 1915450 w 3160170"/>
                    <a:gd name="connsiteY99" fmla="*/ 660437 h 922177"/>
                    <a:gd name="connsiteX100" fmla="*/ 1855125 w 3160170"/>
                    <a:gd name="connsiteY100" fmla="*/ 663612 h 922177"/>
                    <a:gd name="connsiteX101" fmla="*/ 1769400 w 3160170"/>
                    <a:gd name="connsiteY101" fmla="*/ 666787 h 922177"/>
                    <a:gd name="connsiteX102" fmla="*/ 1731300 w 3160170"/>
                    <a:gd name="connsiteY102" fmla="*/ 673137 h 922177"/>
                    <a:gd name="connsiteX103" fmla="*/ 1686850 w 3160170"/>
                    <a:gd name="connsiteY103" fmla="*/ 695362 h 922177"/>
                    <a:gd name="connsiteX104" fmla="*/ 1629700 w 3160170"/>
                    <a:gd name="connsiteY104" fmla="*/ 717587 h 922177"/>
                    <a:gd name="connsiteX105" fmla="*/ 1585250 w 3160170"/>
                    <a:gd name="connsiteY105" fmla="*/ 739812 h 922177"/>
                    <a:gd name="connsiteX106" fmla="*/ 1528100 w 3160170"/>
                    <a:gd name="connsiteY106" fmla="*/ 755687 h 922177"/>
                    <a:gd name="connsiteX107" fmla="*/ 1496350 w 3160170"/>
                    <a:gd name="connsiteY107" fmla="*/ 774737 h 922177"/>
                    <a:gd name="connsiteX108" fmla="*/ 1470950 w 3160170"/>
                    <a:gd name="connsiteY108" fmla="*/ 781087 h 922177"/>
                    <a:gd name="connsiteX109" fmla="*/ 1426500 w 3160170"/>
                    <a:gd name="connsiteY109" fmla="*/ 800137 h 922177"/>
                    <a:gd name="connsiteX110" fmla="*/ 1353475 w 3160170"/>
                    <a:gd name="connsiteY110" fmla="*/ 777912 h 922177"/>
                    <a:gd name="connsiteX111" fmla="*/ 1242350 w 3160170"/>
                    <a:gd name="connsiteY111" fmla="*/ 752512 h 922177"/>
                    <a:gd name="connsiteX112" fmla="*/ 1169325 w 3160170"/>
                    <a:gd name="connsiteY112" fmla="*/ 736637 h 922177"/>
                    <a:gd name="connsiteX113" fmla="*/ 1029625 w 3160170"/>
                    <a:gd name="connsiteY113" fmla="*/ 704887 h 922177"/>
                    <a:gd name="connsiteX114" fmla="*/ 959775 w 3160170"/>
                    <a:gd name="connsiteY114" fmla="*/ 701712 h 922177"/>
                    <a:gd name="connsiteX115" fmla="*/ 867700 w 3160170"/>
                    <a:gd name="connsiteY115" fmla="*/ 698537 h 922177"/>
                    <a:gd name="connsiteX116" fmla="*/ 813725 w 3160170"/>
                    <a:gd name="connsiteY116" fmla="*/ 701712 h 922177"/>
                    <a:gd name="connsiteX117" fmla="*/ 775625 w 3160170"/>
                    <a:gd name="connsiteY117" fmla="*/ 714412 h 922177"/>
                    <a:gd name="connsiteX118" fmla="*/ 712125 w 3160170"/>
                    <a:gd name="connsiteY118" fmla="*/ 727112 h 922177"/>
                    <a:gd name="connsiteX119" fmla="*/ 677200 w 3160170"/>
                    <a:gd name="connsiteY119" fmla="*/ 739812 h 922177"/>
                    <a:gd name="connsiteX120" fmla="*/ 538060 w 3160170"/>
                    <a:gd name="connsiteY120" fmla="*/ 749150 h 922177"/>
                    <a:gd name="connsiteX121" fmla="*/ 427869 w 3160170"/>
                    <a:gd name="connsiteY121" fmla="*/ 731968 h 922177"/>
                    <a:gd name="connsiteX122" fmla="*/ 366050 w 3160170"/>
                    <a:gd name="connsiteY122" fmla="*/ 723937 h 922177"/>
                    <a:gd name="connsiteX123" fmla="*/ 319172 w 3160170"/>
                    <a:gd name="connsiteY123" fmla="*/ 728979 h 922177"/>
                    <a:gd name="connsiteX124" fmla="*/ 232700 w 3160170"/>
                    <a:gd name="connsiteY124" fmla="*/ 717587 h 922177"/>
                    <a:gd name="connsiteX125" fmla="*/ 213650 w 3160170"/>
                    <a:gd name="connsiteY125" fmla="*/ 717587 h 922177"/>
                    <a:gd name="connsiteX126" fmla="*/ 146975 w 3160170"/>
                    <a:gd name="connsiteY126" fmla="*/ 717587 h 922177"/>
                    <a:gd name="connsiteX127" fmla="*/ 131100 w 3160170"/>
                    <a:gd name="connsiteY127" fmla="*/ 720762 h 922177"/>
                    <a:gd name="connsiteX128" fmla="*/ 99350 w 3160170"/>
                    <a:gd name="connsiteY128" fmla="*/ 733462 h 922177"/>
                    <a:gd name="connsiteX129" fmla="*/ 70775 w 3160170"/>
                    <a:gd name="connsiteY129" fmla="*/ 742987 h 922177"/>
                    <a:gd name="connsiteX130" fmla="*/ 17214 w 3160170"/>
                    <a:gd name="connsiteY130" fmla="*/ 752650 h 922177"/>
                    <a:gd name="connsiteX131" fmla="*/ 787 w 3160170"/>
                    <a:gd name="connsiteY131" fmla="*/ 787023 h 922177"/>
                    <a:gd name="connsiteX132" fmla="*/ 37782 w 3160170"/>
                    <a:gd name="connsiteY132" fmla="*/ 843206 h 922177"/>
                    <a:gd name="connsiteX133" fmla="*/ 80438 w 3160170"/>
                    <a:gd name="connsiteY133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36281 w 3160170"/>
                    <a:gd name="connsiteY48" fmla="*/ 38137 h 922177"/>
                    <a:gd name="connsiteX49" fmla="*/ 2664750 w 3160170"/>
                    <a:gd name="connsiteY49" fmla="*/ 15912 h 922177"/>
                    <a:gd name="connsiteX50" fmla="*/ 2600316 w 3160170"/>
                    <a:gd name="connsiteY50" fmla="*/ 2839 h 922177"/>
                    <a:gd name="connsiteX51" fmla="*/ 2546308 w 3160170"/>
                    <a:gd name="connsiteY51" fmla="*/ 1003 h 922177"/>
                    <a:gd name="connsiteX52" fmla="*/ 2518148 w 3160170"/>
                    <a:gd name="connsiteY52" fmla="*/ 15359 h 922177"/>
                    <a:gd name="connsiteX53" fmla="*/ 2480600 w 3160170"/>
                    <a:gd name="connsiteY53" fmla="*/ 50837 h 922177"/>
                    <a:gd name="connsiteX54" fmla="*/ 2461550 w 3160170"/>
                    <a:gd name="connsiteY54" fmla="*/ 85762 h 922177"/>
                    <a:gd name="connsiteX55" fmla="*/ 2455200 w 3160170"/>
                    <a:gd name="connsiteY55" fmla="*/ 117512 h 922177"/>
                    <a:gd name="connsiteX56" fmla="*/ 2463068 w 3160170"/>
                    <a:gd name="connsiteY56" fmla="*/ 141118 h 922177"/>
                    <a:gd name="connsiteX57" fmla="*/ 2486122 w 3160170"/>
                    <a:gd name="connsiteY57" fmla="*/ 155336 h 922177"/>
                    <a:gd name="connsiteX58" fmla="*/ 2515525 w 3160170"/>
                    <a:gd name="connsiteY58" fmla="*/ 165137 h 922177"/>
                    <a:gd name="connsiteX59" fmla="*/ 2531400 w 3160170"/>
                    <a:gd name="connsiteY59" fmla="*/ 165137 h 922177"/>
                    <a:gd name="connsiteX60" fmla="*/ 2559975 w 3160170"/>
                    <a:gd name="connsiteY60" fmla="*/ 165551 h 922177"/>
                    <a:gd name="connsiteX61" fmla="*/ 2569500 w 3160170"/>
                    <a:gd name="connsiteY61" fmla="*/ 168312 h 922177"/>
                    <a:gd name="connsiteX62" fmla="*/ 2601250 w 3160170"/>
                    <a:gd name="connsiteY62" fmla="*/ 171487 h 922177"/>
                    <a:gd name="connsiteX63" fmla="*/ 2664750 w 3160170"/>
                    <a:gd name="connsiteY63" fmla="*/ 174662 h 922177"/>
                    <a:gd name="connsiteX64" fmla="*/ 2721900 w 3160170"/>
                    <a:gd name="connsiteY64" fmla="*/ 215937 h 922177"/>
                    <a:gd name="connsiteX65" fmla="*/ 2763175 w 3160170"/>
                    <a:gd name="connsiteY65" fmla="*/ 285787 h 922177"/>
                    <a:gd name="connsiteX66" fmla="*/ 2779050 w 3160170"/>
                    <a:gd name="connsiteY66" fmla="*/ 320712 h 922177"/>
                    <a:gd name="connsiteX67" fmla="*/ 2791750 w 3160170"/>
                    <a:gd name="connsiteY67" fmla="*/ 361987 h 922177"/>
                    <a:gd name="connsiteX68" fmla="*/ 2804450 w 3160170"/>
                    <a:gd name="connsiteY68" fmla="*/ 400087 h 922177"/>
                    <a:gd name="connsiteX69" fmla="*/ 2807625 w 3160170"/>
                    <a:gd name="connsiteY69" fmla="*/ 419137 h 922177"/>
                    <a:gd name="connsiteX70" fmla="*/ 2807625 w 3160170"/>
                    <a:gd name="connsiteY70" fmla="*/ 441362 h 922177"/>
                    <a:gd name="connsiteX71" fmla="*/ 2810800 w 3160170"/>
                    <a:gd name="connsiteY71" fmla="*/ 476287 h 922177"/>
                    <a:gd name="connsiteX72" fmla="*/ 2813975 w 3160170"/>
                    <a:gd name="connsiteY72" fmla="*/ 504862 h 922177"/>
                    <a:gd name="connsiteX73" fmla="*/ 2817150 w 3160170"/>
                    <a:gd name="connsiteY73" fmla="*/ 530262 h 922177"/>
                    <a:gd name="connsiteX74" fmla="*/ 2817150 w 3160170"/>
                    <a:gd name="connsiteY74" fmla="*/ 558837 h 922177"/>
                    <a:gd name="connsiteX75" fmla="*/ 2813975 w 3160170"/>
                    <a:gd name="connsiteY75" fmla="*/ 571537 h 922177"/>
                    <a:gd name="connsiteX76" fmla="*/ 2807625 w 3160170"/>
                    <a:gd name="connsiteY76" fmla="*/ 584237 h 922177"/>
                    <a:gd name="connsiteX77" fmla="*/ 2798100 w 3160170"/>
                    <a:gd name="connsiteY77" fmla="*/ 603287 h 922177"/>
                    <a:gd name="connsiteX78" fmla="*/ 2794925 w 3160170"/>
                    <a:gd name="connsiteY78" fmla="*/ 619162 h 922177"/>
                    <a:gd name="connsiteX79" fmla="*/ 2794925 w 3160170"/>
                    <a:gd name="connsiteY79" fmla="*/ 635037 h 922177"/>
                    <a:gd name="connsiteX80" fmla="*/ 2798100 w 3160170"/>
                    <a:gd name="connsiteY80" fmla="*/ 647737 h 922177"/>
                    <a:gd name="connsiteX81" fmla="*/ 2798100 w 3160170"/>
                    <a:gd name="connsiteY81" fmla="*/ 647737 h 922177"/>
                    <a:gd name="connsiteX82" fmla="*/ 2747300 w 3160170"/>
                    <a:gd name="connsiteY82" fmla="*/ 666787 h 922177"/>
                    <a:gd name="connsiteX83" fmla="*/ 2696500 w 3160170"/>
                    <a:gd name="connsiteY83" fmla="*/ 676312 h 922177"/>
                    <a:gd name="connsiteX84" fmla="*/ 2648875 w 3160170"/>
                    <a:gd name="connsiteY84" fmla="*/ 682662 h 922177"/>
                    <a:gd name="connsiteX85" fmla="*/ 2623475 w 3160170"/>
                    <a:gd name="connsiteY85" fmla="*/ 682662 h 922177"/>
                    <a:gd name="connsiteX86" fmla="*/ 2585375 w 3160170"/>
                    <a:gd name="connsiteY86" fmla="*/ 682662 h 922177"/>
                    <a:gd name="connsiteX87" fmla="*/ 2538310 w 3160170"/>
                    <a:gd name="connsiteY87" fmla="*/ 697416 h 922177"/>
                    <a:gd name="connsiteX88" fmla="*/ 2483775 w 3160170"/>
                    <a:gd name="connsiteY88" fmla="*/ 704887 h 922177"/>
                    <a:gd name="connsiteX89" fmla="*/ 2439325 w 3160170"/>
                    <a:gd name="connsiteY89" fmla="*/ 714412 h 922177"/>
                    <a:gd name="connsiteX90" fmla="*/ 2394875 w 3160170"/>
                    <a:gd name="connsiteY90" fmla="*/ 723937 h 922177"/>
                    <a:gd name="connsiteX91" fmla="*/ 2347250 w 3160170"/>
                    <a:gd name="connsiteY91" fmla="*/ 730287 h 922177"/>
                    <a:gd name="connsiteX92" fmla="*/ 2315500 w 3160170"/>
                    <a:gd name="connsiteY92" fmla="*/ 717587 h 922177"/>
                    <a:gd name="connsiteX93" fmla="*/ 2252000 w 3160170"/>
                    <a:gd name="connsiteY93" fmla="*/ 704887 h 922177"/>
                    <a:gd name="connsiteX94" fmla="*/ 2213900 w 3160170"/>
                    <a:gd name="connsiteY94" fmla="*/ 698537 h 922177"/>
                    <a:gd name="connsiteX95" fmla="*/ 2172625 w 3160170"/>
                    <a:gd name="connsiteY95" fmla="*/ 692187 h 922177"/>
                    <a:gd name="connsiteX96" fmla="*/ 2115475 w 3160170"/>
                    <a:gd name="connsiteY96" fmla="*/ 682662 h 922177"/>
                    <a:gd name="connsiteX97" fmla="*/ 2077375 w 3160170"/>
                    <a:gd name="connsiteY97" fmla="*/ 676312 h 922177"/>
                    <a:gd name="connsiteX98" fmla="*/ 2029750 w 3160170"/>
                    <a:gd name="connsiteY98" fmla="*/ 666787 h 922177"/>
                    <a:gd name="connsiteX99" fmla="*/ 1915450 w 3160170"/>
                    <a:gd name="connsiteY99" fmla="*/ 660437 h 922177"/>
                    <a:gd name="connsiteX100" fmla="*/ 1855125 w 3160170"/>
                    <a:gd name="connsiteY100" fmla="*/ 663612 h 922177"/>
                    <a:gd name="connsiteX101" fmla="*/ 1769400 w 3160170"/>
                    <a:gd name="connsiteY101" fmla="*/ 666787 h 922177"/>
                    <a:gd name="connsiteX102" fmla="*/ 1731300 w 3160170"/>
                    <a:gd name="connsiteY102" fmla="*/ 673137 h 922177"/>
                    <a:gd name="connsiteX103" fmla="*/ 1686850 w 3160170"/>
                    <a:gd name="connsiteY103" fmla="*/ 695362 h 922177"/>
                    <a:gd name="connsiteX104" fmla="*/ 1629700 w 3160170"/>
                    <a:gd name="connsiteY104" fmla="*/ 717587 h 922177"/>
                    <a:gd name="connsiteX105" fmla="*/ 1585250 w 3160170"/>
                    <a:gd name="connsiteY105" fmla="*/ 739812 h 922177"/>
                    <a:gd name="connsiteX106" fmla="*/ 1528100 w 3160170"/>
                    <a:gd name="connsiteY106" fmla="*/ 755687 h 922177"/>
                    <a:gd name="connsiteX107" fmla="*/ 1496350 w 3160170"/>
                    <a:gd name="connsiteY107" fmla="*/ 774737 h 922177"/>
                    <a:gd name="connsiteX108" fmla="*/ 1470950 w 3160170"/>
                    <a:gd name="connsiteY108" fmla="*/ 781087 h 922177"/>
                    <a:gd name="connsiteX109" fmla="*/ 1426500 w 3160170"/>
                    <a:gd name="connsiteY109" fmla="*/ 800137 h 922177"/>
                    <a:gd name="connsiteX110" fmla="*/ 1353475 w 3160170"/>
                    <a:gd name="connsiteY110" fmla="*/ 777912 h 922177"/>
                    <a:gd name="connsiteX111" fmla="*/ 1242350 w 3160170"/>
                    <a:gd name="connsiteY111" fmla="*/ 752512 h 922177"/>
                    <a:gd name="connsiteX112" fmla="*/ 1169325 w 3160170"/>
                    <a:gd name="connsiteY112" fmla="*/ 736637 h 922177"/>
                    <a:gd name="connsiteX113" fmla="*/ 1029625 w 3160170"/>
                    <a:gd name="connsiteY113" fmla="*/ 704887 h 922177"/>
                    <a:gd name="connsiteX114" fmla="*/ 959775 w 3160170"/>
                    <a:gd name="connsiteY114" fmla="*/ 701712 h 922177"/>
                    <a:gd name="connsiteX115" fmla="*/ 867700 w 3160170"/>
                    <a:gd name="connsiteY115" fmla="*/ 698537 h 922177"/>
                    <a:gd name="connsiteX116" fmla="*/ 813725 w 3160170"/>
                    <a:gd name="connsiteY116" fmla="*/ 701712 h 922177"/>
                    <a:gd name="connsiteX117" fmla="*/ 775625 w 3160170"/>
                    <a:gd name="connsiteY117" fmla="*/ 714412 h 922177"/>
                    <a:gd name="connsiteX118" fmla="*/ 712125 w 3160170"/>
                    <a:gd name="connsiteY118" fmla="*/ 727112 h 922177"/>
                    <a:gd name="connsiteX119" fmla="*/ 677200 w 3160170"/>
                    <a:gd name="connsiteY119" fmla="*/ 739812 h 922177"/>
                    <a:gd name="connsiteX120" fmla="*/ 538060 w 3160170"/>
                    <a:gd name="connsiteY120" fmla="*/ 749150 h 922177"/>
                    <a:gd name="connsiteX121" fmla="*/ 427869 w 3160170"/>
                    <a:gd name="connsiteY121" fmla="*/ 731968 h 922177"/>
                    <a:gd name="connsiteX122" fmla="*/ 366050 w 3160170"/>
                    <a:gd name="connsiteY122" fmla="*/ 723937 h 922177"/>
                    <a:gd name="connsiteX123" fmla="*/ 319172 w 3160170"/>
                    <a:gd name="connsiteY123" fmla="*/ 728979 h 922177"/>
                    <a:gd name="connsiteX124" fmla="*/ 232700 w 3160170"/>
                    <a:gd name="connsiteY124" fmla="*/ 717587 h 922177"/>
                    <a:gd name="connsiteX125" fmla="*/ 213650 w 3160170"/>
                    <a:gd name="connsiteY125" fmla="*/ 717587 h 922177"/>
                    <a:gd name="connsiteX126" fmla="*/ 146975 w 3160170"/>
                    <a:gd name="connsiteY126" fmla="*/ 717587 h 922177"/>
                    <a:gd name="connsiteX127" fmla="*/ 131100 w 3160170"/>
                    <a:gd name="connsiteY127" fmla="*/ 720762 h 922177"/>
                    <a:gd name="connsiteX128" fmla="*/ 99350 w 3160170"/>
                    <a:gd name="connsiteY128" fmla="*/ 733462 h 922177"/>
                    <a:gd name="connsiteX129" fmla="*/ 70775 w 3160170"/>
                    <a:gd name="connsiteY129" fmla="*/ 742987 h 922177"/>
                    <a:gd name="connsiteX130" fmla="*/ 17214 w 3160170"/>
                    <a:gd name="connsiteY130" fmla="*/ 752650 h 922177"/>
                    <a:gd name="connsiteX131" fmla="*/ 787 w 3160170"/>
                    <a:gd name="connsiteY131" fmla="*/ 787023 h 922177"/>
                    <a:gd name="connsiteX132" fmla="*/ 37782 w 3160170"/>
                    <a:gd name="connsiteY132" fmla="*/ 843206 h 922177"/>
                    <a:gd name="connsiteX133" fmla="*/ 80438 w 3160170"/>
                    <a:gd name="connsiteY133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36281 w 3160170"/>
                    <a:gd name="connsiteY48" fmla="*/ 38137 h 922177"/>
                    <a:gd name="connsiteX49" fmla="*/ 2664750 w 3160170"/>
                    <a:gd name="connsiteY49" fmla="*/ 15912 h 922177"/>
                    <a:gd name="connsiteX50" fmla="*/ 2600316 w 3160170"/>
                    <a:gd name="connsiteY50" fmla="*/ 2839 h 922177"/>
                    <a:gd name="connsiteX51" fmla="*/ 2546308 w 3160170"/>
                    <a:gd name="connsiteY51" fmla="*/ 1003 h 922177"/>
                    <a:gd name="connsiteX52" fmla="*/ 2518148 w 3160170"/>
                    <a:gd name="connsiteY52" fmla="*/ 15359 h 922177"/>
                    <a:gd name="connsiteX53" fmla="*/ 2480600 w 3160170"/>
                    <a:gd name="connsiteY53" fmla="*/ 50837 h 922177"/>
                    <a:gd name="connsiteX54" fmla="*/ 2461550 w 3160170"/>
                    <a:gd name="connsiteY54" fmla="*/ 85762 h 922177"/>
                    <a:gd name="connsiteX55" fmla="*/ 2455200 w 3160170"/>
                    <a:gd name="connsiteY55" fmla="*/ 117512 h 922177"/>
                    <a:gd name="connsiteX56" fmla="*/ 2463068 w 3160170"/>
                    <a:gd name="connsiteY56" fmla="*/ 141118 h 922177"/>
                    <a:gd name="connsiteX57" fmla="*/ 2486122 w 3160170"/>
                    <a:gd name="connsiteY57" fmla="*/ 155336 h 922177"/>
                    <a:gd name="connsiteX58" fmla="*/ 2515525 w 3160170"/>
                    <a:gd name="connsiteY58" fmla="*/ 165137 h 922177"/>
                    <a:gd name="connsiteX59" fmla="*/ 2531400 w 3160170"/>
                    <a:gd name="connsiteY59" fmla="*/ 165137 h 922177"/>
                    <a:gd name="connsiteX60" fmla="*/ 2559975 w 3160170"/>
                    <a:gd name="connsiteY60" fmla="*/ 165551 h 922177"/>
                    <a:gd name="connsiteX61" fmla="*/ 2569500 w 3160170"/>
                    <a:gd name="connsiteY61" fmla="*/ 168312 h 922177"/>
                    <a:gd name="connsiteX62" fmla="*/ 2601250 w 3160170"/>
                    <a:gd name="connsiteY62" fmla="*/ 171487 h 922177"/>
                    <a:gd name="connsiteX63" fmla="*/ 2664750 w 3160170"/>
                    <a:gd name="connsiteY63" fmla="*/ 174662 h 922177"/>
                    <a:gd name="connsiteX64" fmla="*/ 2721900 w 3160170"/>
                    <a:gd name="connsiteY64" fmla="*/ 215937 h 922177"/>
                    <a:gd name="connsiteX65" fmla="*/ 2763175 w 3160170"/>
                    <a:gd name="connsiteY65" fmla="*/ 285787 h 922177"/>
                    <a:gd name="connsiteX66" fmla="*/ 2779050 w 3160170"/>
                    <a:gd name="connsiteY66" fmla="*/ 320712 h 922177"/>
                    <a:gd name="connsiteX67" fmla="*/ 2791750 w 3160170"/>
                    <a:gd name="connsiteY67" fmla="*/ 361987 h 922177"/>
                    <a:gd name="connsiteX68" fmla="*/ 2804450 w 3160170"/>
                    <a:gd name="connsiteY68" fmla="*/ 400087 h 922177"/>
                    <a:gd name="connsiteX69" fmla="*/ 2807625 w 3160170"/>
                    <a:gd name="connsiteY69" fmla="*/ 419137 h 922177"/>
                    <a:gd name="connsiteX70" fmla="*/ 2807625 w 3160170"/>
                    <a:gd name="connsiteY70" fmla="*/ 441362 h 922177"/>
                    <a:gd name="connsiteX71" fmla="*/ 2810800 w 3160170"/>
                    <a:gd name="connsiteY71" fmla="*/ 476287 h 922177"/>
                    <a:gd name="connsiteX72" fmla="*/ 2813975 w 3160170"/>
                    <a:gd name="connsiteY72" fmla="*/ 504862 h 922177"/>
                    <a:gd name="connsiteX73" fmla="*/ 2817150 w 3160170"/>
                    <a:gd name="connsiteY73" fmla="*/ 530262 h 922177"/>
                    <a:gd name="connsiteX74" fmla="*/ 2817150 w 3160170"/>
                    <a:gd name="connsiteY74" fmla="*/ 558837 h 922177"/>
                    <a:gd name="connsiteX75" fmla="*/ 2813975 w 3160170"/>
                    <a:gd name="connsiteY75" fmla="*/ 571537 h 922177"/>
                    <a:gd name="connsiteX76" fmla="*/ 2807625 w 3160170"/>
                    <a:gd name="connsiteY76" fmla="*/ 584237 h 922177"/>
                    <a:gd name="connsiteX77" fmla="*/ 2798100 w 3160170"/>
                    <a:gd name="connsiteY77" fmla="*/ 603287 h 922177"/>
                    <a:gd name="connsiteX78" fmla="*/ 2794925 w 3160170"/>
                    <a:gd name="connsiteY78" fmla="*/ 619162 h 922177"/>
                    <a:gd name="connsiteX79" fmla="*/ 2794925 w 3160170"/>
                    <a:gd name="connsiteY79" fmla="*/ 635037 h 922177"/>
                    <a:gd name="connsiteX80" fmla="*/ 2798100 w 3160170"/>
                    <a:gd name="connsiteY80" fmla="*/ 647737 h 922177"/>
                    <a:gd name="connsiteX81" fmla="*/ 2798100 w 3160170"/>
                    <a:gd name="connsiteY81" fmla="*/ 647737 h 922177"/>
                    <a:gd name="connsiteX82" fmla="*/ 2747300 w 3160170"/>
                    <a:gd name="connsiteY82" fmla="*/ 666787 h 922177"/>
                    <a:gd name="connsiteX83" fmla="*/ 2696500 w 3160170"/>
                    <a:gd name="connsiteY83" fmla="*/ 676312 h 922177"/>
                    <a:gd name="connsiteX84" fmla="*/ 2648875 w 3160170"/>
                    <a:gd name="connsiteY84" fmla="*/ 682662 h 922177"/>
                    <a:gd name="connsiteX85" fmla="*/ 2623475 w 3160170"/>
                    <a:gd name="connsiteY85" fmla="*/ 682662 h 922177"/>
                    <a:gd name="connsiteX86" fmla="*/ 2538310 w 3160170"/>
                    <a:gd name="connsiteY86" fmla="*/ 697416 h 922177"/>
                    <a:gd name="connsiteX87" fmla="*/ 2483775 w 3160170"/>
                    <a:gd name="connsiteY87" fmla="*/ 704887 h 922177"/>
                    <a:gd name="connsiteX88" fmla="*/ 2439325 w 3160170"/>
                    <a:gd name="connsiteY88" fmla="*/ 714412 h 922177"/>
                    <a:gd name="connsiteX89" fmla="*/ 2394875 w 3160170"/>
                    <a:gd name="connsiteY89" fmla="*/ 723937 h 922177"/>
                    <a:gd name="connsiteX90" fmla="*/ 2347250 w 3160170"/>
                    <a:gd name="connsiteY90" fmla="*/ 730287 h 922177"/>
                    <a:gd name="connsiteX91" fmla="*/ 2315500 w 3160170"/>
                    <a:gd name="connsiteY91" fmla="*/ 717587 h 922177"/>
                    <a:gd name="connsiteX92" fmla="*/ 2252000 w 3160170"/>
                    <a:gd name="connsiteY92" fmla="*/ 704887 h 922177"/>
                    <a:gd name="connsiteX93" fmla="*/ 2213900 w 3160170"/>
                    <a:gd name="connsiteY93" fmla="*/ 698537 h 922177"/>
                    <a:gd name="connsiteX94" fmla="*/ 2172625 w 3160170"/>
                    <a:gd name="connsiteY94" fmla="*/ 692187 h 922177"/>
                    <a:gd name="connsiteX95" fmla="*/ 2115475 w 3160170"/>
                    <a:gd name="connsiteY95" fmla="*/ 682662 h 922177"/>
                    <a:gd name="connsiteX96" fmla="*/ 2077375 w 3160170"/>
                    <a:gd name="connsiteY96" fmla="*/ 676312 h 922177"/>
                    <a:gd name="connsiteX97" fmla="*/ 2029750 w 3160170"/>
                    <a:gd name="connsiteY97" fmla="*/ 666787 h 922177"/>
                    <a:gd name="connsiteX98" fmla="*/ 1915450 w 3160170"/>
                    <a:gd name="connsiteY98" fmla="*/ 660437 h 922177"/>
                    <a:gd name="connsiteX99" fmla="*/ 1855125 w 3160170"/>
                    <a:gd name="connsiteY99" fmla="*/ 663612 h 922177"/>
                    <a:gd name="connsiteX100" fmla="*/ 1769400 w 3160170"/>
                    <a:gd name="connsiteY100" fmla="*/ 666787 h 922177"/>
                    <a:gd name="connsiteX101" fmla="*/ 1731300 w 3160170"/>
                    <a:gd name="connsiteY101" fmla="*/ 673137 h 922177"/>
                    <a:gd name="connsiteX102" fmla="*/ 1686850 w 3160170"/>
                    <a:gd name="connsiteY102" fmla="*/ 695362 h 922177"/>
                    <a:gd name="connsiteX103" fmla="*/ 1629700 w 3160170"/>
                    <a:gd name="connsiteY103" fmla="*/ 717587 h 922177"/>
                    <a:gd name="connsiteX104" fmla="*/ 1585250 w 3160170"/>
                    <a:gd name="connsiteY104" fmla="*/ 739812 h 922177"/>
                    <a:gd name="connsiteX105" fmla="*/ 1528100 w 3160170"/>
                    <a:gd name="connsiteY105" fmla="*/ 755687 h 922177"/>
                    <a:gd name="connsiteX106" fmla="*/ 1496350 w 3160170"/>
                    <a:gd name="connsiteY106" fmla="*/ 774737 h 922177"/>
                    <a:gd name="connsiteX107" fmla="*/ 1470950 w 3160170"/>
                    <a:gd name="connsiteY107" fmla="*/ 781087 h 922177"/>
                    <a:gd name="connsiteX108" fmla="*/ 1426500 w 3160170"/>
                    <a:gd name="connsiteY108" fmla="*/ 800137 h 922177"/>
                    <a:gd name="connsiteX109" fmla="*/ 1353475 w 3160170"/>
                    <a:gd name="connsiteY109" fmla="*/ 777912 h 922177"/>
                    <a:gd name="connsiteX110" fmla="*/ 1242350 w 3160170"/>
                    <a:gd name="connsiteY110" fmla="*/ 752512 h 922177"/>
                    <a:gd name="connsiteX111" fmla="*/ 1169325 w 3160170"/>
                    <a:gd name="connsiteY111" fmla="*/ 736637 h 922177"/>
                    <a:gd name="connsiteX112" fmla="*/ 1029625 w 3160170"/>
                    <a:gd name="connsiteY112" fmla="*/ 704887 h 922177"/>
                    <a:gd name="connsiteX113" fmla="*/ 959775 w 3160170"/>
                    <a:gd name="connsiteY113" fmla="*/ 701712 h 922177"/>
                    <a:gd name="connsiteX114" fmla="*/ 867700 w 3160170"/>
                    <a:gd name="connsiteY114" fmla="*/ 698537 h 922177"/>
                    <a:gd name="connsiteX115" fmla="*/ 813725 w 3160170"/>
                    <a:gd name="connsiteY115" fmla="*/ 701712 h 922177"/>
                    <a:gd name="connsiteX116" fmla="*/ 775625 w 3160170"/>
                    <a:gd name="connsiteY116" fmla="*/ 714412 h 922177"/>
                    <a:gd name="connsiteX117" fmla="*/ 712125 w 3160170"/>
                    <a:gd name="connsiteY117" fmla="*/ 727112 h 922177"/>
                    <a:gd name="connsiteX118" fmla="*/ 677200 w 3160170"/>
                    <a:gd name="connsiteY118" fmla="*/ 739812 h 922177"/>
                    <a:gd name="connsiteX119" fmla="*/ 538060 w 3160170"/>
                    <a:gd name="connsiteY119" fmla="*/ 749150 h 922177"/>
                    <a:gd name="connsiteX120" fmla="*/ 427869 w 3160170"/>
                    <a:gd name="connsiteY120" fmla="*/ 731968 h 922177"/>
                    <a:gd name="connsiteX121" fmla="*/ 366050 w 3160170"/>
                    <a:gd name="connsiteY121" fmla="*/ 723937 h 922177"/>
                    <a:gd name="connsiteX122" fmla="*/ 319172 w 3160170"/>
                    <a:gd name="connsiteY122" fmla="*/ 728979 h 922177"/>
                    <a:gd name="connsiteX123" fmla="*/ 232700 w 3160170"/>
                    <a:gd name="connsiteY123" fmla="*/ 717587 h 922177"/>
                    <a:gd name="connsiteX124" fmla="*/ 213650 w 3160170"/>
                    <a:gd name="connsiteY124" fmla="*/ 717587 h 922177"/>
                    <a:gd name="connsiteX125" fmla="*/ 146975 w 3160170"/>
                    <a:gd name="connsiteY125" fmla="*/ 717587 h 922177"/>
                    <a:gd name="connsiteX126" fmla="*/ 131100 w 3160170"/>
                    <a:gd name="connsiteY126" fmla="*/ 720762 h 922177"/>
                    <a:gd name="connsiteX127" fmla="*/ 99350 w 3160170"/>
                    <a:gd name="connsiteY127" fmla="*/ 733462 h 922177"/>
                    <a:gd name="connsiteX128" fmla="*/ 70775 w 3160170"/>
                    <a:gd name="connsiteY128" fmla="*/ 742987 h 922177"/>
                    <a:gd name="connsiteX129" fmla="*/ 17214 w 3160170"/>
                    <a:gd name="connsiteY129" fmla="*/ 752650 h 922177"/>
                    <a:gd name="connsiteX130" fmla="*/ 787 w 3160170"/>
                    <a:gd name="connsiteY130" fmla="*/ 787023 h 922177"/>
                    <a:gd name="connsiteX131" fmla="*/ 37782 w 3160170"/>
                    <a:gd name="connsiteY131" fmla="*/ 843206 h 922177"/>
                    <a:gd name="connsiteX132" fmla="*/ 80438 w 3160170"/>
                    <a:gd name="connsiteY132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55250 w 3160170"/>
                    <a:gd name="connsiteY45" fmla="*/ 149262 h 922177"/>
                    <a:gd name="connsiteX46" fmla="*/ 2829850 w 3160170"/>
                    <a:gd name="connsiteY46" fmla="*/ 114337 h 922177"/>
                    <a:gd name="connsiteX47" fmla="*/ 2791750 w 3160170"/>
                    <a:gd name="connsiteY47" fmla="*/ 66712 h 922177"/>
                    <a:gd name="connsiteX48" fmla="*/ 2736281 w 3160170"/>
                    <a:gd name="connsiteY48" fmla="*/ 38137 h 922177"/>
                    <a:gd name="connsiteX49" fmla="*/ 2664750 w 3160170"/>
                    <a:gd name="connsiteY49" fmla="*/ 15912 h 922177"/>
                    <a:gd name="connsiteX50" fmla="*/ 2600316 w 3160170"/>
                    <a:gd name="connsiteY50" fmla="*/ 2839 h 922177"/>
                    <a:gd name="connsiteX51" fmla="*/ 2546308 w 3160170"/>
                    <a:gd name="connsiteY51" fmla="*/ 1003 h 922177"/>
                    <a:gd name="connsiteX52" fmla="*/ 2518148 w 3160170"/>
                    <a:gd name="connsiteY52" fmla="*/ 15359 h 922177"/>
                    <a:gd name="connsiteX53" fmla="*/ 2480600 w 3160170"/>
                    <a:gd name="connsiteY53" fmla="*/ 50837 h 922177"/>
                    <a:gd name="connsiteX54" fmla="*/ 2461550 w 3160170"/>
                    <a:gd name="connsiteY54" fmla="*/ 85762 h 922177"/>
                    <a:gd name="connsiteX55" fmla="*/ 2455200 w 3160170"/>
                    <a:gd name="connsiteY55" fmla="*/ 117512 h 922177"/>
                    <a:gd name="connsiteX56" fmla="*/ 2463068 w 3160170"/>
                    <a:gd name="connsiteY56" fmla="*/ 141118 h 922177"/>
                    <a:gd name="connsiteX57" fmla="*/ 2486122 w 3160170"/>
                    <a:gd name="connsiteY57" fmla="*/ 155336 h 922177"/>
                    <a:gd name="connsiteX58" fmla="*/ 2515525 w 3160170"/>
                    <a:gd name="connsiteY58" fmla="*/ 165137 h 922177"/>
                    <a:gd name="connsiteX59" fmla="*/ 2531400 w 3160170"/>
                    <a:gd name="connsiteY59" fmla="*/ 165137 h 922177"/>
                    <a:gd name="connsiteX60" fmla="*/ 2559975 w 3160170"/>
                    <a:gd name="connsiteY60" fmla="*/ 165551 h 922177"/>
                    <a:gd name="connsiteX61" fmla="*/ 2569500 w 3160170"/>
                    <a:gd name="connsiteY61" fmla="*/ 168312 h 922177"/>
                    <a:gd name="connsiteX62" fmla="*/ 2601250 w 3160170"/>
                    <a:gd name="connsiteY62" fmla="*/ 171487 h 922177"/>
                    <a:gd name="connsiteX63" fmla="*/ 2664750 w 3160170"/>
                    <a:gd name="connsiteY63" fmla="*/ 174662 h 922177"/>
                    <a:gd name="connsiteX64" fmla="*/ 2721900 w 3160170"/>
                    <a:gd name="connsiteY64" fmla="*/ 215937 h 922177"/>
                    <a:gd name="connsiteX65" fmla="*/ 2763175 w 3160170"/>
                    <a:gd name="connsiteY65" fmla="*/ 285787 h 922177"/>
                    <a:gd name="connsiteX66" fmla="*/ 2779050 w 3160170"/>
                    <a:gd name="connsiteY66" fmla="*/ 320712 h 922177"/>
                    <a:gd name="connsiteX67" fmla="*/ 2791750 w 3160170"/>
                    <a:gd name="connsiteY67" fmla="*/ 361987 h 922177"/>
                    <a:gd name="connsiteX68" fmla="*/ 2804450 w 3160170"/>
                    <a:gd name="connsiteY68" fmla="*/ 400087 h 922177"/>
                    <a:gd name="connsiteX69" fmla="*/ 2807625 w 3160170"/>
                    <a:gd name="connsiteY69" fmla="*/ 419137 h 922177"/>
                    <a:gd name="connsiteX70" fmla="*/ 2807625 w 3160170"/>
                    <a:gd name="connsiteY70" fmla="*/ 441362 h 922177"/>
                    <a:gd name="connsiteX71" fmla="*/ 2810800 w 3160170"/>
                    <a:gd name="connsiteY71" fmla="*/ 476287 h 922177"/>
                    <a:gd name="connsiteX72" fmla="*/ 2813975 w 3160170"/>
                    <a:gd name="connsiteY72" fmla="*/ 504862 h 922177"/>
                    <a:gd name="connsiteX73" fmla="*/ 2817150 w 3160170"/>
                    <a:gd name="connsiteY73" fmla="*/ 530262 h 922177"/>
                    <a:gd name="connsiteX74" fmla="*/ 2817150 w 3160170"/>
                    <a:gd name="connsiteY74" fmla="*/ 558837 h 922177"/>
                    <a:gd name="connsiteX75" fmla="*/ 2813975 w 3160170"/>
                    <a:gd name="connsiteY75" fmla="*/ 571537 h 922177"/>
                    <a:gd name="connsiteX76" fmla="*/ 2807625 w 3160170"/>
                    <a:gd name="connsiteY76" fmla="*/ 584237 h 922177"/>
                    <a:gd name="connsiteX77" fmla="*/ 2798100 w 3160170"/>
                    <a:gd name="connsiteY77" fmla="*/ 603287 h 922177"/>
                    <a:gd name="connsiteX78" fmla="*/ 2794925 w 3160170"/>
                    <a:gd name="connsiteY78" fmla="*/ 619162 h 922177"/>
                    <a:gd name="connsiteX79" fmla="*/ 2794925 w 3160170"/>
                    <a:gd name="connsiteY79" fmla="*/ 635037 h 922177"/>
                    <a:gd name="connsiteX80" fmla="*/ 2798100 w 3160170"/>
                    <a:gd name="connsiteY80" fmla="*/ 647737 h 922177"/>
                    <a:gd name="connsiteX81" fmla="*/ 2798100 w 3160170"/>
                    <a:gd name="connsiteY81" fmla="*/ 647737 h 922177"/>
                    <a:gd name="connsiteX82" fmla="*/ 2747300 w 3160170"/>
                    <a:gd name="connsiteY82" fmla="*/ 666787 h 922177"/>
                    <a:gd name="connsiteX83" fmla="*/ 2696500 w 3160170"/>
                    <a:gd name="connsiteY83" fmla="*/ 676312 h 922177"/>
                    <a:gd name="connsiteX84" fmla="*/ 2648875 w 3160170"/>
                    <a:gd name="connsiteY84" fmla="*/ 682662 h 922177"/>
                    <a:gd name="connsiteX85" fmla="*/ 2623475 w 3160170"/>
                    <a:gd name="connsiteY85" fmla="*/ 682662 h 922177"/>
                    <a:gd name="connsiteX86" fmla="*/ 2538310 w 3160170"/>
                    <a:gd name="connsiteY86" fmla="*/ 697416 h 922177"/>
                    <a:gd name="connsiteX87" fmla="*/ 2483775 w 3160170"/>
                    <a:gd name="connsiteY87" fmla="*/ 704887 h 922177"/>
                    <a:gd name="connsiteX88" fmla="*/ 2439325 w 3160170"/>
                    <a:gd name="connsiteY88" fmla="*/ 714412 h 922177"/>
                    <a:gd name="connsiteX89" fmla="*/ 2394875 w 3160170"/>
                    <a:gd name="connsiteY89" fmla="*/ 723937 h 922177"/>
                    <a:gd name="connsiteX90" fmla="*/ 2315500 w 3160170"/>
                    <a:gd name="connsiteY90" fmla="*/ 717587 h 922177"/>
                    <a:gd name="connsiteX91" fmla="*/ 2252000 w 3160170"/>
                    <a:gd name="connsiteY91" fmla="*/ 704887 h 922177"/>
                    <a:gd name="connsiteX92" fmla="*/ 2213900 w 3160170"/>
                    <a:gd name="connsiteY92" fmla="*/ 698537 h 922177"/>
                    <a:gd name="connsiteX93" fmla="*/ 2172625 w 3160170"/>
                    <a:gd name="connsiteY93" fmla="*/ 692187 h 922177"/>
                    <a:gd name="connsiteX94" fmla="*/ 2115475 w 3160170"/>
                    <a:gd name="connsiteY94" fmla="*/ 682662 h 922177"/>
                    <a:gd name="connsiteX95" fmla="*/ 2077375 w 3160170"/>
                    <a:gd name="connsiteY95" fmla="*/ 676312 h 922177"/>
                    <a:gd name="connsiteX96" fmla="*/ 2029750 w 3160170"/>
                    <a:gd name="connsiteY96" fmla="*/ 666787 h 922177"/>
                    <a:gd name="connsiteX97" fmla="*/ 1915450 w 3160170"/>
                    <a:gd name="connsiteY97" fmla="*/ 660437 h 922177"/>
                    <a:gd name="connsiteX98" fmla="*/ 1855125 w 3160170"/>
                    <a:gd name="connsiteY98" fmla="*/ 663612 h 922177"/>
                    <a:gd name="connsiteX99" fmla="*/ 1769400 w 3160170"/>
                    <a:gd name="connsiteY99" fmla="*/ 666787 h 922177"/>
                    <a:gd name="connsiteX100" fmla="*/ 1731300 w 3160170"/>
                    <a:gd name="connsiteY100" fmla="*/ 673137 h 922177"/>
                    <a:gd name="connsiteX101" fmla="*/ 1686850 w 3160170"/>
                    <a:gd name="connsiteY101" fmla="*/ 695362 h 922177"/>
                    <a:gd name="connsiteX102" fmla="*/ 1629700 w 3160170"/>
                    <a:gd name="connsiteY102" fmla="*/ 717587 h 922177"/>
                    <a:gd name="connsiteX103" fmla="*/ 1585250 w 3160170"/>
                    <a:gd name="connsiteY103" fmla="*/ 739812 h 922177"/>
                    <a:gd name="connsiteX104" fmla="*/ 1528100 w 3160170"/>
                    <a:gd name="connsiteY104" fmla="*/ 755687 h 922177"/>
                    <a:gd name="connsiteX105" fmla="*/ 1496350 w 3160170"/>
                    <a:gd name="connsiteY105" fmla="*/ 774737 h 922177"/>
                    <a:gd name="connsiteX106" fmla="*/ 1470950 w 3160170"/>
                    <a:gd name="connsiteY106" fmla="*/ 781087 h 922177"/>
                    <a:gd name="connsiteX107" fmla="*/ 1426500 w 3160170"/>
                    <a:gd name="connsiteY107" fmla="*/ 800137 h 922177"/>
                    <a:gd name="connsiteX108" fmla="*/ 1353475 w 3160170"/>
                    <a:gd name="connsiteY108" fmla="*/ 777912 h 922177"/>
                    <a:gd name="connsiteX109" fmla="*/ 1242350 w 3160170"/>
                    <a:gd name="connsiteY109" fmla="*/ 752512 h 922177"/>
                    <a:gd name="connsiteX110" fmla="*/ 1169325 w 3160170"/>
                    <a:gd name="connsiteY110" fmla="*/ 736637 h 922177"/>
                    <a:gd name="connsiteX111" fmla="*/ 1029625 w 3160170"/>
                    <a:gd name="connsiteY111" fmla="*/ 704887 h 922177"/>
                    <a:gd name="connsiteX112" fmla="*/ 959775 w 3160170"/>
                    <a:gd name="connsiteY112" fmla="*/ 701712 h 922177"/>
                    <a:gd name="connsiteX113" fmla="*/ 867700 w 3160170"/>
                    <a:gd name="connsiteY113" fmla="*/ 698537 h 922177"/>
                    <a:gd name="connsiteX114" fmla="*/ 813725 w 3160170"/>
                    <a:gd name="connsiteY114" fmla="*/ 701712 h 922177"/>
                    <a:gd name="connsiteX115" fmla="*/ 775625 w 3160170"/>
                    <a:gd name="connsiteY115" fmla="*/ 714412 h 922177"/>
                    <a:gd name="connsiteX116" fmla="*/ 712125 w 3160170"/>
                    <a:gd name="connsiteY116" fmla="*/ 727112 h 922177"/>
                    <a:gd name="connsiteX117" fmla="*/ 677200 w 3160170"/>
                    <a:gd name="connsiteY117" fmla="*/ 739812 h 922177"/>
                    <a:gd name="connsiteX118" fmla="*/ 538060 w 3160170"/>
                    <a:gd name="connsiteY118" fmla="*/ 749150 h 922177"/>
                    <a:gd name="connsiteX119" fmla="*/ 427869 w 3160170"/>
                    <a:gd name="connsiteY119" fmla="*/ 731968 h 922177"/>
                    <a:gd name="connsiteX120" fmla="*/ 366050 w 3160170"/>
                    <a:gd name="connsiteY120" fmla="*/ 723937 h 922177"/>
                    <a:gd name="connsiteX121" fmla="*/ 319172 w 3160170"/>
                    <a:gd name="connsiteY121" fmla="*/ 728979 h 922177"/>
                    <a:gd name="connsiteX122" fmla="*/ 232700 w 3160170"/>
                    <a:gd name="connsiteY122" fmla="*/ 717587 h 922177"/>
                    <a:gd name="connsiteX123" fmla="*/ 213650 w 3160170"/>
                    <a:gd name="connsiteY123" fmla="*/ 717587 h 922177"/>
                    <a:gd name="connsiteX124" fmla="*/ 146975 w 3160170"/>
                    <a:gd name="connsiteY124" fmla="*/ 717587 h 922177"/>
                    <a:gd name="connsiteX125" fmla="*/ 131100 w 3160170"/>
                    <a:gd name="connsiteY125" fmla="*/ 720762 h 922177"/>
                    <a:gd name="connsiteX126" fmla="*/ 99350 w 3160170"/>
                    <a:gd name="connsiteY126" fmla="*/ 733462 h 922177"/>
                    <a:gd name="connsiteX127" fmla="*/ 70775 w 3160170"/>
                    <a:gd name="connsiteY127" fmla="*/ 742987 h 922177"/>
                    <a:gd name="connsiteX128" fmla="*/ 17214 w 3160170"/>
                    <a:gd name="connsiteY128" fmla="*/ 752650 h 922177"/>
                    <a:gd name="connsiteX129" fmla="*/ 787 w 3160170"/>
                    <a:gd name="connsiteY129" fmla="*/ 787023 h 922177"/>
                    <a:gd name="connsiteX130" fmla="*/ 37782 w 3160170"/>
                    <a:gd name="connsiteY130" fmla="*/ 843206 h 922177"/>
                    <a:gd name="connsiteX131" fmla="*/ 80438 w 3160170"/>
                    <a:gd name="connsiteY131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71125 w 3160170"/>
                    <a:gd name="connsiteY44" fmla="*/ 161962 h 922177"/>
                    <a:gd name="connsiteX45" fmla="*/ 2829850 w 3160170"/>
                    <a:gd name="connsiteY45" fmla="*/ 114337 h 922177"/>
                    <a:gd name="connsiteX46" fmla="*/ 2791750 w 3160170"/>
                    <a:gd name="connsiteY46" fmla="*/ 66712 h 922177"/>
                    <a:gd name="connsiteX47" fmla="*/ 2736281 w 3160170"/>
                    <a:gd name="connsiteY47" fmla="*/ 38137 h 922177"/>
                    <a:gd name="connsiteX48" fmla="*/ 2664750 w 3160170"/>
                    <a:gd name="connsiteY48" fmla="*/ 15912 h 922177"/>
                    <a:gd name="connsiteX49" fmla="*/ 2600316 w 3160170"/>
                    <a:gd name="connsiteY49" fmla="*/ 2839 h 922177"/>
                    <a:gd name="connsiteX50" fmla="*/ 2546308 w 3160170"/>
                    <a:gd name="connsiteY50" fmla="*/ 1003 h 922177"/>
                    <a:gd name="connsiteX51" fmla="*/ 2518148 w 3160170"/>
                    <a:gd name="connsiteY51" fmla="*/ 15359 h 922177"/>
                    <a:gd name="connsiteX52" fmla="*/ 2480600 w 3160170"/>
                    <a:gd name="connsiteY52" fmla="*/ 50837 h 922177"/>
                    <a:gd name="connsiteX53" fmla="*/ 2461550 w 3160170"/>
                    <a:gd name="connsiteY53" fmla="*/ 85762 h 922177"/>
                    <a:gd name="connsiteX54" fmla="*/ 2455200 w 3160170"/>
                    <a:gd name="connsiteY54" fmla="*/ 117512 h 922177"/>
                    <a:gd name="connsiteX55" fmla="*/ 2463068 w 3160170"/>
                    <a:gd name="connsiteY55" fmla="*/ 141118 h 922177"/>
                    <a:gd name="connsiteX56" fmla="*/ 2486122 w 3160170"/>
                    <a:gd name="connsiteY56" fmla="*/ 155336 h 922177"/>
                    <a:gd name="connsiteX57" fmla="*/ 2515525 w 3160170"/>
                    <a:gd name="connsiteY57" fmla="*/ 165137 h 922177"/>
                    <a:gd name="connsiteX58" fmla="*/ 2531400 w 3160170"/>
                    <a:gd name="connsiteY58" fmla="*/ 165137 h 922177"/>
                    <a:gd name="connsiteX59" fmla="*/ 2559975 w 3160170"/>
                    <a:gd name="connsiteY59" fmla="*/ 165551 h 922177"/>
                    <a:gd name="connsiteX60" fmla="*/ 2569500 w 3160170"/>
                    <a:gd name="connsiteY60" fmla="*/ 168312 h 922177"/>
                    <a:gd name="connsiteX61" fmla="*/ 2601250 w 3160170"/>
                    <a:gd name="connsiteY61" fmla="*/ 171487 h 922177"/>
                    <a:gd name="connsiteX62" fmla="*/ 2664750 w 3160170"/>
                    <a:gd name="connsiteY62" fmla="*/ 174662 h 922177"/>
                    <a:gd name="connsiteX63" fmla="*/ 2721900 w 3160170"/>
                    <a:gd name="connsiteY63" fmla="*/ 215937 h 922177"/>
                    <a:gd name="connsiteX64" fmla="*/ 2763175 w 3160170"/>
                    <a:gd name="connsiteY64" fmla="*/ 285787 h 922177"/>
                    <a:gd name="connsiteX65" fmla="*/ 2779050 w 3160170"/>
                    <a:gd name="connsiteY65" fmla="*/ 320712 h 922177"/>
                    <a:gd name="connsiteX66" fmla="*/ 2791750 w 3160170"/>
                    <a:gd name="connsiteY66" fmla="*/ 361987 h 922177"/>
                    <a:gd name="connsiteX67" fmla="*/ 2804450 w 3160170"/>
                    <a:gd name="connsiteY67" fmla="*/ 400087 h 922177"/>
                    <a:gd name="connsiteX68" fmla="*/ 2807625 w 3160170"/>
                    <a:gd name="connsiteY68" fmla="*/ 419137 h 922177"/>
                    <a:gd name="connsiteX69" fmla="*/ 2807625 w 3160170"/>
                    <a:gd name="connsiteY69" fmla="*/ 441362 h 922177"/>
                    <a:gd name="connsiteX70" fmla="*/ 2810800 w 3160170"/>
                    <a:gd name="connsiteY70" fmla="*/ 476287 h 922177"/>
                    <a:gd name="connsiteX71" fmla="*/ 2813975 w 3160170"/>
                    <a:gd name="connsiteY71" fmla="*/ 504862 h 922177"/>
                    <a:gd name="connsiteX72" fmla="*/ 2817150 w 3160170"/>
                    <a:gd name="connsiteY72" fmla="*/ 530262 h 922177"/>
                    <a:gd name="connsiteX73" fmla="*/ 2817150 w 3160170"/>
                    <a:gd name="connsiteY73" fmla="*/ 558837 h 922177"/>
                    <a:gd name="connsiteX74" fmla="*/ 2813975 w 3160170"/>
                    <a:gd name="connsiteY74" fmla="*/ 571537 h 922177"/>
                    <a:gd name="connsiteX75" fmla="*/ 2807625 w 3160170"/>
                    <a:gd name="connsiteY75" fmla="*/ 584237 h 922177"/>
                    <a:gd name="connsiteX76" fmla="*/ 2798100 w 3160170"/>
                    <a:gd name="connsiteY76" fmla="*/ 603287 h 922177"/>
                    <a:gd name="connsiteX77" fmla="*/ 2794925 w 3160170"/>
                    <a:gd name="connsiteY77" fmla="*/ 619162 h 922177"/>
                    <a:gd name="connsiteX78" fmla="*/ 2794925 w 3160170"/>
                    <a:gd name="connsiteY78" fmla="*/ 635037 h 922177"/>
                    <a:gd name="connsiteX79" fmla="*/ 2798100 w 3160170"/>
                    <a:gd name="connsiteY79" fmla="*/ 647737 h 922177"/>
                    <a:gd name="connsiteX80" fmla="*/ 2798100 w 3160170"/>
                    <a:gd name="connsiteY80" fmla="*/ 647737 h 922177"/>
                    <a:gd name="connsiteX81" fmla="*/ 2747300 w 3160170"/>
                    <a:gd name="connsiteY81" fmla="*/ 666787 h 922177"/>
                    <a:gd name="connsiteX82" fmla="*/ 2696500 w 3160170"/>
                    <a:gd name="connsiteY82" fmla="*/ 676312 h 922177"/>
                    <a:gd name="connsiteX83" fmla="*/ 2648875 w 3160170"/>
                    <a:gd name="connsiteY83" fmla="*/ 682662 h 922177"/>
                    <a:gd name="connsiteX84" fmla="*/ 2623475 w 3160170"/>
                    <a:gd name="connsiteY84" fmla="*/ 682662 h 922177"/>
                    <a:gd name="connsiteX85" fmla="*/ 2538310 w 3160170"/>
                    <a:gd name="connsiteY85" fmla="*/ 697416 h 922177"/>
                    <a:gd name="connsiteX86" fmla="*/ 2483775 w 3160170"/>
                    <a:gd name="connsiteY86" fmla="*/ 704887 h 922177"/>
                    <a:gd name="connsiteX87" fmla="*/ 2439325 w 3160170"/>
                    <a:gd name="connsiteY87" fmla="*/ 714412 h 922177"/>
                    <a:gd name="connsiteX88" fmla="*/ 2394875 w 3160170"/>
                    <a:gd name="connsiteY88" fmla="*/ 723937 h 922177"/>
                    <a:gd name="connsiteX89" fmla="*/ 2315500 w 3160170"/>
                    <a:gd name="connsiteY89" fmla="*/ 717587 h 922177"/>
                    <a:gd name="connsiteX90" fmla="*/ 2252000 w 3160170"/>
                    <a:gd name="connsiteY90" fmla="*/ 704887 h 922177"/>
                    <a:gd name="connsiteX91" fmla="*/ 2213900 w 3160170"/>
                    <a:gd name="connsiteY91" fmla="*/ 698537 h 922177"/>
                    <a:gd name="connsiteX92" fmla="*/ 2172625 w 3160170"/>
                    <a:gd name="connsiteY92" fmla="*/ 692187 h 922177"/>
                    <a:gd name="connsiteX93" fmla="*/ 2115475 w 3160170"/>
                    <a:gd name="connsiteY93" fmla="*/ 682662 h 922177"/>
                    <a:gd name="connsiteX94" fmla="*/ 2077375 w 3160170"/>
                    <a:gd name="connsiteY94" fmla="*/ 676312 h 922177"/>
                    <a:gd name="connsiteX95" fmla="*/ 2029750 w 3160170"/>
                    <a:gd name="connsiteY95" fmla="*/ 666787 h 922177"/>
                    <a:gd name="connsiteX96" fmla="*/ 1915450 w 3160170"/>
                    <a:gd name="connsiteY96" fmla="*/ 660437 h 922177"/>
                    <a:gd name="connsiteX97" fmla="*/ 1855125 w 3160170"/>
                    <a:gd name="connsiteY97" fmla="*/ 663612 h 922177"/>
                    <a:gd name="connsiteX98" fmla="*/ 1769400 w 3160170"/>
                    <a:gd name="connsiteY98" fmla="*/ 666787 h 922177"/>
                    <a:gd name="connsiteX99" fmla="*/ 1731300 w 3160170"/>
                    <a:gd name="connsiteY99" fmla="*/ 673137 h 922177"/>
                    <a:gd name="connsiteX100" fmla="*/ 1686850 w 3160170"/>
                    <a:gd name="connsiteY100" fmla="*/ 695362 h 922177"/>
                    <a:gd name="connsiteX101" fmla="*/ 1629700 w 3160170"/>
                    <a:gd name="connsiteY101" fmla="*/ 717587 h 922177"/>
                    <a:gd name="connsiteX102" fmla="*/ 1585250 w 3160170"/>
                    <a:gd name="connsiteY102" fmla="*/ 739812 h 922177"/>
                    <a:gd name="connsiteX103" fmla="*/ 1528100 w 3160170"/>
                    <a:gd name="connsiteY103" fmla="*/ 755687 h 922177"/>
                    <a:gd name="connsiteX104" fmla="*/ 1496350 w 3160170"/>
                    <a:gd name="connsiteY104" fmla="*/ 774737 h 922177"/>
                    <a:gd name="connsiteX105" fmla="*/ 1470950 w 3160170"/>
                    <a:gd name="connsiteY105" fmla="*/ 781087 h 922177"/>
                    <a:gd name="connsiteX106" fmla="*/ 1426500 w 3160170"/>
                    <a:gd name="connsiteY106" fmla="*/ 800137 h 922177"/>
                    <a:gd name="connsiteX107" fmla="*/ 1353475 w 3160170"/>
                    <a:gd name="connsiteY107" fmla="*/ 777912 h 922177"/>
                    <a:gd name="connsiteX108" fmla="*/ 1242350 w 3160170"/>
                    <a:gd name="connsiteY108" fmla="*/ 752512 h 922177"/>
                    <a:gd name="connsiteX109" fmla="*/ 1169325 w 3160170"/>
                    <a:gd name="connsiteY109" fmla="*/ 736637 h 922177"/>
                    <a:gd name="connsiteX110" fmla="*/ 1029625 w 3160170"/>
                    <a:gd name="connsiteY110" fmla="*/ 704887 h 922177"/>
                    <a:gd name="connsiteX111" fmla="*/ 959775 w 3160170"/>
                    <a:gd name="connsiteY111" fmla="*/ 701712 h 922177"/>
                    <a:gd name="connsiteX112" fmla="*/ 867700 w 3160170"/>
                    <a:gd name="connsiteY112" fmla="*/ 698537 h 922177"/>
                    <a:gd name="connsiteX113" fmla="*/ 813725 w 3160170"/>
                    <a:gd name="connsiteY113" fmla="*/ 701712 h 922177"/>
                    <a:gd name="connsiteX114" fmla="*/ 775625 w 3160170"/>
                    <a:gd name="connsiteY114" fmla="*/ 714412 h 922177"/>
                    <a:gd name="connsiteX115" fmla="*/ 712125 w 3160170"/>
                    <a:gd name="connsiteY115" fmla="*/ 727112 h 922177"/>
                    <a:gd name="connsiteX116" fmla="*/ 677200 w 3160170"/>
                    <a:gd name="connsiteY116" fmla="*/ 739812 h 922177"/>
                    <a:gd name="connsiteX117" fmla="*/ 538060 w 3160170"/>
                    <a:gd name="connsiteY117" fmla="*/ 749150 h 922177"/>
                    <a:gd name="connsiteX118" fmla="*/ 427869 w 3160170"/>
                    <a:gd name="connsiteY118" fmla="*/ 731968 h 922177"/>
                    <a:gd name="connsiteX119" fmla="*/ 366050 w 3160170"/>
                    <a:gd name="connsiteY119" fmla="*/ 723937 h 922177"/>
                    <a:gd name="connsiteX120" fmla="*/ 319172 w 3160170"/>
                    <a:gd name="connsiteY120" fmla="*/ 728979 h 922177"/>
                    <a:gd name="connsiteX121" fmla="*/ 232700 w 3160170"/>
                    <a:gd name="connsiteY121" fmla="*/ 717587 h 922177"/>
                    <a:gd name="connsiteX122" fmla="*/ 213650 w 3160170"/>
                    <a:gd name="connsiteY122" fmla="*/ 717587 h 922177"/>
                    <a:gd name="connsiteX123" fmla="*/ 146975 w 3160170"/>
                    <a:gd name="connsiteY123" fmla="*/ 717587 h 922177"/>
                    <a:gd name="connsiteX124" fmla="*/ 131100 w 3160170"/>
                    <a:gd name="connsiteY124" fmla="*/ 720762 h 922177"/>
                    <a:gd name="connsiteX125" fmla="*/ 99350 w 3160170"/>
                    <a:gd name="connsiteY125" fmla="*/ 733462 h 922177"/>
                    <a:gd name="connsiteX126" fmla="*/ 70775 w 3160170"/>
                    <a:gd name="connsiteY126" fmla="*/ 742987 h 922177"/>
                    <a:gd name="connsiteX127" fmla="*/ 17214 w 3160170"/>
                    <a:gd name="connsiteY127" fmla="*/ 752650 h 922177"/>
                    <a:gd name="connsiteX128" fmla="*/ 787 w 3160170"/>
                    <a:gd name="connsiteY128" fmla="*/ 787023 h 922177"/>
                    <a:gd name="connsiteX129" fmla="*/ 37782 w 3160170"/>
                    <a:gd name="connsiteY129" fmla="*/ 843206 h 922177"/>
                    <a:gd name="connsiteX130" fmla="*/ 80438 w 3160170"/>
                    <a:gd name="connsiteY130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86813 w 3160170"/>
                    <a:gd name="connsiteY44" fmla="*/ 152998 h 922177"/>
                    <a:gd name="connsiteX45" fmla="*/ 2829850 w 3160170"/>
                    <a:gd name="connsiteY45" fmla="*/ 114337 h 922177"/>
                    <a:gd name="connsiteX46" fmla="*/ 2791750 w 3160170"/>
                    <a:gd name="connsiteY46" fmla="*/ 66712 h 922177"/>
                    <a:gd name="connsiteX47" fmla="*/ 2736281 w 3160170"/>
                    <a:gd name="connsiteY47" fmla="*/ 38137 h 922177"/>
                    <a:gd name="connsiteX48" fmla="*/ 2664750 w 3160170"/>
                    <a:gd name="connsiteY48" fmla="*/ 15912 h 922177"/>
                    <a:gd name="connsiteX49" fmla="*/ 2600316 w 3160170"/>
                    <a:gd name="connsiteY49" fmla="*/ 2839 h 922177"/>
                    <a:gd name="connsiteX50" fmla="*/ 2546308 w 3160170"/>
                    <a:gd name="connsiteY50" fmla="*/ 1003 h 922177"/>
                    <a:gd name="connsiteX51" fmla="*/ 2518148 w 3160170"/>
                    <a:gd name="connsiteY51" fmla="*/ 15359 h 922177"/>
                    <a:gd name="connsiteX52" fmla="*/ 2480600 w 3160170"/>
                    <a:gd name="connsiteY52" fmla="*/ 50837 h 922177"/>
                    <a:gd name="connsiteX53" fmla="*/ 2461550 w 3160170"/>
                    <a:gd name="connsiteY53" fmla="*/ 85762 h 922177"/>
                    <a:gd name="connsiteX54" fmla="*/ 2455200 w 3160170"/>
                    <a:gd name="connsiteY54" fmla="*/ 117512 h 922177"/>
                    <a:gd name="connsiteX55" fmla="*/ 2463068 w 3160170"/>
                    <a:gd name="connsiteY55" fmla="*/ 141118 h 922177"/>
                    <a:gd name="connsiteX56" fmla="*/ 2486122 w 3160170"/>
                    <a:gd name="connsiteY56" fmla="*/ 155336 h 922177"/>
                    <a:gd name="connsiteX57" fmla="*/ 2515525 w 3160170"/>
                    <a:gd name="connsiteY57" fmla="*/ 165137 h 922177"/>
                    <a:gd name="connsiteX58" fmla="*/ 2531400 w 3160170"/>
                    <a:gd name="connsiteY58" fmla="*/ 165137 h 922177"/>
                    <a:gd name="connsiteX59" fmla="*/ 2559975 w 3160170"/>
                    <a:gd name="connsiteY59" fmla="*/ 165551 h 922177"/>
                    <a:gd name="connsiteX60" fmla="*/ 2569500 w 3160170"/>
                    <a:gd name="connsiteY60" fmla="*/ 168312 h 922177"/>
                    <a:gd name="connsiteX61" fmla="*/ 2601250 w 3160170"/>
                    <a:gd name="connsiteY61" fmla="*/ 171487 h 922177"/>
                    <a:gd name="connsiteX62" fmla="*/ 2664750 w 3160170"/>
                    <a:gd name="connsiteY62" fmla="*/ 174662 h 922177"/>
                    <a:gd name="connsiteX63" fmla="*/ 2721900 w 3160170"/>
                    <a:gd name="connsiteY63" fmla="*/ 215937 h 922177"/>
                    <a:gd name="connsiteX64" fmla="*/ 2763175 w 3160170"/>
                    <a:gd name="connsiteY64" fmla="*/ 285787 h 922177"/>
                    <a:gd name="connsiteX65" fmla="*/ 2779050 w 3160170"/>
                    <a:gd name="connsiteY65" fmla="*/ 320712 h 922177"/>
                    <a:gd name="connsiteX66" fmla="*/ 2791750 w 3160170"/>
                    <a:gd name="connsiteY66" fmla="*/ 361987 h 922177"/>
                    <a:gd name="connsiteX67" fmla="*/ 2804450 w 3160170"/>
                    <a:gd name="connsiteY67" fmla="*/ 400087 h 922177"/>
                    <a:gd name="connsiteX68" fmla="*/ 2807625 w 3160170"/>
                    <a:gd name="connsiteY68" fmla="*/ 419137 h 922177"/>
                    <a:gd name="connsiteX69" fmla="*/ 2807625 w 3160170"/>
                    <a:gd name="connsiteY69" fmla="*/ 441362 h 922177"/>
                    <a:gd name="connsiteX70" fmla="*/ 2810800 w 3160170"/>
                    <a:gd name="connsiteY70" fmla="*/ 476287 h 922177"/>
                    <a:gd name="connsiteX71" fmla="*/ 2813975 w 3160170"/>
                    <a:gd name="connsiteY71" fmla="*/ 504862 h 922177"/>
                    <a:gd name="connsiteX72" fmla="*/ 2817150 w 3160170"/>
                    <a:gd name="connsiteY72" fmla="*/ 530262 h 922177"/>
                    <a:gd name="connsiteX73" fmla="*/ 2817150 w 3160170"/>
                    <a:gd name="connsiteY73" fmla="*/ 558837 h 922177"/>
                    <a:gd name="connsiteX74" fmla="*/ 2813975 w 3160170"/>
                    <a:gd name="connsiteY74" fmla="*/ 571537 h 922177"/>
                    <a:gd name="connsiteX75" fmla="*/ 2807625 w 3160170"/>
                    <a:gd name="connsiteY75" fmla="*/ 584237 h 922177"/>
                    <a:gd name="connsiteX76" fmla="*/ 2798100 w 3160170"/>
                    <a:gd name="connsiteY76" fmla="*/ 603287 h 922177"/>
                    <a:gd name="connsiteX77" fmla="*/ 2794925 w 3160170"/>
                    <a:gd name="connsiteY77" fmla="*/ 619162 h 922177"/>
                    <a:gd name="connsiteX78" fmla="*/ 2794925 w 3160170"/>
                    <a:gd name="connsiteY78" fmla="*/ 635037 h 922177"/>
                    <a:gd name="connsiteX79" fmla="*/ 2798100 w 3160170"/>
                    <a:gd name="connsiteY79" fmla="*/ 647737 h 922177"/>
                    <a:gd name="connsiteX80" fmla="*/ 2798100 w 3160170"/>
                    <a:gd name="connsiteY80" fmla="*/ 647737 h 922177"/>
                    <a:gd name="connsiteX81" fmla="*/ 2747300 w 3160170"/>
                    <a:gd name="connsiteY81" fmla="*/ 666787 h 922177"/>
                    <a:gd name="connsiteX82" fmla="*/ 2696500 w 3160170"/>
                    <a:gd name="connsiteY82" fmla="*/ 676312 h 922177"/>
                    <a:gd name="connsiteX83" fmla="*/ 2648875 w 3160170"/>
                    <a:gd name="connsiteY83" fmla="*/ 682662 h 922177"/>
                    <a:gd name="connsiteX84" fmla="*/ 2623475 w 3160170"/>
                    <a:gd name="connsiteY84" fmla="*/ 682662 h 922177"/>
                    <a:gd name="connsiteX85" fmla="*/ 2538310 w 3160170"/>
                    <a:gd name="connsiteY85" fmla="*/ 697416 h 922177"/>
                    <a:gd name="connsiteX86" fmla="*/ 2483775 w 3160170"/>
                    <a:gd name="connsiteY86" fmla="*/ 704887 h 922177"/>
                    <a:gd name="connsiteX87" fmla="*/ 2439325 w 3160170"/>
                    <a:gd name="connsiteY87" fmla="*/ 714412 h 922177"/>
                    <a:gd name="connsiteX88" fmla="*/ 2394875 w 3160170"/>
                    <a:gd name="connsiteY88" fmla="*/ 723937 h 922177"/>
                    <a:gd name="connsiteX89" fmla="*/ 2315500 w 3160170"/>
                    <a:gd name="connsiteY89" fmla="*/ 717587 h 922177"/>
                    <a:gd name="connsiteX90" fmla="*/ 2252000 w 3160170"/>
                    <a:gd name="connsiteY90" fmla="*/ 704887 h 922177"/>
                    <a:gd name="connsiteX91" fmla="*/ 2213900 w 3160170"/>
                    <a:gd name="connsiteY91" fmla="*/ 698537 h 922177"/>
                    <a:gd name="connsiteX92" fmla="*/ 2172625 w 3160170"/>
                    <a:gd name="connsiteY92" fmla="*/ 692187 h 922177"/>
                    <a:gd name="connsiteX93" fmla="*/ 2115475 w 3160170"/>
                    <a:gd name="connsiteY93" fmla="*/ 682662 h 922177"/>
                    <a:gd name="connsiteX94" fmla="*/ 2077375 w 3160170"/>
                    <a:gd name="connsiteY94" fmla="*/ 676312 h 922177"/>
                    <a:gd name="connsiteX95" fmla="*/ 2029750 w 3160170"/>
                    <a:gd name="connsiteY95" fmla="*/ 666787 h 922177"/>
                    <a:gd name="connsiteX96" fmla="*/ 1915450 w 3160170"/>
                    <a:gd name="connsiteY96" fmla="*/ 660437 h 922177"/>
                    <a:gd name="connsiteX97" fmla="*/ 1855125 w 3160170"/>
                    <a:gd name="connsiteY97" fmla="*/ 663612 h 922177"/>
                    <a:gd name="connsiteX98" fmla="*/ 1769400 w 3160170"/>
                    <a:gd name="connsiteY98" fmla="*/ 666787 h 922177"/>
                    <a:gd name="connsiteX99" fmla="*/ 1731300 w 3160170"/>
                    <a:gd name="connsiteY99" fmla="*/ 673137 h 922177"/>
                    <a:gd name="connsiteX100" fmla="*/ 1686850 w 3160170"/>
                    <a:gd name="connsiteY100" fmla="*/ 695362 h 922177"/>
                    <a:gd name="connsiteX101" fmla="*/ 1629700 w 3160170"/>
                    <a:gd name="connsiteY101" fmla="*/ 717587 h 922177"/>
                    <a:gd name="connsiteX102" fmla="*/ 1585250 w 3160170"/>
                    <a:gd name="connsiteY102" fmla="*/ 739812 h 922177"/>
                    <a:gd name="connsiteX103" fmla="*/ 1528100 w 3160170"/>
                    <a:gd name="connsiteY103" fmla="*/ 755687 h 922177"/>
                    <a:gd name="connsiteX104" fmla="*/ 1496350 w 3160170"/>
                    <a:gd name="connsiteY104" fmla="*/ 774737 h 922177"/>
                    <a:gd name="connsiteX105" fmla="*/ 1470950 w 3160170"/>
                    <a:gd name="connsiteY105" fmla="*/ 781087 h 922177"/>
                    <a:gd name="connsiteX106" fmla="*/ 1426500 w 3160170"/>
                    <a:gd name="connsiteY106" fmla="*/ 800137 h 922177"/>
                    <a:gd name="connsiteX107" fmla="*/ 1353475 w 3160170"/>
                    <a:gd name="connsiteY107" fmla="*/ 777912 h 922177"/>
                    <a:gd name="connsiteX108" fmla="*/ 1242350 w 3160170"/>
                    <a:gd name="connsiteY108" fmla="*/ 752512 h 922177"/>
                    <a:gd name="connsiteX109" fmla="*/ 1169325 w 3160170"/>
                    <a:gd name="connsiteY109" fmla="*/ 736637 h 922177"/>
                    <a:gd name="connsiteX110" fmla="*/ 1029625 w 3160170"/>
                    <a:gd name="connsiteY110" fmla="*/ 704887 h 922177"/>
                    <a:gd name="connsiteX111" fmla="*/ 959775 w 3160170"/>
                    <a:gd name="connsiteY111" fmla="*/ 701712 h 922177"/>
                    <a:gd name="connsiteX112" fmla="*/ 867700 w 3160170"/>
                    <a:gd name="connsiteY112" fmla="*/ 698537 h 922177"/>
                    <a:gd name="connsiteX113" fmla="*/ 813725 w 3160170"/>
                    <a:gd name="connsiteY113" fmla="*/ 701712 h 922177"/>
                    <a:gd name="connsiteX114" fmla="*/ 775625 w 3160170"/>
                    <a:gd name="connsiteY114" fmla="*/ 714412 h 922177"/>
                    <a:gd name="connsiteX115" fmla="*/ 712125 w 3160170"/>
                    <a:gd name="connsiteY115" fmla="*/ 727112 h 922177"/>
                    <a:gd name="connsiteX116" fmla="*/ 677200 w 3160170"/>
                    <a:gd name="connsiteY116" fmla="*/ 739812 h 922177"/>
                    <a:gd name="connsiteX117" fmla="*/ 538060 w 3160170"/>
                    <a:gd name="connsiteY117" fmla="*/ 749150 h 922177"/>
                    <a:gd name="connsiteX118" fmla="*/ 427869 w 3160170"/>
                    <a:gd name="connsiteY118" fmla="*/ 731968 h 922177"/>
                    <a:gd name="connsiteX119" fmla="*/ 366050 w 3160170"/>
                    <a:gd name="connsiteY119" fmla="*/ 723937 h 922177"/>
                    <a:gd name="connsiteX120" fmla="*/ 319172 w 3160170"/>
                    <a:gd name="connsiteY120" fmla="*/ 728979 h 922177"/>
                    <a:gd name="connsiteX121" fmla="*/ 232700 w 3160170"/>
                    <a:gd name="connsiteY121" fmla="*/ 717587 h 922177"/>
                    <a:gd name="connsiteX122" fmla="*/ 213650 w 3160170"/>
                    <a:gd name="connsiteY122" fmla="*/ 717587 h 922177"/>
                    <a:gd name="connsiteX123" fmla="*/ 146975 w 3160170"/>
                    <a:gd name="connsiteY123" fmla="*/ 717587 h 922177"/>
                    <a:gd name="connsiteX124" fmla="*/ 131100 w 3160170"/>
                    <a:gd name="connsiteY124" fmla="*/ 720762 h 922177"/>
                    <a:gd name="connsiteX125" fmla="*/ 99350 w 3160170"/>
                    <a:gd name="connsiteY125" fmla="*/ 733462 h 922177"/>
                    <a:gd name="connsiteX126" fmla="*/ 70775 w 3160170"/>
                    <a:gd name="connsiteY126" fmla="*/ 742987 h 922177"/>
                    <a:gd name="connsiteX127" fmla="*/ 17214 w 3160170"/>
                    <a:gd name="connsiteY127" fmla="*/ 752650 h 922177"/>
                    <a:gd name="connsiteX128" fmla="*/ 787 w 3160170"/>
                    <a:gd name="connsiteY128" fmla="*/ 787023 h 922177"/>
                    <a:gd name="connsiteX129" fmla="*/ 37782 w 3160170"/>
                    <a:gd name="connsiteY129" fmla="*/ 843206 h 922177"/>
                    <a:gd name="connsiteX130" fmla="*/ 80438 w 3160170"/>
                    <a:gd name="connsiteY130" fmla="*/ 865431 h 922177"/>
                    <a:gd name="connsiteX0" fmla="*/ 73950 w 3160170"/>
                    <a:gd name="connsiteY0" fmla="*/ 866812 h 922177"/>
                    <a:gd name="connsiteX1" fmla="*/ 204125 w 3160170"/>
                    <a:gd name="connsiteY1" fmla="*/ 844587 h 922177"/>
                    <a:gd name="connsiteX2" fmla="*/ 327950 w 3160170"/>
                    <a:gd name="connsiteY2" fmla="*/ 835062 h 922177"/>
                    <a:gd name="connsiteX3" fmla="*/ 448600 w 3160170"/>
                    <a:gd name="connsiteY3" fmla="*/ 876337 h 922177"/>
                    <a:gd name="connsiteX4" fmla="*/ 521625 w 3160170"/>
                    <a:gd name="connsiteY4" fmla="*/ 879512 h 922177"/>
                    <a:gd name="connsiteX5" fmla="*/ 632750 w 3160170"/>
                    <a:gd name="connsiteY5" fmla="*/ 869987 h 922177"/>
                    <a:gd name="connsiteX6" fmla="*/ 712125 w 3160170"/>
                    <a:gd name="connsiteY6" fmla="*/ 847762 h 922177"/>
                    <a:gd name="connsiteX7" fmla="*/ 804200 w 3160170"/>
                    <a:gd name="connsiteY7" fmla="*/ 828712 h 922177"/>
                    <a:gd name="connsiteX8" fmla="*/ 959775 w 3160170"/>
                    <a:gd name="connsiteY8" fmla="*/ 822362 h 922177"/>
                    <a:gd name="connsiteX9" fmla="*/ 1156625 w 3160170"/>
                    <a:gd name="connsiteY9" fmla="*/ 847762 h 922177"/>
                    <a:gd name="connsiteX10" fmla="*/ 1343950 w 3160170"/>
                    <a:gd name="connsiteY10" fmla="*/ 914437 h 922177"/>
                    <a:gd name="connsiteX11" fmla="*/ 1477300 w 3160170"/>
                    <a:gd name="connsiteY11" fmla="*/ 917612 h 922177"/>
                    <a:gd name="connsiteX12" fmla="*/ 1636050 w 3160170"/>
                    <a:gd name="connsiteY12" fmla="*/ 885862 h 922177"/>
                    <a:gd name="connsiteX13" fmla="*/ 1728125 w 3160170"/>
                    <a:gd name="connsiteY13" fmla="*/ 854112 h 922177"/>
                    <a:gd name="connsiteX14" fmla="*/ 1772575 w 3160170"/>
                    <a:gd name="connsiteY14" fmla="*/ 828712 h 922177"/>
                    <a:gd name="connsiteX15" fmla="*/ 1836075 w 3160170"/>
                    <a:gd name="connsiteY15" fmla="*/ 803312 h 922177"/>
                    <a:gd name="connsiteX16" fmla="*/ 1890050 w 3160170"/>
                    <a:gd name="connsiteY16" fmla="*/ 806487 h 922177"/>
                    <a:gd name="connsiteX17" fmla="*/ 2039275 w 3160170"/>
                    <a:gd name="connsiteY17" fmla="*/ 828712 h 922177"/>
                    <a:gd name="connsiteX18" fmla="*/ 2140875 w 3160170"/>
                    <a:gd name="connsiteY18" fmla="*/ 831887 h 922177"/>
                    <a:gd name="connsiteX19" fmla="*/ 2245650 w 3160170"/>
                    <a:gd name="connsiteY19" fmla="*/ 850937 h 922177"/>
                    <a:gd name="connsiteX20" fmla="*/ 2350425 w 3160170"/>
                    <a:gd name="connsiteY20" fmla="*/ 882687 h 922177"/>
                    <a:gd name="connsiteX21" fmla="*/ 2480600 w 3160170"/>
                    <a:gd name="connsiteY21" fmla="*/ 869987 h 922177"/>
                    <a:gd name="connsiteX22" fmla="*/ 2575850 w 3160170"/>
                    <a:gd name="connsiteY22" fmla="*/ 847762 h 922177"/>
                    <a:gd name="connsiteX23" fmla="*/ 2632440 w 3160170"/>
                    <a:gd name="connsiteY23" fmla="*/ 841225 h 922177"/>
                    <a:gd name="connsiteX24" fmla="*/ 2693325 w 3160170"/>
                    <a:gd name="connsiteY24" fmla="*/ 828712 h 922177"/>
                    <a:gd name="connsiteX25" fmla="*/ 2750475 w 3160170"/>
                    <a:gd name="connsiteY25" fmla="*/ 816012 h 922177"/>
                    <a:gd name="connsiteX26" fmla="*/ 2798100 w 3160170"/>
                    <a:gd name="connsiteY26" fmla="*/ 796962 h 922177"/>
                    <a:gd name="connsiteX27" fmla="*/ 2820325 w 3160170"/>
                    <a:gd name="connsiteY27" fmla="*/ 781087 h 922177"/>
                    <a:gd name="connsiteX28" fmla="*/ 2855250 w 3160170"/>
                    <a:gd name="connsiteY28" fmla="*/ 796962 h 922177"/>
                    <a:gd name="connsiteX29" fmla="*/ 2893350 w 3160170"/>
                    <a:gd name="connsiteY29" fmla="*/ 831887 h 922177"/>
                    <a:gd name="connsiteX30" fmla="*/ 2972725 w 3160170"/>
                    <a:gd name="connsiteY30" fmla="*/ 857287 h 922177"/>
                    <a:gd name="connsiteX31" fmla="*/ 3048925 w 3160170"/>
                    <a:gd name="connsiteY31" fmla="*/ 850937 h 922177"/>
                    <a:gd name="connsiteX32" fmla="*/ 3109250 w 3160170"/>
                    <a:gd name="connsiteY32" fmla="*/ 809662 h 922177"/>
                    <a:gd name="connsiteX33" fmla="*/ 3125125 w 3160170"/>
                    <a:gd name="connsiteY33" fmla="*/ 771562 h 922177"/>
                    <a:gd name="connsiteX34" fmla="*/ 3153700 w 3160170"/>
                    <a:gd name="connsiteY34" fmla="*/ 704887 h 922177"/>
                    <a:gd name="connsiteX35" fmla="*/ 3160050 w 3160170"/>
                    <a:gd name="connsiteY35" fmla="*/ 638212 h 922177"/>
                    <a:gd name="connsiteX36" fmla="*/ 3150525 w 3160170"/>
                    <a:gd name="connsiteY36" fmla="*/ 593762 h 922177"/>
                    <a:gd name="connsiteX37" fmla="*/ 3125125 w 3160170"/>
                    <a:gd name="connsiteY37" fmla="*/ 549312 h 922177"/>
                    <a:gd name="connsiteX38" fmla="*/ 3112425 w 3160170"/>
                    <a:gd name="connsiteY38" fmla="*/ 495337 h 922177"/>
                    <a:gd name="connsiteX39" fmla="*/ 3102900 w 3160170"/>
                    <a:gd name="connsiteY39" fmla="*/ 435012 h 922177"/>
                    <a:gd name="connsiteX40" fmla="*/ 3079928 w 3160170"/>
                    <a:gd name="connsiteY40" fmla="*/ 370765 h 922177"/>
                    <a:gd name="connsiteX41" fmla="*/ 3022965 w 3160170"/>
                    <a:gd name="connsiteY41" fmla="*/ 290643 h 922177"/>
                    <a:gd name="connsiteX42" fmla="*/ 2967910 w 3160170"/>
                    <a:gd name="connsiteY42" fmla="*/ 249985 h 922177"/>
                    <a:gd name="connsiteX43" fmla="*/ 2936557 w 3160170"/>
                    <a:gd name="connsiteY43" fmla="*/ 221735 h 922177"/>
                    <a:gd name="connsiteX44" fmla="*/ 2886813 w 3160170"/>
                    <a:gd name="connsiteY44" fmla="*/ 152998 h 922177"/>
                    <a:gd name="connsiteX45" fmla="*/ 2829850 w 3160170"/>
                    <a:gd name="connsiteY45" fmla="*/ 114337 h 922177"/>
                    <a:gd name="connsiteX46" fmla="*/ 2791750 w 3160170"/>
                    <a:gd name="connsiteY46" fmla="*/ 66712 h 922177"/>
                    <a:gd name="connsiteX47" fmla="*/ 2736281 w 3160170"/>
                    <a:gd name="connsiteY47" fmla="*/ 38137 h 922177"/>
                    <a:gd name="connsiteX48" fmla="*/ 2664750 w 3160170"/>
                    <a:gd name="connsiteY48" fmla="*/ 15912 h 922177"/>
                    <a:gd name="connsiteX49" fmla="*/ 2600316 w 3160170"/>
                    <a:gd name="connsiteY49" fmla="*/ 2839 h 922177"/>
                    <a:gd name="connsiteX50" fmla="*/ 2546308 w 3160170"/>
                    <a:gd name="connsiteY50" fmla="*/ 1003 h 922177"/>
                    <a:gd name="connsiteX51" fmla="*/ 2518148 w 3160170"/>
                    <a:gd name="connsiteY51" fmla="*/ 15359 h 922177"/>
                    <a:gd name="connsiteX52" fmla="*/ 2480600 w 3160170"/>
                    <a:gd name="connsiteY52" fmla="*/ 50837 h 922177"/>
                    <a:gd name="connsiteX53" fmla="*/ 2461550 w 3160170"/>
                    <a:gd name="connsiteY53" fmla="*/ 85762 h 922177"/>
                    <a:gd name="connsiteX54" fmla="*/ 2455200 w 3160170"/>
                    <a:gd name="connsiteY54" fmla="*/ 117512 h 922177"/>
                    <a:gd name="connsiteX55" fmla="*/ 2463068 w 3160170"/>
                    <a:gd name="connsiteY55" fmla="*/ 141118 h 922177"/>
                    <a:gd name="connsiteX56" fmla="*/ 2486122 w 3160170"/>
                    <a:gd name="connsiteY56" fmla="*/ 155336 h 922177"/>
                    <a:gd name="connsiteX57" fmla="*/ 2515525 w 3160170"/>
                    <a:gd name="connsiteY57" fmla="*/ 165137 h 922177"/>
                    <a:gd name="connsiteX58" fmla="*/ 2531400 w 3160170"/>
                    <a:gd name="connsiteY58" fmla="*/ 165137 h 922177"/>
                    <a:gd name="connsiteX59" fmla="*/ 2559975 w 3160170"/>
                    <a:gd name="connsiteY59" fmla="*/ 165551 h 922177"/>
                    <a:gd name="connsiteX60" fmla="*/ 2569500 w 3160170"/>
                    <a:gd name="connsiteY60" fmla="*/ 168312 h 922177"/>
                    <a:gd name="connsiteX61" fmla="*/ 2601250 w 3160170"/>
                    <a:gd name="connsiteY61" fmla="*/ 171487 h 922177"/>
                    <a:gd name="connsiteX62" fmla="*/ 2664750 w 3160170"/>
                    <a:gd name="connsiteY62" fmla="*/ 174662 h 922177"/>
                    <a:gd name="connsiteX63" fmla="*/ 2721900 w 3160170"/>
                    <a:gd name="connsiteY63" fmla="*/ 215937 h 922177"/>
                    <a:gd name="connsiteX64" fmla="*/ 2763175 w 3160170"/>
                    <a:gd name="connsiteY64" fmla="*/ 285787 h 922177"/>
                    <a:gd name="connsiteX65" fmla="*/ 2779050 w 3160170"/>
                    <a:gd name="connsiteY65" fmla="*/ 320712 h 922177"/>
                    <a:gd name="connsiteX66" fmla="*/ 2791750 w 3160170"/>
                    <a:gd name="connsiteY66" fmla="*/ 361987 h 922177"/>
                    <a:gd name="connsiteX67" fmla="*/ 2804450 w 3160170"/>
                    <a:gd name="connsiteY67" fmla="*/ 400087 h 922177"/>
                    <a:gd name="connsiteX68" fmla="*/ 2807625 w 3160170"/>
                    <a:gd name="connsiteY68" fmla="*/ 419137 h 922177"/>
                    <a:gd name="connsiteX69" fmla="*/ 2807625 w 3160170"/>
                    <a:gd name="connsiteY69" fmla="*/ 441362 h 922177"/>
                    <a:gd name="connsiteX70" fmla="*/ 2810800 w 3160170"/>
                    <a:gd name="connsiteY70" fmla="*/ 476287 h 922177"/>
                    <a:gd name="connsiteX71" fmla="*/ 2813975 w 3160170"/>
                    <a:gd name="connsiteY71" fmla="*/ 504862 h 922177"/>
                    <a:gd name="connsiteX72" fmla="*/ 2817150 w 3160170"/>
                    <a:gd name="connsiteY72" fmla="*/ 530262 h 922177"/>
                    <a:gd name="connsiteX73" fmla="*/ 2817150 w 3160170"/>
                    <a:gd name="connsiteY73" fmla="*/ 558837 h 922177"/>
                    <a:gd name="connsiteX74" fmla="*/ 2813975 w 3160170"/>
                    <a:gd name="connsiteY74" fmla="*/ 571537 h 922177"/>
                    <a:gd name="connsiteX75" fmla="*/ 2807625 w 3160170"/>
                    <a:gd name="connsiteY75" fmla="*/ 584237 h 922177"/>
                    <a:gd name="connsiteX76" fmla="*/ 2798100 w 3160170"/>
                    <a:gd name="connsiteY76" fmla="*/ 603287 h 922177"/>
                    <a:gd name="connsiteX77" fmla="*/ 2794925 w 3160170"/>
                    <a:gd name="connsiteY77" fmla="*/ 619162 h 922177"/>
                    <a:gd name="connsiteX78" fmla="*/ 2794925 w 3160170"/>
                    <a:gd name="connsiteY78" fmla="*/ 635037 h 922177"/>
                    <a:gd name="connsiteX79" fmla="*/ 2798100 w 3160170"/>
                    <a:gd name="connsiteY79" fmla="*/ 647737 h 922177"/>
                    <a:gd name="connsiteX80" fmla="*/ 2798100 w 3160170"/>
                    <a:gd name="connsiteY80" fmla="*/ 647737 h 922177"/>
                    <a:gd name="connsiteX81" fmla="*/ 2747300 w 3160170"/>
                    <a:gd name="connsiteY81" fmla="*/ 666787 h 922177"/>
                    <a:gd name="connsiteX82" fmla="*/ 2696500 w 3160170"/>
                    <a:gd name="connsiteY82" fmla="*/ 676312 h 922177"/>
                    <a:gd name="connsiteX83" fmla="*/ 2648875 w 3160170"/>
                    <a:gd name="connsiteY83" fmla="*/ 682662 h 922177"/>
                    <a:gd name="connsiteX84" fmla="*/ 2623475 w 3160170"/>
                    <a:gd name="connsiteY84" fmla="*/ 682662 h 922177"/>
                    <a:gd name="connsiteX85" fmla="*/ 2538310 w 3160170"/>
                    <a:gd name="connsiteY85" fmla="*/ 697416 h 922177"/>
                    <a:gd name="connsiteX86" fmla="*/ 2483775 w 3160170"/>
                    <a:gd name="connsiteY86" fmla="*/ 704887 h 922177"/>
                    <a:gd name="connsiteX87" fmla="*/ 2439325 w 3160170"/>
                    <a:gd name="connsiteY87" fmla="*/ 714412 h 922177"/>
                    <a:gd name="connsiteX88" fmla="*/ 2394875 w 3160170"/>
                    <a:gd name="connsiteY88" fmla="*/ 723937 h 922177"/>
                    <a:gd name="connsiteX89" fmla="*/ 2315500 w 3160170"/>
                    <a:gd name="connsiteY89" fmla="*/ 717587 h 922177"/>
                    <a:gd name="connsiteX90" fmla="*/ 2252000 w 3160170"/>
                    <a:gd name="connsiteY90" fmla="*/ 704887 h 922177"/>
                    <a:gd name="connsiteX91" fmla="*/ 2213900 w 3160170"/>
                    <a:gd name="connsiteY91" fmla="*/ 698537 h 922177"/>
                    <a:gd name="connsiteX92" fmla="*/ 2172625 w 3160170"/>
                    <a:gd name="connsiteY92" fmla="*/ 692187 h 922177"/>
                    <a:gd name="connsiteX93" fmla="*/ 2115475 w 3160170"/>
                    <a:gd name="connsiteY93" fmla="*/ 682662 h 922177"/>
                    <a:gd name="connsiteX94" fmla="*/ 2077375 w 3160170"/>
                    <a:gd name="connsiteY94" fmla="*/ 676312 h 922177"/>
                    <a:gd name="connsiteX95" fmla="*/ 2029750 w 3160170"/>
                    <a:gd name="connsiteY95" fmla="*/ 666787 h 922177"/>
                    <a:gd name="connsiteX96" fmla="*/ 1915450 w 3160170"/>
                    <a:gd name="connsiteY96" fmla="*/ 660437 h 922177"/>
                    <a:gd name="connsiteX97" fmla="*/ 1855125 w 3160170"/>
                    <a:gd name="connsiteY97" fmla="*/ 663612 h 922177"/>
                    <a:gd name="connsiteX98" fmla="*/ 1769400 w 3160170"/>
                    <a:gd name="connsiteY98" fmla="*/ 666787 h 922177"/>
                    <a:gd name="connsiteX99" fmla="*/ 1731300 w 3160170"/>
                    <a:gd name="connsiteY99" fmla="*/ 673137 h 922177"/>
                    <a:gd name="connsiteX100" fmla="*/ 1686850 w 3160170"/>
                    <a:gd name="connsiteY100" fmla="*/ 695362 h 922177"/>
                    <a:gd name="connsiteX101" fmla="*/ 1629700 w 3160170"/>
                    <a:gd name="connsiteY101" fmla="*/ 717587 h 922177"/>
                    <a:gd name="connsiteX102" fmla="*/ 1585250 w 3160170"/>
                    <a:gd name="connsiteY102" fmla="*/ 739812 h 922177"/>
                    <a:gd name="connsiteX103" fmla="*/ 1528100 w 3160170"/>
                    <a:gd name="connsiteY103" fmla="*/ 755687 h 922177"/>
                    <a:gd name="connsiteX104" fmla="*/ 1496350 w 3160170"/>
                    <a:gd name="connsiteY104" fmla="*/ 774737 h 922177"/>
                    <a:gd name="connsiteX105" fmla="*/ 1470950 w 3160170"/>
                    <a:gd name="connsiteY105" fmla="*/ 781087 h 922177"/>
                    <a:gd name="connsiteX106" fmla="*/ 1426500 w 3160170"/>
                    <a:gd name="connsiteY106" fmla="*/ 800137 h 922177"/>
                    <a:gd name="connsiteX107" fmla="*/ 1353475 w 3160170"/>
                    <a:gd name="connsiteY107" fmla="*/ 777912 h 922177"/>
                    <a:gd name="connsiteX108" fmla="*/ 1242350 w 3160170"/>
                    <a:gd name="connsiteY108" fmla="*/ 752512 h 922177"/>
                    <a:gd name="connsiteX109" fmla="*/ 1169325 w 3160170"/>
                    <a:gd name="connsiteY109" fmla="*/ 736637 h 922177"/>
                    <a:gd name="connsiteX110" fmla="*/ 1029625 w 3160170"/>
                    <a:gd name="connsiteY110" fmla="*/ 704887 h 922177"/>
                    <a:gd name="connsiteX111" fmla="*/ 959775 w 3160170"/>
                    <a:gd name="connsiteY111" fmla="*/ 701712 h 922177"/>
                    <a:gd name="connsiteX112" fmla="*/ 867700 w 3160170"/>
                    <a:gd name="connsiteY112" fmla="*/ 698537 h 922177"/>
                    <a:gd name="connsiteX113" fmla="*/ 813725 w 3160170"/>
                    <a:gd name="connsiteY113" fmla="*/ 701712 h 922177"/>
                    <a:gd name="connsiteX114" fmla="*/ 775625 w 3160170"/>
                    <a:gd name="connsiteY114" fmla="*/ 714412 h 922177"/>
                    <a:gd name="connsiteX115" fmla="*/ 712125 w 3160170"/>
                    <a:gd name="connsiteY115" fmla="*/ 727112 h 922177"/>
                    <a:gd name="connsiteX116" fmla="*/ 677200 w 3160170"/>
                    <a:gd name="connsiteY116" fmla="*/ 739812 h 922177"/>
                    <a:gd name="connsiteX117" fmla="*/ 538060 w 3160170"/>
                    <a:gd name="connsiteY117" fmla="*/ 749150 h 922177"/>
                    <a:gd name="connsiteX118" fmla="*/ 427869 w 3160170"/>
                    <a:gd name="connsiteY118" fmla="*/ 731968 h 922177"/>
                    <a:gd name="connsiteX119" fmla="*/ 366050 w 3160170"/>
                    <a:gd name="connsiteY119" fmla="*/ 723937 h 922177"/>
                    <a:gd name="connsiteX120" fmla="*/ 319172 w 3160170"/>
                    <a:gd name="connsiteY120" fmla="*/ 728979 h 922177"/>
                    <a:gd name="connsiteX121" fmla="*/ 232700 w 3160170"/>
                    <a:gd name="connsiteY121" fmla="*/ 717587 h 922177"/>
                    <a:gd name="connsiteX122" fmla="*/ 213650 w 3160170"/>
                    <a:gd name="connsiteY122" fmla="*/ 717587 h 922177"/>
                    <a:gd name="connsiteX123" fmla="*/ 146975 w 3160170"/>
                    <a:gd name="connsiteY123" fmla="*/ 717587 h 922177"/>
                    <a:gd name="connsiteX124" fmla="*/ 131100 w 3160170"/>
                    <a:gd name="connsiteY124" fmla="*/ 720762 h 922177"/>
                    <a:gd name="connsiteX125" fmla="*/ 99350 w 3160170"/>
                    <a:gd name="connsiteY125" fmla="*/ 733462 h 922177"/>
                    <a:gd name="connsiteX126" fmla="*/ 70775 w 3160170"/>
                    <a:gd name="connsiteY126" fmla="*/ 742987 h 922177"/>
                    <a:gd name="connsiteX127" fmla="*/ 17214 w 3160170"/>
                    <a:gd name="connsiteY127" fmla="*/ 752650 h 922177"/>
                    <a:gd name="connsiteX128" fmla="*/ 787 w 3160170"/>
                    <a:gd name="connsiteY128" fmla="*/ 787023 h 922177"/>
                    <a:gd name="connsiteX129" fmla="*/ 37782 w 3160170"/>
                    <a:gd name="connsiteY129" fmla="*/ 843206 h 922177"/>
                    <a:gd name="connsiteX130" fmla="*/ 80438 w 3160170"/>
                    <a:gd name="connsiteY130" fmla="*/ 865431 h 92217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</a:cxnLst>
                  <a:rect l="l" t="t" r="r" b="b"/>
                  <a:pathLst>
                    <a:path w="3160170" h="922177">
                      <a:moveTo>
                        <a:pt x="73950" y="866812"/>
                      </a:moveTo>
                      <a:cubicBezTo>
                        <a:pt x="116548" y="851730"/>
                        <a:pt x="161792" y="849879"/>
                        <a:pt x="204125" y="844587"/>
                      </a:cubicBezTo>
                      <a:cubicBezTo>
                        <a:pt x="246458" y="839295"/>
                        <a:pt x="287204" y="829770"/>
                        <a:pt x="327950" y="835062"/>
                      </a:cubicBezTo>
                      <a:cubicBezTo>
                        <a:pt x="368696" y="840354"/>
                        <a:pt x="416321" y="868929"/>
                        <a:pt x="448600" y="876337"/>
                      </a:cubicBezTo>
                      <a:cubicBezTo>
                        <a:pt x="480879" y="883745"/>
                        <a:pt x="490933" y="880570"/>
                        <a:pt x="521625" y="879512"/>
                      </a:cubicBezTo>
                      <a:cubicBezTo>
                        <a:pt x="552317" y="878454"/>
                        <a:pt x="601000" y="875279"/>
                        <a:pt x="632750" y="869987"/>
                      </a:cubicBezTo>
                      <a:cubicBezTo>
                        <a:pt x="664500" y="864695"/>
                        <a:pt x="683550" y="854641"/>
                        <a:pt x="712125" y="847762"/>
                      </a:cubicBezTo>
                      <a:cubicBezTo>
                        <a:pt x="740700" y="840883"/>
                        <a:pt x="762925" y="832945"/>
                        <a:pt x="804200" y="828712"/>
                      </a:cubicBezTo>
                      <a:cubicBezTo>
                        <a:pt x="845475" y="824479"/>
                        <a:pt x="901038" y="819187"/>
                        <a:pt x="959775" y="822362"/>
                      </a:cubicBezTo>
                      <a:cubicBezTo>
                        <a:pt x="1018513" y="825537"/>
                        <a:pt x="1092596" y="832416"/>
                        <a:pt x="1156625" y="847762"/>
                      </a:cubicBezTo>
                      <a:cubicBezTo>
                        <a:pt x="1220654" y="863108"/>
                        <a:pt x="1290504" y="902795"/>
                        <a:pt x="1343950" y="914437"/>
                      </a:cubicBezTo>
                      <a:cubicBezTo>
                        <a:pt x="1397396" y="926079"/>
                        <a:pt x="1428617" y="922375"/>
                        <a:pt x="1477300" y="917612"/>
                      </a:cubicBezTo>
                      <a:cubicBezTo>
                        <a:pt x="1525983" y="912850"/>
                        <a:pt x="1594246" y="896445"/>
                        <a:pt x="1636050" y="885862"/>
                      </a:cubicBezTo>
                      <a:cubicBezTo>
                        <a:pt x="1677854" y="875279"/>
                        <a:pt x="1705371" y="863637"/>
                        <a:pt x="1728125" y="854112"/>
                      </a:cubicBezTo>
                      <a:cubicBezTo>
                        <a:pt x="1750879" y="844587"/>
                        <a:pt x="1754583" y="837179"/>
                        <a:pt x="1772575" y="828712"/>
                      </a:cubicBezTo>
                      <a:cubicBezTo>
                        <a:pt x="1790567" y="820245"/>
                        <a:pt x="1816496" y="807016"/>
                        <a:pt x="1836075" y="803312"/>
                      </a:cubicBezTo>
                      <a:cubicBezTo>
                        <a:pt x="1855654" y="799608"/>
                        <a:pt x="1856183" y="802254"/>
                        <a:pt x="1890050" y="806487"/>
                      </a:cubicBezTo>
                      <a:cubicBezTo>
                        <a:pt x="1923917" y="810720"/>
                        <a:pt x="1997471" y="824479"/>
                        <a:pt x="2039275" y="828712"/>
                      </a:cubicBezTo>
                      <a:cubicBezTo>
                        <a:pt x="2081079" y="832945"/>
                        <a:pt x="2106479" y="828183"/>
                        <a:pt x="2140875" y="831887"/>
                      </a:cubicBezTo>
                      <a:cubicBezTo>
                        <a:pt x="2175271" y="835591"/>
                        <a:pt x="2210725" y="842470"/>
                        <a:pt x="2245650" y="850937"/>
                      </a:cubicBezTo>
                      <a:cubicBezTo>
                        <a:pt x="2280575" y="859404"/>
                        <a:pt x="2311267" y="879512"/>
                        <a:pt x="2350425" y="882687"/>
                      </a:cubicBezTo>
                      <a:cubicBezTo>
                        <a:pt x="2389583" y="885862"/>
                        <a:pt x="2443029" y="875808"/>
                        <a:pt x="2480600" y="869987"/>
                      </a:cubicBezTo>
                      <a:cubicBezTo>
                        <a:pt x="2518171" y="864166"/>
                        <a:pt x="2550543" y="852556"/>
                        <a:pt x="2575850" y="847762"/>
                      </a:cubicBezTo>
                      <a:cubicBezTo>
                        <a:pt x="2601157" y="842968"/>
                        <a:pt x="2612861" y="844400"/>
                        <a:pt x="2632440" y="841225"/>
                      </a:cubicBezTo>
                      <a:cubicBezTo>
                        <a:pt x="2652019" y="838050"/>
                        <a:pt x="2673653" y="832914"/>
                        <a:pt x="2693325" y="828712"/>
                      </a:cubicBezTo>
                      <a:cubicBezTo>
                        <a:pt x="2712998" y="824510"/>
                        <a:pt x="2733013" y="821304"/>
                        <a:pt x="2750475" y="816012"/>
                      </a:cubicBezTo>
                      <a:cubicBezTo>
                        <a:pt x="2767937" y="810720"/>
                        <a:pt x="2786458" y="802783"/>
                        <a:pt x="2798100" y="796962"/>
                      </a:cubicBezTo>
                      <a:cubicBezTo>
                        <a:pt x="2809742" y="791141"/>
                        <a:pt x="2810800" y="781087"/>
                        <a:pt x="2820325" y="781087"/>
                      </a:cubicBezTo>
                      <a:cubicBezTo>
                        <a:pt x="2829850" y="781087"/>
                        <a:pt x="2843079" y="788495"/>
                        <a:pt x="2855250" y="796962"/>
                      </a:cubicBezTo>
                      <a:cubicBezTo>
                        <a:pt x="2867421" y="805429"/>
                        <a:pt x="2873771" y="821833"/>
                        <a:pt x="2893350" y="831887"/>
                      </a:cubicBezTo>
                      <a:cubicBezTo>
                        <a:pt x="2912929" y="841941"/>
                        <a:pt x="2946796" y="854112"/>
                        <a:pt x="2972725" y="857287"/>
                      </a:cubicBezTo>
                      <a:cubicBezTo>
                        <a:pt x="2998654" y="860462"/>
                        <a:pt x="3026171" y="858874"/>
                        <a:pt x="3048925" y="850937"/>
                      </a:cubicBezTo>
                      <a:cubicBezTo>
                        <a:pt x="3071679" y="842999"/>
                        <a:pt x="3096550" y="822891"/>
                        <a:pt x="3109250" y="809662"/>
                      </a:cubicBezTo>
                      <a:cubicBezTo>
                        <a:pt x="3121950" y="796433"/>
                        <a:pt x="3117717" y="789024"/>
                        <a:pt x="3125125" y="771562"/>
                      </a:cubicBezTo>
                      <a:cubicBezTo>
                        <a:pt x="3132533" y="754100"/>
                        <a:pt x="3147879" y="727112"/>
                        <a:pt x="3153700" y="704887"/>
                      </a:cubicBezTo>
                      <a:cubicBezTo>
                        <a:pt x="3159521" y="682662"/>
                        <a:pt x="3160579" y="656733"/>
                        <a:pt x="3160050" y="638212"/>
                      </a:cubicBezTo>
                      <a:cubicBezTo>
                        <a:pt x="3159521" y="619691"/>
                        <a:pt x="3156346" y="608579"/>
                        <a:pt x="3150525" y="593762"/>
                      </a:cubicBezTo>
                      <a:cubicBezTo>
                        <a:pt x="3144704" y="578945"/>
                        <a:pt x="3131475" y="565716"/>
                        <a:pt x="3125125" y="549312"/>
                      </a:cubicBezTo>
                      <a:cubicBezTo>
                        <a:pt x="3118775" y="532908"/>
                        <a:pt x="3116129" y="514387"/>
                        <a:pt x="3112425" y="495337"/>
                      </a:cubicBezTo>
                      <a:cubicBezTo>
                        <a:pt x="3108721" y="476287"/>
                        <a:pt x="3108316" y="455774"/>
                        <a:pt x="3102900" y="435012"/>
                      </a:cubicBezTo>
                      <a:cubicBezTo>
                        <a:pt x="3097484" y="414250"/>
                        <a:pt x="3093250" y="394826"/>
                        <a:pt x="3079928" y="370765"/>
                      </a:cubicBezTo>
                      <a:cubicBezTo>
                        <a:pt x="3066606" y="346704"/>
                        <a:pt x="3041635" y="310773"/>
                        <a:pt x="3022965" y="290643"/>
                      </a:cubicBezTo>
                      <a:cubicBezTo>
                        <a:pt x="3004295" y="270513"/>
                        <a:pt x="2982311" y="261470"/>
                        <a:pt x="2967910" y="249985"/>
                      </a:cubicBezTo>
                      <a:cubicBezTo>
                        <a:pt x="2953509" y="238500"/>
                        <a:pt x="2950073" y="237899"/>
                        <a:pt x="2936557" y="221735"/>
                      </a:cubicBezTo>
                      <a:cubicBezTo>
                        <a:pt x="2923041" y="205571"/>
                        <a:pt x="2904598" y="170898"/>
                        <a:pt x="2886813" y="152998"/>
                      </a:cubicBezTo>
                      <a:cubicBezTo>
                        <a:pt x="2869029" y="135098"/>
                        <a:pt x="2845694" y="128718"/>
                        <a:pt x="2829850" y="114337"/>
                      </a:cubicBezTo>
                      <a:cubicBezTo>
                        <a:pt x="2814006" y="99956"/>
                        <a:pt x="2807345" y="79412"/>
                        <a:pt x="2791750" y="66712"/>
                      </a:cubicBezTo>
                      <a:cubicBezTo>
                        <a:pt x="2776155" y="54012"/>
                        <a:pt x="2757448" y="46604"/>
                        <a:pt x="2736281" y="38137"/>
                      </a:cubicBezTo>
                      <a:cubicBezTo>
                        <a:pt x="2715114" y="29670"/>
                        <a:pt x="2687411" y="21795"/>
                        <a:pt x="2664750" y="15912"/>
                      </a:cubicBezTo>
                      <a:cubicBezTo>
                        <a:pt x="2642089" y="10029"/>
                        <a:pt x="2620056" y="5324"/>
                        <a:pt x="2600316" y="2839"/>
                      </a:cubicBezTo>
                      <a:cubicBezTo>
                        <a:pt x="2580576" y="354"/>
                        <a:pt x="2560003" y="-1084"/>
                        <a:pt x="2546308" y="1003"/>
                      </a:cubicBezTo>
                      <a:cubicBezTo>
                        <a:pt x="2532613" y="3090"/>
                        <a:pt x="2529099" y="7053"/>
                        <a:pt x="2518148" y="15359"/>
                      </a:cubicBezTo>
                      <a:cubicBezTo>
                        <a:pt x="2507197" y="23665"/>
                        <a:pt x="2490033" y="39103"/>
                        <a:pt x="2480600" y="50837"/>
                      </a:cubicBezTo>
                      <a:cubicBezTo>
                        <a:pt x="2471167" y="62571"/>
                        <a:pt x="2465783" y="74649"/>
                        <a:pt x="2461550" y="85762"/>
                      </a:cubicBezTo>
                      <a:cubicBezTo>
                        <a:pt x="2457317" y="96874"/>
                        <a:pt x="2454947" y="108286"/>
                        <a:pt x="2455200" y="117512"/>
                      </a:cubicBezTo>
                      <a:cubicBezTo>
                        <a:pt x="2455453" y="126738"/>
                        <a:pt x="2457914" y="134814"/>
                        <a:pt x="2463068" y="141118"/>
                      </a:cubicBezTo>
                      <a:cubicBezTo>
                        <a:pt x="2468222" y="147422"/>
                        <a:pt x="2477379" y="151333"/>
                        <a:pt x="2486122" y="155336"/>
                      </a:cubicBezTo>
                      <a:cubicBezTo>
                        <a:pt x="2494865" y="159339"/>
                        <a:pt x="2507979" y="163504"/>
                        <a:pt x="2515525" y="165137"/>
                      </a:cubicBezTo>
                      <a:cubicBezTo>
                        <a:pt x="2523071" y="166770"/>
                        <a:pt x="2523992" y="165068"/>
                        <a:pt x="2531400" y="165137"/>
                      </a:cubicBezTo>
                      <a:lnTo>
                        <a:pt x="2559975" y="165551"/>
                      </a:lnTo>
                      <a:cubicBezTo>
                        <a:pt x="2566325" y="166080"/>
                        <a:pt x="2562621" y="167323"/>
                        <a:pt x="2569500" y="168312"/>
                      </a:cubicBezTo>
                      <a:cubicBezTo>
                        <a:pt x="2576379" y="169301"/>
                        <a:pt x="2585375" y="170429"/>
                        <a:pt x="2601250" y="171487"/>
                      </a:cubicBezTo>
                      <a:cubicBezTo>
                        <a:pt x="2617125" y="172545"/>
                        <a:pt x="2644642" y="167254"/>
                        <a:pt x="2664750" y="174662"/>
                      </a:cubicBezTo>
                      <a:cubicBezTo>
                        <a:pt x="2684858" y="182070"/>
                        <a:pt x="2705496" y="197416"/>
                        <a:pt x="2721900" y="215937"/>
                      </a:cubicBezTo>
                      <a:cubicBezTo>
                        <a:pt x="2738304" y="234458"/>
                        <a:pt x="2753650" y="268324"/>
                        <a:pt x="2763175" y="285787"/>
                      </a:cubicBezTo>
                      <a:cubicBezTo>
                        <a:pt x="2772700" y="303249"/>
                        <a:pt x="2774287" y="308012"/>
                        <a:pt x="2779050" y="320712"/>
                      </a:cubicBezTo>
                      <a:cubicBezTo>
                        <a:pt x="2783813" y="333412"/>
                        <a:pt x="2787517" y="348758"/>
                        <a:pt x="2791750" y="361987"/>
                      </a:cubicBezTo>
                      <a:cubicBezTo>
                        <a:pt x="2795983" y="375216"/>
                        <a:pt x="2801804" y="390562"/>
                        <a:pt x="2804450" y="400087"/>
                      </a:cubicBezTo>
                      <a:cubicBezTo>
                        <a:pt x="2807096" y="409612"/>
                        <a:pt x="2807096" y="412258"/>
                        <a:pt x="2807625" y="419137"/>
                      </a:cubicBezTo>
                      <a:cubicBezTo>
                        <a:pt x="2808154" y="426016"/>
                        <a:pt x="2807096" y="431837"/>
                        <a:pt x="2807625" y="441362"/>
                      </a:cubicBezTo>
                      <a:cubicBezTo>
                        <a:pt x="2808154" y="450887"/>
                        <a:pt x="2809742" y="465704"/>
                        <a:pt x="2810800" y="476287"/>
                      </a:cubicBezTo>
                      <a:cubicBezTo>
                        <a:pt x="2811858" y="486870"/>
                        <a:pt x="2812917" y="495866"/>
                        <a:pt x="2813975" y="504862"/>
                      </a:cubicBezTo>
                      <a:cubicBezTo>
                        <a:pt x="2815033" y="513858"/>
                        <a:pt x="2816621" y="521266"/>
                        <a:pt x="2817150" y="530262"/>
                      </a:cubicBezTo>
                      <a:cubicBezTo>
                        <a:pt x="2817679" y="539258"/>
                        <a:pt x="2817679" y="551958"/>
                        <a:pt x="2817150" y="558837"/>
                      </a:cubicBezTo>
                      <a:cubicBezTo>
                        <a:pt x="2816621" y="565716"/>
                        <a:pt x="2815562" y="567304"/>
                        <a:pt x="2813975" y="571537"/>
                      </a:cubicBezTo>
                      <a:cubicBezTo>
                        <a:pt x="2812388" y="575770"/>
                        <a:pt x="2807625" y="584237"/>
                        <a:pt x="2807625" y="584237"/>
                      </a:cubicBezTo>
                      <a:cubicBezTo>
                        <a:pt x="2804979" y="589529"/>
                        <a:pt x="2800217" y="597466"/>
                        <a:pt x="2798100" y="603287"/>
                      </a:cubicBezTo>
                      <a:cubicBezTo>
                        <a:pt x="2795983" y="609108"/>
                        <a:pt x="2795454" y="613870"/>
                        <a:pt x="2794925" y="619162"/>
                      </a:cubicBezTo>
                      <a:cubicBezTo>
                        <a:pt x="2794396" y="624454"/>
                        <a:pt x="2794396" y="630274"/>
                        <a:pt x="2794925" y="635037"/>
                      </a:cubicBezTo>
                      <a:cubicBezTo>
                        <a:pt x="2795454" y="639799"/>
                        <a:pt x="2798100" y="647737"/>
                        <a:pt x="2798100" y="647737"/>
                      </a:cubicBezTo>
                      <a:lnTo>
                        <a:pt x="2798100" y="647737"/>
                      </a:lnTo>
                      <a:cubicBezTo>
                        <a:pt x="2789633" y="650912"/>
                        <a:pt x="2764233" y="662025"/>
                        <a:pt x="2747300" y="666787"/>
                      </a:cubicBezTo>
                      <a:cubicBezTo>
                        <a:pt x="2730367" y="671549"/>
                        <a:pt x="2712904" y="673666"/>
                        <a:pt x="2696500" y="676312"/>
                      </a:cubicBezTo>
                      <a:cubicBezTo>
                        <a:pt x="2680096" y="678958"/>
                        <a:pt x="2661046" y="681604"/>
                        <a:pt x="2648875" y="682662"/>
                      </a:cubicBezTo>
                      <a:cubicBezTo>
                        <a:pt x="2636704" y="683720"/>
                        <a:pt x="2641902" y="680203"/>
                        <a:pt x="2623475" y="682662"/>
                      </a:cubicBezTo>
                      <a:cubicBezTo>
                        <a:pt x="2605048" y="685121"/>
                        <a:pt x="2561593" y="693712"/>
                        <a:pt x="2538310" y="697416"/>
                      </a:cubicBezTo>
                      <a:cubicBezTo>
                        <a:pt x="2515027" y="701120"/>
                        <a:pt x="2500272" y="702054"/>
                        <a:pt x="2483775" y="704887"/>
                      </a:cubicBezTo>
                      <a:cubicBezTo>
                        <a:pt x="2467278" y="707720"/>
                        <a:pt x="2439325" y="714412"/>
                        <a:pt x="2439325" y="714412"/>
                      </a:cubicBezTo>
                      <a:cubicBezTo>
                        <a:pt x="2424508" y="717587"/>
                        <a:pt x="2415512" y="723408"/>
                        <a:pt x="2394875" y="723937"/>
                      </a:cubicBezTo>
                      <a:cubicBezTo>
                        <a:pt x="2374238" y="724466"/>
                        <a:pt x="2339313" y="720762"/>
                        <a:pt x="2315500" y="717587"/>
                      </a:cubicBezTo>
                      <a:cubicBezTo>
                        <a:pt x="2291688" y="714412"/>
                        <a:pt x="2268933" y="708062"/>
                        <a:pt x="2252000" y="704887"/>
                      </a:cubicBezTo>
                      <a:cubicBezTo>
                        <a:pt x="2235067" y="701712"/>
                        <a:pt x="2213900" y="698537"/>
                        <a:pt x="2213900" y="698537"/>
                      </a:cubicBezTo>
                      <a:lnTo>
                        <a:pt x="2172625" y="692187"/>
                      </a:lnTo>
                      <a:lnTo>
                        <a:pt x="2115475" y="682662"/>
                      </a:lnTo>
                      <a:cubicBezTo>
                        <a:pt x="2099600" y="680016"/>
                        <a:pt x="2091662" y="678958"/>
                        <a:pt x="2077375" y="676312"/>
                      </a:cubicBezTo>
                      <a:cubicBezTo>
                        <a:pt x="2063088" y="673666"/>
                        <a:pt x="2056738" y="669433"/>
                        <a:pt x="2029750" y="666787"/>
                      </a:cubicBezTo>
                      <a:cubicBezTo>
                        <a:pt x="2002763" y="664141"/>
                        <a:pt x="1944554" y="660966"/>
                        <a:pt x="1915450" y="660437"/>
                      </a:cubicBezTo>
                      <a:cubicBezTo>
                        <a:pt x="1886346" y="659908"/>
                        <a:pt x="1855125" y="663612"/>
                        <a:pt x="1855125" y="663612"/>
                      </a:cubicBezTo>
                      <a:cubicBezTo>
                        <a:pt x="1830783" y="664670"/>
                        <a:pt x="1790037" y="665200"/>
                        <a:pt x="1769400" y="666787"/>
                      </a:cubicBezTo>
                      <a:cubicBezTo>
                        <a:pt x="1748763" y="668374"/>
                        <a:pt x="1745058" y="668375"/>
                        <a:pt x="1731300" y="673137"/>
                      </a:cubicBezTo>
                      <a:cubicBezTo>
                        <a:pt x="1717542" y="677899"/>
                        <a:pt x="1703783" y="687954"/>
                        <a:pt x="1686850" y="695362"/>
                      </a:cubicBezTo>
                      <a:cubicBezTo>
                        <a:pt x="1669917" y="702770"/>
                        <a:pt x="1646633" y="710179"/>
                        <a:pt x="1629700" y="717587"/>
                      </a:cubicBezTo>
                      <a:cubicBezTo>
                        <a:pt x="1612767" y="724995"/>
                        <a:pt x="1602183" y="733462"/>
                        <a:pt x="1585250" y="739812"/>
                      </a:cubicBezTo>
                      <a:cubicBezTo>
                        <a:pt x="1568317" y="746162"/>
                        <a:pt x="1542917" y="749866"/>
                        <a:pt x="1528100" y="755687"/>
                      </a:cubicBezTo>
                      <a:cubicBezTo>
                        <a:pt x="1513283" y="761508"/>
                        <a:pt x="1505875" y="770504"/>
                        <a:pt x="1496350" y="774737"/>
                      </a:cubicBezTo>
                      <a:cubicBezTo>
                        <a:pt x="1486825" y="778970"/>
                        <a:pt x="1482592" y="776854"/>
                        <a:pt x="1470950" y="781087"/>
                      </a:cubicBezTo>
                      <a:cubicBezTo>
                        <a:pt x="1459308" y="785320"/>
                        <a:pt x="1446079" y="800666"/>
                        <a:pt x="1426500" y="800137"/>
                      </a:cubicBezTo>
                      <a:cubicBezTo>
                        <a:pt x="1406921" y="799608"/>
                        <a:pt x="1384167" y="785849"/>
                        <a:pt x="1353475" y="777912"/>
                      </a:cubicBezTo>
                      <a:cubicBezTo>
                        <a:pt x="1322783" y="769975"/>
                        <a:pt x="1242350" y="752512"/>
                        <a:pt x="1242350" y="752512"/>
                      </a:cubicBezTo>
                      <a:lnTo>
                        <a:pt x="1169325" y="736637"/>
                      </a:lnTo>
                      <a:cubicBezTo>
                        <a:pt x="1133871" y="728700"/>
                        <a:pt x="1064550" y="710708"/>
                        <a:pt x="1029625" y="704887"/>
                      </a:cubicBezTo>
                      <a:cubicBezTo>
                        <a:pt x="994700" y="699066"/>
                        <a:pt x="959775" y="701712"/>
                        <a:pt x="959775" y="701712"/>
                      </a:cubicBezTo>
                      <a:cubicBezTo>
                        <a:pt x="932788" y="700654"/>
                        <a:pt x="892042" y="698537"/>
                        <a:pt x="867700" y="698537"/>
                      </a:cubicBezTo>
                      <a:cubicBezTo>
                        <a:pt x="843358" y="698537"/>
                        <a:pt x="829071" y="699066"/>
                        <a:pt x="813725" y="701712"/>
                      </a:cubicBezTo>
                      <a:cubicBezTo>
                        <a:pt x="798379" y="704358"/>
                        <a:pt x="792558" y="710179"/>
                        <a:pt x="775625" y="714412"/>
                      </a:cubicBezTo>
                      <a:cubicBezTo>
                        <a:pt x="758692" y="718645"/>
                        <a:pt x="728529" y="722879"/>
                        <a:pt x="712125" y="727112"/>
                      </a:cubicBezTo>
                      <a:cubicBezTo>
                        <a:pt x="695721" y="731345"/>
                        <a:pt x="706211" y="736139"/>
                        <a:pt x="677200" y="739812"/>
                      </a:cubicBezTo>
                      <a:cubicBezTo>
                        <a:pt x="648189" y="743485"/>
                        <a:pt x="579615" y="750457"/>
                        <a:pt x="538060" y="749150"/>
                      </a:cubicBezTo>
                      <a:cubicBezTo>
                        <a:pt x="496505" y="747843"/>
                        <a:pt x="456537" y="736170"/>
                        <a:pt x="427869" y="731968"/>
                      </a:cubicBezTo>
                      <a:cubicBezTo>
                        <a:pt x="399201" y="727766"/>
                        <a:pt x="384166" y="724435"/>
                        <a:pt x="366050" y="723937"/>
                      </a:cubicBezTo>
                      <a:cubicBezTo>
                        <a:pt x="347934" y="723439"/>
                        <a:pt x="341397" y="730037"/>
                        <a:pt x="319172" y="728979"/>
                      </a:cubicBezTo>
                      <a:cubicBezTo>
                        <a:pt x="296947" y="727921"/>
                        <a:pt x="250287" y="719486"/>
                        <a:pt x="232700" y="717587"/>
                      </a:cubicBezTo>
                      <a:cubicBezTo>
                        <a:pt x="215113" y="715688"/>
                        <a:pt x="213650" y="717587"/>
                        <a:pt x="213650" y="717587"/>
                      </a:cubicBezTo>
                      <a:lnTo>
                        <a:pt x="146975" y="717587"/>
                      </a:lnTo>
                      <a:cubicBezTo>
                        <a:pt x="133217" y="718116"/>
                        <a:pt x="139037" y="718116"/>
                        <a:pt x="131100" y="720762"/>
                      </a:cubicBezTo>
                      <a:cubicBezTo>
                        <a:pt x="123163" y="723408"/>
                        <a:pt x="109404" y="729758"/>
                        <a:pt x="99350" y="733462"/>
                      </a:cubicBezTo>
                      <a:cubicBezTo>
                        <a:pt x="89296" y="737166"/>
                        <a:pt x="84464" y="739789"/>
                        <a:pt x="70775" y="742987"/>
                      </a:cubicBezTo>
                      <a:cubicBezTo>
                        <a:pt x="57086" y="746185"/>
                        <a:pt x="28879" y="745311"/>
                        <a:pt x="17214" y="752650"/>
                      </a:cubicBezTo>
                      <a:cubicBezTo>
                        <a:pt x="5549" y="759989"/>
                        <a:pt x="-2641" y="771930"/>
                        <a:pt x="787" y="787023"/>
                      </a:cubicBezTo>
                      <a:cubicBezTo>
                        <a:pt x="4215" y="802116"/>
                        <a:pt x="24507" y="830138"/>
                        <a:pt x="37782" y="843206"/>
                      </a:cubicBezTo>
                      <a:cubicBezTo>
                        <a:pt x="51057" y="856274"/>
                        <a:pt x="84671" y="861727"/>
                        <a:pt x="80438" y="865431"/>
                      </a:cubicBezTo>
                    </a:path>
                  </a:pathLst>
                </a:custGeom>
                <a:solidFill>
                  <a:schemeClr val="accent2">
                    <a:lumMod val="75000"/>
                  </a:schemeClr>
                </a:solidFill>
                <a:ln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65887EA3-58E8-435C-872A-9AF3E3DB5071}"/>
                    </a:ext>
                  </a:extLst>
                </p:cNvPr>
                <p:cNvSpPr txBox="1"/>
                <p:nvPr/>
              </p:nvSpPr>
              <p:spPr>
                <a:xfrm>
                  <a:off x="5613824" y="5856991"/>
                  <a:ext cx="639599" cy="2885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lon</a:t>
                  </a:r>
                  <a:endParaRPr lang="en-GB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699A0A89-09BE-4F8E-A074-4F87976CAECF}"/>
                    </a:ext>
                  </a:extLst>
                </p:cNvPr>
                <p:cNvSpPr txBox="1"/>
                <p:nvPr/>
              </p:nvSpPr>
              <p:spPr>
                <a:xfrm>
                  <a:off x="4532603" y="4691310"/>
                  <a:ext cx="791884" cy="2885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ecum</a:t>
                  </a:r>
                  <a:endParaRPr lang="en-GB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45A159EF-CB8C-4236-AFDC-A7554A3E5D08}"/>
                    </a:ext>
                  </a:extLst>
                </p:cNvPr>
                <p:cNvSpPr txBox="1"/>
                <p:nvPr/>
              </p:nvSpPr>
              <p:spPr>
                <a:xfrm>
                  <a:off x="5127373" y="3871474"/>
                  <a:ext cx="1124506" cy="2885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/>
                    <a:t>Small intestine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9FA88040-25CF-4A41-8BE3-7D9E852DE385}"/>
                    </a:ext>
                  </a:extLst>
                </p:cNvPr>
                <p:cNvSpPr txBox="1"/>
                <p:nvPr/>
              </p:nvSpPr>
              <p:spPr>
                <a:xfrm>
                  <a:off x="6177077" y="5335440"/>
                  <a:ext cx="629581" cy="2885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b="1" dirty="0" err="1">
                      <a:solidFill>
                        <a:schemeClr val="accent2">
                          <a:lumMod val="50000"/>
                        </a:schemeClr>
                      </a:solidFill>
                    </a:rPr>
                    <a:t>cMLNs</a:t>
                  </a:r>
                  <a:endParaRPr lang="en-GB" sz="700" b="1" dirty="0">
                    <a:solidFill>
                      <a:schemeClr val="accent2">
                        <a:lumMod val="50000"/>
                      </a:schemeClr>
                    </a:solidFill>
                  </a:endParaRPr>
                </a:p>
              </p:txBody>
            </p:sp>
            <p:sp>
              <p:nvSpPr>
                <p:cNvPr id="52" name="Freeform 115">
                  <a:extLst>
                    <a:ext uri="{FF2B5EF4-FFF2-40B4-BE49-F238E27FC236}">
                      <a16:creationId xmlns:a16="http://schemas.microsoft.com/office/drawing/2014/main" id="{A218FD01-C703-4D81-B50C-D97FA4E215F3}"/>
                    </a:ext>
                  </a:extLst>
                </p:cNvPr>
                <p:cNvSpPr/>
                <p:nvPr/>
              </p:nvSpPr>
              <p:spPr>
                <a:xfrm rot="21299724" flipH="1">
                  <a:off x="6984384" y="5315591"/>
                  <a:ext cx="96264" cy="72190"/>
                </a:xfrm>
                <a:custGeom>
                  <a:avLst/>
                  <a:gdLst>
                    <a:gd name="connsiteX0" fmla="*/ 17538 w 65182"/>
                    <a:gd name="connsiteY0" fmla="*/ 457 h 83007"/>
                    <a:gd name="connsiteX1" fmla="*/ 1663 w 65182"/>
                    <a:gd name="connsiteY1" fmla="*/ 6807 h 83007"/>
                    <a:gd name="connsiteX2" fmla="*/ 11188 w 65182"/>
                    <a:gd name="connsiteY2" fmla="*/ 44907 h 83007"/>
                    <a:gd name="connsiteX3" fmla="*/ 14363 w 65182"/>
                    <a:gd name="connsiteY3" fmla="*/ 54432 h 83007"/>
                    <a:gd name="connsiteX4" fmla="*/ 30238 w 65182"/>
                    <a:gd name="connsiteY4" fmla="*/ 73482 h 83007"/>
                    <a:gd name="connsiteX5" fmla="*/ 39763 w 65182"/>
                    <a:gd name="connsiteY5" fmla="*/ 79832 h 83007"/>
                    <a:gd name="connsiteX6" fmla="*/ 49288 w 65182"/>
                    <a:gd name="connsiteY6" fmla="*/ 83007 h 83007"/>
                    <a:gd name="connsiteX7" fmla="*/ 61988 w 65182"/>
                    <a:gd name="connsiteY7" fmla="*/ 79832 h 83007"/>
                    <a:gd name="connsiteX8" fmla="*/ 65163 w 65182"/>
                    <a:gd name="connsiteY8" fmla="*/ 70307 h 83007"/>
                    <a:gd name="connsiteX9" fmla="*/ 61988 w 65182"/>
                    <a:gd name="connsiteY9" fmla="*/ 22682 h 83007"/>
                    <a:gd name="connsiteX10" fmla="*/ 52463 w 65182"/>
                    <a:gd name="connsiteY10" fmla="*/ 16332 h 83007"/>
                    <a:gd name="connsiteX11" fmla="*/ 17538 w 65182"/>
                    <a:gd name="connsiteY11" fmla="*/ 457 h 83007"/>
                    <a:gd name="connsiteX0" fmla="*/ 17538 w 67692"/>
                    <a:gd name="connsiteY0" fmla="*/ 457 h 83007"/>
                    <a:gd name="connsiteX1" fmla="*/ 1663 w 67692"/>
                    <a:gd name="connsiteY1" fmla="*/ 6807 h 83007"/>
                    <a:gd name="connsiteX2" fmla="*/ 11188 w 67692"/>
                    <a:gd name="connsiteY2" fmla="*/ 44907 h 83007"/>
                    <a:gd name="connsiteX3" fmla="*/ 14363 w 67692"/>
                    <a:gd name="connsiteY3" fmla="*/ 54432 h 83007"/>
                    <a:gd name="connsiteX4" fmla="*/ 30238 w 67692"/>
                    <a:gd name="connsiteY4" fmla="*/ 73482 h 83007"/>
                    <a:gd name="connsiteX5" fmla="*/ 39763 w 67692"/>
                    <a:gd name="connsiteY5" fmla="*/ 79832 h 83007"/>
                    <a:gd name="connsiteX6" fmla="*/ 49288 w 67692"/>
                    <a:gd name="connsiteY6" fmla="*/ 83007 h 83007"/>
                    <a:gd name="connsiteX7" fmla="*/ 61988 w 67692"/>
                    <a:gd name="connsiteY7" fmla="*/ 79832 h 83007"/>
                    <a:gd name="connsiteX8" fmla="*/ 65163 w 67692"/>
                    <a:gd name="connsiteY8" fmla="*/ 70307 h 83007"/>
                    <a:gd name="connsiteX9" fmla="*/ 66171 w 67692"/>
                    <a:gd name="connsiteY9" fmla="*/ 38787 h 83007"/>
                    <a:gd name="connsiteX10" fmla="*/ 52463 w 67692"/>
                    <a:gd name="connsiteY10" fmla="*/ 16332 h 83007"/>
                    <a:gd name="connsiteX11" fmla="*/ 17538 w 67692"/>
                    <a:gd name="connsiteY11" fmla="*/ 457 h 83007"/>
                    <a:gd name="connsiteX0" fmla="*/ 17538 w 67692"/>
                    <a:gd name="connsiteY0" fmla="*/ 457 h 83007"/>
                    <a:gd name="connsiteX1" fmla="*/ 1663 w 67692"/>
                    <a:gd name="connsiteY1" fmla="*/ 6807 h 83007"/>
                    <a:gd name="connsiteX2" fmla="*/ 11188 w 67692"/>
                    <a:gd name="connsiteY2" fmla="*/ 44907 h 83007"/>
                    <a:gd name="connsiteX3" fmla="*/ 14363 w 67692"/>
                    <a:gd name="connsiteY3" fmla="*/ 54432 h 83007"/>
                    <a:gd name="connsiteX4" fmla="*/ 30238 w 67692"/>
                    <a:gd name="connsiteY4" fmla="*/ 73482 h 83007"/>
                    <a:gd name="connsiteX5" fmla="*/ 39763 w 67692"/>
                    <a:gd name="connsiteY5" fmla="*/ 79832 h 83007"/>
                    <a:gd name="connsiteX6" fmla="*/ 49288 w 67692"/>
                    <a:gd name="connsiteY6" fmla="*/ 83007 h 83007"/>
                    <a:gd name="connsiteX7" fmla="*/ 61988 w 67692"/>
                    <a:gd name="connsiteY7" fmla="*/ 79832 h 83007"/>
                    <a:gd name="connsiteX8" fmla="*/ 65163 w 67692"/>
                    <a:gd name="connsiteY8" fmla="*/ 70307 h 83007"/>
                    <a:gd name="connsiteX9" fmla="*/ 66171 w 67692"/>
                    <a:gd name="connsiteY9" fmla="*/ 38787 h 83007"/>
                    <a:gd name="connsiteX10" fmla="*/ 52463 w 67692"/>
                    <a:gd name="connsiteY10" fmla="*/ 16332 h 83007"/>
                    <a:gd name="connsiteX11" fmla="*/ 17538 w 67692"/>
                    <a:gd name="connsiteY11" fmla="*/ 457 h 83007"/>
                    <a:gd name="connsiteX0" fmla="*/ 36755 w 67187"/>
                    <a:gd name="connsiteY0" fmla="*/ 4316 h 78814"/>
                    <a:gd name="connsiteX1" fmla="*/ 1158 w 67187"/>
                    <a:gd name="connsiteY1" fmla="*/ 2614 h 78814"/>
                    <a:gd name="connsiteX2" fmla="*/ 10683 w 67187"/>
                    <a:gd name="connsiteY2" fmla="*/ 40714 h 78814"/>
                    <a:gd name="connsiteX3" fmla="*/ 13858 w 67187"/>
                    <a:gd name="connsiteY3" fmla="*/ 50239 h 78814"/>
                    <a:gd name="connsiteX4" fmla="*/ 29733 w 67187"/>
                    <a:gd name="connsiteY4" fmla="*/ 69289 h 78814"/>
                    <a:gd name="connsiteX5" fmla="*/ 39258 w 67187"/>
                    <a:gd name="connsiteY5" fmla="*/ 75639 h 78814"/>
                    <a:gd name="connsiteX6" fmla="*/ 48783 w 67187"/>
                    <a:gd name="connsiteY6" fmla="*/ 78814 h 78814"/>
                    <a:gd name="connsiteX7" fmla="*/ 61483 w 67187"/>
                    <a:gd name="connsiteY7" fmla="*/ 75639 h 78814"/>
                    <a:gd name="connsiteX8" fmla="*/ 64658 w 67187"/>
                    <a:gd name="connsiteY8" fmla="*/ 66114 h 78814"/>
                    <a:gd name="connsiteX9" fmla="*/ 65666 w 67187"/>
                    <a:gd name="connsiteY9" fmla="*/ 34594 h 78814"/>
                    <a:gd name="connsiteX10" fmla="*/ 51958 w 67187"/>
                    <a:gd name="connsiteY10" fmla="*/ 12139 h 78814"/>
                    <a:gd name="connsiteX11" fmla="*/ 36755 w 67187"/>
                    <a:gd name="connsiteY11" fmla="*/ 4316 h 78814"/>
                    <a:gd name="connsiteX0" fmla="*/ 26098 w 56530"/>
                    <a:gd name="connsiteY0" fmla="*/ 3712 h 78210"/>
                    <a:gd name="connsiteX1" fmla="*/ 4844 w 56530"/>
                    <a:gd name="connsiteY1" fmla="*/ 17495 h 78210"/>
                    <a:gd name="connsiteX2" fmla="*/ 26 w 56530"/>
                    <a:gd name="connsiteY2" fmla="*/ 40110 h 78210"/>
                    <a:gd name="connsiteX3" fmla="*/ 3201 w 56530"/>
                    <a:gd name="connsiteY3" fmla="*/ 49635 h 78210"/>
                    <a:gd name="connsiteX4" fmla="*/ 19076 w 56530"/>
                    <a:gd name="connsiteY4" fmla="*/ 68685 h 78210"/>
                    <a:gd name="connsiteX5" fmla="*/ 28601 w 56530"/>
                    <a:gd name="connsiteY5" fmla="*/ 75035 h 78210"/>
                    <a:gd name="connsiteX6" fmla="*/ 38126 w 56530"/>
                    <a:gd name="connsiteY6" fmla="*/ 78210 h 78210"/>
                    <a:gd name="connsiteX7" fmla="*/ 50826 w 56530"/>
                    <a:gd name="connsiteY7" fmla="*/ 75035 h 78210"/>
                    <a:gd name="connsiteX8" fmla="*/ 54001 w 56530"/>
                    <a:gd name="connsiteY8" fmla="*/ 65510 h 78210"/>
                    <a:gd name="connsiteX9" fmla="*/ 55009 w 56530"/>
                    <a:gd name="connsiteY9" fmla="*/ 33990 h 78210"/>
                    <a:gd name="connsiteX10" fmla="*/ 41301 w 56530"/>
                    <a:gd name="connsiteY10" fmla="*/ 11535 h 78210"/>
                    <a:gd name="connsiteX11" fmla="*/ 26098 w 56530"/>
                    <a:gd name="connsiteY11" fmla="*/ 3712 h 78210"/>
                    <a:gd name="connsiteX0" fmla="*/ 24903 w 56530"/>
                    <a:gd name="connsiteY0" fmla="*/ 7187 h 76111"/>
                    <a:gd name="connsiteX1" fmla="*/ 4844 w 56530"/>
                    <a:gd name="connsiteY1" fmla="*/ 15396 h 76111"/>
                    <a:gd name="connsiteX2" fmla="*/ 26 w 56530"/>
                    <a:gd name="connsiteY2" fmla="*/ 38011 h 76111"/>
                    <a:gd name="connsiteX3" fmla="*/ 3201 w 56530"/>
                    <a:gd name="connsiteY3" fmla="*/ 47536 h 76111"/>
                    <a:gd name="connsiteX4" fmla="*/ 19076 w 56530"/>
                    <a:gd name="connsiteY4" fmla="*/ 66586 h 76111"/>
                    <a:gd name="connsiteX5" fmla="*/ 28601 w 56530"/>
                    <a:gd name="connsiteY5" fmla="*/ 72936 h 76111"/>
                    <a:gd name="connsiteX6" fmla="*/ 38126 w 56530"/>
                    <a:gd name="connsiteY6" fmla="*/ 76111 h 76111"/>
                    <a:gd name="connsiteX7" fmla="*/ 50826 w 56530"/>
                    <a:gd name="connsiteY7" fmla="*/ 72936 h 76111"/>
                    <a:gd name="connsiteX8" fmla="*/ 54001 w 56530"/>
                    <a:gd name="connsiteY8" fmla="*/ 63411 h 76111"/>
                    <a:gd name="connsiteX9" fmla="*/ 55009 w 56530"/>
                    <a:gd name="connsiteY9" fmla="*/ 31891 h 76111"/>
                    <a:gd name="connsiteX10" fmla="*/ 41301 w 56530"/>
                    <a:gd name="connsiteY10" fmla="*/ 9436 h 76111"/>
                    <a:gd name="connsiteX11" fmla="*/ 24903 w 56530"/>
                    <a:gd name="connsiteY11" fmla="*/ 7187 h 76111"/>
                    <a:gd name="connsiteX0" fmla="*/ 24903 w 56550"/>
                    <a:gd name="connsiteY0" fmla="*/ 7187 h 76111"/>
                    <a:gd name="connsiteX1" fmla="*/ 4844 w 56550"/>
                    <a:gd name="connsiteY1" fmla="*/ 15396 h 76111"/>
                    <a:gd name="connsiteX2" fmla="*/ 26 w 56550"/>
                    <a:gd name="connsiteY2" fmla="*/ 38011 h 76111"/>
                    <a:gd name="connsiteX3" fmla="*/ 3201 w 56550"/>
                    <a:gd name="connsiteY3" fmla="*/ 47536 h 76111"/>
                    <a:gd name="connsiteX4" fmla="*/ 19076 w 56550"/>
                    <a:gd name="connsiteY4" fmla="*/ 66586 h 76111"/>
                    <a:gd name="connsiteX5" fmla="*/ 28601 w 56550"/>
                    <a:gd name="connsiteY5" fmla="*/ 72936 h 76111"/>
                    <a:gd name="connsiteX6" fmla="*/ 38126 w 56550"/>
                    <a:gd name="connsiteY6" fmla="*/ 76111 h 76111"/>
                    <a:gd name="connsiteX7" fmla="*/ 50228 w 56550"/>
                    <a:gd name="connsiteY7" fmla="*/ 67981 h 76111"/>
                    <a:gd name="connsiteX8" fmla="*/ 54001 w 56550"/>
                    <a:gd name="connsiteY8" fmla="*/ 63411 h 76111"/>
                    <a:gd name="connsiteX9" fmla="*/ 55009 w 56550"/>
                    <a:gd name="connsiteY9" fmla="*/ 31891 h 76111"/>
                    <a:gd name="connsiteX10" fmla="*/ 41301 w 56550"/>
                    <a:gd name="connsiteY10" fmla="*/ 9436 h 76111"/>
                    <a:gd name="connsiteX11" fmla="*/ 24903 w 56550"/>
                    <a:gd name="connsiteY11" fmla="*/ 7187 h 76111"/>
                    <a:gd name="connsiteX0" fmla="*/ 24903 w 56550"/>
                    <a:gd name="connsiteY0" fmla="*/ 7187 h 73158"/>
                    <a:gd name="connsiteX1" fmla="*/ 4844 w 56550"/>
                    <a:gd name="connsiteY1" fmla="*/ 15396 h 73158"/>
                    <a:gd name="connsiteX2" fmla="*/ 26 w 56550"/>
                    <a:gd name="connsiteY2" fmla="*/ 38011 h 73158"/>
                    <a:gd name="connsiteX3" fmla="*/ 3201 w 56550"/>
                    <a:gd name="connsiteY3" fmla="*/ 47536 h 73158"/>
                    <a:gd name="connsiteX4" fmla="*/ 19076 w 56550"/>
                    <a:gd name="connsiteY4" fmla="*/ 66586 h 73158"/>
                    <a:gd name="connsiteX5" fmla="*/ 28601 w 56550"/>
                    <a:gd name="connsiteY5" fmla="*/ 72936 h 73158"/>
                    <a:gd name="connsiteX6" fmla="*/ 37528 w 56550"/>
                    <a:gd name="connsiteY6" fmla="*/ 72394 h 73158"/>
                    <a:gd name="connsiteX7" fmla="*/ 50228 w 56550"/>
                    <a:gd name="connsiteY7" fmla="*/ 67981 h 73158"/>
                    <a:gd name="connsiteX8" fmla="*/ 54001 w 56550"/>
                    <a:gd name="connsiteY8" fmla="*/ 63411 h 73158"/>
                    <a:gd name="connsiteX9" fmla="*/ 55009 w 56550"/>
                    <a:gd name="connsiteY9" fmla="*/ 31891 h 73158"/>
                    <a:gd name="connsiteX10" fmla="*/ 41301 w 56550"/>
                    <a:gd name="connsiteY10" fmla="*/ 9436 h 73158"/>
                    <a:gd name="connsiteX11" fmla="*/ 24903 w 56550"/>
                    <a:gd name="connsiteY11" fmla="*/ 7187 h 73158"/>
                    <a:gd name="connsiteX0" fmla="*/ 24929 w 56576"/>
                    <a:gd name="connsiteY0" fmla="*/ 7187 h 73469"/>
                    <a:gd name="connsiteX1" fmla="*/ 4870 w 56576"/>
                    <a:gd name="connsiteY1" fmla="*/ 15396 h 73469"/>
                    <a:gd name="connsiteX2" fmla="*/ 52 w 56576"/>
                    <a:gd name="connsiteY2" fmla="*/ 38011 h 73469"/>
                    <a:gd name="connsiteX3" fmla="*/ 3227 w 56576"/>
                    <a:gd name="connsiteY3" fmla="*/ 47536 h 73469"/>
                    <a:gd name="connsiteX4" fmla="*/ 16114 w 56576"/>
                    <a:gd name="connsiteY4" fmla="*/ 61631 h 73469"/>
                    <a:gd name="connsiteX5" fmla="*/ 28627 w 56576"/>
                    <a:gd name="connsiteY5" fmla="*/ 72936 h 73469"/>
                    <a:gd name="connsiteX6" fmla="*/ 37554 w 56576"/>
                    <a:gd name="connsiteY6" fmla="*/ 72394 h 73469"/>
                    <a:gd name="connsiteX7" fmla="*/ 50254 w 56576"/>
                    <a:gd name="connsiteY7" fmla="*/ 67981 h 73469"/>
                    <a:gd name="connsiteX8" fmla="*/ 54027 w 56576"/>
                    <a:gd name="connsiteY8" fmla="*/ 63411 h 73469"/>
                    <a:gd name="connsiteX9" fmla="*/ 55035 w 56576"/>
                    <a:gd name="connsiteY9" fmla="*/ 31891 h 73469"/>
                    <a:gd name="connsiteX10" fmla="*/ 41327 w 56576"/>
                    <a:gd name="connsiteY10" fmla="*/ 9436 h 73469"/>
                    <a:gd name="connsiteX11" fmla="*/ 24929 w 56576"/>
                    <a:gd name="connsiteY11" fmla="*/ 7187 h 73469"/>
                    <a:gd name="connsiteX0" fmla="*/ 24929 w 56576"/>
                    <a:gd name="connsiteY0" fmla="*/ 1300 h 67582"/>
                    <a:gd name="connsiteX1" fmla="*/ 4870 w 56576"/>
                    <a:gd name="connsiteY1" fmla="*/ 9509 h 67582"/>
                    <a:gd name="connsiteX2" fmla="*/ 52 w 56576"/>
                    <a:gd name="connsiteY2" fmla="*/ 32124 h 67582"/>
                    <a:gd name="connsiteX3" fmla="*/ 3227 w 56576"/>
                    <a:gd name="connsiteY3" fmla="*/ 41649 h 67582"/>
                    <a:gd name="connsiteX4" fmla="*/ 16114 w 56576"/>
                    <a:gd name="connsiteY4" fmla="*/ 55744 h 67582"/>
                    <a:gd name="connsiteX5" fmla="*/ 28627 w 56576"/>
                    <a:gd name="connsiteY5" fmla="*/ 67049 h 67582"/>
                    <a:gd name="connsiteX6" fmla="*/ 37554 w 56576"/>
                    <a:gd name="connsiteY6" fmla="*/ 66507 h 67582"/>
                    <a:gd name="connsiteX7" fmla="*/ 50254 w 56576"/>
                    <a:gd name="connsiteY7" fmla="*/ 62094 h 67582"/>
                    <a:gd name="connsiteX8" fmla="*/ 54027 w 56576"/>
                    <a:gd name="connsiteY8" fmla="*/ 57524 h 67582"/>
                    <a:gd name="connsiteX9" fmla="*/ 55035 w 56576"/>
                    <a:gd name="connsiteY9" fmla="*/ 26004 h 67582"/>
                    <a:gd name="connsiteX10" fmla="*/ 50889 w 56576"/>
                    <a:gd name="connsiteY10" fmla="*/ 12840 h 67582"/>
                    <a:gd name="connsiteX11" fmla="*/ 24929 w 56576"/>
                    <a:gd name="connsiteY11" fmla="*/ 1300 h 67582"/>
                    <a:gd name="connsiteX0" fmla="*/ 51512 w 57199"/>
                    <a:gd name="connsiteY0" fmla="*/ 4560 h 59302"/>
                    <a:gd name="connsiteX1" fmla="*/ 5493 w 57199"/>
                    <a:gd name="connsiteY1" fmla="*/ 1229 h 59302"/>
                    <a:gd name="connsiteX2" fmla="*/ 675 w 57199"/>
                    <a:gd name="connsiteY2" fmla="*/ 23844 h 59302"/>
                    <a:gd name="connsiteX3" fmla="*/ 3850 w 57199"/>
                    <a:gd name="connsiteY3" fmla="*/ 33369 h 59302"/>
                    <a:gd name="connsiteX4" fmla="*/ 16737 w 57199"/>
                    <a:gd name="connsiteY4" fmla="*/ 47464 h 59302"/>
                    <a:gd name="connsiteX5" fmla="*/ 29250 w 57199"/>
                    <a:gd name="connsiteY5" fmla="*/ 58769 h 59302"/>
                    <a:gd name="connsiteX6" fmla="*/ 38177 w 57199"/>
                    <a:gd name="connsiteY6" fmla="*/ 58227 h 59302"/>
                    <a:gd name="connsiteX7" fmla="*/ 50877 w 57199"/>
                    <a:gd name="connsiteY7" fmla="*/ 53814 h 59302"/>
                    <a:gd name="connsiteX8" fmla="*/ 54650 w 57199"/>
                    <a:gd name="connsiteY8" fmla="*/ 49244 h 59302"/>
                    <a:gd name="connsiteX9" fmla="*/ 55658 w 57199"/>
                    <a:gd name="connsiteY9" fmla="*/ 17724 h 59302"/>
                    <a:gd name="connsiteX10" fmla="*/ 51512 w 57199"/>
                    <a:gd name="connsiteY10" fmla="*/ 4560 h 59302"/>
                    <a:gd name="connsiteX0" fmla="*/ 33558 w 56577"/>
                    <a:gd name="connsiteY0" fmla="*/ 980 h 64394"/>
                    <a:gd name="connsiteX1" fmla="*/ 4871 w 56577"/>
                    <a:gd name="connsiteY1" fmla="*/ 6321 h 64394"/>
                    <a:gd name="connsiteX2" fmla="*/ 53 w 56577"/>
                    <a:gd name="connsiteY2" fmla="*/ 28936 h 64394"/>
                    <a:gd name="connsiteX3" fmla="*/ 3228 w 56577"/>
                    <a:gd name="connsiteY3" fmla="*/ 38461 h 64394"/>
                    <a:gd name="connsiteX4" fmla="*/ 16115 w 56577"/>
                    <a:gd name="connsiteY4" fmla="*/ 52556 h 64394"/>
                    <a:gd name="connsiteX5" fmla="*/ 28628 w 56577"/>
                    <a:gd name="connsiteY5" fmla="*/ 63861 h 64394"/>
                    <a:gd name="connsiteX6" fmla="*/ 37555 w 56577"/>
                    <a:gd name="connsiteY6" fmla="*/ 63319 h 64394"/>
                    <a:gd name="connsiteX7" fmla="*/ 50255 w 56577"/>
                    <a:gd name="connsiteY7" fmla="*/ 58906 h 64394"/>
                    <a:gd name="connsiteX8" fmla="*/ 54028 w 56577"/>
                    <a:gd name="connsiteY8" fmla="*/ 54336 h 64394"/>
                    <a:gd name="connsiteX9" fmla="*/ 55036 w 56577"/>
                    <a:gd name="connsiteY9" fmla="*/ 22816 h 64394"/>
                    <a:gd name="connsiteX10" fmla="*/ 33558 w 56577"/>
                    <a:gd name="connsiteY10" fmla="*/ 980 h 64394"/>
                    <a:gd name="connsiteX0" fmla="*/ 33558 w 55659"/>
                    <a:gd name="connsiteY0" fmla="*/ 980 h 64394"/>
                    <a:gd name="connsiteX1" fmla="*/ 4871 w 55659"/>
                    <a:gd name="connsiteY1" fmla="*/ 6321 h 64394"/>
                    <a:gd name="connsiteX2" fmla="*/ 53 w 55659"/>
                    <a:gd name="connsiteY2" fmla="*/ 28936 h 64394"/>
                    <a:gd name="connsiteX3" fmla="*/ 3228 w 55659"/>
                    <a:gd name="connsiteY3" fmla="*/ 38461 h 64394"/>
                    <a:gd name="connsiteX4" fmla="*/ 16115 w 55659"/>
                    <a:gd name="connsiteY4" fmla="*/ 52556 h 64394"/>
                    <a:gd name="connsiteX5" fmla="*/ 28628 w 55659"/>
                    <a:gd name="connsiteY5" fmla="*/ 63861 h 64394"/>
                    <a:gd name="connsiteX6" fmla="*/ 37555 w 55659"/>
                    <a:gd name="connsiteY6" fmla="*/ 63319 h 64394"/>
                    <a:gd name="connsiteX7" fmla="*/ 50255 w 55659"/>
                    <a:gd name="connsiteY7" fmla="*/ 58906 h 64394"/>
                    <a:gd name="connsiteX8" fmla="*/ 54028 w 55659"/>
                    <a:gd name="connsiteY8" fmla="*/ 54336 h 64394"/>
                    <a:gd name="connsiteX9" fmla="*/ 53841 w 55659"/>
                    <a:gd name="connsiteY9" fmla="*/ 16003 h 64394"/>
                    <a:gd name="connsiteX10" fmla="*/ 33558 w 55659"/>
                    <a:gd name="connsiteY10" fmla="*/ 980 h 64394"/>
                    <a:gd name="connsiteX0" fmla="*/ 33558 w 55659"/>
                    <a:gd name="connsiteY0" fmla="*/ 980 h 64022"/>
                    <a:gd name="connsiteX1" fmla="*/ 4871 w 55659"/>
                    <a:gd name="connsiteY1" fmla="*/ 6321 h 64022"/>
                    <a:gd name="connsiteX2" fmla="*/ 53 w 55659"/>
                    <a:gd name="connsiteY2" fmla="*/ 28936 h 64022"/>
                    <a:gd name="connsiteX3" fmla="*/ 3228 w 55659"/>
                    <a:gd name="connsiteY3" fmla="*/ 38461 h 64022"/>
                    <a:gd name="connsiteX4" fmla="*/ 16115 w 55659"/>
                    <a:gd name="connsiteY4" fmla="*/ 52556 h 64022"/>
                    <a:gd name="connsiteX5" fmla="*/ 28628 w 55659"/>
                    <a:gd name="connsiteY5" fmla="*/ 63861 h 64022"/>
                    <a:gd name="connsiteX6" fmla="*/ 50255 w 55659"/>
                    <a:gd name="connsiteY6" fmla="*/ 58906 h 64022"/>
                    <a:gd name="connsiteX7" fmla="*/ 54028 w 55659"/>
                    <a:gd name="connsiteY7" fmla="*/ 54336 h 64022"/>
                    <a:gd name="connsiteX8" fmla="*/ 53841 w 55659"/>
                    <a:gd name="connsiteY8" fmla="*/ 16003 h 64022"/>
                    <a:gd name="connsiteX9" fmla="*/ 33558 w 55659"/>
                    <a:gd name="connsiteY9" fmla="*/ 980 h 64022"/>
                    <a:gd name="connsiteX0" fmla="*/ 33558 w 55088"/>
                    <a:gd name="connsiteY0" fmla="*/ 980 h 64871"/>
                    <a:gd name="connsiteX1" fmla="*/ 4871 w 55088"/>
                    <a:gd name="connsiteY1" fmla="*/ 6321 h 64871"/>
                    <a:gd name="connsiteX2" fmla="*/ 53 w 55088"/>
                    <a:gd name="connsiteY2" fmla="*/ 28936 h 64871"/>
                    <a:gd name="connsiteX3" fmla="*/ 3228 w 55088"/>
                    <a:gd name="connsiteY3" fmla="*/ 38461 h 64871"/>
                    <a:gd name="connsiteX4" fmla="*/ 16115 w 55088"/>
                    <a:gd name="connsiteY4" fmla="*/ 52556 h 64871"/>
                    <a:gd name="connsiteX5" fmla="*/ 28628 w 55088"/>
                    <a:gd name="connsiteY5" fmla="*/ 63861 h 64871"/>
                    <a:gd name="connsiteX6" fmla="*/ 50255 w 55088"/>
                    <a:gd name="connsiteY6" fmla="*/ 58906 h 64871"/>
                    <a:gd name="connsiteX7" fmla="*/ 53841 w 55088"/>
                    <a:gd name="connsiteY7" fmla="*/ 16003 h 64871"/>
                    <a:gd name="connsiteX8" fmla="*/ 33558 w 55088"/>
                    <a:gd name="connsiteY8" fmla="*/ 980 h 64871"/>
                    <a:gd name="connsiteX0" fmla="*/ 33558 w 58100"/>
                    <a:gd name="connsiteY0" fmla="*/ 980 h 63887"/>
                    <a:gd name="connsiteX1" fmla="*/ 4871 w 58100"/>
                    <a:gd name="connsiteY1" fmla="*/ 6321 h 63887"/>
                    <a:gd name="connsiteX2" fmla="*/ 53 w 58100"/>
                    <a:gd name="connsiteY2" fmla="*/ 28936 h 63887"/>
                    <a:gd name="connsiteX3" fmla="*/ 3228 w 58100"/>
                    <a:gd name="connsiteY3" fmla="*/ 38461 h 63887"/>
                    <a:gd name="connsiteX4" fmla="*/ 16115 w 58100"/>
                    <a:gd name="connsiteY4" fmla="*/ 52556 h 63887"/>
                    <a:gd name="connsiteX5" fmla="*/ 28628 w 58100"/>
                    <a:gd name="connsiteY5" fmla="*/ 63861 h 63887"/>
                    <a:gd name="connsiteX6" fmla="*/ 56231 w 58100"/>
                    <a:gd name="connsiteY6" fmla="*/ 48996 h 63887"/>
                    <a:gd name="connsiteX7" fmla="*/ 53841 w 58100"/>
                    <a:gd name="connsiteY7" fmla="*/ 16003 h 63887"/>
                    <a:gd name="connsiteX8" fmla="*/ 33558 w 58100"/>
                    <a:gd name="connsiteY8" fmla="*/ 980 h 63887"/>
                    <a:gd name="connsiteX0" fmla="*/ 33558 w 57304"/>
                    <a:gd name="connsiteY0" fmla="*/ 980 h 58971"/>
                    <a:gd name="connsiteX1" fmla="*/ 4871 w 57304"/>
                    <a:gd name="connsiteY1" fmla="*/ 6321 h 58971"/>
                    <a:gd name="connsiteX2" fmla="*/ 53 w 57304"/>
                    <a:gd name="connsiteY2" fmla="*/ 28936 h 58971"/>
                    <a:gd name="connsiteX3" fmla="*/ 3228 w 57304"/>
                    <a:gd name="connsiteY3" fmla="*/ 38461 h 58971"/>
                    <a:gd name="connsiteX4" fmla="*/ 16115 w 57304"/>
                    <a:gd name="connsiteY4" fmla="*/ 52556 h 58971"/>
                    <a:gd name="connsiteX5" fmla="*/ 39386 w 57304"/>
                    <a:gd name="connsiteY5" fmla="*/ 58906 h 58971"/>
                    <a:gd name="connsiteX6" fmla="*/ 56231 w 57304"/>
                    <a:gd name="connsiteY6" fmla="*/ 48996 h 58971"/>
                    <a:gd name="connsiteX7" fmla="*/ 53841 w 57304"/>
                    <a:gd name="connsiteY7" fmla="*/ 16003 h 58971"/>
                    <a:gd name="connsiteX8" fmla="*/ 33558 w 57304"/>
                    <a:gd name="connsiteY8" fmla="*/ 980 h 5897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57304" h="58971">
                      <a:moveTo>
                        <a:pt x="33558" y="980"/>
                      </a:moveTo>
                      <a:cubicBezTo>
                        <a:pt x="25197" y="-1769"/>
                        <a:pt x="10455" y="1662"/>
                        <a:pt x="4871" y="6321"/>
                      </a:cubicBezTo>
                      <a:cubicBezTo>
                        <a:pt x="-713" y="10980"/>
                        <a:pt x="327" y="23579"/>
                        <a:pt x="53" y="28936"/>
                      </a:cubicBezTo>
                      <a:cubicBezTo>
                        <a:pt x="-221" y="34293"/>
                        <a:pt x="551" y="34524"/>
                        <a:pt x="3228" y="38461"/>
                      </a:cubicBezTo>
                      <a:cubicBezTo>
                        <a:pt x="5905" y="42398"/>
                        <a:pt x="10089" y="49149"/>
                        <a:pt x="16115" y="52556"/>
                      </a:cubicBezTo>
                      <a:cubicBezTo>
                        <a:pt x="22141" y="55963"/>
                        <a:pt x="32700" y="59499"/>
                        <a:pt x="39386" y="58906"/>
                      </a:cubicBezTo>
                      <a:cubicBezTo>
                        <a:pt x="46072" y="58313"/>
                        <a:pt x="53822" y="56146"/>
                        <a:pt x="56231" y="48996"/>
                      </a:cubicBezTo>
                      <a:cubicBezTo>
                        <a:pt x="58640" y="41846"/>
                        <a:pt x="56624" y="25657"/>
                        <a:pt x="53841" y="16003"/>
                      </a:cubicBezTo>
                      <a:cubicBezTo>
                        <a:pt x="52967" y="12289"/>
                        <a:pt x="36489" y="3423"/>
                        <a:pt x="33558" y="980"/>
                      </a:cubicBezTo>
                      <a:close/>
                    </a:path>
                  </a:pathLst>
                </a:custGeom>
                <a:solidFill>
                  <a:schemeClr val="accent2">
                    <a:lumMod val="75000"/>
                  </a:schemeClr>
                </a:solidFill>
                <a:ln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3" name="Freeform 116">
                  <a:extLst>
                    <a:ext uri="{FF2B5EF4-FFF2-40B4-BE49-F238E27FC236}">
                      <a16:creationId xmlns:a16="http://schemas.microsoft.com/office/drawing/2014/main" id="{F508F874-E8C7-4D7A-AD95-DFE824A627DF}"/>
                    </a:ext>
                  </a:extLst>
                </p:cNvPr>
                <p:cNvSpPr/>
                <p:nvPr/>
              </p:nvSpPr>
              <p:spPr>
                <a:xfrm rot="21496662" flipH="1">
                  <a:off x="6028699" y="5355140"/>
                  <a:ext cx="202990" cy="132685"/>
                </a:xfrm>
                <a:custGeom>
                  <a:avLst/>
                  <a:gdLst>
                    <a:gd name="connsiteX0" fmla="*/ 241508 w 263733"/>
                    <a:gd name="connsiteY0" fmla="*/ 15875 h 162483"/>
                    <a:gd name="connsiteX1" fmla="*/ 225633 w 263733"/>
                    <a:gd name="connsiteY1" fmla="*/ 12700 h 162483"/>
                    <a:gd name="connsiteX2" fmla="*/ 212933 w 263733"/>
                    <a:gd name="connsiteY2" fmla="*/ 6350 h 162483"/>
                    <a:gd name="connsiteX3" fmla="*/ 155783 w 263733"/>
                    <a:gd name="connsiteY3" fmla="*/ 3175 h 162483"/>
                    <a:gd name="connsiteX4" fmla="*/ 108158 w 263733"/>
                    <a:gd name="connsiteY4" fmla="*/ 6350 h 162483"/>
                    <a:gd name="connsiteX5" fmla="*/ 98633 w 263733"/>
                    <a:gd name="connsiteY5" fmla="*/ 9525 h 162483"/>
                    <a:gd name="connsiteX6" fmla="*/ 82758 w 263733"/>
                    <a:gd name="connsiteY6" fmla="*/ 6350 h 162483"/>
                    <a:gd name="connsiteX7" fmla="*/ 63708 w 263733"/>
                    <a:gd name="connsiteY7" fmla="*/ 0 h 162483"/>
                    <a:gd name="connsiteX8" fmla="*/ 28783 w 263733"/>
                    <a:gd name="connsiteY8" fmla="*/ 6350 h 162483"/>
                    <a:gd name="connsiteX9" fmla="*/ 19258 w 263733"/>
                    <a:gd name="connsiteY9" fmla="*/ 15875 h 162483"/>
                    <a:gd name="connsiteX10" fmla="*/ 9733 w 263733"/>
                    <a:gd name="connsiteY10" fmla="*/ 22225 h 162483"/>
                    <a:gd name="connsiteX11" fmla="*/ 3383 w 263733"/>
                    <a:gd name="connsiteY11" fmla="*/ 31750 h 162483"/>
                    <a:gd name="connsiteX12" fmla="*/ 3383 w 263733"/>
                    <a:gd name="connsiteY12" fmla="*/ 63500 h 162483"/>
                    <a:gd name="connsiteX13" fmla="*/ 6558 w 263733"/>
                    <a:gd name="connsiteY13" fmla="*/ 73025 h 162483"/>
                    <a:gd name="connsiteX14" fmla="*/ 16083 w 263733"/>
                    <a:gd name="connsiteY14" fmla="*/ 79375 h 162483"/>
                    <a:gd name="connsiteX15" fmla="*/ 38308 w 263733"/>
                    <a:gd name="connsiteY15" fmla="*/ 107950 h 162483"/>
                    <a:gd name="connsiteX16" fmla="*/ 44658 w 263733"/>
                    <a:gd name="connsiteY16" fmla="*/ 117475 h 162483"/>
                    <a:gd name="connsiteX17" fmla="*/ 73233 w 263733"/>
                    <a:gd name="connsiteY17" fmla="*/ 136525 h 162483"/>
                    <a:gd name="connsiteX18" fmla="*/ 82758 w 263733"/>
                    <a:gd name="connsiteY18" fmla="*/ 142875 h 162483"/>
                    <a:gd name="connsiteX19" fmla="*/ 92283 w 263733"/>
                    <a:gd name="connsiteY19" fmla="*/ 149225 h 162483"/>
                    <a:gd name="connsiteX20" fmla="*/ 130383 w 263733"/>
                    <a:gd name="connsiteY20" fmla="*/ 155575 h 162483"/>
                    <a:gd name="connsiteX21" fmla="*/ 181183 w 263733"/>
                    <a:gd name="connsiteY21" fmla="*/ 161925 h 162483"/>
                    <a:gd name="connsiteX22" fmla="*/ 200233 w 263733"/>
                    <a:gd name="connsiteY22" fmla="*/ 155575 h 162483"/>
                    <a:gd name="connsiteX23" fmla="*/ 219283 w 263733"/>
                    <a:gd name="connsiteY23" fmla="*/ 139700 h 162483"/>
                    <a:gd name="connsiteX24" fmla="*/ 228808 w 263733"/>
                    <a:gd name="connsiteY24" fmla="*/ 136525 h 162483"/>
                    <a:gd name="connsiteX25" fmla="*/ 235158 w 263733"/>
                    <a:gd name="connsiteY25" fmla="*/ 127000 h 162483"/>
                    <a:gd name="connsiteX26" fmla="*/ 244683 w 263733"/>
                    <a:gd name="connsiteY26" fmla="*/ 120650 h 162483"/>
                    <a:gd name="connsiteX27" fmla="*/ 260558 w 263733"/>
                    <a:gd name="connsiteY27" fmla="*/ 92075 h 162483"/>
                    <a:gd name="connsiteX28" fmla="*/ 263733 w 263733"/>
                    <a:gd name="connsiteY28" fmla="*/ 76200 h 162483"/>
                    <a:gd name="connsiteX29" fmla="*/ 260558 w 263733"/>
                    <a:gd name="connsiteY29" fmla="*/ 53975 h 162483"/>
                    <a:gd name="connsiteX30" fmla="*/ 257383 w 263733"/>
                    <a:gd name="connsiteY30" fmla="*/ 44450 h 162483"/>
                    <a:gd name="connsiteX31" fmla="*/ 219283 w 263733"/>
                    <a:gd name="connsiteY31" fmla="*/ 25400 h 162483"/>
                    <a:gd name="connsiteX32" fmla="*/ 241508 w 263733"/>
                    <a:gd name="connsiteY32" fmla="*/ 15875 h 162483"/>
                    <a:gd name="connsiteX0" fmla="*/ 241508 w 263733"/>
                    <a:gd name="connsiteY0" fmla="*/ 15875 h 162483"/>
                    <a:gd name="connsiteX1" fmla="*/ 225633 w 263733"/>
                    <a:gd name="connsiteY1" fmla="*/ 12700 h 162483"/>
                    <a:gd name="connsiteX2" fmla="*/ 212933 w 263733"/>
                    <a:gd name="connsiteY2" fmla="*/ 6350 h 162483"/>
                    <a:gd name="connsiteX3" fmla="*/ 155783 w 263733"/>
                    <a:gd name="connsiteY3" fmla="*/ 3175 h 162483"/>
                    <a:gd name="connsiteX4" fmla="*/ 108158 w 263733"/>
                    <a:gd name="connsiteY4" fmla="*/ 6350 h 162483"/>
                    <a:gd name="connsiteX5" fmla="*/ 98633 w 263733"/>
                    <a:gd name="connsiteY5" fmla="*/ 9525 h 162483"/>
                    <a:gd name="connsiteX6" fmla="*/ 82758 w 263733"/>
                    <a:gd name="connsiteY6" fmla="*/ 6350 h 162483"/>
                    <a:gd name="connsiteX7" fmla="*/ 63708 w 263733"/>
                    <a:gd name="connsiteY7" fmla="*/ 0 h 162483"/>
                    <a:gd name="connsiteX8" fmla="*/ 28783 w 263733"/>
                    <a:gd name="connsiteY8" fmla="*/ 6350 h 162483"/>
                    <a:gd name="connsiteX9" fmla="*/ 19258 w 263733"/>
                    <a:gd name="connsiteY9" fmla="*/ 15875 h 162483"/>
                    <a:gd name="connsiteX10" fmla="*/ 9733 w 263733"/>
                    <a:gd name="connsiteY10" fmla="*/ 22225 h 162483"/>
                    <a:gd name="connsiteX11" fmla="*/ 3383 w 263733"/>
                    <a:gd name="connsiteY11" fmla="*/ 31750 h 162483"/>
                    <a:gd name="connsiteX12" fmla="*/ 3383 w 263733"/>
                    <a:gd name="connsiteY12" fmla="*/ 63500 h 162483"/>
                    <a:gd name="connsiteX13" fmla="*/ 6558 w 263733"/>
                    <a:gd name="connsiteY13" fmla="*/ 73025 h 162483"/>
                    <a:gd name="connsiteX14" fmla="*/ 16083 w 263733"/>
                    <a:gd name="connsiteY14" fmla="*/ 79375 h 162483"/>
                    <a:gd name="connsiteX15" fmla="*/ 38308 w 263733"/>
                    <a:gd name="connsiteY15" fmla="*/ 107950 h 162483"/>
                    <a:gd name="connsiteX16" fmla="*/ 44658 w 263733"/>
                    <a:gd name="connsiteY16" fmla="*/ 117475 h 162483"/>
                    <a:gd name="connsiteX17" fmla="*/ 73233 w 263733"/>
                    <a:gd name="connsiteY17" fmla="*/ 136525 h 162483"/>
                    <a:gd name="connsiteX18" fmla="*/ 82758 w 263733"/>
                    <a:gd name="connsiteY18" fmla="*/ 142875 h 162483"/>
                    <a:gd name="connsiteX19" fmla="*/ 92283 w 263733"/>
                    <a:gd name="connsiteY19" fmla="*/ 149225 h 162483"/>
                    <a:gd name="connsiteX20" fmla="*/ 130383 w 263733"/>
                    <a:gd name="connsiteY20" fmla="*/ 155575 h 162483"/>
                    <a:gd name="connsiteX21" fmla="*/ 181183 w 263733"/>
                    <a:gd name="connsiteY21" fmla="*/ 161925 h 162483"/>
                    <a:gd name="connsiteX22" fmla="*/ 200233 w 263733"/>
                    <a:gd name="connsiteY22" fmla="*/ 155575 h 162483"/>
                    <a:gd name="connsiteX23" fmla="*/ 219283 w 263733"/>
                    <a:gd name="connsiteY23" fmla="*/ 139700 h 162483"/>
                    <a:gd name="connsiteX24" fmla="*/ 228808 w 263733"/>
                    <a:gd name="connsiteY24" fmla="*/ 136525 h 162483"/>
                    <a:gd name="connsiteX25" fmla="*/ 235158 w 263733"/>
                    <a:gd name="connsiteY25" fmla="*/ 127000 h 162483"/>
                    <a:gd name="connsiteX26" fmla="*/ 244683 w 263733"/>
                    <a:gd name="connsiteY26" fmla="*/ 120650 h 162483"/>
                    <a:gd name="connsiteX27" fmla="*/ 260558 w 263733"/>
                    <a:gd name="connsiteY27" fmla="*/ 92075 h 162483"/>
                    <a:gd name="connsiteX28" fmla="*/ 263733 w 263733"/>
                    <a:gd name="connsiteY28" fmla="*/ 76200 h 162483"/>
                    <a:gd name="connsiteX29" fmla="*/ 260558 w 263733"/>
                    <a:gd name="connsiteY29" fmla="*/ 53975 h 162483"/>
                    <a:gd name="connsiteX30" fmla="*/ 257383 w 263733"/>
                    <a:gd name="connsiteY30" fmla="*/ 44450 h 162483"/>
                    <a:gd name="connsiteX31" fmla="*/ 223293 w 263733"/>
                    <a:gd name="connsiteY31" fmla="*/ 9358 h 162483"/>
                    <a:gd name="connsiteX32" fmla="*/ 241508 w 263733"/>
                    <a:gd name="connsiteY32" fmla="*/ 15875 h 162483"/>
                    <a:gd name="connsiteX0" fmla="*/ 223293 w 263733"/>
                    <a:gd name="connsiteY0" fmla="*/ 9358 h 162483"/>
                    <a:gd name="connsiteX1" fmla="*/ 225633 w 263733"/>
                    <a:gd name="connsiteY1" fmla="*/ 12700 h 162483"/>
                    <a:gd name="connsiteX2" fmla="*/ 212933 w 263733"/>
                    <a:gd name="connsiteY2" fmla="*/ 6350 h 162483"/>
                    <a:gd name="connsiteX3" fmla="*/ 155783 w 263733"/>
                    <a:gd name="connsiteY3" fmla="*/ 3175 h 162483"/>
                    <a:gd name="connsiteX4" fmla="*/ 108158 w 263733"/>
                    <a:gd name="connsiteY4" fmla="*/ 6350 h 162483"/>
                    <a:gd name="connsiteX5" fmla="*/ 98633 w 263733"/>
                    <a:gd name="connsiteY5" fmla="*/ 9525 h 162483"/>
                    <a:gd name="connsiteX6" fmla="*/ 82758 w 263733"/>
                    <a:gd name="connsiteY6" fmla="*/ 6350 h 162483"/>
                    <a:gd name="connsiteX7" fmla="*/ 63708 w 263733"/>
                    <a:gd name="connsiteY7" fmla="*/ 0 h 162483"/>
                    <a:gd name="connsiteX8" fmla="*/ 28783 w 263733"/>
                    <a:gd name="connsiteY8" fmla="*/ 6350 h 162483"/>
                    <a:gd name="connsiteX9" fmla="*/ 19258 w 263733"/>
                    <a:gd name="connsiteY9" fmla="*/ 15875 h 162483"/>
                    <a:gd name="connsiteX10" fmla="*/ 9733 w 263733"/>
                    <a:gd name="connsiteY10" fmla="*/ 22225 h 162483"/>
                    <a:gd name="connsiteX11" fmla="*/ 3383 w 263733"/>
                    <a:gd name="connsiteY11" fmla="*/ 31750 h 162483"/>
                    <a:gd name="connsiteX12" fmla="*/ 3383 w 263733"/>
                    <a:gd name="connsiteY12" fmla="*/ 63500 h 162483"/>
                    <a:gd name="connsiteX13" fmla="*/ 6558 w 263733"/>
                    <a:gd name="connsiteY13" fmla="*/ 73025 h 162483"/>
                    <a:gd name="connsiteX14" fmla="*/ 16083 w 263733"/>
                    <a:gd name="connsiteY14" fmla="*/ 79375 h 162483"/>
                    <a:gd name="connsiteX15" fmla="*/ 38308 w 263733"/>
                    <a:gd name="connsiteY15" fmla="*/ 107950 h 162483"/>
                    <a:gd name="connsiteX16" fmla="*/ 44658 w 263733"/>
                    <a:gd name="connsiteY16" fmla="*/ 117475 h 162483"/>
                    <a:gd name="connsiteX17" fmla="*/ 73233 w 263733"/>
                    <a:gd name="connsiteY17" fmla="*/ 136525 h 162483"/>
                    <a:gd name="connsiteX18" fmla="*/ 82758 w 263733"/>
                    <a:gd name="connsiteY18" fmla="*/ 142875 h 162483"/>
                    <a:gd name="connsiteX19" fmla="*/ 92283 w 263733"/>
                    <a:gd name="connsiteY19" fmla="*/ 149225 h 162483"/>
                    <a:gd name="connsiteX20" fmla="*/ 130383 w 263733"/>
                    <a:gd name="connsiteY20" fmla="*/ 155575 h 162483"/>
                    <a:gd name="connsiteX21" fmla="*/ 181183 w 263733"/>
                    <a:gd name="connsiteY21" fmla="*/ 161925 h 162483"/>
                    <a:gd name="connsiteX22" fmla="*/ 200233 w 263733"/>
                    <a:gd name="connsiteY22" fmla="*/ 155575 h 162483"/>
                    <a:gd name="connsiteX23" fmla="*/ 219283 w 263733"/>
                    <a:gd name="connsiteY23" fmla="*/ 139700 h 162483"/>
                    <a:gd name="connsiteX24" fmla="*/ 228808 w 263733"/>
                    <a:gd name="connsiteY24" fmla="*/ 136525 h 162483"/>
                    <a:gd name="connsiteX25" fmla="*/ 235158 w 263733"/>
                    <a:gd name="connsiteY25" fmla="*/ 127000 h 162483"/>
                    <a:gd name="connsiteX26" fmla="*/ 244683 w 263733"/>
                    <a:gd name="connsiteY26" fmla="*/ 120650 h 162483"/>
                    <a:gd name="connsiteX27" fmla="*/ 260558 w 263733"/>
                    <a:gd name="connsiteY27" fmla="*/ 92075 h 162483"/>
                    <a:gd name="connsiteX28" fmla="*/ 263733 w 263733"/>
                    <a:gd name="connsiteY28" fmla="*/ 76200 h 162483"/>
                    <a:gd name="connsiteX29" fmla="*/ 260558 w 263733"/>
                    <a:gd name="connsiteY29" fmla="*/ 53975 h 162483"/>
                    <a:gd name="connsiteX30" fmla="*/ 257383 w 263733"/>
                    <a:gd name="connsiteY30" fmla="*/ 44450 h 162483"/>
                    <a:gd name="connsiteX31" fmla="*/ 223293 w 263733"/>
                    <a:gd name="connsiteY31" fmla="*/ 9358 h 162483"/>
                    <a:gd name="connsiteX0" fmla="*/ 223293 w 263733"/>
                    <a:gd name="connsiteY0" fmla="*/ 9358 h 162483"/>
                    <a:gd name="connsiteX1" fmla="*/ 225633 w 263733"/>
                    <a:gd name="connsiteY1" fmla="*/ 12700 h 162483"/>
                    <a:gd name="connsiteX2" fmla="*/ 212933 w 263733"/>
                    <a:gd name="connsiteY2" fmla="*/ 6350 h 162483"/>
                    <a:gd name="connsiteX3" fmla="*/ 155783 w 263733"/>
                    <a:gd name="connsiteY3" fmla="*/ 3175 h 162483"/>
                    <a:gd name="connsiteX4" fmla="*/ 108158 w 263733"/>
                    <a:gd name="connsiteY4" fmla="*/ 6350 h 162483"/>
                    <a:gd name="connsiteX5" fmla="*/ 98633 w 263733"/>
                    <a:gd name="connsiteY5" fmla="*/ 9525 h 162483"/>
                    <a:gd name="connsiteX6" fmla="*/ 82758 w 263733"/>
                    <a:gd name="connsiteY6" fmla="*/ 6350 h 162483"/>
                    <a:gd name="connsiteX7" fmla="*/ 63708 w 263733"/>
                    <a:gd name="connsiteY7" fmla="*/ 0 h 162483"/>
                    <a:gd name="connsiteX8" fmla="*/ 28783 w 263733"/>
                    <a:gd name="connsiteY8" fmla="*/ 6350 h 162483"/>
                    <a:gd name="connsiteX9" fmla="*/ 19258 w 263733"/>
                    <a:gd name="connsiteY9" fmla="*/ 15875 h 162483"/>
                    <a:gd name="connsiteX10" fmla="*/ 9733 w 263733"/>
                    <a:gd name="connsiteY10" fmla="*/ 22225 h 162483"/>
                    <a:gd name="connsiteX11" fmla="*/ 3383 w 263733"/>
                    <a:gd name="connsiteY11" fmla="*/ 31750 h 162483"/>
                    <a:gd name="connsiteX12" fmla="*/ 3383 w 263733"/>
                    <a:gd name="connsiteY12" fmla="*/ 63500 h 162483"/>
                    <a:gd name="connsiteX13" fmla="*/ 6558 w 263733"/>
                    <a:gd name="connsiteY13" fmla="*/ 73025 h 162483"/>
                    <a:gd name="connsiteX14" fmla="*/ 16083 w 263733"/>
                    <a:gd name="connsiteY14" fmla="*/ 79375 h 162483"/>
                    <a:gd name="connsiteX15" fmla="*/ 38308 w 263733"/>
                    <a:gd name="connsiteY15" fmla="*/ 107950 h 162483"/>
                    <a:gd name="connsiteX16" fmla="*/ 44658 w 263733"/>
                    <a:gd name="connsiteY16" fmla="*/ 117475 h 162483"/>
                    <a:gd name="connsiteX17" fmla="*/ 73233 w 263733"/>
                    <a:gd name="connsiteY17" fmla="*/ 136525 h 162483"/>
                    <a:gd name="connsiteX18" fmla="*/ 82758 w 263733"/>
                    <a:gd name="connsiteY18" fmla="*/ 142875 h 162483"/>
                    <a:gd name="connsiteX19" fmla="*/ 92283 w 263733"/>
                    <a:gd name="connsiteY19" fmla="*/ 149225 h 162483"/>
                    <a:gd name="connsiteX20" fmla="*/ 130383 w 263733"/>
                    <a:gd name="connsiteY20" fmla="*/ 155575 h 162483"/>
                    <a:gd name="connsiteX21" fmla="*/ 181183 w 263733"/>
                    <a:gd name="connsiteY21" fmla="*/ 161925 h 162483"/>
                    <a:gd name="connsiteX22" fmla="*/ 200233 w 263733"/>
                    <a:gd name="connsiteY22" fmla="*/ 155575 h 162483"/>
                    <a:gd name="connsiteX23" fmla="*/ 219283 w 263733"/>
                    <a:gd name="connsiteY23" fmla="*/ 139700 h 162483"/>
                    <a:gd name="connsiteX24" fmla="*/ 228808 w 263733"/>
                    <a:gd name="connsiteY24" fmla="*/ 136525 h 162483"/>
                    <a:gd name="connsiteX25" fmla="*/ 235158 w 263733"/>
                    <a:gd name="connsiteY25" fmla="*/ 127000 h 162483"/>
                    <a:gd name="connsiteX26" fmla="*/ 244683 w 263733"/>
                    <a:gd name="connsiteY26" fmla="*/ 120650 h 162483"/>
                    <a:gd name="connsiteX27" fmla="*/ 263733 w 263733"/>
                    <a:gd name="connsiteY27" fmla="*/ 76200 h 162483"/>
                    <a:gd name="connsiteX28" fmla="*/ 260558 w 263733"/>
                    <a:gd name="connsiteY28" fmla="*/ 53975 h 162483"/>
                    <a:gd name="connsiteX29" fmla="*/ 257383 w 263733"/>
                    <a:gd name="connsiteY29" fmla="*/ 44450 h 162483"/>
                    <a:gd name="connsiteX30" fmla="*/ 223293 w 263733"/>
                    <a:gd name="connsiteY30" fmla="*/ 9358 h 1624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</a:cxnLst>
                  <a:rect l="l" t="t" r="r" b="b"/>
                  <a:pathLst>
                    <a:path w="263733" h="162483">
                      <a:moveTo>
                        <a:pt x="223293" y="9358"/>
                      </a:moveTo>
                      <a:lnTo>
                        <a:pt x="225633" y="12700"/>
                      </a:lnTo>
                      <a:cubicBezTo>
                        <a:pt x="221143" y="11203"/>
                        <a:pt x="217623" y="6989"/>
                        <a:pt x="212933" y="6350"/>
                      </a:cubicBezTo>
                      <a:cubicBezTo>
                        <a:pt x="194029" y="3772"/>
                        <a:pt x="174833" y="4233"/>
                        <a:pt x="155783" y="3175"/>
                      </a:cubicBezTo>
                      <a:cubicBezTo>
                        <a:pt x="139908" y="4233"/>
                        <a:pt x="123971" y="4593"/>
                        <a:pt x="108158" y="6350"/>
                      </a:cubicBezTo>
                      <a:cubicBezTo>
                        <a:pt x="104832" y="6720"/>
                        <a:pt x="101980" y="9525"/>
                        <a:pt x="98633" y="9525"/>
                      </a:cubicBezTo>
                      <a:cubicBezTo>
                        <a:pt x="93237" y="9525"/>
                        <a:pt x="87964" y="7770"/>
                        <a:pt x="82758" y="6350"/>
                      </a:cubicBezTo>
                      <a:cubicBezTo>
                        <a:pt x="76300" y="4589"/>
                        <a:pt x="63708" y="0"/>
                        <a:pt x="63708" y="0"/>
                      </a:cubicBezTo>
                      <a:cubicBezTo>
                        <a:pt x="62837" y="124"/>
                        <a:pt x="33773" y="3499"/>
                        <a:pt x="28783" y="6350"/>
                      </a:cubicBezTo>
                      <a:cubicBezTo>
                        <a:pt x="24884" y="8578"/>
                        <a:pt x="22707" y="13000"/>
                        <a:pt x="19258" y="15875"/>
                      </a:cubicBezTo>
                      <a:cubicBezTo>
                        <a:pt x="16327" y="18318"/>
                        <a:pt x="12908" y="20108"/>
                        <a:pt x="9733" y="22225"/>
                      </a:cubicBezTo>
                      <a:cubicBezTo>
                        <a:pt x="7616" y="25400"/>
                        <a:pt x="5090" y="28337"/>
                        <a:pt x="3383" y="31750"/>
                      </a:cubicBezTo>
                      <a:cubicBezTo>
                        <a:pt x="-2484" y="43484"/>
                        <a:pt x="462" y="48897"/>
                        <a:pt x="3383" y="63500"/>
                      </a:cubicBezTo>
                      <a:cubicBezTo>
                        <a:pt x="4039" y="66782"/>
                        <a:pt x="4467" y="70412"/>
                        <a:pt x="6558" y="73025"/>
                      </a:cubicBezTo>
                      <a:cubicBezTo>
                        <a:pt x="8942" y="76005"/>
                        <a:pt x="12908" y="77258"/>
                        <a:pt x="16083" y="79375"/>
                      </a:cubicBezTo>
                      <a:cubicBezTo>
                        <a:pt x="48181" y="127523"/>
                        <a:pt x="13439" y="78107"/>
                        <a:pt x="38308" y="107950"/>
                      </a:cubicBezTo>
                      <a:cubicBezTo>
                        <a:pt x="40751" y="110881"/>
                        <a:pt x="41786" y="114962"/>
                        <a:pt x="44658" y="117475"/>
                      </a:cubicBezTo>
                      <a:lnTo>
                        <a:pt x="73233" y="136525"/>
                      </a:lnTo>
                      <a:lnTo>
                        <a:pt x="82758" y="142875"/>
                      </a:lnTo>
                      <a:cubicBezTo>
                        <a:pt x="85933" y="144992"/>
                        <a:pt x="88581" y="148300"/>
                        <a:pt x="92283" y="149225"/>
                      </a:cubicBezTo>
                      <a:cubicBezTo>
                        <a:pt x="113261" y="154469"/>
                        <a:pt x="100653" y="151859"/>
                        <a:pt x="130383" y="155575"/>
                      </a:cubicBezTo>
                      <a:cubicBezTo>
                        <a:pt x="149367" y="161903"/>
                        <a:pt x="151546" y="163485"/>
                        <a:pt x="181183" y="161925"/>
                      </a:cubicBezTo>
                      <a:cubicBezTo>
                        <a:pt x="187867" y="161573"/>
                        <a:pt x="200233" y="155575"/>
                        <a:pt x="200233" y="155575"/>
                      </a:cubicBezTo>
                      <a:cubicBezTo>
                        <a:pt x="207255" y="148553"/>
                        <a:pt x="210442" y="144120"/>
                        <a:pt x="219283" y="139700"/>
                      </a:cubicBezTo>
                      <a:cubicBezTo>
                        <a:pt x="222276" y="138203"/>
                        <a:pt x="225633" y="137583"/>
                        <a:pt x="228808" y="136525"/>
                      </a:cubicBezTo>
                      <a:cubicBezTo>
                        <a:pt x="230925" y="133350"/>
                        <a:pt x="232460" y="129698"/>
                        <a:pt x="235158" y="127000"/>
                      </a:cubicBezTo>
                      <a:cubicBezTo>
                        <a:pt x="237856" y="124302"/>
                        <a:pt x="239920" y="129117"/>
                        <a:pt x="244683" y="120650"/>
                      </a:cubicBezTo>
                      <a:cubicBezTo>
                        <a:pt x="249446" y="112183"/>
                        <a:pt x="261087" y="87313"/>
                        <a:pt x="263733" y="76200"/>
                      </a:cubicBezTo>
                      <a:cubicBezTo>
                        <a:pt x="262675" y="68792"/>
                        <a:pt x="262026" y="61313"/>
                        <a:pt x="260558" y="53975"/>
                      </a:cubicBezTo>
                      <a:cubicBezTo>
                        <a:pt x="259902" y="50693"/>
                        <a:pt x="259750" y="46817"/>
                        <a:pt x="257383" y="44450"/>
                      </a:cubicBezTo>
                      <a:cubicBezTo>
                        <a:pt x="250962" y="38029"/>
                        <a:pt x="233622" y="9358"/>
                        <a:pt x="223293" y="9358"/>
                      </a:cubicBezTo>
                      <a:close/>
                    </a:path>
                  </a:pathLst>
                </a:custGeom>
                <a:solidFill>
                  <a:schemeClr val="accent2">
                    <a:lumMod val="75000"/>
                  </a:schemeClr>
                </a:solidFill>
                <a:ln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A6101628-9712-4882-AC54-EC54AE0C3FA5}"/>
                    </a:ext>
                  </a:extLst>
                </p:cNvPr>
                <p:cNvSpPr txBox="1"/>
                <p:nvPr/>
              </p:nvSpPr>
              <p:spPr>
                <a:xfrm>
                  <a:off x="6953331" y="4835981"/>
                  <a:ext cx="1626233" cy="7433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900" b="1" dirty="0">
                      <a:cs typeface="Arial" panose="020B0604020202020204" pitchFamily="34" charset="0"/>
                    </a:rPr>
                    <a:t>Mesenteric </a:t>
                  </a:r>
                </a:p>
                <a:p>
                  <a:pPr algn="ctr"/>
                  <a:r>
                    <a:rPr lang="en-GB" sz="900" b="1" dirty="0">
                      <a:cs typeface="Arial" panose="020B0604020202020204" pitchFamily="34" charset="0"/>
                    </a:rPr>
                    <a:t>lymph nodes (MLN)</a:t>
                  </a:r>
                </a:p>
              </p:txBody>
            </p:sp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F440DE8F-EEDE-48DC-974C-F8A93A747544}"/>
                    </a:ext>
                  </a:extLst>
                </p:cNvPr>
                <p:cNvGrpSpPr/>
                <p:nvPr/>
              </p:nvGrpSpPr>
              <p:grpSpPr>
                <a:xfrm rot="21271848">
                  <a:off x="6232158" y="4980573"/>
                  <a:ext cx="694514" cy="304082"/>
                  <a:chOff x="6231865" y="4979479"/>
                  <a:chExt cx="694514" cy="304082"/>
                </a:xfrm>
              </p:grpSpPr>
              <p:sp>
                <p:nvSpPr>
                  <p:cNvPr id="56" name="Freeform 119">
                    <a:extLst>
                      <a:ext uri="{FF2B5EF4-FFF2-40B4-BE49-F238E27FC236}">
                        <a16:creationId xmlns:a16="http://schemas.microsoft.com/office/drawing/2014/main" id="{7971AF19-CB4B-4578-924A-3E5EF4939910}"/>
                      </a:ext>
                    </a:extLst>
                  </p:cNvPr>
                  <p:cNvSpPr/>
                  <p:nvPr/>
                </p:nvSpPr>
                <p:spPr>
                  <a:xfrm rot="1137745" flipH="1">
                    <a:off x="6685091" y="5033201"/>
                    <a:ext cx="111622" cy="89367"/>
                  </a:xfrm>
                  <a:custGeom>
                    <a:avLst/>
                    <a:gdLst>
                      <a:gd name="connsiteX0" fmla="*/ 44450 w 77689"/>
                      <a:gd name="connsiteY0" fmla="*/ 619 h 73820"/>
                      <a:gd name="connsiteX1" fmla="*/ 28575 w 77689"/>
                      <a:gd name="connsiteY1" fmla="*/ 3794 h 73820"/>
                      <a:gd name="connsiteX2" fmla="*/ 9525 w 77689"/>
                      <a:gd name="connsiteY2" fmla="*/ 10144 h 73820"/>
                      <a:gd name="connsiteX3" fmla="*/ 0 w 77689"/>
                      <a:gd name="connsiteY3" fmla="*/ 29194 h 73820"/>
                      <a:gd name="connsiteX4" fmla="*/ 3175 w 77689"/>
                      <a:gd name="connsiteY4" fmla="*/ 45069 h 73820"/>
                      <a:gd name="connsiteX5" fmla="*/ 9525 w 77689"/>
                      <a:gd name="connsiteY5" fmla="*/ 54594 h 73820"/>
                      <a:gd name="connsiteX6" fmla="*/ 28575 w 77689"/>
                      <a:gd name="connsiteY6" fmla="*/ 67294 h 73820"/>
                      <a:gd name="connsiteX7" fmla="*/ 47625 w 77689"/>
                      <a:gd name="connsiteY7" fmla="*/ 73644 h 73820"/>
                      <a:gd name="connsiteX8" fmla="*/ 76200 w 77689"/>
                      <a:gd name="connsiteY8" fmla="*/ 70469 h 73820"/>
                      <a:gd name="connsiteX9" fmla="*/ 73025 w 77689"/>
                      <a:gd name="connsiteY9" fmla="*/ 54594 h 73820"/>
                      <a:gd name="connsiteX10" fmla="*/ 63500 w 77689"/>
                      <a:gd name="connsiteY10" fmla="*/ 32369 h 73820"/>
                      <a:gd name="connsiteX11" fmla="*/ 53975 w 77689"/>
                      <a:gd name="connsiteY11" fmla="*/ 26019 h 73820"/>
                      <a:gd name="connsiteX12" fmla="*/ 47625 w 77689"/>
                      <a:gd name="connsiteY12" fmla="*/ 16494 h 73820"/>
                      <a:gd name="connsiteX13" fmla="*/ 44450 w 77689"/>
                      <a:gd name="connsiteY13" fmla="*/ 619 h 73820"/>
                      <a:gd name="connsiteX0" fmla="*/ 44450 w 77689"/>
                      <a:gd name="connsiteY0" fmla="*/ 619 h 73820"/>
                      <a:gd name="connsiteX1" fmla="*/ 28575 w 77689"/>
                      <a:gd name="connsiteY1" fmla="*/ 3794 h 73820"/>
                      <a:gd name="connsiteX2" fmla="*/ 9525 w 77689"/>
                      <a:gd name="connsiteY2" fmla="*/ 10144 h 73820"/>
                      <a:gd name="connsiteX3" fmla="*/ 0 w 77689"/>
                      <a:gd name="connsiteY3" fmla="*/ 29194 h 73820"/>
                      <a:gd name="connsiteX4" fmla="*/ 3175 w 77689"/>
                      <a:gd name="connsiteY4" fmla="*/ 45069 h 73820"/>
                      <a:gd name="connsiteX5" fmla="*/ 9525 w 77689"/>
                      <a:gd name="connsiteY5" fmla="*/ 54594 h 73820"/>
                      <a:gd name="connsiteX6" fmla="*/ 28575 w 77689"/>
                      <a:gd name="connsiteY6" fmla="*/ 67294 h 73820"/>
                      <a:gd name="connsiteX7" fmla="*/ 47625 w 77689"/>
                      <a:gd name="connsiteY7" fmla="*/ 73644 h 73820"/>
                      <a:gd name="connsiteX8" fmla="*/ 76200 w 77689"/>
                      <a:gd name="connsiteY8" fmla="*/ 70469 h 73820"/>
                      <a:gd name="connsiteX9" fmla="*/ 73025 w 77689"/>
                      <a:gd name="connsiteY9" fmla="*/ 54594 h 73820"/>
                      <a:gd name="connsiteX10" fmla="*/ 63500 w 77689"/>
                      <a:gd name="connsiteY10" fmla="*/ 32369 h 73820"/>
                      <a:gd name="connsiteX11" fmla="*/ 53975 w 77689"/>
                      <a:gd name="connsiteY11" fmla="*/ 26019 h 73820"/>
                      <a:gd name="connsiteX12" fmla="*/ 44450 w 77689"/>
                      <a:gd name="connsiteY12" fmla="*/ 619 h 73820"/>
                      <a:gd name="connsiteX0" fmla="*/ 44450 w 78122"/>
                      <a:gd name="connsiteY0" fmla="*/ 619 h 73820"/>
                      <a:gd name="connsiteX1" fmla="*/ 28575 w 78122"/>
                      <a:gd name="connsiteY1" fmla="*/ 3794 h 73820"/>
                      <a:gd name="connsiteX2" fmla="*/ 9525 w 78122"/>
                      <a:gd name="connsiteY2" fmla="*/ 10144 h 73820"/>
                      <a:gd name="connsiteX3" fmla="*/ 0 w 78122"/>
                      <a:gd name="connsiteY3" fmla="*/ 29194 h 73820"/>
                      <a:gd name="connsiteX4" fmla="*/ 3175 w 78122"/>
                      <a:gd name="connsiteY4" fmla="*/ 45069 h 73820"/>
                      <a:gd name="connsiteX5" fmla="*/ 9525 w 78122"/>
                      <a:gd name="connsiteY5" fmla="*/ 54594 h 73820"/>
                      <a:gd name="connsiteX6" fmla="*/ 28575 w 78122"/>
                      <a:gd name="connsiteY6" fmla="*/ 67294 h 73820"/>
                      <a:gd name="connsiteX7" fmla="*/ 47625 w 78122"/>
                      <a:gd name="connsiteY7" fmla="*/ 73644 h 73820"/>
                      <a:gd name="connsiteX8" fmla="*/ 76200 w 78122"/>
                      <a:gd name="connsiteY8" fmla="*/ 70469 h 73820"/>
                      <a:gd name="connsiteX9" fmla="*/ 73025 w 78122"/>
                      <a:gd name="connsiteY9" fmla="*/ 54594 h 73820"/>
                      <a:gd name="connsiteX10" fmla="*/ 53975 w 78122"/>
                      <a:gd name="connsiteY10" fmla="*/ 26019 h 73820"/>
                      <a:gd name="connsiteX11" fmla="*/ 44450 w 78122"/>
                      <a:gd name="connsiteY11" fmla="*/ 619 h 73820"/>
                      <a:gd name="connsiteX0" fmla="*/ 44450 w 77670"/>
                      <a:gd name="connsiteY0" fmla="*/ 852 h 74053"/>
                      <a:gd name="connsiteX1" fmla="*/ 28575 w 77670"/>
                      <a:gd name="connsiteY1" fmla="*/ 4027 h 74053"/>
                      <a:gd name="connsiteX2" fmla="*/ 9525 w 77670"/>
                      <a:gd name="connsiteY2" fmla="*/ 10377 h 74053"/>
                      <a:gd name="connsiteX3" fmla="*/ 0 w 77670"/>
                      <a:gd name="connsiteY3" fmla="*/ 29427 h 74053"/>
                      <a:gd name="connsiteX4" fmla="*/ 3175 w 77670"/>
                      <a:gd name="connsiteY4" fmla="*/ 45302 h 74053"/>
                      <a:gd name="connsiteX5" fmla="*/ 9525 w 77670"/>
                      <a:gd name="connsiteY5" fmla="*/ 54827 h 74053"/>
                      <a:gd name="connsiteX6" fmla="*/ 28575 w 77670"/>
                      <a:gd name="connsiteY6" fmla="*/ 67527 h 74053"/>
                      <a:gd name="connsiteX7" fmla="*/ 47625 w 77670"/>
                      <a:gd name="connsiteY7" fmla="*/ 73877 h 74053"/>
                      <a:gd name="connsiteX8" fmla="*/ 76200 w 77670"/>
                      <a:gd name="connsiteY8" fmla="*/ 70702 h 74053"/>
                      <a:gd name="connsiteX9" fmla="*/ 73025 w 77670"/>
                      <a:gd name="connsiteY9" fmla="*/ 54827 h 74053"/>
                      <a:gd name="connsiteX10" fmla="*/ 70018 w 77670"/>
                      <a:gd name="connsiteY10" fmla="*/ 20237 h 74053"/>
                      <a:gd name="connsiteX11" fmla="*/ 44450 w 77670"/>
                      <a:gd name="connsiteY11" fmla="*/ 852 h 74053"/>
                      <a:gd name="connsiteX0" fmla="*/ 44450 w 91155"/>
                      <a:gd name="connsiteY0" fmla="*/ 852 h 73877"/>
                      <a:gd name="connsiteX1" fmla="*/ 28575 w 91155"/>
                      <a:gd name="connsiteY1" fmla="*/ 4027 h 73877"/>
                      <a:gd name="connsiteX2" fmla="*/ 9525 w 91155"/>
                      <a:gd name="connsiteY2" fmla="*/ 10377 h 73877"/>
                      <a:gd name="connsiteX3" fmla="*/ 0 w 91155"/>
                      <a:gd name="connsiteY3" fmla="*/ 29427 h 73877"/>
                      <a:gd name="connsiteX4" fmla="*/ 3175 w 91155"/>
                      <a:gd name="connsiteY4" fmla="*/ 45302 h 73877"/>
                      <a:gd name="connsiteX5" fmla="*/ 9525 w 91155"/>
                      <a:gd name="connsiteY5" fmla="*/ 54827 h 73877"/>
                      <a:gd name="connsiteX6" fmla="*/ 28575 w 91155"/>
                      <a:gd name="connsiteY6" fmla="*/ 67527 h 73877"/>
                      <a:gd name="connsiteX7" fmla="*/ 47625 w 91155"/>
                      <a:gd name="connsiteY7" fmla="*/ 73877 h 73877"/>
                      <a:gd name="connsiteX8" fmla="*/ 76200 w 91155"/>
                      <a:gd name="connsiteY8" fmla="*/ 70702 h 73877"/>
                      <a:gd name="connsiteX9" fmla="*/ 91072 w 91155"/>
                      <a:gd name="connsiteY9" fmla="*/ 58838 h 73877"/>
                      <a:gd name="connsiteX10" fmla="*/ 70018 w 91155"/>
                      <a:gd name="connsiteY10" fmla="*/ 20237 h 73877"/>
                      <a:gd name="connsiteX11" fmla="*/ 44450 w 91155"/>
                      <a:gd name="connsiteY11" fmla="*/ 852 h 73877"/>
                      <a:gd name="connsiteX0" fmla="*/ 68514 w 91155"/>
                      <a:gd name="connsiteY0" fmla="*/ 8876 h 69869"/>
                      <a:gd name="connsiteX1" fmla="*/ 28575 w 91155"/>
                      <a:gd name="connsiteY1" fmla="*/ 19 h 69869"/>
                      <a:gd name="connsiteX2" fmla="*/ 9525 w 91155"/>
                      <a:gd name="connsiteY2" fmla="*/ 6369 h 69869"/>
                      <a:gd name="connsiteX3" fmla="*/ 0 w 91155"/>
                      <a:gd name="connsiteY3" fmla="*/ 25419 h 69869"/>
                      <a:gd name="connsiteX4" fmla="*/ 3175 w 91155"/>
                      <a:gd name="connsiteY4" fmla="*/ 41294 h 69869"/>
                      <a:gd name="connsiteX5" fmla="*/ 9525 w 91155"/>
                      <a:gd name="connsiteY5" fmla="*/ 50819 h 69869"/>
                      <a:gd name="connsiteX6" fmla="*/ 28575 w 91155"/>
                      <a:gd name="connsiteY6" fmla="*/ 63519 h 69869"/>
                      <a:gd name="connsiteX7" fmla="*/ 47625 w 91155"/>
                      <a:gd name="connsiteY7" fmla="*/ 69869 h 69869"/>
                      <a:gd name="connsiteX8" fmla="*/ 76200 w 91155"/>
                      <a:gd name="connsiteY8" fmla="*/ 66694 h 69869"/>
                      <a:gd name="connsiteX9" fmla="*/ 91072 w 91155"/>
                      <a:gd name="connsiteY9" fmla="*/ 54830 h 69869"/>
                      <a:gd name="connsiteX10" fmla="*/ 70018 w 91155"/>
                      <a:gd name="connsiteY10" fmla="*/ 16229 h 69869"/>
                      <a:gd name="connsiteX11" fmla="*/ 68514 w 91155"/>
                      <a:gd name="connsiteY11" fmla="*/ 8876 h 69869"/>
                      <a:gd name="connsiteX0" fmla="*/ 68514 w 93148"/>
                      <a:gd name="connsiteY0" fmla="*/ 8876 h 69869"/>
                      <a:gd name="connsiteX1" fmla="*/ 28575 w 93148"/>
                      <a:gd name="connsiteY1" fmla="*/ 19 h 69869"/>
                      <a:gd name="connsiteX2" fmla="*/ 9525 w 93148"/>
                      <a:gd name="connsiteY2" fmla="*/ 6369 h 69869"/>
                      <a:gd name="connsiteX3" fmla="*/ 0 w 93148"/>
                      <a:gd name="connsiteY3" fmla="*/ 25419 h 69869"/>
                      <a:gd name="connsiteX4" fmla="*/ 3175 w 93148"/>
                      <a:gd name="connsiteY4" fmla="*/ 41294 h 69869"/>
                      <a:gd name="connsiteX5" fmla="*/ 9525 w 93148"/>
                      <a:gd name="connsiteY5" fmla="*/ 50819 h 69869"/>
                      <a:gd name="connsiteX6" fmla="*/ 28575 w 93148"/>
                      <a:gd name="connsiteY6" fmla="*/ 63519 h 69869"/>
                      <a:gd name="connsiteX7" fmla="*/ 47625 w 93148"/>
                      <a:gd name="connsiteY7" fmla="*/ 69869 h 69869"/>
                      <a:gd name="connsiteX8" fmla="*/ 76200 w 93148"/>
                      <a:gd name="connsiteY8" fmla="*/ 66694 h 69869"/>
                      <a:gd name="connsiteX9" fmla="*/ 93077 w 93148"/>
                      <a:gd name="connsiteY9" fmla="*/ 44804 h 69869"/>
                      <a:gd name="connsiteX10" fmla="*/ 70018 w 93148"/>
                      <a:gd name="connsiteY10" fmla="*/ 16229 h 69869"/>
                      <a:gd name="connsiteX11" fmla="*/ 68514 w 93148"/>
                      <a:gd name="connsiteY11" fmla="*/ 8876 h 69869"/>
                      <a:gd name="connsiteX0" fmla="*/ 70018 w 93148"/>
                      <a:gd name="connsiteY0" fmla="*/ 16432 h 70072"/>
                      <a:gd name="connsiteX1" fmla="*/ 28575 w 93148"/>
                      <a:gd name="connsiteY1" fmla="*/ 222 h 70072"/>
                      <a:gd name="connsiteX2" fmla="*/ 9525 w 93148"/>
                      <a:gd name="connsiteY2" fmla="*/ 6572 h 70072"/>
                      <a:gd name="connsiteX3" fmla="*/ 0 w 93148"/>
                      <a:gd name="connsiteY3" fmla="*/ 25622 h 70072"/>
                      <a:gd name="connsiteX4" fmla="*/ 3175 w 93148"/>
                      <a:gd name="connsiteY4" fmla="*/ 41497 h 70072"/>
                      <a:gd name="connsiteX5" fmla="*/ 9525 w 93148"/>
                      <a:gd name="connsiteY5" fmla="*/ 51022 h 70072"/>
                      <a:gd name="connsiteX6" fmla="*/ 28575 w 93148"/>
                      <a:gd name="connsiteY6" fmla="*/ 63722 h 70072"/>
                      <a:gd name="connsiteX7" fmla="*/ 47625 w 93148"/>
                      <a:gd name="connsiteY7" fmla="*/ 70072 h 70072"/>
                      <a:gd name="connsiteX8" fmla="*/ 76200 w 93148"/>
                      <a:gd name="connsiteY8" fmla="*/ 66897 h 70072"/>
                      <a:gd name="connsiteX9" fmla="*/ 93077 w 93148"/>
                      <a:gd name="connsiteY9" fmla="*/ 45007 h 70072"/>
                      <a:gd name="connsiteX10" fmla="*/ 70018 w 93148"/>
                      <a:gd name="connsiteY10" fmla="*/ 16432 h 70072"/>
                      <a:gd name="connsiteX0" fmla="*/ 70018 w 93148"/>
                      <a:gd name="connsiteY0" fmla="*/ 12422 h 66062"/>
                      <a:gd name="connsiteX1" fmla="*/ 45944 w 93148"/>
                      <a:gd name="connsiteY1" fmla="*/ 1246 h 66062"/>
                      <a:gd name="connsiteX2" fmla="*/ 9525 w 93148"/>
                      <a:gd name="connsiteY2" fmla="*/ 2562 h 66062"/>
                      <a:gd name="connsiteX3" fmla="*/ 0 w 93148"/>
                      <a:gd name="connsiteY3" fmla="*/ 21612 h 66062"/>
                      <a:gd name="connsiteX4" fmla="*/ 3175 w 93148"/>
                      <a:gd name="connsiteY4" fmla="*/ 37487 h 66062"/>
                      <a:gd name="connsiteX5" fmla="*/ 9525 w 93148"/>
                      <a:gd name="connsiteY5" fmla="*/ 47012 h 66062"/>
                      <a:gd name="connsiteX6" fmla="*/ 28575 w 93148"/>
                      <a:gd name="connsiteY6" fmla="*/ 59712 h 66062"/>
                      <a:gd name="connsiteX7" fmla="*/ 47625 w 93148"/>
                      <a:gd name="connsiteY7" fmla="*/ 66062 h 66062"/>
                      <a:gd name="connsiteX8" fmla="*/ 76200 w 93148"/>
                      <a:gd name="connsiteY8" fmla="*/ 62887 h 66062"/>
                      <a:gd name="connsiteX9" fmla="*/ 93077 w 93148"/>
                      <a:gd name="connsiteY9" fmla="*/ 40997 h 66062"/>
                      <a:gd name="connsiteX10" fmla="*/ 70018 w 93148"/>
                      <a:gd name="connsiteY10" fmla="*/ 12422 h 6606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</a:cxnLst>
                    <a:rect l="l" t="t" r="r" b="b"/>
                    <a:pathLst>
                      <a:path w="93148" h="66062">
                        <a:moveTo>
                          <a:pt x="70018" y="12422"/>
                        </a:moveTo>
                        <a:cubicBezTo>
                          <a:pt x="59268" y="4958"/>
                          <a:pt x="56026" y="2889"/>
                          <a:pt x="45944" y="1246"/>
                        </a:cubicBezTo>
                        <a:cubicBezTo>
                          <a:pt x="35862" y="-397"/>
                          <a:pt x="17182" y="-832"/>
                          <a:pt x="9525" y="2562"/>
                        </a:cubicBezTo>
                        <a:cubicBezTo>
                          <a:pt x="1868" y="5956"/>
                          <a:pt x="0" y="15039"/>
                          <a:pt x="0" y="21612"/>
                        </a:cubicBezTo>
                        <a:cubicBezTo>
                          <a:pt x="0" y="27008"/>
                          <a:pt x="1280" y="32434"/>
                          <a:pt x="3175" y="37487"/>
                        </a:cubicBezTo>
                        <a:cubicBezTo>
                          <a:pt x="4515" y="41060"/>
                          <a:pt x="6653" y="44499"/>
                          <a:pt x="9525" y="47012"/>
                        </a:cubicBezTo>
                        <a:cubicBezTo>
                          <a:pt x="15268" y="52038"/>
                          <a:pt x="21335" y="57299"/>
                          <a:pt x="28575" y="59712"/>
                        </a:cubicBezTo>
                        <a:lnTo>
                          <a:pt x="47625" y="66062"/>
                        </a:lnTo>
                        <a:cubicBezTo>
                          <a:pt x="57150" y="65004"/>
                          <a:pt x="68625" y="67064"/>
                          <a:pt x="76200" y="62887"/>
                        </a:cubicBezTo>
                        <a:cubicBezTo>
                          <a:pt x="83775" y="58710"/>
                          <a:pt x="94107" y="49408"/>
                          <a:pt x="93077" y="40997"/>
                        </a:cubicBezTo>
                        <a:cubicBezTo>
                          <a:pt x="92047" y="32586"/>
                          <a:pt x="74780" y="21418"/>
                          <a:pt x="70018" y="12422"/>
                        </a:cubicBezTo>
                        <a:close/>
                      </a:path>
                    </a:pathLst>
                  </a:custGeom>
                  <a:solidFill>
                    <a:srgbClr val="8FAADC"/>
                  </a:solidFill>
                  <a:ln>
                    <a:solidFill>
                      <a:schemeClr val="accent5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7" name="Freeform 120">
                    <a:extLst>
                      <a:ext uri="{FF2B5EF4-FFF2-40B4-BE49-F238E27FC236}">
                        <a16:creationId xmlns:a16="http://schemas.microsoft.com/office/drawing/2014/main" id="{FDA7D390-FBB5-4135-8218-D12BAA8E696A}"/>
                      </a:ext>
                    </a:extLst>
                  </p:cNvPr>
                  <p:cNvSpPr/>
                  <p:nvPr/>
                </p:nvSpPr>
                <p:spPr>
                  <a:xfrm rot="6615057" flipH="1">
                    <a:off x="6574664" y="5059770"/>
                    <a:ext cx="96643" cy="124768"/>
                  </a:xfrm>
                  <a:custGeom>
                    <a:avLst/>
                    <a:gdLst>
                      <a:gd name="connsiteX0" fmla="*/ 95250 w 133569"/>
                      <a:gd name="connsiteY0" fmla="*/ 37 h 69887"/>
                      <a:gd name="connsiteX1" fmla="*/ 66675 w 133569"/>
                      <a:gd name="connsiteY1" fmla="*/ 6387 h 69887"/>
                      <a:gd name="connsiteX2" fmla="*/ 57150 w 133569"/>
                      <a:gd name="connsiteY2" fmla="*/ 12737 h 69887"/>
                      <a:gd name="connsiteX3" fmla="*/ 38100 w 133569"/>
                      <a:gd name="connsiteY3" fmla="*/ 19087 h 69887"/>
                      <a:gd name="connsiteX4" fmla="*/ 28575 w 133569"/>
                      <a:gd name="connsiteY4" fmla="*/ 22262 h 69887"/>
                      <a:gd name="connsiteX5" fmla="*/ 9525 w 133569"/>
                      <a:gd name="connsiteY5" fmla="*/ 31787 h 69887"/>
                      <a:gd name="connsiteX6" fmla="*/ 0 w 133569"/>
                      <a:gd name="connsiteY6" fmla="*/ 50837 h 69887"/>
                      <a:gd name="connsiteX7" fmla="*/ 3175 w 133569"/>
                      <a:gd name="connsiteY7" fmla="*/ 60362 h 69887"/>
                      <a:gd name="connsiteX8" fmla="*/ 22225 w 133569"/>
                      <a:gd name="connsiteY8" fmla="*/ 66712 h 69887"/>
                      <a:gd name="connsiteX9" fmla="*/ 31750 w 133569"/>
                      <a:gd name="connsiteY9" fmla="*/ 69887 h 69887"/>
                      <a:gd name="connsiteX10" fmla="*/ 92075 w 133569"/>
                      <a:gd name="connsiteY10" fmla="*/ 66712 h 69887"/>
                      <a:gd name="connsiteX11" fmla="*/ 101600 w 133569"/>
                      <a:gd name="connsiteY11" fmla="*/ 60362 h 69887"/>
                      <a:gd name="connsiteX12" fmla="*/ 120650 w 133569"/>
                      <a:gd name="connsiteY12" fmla="*/ 50837 h 69887"/>
                      <a:gd name="connsiteX13" fmla="*/ 133350 w 133569"/>
                      <a:gd name="connsiteY13" fmla="*/ 31787 h 69887"/>
                      <a:gd name="connsiteX14" fmla="*/ 123825 w 133569"/>
                      <a:gd name="connsiteY14" fmla="*/ 9562 h 69887"/>
                      <a:gd name="connsiteX15" fmla="*/ 95250 w 133569"/>
                      <a:gd name="connsiteY15" fmla="*/ 37 h 69887"/>
                      <a:gd name="connsiteX0" fmla="*/ 95250 w 133569"/>
                      <a:gd name="connsiteY0" fmla="*/ 37 h 69887"/>
                      <a:gd name="connsiteX1" fmla="*/ 66675 w 133569"/>
                      <a:gd name="connsiteY1" fmla="*/ 6387 h 69887"/>
                      <a:gd name="connsiteX2" fmla="*/ 57150 w 133569"/>
                      <a:gd name="connsiteY2" fmla="*/ 12737 h 69887"/>
                      <a:gd name="connsiteX3" fmla="*/ 38100 w 133569"/>
                      <a:gd name="connsiteY3" fmla="*/ 19087 h 69887"/>
                      <a:gd name="connsiteX4" fmla="*/ 28575 w 133569"/>
                      <a:gd name="connsiteY4" fmla="*/ 22262 h 69887"/>
                      <a:gd name="connsiteX5" fmla="*/ 9525 w 133569"/>
                      <a:gd name="connsiteY5" fmla="*/ 31787 h 69887"/>
                      <a:gd name="connsiteX6" fmla="*/ 0 w 133569"/>
                      <a:gd name="connsiteY6" fmla="*/ 50837 h 69887"/>
                      <a:gd name="connsiteX7" fmla="*/ 3175 w 133569"/>
                      <a:gd name="connsiteY7" fmla="*/ 60362 h 69887"/>
                      <a:gd name="connsiteX8" fmla="*/ 22225 w 133569"/>
                      <a:gd name="connsiteY8" fmla="*/ 66712 h 69887"/>
                      <a:gd name="connsiteX9" fmla="*/ 31750 w 133569"/>
                      <a:gd name="connsiteY9" fmla="*/ 69887 h 69887"/>
                      <a:gd name="connsiteX10" fmla="*/ 92075 w 133569"/>
                      <a:gd name="connsiteY10" fmla="*/ 66712 h 69887"/>
                      <a:gd name="connsiteX11" fmla="*/ 107971 w 133569"/>
                      <a:gd name="connsiteY11" fmla="*/ 60875 h 69887"/>
                      <a:gd name="connsiteX12" fmla="*/ 120650 w 133569"/>
                      <a:gd name="connsiteY12" fmla="*/ 50837 h 69887"/>
                      <a:gd name="connsiteX13" fmla="*/ 133350 w 133569"/>
                      <a:gd name="connsiteY13" fmla="*/ 31787 h 69887"/>
                      <a:gd name="connsiteX14" fmla="*/ 123825 w 133569"/>
                      <a:gd name="connsiteY14" fmla="*/ 9562 h 69887"/>
                      <a:gd name="connsiteX15" fmla="*/ 95250 w 133569"/>
                      <a:gd name="connsiteY15" fmla="*/ 37 h 69887"/>
                      <a:gd name="connsiteX0" fmla="*/ 95250 w 133569"/>
                      <a:gd name="connsiteY0" fmla="*/ 37 h 70851"/>
                      <a:gd name="connsiteX1" fmla="*/ 66675 w 133569"/>
                      <a:gd name="connsiteY1" fmla="*/ 6387 h 70851"/>
                      <a:gd name="connsiteX2" fmla="*/ 57150 w 133569"/>
                      <a:gd name="connsiteY2" fmla="*/ 12737 h 70851"/>
                      <a:gd name="connsiteX3" fmla="*/ 38100 w 133569"/>
                      <a:gd name="connsiteY3" fmla="*/ 19087 h 70851"/>
                      <a:gd name="connsiteX4" fmla="*/ 28575 w 133569"/>
                      <a:gd name="connsiteY4" fmla="*/ 22262 h 70851"/>
                      <a:gd name="connsiteX5" fmla="*/ 9525 w 133569"/>
                      <a:gd name="connsiteY5" fmla="*/ 31787 h 70851"/>
                      <a:gd name="connsiteX6" fmla="*/ 0 w 133569"/>
                      <a:gd name="connsiteY6" fmla="*/ 50837 h 70851"/>
                      <a:gd name="connsiteX7" fmla="*/ 3175 w 133569"/>
                      <a:gd name="connsiteY7" fmla="*/ 60362 h 70851"/>
                      <a:gd name="connsiteX8" fmla="*/ 22225 w 133569"/>
                      <a:gd name="connsiteY8" fmla="*/ 66712 h 70851"/>
                      <a:gd name="connsiteX9" fmla="*/ 31750 w 133569"/>
                      <a:gd name="connsiteY9" fmla="*/ 69887 h 70851"/>
                      <a:gd name="connsiteX10" fmla="*/ 67243 w 133569"/>
                      <a:gd name="connsiteY10" fmla="*/ 70113 h 70851"/>
                      <a:gd name="connsiteX11" fmla="*/ 107971 w 133569"/>
                      <a:gd name="connsiteY11" fmla="*/ 60875 h 70851"/>
                      <a:gd name="connsiteX12" fmla="*/ 120650 w 133569"/>
                      <a:gd name="connsiteY12" fmla="*/ 50837 h 70851"/>
                      <a:gd name="connsiteX13" fmla="*/ 133350 w 133569"/>
                      <a:gd name="connsiteY13" fmla="*/ 31787 h 70851"/>
                      <a:gd name="connsiteX14" fmla="*/ 123825 w 133569"/>
                      <a:gd name="connsiteY14" fmla="*/ 9562 h 70851"/>
                      <a:gd name="connsiteX15" fmla="*/ 95250 w 133569"/>
                      <a:gd name="connsiteY15" fmla="*/ 37 h 70851"/>
                      <a:gd name="connsiteX0" fmla="*/ 95250 w 133569"/>
                      <a:gd name="connsiteY0" fmla="*/ 37 h 70869"/>
                      <a:gd name="connsiteX1" fmla="*/ 66675 w 133569"/>
                      <a:gd name="connsiteY1" fmla="*/ 6387 h 70869"/>
                      <a:gd name="connsiteX2" fmla="*/ 57150 w 133569"/>
                      <a:gd name="connsiteY2" fmla="*/ 12737 h 70869"/>
                      <a:gd name="connsiteX3" fmla="*/ 38100 w 133569"/>
                      <a:gd name="connsiteY3" fmla="*/ 19087 h 70869"/>
                      <a:gd name="connsiteX4" fmla="*/ 28575 w 133569"/>
                      <a:gd name="connsiteY4" fmla="*/ 22262 h 70869"/>
                      <a:gd name="connsiteX5" fmla="*/ 9525 w 133569"/>
                      <a:gd name="connsiteY5" fmla="*/ 31787 h 70869"/>
                      <a:gd name="connsiteX6" fmla="*/ 0 w 133569"/>
                      <a:gd name="connsiteY6" fmla="*/ 50837 h 70869"/>
                      <a:gd name="connsiteX7" fmla="*/ 3175 w 133569"/>
                      <a:gd name="connsiteY7" fmla="*/ 60362 h 70869"/>
                      <a:gd name="connsiteX8" fmla="*/ 22225 w 133569"/>
                      <a:gd name="connsiteY8" fmla="*/ 66712 h 70869"/>
                      <a:gd name="connsiteX9" fmla="*/ 31750 w 133569"/>
                      <a:gd name="connsiteY9" fmla="*/ 69887 h 70869"/>
                      <a:gd name="connsiteX10" fmla="*/ 67243 w 133569"/>
                      <a:gd name="connsiteY10" fmla="*/ 70113 h 70869"/>
                      <a:gd name="connsiteX11" fmla="*/ 99287 w 133569"/>
                      <a:gd name="connsiteY11" fmla="*/ 60632 h 70869"/>
                      <a:gd name="connsiteX12" fmla="*/ 120650 w 133569"/>
                      <a:gd name="connsiteY12" fmla="*/ 50837 h 70869"/>
                      <a:gd name="connsiteX13" fmla="*/ 133350 w 133569"/>
                      <a:gd name="connsiteY13" fmla="*/ 31787 h 70869"/>
                      <a:gd name="connsiteX14" fmla="*/ 123825 w 133569"/>
                      <a:gd name="connsiteY14" fmla="*/ 9562 h 70869"/>
                      <a:gd name="connsiteX15" fmla="*/ 95250 w 133569"/>
                      <a:gd name="connsiteY15" fmla="*/ 37 h 70869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</a:cxnLst>
                    <a:rect l="l" t="t" r="r" b="b"/>
                    <a:pathLst>
                      <a:path w="133569" h="70869">
                        <a:moveTo>
                          <a:pt x="95250" y="37"/>
                        </a:moveTo>
                        <a:cubicBezTo>
                          <a:pt x="85725" y="-492"/>
                          <a:pt x="70598" y="4706"/>
                          <a:pt x="66675" y="6387"/>
                        </a:cubicBezTo>
                        <a:cubicBezTo>
                          <a:pt x="63168" y="7890"/>
                          <a:pt x="60637" y="11187"/>
                          <a:pt x="57150" y="12737"/>
                        </a:cubicBezTo>
                        <a:cubicBezTo>
                          <a:pt x="51033" y="15455"/>
                          <a:pt x="44450" y="16970"/>
                          <a:pt x="38100" y="19087"/>
                        </a:cubicBezTo>
                        <a:cubicBezTo>
                          <a:pt x="34925" y="20145"/>
                          <a:pt x="31360" y="20406"/>
                          <a:pt x="28575" y="22262"/>
                        </a:cubicBezTo>
                        <a:cubicBezTo>
                          <a:pt x="16265" y="30468"/>
                          <a:pt x="22670" y="27405"/>
                          <a:pt x="9525" y="31787"/>
                        </a:cubicBezTo>
                        <a:cubicBezTo>
                          <a:pt x="6314" y="36603"/>
                          <a:pt x="0" y="44264"/>
                          <a:pt x="0" y="50837"/>
                        </a:cubicBezTo>
                        <a:cubicBezTo>
                          <a:pt x="0" y="54184"/>
                          <a:pt x="452" y="58417"/>
                          <a:pt x="3175" y="60362"/>
                        </a:cubicBezTo>
                        <a:cubicBezTo>
                          <a:pt x="8622" y="64253"/>
                          <a:pt x="15875" y="64595"/>
                          <a:pt x="22225" y="66712"/>
                        </a:cubicBezTo>
                        <a:cubicBezTo>
                          <a:pt x="25400" y="67770"/>
                          <a:pt x="24247" y="69320"/>
                          <a:pt x="31750" y="69887"/>
                        </a:cubicBezTo>
                        <a:cubicBezTo>
                          <a:pt x="39253" y="70454"/>
                          <a:pt x="55987" y="71656"/>
                          <a:pt x="67243" y="70113"/>
                        </a:cubicBezTo>
                        <a:cubicBezTo>
                          <a:pt x="78499" y="68571"/>
                          <a:pt x="90386" y="63845"/>
                          <a:pt x="99287" y="60632"/>
                        </a:cubicBezTo>
                        <a:cubicBezTo>
                          <a:pt x="108188" y="57419"/>
                          <a:pt x="93353" y="69035"/>
                          <a:pt x="120650" y="50837"/>
                        </a:cubicBezTo>
                        <a:cubicBezTo>
                          <a:pt x="124883" y="44487"/>
                          <a:pt x="135201" y="39191"/>
                          <a:pt x="133350" y="31787"/>
                        </a:cubicBezTo>
                        <a:cubicBezTo>
                          <a:pt x="131850" y="25786"/>
                          <a:pt x="130322" y="13622"/>
                          <a:pt x="123825" y="9562"/>
                        </a:cubicBezTo>
                        <a:cubicBezTo>
                          <a:pt x="111523" y="1873"/>
                          <a:pt x="104775" y="566"/>
                          <a:pt x="95250" y="37"/>
                        </a:cubicBezTo>
                        <a:close/>
                      </a:path>
                    </a:pathLst>
                  </a:custGeom>
                  <a:solidFill>
                    <a:srgbClr val="8FAADC"/>
                  </a:solidFill>
                  <a:ln>
                    <a:solidFill>
                      <a:schemeClr val="accent5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8" name="Freeform 121">
                    <a:extLst>
                      <a:ext uri="{FF2B5EF4-FFF2-40B4-BE49-F238E27FC236}">
                        <a16:creationId xmlns:a16="http://schemas.microsoft.com/office/drawing/2014/main" id="{92C8D0B1-8291-4A02-AB5E-9A5E5E8EE95A}"/>
                      </a:ext>
                    </a:extLst>
                  </p:cNvPr>
                  <p:cNvSpPr/>
                  <p:nvPr/>
                </p:nvSpPr>
                <p:spPr>
                  <a:xfrm rot="20535515" flipH="1">
                    <a:off x="6404860" y="5124777"/>
                    <a:ext cx="134646" cy="99780"/>
                  </a:xfrm>
                  <a:custGeom>
                    <a:avLst/>
                    <a:gdLst>
                      <a:gd name="connsiteX0" fmla="*/ 107950 w 133068"/>
                      <a:gd name="connsiteY0" fmla="*/ 8396 h 87771"/>
                      <a:gd name="connsiteX1" fmla="*/ 28575 w 133068"/>
                      <a:gd name="connsiteY1" fmla="*/ 2046 h 87771"/>
                      <a:gd name="connsiteX2" fmla="*/ 6350 w 133068"/>
                      <a:gd name="connsiteY2" fmla="*/ 11571 h 87771"/>
                      <a:gd name="connsiteX3" fmla="*/ 0 w 133068"/>
                      <a:gd name="connsiteY3" fmla="*/ 30621 h 87771"/>
                      <a:gd name="connsiteX4" fmla="*/ 6350 w 133068"/>
                      <a:gd name="connsiteY4" fmla="*/ 52846 h 87771"/>
                      <a:gd name="connsiteX5" fmla="*/ 12700 w 133068"/>
                      <a:gd name="connsiteY5" fmla="*/ 62371 h 87771"/>
                      <a:gd name="connsiteX6" fmla="*/ 31750 w 133068"/>
                      <a:gd name="connsiteY6" fmla="*/ 75071 h 87771"/>
                      <a:gd name="connsiteX7" fmla="*/ 44450 w 133068"/>
                      <a:gd name="connsiteY7" fmla="*/ 81421 h 87771"/>
                      <a:gd name="connsiteX8" fmla="*/ 63500 w 133068"/>
                      <a:gd name="connsiteY8" fmla="*/ 87771 h 87771"/>
                      <a:gd name="connsiteX9" fmla="*/ 82550 w 133068"/>
                      <a:gd name="connsiteY9" fmla="*/ 84596 h 87771"/>
                      <a:gd name="connsiteX10" fmla="*/ 101600 w 133068"/>
                      <a:gd name="connsiteY10" fmla="*/ 71896 h 87771"/>
                      <a:gd name="connsiteX11" fmla="*/ 111125 w 133068"/>
                      <a:gd name="connsiteY11" fmla="*/ 65546 h 87771"/>
                      <a:gd name="connsiteX12" fmla="*/ 130175 w 133068"/>
                      <a:gd name="connsiteY12" fmla="*/ 56021 h 87771"/>
                      <a:gd name="connsiteX13" fmla="*/ 107950 w 133068"/>
                      <a:gd name="connsiteY13" fmla="*/ 8396 h 87771"/>
                      <a:gd name="connsiteX0" fmla="*/ 107950 w 128402"/>
                      <a:gd name="connsiteY0" fmla="*/ 7846 h 87221"/>
                      <a:gd name="connsiteX1" fmla="*/ 28575 w 128402"/>
                      <a:gd name="connsiteY1" fmla="*/ 1496 h 87221"/>
                      <a:gd name="connsiteX2" fmla="*/ 6350 w 128402"/>
                      <a:gd name="connsiteY2" fmla="*/ 11021 h 87221"/>
                      <a:gd name="connsiteX3" fmla="*/ 0 w 128402"/>
                      <a:gd name="connsiteY3" fmla="*/ 30071 h 87221"/>
                      <a:gd name="connsiteX4" fmla="*/ 6350 w 128402"/>
                      <a:gd name="connsiteY4" fmla="*/ 52296 h 87221"/>
                      <a:gd name="connsiteX5" fmla="*/ 12700 w 128402"/>
                      <a:gd name="connsiteY5" fmla="*/ 61821 h 87221"/>
                      <a:gd name="connsiteX6" fmla="*/ 31750 w 128402"/>
                      <a:gd name="connsiteY6" fmla="*/ 74521 h 87221"/>
                      <a:gd name="connsiteX7" fmla="*/ 44450 w 128402"/>
                      <a:gd name="connsiteY7" fmla="*/ 80871 h 87221"/>
                      <a:gd name="connsiteX8" fmla="*/ 63500 w 128402"/>
                      <a:gd name="connsiteY8" fmla="*/ 87221 h 87221"/>
                      <a:gd name="connsiteX9" fmla="*/ 82550 w 128402"/>
                      <a:gd name="connsiteY9" fmla="*/ 84046 h 87221"/>
                      <a:gd name="connsiteX10" fmla="*/ 101600 w 128402"/>
                      <a:gd name="connsiteY10" fmla="*/ 71346 h 87221"/>
                      <a:gd name="connsiteX11" fmla="*/ 111125 w 128402"/>
                      <a:gd name="connsiteY11" fmla="*/ 64996 h 87221"/>
                      <a:gd name="connsiteX12" fmla="*/ 124863 w 128402"/>
                      <a:gd name="connsiteY12" fmla="*/ 38838 h 87221"/>
                      <a:gd name="connsiteX13" fmla="*/ 107950 w 128402"/>
                      <a:gd name="connsiteY13" fmla="*/ 7846 h 87221"/>
                      <a:gd name="connsiteX0" fmla="*/ 107950 w 125101"/>
                      <a:gd name="connsiteY0" fmla="*/ 7846 h 87221"/>
                      <a:gd name="connsiteX1" fmla="*/ 28575 w 125101"/>
                      <a:gd name="connsiteY1" fmla="*/ 1496 h 87221"/>
                      <a:gd name="connsiteX2" fmla="*/ 6350 w 125101"/>
                      <a:gd name="connsiteY2" fmla="*/ 11021 h 87221"/>
                      <a:gd name="connsiteX3" fmla="*/ 0 w 125101"/>
                      <a:gd name="connsiteY3" fmla="*/ 30071 h 87221"/>
                      <a:gd name="connsiteX4" fmla="*/ 6350 w 125101"/>
                      <a:gd name="connsiteY4" fmla="*/ 52296 h 87221"/>
                      <a:gd name="connsiteX5" fmla="*/ 12700 w 125101"/>
                      <a:gd name="connsiteY5" fmla="*/ 61821 h 87221"/>
                      <a:gd name="connsiteX6" fmla="*/ 31750 w 125101"/>
                      <a:gd name="connsiteY6" fmla="*/ 74521 h 87221"/>
                      <a:gd name="connsiteX7" fmla="*/ 44450 w 125101"/>
                      <a:gd name="connsiteY7" fmla="*/ 80871 h 87221"/>
                      <a:gd name="connsiteX8" fmla="*/ 63500 w 125101"/>
                      <a:gd name="connsiteY8" fmla="*/ 87221 h 87221"/>
                      <a:gd name="connsiteX9" fmla="*/ 82550 w 125101"/>
                      <a:gd name="connsiteY9" fmla="*/ 84046 h 87221"/>
                      <a:gd name="connsiteX10" fmla="*/ 101600 w 125101"/>
                      <a:gd name="connsiteY10" fmla="*/ 71346 h 87221"/>
                      <a:gd name="connsiteX11" fmla="*/ 124863 w 125101"/>
                      <a:gd name="connsiteY11" fmla="*/ 38838 h 87221"/>
                      <a:gd name="connsiteX12" fmla="*/ 107950 w 125101"/>
                      <a:gd name="connsiteY12" fmla="*/ 7846 h 87221"/>
                      <a:gd name="connsiteX0" fmla="*/ 107950 w 115756"/>
                      <a:gd name="connsiteY0" fmla="*/ 7816 h 87191"/>
                      <a:gd name="connsiteX1" fmla="*/ 28575 w 115756"/>
                      <a:gd name="connsiteY1" fmla="*/ 1466 h 87191"/>
                      <a:gd name="connsiteX2" fmla="*/ 6350 w 115756"/>
                      <a:gd name="connsiteY2" fmla="*/ 10991 h 87191"/>
                      <a:gd name="connsiteX3" fmla="*/ 0 w 115756"/>
                      <a:gd name="connsiteY3" fmla="*/ 30041 h 87191"/>
                      <a:gd name="connsiteX4" fmla="*/ 6350 w 115756"/>
                      <a:gd name="connsiteY4" fmla="*/ 52266 h 87191"/>
                      <a:gd name="connsiteX5" fmla="*/ 12700 w 115756"/>
                      <a:gd name="connsiteY5" fmla="*/ 61791 h 87191"/>
                      <a:gd name="connsiteX6" fmla="*/ 31750 w 115756"/>
                      <a:gd name="connsiteY6" fmla="*/ 74491 h 87191"/>
                      <a:gd name="connsiteX7" fmla="*/ 44450 w 115756"/>
                      <a:gd name="connsiteY7" fmla="*/ 80841 h 87191"/>
                      <a:gd name="connsiteX8" fmla="*/ 63500 w 115756"/>
                      <a:gd name="connsiteY8" fmla="*/ 87191 h 87191"/>
                      <a:gd name="connsiteX9" fmla="*/ 82550 w 115756"/>
                      <a:gd name="connsiteY9" fmla="*/ 84016 h 87191"/>
                      <a:gd name="connsiteX10" fmla="*/ 101600 w 115756"/>
                      <a:gd name="connsiteY10" fmla="*/ 71316 h 87191"/>
                      <a:gd name="connsiteX11" fmla="*/ 112090 w 115756"/>
                      <a:gd name="connsiteY11" fmla="*/ 37690 h 87191"/>
                      <a:gd name="connsiteX12" fmla="*/ 107950 w 115756"/>
                      <a:gd name="connsiteY12" fmla="*/ 7816 h 87191"/>
                      <a:gd name="connsiteX0" fmla="*/ 107950 w 110644"/>
                      <a:gd name="connsiteY0" fmla="*/ 7845 h 87220"/>
                      <a:gd name="connsiteX1" fmla="*/ 28575 w 110644"/>
                      <a:gd name="connsiteY1" fmla="*/ 1495 h 87220"/>
                      <a:gd name="connsiteX2" fmla="*/ 6350 w 110644"/>
                      <a:gd name="connsiteY2" fmla="*/ 11020 h 87220"/>
                      <a:gd name="connsiteX3" fmla="*/ 0 w 110644"/>
                      <a:gd name="connsiteY3" fmla="*/ 30070 h 87220"/>
                      <a:gd name="connsiteX4" fmla="*/ 6350 w 110644"/>
                      <a:gd name="connsiteY4" fmla="*/ 52295 h 87220"/>
                      <a:gd name="connsiteX5" fmla="*/ 12700 w 110644"/>
                      <a:gd name="connsiteY5" fmla="*/ 61820 h 87220"/>
                      <a:gd name="connsiteX6" fmla="*/ 31750 w 110644"/>
                      <a:gd name="connsiteY6" fmla="*/ 74520 h 87220"/>
                      <a:gd name="connsiteX7" fmla="*/ 44450 w 110644"/>
                      <a:gd name="connsiteY7" fmla="*/ 80870 h 87220"/>
                      <a:gd name="connsiteX8" fmla="*/ 63500 w 110644"/>
                      <a:gd name="connsiteY8" fmla="*/ 87220 h 87220"/>
                      <a:gd name="connsiteX9" fmla="*/ 82550 w 110644"/>
                      <a:gd name="connsiteY9" fmla="*/ 84045 h 87220"/>
                      <a:gd name="connsiteX10" fmla="*/ 101600 w 110644"/>
                      <a:gd name="connsiteY10" fmla="*/ 71345 h 87220"/>
                      <a:gd name="connsiteX11" fmla="*/ 92929 w 110644"/>
                      <a:gd name="connsiteY11" fmla="*/ 38815 h 87220"/>
                      <a:gd name="connsiteX12" fmla="*/ 107950 w 110644"/>
                      <a:gd name="connsiteY12" fmla="*/ 7845 h 8722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</a:cxnLst>
                    <a:rect l="l" t="t" r="r" b="b"/>
                    <a:pathLst>
                      <a:path w="110644" h="87220">
                        <a:moveTo>
                          <a:pt x="107950" y="7845"/>
                        </a:moveTo>
                        <a:cubicBezTo>
                          <a:pt x="97224" y="1625"/>
                          <a:pt x="89396" y="-2306"/>
                          <a:pt x="28575" y="1495"/>
                        </a:cubicBezTo>
                        <a:cubicBezTo>
                          <a:pt x="22574" y="2995"/>
                          <a:pt x="10410" y="4523"/>
                          <a:pt x="6350" y="11020"/>
                        </a:cubicBezTo>
                        <a:cubicBezTo>
                          <a:pt x="2802" y="16696"/>
                          <a:pt x="0" y="30070"/>
                          <a:pt x="0" y="30070"/>
                        </a:cubicBezTo>
                        <a:cubicBezTo>
                          <a:pt x="1017" y="34139"/>
                          <a:pt x="4073" y="47740"/>
                          <a:pt x="6350" y="52295"/>
                        </a:cubicBezTo>
                        <a:cubicBezTo>
                          <a:pt x="8057" y="55708"/>
                          <a:pt x="9828" y="59307"/>
                          <a:pt x="12700" y="61820"/>
                        </a:cubicBezTo>
                        <a:cubicBezTo>
                          <a:pt x="18443" y="66846"/>
                          <a:pt x="24924" y="71107"/>
                          <a:pt x="31750" y="74520"/>
                        </a:cubicBezTo>
                        <a:cubicBezTo>
                          <a:pt x="35983" y="76637"/>
                          <a:pt x="40056" y="79112"/>
                          <a:pt x="44450" y="80870"/>
                        </a:cubicBezTo>
                        <a:cubicBezTo>
                          <a:pt x="50665" y="83356"/>
                          <a:pt x="63500" y="87220"/>
                          <a:pt x="63500" y="87220"/>
                        </a:cubicBezTo>
                        <a:cubicBezTo>
                          <a:pt x="69850" y="86162"/>
                          <a:pt x="76608" y="86521"/>
                          <a:pt x="82550" y="84045"/>
                        </a:cubicBezTo>
                        <a:cubicBezTo>
                          <a:pt x="89595" y="81110"/>
                          <a:pt x="99870" y="78883"/>
                          <a:pt x="101600" y="71345"/>
                        </a:cubicBezTo>
                        <a:cubicBezTo>
                          <a:pt x="103330" y="63807"/>
                          <a:pt x="91871" y="49398"/>
                          <a:pt x="92929" y="38815"/>
                        </a:cubicBezTo>
                        <a:cubicBezTo>
                          <a:pt x="93987" y="28232"/>
                          <a:pt x="118676" y="14065"/>
                          <a:pt x="107950" y="7845"/>
                        </a:cubicBezTo>
                        <a:close/>
                      </a:path>
                    </a:pathLst>
                  </a:custGeom>
                  <a:solidFill>
                    <a:srgbClr val="8FAADC"/>
                  </a:solidFill>
                  <a:ln>
                    <a:solidFill>
                      <a:schemeClr val="accent5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59" name="Freeform 122">
                    <a:extLst>
                      <a:ext uri="{FF2B5EF4-FFF2-40B4-BE49-F238E27FC236}">
                        <a16:creationId xmlns:a16="http://schemas.microsoft.com/office/drawing/2014/main" id="{FAE0840A-3720-4D41-BB38-378343FB9F89}"/>
                      </a:ext>
                    </a:extLst>
                  </p:cNvPr>
                  <p:cNvSpPr/>
                  <p:nvPr/>
                </p:nvSpPr>
                <p:spPr>
                  <a:xfrm rot="25342" flipH="1">
                    <a:off x="6231865" y="5151353"/>
                    <a:ext cx="191484" cy="132208"/>
                  </a:xfrm>
                  <a:custGeom>
                    <a:avLst/>
                    <a:gdLst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46245 w 165295"/>
                      <a:gd name="connsiteY19" fmla="*/ 50800 h 98425"/>
                      <a:gd name="connsiteX20" fmla="*/ 136720 w 165295"/>
                      <a:gd name="connsiteY20" fmla="*/ 44450 h 98425"/>
                      <a:gd name="connsiteX21" fmla="*/ 117670 w 165295"/>
                      <a:gd name="connsiteY21" fmla="*/ 34925 h 98425"/>
                      <a:gd name="connsiteX22" fmla="*/ 111320 w 165295"/>
                      <a:gd name="connsiteY22" fmla="*/ 25400 h 98425"/>
                      <a:gd name="connsiteX23" fmla="*/ 98620 w 165295"/>
                      <a:gd name="connsiteY23" fmla="*/ 9525 h 98425"/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46245 w 165295"/>
                      <a:gd name="connsiteY19" fmla="*/ 50800 h 98425"/>
                      <a:gd name="connsiteX20" fmla="*/ 136720 w 165295"/>
                      <a:gd name="connsiteY20" fmla="*/ 44450 h 98425"/>
                      <a:gd name="connsiteX21" fmla="*/ 117670 w 165295"/>
                      <a:gd name="connsiteY21" fmla="*/ 34925 h 98425"/>
                      <a:gd name="connsiteX22" fmla="*/ 121578 w 165295"/>
                      <a:gd name="connsiteY22" fmla="*/ 19403 h 98425"/>
                      <a:gd name="connsiteX23" fmla="*/ 98620 w 165295"/>
                      <a:gd name="connsiteY23" fmla="*/ 9525 h 98425"/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46245 w 165295"/>
                      <a:gd name="connsiteY19" fmla="*/ 50800 h 98425"/>
                      <a:gd name="connsiteX20" fmla="*/ 136720 w 165295"/>
                      <a:gd name="connsiteY20" fmla="*/ 44450 h 98425"/>
                      <a:gd name="connsiteX21" fmla="*/ 133057 w 165295"/>
                      <a:gd name="connsiteY21" fmla="*/ 33425 h 98425"/>
                      <a:gd name="connsiteX22" fmla="*/ 121578 w 165295"/>
                      <a:gd name="connsiteY22" fmla="*/ 19403 h 98425"/>
                      <a:gd name="connsiteX23" fmla="*/ 98620 w 165295"/>
                      <a:gd name="connsiteY23" fmla="*/ 9525 h 98425"/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46245 w 165295"/>
                      <a:gd name="connsiteY19" fmla="*/ 50800 h 98425"/>
                      <a:gd name="connsiteX20" fmla="*/ 136720 w 165295"/>
                      <a:gd name="connsiteY20" fmla="*/ 44450 h 98425"/>
                      <a:gd name="connsiteX21" fmla="*/ 121578 w 165295"/>
                      <a:gd name="connsiteY21" fmla="*/ 19403 h 98425"/>
                      <a:gd name="connsiteX22" fmla="*/ 98620 w 165295"/>
                      <a:gd name="connsiteY22" fmla="*/ 9525 h 98425"/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46245 w 165295"/>
                      <a:gd name="connsiteY19" fmla="*/ 50800 h 98425"/>
                      <a:gd name="connsiteX20" fmla="*/ 121578 w 165295"/>
                      <a:gd name="connsiteY20" fmla="*/ 19403 h 98425"/>
                      <a:gd name="connsiteX21" fmla="*/ 98620 w 165295"/>
                      <a:gd name="connsiteY21" fmla="*/ 9525 h 98425"/>
                      <a:gd name="connsiteX0" fmla="*/ 98620 w 165295"/>
                      <a:gd name="connsiteY0" fmla="*/ 9525 h 98425"/>
                      <a:gd name="connsiteX1" fmla="*/ 82745 w 165295"/>
                      <a:gd name="connsiteY1" fmla="*/ 6350 h 98425"/>
                      <a:gd name="connsiteX2" fmla="*/ 63695 w 165295"/>
                      <a:gd name="connsiteY2" fmla="*/ 0 h 98425"/>
                      <a:gd name="connsiteX3" fmla="*/ 25595 w 165295"/>
                      <a:gd name="connsiteY3" fmla="*/ 6350 h 98425"/>
                      <a:gd name="connsiteX4" fmla="*/ 6545 w 165295"/>
                      <a:gd name="connsiteY4" fmla="*/ 19050 h 98425"/>
                      <a:gd name="connsiteX5" fmla="*/ 195 w 165295"/>
                      <a:gd name="connsiteY5" fmla="*/ 28575 h 98425"/>
                      <a:gd name="connsiteX6" fmla="*/ 3370 w 165295"/>
                      <a:gd name="connsiteY6" fmla="*/ 47625 h 98425"/>
                      <a:gd name="connsiteX7" fmla="*/ 22420 w 165295"/>
                      <a:gd name="connsiteY7" fmla="*/ 63500 h 98425"/>
                      <a:gd name="connsiteX8" fmla="*/ 28770 w 165295"/>
                      <a:gd name="connsiteY8" fmla="*/ 73025 h 98425"/>
                      <a:gd name="connsiteX9" fmla="*/ 38295 w 165295"/>
                      <a:gd name="connsiteY9" fmla="*/ 76200 h 98425"/>
                      <a:gd name="connsiteX10" fmla="*/ 47820 w 165295"/>
                      <a:gd name="connsiteY10" fmla="*/ 82550 h 98425"/>
                      <a:gd name="connsiteX11" fmla="*/ 66870 w 165295"/>
                      <a:gd name="connsiteY11" fmla="*/ 88900 h 98425"/>
                      <a:gd name="connsiteX12" fmla="*/ 85920 w 165295"/>
                      <a:gd name="connsiteY12" fmla="*/ 95250 h 98425"/>
                      <a:gd name="connsiteX13" fmla="*/ 95445 w 165295"/>
                      <a:gd name="connsiteY13" fmla="*/ 98425 h 98425"/>
                      <a:gd name="connsiteX14" fmla="*/ 108145 w 165295"/>
                      <a:gd name="connsiteY14" fmla="*/ 95250 h 98425"/>
                      <a:gd name="connsiteX15" fmla="*/ 127195 w 165295"/>
                      <a:gd name="connsiteY15" fmla="*/ 88900 h 98425"/>
                      <a:gd name="connsiteX16" fmla="*/ 162120 w 165295"/>
                      <a:gd name="connsiteY16" fmla="*/ 85725 h 98425"/>
                      <a:gd name="connsiteX17" fmla="*/ 165295 w 165295"/>
                      <a:gd name="connsiteY17" fmla="*/ 76200 h 98425"/>
                      <a:gd name="connsiteX18" fmla="*/ 155770 w 165295"/>
                      <a:gd name="connsiteY18" fmla="*/ 53975 h 98425"/>
                      <a:gd name="connsiteX19" fmla="*/ 135987 w 165295"/>
                      <a:gd name="connsiteY19" fmla="*/ 34308 h 98425"/>
                      <a:gd name="connsiteX20" fmla="*/ 121578 w 165295"/>
                      <a:gd name="connsiteY20" fmla="*/ 19403 h 98425"/>
                      <a:gd name="connsiteX21" fmla="*/ 98620 w 165295"/>
                      <a:gd name="connsiteY21" fmla="*/ 9525 h 98425"/>
                      <a:gd name="connsiteX0" fmla="*/ 98620 w 165507"/>
                      <a:gd name="connsiteY0" fmla="*/ 9525 h 98425"/>
                      <a:gd name="connsiteX1" fmla="*/ 82745 w 165507"/>
                      <a:gd name="connsiteY1" fmla="*/ 6350 h 98425"/>
                      <a:gd name="connsiteX2" fmla="*/ 63695 w 165507"/>
                      <a:gd name="connsiteY2" fmla="*/ 0 h 98425"/>
                      <a:gd name="connsiteX3" fmla="*/ 25595 w 165507"/>
                      <a:gd name="connsiteY3" fmla="*/ 6350 h 98425"/>
                      <a:gd name="connsiteX4" fmla="*/ 6545 w 165507"/>
                      <a:gd name="connsiteY4" fmla="*/ 19050 h 98425"/>
                      <a:gd name="connsiteX5" fmla="*/ 195 w 165507"/>
                      <a:gd name="connsiteY5" fmla="*/ 28575 h 98425"/>
                      <a:gd name="connsiteX6" fmla="*/ 3370 w 165507"/>
                      <a:gd name="connsiteY6" fmla="*/ 47625 h 98425"/>
                      <a:gd name="connsiteX7" fmla="*/ 22420 w 165507"/>
                      <a:gd name="connsiteY7" fmla="*/ 63500 h 98425"/>
                      <a:gd name="connsiteX8" fmla="*/ 28770 w 165507"/>
                      <a:gd name="connsiteY8" fmla="*/ 73025 h 98425"/>
                      <a:gd name="connsiteX9" fmla="*/ 38295 w 165507"/>
                      <a:gd name="connsiteY9" fmla="*/ 76200 h 98425"/>
                      <a:gd name="connsiteX10" fmla="*/ 47820 w 165507"/>
                      <a:gd name="connsiteY10" fmla="*/ 82550 h 98425"/>
                      <a:gd name="connsiteX11" fmla="*/ 66870 w 165507"/>
                      <a:gd name="connsiteY11" fmla="*/ 88900 h 98425"/>
                      <a:gd name="connsiteX12" fmla="*/ 85920 w 165507"/>
                      <a:gd name="connsiteY12" fmla="*/ 95250 h 98425"/>
                      <a:gd name="connsiteX13" fmla="*/ 95445 w 165507"/>
                      <a:gd name="connsiteY13" fmla="*/ 98425 h 98425"/>
                      <a:gd name="connsiteX14" fmla="*/ 108145 w 165507"/>
                      <a:gd name="connsiteY14" fmla="*/ 95250 h 98425"/>
                      <a:gd name="connsiteX15" fmla="*/ 127195 w 165507"/>
                      <a:gd name="connsiteY15" fmla="*/ 88900 h 98425"/>
                      <a:gd name="connsiteX16" fmla="*/ 162120 w 165507"/>
                      <a:gd name="connsiteY16" fmla="*/ 85725 h 98425"/>
                      <a:gd name="connsiteX17" fmla="*/ 165295 w 165507"/>
                      <a:gd name="connsiteY17" fmla="*/ 76200 h 98425"/>
                      <a:gd name="connsiteX18" fmla="*/ 155770 w 165507"/>
                      <a:gd name="connsiteY18" fmla="*/ 53975 h 98425"/>
                      <a:gd name="connsiteX19" fmla="*/ 135987 w 165507"/>
                      <a:gd name="connsiteY19" fmla="*/ 34308 h 98425"/>
                      <a:gd name="connsiteX20" fmla="*/ 121578 w 165507"/>
                      <a:gd name="connsiteY20" fmla="*/ 19403 h 98425"/>
                      <a:gd name="connsiteX21" fmla="*/ 98620 w 165507"/>
                      <a:gd name="connsiteY21" fmla="*/ 9525 h 98425"/>
                      <a:gd name="connsiteX0" fmla="*/ 98620 w 162184"/>
                      <a:gd name="connsiteY0" fmla="*/ 9525 h 98425"/>
                      <a:gd name="connsiteX1" fmla="*/ 82745 w 162184"/>
                      <a:gd name="connsiteY1" fmla="*/ 6350 h 98425"/>
                      <a:gd name="connsiteX2" fmla="*/ 63695 w 162184"/>
                      <a:gd name="connsiteY2" fmla="*/ 0 h 98425"/>
                      <a:gd name="connsiteX3" fmla="*/ 25595 w 162184"/>
                      <a:gd name="connsiteY3" fmla="*/ 6350 h 98425"/>
                      <a:gd name="connsiteX4" fmla="*/ 6545 w 162184"/>
                      <a:gd name="connsiteY4" fmla="*/ 19050 h 98425"/>
                      <a:gd name="connsiteX5" fmla="*/ 195 w 162184"/>
                      <a:gd name="connsiteY5" fmla="*/ 28575 h 98425"/>
                      <a:gd name="connsiteX6" fmla="*/ 3370 w 162184"/>
                      <a:gd name="connsiteY6" fmla="*/ 47625 h 98425"/>
                      <a:gd name="connsiteX7" fmla="*/ 22420 w 162184"/>
                      <a:gd name="connsiteY7" fmla="*/ 63500 h 98425"/>
                      <a:gd name="connsiteX8" fmla="*/ 28770 w 162184"/>
                      <a:gd name="connsiteY8" fmla="*/ 73025 h 98425"/>
                      <a:gd name="connsiteX9" fmla="*/ 38295 w 162184"/>
                      <a:gd name="connsiteY9" fmla="*/ 76200 h 98425"/>
                      <a:gd name="connsiteX10" fmla="*/ 47820 w 162184"/>
                      <a:gd name="connsiteY10" fmla="*/ 82550 h 98425"/>
                      <a:gd name="connsiteX11" fmla="*/ 66870 w 162184"/>
                      <a:gd name="connsiteY11" fmla="*/ 88900 h 98425"/>
                      <a:gd name="connsiteX12" fmla="*/ 85920 w 162184"/>
                      <a:gd name="connsiteY12" fmla="*/ 95250 h 98425"/>
                      <a:gd name="connsiteX13" fmla="*/ 95445 w 162184"/>
                      <a:gd name="connsiteY13" fmla="*/ 98425 h 98425"/>
                      <a:gd name="connsiteX14" fmla="*/ 108145 w 162184"/>
                      <a:gd name="connsiteY14" fmla="*/ 95250 h 98425"/>
                      <a:gd name="connsiteX15" fmla="*/ 127195 w 162184"/>
                      <a:gd name="connsiteY15" fmla="*/ 88900 h 98425"/>
                      <a:gd name="connsiteX16" fmla="*/ 162120 w 162184"/>
                      <a:gd name="connsiteY16" fmla="*/ 85725 h 98425"/>
                      <a:gd name="connsiteX17" fmla="*/ 149908 w 162184"/>
                      <a:gd name="connsiteY17" fmla="*/ 76200 h 98425"/>
                      <a:gd name="connsiteX18" fmla="*/ 155770 w 162184"/>
                      <a:gd name="connsiteY18" fmla="*/ 53975 h 98425"/>
                      <a:gd name="connsiteX19" fmla="*/ 135987 w 162184"/>
                      <a:gd name="connsiteY19" fmla="*/ 34308 h 98425"/>
                      <a:gd name="connsiteX20" fmla="*/ 121578 w 162184"/>
                      <a:gd name="connsiteY20" fmla="*/ 19403 h 98425"/>
                      <a:gd name="connsiteX21" fmla="*/ 98620 w 162184"/>
                      <a:gd name="connsiteY21" fmla="*/ 9525 h 98425"/>
                      <a:gd name="connsiteX0" fmla="*/ 98620 w 163750"/>
                      <a:gd name="connsiteY0" fmla="*/ 9525 h 98425"/>
                      <a:gd name="connsiteX1" fmla="*/ 82745 w 163750"/>
                      <a:gd name="connsiteY1" fmla="*/ 6350 h 98425"/>
                      <a:gd name="connsiteX2" fmla="*/ 63695 w 163750"/>
                      <a:gd name="connsiteY2" fmla="*/ 0 h 98425"/>
                      <a:gd name="connsiteX3" fmla="*/ 25595 w 163750"/>
                      <a:gd name="connsiteY3" fmla="*/ 6350 h 98425"/>
                      <a:gd name="connsiteX4" fmla="*/ 6545 w 163750"/>
                      <a:gd name="connsiteY4" fmla="*/ 19050 h 98425"/>
                      <a:gd name="connsiteX5" fmla="*/ 195 w 163750"/>
                      <a:gd name="connsiteY5" fmla="*/ 28575 h 98425"/>
                      <a:gd name="connsiteX6" fmla="*/ 3370 w 163750"/>
                      <a:gd name="connsiteY6" fmla="*/ 47625 h 98425"/>
                      <a:gd name="connsiteX7" fmla="*/ 22420 w 163750"/>
                      <a:gd name="connsiteY7" fmla="*/ 63500 h 98425"/>
                      <a:gd name="connsiteX8" fmla="*/ 28770 w 163750"/>
                      <a:gd name="connsiteY8" fmla="*/ 73025 h 98425"/>
                      <a:gd name="connsiteX9" fmla="*/ 38295 w 163750"/>
                      <a:gd name="connsiteY9" fmla="*/ 76200 h 98425"/>
                      <a:gd name="connsiteX10" fmla="*/ 47820 w 163750"/>
                      <a:gd name="connsiteY10" fmla="*/ 82550 h 98425"/>
                      <a:gd name="connsiteX11" fmla="*/ 66870 w 163750"/>
                      <a:gd name="connsiteY11" fmla="*/ 88900 h 98425"/>
                      <a:gd name="connsiteX12" fmla="*/ 85920 w 163750"/>
                      <a:gd name="connsiteY12" fmla="*/ 95250 h 98425"/>
                      <a:gd name="connsiteX13" fmla="*/ 95445 w 163750"/>
                      <a:gd name="connsiteY13" fmla="*/ 98425 h 98425"/>
                      <a:gd name="connsiteX14" fmla="*/ 108145 w 163750"/>
                      <a:gd name="connsiteY14" fmla="*/ 95250 h 98425"/>
                      <a:gd name="connsiteX15" fmla="*/ 127195 w 163750"/>
                      <a:gd name="connsiteY15" fmla="*/ 88900 h 98425"/>
                      <a:gd name="connsiteX16" fmla="*/ 162120 w 163750"/>
                      <a:gd name="connsiteY16" fmla="*/ 85725 h 98425"/>
                      <a:gd name="connsiteX17" fmla="*/ 155770 w 163750"/>
                      <a:gd name="connsiteY17" fmla="*/ 53975 h 98425"/>
                      <a:gd name="connsiteX18" fmla="*/ 135987 w 163750"/>
                      <a:gd name="connsiteY18" fmla="*/ 34308 h 98425"/>
                      <a:gd name="connsiteX19" fmla="*/ 121578 w 163750"/>
                      <a:gd name="connsiteY19" fmla="*/ 19403 h 98425"/>
                      <a:gd name="connsiteX20" fmla="*/ 98620 w 163750"/>
                      <a:gd name="connsiteY20" fmla="*/ 9525 h 98425"/>
                      <a:gd name="connsiteX0" fmla="*/ 98620 w 158521"/>
                      <a:gd name="connsiteY0" fmla="*/ 9525 h 98425"/>
                      <a:gd name="connsiteX1" fmla="*/ 82745 w 158521"/>
                      <a:gd name="connsiteY1" fmla="*/ 6350 h 98425"/>
                      <a:gd name="connsiteX2" fmla="*/ 63695 w 158521"/>
                      <a:gd name="connsiteY2" fmla="*/ 0 h 98425"/>
                      <a:gd name="connsiteX3" fmla="*/ 25595 w 158521"/>
                      <a:gd name="connsiteY3" fmla="*/ 6350 h 98425"/>
                      <a:gd name="connsiteX4" fmla="*/ 6545 w 158521"/>
                      <a:gd name="connsiteY4" fmla="*/ 19050 h 98425"/>
                      <a:gd name="connsiteX5" fmla="*/ 195 w 158521"/>
                      <a:gd name="connsiteY5" fmla="*/ 28575 h 98425"/>
                      <a:gd name="connsiteX6" fmla="*/ 3370 w 158521"/>
                      <a:gd name="connsiteY6" fmla="*/ 47625 h 98425"/>
                      <a:gd name="connsiteX7" fmla="*/ 22420 w 158521"/>
                      <a:gd name="connsiteY7" fmla="*/ 63500 h 98425"/>
                      <a:gd name="connsiteX8" fmla="*/ 28770 w 158521"/>
                      <a:gd name="connsiteY8" fmla="*/ 73025 h 98425"/>
                      <a:gd name="connsiteX9" fmla="*/ 38295 w 158521"/>
                      <a:gd name="connsiteY9" fmla="*/ 76200 h 98425"/>
                      <a:gd name="connsiteX10" fmla="*/ 47820 w 158521"/>
                      <a:gd name="connsiteY10" fmla="*/ 82550 h 98425"/>
                      <a:gd name="connsiteX11" fmla="*/ 66870 w 158521"/>
                      <a:gd name="connsiteY11" fmla="*/ 88900 h 98425"/>
                      <a:gd name="connsiteX12" fmla="*/ 85920 w 158521"/>
                      <a:gd name="connsiteY12" fmla="*/ 95250 h 98425"/>
                      <a:gd name="connsiteX13" fmla="*/ 95445 w 158521"/>
                      <a:gd name="connsiteY13" fmla="*/ 98425 h 98425"/>
                      <a:gd name="connsiteX14" fmla="*/ 108145 w 158521"/>
                      <a:gd name="connsiteY14" fmla="*/ 95250 h 98425"/>
                      <a:gd name="connsiteX15" fmla="*/ 127195 w 158521"/>
                      <a:gd name="connsiteY15" fmla="*/ 88900 h 98425"/>
                      <a:gd name="connsiteX16" fmla="*/ 155281 w 158521"/>
                      <a:gd name="connsiteY16" fmla="*/ 84226 h 98425"/>
                      <a:gd name="connsiteX17" fmla="*/ 155770 w 158521"/>
                      <a:gd name="connsiteY17" fmla="*/ 53975 h 98425"/>
                      <a:gd name="connsiteX18" fmla="*/ 135987 w 158521"/>
                      <a:gd name="connsiteY18" fmla="*/ 34308 h 98425"/>
                      <a:gd name="connsiteX19" fmla="*/ 121578 w 158521"/>
                      <a:gd name="connsiteY19" fmla="*/ 19403 h 98425"/>
                      <a:gd name="connsiteX20" fmla="*/ 98620 w 158521"/>
                      <a:gd name="connsiteY20" fmla="*/ 9525 h 98425"/>
                      <a:gd name="connsiteX0" fmla="*/ 98620 w 159819"/>
                      <a:gd name="connsiteY0" fmla="*/ 9525 h 98425"/>
                      <a:gd name="connsiteX1" fmla="*/ 82745 w 159819"/>
                      <a:gd name="connsiteY1" fmla="*/ 6350 h 98425"/>
                      <a:gd name="connsiteX2" fmla="*/ 63695 w 159819"/>
                      <a:gd name="connsiteY2" fmla="*/ 0 h 98425"/>
                      <a:gd name="connsiteX3" fmla="*/ 25595 w 159819"/>
                      <a:gd name="connsiteY3" fmla="*/ 6350 h 98425"/>
                      <a:gd name="connsiteX4" fmla="*/ 6545 w 159819"/>
                      <a:gd name="connsiteY4" fmla="*/ 19050 h 98425"/>
                      <a:gd name="connsiteX5" fmla="*/ 195 w 159819"/>
                      <a:gd name="connsiteY5" fmla="*/ 28575 h 98425"/>
                      <a:gd name="connsiteX6" fmla="*/ 3370 w 159819"/>
                      <a:gd name="connsiteY6" fmla="*/ 47625 h 98425"/>
                      <a:gd name="connsiteX7" fmla="*/ 22420 w 159819"/>
                      <a:gd name="connsiteY7" fmla="*/ 63500 h 98425"/>
                      <a:gd name="connsiteX8" fmla="*/ 28770 w 159819"/>
                      <a:gd name="connsiteY8" fmla="*/ 73025 h 98425"/>
                      <a:gd name="connsiteX9" fmla="*/ 38295 w 159819"/>
                      <a:gd name="connsiteY9" fmla="*/ 76200 h 98425"/>
                      <a:gd name="connsiteX10" fmla="*/ 47820 w 159819"/>
                      <a:gd name="connsiteY10" fmla="*/ 82550 h 98425"/>
                      <a:gd name="connsiteX11" fmla="*/ 66870 w 159819"/>
                      <a:gd name="connsiteY11" fmla="*/ 88900 h 98425"/>
                      <a:gd name="connsiteX12" fmla="*/ 85920 w 159819"/>
                      <a:gd name="connsiteY12" fmla="*/ 95250 h 98425"/>
                      <a:gd name="connsiteX13" fmla="*/ 95445 w 159819"/>
                      <a:gd name="connsiteY13" fmla="*/ 98425 h 98425"/>
                      <a:gd name="connsiteX14" fmla="*/ 108145 w 159819"/>
                      <a:gd name="connsiteY14" fmla="*/ 95250 h 98425"/>
                      <a:gd name="connsiteX15" fmla="*/ 155281 w 159819"/>
                      <a:gd name="connsiteY15" fmla="*/ 84226 h 98425"/>
                      <a:gd name="connsiteX16" fmla="*/ 155770 w 159819"/>
                      <a:gd name="connsiteY16" fmla="*/ 53975 h 98425"/>
                      <a:gd name="connsiteX17" fmla="*/ 135987 w 159819"/>
                      <a:gd name="connsiteY17" fmla="*/ 34308 h 98425"/>
                      <a:gd name="connsiteX18" fmla="*/ 121578 w 159819"/>
                      <a:gd name="connsiteY18" fmla="*/ 19403 h 98425"/>
                      <a:gd name="connsiteX19" fmla="*/ 98620 w 159819"/>
                      <a:gd name="connsiteY19" fmla="*/ 9525 h 98425"/>
                      <a:gd name="connsiteX0" fmla="*/ 98620 w 159819"/>
                      <a:gd name="connsiteY0" fmla="*/ 9525 h 99477"/>
                      <a:gd name="connsiteX1" fmla="*/ 82745 w 159819"/>
                      <a:gd name="connsiteY1" fmla="*/ 6350 h 99477"/>
                      <a:gd name="connsiteX2" fmla="*/ 63695 w 159819"/>
                      <a:gd name="connsiteY2" fmla="*/ 0 h 99477"/>
                      <a:gd name="connsiteX3" fmla="*/ 25595 w 159819"/>
                      <a:gd name="connsiteY3" fmla="*/ 6350 h 99477"/>
                      <a:gd name="connsiteX4" fmla="*/ 6545 w 159819"/>
                      <a:gd name="connsiteY4" fmla="*/ 19050 h 99477"/>
                      <a:gd name="connsiteX5" fmla="*/ 195 w 159819"/>
                      <a:gd name="connsiteY5" fmla="*/ 28575 h 99477"/>
                      <a:gd name="connsiteX6" fmla="*/ 3370 w 159819"/>
                      <a:gd name="connsiteY6" fmla="*/ 47625 h 99477"/>
                      <a:gd name="connsiteX7" fmla="*/ 22420 w 159819"/>
                      <a:gd name="connsiteY7" fmla="*/ 63500 h 99477"/>
                      <a:gd name="connsiteX8" fmla="*/ 28770 w 159819"/>
                      <a:gd name="connsiteY8" fmla="*/ 73025 h 99477"/>
                      <a:gd name="connsiteX9" fmla="*/ 38295 w 159819"/>
                      <a:gd name="connsiteY9" fmla="*/ 76200 h 99477"/>
                      <a:gd name="connsiteX10" fmla="*/ 47820 w 159819"/>
                      <a:gd name="connsiteY10" fmla="*/ 82550 h 99477"/>
                      <a:gd name="connsiteX11" fmla="*/ 66870 w 159819"/>
                      <a:gd name="connsiteY11" fmla="*/ 88900 h 99477"/>
                      <a:gd name="connsiteX12" fmla="*/ 85920 w 159819"/>
                      <a:gd name="connsiteY12" fmla="*/ 95250 h 99477"/>
                      <a:gd name="connsiteX13" fmla="*/ 95445 w 159819"/>
                      <a:gd name="connsiteY13" fmla="*/ 98425 h 99477"/>
                      <a:gd name="connsiteX14" fmla="*/ 133791 w 159819"/>
                      <a:gd name="connsiteY14" fmla="*/ 98248 h 99477"/>
                      <a:gd name="connsiteX15" fmla="*/ 155281 w 159819"/>
                      <a:gd name="connsiteY15" fmla="*/ 84226 h 99477"/>
                      <a:gd name="connsiteX16" fmla="*/ 155770 w 159819"/>
                      <a:gd name="connsiteY16" fmla="*/ 53975 h 99477"/>
                      <a:gd name="connsiteX17" fmla="*/ 135987 w 159819"/>
                      <a:gd name="connsiteY17" fmla="*/ 34308 h 99477"/>
                      <a:gd name="connsiteX18" fmla="*/ 121578 w 159819"/>
                      <a:gd name="connsiteY18" fmla="*/ 19403 h 99477"/>
                      <a:gd name="connsiteX19" fmla="*/ 98620 w 159819"/>
                      <a:gd name="connsiteY19" fmla="*/ 9525 h 99477"/>
                      <a:gd name="connsiteX0" fmla="*/ 98620 w 159819"/>
                      <a:gd name="connsiteY0" fmla="*/ 9525 h 99477"/>
                      <a:gd name="connsiteX1" fmla="*/ 82745 w 159819"/>
                      <a:gd name="connsiteY1" fmla="*/ 6350 h 99477"/>
                      <a:gd name="connsiteX2" fmla="*/ 63695 w 159819"/>
                      <a:gd name="connsiteY2" fmla="*/ 0 h 99477"/>
                      <a:gd name="connsiteX3" fmla="*/ 25595 w 159819"/>
                      <a:gd name="connsiteY3" fmla="*/ 6350 h 99477"/>
                      <a:gd name="connsiteX4" fmla="*/ 6545 w 159819"/>
                      <a:gd name="connsiteY4" fmla="*/ 19050 h 99477"/>
                      <a:gd name="connsiteX5" fmla="*/ 195 w 159819"/>
                      <a:gd name="connsiteY5" fmla="*/ 28575 h 99477"/>
                      <a:gd name="connsiteX6" fmla="*/ 3370 w 159819"/>
                      <a:gd name="connsiteY6" fmla="*/ 47625 h 99477"/>
                      <a:gd name="connsiteX7" fmla="*/ 22420 w 159819"/>
                      <a:gd name="connsiteY7" fmla="*/ 63500 h 99477"/>
                      <a:gd name="connsiteX8" fmla="*/ 28770 w 159819"/>
                      <a:gd name="connsiteY8" fmla="*/ 73025 h 99477"/>
                      <a:gd name="connsiteX9" fmla="*/ 38295 w 159819"/>
                      <a:gd name="connsiteY9" fmla="*/ 76200 h 99477"/>
                      <a:gd name="connsiteX10" fmla="*/ 66870 w 159819"/>
                      <a:gd name="connsiteY10" fmla="*/ 88900 h 99477"/>
                      <a:gd name="connsiteX11" fmla="*/ 85920 w 159819"/>
                      <a:gd name="connsiteY11" fmla="*/ 95250 h 99477"/>
                      <a:gd name="connsiteX12" fmla="*/ 95445 w 159819"/>
                      <a:gd name="connsiteY12" fmla="*/ 98425 h 99477"/>
                      <a:gd name="connsiteX13" fmla="*/ 133791 w 159819"/>
                      <a:gd name="connsiteY13" fmla="*/ 98248 h 99477"/>
                      <a:gd name="connsiteX14" fmla="*/ 155281 w 159819"/>
                      <a:gd name="connsiteY14" fmla="*/ 84226 h 99477"/>
                      <a:gd name="connsiteX15" fmla="*/ 155770 w 159819"/>
                      <a:gd name="connsiteY15" fmla="*/ 53975 h 99477"/>
                      <a:gd name="connsiteX16" fmla="*/ 135987 w 159819"/>
                      <a:gd name="connsiteY16" fmla="*/ 34308 h 99477"/>
                      <a:gd name="connsiteX17" fmla="*/ 121578 w 159819"/>
                      <a:gd name="connsiteY17" fmla="*/ 19403 h 99477"/>
                      <a:gd name="connsiteX18" fmla="*/ 98620 w 159819"/>
                      <a:gd name="connsiteY18" fmla="*/ 9525 h 99477"/>
                      <a:gd name="connsiteX0" fmla="*/ 98620 w 159819"/>
                      <a:gd name="connsiteY0" fmla="*/ 9525 h 99477"/>
                      <a:gd name="connsiteX1" fmla="*/ 82745 w 159819"/>
                      <a:gd name="connsiteY1" fmla="*/ 6350 h 99477"/>
                      <a:gd name="connsiteX2" fmla="*/ 63695 w 159819"/>
                      <a:gd name="connsiteY2" fmla="*/ 0 h 99477"/>
                      <a:gd name="connsiteX3" fmla="*/ 25595 w 159819"/>
                      <a:gd name="connsiteY3" fmla="*/ 6350 h 99477"/>
                      <a:gd name="connsiteX4" fmla="*/ 6545 w 159819"/>
                      <a:gd name="connsiteY4" fmla="*/ 19050 h 99477"/>
                      <a:gd name="connsiteX5" fmla="*/ 195 w 159819"/>
                      <a:gd name="connsiteY5" fmla="*/ 28575 h 99477"/>
                      <a:gd name="connsiteX6" fmla="*/ 3370 w 159819"/>
                      <a:gd name="connsiteY6" fmla="*/ 47625 h 99477"/>
                      <a:gd name="connsiteX7" fmla="*/ 22420 w 159819"/>
                      <a:gd name="connsiteY7" fmla="*/ 63500 h 99477"/>
                      <a:gd name="connsiteX8" fmla="*/ 28770 w 159819"/>
                      <a:gd name="connsiteY8" fmla="*/ 73025 h 99477"/>
                      <a:gd name="connsiteX9" fmla="*/ 66870 w 159819"/>
                      <a:gd name="connsiteY9" fmla="*/ 88900 h 99477"/>
                      <a:gd name="connsiteX10" fmla="*/ 85920 w 159819"/>
                      <a:gd name="connsiteY10" fmla="*/ 95250 h 99477"/>
                      <a:gd name="connsiteX11" fmla="*/ 95445 w 159819"/>
                      <a:gd name="connsiteY11" fmla="*/ 98425 h 99477"/>
                      <a:gd name="connsiteX12" fmla="*/ 133791 w 159819"/>
                      <a:gd name="connsiteY12" fmla="*/ 98248 h 99477"/>
                      <a:gd name="connsiteX13" fmla="*/ 155281 w 159819"/>
                      <a:gd name="connsiteY13" fmla="*/ 84226 h 99477"/>
                      <a:gd name="connsiteX14" fmla="*/ 155770 w 159819"/>
                      <a:gd name="connsiteY14" fmla="*/ 53975 h 99477"/>
                      <a:gd name="connsiteX15" fmla="*/ 135987 w 159819"/>
                      <a:gd name="connsiteY15" fmla="*/ 34308 h 99477"/>
                      <a:gd name="connsiteX16" fmla="*/ 121578 w 159819"/>
                      <a:gd name="connsiteY16" fmla="*/ 19403 h 99477"/>
                      <a:gd name="connsiteX17" fmla="*/ 98620 w 159819"/>
                      <a:gd name="connsiteY17" fmla="*/ 9525 h 99477"/>
                      <a:gd name="connsiteX0" fmla="*/ 98620 w 159819"/>
                      <a:gd name="connsiteY0" fmla="*/ 9525 h 99477"/>
                      <a:gd name="connsiteX1" fmla="*/ 82745 w 159819"/>
                      <a:gd name="connsiteY1" fmla="*/ 6350 h 99477"/>
                      <a:gd name="connsiteX2" fmla="*/ 63695 w 159819"/>
                      <a:gd name="connsiteY2" fmla="*/ 0 h 99477"/>
                      <a:gd name="connsiteX3" fmla="*/ 25595 w 159819"/>
                      <a:gd name="connsiteY3" fmla="*/ 6350 h 99477"/>
                      <a:gd name="connsiteX4" fmla="*/ 6545 w 159819"/>
                      <a:gd name="connsiteY4" fmla="*/ 19050 h 99477"/>
                      <a:gd name="connsiteX5" fmla="*/ 195 w 159819"/>
                      <a:gd name="connsiteY5" fmla="*/ 28575 h 99477"/>
                      <a:gd name="connsiteX6" fmla="*/ 3370 w 159819"/>
                      <a:gd name="connsiteY6" fmla="*/ 47625 h 99477"/>
                      <a:gd name="connsiteX7" fmla="*/ 22420 w 159819"/>
                      <a:gd name="connsiteY7" fmla="*/ 63500 h 99477"/>
                      <a:gd name="connsiteX8" fmla="*/ 28770 w 159819"/>
                      <a:gd name="connsiteY8" fmla="*/ 73025 h 99477"/>
                      <a:gd name="connsiteX9" fmla="*/ 49772 w 159819"/>
                      <a:gd name="connsiteY9" fmla="*/ 85901 h 99477"/>
                      <a:gd name="connsiteX10" fmla="*/ 85920 w 159819"/>
                      <a:gd name="connsiteY10" fmla="*/ 95250 h 99477"/>
                      <a:gd name="connsiteX11" fmla="*/ 95445 w 159819"/>
                      <a:gd name="connsiteY11" fmla="*/ 98425 h 99477"/>
                      <a:gd name="connsiteX12" fmla="*/ 133791 w 159819"/>
                      <a:gd name="connsiteY12" fmla="*/ 98248 h 99477"/>
                      <a:gd name="connsiteX13" fmla="*/ 155281 w 159819"/>
                      <a:gd name="connsiteY13" fmla="*/ 84226 h 99477"/>
                      <a:gd name="connsiteX14" fmla="*/ 155770 w 159819"/>
                      <a:gd name="connsiteY14" fmla="*/ 53975 h 99477"/>
                      <a:gd name="connsiteX15" fmla="*/ 135987 w 159819"/>
                      <a:gd name="connsiteY15" fmla="*/ 34308 h 99477"/>
                      <a:gd name="connsiteX16" fmla="*/ 121578 w 159819"/>
                      <a:gd name="connsiteY16" fmla="*/ 19403 h 99477"/>
                      <a:gd name="connsiteX17" fmla="*/ 98620 w 159819"/>
                      <a:gd name="connsiteY17" fmla="*/ 9525 h 99477"/>
                      <a:gd name="connsiteX0" fmla="*/ 98620 w 159819"/>
                      <a:gd name="connsiteY0" fmla="*/ 9525 h 98848"/>
                      <a:gd name="connsiteX1" fmla="*/ 82745 w 159819"/>
                      <a:gd name="connsiteY1" fmla="*/ 6350 h 98848"/>
                      <a:gd name="connsiteX2" fmla="*/ 63695 w 159819"/>
                      <a:gd name="connsiteY2" fmla="*/ 0 h 98848"/>
                      <a:gd name="connsiteX3" fmla="*/ 25595 w 159819"/>
                      <a:gd name="connsiteY3" fmla="*/ 6350 h 98848"/>
                      <a:gd name="connsiteX4" fmla="*/ 6545 w 159819"/>
                      <a:gd name="connsiteY4" fmla="*/ 19050 h 98848"/>
                      <a:gd name="connsiteX5" fmla="*/ 195 w 159819"/>
                      <a:gd name="connsiteY5" fmla="*/ 28575 h 98848"/>
                      <a:gd name="connsiteX6" fmla="*/ 3370 w 159819"/>
                      <a:gd name="connsiteY6" fmla="*/ 47625 h 98848"/>
                      <a:gd name="connsiteX7" fmla="*/ 22420 w 159819"/>
                      <a:gd name="connsiteY7" fmla="*/ 63500 h 98848"/>
                      <a:gd name="connsiteX8" fmla="*/ 28770 w 159819"/>
                      <a:gd name="connsiteY8" fmla="*/ 73025 h 98848"/>
                      <a:gd name="connsiteX9" fmla="*/ 49772 w 159819"/>
                      <a:gd name="connsiteY9" fmla="*/ 85901 h 98848"/>
                      <a:gd name="connsiteX10" fmla="*/ 85920 w 159819"/>
                      <a:gd name="connsiteY10" fmla="*/ 95250 h 98848"/>
                      <a:gd name="connsiteX11" fmla="*/ 133791 w 159819"/>
                      <a:gd name="connsiteY11" fmla="*/ 98248 h 98848"/>
                      <a:gd name="connsiteX12" fmla="*/ 155281 w 159819"/>
                      <a:gd name="connsiteY12" fmla="*/ 84226 h 98848"/>
                      <a:gd name="connsiteX13" fmla="*/ 155770 w 159819"/>
                      <a:gd name="connsiteY13" fmla="*/ 53975 h 98848"/>
                      <a:gd name="connsiteX14" fmla="*/ 135987 w 159819"/>
                      <a:gd name="connsiteY14" fmla="*/ 34308 h 98848"/>
                      <a:gd name="connsiteX15" fmla="*/ 121578 w 159819"/>
                      <a:gd name="connsiteY15" fmla="*/ 19403 h 98848"/>
                      <a:gd name="connsiteX16" fmla="*/ 98620 w 159819"/>
                      <a:gd name="connsiteY16" fmla="*/ 9525 h 98848"/>
                      <a:gd name="connsiteX0" fmla="*/ 98620 w 159819"/>
                      <a:gd name="connsiteY0" fmla="*/ 9525 h 98848"/>
                      <a:gd name="connsiteX1" fmla="*/ 82745 w 159819"/>
                      <a:gd name="connsiteY1" fmla="*/ 6350 h 98848"/>
                      <a:gd name="connsiteX2" fmla="*/ 63695 w 159819"/>
                      <a:gd name="connsiteY2" fmla="*/ 0 h 98848"/>
                      <a:gd name="connsiteX3" fmla="*/ 25595 w 159819"/>
                      <a:gd name="connsiteY3" fmla="*/ 6350 h 98848"/>
                      <a:gd name="connsiteX4" fmla="*/ 6545 w 159819"/>
                      <a:gd name="connsiteY4" fmla="*/ 19050 h 98848"/>
                      <a:gd name="connsiteX5" fmla="*/ 195 w 159819"/>
                      <a:gd name="connsiteY5" fmla="*/ 28575 h 98848"/>
                      <a:gd name="connsiteX6" fmla="*/ 3370 w 159819"/>
                      <a:gd name="connsiteY6" fmla="*/ 47625 h 98848"/>
                      <a:gd name="connsiteX7" fmla="*/ 22420 w 159819"/>
                      <a:gd name="connsiteY7" fmla="*/ 63500 h 98848"/>
                      <a:gd name="connsiteX8" fmla="*/ 49772 w 159819"/>
                      <a:gd name="connsiteY8" fmla="*/ 85901 h 98848"/>
                      <a:gd name="connsiteX9" fmla="*/ 85920 w 159819"/>
                      <a:gd name="connsiteY9" fmla="*/ 95250 h 98848"/>
                      <a:gd name="connsiteX10" fmla="*/ 133791 w 159819"/>
                      <a:gd name="connsiteY10" fmla="*/ 98248 h 98848"/>
                      <a:gd name="connsiteX11" fmla="*/ 155281 w 159819"/>
                      <a:gd name="connsiteY11" fmla="*/ 84226 h 98848"/>
                      <a:gd name="connsiteX12" fmla="*/ 155770 w 159819"/>
                      <a:gd name="connsiteY12" fmla="*/ 53975 h 98848"/>
                      <a:gd name="connsiteX13" fmla="*/ 135987 w 159819"/>
                      <a:gd name="connsiteY13" fmla="*/ 34308 h 98848"/>
                      <a:gd name="connsiteX14" fmla="*/ 121578 w 159819"/>
                      <a:gd name="connsiteY14" fmla="*/ 19403 h 98848"/>
                      <a:gd name="connsiteX15" fmla="*/ 98620 w 159819"/>
                      <a:gd name="connsiteY15" fmla="*/ 9525 h 98848"/>
                      <a:gd name="connsiteX0" fmla="*/ 98641 w 159840"/>
                      <a:gd name="connsiteY0" fmla="*/ 9525 h 98848"/>
                      <a:gd name="connsiteX1" fmla="*/ 82766 w 159840"/>
                      <a:gd name="connsiteY1" fmla="*/ 6350 h 98848"/>
                      <a:gd name="connsiteX2" fmla="*/ 63716 w 159840"/>
                      <a:gd name="connsiteY2" fmla="*/ 0 h 98848"/>
                      <a:gd name="connsiteX3" fmla="*/ 25616 w 159840"/>
                      <a:gd name="connsiteY3" fmla="*/ 6350 h 98848"/>
                      <a:gd name="connsiteX4" fmla="*/ 6566 w 159840"/>
                      <a:gd name="connsiteY4" fmla="*/ 19050 h 98848"/>
                      <a:gd name="connsiteX5" fmla="*/ 216 w 159840"/>
                      <a:gd name="connsiteY5" fmla="*/ 28575 h 98848"/>
                      <a:gd name="connsiteX6" fmla="*/ 3391 w 159840"/>
                      <a:gd name="connsiteY6" fmla="*/ 47625 h 98848"/>
                      <a:gd name="connsiteX7" fmla="*/ 17313 w 159840"/>
                      <a:gd name="connsiteY7" fmla="*/ 70996 h 98848"/>
                      <a:gd name="connsiteX8" fmla="*/ 49793 w 159840"/>
                      <a:gd name="connsiteY8" fmla="*/ 85901 h 98848"/>
                      <a:gd name="connsiteX9" fmla="*/ 85941 w 159840"/>
                      <a:gd name="connsiteY9" fmla="*/ 95250 h 98848"/>
                      <a:gd name="connsiteX10" fmla="*/ 133812 w 159840"/>
                      <a:gd name="connsiteY10" fmla="*/ 98248 h 98848"/>
                      <a:gd name="connsiteX11" fmla="*/ 155302 w 159840"/>
                      <a:gd name="connsiteY11" fmla="*/ 84226 h 98848"/>
                      <a:gd name="connsiteX12" fmla="*/ 155791 w 159840"/>
                      <a:gd name="connsiteY12" fmla="*/ 53975 h 98848"/>
                      <a:gd name="connsiteX13" fmla="*/ 136008 w 159840"/>
                      <a:gd name="connsiteY13" fmla="*/ 34308 h 98848"/>
                      <a:gd name="connsiteX14" fmla="*/ 121599 w 159840"/>
                      <a:gd name="connsiteY14" fmla="*/ 19403 h 98848"/>
                      <a:gd name="connsiteX15" fmla="*/ 98641 w 159840"/>
                      <a:gd name="connsiteY15" fmla="*/ 9525 h 9884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</a:cxnLst>
                    <a:rect l="l" t="t" r="r" b="b"/>
                    <a:pathLst>
                      <a:path w="159840" h="98848">
                        <a:moveTo>
                          <a:pt x="98641" y="9525"/>
                        </a:moveTo>
                        <a:cubicBezTo>
                          <a:pt x="92169" y="7350"/>
                          <a:pt x="87972" y="7770"/>
                          <a:pt x="82766" y="6350"/>
                        </a:cubicBezTo>
                        <a:cubicBezTo>
                          <a:pt x="76308" y="4589"/>
                          <a:pt x="63716" y="0"/>
                          <a:pt x="63716" y="0"/>
                        </a:cubicBezTo>
                        <a:cubicBezTo>
                          <a:pt x="58470" y="583"/>
                          <a:pt x="34924" y="1179"/>
                          <a:pt x="25616" y="6350"/>
                        </a:cubicBezTo>
                        <a:cubicBezTo>
                          <a:pt x="18945" y="10056"/>
                          <a:pt x="6566" y="19050"/>
                          <a:pt x="6566" y="19050"/>
                        </a:cubicBezTo>
                        <a:cubicBezTo>
                          <a:pt x="4449" y="22225"/>
                          <a:pt x="637" y="24782"/>
                          <a:pt x="216" y="28575"/>
                        </a:cubicBezTo>
                        <a:cubicBezTo>
                          <a:pt x="-495" y="34973"/>
                          <a:pt x="542" y="40555"/>
                          <a:pt x="3391" y="47625"/>
                        </a:cubicBezTo>
                        <a:cubicBezTo>
                          <a:pt x="6240" y="54695"/>
                          <a:pt x="12253" y="67623"/>
                          <a:pt x="17313" y="70996"/>
                        </a:cubicBezTo>
                        <a:cubicBezTo>
                          <a:pt x="25047" y="77375"/>
                          <a:pt x="38355" y="81859"/>
                          <a:pt x="49793" y="85901"/>
                        </a:cubicBezTo>
                        <a:cubicBezTo>
                          <a:pt x="61231" y="89943"/>
                          <a:pt x="71938" y="93192"/>
                          <a:pt x="85941" y="95250"/>
                        </a:cubicBezTo>
                        <a:cubicBezTo>
                          <a:pt x="99944" y="97308"/>
                          <a:pt x="122252" y="100085"/>
                          <a:pt x="133812" y="98248"/>
                        </a:cubicBezTo>
                        <a:cubicBezTo>
                          <a:pt x="145372" y="96411"/>
                          <a:pt x="147364" y="91105"/>
                          <a:pt x="155302" y="84226"/>
                        </a:cubicBezTo>
                        <a:cubicBezTo>
                          <a:pt x="163240" y="77347"/>
                          <a:pt x="159007" y="62295"/>
                          <a:pt x="155791" y="53975"/>
                        </a:cubicBezTo>
                        <a:cubicBezTo>
                          <a:pt x="152575" y="45655"/>
                          <a:pt x="141707" y="40070"/>
                          <a:pt x="136008" y="34308"/>
                        </a:cubicBezTo>
                        <a:cubicBezTo>
                          <a:pt x="130309" y="28546"/>
                          <a:pt x="127827" y="23534"/>
                          <a:pt x="121599" y="19403"/>
                        </a:cubicBezTo>
                        <a:cubicBezTo>
                          <a:pt x="115371" y="15273"/>
                          <a:pt x="105113" y="11700"/>
                          <a:pt x="98641" y="9525"/>
                        </a:cubicBezTo>
                        <a:close/>
                      </a:path>
                    </a:pathLst>
                  </a:custGeom>
                  <a:solidFill>
                    <a:srgbClr val="8FAADC"/>
                  </a:solidFill>
                  <a:ln>
                    <a:solidFill>
                      <a:schemeClr val="accent5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60" name="Freeform 123">
                    <a:extLst>
                      <a:ext uri="{FF2B5EF4-FFF2-40B4-BE49-F238E27FC236}">
                        <a16:creationId xmlns:a16="http://schemas.microsoft.com/office/drawing/2014/main" id="{80D6DF69-FA1A-4DB5-B3A8-E9F5FFEE6E6A}"/>
                      </a:ext>
                    </a:extLst>
                  </p:cNvPr>
                  <p:cNvSpPr/>
                  <p:nvPr/>
                </p:nvSpPr>
                <p:spPr>
                  <a:xfrm rot="683873" flipH="1">
                    <a:off x="6802011" y="4979479"/>
                    <a:ext cx="124368" cy="91915"/>
                  </a:xfrm>
                  <a:custGeom>
                    <a:avLst/>
                    <a:gdLst>
                      <a:gd name="connsiteX0" fmla="*/ 60085 w 85509"/>
                      <a:gd name="connsiteY0" fmla="*/ 1495 h 51080"/>
                      <a:gd name="connsiteX1" fmla="*/ 2935 w 85509"/>
                      <a:gd name="connsiteY1" fmla="*/ 4670 h 51080"/>
                      <a:gd name="connsiteX2" fmla="*/ 6110 w 85509"/>
                      <a:gd name="connsiteY2" fmla="*/ 30070 h 51080"/>
                      <a:gd name="connsiteX3" fmla="*/ 9285 w 85509"/>
                      <a:gd name="connsiteY3" fmla="*/ 39595 h 51080"/>
                      <a:gd name="connsiteX4" fmla="*/ 28335 w 85509"/>
                      <a:gd name="connsiteY4" fmla="*/ 45945 h 51080"/>
                      <a:gd name="connsiteX5" fmla="*/ 37860 w 85509"/>
                      <a:gd name="connsiteY5" fmla="*/ 49120 h 51080"/>
                      <a:gd name="connsiteX6" fmla="*/ 85485 w 85509"/>
                      <a:gd name="connsiteY6" fmla="*/ 36420 h 51080"/>
                      <a:gd name="connsiteX7" fmla="*/ 82310 w 85509"/>
                      <a:gd name="connsiteY7" fmla="*/ 17370 h 51080"/>
                      <a:gd name="connsiteX8" fmla="*/ 63260 w 85509"/>
                      <a:gd name="connsiteY8" fmla="*/ 4670 h 51080"/>
                      <a:gd name="connsiteX9" fmla="*/ 60085 w 85509"/>
                      <a:gd name="connsiteY9" fmla="*/ 1495 h 51080"/>
                      <a:gd name="connsiteX0" fmla="*/ 32416 w 84235"/>
                      <a:gd name="connsiteY0" fmla="*/ 0 h 54518"/>
                      <a:gd name="connsiteX1" fmla="*/ 1661 w 84235"/>
                      <a:gd name="connsiteY1" fmla="*/ 8108 h 54518"/>
                      <a:gd name="connsiteX2" fmla="*/ 4836 w 84235"/>
                      <a:gd name="connsiteY2" fmla="*/ 33508 h 54518"/>
                      <a:gd name="connsiteX3" fmla="*/ 8011 w 84235"/>
                      <a:gd name="connsiteY3" fmla="*/ 43033 h 54518"/>
                      <a:gd name="connsiteX4" fmla="*/ 27061 w 84235"/>
                      <a:gd name="connsiteY4" fmla="*/ 49383 h 54518"/>
                      <a:gd name="connsiteX5" fmla="*/ 36586 w 84235"/>
                      <a:gd name="connsiteY5" fmla="*/ 52558 h 54518"/>
                      <a:gd name="connsiteX6" fmla="*/ 84211 w 84235"/>
                      <a:gd name="connsiteY6" fmla="*/ 39858 h 54518"/>
                      <a:gd name="connsiteX7" fmla="*/ 81036 w 84235"/>
                      <a:gd name="connsiteY7" fmla="*/ 20808 h 54518"/>
                      <a:gd name="connsiteX8" fmla="*/ 61986 w 84235"/>
                      <a:gd name="connsiteY8" fmla="*/ 8108 h 54518"/>
                      <a:gd name="connsiteX9" fmla="*/ 32416 w 84235"/>
                      <a:gd name="connsiteY9" fmla="*/ 0 h 54518"/>
                      <a:gd name="connsiteX0" fmla="*/ 32416 w 85177"/>
                      <a:gd name="connsiteY0" fmla="*/ 0 h 56669"/>
                      <a:gd name="connsiteX1" fmla="*/ 1661 w 85177"/>
                      <a:gd name="connsiteY1" fmla="*/ 8108 h 56669"/>
                      <a:gd name="connsiteX2" fmla="*/ 4836 w 85177"/>
                      <a:gd name="connsiteY2" fmla="*/ 33508 h 56669"/>
                      <a:gd name="connsiteX3" fmla="*/ 8011 w 85177"/>
                      <a:gd name="connsiteY3" fmla="*/ 43033 h 56669"/>
                      <a:gd name="connsiteX4" fmla="*/ 27061 w 85177"/>
                      <a:gd name="connsiteY4" fmla="*/ 49383 h 56669"/>
                      <a:gd name="connsiteX5" fmla="*/ 68057 w 85177"/>
                      <a:gd name="connsiteY5" fmla="*/ 56669 h 56669"/>
                      <a:gd name="connsiteX6" fmla="*/ 84211 w 85177"/>
                      <a:gd name="connsiteY6" fmla="*/ 39858 h 56669"/>
                      <a:gd name="connsiteX7" fmla="*/ 81036 w 85177"/>
                      <a:gd name="connsiteY7" fmla="*/ 20808 h 56669"/>
                      <a:gd name="connsiteX8" fmla="*/ 61986 w 85177"/>
                      <a:gd name="connsiteY8" fmla="*/ 8108 h 56669"/>
                      <a:gd name="connsiteX9" fmla="*/ 32416 w 85177"/>
                      <a:gd name="connsiteY9" fmla="*/ 0 h 56669"/>
                      <a:gd name="connsiteX0" fmla="*/ 32990 w 85751"/>
                      <a:gd name="connsiteY0" fmla="*/ 0 h 56669"/>
                      <a:gd name="connsiteX1" fmla="*/ 2235 w 85751"/>
                      <a:gd name="connsiteY1" fmla="*/ 8108 h 56669"/>
                      <a:gd name="connsiteX2" fmla="*/ 3380 w 85751"/>
                      <a:gd name="connsiteY2" fmla="*/ 25286 h 56669"/>
                      <a:gd name="connsiteX3" fmla="*/ 8585 w 85751"/>
                      <a:gd name="connsiteY3" fmla="*/ 43033 h 56669"/>
                      <a:gd name="connsiteX4" fmla="*/ 27635 w 85751"/>
                      <a:gd name="connsiteY4" fmla="*/ 49383 h 56669"/>
                      <a:gd name="connsiteX5" fmla="*/ 68631 w 85751"/>
                      <a:gd name="connsiteY5" fmla="*/ 56669 h 56669"/>
                      <a:gd name="connsiteX6" fmla="*/ 84785 w 85751"/>
                      <a:gd name="connsiteY6" fmla="*/ 39858 h 56669"/>
                      <a:gd name="connsiteX7" fmla="*/ 81610 w 85751"/>
                      <a:gd name="connsiteY7" fmla="*/ 20808 h 56669"/>
                      <a:gd name="connsiteX8" fmla="*/ 62560 w 85751"/>
                      <a:gd name="connsiteY8" fmla="*/ 8108 h 56669"/>
                      <a:gd name="connsiteX9" fmla="*/ 32990 w 85751"/>
                      <a:gd name="connsiteY9" fmla="*/ 0 h 56669"/>
                      <a:gd name="connsiteX0" fmla="*/ 32990 w 86576"/>
                      <a:gd name="connsiteY0" fmla="*/ 0 h 55777"/>
                      <a:gd name="connsiteX1" fmla="*/ 2235 w 86576"/>
                      <a:gd name="connsiteY1" fmla="*/ 8108 h 55777"/>
                      <a:gd name="connsiteX2" fmla="*/ 3380 w 86576"/>
                      <a:gd name="connsiteY2" fmla="*/ 25286 h 55777"/>
                      <a:gd name="connsiteX3" fmla="*/ 8585 w 86576"/>
                      <a:gd name="connsiteY3" fmla="*/ 43033 h 55777"/>
                      <a:gd name="connsiteX4" fmla="*/ 27635 w 86576"/>
                      <a:gd name="connsiteY4" fmla="*/ 49383 h 55777"/>
                      <a:gd name="connsiteX5" fmla="*/ 57454 w 86576"/>
                      <a:gd name="connsiteY5" fmla="*/ 55777 h 55777"/>
                      <a:gd name="connsiteX6" fmla="*/ 84785 w 86576"/>
                      <a:gd name="connsiteY6" fmla="*/ 39858 h 55777"/>
                      <a:gd name="connsiteX7" fmla="*/ 81610 w 86576"/>
                      <a:gd name="connsiteY7" fmla="*/ 20808 h 55777"/>
                      <a:gd name="connsiteX8" fmla="*/ 62560 w 86576"/>
                      <a:gd name="connsiteY8" fmla="*/ 8108 h 55777"/>
                      <a:gd name="connsiteX9" fmla="*/ 32990 w 86576"/>
                      <a:gd name="connsiteY9" fmla="*/ 0 h 55777"/>
                      <a:gd name="connsiteX0" fmla="*/ 33222 w 86808"/>
                      <a:gd name="connsiteY0" fmla="*/ 0 h 55777"/>
                      <a:gd name="connsiteX1" fmla="*/ 2467 w 86808"/>
                      <a:gd name="connsiteY1" fmla="*/ 8108 h 55777"/>
                      <a:gd name="connsiteX2" fmla="*/ 3612 w 86808"/>
                      <a:gd name="connsiteY2" fmla="*/ 25286 h 55777"/>
                      <a:gd name="connsiteX3" fmla="*/ 17480 w 86808"/>
                      <a:gd name="connsiteY3" fmla="*/ 40161 h 55777"/>
                      <a:gd name="connsiteX4" fmla="*/ 27867 w 86808"/>
                      <a:gd name="connsiteY4" fmla="*/ 49383 h 55777"/>
                      <a:gd name="connsiteX5" fmla="*/ 57686 w 86808"/>
                      <a:gd name="connsiteY5" fmla="*/ 55777 h 55777"/>
                      <a:gd name="connsiteX6" fmla="*/ 85017 w 86808"/>
                      <a:gd name="connsiteY6" fmla="*/ 39858 h 55777"/>
                      <a:gd name="connsiteX7" fmla="*/ 81842 w 86808"/>
                      <a:gd name="connsiteY7" fmla="*/ 20808 h 55777"/>
                      <a:gd name="connsiteX8" fmla="*/ 62792 w 86808"/>
                      <a:gd name="connsiteY8" fmla="*/ 8108 h 55777"/>
                      <a:gd name="connsiteX9" fmla="*/ 33222 w 86808"/>
                      <a:gd name="connsiteY9" fmla="*/ 0 h 55777"/>
                      <a:gd name="connsiteX0" fmla="*/ 33222 w 86808"/>
                      <a:gd name="connsiteY0" fmla="*/ 0 h 55997"/>
                      <a:gd name="connsiteX1" fmla="*/ 2467 w 86808"/>
                      <a:gd name="connsiteY1" fmla="*/ 8108 h 55997"/>
                      <a:gd name="connsiteX2" fmla="*/ 3612 w 86808"/>
                      <a:gd name="connsiteY2" fmla="*/ 25286 h 55997"/>
                      <a:gd name="connsiteX3" fmla="*/ 17480 w 86808"/>
                      <a:gd name="connsiteY3" fmla="*/ 40161 h 55997"/>
                      <a:gd name="connsiteX4" fmla="*/ 38244 w 86808"/>
                      <a:gd name="connsiteY4" fmla="*/ 48548 h 55997"/>
                      <a:gd name="connsiteX5" fmla="*/ 57686 w 86808"/>
                      <a:gd name="connsiteY5" fmla="*/ 55777 h 55997"/>
                      <a:gd name="connsiteX6" fmla="*/ 85017 w 86808"/>
                      <a:gd name="connsiteY6" fmla="*/ 39858 h 55997"/>
                      <a:gd name="connsiteX7" fmla="*/ 81842 w 86808"/>
                      <a:gd name="connsiteY7" fmla="*/ 20808 h 55997"/>
                      <a:gd name="connsiteX8" fmla="*/ 62792 w 86808"/>
                      <a:gd name="connsiteY8" fmla="*/ 8108 h 55997"/>
                      <a:gd name="connsiteX9" fmla="*/ 33222 w 86808"/>
                      <a:gd name="connsiteY9" fmla="*/ 0 h 55997"/>
                      <a:gd name="connsiteX0" fmla="*/ 33222 w 86316"/>
                      <a:gd name="connsiteY0" fmla="*/ 0 h 49638"/>
                      <a:gd name="connsiteX1" fmla="*/ 2467 w 86316"/>
                      <a:gd name="connsiteY1" fmla="*/ 8108 h 49638"/>
                      <a:gd name="connsiteX2" fmla="*/ 3612 w 86316"/>
                      <a:gd name="connsiteY2" fmla="*/ 25286 h 49638"/>
                      <a:gd name="connsiteX3" fmla="*/ 17480 w 86316"/>
                      <a:gd name="connsiteY3" fmla="*/ 40161 h 49638"/>
                      <a:gd name="connsiteX4" fmla="*/ 38244 w 86316"/>
                      <a:gd name="connsiteY4" fmla="*/ 48548 h 49638"/>
                      <a:gd name="connsiteX5" fmla="*/ 64347 w 86316"/>
                      <a:gd name="connsiteY5" fmla="*/ 48588 h 49638"/>
                      <a:gd name="connsiteX6" fmla="*/ 85017 w 86316"/>
                      <a:gd name="connsiteY6" fmla="*/ 39858 h 49638"/>
                      <a:gd name="connsiteX7" fmla="*/ 81842 w 86316"/>
                      <a:gd name="connsiteY7" fmla="*/ 20808 h 49638"/>
                      <a:gd name="connsiteX8" fmla="*/ 62792 w 86316"/>
                      <a:gd name="connsiteY8" fmla="*/ 8108 h 49638"/>
                      <a:gd name="connsiteX9" fmla="*/ 33222 w 86316"/>
                      <a:gd name="connsiteY9" fmla="*/ 0 h 4963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86316" h="49638">
                        <a:moveTo>
                          <a:pt x="33222" y="0"/>
                        </a:moveTo>
                        <a:cubicBezTo>
                          <a:pt x="14172" y="1058"/>
                          <a:pt x="7402" y="3894"/>
                          <a:pt x="2467" y="8108"/>
                        </a:cubicBezTo>
                        <a:cubicBezTo>
                          <a:pt x="-2468" y="12322"/>
                          <a:pt x="1110" y="19944"/>
                          <a:pt x="3612" y="25286"/>
                        </a:cubicBezTo>
                        <a:cubicBezTo>
                          <a:pt x="6114" y="30628"/>
                          <a:pt x="11708" y="36284"/>
                          <a:pt x="17480" y="40161"/>
                        </a:cubicBezTo>
                        <a:cubicBezTo>
                          <a:pt x="23252" y="44038"/>
                          <a:pt x="30433" y="47144"/>
                          <a:pt x="38244" y="48548"/>
                        </a:cubicBezTo>
                        <a:cubicBezTo>
                          <a:pt x="46055" y="49952"/>
                          <a:pt x="56552" y="50036"/>
                          <a:pt x="64347" y="48588"/>
                        </a:cubicBezTo>
                        <a:cubicBezTo>
                          <a:pt x="72142" y="47140"/>
                          <a:pt x="82101" y="44488"/>
                          <a:pt x="85017" y="39858"/>
                        </a:cubicBezTo>
                        <a:cubicBezTo>
                          <a:pt x="87933" y="35228"/>
                          <a:pt x="85534" y="26082"/>
                          <a:pt x="81842" y="20808"/>
                        </a:cubicBezTo>
                        <a:cubicBezTo>
                          <a:pt x="77465" y="14556"/>
                          <a:pt x="68188" y="13504"/>
                          <a:pt x="62792" y="8108"/>
                        </a:cubicBezTo>
                        <a:lnTo>
                          <a:pt x="33222" y="0"/>
                        </a:lnTo>
                        <a:close/>
                      </a:path>
                    </a:pathLst>
                  </a:custGeom>
                  <a:solidFill>
                    <a:srgbClr val="8FAADC"/>
                  </a:solidFill>
                  <a:ln>
                    <a:solidFill>
                      <a:schemeClr val="accent5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</p:grp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E2D38C9E-CCCA-4C19-B0C3-154EE55531F8}"/>
                </a:ext>
              </a:extLst>
            </p:cNvPr>
            <p:cNvCxnSpPr>
              <a:cxnSpLocks/>
            </p:cNvCxnSpPr>
            <p:nvPr/>
          </p:nvCxnSpPr>
          <p:spPr>
            <a:xfrm>
              <a:off x="3953774" y="846582"/>
              <a:ext cx="460248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3C4801D3-27E4-46E8-9924-4EEA629C35E6}"/>
                </a:ext>
              </a:extLst>
            </p:cNvPr>
            <p:cNvCxnSpPr>
              <a:cxnSpLocks/>
            </p:cNvCxnSpPr>
            <p:nvPr/>
          </p:nvCxnSpPr>
          <p:spPr>
            <a:xfrm>
              <a:off x="5021220" y="844763"/>
              <a:ext cx="456554" cy="33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6BBC31E4-C49E-454F-A233-A5D344963753}"/>
                </a:ext>
              </a:extLst>
            </p:cNvPr>
            <p:cNvCxnSpPr>
              <a:cxnSpLocks/>
            </p:cNvCxnSpPr>
            <p:nvPr/>
          </p:nvCxnSpPr>
          <p:spPr>
            <a:xfrm>
              <a:off x="5092202" y="1984094"/>
              <a:ext cx="43147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DAD379D0-27CE-4CE4-8DA7-208C105351DE}"/>
                </a:ext>
              </a:extLst>
            </p:cNvPr>
            <p:cNvCxnSpPr>
              <a:cxnSpLocks/>
            </p:cNvCxnSpPr>
            <p:nvPr/>
          </p:nvCxnSpPr>
          <p:spPr>
            <a:xfrm>
              <a:off x="4020378" y="1977246"/>
              <a:ext cx="43147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7C7519C4-3D04-4236-84FD-6121C6FB668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81603" y="5568923"/>
              <a:ext cx="539080" cy="440258"/>
              <a:chOff x="4891219" y="3406769"/>
              <a:chExt cx="508308" cy="415133"/>
            </a:xfrm>
          </p:grpSpPr>
          <p:pic>
            <p:nvPicPr>
              <p:cNvPr id="78" name="Picture 77">
                <a:extLst>
                  <a:ext uri="{FF2B5EF4-FFF2-40B4-BE49-F238E27FC236}">
                    <a16:creationId xmlns:a16="http://schemas.microsoft.com/office/drawing/2014/main" id="{C845E9A3-5FC7-4A5C-B4BD-F4987BD8C6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3280" t="66369" r="3143" b="24765"/>
              <a:stretch/>
            </p:blipFill>
            <p:spPr>
              <a:xfrm>
                <a:off x="4910296" y="3406769"/>
                <a:ext cx="489231" cy="415133"/>
              </a:xfrm>
              <a:prstGeom prst="rect">
                <a:avLst/>
              </a:prstGeom>
            </p:spPr>
          </p:pic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5ADBAFD9-6937-42D4-9C63-50A87F9EF9CA}"/>
                  </a:ext>
                </a:extLst>
              </p:cNvPr>
              <p:cNvSpPr txBox="1"/>
              <p:nvPr/>
            </p:nvSpPr>
            <p:spPr>
              <a:xfrm>
                <a:off x="4891219" y="3422646"/>
                <a:ext cx="237566" cy="3420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>
                    <a:solidFill>
                      <a:schemeClr val="bg2">
                        <a:lumMod val="50000"/>
                      </a:schemeClr>
                    </a:solidFill>
                  </a:rPr>
                  <a:t>.</a:t>
                </a:r>
              </a:p>
            </p:txBody>
          </p:sp>
        </p:grp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86A58784-C2A3-4EC9-89ED-652884E05427}"/>
                </a:ext>
              </a:extLst>
            </p:cNvPr>
            <p:cNvSpPr/>
            <p:nvPr/>
          </p:nvSpPr>
          <p:spPr>
            <a:xfrm>
              <a:off x="5690562" y="5655679"/>
              <a:ext cx="83510" cy="3865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565167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8E54C160-EB29-4255-B9CD-71CE2335B6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801" y="441960"/>
            <a:ext cx="64087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8" name="Footer Placeholder 2">
            <a:extLst>
              <a:ext uri="{FF2B5EF4-FFF2-40B4-BE49-F238E27FC236}">
                <a16:creationId xmlns:a16="http://schemas.microsoft.com/office/drawing/2014/main" id="{F4305BB8-5A1D-4E99-A789-A7B4D17DF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013881"/>
            <a:ext cx="6408738" cy="1372003"/>
          </a:xfrm>
        </p:spPr>
        <p:txBody>
          <a:bodyPr anchor="t" anchorCtr="0"/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gure S4 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2W1S:I-Ab tetramer</a:t>
            </a:r>
            <a:r>
              <a:rPr lang="en-GB" sz="12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+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CD4 T cells in the colon and MLN express T-bet and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IFNγ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but not ROR</a:t>
            </a:r>
            <a:r>
              <a:rPr lang="el-GR" sz="1200" dirty="0">
                <a:solidFill>
                  <a:schemeClr val="tx1"/>
                </a:solidFill>
                <a:latin typeface="Calibri" panose="020F0502020204030204" pitchFamily="34" charset="0"/>
              </a:rPr>
              <a:t>γ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T, FoxP3 or IL17A. </a:t>
            </a:r>
            <a:r>
              <a:rPr lang="en-GB" sz="1200" b="1" dirty="0">
                <a:solidFill>
                  <a:schemeClr val="tx1"/>
                </a:solidFill>
                <a:latin typeface="Calibri" panose="020F0502020204030204" pitchFamily="34" charset="0"/>
              </a:rPr>
              <a:t>a 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Representative plots of TF expression by colonic CD4 T cells that are tetramer</a:t>
            </a:r>
            <a:r>
              <a:rPr lang="en-GB" sz="16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-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or tetramer</a:t>
            </a:r>
            <a:r>
              <a:rPr lang="en-GB" sz="12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+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. </a:t>
            </a:r>
            <a:r>
              <a:rPr lang="en-GB" sz="1200" b="1" dirty="0">
                <a:solidFill>
                  <a:schemeClr val="tx1"/>
                </a:solidFill>
                <a:latin typeface="Calibri" panose="020F0502020204030204" pitchFamily="34" charset="0"/>
              </a:rPr>
              <a:t>b 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Tetramer</a:t>
            </a:r>
            <a:r>
              <a:rPr lang="en-GB" sz="12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+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cells in the colon (left) and MLN (right) are predominantly T-bet</a:t>
            </a:r>
            <a:r>
              <a:rPr lang="en-GB" sz="12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+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and do not express ROR</a:t>
            </a:r>
            <a:r>
              <a:rPr lang="el-GR" sz="1200" dirty="0">
                <a:solidFill>
                  <a:schemeClr val="tx1"/>
                </a:solidFill>
                <a:latin typeface="Calibri" panose="020F0502020204030204" pitchFamily="34" charset="0"/>
              </a:rPr>
              <a:t>γ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T or FoxP3 at day 6, day 30 and day 60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p.i.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</a:t>
            </a:r>
            <a:r>
              <a:rPr lang="en-GB" sz="1200" b="1" dirty="0">
                <a:solidFill>
                  <a:schemeClr val="tx1"/>
                </a:solidFill>
                <a:latin typeface="Calibri" panose="020F0502020204030204" pitchFamily="34" charset="0"/>
              </a:rPr>
              <a:t>c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Representative plots of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IFNγ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and IL-17A expression by 2W1S-specific CD4 T cells 11 days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p.i.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</a:t>
            </a:r>
            <a:r>
              <a:rPr lang="en-GB" sz="1200" b="1" dirty="0">
                <a:solidFill>
                  <a:schemeClr val="tx1"/>
                </a:solidFill>
                <a:latin typeface="Calibri" panose="020F0502020204030204" pitchFamily="34" charset="0"/>
              </a:rPr>
              <a:t>d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The proportion of 2W1S:I-Ab tetramer</a:t>
            </a:r>
            <a:r>
              <a:rPr lang="en-GB" sz="1200" baseline="30000" dirty="0">
                <a:solidFill>
                  <a:schemeClr val="tx1"/>
                </a:solidFill>
                <a:latin typeface="Calibri" panose="020F0502020204030204" pitchFamily="34" charset="0"/>
              </a:rPr>
              <a:t>+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CD4 T cells expressing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IFNγ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and/or IL17A in the colon (left) and MLN (right) are shown 11 days </a:t>
            </a:r>
            <a:r>
              <a:rPr lang="en-GB" sz="1200" dirty="0" err="1">
                <a:solidFill>
                  <a:schemeClr val="tx1"/>
                </a:solidFill>
                <a:latin typeface="Calibri" panose="020F0502020204030204" pitchFamily="34" charset="0"/>
              </a:rPr>
              <a:t>p.i.</a:t>
            </a:r>
            <a:r>
              <a:rPr lang="en-GB" sz="1200" dirty="0">
                <a:solidFill>
                  <a:schemeClr val="tx1"/>
                </a:solidFill>
                <a:latin typeface="Calibri" panose="020F0502020204030204" pitchFamily="34" charset="0"/>
              </a:rPr>
              <a:t> Means ± SEM are plotted.</a:t>
            </a:r>
            <a:endParaRPr lang="en-GB" sz="12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GB" sz="12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GB" sz="14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GB" sz="14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D0197FA-64CC-41B1-A32F-331082E39E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9432"/>
          <a:stretch/>
        </p:blipFill>
        <p:spPr>
          <a:xfrm>
            <a:off x="276821" y="466472"/>
            <a:ext cx="5793531" cy="148629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26EE982-CA29-4DA0-B9B0-1BF851C2DD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7896"/>
          <a:stretch/>
        </p:blipFill>
        <p:spPr>
          <a:xfrm>
            <a:off x="234041" y="2348771"/>
            <a:ext cx="5828897" cy="15519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9A718B7-3DD0-4A42-9DBD-4E5612909CC9}"/>
              </a:ext>
            </a:extLst>
          </p:cNvPr>
          <p:cNvSpPr txBox="1"/>
          <p:nvPr/>
        </p:nvSpPr>
        <p:spPr>
          <a:xfrm>
            <a:off x="130746" y="39332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5389281-DA50-4961-8466-E97F3BE6E1A6}"/>
              </a:ext>
            </a:extLst>
          </p:cNvPr>
          <p:cNvSpPr txBox="1"/>
          <p:nvPr/>
        </p:nvSpPr>
        <p:spPr>
          <a:xfrm>
            <a:off x="157888" y="200782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Rectangle 3">
            <a:extLst>
              <a:ext uri="{FF2B5EF4-FFF2-40B4-BE49-F238E27FC236}">
                <a16:creationId xmlns:a16="http://schemas.microsoft.com/office/drawing/2014/main" id="{7719B916-BB51-4760-86EB-A478E39C6A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390942"/>
            <a:ext cx="64087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5965083-87B6-49FE-AE89-8A1CED6956C2}"/>
              </a:ext>
            </a:extLst>
          </p:cNvPr>
          <p:cNvSpPr txBox="1"/>
          <p:nvPr/>
        </p:nvSpPr>
        <p:spPr>
          <a:xfrm>
            <a:off x="234307" y="3933185"/>
            <a:ext cx="1566576" cy="328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 Nova" panose="020B0504020202020204" pitchFamily="34" charset="0"/>
              </a:rPr>
              <a:t>Tetramer</a:t>
            </a:r>
            <a:r>
              <a:rPr lang="en-GB" sz="1600" b="1" baseline="30000" dirty="0">
                <a:latin typeface="Arial Nova" panose="020B0504020202020204" pitchFamily="34" charset="0"/>
              </a:rPr>
              <a:t>-</a:t>
            </a:r>
            <a:endParaRPr lang="en-GB" sz="900" b="1" dirty="0">
              <a:latin typeface="Arial Nova" panose="020B05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F3FFA12-74B1-4B6A-A09C-9CE21E309C6A}"/>
              </a:ext>
            </a:extLst>
          </p:cNvPr>
          <p:cNvGrpSpPr/>
          <p:nvPr/>
        </p:nvGrpSpPr>
        <p:grpSpPr>
          <a:xfrm>
            <a:off x="533167" y="4130785"/>
            <a:ext cx="1058925" cy="1103383"/>
            <a:chOff x="1370347" y="3585959"/>
            <a:chExt cx="1090510" cy="1136294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2371BEFC-974A-49AB-968A-95B049D72B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555" b="14052"/>
            <a:stretch/>
          </p:blipFill>
          <p:spPr>
            <a:xfrm>
              <a:off x="1370347" y="3585959"/>
              <a:ext cx="1090510" cy="1136294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C9A8F6E-4782-4C76-BC68-C6BE38E05F01}"/>
                </a:ext>
              </a:extLst>
            </p:cNvPr>
            <p:cNvSpPr txBox="1"/>
            <p:nvPr/>
          </p:nvSpPr>
          <p:spPr>
            <a:xfrm>
              <a:off x="1405270" y="3731499"/>
              <a:ext cx="228712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40.8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539C99E-6575-40A1-BF0E-7CFB6928F8E4}"/>
                </a:ext>
              </a:extLst>
            </p:cNvPr>
            <p:cNvSpPr txBox="1"/>
            <p:nvPr/>
          </p:nvSpPr>
          <p:spPr>
            <a:xfrm>
              <a:off x="2185997" y="3723996"/>
              <a:ext cx="174210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4.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6BEB921-35E8-4853-972E-CCAFB891527D}"/>
                </a:ext>
              </a:extLst>
            </p:cNvPr>
            <p:cNvSpPr txBox="1"/>
            <p:nvPr/>
          </p:nvSpPr>
          <p:spPr>
            <a:xfrm>
              <a:off x="2131495" y="4558583"/>
              <a:ext cx="228712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15.6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36523B1-80E3-450E-8B9E-FBB54A96BAA6}"/>
                </a:ext>
              </a:extLst>
            </p:cNvPr>
            <p:cNvSpPr txBox="1"/>
            <p:nvPr/>
          </p:nvSpPr>
          <p:spPr>
            <a:xfrm>
              <a:off x="1405270" y="4558569"/>
              <a:ext cx="228712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39.4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E7346B0A-6ADE-478F-8537-2DA0FA95665A}"/>
              </a:ext>
            </a:extLst>
          </p:cNvPr>
          <p:cNvGrpSpPr/>
          <p:nvPr/>
        </p:nvGrpSpPr>
        <p:grpSpPr>
          <a:xfrm>
            <a:off x="1783048" y="4172974"/>
            <a:ext cx="1043301" cy="1169089"/>
            <a:chOff x="2589554" y="3629406"/>
            <a:chExt cx="1074420" cy="1203960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1684083-5C73-4BBD-A5F8-B53EEC49E4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89554" y="3629406"/>
              <a:ext cx="1074420" cy="120396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15DC4C3-305F-4C3A-8116-8798C746D927}"/>
                </a:ext>
              </a:extLst>
            </p:cNvPr>
            <p:cNvSpPr txBox="1"/>
            <p:nvPr/>
          </p:nvSpPr>
          <p:spPr>
            <a:xfrm>
              <a:off x="2611586" y="3733796"/>
              <a:ext cx="228712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88.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3193669-D902-4203-A3D0-4F0F0F36375E}"/>
                </a:ext>
              </a:extLst>
            </p:cNvPr>
            <p:cNvSpPr txBox="1"/>
            <p:nvPr/>
          </p:nvSpPr>
          <p:spPr>
            <a:xfrm>
              <a:off x="3388373" y="3734695"/>
              <a:ext cx="174210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2.9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E7266CB-265D-4CFC-90F1-D52BA9C9B9B7}"/>
                </a:ext>
              </a:extLst>
            </p:cNvPr>
            <p:cNvSpPr txBox="1"/>
            <p:nvPr/>
          </p:nvSpPr>
          <p:spPr>
            <a:xfrm>
              <a:off x="3388373" y="4558583"/>
              <a:ext cx="174210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0.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EDB9B33-043C-4616-9926-FF60A2BD488D}"/>
                </a:ext>
              </a:extLst>
            </p:cNvPr>
            <p:cNvSpPr txBox="1"/>
            <p:nvPr/>
          </p:nvSpPr>
          <p:spPr>
            <a:xfrm>
              <a:off x="2614811" y="4558583"/>
              <a:ext cx="174210" cy="13080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>
              <a:spAutoFit/>
            </a:bodyPr>
            <a:lstStyle/>
            <a:p>
              <a:r>
                <a:rPr lang="en-GB" sz="850" b="1" dirty="0"/>
                <a:t>8.2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D559C48-E3F0-40D7-99D4-33FEF98565CC}"/>
              </a:ext>
            </a:extLst>
          </p:cNvPr>
          <p:cNvSpPr txBox="1"/>
          <p:nvPr/>
        </p:nvSpPr>
        <p:spPr>
          <a:xfrm>
            <a:off x="1462338" y="3994466"/>
            <a:ext cx="1566576" cy="268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 Nova" panose="020B0504020202020204" pitchFamily="34" charset="0"/>
              </a:rPr>
              <a:t>Tetramer</a:t>
            </a:r>
            <a:r>
              <a:rPr lang="en-GB" sz="1200" b="1" baseline="24000" dirty="0">
                <a:latin typeface="Arial Nova" panose="020B0504020202020204" pitchFamily="34" charset="0"/>
              </a:rPr>
              <a:t>+</a:t>
            </a:r>
            <a:endParaRPr lang="en-GB" sz="900" b="1" dirty="0">
              <a:latin typeface="Arial Nova" panose="020B05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3791A59-143F-45AE-8ECD-2BD6BDCB0C20}"/>
              </a:ext>
            </a:extLst>
          </p:cNvPr>
          <p:cNvSpPr txBox="1"/>
          <p:nvPr/>
        </p:nvSpPr>
        <p:spPr>
          <a:xfrm rot="16200000">
            <a:off x="126128" y="4623089"/>
            <a:ext cx="608899" cy="2390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 Nova" panose="020B0504020202020204" pitchFamily="34" charset="0"/>
              </a:rPr>
              <a:t>IFN</a:t>
            </a:r>
            <a:r>
              <a:rPr lang="el-GR" sz="1000" b="1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endParaRPr lang="en-GB" sz="900" b="1" dirty="0">
              <a:latin typeface="Arial Nova" panose="020B05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4E216BF-7E0A-461F-809C-758C5732EAA4}"/>
              </a:ext>
            </a:extLst>
          </p:cNvPr>
          <p:cNvSpPr txBox="1"/>
          <p:nvPr/>
        </p:nvSpPr>
        <p:spPr>
          <a:xfrm>
            <a:off x="713144" y="5212232"/>
            <a:ext cx="608899" cy="2390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 Nova" panose="020B0504020202020204" pitchFamily="34" charset="0"/>
              </a:rPr>
              <a:t>IL17A</a:t>
            </a:r>
            <a:endParaRPr lang="en-GB" sz="900" b="1" dirty="0">
              <a:latin typeface="Arial Nova" panose="020B0504020202020204" pitchFamily="34" charset="0"/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9F1645C-32F8-4F6F-AE97-AC057F79F213}"/>
              </a:ext>
            </a:extLst>
          </p:cNvPr>
          <p:cNvCxnSpPr>
            <a:cxnSpLocks/>
          </p:cNvCxnSpPr>
          <p:nvPr/>
        </p:nvCxnSpPr>
        <p:spPr>
          <a:xfrm>
            <a:off x="1251750" y="5331778"/>
            <a:ext cx="1239747" cy="623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56C08FD9-3869-424D-8856-15FC9AA0DA70}"/>
              </a:ext>
            </a:extLst>
          </p:cNvPr>
          <p:cNvGrpSpPr/>
          <p:nvPr/>
        </p:nvGrpSpPr>
        <p:grpSpPr>
          <a:xfrm>
            <a:off x="3047659" y="3956459"/>
            <a:ext cx="2247053" cy="1617929"/>
            <a:chOff x="1174886" y="5807238"/>
            <a:chExt cx="2247053" cy="1617929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B6C32DE-69B1-4B99-B42D-47F05AA820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6610"/>
            <a:stretch/>
          </p:blipFill>
          <p:spPr>
            <a:xfrm>
              <a:off x="1174886" y="5975264"/>
              <a:ext cx="2247053" cy="1449903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E177E77-839C-4997-83F2-CDA85D78A7CB}"/>
                </a:ext>
              </a:extLst>
            </p:cNvPr>
            <p:cNvSpPr txBox="1"/>
            <p:nvPr/>
          </p:nvSpPr>
          <p:spPr>
            <a:xfrm>
              <a:off x="2101075" y="5807238"/>
              <a:ext cx="5549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olon</a:t>
              </a:r>
              <a:endParaRPr lang="en-GB" sz="1200" b="1" dirty="0"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1162676E-7AA6-48B3-B436-4AE6D55E7819}"/>
              </a:ext>
            </a:extLst>
          </p:cNvPr>
          <p:cNvGrpSpPr/>
          <p:nvPr/>
        </p:nvGrpSpPr>
        <p:grpSpPr>
          <a:xfrm>
            <a:off x="4794545" y="3947827"/>
            <a:ext cx="1832511" cy="1627711"/>
            <a:chOff x="3722312" y="5801573"/>
            <a:chExt cx="1832511" cy="1627711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AB7871A-CFF7-44DA-8746-44064D1CB0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9472" t="22283"/>
            <a:stretch/>
          </p:blipFill>
          <p:spPr>
            <a:xfrm>
              <a:off x="3722312" y="5882814"/>
              <a:ext cx="1832511" cy="1546470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F4A1B88-9129-4DC3-BA5D-B00453FF40F3}"/>
                </a:ext>
              </a:extLst>
            </p:cNvPr>
            <p:cNvSpPr txBox="1"/>
            <p:nvPr/>
          </p:nvSpPr>
          <p:spPr>
            <a:xfrm>
              <a:off x="4261597" y="5801573"/>
              <a:ext cx="486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LN</a:t>
              </a:r>
              <a:endParaRPr lang="en-GB" sz="1200" b="1" dirty="0"/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20A77BFB-1E3F-467B-B5CB-7BA908CC0EFC}"/>
              </a:ext>
            </a:extLst>
          </p:cNvPr>
          <p:cNvSpPr txBox="1"/>
          <p:nvPr/>
        </p:nvSpPr>
        <p:spPr>
          <a:xfrm>
            <a:off x="1733819" y="2158385"/>
            <a:ext cx="554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lon</a:t>
            </a:r>
            <a:endParaRPr lang="en-GB" sz="1200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9349452-852B-4343-A186-888F2460E42D}"/>
              </a:ext>
            </a:extLst>
          </p:cNvPr>
          <p:cNvSpPr txBox="1"/>
          <p:nvPr/>
        </p:nvSpPr>
        <p:spPr>
          <a:xfrm>
            <a:off x="4366057" y="2152720"/>
            <a:ext cx="486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LN</a:t>
            </a:r>
            <a:endParaRPr lang="en-GB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FD0EC6-032B-4305-9568-638C665BFCA0}"/>
              </a:ext>
            </a:extLst>
          </p:cNvPr>
          <p:cNvSpPr txBox="1"/>
          <p:nvPr/>
        </p:nvSpPr>
        <p:spPr>
          <a:xfrm>
            <a:off x="171587" y="378718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35BB61-F94F-457B-A552-B67D138C6D55}"/>
              </a:ext>
            </a:extLst>
          </p:cNvPr>
          <p:cNvSpPr txBox="1"/>
          <p:nvPr/>
        </p:nvSpPr>
        <p:spPr>
          <a:xfrm>
            <a:off x="2930139" y="3774449"/>
            <a:ext cx="309700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1197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D7D56E9-BD1A-4C41-A7D8-567FC2D4A649}"/>
              </a:ext>
            </a:extLst>
          </p:cNvPr>
          <p:cNvGrpSpPr/>
          <p:nvPr/>
        </p:nvGrpSpPr>
        <p:grpSpPr>
          <a:xfrm>
            <a:off x="887966" y="267044"/>
            <a:ext cx="5349004" cy="2669276"/>
            <a:chOff x="887966" y="267044"/>
            <a:chExt cx="5349004" cy="2669276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4205A9F9-A7BF-4760-8E96-B5342B68A9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8839" r="2255"/>
            <a:stretch/>
          </p:blipFill>
          <p:spPr>
            <a:xfrm>
              <a:off x="887966" y="661531"/>
              <a:ext cx="5349004" cy="2274789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081E659-A867-4A54-9071-EE5DC8861ED1}"/>
                </a:ext>
              </a:extLst>
            </p:cNvPr>
            <p:cNvSpPr txBox="1"/>
            <p:nvPr/>
          </p:nvSpPr>
          <p:spPr>
            <a:xfrm>
              <a:off x="1354282" y="267044"/>
              <a:ext cx="39741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.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Tm recovered from tissues and intestinal content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D862299-9FA6-446E-9353-CDC338F4A846}"/>
              </a:ext>
            </a:extLst>
          </p:cNvPr>
          <p:cNvGrpSpPr>
            <a:grpSpLocks noChangeAspect="1"/>
          </p:cNvGrpSpPr>
          <p:nvPr/>
        </p:nvGrpSpPr>
        <p:grpSpPr>
          <a:xfrm>
            <a:off x="19259" y="5225020"/>
            <a:ext cx="1870959" cy="2102713"/>
            <a:chOff x="19258" y="5215504"/>
            <a:chExt cx="1969430" cy="2213382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C178ADE-C82F-4232-B5DD-D4642DCE2F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258" y="5215504"/>
              <a:ext cx="1969028" cy="1906089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FE69F57-E9F7-49B6-9C51-F96620EEFCEE}"/>
                </a:ext>
              </a:extLst>
            </p:cNvPr>
            <p:cNvSpPr txBox="1"/>
            <p:nvPr/>
          </p:nvSpPr>
          <p:spPr>
            <a:xfrm>
              <a:off x="780192" y="7023917"/>
              <a:ext cx="1208496" cy="404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D30           </a:t>
              </a:r>
              <a:r>
                <a:rPr lang="en-GB" sz="9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30</a:t>
              </a:r>
              <a:endParaRPr lang="en-GB" sz="9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after Abx</a:t>
              </a:r>
            </a:p>
          </p:txBody>
        </p: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D55D35E8-7472-4DFE-9BB7-97243EAE63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9561" t="22692" r="18886" b="49019"/>
          <a:stretch/>
        </p:blipFill>
        <p:spPr>
          <a:xfrm>
            <a:off x="4990865" y="687894"/>
            <a:ext cx="502920" cy="709413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03D6EBE0-AF5B-4383-BA5A-95F88F5784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4087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528D61A-5F1E-46EE-A6DF-9ACD13BAE3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418386"/>
            <a:ext cx="6408738" cy="1938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/>
              <a:t>Figure S5. </a:t>
            </a:r>
            <a:r>
              <a:rPr lang="en-GB" sz="1200" dirty="0"/>
              <a:t>Enrofloxacin treatment for 3 weeks eliminates any detectable </a:t>
            </a:r>
            <a:r>
              <a:rPr lang="en-GB" sz="1200" i="1" dirty="0"/>
              <a:t>Salmonella</a:t>
            </a:r>
            <a:r>
              <a:rPr lang="en-GB" sz="1200" dirty="0"/>
              <a:t> CFUs, reduces the number of tetramer</a:t>
            </a:r>
            <a:r>
              <a:rPr lang="en-GB" sz="1200" baseline="30000" dirty="0"/>
              <a:t>+</a:t>
            </a:r>
            <a:r>
              <a:rPr lang="en-GB" sz="1200" dirty="0"/>
              <a:t> CD4 T cells, and partially reduces the Th1 bias at day 30 </a:t>
            </a:r>
            <a:r>
              <a:rPr lang="en-GB" sz="1200" dirty="0" err="1"/>
              <a:t>p.i.</a:t>
            </a:r>
            <a:r>
              <a:rPr lang="en-GB" sz="1200" dirty="0"/>
              <a:t> </a:t>
            </a:r>
            <a:r>
              <a:rPr lang="en-GB" sz="1200" b="1" dirty="0"/>
              <a:t>a</a:t>
            </a:r>
            <a:r>
              <a:rPr lang="en-GB" sz="1200" dirty="0"/>
              <a:t> Samples of caecal content, faeces and tissues were plated following harvest and the number of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/>
              <a:t> CFUs recovered / organ or mg of intestinal content was plotted. </a:t>
            </a:r>
            <a:r>
              <a:rPr lang="en-GB" sz="1200" b="1" dirty="0"/>
              <a:t>b</a:t>
            </a:r>
            <a:r>
              <a:rPr lang="en-GB" sz="1200" dirty="0"/>
              <a:t> The proportion and </a:t>
            </a:r>
            <a:r>
              <a:rPr lang="en-GB" sz="1200" b="1" dirty="0"/>
              <a:t>c</a:t>
            </a:r>
            <a:r>
              <a:rPr lang="en-GB" sz="1200" dirty="0"/>
              <a:t> absolute number of CD4 T cells that are tetramer</a:t>
            </a:r>
            <a:r>
              <a:rPr lang="en-GB" sz="1200" baseline="30000" dirty="0"/>
              <a:t>+</a:t>
            </a:r>
            <a:r>
              <a:rPr lang="en-GB" sz="1200" dirty="0"/>
              <a:t> at day 6, 30 or 60 </a:t>
            </a:r>
            <a:r>
              <a:rPr lang="en-GB" sz="1200" dirty="0" err="1"/>
              <a:t>p.i.</a:t>
            </a:r>
            <a:r>
              <a:rPr lang="en-GB" sz="1200" dirty="0"/>
              <a:t> is shown following 24 days of treatment with enrofloxacin in drinking water from 6 days </a:t>
            </a:r>
            <a:r>
              <a:rPr lang="en-GB" sz="1200" dirty="0" err="1"/>
              <a:t>p.i.</a:t>
            </a:r>
            <a:r>
              <a:rPr lang="en-GB" sz="1200" dirty="0"/>
              <a:t> The proportion of 2W1S-specific T cells (</a:t>
            </a:r>
            <a:r>
              <a:rPr lang="en-GB" sz="1200" b="1" dirty="0"/>
              <a:t>d</a:t>
            </a:r>
            <a:r>
              <a:rPr lang="en-GB" sz="1200" dirty="0"/>
              <a:t>), Tconvs (</a:t>
            </a:r>
            <a:r>
              <a:rPr lang="en-GB" sz="1200" b="1" dirty="0"/>
              <a:t>e</a:t>
            </a:r>
            <a:r>
              <a:rPr lang="en-GB" sz="1200" dirty="0"/>
              <a:t>) and Tregs (</a:t>
            </a:r>
            <a:r>
              <a:rPr lang="en-GB" sz="1200" b="1" dirty="0"/>
              <a:t>f</a:t>
            </a:r>
            <a:r>
              <a:rPr lang="en-GB" sz="1200" dirty="0"/>
              <a:t>) expressing ROR</a:t>
            </a:r>
            <a:r>
              <a:rPr lang="el-GR" sz="1200" dirty="0"/>
              <a:t>γ</a:t>
            </a:r>
            <a:r>
              <a:rPr lang="en-GB" sz="1200" dirty="0"/>
              <a:t>T or T-bet are shown from enrofloxacin-treated or untreated mice at day 30 </a:t>
            </a:r>
            <a:r>
              <a:rPr lang="en-GB" sz="1200" dirty="0" err="1"/>
              <a:t>p.i.</a:t>
            </a:r>
            <a:r>
              <a:rPr lang="en-GB" sz="1200" dirty="0"/>
              <a:t> Data is from one experiment (n=3-6). Mean ± SEM are plotted. Statistical significance calculated for each tissue by a one-way ANOVA with Tukey’s test. ns, not significant; *p&lt;.05; **p&lt;.01; ***p&lt;.001; ****p&lt;.0001; Abx, antibiotics; ND, not detected).</a:t>
            </a:r>
            <a:endParaRPr kumimoji="0" lang="en-GB" altLang="en-US" sz="20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B2DF2FB-EE2C-4B94-8676-7AC71C47F59B}"/>
              </a:ext>
            </a:extLst>
          </p:cNvPr>
          <p:cNvSpPr txBox="1"/>
          <p:nvPr/>
        </p:nvSpPr>
        <p:spPr>
          <a:xfrm>
            <a:off x="803639" y="11050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D45AB85-CFCF-43E7-985C-62C32921537F}"/>
              </a:ext>
            </a:extLst>
          </p:cNvPr>
          <p:cNvSpPr txBox="1"/>
          <p:nvPr/>
        </p:nvSpPr>
        <p:spPr>
          <a:xfrm>
            <a:off x="131960" y="282556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E7BCB5F-0FC3-45DA-B191-E1CB4C2C19EE}"/>
              </a:ext>
            </a:extLst>
          </p:cNvPr>
          <p:cNvSpPr txBox="1"/>
          <p:nvPr/>
        </p:nvSpPr>
        <p:spPr>
          <a:xfrm>
            <a:off x="3169489" y="282556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206FF07-A18D-48B3-853C-11AB3AE659B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051" r="34879"/>
          <a:stretch/>
        </p:blipFill>
        <p:spPr>
          <a:xfrm>
            <a:off x="271152" y="3189591"/>
            <a:ext cx="2834837" cy="210528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1D928253-D060-4DC6-8710-856B498390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803" r="30810" b="82535"/>
          <a:stretch/>
        </p:blipFill>
        <p:spPr>
          <a:xfrm>
            <a:off x="1020987" y="2985260"/>
            <a:ext cx="1919071" cy="4162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FF24864-F063-4538-90CC-7F157DCEB24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1184" r="35486"/>
          <a:stretch/>
        </p:blipFill>
        <p:spPr>
          <a:xfrm>
            <a:off x="3292061" y="3378034"/>
            <a:ext cx="2830530" cy="191801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573CA231-4AFB-4E48-8151-2B1F9F22191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032" r="71456" b="87241"/>
          <a:stretch/>
        </p:blipFill>
        <p:spPr>
          <a:xfrm>
            <a:off x="4059031" y="2992044"/>
            <a:ext cx="188135" cy="29509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1EE433B-28E4-43A4-BF58-0AD1B0693C00}"/>
              </a:ext>
            </a:extLst>
          </p:cNvPr>
          <p:cNvSpPr txBox="1"/>
          <p:nvPr/>
        </p:nvSpPr>
        <p:spPr>
          <a:xfrm>
            <a:off x="151054" y="516765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C5D893E-42C1-491C-A1AC-C94BFBD99835}"/>
              </a:ext>
            </a:extLst>
          </p:cNvPr>
          <p:cNvGrpSpPr>
            <a:grpSpLocks noChangeAspect="1"/>
          </p:cNvGrpSpPr>
          <p:nvPr/>
        </p:nvGrpSpPr>
        <p:grpSpPr>
          <a:xfrm>
            <a:off x="2017581" y="5388498"/>
            <a:ext cx="1893540" cy="1951930"/>
            <a:chOff x="2050922" y="5378984"/>
            <a:chExt cx="1993200" cy="2054663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25F31D5-AE5C-4F67-A829-8244DBC9A933}"/>
                </a:ext>
              </a:extLst>
            </p:cNvPr>
            <p:cNvSpPr txBox="1"/>
            <p:nvPr/>
          </p:nvSpPr>
          <p:spPr>
            <a:xfrm>
              <a:off x="2651862" y="7028678"/>
              <a:ext cx="1208496" cy="404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D30           </a:t>
              </a:r>
              <a:r>
                <a:rPr lang="en-GB" sz="9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30</a:t>
              </a:r>
              <a:endParaRPr lang="en-GB" sz="9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after Abx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2259C4DA-EEE3-40DE-B391-0F02643815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25075"/>
            <a:stretch/>
          </p:blipFill>
          <p:spPr>
            <a:xfrm>
              <a:off x="2050922" y="5378984"/>
              <a:ext cx="1993200" cy="1853724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78849D3B-17D3-482B-A270-6DB850AC1365}"/>
              </a:ext>
            </a:extLst>
          </p:cNvPr>
          <p:cNvGrpSpPr>
            <a:grpSpLocks noChangeAspect="1"/>
          </p:cNvGrpSpPr>
          <p:nvPr/>
        </p:nvGrpSpPr>
        <p:grpSpPr>
          <a:xfrm>
            <a:off x="3933783" y="5381053"/>
            <a:ext cx="1870577" cy="1973840"/>
            <a:chOff x="4009990" y="5371538"/>
            <a:chExt cx="1969028" cy="2077726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E9EF72E-EF68-47BF-8271-92CC30DC71DE}"/>
                </a:ext>
              </a:extLst>
            </p:cNvPr>
            <p:cNvSpPr txBox="1"/>
            <p:nvPr/>
          </p:nvSpPr>
          <p:spPr>
            <a:xfrm>
              <a:off x="4616692" y="7044295"/>
              <a:ext cx="1208496" cy="404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D30           </a:t>
              </a:r>
              <a:r>
                <a:rPr lang="en-GB" sz="9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30</a:t>
              </a:r>
              <a:endParaRPr lang="en-GB" sz="9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95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after Abx</a:t>
              </a: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CA3B0FDA-878D-4697-B9F5-C928BD77CA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25984"/>
            <a:stretch/>
          </p:blipFill>
          <p:spPr>
            <a:xfrm>
              <a:off x="4009990" y="5371538"/>
              <a:ext cx="1969028" cy="1754231"/>
            </a:xfrm>
            <a:prstGeom prst="rect">
              <a:avLst/>
            </a:prstGeom>
          </p:spPr>
        </p:pic>
      </p:grpSp>
      <p:pic>
        <p:nvPicPr>
          <p:cNvPr id="35" name="Picture 34">
            <a:extLst>
              <a:ext uri="{FF2B5EF4-FFF2-40B4-BE49-F238E27FC236}">
                <a16:creationId xmlns:a16="http://schemas.microsoft.com/office/drawing/2014/main" id="{995A4AD9-5438-470B-B0ED-04D04A3AAD2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089" t="3275" r="32854" b="82535"/>
          <a:stretch/>
        </p:blipFill>
        <p:spPr>
          <a:xfrm>
            <a:off x="4256998" y="3058193"/>
            <a:ext cx="1615823" cy="33821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D56BCD8-E59F-4911-9ADD-60D40401C8F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3591" t="27279" b="42906"/>
          <a:stretch/>
        </p:blipFill>
        <p:spPr>
          <a:xfrm>
            <a:off x="5666806" y="5749190"/>
            <a:ext cx="702566" cy="52301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E185C5F-000F-4339-91F4-98D1931BEB98}"/>
              </a:ext>
            </a:extLst>
          </p:cNvPr>
          <p:cNvSpPr txBox="1"/>
          <p:nvPr/>
        </p:nvSpPr>
        <p:spPr>
          <a:xfrm>
            <a:off x="2008904" y="516585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BFC2898-4FEB-4B8F-AD73-55C8362BFA1A}"/>
              </a:ext>
            </a:extLst>
          </p:cNvPr>
          <p:cNvSpPr txBox="1"/>
          <p:nvPr/>
        </p:nvSpPr>
        <p:spPr>
          <a:xfrm>
            <a:off x="3956765" y="516585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355623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2A1407CB-B6DF-4C66-99B3-E2067C67F93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262" r="26512"/>
          <a:stretch/>
        </p:blipFill>
        <p:spPr>
          <a:xfrm>
            <a:off x="1944268" y="2137337"/>
            <a:ext cx="1612131" cy="131191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C9DFB68-7EAC-470F-A1CC-13043F33B6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12" t="12262" r="27588" b="73929"/>
          <a:stretch/>
        </p:blipFill>
        <p:spPr>
          <a:xfrm>
            <a:off x="3346873" y="2141771"/>
            <a:ext cx="1430383" cy="20648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E53997E-3F2B-459C-8BD7-174086D6639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99" t="12010" r="35087" b="76725"/>
          <a:stretch/>
        </p:blipFill>
        <p:spPr>
          <a:xfrm>
            <a:off x="4568352" y="2142780"/>
            <a:ext cx="1237109" cy="167961"/>
          </a:xfrm>
          <a:prstGeom prst="rect">
            <a:avLst/>
          </a:prstGeom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id="{D8FC138D-0534-4A1B-83C6-351CA806E374}"/>
              </a:ext>
            </a:extLst>
          </p:cNvPr>
          <p:cNvGrpSpPr>
            <a:grpSpLocks noChangeAspect="1"/>
          </p:cNvGrpSpPr>
          <p:nvPr/>
        </p:nvGrpSpPr>
        <p:grpSpPr>
          <a:xfrm>
            <a:off x="82922" y="2089534"/>
            <a:ext cx="1830458" cy="1474529"/>
            <a:chOff x="368573" y="3924301"/>
            <a:chExt cx="2013706" cy="162214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04E3AAF-05D7-4E7F-977A-A75DA2F208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30972"/>
            <a:stretch/>
          </p:blipFill>
          <p:spPr>
            <a:xfrm>
              <a:off x="368573" y="3924301"/>
              <a:ext cx="1485628" cy="1622144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A1CEED4-6507-449D-8751-74989DBF22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0801" t="38152" r="285" b="32097"/>
            <a:stretch/>
          </p:blipFill>
          <p:spPr>
            <a:xfrm>
              <a:off x="1760000" y="4252772"/>
              <a:ext cx="622279" cy="482601"/>
            </a:xfrm>
            <a:prstGeom prst="rect">
              <a:avLst/>
            </a:prstGeom>
          </p:spPr>
        </p:pic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173DBFCF-BF9B-42B1-971D-E9D97038368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1700" t="12010"/>
          <a:stretch/>
        </p:blipFill>
        <p:spPr>
          <a:xfrm>
            <a:off x="5773711" y="2098629"/>
            <a:ext cx="618401" cy="131191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0FEC0E6-C5A0-4ABA-AB42-EA644A34C3BA}"/>
              </a:ext>
            </a:extLst>
          </p:cNvPr>
          <p:cNvPicPr/>
          <p:nvPr/>
        </p:nvPicPr>
        <p:blipFill rotWithShape="1">
          <a:blip r:embed="rId6"/>
          <a:srcRect t="7568" b="50492"/>
          <a:stretch/>
        </p:blipFill>
        <p:spPr>
          <a:xfrm>
            <a:off x="-57475" y="572908"/>
            <a:ext cx="4122420" cy="123228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2CC50B7-ABF5-4E5E-A47C-3D3BBFE1AE38}"/>
              </a:ext>
            </a:extLst>
          </p:cNvPr>
          <p:cNvPicPr/>
          <p:nvPr/>
        </p:nvPicPr>
        <p:blipFill rotWithShape="1">
          <a:blip r:embed="rId6"/>
          <a:srcRect l="23705" t="58060" r="22508"/>
          <a:stretch/>
        </p:blipFill>
        <p:spPr>
          <a:xfrm>
            <a:off x="4077627" y="559408"/>
            <a:ext cx="2217348" cy="123228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C922DD5-5F75-4C29-A978-E6F7A3B64DA8}"/>
              </a:ext>
            </a:extLst>
          </p:cNvPr>
          <p:cNvSpPr txBox="1"/>
          <p:nvPr/>
        </p:nvSpPr>
        <p:spPr>
          <a:xfrm>
            <a:off x="1851986" y="195021"/>
            <a:ext cx="3876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BMCs     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Colon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59C88FF5-9AAE-4902-8D55-B5596B1A90BB}"/>
              </a:ext>
            </a:extLst>
          </p:cNvPr>
          <p:cNvGrpSpPr>
            <a:grpSpLocks noChangeAspect="1"/>
          </p:cNvGrpSpPr>
          <p:nvPr/>
        </p:nvGrpSpPr>
        <p:grpSpPr>
          <a:xfrm>
            <a:off x="64110" y="4032538"/>
            <a:ext cx="1942594" cy="1544786"/>
            <a:chOff x="445011" y="3050896"/>
            <a:chExt cx="2267909" cy="1803481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25A82847-C4B9-4F3C-908E-BAF6822EBD2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59300" y="3050896"/>
              <a:ext cx="2185868" cy="1803481"/>
              <a:chOff x="459301" y="3050896"/>
              <a:chExt cx="1987153" cy="1639528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6C50FEED-6AE6-49CC-A708-1C6232E849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r="24246"/>
              <a:stretch/>
            </p:blipFill>
            <p:spPr>
              <a:xfrm>
                <a:off x="459301" y="3050896"/>
                <a:ext cx="1987153" cy="1575714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168E8FF-F902-4EBE-95E1-AB03594C5203}"/>
                  </a:ext>
                </a:extLst>
              </p:cNvPr>
              <p:cNvSpPr txBox="1"/>
              <p:nvPr/>
            </p:nvSpPr>
            <p:spPr>
              <a:xfrm>
                <a:off x="1171962" y="4461767"/>
                <a:ext cx="1087482" cy="2286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TR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DEREG</a:t>
                </a:r>
              </a:p>
            </p:txBody>
          </p:sp>
        </p:grp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0F1C8DD-66C8-42E6-AAE4-80923D3B54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85736"/>
            <a:stretch/>
          </p:blipFill>
          <p:spPr>
            <a:xfrm>
              <a:off x="445011" y="3070336"/>
              <a:ext cx="2267909" cy="253916"/>
            </a:xfrm>
            <a:prstGeom prst="rect">
              <a:avLst/>
            </a:prstGeom>
          </p:spPr>
        </p:pic>
      </p:grpSp>
      <p:pic>
        <p:nvPicPr>
          <p:cNvPr id="27" name="Picture 26">
            <a:extLst>
              <a:ext uri="{FF2B5EF4-FFF2-40B4-BE49-F238E27FC236}">
                <a16:creationId xmlns:a16="http://schemas.microsoft.com/office/drawing/2014/main" id="{1A2457AA-5149-4FE2-909B-4CE74075685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25279"/>
          <a:stretch/>
        </p:blipFill>
        <p:spPr>
          <a:xfrm>
            <a:off x="1976730" y="4036610"/>
            <a:ext cx="1682757" cy="148503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011B04F7-96CE-4144-8A7C-19479341A300}"/>
              </a:ext>
            </a:extLst>
          </p:cNvPr>
          <p:cNvSpPr txBox="1"/>
          <p:nvPr/>
        </p:nvSpPr>
        <p:spPr>
          <a:xfrm>
            <a:off x="-21018" y="376737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E0B74CF-2709-4B5E-9BE3-03309D1413D1}"/>
              </a:ext>
            </a:extLst>
          </p:cNvPr>
          <p:cNvSpPr txBox="1"/>
          <p:nvPr/>
        </p:nvSpPr>
        <p:spPr>
          <a:xfrm>
            <a:off x="3646843" y="377450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FBCF554-A847-4DA1-A282-AE5CE386C836}"/>
              </a:ext>
            </a:extLst>
          </p:cNvPr>
          <p:cNvSpPr txBox="1"/>
          <p:nvPr/>
        </p:nvSpPr>
        <p:spPr>
          <a:xfrm>
            <a:off x="-21018" y="1800002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17C1380-7F13-4E40-8866-7F5B3104D75C}"/>
              </a:ext>
            </a:extLst>
          </p:cNvPr>
          <p:cNvSpPr txBox="1"/>
          <p:nvPr/>
        </p:nvSpPr>
        <p:spPr>
          <a:xfrm>
            <a:off x="1872351" y="180925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FC9E680D-88D9-4D53-8339-018EDD1AF943}"/>
              </a:ext>
            </a:extLst>
          </p:cNvPr>
          <p:cNvCxnSpPr>
            <a:cxnSpLocks/>
          </p:cNvCxnSpPr>
          <p:nvPr/>
        </p:nvCxnSpPr>
        <p:spPr>
          <a:xfrm flipV="1">
            <a:off x="312932" y="489841"/>
            <a:ext cx="3777050" cy="192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51AD4623-2FDE-42F6-82F3-E6C2591F13AA}"/>
              </a:ext>
            </a:extLst>
          </p:cNvPr>
          <p:cNvCxnSpPr>
            <a:cxnSpLocks/>
          </p:cNvCxnSpPr>
          <p:nvPr/>
        </p:nvCxnSpPr>
        <p:spPr>
          <a:xfrm>
            <a:off x="4439414" y="489837"/>
            <a:ext cx="1801593" cy="0"/>
          </a:xfrm>
          <a:prstGeom prst="line">
            <a:avLst/>
          </a:prstGeom>
          <a:ln w="952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44A74BB-6CCD-47F5-BAE8-40CD4BCF83D3}"/>
              </a:ext>
            </a:extLst>
          </p:cNvPr>
          <p:cNvSpPr txBox="1"/>
          <p:nvPr/>
        </p:nvSpPr>
        <p:spPr>
          <a:xfrm>
            <a:off x="-21018" y="9067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A03EE06-729A-412C-AF75-6352E1775155}"/>
              </a:ext>
            </a:extLst>
          </p:cNvPr>
          <p:cNvSpPr txBox="1"/>
          <p:nvPr/>
        </p:nvSpPr>
        <p:spPr>
          <a:xfrm>
            <a:off x="4106333" y="9992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27DB17C-702D-42A2-8BB5-48A91E5EC464}"/>
              </a:ext>
            </a:extLst>
          </p:cNvPr>
          <p:cNvSpPr txBox="1"/>
          <p:nvPr/>
        </p:nvSpPr>
        <p:spPr>
          <a:xfrm>
            <a:off x="4194748" y="5536904"/>
            <a:ext cx="1103781" cy="361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/>
              <a:t>Mock (PBS)-infected</a:t>
            </a:r>
            <a:endParaRPr lang="en-GB" sz="9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D90F94C-8086-4DFC-877D-BCF6EDF6A2FF}"/>
              </a:ext>
            </a:extLst>
          </p:cNvPr>
          <p:cNvSpPr txBox="1"/>
          <p:nvPr/>
        </p:nvSpPr>
        <p:spPr>
          <a:xfrm>
            <a:off x="4888152" y="5536904"/>
            <a:ext cx="110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i="1" dirty="0"/>
              <a:t>S.</a:t>
            </a:r>
            <a:r>
              <a:rPr lang="en-US" sz="900" b="1" dirty="0"/>
              <a:t> Tm-</a:t>
            </a:r>
          </a:p>
          <a:p>
            <a:pPr algn="ctr"/>
            <a:r>
              <a:rPr lang="en-US" sz="900" b="1" dirty="0"/>
              <a:t>infected</a:t>
            </a:r>
            <a:endParaRPr lang="en-GB" sz="900" b="1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89225726-45F9-44E5-B9B8-F63FCD1BEE55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t="56029"/>
          <a:stretch/>
        </p:blipFill>
        <p:spPr>
          <a:xfrm>
            <a:off x="5124920" y="5524467"/>
            <a:ext cx="604491" cy="44768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6660AC64-0FA7-44E9-B323-E2D4AA2FB369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t="56029"/>
          <a:stretch/>
        </p:blipFill>
        <p:spPr>
          <a:xfrm>
            <a:off x="4442936" y="5524467"/>
            <a:ext cx="604491" cy="447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135CE8-DC57-4358-BCB5-4069B50EC17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4439" r="25529" b="17712"/>
          <a:stretch/>
        </p:blipFill>
        <p:spPr>
          <a:xfrm>
            <a:off x="3662964" y="3981950"/>
            <a:ext cx="2166219" cy="1401775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668EA2F2-D392-4FEC-BC23-3E53572FF809}"/>
              </a:ext>
            </a:extLst>
          </p:cNvPr>
          <p:cNvSpPr txBox="1">
            <a:spLocks noChangeAspect="1"/>
          </p:cNvSpPr>
          <p:nvPr/>
        </p:nvSpPr>
        <p:spPr>
          <a:xfrm>
            <a:off x="2404171" y="339048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L/6     </a:t>
            </a:r>
            <a:r>
              <a:rPr lang="en-GB" sz="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DERE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7C0D066-7190-438B-B4B9-F2C8706CA850}"/>
              </a:ext>
            </a:extLst>
          </p:cNvPr>
          <p:cNvSpPr txBox="1">
            <a:spLocks noChangeAspect="1"/>
          </p:cNvSpPr>
          <p:nvPr/>
        </p:nvSpPr>
        <p:spPr>
          <a:xfrm>
            <a:off x="3619927" y="3388646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L/6     </a:t>
            </a:r>
            <a:r>
              <a:rPr lang="en-GB" sz="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DEREG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E544E4D-51ED-451E-93AE-6DA81BB88E5E}"/>
              </a:ext>
            </a:extLst>
          </p:cNvPr>
          <p:cNvSpPr txBox="1">
            <a:spLocks noChangeAspect="1"/>
          </p:cNvSpPr>
          <p:nvPr/>
        </p:nvSpPr>
        <p:spPr>
          <a:xfrm>
            <a:off x="4850017" y="3388642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L/6     </a:t>
            </a:r>
            <a:r>
              <a:rPr lang="en-GB" sz="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DEREG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5C6E99A2-6BB7-449D-9571-32C18C82F3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1700" t="12010"/>
          <a:stretch/>
        </p:blipFill>
        <p:spPr>
          <a:xfrm>
            <a:off x="5773707" y="3900222"/>
            <a:ext cx="618401" cy="1311911"/>
          </a:xfrm>
          <a:prstGeom prst="rect">
            <a:avLst/>
          </a:prstGeom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9316AFBA-0257-4808-951A-9F40E754B0C6}"/>
              </a:ext>
            </a:extLst>
          </p:cNvPr>
          <p:cNvSpPr/>
          <p:nvPr/>
        </p:nvSpPr>
        <p:spPr>
          <a:xfrm>
            <a:off x="0" y="6050330"/>
            <a:ext cx="6408738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6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Diphtheria toxin (D.T.) treatment of DEREG mice depletes Tregs in PBMC and colonic lamina propria; Tregs in untreated DEREG mice express similar levels of T-bet and ROR</a:t>
            </a:r>
            <a:r>
              <a:rPr lang="el-GR" sz="1200" dirty="0"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 as C57BL/6 mice; and </a:t>
            </a:r>
            <a:r>
              <a:rPr lang="en-GB" sz="1200" dirty="0">
                <a:ea typeface="Times New Roman" panose="02020603050405020304" pitchFamily="18" charset="0"/>
                <a:cs typeface="Arial" panose="020B0604020202020204" pitchFamily="34" charset="0"/>
              </a:rPr>
              <a:t>Treg ablation in mock-infected mice does not significantly shift the Th1-Th17 bias nor increase colonic </a:t>
            </a:r>
            <a:r>
              <a:rPr lang="en-GB" sz="1200" dirty="0" err="1">
                <a:ea typeface="Times New Roman" panose="02020603050405020304" pitchFamily="18" charset="0"/>
                <a:cs typeface="Arial" panose="020B0604020202020204" pitchFamily="34" charset="0"/>
              </a:rPr>
              <a:t>Tconv</a:t>
            </a:r>
            <a:r>
              <a:rPr lang="en-GB" sz="1200" dirty="0">
                <a:ea typeface="Times New Roman" panose="02020603050405020304" pitchFamily="18" charset="0"/>
                <a:cs typeface="Arial" panose="020B0604020202020204" pitchFamily="34" charset="0"/>
              </a:rPr>
              <a:t> numbers, as observed following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ea typeface="Times New Roman" panose="02020603050405020304" pitchFamily="18" charset="0"/>
                <a:cs typeface="Arial" panose="020B0604020202020204" pitchFamily="34" charset="0"/>
              </a:rPr>
              <a:t> infection.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Representative plots of CD4 T cells from PBMCs are shown from a WT littermate (left) and DEREG mouse at 1, 3 or 5 days following 2 D.T. treatments, 24 hrs apart.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Representative plots show the proportion of colon CD4 T cells that are FoxP3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5 days after D.T. treatment. CD4 T cells are identified as described in Fig. 1d. Gate numbers represent the proportion of CD4 T cells that are FoxP3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proportion of colon Tregs from C57BL/6 mice that express T-bet or ROR</a:t>
            </a:r>
            <a:r>
              <a:rPr lang="el-GR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 are plotted following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fection.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aphs compare Treg expression of T-bet or ROR</a:t>
            </a:r>
            <a:r>
              <a:rPr lang="el-GR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 between C57BL/6 mice and Treg replete (untreated) DEREG mice at day 0, 6 and 11 following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fection.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absolute number (left) and  proportion (right) of colonic CD44</a:t>
            </a:r>
            <a:r>
              <a:rPr lang="en-GB" sz="1200" baseline="300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i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convs that are RORγT</a:t>
            </a:r>
            <a:r>
              <a:rPr lang="en-GB" sz="1200" baseline="300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T-bet</a:t>
            </a:r>
            <a:r>
              <a:rPr lang="en-GB" sz="1200" baseline="300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re shown 4 days following D.T. treatment in uninfected DEREG mice or wild type (WT) littermates.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number of ROR</a:t>
            </a:r>
            <a:r>
              <a:rPr lang="el-GR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γ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GB" sz="1200" baseline="300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T-bet</a:t>
            </a:r>
            <a:r>
              <a:rPr lang="en-GB" sz="1200" baseline="300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convs are stacked to show changes in cell numbers 4 days following Treg depletion in mock- or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infected mice 6 days </a:t>
            </a:r>
            <a:r>
              <a:rPr lang="en-GB" sz="1200" dirty="0" err="1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.i.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ata represent n=3-8/group. Means ± SEM are plotted. Statistical significance calculated by one-way ANOVA (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or two-way ANOVA with Holm-</a:t>
            </a:r>
            <a:r>
              <a:rPr lang="en-GB" sz="1200" dirty="0" err="1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Šídák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est of compiled columns (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. ns, </a:t>
            </a:r>
            <a:r>
              <a:rPr lang="en-GB" sz="1200" dirty="0"/>
              <a:t>not significant; *p&lt;.05; **p&lt;.01; ***p&lt;.001; ****p&lt;.0001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F9CABD9F-A5A5-41F0-AEA0-D98C0F041E1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3707" t="31949" r="29984"/>
          <a:stretch/>
        </p:blipFill>
        <p:spPr>
          <a:xfrm>
            <a:off x="4681241" y="2399389"/>
            <a:ext cx="1285145" cy="1059716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0265E4E5-3660-4B05-A24F-DFAA0E94EB75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1058" t="34449" r="36163"/>
          <a:stretch/>
        </p:blipFill>
        <p:spPr>
          <a:xfrm>
            <a:off x="3366410" y="2435395"/>
            <a:ext cx="1228200" cy="1023715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1A67CB1F-EE05-454D-BA04-BA0FBED1BCBD}"/>
              </a:ext>
            </a:extLst>
          </p:cNvPr>
          <p:cNvSpPr txBox="1"/>
          <p:nvPr/>
        </p:nvSpPr>
        <p:spPr>
          <a:xfrm>
            <a:off x="2458113" y="5360994"/>
            <a:ext cx="10246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TR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     DERE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2EE32CB-905D-457E-9B7A-5F02745F5A7E}"/>
              </a:ext>
            </a:extLst>
          </p:cNvPr>
          <p:cNvSpPr txBox="1"/>
          <p:nvPr/>
        </p:nvSpPr>
        <p:spPr>
          <a:xfrm>
            <a:off x="4338661" y="5336849"/>
            <a:ext cx="1505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DTR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  DEREG   </a:t>
            </a:r>
            <a:r>
              <a:rPr lang="en-GB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DTR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  DEREG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78A01C5-F714-46D2-BE13-173CC5126412}"/>
              </a:ext>
            </a:extLst>
          </p:cNvPr>
          <p:cNvSpPr txBox="1"/>
          <p:nvPr/>
        </p:nvSpPr>
        <p:spPr>
          <a:xfrm>
            <a:off x="536729" y="561396"/>
            <a:ext cx="3419526" cy="123111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TR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Day 1                        Day 3                          Day 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CE496DC-83FC-4F1A-B230-983645F10441}"/>
              </a:ext>
            </a:extLst>
          </p:cNvPr>
          <p:cNvSpPr txBox="1"/>
          <p:nvPr/>
        </p:nvSpPr>
        <p:spPr>
          <a:xfrm>
            <a:off x="4667931" y="549936"/>
            <a:ext cx="1396536" cy="123111"/>
          </a:xfrm>
          <a:prstGeom prst="rect">
            <a:avLst/>
          </a:prstGeom>
          <a:solidFill>
            <a:schemeClr val="bg1"/>
          </a:solidFill>
        </p:spPr>
        <p:txBody>
          <a:bodyPr wrap="none" tIns="0" bIns="0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TR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Day5</a:t>
            </a:r>
          </a:p>
        </p:txBody>
      </p:sp>
    </p:spTree>
    <p:extLst>
      <p:ext uri="{BB962C8B-B14F-4D97-AF65-F5344CB8AC3E}">
        <p14:creationId xmlns:p14="http://schemas.microsoft.com/office/powerpoint/2010/main" val="17827720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D3DC539F-FF11-40F7-8033-97DDF97CD87D}"/>
              </a:ext>
            </a:extLst>
          </p:cNvPr>
          <p:cNvSpPr txBox="1"/>
          <p:nvPr/>
        </p:nvSpPr>
        <p:spPr>
          <a:xfrm>
            <a:off x="17373" y="-7750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483AA0-AD5E-42BF-BE48-57988A1FFF23}"/>
              </a:ext>
            </a:extLst>
          </p:cNvPr>
          <p:cNvSpPr txBox="1"/>
          <p:nvPr/>
        </p:nvSpPr>
        <p:spPr>
          <a:xfrm>
            <a:off x="2316756" y="-7750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10DE42C-75EA-49B1-AA0E-9018E9B1A41A}"/>
              </a:ext>
            </a:extLst>
          </p:cNvPr>
          <p:cNvSpPr txBox="1"/>
          <p:nvPr/>
        </p:nvSpPr>
        <p:spPr>
          <a:xfrm>
            <a:off x="6730" y="176266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33FC5E1-3223-4BCA-A9A4-63BF6557C1D6}"/>
              </a:ext>
            </a:extLst>
          </p:cNvPr>
          <p:cNvSpPr txBox="1"/>
          <p:nvPr/>
        </p:nvSpPr>
        <p:spPr>
          <a:xfrm>
            <a:off x="34439" y="3218375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C249202D-6F5F-4381-BB9B-E5DD3A2E14F6}"/>
              </a:ext>
            </a:extLst>
          </p:cNvPr>
          <p:cNvGrpSpPr/>
          <p:nvPr/>
        </p:nvGrpSpPr>
        <p:grpSpPr>
          <a:xfrm>
            <a:off x="3453679" y="1768387"/>
            <a:ext cx="1309733" cy="1562100"/>
            <a:chOff x="3359145" y="1810815"/>
            <a:chExt cx="1309733" cy="156210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4856740-096A-47D5-8566-549C18E75348}"/>
                </a:ext>
              </a:extLst>
            </p:cNvPr>
            <p:cNvGrpSpPr/>
            <p:nvPr/>
          </p:nvGrpSpPr>
          <p:grpSpPr>
            <a:xfrm>
              <a:off x="3359145" y="1810815"/>
              <a:ext cx="1289657" cy="1562100"/>
              <a:chOff x="3359145" y="3601525"/>
              <a:chExt cx="1289657" cy="1562100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1CB1738-C26D-435D-AE60-409F3C7ECB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5850" t="28647" r="15788"/>
              <a:stretch/>
            </p:blipFill>
            <p:spPr>
              <a:xfrm>
                <a:off x="3533397" y="3802918"/>
                <a:ext cx="1115405" cy="1343484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E9D0B05-4C10-49BF-BC22-D693EF948756}"/>
                  </a:ext>
                </a:extLst>
              </p:cNvPr>
              <p:cNvSpPr txBox="1"/>
              <p:nvPr/>
            </p:nvSpPr>
            <p:spPr>
              <a:xfrm rot="16200000">
                <a:off x="2701206" y="4259464"/>
                <a:ext cx="15621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% tetramer</a:t>
                </a:r>
                <a:r>
                  <a:rPr lang="en-US" sz="1000" b="1" baseline="30000" dirty="0"/>
                  <a:t>+</a:t>
                </a:r>
                <a:r>
                  <a:rPr lang="en-US" sz="1000" b="1" dirty="0"/>
                  <a:t> of Tconvs</a:t>
                </a:r>
                <a:endParaRPr lang="en-GB" sz="1000" b="1" dirty="0"/>
              </a:p>
            </p:txBody>
          </p:sp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5F8BF8D-013E-4137-86DB-68B1C062D65A}"/>
                </a:ext>
              </a:extLst>
            </p:cNvPr>
            <p:cNvSpPr txBox="1"/>
            <p:nvPr/>
          </p:nvSpPr>
          <p:spPr>
            <a:xfrm>
              <a:off x="3788509" y="3171455"/>
              <a:ext cx="880369" cy="15946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36000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 DEREG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BEF19888-0C49-4426-AAEE-D4DAE4DB4796}"/>
              </a:ext>
            </a:extLst>
          </p:cNvPr>
          <p:cNvGrpSpPr/>
          <p:nvPr/>
        </p:nvGrpSpPr>
        <p:grpSpPr>
          <a:xfrm>
            <a:off x="112709" y="1888929"/>
            <a:ext cx="1804828" cy="1398014"/>
            <a:chOff x="3115303" y="431128"/>
            <a:chExt cx="1804828" cy="1398014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A261E3C-EB2E-46F1-BC87-9B0C5D70A1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2771" r="88207" b="2294"/>
            <a:stretch/>
          </p:blipFill>
          <p:spPr>
            <a:xfrm>
              <a:off x="3115303" y="734348"/>
              <a:ext cx="211813" cy="831687"/>
            </a:xfrm>
            <a:prstGeom prst="rect">
              <a:avLst/>
            </a:prstGeom>
            <a:solidFill>
              <a:schemeClr val="bg1"/>
            </a:solidFill>
          </p:spPr>
        </p:pic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61705498-8ED1-46A6-B3D0-E7F968B8D67B}"/>
                </a:ext>
              </a:extLst>
            </p:cNvPr>
            <p:cNvGrpSpPr/>
            <p:nvPr/>
          </p:nvGrpSpPr>
          <p:grpSpPr>
            <a:xfrm>
              <a:off x="3354822" y="431128"/>
              <a:ext cx="1565309" cy="1398014"/>
              <a:chOff x="3354822" y="431128"/>
              <a:chExt cx="1565309" cy="1398014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FF23B453-68C0-4A14-8324-6709D0A9C0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2851" t="23601" b="2295"/>
              <a:stretch/>
            </p:blipFill>
            <p:spPr>
              <a:xfrm>
                <a:off x="3354822" y="431128"/>
                <a:ext cx="1565309" cy="1371567"/>
              </a:xfrm>
              <a:prstGeom prst="rect">
                <a:avLst/>
              </a:prstGeom>
              <a:solidFill>
                <a:schemeClr val="bg1"/>
              </a:solidFill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0F53A2C-B14C-448D-8DAB-5C679EC2D8FB}"/>
                  </a:ext>
                </a:extLst>
              </p:cNvPr>
              <p:cNvSpPr txBox="1"/>
              <p:nvPr/>
            </p:nvSpPr>
            <p:spPr>
              <a:xfrm>
                <a:off x="3808194" y="1669680"/>
                <a:ext cx="880369" cy="15946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tIns="0" bIns="36000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TR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DEREG</a:t>
                </a:r>
              </a:p>
            </p:txBody>
          </p:sp>
        </p:grp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E17F443A-FBF1-4CF9-A3BE-339A501052D3}"/>
              </a:ext>
            </a:extLst>
          </p:cNvPr>
          <p:cNvGrpSpPr/>
          <p:nvPr/>
        </p:nvGrpSpPr>
        <p:grpSpPr>
          <a:xfrm>
            <a:off x="4833021" y="1982197"/>
            <a:ext cx="1522378" cy="1331961"/>
            <a:chOff x="4672300" y="2028855"/>
            <a:chExt cx="1522378" cy="1331961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A0C2C74-1C08-4F24-B6D8-C080574F90C1}"/>
                </a:ext>
              </a:extLst>
            </p:cNvPr>
            <p:cNvSpPr txBox="1"/>
            <p:nvPr/>
          </p:nvSpPr>
          <p:spPr>
            <a:xfrm rot="16200000">
              <a:off x="4200338" y="2539814"/>
              <a:ext cx="1197521" cy="253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# of tetramer</a:t>
              </a:r>
              <a:r>
                <a:rPr lang="en-US" sz="1000" b="1" baseline="30000" dirty="0"/>
                <a:t>+</a:t>
              </a:r>
              <a:r>
                <a:rPr lang="en-US" sz="1000" b="1" dirty="0"/>
                <a:t> cells</a:t>
              </a:r>
              <a:endParaRPr lang="en-GB" sz="1000" b="1" dirty="0"/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E6F3D207-D0BC-44EC-9E48-0A518295CD1C}"/>
                </a:ext>
              </a:extLst>
            </p:cNvPr>
            <p:cNvGrpSpPr/>
            <p:nvPr/>
          </p:nvGrpSpPr>
          <p:grpSpPr>
            <a:xfrm>
              <a:off x="4886742" y="2028855"/>
              <a:ext cx="1307936" cy="1331961"/>
              <a:chOff x="4886742" y="2028855"/>
              <a:chExt cx="1307936" cy="1331961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B2595BE-13A3-4361-89C6-C9FB3E1254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4737" t="28213" r="14250"/>
              <a:stretch/>
            </p:blipFill>
            <p:spPr>
              <a:xfrm>
                <a:off x="4886742" y="2028855"/>
                <a:ext cx="1307936" cy="1331961"/>
              </a:xfrm>
              <a:prstGeom prst="rect">
                <a:avLst/>
              </a:prstGeom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730944A-8144-4117-AC21-7D3EEA1F0DB5}"/>
                  </a:ext>
                </a:extLst>
              </p:cNvPr>
              <p:cNvSpPr txBox="1"/>
              <p:nvPr/>
            </p:nvSpPr>
            <p:spPr>
              <a:xfrm>
                <a:off x="5395694" y="3161930"/>
                <a:ext cx="768406" cy="15946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0" rIns="36000" bIns="36000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TR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DEREG</a:t>
                </a:r>
              </a:p>
            </p:txBody>
          </p:sp>
        </p:grp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C3068721-0F86-4464-BFC0-6BCD47BACE89}"/>
              </a:ext>
            </a:extLst>
          </p:cNvPr>
          <p:cNvGrpSpPr/>
          <p:nvPr/>
        </p:nvGrpSpPr>
        <p:grpSpPr>
          <a:xfrm>
            <a:off x="1621975" y="5372090"/>
            <a:ext cx="1937016" cy="1412637"/>
            <a:chOff x="4714352" y="3748617"/>
            <a:chExt cx="1796119" cy="1334453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2A06B55F-A6B8-4943-8A51-E88F3AB375D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14352" y="3748617"/>
              <a:ext cx="1796119" cy="1334453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7EA7F7F-60C8-4848-9C54-BAF8618BD67D}"/>
                </a:ext>
              </a:extLst>
            </p:cNvPr>
            <p:cNvSpPr txBox="1"/>
            <p:nvPr/>
          </p:nvSpPr>
          <p:spPr>
            <a:xfrm>
              <a:off x="5465902" y="4905005"/>
              <a:ext cx="739268" cy="15063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36000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GB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DEREG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0729F314-B3DA-49CD-B37A-76E343D97585}"/>
              </a:ext>
            </a:extLst>
          </p:cNvPr>
          <p:cNvGrpSpPr/>
          <p:nvPr/>
        </p:nvGrpSpPr>
        <p:grpSpPr>
          <a:xfrm>
            <a:off x="86400" y="5440381"/>
            <a:ext cx="1556695" cy="1331810"/>
            <a:chOff x="3110604" y="3749676"/>
            <a:chExt cx="1556695" cy="1331810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4579D68-24BA-4FD0-9CFA-D937D3E580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2771" r="88207" b="2294"/>
            <a:stretch/>
          </p:blipFill>
          <p:spPr>
            <a:xfrm>
              <a:off x="3110604" y="3966099"/>
              <a:ext cx="211813" cy="831687"/>
            </a:xfrm>
            <a:prstGeom prst="rect">
              <a:avLst/>
            </a:prstGeom>
            <a:solidFill>
              <a:schemeClr val="bg1"/>
            </a:solidFill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44FFC22A-0585-4486-8707-842B6D1B697B}"/>
                </a:ext>
              </a:extLst>
            </p:cNvPr>
            <p:cNvGrpSpPr/>
            <p:nvPr/>
          </p:nvGrpSpPr>
          <p:grpSpPr>
            <a:xfrm>
              <a:off x="3310239" y="3749676"/>
              <a:ext cx="1357060" cy="1331810"/>
              <a:chOff x="3310239" y="3749676"/>
              <a:chExt cx="1357060" cy="1331810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87A5086B-D69D-4522-87B6-6ECC7959F7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492" t="28044" r="13760"/>
              <a:stretch/>
            </p:blipFill>
            <p:spPr>
              <a:xfrm>
                <a:off x="3310239" y="3749676"/>
                <a:ext cx="1357060" cy="1331810"/>
              </a:xfrm>
              <a:prstGeom prst="rect">
                <a:avLst/>
              </a:prstGeom>
              <a:solidFill>
                <a:schemeClr val="bg1"/>
              </a:solidFill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1137D1EA-2B76-41A0-8044-8B4DC6195B6E}"/>
                  </a:ext>
                </a:extLst>
              </p:cNvPr>
              <p:cNvSpPr txBox="1"/>
              <p:nvPr/>
            </p:nvSpPr>
            <p:spPr>
              <a:xfrm>
                <a:off x="3853914" y="4898655"/>
                <a:ext cx="768406" cy="15946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0" rIns="36000" bIns="36000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TR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DEREG</a:t>
                </a:r>
              </a:p>
            </p:txBody>
          </p:sp>
        </p:grp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86E4819-F124-450F-A343-EF27D08D2506}"/>
              </a:ext>
            </a:extLst>
          </p:cNvPr>
          <p:cNvGrpSpPr/>
          <p:nvPr/>
        </p:nvGrpSpPr>
        <p:grpSpPr>
          <a:xfrm>
            <a:off x="3400371" y="5263119"/>
            <a:ext cx="1504915" cy="1562100"/>
            <a:chOff x="3422685" y="5072469"/>
            <a:chExt cx="1504915" cy="1562100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1F71793-3EA7-4C62-BF8C-83B5C1D445B8}"/>
                </a:ext>
              </a:extLst>
            </p:cNvPr>
            <p:cNvGrpSpPr/>
            <p:nvPr/>
          </p:nvGrpSpPr>
          <p:grpSpPr>
            <a:xfrm>
              <a:off x="3422685" y="5072469"/>
              <a:ext cx="1504915" cy="1562100"/>
              <a:chOff x="3422685" y="6863179"/>
              <a:chExt cx="1504915" cy="1562100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01E37029-FB24-4C42-BCE3-25E5C18C42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0334" t="27255"/>
              <a:stretch/>
            </p:blipFill>
            <p:spPr>
              <a:xfrm>
                <a:off x="3627769" y="7019107"/>
                <a:ext cx="1299831" cy="1373018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647CE9F-1DDE-493F-AF4F-621E739FA4C3}"/>
                  </a:ext>
                </a:extLst>
              </p:cNvPr>
              <p:cNvSpPr txBox="1"/>
              <p:nvPr/>
            </p:nvSpPr>
            <p:spPr>
              <a:xfrm rot="16200000">
                <a:off x="2764746" y="7521118"/>
                <a:ext cx="15621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% tetramer</a:t>
                </a:r>
                <a:r>
                  <a:rPr lang="en-US" sz="1000" b="1" baseline="30000" dirty="0"/>
                  <a:t>+</a:t>
                </a:r>
                <a:r>
                  <a:rPr lang="en-US" sz="1000" b="1" dirty="0"/>
                  <a:t> of Tconvs</a:t>
                </a:r>
                <a:endParaRPr lang="en-GB" sz="1000" b="1" dirty="0"/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4BE8629-F2B7-4B5A-9FB0-81159B8CF07D}"/>
                </a:ext>
              </a:extLst>
            </p:cNvPr>
            <p:cNvSpPr txBox="1"/>
            <p:nvPr/>
          </p:nvSpPr>
          <p:spPr>
            <a:xfrm>
              <a:off x="3871059" y="6403605"/>
              <a:ext cx="768406" cy="15946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36000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 DEREG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CBA5AAD2-FE81-4A25-A4CC-9B9E205D1D9C}"/>
              </a:ext>
            </a:extLst>
          </p:cNvPr>
          <p:cNvGrpSpPr/>
          <p:nvPr/>
        </p:nvGrpSpPr>
        <p:grpSpPr>
          <a:xfrm>
            <a:off x="4740007" y="5456788"/>
            <a:ext cx="1527680" cy="1330193"/>
            <a:chOff x="4695469" y="5267895"/>
            <a:chExt cx="1527680" cy="1330193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C584E41-1A35-4DB3-83A2-F701A96D1649}"/>
                </a:ext>
              </a:extLst>
            </p:cNvPr>
            <p:cNvSpPr txBox="1"/>
            <p:nvPr/>
          </p:nvSpPr>
          <p:spPr>
            <a:xfrm rot="16200000">
              <a:off x="4200300" y="5763064"/>
              <a:ext cx="1236562" cy="246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# of tetramer</a:t>
              </a:r>
              <a:r>
                <a:rPr lang="en-US" sz="1000" b="1" baseline="30000" dirty="0"/>
                <a:t>+</a:t>
              </a:r>
              <a:r>
                <a:rPr lang="en-US" sz="1000" b="1" dirty="0"/>
                <a:t> cells</a:t>
              </a:r>
              <a:endParaRPr lang="en-GB" sz="1000" b="1" dirty="0"/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DC8FED0-FA5C-4712-B662-585B90916E6F}"/>
                </a:ext>
              </a:extLst>
            </p:cNvPr>
            <p:cNvGrpSpPr/>
            <p:nvPr/>
          </p:nvGrpSpPr>
          <p:grpSpPr>
            <a:xfrm>
              <a:off x="4923317" y="5398814"/>
              <a:ext cx="1299832" cy="1199274"/>
              <a:chOff x="4923317" y="5398814"/>
              <a:chExt cx="1299832" cy="1199274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A9DB7ED-C61D-4303-AB86-B5181105D2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5629" t="35364" r="13798"/>
              <a:stretch/>
            </p:blipFill>
            <p:spPr>
              <a:xfrm>
                <a:off x="4923317" y="5398814"/>
                <a:ext cx="1299832" cy="1199274"/>
              </a:xfrm>
              <a:prstGeom prst="rect">
                <a:avLst/>
              </a:prstGeom>
            </p:spPr>
          </p:pic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76B3E602-E7FC-4C31-B2F5-BD2428953602}"/>
                  </a:ext>
                </a:extLst>
              </p:cNvPr>
              <p:cNvSpPr txBox="1"/>
              <p:nvPr/>
            </p:nvSpPr>
            <p:spPr>
              <a:xfrm>
                <a:off x="5421094" y="6403605"/>
                <a:ext cx="768406" cy="15946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0" rIns="36000" bIns="36000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TR</a:t>
                </a:r>
                <a:r>
                  <a:rPr lang="en-GB" sz="12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DEREG</a:t>
                </a:r>
              </a:p>
            </p:txBody>
          </p:sp>
        </p:grp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0EE43AE4-158A-4C17-BA74-E674BFECA117}"/>
              </a:ext>
            </a:extLst>
          </p:cNvPr>
          <p:cNvGrpSpPr>
            <a:grpSpLocks noChangeAspect="1"/>
          </p:cNvGrpSpPr>
          <p:nvPr/>
        </p:nvGrpSpPr>
        <p:grpSpPr>
          <a:xfrm>
            <a:off x="149438" y="86983"/>
            <a:ext cx="2113289" cy="1763464"/>
            <a:chOff x="266755" y="901908"/>
            <a:chExt cx="2641611" cy="220433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85CEA86-D216-4AD9-8E2A-BF5DE41CC3E4}"/>
                </a:ext>
              </a:extLst>
            </p:cNvPr>
            <p:cNvPicPr/>
            <p:nvPr/>
          </p:nvPicPr>
          <p:blipFill rotWithShape="1">
            <a:blip r:embed="rId9"/>
            <a:srcRect l="5168" t="34855" r="48486" b="29127"/>
            <a:stretch/>
          </p:blipFill>
          <p:spPr>
            <a:xfrm>
              <a:off x="266755" y="901908"/>
              <a:ext cx="2641611" cy="2204330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7020ACB-6F82-496F-95CD-25BDAA919973}"/>
                </a:ext>
              </a:extLst>
            </p:cNvPr>
            <p:cNvSpPr txBox="1"/>
            <p:nvPr/>
          </p:nvSpPr>
          <p:spPr>
            <a:xfrm>
              <a:off x="2181374" y="1022489"/>
              <a:ext cx="691296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600" baseline="300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littermates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F50AC665-C874-443E-A413-665DFD1F1A74}"/>
              </a:ext>
            </a:extLst>
          </p:cNvPr>
          <p:cNvGrpSpPr>
            <a:grpSpLocks noChangeAspect="1"/>
          </p:cNvGrpSpPr>
          <p:nvPr/>
        </p:nvGrpSpPr>
        <p:grpSpPr>
          <a:xfrm>
            <a:off x="-1090" y="3525602"/>
            <a:ext cx="2511473" cy="1731499"/>
            <a:chOff x="329412" y="3719946"/>
            <a:chExt cx="2511473" cy="173149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0A020C0-9AC8-4254-94EE-66079F7025C6}"/>
                </a:ext>
              </a:extLst>
            </p:cNvPr>
            <p:cNvPicPr/>
            <p:nvPr/>
          </p:nvPicPr>
          <p:blipFill rotWithShape="1">
            <a:blip r:embed="rId10"/>
            <a:srcRect l="2380" t="37031" r="43695" b="29058"/>
            <a:stretch/>
          </p:blipFill>
          <p:spPr>
            <a:xfrm>
              <a:off x="329412" y="3719946"/>
              <a:ext cx="2511473" cy="1731499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75773DA-A1EB-4691-A6A6-7FBB9A7F9990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018828" y="4562235"/>
              <a:ext cx="553037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600" baseline="300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littermates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91DEE468-3013-4311-9D7A-C41092B2DC68}"/>
              </a:ext>
            </a:extLst>
          </p:cNvPr>
          <p:cNvSpPr txBox="1"/>
          <p:nvPr/>
        </p:nvSpPr>
        <p:spPr>
          <a:xfrm>
            <a:off x="1570087" y="176266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FE4B739F-05F5-4BE5-9071-F297AF12EDC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2808" r="23723"/>
          <a:stretch/>
        </p:blipFill>
        <p:spPr>
          <a:xfrm>
            <a:off x="2361665" y="141946"/>
            <a:ext cx="1928964" cy="1461681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CF452F43-6761-4B79-9F4C-70253FB5F71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4033"/>
          <a:stretch/>
        </p:blipFill>
        <p:spPr>
          <a:xfrm>
            <a:off x="4207369" y="203569"/>
            <a:ext cx="2209800" cy="1416594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85EDA41D-64E4-4EC0-B58D-A9F60670EA98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3928"/>
          <a:stretch/>
        </p:blipFill>
        <p:spPr>
          <a:xfrm>
            <a:off x="4277860" y="3540238"/>
            <a:ext cx="2152650" cy="1475691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3036D23A-0B8F-42CA-9DFF-9C7EB7F92E9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4638" r="28437"/>
          <a:stretch/>
        </p:blipFill>
        <p:spPr>
          <a:xfrm>
            <a:off x="2473408" y="3565465"/>
            <a:ext cx="1796119" cy="1447282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73695065-FEA6-4982-939C-6B723F66D6F7}"/>
              </a:ext>
            </a:extLst>
          </p:cNvPr>
          <p:cNvSpPr txBox="1"/>
          <p:nvPr/>
        </p:nvSpPr>
        <p:spPr>
          <a:xfrm>
            <a:off x="2408377" y="325647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46319DD-DF99-4DCB-90F9-C931371697E9}"/>
              </a:ext>
            </a:extLst>
          </p:cNvPr>
          <p:cNvSpPr txBox="1"/>
          <p:nvPr/>
        </p:nvSpPr>
        <p:spPr>
          <a:xfrm>
            <a:off x="5560" y="520015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9A1E2ED-D608-4B3F-9C40-5EC37445A58D}"/>
              </a:ext>
            </a:extLst>
          </p:cNvPr>
          <p:cNvSpPr txBox="1"/>
          <p:nvPr/>
        </p:nvSpPr>
        <p:spPr>
          <a:xfrm>
            <a:off x="1572404" y="5200152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6364AF4-881A-45FC-938C-614C8F869FB6}"/>
              </a:ext>
            </a:extLst>
          </p:cNvPr>
          <p:cNvSpPr txBox="1"/>
          <p:nvPr/>
        </p:nvSpPr>
        <p:spPr>
          <a:xfrm>
            <a:off x="3250843" y="5200152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2F54B77-2B9A-491B-9FF5-A90C14B4D404}"/>
              </a:ext>
            </a:extLst>
          </p:cNvPr>
          <p:cNvSpPr txBox="1"/>
          <p:nvPr/>
        </p:nvSpPr>
        <p:spPr>
          <a:xfrm>
            <a:off x="3327232" y="176266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6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A34AF7A-0880-4682-8E60-C4C9FE1D6331}"/>
              </a:ext>
            </a:extLst>
          </p:cNvPr>
          <p:cNvGrpSpPr/>
          <p:nvPr/>
        </p:nvGrpSpPr>
        <p:grpSpPr>
          <a:xfrm>
            <a:off x="1682163" y="1950539"/>
            <a:ext cx="1860103" cy="1352733"/>
            <a:chOff x="4709259" y="492453"/>
            <a:chExt cx="1860103" cy="135273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70BA138-2FEC-4FEC-A09B-DF3847BB50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709259" y="492453"/>
              <a:ext cx="1860103" cy="1352733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B68DBBE-918E-448D-B4F6-101D206E3227}"/>
                </a:ext>
              </a:extLst>
            </p:cNvPr>
            <p:cNvSpPr txBox="1"/>
            <p:nvPr/>
          </p:nvSpPr>
          <p:spPr>
            <a:xfrm>
              <a:off x="5514433" y="1669132"/>
              <a:ext cx="768406" cy="15946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36000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TR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 DEREG</a:t>
              </a:r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id="{EBEFF4C9-D8CE-4EFF-AFE6-3A940AB8C94A}"/>
              </a:ext>
            </a:extLst>
          </p:cNvPr>
          <p:cNvSpPr txBox="1"/>
          <p:nvPr/>
        </p:nvSpPr>
        <p:spPr>
          <a:xfrm>
            <a:off x="3093657" y="1489273"/>
            <a:ext cx="938325" cy="17485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36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      T-bet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01A2C07-6AE1-4831-978C-FCCA6422DE78}"/>
              </a:ext>
            </a:extLst>
          </p:cNvPr>
          <p:cNvSpPr txBox="1"/>
          <p:nvPr/>
        </p:nvSpPr>
        <p:spPr>
          <a:xfrm>
            <a:off x="4693864" y="1489272"/>
            <a:ext cx="1002445" cy="17485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36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       T-bet 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25D34A5-BE71-45E9-AF22-849E4CD91554}"/>
              </a:ext>
            </a:extLst>
          </p:cNvPr>
          <p:cNvSpPr txBox="1"/>
          <p:nvPr/>
        </p:nvSpPr>
        <p:spPr>
          <a:xfrm>
            <a:off x="3126311" y="4891074"/>
            <a:ext cx="1002445" cy="17485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36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        T-bet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E76A0DE-5C61-4091-BD3A-CF1067EF0597}"/>
              </a:ext>
            </a:extLst>
          </p:cNvPr>
          <p:cNvSpPr txBox="1"/>
          <p:nvPr/>
        </p:nvSpPr>
        <p:spPr>
          <a:xfrm>
            <a:off x="4726518" y="4891073"/>
            <a:ext cx="1034505" cy="17485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36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       T-bet 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874C21F8-76DD-4115-AEC5-78F32D9F1079}"/>
              </a:ext>
            </a:extLst>
          </p:cNvPr>
          <p:cNvSpPr/>
          <p:nvPr/>
        </p:nvSpPr>
        <p:spPr>
          <a:xfrm>
            <a:off x="15082" y="6738275"/>
            <a:ext cx="6393656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Figure S7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reg depletion of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-infected mice does not cause significant weight loss, change faecal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burden or tetramer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cells, but consistently shifts Th bias.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Weight loss in DEREG mice and WT littermates following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infection and D.T. treatment (represented by dashed lines) at day 1-2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b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Pooled data showing the number (left) and proportion (right) of CD44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CD4 Tconvs expressing ROR</a:t>
            </a:r>
            <a:r>
              <a:rPr lang="el-GR" sz="1200" dirty="0"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 or T-bet at day 6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c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STM CFU recovered from faeces at day 6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d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he number of colonic CD4 T cells in DEREG mice and WT littermates are shown. 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e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he proportion (left) and number (right) of colonic Tconvs that are tetramer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are shown.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f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Weight loss shown following STM infection and D.T. treatments at day 6-7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Pooled data shows the number (left) and proportion (right) of Tconvs expressing ROR</a:t>
            </a:r>
            <a:r>
              <a:rPr lang="el-GR" sz="1200" dirty="0"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 or T-bet at day 11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h </a:t>
            </a:r>
            <a:r>
              <a:rPr lang="en-US" sz="1200" i="1" dirty="0"/>
              <a:t>S.</a:t>
            </a:r>
            <a:r>
              <a:rPr lang="en-US" sz="1200" dirty="0"/>
              <a:t> Tm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CFU recovered from faeces at day 11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p.i.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The number of CD4 T cells,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The proportion (left) and number (right) of colonic Tconvs that are tetramer</a:t>
            </a:r>
            <a:r>
              <a:rPr lang="en-GB" sz="12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are shown. Data are representative examples of three independent experiments (n=3-5) (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) or are pooled from 3 independent experiments (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b, g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). Means ± SEM are plotted.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tistical significance calculated by Mann-Whitney test 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 one-way ANOVA with Holm-</a:t>
            </a:r>
            <a:r>
              <a:rPr lang="en-GB" sz="1200" dirty="0" err="1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Šídák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est (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ns, not significant; *p&lt;.05; **p&lt;.01; ***p&lt;.001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28319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BBD48CB-F142-49A0-9707-C4E3F5D7AD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1080963"/>
              </p:ext>
            </p:extLst>
          </p:nvPr>
        </p:nvGraphicFramePr>
        <p:xfrm>
          <a:off x="769621" y="922699"/>
          <a:ext cx="4808220" cy="7625922"/>
        </p:xfrm>
        <a:graphic>
          <a:graphicData uri="http://schemas.openxmlformats.org/drawingml/2006/table">
            <a:tbl>
              <a:tblPr firstRow="1" firstCol="1" bandRow="1"/>
              <a:tblGrid>
                <a:gridCol w="953050">
                  <a:extLst>
                    <a:ext uri="{9D8B030D-6E8A-4147-A177-3AD203B41FA5}">
                      <a16:colId xmlns:a16="http://schemas.microsoft.com/office/drawing/2014/main" val="3798916640"/>
                    </a:ext>
                  </a:extLst>
                </a:gridCol>
                <a:gridCol w="902419">
                  <a:extLst>
                    <a:ext uri="{9D8B030D-6E8A-4147-A177-3AD203B41FA5}">
                      <a16:colId xmlns:a16="http://schemas.microsoft.com/office/drawing/2014/main" val="702860906"/>
                    </a:ext>
                  </a:extLst>
                </a:gridCol>
                <a:gridCol w="902970">
                  <a:extLst>
                    <a:ext uri="{9D8B030D-6E8A-4147-A177-3AD203B41FA5}">
                      <a16:colId xmlns:a16="http://schemas.microsoft.com/office/drawing/2014/main" val="3343141336"/>
                    </a:ext>
                  </a:extLst>
                </a:gridCol>
                <a:gridCol w="929640">
                  <a:extLst>
                    <a:ext uri="{9D8B030D-6E8A-4147-A177-3AD203B41FA5}">
                      <a16:colId xmlns:a16="http://schemas.microsoft.com/office/drawing/2014/main" val="1260066056"/>
                    </a:ext>
                  </a:extLst>
                </a:gridCol>
                <a:gridCol w="1120141">
                  <a:extLst>
                    <a:ext uri="{9D8B030D-6E8A-4147-A177-3AD203B41FA5}">
                      <a16:colId xmlns:a16="http://schemas.microsoft.com/office/drawing/2014/main" val="1051513689"/>
                    </a:ext>
                  </a:extLst>
                </a:gridCol>
              </a:tblGrid>
              <a:tr h="179917">
                <a:tc>
                  <a:txBody>
                    <a:bodyPr/>
                    <a:lstStyle/>
                    <a:p>
                      <a:pPr algn="ctr">
                        <a:lnSpc>
                          <a:spcPct val="18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rker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8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orochrom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8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8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8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ufacturer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277597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AA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µl/sampl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2828062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22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3-6B2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4371290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R6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-2L1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772826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2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6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312092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A2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1436670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ε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7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500A2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9287965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ε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UV39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5-2C1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5779564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UV8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K1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7561135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64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K1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982538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K1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12779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667374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8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259197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8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-F1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537347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7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-F1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900602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8α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-6.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124464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XCR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2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XCR3-17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587280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XCR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XCR3-17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5832520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4/8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M8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6818282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xable viability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Fluor 78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330788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JK-16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3561052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JK-16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9695590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7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JK-16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6381981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A3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/Cy5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WAJ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543545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lio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488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F6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805779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lios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/Cy5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F6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1658178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-A/I-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5/114.15.2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701646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γ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E4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624814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γ 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/Cy5.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MG1.2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823438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7A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11-18H10.1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7681183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RγT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KJS-9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3003968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RγT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2D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vitrogen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2875389"/>
                  </a:ext>
                </a:extLst>
              </a:tr>
              <a:tr h="179917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-bet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4B1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587" marR="5258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076788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6BAFBD03-AB3D-4E56-9FE3-080CB15B612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93007" y="657577"/>
            <a:ext cx="270458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8 Antibodies used for flow cytometry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3579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975</TotalTime>
  <Words>1780</Words>
  <Application>Microsoft Office PowerPoint</Application>
  <PresentationFormat>Custom</PresentationFormat>
  <Paragraphs>29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Calibri</vt:lpstr>
      <vt:lpstr>Arial</vt:lpstr>
      <vt:lpstr>Calibri Light</vt:lpstr>
      <vt:lpstr>Arial Nov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ater</dc:creator>
  <cp:lastModifiedBy>Slater</cp:lastModifiedBy>
  <cp:revision>2588</cp:revision>
  <cp:lastPrinted>2020-03-05T19:16:46Z</cp:lastPrinted>
  <dcterms:created xsi:type="dcterms:W3CDTF">2018-12-20T15:34:39Z</dcterms:created>
  <dcterms:modified xsi:type="dcterms:W3CDTF">2020-04-09T19:56:15Z</dcterms:modified>
</cp:coreProperties>
</file>